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5" r:id="rId3"/>
    <p:sldId id="266" r:id="rId4"/>
    <p:sldId id="287" r:id="rId5"/>
    <p:sldId id="286" r:id="rId6"/>
    <p:sldId id="294" r:id="rId7"/>
    <p:sldId id="29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gin Nguyen" initials="MN" lastIdx="4" clrIdx="0">
    <p:extLst>
      <p:ext uri="{19B8F6BF-5375-455C-9EA6-DF929625EA0E}">
        <p15:presenceInfo xmlns:p15="http://schemas.microsoft.com/office/powerpoint/2012/main" userId="5019353cdda7aaeb" providerId="Windows Live"/>
      </p:ext>
    </p:extLst>
  </p:cmAuthor>
  <p:cmAuthor id="2" name="Yuk Y Sham" initials="YYS" lastIdx="1" clrIdx="1">
    <p:extLst>
      <p:ext uri="{19B8F6BF-5375-455C-9EA6-DF929625EA0E}">
        <p15:presenceInfo xmlns:p15="http://schemas.microsoft.com/office/powerpoint/2012/main" userId="Yuk Y Sha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8200"/>
    <a:srgbClr val="34CFCF"/>
    <a:srgbClr val="FF01FF"/>
    <a:srgbClr val="0F9C3C"/>
    <a:srgbClr val="1515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DCD2175-FEF5-4C21-BE42-1A2B03B60326}" v="119" dt="2020-12-05T01:46:13.7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48" autoAdjust="0"/>
    <p:restoredTop sz="94660"/>
  </p:normalViewPr>
  <p:slideViewPr>
    <p:cSldViewPr snapToGrid="0">
      <p:cViewPr>
        <p:scale>
          <a:sx n="100" d="100"/>
          <a:sy n="100" d="100"/>
        </p:scale>
        <p:origin x="792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24" Type="http://schemas.microsoft.com/office/2015/10/relationships/revisionInfo" Target="revisionInfo.xml"/><Relationship Id="rId5" Type="http://schemas.openxmlformats.org/officeDocument/2006/relationships/slide" Target="slides/slide4.xml"/><Relationship Id="rId23" Type="http://schemas.microsoft.com/office/2016/11/relationships/changesInfo" Target="changesInfos/changesInfo1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gin Nguyen" userId="5019353cdda7aaeb" providerId="LiveId" clId="{BDCD2175-FEF5-4C21-BE42-1A2B03B60326}"/>
    <pc:docChg chg="undo custSel addSld delSld modSld">
      <pc:chgData name="Megin Nguyen" userId="5019353cdda7aaeb" providerId="LiveId" clId="{BDCD2175-FEF5-4C21-BE42-1A2B03B60326}" dt="2020-12-05T01:46:37.561" v="984" actId="20577"/>
      <pc:docMkLst>
        <pc:docMk/>
      </pc:docMkLst>
      <pc:sldChg chg="addSp delSp modSp mod delCm">
        <pc:chgData name="Megin Nguyen" userId="5019353cdda7aaeb" providerId="LiveId" clId="{BDCD2175-FEF5-4C21-BE42-1A2B03B60326}" dt="2020-12-05T01:11:11.673" v="375" actId="478"/>
        <pc:sldMkLst>
          <pc:docMk/>
          <pc:sldMk cId="2739586894" sldId="279"/>
        </pc:sldMkLst>
        <pc:spChg chg="mod">
          <ac:chgData name="Megin Nguyen" userId="5019353cdda7aaeb" providerId="LiveId" clId="{BDCD2175-FEF5-4C21-BE42-1A2B03B60326}" dt="2020-12-05T00:46:47.779" v="362" actId="1036"/>
          <ac:spMkLst>
            <pc:docMk/>
            <pc:sldMk cId="2739586894" sldId="279"/>
            <ac:spMk id="152" creationId="{7B8E4A0D-5031-4A1B-9790-406DAF792D5B}"/>
          </ac:spMkLst>
        </pc:spChg>
        <pc:spChg chg="del">
          <ac:chgData name="Megin Nguyen" userId="5019353cdda7aaeb" providerId="LiveId" clId="{BDCD2175-FEF5-4C21-BE42-1A2B03B60326}" dt="2020-12-05T00:43:22.670" v="340" actId="478"/>
          <ac:spMkLst>
            <pc:docMk/>
            <pc:sldMk cId="2739586894" sldId="279"/>
            <ac:spMk id="304" creationId="{ECB754E8-48A4-4786-9490-3F6BD9F5F0A0}"/>
          </ac:spMkLst>
        </pc:spChg>
        <pc:grpChg chg="mod">
          <ac:chgData name="Megin Nguyen" userId="5019353cdda7aaeb" providerId="LiveId" clId="{BDCD2175-FEF5-4C21-BE42-1A2B03B60326}" dt="2020-12-05T00:42:30.063" v="331" actId="1076"/>
          <ac:grpSpMkLst>
            <pc:docMk/>
            <pc:sldMk cId="2739586894" sldId="279"/>
            <ac:grpSpMk id="2" creationId="{00000000-0000-0000-0000-000000000000}"/>
          </ac:grpSpMkLst>
        </pc:grpChg>
        <pc:graphicFrameChg chg="add del mod">
          <ac:chgData name="Megin Nguyen" userId="5019353cdda7aaeb" providerId="LiveId" clId="{BDCD2175-FEF5-4C21-BE42-1A2B03B60326}" dt="2020-12-05T01:11:11.673" v="375" actId="478"/>
          <ac:graphicFrameMkLst>
            <pc:docMk/>
            <pc:sldMk cId="2739586894" sldId="279"/>
            <ac:graphicFrameMk id="178" creationId="{8E2CE5D4-D48E-44AE-B5BB-3F4C226B767A}"/>
          </ac:graphicFrameMkLst>
        </pc:graphicFrameChg>
        <pc:picChg chg="mod">
          <ac:chgData name="Megin Nguyen" userId="5019353cdda7aaeb" providerId="LiveId" clId="{BDCD2175-FEF5-4C21-BE42-1A2B03B60326}" dt="2020-12-05T00:42:27.547" v="329" actId="1076"/>
          <ac:picMkLst>
            <pc:docMk/>
            <pc:sldMk cId="2739586894" sldId="279"/>
            <ac:picMk id="4" creationId="{ED446B98-BA37-4A2F-B066-D691A5D64946}"/>
          </ac:picMkLst>
        </pc:picChg>
        <pc:picChg chg="add del mod">
          <ac:chgData name="Megin Nguyen" userId="5019353cdda7aaeb" providerId="LiveId" clId="{BDCD2175-FEF5-4C21-BE42-1A2B03B60326}" dt="2020-12-05T00:42:43.802" v="333"/>
          <ac:picMkLst>
            <pc:docMk/>
            <pc:sldMk cId="2739586894" sldId="279"/>
            <ac:picMk id="176" creationId="{B3204128-3511-4F01-8926-03F51AFF5509}"/>
          </ac:picMkLst>
        </pc:picChg>
      </pc:sldChg>
      <pc:sldChg chg="modSp mod">
        <pc:chgData name="Megin Nguyen" userId="5019353cdda7aaeb" providerId="LiveId" clId="{BDCD2175-FEF5-4C21-BE42-1A2B03B60326}" dt="2020-12-05T01:45:47.754" v="981" actId="20577"/>
        <pc:sldMkLst>
          <pc:docMk/>
          <pc:sldMk cId="1394253872" sldId="291"/>
        </pc:sldMkLst>
        <pc:spChg chg="mod">
          <ac:chgData name="Megin Nguyen" userId="5019353cdda7aaeb" providerId="LiveId" clId="{BDCD2175-FEF5-4C21-BE42-1A2B03B60326}" dt="2020-12-05T01:45:47.754" v="981" actId="20577"/>
          <ac:spMkLst>
            <pc:docMk/>
            <pc:sldMk cId="1394253872" sldId="291"/>
            <ac:spMk id="5" creationId="{B75B0EDE-D7C4-42E3-8651-65133E01369D}"/>
          </ac:spMkLst>
        </pc:spChg>
      </pc:sldChg>
      <pc:sldChg chg="addSp delSp modSp new mod">
        <pc:chgData name="Megin Nguyen" userId="5019353cdda7aaeb" providerId="LiveId" clId="{BDCD2175-FEF5-4C21-BE42-1A2B03B60326}" dt="2020-12-05T00:39:29.288" v="325" actId="20577"/>
        <pc:sldMkLst>
          <pc:docMk/>
          <pc:sldMk cId="3669773805" sldId="294"/>
        </pc:sldMkLst>
        <pc:spChg chg="add mod">
          <ac:chgData name="Megin Nguyen" userId="5019353cdda7aaeb" providerId="LiveId" clId="{BDCD2175-FEF5-4C21-BE42-1A2B03B60326}" dt="2020-12-05T00:32:20.464" v="182" actId="20577"/>
          <ac:spMkLst>
            <pc:docMk/>
            <pc:sldMk cId="3669773805" sldId="294"/>
            <ac:spMk id="2" creationId="{BD0EF4E5-118A-4D4D-8340-3675C3FAF098}"/>
          </ac:spMkLst>
        </pc:spChg>
        <pc:spChg chg="add del mod topLvl">
          <ac:chgData name="Megin Nguyen" userId="5019353cdda7aaeb" providerId="LiveId" clId="{BDCD2175-FEF5-4C21-BE42-1A2B03B60326}" dt="2020-12-05T00:38:40.205" v="323" actId="478"/>
          <ac:spMkLst>
            <pc:docMk/>
            <pc:sldMk cId="3669773805" sldId="294"/>
            <ac:spMk id="4" creationId="{67699510-A11E-4F5D-B5C3-5AC2AB8148A0}"/>
          </ac:spMkLst>
        </pc:spChg>
        <pc:grpChg chg="add del mod">
          <ac:chgData name="Megin Nguyen" userId="5019353cdda7aaeb" providerId="LiveId" clId="{BDCD2175-FEF5-4C21-BE42-1A2B03B60326}" dt="2020-12-05T00:38:40.205" v="323" actId="478"/>
          <ac:grpSpMkLst>
            <pc:docMk/>
            <pc:sldMk cId="3669773805" sldId="294"/>
            <ac:grpSpMk id="8" creationId="{03259FEC-D6D1-4EDE-B5CC-BA724742B90B}"/>
          </ac:grpSpMkLst>
        </pc:grpChg>
        <pc:graphicFrameChg chg="add mod topLvl">
          <ac:chgData name="Megin Nguyen" userId="5019353cdda7aaeb" providerId="LiveId" clId="{BDCD2175-FEF5-4C21-BE42-1A2B03B60326}" dt="2020-12-05T00:39:29.288" v="325" actId="20577"/>
          <ac:graphicFrameMkLst>
            <pc:docMk/>
            <pc:sldMk cId="3669773805" sldId="294"/>
            <ac:graphicFrameMk id="3" creationId="{87081137-DD9F-474E-B142-850D93556530}"/>
          </ac:graphicFrameMkLst>
        </pc:graphicFrameChg>
        <pc:cxnChg chg="add del mod">
          <ac:chgData name="Megin Nguyen" userId="5019353cdda7aaeb" providerId="LiveId" clId="{BDCD2175-FEF5-4C21-BE42-1A2B03B60326}" dt="2020-12-05T00:37:42.065" v="320" actId="478"/>
          <ac:cxnSpMkLst>
            <pc:docMk/>
            <pc:sldMk cId="3669773805" sldId="294"/>
            <ac:cxnSpMk id="6" creationId="{806E9CD3-8743-4DC3-B0B8-236386A45BB1}"/>
          </ac:cxnSpMkLst>
        </pc:cxnChg>
        <pc:cxnChg chg="add del mod">
          <ac:chgData name="Megin Nguyen" userId="5019353cdda7aaeb" providerId="LiveId" clId="{BDCD2175-FEF5-4C21-BE42-1A2B03B60326}" dt="2020-12-05T00:37:41.220" v="319" actId="478"/>
          <ac:cxnSpMkLst>
            <pc:docMk/>
            <pc:sldMk cId="3669773805" sldId="294"/>
            <ac:cxnSpMk id="7" creationId="{F983B0F0-058A-4425-A6F4-F34D0DFDD70D}"/>
          </ac:cxnSpMkLst>
        </pc:cxnChg>
      </pc:sldChg>
      <pc:sldChg chg="addSp delSp modSp add mod delCm">
        <pc:chgData name="Megin Nguyen" userId="5019353cdda7aaeb" providerId="LiveId" clId="{BDCD2175-FEF5-4C21-BE42-1A2B03B60326}" dt="2020-12-05T01:46:37.561" v="984" actId="20577"/>
        <pc:sldMkLst>
          <pc:docMk/>
          <pc:sldMk cId="3158621930" sldId="295"/>
        </pc:sldMkLst>
        <pc:spChg chg="add mod">
          <ac:chgData name="Megin Nguyen" userId="5019353cdda7aaeb" providerId="LiveId" clId="{BDCD2175-FEF5-4C21-BE42-1A2B03B60326}" dt="2020-12-05T01:42:30.835" v="945" actId="164"/>
          <ac:spMkLst>
            <pc:docMk/>
            <pc:sldMk cId="3158621930" sldId="295"/>
            <ac:spMk id="7" creationId="{6F803FC5-4FBF-4D84-8D06-F95C7DF898BB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8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4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49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7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8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59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6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6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6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6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64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43:17.908" v="339" actId="478"/>
          <ac:spMkLst>
            <pc:docMk/>
            <pc:sldMk cId="3158621930" sldId="295"/>
            <ac:spMk id="66" creationId="{9D8921BC-7351-4BF3-B27D-60C8240BB621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68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69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70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71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72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73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7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7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77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79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8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8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8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86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90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92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94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96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98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99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101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10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0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0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1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1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1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17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18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3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47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1" creationId="{00000000-0000-0000-0000-000000000000}"/>
          </ac:spMkLst>
        </pc:spChg>
        <pc:spChg chg="del">
          <ac:chgData name="Megin Nguyen" userId="5019353cdda7aaeb" providerId="LiveId" clId="{BDCD2175-FEF5-4C21-BE42-1A2B03B60326}" dt="2020-12-05T00:42:53.953" v="335" actId="478"/>
          <ac:spMkLst>
            <pc:docMk/>
            <pc:sldMk cId="3158621930" sldId="295"/>
            <ac:spMk id="152" creationId="{7B8E4A0D-5031-4A1B-9790-406DAF792D5B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7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8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59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7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8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69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0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77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43:17.908" v="339" actId="478"/>
          <ac:spMkLst>
            <pc:docMk/>
            <pc:sldMk cId="3158621930" sldId="295"/>
            <ac:spMk id="180" creationId="{00000000-0000-0000-0000-000000000000}"/>
          </ac:spMkLst>
        </pc:spChg>
        <pc:spChg chg="del mod topLvl">
          <ac:chgData name="Megin Nguyen" userId="5019353cdda7aaeb" providerId="LiveId" clId="{BDCD2175-FEF5-4C21-BE42-1A2B03B60326}" dt="2020-12-05T00:43:17.908" v="339" actId="478"/>
          <ac:spMkLst>
            <pc:docMk/>
            <pc:sldMk cId="3158621930" sldId="295"/>
            <ac:spMk id="181" creationId="{00000000-0000-0000-0000-000000000000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183" creationId="{B9FB44E8-400B-423B-9A50-2C7BDA56E4F4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184" creationId="{09EED6B6-24E6-4661-A9A5-42ACECCE3D82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187" creationId="{E4AB17DD-636B-4E01-921C-038B05613BB1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1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2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3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4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5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6" creationId="{00000000-0000-0000-0000-00000000000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197" creationId="{00000000-0000-0000-0000-000000000000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198" creationId="{2FF64A9D-1D7A-49BE-B59C-D41BAFCDFD82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199" creationId="{9A3DAFF5-51BA-4F65-BD28-6789A6E5CAA4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03" creationId="{12733107-25BE-4F24-962F-DC88EA2E7D51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04" creationId="{EBB39184-5E45-4374-935B-F70B22B30A60}"/>
          </ac:spMkLst>
        </pc:spChg>
        <pc:spChg chg="mod topLvl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05" creationId="{F21845AD-32B3-44EF-BF41-703251973C4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08" creationId="{E4BDA9DE-E6B9-4E5C-AAD7-487FECF97ED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09" creationId="{DAAF3F8D-DC70-4706-A5D8-8FAF0E12CC4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0" creationId="{0F8BBA0E-E01B-431C-AFDB-EDFD1B6BC29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1" creationId="{AB24E69B-C09C-4C27-BF3C-6303E7B4A57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2" creationId="{28E19E29-4B14-4B8B-90B1-189669E0588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3" creationId="{382A7DF1-6FC9-483D-B78B-BFBFA548A8E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4" creationId="{F2F0F82C-281B-41E8-877E-5B289C17C59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5" creationId="{7B7FE422-5F57-47C8-BEA8-352B0D0E0AC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6" creationId="{BF9D5386-5E23-4214-95A5-A99451FB578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7" creationId="{3DC85743-C444-4B15-822E-D81F15D6507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8" creationId="{589235A6-2814-484B-A32B-88C25988906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19" creationId="{EB1DD131-F995-4B02-8D91-A5B10D268A8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0" creationId="{E0F3206E-34A1-4C2C-B5BC-7A82B129914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1" creationId="{A2C7452D-42D2-445E-AB75-354C763F5A6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2" creationId="{849A8671-7295-4083-9323-26F3C248581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4" creationId="{20B6D34B-BCCF-401F-A725-8BEF20F299F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5" creationId="{8A577E06-A06E-4A0B-9F67-BE690492B47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6" creationId="{5BABF0F8-6920-4AC9-8ACF-270894953AA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7" creationId="{5ED0F55A-FA81-49E1-B9C8-A201DD53AA1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8" creationId="{D9135618-42EB-4631-917C-D7BCEEB7289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29" creationId="{63713AC1-4109-4546-A077-0601F0FF686C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0" creationId="{27FD74E3-A76E-446C-AA75-0C014C5A542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1" creationId="{70CD8CA5-C9EC-4E7A-85E5-B5D4C7821B29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2" creationId="{05EC5F7A-0A85-41B5-9B00-B0FCFCC5AB6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3" creationId="{CC966917-01D9-4070-9852-B6DF7B35AA5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4" creationId="{3A07E054-20CF-43D2-8EB8-5B0C2F3D9D7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5" creationId="{4F138E5B-CC46-4CD6-B53D-BD6A82E80CD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6" creationId="{72D58E65-DE73-4994-9538-1933E838518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37" creationId="{711B5159-9E53-4EBD-9637-19310E76022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0" creationId="{9077DE32-0B96-424E-8B58-13FCE98F6B4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1" creationId="{B8262A1A-E924-46DD-9CF5-3C4F449FF92B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2" creationId="{E6FF2829-3BF4-4DD3-94A6-C7BFE4CB406A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3" creationId="{66604554-DECD-426C-A6AA-099DC118BD4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4" creationId="{43235063-1183-4A0B-B89A-6918E86F644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5" creationId="{0F0CFD55-2FCD-43BA-9305-218FE65B4D2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6" creationId="{E27F7C9E-3A63-4778-812B-9AF624A0E49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7" creationId="{5CF56C97-EC1B-4655-8FDD-21E2BCAF4FF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8" creationId="{02677E0D-1F35-4742-A5E5-5955A212D20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49" creationId="{838E85E5-7FB6-49AF-84F5-95FF11D2530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0" creationId="{1A3B1A38-C8AB-4706-8167-2C0A3B20669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1" creationId="{A63CAF7D-11D7-4E67-8550-2948396A1069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2" creationId="{E5378841-54D6-43D0-B432-A4B1AF3B4AF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3" creationId="{CFE0C57C-21C0-4FC5-93C4-D6C5F0BAB68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4" creationId="{5C0B9DE9-24FE-4685-89C4-A2DDE6B44E2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5" creationId="{14B33660-3E72-4C6B-99E9-6B13F261722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6" creationId="{BEE9BF06-F84D-44C0-8940-9AB462D63C3A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7" creationId="{7927A74E-747B-4DF1-9020-2ED4D19C6C4B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8" creationId="{55F3C461-E978-4780-A6AA-9E562D755EC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59" creationId="{71D03FD2-9EDF-4B99-BF5B-A691BDD2E7A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0" creationId="{0D60BE1F-B9D6-4E88-95C7-6A7B0FFFEB3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1" creationId="{CBF47C9A-153B-406D-A22C-94E64FBADCA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2" creationId="{F4633496-9675-44E5-8682-FE295334387A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3" creationId="{0F4A46A2-A941-404B-974B-147476997109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4" creationId="{DF9433A2-0542-45BB-B8D7-A5978B508FDB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5" creationId="{55EF0BD3-4286-4338-8DA9-91795808963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67" creationId="{79CECE07-CFE3-404B-B877-50FE1062188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0" creationId="{46AC2F27-61C9-46B2-A724-DE6CDAC1D0A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1" creationId="{189663B8-69E2-44B5-AFF4-ADDC2F73CC2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2" creationId="{FEC34F19-C4BB-4FC7-BB42-1D8E0492122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3" creationId="{38061E18-4617-4669-8596-7BDAEE735BD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4" creationId="{5AF8FC78-8BF8-48B7-ADB0-6AD8982FD77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5" creationId="{74F83FDC-60E3-4BC6-83B9-FAEBD500D49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6" creationId="{5FA12E2E-909E-4452-BA92-151F92525D7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8" creationId="{9AB3CEA1-E0EE-484F-B98A-90E3720EEDA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79" creationId="{4D5A1B37-73BB-4796-B0FD-691258A2FDC9}"/>
          </ac:spMkLst>
        </pc:spChg>
        <pc:spChg chg="del mod topLvl">
          <ac:chgData name="Megin Nguyen" userId="5019353cdda7aaeb" providerId="LiveId" clId="{BDCD2175-FEF5-4C21-BE42-1A2B03B60326}" dt="2020-12-05T00:43:17.908" v="339" actId="478"/>
          <ac:spMkLst>
            <pc:docMk/>
            <pc:sldMk cId="3158621930" sldId="295"/>
            <ac:spMk id="280" creationId="{D9B48154-9858-4125-A190-11E2017C32CC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281" creationId="{267A4D7D-FC43-4D00-AEF4-197E6AB2FCB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82" creationId="{0A352C28-2CA8-495B-9461-1CECB00F555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283" creationId="{EFEDF8A3-AC22-4DE5-BFDE-7B7AA811262A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87" creationId="{BDAF9C6B-5F24-4591-BD08-6D37448A3DE3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88" creationId="{CBA8C1A1-2F28-4014-B322-B46144ECB59C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89" creationId="{0A043BB1-EF73-40D4-93DE-8F03D2FEC292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0" creationId="{CCAEEB30-E5A3-4C60-8017-310B6B8E6BE8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1" creationId="{3BB09D89-C2E1-4A45-BEF3-8A658FDD72C8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2" creationId="{FA354C45-1C05-44ED-B05D-6B25DAACC618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3" creationId="{46DC9721-3937-44A9-89E5-AAC4FDED4BAD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4" creationId="{1A7185C3-8BAA-425B-8C0A-39830FCAB59C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5" creationId="{9FAC9E00-7F6E-47A8-BD7A-12E78EDDB828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6" creationId="{B2C389BD-892A-40F6-A1F3-14E4C5852CAD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7" creationId="{D112DBF9-124B-4288-8489-CEA67E182F97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8" creationId="{CD7031A5-5721-4183-B452-8D6F719863DC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299" creationId="{4B80730C-5CAF-4F35-8806-80CD5C2AA96C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0" creationId="{85D25D73-50D8-449C-945D-1B9A6351FDA8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1" creationId="{B85CEEFE-8153-402D-AAB0-D74866E2C57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2" creationId="{871AB47B-7D7B-4B10-962E-3FF0E0F9E4EA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3" creationId="{F916FFA6-BB31-4968-97C0-113AD8BF8BF7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4" creationId="{ECB754E8-48A4-4786-9490-3F6BD9F5F0A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5" creationId="{C72BD4E3-32CC-43A1-B5DA-4F1D665E033A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6" creationId="{058181A7-5E99-4C23-A0C1-D607BE0AB17F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7" creationId="{61B2A3A9-245F-42CC-9BC0-E59A3B1D7820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8" creationId="{C8B15569-85B4-4B45-A961-3D984A633B15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09" creationId="{ACE9D78C-838E-4120-AB35-38D3381E40B4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10" creationId="{BB73E59A-D293-45B5-88EE-D0EDE28F6F2E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11" creationId="{FA4A2538-9D20-4D73-8072-B423622CA8AF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12" creationId="{C75589E1-5E94-450E-BE32-BC5D7083BDC2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13" creationId="{B7353011-09F7-4C27-983A-CA670EE8CE12}"/>
          </ac:spMkLst>
        </pc:spChg>
        <pc:spChg chg="mod">
          <ac:chgData name="Megin Nguyen" userId="5019353cdda7aaeb" providerId="LiveId" clId="{BDCD2175-FEF5-4C21-BE42-1A2B03B60326}" dt="2020-12-05T00:43:12.911" v="338" actId="165"/>
          <ac:spMkLst>
            <pc:docMk/>
            <pc:sldMk cId="3158621930" sldId="295"/>
            <ac:spMk id="315" creationId="{C94EF5EF-EBF4-4670-983D-4779ADF4F169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16" creationId="{92B08E82-4748-4B31-AA97-42A0FCDF16F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17" creationId="{944969B4-9428-41BC-8621-CB60272A9F4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18" creationId="{70E91B9B-A399-48E2-80AA-999B0744488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19" creationId="{9581C864-6991-4736-A716-10558A05D83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3" creationId="{69749AC4-24E9-43DB-AAFF-BEBCBAEC492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4" creationId="{4C15FE98-685F-4E96-8B8E-D46BD40CE25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5" creationId="{39B346BA-16AB-4EB0-BE67-A032281AAC4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6" creationId="{E385A883-CAAA-4E6B-A6B5-4C7D58CB79A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7" creationId="{73EC8D28-C017-4A89-B400-A6840075EB2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8" creationId="{2F66C016-59A4-4BE4-9463-FC74EAC92BC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29" creationId="{5E268476-0D1B-4307-A121-25968E52C14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2" creationId="{24155B70-6DE1-4648-B07C-ECF21992F85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3" creationId="{793400FB-48A1-447B-A8B2-CD8A96FF36A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4" creationId="{F6E592F3-FB85-473B-B757-AEA20B55695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5" creationId="{3047F6FF-41F1-42C2-9CBC-6237F3BFACF9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6" creationId="{D895C0E6-76F8-483B-935A-F1C868D2332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7" creationId="{7B6DD82B-B3BC-4AE6-863E-13B03E447C3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39" creationId="{52DF9530-2BC8-4785-B929-5A7452F13A48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0" creationId="{05922B69-3E27-488E-B9CB-55E131E4438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1" creationId="{383D8F2A-DBD2-491E-86D4-9859F830E66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2" creationId="{A7F4DF56-CA7F-433E-9641-D9AEFEE9146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3" creationId="{80803E0E-A985-4AE3-BB20-757B8F36670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4" creationId="{805A4DA1-094B-414C-A9B5-F7633E6A97B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5" creationId="{66B0E148-91CC-450F-B071-EFB979E6D11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46" creationId="{5330EA6D-2194-4CED-8AF6-570E373834AE}"/>
          </ac:spMkLst>
        </pc:spChg>
        <pc:spChg chg="del mod topLvl">
          <ac:chgData name="Megin Nguyen" userId="5019353cdda7aaeb" providerId="LiveId" clId="{BDCD2175-FEF5-4C21-BE42-1A2B03B60326}" dt="2020-12-05T00:43:17.908" v="339" actId="478"/>
          <ac:spMkLst>
            <pc:docMk/>
            <pc:sldMk cId="3158621930" sldId="295"/>
            <ac:spMk id="348" creationId="{B4188E26-7917-4292-B656-2723770A7EB5}"/>
          </ac:spMkLst>
        </pc:spChg>
        <pc:spChg chg="del mod topLvl">
          <ac:chgData name="Megin Nguyen" userId="5019353cdda7aaeb" providerId="LiveId" clId="{BDCD2175-FEF5-4C21-BE42-1A2B03B60326}" dt="2020-12-05T00:43:17.908" v="339" actId="478"/>
          <ac:spMkLst>
            <pc:docMk/>
            <pc:sldMk cId="3158621930" sldId="295"/>
            <ac:spMk id="349" creationId="{D15A23B2-E2B8-4CD1-B4EF-13FDBDAC9A42}"/>
          </ac:spMkLst>
        </pc:spChg>
        <pc:spChg chg="del mod topLvl">
          <ac:chgData name="Megin Nguyen" userId="5019353cdda7aaeb" providerId="LiveId" clId="{BDCD2175-FEF5-4C21-BE42-1A2B03B60326}" dt="2020-12-05T00:56:49.913" v="367" actId="478"/>
          <ac:spMkLst>
            <pc:docMk/>
            <pc:sldMk cId="3158621930" sldId="295"/>
            <ac:spMk id="350" creationId="{276FA1AD-2543-4689-9E0A-2B5D09F9DBF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3" creationId="{40CB0AB9-EDC9-4932-AC1F-0CE97924A91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4" creationId="{587D13FB-B9C1-40CF-A228-A4771921BAE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5" creationId="{139FDB9B-D75C-483D-9D7C-1EF331D4088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6" creationId="{2A792745-29E1-46FF-A838-F47CDA61792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7" creationId="{24A14A6A-BB01-4C49-B84C-1FA30B71C48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8" creationId="{23F1E35F-C339-42F6-8E6F-0A8582CFC2AB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59" creationId="{46ECA1E7-D004-45AA-A967-326BA53CBBA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2" creationId="{5F517187-2334-453D-9F6D-9B85CC78692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3" creationId="{7F5E41FF-5F64-4B29-945B-3FF87B498AAF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4" creationId="{AB1D46AA-ABBC-45AD-BC47-6D611517DA0E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5" creationId="{36D4D53C-CB4D-40CE-B5CE-F07950206B7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6" creationId="{8F05DB9E-98BB-4A31-882A-FCFFA855165B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7" creationId="{9F6997CA-0AB6-4990-A616-F13BF516FB49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8" creationId="{CF8BC890-04AB-4AA8-8DDC-55C5DEB4BB8B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69" creationId="{47A3EEFB-CAFC-4094-91E0-BC2827FB2425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0" creationId="{F1EB845C-644B-4DCC-90E4-64B1A63E908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1" creationId="{8E0E6919-A1A6-4B7F-8F96-B83E17B9EC1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2" creationId="{31969241-B17E-4D1A-85A3-43C65718282C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3" creationId="{A0E0A4AD-1E7F-406B-9760-37470A596E1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4" creationId="{C39132D4-902B-4FB8-ACAB-CFC32608F61A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5" creationId="{776AE861-EB37-4F16-9F56-0B26B767D8D1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6" creationId="{48AFA934-462B-458B-9E69-7694FC941C64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7" creationId="{654BEC9D-C39F-4ED7-98EF-13757E7EFED6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8" creationId="{FBE97472-3F71-4FEB-A7A7-7D18EE78E350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79" creationId="{9AC8A58A-1801-4018-B8F2-22ACCB8A9F9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80" creationId="{157B320F-3DAF-405A-B9BC-5252F6035443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81" creationId="{8BF28BD9-CF3C-4F69-8892-721B597BE937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82" creationId="{7090AA78-2993-4435-AD30-2B2ECB0B3D42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83" creationId="{DA3815E3-F139-42F4-A8CB-00283B514A8D}"/>
          </ac:spMkLst>
        </pc:spChg>
        <pc:spChg chg="mod">
          <ac:chgData name="Megin Nguyen" userId="5019353cdda7aaeb" providerId="LiveId" clId="{BDCD2175-FEF5-4C21-BE42-1A2B03B60326}" dt="2020-12-05T00:57:01.402" v="369" actId="165"/>
          <ac:spMkLst>
            <pc:docMk/>
            <pc:sldMk cId="3158621930" sldId="295"/>
            <ac:spMk id="384" creationId="{A5659081-7BD8-4947-81E2-B85A1519FCBF}"/>
          </ac:spMkLst>
        </pc:spChg>
        <pc:spChg chg="add mod">
          <ac:chgData name="Megin Nguyen" userId="5019353cdda7aaeb" providerId="LiveId" clId="{BDCD2175-FEF5-4C21-BE42-1A2B03B60326}" dt="2020-12-05T01:42:30.835" v="945" actId="164"/>
          <ac:spMkLst>
            <pc:docMk/>
            <pc:sldMk cId="3158621930" sldId="295"/>
            <ac:spMk id="390" creationId="{06ED7D50-7F36-4C10-A8C8-B06DB84513F4}"/>
          </ac:spMkLst>
        </pc:spChg>
        <pc:spChg chg="add mod">
          <ac:chgData name="Megin Nguyen" userId="5019353cdda7aaeb" providerId="LiveId" clId="{BDCD2175-FEF5-4C21-BE42-1A2B03B60326}" dt="2020-12-05T01:42:30.835" v="945" actId="164"/>
          <ac:spMkLst>
            <pc:docMk/>
            <pc:sldMk cId="3158621930" sldId="295"/>
            <ac:spMk id="391" creationId="{B0C36D5D-C0D3-4821-906A-0D980C0FFAAE}"/>
          </ac:spMkLst>
        </pc:spChg>
        <pc:spChg chg="add mod">
          <ac:chgData name="Megin Nguyen" userId="5019353cdda7aaeb" providerId="LiveId" clId="{BDCD2175-FEF5-4C21-BE42-1A2B03B60326}" dt="2020-12-05T01:42:26.872" v="944" actId="164"/>
          <ac:spMkLst>
            <pc:docMk/>
            <pc:sldMk cId="3158621930" sldId="295"/>
            <ac:spMk id="392" creationId="{7ACF44F5-6D84-498C-A5B5-F24AC18E17BD}"/>
          </ac:spMkLst>
        </pc:spChg>
        <pc:spChg chg="add mod">
          <ac:chgData name="Megin Nguyen" userId="5019353cdda7aaeb" providerId="LiveId" clId="{BDCD2175-FEF5-4C21-BE42-1A2B03B60326}" dt="2020-12-05T01:42:26.872" v="944" actId="164"/>
          <ac:spMkLst>
            <pc:docMk/>
            <pc:sldMk cId="3158621930" sldId="295"/>
            <ac:spMk id="393" creationId="{EC8F2D88-AE33-464E-843B-F41D39A1D43D}"/>
          </ac:spMkLst>
        </pc:spChg>
        <pc:spChg chg="add mod">
          <ac:chgData name="Megin Nguyen" userId="5019353cdda7aaeb" providerId="LiveId" clId="{BDCD2175-FEF5-4C21-BE42-1A2B03B60326}" dt="2020-12-05T01:42:26.872" v="944" actId="164"/>
          <ac:spMkLst>
            <pc:docMk/>
            <pc:sldMk cId="3158621930" sldId="295"/>
            <ac:spMk id="394" creationId="{81B1D12D-2B28-4306-A4CE-25FC1DB158A3}"/>
          </ac:spMkLst>
        </pc:spChg>
        <pc:spChg chg="add mod">
          <ac:chgData name="Megin Nguyen" userId="5019353cdda7aaeb" providerId="LiveId" clId="{BDCD2175-FEF5-4C21-BE42-1A2B03B60326}" dt="2020-12-05T01:42:26.872" v="944" actId="164"/>
          <ac:spMkLst>
            <pc:docMk/>
            <pc:sldMk cId="3158621930" sldId="295"/>
            <ac:spMk id="395" creationId="{30C66579-F154-41AF-ADB8-0C9B430F874E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399" creationId="{88D728A5-7B07-4BC8-B905-F6336E85DF96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0" creationId="{308C577E-DA36-4A54-8929-FC20AC57A601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1" creationId="{3CAED164-C101-4225-B4A2-A09E7AF0ADF5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2" creationId="{41D5E8A8-967F-4520-BFB2-CE4624CC9B9C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3" creationId="{476DC8A8-6968-4DEF-8A8B-A57A59DB4B67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4" creationId="{752A9C1B-7BDC-49BA-B54A-0A35EA39058B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5" creationId="{01EB472C-F83A-4562-BAC5-1D8D289A9DD5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6" creationId="{F9826156-3D57-4DD4-AAF9-4F9CE87803EA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7" creationId="{236F36ED-7782-42F2-B54C-D9D067838173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8" creationId="{B2A864B6-7F94-4E64-A82E-0280E8D0E3C4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09" creationId="{7CB06FBF-8B9F-4E47-8073-7E2E90B573CF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10" creationId="{74B9C974-722E-48D8-9FAE-1CF3748E334F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11" creationId="{86200820-6717-45C2-87F4-396932E4C1DC}"/>
          </ac:spMkLst>
        </pc:spChg>
        <pc:spChg chg="mod">
          <ac:chgData name="Megin Nguyen" userId="5019353cdda7aaeb" providerId="LiveId" clId="{BDCD2175-FEF5-4C21-BE42-1A2B03B60326}" dt="2020-12-05T01:25:18.969" v="909"/>
          <ac:spMkLst>
            <pc:docMk/>
            <pc:sldMk cId="3158621930" sldId="295"/>
            <ac:spMk id="412" creationId="{2D04E33C-E979-4153-88BF-CFCBF22A034F}"/>
          </ac:spMkLst>
        </pc:spChg>
        <pc:spChg chg="add mod">
          <ac:chgData name="Megin Nguyen" userId="5019353cdda7aaeb" providerId="LiveId" clId="{BDCD2175-FEF5-4C21-BE42-1A2B03B60326}" dt="2020-12-05T01:46:37.561" v="984" actId="20577"/>
          <ac:spMkLst>
            <pc:docMk/>
            <pc:sldMk cId="3158621930" sldId="295"/>
            <ac:spMk id="415" creationId="{266AC66E-5DCF-45B0-BCD7-8F05F35C0EB8}"/>
          </ac:spMkLst>
        </pc:spChg>
        <pc:grpChg chg="del">
          <ac:chgData name="Megin Nguyen" userId="5019353cdda7aaeb" providerId="LiveId" clId="{BDCD2175-FEF5-4C21-BE42-1A2B03B60326}" dt="2020-12-05T00:43:12.911" v="338" actId="165"/>
          <ac:grpSpMkLst>
            <pc:docMk/>
            <pc:sldMk cId="3158621930" sldId="295"/>
            <ac:grpSpMk id="2" creationId="{00000000-0000-0000-0000-000000000000}"/>
          </ac:grpSpMkLst>
        </pc:grpChg>
        <pc:grpChg chg="add del mod">
          <ac:chgData name="Megin Nguyen" userId="5019353cdda7aaeb" providerId="LiveId" clId="{BDCD2175-FEF5-4C21-BE42-1A2B03B60326}" dt="2020-12-05T00:56:49.913" v="367" actId="478"/>
          <ac:grpSpMkLst>
            <pc:docMk/>
            <pc:sldMk cId="3158621930" sldId="295"/>
            <ac:grpSpMk id="6" creationId="{21A85C75-EB58-496F-8901-CE59701E722C}"/>
          </ac:grpSpMkLst>
        </pc:grpChg>
        <pc:grpChg chg="add mod">
          <ac:chgData name="Megin Nguyen" userId="5019353cdda7aaeb" providerId="LiveId" clId="{BDCD2175-FEF5-4C21-BE42-1A2B03B60326}" dt="2020-12-05T01:42:34.512" v="951" actId="1036"/>
          <ac:grpSpMkLst>
            <pc:docMk/>
            <pc:sldMk cId="3158621930" sldId="295"/>
            <ac:grpSpMk id="11" creationId="{285B3CDE-857D-43DF-AA12-8A5290620B30}"/>
          </ac:grpSpMkLst>
        </pc:grpChg>
        <pc:grpChg chg="del mod topLvl">
          <ac:chgData name="Megin Nguyen" userId="5019353cdda7aaeb" providerId="LiveId" clId="{BDCD2175-FEF5-4C21-BE42-1A2B03B60326}" dt="2020-12-05T00:43:17.908" v="339" actId="478"/>
          <ac:grpSpMkLst>
            <pc:docMk/>
            <pc:sldMk cId="3158621930" sldId="295"/>
            <ac:grpSpMk id="13" creationId="{42244CE1-5ED8-4C2D-8E08-FD5E34D7186F}"/>
          </ac:grpSpMkLst>
        </pc:grpChg>
        <pc:grpChg chg="add mod">
          <ac:chgData name="Megin Nguyen" userId="5019353cdda7aaeb" providerId="LiveId" clId="{BDCD2175-FEF5-4C21-BE42-1A2B03B60326}" dt="2020-12-05T01:42:38.707" v="955" actId="1036"/>
          <ac:grpSpMkLst>
            <pc:docMk/>
            <pc:sldMk cId="3158621930" sldId="295"/>
            <ac:grpSpMk id="14" creationId="{563C3ED6-491D-4510-BEC6-05F9B63C7CAB}"/>
          </ac:grpSpMkLst>
        </pc:grpChg>
        <pc:grpChg chg="del mod topLvl">
          <ac:chgData name="Megin Nguyen" userId="5019353cdda7aaeb" providerId="LiveId" clId="{BDCD2175-FEF5-4C21-BE42-1A2B03B60326}" dt="2020-12-05T00:56:49.913" v="367" actId="478"/>
          <ac:grpSpMkLst>
            <pc:docMk/>
            <pc:sldMk cId="3158621930" sldId="295"/>
            <ac:grpSpMk id="27" creationId="{083C74BA-0F23-412E-A8D8-9B70D6B3AB8A}"/>
          </ac:grpSpMkLst>
        </pc:grpChg>
        <pc:grpChg chg="del mod topLvl">
          <ac:chgData name="Megin Nguyen" userId="5019353cdda7aaeb" providerId="LiveId" clId="{BDCD2175-FEF5-4C21-BE42-1A2B03B60326}" dt="2020-12-05T00:43:17.908" v="339" actId="478"/>
          <ac:grpSpMkLst>
            <pc:docMk/>
            <pc:sldMk cId="3158621930" sldId="295"/>
            <ac:grpSpMk id="37" creationId="{BECBB9E9-7BE1-4251-9681-1765CDDBD071}"/>
          </ac:grpSpMkLst>
        </pc:grpChg>
        <pc:grpChg chg="del mod topLvl">
          <ac:chgData name="Megin Nguyen" userId="5019353cdda7aaeb" providerId="LiveId" clId="{BDCD2175-FEF5-4C21-BE42-1A2B03B60326}" dt="2020-12-05T00:43:37.682" v="341" actId="165"/>
          <ac:grpSpMkLst>
            <pc:docMk/>
            <pc:sldMk cId="3158621930" sldId="295"/>
            <ac:grpSpMk id="44" creationId="{084EAF5C-C623-489D-826E-23FA4E7E18B7}"/>
          </ac:grpSpMkLst>
        </pc:grpChg>
        <pc:grpChg chg="del mod topLvl">
          <ac:chgData name="Megin Nguyen" userId="5019353cdda7aaeb" providerId="LiveId" clId="{BDCD2175-FEF5-4C21-BE42-1A2B03B60326}" dt="2020-12-05T00:43:17.908" v="339" actId="478"/>
          <ac:grpSpMkLst>
            <pc:docMk/>
            <pc:sldMk cId="3158621930" sldId="295"/>
            <ac:grpSpMk id="65" creationId="{FB616C8C-C89E-4769-AB9D-8BECB47B18D5}"/>
          </ac:grpSpMkLst>
        </pc:grpChg>
        <pc:grpChg chg="mod">
          <ac:chgData name="Megin Nguyen" userId="5019353cdda7aaeb" providerId="LiveId" clId="{BDCD2175-FEF5-4C21-BE42-1A2B03B60326}" dt="2020-12-05T00:43:12.911" v="338" actId="165"/>
          <ac:grpSpMkLst>
            <pc:docMk/>
            <pc:sldMk cId="3158621930" sldId="295"/>
            <ac:grpSpMk id="75" creationId="{00000000-0000-0000-0000-000000000000}"/>
          </ac:grpSpMkLst>
        </pc:grpChg>
        <pc:grpChg chg="add del mod">
          <ac:chgData name="Megin Nguyen" userId="5019353cdda7aaeb" providerId="LiveId" clId="{BDCD2175-FEF5-4C21-BE42-1A2B03B60326}" dt="2020-12-05T00:57:01.402" v="369" actId="165"/>
          <ac:grpSpMkLst>
            <pc:docMk/>
            <pc:sldMk cId="3158621930" sldId="295"/>
            <ac:grpSpMk id="179" creationId="{AB0CCF78-0626-491A-A846-39C9997FCDAA}"/>
          </ac:grpSpMkLst>
        </pc:grpChg>
        <pc:grpChg chg="mod topLvl">
          <ac:chgData name="Megin Nguyen" userId="5019353cdda7aaeb" providerId="LiveId" clId="{BDCD2175-FEF5-4C21-BE42-1A2B03B60326}" dt="2020-12-05T00:57:01.402" v="369" actId="165"/>
          <ac:grpSpMkLst>
            <pc:docMk/>
            <pc:sldMk cId="3158621930" sldId="295"/>
            <ac:grpSpMk id="182" creationId="{285D867C-984D-47ED-9E2C-115768581DEC}"/>
          </ac:grpSpMkLst>
        </pc:grpChg>
        <pc:grpChg chg="mod topLvl">
          <ac:chgData name="Megin Nguyen" userId="5019353cdda7aaeb" providerId="LiveId" clId="{BDCD2175-FEF5-4C21-BE42-1A2B03B60326}" dt="2020-12-05T00:57:01.402" v="369" actId="165"/>
          <ac:grpSpMkLst>
            <pc:docMk/>
            <pc:sldMk cId="3158621930" sldId="295"/>
            <ac:grpSpMk id="185" creationId="{5379A009-A3A0-413E-9D52-EBF7799FD9A7}"/>
          </ac:grpSpMkLst>
        </pc:grpChg>
        <pc:grpChg chg="mod topLvl">
          <ac:chgData name="Megin Nguyen" userId="5019353cdda7aaeb" providerId="LiveId" clId="{BDCD2175-FEF5-4C21-BE42-1A2B03B60326}" dt="2020-12-05T01:42:42.202" v="958" actId="1035"/>
          <ac:grpSpMkLst>
            <pc:docMk/>
            <pc:sldMk cId="3158621930" sldId="295"/>
            <ac:grpSpMk id="186" creationId="{6A3BF8A5-08E4-45B1-942D-05E4417ABD87}"/>
          </ac:grpSpMkLst>
        </pc:grpChg>
        <pc:grpChg chg="mod">
          <ac:chgData name="Megin Nguyen" userId="5019353cdda7aaeb" providerId="LiveId" clId="{BDCD2175-FEF5-4C21-BE42-1A2B03B60326}" dt="2020-12-05T00:43:12.911" v="338" actId="165"/>
          <ac:grpSpMkLst>
            <pc:docMk/>
            <pc:sldMk cId="3158621930" sldId="295"/>
            <ac:grpSpMk id="188" creationId="{00000000-0000-0000-0000-000000000000}"/>
          </ac:grpSpMkLst>
        </pc:grpChg>
        <pc:grpChg chg="mod topLvl">
          <ac:chgData name="Megin Nguyen" userId="5019353cdda7aaeb" providerId="LiveId" clId="{BDCD2175-FEF5-4C21-BE42-1A2B03B60326}" dt="2020-12-05T01:42:13.576" v="941" actId="1036"/>
          <ac:grpSpMkLst>
            <pc:docMk/>
            <pc:sldMk cId="3158621930" sldId="295"/>
            <ac:grpSpMk id="200" creationId="{F133E598-56A3-4C4C-B9B5-A7E43A36C29C}"/>
          </ac:grpSpMkLst>
        </pc:grpChg>
        <pc:grpChg chg="del mod topLvl">
          <ac:chgData name="Megin Nguyen" userId="5019353cdda7aaeb" providerId="LiveId" clId="{BDCD2175-FEF5-4C21-BE42-1A2B03B60326}" dt="2020-12-05T00:57:03.838" v="370" actId="478"/>
          <ac:grpSpMkLst>
            <pc:docMk/>
            <pc:sldMk cId="3158621930" sldId="295"/>
            <ac:grpSpMk id="201" creationId="{C8CC10A9-DDF9-462A-AC85-62AC1D773FC7}"/>
          </ac:grpSpMkLst>
        </pc:grpChg>
        <pc:grpChg chg="del mod topLvl">
          <ac:chgData name="Megin Nguyen" userId="5019353cdda7aaeb" providerId="LiveId" clId="{BDCD2175-FEF5-4C21-BE42-1A2B03B60326}" dt="2020-12-05T00:57:04.294" v="371" actId="478"/>
          <ac:grpSpMkLst>
            <pc:docMk/>
            <pc:sldMk cId="3158621930" sldId="295"/>
            <ac:grpSpMk id="202" creationId="{313FBC16-428A-4E6B-AD0C-E614B15FA97D}"/>
          </ac:grpSpMkLst>
        </pc:grpChg>
        <pc:grpChg chg="del mod topLvl">
          <ac:chgData name="Megin Nguyen" userId="5019353cdda7aaeb" providerId="LiveId" clId="{BDCD2175-FEF5-4C21-BE42-1A2B03B60326}" dt="2020-12-05T00:43:17.908" v="339" actId="478"/>
          <ac:grpSpMkLst>
            <pc:docMk/>
            <pc:sldMk cId="3158621930" sldId="295"/>
            <ac:grpSpMk id="284" creationId="{EEC48F1A-7815-4368-BAA4-EA30335B4D2F}"/>
          </ac:grpSpMkLst>
        </pc:grpChg>
        <pc:grpChg chg="mod">
          <ac:chgData name="Megin Nguyen" userId="5019353cdda7aaeb" providerId="LiveId" clId="{BDCD2175-FEF5-4C21-BE42-1A2B03B60326}" dt="2020-12-05T00:57:01.402" v="369" actId="165"/>
          <ac:grpSpMkLst>
            <pc:docMk/>
            <pc:sldMk cId="3158621930" sldId="295"/>
            <ac:grpSpMk id="320" creationId="{CA34EDC1-25BD-4904-B84E-D5135E685F0C}"/>
          </ac:grpSpMkLst>
        </pc:grpChg>
        <pc:grpChg chg="mod">
          <ac:chgData name="Megin Nguyen" userId="5019353cdda7aaeb" providerId="LiveId" clId="{BDCD2175-FEF5-4C21-BE42-1A2B03B60326}" dt="2020-12-05T00:57:01.402" v="369" actId="165"/>
          <ac:grpSpMkLst>
            <pc:docMk/>
            <pc:sldMk cId="3158621930" sldId="295"/>
            <ac:grpSpMk id="347" creationId="{564BBEF5-48A6-4458-A655-F3D20F9ED44F}"/>
          </ac:grpSpMkLst>
        </pc:grpChg>
        <pc:grpChg chg="add mod">
          <ac:chgData name="Megin Nguyen" userId="5019353cdda7aaeb" providerId="LiveId" clId="{BDCD2175-FEF5-4C21-BE42-1A2B03B60326}" dt="2020-12-05T01:42:54.250" v="959" actId="1076"/>
          <ac:grpSpMkLst>
            <pc:docMk/>
            <pc:sldMk cId="3158621930" sldId="295"/>
            <ac:grpSpMk id="397" creationId="{403E39B4-396C-4BD3-A9C3-EFE92EB23E31}"/>
          </ac:grpSpMkLst>
        </pc:grpChg>
        <pc:graphicFrameChg chg="add del mod ord">
          <ac:chgData name="Megin Nguyen" userId="5019353cdda7aaeb" providerId="LiveId" clId="{BDCD2175-FEF5-4C21-BE42-1A2B03B60326}" dt="2020-12-05T01:42:30.835" v="945" actId="164"/>
          <ac:graphicFrameMkLst>
            <pc:docMk/>
            <pc:sldMk cId="3158621930" sldId="295"/>
            <ac:graphicFrameMk id="385" creationId="{8E2CE5D4-D48E-44AE-B5BB-3F4C226B767A}"/>
          </ac:graphicFrameMkLst>
        </pc:graphicFrameChg>
        <pc:graphicFrameChg chg="add del mod">
          <ac:chgData name="Megin Nguyen" userId="5019353cdda7aaeb" providerId="LiveId" clId="{BDCD2175-FEF5-4C21-BE42-1A2B03B60326}" dt="2020-12-05T01:42:26.872" v="944" actId="164"/>
          <ac:graphicFrameMkLst>
            <pc:docMk/>
            <pc:sldMk cId="3158621930" sldId="295"/>
            <ac:graphicFrameMk id="386" creationId="{8E2CE5D4-D48E-44AE-B5BB-3F4C226B767A}"/>
          </ac:graphicFrameMkLst>
        </pc:graphicFrameChg>
        <pc:graphicFrameChg chg="add mod">
          <ac:chgData name="Megin Nguyen" userId="5019353cdda7aaeb" providerId="LiveId" clId="{BDCD2175-FEF5-4C21-BE42-1A2B03B60326}" dt="2020-12-05T01:29:02.040" v="927"/>
          <ac:graphicFrameMkLst>
            <pc:docMk/>
            <pc:sldMk cId="3158621930" sldId="295"/>
            <ac:graphicFrameMk id="413" creationId="{8E2CE5D4-D48E-44AE-B5BB-3F4C226B767A}"/>
          </ac:graphicFrameMkLst>
        </pc:graphicFrameChg>
        <pc:graphicFrameChg chg="add mod">
          <ac:chgData name="Megin Nguyen" userId="5019353cdda7aaeb" providerId="LiveId" clId="{BDCD2175-FEF5-4C21-BE42-1A2B03B60326}" dt="2020-12-05T01:28:59.847" v="923"/>
          <ac:graphicFrameMkLst>
            <pc:docMk/>
            <pc:sldMk cId="3158621930" sldId="295"/>
            <ac:graphicFrameMk id="414" creationId="{8E2CE5D4-D48E-44AE-B5BB-3F4C226B767A}"/>
          </ac:graphicFrameMkLst>
        </pc:graphicFrame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3" creationId="{B18FD82D-82F6-48B1-866C-3B49E75CB4B2}"/>
          </ac:picMkLst>
        </pc:picChg>
        <pc:picChg chg="del mod topLvl">
          <ac:chgData name="Megin Nguyen" userId="5019353cdda7aaeb" providerId="LiveId" clId="{BDCD2175-FEF5-4C21-BE42-1A2B03B60326}" dt="2020-12-05T00:56:49.913" v="367" actId="478"/>
          <ac:picMkLst>
            <pc:docMk/>
            <pc:sldMk cId="3158621930" sldId="295"/>
            <ac:picMk id="4" creationId="{ED446B98-BA37-4A2F-B066-D691A5D64946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5" creationId="{6116DDB1-1B5B-4681-91DA-247CCC1B28B1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9" creationId="{0015581D-9416-44BC-B2E7-E44FDD2B94BF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8" creationId="{A9D79E25-B55D-4F75-88F7-4653C7D81E21}"/>
          </ac:picMkLst>
        </pc:picChg>
        <pc:picChg chg="del mod topLvl">
          <ac:chgData name="Megin Nguyen" userId="5019353cdda7aaeb" providerId="LiveId" clId="{BDCD2175-FEF5-4C21-BE42-1A2B03B60326}" dt="2020-12-05T00:56:49.913" v="367" actId="478"/>
          <ac:picMkLst>
            <pc:docMk/>
            <pc:sldMk cId="3158621930" sldId="295"/>
            <ac:picMk id="19" creationId="{09A36DE6-8ECA-4475-BCB9-974522CA2094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56" creationId="{A9D79E25-B55D-4F75-88F7-4653C7D81E21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15" creationId="{46AD38FF-701A-4A7C-8077-F1D3FF6006DC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20" creationId="{A768852E-7C92-4B7D-9507-0D4697D2AAB3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28" creationId="{A453C95A-0018-492B-8F6B-0BC1EB8B734C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34" creationId="{A768852E-7C92-4B7D-9507-0D4697D2AAB3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38" creationId="{A768852E-7C92-4B7D-9507-0D4697D2AAB3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39" creationId="{0015581D-9416-44BC-B2E7-E44FDD2B94BF}"/>
          </ac:picMkLst>
        </pc:picChg>
        <pc:picChg chg="add mod modCrop">
          <ac:chgData name="Megin Nguyen" userId="5019353cdda7aaeb" providerId="LiveId" clId="{BDCD2175-FEF5-4C21-BE42-1A2B03B60326}" dt="2020-12-05T00:45:53.454" v="356" actId="164"/>
          <ac:picMkLst>
            <pc:docMk/>
            <pc:sldMk cId="3158621930" sldId="295"/>
            <ac:picMk id="176" creationId="{AA48C520-B296-47FE-8A4B-7F1878897679}"/>
          </ac:picMkLst>
        </pc:picChg>
        <pc:picChg chg="add mod modCrop">
          <ac:chgData name="Megin Nguyen" userId="5019353cdda7aaeb" providerId="LiveId" clId="{BDCD2175-FEF5-4C21-BE42-1A2B03B60326}" dt="2020-12-05T00:45:53.454" v="356" actId="164"/>
          <ac:picMkLst>
            <pc:docMk/>
            <pc:sldMk cId="3158621930" sldId="295"/>
            <ac:picMk id="178" creationId="{BA991387-F454-4393-9AB0-8D756DEE8A26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89" creationId="{A9D79E25-B55D-4F75-88F7-4653C7D81E21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190" creationId="{A768852E-7C92-4B7D-9507-0D4697D2AAB3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06" creationId="{7C251DE4-EC94-41B8-9A6B-A8145B92E1AE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07" creationId="{0DAB2606-4D01-4670-A998-7B0AF2F7C6D6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23" creationId="{9006C460-6C59-4AE2-9F47-CA067BEFDCD0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38" creationId="{2905A6F0-1DC8-4019-806E-E1CF01CA3868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39" creationId="{132B7A8E-D55F-4606-88AD-C509A473358D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66" creationId="{72142A67-5E42-4767-AAE3-21349E515958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68" creationId="{176EA2AF-97A3-472E-AA6A-DDF54502B88F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69" creationId="{C12FE344-B432-4134-B05D-D8A7AF4F8749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277" creationId="{E107BDAD-9BE4-4A19-B56E-D5A1DF16E5A3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285" creationId="{1AF12576-4D5E-45BD-B8AA-EAE64E9D43DD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286" creationId="{0E95076C-C028-4C5C-BB57-B0DB6ED42628}"/>
          </ac:picMkLst>
        </pc:picChg>
        <pc:picChg chg="mod">
          <ac:chgData name="Megin Nguyen" userId="5019353cdda7aaeb" providerId="LiveId" clId="{BDCD2175-FEF5-4C21-BE42-1A2B03B60326}" dt="2020-12-05T00:43:12.911" v="338" actId="165"/>
          <ac:picMkLst>
            <pc:docMk/>
            <pc:sldMk cId="3158621930" sldId="295"/>
            <ac:picMk id="314" creationId="{3F00E653-1368-4EF3-BF7D-A56FB2485E93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21" creationId="{9406F9FA-C91E-4FC9-8A53-E0514D8846A8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22" creationId="{3CF11752-530B-4F86-BD12-CDC468C00CE6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30" creationId="{B4088D4C-39A4-4C55-B47A-55CBD7908B75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31" creationId="{0F718ECA-5F7F-4853-92B8-90FDD06BB3EB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38" creationId="{24335A46-8A67-4AA8-B0B2-3E4316096254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51" creationId="{291EABB2-4CE0-4BDD-BF29-76378CBAD831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52" creationId="{1BC75E08-2F56-4D89-B59D-2158B26653E3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60" creationId="{34142470-8664-4840-A8A5-D89A12DEAADE}"/>
          </ac:picMkLst>
        </pc:picChg>
        <pc:picChg chg="mod">
          <ac:chgData name="Megin Nguyen" userId="5019353cdda7aaeb" providerId="LiveId" clId="{BDCD2175-FEF5-4C21-BE42-1A2B03B60326}" dt="2020-12-05T00:57:01.402" v="369" actId="165"/>
          <ac:picMkLst>
            <pc:docMk/>
            <pc:sldMk cId="3158621930" sldId="295"/>
            <ac:picMk id="361" creationId="{4471EF53-5042-4D37-9686-D8E35171D24D}"/>
          </ac:picMkLst>
        </pc:picChg>
        <pc:picChg chg="add mod modCrop">
          <ac:chgData name="Megin Nguyen" userId="5019353cdda7aaeb" providerId="LiveId" clId="{BDCD2175-FEF5-4C21-BE42-1A2B03B60326}" dt="2020-12-05T01:42:30.835" v="945" actId="164"/>
          <ac:picMkLst>
            <pc:docMk/>
            <pc:sldMk cId="3158621930" sldId="295"/>
            <ac:picMk id="387" creationId="{E97FCAF1-77B5-441C-89A4-5906311F824A}"/>
          </ac:picMkLst>
        </pc:picChg>
        <pc:picChg chg="add mod modCrop">
          <ac:chgData name="Megin Nguyen" userId="5019353cdda7aaeb" providerId="LiveId" clId="{BDCD2175-FEF5-4C21-BE42-1A2B03B60326}" dt="2020-12-05T01:42:26.872" v="944" actId="164"/>
          <ac:picMkLst>
            <pc:docMk/>
            <pc:sldMk cId="3158621930" sldId="295"/>
            <ac:picMk id="388" creationId="{506A178C-8BA6-41B3-B514-E8C9213E6CB0}"/>
          </ac:picMkLst>
        </pc:picChg>
        <pc:picChg chg="add del mod modCrop">
          <ac:chgData name="Megin Nguyen" userId="5019353cdda7aaeb" providerId="LiveId" clId="{BDCD2175-FEF5-4C21-BE42-1A2B03B60326}" dt="2020-12-05T01:20:58.706" v="559" actId="478"/>
          <ac:picMkLst>
            <pc:docMk/>
            <pc:sldMk cId="3158621930" sldId="295"/>
            <ac:picMk id="389" creationId="{647FFF6D-FAC0-4D6B-8642-D15F233CB179}"/>
          </ac:picMkLst>
        </pc:picChg>
        <pc:picChg chg="add mod">
          <ac:chgData name="Megin Nguyen" userId="5019353cdda7aaeb" providerId="LiveId" clId="{BDCD2175-FEF5-4C21-BE42-1A2B03B60326}" dt="2020-12-05T01:42:57.593" v="960" actId="1076"/>
          <ac:picMkLst>
            <pc:docMk/>
            <pc:sldMk cId="3158621930" sldId="295"/>
            <ac:picMk id="396" creationId="{73A94FC8-9A91-4E3B-AEB4-358326A98B7B}"/>
          </ac:picMkLst>
        </pc:picChg>
        <pc:picChg chg="mod">
          <ac:chgData name="Megin Nguyen" userId="5019353cdda7aaeb" providerId="LiveId" clId="{BDCD2175-FEF5-4C21-BE42-1A2B03B60326}" dt="2020-12-05T01:25:18.969" v="909"/>
          <ac:picMkLst>
            <pc:docMk/>
            <pc:sldMk cId="3158621930" sldId="295"/>
            <ac:picMk id="398" creationId="{8215CEBC-D512-4C75-B9D2-CECF97E58665}"/>
          </ac:picMkLst>
        </pc:picChg>
      </pc:sldChg>
      <pc:sldChg chg="addSp delSp modSp new del mod">
        <pc:chgData name="Megin Nguyen" userId="5019353cdda7aaeb" providerId="LiveId" clId="{BDCD2175-FEF5-4C21-BE42-1A2B03B60326}" dt="2020-12-05T01:45:08.191" v="961" actId="2696"/>
        <pc:sldMkLst>
          <pc:docMk/>
          <pc:sldMk cId="793350863" sldId="296"/>
        </pc:sldMkLst>
        <pc:spChg chg="del mod topLvl">
          <ac:chgData name="Megin Nguyen" userId="5019353cdda7aaeb" providerId="LiveId" clId="{BDCD2175-FEF5-4C21-BE42-1A2B03B60326}" dt="2020-12-05T01:16:17.271" v="444" actId="478"/>
          <ac:spMkLst>
            <pc:docMk/>
            <pc:sldMk cId="793350863" sldId="296"/>
            <ac:spMk id="4" creationId="{2F9A3A44-AD21-41B3-87AE-5E062292FDC3}"/>
          </ac:spMkLst>
        </pc:spChg>
        <pc:spChg chg="del mod topLvl">
          <ac:chgData name="Megin Nguyen" userId="5019353cdda7aaeb" providerId="LiveId" clId="{BDCD2175-FEF5-4C21-BE42-1A2B03B60326}" dt="2020-12-05T01:16:17.271" v="444" actId="478"/>
          <ac:spMkLst>
            <pc:docMk/>
            <pc:sldMk cId="793350863" sldId="296"/>
            <ac:spMk id="5" creationId="{765BB35E-2B94-4F5D-96EE-45D73A341510}"/>
          </ac:spMkLst>
        </pc:spChg>
        <pc:spChg chg="del mod topLvl">
          <ac:chgData name="Megin Nguyen" userId="5019353cdda7aaeb" providerId="LiveId" clId="{BDCD2175-FEF5-4C21-BE42-1A2B03B60326}" dt="2020-12-05T01:16:17.271" v="444" actId="478"/>
          <ac:spMkLst>
            <pc:docMk/>
            <pc:sldMk cId="793350863" sldId="296"/>
            <ac:spMk id="8" creationId="{7B2C501A-64BC-4AE0-8376-3E99CADC00A3}"/>
          </ac:spMkLst>
        </pc:spChg>
        <pc:spChg chg="del mod topLvl">
          <ac:chgData name="Megin Nguyen" userId="5019353cdda7aaeb" providerId="LiveId" clId="{BDCD2175-FEF5-4C21-BE42-1A2B03B60326}" dt="2020-12-05T01:16:17.271" v="444" actId="478"/>
          <ac:spMkLst>
            <pc:docMk/>
            <pc:sldMk cId="793350863" sldId="296"/>
            <ac:spMk id="9" creationId="{255D053A-AD55-4097-85C3-2D6B6A84EF8E}"/>
          </ac:spMkLst>
        </pc:spChg>
        <pc:spChg chg="mod topLvl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10" creationId="{12F6F7F9-CCF4-45E5-BB41-223423600E13}"/>
          </ac:spMkLst>
        </pc:spChg>
        <pc:spChg chg="del mod topLvl">
          <ac:chgData name="Megin Nguyen" userId="5019353cdda7aaeb" providerId="LiveId" clId="{BDCD2175-FEF5-4C21-BE42-1A2B03B60326}" dt="2020-12-05T01:16:17.271" v="444" actId="478"/>
          <ac:spMkLst>
            <pc:docMk/>
            <pc:sldMk cId="793350863" sldId="296"/>
            <ac:spMk id="14" creationId="{26336335-984A-4D41-9E39-CBA228881834}"/>
          </ac:spMkLst>
        </pc:spChg>
        <pc:spChg chg="del mod topLvl">
          <ac:chgData name="Megin Nguyen" userId="5019353cdda7aaeb" providerId="LiveId" clId="{BDCD2175-FEF5-4C21-BE42-1A2B03B60326}" dt="2020-12-05T01:16:17.271" v="444" actId="478"/>
          <ac:spMkLst>
            <pc:docMk/>
            <pc:sldMk cId="793350863" sldId="296"/>
            <ac:spMk id="15" creationId="{524DF46C-5357-4614-80CE-077DCDDEC1F6}"/>
          </ac:spMkLst>
        </pc:spChg>
        <pc:spChg chg="mod topLvl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16" creationId="{FE71475A-DA3D-4DBD-AEAA-F2EFA69D06D1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19" creationId="{4AEF97E0-AFD2-4030-8B3F-F52376322190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0" creationId="{FAE9CBCA-E560-4AB7-B028-53D8F644727F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1" creationId="{819BC287-8C65-43D8-8267-7E3C9353B09A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2" creationId="{0DCC3E7A-58FB-4060-A559-D8AF469C06FA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3" creationId="{2F7CD1BF-6A6D-4CA5-BE01-17FAEC418830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4" creationId="{85011D4C-6210-44C2-8F66-9C0D8E0BB21E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5" creationId="{E9170A33-7E45-4D1F-BEFE-C18AF9C26250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6" creationId="{731B4650-1E42-4247-9264-AADA576E8B93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7" creationId="{D7B87B67-9EA2-4F02-A66A-7F78751FB8D9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8" creationId="{A32FFC43-B2F8-487E-9923-AE73E487D1A0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29" creationId="{CB2E7049-72A3-4B96-924F-40F647E5D4CA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30" creationId="{6E624AB3-ECA7-4B1E-886D-687BFD38CC73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31" creationId="{215A9B2F-E78A-44E9-879E-5D4A3DFEB293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32" creationId="{20FC3D7E-3C31-4762-86B4-2BC785E459D3}"/>
          </ac:spMkLst>
        </pc:spChg>
        <pc:spChg chg="mod topLvl">
          <ac:chgData name="Megin Nguyen" userId="5019353cdda7aaeb" providerId="LiveId" clId="{BDCD2175-FEF5-4C21-BE42-1A2B03B60326}" dt="2020-12-05T01:17:07.057" v="453" actId="165"/>
          <ac:spMkLst>
            <pc:docMk/>
            <pc:sldMk cId="793350863" sldId="296"/>
            <ac:spMk id="33" creationId="{83855F51-B23E-4560-875D-B2F0E987866E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35" creationId="{D8AA2884-96C7-434A-88AD-BAA90F2492CD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36" creationId="{3007417E-DFA5-43F1-802A-F4EC0AA7E4C7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37" creationId="{5E258CCF-2133-4474-B331-01E4327A04B6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38" creationId="{BD13CC84-57BF-4C0D-94F7-BE71E00B0524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39" creationId="{3AB82028-0A8D-472A-9ADE-EEEE413F3CF6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0" creationId="{95C487E8-316F-4342-A246-C426E104F990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1" creationId="{A5904C20-F905-4A3D-8774-269BB21F454C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2" creationId="{9EA13F66-0919-4330-98AA-0BF0D5442B75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3" creationId="{10B918D6-B2F8-4037-AAE3-48781EE388E7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4" creationId="{3B907665-36FB-4F73-A017-8CE9A2B969DF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5" creationId="{AA7A66A0-328C-479C-9CD0-2802AC17B992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6" creationId="{63CE0A41-F96F-4E12-8555-36C9D18C6AF4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7" creationId="{487074AC-FB25-4499-8163-2571EDD38A5D}"/>
          </ac:spMkLst>
        </pc:spChg>
        <pc:spChg chg="mod">
          <ac:chgData name="Megin Nguyen" userId="5019353cdda7aaeb" providerId="LiveId" clId="{BDCD2175-FEF5-4C21-BE42-1A2B03B60326}" dt="2020-12-05T01:17:04.661" v="452" actId="338"/>
          <ac:spMkLst>
            <pc:docMk/>
            <pc:sldMk cId="793350863" sldId="296"/>
            <ac:spMk id="48" creationId="{A50F5BDB-27C3-4ECF-B6E1-83EA3CB99E2C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1" creationId="{3F1255A9-498C-4D5D-A8A3-4F5327D3909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2" creationId="{98A69E13-01E1-4420-9F0E-B00D09206EBB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3" creationId="{BED7C59E-11C5-4E1F-9344-FE6FE098871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4" creationId="{1B4C895B-19B6-4DFA-8343-DFF015DC3803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5" creationId="{656A71DD-1FCA-4A07-A94B-5965262B7F4A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6" creationId="{F092F0CE-4DAF-4AA1-952B-6B8D45A73377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7" creationId="{C9460282-1C13-4062-95CB-43AFAC66022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8" creationId="{D048D6EA-ACEA-4824-9BB8-A5A04FBB571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59" creationId="{6202A54B-FF6F-4A9D-8FA2-C005A8D00D6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0" creationId="{BDA5A481-EE95-4723-876C-920C678BECDF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1" creationId="{781401F8-8420-4B00-8ACA-2B7FAD00AB39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2" creationId="{7A642B6C-8D94-49FF-87E5-E338C9784B58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3" creationId="{2A9ED31A-5C71-4F41-9B77-AB9808F386D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4" creationId="{F5E88171-6D5B-4507-90F1-F427844ECA6B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5" creationId="{03906BCF-123C-4472-99DE-11B7591361D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6" creationId="{419DD0D0-FD39-4634-BC77-6A53CF05DDB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7" creationId="{49B29A61-D098-4C70-93CC-47948469932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8" creationId="{2654D7B4-899B-4AE3-B1BA-61DED70CB59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69" creationId="{99FD9833-7D1F-402E-BE86-9AFE99EF6581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0" creationId="{6E1450AB-3253-4698-A133-05947958C4D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1" creationId="{7E6B6177-C3B2-4AE6-A1B0-2C5215C216E3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2" creationId="{461344CF-2974-438E-8980-F93BB8B9A05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3" creationId="{D8738361-0F03-4CE5-A09F-902CC31799BA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4" creationId="{CE6F653C-8E12-47E3-87C4-A143EEBE7EA4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5" creationId="{74CFB6DE-896D-4D23-83D9-93834CCE130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6" creationId="{CD7AA82F-9E49-4A9A-AA00-B605244BF811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78" creationId="{63671417-D5DB-46E3-8562-FB1E0D5CC22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1" creationId="{EA68CF2A-5580-48CB-847B-18777112C46C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2" creationId="{8EC3D88D-C1AF-4A78-B40A-1C520647CCA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3" creationId="{D23DAE85-0E8A-4BA9-A021-C78D27701208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4" creationId="{758B817A-3CBA-46B6-AE3F-CB2CF46134F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5" creationId="{8E32ED07-B8D4-419A-BA48-1CCF8F87295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6" creationId="{BE9FF4B4-4C15-45CB-B8BE-8B869D82E25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7" creationId="{CB7DD079-7908-4760-8E3D-BC324FB0D439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89" creationId="{DF60AC04-D25C-49D1-B04C-2BAD8AD55FA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0" creationId="{9F1F38A9-1E6F-4C0E-AC82-7287870E2A9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1" creationId="{33D33D8E-5B73-4A2E-A814-BE01DF4914CF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2" creationId="{367F3EA3-3492-4AFE-A07E-BC1930264F41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3" creationId="{E338EEAA-C9BC-48E2-A91C-6A9A354BE97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4" creationId="{449A57B3-CECF-48F1-BC24-05D3A8BBFF7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5" creationId="{6BFC4ED2-9073-4D4B-B3A1-1D558EC5C3A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96" creationId="{FF4778FE-09CF-4E5B-B500-2332B8301F7A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0" creationId="{CD51704B-7052-464C-8AB4-D0C83341DF0A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1" creationId="{141688CB-9A73-493D-90F0-5A383D2905E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2" creationId="{69DDC35A-A97E-467D-B10B-CF7C463F7A84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3" creationId="{2BE51F9D-6510-4335-B41D-6604980D3608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4" creationId="{615AA698-4EF4-4A7A-A410-F14CD5D29F8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5" creationId="{84115BE2-650E-4C83-928C-5E7B74D97D64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6" creationId="{C3C93948-97BB-479F-8822-E652D7E88D0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09" creationId="{85E5DE68-5711-4444-8E37-4FD6D601D42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0" creationId="{B47F5895-6BDE-4C04-9ECE-A74001BF3D7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1" creationId="{8E410B09-3BFF-4331-9C7B-71BA930D990C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2" creationId="{0CA31119-33A4-4AB6-8093-EFE6376505E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3" creationId="{A2B3B43D-D43E-44DA-B0E3-C2887871AD59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4" creationId="{048DE152-8D8E-44F2-A5D7-A166B5B0DE31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6" creationId="{A85F82CC-116B-4B27-BD5E-27D029E097B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7" creationId="{9428F634-E693-4DA2-9C8F-999ECCAA20C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8" creationId="{4E2DE1A7-F6DD-4A42-A18C-F3DA3F6BA96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19" creationId="{6EC3EEFD-3FE7-4F7C-A7E3-A727C784A0E8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0" creationId="{BDC75CC8-640A-471E-84C0-9955278A531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1" creationId="{C3806E5D-AAB5-4456-8F80-D5C39426AF4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2" creationId="{CFFA8F0C-10C2-46DE-82B0-6C11C84B8E5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3" creationId="{D7BD4C33-1AEF-4BBC-A829-67818267C0E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7" creationId="{3C568DDE-F87B-45E3-96E1-90FBA70A1AB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8" creationId="{05354836-8AB4-4548-9AE4-E54F94CB7FA4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29" creationId="{B89A2116-3B17-4F36-B422-238AB3FC395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0" creationId="{6F144EA7-8AB1-4502-A6C3-76F81990C93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1" creationId="{E5DAC124-7215-4CDE-BFDF-C0D6C48F8106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2" creationId="{614D525C-30B9-46BA-B808-EA32215AADD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3" creationId="{B14A3FDC-743A-439C-BACF-0E08449A0C0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6" creationId="{94DFB06F-5A9B-4880-8A2B-E38AE96C664B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7" creationId="{22BE557E-B4E4-4204-95A1-F01EC012829D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8" creationId="{746DC277-4105-44B2-9F8F-83211D5AAA88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39" creationId="{D427C6C5-41B1-45A3-B1E9-FD4B3C092CE9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0" creationId="{79284F53-825E-4500-8C86-4C566FBEAB53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1" creationId="{CCC591A0-FC70-4A38-A42F-18F089BA81F6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2" creationId="{001ACE43-3CAC-437A-B13A-B9BC34E675D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3" creationId="{AD28FE66-9E46-4DAA-8449-AE22728FBB45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4" creationId="{E053ED64-DCBB-4E6A-A2E1-254BE7433CB1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5" creationId="{00B2237E-DBDB-46D9-99DB-CE82A4D3F4F3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6" creationId="{56E234FE-89B8-45BA-8EF2-F36DC419049C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7" creationId="{2F9D38A6-E2E7-47F3-A705-BE8F1048CC1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8" creationId="{64BB938A-BC6C-45EA-9DA4-3E49CC178C0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49" creationId="{3EE67E38-E74C-43AB-A828-2B0080D0ECE3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0" creationId="{F8CC1CC4-247F-4D5B-8E7B-89A1A500F374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1" creationId="{84DFBD7D-C423-4F38-B8A4-FE93D39CEC4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2" creationId="{751F707E-6F84-4090-9513-C977F494928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3" creationId="{17B9C0F6-8E7F-417F-85F1-0996057E1CF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4" creationId="{CF8A7B7D-E109-4241-8E0B-7AF41C9E79DC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5" creationId="{DC21494C-AFC9-4B61-81B9-7DEB0414CD42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6" creationId="{BE7B0634-4205-4118-B132-C640755BA170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7" creationId="{E34E9958-913A-4FC8-A4F3-441514F8BC4E}"/>
          </ac:spMkLst>
        </pc:spChg>
        <pc:spChg chg="mod">
          <ac:chgData name="Megin Nguyen" userId="5019353cdda7aaeb" providerId="LiveId" clId="{BDCD2175-FEF5-4C21-BE42-1A2B03B60326}" dt="2020-12-05T01:16:11.146" v="443" actId="165"/>
          <ac:spMkLst>
            <pc:docMk/>
            <pc:sldMk cId="793350863" sldId="296"/>
            <ac:spMk id="158" creationId="{630836E2-2B40-4B68-A76E-83A03DDBE4CC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1" creationId="{3015668D-51D5-4785-A397-405AC54DD090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2" creationId="{F4BD81CC-7D5D-494A-9C0A-53D044E56C80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3" creationId="{09279F6F-0E6B-4F7C-A9E5-EDD5996565E4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4" creationId="{75FAD736-AC07-4586-8D68-88D094A44CE3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5" creationId="{B74BF115-435F-41D4-A7B1-4A54D08F88ED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6" creationId="{42E53D83-3FCF-455D-B56A-8FA0E203AE34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7" creationId="{4DD57F3E-F003-40E8-8301-65FA6BBCA8DA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8" creationId="{C05DE5F5-631B-4D31-9A8B-5CA806104FA6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69" creationId="{9EF77D01-F02E-42F7-9F34-C1A8F61883E5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70" creationId="{0D3BED30-C13E-475A-8FE6-10D08FCF55A7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71" creationId="{D6A78867-1C0F-48D6-B5E5-021D6733528E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72" creationId="{18E65DB6-B626-416A-892A-E5FE940FB54E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73" creationId="{0808A71E-78BD-45B1-925B-6FCACBDE2215}"/>
          </ac:spMkLst>
        </pc:spChg>
        <pc:spChg chg="del mod topLvl">
          <ac:chgData name="Megin Nguyen" userId="5019353cdda7aaeb" providerId="LiveId" clId="{BDCD2175-FEF5-4C21-BE42-1A2B03B60326}" dt="2020-12-05T01:17:15.388" v="456" actId="478"/>
          <ac:spMkLst>
            <pc:docMk/>
            <pc:sldMk cId="793350863" sldId="296"/>
            <ac:spMk id="174" creationId="{A1DBBEDE-E50B-4CA8-99FE-2E57673BE4A1}"/>
          </ac:spMkLst>
        </pc:spChg>
        <pc:grpChg chg="add del mod">
          <ac:chgData name="Megin Nguyen" userId="5019353cdda7aaeb" providerId="LiveId" clId="{BDCD2175-FEF5-4C21-BE42-1A2B03B60326}" dt="2020-12-05T01:16:11.146" v="443" actId="165"/>
          <ac:grpSpMkLst>
            <pc:docMk/>
            <pc:sldMk cId="793350863" sldId="296"/>
            <ac:grpSpMk id="2" creationId="{37EB808D-D019-4CDE-A9E2-321391D92CF4}"/>
          </ac:grpSpMkLst>
        </pc:grpChg>
        <pc:grpChg chg="del mod topLvl">
          <ac:chgData name="Megin Nguyen" userId="5019353cdda7aaeb" providerId="LiveId" clId="{BDCD2175-FEF5-4C21-BE42-1A2B03B60326}" dt="2020-12-05T01:16:17.271" v="444" actId="478"/>
          <ac:grpSpMkLst>
            <pc:docMk/>
            <pc:sldMk cId="793350863" sldId="296"/>
            <ac:grpSpMk id="3" creationId="{03D4E2CC-1CCC-4A24-865F-67FB4E04AC38}"/>
          </ac:grpSpMkLst>
        </pc:grpChg>
        <pc:grpChg chg="del mod topLvl">
          <ac:chgData name="Megin Nguyen" userId="5019353cdda7aaeb" providerId="LiveId" clId="{BDCD2175-FEF5-4C21-BE42-1A2B03B60326}" dt="2020-12-05T01:16:17.271" v="444" actId="478"/>
          <ac:grpSpMkLst>
            <pc:docMk/>
            <pc:sldMk cId="793350863" sldId="296"/>
            <ac:grpSpMk id="6" creationId="{8CB5AC4C-4746-400A-8680-335048B1166B}"/>
          </ac:grpSpMkLst>
        </pc:grpChg>
        <pc:grpChg chg="del mod topLvl">
          <ac:chgData name="Megin Nguyen" userId="5019353cdda7aaeb" providerId="LiveId" clId="{BDCD2175-FEF5-4C21-BE42-1A2B03B60326}" dt="2020-12-05T01:16:17.271" v="444" actId="478"/>
          <ac:grpSpMkLst>
            <pc:docMk/>
            <pc:sldMk cId="793350863" sldId="296"/>
            <ac:grpSpMk id="7" creationId="{BBDDE955-ACDA-495F-B474-EF35E22B4BA3}"/>
          </ac:grpSpMkLst>
        </pc:grpChg>
        <pc:grpChg chg="del mod topLvl">
          <ac:chgData name="Megin Nguyen" userId="5019353cdda7aaeb" providerId="LiveId" clId="{BDCD2175-FEF5-4C21-BE42-1A2B03B60326}" dt="2020-12-05T01:16:17.271" v="444" actId="478"/>
          <ac:grpSpMkLst>
            <pc:docMk/>
            <pc:sldMk cId="793350863" sldId="296"/>
            <ac:grpSpMk id="11" creationId="{393EA812-6DF4-4AE8-A241-67B506458DD8}"/>
          </ac:grpSpMkLst>
        </pc:grpChg>
        <pc:grpChg chg="mod topLvl">
          <ac:chgData name="Megin Nguyen" userId="5019353cdda7aaeb" providerId="LiveId" clId="{BDCD2175-FEF5-4C21-BE42-1A2B03B60326}" dt="2020-12-05T01:17:04.661" v="452" actId="338"/>
          <ac:grpSpMkLst>
            <pc:docMk/>
            <pc:sldMk cId="793350863" sldId="296"/>
            <ac:grpSpMk id="12" creationId="{6D308C03-847D-405C-97BC-BEFC8889636D}"/>
          </ac:grpSpMkLst>
        </pc:grpChg>
        <pc:grpChg chg="del mod topLvl">
          <ac:chgData name="Megin Nguyen" userId="5019353cdda7aaeb" providerId="LiveId" clId="{BDCD2175-FEF5-4C21-BE42-1A2B03B60326}" dt="2020-12-05T01:17:07.057" v="453" actId="165"/>
          <ac:grpSpMkLst>
            <pc:docMk/>
            <pc:sldMk cId="793350863" sldId="296"/>
            <ac:grpSpMk id="13" creationId="{5BC3C833-E02A-447D-8049-B5198E8C1435}"/>
          </ac:grpSpMkLst>
        </pc:grpChg>
        <pc:grpChg chg="mod">
          <ac:chgData name="Megin Nguyen" userId="5019353cdda7aaeb" providerId="LiveId" clId="{BDCD2175-FEF5-4C21-BE42-1A2B03B60326}" dt="2020-12-05T01:16:11.146" v="443" actId="165"/>
          <ac:grpSpMkLst>
            <pc:docMk/>
            <pc:sldMk cId="793350863" sldId="296"/>
            <ac:grpSpMk id="97" creationId="{43A9AC1B-79FE-4E08-92C4-3CFB3535D82B}"/>
          </ac:grpSpMkLst>
        </pc:grpChg>
        <pc:grpChg chg="mod">
          <ac:chgData name="Megin Nguyen" userId="5019353cdda7aaeb" providerId="LiveId" clId="{BDCD2175-FEF5-4C21-BE42-1A2B03B60326}" dt="2020-12-05T01:16:11.146" v="443" actId="165"/>
          <ac:grpSpMkLst>
            <pc:docMk/>
            <pc:sldMk cId="793350863" sldId="296"/>
            <ac:grpSpMk id="124" creationId="{4850B484-41CB-46E0-8204-F2CFC933C367}"/>
          </ac:grpSpMkLst>
        </pc:grpChg>
        <pc:grpChg chg="add del mod">
          <ac:chgData name="Megin Nguyen" userId="5019353cdda7aaeb" providerId="LiveId" clId="{BDCD2175-FEF5-4C21-BE42-1A2B03B60326}" dt="2020-12-05T01:16:30.546" v="447" actId="165"/>
          <ac:grpSpMkLst>
            <pc:docMk/>
            <pc:sldMk cId="793350863" sldId="296"/>
            <ac:grpSpMk id="159" creationId="{74F01D69-4D04-4FF5-904C-51BECC768CEC}"/>
          </ac:grpSpMkLst>
        </pc:grpChg>
        <pc:grpChg chg="add mod">
          <ac:chgData name="Megin Nguyen" userId="5019353cdda7aaeb" providerId="LiveId" clId="{BDCD2175-FEF5-4C21-BE42-1A2B03B60326}" dt="2020-12-05T01:17:04.661" v="452" actId="338"/>
          <ac:grpSpMkLst>
            <pc:docMk/>
            <pc:sldMk cId="793350863" sldId="296"/>
            <ac:grpSpMk id="175" creationId="{815C3EC7-DDE8-4FB5-8B68-D86EACA0567D}"/>
          </ac:grpSpMkLst>
        </pc:grpChg>
        <pc:picChg chg="mod topLvl">
          <ac:chgData name="Megin Nguyen" userId="5019353cdda7aaeb" providerId="LiveId" clId="{BDCD2175-FEF5-4C21-BE42-1A2B03B60326}" dt="2020-12-05T01:17:07.057" v="453" actId="165"/>
          <ac:picMkLst>
            <pc:docMk/>
            <pc:sldMk cId="793350863" sldId="296"/>
            <ac:picMk id="17" creationId="{75CACFA5-660C-4064-AE32-FA523B7951CC}"/>
          </ac:picMkLst>
        </pc:picChg>
        <pc:picChg chg="mod topLvl">
          <ac:chgData name="Megin Nguyen" userId="5019353cdda7aaeb" providerId="LiveId" clId="{BDCD2175-FEF5-4C21-BE42-1A2B03B60326}" dt="2020-12-05T01:17:07.057" v="453" actId="165"/>
          <ac:picMkLst>
            <pc:docMk/>
            <pc:sldMk cId="793350863" sldId="296"/>
            <ac:picMk id="18" creationId="{91D1E3C1-D0D7-493B-94A6-08F048A88037}"/>
          </ac:picMkLst>
        </pc:picChg>
        <pc:picChg chg="mod">
          <ac:chgData name="Megin Nguyen" userId="5019353cdda7aaeb" providerId="LiveId" clId="{BDCD2175-FEF5-4C21-BE42-1A2B03B60326}" dt="2020-12-05T01:17:04.661" v="452" actId="338"/>
          <ac:picMkLst>
            <pc:docMk/>
            <pc:sldMk cId="793350863" sldId="296"/>
            <ac:picMk id="34" creationId="{27CAD6A4-B075-4D47-9CD6-9579BEE0E6E7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49" creationId="{A22E65F2-64C8-4726-8791-3EE6E779AE52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50" creationId="{0F47D696-E63E-472C-A765-762BC6E6E784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77" creationId="{56894DC1-989C-4571-8EFC-310A70254AC7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79" creationId="{CA7DC07F-A16B-4F2E-AA47-6F5126E2234A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80" creationId="{C59872B5-68C6-4F4F-ADB0-D2AF3C059738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88" creationId="{C538A886-79B9-4630-82EA-C0EEE4149F81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98" creationId="{39318E8F-3B90-4C25-A60D-0E52F6A02E90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99" creationId="{C3900AD3-7DAD-4D11-8122-E4C9FB2E75CC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07" creationId="{46F6C23A-ED6A-4A03-8C8C-376229EBF4ED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08" creationId="{859A66BA-2C8A-4992-8242-4BB787D67296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15" creationId="{2E366CCB-9F57-4E66-A72F-C547652FE4E8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25" creationId="{899BD328-2832-4DB1-8178-91E347917FFE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26" creationId="{E3C62186-43B0-4C5B-98D5-4C1720020A05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34" creationId="{678ECCC6-F4E9-4FE8-B08F-CDDEBD4CC135}"/>
          </ac:picMkLst>
        </pc:picChg>
        <pc:picChg chg="mod">
          <ac:chgData name="Megin Nguyen" userId="5019353cdda7aaeb" providerId="LiveId" clId="{BDCD2175-FEF5-4C21-BE42-1A2B03B60326}" dt="2020-12-05T01:16:11.146" v="443" actId="165"/>
          <ac:picMkLst>
            <pc:docMk/>
            <pc:sldMk cId="793350863" sldId="296"/>
            <ac:picMk id="135" creationId="{5737762F-8F62-496D-985C-CC31E6A245C9}"/>
          </ac:picMkLst>
        </pc:picChg>
        <pc:picChg chg="mod topLvl modCrop">
          <ac:chgData name="Megin Nguyen" userId="5019353cdda7aaeb" providerId="LiveId" clId="{BDCD2175-FEF5-4C21-BE42-1A2B03B60326}" dt="2020-12-05T01:16:38.519" v="448" actId="732"/>
          <ac:picMkLst>
            <pc:docMk/>
            <pc:sldMk cId="793350863" sldId="296"/>
            <ac:picMk id="160" creationId="{D126FCF2-300A-4686-B28F-A7E7BAC205D9}"/>
          </ac:picMkLst>
        </pc:picChg>
        <pc:picChg chg="add mod modCrop">
          <ac:chgData name="Megin Nguyen" userId="5019353cdda7aaeb" providerId="LiveId" clId="{BDCD2175-FEF5-4C21-BE42-1A2B03B60326}" dt="2020-12-05T01:17:31.293" v="462" actId="732"/>
          <ac:picMkLst>
            <pc:docMk/>
            <pc:sldMk cId="793350863" sldId="296"/>
            <ac:picMk id="176" creationId="{CA3B83E4-1A69-4F95-A1FD-2375ABAC8BEF}"/>
          </ac:picMkLst>
        </pc:picChg>
      </pc:sldChg>
    </pc:docChg>
  </pc:docChgLst>
  <pc:docChgLst>
    <pc:chgData name="Megin Nguyen" userId="5019353cdda7aaeb" providerId="LiveId" clId="{B68CD8BF-0F83-4A26-8C6A-38D6417C8AA1}"/>
    <pc:docChg chg="undo redo custSel modSld">
      <pc:chgData name="Megin Nguyen" userId="5019353cdda7aaeb" providerId="LiveId" clId="{B68CD8BF-0F83-4A26-8C6A-38D6417C8AA1}" dt="2020-10-07T19:06:27.950" v="242" actId="1076"/>
      <pc:docMkLst>
        <pc:docMk/>
      </pc:docMkLst>
      <pc:sldChg chg="addSp delSp modSp mod">
        <pc:chgData name="Megin Nguyen" userId="5019353cdda7aaeb" providerId="LiveId" clId="{B68CD8BF-0F83-4A26-8C6A-38D6417C8AA1}" dt="2020-10-07T18:53:16.366" v="157" actId="1076"/>
        <pc:sldMkLst>
          <pc:docMk/>
          <pc:sldMk cId="3198319802" sldId="261"/>
        </pc:sldMkLst>
        <pc:spChg chg="mod">
          <ac:chgData name="Megin Nguyen" userId="5019353cdda7aaeb" providerId="LiveId" clId="{B68CD8BF-0F83-4A26-8C6A-38D6417C8AA1}" dt="2020-10-07T18:03:32.532" v="29" actId="1035"/>
          <ac:spMkLst>
            <pc:docMk/>
            <pc:sldMk cId="3198319802" sldId="261"/>
            <ac:spMk id="9" creationId="{57241B0F-BF3A-473D-A9D0-CEED7A8D2633}"/>
          </ac:spMkLst>
        </pc:spChg>
        <pc:spChg chg="mod">
          <ac:chgData name="Megin Nguyen" userId="5019353cdda7aaeb" providerId="LiveId" clId="{B68CD8BF-0F83-4A26-8C6A-38D6417C8AA1}" dt="2020-10-07T18:43:54.730" v="144" actId="1076"/>
          <ac:spMkLst>
            <pc:docMk/>
            <pc:sldMk cId="3198319802" sldId="261"/>
            <ac:spMk id="10" creationId="{B196468D-E613-4300-9D1F-D2CD3333D130}"/>
          </ac:spMkLst>
        </pc:spChg>
        <pc:spChg chg="mod">
          <ac:chgData name="Megin Nguyen" userId="5019353cdda7aaeb" providerId="LiveId" clId="{B68CD8BF-0F83-4A26-8C6A-38D6417C8AA1}" dt="2020-10-07T18:34:12.834" v="110" actId="1076"/>
          <ac:spMkLst>
            <pc:docMk/>
            <pc:sldMk cId="3198319802" sldId="261"/>
            <ac:spMk id="17" creationId="{00000000-0000-0000-0000-000000000000}"/>
          </ac:spMkLst>
        </pc:spChg>
        <pc:spChg chg="add mod">
          <ac:chgData name="Megin Nguyen" userId="5019353cdda7aaeb" providerId="LiveId" clId="{B68CD8BF-0F83-4A26-8C6A-38D6417C8AA1}" dt="2020-10-07T18:31:27.197" v="86" actId="164"/>
          <ac:spMkLst>
            <pc:docMk/>
            <pc:sldMk cId="3198319802" sldId="261"/>
            <ac:spMk id="18" creationId="{7CB2E7DB-4788-4151-99AA-CC06AD587656}"/>
          </ac:spMkLst>
        </pc:spChg>
        <pc:spChg chg="add del">
          <ac:chgData name="Megin Nguyen" userId="5019353cdda7aaeb" providerId="LiveId" clId="{B68CD8BF-0F83-4A26-8C6A-38D6417C8AA1}" dt="2020-10-07T18:30:54.455" v="76"/>
          <ac:spMkLst>
            <pc:docMk/>
            <pc:sldMk cId="3198319802" sldId="261"/>
            <ac:spMk id="19" creationId="{29058E68-465E-4E16-814E-F905018FC545}"/>
          </ac:spMkLst>
        </pc:spChg>
        <pc:spChg chg="add mod">
          <ac:chgData name="Megin Nguyen" userId="5019353cdda7aaeb" providerId="LiveId" clId="{B68CD8BF-0F83-4A26-8C6A-38D6417C8AA1}" dt="2020-10-07T18:31:27.197" v="86" actId="164"/>
          <ac:spMkLst>
            <pc:docMk/>
            <pc:sldMk cId="3198319802" sldId="261"/>
            <ac:spMk id="20" creationId="{D2B11183-8C1D-4E9E-A918-A3FFBCC44CD6}"/>
          </ac:spMkLst>
        </pc:spChg>
        <pc:spChg chg="add mod">
          <ac:chgData name="Megin Nguyen" userId="5019353cdda7aaeb" providerId="LiveId" clId="{B68CD8BF-0F83-4A26-8C6A-38D6417C8AA1}" dt="2020-10-07T18:31:27.197" v="86" actId="164"/>
          <ac:spMkLst>
            <pc:docMk/>
            <pc:sldMk cId="3198319802" sldId="261"/>
            <ac:spMk id="21" creationId="{64DFC53D-FCF0-408E-B6BF-233091D4410B}"/>
          </ac:spMkLst>
        </pc:spChg>
        <pc:spChg chg="add mod">
          <ac:chgData name="Megin Nguyen" userId="5019353cdda7aaeb" providerId="LiveId" clId="{B68CD8BF-0F83-4A26-8C6A-38D6417C8AA1}" dt="2020-10-07T18:33:21.915" v="101" actId="164"/>
          <ac:spMkLst>
            <pc:docMk/>
            <pc:sldMk cId="3198319802" sldId="261"/>
            <ac:spMk id="42" creationId="{430A9F36-55E6-4BAC-A18D-07215A41EB7D}"/>
          </ac:spMkLst>
        </pc:spChg>
        <pc:spChg chg="mod">
          <ac:chgData name="Megin Nguyen" userId="5019353cdda7aaeb" providerId="LiveId" clId="{B68CD8BF-0F83-4A26-8C6A-38D6417C8AA1}" dt="2020-10-07T18:34:09.096" v="109" actId="1076"/>
          <ac:spMkLst>
            <pc:docMk/>
            <pc:sldMk cId="3198319802" sldId="261"/>
            <ac:spMk id="43" creationId="{00000000-0000-0000-0000-000000000000}"/>
          </ac:spMkLst>
        </pc:spChg>
        <pc:spChg chg="add mod">
          <ac:chgData name="Megin Nguyen" userId="5019353cdda7aaeb" providerId="LiveId" clId="{B68CD8BF-0F83-4A26-8C6A-38D6417C8AA1}" dt="2020-10-07T18:33:21.915" v="101" actId="164"/>
          <ac:spMkLst>
            <pc:docMk/>
            <pc:sldMk cId="3198319802" sldId="261"/>
            <ac:spMk id="44" creationId="{B3569F26-87F4-4D84-B444-638B7A182A4F}"/>
          </ac:spMkLst>
        </pc:spChg>
        <pc:spChg chg="add mod">
          <ac:chgData name="Megin Nguyen" userId="5019353cdda7aaeb" providerId="LiveId" clId="{B68CD8BF-0F83-4A26-8C6A-38D6417C8AA1}" dt="2020-10-07T18:33:21.915" v="101" actId="164"/>
          <ac:spMkLst>
            <pc:docMk/>
            <pc:sldMk cId="3198319802" sldId="261"/>
            <ac:spMk id="45" creationId="{6980A6C8-41E6-47D1-897E-65C85C06AE91}"/>
          </ac:spMkLst>
        </pc:spChg>
        <pc:spChg chg="del">
          <ac:chgData name="Megin Nguyen" userId="5019353cdda7aaeb" providerId="LiveId" clId="{B68CD8BF-0F83-4A26-8C6A-38D6417C8AA1}" dt="2020-10-07T18:03:23.678" v="10" actId="478"/>
          <ac:spMkLst>
            <pc:docMk/>
            <pc:sldMk cId="3198319802" sldId="261"/>
            <ac:spMk id="46" creationId="{00000000-0000-0000-0000-000000000000}"/>
          </ac:spMkLst>
        </pc:spChg>
        <pc:spChg chg="del">
          <ac:chgData name="Megin Nguyen" userId="5019353cdda7aaeb" providerId="LiveId" clId="{B68CD8BF-0F83-4A26-8C6A-38D6417C8AA1}" dt="2020-10-07T18:03:25.260" v="11" actId="478"/>
          <ac:spMkLst>
            <pc:docMk/>
            <pc:sldMk cId="3198319802" sldId="261"/>
            <ac:spMk id="47" creationId="{00000000-0000-0000-0000-000000000000}"/>
          </ac:spMkLst>
        </pc:spChg>
        <pc:spChg chg="del">
          <ac:chgData name="Megin Nguyen" userId="5019353cdda7aaeb" providerId="LiveId" clId="{B68CD8BF-0F83-4A26-8C6A-38D6417C8AA1}" dt="2020-10-07T18:03:27.601" v="12" actId="478"/>
          <ac:spMkLst>
            <pc:docMk/>
            <pc:sldMk cId="3198319802" sldId="261"/>
            <ac:spMk id="48" creationId="{00000000-0000-0000-0000-000000000000}"/>
          </ac:spMkLst>
        </pc:spChg>
        <pc:spChg chg="mod">
          <ac:chgData name="Megin Nguyen" userId="5019353cdda7aaeb" providerId="LiveId" clId="{B68CD8BF-0F83-4A26-8C6A-38D6417C8AA1}" dt="2020-10-07T18:33:46.337" v="105" actId="1076"/>
          <ac:spMkLst>
            <pc:docMk/>
            <pc:sldMk cId="3198319802" sldId="261"/>
            <ac:spMk id="49" creationId="{00000000-0000-0000-0000-000000000000}"/>
          </ac:spMkLst>
        </pc:spChg>
        <pc:spChg chg="mod">
          <ac:chgData name="Megin Nguyen" userId="5019353cdda7aaeb" providerId="LiveId" clId="{B68CD8BF-0F83-4A26-8C6A-38D6417C8AA1}" dt="2020-10-07T18:34:00.005" v="108" actId="1076"/>
          <ac:spMkLst>
            <pc:docMk/>
            <pc:sldMk cId="3198319802" sldId="261"/>
            <ac:spMk id="50" creationId="{00000000-0000-0000-0000-000000000000}"/>
          </ac:spMkLst>
        </pc:spChg>
        <pc:spChg chg="mod">
          <ac:chgData name="Megin Nguyen" userId="5019353cdda7aaeb" providerId="LiveId" clId="{B68CD8BF-0F83-4A26-8C6A-38D6417C8AA1}" dt="2020-10-07T18:33:54.869" v="107" actId="1076"/>
          <ac:spMkLst>
            <pc:docMk/>
            <pc:sldMk cId="3198319802" sldId="261"/>
            <ac:spMk id="51" creationId="{00000000-0000-0000-0000-000000000000}"/>
          </ac:spMkLst>
        </pc:spChg>
        <pc:spChg chg="mod">
          <ac:chgData name="Megin Nguyen" userId="5019353cdda7aaeb" providerId="LiveId" clId="{B68CD8BF-0F83-4A26-8C6A-38D6417C8AA1}" dt="2020-10-07T18:33:49.781" v="106" actId="1076"/>
          <ac:spMkLst>
            <pc:docMk/>
            <pc:sldMk cId="3198319802" sldId="261"/>
            <ac:spMk id="52" creationId="{00000000-0000-0000-0000-000000000000}"/>
          </ac:spMkLst>
        </pc:spChg>
        <pc:spChg chg="mod">
          <ac:chgData name="Megin Nguyen" userId="5019353cdda7aaeb" providerId="LiveId" clId="{B68CD8BF-0F83-4A26-8C6A-38D6417C8AA1}" dt="2020-10-07T18:34:22.555" v="111" actId="1076"/>
          <ac:spMkLst>
            <pc:docMk/>
            <pc:sldMk cId="3198319802" sldId="261"/>
            <ac:spMk id="53" creationId="{00000000-0000-0000-0000-000000000000}"/>
          </ac:spMkLst>
        </pc:spChg>
        <pc:spChg chg="add mod">
          <ac:chgData name="Megin Nguyen" userId="5019353cdda7aaeb" providerId="LiveId" clId="{B68CD8BF-0F83-4A26-8C6A-38D6417C8AA1}" dt="2020-10-07T18:44:11.585" v="146" actId="164"/>
          <ac:spMkLst>
            <pc:docMk/>
            <pc:sldMk cId="3198319802" sldId="261"/>
            <ac:spMk id="63" creationId="{FE77142E-FF6E-4722-A39B-E82B0761815E}"/>
          </ac:spMkLst>
        </pc:spChg>
        <pc:spChg chg="add mod">
          <ac:chgData name="Megin Nguyen" userId="5019353cdda7aaeb" providerId="LiveId" clId="{B68CD8BF-0F83-4A26-8C6A-38D6417C8AA1}" dt="2020-10-07T18:44:11.585" v="146" actId="164"/>
          <ac:spMkLst>
            <pc:docMk/>
            <pc:sldMk cId="3198319802" sldId="261"/>
            <ac:spMk id="65" creationId="{B5F874C9-7332-4FB2-9360-8858D85EF7EB}"/>
          </ac:spMkLst>
        </pc:spChg>
        <pc:spChg chg="add mod">
          <ac:chgData name="Megin Nguyen" userId="5019353cdda7aaeb" providerId="LiveId" clId="{B68CD8BF-0F83-4A26-8C6A-38D6417C8AA1}" dt="2020-10-07T18:44:11.585" v="146" actId="164"/>
          <ac:spMkLst>
            <pc:docMk/>
            <pc:sldMk cId="3198319802" sldId="261"/>
            <ac:spMk id="67" creationId="{8FA6B3F4-B658-4744-A9DF-6118D4EDC3F4}"/>
          </ac:spMkLst>
        </pc:spChg>
        <pc:spChg chg="add mod">
          <ac:chgData name="Megin Nguyen" userId="5019353cdda7aaeb" providerId="LiveId" clId="{B68CD8BF-0F83-4A26-8C6A-38D6417C8AA1}" dt="2020-10-07T18:44:03.087" v="145" actId="164"/>
          <ac:spMkLst>
            <pc:docMk/>
            <pc:sldMk cId="3198319802" sldId="261"/>
            <ac:spMk id="71" creationId="{9B94D5D1-F2E3-4F17-8D82-EE7886E36173}"/>
          </ac:spMkLst>
        </pc:spChg>
        <pc:spChg chg="add mod">
          <ac:chgData name="Megin Nguyen" userId="5019353cdda7aaeb" providerId="LiveId" clId="{B68CD8BF-0F83-4A26-8C6A-38D6417C8AA1}" dt="2020-10-07T18:44:03.087" v="145" actId="164"/>
          <ac:spMkLst>
            <pc:docMk/>
            <pc:sldMk cId="3198319802" sldId="261"/>
            <ac:spMk id="73" creationId="{433B1DB4-CE65-4147-ACD2-30C371239465}"/>
          </ac:spMkLst>
        </pc:spChg>
        <pc:spChg chg="add mod">
          <ac:chgData name="Megin Nguyen" userId="5019353cdda7aaeb" providerId="LiveId" clId="{B68CD8BF-0F83-4A26-8C6A-38D6417C8AA1}" dt="2020-10-07T18:44:03.087" v="145" actId="164"/>
          <ac:spMkLst>
            <pc:docMk/>
            <pc:sldMk cId="3198319802" sldId="261"/>
            <ac:spMk id="75" creationId="{B7D96867-3B0B-42F3-B689-E56560DF10C1}"/>
          </ac:spMkLst>
        </pc:spChg>
        <pc:spChg chg="add mod">
          <ac:chgData name="Megin Nguyen" userId="5019353cdda7aaeb" providerId="LiveId" clId="{B68CD8BF-0F83-4A26-8C6A-38D6417C8AA1}" dt="2020-10-07T18:53:00.606" v="153" actId="1076"/>
          <ac:spMkLst>
            <pc:docMk/>
            <pc:sldMk cId="3198319802" sldId="261"/>
            <ac:spMk id="79" creationId="{08DBCF29-97E0-478D-BDBC-27AD59F2CBF4}"/>
          </ac:spMkLst>
        </pc:spChg>
        <pc:spChg chg="add mod">
          <ac:chgData name="Megin Nguyen" userId="5019353cdda7aaeb" providerId="LiveId" clId="{B68CD8BF-0F83-4A26-8C6A-38D6417C8AA1}" dt="2020-10-07T18:53:04.467" v="154" actId="1076"/>
          <ac:spMkLst>
            <pc:docMk/>
            <pc:sldMk cId="3198319802" sldId="261"/>
            <ac:spMk id="81" creationId="{CD682A4B-0F17-43BB-AF31-7D28B5032B0E}"/>
          </ac:spMkLst>
        </pc:spChg>
        <pc:spChg chg="add mod">
          <ac:chgData name="Megin Nguyen" userId="5019353cdda7aaeb" providerId="LiveId" clId="{B68CD8BF-0F83-4A26-8C6A-38D6417C8AA1}" dt="2020-10-07T18:53:00.606" v="153" actId="1076"/>
          <ac:spMkLst>
            <pc:docMk/>
            <pc:sldMk cId="3198319802" sldId="261"/>
            <ac:spMk id="83" creationId="{314A8ADA-E7A3-4354-B13E-E539F25BF345}"/>
          </ac:spMkLst>
        </pc:spChg>
        <pc:spChg chg="add mod">
          <ac:chgData name="Megin Nguyen" userId="5019353cdda7aaeb" providerId="LiveId" clId="{B68CD8BF-0F83-4A26-8C6A-38D6417C8AA1}" dt="2020-10-07T18:53:13.220" v="156" actId="1076"/>
          <ac:spMkLst>
            <pc:docMk/>
            <pc:sldMk cId="3198319802" sldId="261"/>
            <ac:spMk id="85" creationId="{3115E879-5ADB-46DB-8B15-CD18B843E312}"/>
          </ac:spMkLst>
        </pc:spChg>
        <pc:spChg chg="add mod">
          <ac:chgData name="Megin Nguyen" userId="5019353cdda7aaeb" providerId="LiveId" clId="{B68CD8BF-0F83-4A26-8C6A-38D6417C8AA1}" dt="2020-10-07T18:53:16.366" v="157" actId="1076"/>
          <ac:spMkLst>
            <pc:docMk/>
            <pc:sldMk cId="3198319802" sldId="261"/>
            <ac:spMk id="87" creationId="{1C962CAC-C0D9-4F8D-8C6C-8F8C9DF2A136}"/>
          </ac:spMkLst>
        </pc:spChg>
        <pc:spChg chg="add mod">
          <ac:chgData name="Megin Nguyen" userId="5019353cdda7aaeb" providerId="LiveId" clId="{B68CD8BF-0F83-4A26-8C6A-38D6417C8AA1}" dt="2020-10-07T18:53:00.606" v="153" actId="1076"/>
          <ac:spMkLst>
            <pc:docMk/>
            <pc:sldMk cId="3198319802" sldId="261"/>
            <ac:spMk id="89" creationId="{2C2EFCA7-77F8-41AB-A4A0-F6D9502F2548}"/>
          </ac:spMkLst>
        </pc:spChg>
        <pc:spChg chg="add mod">
          <ac:chgData name="Megin Nguyen" userId="5019353cdda7aaeb" providerId="LiveId" clId="{B68CD8BF-0F83-4A26-8C6A-38D6417C8AA1}" dt="2020-10-07T18:53:09.507" v="155" actId="1076"/>
          <ac:spMkLst>
            <pc:docMk/>
            <pc:sldMk cId="3198319802" sldId="261"/>
            <ac:spMk id="91" creationId="{9B87B809-8B12-4D6F-BB4D-FCB87A4CA45C}"/>
          </ac:spMkLst>
        </pc:spChg>
        <pc:grpChg chg="mod topLvl">
          <ac:chgData name="Megin Nguyen" userId="5019353cdda7aaeb" providerId="LiveId" clId="{B68CD8BF-0F83-4A26-8C6A-38D6417C8AA1}" dt="2020-10-07T18:33:21.915" v="101" actId="164"/>
          <ac:grpSpMkLst>
            <pc:docMk/>
            <pc:sldMk cId="3198319802" sldId="261"/>
            <ac:grpSpMk id="23" creationId="{D9CADC4C-E2D7-4922-9F84-D888035E3241}"/>
          </ac:grpSpMkLst>
        </pc:grpChg>
        <pc:grpChg chg="add mod">
          <ac:chgData name="Megin Nguyen" userId="5019353cdda7aaeb" providerId="LiveId" clId="{B68CD8BF-0F83-4A26-8C6A-38D6417C8AA1}" dt="2020-10-07T18:31:27.197" v="86" actId="164"/>
          <ac:grpSpMkLst>
            <pc:docMk/>
            <pc:sldMk cId="3198319802" sldId="261"/>
            <ac:grpSpMk id="25" creationId="{1892BA8C-C76F-44F6-8C00-929B9EB8FF14}"/>
          </ac:grpSpMkLst>
        </pc:grpChg>
        <pc:grpChg chg="mod topLvl">
          <ac:chgData name="Megin Nguyen" userId="5019353cdda7aaeb" providerId="LiveId" clId="{B68CD8BF-0F83-4A26-8C6A-38D6417C8AA1}" dt="2020-10-07T18:31:27.197" v="86" actId="164"/>
          <ac:grpSpMkLst>
            <pc:docMk/>
            <pc:sldMk cId="3198319802" sldId="261"/>
            <ac:grpSpMk id="31" creationId="{8582073B-A287-4913-8932-4FFC5B077E6D}"/>
          </ac:grpSpMkLst>
        </pc:grpChg>
        <pc:grpChg chg="mod topLvl">
          <ac:chgData name="Megin Nguyen" userId="5019353cdda7aaeb" providerId="LiveId" clId="{B68CD8BF-0F83-4A26-8C6A-38D6417C8AA1}" dt="2020-10-07T18:44:03.087" v="145" actId="164"/>
          <ac:grpSpMkLst>
            <pc:docMk/>
            <pc:sldMk cId="3198319802" sldId="261"/>
            <ac:grpSpMk id="32" creationId="{1D1DAF5E-8E02-427F-80FE-4958BB0EDC2B}"/>
          </ac:grpSpMkLst>
        </pc:grpChg>
        <pc:grpChg chg="add del mod topLvl">
          <ac:chgData name="Megin Nguyen" userId="5019353cdda7aaeb" providerId="LiveId" clId="{B68CD8BF-0F83-4A26-8C6A-38D6417C8AA1}" dt="2020-10-07T18:44:11.585" v="146" actId="164"/>
          <ac:grpSpMkLst>
            <pc:docMk/>
            <pc:sldMk cId="3198319802" sldId="261"/>
            <ac:grpSpMk id="35" creationId="{ACE7819C-07E9-44D2-A5D4-ECB590F1FDA7}"/>
          </ac:grpSpMkLst>
        </pc:grpChg>
        <pc:grpChg chg="del mod">
          <ac:chgData name="Megin Nguyen" userId="5019353cdda7aaeb" providerId="LiveId" clId="{B68CD8BF-0F83-4A26-8C6A-38D6417C8AA1}" dt="2020-10-07T18:42:58.546" v="130" actId="165"/>
          <ac:grpSpMkLst>
            <pc:docMk/>
            <pc:sldMk cId="3198319802" sldId="261"/>
            <ac:grpSpMk id="38" creationId="{F75A5F81-5651-4B12-876E-A490FF412C62}"/>
          </ac:grpSpMkLst>
        </pc:grpChg>
        <pc:grpChg chg="add del">
          <ac:chgData name="Megin Nguyen" userId="5019353cdda7aaeb" providerId="LiveId" clId="{B68CD8BF-0F83-4A26-8C6A-38D6417C8AA1}" dt="2020-10-07T18:29:36.308" v="43" actId="165"/>
          <ac:grpSpMkLst>
            <pc:docMk/>
            <pc:sldMk cId="3198319802" sldId="261"/>
            <ac:grpSpMk id="39" creationId="{F5439FEB-29D8-4C27-8A2C-BD52DC471220}"/>
          </ac:grpSpMkLst>
        </pc:grpChg>
        <pc:grpChg chg="del">
          <ac:chgData name="Megin Nguyen" userId="5019353cdda7aaeb" providerId="LiveId" clId="{B68CD8BF-0F83-4A26-8C6A-38D6417C8AA1}" dt="2020-10-07T18:32:16.951" v="87" actId="165"/>
          <ac:grpSpMkLst>
            <pc:docMk/>
            <pc:sldMk cId="3198319802" sldId="261"/>
            <ac:grpSpMk id="40" creationId="{2D674A31-A355-4CDB-9CE9-6CD1260D243C}"/>
          </ac:grpSpMkLst>
        </pc:grpChg>
        <pc:grpChg chg="del">
          <ac:chgData name="Megin Nguyen" userId="5019353cdda7aaeb" providerId="LiveId" clId="{B68CD8BF-0F83-4A26-8C6A-38D6417C8AA1}" dt="2020-10-07T18:36:06.186" v="112" actId="165"/>
          <ac:grpSpMkLst>
            <pc:docMk/>
            <pc:sldMk cId="3198319802" sldId="261"/>
            <ac:grpSpMk id="41" creationId="{2175E60F-BB83-4685-B14D-58E6A67358A1}"/>
          </ac:grpSpMkLst>
        </pc:grpChg>
        <pc:grpChg chg="add mod ord">
          <ac:chgData name="Megin Nguyen" userId="5019353cdda7aaeb" providerId="LiveId" clId="{B68CD8BF-0F83-4A26-8C6A-38D6417C8AA1}" dt="2020-10-07T18:33:25.038" v="102" actId="167"/>
          <ac:grpSpMkLst>
            <pc:docMk/>
            <pc:sldMk cId="3198319802" sldId="261"/>
            <ac:grpSpMk id="59" creationId="{4A2EB29A-09E3-477F-9A1B-84FDFE10FC93}"/>
          </ac:grpSpMkLst>
        </pc:grpChg>
        <pc:grpChg chg="add mod">
          <ac:chgData name="Megin Nguyen" userId="5019353cdda7aaeb" providerId="LiveId" clId="{B68CD8BF-0F83-4A26-8C6A-38D6417C8AA1}" dt="2020-10-07T18:44:03.087" v="145" actId="164"/>
          <ac:grpSpMkLst>
            <pc:docMk/>
            <pc:sldMk cId="3198319802" sldId="261"/>
            <ac:grpSpMk id="76" creationId="{DAFAB220-B7D9-4FC5-AFEB-D7E6A970EDB6}"/>
          </ac:grpSpMkLst>
        </pc:grpChg>
        <pc:grpChg chg="add mod ord">
          <ac:chgData name="Megin Nguyen" userId="5019353cdda7aaeb" providerId="LiveId" clId="{B68CD8BF-0F83-4A26-8C6A-38D6417C8AA1}" dt="2020-10-07T18:52:43.492" v="151" actId="167"/>
          <ac:grpSpMkLst>
            <pc:docMk/>
            <pc:sldMk cId="3198319802" sldId="261"/>
            <ac:grpSpMk id="77" creationId="{2F15C7F8-333E-40FE-8F0F-4213CFA2D81F}"/>
          </ac:grpSpMkLst>
        </pc:grpChg>
        <pc:picChg chg="mod">
          <ac:chgData name="Megin Nguyen" userId="5019353cdda7aaeb" providerId="LiveId" clId="{B68CD8BF-0F83-4A26-8C6A-38D6417C8AA1}" dt="2020-10-07T18:44:03.087" v="145" actId="164"/>
          <ac:picMkLst>
            <pc:docMk/>
            <pc:sldMk cId="3198319802" sldId="261"/>
            <ac:picMk id="7" creationId="{90520F42-1F4D-400B-9DCD-1E0492FE6692}"/>
          </ac:picMkLst>
        </pc:picChg>
        <pc:picChg chg="mod">
          <ac:chgData name="Megin Nguyen" userId="5019353cdda7aaeb" providerId="LiveId" clId="{B68CD8BF-0F83-4A26-8C6A-38D6417C8AA1}" dt="2020-10-07T18:29:36.308" v="43" actId="165"/>
          <ac:picMkLst>
            <pc:docMk/>
            <pc:sldMk cId="3198319802" sldId="261"/>
            <ac:picMk id="13" creationId="{A081640E-E831-405C-B22B-097B5B3DFB11}"/>
          </ac:picMkLst>
        </pc:picChg>
        <pc:picChg chg="add mod ord modCrop">
          <ac:chgData name="Megin Nguyen" userId="5019353cdda7aaeb" providerId="LiveId" clId="{B68CD8BF-0F83-4A26-8C6A-38D6417C8AA1}" dt="2020-10-07T18:31:27.197" v="86" actId="164"/>
          <ac:picMkLst>
            <pc:docMk/>
            <pc:sldMk cId="3198319802" sldId="261"/>
            <ac:picMk id="14" creationId="{2EC1E250-464C-403E-BA7D-CFCEBCE44A87}"/>
          </ac:picMkLst>
        </pc:picChg>
        <pc:picChg chg="mod">
          <ac:chgData name="Megin Nguyen" userId="5019353cdda7aaeb" providerId="LiveId" clId="{B68CD8BF-0F83-4A26-8C6A-38D6417C8AA1}" dt="2020-10-07T18:32:16.951" v="87" actId="165"/>
          <ac:picMkLst>
            <pc:docMk/>
            <pc:sldMk cId="3198319802" sldId="261"/>
            <ac:picMk id="15" creationId="{67520CF3-1C2F-49E3-8F36-72A90459CEC1}"/>
          </ac:picMkLst>
        </pc:picChg>
        <pc:picChg chg="mod">
          <ac:chgData name="Megin Nguyen" userId="5019353cdda7aaeb" providerId="LiveId" clId="{B68CD8BF-0F83-4A26-8C6A-38D6417C8AA1}" dt="2020-10-07T18:32:16.951" v="87" actId="165"/>
          <ac:picMkLst>
            <pc:docMk/>
            <pc:sldMk cId="3198319802" sldId="261"/>
            <ac:picMk id="16" creationId="{8933796C-7297-4949-9333-468C11A4185D}"/>
          </ac:picMkLst>
        </pc:picChg>
        <pc:picChg chg="mod">
          <ac:chgData name="Megin Nguyen" userId="5019353cdda7aaeb" providerId="LiveId" clId="{B68CD8BF-0F83-4A26-8C6A-38D6417C8AA1}" dt="2020-10-07T18:29:36.308" v="43" actId="165"/>
          <ac:picMkLst>
            <pc:docMk/>
            <pc:sldMk cId="3198319802" sldId="261"/>
            <ac:picMk id="22" creationId="{88FC9A63-7D2A-4C51-8DB5-CA0D0E05DFEA}"/>
          </ac:picMkLst>
        </pc:picChg>
        <pc:picChg chg="del mod topLvl">
          <ac:chgData name="Megin Nguyen" userId="5019353cdda7aaeb" providerId="LiveId" clId="{B68CD8BF-0F83-4A26-8C6A-38D6417C8AA1}" dt="2020-10-07T18:29:37.832" v="44" actId="478"/>
          <ac:picMkLst>
            <pc:docMk/>
            <pc:sldMk cId="3198319802" sldId="261"/>
            <ac:picMk id="24" creationId="{DD76EBD7-9587-4CEE-B9D2-E54DE30C75B7}"/>
          </ac:picMkLst>
        </pc:picChg>
        <pc:picChg chg="del mod topLvl">
          <ac:chgData name="Megin Nguyen" userId="5019353cdda7aaeb" providerId="LiveId" clId="{B68CD8BF-0F83-4A26-8C6A-38D6417C8AA1}" dt="2020-10-07T18:32:19.211" v="88" actId="478"/>
          <ac:picMkLst>
            <pc:docMk/>
            <pc:sldMk cId="3198319802" sldId="261"/>
            <ac:picMk id="26" creationId="{94037A90-E135-49DE-A678-51CD4B991E51}"/>
          </ac:picMkLst>
        </pc:picChg>
        <pc:picChg chg="del mod topLvl">
          <ac:chgData name="Megin Nguyen" userId="5019353cdda7aaeb" providerId="LiveId" clId="{B68CD8BF-0F83-4A26-8C6A-38D6417C8AA1}" dt="2020-10-07T18:43:00.280" v="131" actId="478"/>
          <ac:picMkLst>
            <pc:docMk/>
            <pc:sldMk cId="3198319802" sldId="261"/>
            <ac:picMk id="28" creationId="{C05C24EF-EC54-40D2-88DD-777AE815FCA5}"/>
          </ac:picMkLst>
        </pc:picChg>
        <pc:picChg chg="add mod ord modCrop">
          <ac:chgData name="Megin Nguyen" userId="5019353cdda7aaeb" providerId="LiveId" clId="{B68CD8BF-0F83-4A26-8C6A-38D6417C8AA1}" dt="2020-10-07T18:33:21.915" v="101" actId="164"/>
          <ac:picMkLst>
            <pc:docMk/>
            <pc:sldMk cId="3198319802" sldId="261"/>
            <ac:picMk id="29" creationId="{C447E881-58CA-4350-B0CD-54B1567A3F36}"/>
          </ac:picMkLst>
        </pc:picChg>
        <pc:picChg chg="add del mod topLvl">
          <ac:chgData name="Megin Nguyen" userId="5019353cdda7aaeb" providerId="LiveId" clId="{B68CD8BF-0F83-4A26-8C6A-38D6417C8AA1}" dt="2020-10-07T18:36:10.180" v="115" actId="478"/>
          <ac:picMkLst>
            <pc:docMk/>
            <pc:sldMk cId="3198319802" sldId="261"/>
            <ac:picMk id="30" creationId="{A1AAF2F1-0BAA-4835-B2C8-6500EDD17CA7}"/>
          </ac:picMkLst>
        </pc:picChg>
        <pc:picChg chg="mod">
          <ac:chgData name="Megin Nguyen" userId="5019353cdda7aaeb" providerId="LiveId" clId="{B68CD8BF-0F83-4A26-8C6A-38D6417C8AA1}" dt="2020-10-07T18:42:58.546" v="130" actId="165"/>
          <ac:picMkLst>
            <pc:docMk/>
            <pc:sldMk cId="3198319802" sldId="261"/>
            <ac:picMk id="33" creationId="{28E4D2DD-E575-4AB5-8AFE-1D180C91C4C3}"/>
          </ac:picMkLst>
        </pc:picChg>
        <pc:picChg chg="mod">
          <ac:chgData name="Megin Nguyen" userId="5019353cdda7aaeb" providerId="LiveId" clId="{B68CD8BF-0F83-4A26-8C6A-38D6417C8AA1}" dt="2020-10-07T18:42:58.546" v="130" actId="165"/>
          <ac:picMkLst>
            <pc:docMk/>
            <pc:sldMk cId="3198319802" sldId="261"/>
            <ac:picMk id="34" creationId="{D3B3F5D7-6435-4CF7-8A11-9A07532DEA23}"/>
          </ac:picMkLst>
        </pc:picChg>
        <pc:picChg chg="mod">
          <ac:chgData name="Megin Nguyen" userId="5019353cdda7aaeb" providerId="LiveId" clId="{B68CD8BF-0F83-4A26-8C6A-38D6417C8AA1}" dt="2020-10-07T18:36:06.186" v="112" actId="165"/>
          <ac:picMkLst>
            <pc:docMk/>
            <pc:sldMk cId="3198319802" sldId="261"/>
            <ac:picMk id="36" creationId="{B9700D41-4FBF-489F-BA95-906FCBCCBF76}"/>
          </ac:picMkLst>
        </pc:picChg>
        <pc:picChg chg="mod">
          <ac:chgData name="Megin Nguyen" userId="5019353cdda7aaeb" providerId="LiveId" clId="{B68CD8BF-0F83-4A26-8C6A-38D6417C8AA1}" dt="2020-10-07T18:36:06.186" v="112" actId="165"/>
          <ac:picMkLst>
            <pc:docMk/>
            <pc:sldMk cId="3198319802" sldId="261"/>
            <ac:picMk id="37" creationId="{F38C7FAC-07E8-453A-B476-7CFCF54F6D3D}"/>
          </ac:picMkLst>
        </pc:picChg>
        <pc:picChg chg="add mod ord modCrop">
          <ac:chgData name="Megin Nguyen" userId="5019353cdda7aaeb" providerId="LiveId" clId="{B68CD8BF-0F83-4A26-8C6A-38D6417C8AA1}" dt="2020-10-07T18:44:11.585" v="146" actId="164"/>
          <ac:picMkLst>
            <pc:docMk/>
            <pc:sldMk cId="3198319802" sldId="261"/>
            <ac:picMk id="61" creationId="{6833A971-A460-40EA-A6D8-D7BD6019E57B}"/>
          </ac:picMkLst>
        </pc:picChg>
        <pc:picChg chg="add mod ord modCrop">
          <ac:chgData name="Megin Nguyen" userId="5019353cdda7aaeb" providerId="LiveId" clId="{B68CD8BF-0F83-4A26-8C6A-38D6417C8AA1}" dt="2020-10-07T18:44:03.087" v="145" actId="164"/>
          <ac:picMkLst>
            <pc:docMk/>
            <pc:sldMk cId="3198319802" sldId="261"/>
            <ac:picMk id="69" creationId="{EAD59290-A0E3-4AEB-9B92-E497693A410D}"/>
          </ac:picMkLst>
        </pc:picChg>
      </pc:sldChg>
      <pc:sldChg chg="modSp mod">
        <pc:chgData name="Megin Nguyen" userId="5019353cdda7aaeb" providerId="LiveId" clId="{B68CD8BF-0F83-4A26-8C6A-38D6417C8AA1}" dt="2020-10-07T19:05:50.971" v="236" actId="1076"/>
        <pc:sldMkLst>
          <pc:docMk/>
          <pc:sldMk cId="1681870138" sldId="265"/>
        </pc:sldMkLst>
        <pc:spChg chg="mod">
          <ac:chgData name="Megin Nguyen" userId="5019353cdda7aaeb" providerId="LiveId" clId="{B68CD8BF-0F83-4A26-8C6A-38D6417C8AA1}" dt="2020-10-07T19:05:50.971" v="236" actId="1076"/>
          <ac:spMkLst>
            <pc:docMk/>
            <pc:sldMk cId="1681870138" sldId="265"/>
            <ac:spMk id="32" creationId="{30FC710E-DD51-4896-96E2-52C4EA4342DC}"/>
          </ac:spMkLst>
        </pc:spChg>
        <pc:picChg chg="mod">
          <ac:chgData name="Megin Nguyen" userId="5019353cdda7aaeb" providerId="LiveId" clId="{B68CD8BF-0F83-4A26-8C6A-38D6417C8AA1}" dt="2020-10-07T19:05:44.738" v="235" actId="1076"/>
          <ac:picMkLst>
            <pc:docMk/>
            <pc:sldMk cId="1681870138" sldId="265"/>
            <ac:picMk id="6" creationId="{28963F09-3FB7-4021-92AE-B459955CBE95}"/>
          </ac:picMkLst>
        </pc:picChg>
      </pc:sldChg>
      <pc:sldChg chg="modSp mod">
        <pc:chgData name="Megin Nguyen" userId="5019353cdda7aaeb" providerId="LiveId" clId="{B68CD8BF-0F83-4A26-8C6A-38D6417C8AA1}" dt="2020-10-07T19:05:30.301" v="234" actId="207"/>
        <pc:sldMkLst>
          <pc:docMk/>
          <pc:sldMk cId="1282517269" sldId="266"/>
        </pc:sldMkLst>
        <pc:spChg chg="mod">
          <ac:chgData name="Megin Nguyen" userId="5019353cdda7aaeb" providerId="LiveId" clId="{B68CD8BF-0F83-4A26-8C6A-38D6417C8AA1}" dt="2020-10-07T19:05:30.301" v="234" actId="207"/>
          <ac:spMkLst>
            <pc:docMk/>
            <pc:sldMk cId="1282517269" sldId="266"/>
            <ac:spMk id="8" creationId="{77004991-AB3C-4787-BEFD-E9D9A1F6B881}"/>
          </ac:spMkLst>
        </pc:spChg>
      </pc:sldChg>
      <pc:sldChg chg="modSp mod">
        <pc:chgData name="Megin Nguyen" userId="5019353cdda7aaeb" providerId="LiveId" clId="{B68CD8BF-0F83-4A26-8C6A-38D6417C8AA1}" dt="2020-10-07T19:05:24.810" v="233" actId="207"/>
        <pc:sldMkLst>
          <pc:docMk/>
          <pc:sldMk cId="1119141596" sldId="267"/>
        </pc:sldMkLst>
        <pc:spChg chg="mod">
          <ac:chgData name="Megin Nguyen" userId="5019353cdda7aaeb" providerId="LiveId" clId="{B68CD8BF-0F83-4A26-8C6A-38D6417C8AA1}" dt="2020-10-07T19:05:24.810" v="233" actId="207"/>
          <ac:spMkLst>
            <pc:docMk/>
            <pc:sldMk cId="1119141596" sldId="267"/>
            <ac:spMk id="4" creationId="{73D3E7AB-2035-463B-81C1-81163EBC98A6}"/>
          </ac:spMkLst>
        </pc:spChg>
      </pc:sldChg>
      <pc:sldChg chg="addSp modSp mod">
        <pc:chgData name="Megin Nguyen" userId="5019353cdda7aaeb" providerId="LiveId" clId="{B68CD8BF-0F83-4A26-8C6A-38D6417C8AA1}" dt="2020-10-07T19:06:14.439" v="239" actId="1076"/>
        <pc:sldMkLst>
          <pc:docMk/>
          <pc:sldMk cId="1224543426" sldId="280"/>
        </pc:sldMkLst>
        <pc:spChg chg="add mod">
          <ac:chgData name="Megin Nguyen" userId="5019353cdda7aaeb" providerId="LiveId" clId="{B68CD8BF-0F83-4A26-8C6A-38D6417C8AA1}" dt="2020-10-07T19:06:14.439" v="239" actId="1076"/>
          <ac:spMkLst>
            <pc:docMk/>
            <pc:sldMk cId="1224543426" sldId="280"/>
            <ac:spMk id="5" creationId="{A374F284-D71D-40EA-A703-7294034B985B}"/>
          </ac:spMkLst>
        </pc:spChg>
        <pc:grpChg chg="mod">
          <ac:chgData name="Megin Nguyen" userId="5019353cdda7aaeb" providerId="LiveId" clId="{B68CD8BF-0F83-4A26-8C6A-38D6417C8AA1}" dt="2020-10-07T19:06:06.921" v="237" actId="1076"/>
          <ac:grpSpMkLst>
            <pc:docMk/>
            <pc:sldMk cId="1224543426" sldId="280"/>
            <ac:grpSpMk id="15" creationId="{00000000-0000-0000-0000-000000000000}"/>
          </ac:grpSpMkLst>
        </pc:grpChg>
      </pc:sldChg>
      <pc:sldChg chg="addSp modSp mod">
        <pc:chgData name="Megin Nguyen" userId="5019353cdda7aaeb" providerId="LiveId" clId="{B68CD8BF-0F83-4A26-8C6A-38D6417C8AA1}" dt="2020-10-07T18:03:16.466" v="9" actId="1076"/>
        <pc:sldMkLst>
          <pc:docMk/>
          <pc:sldMk cId="212672644" sldId="285"/>
        </pc:sldMkLst>
        <pc:spChg chg="mod">
          <ac:chgData name="Megin Nguyen" userId="5019353cdda7aaeb" providerId="LiveId" clId="{B68CD8BF-0F83-4A26-8C6A-38D6417C8AA1}" dt="2020-10-07T18:02:45.985" v="5" actId="1076"/>
          <ac:spMkLst>
            <pc:docMk/>
            <pc:sldMk cId="212672644" sldId="285"/>
            <ac:spMk id="2" creationId="{00000000-0000-0000-0000-000000000000}"/>
          </ac:spMkLst>
        </pc:spChg>
        <pc:spChg chg="add mod">
          <ac:chgData name="Megin Nguyen" userId="5019353cdda7aaeb" providerId="LiveId" clId="{B68CD8BF-0F83-4A26-8C6A-38D6417C8AA1}" dt="2020-10-07T18:03:16.466" v="9" actId="1076"/>
          <ac:spMkLst>
            <pc:docMk/>
            <pc:sldMk cId="212672644" sldId="285"/>
            <ac:spMk id="3" creationId="{710241B1-8319-4B35-868B-DC55A97377DF}"/>
          </ac:spMkLst>
        </pc:spChg>
        <pc:spChg chg="add mod">
          <ac:chgData name="Megin Nguyen" userId="5019353cdda7aaeb" providerId="LiveId" clId="{B68CD8BF-0F83-4A26-8C6A-38D6417C8AA1}" dt="2020-10-07T18:03:11.594" v="8" actId="1076"/>
          <ac:spMkLst>
            <pc:docMk/>
            <pc:sldMk cId="212672644" sldId="285"/>
            <ac:spMk id="4" creationId="{CDDBAF9B-789A-4298-9752-FC619EADDEAC}"/>
          </ac:spMkLst>
        </pc:spChg>
        <pc:spChg chg="mod">
          <ac:chgData name="Megin Nguyen" userId="5019353cdda7aaeb" providerId="LiveId" clId="{B68CD8BF-0F83-4A26-8C6A-38D6417C8AA1}" dt="2020-10-07T18:02:53.106" v="6" actId="1076"/>
          <ac:spMkLst>
            <pc:docMk/>
            <pc:sldMk cId="212672644" sldId="285"/>
            <ac:spMk id="30" creationId="{00000000-0000-0000-0000-000000000000}"/>
          </ac:spMkLst>
        </pc:spChg>
        <pc:spChg chg="mod">
          <ac:chgData name="Megin Nguyen" userId="5019353cdda7aaeb" providerId="LiveId" clId="{B68CD8BF-0F83-4A26-8C6A-38D6417C8AA1}" dt="2020-10-07T18:02:42.753" v="3" actId="1076"/>
          <ac:spMkLst>
            <pc:docMk/>
            <pc:sldMk cId="212672644" sldId="285"/>
            <ac:spMk id="32" creationId="{00000000-0000-0000-0000-000000000000}"/>
          </ac:spMkLst>
        </pc:spChg>
      </pc:sldChg>
      <pc:sldChg chg="modSp mod">
        <pc:chgData name="Megin Nguyen" userId="5019353cdda7aaeb" providerId="LiveId" clId="{B68CD8BF-0F83-4A26-8C6A-38D6417C8AA1}" dt="2020-10-07T19:02:16.956" v="231" actId="20577"/>
        <pc:sldMkLst>
          <pc:docMk/>
          <pc:sldMk cId="1786095780" sldId="287"/>
        </pc:sldMkLst>
        <pc:spChg chg="mod">
          <ac:chgData name="Megin Nguyen" userId="5019353cdda7aaeb" providerId="LiveId" clId="{B68CD8BF-0F83-4A26-8C6A-38D6417C8AA1}" dt="2020-10-07T19:02:16.956" v="231" actId="20577"/>
          <ac:spMkLst>
            <pc:docMk/>
            <pc:sldMk cId="1786095780" sldId="287"/>
            <ac:spMk id="8" creationId="{77004991-AB3C-4787-BEFD-E9D9A1F6B881}"/>
          </ac:spMkLst>
        </pc:spChg>
      </pc:sldChg>
      <pc:sldChg chg="modSp mod">
        <pc:chgData name="Megin Nguyen" userId="5019353cdda7aaeb" providerId="LiveId" clId="{B68CD8BF-0F83-4A26-8C6A-38D6417C8AA1}" dt="2020-10-07T19:02:06.981" v="226" actId="1076"/>
        <pc:sldMkLst>
          <pc:docMk/>
          <pc:sldMk cId="1470636931" sldId="288"/>
        </pc:sldMkLst>
        <pc:spChg chg="mod">
          <ac:chgData name="Megin Nguyen" userId="5019353cdda7aaeb" providerId="LiveId" clId="{B68CD8BF-0F83-4A26-8C6A-38D6417C8AA1}" dt="2020-10-07T19:02:06.981" v="226" actId="1076"/>
          <ac:spMkLst>
            <pc:docMk/>
            <pc:sldMk cId="1470636931" sldId="288"/>
            <ac:spMk id="8" creationId="{77004991-AB3C-4787-BEFD-E9D9A1F6B881}"/>
          </ac:spMkLst>
        </pc:spChg>
      </pc:sldChg>
      <pc:sldChg chg="modSp mod">
        <pc:chgData name="Megin Nguyen" userId="5019353cdda7aaeb" providerId="LiveId" clId="{B68CD8BF-0F83-4A26-8C6A-38D6417C8AA1}" dt="2020-10-07T19:06:27.950" v="242" actId="1076"/>
        <pc:sldMkLst>
          <pc:docMk/>
          <pc:sldMk cId="2513067417" sldId="290"/>
        </pc:sldMkLst>
        <pc:spChg chg="mod">
          <ac:chgData name="Megin Nguyen" userId="5019353cdda7aaeb" providerId="LiveId" clId="{B68CD8BF-0F83-4A26-8C6A-38D6417C8AA1}" dt="2020-10-07T18:56:11.727" v="161" actId="20577"/>
          <ac:spMkLst>
            <pc:docMk/>
            <pc:sldMk cId="2513067417" sldId="290"/>
            <ac:spMk id="3" creationId="{FA65F04B-31B5-4C97-925E-F7E69DCB5F5B}"/>
          </ac:spMkLst>
        </pc:spChg>
        <pc:spChg chg="mod">
          <ac:chgData name="Megin Nguyen" userId="5019353cdda7aaeb" providerId="LiveId" clId="{B68CD8BF-0F83-4A26-8C6A-38D6417C8AA1}" dt="2020-10-07T19:06:27.950" v="242" actId="1076"/>
          <ac:spMkLst>
            <pc:docMk/>
            <pc:sldMk cId="2513067417" sldId="290"/>
            <ac:spMk id="18" creationId="{7B70933E-E262-4111-BF7D-C81CD5E5D24C}"/>
          </ac:spMkLst>
        </pc:spChg>
        <pc:grpChg chg="mod">
          <ac:chgData name="Megin Nguyen" userId="5019353cdda7aaeb" providerId="LiveId" clId="{B68CD8BF-0F83-4A26-8C6A-38D6417C8AA1}" dt="2020-10-07T19:06:23.959" v="241" actId="1076"/>
          <ac:grpSpMkLst>
            <pc:docMk/>
            <pc:sldMk cId="2513067417" sldId="290"/>
            <ac:grpSpMk id="4" creationId="{00000000-0000-0000-0000-000000000000}"/>
          </ac:grpSpMkLst>
        </pc:grpChg>
      </pc:sldChg>
      <pc:sldChg chg="modSp mod">
        <pc:chgData name="Megin Nguyen" userId="5019353cdda7aaeb" providerId="LiveId" clId="{B68CD8BF-0F83-4A26-8C6A-38D6417C8AA1}" dt="2020-10-07T18:56:36.833" v="181" actId="20577"/>
        <pc:sldMkLst>
          <pc:docMk/>
          <pc:sldMk cId="1394253872" sldId="291"/>
        </pc:sldMkLst>
        <pc:spChg chg="mod">
          <ac:chgData name="Megin Nguyen" userId="5019353cdda7aaeb" providerId="LiveId" clId="{B68CD8BF-0F83-4A26-8C6A-38D6417C8AA1}" dt="2020-10-07T18:56:36.833" v="181" actId="20577"/>
          <ac:spMkLst>
            <pc:docMk/>
            <pc:sldMk cId="1394253872" sldId="291"/>
            <ac:spMk id="5" creationId="{B75B0EDE-D7C4-42E3-8651-65133E01369D}"/>
          </ac:spMkLst>
        </pc:spChg>
        <pc:graphicFrameChg chg="modGraphic">
          <ac:chgData name="Megin Nguyen" userId="5019353cdda7aaeb" providerId="LiveId" clId="{B68CD8BF-0F83-4A26-8C6A-38D6417C8AA1}" dt="2020-10-07T18:04:48.728" v="40" actId="2166"/>
          <ac:graphicFrameMkLst>
            <pc:docMk/>
            <pc:sldMk cId="1394253872" sldId="291"/>
            <ac:graphicFrameMk id="3" creationId="{585A9D07-7820-4F44-A31D-BBC840C135AF}"/>
          </ac:graphicFrameMkLst>
        </pc:graphicFrameChg>
      </pc:sldChg>
    </pc:docChg>
  </pc:docChgLst>
  <pc:docChgLst>
    <pc:chgData name="Megin Nguyen" userId="5019353cdda7aaeb" providerId="LiveId" clId="{39F52628-9D7D-3D46-9647-93D135210C47}"/>
    <pc:docChg chg="modSld">
      <pc:chgData name="Megin Nguyen" userId="5019353cdda7aaeb" providerId="LiveId" clId="{39F52628-9D7D-3D46-9647-93D135210C47}" dt="2020-12-03T17:09:06.394" v="0" actId="1076"/>
      <pc:docMkLst>
        <pc:docMk/>
      </pc:docMkLst>
      <pc:sldChg chg="modSp">
        <pc:chgData name="Megin Nguyen" userId="5019353cdda7aaeb" providerId="LiveId" clId="{39F52628-9D7D-3D46-9647-93D135210C47}" dt="2020-12-03T17:09:06.394" v="0" actId="1076"/>
        <pc:sldMkLst>
          <pc:docMk/>
          <pc:sldMk cId="489820577" sldId="292"/>
        </pc:sldMkLst>
        <pc:spChg chg="mod">
          <ac:chgData name="Megin Nguyen" userId="5019353cdda7aaeb" providerId="LiveId" clId="{39F52628-9D7D-3D46-9647-93D135210C47}" dt="2020-12-03T17:09:06.394" v="0" actId="1076"/>
          <ac:spMkLst>
            <pc:docMk/>
            <pc:sldMk cId="489820577" sldId="292"/>
            <ac:spMk id="3" creationId="{FA65F04B-31B5-4C97-925E-F7E69DCB5F5B}"/>
          </ac:spMkLst>
        </pc:spChg>
      </pc:sldChg>
    </pc:docChg>
  </pc:docChgLst>
  <pc:docChgLst>
    <pc:chgData name="Megin Nguyen" userId="5019353cdda7aaeb" providerId="LiveId" clId="{C221C7D5-BA2B-4BAD-A469-21AA51A6FB27}"/>
    <pc:docChg chg="undo custSel addSld delSld modSld">
      <pc:chgData name="Megin Nguyen" userId="5019353cdda7aaeb" providerId="LiveId" clId="{C221C7D5-BA2B-4BAD-A469-21AA51A6FB27}" dt="2020-10-06T01:19:44.121" v="653" actId="47"/>
      <pc:docMkLst>
        <pc:docMk/>
      </pc:docMkLst>
      <pc:sldChg chg="del">
        <pc:chgData name="Megin Nguyen" userId="5019353cdda7aaeb" providerId="LiveId" clId="{C221C7D5-BA2B-4BAD-A469-21AA51A6FB27}" dt="2020-10-06T01:19:44.121" v="653" actId="47"/>
        <pc:sldMkLst>
          <pc:docMk/>
          <pc:sldMk cId="2161274620" sldId="260"/>
        </pc:sldMkLst>
      </pc:sldChg>
      <pc:sldChg chg="addSp modSp mod">
        <pc:chgData name="Megin Nguyen" userId="5019353cdda7aaeb" providerId="LiveId" clId="{C221C7D5-BA2B-4BAD-A469-21AA51A6FB27}" dt="2020-10-05T22:59:22.064" v="100" actId="1076"/>
        <pc:sldMkLst>
          <pc:docMk/>
          <pc:sldMk cId="3198319802" sldId="261"/>
        </pc:sldMkLst>
        <pc:graphicFrameChg chg="add mod modGraphic">
          <ac:chgData name="Megin Nguyen" userId="5019353cdda7aaeb" providerId="LiveId" clId="{C221C7D5-BA2B-4BAD-A469-21AA51A6FB27}" dt="2020-10-05T22:59:22.064" v="100" actId="1076"/>
          <ac:graphicFrameMkLst>
            <pc:docMk/>
            <pc:sldMk cId="3198319802" sldId="261"/>
            <ac:graphicFrameMk id="12" creationId="{E728D85B-1871-438F-B947-E203BF134035}"/>
          </ac:graphicFrameMkLst>
        </pc:graphicFrameChg>
      </pc:sldChg>
      <pc:sldChg chg="addSp modSp mod">
        <pc:chgData name="Megin Nguyen" userId="5019353cdda7aaeb" providerId="LiveId" clId="{C221C7D5-BA2B-4BAD-A469-21AA51A6FB27}" dt="2020-10-06T00:52:05.621" v="540" actId="1037"/>
        <pc:sldMkLst>
          <pc:docMk/>
          <pc:sldMk cId="3822879238" sldId="286"/>
        </pc:sldMkLst>
        <pc:spChg chg="add mod">
          <ac:chgData name="Megin Nguyen" userId="5019353cdda7aaeb" providerId="LiveId" clId="{C221C7D5-BA2B-4BAD-A469-21AA51A6FB27}" dt="2020-10-06T00:52:05.621" v="540" actId="1037"/>
          <ac:spMkLst>
            <pc:docMk/>
            <pc:sldMk cId="3822879238" sldId="286"/>
            <ac:spMk id="2" creationId="{7E07FF66-9321-4613-A7D5-FAE6FA1C466F}"/>
          </ac:spMkLst>
        </pc:spChg>
        <pc:spChg chg="add mod">
          <ac:chgData name="Megin Nguyen" userId="5019353cdda7aaeb" providerId="LiveId" clId="{C221C7D5-BA2B-4BAD-A469-21AA51A6FB27}" dt="2020-10-06T00:52:05.621" v="540" actId="1037"/>
          <ac:spMkLst>
            <pc:docMk/>
            <pc:sldMk cId="3822879238" sldId="286"/>
            <ac:spMk id="7" creationId="{A359CE6E-A283-4AD4-B675-A3FDE8E93E14}"/>
          </ac:spMkLst>
        </pc:spChg>
        <pc:spChg chg="add mod">
          <ac:chgData name="Megin Nguyen" userId="5019353cdda7aaeb" providerId="LiveId" clId="{C221C7D5-BA2B-4BAD-A469-21AA51A6FB27}" dt="2020-10-06T00:52:05.621" v="540" actId="1037"/>
          <ac:spMkLst>
            <pc:docMk/>
            <pc:sldMk cId="3822879238" sldId="286"/>
            <ac:spMk id="12" creationId="{A339D09E-717F-46E4-A01F-85F470206A6D}"/>
          </ac:spMkLst>
        </pc:spChg>
        <pc:spChg chg="add mod">
          <ac:chgData name="Megin Nguyen" userId="5019353cdda7aaeb" providerId="LiveId" clId="{C221C7D5-BA2B-4BAD-A469-21AA51A6FB27}" dt="2020-10-06T00:52:05.621" v="540" actId="1037"/>
          <ac:spMkLst>
            <pc:docMk/>
            <pc:sldMk cId="3822879238" sldId="286"/>
            <ac:spMk id="14" creationId="{6E21A8FD-3D17-456B-90ED-01622B0B2055}"/>
          </ac:spMkLst>
        </pc:spChg>
        <pc:spChg chg="add mod">
          <ac:chgData name="Megin Nguyen" userId="5019353cdda7aaeb" providerId="LiveId" clId="{C221C7D5-BA2B-4BAD-A469-21AA51A6FB27}" dt="2020-10-06T00:52:05.621" v="540" actId="1037"/>
          <ac:spMkLst>
            <pc:docMk/>
            <pc:sldMk cId="3822879238" sldId="286"/>
            <ac:spMk id="16" creationId="{E9F4671C-AECF-4702-8C5F-9FAC5D8B428B}"/>
          </ac:spMkLst>
        </pc:spChg>
        <pc:spChg chg="add mod">
          <ac:chgData name="Megin Nguyen" userId="5019353cdda7aaeb" providerId="LiveId" clId="{C221C7D5-BA2B-4BAD-A469-21AA51A6FB27}" dt="2020-10-06T00:52:05.621" v="540" actId="1037"/>
          <ac:spMkLst>
            <pc:docMk/>
            <pc:sldMk cId="3822879238" sldId="286"/>
            <ac:spMk id="18" creationId="{D48CB077-D44D-4281-A735-9518262CC3BC}"/>
          </ac:spMkLst>
        </pc:spChg>
        <pc:picChg chg="mod">
          <ac:chgData name="Megin Nguyen" userId="5019353cdda7aaeb" providerId="LiveId" clId="{C221C7D5-BA2B-4BAD-A469-21AA51A6FB27}" dt="2020-10-06T00:49:22.889" v="509" actId="1076"/>
          <ac:picMkLst>
            <pc:docMk/>
            <pc:sldMk cId="3822879238" sldId="286"/>
            <ac:picMk id="10" creationId="{5159DD3A-CECC-4D87-B81F-33D6C91DB553}"/>
          </ac:picMkLst>
        </pc:picChg>
      </pc:sldChg>
      <pc:sldChg chg="addSp modSp mod">
        <pc:chgData name="Megin Nguyen" userId="5019353cdda7aaeb" providerId="LiveId" clId="{C221C7D5-BA2B-4BAD-A469-21AA51A6FB27}" dt="2020-10-06T00:53:16.583" v="569" actId="20577"/>
        <pc:sldMkLst>
          <pc:docMk/>
          <pc:sldMk cId="1786095780" sldId="287"/>
        </pc:sldMkLst>
        <pc:spChg chg="add mod">
          <ac:chgData name="Megin Nguyen" userId="5019353cdda7aaeb" providerId="LiveId" clId="{C221C7D5-BA2B-4BAD-A469-21AA51A6FB27}" dt="2020-10-05T22:26:57.908" v="1" actId="1076"/>
          <ac:spMkLst>
            <pc:docMk/>
            <pc:sldMk cId="1786095780" sldId="287"/>
            <ac:spMk id="2" creationId="{1EB258AB-A853-4B7B-BE4E-18361C99E9FD}"/>
          </ac:spMkLst>
        </pc:spChg>
        <pc:spChg chg="add mod">
          <ac:chgData name="Megin Nguyen" userId="5019353cdda7aaeb" providerId="LiveId" clId="{C221C7D5-BA2B-4BAD-A469-21AA51A6FB27}" dt="2020-10-05T22:26:57.908" v="1" actId="1076"/>
          <ac:spMkLst>
            <pc:docMk/>
            <pc:sldMk cId="1786095780" sldId="287"/>
            <ac:spMk id="3" creationId="{FE0D9B96-CD7B-4D72-97A1-849941EB4EA4}"/>
          </ac:spMkLst>
        </pc:spChg>
        <pc:spChg chg="add mod">
          <ac:chgData name="Megin Nguyen" userId="5019353cdda7aaeb" providerId="LiveId" clId="{C221C7D5-BA2B-4BAD-A469-21AA51A6FB27}" dt="2020-10-05T22:26:57.908" v="1" actId="1076"/>
          <ac:spMkLst>
            <pc:docMk/>
            <pc:sldMk cId="1786095780" sldId="287"/>
            <ac:spMk id="4" creationId="{C829A139-5CDB-427B-9C7B-DAAF57604F2D}"/>
          </ac:spMkLst>
        </pc:spChg>
        <pc:spChg chg="mod">
          <ac:chgData name="Megin Nguyen" userId="5019353cdda7aaeb" providerId="LiveId" clId="{C221C7D5-BA2B-4BAD-A469-21AA51A6FB27}" dt="2020-10-06T00:53:16.583" v="569" actId="20577"/>
          <ac:spMkLst>
            <pc:docMk/>
            <pc:sldMk cId="1786095780" sldId="287"/>
            <ac:spMk id="8" creationId="{77004991-AB3C-4787-BEFD-E9D9A1F6B881}"/>
          </ac:spMkLst>
        </pc:spChg>
      </pc:sldChg>
      <pc:sldChg chg="addSp modSp mod">
        <pc:chgData name="Megin Nguyen" userId="5019353cdda7aaeb" providerId="LiveId" clId="{C221C7D5-BA2B-4BAD-A469-21AA51A6FB27}" dt="2020-10-06T00:53:28.091" v="574" actId="20577"/>
        <pc:sldMkLst>
          <pc:docMk/>
          <pc:sldMk cId="1470636931" sldId="288"/>
        </pc:sldMkLst>
        <pc:spChg chg="add">
          <ac:chgData name="Megin Nguyen" userId="5019353cdda7aaeb" providerId="LiveId" clId="{C221C7D5-BA2B-4BAD-A469-21AA51A6FB27}" dt="2020-10-05T22:27:01.055" v="2" actId="22"/>
          <ac:spMkLst>
            <pc:docMk/>
            <pc:sldMk cId="1470636931" sldId="288"/>
            <ac:spMk id="2" creationId="{334CFD78-F031-4175-9FF7-49194D99A2A8}"/>
          </ac:spMkLst>
        </pc:spChg>
        <pc:spChg chg="add">
          <ac:chgData name="Megin Nguyen" userId="5019353cdda7aaeb" providerId="LiveId" clId="{C221C7D5-BA2B-4BAD-A469-21AA51A6FB27}" dt="2020-10-05T22:27:01.055" v="2" actId="22"/>
          <ac:spMkLst>
            <pc:docMk/>
            <pc:sldMk cId="1470636931" sldId="288"/>
            <ac:spMk id="4" creationId="{A3F2B032-3252-42B2-A29F-72684CE66D44}"/>
          </ac:spMkLst>
        </pc:spChg>
        <pc:spChg chg="mod">
          <ac:chgData name="Megin Nguyen" userId="5019353cdda7aaeb" providerId="LiveId" clId="{C221C7D5-BA2B-4BAD-A469-21AA51A6FB27}" dt="2020-10-06T00:53:28.091" v="574" actId="20577"/>
          <ac:spMkLst>
            <pc:docMk/>
            <pc:sldMk cId="1470636931" sldId="288"/>
            <ac:spMk id="8" creationId="{77004991-AB3C-4787-BEFD-E9D9A1F6B881}"/>
          </ac:spMkLst>
        </pc:spChg>
        <pc:spChg chg="add">
          <ac:chgData name="Megin Nguyen" userId="5019353cdda7aaeb" providerId="LiveId" clId="{C221C7D5-BA2B-4BAD-A469-21AA51A6FB27}" dt="2020-10-05T22:27:01.055" v="2" actId="22"/>
          <ac:spMkLst>
            <pc:docMk/>
            <pc:sldMk cId="1470636931" sldId="288"/>
            <ac:spMk id="11" creationId="{65365229-160E-446E-B09A-FF2D746711A0}"/>
          </ac:spMkLst>
        </pc:spChg>
      </pc:sldChg>
      <pc:sldChg chg="addSp modSp mod">
        <pc:chgData name="Megin Nguyen" userId="5019353cdda7aaeb" providerId="LiveId" clId="{C221C7D5-BA2B-4BAD-A469-21AA51A6FB27}" dt="2020-10-06T01:19:04.077" v="652" actId="20577"/>
        <pc:sldMkLst>
          <pc:docMk/>
          <pc:sldMk cId="2513067417" sldId="290"/>
        </pc:sldMkLst>
        <pc:spChg chg="mod">
          <ac:chgData name="Megin Nguyen" userId="5019353cdda7aaeb" providerId="LiveId" clId="{C221C7D5-BA2B-4BAD-A469-21AA51A6FB27}" dt="2020-10-06T01:17:52.798" v="580" actId="20577"/>
          <ac:spMkLst>
            <pc:docMk/>
            <pc:sldMk cId="2513067417" sldId="290"/>
            <ac:spMk id="3" creationId="{FA65F04B-31B5-4C97-925E-F7E69DCB5F5B}"/>
          </ac:spMkLst>
        </pc:spChg>
        <pc:spChg chg="add mod">
          <ac:chgData name="Megin Nguyen" userId="5019353cdda7aaeb" providerId="LiveId" clId="{C221C7D5-BA2B-4BAD-A469-21AA51A6FB27}" dt="2020-10-06T01:19:04.077" v="652" actId="20577"/>
          <ac:spMkLst>
            <pc:docMk/>
            <pc:sldMk cId="2513067417" sldId="290"/>
            <ac:spMk id="18" creationId="{7B70933E-E262-4111-BF7D-C81CD5E5D24C}"/>
          </ac:spMkLst>
        </pc:spChg>
      </pc:sldChg>
      <pc:sldChg chg="addSp modSp new mod">
        <pc:chgData name="Megin Nguyen" userId="5019353cdda7aaeb" providerId="LiveId" clId="{C221C7D5-BA2B-4BAD-A469-21AA51A6FB27}" dt="2020-10-05T23:32:29.373" v="507" actId="20577"/>
        <pc:sldMkLst>
          <pc:docMk/>
          <pc:sldMk cId="1394253872" sldId="291"/>
        </pc:sldMkLst>
        <pc:spChg chg="add mod">
          <ac:chgData name="Megin Nguyen" userId="5019353cdda7aaeb" providerId="LiveId" clId="{C221C7D5-BA2B-4BAD-A469-21AA51A6FB27}" dt="2020-10-05T23:32:29.373" v="507" actId="20577"/>
          <ac:spMkLst>
            <pc:docMk/>
            <pc:sldMk cId="1394253872" sldId="291"/>
            <ac:spMk id="5" creationId="{B75B0EDE-D7C4-42E3-8651-65133E01369D}"/>
          </ac:spMkLst>
        </pc:spChg>
        <pc:graphicFrameChg chg="add mod modGraphic">
          <ac:chgData name="Megin Nguyen" userId="5019353cdda7aaeb" providerId="LiveId" clId="{C221C7D5-BA2B-4BAD-A469-21AA51A6FB27}" dt="2020-10-05T23:08:01.579" v="479" actId="1076"/>
          <ac:graphicFrameMkLst>
            <pc:docMk/>
            <pc:sldMk cId="1394253872" sldId="291"/>
            <ac:graphicFrameMk id="3" creationId="{585A9D07-7820-4F44-A31D-BBC840C135AF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019353cdda7aaeb/Research/data/GTs/HepI-GtfA/Carlos_Anton/dcom_combin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67757770927013"/>
          <c:y val="4.6881745766816557E-2"/>
          <c:w val="0.83001818288923357"/>
          <c:h val="0.7379336435813354"/>
        </c:manualLayout>
      </c:layout>
      <c:scatterChart>
        <c:scatterStyle val="smoothMarker"/>
        <c:varyColors val="0"/>
        <c:ser>
          <c:idx val="0"/>
          <c:order val="0"/>
          <c:tx>
            <c:v>HepI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A$2:$A$7752</c:f>
              <c:numCache>
                <c:formatCode>General</c:formatCode>
                <c:ptCount val="7751"/>
                <c:pt idx="0">
                  <c:v>0</c:v>
                </c:pt>
                <c:pt idx="1">
                  <c:v>0.232228099600052</c:v>
                </c:pt>
                <c:pt idx="2">
                  <c:v>0.464456199200103</c:v>
                </c:pt>
                <c:pt idx="3">
                  <c:v>0.69668429880015503</c:v>
                </c:pt>
                <c:pt idx="4">
                  <c:v>0.92891239840020601</c:v>
                </c:pt>
                <c:pt idx="5">
                  <c:v>1.16114049800026</c:v>
                </c:pt>
                <c:pt idx="6">
                  <c:v>1.3933685976003101</c:v>
                </c:pt>
                <c:pt idx="7">
                  <c:v>1.6255966972003599</c:v>
                </c:pt>
                <c:pt idx="8">
                  <c:v>1.85782479680041</c:v>
                </c:pt>
                <c:pt idx="9">
                  <c:v>2.0900528964004601</c:v>
                </c:pt>
                <c:pt idx="10">
                  <c:v>2.32228099600052</c:v>
                </c:pt>
                <c:pt idx="11">
                  <c:v>2.55450909560057</c:v>
                </c:pt>
                <c:pt idx="12">
                  <c:v>2.7867371952006201</c:v>
                </c:pt>
                <c:pt idx="13">
                  <c:v>3.0189652948006702</c:v>
                </c:pt>
                <c:pt idx="14">
                  <c:v>3.2511933944007199</c:v>
                </c:pt>
                <c:pt idx="15">
                  <c:v>3.4834214940007699</c:v>
                </c:pt>
                <c:pt idx="16">
                  <c:v>3.7156495936008298</c:v>
                </c:pt>
                <c:pt idx="17">
                  <c:v>3.9478776932008799</c:v>
                </c:pt>
                <c:pt idx="18">
                  <c:v>4.18010579280093</c:v>
                </c:pt>
                <c:pt idx="19">
                  <c:v>4.4123338924009801</c:v>
                </c:pt>
                <c:pt idx="20">
                  <c:v>4.6445619920010301</c:v>
                </c:pt>
                <c:pt idx="21">
                  <c:v>4.8767900916010802</c:v>
                </c:pt>
                <c:pt idx="22">
                  <c:v>5.1090181912011401</c:v>
                </c:pt>
                <c:pt idx="23">
                  <c:v>5.3412462908011902</c:v>
                </c:pt>
                <c:pt idx="24">
                  <c:v>5.5734743904012403</c:v>
                </c:pt>
                <c:pt idx="25">
                  <c:v>5.8057024900012904</c:v>
                </c:pt>
                <c:pt idx="26">
                  <c:v>6.0379305896013404</c:v>
                </c:pt>
                <c:pt idx="27">
                  <c:v>6.2701586892013896</c:v>
                </c:pt>
                <c:pt idx="28">
                  <c:v>6.5023867888014504</c:v>
                </c:pt>
                <c:pt idx="29">
                  <c:v>6.7346148884014996</c:v>
                </c:pt>
                <c:pt idx="30">
                  <c:v>6.9668429880015497</c:v>
                </c:pt>
                <c:pt idx="31">
                  <c:v>7.1990710876015997</c:v>
                </c:pt>
                <c:pt idx="32">
                  <c:v>7.4312991872016498</c:v>
                </c:pt>
                <c:pt idx="33">
                  <c:v>7.6635272868016999</c:v>
                </c:pt>
                <c:pt idx="34">
                  <c:v>7.89575538640175</c:v>
                </c:pt>
                <c:pt idx="35">
                  <c:v>8.1279834860018099</c:v>
                </c:pt>
                <c:pt idx="36">
                  <c:v>8.36021158560186</c:v>
                </c:pt>
                <c:pt idx="37">
                  <c:v>8.59243968520191</c:v>
                </c:pt>
                <c:pt idx="38">
                  <c:v>8.8246677848019601</c:v>
                </c:pt>
                <c:pt idx="39">
                  <c:v>9.0568958844020102</c:v>
                </c:pt>
                <c:pt idx="40">
                  <c:v>9.2891239840020603</c:v>
                </c:pt>
                <c:pt idx="41">
                  <c:v>9.5213520836021193</c:v>
                </c:pt>
                <c:pt idx="42">
                  <c:v>9.7535801832021694</c:v>
                </c:pt>
                <c:pt idx="43">
                  <c:v>9.9858082828022194</c:v>
                </c:pt>
                <c:pt idx="44">
                  <c:v>10.2180363824023</c:v>
                </c:pt>
                <c:pt idx="45">
                  <c:v>10.4502644820023</c:v>
                </c:pt>
                <c:pt idx="46">
                  <c:v>10.6824925816024</c:v>
                </c:pt>
                <c:pt idx="47">
                  <c:v>10.9147206812024</c:v>
                </c:pt>
                <c:pt idx="48">
                  <c:v>11.1469487808025</c:v>
                </c:pt>
                <c:pt idx="49">
                  <c:v>11.3791768804025</c:v>
                </c:pt>
                <c:pt idx="50">
                  <c:v>11.6114049800026</c:v>
                </c:pt>
                <c:pt idx="51">
                  <c:v>11.843633079602601</c:v>
                </c:pt>
                <c:pt idx="52">
                  <c:v>12.0758611792027</c:v>
                </c:pt>
                <c:pt idx="53">
                  <c:v>12.308089278802701</c:v>
                </c:pt>
                <c:pt idx="54">
                  <c:v>12.540317378402801</c:v>
                </c:pt>
                <c:pt idx="55">
                  <c:v>12.772545478002799</c:v>
                </c:pt>
                <c:pt idx="56">
                  <c:v>13.004773577602901</c:v>
                </c:pt>
                <c:pt idx="57">
                  <c:v>13.237001677202899</c:v>
                </c:pt>
                <c:pt idx="58">
                  <c:v>13.469229776802999</c:v>
                </c:pt>
                <c:pt idx="59">
                  <c:v>13.701457876403</c:v>
                </c:pt>
                <c:pt idx="60">
                  <c:v>13.933685976003099</c:v>
                </c:pt>
                <c:pt idx="61">
                  <c:v>14.1659140756031</c:v>
                </c:pt>
                <c:pt idx="62">
                  <c:v>14.398142175203199</c:v>
                </c:pt>
                <c:pt idx="63">
                  <c:v>14.630370274803299</c:v>
                </c:pt>
                <c:pt idx="64">
                  <c:v>14.8625983744033</c:v>
                </c:pt>
                <c:pt idx="65">
                  <c:v>15.094826474003399</c:v>
                </c:pt>
                <c:pt idx="66">
                  <c:v>15.3270545736034</c:v>
                </c:pt>
                <c:pt idx="67">
                  <c:v>15.5592826732035</c:v>
                </c:pt>
                <c:pt idx="68">
                  <c:v>15.7915107728035</c:v>
                </c:pt>
                <c:pt idx="69">
                  <c:v>16.023738872403602</c:v>
                </c:pt>
                <c:pt idx="70">
                  <c:v>16.255966972003598</c:v>
                </c:pt>
                <c:pt idx="71">
                  <c:v>16.488195071603698</c:v>
                </c:pt>
                <c:pt idx="72">
                  <c:v>16.720423171203699</c:v>
                </c:pt>
                <c:pt idx="73">
                  <c:v>16.952651270803798</c:v>
                </c:pt>
                <c:pt idx="74">
                  <c:v>17.184879370403799</c:v>
                </c:pt>
                <c:pt idx="75">
                  <c:v>17.417107470003899</c:v>
                </c:pt>
                <c:pt idx="76">
                  <c:v>17.649335569603899</c:v>
                </c:pt>
                <c:pt idx="77">
                  <c:v>17.881563669203999</c:v>
                </c:pt>
                <c:pt idx="78">
                  <c:v>18.113791768803999</c:v>
                </c:pt>
                <c:pt idx="79">
                  <c:v>18.346019868404099</c:v>
                </c:pt>
                <c:pt idx="80">
                  <c:v>18.578247968004099</c:v>
                </c:pt>
                <c:pt idx="81">
                  <c:v>18.810476067604199</c:v>
                </c:pt>
                <c:pt idx="82">
                  <c:v>19.042704167204199</c:v>
                </c:pt>
                <c:pt idx="83">
                  <c:v>19.274932266804299</c:v>
                </c:pt>
                <c:pt idx="84">
                  <c:v>19.5071603664043</c:v>
                </c:pt>
                <c:pt idx="85">
                  <c:v>19.739388466004399</c:v>
                </c:pt>
                <c:pt idx="86">
                  <c:v>19.9716165656044</c:v>
                </c:pt>
                <c:pt idx="87">
                  <c:v>20.2038446652045</c:v>
                </c:pt>
                <c:pt idx="88">
                  <c:v>20.4360727648045</c:v>
                </c:pt>
                <c:pt idx="89">
                  <c:v>20.6683008644046</c:v>
                </c:pt>
                <c:pt idx="90">
                  <c:v>20.9005289640046</c:v>
                </c:pt>
                <c:pt idx="91">
                  <c:v>21.1327570636047</c:v>
                </c:pt>
                <c:pt idx="92">
                  <c:v>21.3649851632048</c:v>
                </c:pt>
                <c:pt idx="93">
                  <c:v>21.5972132628048</c:v>
                </c:pt>
                <c:pt idx="94">
                  <c:v>21.8294413624049</c:v>
                </c:pt>
                <c:pt idx="95">
                  <c:v>22.0616694620049</c:v>
                </c:pt>
                <c:pt idx="96">
                  <c:v>22.293897561605</c:v>
                </c:pt>
                <c:pt idx="97">
                  <c:v>22.526125661205</c:v>
                </c:pt>
                <c:pt idx="98">
                  <c:v>22.7583537608051</c:v>
                </c:pt>
                <c:pt idx="99">
                  <c:v>22.990581860405101</c:v>
                </c:pt>
                <c:pt idx="100">
                  <c:v>23.2228099600052</c:v>
                </c:pt>
                <c:pt idx="101">
                  <c:v>23.455038059605201</c:v>
                </c:pt>
                <c:pt idx="102">
                  <c:v>23.687266159205301</c:v>
                </c:pt>
                <c:pt idx="103">
                  <c:v>23.919494258805301</c:v>
                </c:pt>
                <c:pt idx="104">
                  <c:v>24.151722358405401</c:v>
                </c:pt>
                <c:pt idx="105">
                  <c:v>24.383950458005401</c:v>
                </c:pt>
                <c:pt idx="106">
                  <c:v>24.616178557605501</c:v>
                </c:pt>
                <c:pt idx="107">
                  <c:v>24.848406657205501</c:v>
                </c:pt>
                <c:pt idx="108">
                  <c:v>25.080634756805601</c:v>
                </c:pt>
                <c:pt idx="109">
                  <c:v>25.312862856405602</c:v>
                </c:pt>
                <c:pt idx="110">
                  <c:v>25.545090956005701</c:v>
                </c:pt>
                <c:pt idx="111">
                  <c:v>25.777319055605702</c:v>
                </c:pt>
                <c:pt idx="112">
                  <c:v>26.009547155205802</c:v>
                </c:pt>
                <c:pt idx="113">
                  <c:v>26.241775254805798</c:v>
                </c:pt>
                <c:pt idx="114">
                  <c:v>26.474003354405902</c:v>
                </c:pt>
                <c:pt idx="115">
                  <c:v>26.706231454005898</c:v>
                </c:pt>
                <c:pt idx="116">
                  <c:v>26.938459553605998</c:v>
                </c:pt>
                <c:pt idx="117">
                  <c:v>27.170687653205999</c:v>
                </c:pt>
                <c:pt idx="118">
                  <c:v>27.402915752806098</c:v>
                </c:pt>
                <c:pt idx="119">
                  <c:v>27.635143852406099</c:v>
                </c:pt>
                <c:pt idx="120">
                  <c:v>27.867371952006199</c:v>
                </c:pt>
                <c:pt idx="121">
                  <c:v>28.099600051606199</c:v>
                </c:pt>
                <c:pt idx="122">
                  <c:v>28.331828151206299</c:v>
                </c:pt>
                <c:pt idx="123">
                  <c:v>28.564056250806299</c:v>
                </c:pt>
                <c:pt idx="124">
                  <c:v>28.796284350406399</c:v>
                </c:pt>
                <c:pt idx="125">
                  <c:v>29.028512450006499</c:v>
                </c:pt>
                <c:pt idx="126">
                  <c:v>29.260740549606499</c:v>
                </c:pt>
                <c:pt idx="127">
                  <c:v>29.492968649206599</c:v>
                </c:pt>
                <c:pt idx="128">
                  <c:v>29.725196748806599</c:v>
                </c:pt>
                <c:pt idx="129">
                  <c:v>29.957424848406699</c:v>
                </c:pt>
                <c:pt idx="130">
                  <c:v>30.1896529480067</c:v>
                </c:pt>
                <c:pt idx="131">
                  <c:v>30.421881047606799</c:v>
                </c:pt>
                <c:pt idx="132">
                  <c:v>30.6541091472068</c:v>
                </c:pt>
                <c:pt idx="133">
                  <c:v>30.8863372468069</c:v>
                </c:pt>
                <c:pt idx="134">
                  <c:v>31.1185653464069</c:v>
                </c:pt>
                <c:pt idx="135">
                  <c:v>31.350793446007</c:v>
                </c:pt>
                <c:pt idx="136">
                  <c:v>31.583021545607</c:v>
                </c:pt>
                <c:pt idx="137">
                  <c:v>31.8152496452071</c:v>
                </c:pt>
                <c:pt idx="138">
                  <c:v>32.047477744807097</c:v>
                </c:pt>
                <c:pt idx="139">
                  <c:v>32.279705844407196</c:v>
                </c:pt>
                <c:pt idx="140">
                  <c:v>32.511933944007197</c:v>
                </c:pt>
                <c:pt idx="141">
                  <c:v>32.744162043607297</c:v>
                </c:pt>
                <c:pt idx="142">
                  <c:v>32.976390143207297</c:v>
                </c:pt>
                <c:pt idx="143">
                  <c:v>33.208618242807397</c:v>
                </c:pt>
                <c:pt idx="144">
                  <c:v>33.440846342407397</c:v>
                </c:pt>
                <c:pt idx="145">
                  <c:v>33.673074442007497</c:v>
                </c:pt>
                <c:pt idx="146">
                  <c:v>33.905302541607497</c:v>
                </c:pt>
                <c:pt idx="147">
                  <c:v>34.137530641207597</c:v>
                </c:pt>
                <c:pt idx="148">
                  <c:v>34.369758740807598</c:v>
                </c:pt>
                <c:pt idx="149">
                  <c:v>34.601986840407697</c:v>
                </c:pt>
                <c:pt idx="150">
                  <c:v>34.834214940007698</c:v>
                </c:pt>
                <c:pt idx="151">
                  <c:v>35.066443039607798</c:v>
                </c:pt>
                <c:pt idx="152">
                  <c:v>35.298671139207798</c:v>
                </c:pt>
                <c:pt idx="153">
                  <c:v>35.530899238807898</c:v>
                </c:pt>
                <c:pt idx="154">
                  <c:v>35.763127338407898</c:v>
                </c:pt>
                <c:pt idx="155">
                  <c:v>35.995355438007998</c:v>
                </c:pt>
                <c:pt idx="156">
                  <c:v>36.227583537608098</c:v>
                </c:pt>
                <c:pt idx="157">
                  <c:v>36.459811637208098</c:v>
                </c:pt>
                <c:pt idx="158">
                  <c:v>36.692039736808198</c:v>
                </c:pt>
                <c:pt idx="159">
                  <c:v>36.924267836408198</c:v>
                </c:pt>
                <c:pt idx="160">
                  <c:v>37.156495936008298</c:v>
                </c:pt>
                <c:pt idx="161">
                  <c:v>37.388724035608298</c:v>
                </c:pt>
                <c:pt idx="162">
                  <c:v>37.620952135208398</c:v>
                </c:pt>
                <c:pt idx="163">
                  <c:v>37.853180234808399</c:v>
                </c:pt>
                <c:pt idx="164">
                  <c:v>38.085408334408498</c:v>
                </c:pt>
                <c:pt idx="165">
                  <c:v>38.317636434008499</c:v>
                </c:pt>
                <c:pt idx="166">
                  <c:v>38.549864533608599</c:v>
                </c:pt>
                <c:pt idx="167">
                  <c:v>38.782092633208599</c:v>
                </c:pt>
                <c:pt idx="168">
                  <c:v>39.014320732808699</c:v>
                </c:pt>
                <c:pt idx="169">
                  <c:v>39.246548832408699</c:v>
                </c:pt>
                <c:pt idx="170">
                  <c:v>39.478776932008799</c:v>
                </c:pt>
                <c:pt idx="171">
                  <c:v>39.711005031608799</c:v>
                </c:pt>
                <c:pt idx="172">
                  <c:v>39.943233131208899</c:v>
                </c:pt>
                <c:pt idx="173">
                  <c:v>40.175461230808899</c:v>
                </c:pt>
                <c:pt idx="174">
                  <c:v>40.407689330408999</c:v>
                </c:pt>
                <c:pt idx="175">
                  <c:v>40.639917430009</c:v>
                </c:pt>
                <c:pt idx="176">
                  <c:v>40.872145529609099</c:v>
                </c:pt>
                <c:pt idx="177">
                  <c:v>41.1043736292091</c:v>
                </c:pt>
                <c:pt idx="178">
                  <c:v>41.3366017288092</c:v>
                </c:pt>
                <c:pt idx="179">
                  <c:v>41.5688298284092</c:v>
                </c:pt>
                <c:pt idx="180">
                  <c:v>41.8010579280093</c:v>
                </c:pt>
                <c:pt idx="181">
                  <c:v>42.0332860276093</c:v>
                </c:pt>
                <c:pt idx="182">
                  <c:v>42.2655141272094</c:v>
                </c:pt>
                <c:pt idx="183">
                  <c:v>42.4977422268094</c:v>
                </c:pt>
                <c:pt idx="184">
                  <c:v>42.7299703264095</c:v>
                </c:pt>
                <c:pt idx="185">
                  <c:v>42.9621984260096</c:v>
                </c:pt>
                <c:pt idx="186">
                  <c:v>43.1944265256096</c:v>
                </c:pt>
                <c:pt idx="187">
                  <c:v>43.4266546252097</c:v>
                </c:pt>
                <c:pt idx="188">
                  <c:v>43.6588827248097</c:v>
                </c:pt>
                <c:pt idx="189">
                  <c:v>43.8911108244098</c:v>
                </c:pt>
                <c:pt idx="190">
                  <c:v>44.123338924009801</c:v>
                </c:pt>
                <c:pt idx="191">
                  <c:v>44.3555670236099</c:v>
                </c:pt>
                <c:pt idx="192">
                  <c:v>44.587795123209901</c:v>
                </c:pt>
                <c:pt idx="193">
                  <c:v>44.820023222810001</c:v>
                </c:pt>
                <c:pt idx="194">
                  <c:v>45.052251322410001</c:v>
                </c:pt>
                <c:pt idx="195">
                  <c:v>45.284479422010101</c:v>
                </c:pt>
                <c:pt idx="196">
                  <c:v>45.516707521610101</c:v>
                </c:pt>
                <c:pt idx="197">
                  <c:v>45.748935621210201</c:v>
                </c:pt>
                <c:pt idx="198">
                  <c:v>45.981163720810201</c:v>
                </c:pt>
                <c:pt idx="199">
                  <c:v>46.213391820410301</c:v>
                </c:pt>
                <c:pt idx="200">
                  <c:v>46.445619920010301</c:v>
                </c:pt>
                <c:pt idx="201">
                  <c:v>46.677848019610401</c:v>
                </c:pt>
                <c:pt idx="202">
                  <c:v>46.910076119210402</c:v>
                </c:pt>
                <c:pt idx="203">
                  <c:v>47.142304218810501</c:v>
                </c:pt>
                <c:pt idx="204">
                  <c:v>47.374532318410502</c:v>
                </c:pt>
                <c:pt idx="205">
                  <c:v>47.606760418010602</c:v>
                </c:pt>
                <c:pt idx="206">
                  <c:v>47.838988517610602</c:v>
                </c:pt>
                <c:pt idx="207">
                  <c:v>48.071216617210702</c:v>
                </c:pt>
                <c:pt idx="208">
                  <c:v>48.303444716810702</c:v>
                </c:pt>
                <c:pt idx="209">
                  <c:v>48.535672816410802</c:v>
                </c:pt>
                <c:pt idx="210">
                  <c:v>48.767900916010802</c:v>
                </c:pt>
                <c:pt idx="211">
                  <c:v>49.000129015610902</c:v>
                </c:pt>
                <c:pt idx="212">
                  <c:v>49.232357115210903</c:v>
                </c:pt>
                <c:pt idx="213">
                  <c:v>49.464585214811002</c:v>
                </c:pt>
                <c:pt idx="214">
                  <c:v>49.696813314411003</c:v>
                </c:pt>
                <c:pt idx="215">
                  <c:v>49.929041414011103</c:v>
                </c:pt>
                <c:pt idx="216">
                  <c:v>50.161269513611103</c:v>
                </c:pt>
                <c:pt idx="217">
                  <c:v>50.393497613211203</c:v>
                </c:pt>
                <c:pt idx="218">
                  <c:v>50.625725712811303</c:v>
                </c:pt>
                <c:pt idx="219">
                  <c:v>50.857953812411303</c:v>
                </c:pt>
                <c:pt idx="220">
                  <c:v>51.090181912011403</c:v>
                </c:pt>
                <c:pt idx="221">
                  <c:v>51.322410011611403</c:v>
                </c:pt>
                <c:pt idx="222">
                  <c:v>51.554638111211503</c:v>
                </c:pt>
                <c:pt idx="223">
                  <c:v>51.786866210811503</c:v>
                </c:pt>
                <c:pt idx="224">
                  <c:v>52.019094310411603</c:v>
                </c:pt>
                <c:pt idx="225">
                  <c:v>52.251322410011603</c:v>
                </c:pt>
                <c:pt idx="226">
                  <c:v>52.483550509611703</c:v>
                </c:pt>
                <c:pt idx="227">
                  <c:v>52.715778609211696</c:v>
                </c:pt>
                <c:pt idx="228">
                  <c:v>52.948006708811803</c:v>
                </c:pt>
                <c:pt idx="229">
                  <c:v>53.180234808411797</c:v>
                </c:pt>
                <c:pt idx="230">
                  <c:v>53.412462908011904</c:v>
                </c:pt>
                <c:pt idx="231">
                  <c:v>53.644691007611897</c:v>
                </c:pt>
                <c:pt idx="232">
                  <c:v>53.876919107211997</c:v>
                </c:pt>
                <c:pt idx="233">
                  <c:v>54.109147206811997</c:v>
                </c:pt>
                <c:pt idx="234">
                  <c:v>54.341375306412097</c:v>
                </c:pt>
                <c:pt idx="235">
                  <c:v>54.573603406012097</c:v>
                </c:pt>
                <c:pt idx="236">
                  <c:v>54.805831505612197</c:v>
                </c:pt>
                <c:pt idx="237">
                  <c:v>55.038059605212197</c:v>
                </c:pt>
                <c:pt idx="238">
                  <c:v>55.270287704812297</c:v>
                </c:pt>
                <c:pt idx="239">
                  <c:v>55.502515804412297</c:v>
                </c:pt>
                <c:pt idx="240">
                  <c:v>55.734743904012397</c:v>
                </c:pt>
                <c:pt idx="241">
                  <c:v>55.966972003612398</c:v>
                </c:pt>
                <c:pt idx="242">
                  <c:v>56.199200103212497</c:v>
                </c:pt>
                <c:pt idx="243">
                  <c:v>56.431428202812498</c:v>
                </c:pt>
                <c:pt idx="244">
                  <c:v>56.663656302412598</c:v>
                </c:pt>
                <c:pt idx="245">
                  <c:v>56.895884402012598</c:v>
                </c:pt>
                <c:pt idx="246">
                  <c:v>57.128112501612698</c:v>
                </c:pt>
                <c:pt idx="247">
                  <c:v>57.360340601212698</c:v>
                </c:pt>
                <c:pt idx="248">
                  <c:v>57.592568700812798</c:v>
                </c:pt>
                <c:pt idx="249">
                  <c:v>57.824796800412798</c:v>
                </c:pt>
                <c:pt idx="250">
                  <c:v>58.057024900012898</c:v>
                </c:pt>
                <c:pt idx="251">
                  <c:v>58.289252999612998</c:v>
                </c:pt>
                <c:pt idx="252">
                  <c:v>58.521481099212998</c:v>
                </c:pt>
                <c:pt idx="253">
                  <c:v>58.753709198813098</c:v>
                </c:pt>
                <c:pt idx="254">
                  <c:v>58.985937298413099</c:v>
                </c:pt>
                <c:pt idx="255">
                  <c:v>59.218165398013198</c:v>
                </c:pt>
                <c:pt idx="256">
                  <c:v>59.450393497613199</c:v>
                </c:pt>
                <c:pt idx="257">
                  <c:v>59.682621597213299</c:v>
                </c:pt>
                <c:pt idx="258">
                  <c:v>59.914849696813299</c:v>
                </c:pt>
                <c:pt idx="259">
                  <c:v>60.147077796413399</c:v>
                </c:pt>
                <c:pt idx="260">
                  <c:v>60.379305896013399</c:v>
                </c:pt>
                <c:pt idx="261">
                  <c:v>60.611533995613499</c:v>
                </c:pt>
                <c:pt idx="262">
                  <c:v>60.843762095213499</c:v>
                </c:pt>
                <c:pt idx="263">
                  <c:v>61.075990194813599</c:v>
                </c:pt>
                <c:pt idx="264">
                  <c:v>61.308218294413599</c:v>
                </c:pt>
                <c:pt idx="265">
                  <c:v>61.540446394013699</c:v>
                </c:pt>
                <c:pt idx="266">
                  <c:v>61.7726744936137</c:v>
                </c:pt>
                <c:pt idx="267">
                  <c:v>62.004902593213799</c:v>
                </c:pt>
                <c:pt idx="268">
                  <c:v>62.2371306928138</c:v>
                </c:pt>
                <c:pt idx="269">
                  <c:v>62.4693587924139</c:v>
                </c:pt>
                <c:pt idx="270">
                  <c:v>62.7015868920139</c:v>
                </c:pt>
                <c:pt idx="271">
                  <c:v>62.933814991614</c:v>
                </c:pt>
                <c:pt idx="272">
                  <c:v>63.166043091214</c:v>
                </c:pt>
                <c:pt idx="273">
                  <c:v>63.3982711908141</c:v>
                </c:pt>
                <c:pt idx="274">
                  <c:v>63.6304992904141</c:v>
                </c:pt>
                <c:pt idx="275">
                  <c:v>63.8627273900142</c:v>
                </c:pt>
                <c:pt idx="276">
                  <c:v>64.094955489614307</c:v>
                </c:pt>
                <c:pt idx="277">
                  <c:v>64.3271835892143</c:v>
                </c:pt>
                <c:pt idx="278">
                  <c:v>64.559411688814393</c:v>
                </c:pt>
                <c:pt idx="279">
                  <c:v>64.7916397884144</c:v>
                </c:pt>
                <c:pt idx="280">
                  <c:v>65.023867888014493</c:v>
                </c:pt>
                <c:pt idx="281">
                  <c:v>65.256095987614501</c:v>
                </c:pt>
                <c:pt idx="282">
                  <c:v>65.488324087214593</c:v>
                </c:pt>
                <c:pt idx="283">
                  <c:v>65.720552186814601</c:v>
                </c:pt>
                <c:pt idx="284">
                  <c:v>65.952780286414693</c:v>
                </c:pt>
                <c:pt idx="285">
                  <c:v>66.185008386014701</c:v>
                </c:pt>
                <c:pt idx="286">
                  <c:v>66.417236485614794</c:v>
                </c:pt>
                <c:pt idx="287">
                  <c:v>66.649464585214801</c:v>
                </c:pt>
                <c:pt idx="288">
                  <c:v>66.881692684814894</c:v>
                </c:pt>
                <c:pt idx="289">
                  <c:v>67.113920784414901</c:v>
                </c:pt>
                <c:pt idx="290">
                  <c:v>67.346148884014994</c:v>
                </c:pt>
                <c:pt idx="291">
                  <c:v>67.578376983615001</c:v>
                </c:pt>
                <c:pt idx="292">
                  <c:v>67.810605083215094</c:v>
                </c:pt>
                <c:pt idx="293">
                  <c:v>68.042833182815102</c:v>
                </c:pt>
                <c:pt idx="294">
                  <c:v>68.275061282415194</c:v>
                </c:pt>
                <c:pt idx="295">
                  <c:v>68.507289382015202</c:v>
                </c:pt>
                <c:pt idx="296">
                  <c:v>68.739517481615295</c:v>
                </c:pt>
                <c:pt idx="297">
                  <c:v>68.971745581215302</c:v>
                </c:pt>
                <c:pt idx="298">
                  <c:v>69.203973680815395</c:v>
                </c:pt>
                <c:pt idx="299">
                  <c:v>69.436201780415402</c:v>
                </c:pt>
                <c:pt idx="300">
                  <c:v>69.668429880015495</c:v>
                </c:pt>
                <c:pt idx="301">
                  <c:v>69.900657979615502</c:v>
                </c:pt>
                <c:pt idx="302">
                  <c:v>70.132886079215595</c:v>
                </c:pt>
                <c:pt idx="303">
                  <c:v>70.365114178815602</c:v>
                </c:pt>
                <c:pt idx="304">
                  <c:v>70.597342278415695</c:v>
                </c:pt>
                <c:pt idx="305">
                  <c:v>70.829570378015703</c:v>
                </c:pt>
                <c:pt idx="306">
                  <c:v>71.061798477615795</c:v>
                </c:pt>
                <c:pt idx="307">
                  <c:v>71.294026577215803</c:v>
                </c:pt>
                <c:pt idx="308">
                  <c:v>71.526254676815896</c:v>
                </c:pt>
                <c:pt idx="309">
                  <c:v>71.758482776415903</c:v>
                </c:pt>
                <c:pt idx="310">
                  <c:v>71.990710876015996</c:v>
                </c:pt>
                <c:pt idx="311">
                  <c:v>72.222938975616003</c:v>
                </c:pt>
                <c:pt idx="312">
                  <c:v>72.455167075216096</c:v>
                </c:pt>
                <c:pt idx="313">
                  <c:v>72.687395174816203</c:v>
                </c:pt>
                <c:pt idx="314">
                  <c:v>72.919623274416196</c:v>
                </c:pt>
                <c:pt idx="315">
                  <c:v>73.151851374016303</c:v>
                </c:pt>
                <c:pt idx="316">
                  <c:v>73.384079473616296</c:v>
                </c:pt>
                <c:pt idx="317">
                  <c:v>73.616307573216403</c:v>
                </c:pt>
                <c:pt idx="318">
                  <c:v>73.848535672816396</c:v>
                </c:pt>
                <c:pt idx="319">
                  <c:v>74.080763772416503</c:v>
                </c:pt>
                <c:pt idx="320">
                  <c:v>74.312991872016497</c:v>
                </c:pt>
                <c:pt idx="321">
                  <c:v>74.545219971616604</c:v>
                </c:pt>
                <c:pt idx="322">
                  <c:v>74.777448071216597</c:v>
                </c:pt>
                <c:pt idx="323">
                  <c:v>75.009676170816704</c:v>
                </c:pt>
                <c:pt idx="324">
                  <c:v>75.241904270416697</c:v>
                </c:pt>
                <c:pt idx="325">
                  <c:v>75.474132370016804</c:v>
                </c:pt>
                <c:pt idx="326">
                  <c:v>75.706360469616797</c:v>
                </c:pt>
                <c:pt idx="327">
                  <c:v>75.938588569216904</c:v>
                </c:pt>
                <c:pt idx="328">
                  <c:v>76.170816668816897</c:v>
                </c:pt>
                <c:pt idx="329">
                  <c:v>76.403044768417004</c:v>
                </c:pt>
                <c:pt idx="330">
                  <c:v>76.635272868016997</c:v>
                </c:pt>
                <c:pt idx="331">
                  <c:v>76.867500967617104</c:v>
                </c:pt>
                <c:pt idx="332">
                  <c:v>77.099729067217098</c:v>
                </c:pt>
                <c:pt idx="333">
                  <c:v>77.331957166817205</c:v>
                </c:pt>
                <c:pt idx="334">
                  <c:v>77.564185266417198</c:v>
                </c:pt>
                <c:pt idx="335">
                  <c:v>77.796413366017305</c:v>
                </c:pt>
                <c:pt idx="336">
                  <c:v>78.028641465617298</c:v>
                </c:pt>
                <c:pt idx="337">
                  <c:v>78.260869565217405</c:v>
                </c:pt>
                <c:pt idx="338">
                  <c:v>78.493097664817398</c:v>
                </c:pt>
                <c:pt idx="339">
                  <c:v>78.725325764417505</c:v>
                </c:pt>
                <c:pt idx="340">
                  <c:v>78.957553864017598</c:v>
                </c:pt>
                <c:pt idx="341">
                  <c:v>79.189781963617605</c:v>
                </c:pt>
                <c:pt idx="342">
                  <c:v>79.422010063217698</c:v>
                </c:pt>
                <c:pt idx="343">
                  <c:v>79.654238162817705</c:v>
                </c:pt>
                <c:pt idx="344">
                  <c:v>79.886466262417798</c:v>
                </c:pt>
                <c:pt idx="345">
                  <c:v>80.118694362017806</c:v>
                </c:pt>
                <c:pt idx="346">
                  <c:v>80.350922461617898</c:v>
                </c:pt>
                <c:pt idx="347">
                  <c:v>80.583150561217906</c:v>
                </c:pt>
                <c:pt idx="348">
                  <c:v>80.815378660817998</c:v>
                </c:pt>
                <c:pt idx="349">
                  <c:v>81.047606760418006</c:v>
                </c:pt>
                <c:pt idx="350">
                  <c:v>81.279834860018099</c:v>
                </c:pt>
                <c:pt idx="351">
                  <c:v>81.512062959618106</c:v>
                </c:pt>
                <c:pt idx="352">
                  <c:v>81.744291059218199</c:v>
                </c:pt>
                <c:pt idx="353">
                  <c:v>81.976519158818206</c:v>
                </c:pt>
                <c:pt idx="354">
                  <c:v>82.208747258418299</c:v>
                </c:pt>
                <c:pt idx="355">
                  <c:v>82.440975358018306</c:v>
                </c:pt>
                <c:pt idx="356">
                  <c:v>82.673203457618399</c:v>
                </c:pt>
                <c:pt idx="357">
                  <c:v>82.905431557218407</c:v>
                </c:pt>
                <c:pt idx="358">
                  <c:v>83.137659656818499</c:v>
                </c:pt>
                <c:pt idx="359">
                  <c:v>83.369887756418507</c:v>
                </c:pt>
                <c:pt idx="360">
                  <c:v>83.6021158560186</c:v>
                </c:pt>
                <c:pt idx="361">
                  <c:v>83.834343955618607</c:v>
                </c:pt>
                <c:pt idx="362">
                  <c:v>84.0665720552187</c:v>
                </c:pt>
                <c:pt idx="363">
                  <c:v>84.298800154818693</c:v>
                </c:pt>
                <c:pt idx="364">
                  <c:v>84.5310282544188</c:v>
                </c:pt>
                <c:pt idx="365">
                  <c:v>84.763256354018793</c:v>
                </c:pt>
                <c:pt idx="366">
                  <c:v>84.9954844536189</c:v>
                </c:pt>
                <c:pt idx="367">
                  <c:v>85.227712553218893</c:v>
                </c:pt>
                <c:pt idx="368">
                  <c:v>85.459940652819</c:v>
                </c:pt>
                <c:pt idx="369">
                  <c:v>85.692168752419093</c:v>
                </c:pt>
                <c:pt idx="370">
                  <c:v>85.9243968520191</c:v>
                </c:pt>
                <c:pt idx="371">
                  <c:v>86.156624951619193</c:v>
                </c:pt>
                <c:pt idx="372">
                  <c:v>86.388853051219201</c:v>
                </c:pt>
                <c:pt idx="373">
                  <c:v>86.621081150819293</c:v>
                </c:pt>
                <c:pt idx="374">
                  <c:v>86.853309250419301</c:v>
                </c:pt>
                <c:pt idx="375">
                  <c:v>87.085537350019393</c:v>
                </c:pt>
                <c:pt idx="376">
                  <c:v>87.317765449619401</c:v>
                </c:pt>
                <c:pt idx="377">
                  <c:v>87.549993549219494</c:v>
                </c:pt>
                <c:pt idx="378">
                  <c:v>87.782221648819501</c:v>
                </c:pt>
                <c:pt idx="379">
                  <c:v>88.014449748419594</c:v>
                </c:pt>
                <c:pt idx="380">
                  <c:v>88.246677848019601</c:v>
                </c:pt>
                <c:pt idx="381">
                  <c:v>88.478905947619694</c:v>
                </c:pt>
                <c:pt idx="382">
                  <c:v>88.711134047219701</c:v>
                </c:pt>
                <c:pt idx="383">
                  <c:v>88.943362146819794</c:v>
                </c:pt>
                <c:pt idx="384">
                  <c:v>89.175590246419802</c:v>
                </c:pt>
                <c:pt idx="385">
                  <c:v>89.407818346019894</c:v>
                </c:pt>
                <c:pt idx="386">
                  <c:v>89.640046445619902</c:v>
                </c:pt>
                <c:pt idx="387">
                  <c:v>89.872274545219994</c:v>
                </c:pt>
                <c:pt idx="388">
                  <c:v>90.104502644820002</c:v>
                </c:pt>
                <c:pt idx="389">
                  <c:v>90.336730744420095</c:v>
                </c:pt>
                <c:pt idx="390">
                  <c:v>90.568958844020102</c:v>
                </c:pt>
                <c:pt idx="391">
                  <c:v>90.801186943620195</c:v>
                </c:pt>
                <c:pt idx="392">
                  <c:v>91.033415043220202</c:v>
                </c:pt>
                <c:pt idx="393">
                  <c:v>91.265643142820295</c:v>
                </c:pt>
                <c:pt idx="394">
                  <c:v>91.497871242420302</c:v>
                </c:pt>
                <c:pt idx="395">
                  <c:v>91.730099342020395</c:v>
                </c:pt>
                <c:pt idx="396">
                  <c:v>91.962327441620403</c:v>
                </c:pt>
                <c:pt idx="397">
                  <c:v>92.194555541220495</c:v>
                </c:pt>
                <c:pt idx="398">
                  <c:v>92.426783640820503</c:v>
                </c:pt>
                <c:pt idx="399">
                  <c:v>92.659011740420596</c:v>
                </c:pt>
                <c:pt idx="400">
                  <c:v>92.891239840020603</c:v>
                </c:pt>
                <c:pt idx="401">
                  <c:v>93.123467939620696</c:v>
                </c:pt>
                <c:pt idx="402">
                  <c:v>93.355696039220703</c:v>
                </c:pt>
                <c:pt idx="403">
                  <c:v>93.587924138820796</c:v>
                </c:pt>
                <c:pt idx="404">
                  <c:v>93.820152238420803</c:v>
                </c:pt>
                <c:pt idx="405">
                  <c:v>94.052380338020896</c:v>
                </c:pt>
                <c:pt idx="406">
                  <c:v>94.284608437621003</c:v>
                </c:pt>
                <c:pt idx="407">
                  <c:v>94.516836537220996</c:v>
                </c:pt>
                <c:pt idx="408">
                  <c:v>94.749064636821103</c:v>
                </c:pt>
                <c:pt idx="409">
                  <c:v>94.981292736421096</c:v>
                </c:pt>
                <c:pt idx="410">
                  <c:v>95.213520836021203</c:v>
                </c:pt>
                <c:pt idx="411">
                  <c:v>95.445748935621197</c:v>
                </c:pt>
                <c:pt idx="412">
                  <c:v>95.677977035221303</c:v>
                </c:pt>
                <c:pt idx="413">
                  <c:v>95.910205134821297</c:v>
                </c:pt>
                <c:pt idx="414">
                  <c:v>96.142433234421404</c:v>
                </c:pt>
                <c:pt idx="415">
                  <c:v>96.374661334021397</c:v>
                </c:pt>
                <c:pt idx="416">
                  <c:v>96.606889433621504</c:v>
                </c:pt>
                <c:pt idx="417">
                  <c:v>96.839117533221497</c:v>
                </c:pt>
                <c:pt idx="418">
                  <c:v>97.071345632821604</c:v>
                </c:pt>
                <c:pt idx="419">
                  <c:v>97.303573732421597</c:v>
                </c:pt>
                <c:pt idx="420">
                  <c:v>97.535801832021704</c:v>
                </c:pt>
                <c:pt idx="421">
                  <c:v>97.768029931621697</c:v>
                </c:pt>
                <c:pt idx="422">
                  <c:v>98.000258031221804</c:v>
                </c:pt>
                <c:pt idx="423">
                  <c:v>98.232486130821798</c:v>
                </c:pt>
                <c:pt idx="424">
                  <c:v>98.464714230421905</c:v>
                </c:pt>
                <c:pt idx="425">
                  <c:v>98.696942330021898</c:v>
                </c:pt>
                <c:pt idx="426">
                  <c:v>98.929170429622005</c:v>
                </c:pt>
                <c:pt idx="427">
                  <c:v>99.161398529221998</c:v>
                </c:pt>
                <c:pt idx="428">
                  <c:v>99.393626628822105</c:v>
                </c:pt>
                <c:pt idx="429">
                  <c:v>99.625854728422098</c:v>
                </c:pt>
                <c:pt idx="430">
                  <c:v>99.858082828022205</c:v>
                </c:pt>
                <c:pt idx="431">
                  <c:v>100.090310927622</c:v>
                </c:pt>
                <c:pt idx="432">
                  <c:v>100.32253902722201</c:v>
                </c:pt>
                <c:pt idx="433">
                  <c:v>100.554767126822</c:v>
                </c:pt>
                <c:pt idx="434">
                  <c:v>100.78699522642199</c:v>
                </c:pt>
                <c:pt idx="435">
                  <c:v>101.019223326022</c:v>
                </c:pt>
                <c:pt idx="436">
                  <c:v>101.251451425623</c:v>
                </c:pt>
                <c:pt idx="437">
                  <c:v>101.483679525223</c:v>
                </c:pt>
                <c:pt idx="438">
                  <c:v>101.715907624823</c:v>
                </c:pt>
                <c:pt idx="439">
                  <c:v>101.948135724423</c:v>
                </c:pt>
                <c:pt idx="440">
                  <c:v>102.180363824023</c:v>
                </c:pt>
                <c:pt idx="441">
                  <c:v>102.412591923623</c:v>
                </c:pt>
                <c:pt idx="442">
                  <c:v>102.64482002322301</c:v>
                </c:pt>
                <c:pt idx="443">
                  <c:v>102.877048122823</c:v>
                </c:pt>
                <c:pt idx="444">
                  <c:v>103.10927622242301</c:v>
                </c:pt>
                <c:pt idx="445">
                  <c:v>103.341504322023</c:v>
                </c:pt>
                <c:pt idx="446">
                  <c:v>103.57373242162301</c:v>
                </c:pt>
                <c:pt idx="447">
                  <c:v>103.805960521223</c:v>
                </c:pt>
                <c:pt idx="448">
                  <c:v>104.03818862082299</c:v>
                </c:pt>
                <c:pt idx="449">
                  <c:v>104.270416720423</c:v>
                </c:pt>
                <c:pt idx="450">
                  <c:v>104.50264482002299</c:v>
                </c:pt>
                <c:pt idx="451">
                  <c:v>104.734872919623</c:v>
                </c:pt>
                <c:pt idx="452">
                  <c:v>104.96710101922299</c:v>
                </c:pt>
                <c:pt idx="453">
                  <c:v>105.199329118823</c:v>
                </c:pt>
                <c:pt idx="454">
                  <c:v>105.43155721842299</c:v>
                </c:pt>
                <c:pt idx="455">
                  <c:v>105.663785318023</c:v>
                </c:pt>
                <c:pt idx="456">
                  <c:v>105.896013417624</c:v>
                </c:pt>
                <c:pt idx="457">
                  <c:v>106.128241517224</c:v>
                </c:pt>
                <c:pt idx="458">
                  <c:v>106.36046961682401</c:v>
                </c:pt>
                <c:pt idx="459">
                  <c:v>106.592697716424</c:v>
                </c:pt>
                <c:pt idx="460">
                  <c:v>106.82492581602401</c:v>
                </c:pt>
                <c:pt idx="461">
                  <c:v>107.057153915624</c:v>
                </c:pt>
                <c:pt idx="462">
                  <c:v>107.28938201522401</c:v>
                </c:pt>
                <c:pt idx="463">
                  <c:v>107.521610114824</c:v>
                </c:pt>
                <c:pt idx="464">
                  <c:v>107.75383821442399</c:v>
                </c:pt>
                <c:pt idx="465">
                  <c:v>107.986066314024</c:v>
                </c:pt>
                <c:pt idx="466">
                  <c:v>108.21829441362399</c:v>
                </c:pt>
                <c:pt idx="467">
                  <c:v>108.450522513224</c:v>
                </c:pt>
                <c:pt idx="468">
                  <c:v>108.68275061282399</c:v>
                </c:pt>
                <c:pt idx="469">
                  <c:v>108.914978712424</c:v>
                </c:pt>
                <c:pt idx="470">
                  <c:v>109.147206812024</c:v>
                </c:pt>
                <c:pt idx="471">
                  <c:v>109.379434911624</c:v>
                </c:pt>
                <c:pt idx="472">
                  <c:v>109.611663011224</c:v>
                </c:pt>
                <c:pt idx="473">
                  <c:v>109.843891110824</c:v>
                </c:pt>
                <c:pt idx="474">
                  <c:v>110.076119210424</c:v>
                </c:pt>
                <c:pt idx="475">
                  <c:v>110.308347310025</c:v>
                </c:pt>
                <c:pt idx="476">
                  <c:v>110.54057540962501</c:v>
                </c:pt>
                <c:pt idx="477">
                  <c:v>110.772803509225</c:v>
                </c:pt>
                <c:pt idx="478">
                  <c:v>111.00503160882501</c:v>
                </c:pt>
                <c:pt idx="479">
                  <c:v>111.237259708425</c:v>
                </c:pt>
                <c:pt idx="480">
                  <c:v>111.46948780802499</c:v>
                </c:pt>
                <c:pt idx="481">
                  <c:v>111.701715907625</c:v>
                </c:pt>
                <c:pt idx="482">
                  <c:v>111.93394400722499</c:v>
                </c:pt>
                <c:pt idx="483">
                  <c:v>112.166172106825</c:v>
                </c:pt>
                <c:pt idx="484">
                  <c:v>112.39840020642499</c:v>
                </c:pt>
                <c:pt idx="485">
                  <c:v>112.630628306025</c:v>
                </c:pt>
                <c:pt idx="486">
                  <c:v>112.862856405625</c:v>
                </c:pt>
                <c:pt idx="487">
                  <c:v>113.095084505225</c:v>
                </c:pt>
                <c:pt idx="488">
                  <c:v>113.327312604825</c:v>
                </c:pt>
                <c:pt idx="489">
                  <c:v>113.559540704425</c:v>
                </c:pt>
                <c:pt idx="490">
                  <c:v>113.791768804025</c:v>
                </c:pt>
                <c:pt idx="491">
                  <c:v>114.023996903625</c:v>
                </c:pt>
                <c:pt idx="492">
                  <c:v>114.256225003225</c:v>
                </c:pt>
                <c:pt idx="493">
                  <c:v>114.48845310282501</c:v>
                </c:pt>
                <c:pt idx="494">
                  <c:v>114.720681202425</c:v>
                </c:pt>
                <c:pt idx="495">
                  <c:v>114.952909302026</c:v>
                </c:pt>
                <c:pt idx="496">
                  <c:v>115.18513740162599</c:v>
                </c:pt>
                <c:pt idx="497">
                  <c:v>115.417365501226</c:v>
                </c:pt>
                <c:pt idx="498">
                  <c:v>115.64959360082599</c:v>
                </c:pt>
                <c:pt idx="499">
                  <c:v>115.881821700426</c:v>
                </c:pt>
                <c:pt idx="500">
                  <c:v>116.114049800026</c:v>
                </c:pt>
                <c:pt idx="501">
                  <c:v>116.346277899626</c:v>
                </c:pt>
                <c:pt idx="502">
                  <c:v>116.578505999226</c:v>
                </c:pt>
                <c:pt idx="503">
                  <c:v>116.810734098826</c:v>
                </c:pt>
                <c:pt idx="504">
                  <c:v>117.042962198426</c:v>
                </c:pt>
                <c:pt idx="505">
                  <c:v>117.275190298026</c:v>
                </c:pt>
                <c:pt idx="506">
                  <c:v>117.507418397626</c:v>
                </c:pt>
                <c:pt idx="507">
                  <c:v>117.739646497226</c:v>
                </c:pt>
                <c:pt idx="508">
                  <c:v>117.971874596826</c:v>
                </c:pt>
                <c:pt idx="509">
                  <c:v>118.20410269642601</c:v>
                </c:pt>
                <c:pt idx="510">
                  <c:v>118.436330796026</c:v>
                </c:pt>
                <c:pt idx="511">
                  <c:v>118.66855889562601</c:v>
                </c:pt>
                <c:pt idx="512">
                  <c:v>118.900786995226</c:v>
                </c:pt>
                <c:pt idx="513">
                  <c:v>119.13301509482601</c:v>
                </c:pt>
                <c:pt idx="514">
                  <c:v>119.36524319442699</c:v>
                </c:pt>
                <c:pt idx="515">
                  <c:v>119.597471294027</c:v>
                </c:pt>
                <c:pt idx="516">
                  <c:v>119.829699393627</c:v>
                </c:pt>
                <c:pt idx="517">
                  <c:v>120.061927493227</c:v>
                </c:pt>
                <c:pt idx="518">
                  <c:v>120.294155592827</c:v>
                </c:pt>
                <c:pt idx="519">
                  <c:v>120.526383692427</c:v>
                </c:pt>
                <c:pt idx="520">
                  <c:v>120.758611792027</c:v>
                </c:pt>
                <c:pt idx="521">
                  <c:v>120.990839891627</c:v>
                </c:pt>
                <c:pt idx="522">
                  <c:v>121.223067991227</c:v>
                </c:pt>
                <c:pt idx="523">
                  <c:v>121.45529609082701</c:v>
                </c:pt>
                <c:pt idx="524">
                  <c:v>121.687524190427</c:v>
                </c:pt>
                <c:pt idx="525">
                  <c:v>121.91975229002701</c:v>
                </c:pt>
                <c:pt idx="526">
                  <c:v>122.151980389627</c:v>
                </c:pt>
                <c:pt idx="527">
                  <c:v>122.38420848922701</c:v>
                </c:pt>
                <c:pt idx="528">
                  <c:v>122.616436588827</c:v>
                </c:pt>
                <c:pt idx="529">
                  <c:v>122.84866468842699</c:v>
                </c:pt>
                <c:pt idx="530">
                  <c:v>123.080892788027</c:v>
                </c:pt>
                <c:pt idx="531">
                  <c:v>123.31312088762699</c:v>
                </c:pt>
                <c:pt idx="532">
                  <c:v>123.545348987227</c:v>
                </c:pt>
                <c:pt idx="533">
                  <c:v>123.777577086828</c:v>
                </c:pt>
                <c:pt idx="534">
                  <c:v>124.009805186428</c:v>
                </c:pt>
                <c:pt idx="535">
                  <c:v>124.242033286028</c:v>
                </c:pt>
                <c:pt idx="536">
                  <c:v>124.474261385628</c:v>
                </c:pt>
                <c:pt idx="537">
                  <c:v>124.706489485228</c:v>
                </c:pt>
                <c:pt idx="538">
                  <c:v>124.938717584828</c:v>
                </c:pt>
                <c:pt idx="539">
                  <c:v>125.17094568442801</c:v>
                </c:pt>
                <c:pt idx="540">
                  <c:v>125.403173784028</c:v>
                </c:pt>
                <c:pt idx="541">
                  <c:v>125.63540188362801</c:v>
                </c:pt>
                <c:pt idx="542">
                  <c:v>125.867629983228</c:v>
                </c:pt>
                <c:pt idx="543">
                  <c:v>126.09985808282801</c:v>
                </c:pt>
                <c:pt idx="544">
                  <c:v>126.332086182428</c:v>
                </c:pt>
                <c:pt idx="545">
                  <c:v>126.56431428202799</c:v>
                </c:pt>
                <c:pt idx="546">
                  <c:v>126.796542381628</c:v>
                </c:pt>
                <c:pt idx="547">
                  <c:v>127.02877048122799</c:v>
                </c:pt>
                <c:pt idx="548">
                  <c:v>127.260998580828</c:v>
                </c:pt>
                <c:pt idx="549">
                  <c:v>127.49322668042799</c:v>
                </c:pt>
                <c:pt idx="550">
                  <c:v>127.725454780028</c:v>
                </c:pt>
                <c:pt idx="551">
                  <c:v>127.957682879628</c:v>
                </c:pt>
                <c:pt idx="552">
                  <c:v>128.18991097922901</c:v>
                </c:pt>
                <c:pt idx="553">
                  <c:v>128.42213907882899</c:v>
                </c:pt>
                <c:pt idx="554">
                  <c:v>128.654367178429</c:v>
                </c:pt>
                <c:pt idx="555">
                  <c:v>128.88659527802901</c:v>
                </c:pt>
                <c:pt idx="556">
                  <c:v>129.11882337762901</c:v>
                </c:pt>
                <c:pt idx="557">
                  <c:v>129.35105147722899</c:v>
                </c:pt>
                <c:pt idx="558">
                  <c:v>129.583279576829</c:v>
                </c:pt>
                <c:pt idx="559">
                  <c:v>129.81550767642901</c:v>
                </c:pt>
                <c:pt idx="560">
                  <c:v>130.04773577602899</c:v>
                </c:pt>
                <c:pt idx="561">
                  <c:v>130.27996387562899</c:v>
                </c:pt>
                <c:pt idx="562">
                  <c:v>130.512191975229</c:v>
                </c:pt>
                <c:pt idx="563">
                  <c:v>130.74442007482901</c:v>
                </c:pt>
                <c:pt idx="564">
                  <c:v>130.97664817442899</c:v>
                </c:pt>
                <c:pt idx="565">
                  <c:v>131.208876274029</c:v>
                </c:pt>
                <c:pt idx="566">
                  <c:v>131.441104373629</c:v>
                </c:pt>
                <c:pt idx="567">
                  <c:v>131.67333247322901</c:v>
                </c:pt>
                <c:pt idx="568">
                  <c:v>131.90556057282899</c:v>
                </c:pt>
                <c:pt idx="569">
                  <c:v>132.137788672429</c:v>
                </c:pt>
                <c:pt idx="570">
                  <c:v>132.370016772029</c:v>
                </c:pt>
                <c:pt idx="571">
                  <c:v>132.60224487162901</c:v>
                </c:pt>
                <c:pt idx="572">
                  <c:v>132.83447297123001</c:v>
                </c:pt>
                <c:pt idx="573">
                  <c:v>133.06670107082999</c:v>
                </c:pt>
                <c:pt idx="574">
                  <c:v>133.29892917043</c:v>
                </c:pt>
                <c:pt idx="575">
                  <c:v>133.53115727003001</c:v>
                </c:pt>
                <c:pt idx="576">
                  <c:v>133.76338536962999</c:v>
                </c:pt>
                <c:pt idx="577">
                  <c:v>133.99561346922999</c:v>
                </c:pt>
                <c:pt idx="578">
                  <c:v>134.22784156883</c:v>
                </c:pt>
                <c:pt idx="579">
                  <c:v>134.46006966843001</c:v>
                </c:pt>
                <c:pt idx="580">
                  <c:v>134.69229776802999</c:v>
                </c:pt>
                <c:pt idx="581">
                  <c:v>134.92452586763</c:v>
                </c:pt>
                <c:pt idx="582">
                  <c:v>135.15675396723</c:v>
                </c:pt>
                <c:pt idx="583">
                  <c:v>135.38898206683001</c:v>
                </c:pt>
                <c:pt idx="584">
                  <c:v>135.62121016642999</c:v>
                </c:pt>
                <c:pt idx="585">
                  <c:v>135.85343826603</c:v>
                </c:pt>
                <c:pt idx="586">
                  <c:v>136.08566636563</c:v>
                </c:pt>
                <c:pt idx="587">
                  <c:v>136.31789446523001</c:v>
                </c:pt>
                <c:pt idx="588">
                  <c:v>136.55012256482999</c:v>
                </c:pt>
                <c:pt idx="589">
                  <c:v>136.78235066443</c:v>
                </c:pt>
                <c:pt idx="590">
                  <c:v>137.01457876403001</c:v>
                </c:pt>
                <c:pt idx="591">
                  <c:v>137.24680686363001</c:v>
                </c:pt>
                <c:pt idx="592">
                  <c:v>137.47903496323099</c:v>
                </c:pt>
                <c:pt idx="593">
                  <c:v>137.71126306283099</c:v>
                </c:pt>
                <c:pt idx="594">
                  <c:v>137.943491162431</c:v>
                </c:pt>
                <c:pt idx="595">
                  <c:v>138.17571926203101</c:v>
                </c:pt>
                <c:pt idx="596">
                  <c:v>138.40794736163099</c:v>
                </c:pt>
                <c:pt idx="597">
                  <c:v>138.640175461231</c:v>
                </c:pt>
                <c:pt idx="598">
                  <c:v>138.872403560831</c:v>
                </c:pt>
                <c:pt idx="599">
                  <c:v>139.10463166043101</c:v>
                </c:pt>
                <c:pt idx="600">
                  <c:v>139.33685976003099</c:v>
                </c:pt>
                <c:pt idx="601">
                  <c:v>139.569087859631</c:v>
                </c:pt>
                <c:pt idx="602">
                  <c:v>139.801315959231</c:v>
                </c:pt>
                <c:pt idx="603">
                  <c:v>140.03354405883101</c:v>
                </c:pt>
                <c:pt idx="604">
                  <c:v>140.26577215843099</c:v>
                </c:pt>
                <c:pt idx="605">
                  <c:v>140.498000258031</c:v>
                </c:pt>
                <c:pt idx="606">
                  <c:v>140.73022835763101</c:v>
                </c:pt>
                <c:pt idx="607">
                  <c:v>140.96245645723101</c:v>
                </c:pt>
                <c:pt idx="608">
                  <c:v>141.19468455683099</c:v>
                </c:pt>
                <c:pt idx="609">
                  <c:v>141.426912656431</c:v>
                </c:pt>
                <c:pt idx="610">
                  <c:v>141.65914075603101</c:v>
                </c:pt>
                <c:pt idx="611">
                  <c:v>141.89136885563201</c:v>
                </c:pt>
                <c:pt idx="612">
                  <c:v>142.12359695523199</c:v>
                </c:pt>
                <c:pt idx="613">
                  <c:v>142.355825054832</c:v>
                </c:pt>
                <c:pt idx="614">
                  <c:v>142.588053154432</c:v>
                </c:pt>
                <c:pt idx="615">
                  <c:v>142.82028125403201</c:v>
                </c:pt>
                <c:pt idx="616">
                  <c:v>143.05250935363199</c:v>
                </c:pt>
                <c:pt idx="617">
                  <c:v>143.284737453232</c:v>
                </c:pt>
                <c:pt idx="618">
                  <c:v>143.516965552832</c:v>
                </c:pt>
                <c:pt idx="619">
                  <c:v>143.74919365243201</c:v>
                </c:pt>
                <c:pt idx="620">
                  <c:v>143.98142175203199</c:v>
                </c:pt>
                <c:pt idx="621">
                  <c:v>144.213649851632</c:v>
                </c:pt>
                <c:pt idx="622">
                  <c:v>144.44587795123201</c:v>
                </c:pt>
                <c:pt idx="623">
                  <c:v>144.67810605083201</c:v>
                </c:pt>
                <c:pt idx="624">
                  <c:v>144.91033415043199</c:v>
                </c:pt>
                <c:pt idx="625">
                  <c:v>145.142562250032</c:v>
                </c:pt>
                <c:pt idx="626">
                  <c:v>145.37479034963201</c:v>
                </c:pt>
                <c:pt idx="627">
                  <c:v>145.60701844923199</c:v>
                </c:pt>
                <c:pt idx="628">
                  <c:v>145.83924654883199</c:v>
                </c:pt>
                <c:pt idx="629">
                  <c:v>146.071474648432</c:v>
                </c:pt>
                <c:pt idx="630">
                  <c:v>146.303702748033</c:v>
                </c:pt>
                <c:pt idx="631">
                  <c:v>146.53593084763301</c:v>
                </c:pt>
                <c:pt idx="632">
                  <c:v>146.76815894723299</c:v>
                </c:pt>
                <c:pt idx="633">
                  <c:v>147.000387046833</c:v>
                </c:pt>
                <c:pt idx="634">
                  <c:v>147.23261514643301</c:v>
                </c:pt>
                <c:pt idx="635">
                  <c:v>147.46484324603301</c:v>
                </c:pt>
                <c:pt idx="636">
                  <c:v>147.69707134563299</c:v>
                </c:pt>
                <c:pt idx="637">
                  <c:v>147.929299445233</c:v>
                </c:pt>
                <c:pt idx="638">
                  <c:v>148.16152754483301</c:v>
                </c:pt>
                <c:pt idx="639">
                  <c:v>148.39375564443301</c:v>
                </c:pt>
                <c:pt idx="640">
                  <c:v>148.62598374403299</c:v>
                </c:pt>
                <c:pt idx="641">
                  <c:v>148.858211843633</c:v>
                </c:pt>
                <c:pt idx="642">
                  <c:v>149.09043994323301</c:v>
                </c:pt>
                <c:pt idx="643">
                  <c:v>149.32266804283299</c:v>
                </c:pt>
                <c:pt idx="644">
                  <c:v>149.55489614243299</c:v>
                </c:pt>
                <c:pt idx="645">
                  <c:v>149.787124242033</c:v>
                </c:pt>
                <c:pt idx="646">
                  <c:v>150.01935234163301</c:v>
                </c:pt>
                <c:pt idx="647">
                  <c:v>150.25158044123299</c:v>
                </c:pt>
                <c:pt idx="648">
                  <c:v>150.483808540833</c:v>
                </c:pt>
                <c:pt idx="649">
                  <c:v>150.716036640433</c:v>
                </c:pt>
                <c:pt idx="650">
                  <c:v>150.94826474003401</c:v>
                </c:pt>
                <c:pt idx="651">
                  <c:v>151.18049283963401</c:v>
                </c:pt>
                <c:pt idx="652">
                  <c:v>151.41272093923399</c:v>
                </c:pt>
                <c:pt idx="653">
                  <c:v>151.644949038834</c:v>
                </c:pt>
                <c:pt idx="654">
                  <c:v>151.87717713843401</c:v>
                </c:pt>
                <c:pt idx="655">
                  <c:v>152.10940523803399</c:v>
                </c:pt>
                <c:pt idx="656">
                  <c:v>152.34163333763399</c:v>
                </c:pt>
                <c:pt idx="657">
                  <c:v>152.573861437234</c:v>
                </c:pt>
                <c:pt idx="658">
                  <c:v>152.80608953683401</c:v>
                </c:pt>
                <c:pt idx="659">
                  <c:v>153.03831763643399</c:v>
                </c:pt>
                <c:pt idx="660">
                  <c:v>153.27054573603399</c:v>
                </c:pt>
                <c:pt idx="661">
                  <c:v>153.502773835634</c:v>
                </c:pt>
                <c:pt idx="662">
                  <c:v>153.73500193523401</c:v>
                </c:pt>
                <c:pt idx="663">
                  <c:v>153.96723003483399</c:v>
                </c:pt>
                <c:pt idx="664">
                  <c:v>154.199458134434</c:v>
                </c:pt>
                <c:pt idx="665">
                  <c:v>154.431686234034</c:v>
                </c:pt>
                <c:pt idx="666">
                  <c:v>154.66391433363401</c:v>
                </c:pt>
                <c:pt idx="667">
                  <c:v>154.89614243323399</c:v>
                </c:pt>
                <c:pt idx="668">
                  <c:v>155.128370532834</c:v>
                </c:pt>
                <c:pt idx="669">
                  <c:v>155.360598632435</c:v>
                </c:pt>
                <c:pt idx="670">
                  <c:v>155.59282673203501</c:v>
                </c:pt>
                <c:pt idx="671">
                  <c:v>155.82505483163499</c:v>
                </c:pt>
                <c:pt idx="672">
                  <c:v>156.05728293123499</c:v>
                </c:pt>
                <c:pt idx="673">
                  <c:v>156.289511030835</c:v>
                </c:pt>
                <c:pt idx="674">
                  <c:v>156.52173913043501</c:v>
                </c:pt>
                <c:pt idx="675">
                  <c:v>156.75396723003499</c:v>
                </c:pt>
                <c:pt idx="676">
                  <c:v>156.986195329635</c:v>
                </c:pt>
                <c:pt idx="677">
                  <c:v>157.218423429235</c:v>
                </c:pt>
                <c:pt idx="678">
                  <c:v>157.45065152883501</c:v>
                </c:pt>
                <c:pt idx="679">
                  <c:v>157.68287962843499</c:v>
                </c:pt>
                <c:pt idx="680">
                  <c:v>157.915107728035</c:v>
                </c:pt>
                <c:pt idx="681">
                  <c:v>158.147335827635</c:v>
                </c:pt>
                <c:pt idx="682">
                  <c:v>158.37956392723501</c:v>
                </c:pt>
                <c:pt idx="683">
                  <c:v>158.61179202683499</c:v>
                </c:pt>
                <c:pt idx="684">
                  <c:v>158.844020126435</c:v>
                </c:pt>
                <c:pt idx="685">
                  <c:v>159.07624822603501</c:v>
                </c:pt>
                <c:pt idx="686">
                  <c:v>159.30847632563501</c:v>
                </c:pt>
                <c:pt idx="687">
                  <c:v>159.54070442523499</c:v>
                </c:pt>
                <c:pt idx="688">
                  <c:v>159.77293252483599</c:v>
                </c:pt>
                <c:pt idx="689">
                  <c:v>160.005160624436</c:v>
                </c:pt>
                <c:pt idx="690">
                  <c:v>160.23738872403601</c:v>
                </c:pt>
                <c:pt idx="691">
                  <c:v>160.46961682363599</c:v>
                </c:pt>
                <c:pt idx="692">
                  <c:v>160.701844923236</c:v>
                </c:pt>
                <c:pt idx="693">
                  <c:v>160.934073022836</c:v>
                </c:pt>
                <c:pt idx="694">
                  <c:v>161.16630112243601</c:v>
                </c:pt>
                <c:pt idx="695">
                  <c:v>161.39852922203599</c:v>
                </c:pt>
                <c:pt idx="696">
                  <c:v>161.630757321636</c:v>
                </c:pt>
                <c:pt idx="697">
                  <c:v>161.862985421236</c:v>
                </c:pt>
                <c:pt idx="698">
                  <c:v>162.09521352083601</c:v>
                </c:pt>
                <c:pt idx="699">
                  <c:v>162.32744162043599</c:v>
                </c:pt>
                <c:pt idx="700">
                  <c:v>162.559669720036</c:v>
                </c:pt>
                <c:pt idx="701">
                  <c:v>162.79189781963601</c:v>
                </c:pt>
                <c:pt idx="702">
                  <c:v>163.02412591923601</c:v>
                </c:pt>
                <c:pt idx="703">
                  <c:v>163.25635401883599</c:v>
                </c:pt>
                <c:pt idx="704">
                  <c:v>163.488582118436</c:v>
                </c:pt>
                <c:pt idx="705">
                  <c:v>163.72081021803601</c:v>
                </c:pt>
                <c:pt idx="706">
                  <c:v>163.95303831763599</c:v>
                </c:pt>
                <c:pt idx="707">
                  <c:v>164.18526641723599</c:v>
                </c:pt>
                <c:pt idx="708">
                  <c:v>164.417494516837</c:v>
                </c:pt>
                <c:pt idx="709">
                  <c:v>164.649722616437</c:v>
                </c:pt>
                <c:pt idx="710">
                  <c:v>164.88195071603701</c:v>
                </c:pt>
                <c:pt idx="711">
                  <c:v>165.11417881563699</c:v>
                </c:pt>
                <c:pt idx="712">
                  <c:v>165.346406915237</c:v>
                </c:pt>
                <c:pt idx="713">
                  <c:v>165.578635014837</c:v>
                </c:pt>
                <c:pt idx="714">
                  <c:v>165.81086311443701</c:v>
                </c:pt>
                <c:pt idx="715">
                  <c:v>166.04309121403699</c:v>
                </c:pt>
                <c:pt idx="716">
                  <c:v>166.275319313637</c:v>
                </c:pt>
                <c:pt idx="717">
                  <c:v>166.50754741323701</c:v>
                </c:pt>
                <c:pt idx="718">
                  <c:v>166.73977551283701</c:v>
                </c:pt>
                <c:pt idx="719">
                  <c:v>166.97200361243699</c:v>
                </c:pt>
                <c:pt idx="720">
                  <c:v>167.204231712037</c:v>
                </c:pt>
                <c:pt idx="721">
                  <c:v>167.43645981163701</c:v>
                </c:pt>
                <c:pt idx="722">
                  <c:v>167.66868791123699</c:v>
                </c:pt>
                <c:pt idx="723">
                  <c:v>167.90091601083699</c:v>
                </c:pt>
                <c:pt idx="724">
                  <c:v>168.133144110437</c:v>
                </c:pt>
                <c:pt idx="725">
                  <c:v>168.36537221003701</c:v>
                </c:pt>
                <c:pt idx="726">
                  <c:v>168.59760030963699</c:v>
                </c:pt>
                <c:pt idx="727">
                  <c:v>168.82982840923799</c:v>
                </c:pt>
                <c:pt idx="728">
                  <c:v>169.062056508838</c:v>
                </c:pt>
                <c:pt idx="729">
                  <c:v>169.29428460843801</c:v>
                </c:pt>
                <c:pt idx="730">
                  <c:v>169.52651270803801</c:v>
                </c:pt>
                <c:pt idx="731">
                  <c:v>169.75874080763799</c:v>
                </c:pt>
                <c:pt idx="732">
                  <c:v>169.990968907238</c:v>
                </c:pt>
                <c:pt idx="733">
                  <c:v>170.22319700683801</c:v>
                </c:pt>
                <c:pt idx="734">
                  <c:v>170.45542510643801</c:v>
                </c:pt>
                <c:pt idx="735">
                  <c:v>170.68765320603799</c:v>
                </c:pt>
                <c:pt idx="736">
                  <c:v>170.919881305638</c:v>
                </c:pt>
                <c:pt idx="737">
                  <c:v>171.15210940523801</c:v>
                </c:pt>
                <c:pt idx="738">
                  <c:v>171.38433750483799</c:v>
                </c:pt>
                <c:pt idx="739">
                  <c:v>171.61656560443799</c:v>
                </c:pt>
                <c:pt idx="740">
                  <c:v>171.848793704038</c:v>
                </c:pt>
                <c:pt idx="741">
                  <c:v>172.08102180363801</c:v>
                </c:pt>
                <c:pt idx="742">
                  <c:v>172.31324990323799</c:v>
                </c:pt>
                <c:pt idx="743">
                  <c:v>172.545478002838</c:v>
                </c:pt>
                <c:pt idx="744">
                  <c:v>172.777706102438</c:v>
                </c:pt>
                <c:pt idx="745">
                  <c:v>173.00993420203801</c:v>
                </c:pt>
                <c:pt idx="746">
                  <c:v>173.24216230163901</c:v>
                </c:pt>
                <c:pt idx="747">
                  <c:v>173.47439040123899</c:v>
                </c:pt>
                <c:pt idx="748">
                  <c:v>173.706618500839</c:v>
                </c:pt>
                <c:pt idx="749">
                  <c:v>173.93884660043901</c:v>
                </c:pt>
                <c:pt idx="750">
                  <c:v>174.17107470003899</c:v>
                </c:pt>
                <c:pt idx="751">
                  <c:v>174.40330279963899</c:v>
                </c:pt>
                <c:pt idx="752">
                  <c:v>174.635530899239</c:v>
                </c:pt>
                <c:pt idx="753">
                  <c:v>174.86775899883901</c:v>
                </c:pt>
                <c:pt idx="754">
                  <c:v>175.09998709843899</c:v>
                </c:pt>
                <c:pt idx="755">
                  <c:v>175.33221519803899</c:v>
                </c:pt>
                <c:pt idx="756">
                  <c:v>175.564443297639</c:v>
                </c:pt>
                <c:pt idx="757">
                  <c:v>175.79667139723901</c:v>
                </c:pt>
                <c:pt idx="758">
                  <c:v>176.02889949683899</c:v>
                </c:pt>
                <c:pt idx="759">
                  <c:v>176.261127596439</c:v>
                </c:pt>
                <c:pt idx="760">
                  <c:v>176.493355696039</c:v>
                </c:pt>
                <c:pt idx="761">
                  <c:v>176.72558379563901</c:v>
                </c:pt>
                <c:pt idx="762">
                  <c:v>176.95781189523899</c:v>
                </c:pt>
                <c:pt idx="763">
                  <c:v>177.190039994839</c:v>
                </c:pt>
                <c:pt idx="764">
                  <c:v>177.422268094439</c:v>
                </c:pt>
                <c:pt idx="765">
                  <c:v>177.65449619403901</c:v>
                </c:pt>
                <c:pt idx="766">
                  <c:v>177.88672429363999</c:v>
                </c:pt>
                <c:pt idx="767">
                  <c:v>178.11895239323999</c:v>
                </c:pt>
                <c:pt idx="768">
                  <c:v>178.35118049284</c:v>
                </c:pt>
                <c:pt idx="769">
                  <c:v>178.58340859244001</c:v>
                </c:pt>
                <c:pt idx="770">
                  <c:v>178.81563669203999</c:v>
                </c:pt>
                <c:pt idx="771">
                  <c:v>179.04786479164</c:v>
                </c:pt>
                <c:pt idx="772">
                  <c:v>179.28009289124</c:v>
                </c:pt>
                <c:pt idx="773">
                  <c:v>179.51232099084001</c:v>
                </c:pt>
                <c:pt idx="774">
                  <c:v>179.74454909043999</c:v>
                </c:pt>
                <c:pt idx="775">
                  <c:v>179.97677719004</c:v>
                </c:pt>
                <c:pt idx="776">
                  <c:v>180.20900528964</c:v>
                </c:pt>
                <c:pt idx="777">
                  <c:v>180.44123338924001</c:v>
                </c:pt>
                <c:pt idx="778">
                  <c:v>180.67346148883999</c:v>
                </c:pt>
                <c:pt idx="779">
                  <c:v>180.90568958844</c:v>
                </c:pt>
                <c:pt idx="780">
                  <c:v>181.13791768804001</c:v>
                </c:pt>
                <c:pt idx="781">
                  <c:v>181.37014578764001</c:v>
                </c:pt>
                <c:pt idx="782">
                  <c:v>181.60237388723999</c:v>
                </c:pt>
                <c:pt idx="783">
                  <c:v>181.83460198684</c:v>
                </c:pt>
                <c:pt idx="784">
                  <c:v>182.06683008644001</c:v>
                </c:pt>
                <c:pt idx="785">
                  <c:v>182.29905818604101</c:v>
                </c:pt>
                <c:pt idx="786">
                  <c:v>182.53128628564099</c:v>
                </c:pt>
                <c:pt idx="787">
                  <c:v>182.763514385241</c:v>
                </c:pt>
                <c:pt idx="788">
                  <c:v>182.995742484841</c:v>
                </c:pt>
                <c:pt idx="789">
                  <c:v>183.22797058444101</c:v>
                </c:pt>
                <c:pt idx="790">
                  <c:v>183.46019868404099</c:v>
                </c:pt>
                <c:pt idx="791">
                  <c:v>183.692426783641</c:v>
                </c:pt>
                <c:pt idx="792">
                  <c:v>183.924654883241</c:v>
                </c:pt>
                <c:pt idx="793">
                  <c:v>184.15688298284101</c:v>
                </c:pt>
                <c:pt idx="794">
                  <c:v>184.38911108244099</c:v>
                </c:pt>
                <c:pt idx="795">
                  <c:v>184.621339182041</c:v>
                </c:pt>
                <c:pt idx="796">
                  <c:v>184.85356728164101</c:v>
                </c:pt>
                <c:pt idx="797">
                  <c:v>185.08579538124101</c:v>
                </c:pt>
                <c:pt idx="798">
                  <c:v>185.31802348084099</c:v>
                </c:pt>
                <c:pt idx="799">
                  <c:v>185.550251580441</c:v>
                </c:pt>
                <c:pt idx="800">
                  <c:v>185.78247968004101</c:v>
                </c:pt>
                <c:pt idx="801">
                  <c:v>186.01470777964099</c:v>
                </c:pt>
                <c:pt idx="802">
                  <c:v>186.24693587924099</c:v>
                </c:pt>
                <c:pt idx="803">
                  <c:v>186.479163978841</c:v>
                </c:pt>
                <c:pt idx="804">
                  <c:v>186.71139207844101</c:v>
                </c:pt>
                <c:pt idx="805">
                  <c:v>186.94362017804201</c:v>
                </c:pt>
                <c:pt idx="806">
                  <c:v>187.17584827764199</c:v>
                </c:pt>
                <c:pt idx="807">
                  <c:v>187.408076377242</c:v>
                </c:pt>
                <c:pt idx="808">
                  <c:v>187.640304476842</c:v>
                </c:pt>
                <c:pt idx="809">
                  <c:v>187.87253257644201</c:v>
                </c:pt>
                <c:pt idx="810">
                  <c:v>188.10476067604199</c:v>
                </c:pt>
                <c:pt idx="811">
                  <c:v>188.336988775642</c:v>
                </c:pt>
                <c:pt idx="812">
                  <c:v>188.56921687524201</c:v>
                </c:pt>
                <c:pt idx="813">
                  <c:v>188.80144497484201</c:v>
                </c:pt>
                <c:pt idx="814">
                  <c:v>189.03367307444199</c:v>
                </c:pt>
                <c:pt idx="815">
                  <c:v>189.265901174042</c:v>
                </c:pt>
                <c:pt idx="816">
                  <c:v>189.49812927364201</c:v>
                </c:pt>
                <c:pt idx="817">
                  <c:v>189.73035737324199</c:v>
                </c:pt>
                <c:pt idx="818">
                  <c:v>189.96258547284199</c:v>
                </c:pt>
                <c:pt idx="819">
                  <c:v>190.194813572442</c:v>
                </c:pt>
                <c:pt idx="820">
                  <c:v>190.42704167204201</c:v>
                </c:pt>
                <c:pt idx="821">
                  <c:v>190.65926977164199</c:v>
                </c:pt>
                <c:pt idx="822">
                  <c:v>190.891497871242</c:v>
                </c:pt>
                <c:pt idx="823">
                  <c:v>191.123725970842</c:v>
                </c:pt>
                <c:pt idx="824">
                  <c:v>191.355954070443</c:v>
                </c:pt>
                <c:pt idx="825">
                  <c:v>191.58818217004301</c:v>
                </c:pt>
                <c:pt idx="826">
                  <c:v>191.82041026964299</c:v>
                </c:pt>
                <c:pt idx="827">
                  <c:v>192.052638369243</c:v>
                </c:pt>
                <c:pt idx="828">
                  <c:v>192.28486646884301</c:v>
                </c:pt>
                <c:pt idx="829">
                  <c:v>192.51709456844301</c:v>
                </c:pt>
                <c:pt idx="830">
                  <c:v>192.74932266804299</c:v>
                </c:pt>
                <c:pt idx="831">
                  <c:v>192.981550767643</c:v>
                </c:pt>
                <c:pt idx="832">
                  <c:v>193.21377886724301</c:v>
                </c:pt>
                <c:pt idx="833">
                  <c:v>193.44600696684299</c:v>
                </c:pt>
                <c:pt idx="834">
                  <c:v>193.67823506644299</c:v>
                </c:pt>
                <c:pt idx="835">
                  <c:v>193.910463166043</c:v>
                </c:pt>
                <c:pt idx="836">
                  <c:v>194.14269126564301</c:v>
                </c:pt>
                <c:pt idx="837">
                  <c:v>194.37491936524299</c:v>
                </c:pt>
                <c:pt idx="838">
                  <c:v>194.607147464843</c:v>
                </c:pt>
                <c:pt idx="839">
                  <c:v>194.839375564443</c:v>
                </c:pt>
                <c:pt idx="840">
                  <c:v>195.07160366404301</c:v>
                </c:pt>
                <c:pt idx="841">
                  <c:v>195.30383176364299</c:v>
                </c:pt>
                <c:pt idx="842">
                  <c:v>195.536059863243</c:v>
                </c:pt>
                <c:pt idx="843">
                  <c:v>195.768287962844</c:v>
                </c:pt>
                <c:pt idx="844">
                  <c:v>196.00051606244401</c:v>
                </c:pt>
                <c:pt idx="845">
                  <c:v>196.23274416204401</c:v>
                </c:pt>
                <c:pt idx="846">
                  <c:v>196.46497226164399</c:v>
                </c:pt>
                <c:pt idx="847">
                  <c:v>196.697200361244</c:v>
                </c:pt>
                <c:pt idx="848">
                  <c:v>196.92942846084401</c:v>
                </c:pt>
                <c:pt idx="849">
                  <c:v>197.16165656044399</c:v>
                </c:pt>
                <c:pt idx="850">
                  <c:v>197.39388466004399</c:v>
                </c:pt>
                <c:pt idx="851">
                  <c:v>197.626112759644</c:v>
                </c:pt>
                <c:pt idx="852">
                  <c:v>197.85834085924401</c:v>
                </c:pt>
                <c:pt idx="853">
                  <c:v>198.09056895884399</c:v>
                </c:pt>
                <c:pt idx="854">
                  <c:v>198.322797058444</c:v>
                </c:pt>
                <c:pt idx="855">
                  <c:v>198.555025158044</c:v>
                </c:pt>
                <c:pt idx="856">
                  <c:v>198.78725325764401</c:v>
                </c:pt>
                <c:pt idx="857">
                  <c:v>199.01948135724399</c:v>
                </c:pt>
                <c:pt idx="858">
                  <c:v>199.251709456844</c:v>
                </c:pt>
                <c:pt idx="859">
                  <c:v>199.483937556444</c:v>
                </c:pt>
                <c:pt idx="860">
                  <c:v>199.71616565604401</c:v>
                </c:pt>
                <c:pt idx="861">
                  <c:v>199.94839375564399</c:v>
                </c:pt>
                <c:pt idx="862">
                  <c:v>200.180621855244</c:v>
                </c:pt>
                <c:pt idx="863">
                  <c:v>200.412849954845</c:v>
                </c:pt>
                <c:pt idx="864">
                  <c:v>200.64507805444501</c:v>
                </c:pt>
                <c:pt idx="865">
                  <c:v>200.87730615404499</c:v>
                </c:pt>
                <c:pt idx="866">
                  <c:v>201.10953425364499</c:v>
                </c:pt>
                <c:pt idx="867">
                  <c:v>201.341762353245</c:v>
                </c:pt>
                <c:pt idx="868">
                  <c:v>201.57399045284501</c:v>
                </c:pt>
                <c:pt idx="869">
                  <c:v>201.80621855244499</c:v>
                </c:pt>
                <c:pt idx="870">
                  <c:v>202.038446652045</c:v>
                </c:pt>
                <c:pt idx="871">
                  <c:v>202.270674751645</c:v>
                </c:pt>
                <c:pt idx="872">
                  <c:v>202.50290285124501</c:v>
                </c:pt>
                <c:pt idx="873">
                  <c:v>202.73513095084499</c:v>
                </c:pt>
                <c:pt idx="874">
                  <c:v>202.967359050445</c:v>
                </c:pt>
                <c:pt idx="875">
                  <c:v>203.19958715004501</c:v>
                </c:pt>
                <c:pt idx="876">
                  <c:v>203.43181524964501</c:v>
                </c:pt>
                <c:pt idx="877">
                  <c:v>203.66404334924499</c:v>
                </c:pt>
                <c:pt idx="878">
                  <c:v>203.896271448845</c:v>
                </c:pt>
                <c:pt idx="879">
                  <c:v>204.12849954844501</c:v>
                </c:pt>
                <c:pt idx="880">
                  <c:v>204.36072764804501</c:v>
                </c:pt>
                <c:pt idx="881">
                  <c:v>204.59295574764499</c:v>
                </c:pt>
                <c:pt idx="882">
                  <c:v>204.825183847246</c:v>
                </c:pt>
                <c:pt idx="883">
                  <c:v>205.057411946846</c:v>
                </c:pt>
                <c:pt idx="884">
                  <c:v>205.28964004644601</c:v>
                </c:pt>
                <c:pt idx="885">
                  <c:v>205.52186814604599</c:v>
                </c:pt>
                <c:pt idx="886">
                  <c:v>205.754096245646</c:v>
                </c:pt>
                <c:pt idx="887">
                  <c:v>205.986324345246</c:v>
                </c:pt>
                <c:pt idx="888">
                  <c:v>206.21855244484601</c:v>
                </c:pt>
                <c:pt idx="889">
                  <c:v>206.45078054444599</c:v>
                </c:pt>
                <c:pt idx="890">
                  <c:v>206.683008644046</c:v>
                </c:pt>
                <c:pt idx="891">
                  <c:v>206.91523674364601</c:v>
                </c:pt>
                <c:pt idx="892">
                  <c:v>207.14746484324601</c:v>
                </c:pt>
                <c:pt idx="893">
                  <c:v>207.37969294284599</c:v>
                </c:pt>
                <c:pt idx="894">
                  <c:v>207.611921042446</c:v>
                </c:pt>
                <c:pt idx="895">
                  <c:v>207.84414914204601</c:v>
                </c:pt>
                <c:pt idx="896">
                  <c:v>208.07637724164599</c:v>
                </c:pt>
                <c:pt idx="897">
                  <c:v>208.30860534124599</c:v>
                </c:pt>
                <c:pt idx="898">
                  <c:v>208.540833440846</c:v>
                </c:pt>
                <c:pt idx="899">
                  <c:v>208.77306154044601</c:v>
                </c:pt>
                <c:pt idx="900">
                  <c:v>209.00528964004599</c:v>
                </c:pt>
                <c:pt idx="901">
                  <c:v>209.23751773964699</c:v>
                </c:pt>
                <c:pt idx="902">
                  <c:v>209.469745839247</c:v>
                </c:pt>
                <c:pt idx="903">
                  <c:v>209.701973938847</c:v>
                </c:pt>
                <c:pt idx="904">
                  <c:v>209.93420203844701</c:v>
                </c:pt>
                <c:pt idx="905">
                  <c:v>210.16643013804699</c:v>
                </c:pt>
                <c:pt idx="906">
                  <c:v>210.398658237647</c:v>
                </c:pt>
                <c:pt idx="907">
                  <c:v>210.63088633724701</c:v>
                </c:pt>
                <c:pt idx="908">
                  <c:v>210.86311443684701</c:v>
                </c:pt>
                <c:pt idx="909">
                  <c:v>211.09534253644699</c:v>
                </c:pt>
                <c:pt idx="910">
                  <c:v>211.327570636047</c:v>
                </c:pt>
                <c:pt idx="911">
                  <c:v>211.55979873564701</c:v>
                </c:pt>
                <c:pt idx="912">
                  <c:v>211.79202683524699</c:v>
                </c:pt>
                <c:pt idx="913">
                  <c:v>212.02425493484699</c:v>
                </c:pt>
                <c:pt idx="914">
                  <c:v>212.256483034447</c:v>
                </c:pt>
                <c:pt idx="915">
                  <c:v>212.48871113404701</c:v>
                </c:pt>
                <c:pt idx="916">
                  <c:v>212.72093923364699</c:v>
                </c:pt>
                <c:pt idx="917">
                  <c:v>212.95316733324699</c:v>
                </c:pt>
                <c:pt idx="918">
                  <c:v>213.185395432847</c:v>
                </c:pt>
                <c:pt idx="919">
                  <c:v>213.41762353244701</c:v>
                </c:pt>
                <c:pt idx="920">
                  <c:v>213.64985163204699</c:v>
                </c:pt>
                <c:pt idx="921">
                  <c:v>213.88207973164799</c:v>
                </c:pt>
                <c:pt idx="922">
                  <c:v>214.114307831248</c:v>
                </c:pt>
                <c:pt idx="923">
                  <c:v>214.34653593084801</c:v>
                </c:pt>
                <c:pt idx="924">
                  <c:v>214.57876403044801</c:v>
                </c:pt>
                <c:pt idx="925">
                  <c:v>214.81099213004799</c:v>
                </c:pt>
                <c:pt idx="926">
                  <c:v>215.043220229648</c:v>
                </c:pt>
                <c:pt idx="927">
                  <c:v>215.27544832924801</c:v>
                </c:pt>
                <c:pt idx="928">
                  <c:v>215.50767642884799</c:v>
                </c:pt>
                <c:pt idx="929">
                  <c:v>215.73990452844799</c:v>
                </c:pt>
                <c:pt idx="930">
                  <c:v>215.972132628048</c:v>
                </c:pt>
                <c:pt idx="931">
                  <c:v>216.20436072764801</c:v>
                </c:pt>
                <c:pt idx="932">
                  <c:v>216.43658882724799</c:v>
                </c:pt>
                <c:pt idx="933">
                  <c:v>216.668816926848</c:v>
                </c:pt>
                <c:pt idx="934">
                  <c:v>216.901045026448</c:v>
                </c:pt>
                <c:pt idx="935">
                  <c:v>217.13327312604801</c:v>
                </c:pt>
                <c:pt idx="936">
                  <c:v>217.36550122564799</c:v>
                </c:pt>
                <c:pt idx="937">
                  <c:v>217.597729325248</c:v>
                </c:pt>
                <c:pt idx="938">
                  <c:v>217.829957424848</c:v>
                </c:pt>
                <c:pt idx="939">
                  <c:v>218.06218552444801</c:v>
                </c:pt>
                <c:pt idx="940">
                  <c:v>218.29441362404901</c:v>
                </c:pt>
                <c:pt idx="941">
                  <c:v>218.52664172364899</c:v>
                </c:pt>
                <c:pt idx="942">
                  <c:v>218.758869823249</c:v>
                </c:pt>
                <c:pt idx="943">
                  <c:v>218.99109792284901</c:v>
                </c:pt>
                <c:pt idx="944">
                  <c:v>219.22332602244899</c:v>
                </c:pt>
                <c:pt idx="945">
                  <c:v>219.45555412204899</c:v>
                </c:pt>
                <c:pt idx="946">
                  <c:v>219.687782221649</c:v>
                </c:pt>
                <c:pt idx="947">
                  <c:v>219.92001032124901</c:v>
                </c:pt>
                <c:pt idx="948">
                  <c:v>220.15223842084899</c:v>
                </c:pt>
                <c:pt idx="949">
                  <c:v>220.384466520449</c:v>
                </c:pt>
                <c:pt idx="950">
                  <c:v>220.616694620049</c:v>
                </c:pt>
                <c:pt idx="951">
                  <c:v>220.84892271964901</c:v>
                </c:pt>
                <c:pt idx="952">
                  <c:v>221.08115081924899</c:v>
                </c:pt>
                <c:pt idx="953">
                  <c:v>221.313378918849</c:v>
                </c:pt>
                <c:pt idx="954">
                  <c:v>221.545607018449</c:v>
                </c:pt>
                <c:pt idx="955">
                  <c:v>221.77783511804901</c:v>
                </c:pt>
                <c:pt idx="956">
                  <c:v>222.01006321764899</c:v>
                </c:pt>
                <c:pt idx="957">
                  <c:v>222.242291317249</c:v>
                </c:pt>
                <c:pt idx="958">
                  <c:v>222.47451941684901</c:v>
                </c:pt>
                <c:pt idx="959">
                  <c:v>222.70674751644901</c:v>
                </c:pt>
                <c:pt idx="960">
                  <c:v>222.93897561604999</c:v>
                </c:pt>
                <c:pt idx="961">
                  <c:v>223.17120371564999</c:v>
                </c:pt>
                <c:pt idx="962">
                  <c:v>223.40343181525</c:v>
                </c:pt>
                <c:pt idx="963">
                  <c:v>223.63565991485001</c:v>
                </c:pt>
                <c:pt idx="964">
                  <c:v>223.86788801444999</c:v>
                </c:pt>
                <c:pt idx="965">
                  <c:v>224.10011611405</c:v>
                </c:pt>
                <c:pt idx="966">
                  <c:v>224.33234421365</c:v>
                </c:pt>
                <c:pt idx="967">
                  <c:v>224.56457231325001</c:v>
                </c:pt>
                <c:pt idx="968">
                  <c:v>224.79680041284999</c:v>
                </c:pt>
                <c:pt idx="969">
                  <c:v>225.02902851245</c:v>
                </c:pt>
                <c:pt idx="970">
                  <c:v>225.26125661205</c:v>
                </c:pt>
                <c:pt idx="971">
                  <c:v>225.49348471165001</c:v>
                </c:pt>
                <c:pt idx="972">
                  <c:v>225.72571281124999</c:v>
                </c:pt>
                <c:pt idx="973">
                  <c:v>225.95794091085</c:v>
                </c:pt>
                <c:pt idx="974">
                  <c:v>226.19016901045001</c:v>
                </c:pt>
                <c:pt idx="975">
                  <c:v>226.42239711005001</c:v>
                </c:pt>
                <c:pt idx="976">
                  <c:v>226.65462520964999</c:v>
                </c:pt>
                <c:pt idx="977">
                  <c:v>226.88685330925</c:v>
                </c:pt>
                <c:pt idx="978">
                  <c:v>227.11908140885001</c:v>
                </c:pt>
                <c:pt idx="979">
                  <c:v>227.35130950845101</c:v>
                </c:pt>
                <c:pt idx="980">
                  <c:v>227.58353760805099</c:v>
                </c:pt>
                <c:pt idx="981">
                  <c:v>227.815765707651</c:v>
                </c:pt>
                <c:pt idx="982">
                  <c:v>228.047993807251</c:v>
                </c:pt>
                <c:pt idx="983">
                  <c:v>228.28022190685101</c:v>
                </c:pt>
                <c:pt idx="984">
                  <c:v>228.51245000645099</c:v>
                </c:pt>
                <c:pt idx="985">
                  <c:v>228.744678106051</c:v>
                </c:pt>
                <c:pt idx="986">
                  <c:v>228.97690620565101</c:v>
                </c:pt>
                <c:pt idx="987">
                  <c:v>229.20913430525101</c:v>
                </c:pt>
                <c:pt idx="988">
                  <c:v>229.44136240485099</c:v>
                </c:pt>
                <c:pt idx="989">
                  <c:v>229.673590504451</c:v>
                </c:pt>
                <c:pt idx="990">
                  <c:v>229.90581860405101</c:v>
                </c:pt>
                <c:pt idx="991">
                  <c:v>230.13804670365101</c:v>
                </c:pt>
                <c:pt idx="992">
                  <c:v>230.37027480325099</c:v>
                </c:pt>
                <c:pt idx="993">
                  <c:v>230.602502902851</c:v>
                </c:pt>
                <c:pt idx="994">
                  <c:v>230.83473100245101</c:v>
                </c:pt>
                <c:pt idx="995">
                  <c:v>231.06695910205099</c:v>
                </c:pt>
                <c:pt idx="996">
                  <c:v>231.29918720165099</c:v>
                </c:pt>
                <c:pt idx="997">
                  <c:v>231.531415301251</c:v>
                </c:pt>
                <c:pt idx="998">
                  <c:v>231.763643400852</c:v>
                </c:pt>
                <c:pt idx="999">
                  <c:v>231.99587150045201</c:v>
                </c:pt>
                <c:pt idx="1000">
                  <c:v>232.22809960005199</c:v>
                </c:pt>
                <c:pt idx="1001">
                  <c:v>232.460327699652</c:v>
                </c:pt>
                <c:pt idx="1002">
                  <c:v>232.69255579925201</c:v>
                </c:pt>
                <c:pt idx="1003">
                  <c:v>232.92478389885201</c:v>
                </c:pt>
                <c:pt idx="1004">
                  <c:v>233.15701199845199</c:v>
                </c:pt>
                <c:pt idx="1005">
                  <c:v>233.389240098052</c:v>
                </c:pt>
                <c:pt idx="1006">
                  <c:v>233.62146819765201</c:v>
                </c:pt>
                <c:pt idx="1007">
                  <c:v>233.85369629725199</c:v>
                </c:pt>
                <c:pt idx="1008">
                  <c:v>234.08592439685199</c:v>
                </c:pt>
                <c:pt idx="1009">
                  <c:v>234.318152496452</c:v>
                </c:pt>
                <c:pt idx="1010">
                  <c:v>234.55038059605201</c:v>
                </c:pt>
                <c:pt idx="1011">
                  <c:v>234.78260869565199</c:v>
                </c:pt>
                <c:pt idx="1012">
                  <c:v>235.01483679525199</c:v>
                </c:pt>
                <c:pt idx="1013">
                  <c:v>235.247064894852</c:v>
                </c:pt>
                <c:pt idx="1014">
                  <c:v>235.47929299445201</c:v>
                </c:pt>
                <c:pt idx="1015">
                  <c:v>235.71152109405199</c:v>
                </c:pt>
                <c:pt idx="1016">
                  <c:v>235.943749193652</c:v>
                </c:pt>
                <c:pt idx="1017">
                  <c:v>236.175977293252</c:v>
                </c:pt>
                <c:pt idx="1018">
                  <c:v>236.40820539285301</c:v>
                </c:pt>
                <c:pt idx="1019">
                  <c:v>236.64043349245301</c:v>
                </c:pt>
                <c:pt idx="1020">
                  <c:v>236.87266159205299</c:v>
                </c:pt>
                <c:pt idx="1021">
                  <c:v>237.104889691653</c:v>
                </c:pt>
                <c:pt idx="1022">
                  <c:v>237.33711779125301</c:v>
                </c:pt>
                <c:pt idx="1023">
                  <c:v>237.56934589085299</c:v>
                </c:pt>
                <c:pt idx="1024">
                  <c:v>237.80157399045299</c:v>
                </c:pt>
                <c:pt idx="1025">
                  <c:v>238.033802090053</c:v>
                </c:pt>
                <c:pt idx="1026">
                  <c:v>238.26603018965301</c:v>
                </c:pt>
                <c:pt idx="1027">
                  <c:v>238.49825828925299</c:v>
                </c:pt>
                <c:pt idx="1028">
                  <c:v>238.730486388853</c:v>
                </c:pt>
                <c:pt idx="1029">
                  <c:v>238.962714488453</c:v>
                </c:pt>
                <c:pt idx="1030">
                  <c:v>239.19494258805301</c:v>
                </c:pt>
                <c:pt idx="1031">
                  <c:v>239.42717068765299</c:v>
                </c:pt>
                <c:pt idx="1032">
                  <c:v>239.659398787253</c:v>
                </c:pt>
                <c:pt idx="1033">
                  <c:v>239.891626886853</c:v>
                </c:pt>
                <c:pt idx="1034">
                  <c:v>240.12385498645301</c:v>
                </c:pt>
                <c:pt idx="1035">
                  <c:v>240.35608308605299</c:v>
                </c:pt>
                <c:pt idx="1036">
                  <c:v>240.588311185653</c:v>
                </c:pt>
                <c:pt idx="1037">
                  <c:v>240.820539285254</c:v>
                </c:pt>
                <c:pt idx="1038">
                  <c:v>241.05276738485401</c:v>
                </c:pt>
                <c:pt idx="1039">
                  <c:v>241.28499548445399</c:v>
                </c:pt>
                <c:pt idx="1040">
                  <c:v>241.51722358405399</c:v>
                </c:pt>
                <c:pt idx="1041">
                  <c:v>241.749451683654</c:v>
                </c:pt>
                <c:pt idx="1042">
                  <c:v>241.98167978325401</c:v>
                </c:pt>
                <c:pt idx="1043">
                  <c:v>242.21390788285399</c:v>
                </c:pt>
                <c:pt idx="1044">
                  <c:v>242.446135982454</c:v>
                </c:pt>
                <c:pt idx="1045">
                  <c:v>242.678364082054</c:v>
                </c:pt>
                <c:pt idx="1046">
                  <c:v>242.91059218165401</c:v>
                </c:pt>
                <c:pt idx="1047">
                  <c:v>243.14282028125399</c:v>
                </c:pt>
                <c:pt idx="1048">
                  <c:v>243.375048380854</c:v>
                </c:pt>
                <c:pt idx="1049">
                  <c:v>243.607276480454</c:v>
                </c:pt>
                <c:pt idx="1050">
                  <c:v>243.83950458005401</c:v>
                </c:pt>
                <c:pt idx="1051">
                  <c:v>244.07173267965399</c:v>
                </c:pt>
                <c:pt idx="1052">
                  <c:v>244.303960779254</c:v>
                </c:pt>
                <c:pt idx="1053">
                  <c:v>244.53618887885401</c:v>
                </c:pt>
                <c:pt idx="1054">
                  <c:v>244.76841697845401</c:v>
                </c:pt>
                <c:pt idx="1055">
                  <c:v>245.00064507805399</c:v>
                </c:pt>
                <c:pt idx="1056">
                  <c:v>245.23287317765499</c:v>
                </c:pt>
                <c:pt idx="1057">
                  <c:v>245.465101277255</c:v>
                </c:pt>
                <c:pt idx="1058">
                  <c:v>245.69732937685501</c:v>
                </c:pt>
                <c:pt idx="1059">
                  <c:v>245.92955747645499</c:v>
                </c:pt>
                <c:pt idx="1060">
                  <c:v>246.161785576055</c:v>
                </c:pt>
                <c:pt idx="1061">
                  <c:v>246.394013675655</c:v>
                </c:pt>
                <c:pt idx="1062">
                  <c:v>246.62624177525501</c:v>
                </c:pt>
                <c:pt idx="1063">
                  <c:v>246.85846987485499</c:v>
                </c:pt>
                <c:pt idx="1064">
                  <c:v>247.090697974455</c:v>
                </c:pt>
                <c:pt idx="1065">
                  <c:v>247.322926074055</c:v>
                </c:pt>
                <c:pt idx="1066">
                  <c:v>247.55515417365501</c:v>
                </c:pt>
                <c:pt idx="1067">
                  <c:v>247.78738227325499</c:v>
                </c:pt>
                <c:pt idx="1068">
                  <c:v>248.019610372855</c:v>
                </c:pt>
                <c:pt idx="1069">
                  <c:v>248.25183847245501</c:v>
                </c:pt>
                <c:pt idx="1070">
                  <c:v>248.48406657205501</c:v>
                </c:pt>
                <c:pt idx="1071">
                  <c:v>248.71629467165499</c:v>
                </c:pt>
                <c:pt idx="1072">
                  <c:v>248.948522771255</c:v>
                </c:pt>
                <c:pt idx="1073">
                  <c:v>249.18075087085501</c:v>
                </c:pt>
                <c:pt idx="1074">
                  <c:v>249.41297897045499</c:v>
                </c:pt>
                <c:pt idx="1075">
                  <c:v>249.64520707005499</c:v>
                </c:pt>
                <c:pt idx="1076">
                  <c:v>249.877435169656</c:v>
                </c:pt>
                <c:pt idx="1077">
                  <c:v>250.109663269256</c:v>
                </c:pt>
                <c:pt idx="1078">
                  <c:v>250.34189136885601</c:v>
                </c:pt>
                <c:pt idx="1079">
                  <c:v>250.57411946845599</c:v>
                </c:pt>
                <c:pt idx="1080">
                  <c:v>250.806347568056</c:v>
                </c:pt>
                <c:pt idx="1081">
                  <c:v>251.038575667656</c:v>
                </c:pt>
                <c:pt idx="1082">
                  <c:v>251.27080376725601</c:v>
                </c:pt>
                <c:pt idx="1083">
                  <c:v>251.50303186685599</c:v>
                </c:pt>
                <c:pt idx="1084">
                  <c:v>251.735259966456</c:v>
                </c:pt>
                <c:pt idx="1085">
                  <c:v>251.96748806605601</c:v>
                </c:pt>
                <c:pt idx="1086">
                  <c:v>252.19971616565601</c:v>
                </c:pt>
                <c:pt idx="1087">
                  <c:v>252.43194426525599</c:v>
                </c:pt>
                <c:pt idx="1088">
                  <c:v>252.664172364856</c:v>
                </c:pt>
                <c:pt idx="1089">
                  <c:v>252.89640046445601</c:v>
                </c:pt>
                <c:pt idx="1090">
                  <c:v>253.12862856405599</c:v>
                </c:pt>
                <c:pt idx="1091">
                  <c:v>253.36085666365599</c:v>
                </c:pt>
                <c:pt idx="1092">
                  <c:v>253.593084763256</c:v>
                </c:pt>
                <c:pt idx="1093">
                  <c:v>253.82531286285601</c:v>
                </c:pt>
                <c:pt idx="1094">
                  <c:v>254.05754096245599</c:v>
                </c:pt>
                <c:pt idx="1095">
                  <c:v>254.28976906205699</c:v>
                </c:pt>
                <c:pt idx="1096">
                  <c:v>254.521997161657</c:v>
                </c:pt>
                <c:pt idx="1097">
                  <c:v>254.75422526125701</c:v>
                </c:pt>
                <c:pt idx="1098">
                  <c:v>254.98645336085701</c:v>
                </c:pt>
                <c:pt idx="1099">
                  <c:v>255.21868146045699</c:v>
                </c:pt>
                <c:pt idx="1100">
                  <c:v>255.450909560057</c:v>
                </c:pt>
                <c:pt idx="1101">
                  <c:v>255.68313765965701</c:v>
                </c:pt>
                <c:pt idx="1102">
                  <c:v>255.91536575925701</c:v>
                </c:pt>
                <c:pt idx="1103">
                  <c:v>256.14759385885702</c:v>
                </c:pt>
                <c:pt idx="1104">
                  <c:v>256.379821958457</c:v>
                </c:pt>
                <c:pt idx="1105">
                  <c:v>256.61205005805698</c:v>
                </c:pt>
                <c:pt idx="1106">
                  <c:v>256.84427815765702</c:v>
                </c:pt>
                <c:pt idx="1107">
                  <c:v>257.07650625725699</c:v>
                </c:pt>
                <c:pt idx="1108">
                  <c:v>257.30873435685697</c:v>
                </c:pt>
                <c:pt idx="1109">
                  <c:v>257.54096245645701</c:v>
                </c:pt>
                <c:pt idx="1110">
                  <c:v>257.77319055605699</c:v>
                </c:pt>
                <c:pt idx="1111">
                  <c:v>258.00541865565702</c:v>
                </c:pt>
                <c:pt idx="1112">
                  <c:v>258.237646755257</c:v>
                </c:pt>
                <c:pt idx="1113">
                  <c:v>258.46987485485698</c:v>
                </c:pt>
                <c:pt idx="1114">
                  <c:v>258.70210295445702</c:v>
                </c:pt>
                <c:pt idx="1115">
                  <c:v>258.93433105405802</c:v>
                </c:pt>
                <c:pt idx="1116">
                  <c:v>259.166559153658</c:v>
                </c:pt>
                <c:pt idx="1117">
                  <c:v>259.39878725325798</c:v>
                </c:pt>
                <c:pt idx="1118">
                  <c:v>259.63101535285801</c:v>
                </c:pt>
                <c:pt idx="1119">
                  <c:v>259.86324345245799</c:v>
                </c:pt>
                <c:pt idx="1120">
                  <c:v>260.09547155205797</c:v>
                </c:pt>
                <c:pt idx="1121">
                  <c:v>260.32769965165801</c:v>
                </c:pt>
                <c:pt idx="1122">
                  <c:v>260.55992775125799</c:v>
                </c:pt>
                <c:pt idx="1123">
                  <c:v>260.79215585085802</c:v>
                </c:pt>
                <c:pt idx="1124">
                  <c:v>261.024383950458</c:v>
                </c:pt>
                <c:pt idx="1125">
                  <c:v>261.25661205005798</c:v>
                </c:pt>
                <c:pt idx="1126">
                  <c:v>261.48884014965802</c:v>
                </c:pt>
                <c:pt idx="1127">
                  <c:v>261.721068249258</c:v>
                </c:pt>
                <c:pt idx="1128">
                  <c:v>261.95329634885798</c:v>
                </c:pt>
                <c:pt idx="1129">
                  <c:v>262.18552444845801</c:v>
                </c:pt>
                <c:pt idx="1130">
                  <c:v>262.41775254805799</c:v>
                </c:pt>
                <c:pt idx="1131">
                  <c:v>262.64998064765803</c:v>
                </c:pt>
                <c:pt idx="1132">
                  <c:v>262.88220874725801</c:v>
                </c:pt>
                <c:pt idx="1133">
                  <c:v>263.11443684685798</c:v>
                </c:pt>
                <c:pt idx="1134">
                  <c:v>263.34666494645899</c:v>
                </c:pt>
                <c:pt idx="1135">
                  <c:v>263.57889304605902</c:v>
                </c:pt>
                <c:pt idx="1136">
                  <c:v>263.811121145659</c:v>
                </c:pt>
                <c:pt idx="1137">
                  <c:v>264.04334924525898</c:v>
                </c:pt>
                <c:pt idx="1138">
                  <c:v>264.27557734485902</c:v>
                </c:pt>
                <c:pt idx="1139">
                  <c:v>264.507805444459</c:v>
                </c:pt>
                <c:pt idx="1140">
                  <c:v>264.74003354405897</c:v>
                </c:pt>
                <c:pt idx="1141">
                  <c:v>264.97226164365901</c:v>
                </c:pt>
                <c:pt idx="1142">
                  <c:v>265.20448974325899</c:v>
                </c:pt>
                <c:pt idx="1143">
                  <c:v>265.43671784285903</c:v>
                </c:pt>
                <c:pt idx="1144">
                  <c:v>265.668945942459</c:v>
                </c:pt>
                <c:pt idx="1145">
                  <c:v>265.90117404205898</c:v>
                </c:pt>
                <c:pt idx="1146">
                  <c:v>266.13340214165902</c:v>
                </c:pt>
                <c:pt idx="1147">
                  <c:v>266.365630241259</c:v>
                </c:pt>
                <c:pt idx="1148">
                  <c:v>266.59785834085898</c:v>
                </c:pt>
                <c:pt idx="1149">
                  <c:v>266.83008644045901</c:v>
                </c:pt>
                <c:pt idx="1150">
                  <c:v>267.06231454005899</c:v>
                </c:pt>
                <c:pt idx="1151">
                  <c:v>267.29454263965903</c:v>
                </c:pt>
                <c:pt idx="1152">
                  <c:v>267.52677073925901</c:v>
                </c:pt>
                <c:pt idx="1153">
                  <c:v>267.75899883885899</c:v>
                </c:pt>
                <c:pt idx="1154">
                  <c:v>267.99122693845999</c:v>
                </c:pt>
                <c:pt idx="1155">
                  <c:v>268.22345503806002</c:v>
                </c:pt>
                <c:pt idx="1156">
                  <c:v>268.45568313766</c:v>
                </c:pt>
                <c:pt idx="1157">
                  <c:v>268.68791123725998</c:v>
                </c:pt>
                <c:pt idx="1158">
                  <c:v>268.92013933686002</c:v>
                </c:pt>
                <c:pt idx="1159">
                  <c:v>269.15236743646</c:v>
                </c:pt>
                <c:pt idx="1160">
                  <c:v>269.38459553605998</c:v>
                </c:pt>
                <c:pt idx="1161">
                  <c:v>269.61682363566001</c:v>
                </c:pt>
                <c:pt idx="1162">
                  <c:v>269.84905173525999</c:v>
                </c:pt>
                <c:pt idx="1163">
                  <c:v>270.08127983486003</c:v>
                </c:pt>
                <c:pt idx="1164">
                  <c:v>270.31350793446001</c:v>
                </c:pt>
                <c:pt idx="1165">
                  <c:v>270.54573603405998</c:v>
                </c:pt>
                <c:pt idx="1166">
                  <c:v>270.77796413366002</c:v>
                </c:pt>
                <c:pt idx="1167">
                  <c:v>271.01019223326</c:v>
                </c:pt>
                <c:pt idx="1168">
                  <c:v>271.24242033285998</c:v>
                </c:pt>
                <c:pt idx="1169">
                  <c:v>271.47464843246001</c:v>
                </c:pt>
                <c:pt idx="1170">
                  <c:v>271.70687653205999</c:v>
                </c:pt>
                <c:pt idx="1171">
                  <c:v>271.93910463165997</c:v>
                </c:pt>
                <c:pt idx="1172">
                  <c:v>272.17133273126001</c:v>
                </c:pt>
                <c:pt idx="1173">
                  <c:v>272.40356083086101</c:v>
                </c:pt>
                <c:pt idx="1174">
                  <c:v>272.63578893046099</c:v>
                </c:pt>
                <c:pt idx="1175">
                  <c:v>272.86801703006103</c:v>
                </c:pt>
                <c:pt idx="1176">
                  <c:v>273.100245129661</c:v>
                </c:pt>
                <c:pt idx="1177">
                  <c:v>273.33247322926098</c:v>
                </c:pt>
                <c:pt idx="1178">
                  <c:v>273.56470132886102</c:v>
                </c:pt>
                <c:pt idx="1179">
                  <c:v>273.796929428461</c:v>
                </c:pt>
                <c:pt idx="1180">
                  <c:v>274.02915752806098</c:v>
                </c:pt>
                <c:pt idx="1181">
                  <c:v>274.26138562766101</c:v>
                </c:pt>
                <c:pt idx="1182">
                  <c:v>274.49361372726099</c:v>
                </c:pt>
                <c:pt idx="1183">
                  <c:v>274.72584182686097</c:v>
                </c:pt>
                <c:pt idx="1184">
                  <c:v>274.95806992646101</c:v>
                </c:pt>
                <c:pt idx="1185">
                  <c:v>275.19029802606099</c:v>
                </c:pt>
                <c:pt idx="1186">
                  <c:v>275.42252612566102</c:v>
                </c:pt>
                <c:pt idx="1187">
                  <c:v>275.654754225261</c:v>
                </c:pt>
                <c:pt idx="1188">
                  <c:v>275.88698232486098</c:v>
                </c:pt>
                <c:pt idx="1189">
                  <c:v>276.11921042446102</c:v>
                </c:pt>
                <c:pt idx="1190">
                  <c:v>276.351438524061</c:v>
                </c:pt>
                <c:pt idx="1191">
                  <c:v>276.58366662366097</c:v>
                </c:pt>
                <c:pt idx="1192">
                  <c:v>276.81589472326198</c:v>
                </c:pt>
                <c:pt idx="1193">
                  <c:v>277.04812282286201</c:v>
                </c:pt>
                <c:pt idx="1194">
                  <c:v>277.28035092246199</c:v>
                </c:pt>
                <c:pt idx="1195">
                  <c:v>277.51257902206203</c:v>
                </c:pt>
                <c:pt idx="1196">
                  <c:v>277.74480712166201</c:v>
                </c:pt>
                <c:pt idx="1197">
                  <c:v>277.97703522126199</c:v>
                </c:pt>
                <c:pt idx="1198">
                  <c:v>278.20926332086202</c:v>
                </c:pt>
                <c:pt idx="1199">
                  <c:v>278.441491420462</c:v>
                </c:pt>
                <c:pt idx="1200">
                  <c:v>278.67371952006198</c:v>
                </c:pt>
                <c:pt idx="1201">
                  <c:v>278.90594761966202</c:v>
                </c:pt>
                <c:pt idx="1202">
                  <c:v>279.13817571926199</c:v>
                </c:pt>
                <c:pt idx="1203">
                  <c:v>279.37040381886197</c:v>
                </c:pt>
                <c:pt idx="1204">
                  <c:v>279.60263191846201</c:v>
                </c:pt>
                <c:pt idx="1205">
                  <c:v>279.83486001806199</c:v>
                </c:pt>
                <c:pt idx="1206">
                  <c:v>280.06708811766202</c:v>
                </c:pt>
                <c:pt idx="1207">
                  <c:v>280.299316217262</c:v>
                </c:pt>
                <c:pt idx="1208">
                  <c:v>280.53154431686198</c:v>
                </c:pt>
                <c:pt idx="1209">
                  <c:v>280.76377241646202</c:v>
                </c:pt>
                <c:pt idx="1210">
                  <c:v>280.996000516062</c:v>
                </c:pt>
                <c:pt idx="1211">
                  <c:v>281.22822861566198</c:v>
                </c:pt>
                <c:pt idx="1212">
                  <c:v>281.46045671526298</c:v>
                </c:pt>
                <c:pt idx="1213">
                  <c:v>281.69268481486301</c:v>
                </c:pt>
                <c:pt idx="1214">
                  <c:v>281.92491291446299</c:v>
                </c:pt>
                <c:pt idx="1215">
                  <c:v>282.15714101406297</c:v>
                </c:pt>
                <c:pt idx="1216">
                  <c:v>282.38936911366301</c:v>
                </c:pt>
                <c:pt idx="1217">
                  <c:v>282.62159721326299</c:v>
                </c:pt>
                <c:pt idx="1218">
                  <c:v>282.85382531286302</c:v>
                </c:pt>
                <c:pt idx="1219">
                  <c:v>283.086053412463</c:v>
                </c:pt>
                <c:pt idx="1220">
                  <c:v>283.31828151206298</c:v>
                </c:pt>
                <c:pt idx="1221">
                  <c:v>283.55050961166302</c:v>
                </c:pt>
                <c:pt idx="1222">
                  <c:v>283.782737711263</c:v>
                </c:pt>
                <c:pt idx="1223">
                  <c:v>284.01496581086298</c:v>
                </c:pt>
                <c:pt idx="1224">
                  <c:v>284.24719391046301</c:v>
                </c:pt>
                <c:pt idx="1225">
                  <c:v>284.47942201006299</c:v>
                </c:pt>
                <c:pt idx="1226">
                  <c:v>284.71165010966303</c:v>
                </c:pt>
                <c:pt idx="1227">
                  <c:v>284.943878209263</c:v>
                </c:pt>
                <c:pt idx="1228">
                  <c:v>285.17610630886298</c:v>
                </c:pt>
                <c:pt idx="1229">
                  <c:v>285.40833440846302</c:v>
                </c:pt>
                <c:pt idx="1230">
                  <c:v>285.64056250806402</c:v>
                </c:pt>
                <c:pt idx="1231">
                  <c:v>285.872790607664</c:v>
                </c:pt>
                <c:pt idx="1232">
                  <c:v>286.10501870726398</c:v>
                </c:pt>
                <c:pt idx="1233">
                  <c:v>286.33724680686402</c:v>
                </c:pt>
                <c:pt idx="1234">
                  <c:v>286.569474906464</c:v>
                </c:pt>
                <c:pt idx="1235">
                  <c:v>286.80170300606397</c:v>
                </c:pt>
                <c:pt idx="1236">
                  <c:v>287.03393110566401</c:v>
                </c:pt>
                <c:pt idx="1237">
                  <c:v>287.26615920526399</c:v>
                </c:pt>
                <c:pt idx="1238">
                  <c:v>287.49838730486402</c:v>
                </c:pt>
                <c:pt idx="1239">
                  <c:v>287.730615404464</c:v>
                </c:pt>
                <c:pt idx="1240">
                  <c:v>287.96284350406398</c:v>
                </c:pt>
                <c:pt idx="1241">
                  <c:v>288.19507160366402</c:v>
                </c:pt>
                <c:pt idx="1242">
                  <c:v>288.427299703264</c:v>
                </c:pt>
                <c:pt idx="1243">
                  <c:v>288.65952780286398</c:v>
                </c:pt>
                <c:pt idx="1244">
                  <c:v>288.89175590246401</c:v>
                </c:pt>
                <c:pt idx="1245">
                  <c:v>289.12398400206399</c:v>
                </c:pt>
                <c:pt idx="1246">
                  <c:v>289.35621210166403</c:v>
                </c:pt>
                <c:pt idx="1247">
                  <c:v>289.58844020126401</c:v>
                </c:pt>
                <c:pt idx="1248">
                  <c:v>289.82066830086399</c:v>
                </c:pt>
                <c:pt idx="1249">
                  <c:v>290.05289640046402</c:v>
                </c:pt>
                <c:pt idx="1250">
                  <c:v>290.28512450006502</c:v>
                </c:pt>
                <c:pt idx="1251">
                  <c:v>290.517352599665</c:v>
                </c:pt>
                <c:pt idx="1252">
                  <c:v>290.74958069926498</c:v>
                </c:pt>
                <c:pt idx="1253">
                  <c:v>290.98180879886502</c:v>
                </c:pt>
                <c:pt idx="1254">
                  <c:v>291.214036898465</c:v>
                </c:pt>
                <c:pt idx="1255">
                  <c:v>291.44626499806498</c:v>
                </c:pt>
                <c:pt idx="1256">
                  <c:v>291.67849309766501</c:v>
                </c:pt>
                <c:pt idx="1257">
                  <c:v>291.91072119726499</c:v>
                </c:pt>
                <c:pt idx="1258">
                  <c:v>292.14294929686503</c:v>
                </c:pt>
                <c:pt idx="1259">
                  <c:v>292.37517739646501</c:v>
                </c:pt>
                <c:pt idx="1260">
                  <c:v>292.60740549606498</c:v>
                </c:pt>
                <c:pt idx="1261">
                  <c:v>292.83963359566502</c:v>
                </c:pt>
                <c:pt idx="1262">
                  <c:v>293.071861695265</c:v>
                </c:pt>
                <c:pt idx="1263">
                  <c:v>293.30408979486498</c:v>
                </c:pt>
                <c:pt idx="1264">
                  <c:v>293.53631789446501</c:v>
                </c:pt>
                <c:pt idx="1265">
                  <c:v>293.76854599406499</c:v>
                </c:pt>
                <c:pt idx="1266">
                  <c:v>294.00077409366497</c:v>
                </c:pt>
                <c:pt idx="1267">
                  <c:v>294.23300219326501</c:v>
                </c:pt>
                <c:pt idx="1268">
                  <c:v>294.46523029286499</c:v>
                </c:pt>
                <c:pt idx="1269">
                  <c:v>294.69745839246502</c:v>
                </c:pt>
                <c:pt idx="1270">
                  <c:v>294.92968649206603</c:v>
                </c:pt>
                <c:pt idx="1271">
                  <c:v>295.161914591666</c:v>
                </c:pt>
                <c:pt idx="1272">
                  <c:v>295.39414269126598</c:v>
                </c:pt>
                <c:pt idx="1273">
                  <c:v>295.62637079086602</c:v>
                </c:pt>
                <c:pt idx="1274">
                  <c:v>295.858598890466</c:v>
                </c:pt>
                <c:pt idx="1275">
                  <c:v>296.09082699006598</c:v>
                </c:pt>
                <c:pt idx="1276">
                  <c:v>296.32305508966601</c:v>
                </c:pt>
                <c:pt idx="1277">
                  <c:v>296.55528318926599</c:v>
                </c:pt>
                <c:pt idx="1278">
                  <c:v>296.78751128886603</c:v>
                </c:pt>
                <c:pt idx="1279">
                  <c:v>297.01973938846601</c:v>
                </c:pt>
                <c:pt idx="1280">
                  <c:v>297.25196748806599</c:v>
                </c:pt>
                <c:pt idx="1281">
                  <c:v>297.48419558766602</c:v>
                </c:pt>
                <c:pt idx="1282">
                  <c:v>297.716423687266</c:v>
                </c:pt>
                <c:pt idx="1283">
                  <c:v>297.94865178686598</c:v>
                </c:pt>
                <c:pt idx="1284">
                  <c:v>298.18087988646602</c:v>
                </c:pt>
                <c:pt idx="1285">
                  <c:v>298.413107986066</c:v>
                </c:pt>
                <c:pt idx="1286">
                  <c:v>298.64533608566597</c:v>
                </c:pt>
                <c:pt idx="1287">
                  <c:v>298.87756418526601</c:v>
                </c:pt>
                <c:pt idx="1288">
                  <c:v>299.10979228486701</c:v>
                </c:pt>
                <c:pt idx="1289">
                  <c:v>299.34202038446699</c:v>
                </c:pt>
                <c:pt idx="1290">
                  <c:v>299.57424848406703</c:v>
                </c:pt>
                <c:pt idx="1291">
                  <c:v>299.80647658366701</c:v>
                </c:pt>
                <c:pt idx="1292">
                  <c:v>300.03870468326699</c:v>
                </c:pt>
                <c:pt idx="1293">
                  <c:v>300.27093278286702</c:v>
                </c:pt>
                <c:pt idx="1294">
                  <c:v>300.503160882467</c:v>
                </c:pt>
                <c:pt idx="1295">
                  <c:v>300.73538898206698</c:v>
                </c:pt>
                <c:pt idx="1296">
                  <c:v>300.96761708166702</c:v>
                </c:pt>
                <c:pt idx="1297">
                  <c:v>301.19984518126699</c:v>
                </c:pt>
                <c:pt idx="1298">
                  <c:v>301.43207328086697</c:v>
                </c:pt>
                <c:pt idx="1299">
                  <c:v>301.66430138046701</c:v>
                </c:pt>
                <c:pt idx="1300">
                  <c:v>301.89652948006699</c:v>
                </c:pt>
                <c:pt idx="1301">
                  <c:v>302.12875757966702</c:v>
                </c:pt>
                <c:pt idx="1302">
                  <c:v>302.360985679267</c:v>
                </c:pt>
                <c:pt idx="1303">
                  <c:v>302.59321377886698</c:v>
                </c:pt>
                <c:pt idx="1304">
                  <c:v>302.82544187846702</c:v>
                </c:pt>
                <c:pt idx="1305">
                  <c:v>303.057669978067</c:v>
                </c:pt>
                <c:pt idx="1306">
                  <c:v>303.28989807766698</c:v>
                </c:pt>
                <c:pt idx="1307">
                  <c:v>303.52212617726701</c:v>
                </c:pt>
                <c:pt idx="1308">
                  <c:v>303.75435427686801</c:v>
                </c:pt>
                <c:pt idx="1309">
                  <c:v>303.98658237646799</c:v>
                </c:pt>
                <c:pt idx="1310">
                  <c:v>304.21881047606797</c:v>
                </c:pt>
                <c:pt idx="1311">
                  <c:v>304.45103857566801</c:v>
                </c:pt>
                <c:pt idx="1312">
                  <c:v>304.68326667526799</c:v>
                </c:pt>
                <c:pt idx="1313">
                  <c:v>304.91549477486802</c:v>
                </c:pt>
                <c:pt idx="1314">
                  <c:v>305.147722874468</c:v>
                </c:pt>
                <c:pt idx="1315">
                  <c:v>305.37995097406798</c:v>
                </c:pt>
                <c:pt idx="1316">
                  <c:v>305.61217907366802</c:v>
                </c:pt>
                <c:pt idx="1317">
                  <c:v>305.844407173268</c:v>
                </c:pt>
                <c:pt idx="1318">
                  <c:v>306.07663527286797</c:v>
                </c:pt>
                <c:pt idx="1319">
                  <c:v>306.30886337246801</c:v>
                </c:pt>
                <c:pt idx="1320">
                  <c:v>306.54109147206799</c:v>
                </c:pt>
                <c:pt idx="1321">
                  <c:v>306.77331957166803</c:v>
                </c:pt>
                <c:pt idx="1322">
                  <c:v>307.005547671268</c:v>
                </c:pt>
                <c:pt idx="1323">
                  <c:v>307.23777577086798</c:v>
                </c:pt>
                <c:pt idx="1324">
                  <c:v>307.47000387046802</c:v>
                </c:pt>
                <c:pt idx="1325">
                  <c:v>307.702231970068</c:v>
                </c:pt>
                <c:pt idx="1326">
                  <c:v>307.93446006966798</c:v>
                </c:pt>
                <c:pt idx="1327">
                  <c:v>308.16668816926801</c:v>
                </c:pt>
                <c:pt idx="1328">
                  <c:v>308.39891626886902</c:v>
                </c:pt>
                <c:pt idx="1329">
                  <c:v>308.63114436846899</c:v>
                </c:pt>
                <c:pt idx="1330">
                  <c:v>308.86337246806897</c:v>
                </c:pt>
                <c:pt idx="1331">
                  <c:v>309.09560056766901</c:v>
                </c:pt>
                <c:pt idx="1332">
                  <c:v>309.32782866726899</c:v>
                </c:pt>
                <c:pt idx="1333">
                  <c:v>309.56005676686902</c:v>
                </c:pt>
                <c:pt idx="1334">
                  <c:v>309.792284866469</c:v>
                </c:pt>
                <c:pt idx="1335">
                  <c:v>310.02451296606898</c:v>
                </c:pt>
                <c:pt idx="1336">
                  <c:v>310.25674106566902</c:v>
                </c:pt>
                <c:pt idx="1337">
                  <c:v>310.488969165269</c:v>
                </c:pt>
                <c:pt idx="1338">
                  <c:v>310.72119726486898</c:v>
                </c:pt>
                <c:pt idx="1339">
                  <c:v>310.95342536446901</c:v>
                </c:pt>
                <c:pt idx="1340">
                  <c:v>311.18565346406899</c:v>
                </c:pt>
                <c:pt idx="1341">
                  <c:v>311.41788156366903</c:v>
                </c:pt>
                <c:pt idx="1342">
                  <c:v>311.65010966326901</c:v>
                </c:pt>
                <c:pt idx="1343">
                  <c:v>311.88233776286899</c:v>
                </c:pt>
                <c:pt idx="1344">
                  <c:v>312.11456586246902</c:v>
                </c:pt>
                <c:pt idx="1345">
                  <c:v>312.346793962069</c:v>
                </c:pt>
                <c:pt idx="1346">
                  <c:v>312.57902206166898</c:v>
                </c:pt>
                <c:pt idx="1347">
                  <c:v>312.81125016126998</c:v>
                </c:pt>
                <c:pt idx="1348">
                  <c:v>313.04347826087002</c:v>
                </c:pt>
                <c:pt idx="1349">
                  <c:v>313.27570636047</c:v>
                </c:pt>
                <c:pt idx="1350">
                  <c:v>313.50793446006998</c:v>
                </c:pt>
                <c:pt idx="1351">
                  <c:v>313.74016255967001</c:v>
                </c:pt>
                <c:pt idx="1352">
                  <c:v>313.97239065926999</c:v>
                </c:pt>
                <c:pt idx="1353">
                  <c:v>314.20461875887003</c:v>
                </c:pt>
                <c:pt idx="1354">
                  <c:v>314.43684685847001</c:v>
                </c:pt>
                <c:pt idx="1355">
                  <c:v>314.66907495806998</c:v>
                </c:pt>
                <c:pt idx="1356">
                  <c:v>314.90130305767002</c:v>
                </c:pt>
                <c:pt idx="1357">
                  <c:v>315.13353115727</c:v>
                </c:pt>
                <c:pt idx="1358">
                  <c:v>315.36575925686998</c:v>
                </c:pt>
                <c:pt idx="1359">
                  <c:v>315.59798735647001</c:v>
                </c:pt>
                <c:pt idx="1360">
                  <c:v>315.83021545606999</c:v>
                </c:pt>
                <c:pt idx="1361">
                  <c:v>316.06244355566997</c:v>
                </c:pt>
                <c:pt idx="1362">
                  <c:v>316.29467165527001</c:v>
                </c:pt>
                <c:pt idx="1363">
                  <c:v>316.52689975486999</c:v>
                </c:pt>
                <c:pt idx="1364">
                  <c:v>316.75912785447002</c:v>
                </c:pt>
                <c:pt idx="1365">
                  <c:v>316.99135595407</c:v>
                </c:pt>
                <c:pt idx="1366">
                  <c:v>317.22358405366998</c:v>
                </c:pt>
                <c:pt idx="1367">
                  <c:v>317.45581215327098</c:v>
                </c:pt>
                <c:pt idx="1368">
                  <c:v>317.68804025287102</c:v>
                </c:pt>
                <c:pt idx="1369">
                  <c:v>317.920268352471</c:v>
                </c:pt>
                <c:pt idx="1370">
                  <c:v>318.15249645207098</c:v>
                </c:pt>
                <c:pt idx="1371">
                  <c:v>318.38472455167101</c:v>
                </c:pt>
                <c:pt idx="1372">
                  <c:v>318.61695265127099</c:v>
                </c:pt>
                <c:pt idx="1373">
                  <c:v>318.84918075087103</c:v>
                </c:pt>
                <c:pt idx="1374">
                  <c:v>319.08140885047101</c:v>
                </c:pt>
                <c:pt idx="1375">
                  <c:v>319.31363695007099</c:v>
                </c:pt>
                <c:pt idx="1376">
                  <c:v>319.54586504967102</c:v>
                </c:pt>
                <c:pt idx="1377">
                  <c:v>319.778093149271</c:v>
                </c:pt>
                <c:pt idx="1378">
                  <c:v>320.01032124887098</c:v>
                </c:pt>
                <c:pt idx="1379">
                  <c:v>320.24254934847102</c:v>
                </c:pt>
                <c:pt idx="1380">
                  <c:v>320.47477744807099</c:v>
                </c:pt>
                <c:pt idx="1381">
                  <c:v>320.70700554767097</c:v>
                </c:pt>
                <c:pt idx="1382">
                  <c:v>320.93923364727101</c:v>
                </c:pt>
                <c:pt idx="1383">
                  <c:v>321.17146174687099</c:v>
                </c:pt>
                <c:pt idx="1384">
                  <c:v>321.40368984647102</c:v>
                </c:pt>
                <c:pt idx="1385">
                  <c:v>321.635917946071</c:v>
                </c:pt>
                <c:pt idx="1386">
                  <c:v>321.86814604567201</c:v>
                </c:pt>
                <c:pt idx="1387">
                  <c:v>322.10037414527199</c:v>
                </c:pt>
                <c:pt idx="1388">
                  <c:v>322.33260224487202</c:v>
                </c:pt>
                <c:pt idx="1389">
                  <c:v>322.564830344472</c:v>
                </c:pt>
                <c:pt idx="1390">
                  <c:v>322.79705844407198</c:v>
                </c:pt>
                <c:pt idx="1391">
                  <c:v>323.02928654367201</c:v>
                </c:pt>
                <c:pt idx="1392">
                  <c:v>323.26151464327199</c:v>
                </c:pt>
                <c:pt idx="1393">
                  <c:v>323.49374274287197</c:v>
                </c:pt>
                <c:pt idx="1394">
                  <c:v>323.72597084247201</c:v>
                </c:pt>
                <c:pt idx="1395">
                  <c:v>323.95819894207199</c:v>
                </c:pt>
                <c:pt idx="1396">
                  <c:v>324.19042704167202</c:v>
                </c:pt>
                <c:pt idx="1397">
                  <c:v>324.422655141272</c:v>
                </c:pt>
                <c:pt idx="1398">
                  <c:v>324.65488324087198</c:v>
                </c:pt>
                <c:pt idx="1399">
                  <c:v>324.88711134047202</c:v>
                </c:pt>
                <c:pt idx="1400">
                  <c:v>325.119339440072</c:v>
                </c:pt>
                <c:pt idx="1401">
                  <c:v>325.35156753967198</c:v>
                </c:pt>
                <c:pt idx="1402">
                  <c:v>325.58379563927201</c:v>
                </c:pt>
                <c:pt idx="1403">
                  <c:v>325.81602373887199</c:v>
                </c:pt>
                <c:pt idx="1404">
                  <c:v>326.04825183847203</c:v>
                </c:pt>
                <c:pt idx="1405">
                  <c:v>326.28047993807297</c:v>
                </c:pt>
                <c:pt idx="1406">
                  <c:v>326.51270803767301</c:v>
                </c:pt>
                <c:pt idx="1407">
                  <c:v>326.74493613727299</c:v>
                </c:pt>
                <c:pt idx="1408">
                  <c:v>326.97716423687302</c:v>
                </c:pt>
                <c:pt idx="1409">
                  <c:v>327.209392336473</c:v>
                </c:pt>
                <c:pt idx="1410">
                  <c:v>327.44162043607298</c:v>
                </c:pt>
                <c:pt idx="1411">
                  <c:v>327.67384853567302</c:v>
                </c:pt>
                <c:pt idx="1412">
                  <c:v>327.906076635273</c:v>
                </c:pt>
                <c:pt idx="1413">
                  <c:v>328.13830473487297</c:v>
                </c:pt>
                <c:pt idx="1414">
                  <c:v>328.37053283447301</c:v>
                </c:pt>
                <c:pt idx="1415">
                  <c:v>328.60276093407299</c:v>
                </c:pt>
                <c:pt idx="1416">
                  <c:v>328.83498903367303</c:v>
                </c:pt>
                <c:pt idx="1417">
                  <c:v>329.067217133273</c:v>
                </c:pt>
                <c:pt idx="1418">
                  <c:v>329.29944523287298</c:v>
                </c:pt>
                <c:pt idx="1419">
                  <c:v>329.53167333247302</c:v>
                </c:pt>
                <c:pt idx="1420">
                  <c:v>329.763901432073</c:v>
                </c:pt>
                <c:pt idx="1421">
                  <c:v>329.99612953167298</c:v>
                </c:pt>
                <c:pt idx="1422">
                  <c:v>330.22835763127301</c:v>
                </c:pt>
                <c:pt idx="1423">
                  <c:v>330.46058573087299</c:v>
                </c:pt>
                <c:pt idx="1424">
                  <c:v>330.69281383047303</c:v>
                </c:pt>
                <c:pt idx="1425">
                  <c:v>330.92504193007397</c:v>
                </c:pt>
                <c:pt idx="1426">
                  <c:v>331.15727002967401</c:v>
                </c:pt>
                <c:pt idx="1427">
                  <c:v>331.38949812927399</c:v>
                </c:pt>
                <c:pt idx="1428">
                  <c:v>331.62172622887402</c:v>
                </c:pt>
                <c:pt idx="1429">
                  <c:v>331.853954328474</c:v>
                </c:pt>
                <c:pt idx="1430">
                  <c:v>332.08618242807398</c:v>
                </c:pt>
                <c:pt idx="1431">
                  <c:v>332.31841052767402</c:v>
                </c:pt>
                <c:pt idx="1432">
                  <c:v>332.550638627274</c:v>
                </c:pt>
                <c:pt idx="1433">
                  <c:v>332.78286672687398</c:v>
                </c:pt>
                <c:pt idx="1434">
                  <c:v>333.01509482647401</c:v>
                </c:pt>
                <c:pt idx="1435">
                  <c:v>333.24732292607399</c:v>
                </c:pt>
                <c:pt idx="1436">
                  <c:v>333.47955102567403</c:v>
                </c:pt>
                <c:pt idx="1437">
                  <c:v>333.71177912527401</c:v>
                </c:pt>
                <c:pt idx="1438">
                  <c:v>333.94400722487399</c:v>
                </c:pt>
                <c:pt idx="1439">
                  <c:v>334.17623532447402</c:v>
                </c:pt>
                <c:pt idx="1440">
                  <c:v>334.408463424074</c:v>
                </c:pt>
                <c:pt idx="1441">
                  <c:v>334.64069152367398</c:v>
                </c:pt>
                <c:pt idx="1442">
                  <c:v>334.87291962327402</c:v>
                </c:pt>
                <c:pt idx="1443">
                  <c:v>335.10514772287502</c:v>
                </c:pt>
                <c:pt idx="1444">
                  <c:v>335.337375822475</c:v>
                </c:pt>
                <c:pt idx="1445">
                  <c:v>335.56960392207498</c:v>
                </c:pt>
                <c:pt idx="1446">
                  <c:v>335.80183202167501</c:v>
                </c:pt>
                <c:pt idx="1447">
                  <c:v>336.03406012127499</c:v>
                </c:pt>
                <c:pt idx="1448">
                  <c:v>336.26628822087503</c:v>
                </c:pt>
                <c:pt idx="1449">
                  <c:v>336.49851632047501</c:v>
                </c:pt>
                <c:pt idx="1450">
                  <c:v>336.73074442007498</c:v>
                </c:pt>
                <c:pt idx="1451">
                  <c:v>336.96297251967502</c:v>
                </c:pt>
                <c:pt idx="1452">
                  <c:v>337.195200619275</c:v>
                </c:pt>
                <c:pt idx="1453">
                  <c:v>337.42742871887498</c:v>
                </c:pt>
                <c:pt idx="1454">
                  <c:v>337.65965681847501</c:v>
                </c:pt>
                <c:pt idx="1455">
                  <c:v>337.89188491807499</c:v>
                </c:pt>
                <c:pt idx="1456">
                  <c:v>338.12411301767497</c:v>
                </c:pt>
                <c:pt idx="1457">
                  <c:v>338.35634111727501</c:v>
                </c:pt>
                <c:pt idx="1458">
                  <c:v>338.58856921687499</c:v>
                </c:pt>
                <c:pt idx="1459">
                  <c:v>338.82079731647502</c:v>
                </c:pt>
                <c:pt idx="1460">
                  <c:v>339.053025416075</c:v>
                </c:pt>
                <c:pt idx="1461">
                  <c:v>339.28525351567498</c:v>
                </c:pt>
                <c:pt idx="1462">
                  <c:v>339.51748161527502</c:v>
                </c:pt>
                <c:pt idx="1463">
                  <c:v>339.74970971487602</c:v>
                </c:pt>
                <c:pt idx="1464">
                  <c:v>339.981937814476</c:v>
                </c:pt>
                <c:pt idx="1465">
                  <c:v>340.21416591407598</c:v>
                </c:pt>
                <c:pt idx="1466">
                  <c:v>340.44639401367601</c:v>
                </c:pt>
                <c:pt idx="1467">
                  <c:v>340.67862211327599</c:v>
                </c:pt>
                <c:pt idx="1468">
                  <c:v>340.91085021287603</c:v>
                </c:pt>
                <c:pt idx="1469">
                  <c:v>341.14307831247601</c:v>
                </c:pt>
                <c:pt idx="1470">
                  <c:v>341.37530641207599</c:v>
                </c:pt>
                <c:pt idx="1471">
                  <c:v>341.60753451167602</c:v>
                </c:pt>
                <c:pt idx="1472">
                  <c:v>341.839762611276</c:v>
                </c:pt>
                <c:pt idx="1473">
                  <c:v>342.07199071087598</c:v>
                </c:pt>
                <c:pt idx="1474">
                  <c:v>342.30421881047602</c:v>
                </c:pt>
                <c:pt idx="1475">
                  <c:v>342.53644691007599</c:v>
                </c:pt>
                <c:pt idx="1476">
                  <c:v>342.76867500967597</c:v>
                </c:pt>
                <c:pt idx="1477">
                  <c:v>343.00090310927601</c:v>
                </c:pt>
                <c:pt idx="1478">
                  <c:v>343.23313120887599</c:v>
                </c:pt>
                <c:pt idx="1479">
                  <c:v>343.46535930847602</c:v>
                </c:pt>
                <c:pt idx="1480">
                  <c:v>343.697587408076</c:v>
                </c:pt>
                <c:pt idx="1481">
                  <c:v>343.92981550767598</c:v>
                </c:pt>
                <c:pt idx="1482">
                  <c:v>344.16204360727602</c:v>
                </c:pt>
                <c:pt idx="1483">
                  <c:v>344.39427170687702</c:v>
                </c:pt>
                <c:pt idx="1484">
                  <c:v>344.626499806477</c:v>
                </c:pt>
                <c:pt idx="1485">
                  <c:v>344.85872790607698</c:v>
                </c:pt>
                <c:pt idx="1486">
                  <c:v>345.09095600567701</c:v>
                </c:pt>
                <c:pt idx="1487">
                  <c:v>345.32318410527699</c:v>
                </c:pt>
                <c:pt idx="1488">
                  <c:v>345.55541220487697</c:v>
                </c:pt>
                <c:pt idx="1489">
                  <c:v>345.78764030447701</c:v>
                </c:pt>
                <c:pt idx="1490">
                  <c:v>346.01986840407699</c:v>
                </c:pt>
                <c:pt idx="1491">
                  <c:v>346.25209650367702</c:v>
                </c:pt>
                <c:pt idx="1492">
                  <c:v>346.484324603277</c:v>
                </c:pt>
                <c:pt idx="1493">
                  <c:v>346.71655270287698</c:v>
                </c:pt>
                <c:pt idx="1494">
                  <c:v>346.94878080247702</c:v>
                </c:pt>
                <c:pt idx="1495">
                  <c:v>347.181008902077</c:v>
                </c:pt>
                <c:pt idx="1496">
                  <c:v>347.41323700167698</c:v>
                </c:pt>
                <c:pt idx="1497">
                  <c:v>347.64546510127701</c:v>
                </c:pt>
                <c:pt idx="1498">
                  <c:v>347.87769320087699</c:v>
                </c:pt>
                <c:pt idx="1499">
                  <c:v>348.10992130047703</c:v>
                </c:pt>
                <c:pt idx="1500">
                  <c:v>348.34214940007701</c:v>
                </c:pt>
                <c:pt idx="1501">
                  <c:v>348.57437749967698</c:v>
                </c:pt>
                <c:pt idx="1502">
                  <c:v>348.80660559927799</c:v>
                </c:pt>
                <c:pt idx="1503">
                  <c:v>349.03883369887802</c:v>
                </c:pt>
                <c:pt idx="1504">
                  <c:v>349.271061798478</c:v>
                </c:pt>
                <c:pt idx="1505">
                  <c:v>349.50328989807798</c:v>
                </c:pt>
                <c:pt idx="1506">
                  <c:v>349.73551799767802</c:v>
                </c:pt>
                <c:pt idx="1507">
                  <c:v>349.967746097278</c:v>
                </c:pt>
                <c:pt idx="1508">
                  <c:v>350.19997419687797</c:v>
                </c:pt>
                <c:pt idx="1509">
                  <c:v>350.43220229647801</c:v>
                </c:pt>
                <c:pt idx="1510">
                  <c:v>350.66443039607799</c:v>
                </c:pt>
                <c:pt idx="1511">
                  <c:v>350.89665849567803</c:v>
                </c:pt>
                <c:pt idx="1512">
                  <c:v>351.128886595278</c:v>
                </c:pt>
                <c:pt idx="1513">
                  <c:v>351.36111469487798</c:v>
                </c:pt>
                <c:pt idx="1514">
                  <c:v>351.59334279447802</c:v>
                </c:pt>
                <c:pt idx="1515">
                  <c:v>351.825570894078</c:v>
                </c:pt>
                <c:pt idx="1516">
                  <c:v>352.05779899367798</c:v>
                </c:pt>
                <c:pt idx="1517">
                  <c:v>352.29002709327801</c:v>
                </c:pt>
                <c:pt idx="1518">
                  <c:v>352.52225519287799</c:v>
                </c:pt>
                <c:pt idx="1519">
                  <c:v>352.75448329247803</c:v>
                </c:pt>
                <c:pt idx="1520">
                  <c:v>352.98671139207801</c:v>
                </c:pt>
                <c:pt idx="1521">
                  <c:v>353.21893949167799</c:v>
                </c:pt>
                <c:pt idx="1522">
                  <c:v>353.45116759127899</c:v>
                </c:pt>
                <c:pt idx="1523">
                  <c:v>353.68339569087902</c:v>
                </c:pt>
                <c:pt idx="1524">
                  <c:v>353.915623790479</c:v>
                </c:pt>
                <c:pt idx="1525">
                  <c:v>354.14785189007898</c:v>
                </c:pt>
                <c:pt idx="1526">
                  <c:v>354.38007998967902</c:v>
                </c:pt>
                <c:pt idx="1527">
                  <c:v>354.612308089279</c:v>
                </c:pt>
                <c:pt idx="1528">
                  <c:v>354.84453618887898</c:v>
                </c:pt>
                <c:pt idx="1529">
                  <c:v>355.07676428847901</c:v>
                </c:pt>
                <c:pt idx="1530">
                  <c:v>355.30899238807899</c:v>
                </c:pt>
                <c:pt idx="1531">
                  <c:v>355.54122048767903</c:v>
                </c:pt>
                <c:pt idx="1532">
                  <c:v>355.77344858727901</c:v>
                </c:pt>
                <c:pt idx="1533">
                  <c:v>356.00567668687899</c:v>
                </c:pt>
                <c:pt idx="1534">
                  <c:v>356.23790478647902</c:v>
                </c:pt>
                <c:pt idx="1535">
                  <c:v>356.470132886079</c:v>
                </c:pt>
                <c:pt idx="1536">
                  <c:v>356.70236098567898</c:v>
                </c:pt>
                <c:pt idx="1537">
                  <c:v>356.93458908527901</c:v>
                </c:pt>
                <c:pt idx="1538">
                  <c:v>357.16681718487899</c:v>
                </c:pt>
                <c:pt idx="1539">
                  <c:v>357.39904528447897</c:v>
                </c:pt>
                <c:pt idx="1540">
                  <c:v>357.63127338407901</c:v>
                </c:pt>
                <c:pt idx="1541">
                  <c:v>357.86350148368001</c:v>
                </c:pt>
                <c:pt idx="1542">
                  <c:v>358.09572958327999</c:v>
                </c:pt>
                <c:pt idx="1543">
                  <c:v>358.32795768288003</c:v>
                </c:pt>
                <c:pt idx="1544">
                  <c:v>358.56018578248</c:v>
                </c:pt>
                <c:pt idx="1545">
                  <c:v>358.79241388207998</c:v>
                </c:pt>
                <c:pt idx="1546">
                  <c:v>359.02464198168002</c:v>
                </c:pt>
                <c:pt idx="1547">
                  <c:v>359.25687008128</c:v>
                </c:pt>
                <c:pt idx="1548">
                  <c:v>359.48909818087998</c:v>
                </c:pt>
                <c:pt idx="1549">
                  <c:v>359.72132628048001</c:v>
                </c:pt>
                <c:pt idx="1550">
                  <c:v>359.95355438007999</c:v>
                </c:pt>
                <c:pt idx="1551">
                  <c:v>360.18578247967997</c:v>
                </c:pt>
                <c:pt idx="1552">
                  <c:v>360.41801057928001</c:v>
                </c:pt>
                <c:pt idx="1553">
                  <c:v>360.65023867887999</c:v>
                </c:pt>
                <c:pt idx="1554">
                  <c:v>360.88246677848002</c:v>
                </c:pt>
                <c:pt idx="1555">
                  <c:v>361.11469487808</c:v>
                </c:pt>
                <c:pt idx="1556">
                  <c:v>361.34692297767998</c:v>
                </c:pt>
                <c:pt idx="1557">
                  <c:v>361.57915107728002</c:v>
                </c:pt>
                <c:pt idx="1558">
                  <c:v>361.81137917688</c:v>
                </c:pt>
                <c:pt idx="1559">
                  <c:v>362.04360727647997</c:v>
                </c:pt>
                <c:pt idx="1560">
                  <c:v>362.27583537608098</c:v>
                </c:pt>
                <c:pt idx="1561">
                  <c:v>362.50806347568101</c:v>
                </c:pt>
                <c:pt idx="1562">
                  <c:v>362.74029157528099</c:v>
                </c:pt>
                <c:pt idx="1563">
                  <c:v>362.97251967488103</c:v>
                </c:pt>
                <c:pt idx="1564">
                  <c:v>363.20474777448101</c:v>
                </c:pt>
                <c:pt idx="1565">
                  <c:v>363.43697587408099</c:v>
                </c:pt>
                <c:pt idx="1566">
                  <c:v>363.66920397368102</c:v>
                </c:pt>
                <c:pt idx="1567">
                  <c:v>363.901432073281</c:v>
                </c:pt>
                <c:pt idx="1568">
                  <c:v>364.13366017288098</c:v>
                </c:pt>
                <c:pt idx="1569">
                  <c:v>364.36588827248102</c:v>
                </c:pt>
                <c:pt idx="1570">
                  <c:v>364.59811637208099</c:v>
                </c:pt>
                <c:pt idx="1571">
                  <c:v>364.83034447168097</c:v>
                </c:pt>
                <c:pt idx="1572">
                  <c:v>365.06257257128101</c:v>
                </c:pt>
                <c:pt idx="1573">
                  <c:v>365.29480067088099</c:v>
                </c:pt>
                <c:pt idx="1574">
                  <c:v>365.52702877048102</c:v>
                </c:pt>
                <c:pt idx="1575">
                  <c:v>365.759256870081</c:v>
                </c:pt>
                <c:pt idx="1576">
                  <c:v>365.99148496968098</c:v>
                </c:pt>
                <c:pt idx="1577">
                  <c:v>366.22371306928102</c:v>
                </c:pt>
                <c:pt idx="1578">
                  <c:v>366.455941168881</c:v>
                </c:pt>
                <c:pt idx="1579">
                  <c:v>366.68816926848098</c:v>
                </c:pt>
                <c:pt idx="1580">
                  <c:v>366.92039736808198</c:v>
                </c:pt>
                <c:pt idx="1581">
                  <c:v>367.15262546768201</c:v>
                </c:pt>
                <c:pt idx="1582">
                  <c:v>367.38485356728199</c:v>
                </c:pt>
                <c:pt idx="1583">
                  <c:v>367.61708166688197</c:v>
                </c:pt>
                <c:pt idx="1584">
                  <c:v>367.84930976648201</c:v>
                </c:pt>
                <c:pt idx="1585">
                  <c:v>368.08153786608199</c:v>
                </c:pt>
                <c:pt idx="1586">
                  <c:v>368.31376596568202</c:v>
                </c:pt>
                <c:pt idx="1587">
                  <c:v>368.545994065282</c:v>
                </c:pt>
                <c:pt idx="1588">
                  <c:v>368.77822216488198</c:v>
                </c:pt>
                <c:pt idx="1589">
                  <c:v>369.01045026448202</c:v>
                </c:pt>
                <c:pt idx="1590">
                  <c:v>369.242678364082</c:v>
                </c:pt>
                <c:pt idx="1591">
                  <c:v>369.47490646368198</c:v>
                </c:pt>
                <c:pt idx="1592">
                  <c:v>369.70713456328201</c:v>
                </c:pt>
                <c:pt idx="1593">
                  <c:v>369.93936266288199</c:v>
                </c:pt>
                <c:pt idx="1594">
                  <c:v>370.17159076248203</c:v>
                </c:pt>
                <c:pt idx="1595">
                  <c:v>370.40381886208201</c:v>
                </c:pt>
                <c:pt idx="1596">
                  <c:v>370.63604696168198</c:v>
                </c:pt>
                <c:pt idx="1597">
                  <c:v>370.86827506128202</c:v>
                </c:pt>
                <c:pt idx="1598">
                  <c:v>371.100503160882</c:v>
                </c:pt>
                <c:pt idx="1599">
                  <c:v>371.332731260483</c:v>
                </c:pt>
                <c:pt idx="1600">
                  <c:v>371.56495936008298</c:v>
                </c:pt>
                <c:pt idx="1601">
                  <c:v>371.79718745968302</c:v>
                </c:pt>
                <c:pt idx="1602">
                  <c:v>372.029415559283</c:v>
                </c:pt>
                <c:pt idx="1603">
                  <c:v>372.26164365888297</c:v>
                </c:pt>
                <c:pt idx="1604">
                  <c:v>372.49387175848301</c:v>
                </c:pt>
                <c:pt idx="1605">
                  <c:v>372.72609985808299</c:v>
                </c:pt>
                <c:pt idx="1606">
                  <c:v>372.95832795768303</c:v>
                </c:pt>
                <c:pt idx="1607">
                  <c:v>373.190556057283</c:v>
                </c:pt>
                <c:pt idx="1608">
                  <c:v>373.42278415688298</c:v>
                </c:pt>
                <c:pt idx="1609">
                  <c:v>373.65501225648302</c:v>
                </c:pt>
                <c:pt idx="1610">
                  <c:v>373.887240356083</c:v>
                </c:pt>
                <c:pt idx="1611">
                  <c:v>374.11946845568298</c:v>
                </c:pt>
                <c:pt idx="1612">
                  <c:v>374.35169655528301</c:v>
                </c:pt>
                <c:pt idx="1613">
                  <c:v>374.58392465488299</c:v>
                </c:pt>
                <c:pt idx="1614">
                  <c:v>374.81615275448303</c:v>
                </c:pt>
                <c:pt idx="1615">
                  <c:v>375.04838085408301</c:v>
                </c:pt>
                <c:pt idx="1616">
                  <c:v>375.28060895368299</c:v>
                </c:pt>
                <c:pt idx="1617">
                  <c:v>375.51283705328302</c:v>
                </c:pt>
                <c:pt idx="1618">
                  <c:v>375.74506515288402</c:v>
                </c:pt>
                <c:pt idx="1619">
                  <c:v>375.977293252484</c:v>
                </c:pt>
                <c:pt idx="1620">
                  <c:v>376.20952135208398</c:v>
                </c:pt>
                <c:pt idx="1621">
                  <c:v>376.44174945168402</c:v>
                </c:pt>
                <c:pt idx="1622">
                  <c:v>376.673977551284</c:v>
                </c:pt>
                <c:pt idx="1623">
                  <c:v>376.90620565088398</c:v>
                </c:pt>
                <c:pt idx="1624">
                  <c:v>377.13843375048401</c:v>
                </c:pt>
                <c:pt idx="1625">
                  <c:v>377.37066185008399</c:v>
                </c:pt>
                <c:pt idx="1626">
                  <c:v>377.60288994968403</c:v>
                </c:pt>
                <c:pt idx="1627">
                  <c:v>377.83511804928401</c:v>
                </c:pt>
                <c:pt idx="1628">
                  <c:v>378.06734614888398</c:v>
                </c:pt>
                <c:pt idx="1629">
                  <c:v>378.29957424848402</c:v>
                </c:pt>
                <c:pt idx="1630">
                  <c:v>378.531802348084</c:v>
                </c:pt>
                <c:pt idx="1631">
                  <c:v>378.76403044768398</c:v>
                </c:pt>
                <c:pt idx="1632">
                  <c:v>378.99625854728401</c:v>
                </c:pt>
                <c:pt idx="1633">
                  <c:v>379.22848664688399</c:v>
                </c:pt>
                <c:pt idx="1634">
                  <c:v>379.46071474648397</c:v>
                </c:pt>
                <c:pt idx="1635">
                  <c:v>379.69294284608401</c:v>
                </c:pt>
                <c:pt idx="1636">
                  <c:v>379.92517094568399</c:v>
                </c:pt>
                <c:pt idx="1637">
                  <c:v>380.15739904528402</c:v>
                </c:pt>
                <c:pt idx="1638">
                  <c:v>380.38962714488503</c:v>
                </c:pt>
                <c:pt idx="1639">
                  <c:v>380.621855244485</c:v>
                </c:pt>
                <c:pt idx="1640">
                  <c:v>380.85408334408498</c:v>
                </c:pt>
                <c:pt idx="1641">
                  <c:v>381.08631144368502</c:v>
                </c:pt>
                <c:pt idx="1642">
                  <c:v>381.318539543285</c:v>
                </c:pt>
                <c:pt idx="1643">
                  <c:v>381.55076764288498</c:v>
                </c:pt>
                <c:pt idx="1644">
                  <c:v>381.78299574248501</c:v>
                </c:pt>
                <c:pt idx="1645">
                  <c:v>382.01522384208499</c:v>
                </c:pt>
                <c:pt idx="1646">
                  <c:v>382.24745194168497</c:v>
                </c:pt>
                <c:pt idx="1647">
                  <c:v>382.47968004128501</c:v>
                </c:pt>
                <c:pt idx="1648">
                  <c:v>382.71190814088499</c:v>
                </c:pt>
                <c:pt idx="1649">
                  <c:v>382.94413624048502</c:v>
                </c:pt>
                <c:pt idx="1650">
                  <c:v>383.176364340085</c:v>
                </c:pt>
                <c:pt idx="1651">
                  <c:v>383.40859243968498</c:v>
                </c:pt>
                <c:pt idx="1652">
                  <c:v>383.64082053928502</c:v>
                </c:pt>
                <c:pt idx="1653">
                  <c:v>383.873048638885</c:v>
                </c:pt>
                <c:pt idx="1654">
                  <c:v>384.10527673848497</c:v>
                </c:pt>
                <c:pt idx="1655">
                  <c:v>384.33750483808501</c:v>
                </c:pt>
                <c:pt idx="1656">
                  <c:v>384.56973293768499</c:v>
                </c:pt>
                <c:pt idx="1657">
                  <c:v>384.80196103728599</c:v>
                </c:pt>
                <c:pt idx="1658">
                  <c:v>385.03418913688603</c:v>
                </c:pt>
                <c:pt idx="1659">
                  <c:v>385.26641723648601</c:v>
                </c:pt>
                <c:pt idx="1660">
                  <c:v>385.49864533608599</c:v>
                </c:pt>
                <c:pt idx="1661">
                  <c:v>385.73087343568602</c:v>
                </c:pt>
                <c:pt idx="1662">
                  <c:v>385.963101535286</c:v>
                </c:pt>
                <c:pt idx="1663">
                  <c:v>386.19532963488598</c:v>
                </c:pt>
                <c:pt idx="1664">
                  <c:v>386.42755773448602</c:v>
                </c:pt>
                <c:pt idx="1665">
                  <c:v>386.65978583408599</c:v>
                </c:pt>
                <c:pt idx="1666">
                  <c:v>386.89201393368597</c:v>
                </c:pt>
                <c:pt idx="1667">
                  <c:v>387.12424203328601</c:v>
                </c:pt>
                <c:pt idx="1668">
                  <c:v>387.35647013288599</c:v>
                </c:pt>
                <c:pt idx="1669">
                  <c:v>387.58869823248602</c:v>
                </c:pt>
                <c:pt idx="1670">
                  <c:v>387.820926332086</c:v>
                </c:pt>
                <c:pt idx="1671">
                  <c:v>388.05315443168598</c:v>
                </c:pt>
                <c:pt idx="1672">
                  <c:v>388.28538253128602</c:v>
                </c:pt>
                <c:pt idx="1673">
                  <c:v>388.517610630886</c:v>
                </c:pt>
                <c:pt idx="1674">
                  <c:v>388.74983873048598</c:v>
                </c:pt>
                <c:pt idx="1675">
                  <c:v>388.98206683008601</c:v>
                </c:pt>
                <c:pt idx="1676">
                  <c:v>389.21429492968701</c:v>
                </c:pt>
                <c:pt idx="1677">
                  <c:v>389.44652302928699</c:v>
                </c:pt>
                <c:pt idx="1678">
                  <c:v>389.67875112888697</c:v>
                </c:pt>
                <c:pt idx="1679">
                  <c:v>389.91097922848701</c:v>
                </c:pt>
                <c:pt idx="1680">
                  <c:v>390.14320732808699</c:v>
                </c:pt>
                <c:pt idx="1681">
                  <c:v>390.37543542768702</c:v>
                </c:pt>
                <c:pt idx="1682">
                  <c:v>390.607663527287</c:v>
                </c:pt>
                <c:pt idx="1683">
                  <c:v>390.83989162688698</c:v>
                </c:pt>
                <c:pt idx="1684">
                  <c:v>391.07211972648702</c:v>
                </c:pt>
                <c:pt idx="1685">
                  <c:v>391.304347826087</c:v>
                </c:pt>
                <c:pt idx="1686">
                  <c:v>391.53657592568698</c:v>
                </c:pt>
                <c:pt idx="1687">
                  <c:v>391.76880402528701</c:v>
                </c:pt>
                <c:pt idx="1688">
                  <c:v>392.00103212488699</c:v>
                </c:pt>
                <c:pt idx="1689">
                  <c:v>392.23326022448703</c:v>
                </c:pt>
                <c:pt idx="1690">
                  <c:v>392.465488324087</c:v>
                </c:pt>
                <c:pt idx="1691">
                  <c:v>392.69771642368698</c:v>
                </c:pt>
                <c:pt idx="1692">
                  <c:v>392.92994452328702</c:v>
                </c:pt>
                <c:pt idx="1693">
                  <c:v>393.162172622887</c:v>
                </c:pt>
                <c:pt idx="1694">
                  <c:v>393.39440072248698</c:v>
                </c:pt>
                <c:pt idx="1695">
                  <c:v>393.62662882208701</c:v>
                </c:pt>
                <c:pt idx="1696">
                  <c:v>393.85885692168802</c:v>
                </c:pt>
                <c:pt idx="1697">
                  <c:v>394.091085021288</c:v>
                </c:pt>
                <c:pt idx="1698">
                  <c:v>394.32331312088797</c:v>
                </c:pt>
                <c:pt idx="1699">
                  <c:v>394.55554122048801</c:v>
                </c:pt>
                <c:pt idx="1700">
                  <c:v>394.78776932008799</c:v>
                </c:pt>
                <c:pt idx="1701">
                  <c:v>395.01999741968802</c:v>
                </c:pt>
                <c:pt idx="1702">
                  <c:v>395.252225519288</c:v>
                </c:pt>
                <c:pt idx="1703">
                  <c:v>395.48445361888798</c:v>
                </c:pt>
                <c:pt idx="1704">
                  <c:v>395.71668171848802</c:v>
                </c:pt>
                <c:pt idx="1705">
                  <c:v>395.948909818088</c:v>
                </c:pt>
                <c:pt idx="1706">
                  <c:v>396.18113791768798</c:v>
                </c:pt>
                <c:pt idx="1707">
                  <c:v>396.41336601728801</c:v>
                </c:pt>
                <c:pt idx="1708">
                  <c:v>396.64559411688799</c:v>
                </c:pt>
                <c:pt idx="1709">
                  <c:v>396.87782221648803</c:v>
                </c:pt>
                <c:pt idx="1710">
                  <c:v>397.11005031608801</c:v>
                </c:pt>
                <c:pt idx="1711">
                  <c:v>397.34227841568799</c:v>
                </c:pt>
                <c:pt idx="1712">
                  <c:v>397.57450651528802</c:v>
                </c:pt>
                <c:pt idx="1713">
                  <c:v>397.806734614888</c:v>
                </c:pt>
                <c:pt idx="1714">
                  <c:v>398.03896271448798</c:v>
                </c:pt>
                <c:pt idx="1715">
                  <c:v>398.27119081408898</c:v>
                </c:pt>
                <c:pt idx="1716">
                  <c:v>398.50341891368902</c:v>
                </c:pt>
                <c:pt idx="1717">
                  <c:v>398.735647013289</c:v>
                </c:pt>
                <c:pt idx="1718">
                  <c:v>398.96787511288898</c:v>
                </c:pt>
                <c:pt idx="1719">
                  <c:v>399.20010321248901</c:v>
                </c:pt>
                <c:pt idx="1720">
                  <c:v>399.43233131208899</c:v>
                </c:pt>
                <c:pt idx="1721">
                  <c:v>399.66455941168903</c:v>
                </c:pt>
                <c:pt idx="1722">
                  <c:v>399.89678751128901</c:v>
                </c:pt>
                <c:pt idx="1723">
                  <c:v>400.12901561088898</c:v>
                </c:pt>
                <c:pt idx="1724">
                  <c:v>400.36124371048902</c:v>
                </c:pt>
                <c:pt idx="1725">
                  <c:v>400.593471810089</c:v>
                </c:pt>
                <c:pt idx="1726">
                  <c:v>400.82569990968898</c:v>
                </c:pt>
                <c:pt idx="1727">
                  <c:v>401.05792800928901</c:v>
                </c:pt>
                <c:pt idx="1728">
                  <c:v>401.29015610888899</c:v>
                </c:pt>
                <c:pt idx="1729">
                  <c:v>401.52238420848897</c:v>
                </c:pt>
                <c:pt idx="1730">
                  <c:v>401.75461230808901</c:v>
                </c:pt>
                <c:pt idx="1731">
                  <c:v>401.98684040768899</c:v>
                </c:pt>
                <c:pt idx="1732">
                  <c:v>402.21906850728902</c:v>
                </c:pt>
                <c:pt idx="1733">
                  <c:v>402.451296606889</c:v>
                </c:pt>
                <c:pt idx="1734">
                  <c:v>402.68352470648898</c:v>
                </c:pt>
                <c:pt idx="1735">
                  <c:v>402.91575280608998</c:v>
                </c:pt>
                <c:pt idx="1736">
                  <c:v>403.14798090569002</c:v>
                </c:pt>
                <c:pt idx="1737">
                  <c:v>403.38020900529</c:v>
                </c:pt>
                <c:pt idx="1738">
                  <c:v>403.61243710488998</c:v>
                </c:pt>
                <c:pt idx="1739">
                  <c:v>403.84466520449001</c:v>
                </c:pt>
                <c:pt idx="1740">
                  <c:v>404.07689330408999</c:v>
                </c:pt>
                <c:pt idx="1741">
                  <c:v>404.30912140369003</c:v>
                </c:pt>
                <c:pt idx="1742">
                  <c:v>404.54134950329001</c:v>
                </c:pt>
                <c:pt idx="1743">
                  <c:v>404.77357760288999</c:v>
                </c:pt>
                <c:pt idx="1744">
                  <c:v>405.00580570249002</c:v>
                </c:pt>
                <c:pt idx="1745">
                  <c:v>405.23803380209</c:v>
                </c:pt>
                <c:pt idx="1746">
                  <c:v>405.47026190168998</c:v>
                </c:pt>
                <c:pt idx="1747">
                  <c:v>405.70249000129002</c:v>
                </c:pt>
                <c:pt idx="1748">
                  <c:v>405.93471810089</c:v>
                </c:pt>
                <c:pt idx="1749">
                  <c:v>406.16694620048997</c:v>
                </c:pt>
                <c:pt idx="1750">
                  <c:v>406.39917430009001</c:v>
                </c:pt>
                <c:pt idx="1751">
                  <c:v>406.63140239968999</c:v>
                </c:pt>
                <c:pt idx="1752">
                  <c:v>406.86363049929002</c:v>
                </c:pt>
                <c:pt idx="1753">
                  <c:v>407.09585859889</c:v>
                </c:pt>
                <c:pt idx="1754">
                  <c:v>407.32808669849101</c:v>
                </c:pt>
                <c:pt idx="1755">
                  <c:v>407.56031479809099</c:v>
                </c:pt>
                <c:pt idx="1756">
                  <c:v>407.79254289769102</c:v>
                </c:pt>
                <c:pt idx="1757">
                  <c:v>408.024770997291</c:v>
                </c:pt>
                <c:pt idx="1758">
                  <c:v>408.25699909689098</c:v>
                </c:pt>
                <c:pt idx="1759">
                  <c:v>408.48922719649102</c:v>
                </c:pt>
                <c:pt idx="1760">
                  <c:v>408.72145529609099</c:v>
                </c:pt>
                <c:pt idx="1761">
                  <c:v>408.95368339569097</c:v>
                </c:pt>
                <c:pt idx="1762">
                  <c:v>409.18591149529101</c:v>
                </c:pt>
                <c:pt idx="1763">
                  <c:v>409.41813959489099</c:v>
                </c:pt>
                <c:pt idx="1764">
                  <c:v>409.65036769449102</c:v>
                </c:pt>
                <c:pt idx="1765">
                  <c:v>409.882595794091</c:v>
                </c:pt>
                <c:pt idx="1766">
                  <c:v>410.11482389369098</c:v>
                </c:pt>
                <c:pt idx="1767">
                  <c:v>410.34705199329102</c:v>
                </c:pt>
                <c:pt idx="1768">
                  <c:v>410.579280092891</c:v>
                </c:pt>
                <c:pt idx="1769">
                  <c:v>410.81150819249098</c:v>
                </c:pt>
                <c:pt idx="1770">
                  <c:v>411.04373629209101</c:v>
                </c:pt>
                <c:pt idx="1771">
                  <c:v>411.27596439169099</c:v>
                </c:pt>
                <c:pt idx="1772">
                  <c:v>411.50819249129103</c:v>
                </c:pt>
                <c:pt idx="1773">
                  <c:v>411.74042059089197</c:v>
                </c:pt>
                <c:pt idx="1774">
                  <c:v>411.97264869049201</c:v>
                </c:pt>
                <c:pt idx="1775">
                  <c:v>412.20487679009199</c:v>
                </c:pt>
                <c:pt idx="1776">
                  <c:v>412.43710488969202</c:v>
                </c:pt>
                <c:pt idx="1777">
                  <c:v>412.669332989292</c:v>
                </c:pt>
                <c:pt idx="1778">
                  <c:v>412.90156108889198</c:v>
                </c:pt>
                <c:pt idx="1779">
                  <c:v>413.13378918849202</c:v>
                </c:pt>
                <c:pt idx="1780">
                  <c:v>413.366017288092</c:v>
                </c:pt>
                <c:pt idx="1781">
                  <c:v>413.59824538769197</c:v>
                </c:pt>
                <c:pt idx="1782">
                  <c:v>413.83047348729201</c:v>
                </c:pt>
                <c:pt idx="1783">
                  <c:v>414.06270158689199</c:v>
                </c:pt>
                <c:pt idx="1784">
                  <c:v>414.29492968649203</c:v>
                </c:pt>
                <c:pt idx="1785">
                  <c:v>414.527157786092</c:v>
                </c:pt>
                <c:pt idx="1786">
                  <c:v>414.75938588569198</c:v>
                </c:pt>
                <c:pt idx="1787">
                  <c:v>414.99161398529202</c:v>
                </c:pt>
                <c:pt idx="1788">
                  <c:v>415.223842084892</c:v>
                </c:pt>
                <c:pt idx="1789">
                  <c:v>415.45607018449198</c:v>
                </c:pt>
                <c:pt idx="1790">
                  <c:v>415.68829828409201</c:v>
                </c:pt>
                <c:pt idx="1791">
                  <c:v>415.92052638369199</c:v>
                </c:pt>
                <c:pt idx="1792">
                  <c:v>416.15275448329197</c:v>
                </c:pt>
                <c:pt idx="1793">
                  <c:v>416.38498258289297</c:v>
                </c:pt>
                <c:pt idx="1794">
                  <c:v>416.61721068249301</c:v>
                </c:pt>
                <c:pt idx="1795">
                  <c:v>416.84943878209299</c:v>
                </c:pt>
                <c:pt idx="1796">
                  <c:v>417.08166688169302</c:v>
                </c:pt>
                <c:pt idx="1797">
                  <c:v>417.313894981293</c:v>
                </c:pt>
                <c:pt idx="1798">
                  <c:v>417.54612308089298</c:v>
                </c:pt>
                <c:pt idx="1799">
                  <c:v>417.77835118049302</c:v>
                </c:pt>
                <c:pt idx="1800">
                  <c:v>418.010579280093</c:v>
                </c:pt>
                <c:pt idx="1801">
                  <c:v>418.24280737969298</c:v>
                </c:pt>
                <c:pt idx="1802">
                  <c:v>418.47503547929301</c:v>
                </c:pt>
                <c:pt idx="1803">
                  <c:v>418.70726357889299</c:v>
                </c:pt>
                <c:pt idx="1804">
                  <c:v>418.93949167849303</c:v>
                </c:pt>
                <c:pt idx="1805">
                  <c:v>419.17171977809301</c:v>
                </c:pt>
                <c:pt idx="1806">
                  <c:v>419.40394787769299</c:v>
                </c:pt>
                <c:pt idx="1807">
                  <c:v>419.63617597729302</c:v>
                </c:pt>
                <c:pt idx="1808">
                  <c:v>419.868404076893</c:v>
                </c:pt>
                <c:pt idx="1809">
                  <c:v>420.10063217649298</c:v>
                </c:pt>
                <c:pt idx="1810">
                  <c:v>420.33286027609302</c:v>
                </c:pt>
                <c:pt idx="1811">
                  <c:v>420.56508837569299</c:v>
                </c:pt>
                <c:pt idx="1812">
                  <c:v>420.797316475294</c:v>
                </c:pt>
                <c:pt idx="1813">
                  <c:v>421.02954457489398</c:v>
                </c:pt>
                <c:pt idx="1814">
                  <c:v>421.26177267449401</c:v>
                </c:pt>
                <c:pt idx="1815">
                  <c:v>421.49400077409399</c:v>
                </c:pt>
                <c:pt idx="1816">
                  <c:v>421.72622887369403</c:v>
                </c:pt>
                <c:pt idx="1817">
                  <c:v>421.95845697329401</c:v>
                </c:pt>
                <c:pt idx="1818">
                  <c:v>422.19068507289398</c:v>
                </c:pt>
                <c:pt idx="1819">
                  <c:v>422.42291317249402</c:v>
                </c:pt>
                <c:pt idx="1820">
                  <c:v>422.655141272094</c:v>
                </c:pt>
                <c:pt idx="1821">
                  <c:v>422.88736937169398</c:v>
                </c:pt>
                <c:pt idx="1822">
                  <c:v>423.11959747129401</c:v>
                </c:pt>
                <c:pt idx="1823">
                  <c:v>423.35182557089399</c:v>
                </c:pt>
                <c:pt idx="1824">
                  <c:v>423.58405367049397</c:v>
                </c:pt>
                <c:pt idx="1825">
                  <c:v>423.81628177009401</c:v>
                </c:pt>
                <c:pt idx="1826">
                  <c:v>424.04850986969399</c:v>
                </c:pt>
                <c:pt idx="1827">
                  <c:v>424.28073796929402</c:v>
                </c:pt>
                <c:pt idx="1828">
                  <c:v>424.512966068894</c:v>
                </c:pt>
                <c:pt idx="1829">
                  <c:v>424.74519416849398</c:v>
                </c:pt>
                <c:pt idx="1830">
                  <c:v>424.97742226809402</c:v>
                </c:pt>
                <c:pt idx="1831">
                  <c:v>425.20965036769502</c:v>
                </c:pt>
                <c:pt idx="1832">
                  <c:v>425.441878467295</c:v>
                </c:pt>
                <c:pt idx="1833">
                  <c:v>425.67410656689498</c:v>
                </c:pt>
                <c:pt idx="1834">
                  <c:v>425.90633466649501</c:v>
                </c:pt>
                <c:pt idx="1835">
                  <c:v>426.13856276609499</c:v>
                </c:pt>
                <c:pt idx="1836">
                  <c:v>426.37079086569503</c:v>
                </c:pt>
                <c:pt idx="1837">
                  <c:v>426.60301896529501</c:v>
                </c:pt>
                <c:pt idx="1838">
                  <c:v>426.83524706489499</c:v>
                </c:pt>
                <c:pt idx="1839">
                  <c:v>427.06747516449502</c:v>
                </c:pt>
                <c:pt idx="1840">
                  <c:v>427.299703264095</c:v>
                </c:pt>
                <c:pt idx="1841">
                  <c:v>427.53193136369498</c:v>
                </c:pt>
                <c:pt idx="1842">
                  <c:v>427.76415946329502</c:v>
                </c:pt>
                <c:pt idx="1843">
                  <c:v>427.99638756289499</c:v>
                </c:pt>
                <c:pt idx="1844">
                  <c:v>428.22861566249497</c:v>
                </c:pt>
                <c:pt idx="1845">
                  <c:v>428.46084376209501</c:v>
                </c:pt>
                <c:pt idx="1846">
                  <c:v>428.69307186169499</c:v>
                </c:pt>
                <c:pt idx="1847">
                  <c:v>428.92529996129502</c:v>
                </c:pt>
                <c:pt idx="1848">
                  <c:v>429.157528060895</c:v>
                </c:pt>
                <c:pt idx="1849">
                  <c:v>429.38975616049498</c:v>
                </c:pt>
                <c:pt idx="1850">
                  <c:v>429.62198426009502</c:v>
                </c:pt>
                <c:pt idx="1851">
                  <c:v>429.85421235969602</c:v>
                </c:pt>
                <c:pt idx="1852">
                  <c:v>430.086440459296</c:v>
                </c:pt>
                <c:pt idx="1853">
                  <c:v>430.31866855889598</c:v>
                </c:pt>
                <c:pt idx="1854">
                  <c:v>430.55089665849601</c:v>
                </c:pt>
                <c:pt idx="1855">
                  <c:v>430.78312475809599</c:v>
                </c:pt>
                <c:pt idx="1856">
                  <c:v>431.01535285769597</c:v>
                </c:pt>
                <c:pt idx="1857">
                  <c:v>431.24758095729601</c:v>
                </c:pt>
                <c:pt idx="1858">
                  <c:v>431.47980905689599</c:v>
                </c:pt>
                <c:pt idx="1859">
                  <c:v>431.71203715649602</c:v>
                </c:pt>
                <c:pt idx="1860">
                  <c:v>431.944265256096</c:v>
                </c:pt>
                <c:pt idx="1861">
                  <c:v>432.17649335569598</c:v>
                </c:pt>
                <c:pt idx="1862">
                  <c:v>432.40872145529602</c:v>
                </c:pt>
                <c:pt idx="1863">
                  <c:v>432.640949554896</c:v>
                </c:pt>
                <c:pt idx="1864">
                  <c:v>432.87317765449598</c:v>
                </c:pt>
                <c:pt idx="1865">
                  <c:v>433.10540575409601</c:v>
                </c:pt>
                <c:pt idx="1866">
                  <c:v>433.33763385369599</c:v>
                </c:pt>
                <c:pt idx="1867">
                  <c:v>433.56986195329603</c:v>
                </c:pt>
                <c:pt idx="1868">
                  <c:v>433.80209005289601</c:v>
                </c:pt>
                <c:pt idx="1869">
                  <c:v>434.03431815249598</c:v>
                </c:pt>
                <c:pt idx="1870">
                  <c:v>434.26654625209699</c:v>
                </c:pt>
                <c:pt idx="1871">
                  <c:v>434.49877435169702</c:v>
                </c:pt>
                <c:pt idx="1872">
                  <c:v>434.731002451297</c:v>
                </c:pt>
                <c:pt idx="1873">
                  <c:v>434.96323055089698</c:v>
                </c:pt>
                <c:pt idx="1874">
                  <c:v>435.19545865049702</c:v>
                </c:pt>
                <c:pt idx="1875">
                  <c:v>435.427686750097</c:v>
                </c:pt>
                <c:pt idx="1876">
                  <c:v>435.65991484969697</c:v>
                </c:pt>
                <c:pt idx="1877">
                  <c:v>435.89214294929701</c:v>
                </c:pt>
                <c:pt idx="1878">
                  <c:v>436.12437104889699</c:v>
                </c:pt>
                <c:pt idx="1879">
                  <c:v>436.35659914849703</c:v>
                </c:pt>
                <c:pt idx="1880">
                  <c:v>436.588827248097</c:v>
                </c:pt>
                <c:pt idx="1881">
                  <c:v>436.82105534769698</c:v>
                </c:pt>
                <c:pt idx="1882">
                  <c:v>437.05328344729702</c:v>
                </c:pt>
                <c:pt idx="1883">
                  <c:v>437.285511546897</c:v>
                </c:pt>
                <c:pt idx="1884">
                  <c:v>437.51773964649698</c:v>
                </c:pt>
                <c:pt idx="1885">
                  <c:v>437.74996774609701</c:v>
                </c:pt>
                <c:pt idx="1886">
                  <c:v>437.98219584569699</c:v>
                </c:pt>
                <c:pt idx="1887">
                  <c:v>438.21442394529703</c:v>
                </c:pt>
                <c:pt idx="1888">
                  <c:v>438.44665204489701</c:v>
                </c:pt>
                <c:pt idx="1889">
                  <c:v>438.67888014449699</c:v>
                </c:pt>
                <c:pt idx="1890">
                  <c:v>438.91110824409799</c:v>
                </c:pt>
                <c:pt idx="1891">
                  <c:v>439.14333634369802</c:v>
                </c:pt>
                <c:pt idx="1892">
                  <c:v>439.375564443298</c:v>
                </c:pt>
                <c:pt idx="1893">
                  <c:v>439.60779254289798</c:v>
                </c:pt>
                <c:pt idx="1894">
                  <c:v>439.84002064249802</c:v>
                </c:pt>
                <c:pt idx="1895">
                  <c:v>440.072248742098</c:v>
                </c:pt>
                <c:pt idx="1896">
                  <c:v>440.30447684169798</c:v>
                </c:pt>
                <c:pt idx="1897">
                  <c:v>440.53670494129801</c:v>
                </c:pt>
                <c:pt idx="1898">
                  <c:v>440.76893304089799</c:v>
                </c:pt>
                <c:pt idx="1899">
                  <c:v>441.00116114049803</c:v>
                </c:pt>
                <c:pt idx="1900">
                  <c:v>441.23338924009801</c:v>
                </c:pt>
                <c:pt idx="1901">
                  <c:v>441.46561733969799</c:v>
                </c:pt>
                <c:pt idx="1902">
                  <c:v>441.69784543929802</c:v>
                </c:pt>
                <c:pt idx="1903">
                  <c:v>441.930073538898</c:v>
                </c:pt>
                <c:pt idx="1904">
                  <c:v>442.16230163849798</c:v>
                </c:pt>
                <c:pt idx="1905">
                  <c:v>442.39452973809802</c:v>
                </c:pt>
                <c:pt idx="1906">
                  <c:v>442.62675783769799</c:v>
                </c:pt>
                <c:pt idx="1907">
                  <c:v>442.85898593729797</c:v>
                </c:pt>
                <c:pt idx="1908">
                  <c:v>443.09121403689801</c:v>
                </c:pt>
                <c:pt idx="1909">
                  <c:v>443.32344213649901</c:v>
                </c:pt>
                <c:pt idx="1910">
                  <c:v>443.55567023609899</c:v>
                </c:pt>
                <c:pt idx="1911">
                  <c:v>443.78789833569903</c:v>
                </c:pt>
                <c:pt idx="1912">
                  <c:v>444.02012643529901</c:v>
                </c:pt>
                <c:pt idx="1913">
                  <c:v>444.25235453489898</c:v>
                </c:pt>
                <c:pt idx="1914">
                  <c:v>444.48458263449902</c:v>
                </c:pt>
                <c:pt idx="1915">
                  <c:v>444.716810734099</c:v>
                </c:pt>
                <c:pt idx="1916">
                  <c:v>444.94903883369898</c:v>
                </c:pt>
                <c:pt idx="1917">
                  <c:v>445.18126693329901</c:v>
                </c:pt>
                <c:pt idx="1918">
                  <c:v>445.41349503289899</c:v>
                </c:pt>
                <c:pt idx="1919">
                  <c:v>445.64572313249897</c:v>
                </c:pt>
                <c:pt idx="1920">
                  <c:v>445.87795123209901</c:v>
                </c:pt>
                <c:pt idx="1921">
                  <c:v>446.11017933169899</c:v>
                </c:pt>
                <c:pt idx="1922">
                  <c:v>446.34240743129902</c:v>
                </c:pt>
                <c:pt idx="1923">
                  <c:v>446.574635530899</c:v>
                </c:pt>
                <c:pt idx="1924">
                  <c:v>446.80686363049898</c:v>
                </c:pt>
                <c:pt idx="1925">
                  <c:v>447.03909173009902</c:v>
                </c:pt>
                <c:pt idx="1926">
                  <c:v>447.271319829699</c:v>
                </c:pt>
                <c:pt idx="1927">
                  <c:v>447.50354792929897</c:v>
                </c:pt>
                <c:pt idx="1928">
                  <c:v>447.73577602889998</c:v>
                </c:pt>
                <c:pt idx="1929">
                  <c:v>447.96800412850001</c:v>
                </c:pt>
                <c:pt idx="1930">
                  <c:v>448.20023222809999</c:v>
                </c:pt>
                <c:pt idx="1931">
                  <c:v>448.43246032770003</c:v>
                </c:pt>
                <c:pt idx="1932">
                  <c:v>448.66468842730001</c:v>
                </c:pt>
                <c:pt idx="1933">
                  <c:v>448.89691652689999</c:v>
                </c:pt>
                <c:pt idx="1934">
                  <c:v>449.12914462650002</c:v>
                </c:pt>
                <c:pt idx="1935">
                  <c:v>449.3613727261</c:v>
                </c:pt>
                <c:pt idx="1936">
                  <c:v>449.59360082569998</c:v>
                </c:pt>
                <c:pt idx="1937">
                  <c:v>449.82582892530002</c:v>
                </c:pt>
                <c:pt idx="1938">
                  <c:v>450.05805702489999</c:v>
                </c:pt>
                <c:pt idx="1939">
                  <c:v>450.29028512449997</c:v>
                </c:pt>
                <c:pt idx="1940">
                  <c:v>450.52251322410001</c:v>
                </c:pt>
                <c:pt idx="1941">
                  <c:v>450.75474132369999</c:v>
                </c:pt>
                <c:pt idx="1942">
                  <c:v>450.98696942330002</c:v>
                </c:pt>
                <c:pt idx="1943">
                  <c:v>451.2191975229</c:v>
                </c:pt>
                <c:pt idx="1944">
                  <c:v>451.45142562249998</c:v>
                </c:pt>
                <c:pt idx="1945">
                  <c:v>451.68365372210002</c:v>
                </c:pt>
                <c:pt idx="1946">
                  <c:v>451.9158818217</c:v>
                </c:pt>
                <c:pt idx="1947">
                  <c:v>452.14810992129998</c:v>
                </c:pt>
                <c:pt idx="1948">
                  <c:v>452.38033802090098</c:v>
                </c:pt>
                <c:pt idx="1949">
                  <c:v>452.61256612050101</c:v>
                </c:pt>
                <c:pt idx="1950">
                  <c:v>452.84479422010099</c:v>
                </c:pt>
                <c:pt idx="1951">
                  <c:v>453.07702231970097</c:v>
                </c:pt>
                <c:pt idx="1952">
                  <c:v>453.30925041930101</c:v>
                </c:pt>
                <c:pt idx="1953">
                  <c:v>453.54147851890099</c:v>
                </c:pt>
                <c:pt idx="1954">
                  <c:v>453.77370661850102</c:v>
                </c:pt>
                <c:pt idx="1955">
                  <c:v>454.005934718101</c:v>
                </c:pt>
                <c:pt idx="1956">
                  <c:v>454.23816281770098</c:v>
                </c:pt>
                <c:pt idx="1957">
                  <c:v>454.47039091730102</c:v>
                </c:pt>
                <c:pt idx="1958">
                  <c:v>454.702619016901</c:v>
                </c:pt>
                <c:pt idx="1959">
                  <c:v>454.93484711650098</c:v>
                </c:pt>
                <c:pt idx="1960">
                  <c:v>455.16707521610101</c:v>
                </c:pt>
                <c:pt idx="1961">
                  <c:v>455.39930331570099</c:v>
                </c:pt>
                <c:pt idx="1962">
                  <c:v>455.63153141530103</c:v>
                </c:pt>
                <c:pt idx="1963">
                  <c:v>455.86375951490101</c:v>
                </c:pt>
                <c:pt idx="1964">
                  <c:v>456.09598761450098</c:v>
                </c:pt>
                <c:pt idx="1965">
                  <c:v>456.32821571410102</c:v>
                </c:pt>
                <c:pt idx="1966">
                  <c:v>456.560443813701</c:v>
                </c:pt>
                <c:pt idx="1967">
                  <c:v>456.792671913302</c:v>
                </c:pt>
                <c:pt idx="1968">
                  <c:v>457.02490001290198</c:v>
                </c:pt>
                <c:pt idx="1969">
                  <c:v>457.25712811250202</c:v>
                </c:pt>
                <c:pt idx="1970">
                  <c:v>457.489356212102</c:v>
                </c:pt>
                <c:pt idx="1971">
                  <c:v>457.72158431170197</c:v>
                </c:pt>
                <c:pt idx="1972">
                  <c:v>457.95381241130201</c:v>
                </c:pt>
                <c:pt idx="1973">
                  <c:v>458.18604051090199</c:v>
                </c:pt>
                <c:pt idx="1974">
                  <c:v>458.41826861050203</c:v>
                </c:pt>
                <c:pt idx="1975">
                  <c:v>458.650496710102</c:v>
                </c:pt>
                <c:pt idx="1976">
                  <c:v>458.88272480970198</c:v>
                </c:pt>
                <c:pt idx="1977">
                  <c:v>459.11495290930202</c:v>
                </c:pt>
                <c:pt idx="1978">
                  <c:v>459.347181008902</c:v>
                </c:pt>
                <c:pt idx="1979">
                  <c:v>459.57940910850198</c:v>
                </c:pt>
                <c:pt idx="1980">
                  <c:v>459.81163720810201</c:v>
                </c:pt>
                <c:pt idx="1981">
                  <c:v>460.04386530770199</c:v>
                </c:pt>
                <c:pt idx="1982">
                  <c:v>460.27609340730203</c:v>
                </c:pt>
                <c:pt idx="1983">
                  <c:v>460.50832150690201</c:v>
                </c:pt>
                <c:pt idx="1984">
                  <c:v>460.74054960650199</c:v>
                </c:pt>
                <c:pt idx="1985">
                  <c:v>460.97277770610202</c:v>
                </c:pt>
                <c:pt idx="1986">
                  <c:v>461.20500580570302</c:v>
                </c:pt>
                <c:pt idx="1987">
                  <c:v>461.437233905303</c:v>
                </c:pt>
                <c:pt idx="1988">
                  <c:v>461.66946200490298</c:v>
                </c:pt>
                <c:pt idx="1989">
                  <c:v>461.90169010450302</c:v>
                </c:pt>
                <c:pt idx="1990">
                  <c:v>462.133918204103</c:v>
                </c:pt>
                <c:pt idx="1991">
                  <c:v>462.36614630370298</c:v>
                </c:pt>
                <c:pt idx="1992">
                  <c:v>462.59837440330301</c:v>
                </c:pt>
                <c:pt idx="1993">
                  <c:v>462.83060250290299</c:v>
                </c:pt>
                <c:pt idx="1994">
                  <c:v>463.06283060250303</c:v>
                </c:pt>
                <c:pt idx="1995">
                  <c:v>463.29505870210301</c:v>
                </c:pt>
                <c:pt idx="1996">
                  <c:v>463.52728680170299</c:v>
                </c:pt>
                <c:pt idx="1997">
                  <c:v>463.75951490130302</c:v>
                </c:pt>
                <c:pt idx="1998">
                  <c:v>463.991743000903</c:v>
                </c:pt>
                <c:pt idx="1999">
                  <c:v>464.22397110050298</c:v>
                </c:pt>
                <c:pt idx="2000">
                  <c:v>464.45619920010301</c:v>
                </c:pt>
                <c:pt idx="2001">
                  <c:v>464.68842729970299</c:v>
                </c:pt>
                <c:pt idx="2002">
                  <c:v>464.92065539930297</c:v>
                </c:pt>
                <c:pt idx="2003">
                  <c:v>465.15288349890301</c:v>
                </c:pt>
                <c:pt idx="2004">
                  <c:v>465.38511159850299</c:v>
                </c:pt>
                <c:pt idx="2005">
                  <c:v>465.61733969810302</c:v>
                </c:pt>
                <c:pt idx="2006">
                  <c:v>465.84956779770403</c:v>
                </c:pt>
                <c:pt idx="2007">
                  <c:v>466.081795897304</c:v>
                </c:pt>
                <c:pt idx="2008">
                  <c:v>466.31402399690398</c:v>
                </c:pt>
                <c:pt idx="2009">
                  <c:v>466.54625209650402</c:v>
                </c:pt>
                <c:pt idx="2010">
                  <c:v>466.778480196104</c:v>
                </c:pt>
                <c:pt idx="2011">
                  <c:v>467.01070829570398</c:v>
                </c:pt>
                <c:pt idx="2012">
                  <c:v>467.24293639530401</c:v>
                </c:pt>
                <c:pt idx="2013">
                  <c:v>467.47516449490399</c:v>
                </c:pt>
                <c:pt idx="2014">
                  <c:v>467.70739259450397</c:v>
                </c:pt>
                <c:pt idx="2015">
                  <c:v>467.93962069410401</c:v>
                </c:pt>
                <c:pt idx="2016">
                  <c:v>468.17184879370399</c:v>
                </c:pt>
                <c:pt idx="2017">
                  <c:v>468.40407689330402</c:v>
                </c:pt>
                <c:pt idx="2018">
                  <c:v>468.636304992904</c:v>
                </c:pt>
                <c:pt idx="2019">
                  <c:v>468.86853309250398</c:v>
                </c:pt>
                <c:pt idx="2020">
                  <c:v>469.10076119210402</c:v>
                </c:pt>
                <c:pt idx="2021">
                  <c:v>469.332989291704</c:v>
                </c:pt>
                <c:pt idx="2022">
                  <c:v>469.56521739130397</c:v>
                </c:pt>
                <c:pt idx="2023">
                  <c:v>469.79744549090401</c:v>
                </c:pt>
                <c:pt idx="2024">
                  <c:v>470.02967359050399</c:v>
                </c:pt>
                <c:pt idx="2025">
                  <c:v>470.26190169010499</c:v>
                </c:pt>
                <c:pt idx="2026">
                  <c:v>470.49412978970503</c:v>
                </c:pt>
                <c:pt idx="2027">
                  <c:v>470.72635788930501</c:v>
                </c:pt>
                <c:pt idx="2028">
                  <c:v>470.95858598890499</c:v>
                </c:pt>
                <c:pt idx="2029">
                  <c:v>471.19081408850502</c:v>
                </c:pt>
                <c:pt idx="2030">
                  <c:v>471.423042188105</c:v>
                </c:pt>
                <c:pt idx="2031">
                  <c:v>471.65527028770498</c:v>
                </c:pt>
                <c:pt idx="2032">
                  <c:v>471.88749838730502</c:v>
                </c:pt>
                <c:pt idx="2033">
                  <c:v>472.11972648690499</c:v>
                </c:pt>
                <c:pt idx="2034">
                  <c:v>472.35195458650497</c:v>
                </c:pt>
                <c:pt idx="2035">
                  <c:v>472.58418268610501</c:v>
                </c:pt>
                <c:pt idx="2036">
                  <c:v>472.81641078570499</c:v>
                </c:pt>
                <c:pt idx="2037">
                  <c:v>473.04863888530502</c:v>
                </c:pt>
                <c:pt idx="2038">
                  <c:v>473.280866984905</c:v>
                </c:pt>
                <c:pt idx="2039">
                  <c:v>473.51309508450498</c:v>
                </c:pt>
                <c:pt idx="2040">
                  <c:v>473.74532318410502</c:v>
                </c:pt>
                <c:pt idx="2041">
                  <c:v>473.977551283705</c:v>
                </c:pt>
                <c:pt idx="2042">
                  <c:v>474.20977938330498</c:v>
                </c:pt>
                <c:pt idx="2043">
                  <c:v>474.44200748290501</c:v>
                </c:pt>
                <c:pt idx="2044">
                  <c:v>474.67423558250601</c:v>
                </c:pt>
                <c:pt idx="2045">
                  <c:v>474.90646368210599</c:v>
                </c:pt>
                <c:pt idx="2046">
                  <c:v>475.13869178170597</c:v>
                </c:pt>
                <c:pt idx="2047">
                  <c:v>475.37091988130601</c:v>
                </c:pt>
                <c:pt idx="2048">
                  <c:v>475.60314798090599</c:v>
                </c:pt>
                <c:pt idx="2049">
                  <c:v>475.83537608050602</c:v>
                </c:pt>
                <c:pt idx="2050">
                  <c:v>476.067604180106</c:v>
                </c:pt>
                <c:pt idx="2051">
                  <c:v>476.29983227970598</c:v>
                </c:pt>
                <c:pt idx="2052">
                  <c:v>476.53206037930602</c:v>
                </c:pt>
                <c:pt idx="2053">
                  <c:v>476.764288478906</c:v>
                </c:pt>
                <c:pt idx="2054">
                  <c:v>476.99651657850598</c:v>
                </c:pt>
                <c:pt idx="2055">
                  <c:v>477.22874467810601</c:v>
                </c:pt>
                <c:pt idx="2056">
                  <c:v>477.46097277770599</c:v>
                </c:pt>
                <c:pt idx="2057">
                  <c:v>477.69320087730603</c:v>
                </c:pt>
                <c:pt idx="2058">
                  <c:v>477.92542897690601</c:v>
                </c:pt>
                <c:pt idx="2059">
                  <c:v>478.15765707650598</c:v>
                </c:pt>
                <c:pt idx="2060">
                  <c:v>478.38988517610602</c:v>
                </c:pt>
                <c:pt idx="2061">
                  <c:v>478.622113275706</c:v>
                </c:pt>
                <c:pt idx="2062">
                  <c:v>478.85434137530598</c:v>
                </c:pt>
                <c:pt idx="2063">
                  <c:v>479.08656947490601</c:v>
                </c:pt>
                <c:pt idx="2064">
                  <c:v>479.31879757450702</c:v>
                </c:pt>
                <c:pt idx="2065">
                  <c:v>479.551025674107</c:v>
                </c:pt>
                <c:pt idx="2066">
                  <c:v>479.78325377370697</c:v>
                </c:pt>
                <c:pt idx="2067">
                  <c:v>480.01548187330701</c:v>
                </c:pt>
                <c:pt idx="2068">
                  <c:v>480.24770997290699</c:v>
                </c:pt>
                <c:pt idx="2069">
                  <c:v>480.47993807250703</c:v>
                </c:pt>
                <c:pt idx="2070">
                  <c:v>480.712166172107</c:v>
                </c:pt>
                <c:pt idx="2071">
                  <c:v>480.94439427170698</c:v>
                </c:pt>
                <c:pt idx="2072">
                  <c:v>481.17662237130702</c:v>
                </c:pt>
                <c:pt idx="2073">
                  <c:v>481.408850470907</c:v>
                </c:pt>
                <c:pt idx="2074">
                  <c:v>481.64107857050698</c:v>
                </c:pt>
                <c:pt idx="2075">
                  <c:v>481.87330667010701</c:v>
                </c:pt>
                <c:pt idx="2076">
                  <c:v>482.10553476970699</c:v>
                </c:pt>
                <c:pt idx="2077">
                  <c:v>482.33776286930703</c:v>
                </c:pt>
                <c:pt idx="2078">
                  <c:v>482.56999096890701</c:v>
                </c:pt>
                <c:pt idx="2079">
                  <c:v>482.80221906850699</c:v>
                </c:pt>
                <c:pt idx="2080">
                  <c:v>483.03444716810702</c:v>
                </c:pt>
                <c:pt idx="2081">
                  <c:v>483.266675267707</c:v>
                </c:pt>
                <c:pt idx="2082">
                  <c:v>483.49890336730698</c:v>
                </c:pt>
                <c:pt idx="2083">
                  <c:v>483.73113146690798</c:v>
                </c:pt>
                <c:pt idx="2084">
                  <c:v>483.96335956650802</c:v>
                </c:pt>
                <c:pt idx="2085">
                  <c:v>484.195587666108</c:v>
                </c:pt>
                <c:pt idx="2086">
                  <c:v>484.42781576570798</c:v>
                </c:pt>
                <c:pt idx="2087">
                  <c:v>484.66004386530801</c:v>
                </c:pt>
                <c:pt idx="2088">
                  <c:v>484.89227196490799</c:v>
                </c:pt>
                <c:pt idx="2089">
                  <c:v>485.12450006450803</c:v>
                </c:pt>
                <c:pt idx="2090">
                  <c:v>485.35672816410801</c:v>
                </c:pt>
                <c:pt idx="2091">
                  <c:v>485.58895626370798</c:v>
                </c:pt>
                <c:pt idx="2092">
                  <c:v>485.82118436330802</c:v>
                </c:pt>
                <c:pt idx="2093">
                  <c:v>486.053412462908</c:v>
                </c:pt>
                <c:pt idx="2094">
                  <c:v>486.28564056250798</c:v>
                </c:pt>
                <c:pt idx="2095">
                  <c:v>486.51786866210801</c:v>
                </c:pt>
                <c:pt idx="2096">
                  <c:v>486.75009676170799</c:v>
                </c:pt>
                <c:pt idx="2097">
                  <c:v>486.98232486130797</c:v>
                </c:pt>
                <c:pt idx="2098">
                  <c:v>487.21455296090801</c:v>
                </c:pt>
                <c:pt idx="2099">
                  <c:v>487.44678106050799</c:v>
                </c:pt>
                <c:pt idx="2100">
                  <c:v>487.67900916010802</c:v>
                </c:pt>
                <c:pt idx="2101">
                  <c:v>487.911237259708</c:v>
                </c:pt>
                <c:pt idx="2102">
                  <c:v>488.14346535930798</c:v>
                </c:pt>
                <c:pt idx="2103">
                  <c:v>488.37569345890898</c:v>
                </c:pt>
                <c:pt idx="2104">
                  <c:v>488.60792155850902</c:v>
                </c:pt>
                <c:pt idx="2105">
                  <c:v>488.840149658109</c:v>
                </c:pt>
                <c:pt idx="2106">
                  <c:v>489.07237775770898</c:v>
                </c:pt>
                <c:pt idx="2107">
                  <c:v>489.30460585730901</c:v>
                </c:pt>
                <c:pt idx="2108">
                  <c:v>489.53683395690899</c:v>
                </c:pt>
                <c:pt idx="2109">
                  <c:v>489.76906205650897</c:v>
                </c:pt>
                <c:pt idx="2110">
                  <c:v>490.00129015610901</c:v>
                </c:pt>
                <c:pt idx="2111">
                  <c:v>490.23351825570899</c:v>
                </c:pt>
                <c:pt idx="2112">
                  <c:v>490.46574635530902</c:v>
                </c:pt>
                <c:pt idx="2113">
                  <c:v>490.697974454909</c:v>
                </c:pt>
                <c:pt idx="2114">
                  <c:v>490.93020255450898</c:v>
                </c:pt>
                <c:pt idx="2115">
                  <c:v>491.16243065410902</c:v>
                </c:pt>
                <c:pt idx="2116">
                  <c:v>491.394658753709</c:v>
                </c:pt>
                <c:pt idx="2117">
                  <c:v>491.62688685330897</c:v>
                </c:pt>
                <c:pt idx="2118">
                  <c:v>491.85911495290901</c:v>
                </c:pt>
                <c:pt idx="2119">
                  <c:v>492.09134305250899</c:v>
                </c:pt>
                <c:pt idx="2120">
                  <c:v>492.32357115210903</c:v>
                </c:pt>
                <c:pt idx="2121">
                  <c:v>492.555799251709</c:v>
                </c:pt>
                <c:pt idx="2122">
                  <c:v>492.78802735130898</c:v>
                </c:pt>
                <c:pt idx="2123">
                  <c:v>493.02025545090999</c:v>
                </c:pt>
                <c:pt idx="2124">
                  <c:v>493.25248355051002</c:v>
                </c:pt>
                <c:pt idx="2125">
                  <c:v>493.48471165011</c:v>
                </c:pt>
                <c:pt idx="2126">
                  <c:v>493.71693974970998</c:v>
                </c:pt>
                <c:pt idx="2127">
                  <c:v>493.94916784931002</c:v>
                </c:pt>
                <c:pt idx="2128">
                  <c:v>494.18139594890999</c:v>
                </c:pt>
                <c:pt idx="2129">
                  <c:v>494.41362404850997</c:v>
                </c:pt>
                <c:pt idx="2130">
                  <c:v>494.64585214811001</c:v>
                </c:pt>
                <c:pt idx="2131">
                  <c:v>494.87808024770999</c:v>
                </c:pt>
                <c:pt idx="2132">
                  <c:v>495.11030834731002</c:v>
                </c:pt>
                <c:pt idx="2133">
                  <c:v>495.34253644691</c:v>
                </c:pt>
                <c:pt idx="2134">
                  <c:v>495.57476454650998</c:v>
                </c:pt>
                <c:pt idx="2135">
                  <c:v>495.80699264611002</c:v>
                </c:pt>
                <c:pt idx="2136">
                  <c:v>496.03922074571</c:v>
                </c:pt>
                <c:pt idx="2137">
                  <c:v>496.27144884530998</c:v>
                </c:pt>
                <c:pt idx="2138">
                  <c:v>496.50367694491001</c:v>
                </c:pt>
                <c:pt idx="2139">
                  <c:v>496.73590504450999</c:v>
                </c:pt>
                <c:pt idx="2140">
                  <c:v>496.96813314411003</c:v>
                </c:pt>
                <c:pt idx="2141">
                  <c:v>497.20036124371097</c:v>
                </c:pt>
                <c:pt idx="2142">
                  <c:v>497.43258934331101</c:v>
                </c:pt>
                <c:pt idx="2143">
                  <c:v>497.66481744291099</c:v>
                </c:pt>
                <c:pt idx="2144">
                  <c:v>497.89704554251102</c:v>
                </c:pt>
                <c:pt idx="2145">
                  <c:v>498.129273642111</c:v>
                </c:pt>
                <c:pt idx="2146">
                  <c:v>498.36150174171098</c:v>
                </c:pt>
                <c:pt idx="2147">
                  <c:v>498.59372984131102</c:v>
                </c:pt>
                <c:pt idx="2148">
                  <c:v>498.825957940911</c:v>
                </c:pt>
                <c:pt idx="2149">
                  <c:v>499.05818604051098</c:v>
                </c:pt>
                <c:pt idx="2150">
                  <c:v>499.29041414011101</c:v>
                </c:pt>
                <c:pt idx="2151">
                  <c:v>499.52264223971099</c:v>
                </c:pt>
                <c:pt idx="2152">
                  <c:v>499.75487033931103</c:v>
                </c:pt>
                <c:pt idx="2153">
                  <c:v>499.987098438911</c:v>
                </c:pt>
                <c:pt idx="2154">
                  <c:v>500.21932653851098</c:v>
                </c:pt>
                <c:pt idx="2155">
                  <c:v>500.45155463811102</c:v>
                </c:pt>
                <c:pt idx="2156">
                  <c:v>500.683782737711</c:v>
                </c:pt>
                <c:pt idx="2157">
                  <c:v>500.91601083731098</c:v>
                </c:pt>
                <c:pt idx="2158">
                  <c:v>501.14823893691101</c:v>
                </c:pt>
                <c:pt idx="2159">
                  <c:v>501.38046703651099</c:v>
                </c:pt>
                <c:pt idx="2160">
                  <c:v>501.61269513611097</c:v>
                </c:pt>
                <c:pt idx="2161">
                  <c:v>501.84492323571197</c:v>
                </c:pt>
                <c:pt idx="2162">
                  <c:v>502.07715133531201</c:v>
                </c:pt>
                <c:pt idx="2163">
                  <c:v>502.30937943491199</c:v>
                </c:pt>
                <c:pt idx="2164">
                  <c:v>502.54160753451202</c:v>
                </c:pt>
                <c:pt idx="2165">
                  <c:v>502.773835634112</c:v>
                </c:pt>
                <c:pt idx="2166">
                  <c:v>503.00606373371198</c:v>
                </c:pt>
                <c:pt idx="2167">
                  <c:v>503.23829183331202</c:v>
                </c:pt>
                <c:pt idx="2168">
                  <c:v>503.470519932912</c:v>
                </c:pt>
                <c:pt idx="2169">
                  <c:v>503.70274803251198</c:v>
                </c:pt>
                <c:pt idx="2170">
                  <c:v>503.93497613211201</c:v>
                </c:pt>
                <c:pt idx="2171">
                  <c:v>504.16720423171199</c:v>
                </c:pt>
                <c:pt idx="2172">
                  <c:v>504.39943233131203</c:v>
                </c:pt>
                <c:pt idx="2173">
                  <c:v>504.63166043091201</c:v>
                </c:pt>
                <c:pt idx="2174">
                  <c:v>504.86388853051199</c:v>
                </c:pt>
                <c:pt idx="2175">
                  <c:v>505.09611663011202</c:v>
                </c:pt>
                <c:pt idx="2176">
                  <c:v>505.328344729712</c:v>
                </c:pt>
                <c:pt idx="2177">
                  <c:v>505.56057282931198</c:v>
                </c:pt>
                <c:pt idx="2178">
                  <c:v>505.79280092891202</c:v>
                </c:pt>
                <c:pt idx="2179">
                  <c:v>506.02502902851199</c:v>
                </c:pt>
                <c:pt idx="2180">
                  <c:v>506.257257128113</c:v>
                </c:pt>
                <c:pt idx="2181">
                  <c:v>506.48948522771298</c:v>
                </c:pt>
                <c:pt idx="2182">
                  <c:v>506.72171332731301</c:v>
                </c:pt>
                <c:pt idx="2183">
                  <c:v>506.95394142691299</c:v>
                </c:pt>
                <c:pt idx="2184">
                  <c:v>507.18616952651303</c:v>
                </c:pt>
                <c:pt idx="2185">
                  <c:v>507.41839762611301</c:v>
                </c:pt>
                <c:pt idx="2186">
                  <c:v>507.65062572571298</c:v>
                </c:pt>
                <c:pt idx="2187">
                  <c:v>507.88285382531302</c:v>
                </c:pt>
                <c:pt idx="2188">
                  <c:v>508.115081924913</c:v>
                </c:pt>
                <c:pt idx="2189">
                  <c:v>508.34731002451298</c:v>
                </c:pt>
                <c:pt idx="2190">
                  <c:v>508.57953812411301</c:v>
                </c:pt>
                <c:pt idx="2191">
                  <c:v>508.81176622371299</c:v>
                </c:pt>
                <c:pt idx="2192">
                  <c:v>509.04399432331297</c:v>
                </c:pt>
                <c:pt idx="2193">
                  <c:v>509.27622242291301</c:v>
                </c:pt>
                <c:pt idx="2194">
                  <c:v>509.50845052251299</c:v>
                </c:pt>
                <c:pt idx="2195">
                  <c:v>509.74067862211302</c:v>
                </c:pt>
                <c:pt idx="2196">
                  <c:v>509.972906721713</c:v>
                </c:pt>
                <c:pt idx="2197">
                  <c:v>510.20513482131298</c:v>
                </c:pt>
                <c:pt idx="2198">
                  <c:v>510.43736292091302</c:v>
                </c:pt>
                <c:pt idx="2199">
                  <c:v>510.66959102051402</c:v>
                </c:pt>
                <c:pt idx="2200">
                  <c:v>510.901819120114</c:v>
                </c:pt>
                <c:pt idx="2201">
                  <c:v>511.13404721971398</c:v>
                </c:pt>
                <c:pt idx="2202">
                  <c:v>511.36627531931401</c:v>
                </c:pt>
                <c:pt idx="2203">
                  <c:v>511.59850341891399</c:v>
                </c:pt>
                <c:pt idx="2204">
                  <c:v>511.83073151851403</c:v>
                </c:pt>
                <c:pt idx="2205">
                  <c:v>512.06295961811395</c:v>
                </c:pt>
                <c:pt idx="2206">
                  <c:v>512.29518771771404</c:v>
                </c:pt>
                <c:pt idx="2207">
                  <c:v>512.52741581731402</c:v>
                </c:pt>
                <c:pt idx="2208">
                  <c:v>512.759643916914</c:v>
                </c:pt>
                <c:pt idx="2209">
                  <c:v>512.99187201651398</c:v>
                </c:pt>
                <c:pt idx="2210">
                  <c:v>513.22410011611396</c:v>
                </c:pt>
                <c:pt idx="2211">
                  <c:v>513.45632821571405</c:v>
                </c:pt>
                <c:pt idx="2212">
                  <c:v>513.68855631531403</c:v>
                </c:pt>
                <c:pt idx="2213">
                  <c:v>513.92078441491401</c:v>
                </c:pt>
                <c:pt idx="2214">
                  <c:v>514.15301251451399</c:v>
                </c:pt>
                <c:pt idx="2215">
                  <c:v>514.38524061411397</c:v>
                </c:pt>
                <c:pt idx="2216">
                  <c:v>514.61746871371395</c:v>
                </c:pt>
                <c:pt idx="2217">
                  <c:v>514.84969681331404</c:v>
                </c:pt>
                <c:pt idx="2218">
                  <c:v>515.08192491291402</c:v>
                </c:pt>
                <c:pt idx="2219">
                  <c:v>515.31415301251502</c:v>
                </c:pt>
                <c:pt idx="2220">
                  <c:v>515.546381112115</c:v>
                </c:pt>
                <c:pt idx="2221">
                  <c:v>515.77860921171498</c:v>
                </c:pt>
                <c:pt idx="2222">
                  <c:v>516.01083731131496</c:v>
                </c:pt>
                <c:pt idx="2223">
                  <c:v>516.24306541091505</c:v>
                </c:pt>
                <c:pt idx="2224">
                  <c:v>516.47529351051503</c:v>
                </c:pt>
                <c:pt idx="2225">
                  <c:v>516.70752161011501</c:v>
                </c:pt>
                <c:pt idx="2226">
                  <c:v>516.93974970971499</c:v>
                </c:pt>
                <c:pt idx="2227">
                  <c:v>517.17197780931497</c:v>
                </c:pt>
                <c:pt idx="2228">
                  <c:v>517.40420590891495</c:v>
                </c:pt>
                <c:pt idx="2229">
                  <c:v>517.63643400851504</c:v>
                </c:pt>
                <c:pt idx="2230">
                  <c:v>517.86866210811502</c:v>
                </c:pt>
                <c:pt idx="2231">
                  <c:v>518.100890207715</c:v>
                </c:pt>
                <c:pt idx="2232">
                  <c:v>518.33311830731498</c:v>
                </c:pt>
                <c:pt idx="2233">
                  <c:v>518.56534640691495</c:v>
                </c:pt>
                <c:pt idx="2234">
                  <c:v>518.79757450651505</c:v>
                </c:pt>
                <c:pt idx="2235">
                  <c:v>519.02980260611503</c:v>
                </c:pt>
                <c:pt idx="2236">
                  <c:v>519.26203070571501</c:v>
                </c:pt>
                <c:pt idx="2237">
                  <c:v>519.49425880531498</c:v>
                </c:pt>
                <c:pt idx="2238">
                  <c:v>519.72648690491599</c:v>
                </c:pt>
                <c:pt idx="2239">
                  <c:v>519.95871500451597</c:v>
                </c:pt>
                <c:pt idx="2240">
                  <c:v>520.19094310411595</c:v>
                </c:pt>
                <c:pt idx="2241">
                  <c:v>520.42317120371604</c:v>
                </c:pt>
                <c:pt idx="2242">
                  <c:v>520.65539930331602</c:v>
                </c:pt>
                <c:pt idx="2243">
                  <c:v>520.887627402916</c:v>
                </c:pt>
                <c:pt idx="2244">
                  <c:v>521.11985550251597</c:v>
                </c:pt>
                <c:pt idx="2245">
                  <c:v>521.35208360211595</c:v>
                </c:pt>
                <c:pt idx="2246">
                  <c:v>521.58431170171605</c:v>
                </c:pt>
                <c:pt idx="2247">
                  <c:v>521.81653980131603</c:v>
                </c:pt>
                <c:pt idx="2248">
                  <c:v>522.048767900916</c:v>
                </c:pt>
                <c:pt idx="2249">
                  <c:v>522.28099600051598</c:v>
                </c:pt>
                <c:pt idx="2250">
                  <c:v>522.51322410011596</c:v>
                </c:pt>
                <c:pt idx="2251">
                  <c:v>522.74545219971606</c:v>
                </c:pt>
                <c:pt idx="2252">
                  <c:v>522.97768029931603</c:v>
                </c:pt>
                <c:pt idx="2253">
                  <c:v>523.20990839891601</c:v>
                </c:pt>
                <c:pt idx="2254">
                  <c:v>523.44213649851599</c:v>
                </c:pt>
                <c:pt idx="2255">
                  <c:v>523.67436459811597</c:v>
                </c:pt>
                <c:pt idx="2256">
                  <c:v>523.90659269771595</c:v>
                </c:pt>
                <c:pt idx="2257">
                  <c:v>524.13882079731604</c:v>
                </c:pt>
                <c:pt idx="2258">
                  <c:v>524.37104889691705</c:v>
                </c:pt>
                <c:pt idx="2259">
                  <c:v>524.60327699651702</c:v>
                </c:pt>
                <c:pt idx="2260">
                  <c:v>524.835505096117</c:v>
                </c:pt>
                <c:pt idx="2261">
                  <c:v>525.06773319571698</c:v>
                </c:pt>
                <c:pt idx="2262">
                  <c:v>525.29996129531696</c:v>
                </c:pt>
                <c:pt idx="2263">
                  <c:v>525.53218939491705</c:v>
                </c:pt>
                <c:pt idx="2264">
                  <c:v>525.76441749451703</c:v>
                </c:pt>
                <c:pt idx="2265">
                  <c:v>525.99664559411701</c:v>
                </c:pt>
                <c:pt idx="2266">
                  <c:v>526.22887369371699</c:v>
                </c:pt>
                <c:pt idx="2267">
                  <c:v>526.46110179331697</c:v>
                </c:pt>
                <c:pt idx="2268">
                  <c:v>526.69332989291695</c:v>
                </c:pt>
                <c:pt idx="2269">
                  <c:v>526.92555799251704</c:v>
                </c:pt>
                <c:pt idx="2270">
                  <c:v>527.15778609211702</c:v>
                </c:pt>
                <c:pt idx="2271">
                  <c:v>527.390014191717</c:v>
                </c:pt>
                <c:pt idx="2272">
                  <c:v>527.62224229131698</c:v>
                </c:pt>
                <c:pt idx="2273">
                  <c:v>527.85447039091696</c:v>
                </c:pt>
                <c:pt idx="2274">
                  <c:v>528.08669849051705</c:v>
                </c:pt>
                <c:pt idx="2275">
                  <c:v>528.31892659011703</c:v>
                </c:pt>
                <c:pt idx="2276">
                  <c:v>528.55115468971701</c:v>
                </c:pt>
                <c:pt idx="2277">
                  <c:v>528.78338278931801</c:v>
                </c:pt>
                <c:pt idx="2278">
                  <c:v>529.01561088891799</c:v>
                </c:pt>
                <c:pt idx="2279">
                  <c:v>529.24783898851797</c:v>
                </c:pt>
                <c:pt idx="2280">
                  <c:v>529.48006708811795</c:v>
                </c:pt>
                <c:pt idx="2281">
                  <c:v>529.71229518771804</c:v>
                </c:pt>
                <c:pt idx="2282">
                  <c:v>529.94452328731802</c:v>
                </c:pt>
                <c:pt idx="2283">
                  <c:v>530.176751386918</c:v>
                </c:pt>
                <c:pt idx="2284">
                  <c:v>530.40897948651798</c:v>
                </c:pt>
                <c:pt idx="2285">
                  <c:v>530.64120758611796</c:v>
                </c:pt>
                <c:pt idx="2286">
                  <c:v>530.87343568571805</c:v>
                </c:pt>
                <c:pt idx="2287">
                  <c:v>531.10566378531803</c:v>
                </c:pt>
                <c:pt idx="2288">
                  <c:v>531.33789188491801</c:v>
                </c:pt>
                <c:pt idx="2289">
                  <c:v>531.57011998451799</c:v>
                </c:pt>
                <c:pt idx="2290">
                  <c:v>531.80234808411797</c:v>
                </c:pt>
                <c:pt idx="2291">
                  <c:v>532.03457618371795</c:v>
                </c:pt>
                <c:pt idx="2292">
                  <c:v>532.26680428331804</c:v>
                </c:pt>
                <c:pt idx="2293">
                  <c:v>532.49903238291802</c:v>
                </c:pt>
                <c:pt idx="2294">
                  <c:v>532.731260482518</c:v>
                </c:pt>
                <c:pt idx="2295">
                  <c:v>532.96348858211798</c:v>
                </c:pt>
                <c:pt idx="2296">
                  <c:v>533.19571668171898</c:v>
                </c:pt>
                <c:pt idx="2297">
                  <c:v>533.42794478131896</c:v>
                </c:pt>
                <c:pt idx="2298">
                  <c:v>533.66017288091905</c:v>
                </c:pt>
                <c:pt idx="2299">
                  <c:v>533.89240098051903</c:v>
                </c:pt>
                <c:pt idx="2300">
                  <c:v>534.12462908011901</c:v>
                </c:pt>
                <c:pt idx="2301">
                  <c:v>534.35685717971899</c:v>
                </c:pt>
                <c:pt idx="2302">
                  <c:v>534.58908527931897</c:v>
                </c:pt>
                <c:pt idx="2303">
                  <c:v>534.82131337891894</c:v>
                </c:pt>
                <c:pt idx="2304">
                  <c:v>535.05354147851904</c:v>
                </c:pt>
                <c:pt idx="2305">
                  <c:v>535.28576957811902</c:v>
                </c:pt>
                <c:pt idx="2306">
                  <c:v>535.51799767771899</c:v>
                </c:pt>
                <c:pt idx="2307">
                  <c:v>535.75022577731897</c:v>
                </c:pt>
                <c:pt idx="2308">
                  <c:v>535.98245387691895</c:v>
                </c:pt>
                <c:pt idx="2309">
                  <c:v>536.21468197651905</c:v>
                </c:pt>
                <c:pt idx="2310">
                  <c:v>536.44691007611902</c:v>
                </c:pt>
                <c:pt idx="2311">
                  <c:v>536.679138175719</c:v>
                </c:pt>
                <c:pt idx="2312">
                  <c:v>536.91136627531898</c:v>
                </c:pt>
                <c:pt idx="2313">
                  <c:v>537.14359437491896</c:v>
                </c:pt>
                <c:pt idx="2314">
                  <c:v>537.37582247451905</c:v>
                </c:pt>
                <c:pt idx="2315">
                  <c:v>537.60805057411903</c:v>
                </c:pt>
                <c:pt idx="2316">
                  <c:v>537.84027867372004</c:v>
                </c:pt>
                <c:pt idx="2317">
                  <c:v>538.07250677332001</c:v>
                </c:pt>
                <c:pt idx="2318">
                  <c:v>538.30473487291999</c:v>
                </c:pt>
                <c:pt idx="2319">
                  <c:v>538.53696297251997</c:v>
                </c:pt>
                <c:pt idx="2320">
                  <c:v>538.76919107211995</c:v>
                </c:pt>
                <c:pt idx="2321">
                  <c:v>539.00141917172004</c:v>
                </c:pt>
                <c:pt idx="2322">
                  <c:v>539.23364727132002</c:v>
                </c:pt>
                <c:pt idx="2323">
                  <c:v>539.46587537092</c:v>
                </c:pt>
                <c:pt idx="2324">
                  <c:v>539.69810347051998</c:v>
                </c:pt>
                <c:pt idx="2325">
                  <c:v>539.93033157011996</c:v>
                </c:pt>
                <c:pt idx="2326">
                  <c:v>540.16255966972005</c:v>
                </c:pt>
                <c:pt idx="2327">
                  <c:v>540.39478776932003</c:v>
                </c:pt>
                <c:pt idx="2328">
                  <c:v>540.62701586892001</c:v>
                </c:pt>
                <c:pt idx="2329">
                  <c:v>540.85924396851999</c:v>
                </c:pt>
                <c:pt idx="2330">
                  <c:v>541.09147206811997</c:v>
                </c:pt>
                <c:pt idx="2331">
                  <c:v>541.32370016771995</c:v>
                </c:pt>
                <c:pt idx="2332">
                  <c:v>541.55592826732004</c:v>
                </c:pt>
                <c:pt idx="2333">
                  <c:v>541.78815636692002</c:v>
                </c:pt>
                <c:pt idx="2334">
                  <c:v>542.02038446652</c:v>
                </c:pt>
                <c:pt idx="2335">
                  <c:v>542.252612566121</c:v>
                </c:pt>
                <c:pt idx="2336">
                  <c:v>542.48484066572098</c:v>
                </c:pt>
                <c:pt idx="2337">
                  <c:v>542.71706876532096</c:v>
                </c:pt>
                <c:pt idx="2338">
                  <c:v>542.94929686492105</c:v>
                </c:pt>
                <c:pt idx="2339">
                  <c:v>543.18152496452103</c:v>
                </c:pt>
                <c:pt idx="2340">
                  <c:v>543.41375306412101</c:v>
                </c:pt>
                <c:pt idx="2341">
                  <c:v>543.64598116372099</c:v>
                </c:pt>
                <c:pt idx="2342">
                  <c:v>543.87820926332097</c:v>
                </c:pt>
                <c:pt idx="2343">
                  <c:v>544.11043736292095</c:v>
                </c:pt>
                <c:pt idx="2344">
                  <c:v>544.34266546252104</c:v>
                </c:pt>
                <c:pt idx="2345">
                  <c:v>544.57489356212102</c:v>
                </c:pt>
                <c:pt idx="2346">
                  <c:v>544.807121661721</c:v>
                </c:pt>
                <c:pt idx="2347">
                  <c:v>545.03934976132098</c:v>
                </c:pt>
                <c:pt idx="2348">
                  <c:v>545.27157786092096</c:v>
                </c:pt>
                <c:pt idx="2349">
                  <c:v>545.50380596052105</c:v>
                </c:pt>
                <c:pt idx="2350">
                  <c:v>545.73603406012103</c:v>
                </c:pt>
                <c:pt idx="2351">
                  <c:v>545.96826215972101</c:v>
                </c:pt>
                <c:pt idx="2352">
                  <c:v>546.20049025932099</c:v>
                </c:pt>
                <c:pt idx="2353">
                  <c:v>546.43271835892097</c:v>
                </c:pt>
                <c:pt idx="2354">
                  <c:v>546.66494645852197</c:v>
                </c:pt>
                <c:pt idx="2355">
                  <c:v>546.89717455812104</c:v>
                </c:pt>
                <c:pt idx="2356">
                  <c:v>547.12940265772204</c:v>
                </c:pt>
                <c:pt idx="2357">
                  <c:v>547.36163075732202</c:v>
                </c:pt>
                <c:pt idx="2358">
                  <c:v>547.593858856922</c:v>
                </c:pt>
                <c:pt idx="2359">
                  <c:v>547.82608695652198</c:v>
                </c:pt>
                <c:pt idx="2360">
                  <c:v>548.05831505612196</c:v>
                </c:pt>
                <c:pt idx="2361">
                  <c:v>548.29054315572205</c:v>
                </c:pt>
                <c:pt idx="2362">
                  <c:v>548.52277125532203</c:v>
                </c:pt>
                <c:pt idx="2363">
                  <c:v>548.75499935492201</c:v>
                </c:pt>
                <c:pt idx="2364">
                  <c:v>548.98722745452199</c:v>
                </c:pt>
                <c:pt idx="2365">
                  <c:v>549.21945555412196</c:v>
                </c:pt>
                <c:pt idx="2366">
                  <c:v>549.45168365372194</c:v>
                </c:pt>
                <c:pt idx="2367">
                  <c:v>549.68391175332204</c:v>
                </c:pt>
                <c:pt idx="2368">
                  <c:v>549.91613985292202</c:v>
                </c:pt>
                <c:pt idx="2369">
                  <c:v>550.14836795252199</c:v>
                </c:pt>
                <c:pt idx="2370">
                  <c:v>550.38059605212197</c:v>
                </c:pt>
                <c:pt idx="2371">
                  <c:v>550.61282415172195</c:v>
                </c:pt>
                <c:pt idx="2372">
                  <c:v>550.84505225132204</c:v>
                </c:pt>
                <c:pt idx="2373">
                  <c:v>551.07728035092202</c:v>
                </c:pt>
                <c:pt idx="2374">
                  <c:v>551.30950845052303</c:v>
                </c:pt>
                <c:pt idx="2375">
                  <c:v>551.54173655012301</c:v>
                </c:pt>
                <c:pt idx="2376">
                  <c:v>551.77396464972298</c:v>
                </c:pt>
                <c:pt idx="2377">
                  <c:v>552.00619274932296</c:v>
                </c:pt>
                <c:pt idx="2378">
                  <c:v>552.23842084892306</c:v>
                </c:pt>
                <c:pt idx="2379">
                  <c:v>552.47064894852303</c:v>
                </c:pt>
                <c:pt idx="2380">
                  <c:v>552.70287704812301</c:v>
                </c:pt>
                <c:pt idx="2381">
                  <c:v>552.93510514772299</c:v>
                </c:pt>
                <c:pt idx="2382">
                  <c:v>553.16733324732297</c:v>
                </c:pt>
                <c:pt idx="2383">
                  <c:v>553.39956134692295</c:v>
                </c:pt>
                <c:pt idx="2384">
                  <c:v>553.63178944652304</c:v>
                </c:pt>
                <c:pt idx="2385">
                  <c:v>553.86401754612302</c:v>
                </c:pt>
                <c:pt idx="2386">
                  <c:v>554.096245645723</c:v>
                </c:pt>
                <c:pt idx="2387">
                  <c:v>554.32847374532298</c:v>
                </c:pt>
                <c:pt idx="2388">
                  <c:v>554.56070184492296</c:v>
                </c:pt>
                <c:pt idx="2389">
                  <c:v>554.79292994452305</c:v>
                </c:pt>
                <c:pt idx="2390">
                  <c:v>555.02515804412303</c:v>
                </c:pt>
                <c:pt idx="2391">
                  <c:v>555.25738614372301</c:v>
                </c:pt>
                <c:pt idx="2392">
                  <c:v>555.48961424332299</c:v>
                </c:pt>
                <c:pt idx="2393">
                  <c:v>555.72184234292399</c:v>
                </c:pt>
                <c:pt idx="2394">
                  <c:v>555.95407044252397</c:v>
                </c:pt>
                <c:pt idx="2395">
                  <c:v>556.18629854212395</c:v>
                </c:pt>
                <c:pt idx="2396">
                  <c:v>556.41852664172404</c:v>
                </c:pt>
                <c:pt idx="2397">
                  <c:v>556.65075474132402</c:v>
                </c:pt>
                <c:pt idx="2398">
                  <c:v>556.882982840924</c:v>
                </c:pt>
                <c:pt idx="2399">
                  <c:v>557.11521094052398</c:v>
                </c:pt>
                <c:pt idx="2400">
                  <c:v>557.34743904012396</c:v>
                </c:pt>
                <c:pt idx="2401">
                  <c:v>557.57966713972405</c:v>
                </c:pt>
                <c:pt idx="2402">
                  <c:v>557.81189523932403</c:v>
                </c:pt>
                <c:pt idx="2403">
                  <c:v>558.04412333892401</c:v>
                </c:pt>
                <c:pt idx="2404">
                  <c:v>558.27635143852399</c:v>
                </c:pt>
                <c:pt idx="2405">
                  <c:v>558.50857953812397</c:v>
                </c:pt>
                <c:pt idx="2406">
                  <c:v>558.74080763772395</c:v>
                </c:pt>
                <c:pt idx="2407">
                  <c:v>558.97303573732404</c:v>
                </c:pt>
                <c:pt idx="2408">
                  <c:v>559.20526383692402</c:v>
                </c:pt>
                <c:pt idx="2409">
                  <c:v>559.437491936524</c:v>
                </c:pt>
                <c:pt idx="2410">
                  <c:v>559.66972003612398</c:v>
                </c:pt>
                <c:pt idx="2411">
                  <c:v>559.90194813572396</c:v>
                </c:pt>
                <c:pt idx="2412">
                  <c:v>560.13417623532496</c:v>
                </c:pt>
                <c:pt idx="2413">
                  <c:v>560.36640433492505</c:v>
                </c:pt>
                <c:pt idx="2414">
                  <c:v>560.59863243452503</c:v>
                </c:pt>
                <c:pt idx="2415">
                  <c:v>560.83086053412501</c:v>
                </c:pt>
                <c:pt idx="2416">
                  <c:v>561.06308863372499</c:v>
                </c:pt>
                <c:pt idx="2417">
                  <c:v>561.29531673332497</c:v>
                </c:pt>
                <c:pt idx="2418">
                  <c:v>561.52754483292495</c:v>
                </c:pt>
                <c:pt idx="2419">
                  <c:v>561.75977293252504</c:v>
                </c:pt>
                <c:pt idx="2420">
                  <c:v>561.99200103212502</c:v>
                </c:pt>
                <c:pt idx="2421">
                  <c:v>562.224229131725</c:v>
                </c:pt>
                <c:pt idx="2422">
                  <c:v>562.45645723132498</c:v>
                </c:pt>
                <c:pt idx="2423">
                  <c:v>562.68868533092495</c:v>
                </c:pt>
                <c:pt idx="2424">
                  <c:v>562.92091343052505</c:v>
                </c:pt>
                <c:pt idx="2425">
                  <c:v>563.15314153012503</c:v>
                </c:pt>
                <c:pt idx="2426">
                  <c:v>563.38536962972501</c:v>
                </c:pt>
                <c:pt idx="2427">
                  <c:v>563.61759772932498</c:v>
                </c:pt>
                <c:pt idx="2428">
                  <c:v>563.84982582892496</c:v>
                </c:pt>
                <c:pt idx="2429">
                  <c:v>564.08205392852506</c:v>
                </c:pt>
                <c:pt idx="2430">
                  <c:v>564.31428202812504</c:v>
                </c:pt>
                <c:pt idx="2431">
                  <c:v>564.54651012772501</c:v>
                </c:pt>
                <c:pt idx="2432">
                  <c:v>564.77873822732602</c:v>
                </c:pt>
                <c:pt idx="2433">
                  <c:v>565.010966326926</c:v>
                </c:pt>
                <c:pt idx="2434">
                  <c:v>565.24319442652597</c:v>
                </c:pt>
                <c:pt idx="2435">
                  <c:v>565.47542252612595</c:v>
                </c:pt>
                <c:pt idx="2436">
                  <c:v>565.70765062572605</c:v>
                </c:pt>
                <c:pt idx="2437">
                  <c:v>565.93987872532603</c:v>
                </c:pt>
                <c:pt idx="2438">
                  <c:v>566.172106824926</c:v>
                </c:pt>
                <c:pt idx="2439">
                  <c:v>566.40433492452598</c:v>
                </c:pt>
                <c:pt idx="2440">
                  <c:v>566.63656302412596</c:v>
                </c:pt>
                <c:pt idx="2441">
                  <c:v>566.86879112372606</c:v>
                </c:pt>
                <c:pt idx="2442">
                  <c:v>567.10101922332603</c:v>
                </c:pt>
                <c:pt idx="2443">
                  <c:v>567.33324732292601</c:v>
                </c:pt>
                <c:pt idx="2444">
                  <c:v>567.56547542252599</c:v>
                </c:pt>
                <c:pt idx="2445">
                  <c:v>567.79770352212597</c:v>
                </c:pt>
                <c:pt idx="2446">
                  <c:v>568.02993162172595</c:v>
                </c:pt>
                <c:pt idx="2447">
                  <c:v>568.26215972132604</c:v>
                </c:pt>
                <c:pt idx="2448">
                  <c:v>568.49438782092602</c:v>
                </c:pt>
                <c:pt idx="2449">
                  <c:v>568.726615920526</c:v>
                </c:pt>
                <c:pt idx="2450">
                  <c:v>568.95884402012598</c:v>
                </c:pt>
                <c:pt idx="2451">
                  <c:v>569.19107211972698</c:v>
                </c:pt>
                <c:pt idx="2452">
                  <c:v>569.42330021932696</c:v>
                </c:pt>
                <c:pt idx="2453">
                  <c:v>569.65552831892705</c:v>
                </c:pt>
                <c:pt idx="2454">
                  <c:v>569.88775641852703</c:v>
                </c:pt>
                <c:pt idx="2455">
                  <c:v>570.11998451812701</c:v>
                </c:pt>
                <c:pt idx="2456">
                  <c:v>570.35221261772699</c:v>
                </c:pt>
                <c:pt idx="2457">
                  <c:v>570.58444071732697</c:v>
                </c:pt>
                <c:pt idx="2458">
                  <c:v>570.81666881692695</c:v>
                </c:pt>
                <c:pt idx="2459">
                  <c:v>571.04889691652704</c:v>
                </c:pt>
                <c:pt idx="2460">
                  <c:v>571.28112501612702</c:v>
                </c:pt>
                <c:pt idx="2461">
                  <c:v>571.513353115727</c:v>
                </c:pt>
                <c:pt idx="2462">
                  <c:v>571.74558121532698</c:v>
                </c:pt>
                <c:pt idx="2463">
                  <c:v>571.97780931492696</c:v>
                </c:pt>
                <c:pt idx="2464">
                  <c:v>572.21003741452705</c:v>
                </c:pt>
                <c:pt idx="2465">
                  <c:v>572.44226551412703</c:v>
                </c:pt>
                <c:pt idx="2466">
                  <c:v>572.67449361372701</c:v>
                </c:pt>
                <c:pt idx="2467">
                  <c:v>572.90672171332699</c:v>
                </c:pt>
                <c:pt idx="2468">
                  <c:v>573.13894981292697</c:v>
                </c:pt>
                <c:pt idx="2469">
                  <c:v>573.37117791252695</c:v>
                </c:pt>
                <c:pt idx="2470">
                  <c:v>573.60340601212704</c:v>
                </c:pt>
                <c:pt idx="2471">
                  <c:v>573.83563411172804</c:v>
                </c:pt>
                <c:pt idx="2472">
                  <c:v>574.06786221132802</c:v>
                </c:pt>
                <c:pt idx="2473">
                  <c:v>574.300090310928</c:v>
                </c:pt>
                <c:pt idx="2474">
                  <c:v>574.53231841052798</c:v>
                </c:pt>
                <c:pt idx="2475">
                  <c:v>574.76454651012796</c:v>
                </c:pt>
                <c:pt idx="2476">
                  <c:v>574.99677460972805</c:v>
                </c:pt>
                <c:pt idx="2477">
                  <c:v>575.22900270932803</c:v>
                </c:pt>
                <c:pt idx="2478">
                  <c:v>575.46123080892801</c:v>
                </c:pt>
                <c:pt idx="2479">
                  <c:v>575.69345890852799</c:v>
                </c:pt>
                <c:pt idx="2480">
                  <c:v>575.92568700812797</c:v>
                </c:pt>
                <c:pt idx="2481">
                  <c:v>576.15791510772794</c:v>
                </c:pt>
                <c:pt idx="2482">
                  <c:v>576.39014320732804</c:v>
                </c:pt>
                <c:pt idx="2483">
                  <c:v>576.62237130692802</c:v>
                </c:pt>
                <c:pt idx="2484">
                  <c:v>576.854599406528</c:v>
                </c:pt>
                <c:pt idx="2485">
                  <c:v>577.08682750612797</c:v>
                </c:pt>
                <c:pt idx="2486">
                  <c:v>577.31905560572795</c:v>
                </c:pt>
                <c:pt idx="2487">
                  <c:v>577.55128370532805</c:v>
                </c:pt>
                <c:pt idx="2488">
                  <c:v>577.78351180492803</c:v>
                </c:pt>
                <c:pt idx="2489">
                  <c:v>578.015739904528</c:v>
                </c:pt>
                <c:pt idx="2490">
                  <c:v>578.24796800412901</c:v>
                </c:pt>
                <c:pt idx="2491">
                  <c:v>578.48019610372899</c:v>
                </c:pt>
                <c:pt idx="2492">
                  <c:v>578.71242420332896</c:v>
                </c:pt>
                <c:pt idx="2493">
                  <c:v>578.94465230292894</c:v>
                </c:pt>
                <c:pt idx="2494">
                  <c:v>579.17688040252904</c:v>
                </c:pt>
                <c:pt idx="2495">
                  <c:v>579.40910850212902</c:v>
                </c:pt>
                <c:pt idx="2496">
                  <c:v>579.64133660172899</c:v>
                </c:pt>
                <c:pt idx="2497">
                  <c:v>579.87356470132897</c:v>
                </c:pt>
                <c:pt idx="2498">
                  <c:v>580.10579280092895</c:v>
                </c:pt>
                <c:pt idx="2499">
                  <c:v>580.33802090052905</c:v>
                </c:pt>
                <c:pt idx="2500">
                  <c:v>580.57024900012902</c:v>
                </c:pt>
                <c:pt idx="2501">
                  <c:v>580.802477099729</c:v>
                </c:pt>
                <c:pt idx="2502">
                  <c:v>581.03470519932898</c:v>
                </c:pt>
                <c:pt idx="2503">
                  <c:v>581.26693329892896</c:v>
                </c:pt>
                <c:pt idx="2504">
                  <c:v>581.49916139852905</c:v>
                </c:pt>
                <c:pt idx="2505">
                  <c:v>581.73138949812903</c:v>
                </c:pt>
                <c:pt idx="2506">
                  <c:v>581.96361759772901</c:v>
                </c:pt>
                <c:pt idx="2507">
                  <c:v>582.19584569732899</c:v>
                </c:pt>
                <c:pt idx="2508">
                  <c:v>582.42807379692897</c:v>
                </c:pt>
                <c:pt idx="2509">
                  <c:v>582.66030189652997</c:v>
                </c:pt>
                <c:pt idx="2510">
                  <c:v>582.89252999612904</c:v>
                </c:pt>
                <c:pt idx="2511">
                  <c:v>583.12475809573004</c:v>
                </c:pt>
                <c:pt idx="2512">
                  <c:v>583.35698619533002</c:v>
                </c:pt>
                <c:pt idx="2513">
                  <c:v>583.58921429493</c:v>
                </c:pt>
                <c:pt idx="2514">
                  <c:v>583.82144239452998</c:v>
                </c:pt>
                <c:pt idx="2515">
                  <c:v>584.05367049412996</c:v>
                </c:pt>
                <c:pt idx="2516">
                  <c:v>584.28589859373005</c:v>
                </c:pt>
                <c:pt idx="2517">
                  <c:v>584.51812669333003</c:v>
                </c:pt>
                <c:pt idx="2518">
                  <c:v>584.75035479293001</c:v>
                </c:pt>
                <c:pt idx="2519">
                  <c:v>584.98258289252999</c:v>
                </c:pt>
                <c:pt idx="2520">
                  <c:v>585.21481099212997</c:v>
                </c:pt>
                <c:pt idx="2521">
                  <c:v>585.44703909172995</c:v>
                </c:pt>
                <c:pt idx="2522">
                  <c:v>585.67926719133004</c:v>
                </c:pt>
                <c:pt idx="2523">
                  <c:v>585.91149529093002</c:v>
                </c:pt>
                <c:pt idx="2524">
                  <c:v>586.14372339053</c:v>
                </c:pt>
                <c:pt idx="2525">
                  <c:v>586.37595149012998</c:v>
                </c:pt>
                <c:pt idx="2526">
                  <c:v>586.60817958972996</c:v>
                </c:pt>
                <c:pt idx="2527">
                  <c:v>586.84040768933005</c:v>
                </c:pt>
                <c:pt idx="2528">
                  <c:v>587.07263578893003</c:v>
                </c:pt>
                <c:pt idx="2529">
                  <c:v>587.30486388853103</c:v>
                </c:pt>
                <c:pt idx="2530">
                  <c:v>587.53709198813101</c:v>
                </c:pt>
                <c:pt idx="2531">
                  <c:v>587.76932008773099</c:v>
                </c:pt>
                <c:pt idx="2532">
                  <c:v>588.00154818733097</c:v>
                </c:pt>
                <c:pt idx="2533">
                  <c:v>588.23377628693095</c:v>
                </c:pt>
                <c:pt idx="2534">
                  <c:v>588.46600438653104</c:v>
                </c:pt>
                <c:pt idx="2535">
                  <c:v>588.69823248613102</c:v>
                </c:pt>
                <c:pt idx="2536">
                  <c:v>588.930460585731</c:v>
                </c:pt>
                <c:pt idx="2537">
                  <c:v>589.16268868533098</c:v>
                </c:pt>
                <c:pt idx="2538">
                  <c:v>589.39491678493096</c:v>
                </c:pt>
                <c:pt idx="2539">
                  <c:v>589.62714488453105</c:v>
                </c:pt>
                <c:pt idx="2540">
                  <c:v>589.85937298413103</c:v>
                </c:pt>
                <c:pt idx="2541">
                  <c:v>590.09160108373101</c:v>
                </c:pt>
                <c:pt idx="2542">
                  <c:v>590.32382918333099</c:v>
                </c:pt>
                <c:pt idx="2543">
                  <c:v>590.55605728293096</c:v>
                </c:pt>
                <c:pt idx="2544">
                  <c:v>590.78828538253094</c:v>
                </c:pt>
                <c:pt idx="2545">
                  <c:v>591.02051348213104</c:v>
                </c:pt>
                <c:pt idx="2546">
                  <c:v>591.25274158173102</c:v>
                </c:pt>
                <c:pt idx="2547">
                  <c:v>591.48496968133099</c:v>
                </c:pt>
                <c:pt idx="2548">
                  <c:v>591.717197780932</c:v>
                </c:pt>
                <c:pt idx="2549">
                  <c:v>591.94942588053198</c:v>
                </c:pt>
                <c:pt idx="2550">
                  <c:v>592.18165398013195</c:v>
                </c:pt>
                <c:pt idx="2551">
                  <c:v>592.41388207973205</c:v>
                </c:pt>
                <c:pt idx="2552">
                  <c:v>592.64611017933203</c:v>
                </c:pt>
                <c:pt idx="2553">
                  <c:v>592.87833827893201</c:v>
                </c:pt>
                <c:pt idx="2554">
                  <c:v>593.11056637853198</c:v>
                </c:pt>
                <c:pt idx="2555">
                  <c:v>593.34279447813196</c:v>
                </c:pt>
                <c:pt idx="2556">
                  <c:v>593.57502257773206</c:v>
                </c:pt>
                <c:pt idx="2557">
                  <c:v>593.80725067733204</c:v>
                </c:pt>
                <c:pt idx="2558">
                  <c:v>594.03947877693201</c:v>
                </c:pt>
                <c:pt idx="2559">
                  <c:v>594.27170687653199</c:v>
                </c:pt>
                <c:pt idx="2560">
                  <c:v>594.50393497613197</c:v>
                </c:pt>
                <c:pt idx="2561">
                  <c:v>594.73616307573195</c:v>
                </c:pt>
                <c:pt idx="2562">
                  <c:v>594.96839117533204</c:v>
                </c:pt>
                <c:pt idx="2563">
                  <c:v>595.20061927493202</c:v>
                </c:pt>
                <c:pt idx="2564">
                  <c:v>595.432847374532</c:v>
                </c:pt>
                <c:pt idx="2565">
                  <c:v>595.66507547413198</c:v>
                </c:pt>
                <c:pt idx="2566">
                  <c:v>595.89730357373196</c:v>
                </c:pt>
                <c:pt idx="2567">
                  <c:v>596.12953167333296</c:v>
                </c:pt>
                <c:pt idx="2568">
                  <c:v>596.36175977293203</c:v>
                </c:pt>
                <c:pt idx="2569">
                  <c:v>596.59398787253303</c:v>
                </c:pt>
                <c:pt idx="2570">
                  <c:v>596.82621597213301</c:v>
                </c:pt>
                <c:pt idx="2571">
                  <c:v>597.05844407173299</c:v>
                </c:pt>
                <c:pt idx="2572">
                  <c:v>597.29067217133297</c:v>
                </c:pt>
                <c:pt idx="2573">
                  <c:v>597.52290027093295</c:v>
                </c:pt>
                <c:pt idx="2574">
                  <c:v>597.75512837053304</c:v>
                </c:pt>
                <c:pt idx="2575">
                  <c:v>597.98735647013302</c:v>
                </c:pt>
                <c:pt idx="2576">
                  <c:v>598.219584569733</c:v>
                </c:pt>
                <c:pt idx="2577">
                  <c:v>598.45181266933298</c:v>
                </c:pt>
                <c:pt idx="2578">
                  <c:v>598.68404076893296</c:v>
                </c:pt>
                <c:pt idx="2579">
                  <c:v>598.91626886853305</c:v>
                </c:pt>
                <c:pt idx="2580">
                  <c:v>599.14849696813303</c:v>
                </c:pt>
                <c:pt idx="2581">
                  <c:v>599.38072506773301</c:v>
                </c:pt>
                <c:pt idx="2582">
                  <c:v>599.61295316733299</c:v>
                </c:pt>
                <c:pt idx="2583">
                  <c:v>599.84518126693297</c:v>
                </c:pt>
                <c:pt idx="2584">
                  <c:v>600.07740936653295</c:v>
                </c:pt>
                <c:pt idx="2585">
                  <c:v>600.30963746613304</c:v>
                </c:pt>
                <c:pt idx="2586">
                  <c:v>600.54186556573302</c:v>
                </c:pt>
                <c:pt idx="2587">
                  <c:v>600.77409366533402</c:v>
                </c:pt>
                <c:pt idx="2588">
                  <c:v>601.006321764934</c:v>
                </c:pt>
                <c:pt idx="2589">
                  <c:v>601.23854986453398</c:v>
                </c:pt>
                <c:pt idx="2590">
                  <c:v>601.47077796413396</c:v>
                </c:pt>
                <c:pt idx="2591">
                  <c:v>601.70300606373405</c:v>
                </c:pt>
                <c:pt idx="2592">
                  <c:v>601.93523416333403</c:v>
                </c:pt>
                <c:pt idx="2593">
                  <c:v>602.16746226293401</c:v>
                </c:pt>
                <c:pt idx="2594">
                  <c:v>602.39969036253399</c:v>
                </c:pt>
                <c:pt idx="2595">
                  <c:v>602.63191846213397</c:v>
                </c:pt>
                <c:pt idx="2596">
                  <c:v>602.86414656173395</c:v>
                </c:pt>
                <c:pt idx="2597">
                  <c:v>603.09637466133404</c:v>
                </c:pt>
                <c:pt idx="2598">
                  <c:v>603.32860276093402</c:v>
                </c:pt>
                <c:pt idx="2599">
                  <c:v>603.560830860534</c:v>
                </c:pt>
                <c:pt idx="2600">
                  <c:v>603.79305896013398</c:v>
                </c:pt>
                <c:pt idx="2601">
                  <c:v>604.02528705973396</c:v>
                </c:pt>
                <c:pt idx="2602">
                  <c:v>604.25751515933405</c:v>
                </c:pt>
                <c:pt idx="2603">
                  <c:v>604.48974325893403</c:v>
                </c:pt>
                <c:pt idx="2604">
                  <c:v>604.72197135853401</c:v>
                </c:pt>
                <c:pt idx="2605">
                  <c:v>604.95419945813398</c:v>
                </c:pt>
                <c:pt idx="2606">
                  <c:v>605.18642755773499</c:v>
                </c:pt>
                <c:pt idx="2607">
                  <c:v>605.41865565733497</c:v>
                </c:pt>
                <c:pt idx="2608">
                  <c:v>605.65088375693495</c:v>
                </c:pt>
                <c:pt idx="2609">
                  <c:v>605.88311185653504</c:v>
                </c:pt>
                <c:pt idx="2610">
                  <c:v>606.11533995613502</c:v>
                </c:pt>
                <c:pt idx="2611">
                  <c:v>606.347568055735</c:v>
                </c:pt>
                <c:pt idx="2612">
                  <c:v>606.57979615533498</c:v>
                </c:pt>
                <c:pt idx="2613">
                  <c:v>606.81202425493495</c:v>
                </c:pt>
                <c:pt idx="2614">
                  <c:v>607.04425235453505</c:v>
                </c:pt>
                <c:pt idx="2615">
                  <c:v>607.27648045413503</c:v>
                </c:pt>
                <c:pt idx="2616">
                  <c:v>607.508708553735</c:v>
                </c:pt>
                <c:pt idx="2617">
                  <c:v>607.74093665333498</c:v>
                </c:pt>
                <c:pt idx="2618">
                  <c:v>607.97316475293496</c:v>
                </c:pt>
                <c:pt idx="2619">
                  <c:v>608.20539285253506</c:v>
                </c:pt>
                <c:pt idx="2620">
                  <c:v>608.43762095213503</c:v>
                </c:pt>
                <c:pt idx="2621">
                  <c:v>608.66984905173501</c:v>
                </c:pt>
                <c:pt idx="2622">
                  <c:v>608.90207715133499</c:v>
                </c:pt>
                <c:pt idx="2623">
                  <c:v>609.13430525093497</c:v>
                </c:pt>
                <c:pt idx="2624">
                  <c:v>609.36653335053495</c:v>
                </c:pt>
                <c:pt idx="2625">
                  <c:v>609.59876145013504</c:v>
                </c:pt>
                <c:pt idx="2626">
                  <c:v>609.83098954973605</c:v>
                </c:pt>
                <c:pt idx="2627">
                  <c:v>610.06321764933602</c:v>
                </c:pt>
                <c:pt idx="2628">
                  <c:v>610.295445748936</c:v>
                </c:pt>
                <c:pt idx="2629">
                  <c:v>610.52767384853598</c:v>
                </c:pt>
                <c:pt idx="2630">
                  <c:v>610.75990194813596</c:v>
                </c:pt>
                <c:pt idx="2631">
                  <c:v>610.99213004773605</c:v>
                </c:pt>
                <c:pt idx="2632">
                  <c:v>611.22435814733603</c:v>
                </c:pt>
                <c:pt idx="2633">
                  <c:v>611.45658624693601</c:v>
                </c:pt>
                <c:pt idx="2634">
                  <c:v>611.68881434653599</c:v>
                </c:pt>
                <c:pt idx="2635">
                  <c:v>611.92104244613597</c:v>
                </c:pt>
                <c:pt idx="2636">
                  <c:v>612.15327054573595</c:v>
                </c:pt>
                <c:pt idx="2637">
                  <c:v>612.38549864533604</c:v>
                </c:pt>
                <c:pt idx="2638">
                  <c:v>612.61772674493602</c:v>
                </c:pt>
                <c:pt idx="2639">
                  <c:v>612.849954844536</c:v>
                </c:pt>
                <c:pt idx="2640">
                  <c:v>613.08218294413598</c:v>
                </c:pt>
                <c:pt idx="2641">
                  <c:v>613.31441104373596</c:v>
                </c:pt>
                <c:pt idx="2642">
                  <c:v>613.54663914333605</c:v>
                </c:pt>
                <c:pt idx="2643">
                  <c:v>613.77886724293603</c:v>
                </c:pt>
                <c:pt idx="2644">
                  <c:v>614.01109534253601</c:v>
                </c:pt>
                <c:pt idx="2645">
                  <c:v>614.24332344213701</c:v>
                </c:pt>
                <c:pt idx="2646">
                  <c:v>614.47555154173699</c:v>
                </c:pt>
                <c:pt idx="2647">
                  <c:v>614.70777964133697</c:v>
                </c:pt>
                <c:pt idx="2648">
                  <c:v>614.94000774093695</c:v>
                </c:pt>
                <c:pt idx="2649">
                  <c:v>615.17223584053704</c:v>
                </c:pt>
                <c:pt idx="2650">
                  <c:v>615.40446394013702</c:v>
                </c:pt>
                <c:pt idx="2651">
                  <c:v>615.636692039737</c:v>
                </c:pt>
                <c:pt idx="2652">
                  <c:v>615.86892013933698</c:v>
                </c:pt>
                <c:pt idx="2653">
                  <c:v>616.10114823893696</c:v>
                </c:pt>
                <c:pt idx="2654">
                  <c:v>616.33337633853705</c:v>
                </c:pt>
                <c:pt idx="2655">
                  <c:v>616.56560443813703</c:v>
                </c:pt>
                <c:pt idx="2656">
                  <c:v>616.79783253773701</c:v>
                </c:pt>
                <c:pt idx="2657">
                  <c:v>617.03006063733699</c:v>
                </c:pt>
                <c:pt idx="2658">
                  <c:v>617.26228873693697</c:v>
                </c:pt>
                <c:pt idx="2659">
                  <c:v>617.49451683653695</c:v>
                </c:pt>
                <c:pt idx="2660">
                  <c:v>617.72674493613704</c:v>
                </c:pt>
                <c:pt idx="2661">
                  <c:v>617.95897303573702</c:v>
                </c:pt>
                <c:pt idx="2662">
                  <c:v>618.191201135337</c:v>
                </c:pt>
                <c:pt idx="2663">
                  <c:v>618.42342923493698</c:v>
                </c:pt>
                <c:pt idx="2664">
                  <c:v>618.65565733453798</c:v>
                </c:pt>
                <c:pt idx="2665">
                  <c:v>618.88788543413796</c:v>
                </c:pt>
                <c:pt idx="2666">
                  <c:v>619.12011353373805</c:v>
                </c:pt>
                <c:pt idx="2667">
                  <c:v>619.35234163333803</c:v>
                </c:pt>
                <c:pt idx="2668">
                  <c:v>619.58456973293801</c:v>
                </c:pt>
                <c:pt idx="2669">
                  <c:v>619.81679783253799</c:v>
                </c:pt>
                <c:pt idx="2670">
                  <c:v>620.04902593213797</c:v>
                </c:pt>
                <c:pt idx="2671">
                  <c:v>620.28125403173794</c:v>
                </c:pt>
                <c:pt idx="2672">
                  <c:v>620.51348213133804</c:v>
                </c:pt>
                <c:pt idx="2673">
                  <c:v>620.74571023093802</c:v>
                </c:pt>
                <c:pt idx="2674">
                  <c:v>620.977938330538</c:v>
                </c:pt>
                <c:pt idx="2675">
                  <c:v>621.21016643013797</c:v>
                </c:pt>
                <c:pt idx="2676">
                  <c:v>621.44239452973795</c:v>
                </c:pt>
                <c:pt idx="2677">
                  <c:v>621.67462262933805</c:v>
                </c:pt>
                <c:pt idx="2678">
                  <c:v>621.90685072893802</c:v>
                </c:pt>
                <c:pt idx="2679">
                  <c:v>622.139078828538</c:v>
                </c:pt>
                <c:pt idx="2680">
                  <c:v>622.37130692813798</c:v>
                </c:pt>
                <c:pt idx="2681">
                  <c:v>622.60353502773796</c:v>
                </c:pt>
                <c:pt idx="2682">
                  <c:v>622.83576312733805</c:v>
                </c:pt>
                <c:pt idx="2683">
                  <c:v>623.06799122693803</c:v>
                </c:pt>
                <c:pt idx="2684">
                  <c:v>623.30021932653904</c:v>
                </c:pt>
                <c:pt idx="2685">
                  <c:v>623.53244742613902</c:v>
                </c:pt>
                <c:pt idx="2686">
                  <c:v>623.76467552573899</c:v>
                </c:pt>
                <c:pt idx="2687">
                  <c:v>623.99690362533897</c:v>
                </c:pt>
                <c:pt idx="2688">
                  <c:v>624.22913172493895</c:v>
                </c:pt>
                <c:pt idx="2689">
                  <c:v>624.46135982453904</c:v>
                </c:pt>
                <c:pt idx="2690">
                  <c:v>624.69358792413902</c:v>
                </c:pt>
                <c:pt idx="2691">
                  <c:v>624.925816023739</c:v>
                </c:pt>
                <c:pt idx="2692">
                  <c:v>625.15804412333898</c:v>
                </c:pt>
                <c:pt idx="2693">
                  <c:v>625.39027222293896</c:v>
                </c:pt>
                <c:pt idx="2694">
                  <c:v>625.62250032253905</c:v>
                </c:pt>
                <c:pt idx="2695">
                  <c:v>625.85472842213903</c:v>
                </c:pt>
                <c:pt idx="2696">
                  <c:v>626.08695652173901</c:v>
                </c:pt>
                <c:pt idx="2697">
                  <c:v>626.31918462133899</c:v>
                </c:pt>
                <c:pt idx="2698">
                  <c:v>626.55141272093897</c:v>
                </c:pt>
                <c:pt idx="2699">
                  <c:v>626.78364082053895</c:v>
                </c:pt>
                <c:pt idx="2700">
                  <c:v>627.01586892013904</c:v>
                </c:pt>
                <c:pt idx="2701">
                  <c:v>627.24809701973902</c:v>
                </c:pt>
                <c:pt idx="2702">
                  <c:v>627.480325119339</c:v>
                </c:pt>
                <c:pt idx="2703">
                  <c:v>627.71255321894</c:v>
                </c:pt>
                <c:pt idx="2704">
                  <c:v>627.94478131853998</c:v>
                </c:pt>
                <c:pt idx="2705">
                  <c:v>628.17700941813996</c:v>
                </c:pt>
                <c:pt idx="2706">
                  <c:v>628.40923751774005</c:v>
                </c:pt>
                <c:pt idx="2707">
                  <c:v>628.64146561734003</c:v>
                </c:pt>
                <c:pt idx="2708">
                  <c:v>628.87369371694001</c:v>
                </c:pt>
                <c:pt idx="2709">
                  <c:v>629.10592181653999</c:v>
                </c:pt>
                <c:pt idx="2710">
                  <c:v>629.33814991613997</c:v>
                </c:pt>
                <c:pt idx="2711">
                  <c:v>629.57037801573995</c:v>
                </c:pt>
                <c:pt idx="2712">
                  <c:v>629.80260611534004</c:v>
                </c:pt>
                <c:pt idx="2713">
                  <c:v>630.03483421494002</c:v>
                </c:pt>
                <c:pt idx="2714">
                  <c:v>630.26706231454</c:v>
                </c:pt>
                <c:pt idx="2715">
                  <c:v>630.49929041413998</c:v>
                </c:pt>
                <c:pt idx="2716">
                  <c:v>630.73151851373996</c:v>
                </c:pt>
                <c:pt idx="2717">
                  <c:v>630.96374661334005</c:v>
                </c:pt>
                <c:pt idx="2718">
                  <c:v>631.19597471294003</c:v>
                </c:pt>
                <c:pt idx="2719">
                  <c:v>631.42820281254001</c:v>
                </c:pt>
                <c:pt idx="2720">
                  <c:v>631.66043091213999</c:v>
                </c:pt>
                <c:pt idx="2721">
                  <c:v>631.89265901173997</c:v>
                </c:pt>
                <c:pt idx="2722">
                  <c:v>632.12488711134097</c:v>
                </c:pt>
                <c:pt idx="2723">
                  <c:v>632.35711521094004</c:v>
                </c:pt>
                <c:pt idx="2724">
                  <c:v>632.58934331054104</c:v>
                </c:pt>
                <c:pt idx="2725">
                  <c:v>632.82157141014102</c:v>
                </c:pt>
                <c:pt idx="2726">
                  <c:v>633.053799509741</c:v>
                </c:pt>
                <c:pt idx="2727">
                  <c:v>633.28602760934098</c:v>
                </c:pt>
                <c:pt idx="2728">
                  <c:v>633.51825570894096</c:v>
                </c:pt>
                <c:pt idx="2729">
                  <c:v>633.75048380854105</c:v>
                </c:pt>
                <c:pt idx="2730">
                  <c:v>633.98271190814103</c:v>
                </c:pt>
                <c:pt idx="2731">
                  <c:v>634.21494000774101</c:v>
                </c:pt>
                <c:pt idx="2732">
                  <c:v>634.44716810734099</c:v>
                </c:pt>
                <c:pt idx="2733">
                  <c:v>634.67939620694096</c:v>
                </c:pt>
                <c:pt idx="2734">
                  <c:v>634.91162430654094</c:v>
                </c:pt>
                <c:pt idx="2735">
                  <c:v>635.14385240614104</c:v>
                </c:pt>
                <c:pt idx="2736">
                  <c:v>635.37608050574102</c:v>
                </c:pt>
                <c:pt idx="2737">
                  <c:v>635.60830860534099</c:v>
                </c:pt>
                <c:pt idx="2738">
                  <c:v>635.84053670494097</c:v>
                </c:pt>
                <c:pt idx="2739">
                  <c:v>636.07276480454095</c:v>
                </c:pt>
                <c:pt idx="2740">
                  <c:v>636.30499290414105</c:v>
                </c:pt>
                <c:pt idx="2741">
                  <c:v>636.53722100374102</c:v>
                </c:pt>
                <c:pt idx="2742">
                  <c:v>636.76944910334203</c:v>
                </c:pt>
                <c:pt idx="2743">
                  <c:v>637.00167720294201</c:v>
                </c:pt>
                <c:pt idx="2744">
                  <c:v>637.23390530254198</c:v>
                </c:pt>
                <c:pt idx="2745">
                  <c:v>637.46613340214196</c:v>
                </c:pt>
                <c:pt idx="2746">
                  <c:v>637.69836150174206</c:v>
                </c:pt>
                <c:pt idx="2747">
                  <c:v>637.93058960134204</c:v>
                </c:pt>
                <c:pt idx="2748">
                  <c:v>638.16281770094201</c:v>
                </c:pt>
                <c:pt idx="2749">
                  <c:v>638.39504580054199</c:v>
                </c:pt>
                <c:pt idx="2750">
                  <c:v>638.62727390014197</c:v>
                </c:pt>
                <c:pt idx="2751">
                  <c:v>638.85950199974195</c:v>
                </c:pt>
                <c:pt idx="2752">
                  <c:v>639.09173009934204</c:v>
                </c:pt>
                <c:pt idx="2753">
                  <c:v>639.32395819894202</c:v>
                </c:pt>
                <c:pt idx="2754">
                  <c:v>639.556186298542</c:v>
                </c:pt>
                <c:pt idx="2755">
                  <c:v>639.78841439814198</c:v>
                </c:pt>
                <c:pt idx="2756">
                  <c:v>640.02064249774196</c:v>
                </c:pt>
                <c:pt idx="2757">
                  <c:v>640.25287059734205</c:v>
                </c:pt>
                <c:pt idx="2758">
                  <c:v>640.48509869694203</c:v>
                </c:pt>
                <c:pt idx="2759">
                  <c:v>640.71732679654201</c:v>
                </c:pt>
                <c:pt idx="2760">
                  <c:v>640.94955489614199</c:v>
                </c:pt>
                <c:pt idx="2761">
                  <c:v>641.18178299574299</c:v>
                </c:pt>
                <c:pt idx="2762">
                  <c:v>641.41401109534297</c:v>
                </c:pt>
                <c:pt idx="2763">
                  <c:v>641.64623919494295</c:v>
                </c:pt>
                <c:pt idx="2764">
                  <c:v>641.87846729454304</c:v>
                </c:pt>
                <c:pt idx="2765">
                  <c:v>642.11069539414302</c:v>
                </c:pt>
                <c:pt idx="2766">
                  <c:v>642.342923493743</c:v>
                </c:pt>
                <c:pt idx="2767">
                  <c:v>642.57515159334298</c:v>
                </c:pt>
                <c:pt idx="2768">
                  <c:v>642.80737969294296</c:v>
                </c:pt>
                <c:pt idx="2769">
                  <c:v>643.03960779254305</c:v>
                </c:pt>
                <c:pt idx="2770">
                  <c:v>643.27183589214303</c:v>
                </c:pt>
                <c:pt idx="2771">
                  <c:v>643.50406399174301</c:v>
                </c:pt>
                <c:pt idx="2772">
                  <c:v>643.73629209134299</c:v>
                </c:pt>
                <c:pt idx="2773">
                  <c:v>643.96852019094297</c:v>
                </c:pt>
                <c:pt idx="2774">
                  <c:v>644.20074829054295</c:v>
                </c:pt>
                <c:pt idx="2775">
                  <c:v>644.43297639014304</c:v>
                </c:pt>
                <c:pt idx="2776">
                  <c:v>644.66520448974302</c:v>
                </c:pt>
                <c:pt idx="2777">
                  <c:v>644.897432589343</c:v>
                </c:pt>
                <c:pt idx="2778">
                  <c:v>645.12966068894298</c:v>
                </c:pt>
                <c:pt idx="2779">
                  <c:v>645.36188878854296</c:v>
                </c:pt>
                <c:pt idx="2780">
                  <c:v>645.59411688814396</c:v>
                </c:pt>
                <c:pt idx="2781">
                  <c:v>645.82634498774303</c:v>
                </c:pt>
                <c:pt idx="2782">
                  <c:v>646.05857308734403</c:v>
                </c:pt>
                <c:pt idx="2783">
                  <c:v>646.29080118694401</c:v>
                </c:pt>
                <c:pt idx="2784">
                  <c:v>646.52302928654399</c:v>
                </c:pt>
                <c:pt idx="2785">
                  <c:v>646.75525738614397</c:v>
                </c:pt>
                <c:pt idx="2786">
                  <c:v>646.98748548574395</c:v>
                </c:pt>
                <c:pt idx="2787">
                  <c:v>647.21971358534404</c:v>
                </c:pt>
                <c:pt idx="2788">
                  <c:v>647.45194168494402</c:v>
                </c:pt>
                <c:pt idx="2789">
                  <c:v>647.684169784544</c:v>
                </c:pt>
                <c:pt idx="2790">
                  <c:v>647.91639788414398</c:v>
                </c:pt>
                <c:pt idx="2791">
                  <c:v>648.14862598374395</c:v>
                </c:pt>
                <c:pt idx="2792">
                  <c:v>648.38085408334405</c:v>
                </c:pt>
                <c:pt idx="2793">
                  <c:v>648.61308218294403</c:v>
                </c:pt>
                <c:pt idx="2794">
                  <c:v>648.84531028254401</c:v>
                </c:pt>
                <c:pt idx="2795">
                  <c:v>649.07753838214398</c:v>
                </c:pt>
                <c:pt idx="2796">
                  <c:v>649.30976648174396</c:v>
                </c:pt>
                <c:pt idx="2797">
                  <c:v>649.54199458134406</c:v>
                </c:pt>
                <c:pt idx="2798">
                  <c:v>649.77422268094404</c:v>
                </c:pt>
                <c:pt idx="2799">
                  <c:v>650.00645078054401</c:v>
                </c:pt>
                <c:pt idx="2800">
                  <c:v>650.23867888014502</c:v>
                </c:pt>
                <c:pt idx="2801">
                  <c:v>650.470906979745</c:v>
                </c:pt>
                <c:pt idx="2802">
                  <c:v>650.70313507934497</c:v>
                </c:pt>
                <c:pt idx="2803">
                  <c:v>650.93536317894495</c:v>
                </c:pt>
                <c:pt idx="2804">
                  <c:v>651.16759127854505</c:v>
                </c:pt>
                <c:pt idx="2805">
                  <c:v>651.39981937814503</c:v>
                </c:pt>
                <c:pt idx="2806">
                  <c:v>651.632047477745</c:v>
                </c:pt>
                <c:pt idx="2807">
                  <c:v>651.86427557734498</c:v>
                </c:pt>
                <c:pt idx="2808">
                  <c:v>652.09650367694496</c:v>
                </c:pt>
                <c:pt idx="2809">
                  <c:v>652.32873177654506</c:v>
                </c:pt>
                <c:pt idx="2810">
                  <c:v>652.56095987614503</c:v>
                </c:pt>
                <c:pt idx="2811">
                  <c:v>652.79318797574501</c:v>
                </c:pt>
                <c:pt idx="2812">
                  <c:v>653.02541607534499</c:v>
                </c:pt>
                <c:pt idx="2813">
                  <c:v>653.25764417494497</c:v>
                </c:pt>
                <c:pt idx="2814">
                  <c:v>653.48987227454495</c:v>
                </c:pt>
                <c:pt idx="2815">
                  <c:v>653.72210037414504</c:v>
                </c:pt>
                <c:pt idx="2816">
                  <c:v>653.95432847374502</c:v>
                </c:pt>
                <c:pt idx="2817">
                  <c:v>654.186556573345</c:v>
                </c:pt>
                <c:pt idx="2818">
                  <c:v>654.41878467294498</c:v>
                </c:pt>
                <c:pt idx="2819">
                  <c:v>654.65101277254598</c:v>
                </c:pt>
                <c:pt idx="2820">
                  <c:v>654.88324087214596</c:v>
                </c:pt>
                <c:pt idx="2821">
                  <c:v>655.11546897174605</c:v>
                </c:pt>
                <c:pt idx="2822">
                  <c:v>655.34769707134603</c:v>
                </c:pt>
                <c:pt idx="2823">
                  <c:v>655.57992517094601</c:v>
                </c:pt>
                <c:pt idx="2824">
                  <c:v>655.81215327054599</c:v>
                </c:pt>
                <c:pt idx="2825">
                  <c:v>656.04438137014597</c:v>
                </c:pt>
                <c:pt idx="2826">
                  <c:v>656.27660946974595</c:v>
                </c:pt>
                <c:pt idx="2827">
                  <c:v>656.50883756934604</c:v>
                </c:pt>
                <c:pt idx="2828">
                  <c:v>656.74106566894602</c:v>
                </c:pt>
                <c:pt idx="2829">
                  <c:v>656.973293768546</c:v>
                </c:pt>
                <c:pt idx="2830">
                  <c:v>657.20552186814598</c:v>
                </c:pt>
                <c:pt idx="2831">
                  <c:v>657.43774996774596</c:v>
                </c:pt>
                <c:pt idx="2832">
                  <c:v>657.66997806734605</c:v>
                </c:pt>
                <c:pt idx="2833">
                  <c:v>657.90220616694603</c:v>
                </c:pt>
                <c:pt idx="2834">
                  <c:v>658.13443426654601</c:v>
                </c:pt>
                <c:pt idx="2835">
                  <c:v>658.36666236614599</c:v>
                </c:pt>
                <c:pt idx="2836">
                  <c:v>658.59889046574597</c:v>
                </c:pt>
                <c:pt idx="2837">
                  <c:v>658.83111856534595</c:v>
                </c:pt>
                <c:pt idx="2838">
                  <c:v>659.06334666494604</c:v>
                </c:pt>
                <c:pt idx="2839">
                  <c:v>659.29557476454602</c:v>
                </c:pt>
                <c:pt idx="2840">
                  <c:v>659.52780286414702</c:v>
                </c:pt>
                <c:pt idx="2841">
                  <c:v>659.760030963747</c:v>
                </c:pt>
                <c:pt idx="2842">
                  <c:v>659.99225906334698</c:v>
                </c:pt>
                <c:pt idx="2843">
                  <c:v>660.22448716294696</c:v>
                </c:pt>
                <c:pt idx="2844">
                  <c:v>660.45671526254705</c:v>
                </c:pt>
                <c:pt idx="2845">
                  <c:v>660.68894336214703</c:v>
                </c:pt>
                <c:pt idx="2846">
                  <c:v>660.92117146174701</c:v>
                </c:pt>
                <c:pt idx="2847">
                  <c:v>661.15339956134699</c:v>
                </c:pt>
                <c:pt idx="2848">
                  <c:v>661.38562766094697</c:v>
                </c:pt>
                <c:pt idx="2849">
                  <c:v>661.61785576054695</c:v>
                </c:pt>
                <c:pt idx="2850">
                  <c:v>661.85008386014704</c:v>
                </c:pt>
                <c:pt idx="2851">
                  <c:v>662.08231195974702</c:v>
                </c:pt>
                <c:pt idx="2852">
                  <c:v>662.314540059347</c:v>
                </c:pt>
                <c:pt idx="2853">
                  <c:v>662.54676815894697</c:v>
                </c:pt>
                <c:pt idx="2854">
                  <c:v>662.77899625854695</c:v>
                </c:pt>
                <c:pt idx="2855">
                  <c:v>663.01122435814705</c:v>
                </c:pt>
                <c:pt idx="2856">
                  <c:v>663.24345245774703</c:v>
                </c:pt>
                <c:pt idx="2857">
                  <c:v>663.475680557347</c:v>
                </c:pt>
                <c:pt idx="2858">
                  <c:v>663.70790865694801</c:v>
                </c:pt>
                <c:pt idx="2859">
                  <c:v>663.94013675654799</c:v>
                </c:pt>
                <c:pt idx="2860">
                  <c:v>664.17236485614796</c:v>
                </c:pt>
                <c:pt idx="2861">
                  <c:v>664.40459295574794</c:v>
                </c:pt>
                <c:pt idx="2862">
                  <c:v>664.63682105534804</c:v>
                </c:pt>
                <c:pt idx="2863">
                  <c:v>664.86904915494802</c:v>
                </c:pt>
                <c:pt idx="2864">
                  <c:v>665.10127725454799</c:v>
                </c:pt>
                <c:pt idx="2865">
                  <c:v>665.33350535414797</c:v>
                </c:pt>
                <c:pt idx="2866">
                  <c:v>665.56573345374795</c:v>
                </c:pt>
                <c:pt idx="2867">
                  <c:v>665.79796155334805</c:v>
                </c:pt>
                <c:pt idx="2868">
                  <c:v>666.03018965294802</c:v>
                </c:pt>
                <c:pt idx="2869">
                  <c:v>666.262417752548</c:v>
                </c:pt>
                <c:pt idx="2870">
                  <c:v>666.49464585214798</c:v>
                </c:pt>
                <c:pt idx="2871">
                  <c:v>666.72687395174796</c:v>
                </c:pt>
                <c:pt idx="2872">
                  <c:v>666.95910205134805</c:v>
                </c:pt>
                <c:pt idx="2873">
                  <c:v>667.19133015094803</c:v>
                </c:pt>
                <c:pt idx="2874">
                  <c:v>667.42355825054801</c:v>
                </c:pt>
                <c:pt idx="2875">
                  <c:v>667.65578635014799</c:v>
                </c:pt>
                <c:pt idx="2876">
                  <c:v>667.88801444974797</c:v>
                </c:pt>
                <c:pt idx="2877">
                  <c:v>668.12024254934897</c:v>
                </c:pt>
                <c:pt idx="2878">
                  <c:v>668.35247064894804</c:v>
                </c:pt>
                <c:pt idx="2879">
                  <c:v>668.58469874854904</c:v>
                </c:pt>
                <c:pt idx="2880">
                  <c:v>668.81692684814902</c:v>
                </c:pt>
                <c:pt idx="2881">
                  <c:v>669.049154947749</c:v>
                </c:pt>
                <c:pt idx="2882">
                  <c:v>669.28138304734898</c:v>
                </c:pt>
                <c:pt idx="2883">
                  <c:v>669.51361114694896</c:v>
                </c:pt>
                <c:pt idx="2884">
                  <c:v>669.74583924654905</c:v>
                </c:pt>
                <c:pt idx="2885">
                  <c:v>669.97806734614903</c:v>
                </c:pt>
                <c:pt idx="2886">
                  <c:v>670.21029544574901</c:v>
                </c:pt>
                <c:pt idx="2887">
                  <c:v>670.44252354534899</c:v>
                </c:pt>
                <c:pt idx="2888">
                  <c:v>670.67475164494897</c:v>
                </c:pt>
                <c:pt idx="2889">
                  <c:v>670.90697974454895</c:v>
                </c:pt>
                <c:pt idx="2890">
                  <c:v>671.13920784414904</c:v>
                </c:pt>
                <c:pt idx="2891">
                  <c:v>671.37143594374902</c:v>
                </c:pt>
                <c:pt idx="2892">
                  <c:v>671.603664043349</c:v>
                </c:pt>
                <c:pt idx="2893">
                  <c:v>671.83589214294898</c:v>
                </c:pt>
                <c:pt idx="2894">
                  <c:v>672.06812024254896</c:v>
                </c:pt>
                <c:pt idx="2895">
                  <c:v>672.30034834214905</c:v>
                </c:pt>
                <c:pt idx="2896">
                  <c:v>672.53257644174903</c:v>
                </c:pt>
                <c:pt idx="2897">
                  <c:v>672.76480454135003</c:v>
                </c:pt>
                <c:pt idx="2898">
                  <c:v>672.99703264095001</c:v>
                </c:pt>
                <c:pt idx="2899">
                  <c:v>673.22926074054999</c:v>
                </c:pt>
                <c:pt idx="2900">
                  <c:v>673.46148884014997</c:v>
                </c:pt>
                <c:pt idx="2901">
                  <c:v>673.69371693974995</c:v>
                </c:pt>
                <c:pt idx="2902">
                  <c:v>673.92594503935004</c:v>
                </c:pt>
                <c:pt idx="2903">
                  <c:v>674.15817313895002</c:v>
                </c:pt>
                <c:pt idx="2904">
                  <c:v>674.39040123855</c:v>
                </c:pt>
                <c:pt idx="2905">
                  <c:v>674.62262933814998</c:v>
                </c:pt>
                <c:pt idx="2906">
                  <c:v>674.85485743774996</c:v>
                </c:pt>
                <c:pt idx="2907">
                  <c:v>675.08708553735005</c:v>
                </c:pt>
                <c:pt idx="2908">
                  <c:v>675.31931363695003</c:v>
                </c:pt>
                <c:pt idx="2909">
                  <c:v>675.55154173655001</c:v>
                </c:pt>
                <c:pt idx="2910">
                  <c:v>675.78376983614999</c:v>
                </c:pt>
                <c:pt idx="2911">
                  <c:v>676.01599793574997</c:v>
                </c:pt>
                <c:pt idx="2912">
                  <c:v>676.24822603534994</c:v>
                </c:pt>
                <c:pt idx="2913">
                  <c:v>676.48045413495004</c:v>
                </c:pt>
                <c:pt idx="2914">
                  <c:v>676.71268223455002</c:v>
                </c:pt>
                <c:pt idx="2915">
                  <c:v>676.94491033414999</c:v>
                </c:pt>
                <c:pt idx="2916">
                  <c:v>677.177138433751</c:v>
                </c:pt>
                <c:pt idx="2917">
                  <c:v>677.40936653335098</c:v>
                </c:pt>
                <c:pt idx="2918">
                  <c:v>677.64159463295096</c:v>
                </c:pt>
                <c:pt idx="2919">
                  <c:v>677.87382273255105</c:v>
                </c:pt>
                <c:pt idx="2920">
                  <c:v>678.10605083215103</c:v>
                </c:pt>
                <c:pt idx="2921">
                  <c:v>678.33827893175101</c:v>
                </c:pt>
                <c:pt idx="2922">
                  <c:v>678.57050703135099</c:v>
                </c:pt>
                <c:pt idx="2923">
                  <c:v>678.80273513095096</c:v>
                </c:pt>
                <c:pt idx="2924">
                  <c:v>679.03496323055106</c:v>
                </c:pt>
                <c:pt idx="2925">
                  <c:v>679.26719133015104</c:v>
                </c:pt>
                <c:pt idx="2926">
                  <c:v>679.49941942975101</c:v>
                </c:pt>
                <c:pt idx="2927">
                  <c:v>679.73164752935099</c:v>
                </c:pt>
                <c:pt idx="2928">
                  <c:v>679.96387562895097</c:v>
                </c:pt>
                <c:pt idx="2929">
                  <c:v>680.19610372855095</c:v>
                </c:pt>
                <c:pt idx="2930">
                  <c:v>680.42833182815104</c:v>
                </c:pt>
                <c:pt idx="2931">
                  <c:v>680.66055992775102</c:v>
                </c:pt>
                <c:pt idx="2932">
                  <c:v>680.892788027351</c:v>
                </c:pt>
                <c:pt idx="2933">
                  <c:v>681.12501612695098</c:v>
                </c:pt>
                <c:pt idx="2934">
                  <c:v>681.35724422655096</c:v>
                </c:pt>
                <c:pt idx="2935">
                  <c:v>681.58947232615196</c:v>
                </c:pt>
                <c:pt idx="2936">
                  <c:v>681.82170042575103</c:v>
                </c:pt>
                <c:pt idx="2937">
                  <c:v>682.05392852535203</c:v>
                </c:pt>
                <c:pt idx="2938">
                  <c:v>682.28615662495201</c:v>
                </c:pt>
                <c:pt idx="2939">
                  <c:v>682.51838472455199</c:v>
                </c:pt>
                <c:pt idx="2940">
                  <c:v>682.75061282415197</c:v>
                </c:pt>
                <c:pt idx="2941">
                  <c:v>682.98284092375195</c:v>
                </c:pt>
                <c:pt idx="2942">
                  <c:v>683.21506902335204</c:v>
                </c:pt>
                <c:pt idx="2943">
                  <c:v>683.44729712295202</c:v>
                </c:pt>
                <c:pt idx="2944">
                  <c:v>683.679525222552</c:v>
                </c:pt>
                <c:pt idx="2945">
                  <c:v>683.91175332215198</c:v>
                </c:pt>
                <c:pt idx="2946">
                  <c:v>684.14398142175196</c:v>
                </c:pt>
                <c:pt idx="2947">
                  <c:v>684.37620952135205</c:v>
                </c:pt>
                <c:pt idx="2948">
                  <c:v>684.60843762095203</c:v>
                </c:pt>
                <c:pt idx="2949">
                  <c:v>684.84066572055201</c:v>
                </c:pt>
                <c:pt idx="2950">
                  <c:v>685.07289382015199</c:v>
                </c:pt>
                <c:pt idx="2951">
                  <c:v>685.30512191975197</c:v>
                </c:pt>
                <c:pt idx="2952">
                  <c:v>685.53735001935195</c:v>
                </c:pt>
                <c:pt idx="2953">
                  <c:v>685.76957811895204</c:v>
                </c:pt>
                <c:pt idx="2954">
                  <c:v>686.00180621855202</c:v>
                </c:pt>
                <c:pt idx="2955">
                  <c:v>686.23403431815302</c:v>
                </c:pt>
                <c:pt idx="2956">
                  <c:v>686.466262417753</c:v>
                </c:pt>
                <c:pt idx="2957">
                  <c:v>686.69849051735298</c:v>
                </c:pt>
                <c:pt idx="2958">
                  <c:v>686.93071861695296</c:v>
                </c:pt>
                <c:pt idx="2959">
                  <c:v>687.16294671655305</c:v>
                </c:pt>
                <c:pt idx="2960">
                  <c:v>687.39517481615303</c:v>
                </c:pt>
                <c:pt idx="2961">
                  <c:v>687.62740291575301</c:v>
                </c:pt>
                <c:pt idx="2962">
                  <c:v>687.85963101535299</c:v>
                </c:pt>
                <c:pt idx="2963">
                  <c:v>688.09185911495297</c:v>
                </c:pt>
                <c:pt idx="2964">
                  <c:v>688.32408721455295</c:v>
                </c:pt>
                <c:pt idx="2965">
                  <c:v>688.55631531415304</c:v>
                </c:pt>
                <c:pt idx="2966">
                  <c:v>688.78854341375302</c:v>
                </c:pt>
                <c:pt idx="2967">
                  <c:v>689.020771513353</c:v>
                </c:pt>
                <c:pt idx="2968">
                  <c:v>689.25299961295298</c:v>
                </c:pt>
                <c:pt idx="2969">
                  <c:v>689.48522771255296</c:v>
                </c:pt>
                <c:pt idx="2970">
                  <c:v>689.71745581215305</c:v>
                </c:pt>
                <c:pt idx="2971">
                  <c:v>689.94968391175303</c:v>
                </c:pt>
                <c:pt idx="2972">
                  <c:v>690.18191201135301</c:v>
                </c:pt>
                <c:pt idx="2973">
                  <c:v>690.41414011095299</c:v>
                </c:pt>
                <c:pt idx="2974">
                  <c:v>690.64636821055399</c:v>
                </c:pt>
                <c:pt idx="2975">
                  <c:v>690.87859631015397</c:v>
                </c:pt>
                <c:pt idx="2976">
                  <c:v>691.11082440975395</c:v>
                </c:pt>
                <c:pt idx="2977">
                  <c:v>691.34305250935404</c:v>
                </c:pt>
                <c:pt idx="2978">
                  <c:v>691.57528060895402</c:v>
                </c:pt>
                <c:pt idx="2979">
                  <c:v>691.807508708554</c:v>
                </c:pt>
                <c:pt idx="2980">
                  <c:v>692.03973680815398</c:v>
                </c:pt>
                <c:pt idx="2981">
                  <c:v>692.27196490775395</c:v>
                </c:pt>
                <c:pt idx="2982">
                  <c:v>692.50419300735405</c:v>
                </c:pt>
                <c:pt idx="2983">
                  <c:v>692.73642110695403</c:v>
                </c:pt>
                <c:pt idx="2984">
                  <c:v>692.96864920655401</c:v>
                </c:pt>
                <c:pt idx="2985">
                  <c:v>693.20087730615398</c:v>
                </c:pt>
                <c:pt idx="2986">
                  <c:v>693.43310540575396</c:v>
                </c:pt>
                <c:pt idx="2987">
                  <c:v>693.66533350535406</c:v>
                </c:pt>
                <c:pt idx="2988">
                  <c:v>693.89756160495403</c:v>
                </c:pt>
                <c:pt idx="2989">
                  <c:v>694.12978970455401</c:v>
                </c:pt>
                <c:pt idx="2990">
                  <c:v>694.36201780415399</c:v>
                </c:pt>
                <c:pt idx="2991">
                  <c:v>694.59424590375397</c:v>
                </c:pt>
                <c:pt idx="2992">
                  <c:v>694.82647400335395</c:v>
                </c:pt>
                <c:pt idx="2993">
                  <c:v>695.05870210295404</c:v>
                </c:pt>
                <c:pt idx="2994">
                  <c:v>695.29093020255402</c:v>
                </c:pt>
                <c:pt idx="2995">
                  <c:v>695.52315830215503</c:v>
                </c:pt>
                <c:pt idx="2996">
                  <c:v>695.755386401755</c:v>
                </c:pt>
                <c:pt idx="2997">
                  <c:v>695.98761450135498</c:v>
                </c:pt>
                <c:pt idx="2998">
                  <c:v>696.21984260095496</c:v>
                </c:pt>
                <c:pt idx="2999">
                  <c:v>696.45207070055505</c:v>
                </c:pt>
                <c:pt idx="3000">
                  <c:v>696.68429880015503</c:v>
                </c:pt>
                <c:pt idx="3001">
                  <c:v>696.91652689975501</c:v>
                </c:pt>
                <c:pt idx="3002">
                  <c:v>697.14875499935499</c:v>
                </c:pt>
                <c:pt idx="3003">
                  <c:v>697.38098309895497</c:v>
                </c:pt>
                <c:pt idx="3004">
                  <c:v>697.61321119855495</c:v>
                </c:pt>
                <c:pt idx="3005">
                  <c:v>697.84543929815504</c:v>
                </c:pt>
                <c:pt idx="3006">
                  <c:v>698.07766739775502</c:v>
                </c:pt>
                <c:pt idx="3007">
                  <c:v>698.309895497355</c:v>
                </c:pt>
                <c:pt idx="3008">
                  <c:v>698.54212359695498</c:v>
                </c:pt>
                <c:pt idx="3009">
                  <c:v>698.77435169655496</c:v>
                </c:pt>
                <c:pt idx="3010">
                  <c:v>699.00657979615505</c:v>
                </c:pt>
                <c:pt idx="3011">
                  <c:v>699.23880789575503</c:v>
                </c:pt>
                <c:pt idx="3012">
                  <c:v>699.47103599535501</c:v>
                </c:pt>
                <c:pt idx="3013">
                  <c:v>699.70326409495601</c:v>
                </c:pt>
                <c:pt idx="3014">
                  <c:v>699.93549219455599</c:v>
                </c:pt>
                <c:pt idx="3015">
                  <c:v>700.16772029415597</c:v>
                </c:pt>
                <c:pt idx="3016">
                  <c:v>700.39994839375595</c:v>
                </c:pt>
                <c:pt idx="3017">
                  <c:v>700.63217649335604</c:v>
                </c:pt>
                <c:pt idx="3018">
                  <c:v>700.86440459295602</c:v>
                </c:pt>
                <c:pt idx="3019">
                  <c:v>701.096632692556</c:v>
                </c:pt>
                <c:pt idx="3020">
                  <c:v>701.32886079215598</c:v>
                </c:pt>
                <c:pt idx="3021">
                  <c:v>701.56108889175596</c:v>
                </c:pt>
                <c:pt idx="3022">
                  <c:v>701.79331699135605</c:v>
                </c:pt>
                <c:pt idx="3023">
                  <c:v>702.02554509095603</c:v>
                </c:pt>
                <c:pt idx="3024">
                  <c:v>702.25777319055601</c:v>
                </c:pt>
                <c:pt idx="3025">
                  <c:v>702.49000129015599</c:v>
                </c:pt>
                <c:pt idx="3026">
                  <c:v>702.72222938975597</c:v>
                </c:pt>
                <c:pt idx="3027">
                  <c:v>702.95445748935595</c:v>
                </c:pt>
                <c:pt idx="3028">
                  <c:v>703.18668558895604</c:v>
                </c:pt>
                <c:pt idx="3029">
                  <c:v>703.41891368855602</c:v>
                </c:pt>
                <c:pt idx="3030">
                  <c:v>703.651141788156</c:v>
                </c:pt>
                <c:pt idx="3031">
                  <c:v>703.88336988775598</c:v>
                </c:pt>
                <c:pt idx="3032">
                  <c:v>704.11559798735698</c:v>
                </c:pt>
                <c:pt idx="3033">
                  <c:v>704.34782608695696</c:v>
                </c:pt>
                <c:pt idx="3034">
                  <c:v>704.58005418655705</c:v>
                </c:pt>
                <c:pt idx="3035">
                  <c:v>704.81228228615703</c:v>
                </c:pt>
                <c:pt idx="3036">
                  <c:v>705.04451038575701</c:v>
                </c:pt>
                <c:pt idx="3037">
                  <c:v>705.27673848535699</c:v>
                </c:pt>
                <c:pt idx="3038">
                  <c:v>705.50896658495697</c:v>
                </c:pt>
                <c:pt idx="3039">
                  <c:v>705.74119468455694</c:v>
                </c:pt>
                <c:pt idx="3040">
                  <c:v>705.97342278415704</c:v>
                </c:pt>
                <c:pt idx="3041">
                  <c:v>706.20565088375702</c:v>
                </c:pt>
                <c:pt idx="3042">
                  <c:v>706.437878983357</c:v>
                </c:pt>
                <c:pt idx="3043">
                  <c:v>706.67010708295697</c:v>
                </c:pt>
                <c:pt idx="3044">
                  <c:v>706.90233518255695</c:v>
                </c:pt>
                <c:pt idx="3045">
                  <c:v>707.13456328215705</c:v>
                </c:pt>
                <c:pt idx="3046">
                  <c:v>707.36679138175703</c:v>
                </c:pt>
                <c:pt idx="3047">
                  <c:v>707.599019481357</c:v>
                </c:pt>
                <c:pt idx="3048">
                  <c:v>707.83124758095698</c:v>
                </c:pt>
                <c:pt idx="3049">
                  <c:v>708.06347568055696</c:v>
                </c:pt>
                <c:pt idx="3050">
                  <c:v>708.29570378015706</c:v>
                </c:pt>
                <c:pt idx="3051">
                  <c:v>708.52793187975703</c:v>
                </c:pt>
                <c:pt idx="3052">
                  <c:v>708.76015997935701</c:v>
                </c:pt>
                <c:pt idx="3053">
                  <c:v>708.99238807895802</c:v>
                </c:pt>
                <c:pt idx="3054">
                  <c:v>709.22461617855799</c:v>
                </c:pt>
                <c:pt idx="3055">
                  <c:v>709.45684427815797</c:v>
                </c:pt>
                <c:pt idx="3056">
                  <c:v>709.68907237775795</c:v>
                </c:pt>
                <c:pt idx="3057">
                  <c:v>709.92130047735805</c:v>
                </c:pt>
                <c:pt idx="3058">
                  <c:v>710.15352857695802</c:v>
                </c:pt>
                <c:pt idx="3059">
                  <c:v>710.385756676558</c:v>
                </c:pt>
                <c:pt idx="3060">
                  <c:v>710.61798477615798</c:v>
                </c:pt>
                <c:pt idx="3061">
                  <c:v>710.85021287575796</c:v>
                </c:pt>
                <c:pt idx="3062">
                  <c:v>711.08244097535805</c:v>
                </c:pt>
                <c:pt idx="3063">
                  <c:v>711.31466907495803</c:v>
                </c:pt>
                <c:pt idx="3064">
                  <c:v>711.54689717455801</c:v>
                </c:pt>
                <c:pt idx="3065">
                  <c:v>711.77912527415799</c:v>
                </c:pt>
                <c:pt idx="3066">
                  <c:v>712.01135337375797</c:v>
                </c:pt>
                <c:pt idx="3067">
                  <c:v>712.24358147335795</c:v>
                </c:pt>
                <c:pt idx="3068">
                  <c:v>712.47580957295804</c:v>
                </c:pt>
                <c:pt idx="3069">
                  <c:v>712.70803767255802</c:v>
                </c:pt>
                <c:pt idx="3070">
                  <c:v>712.940265772158</c:v>
                </c:pt>
                <c:pt idx="3071">
                  <c:v>713.172493871759</c:v>
                </c:pt>
                <c:pt idx="3072">
                  <c:v>713.40472197135898</c:v>
                </c:pt>
                <c:pt idx="3073">
                  <c:v>713.63695007095896</c:v>
                </c:pt>
                <c:pt idx="3074">
                  <c:v>713.86917817055905</c:v>
                </c:pt>
                <c:pt idx="3075">
                  <c:v>714.10140627015903</c:v>
                </c:pt>
                <c:pt idx="3076">
                  <c:v>714.33363436975901</c:v>
                </c:pt>
                <c:pt idx="3077">
                  <c:v>714.56586246935899</c:v>
                </c:pt>
                <c:pt idx="3078">
                  <c:v>714.79809056895897</c:v>
                </c:pt>
                <c:pt idx="3079">
                  <c:v>715.03031866855895</c:v>
                </c:pt>
                <c:pt idx="3080">
                  <c:v>715.26254676815904</c:v>
                </c:pt>
                <c:pt idx="3081">
                  <c:v>715.49477486775902</c:v>
                </c:pt>
                <c:pt idx="3082">
                  <c:v>715.727002967359</c:v>
                </c:pt>
                <c:pt idx="3083">
                  <c:v>715.95923106695898</c:v>
                </c:pt>
                <c:pt idx="3084">
                  <c:v>716.19145916655896</c:v>
                </c:pt>
                <c:pt idx="3085">
                  <c:v>716.42368726615905</c:v>
                </c:pt>
                <c:pt idx="3086">
                  <c:v>716.65591536575903</c:v>
                </c:pt>
                <c:pt idx="3087">
                  <c:v>716.88814346535901</c:v>
                </c:pt>
                <c:pt idx="3088">
                  <c:v>717.12037156495899</c:v>
                </c:pt>
                <c:pt idx="3089">
                  <c:v>717.35259966455897</c:v>
                </c:pt>
                <c:pt idx="3090">
                  <c:v>717.58482776415997</c:v>
                </c:pt>
                <c:pt idx="3091">
                  <c:v>717.81705586375904</c:v>
                </c:pt>
                <c:pt idx="3092">
                  <c:v>718.04928396336004</c:v>
                </c:pt>
                <c:pt idx="3093">
                  <c:v>718.28151206296002</c:v>
                </c:pt>
                <c:pt idx="3094">
                  <c:v>718.51374016256</c:v>
                </c:pt>
                <c:pt idx="3095">
                  <c:v>718.74596826215998</c:v>
                </c:pt>
                <c:pt idx="3096">
                  <c:v>718.97819636175996</c:v>
                </c:pt>
                <c:pt idx="3097">
                  <c:v>719.21042446136005</c:v>
                </c:pt>
                <c:pt idx="3098">
                  <c:v>719.44265256096003</c:v>
                </c:pt>
                <c:pt idx="3099">
                  <c:v>719.67488066056001</c:v>
                </c:pt>
                <c:pt idx="3100">
                  <c:v>719.90710876015999</c:v>
                </c:pt>
                <c:pt idx="3101">
                  <c:v>720.13933685975996</c:v>
                </c:pt>
                <c:pt idx="3102">
                  <c:v>720.37156495935994</c:v>
                </c:pt>
                <c:pt idx="3103">
                  <c:v>720.60379305896004</c:v>
                </c:pt>
                <c:pt idx="3104">
                  <c:v>720.83602115856002</c:v>
                </c:pt>
                <c:pt idx="3105">
                  <c:v>721.06824925815999</c:v>
                </c:pt>
                <c:pt idx="3106">
                  <c:v>721.30047735775997</c:v>
                </c:pt>
                <c:pt idx="3107">
                  <c:v>721.53270545735995</c:v>
                </c:pt>
                <c:pt idx="3108">
                  <c:v>721.76493355696005</c:v>
                </c:pt>
                <c:pt idx="3109">
                  <c:v>721.99716165656002</c:v>
                </c:pt>
                <c:pt idx="3110">
                  <c:v>722.22938975616103</c:v>
                </c:pt>
                <c:pt idx="3111">
                  <c:v>722.46161785576101</c:v>
                </c:pt>
                <c:pt idx="3112">
                  <c:v>722.69384595536098</c:v>
                </c:pt>
                <c:pt idx="3113">
                  <c:v>722.92607405496096</c:v>
                </c:pt>
                <c:pt idx="3114">
                  <c:v>723.15830215456106</c:v>
                </c:pt>
                <c:pt idx="3115">
                  <c:v>723.39053025416104</c:v>
                </c:pt>
                <c:pt idx="3116">
                  <c:v>723.62275835376101</c:v>
                </c:pt>
                <c:pt idx="3117">
                  <c:v>723.85498645336099</c:v>
                </c:pt>
                <c:pt idx="3118">
                  <c:v>724.08721455296097</c:v>
                </c:pt>
                <c:pt idx="3119">
                  <c:v>724.31944265256095</c:v>
                </c:pt>
                <c:pt idx="3120">
                  <c:v>724.55167075216104</c:v>
                </c:pt>
                <c:pt idx="3121">
                  <c:v>724.78389885176102</c:v>
                </c:pt>
                <c:pt idx="3122">
                  <c:v>725.016126951361</c:v>
                </c:pt>
                <c:pt idx="3123">
                  <c:v>725.24835505096098</c:v>
                </c:pt>
                <c:pt idx="3124">
                  <c:v>725.48058315056096</c:v>
                </c:pt>
                <c:pt idx="3125">
                  <c:v>725.71281125016105</c:v>
                </c:pt>
                <c:pt idx="3126">
                  <c:v>725.94503934976103</c:v>
                </c:pt>
                <c:pt idx="3127">
                  <c:v>726.17726744936101</c:v>
                </c:pt>
                <c:pt idx="3128">
                  <c:v>726.40949554896099</c:v>
                </c:pt>
                <c:pt idx="3129">
                  <c:v>726.64172364856199</c:v>
                </c:pt>
                <c:pt idx="3130">
                  <c:v>726.87395174816197</c:v>
                </c:pt>
                <c:pt idx="3131">
                  <c:v>727.10617984776195</c:v>
                </c:pt>
                <c:pt idx="3132">
                  <c:v>727.33840794736204</c:v>
                </c:pt>
                <c:pt idx="3133">
                  <c:v>727.57063604696202</c:v>
                </c:pt>
                <c:pt idx="3134">
                  <c:v>727.802864146562</c:v>
                </c:pt>
                <c:pt idx="3135">
                  <c:v>728.03509224616198</c:v>
                </c:pt>
                <c:pt idx="3136">
                  <c:v>728.26732034576196</c:v>
                </c:pt>
                <c:pt idx="3137">
                  <c:v>728.49954844536205</c:v>
                </c:pt>
                <c:pt idx="3138">
                  <c:v>728.73177654496203</c:v>
                </c:pt>
                <c:pt idx="3139">
                  <c:v>728.96400464456201</c:v>
                </c:pt>
                <c:pt idx="3140">
                  <c:v>729.19623274416199</c:v>
                </c:pt>
                <c:pt idx="3141">
                  <c:v>729.42846084376197</c:v>
                </c:pt>
                <c:pt idx="3142">
                  <c:v>729.66068894336195</c:v>
                </c:pt>
                <c:pt idx="3143">
                  <c:v>729.89291704296204</c:v>
                </c:pt>
                <c:pt idx="3144">
                  <c:v>730.12514514256202</c:v>
                </c:pt>
                <c:pt idx="3145">
                  <c:v>730.357373242162</c:v>
                </c:pt>
                <c:pt idx="3146">
                  <c:v>730.58960134176198</c:v>
                </c:pt>
                <c:pt idx="3147">
                  <c:v>730.82182944136196</c:v>
                </c:pt>
                <c:pt idx="3148">
                  <c:v>731.05405754096296</c:v>
                </c:pt>
                <c:pt idx="3149">
                  <c:v>731.28628564056203</c:v>
                </c:pt>
                <c:pt idx="3150">
                  <c:v>731.51851374016303</c:v>
                </c:pt>
                <c:pt idx="3151">
                  <c:v>731.75074183976301</c:v>
                </c:pt>
                <c:pt idx="3152">
                  <c:v>731.98296993936299</c:v>
                </c:pt>
                <c:pt idx="3153">
                  <c:v>732.21519803896297</c:v>
                </c:pt>
                <c:pt idx="3154">
                  <c:v>732.44742613856295</c:v>
                </c:pt>
                <c:pt idx="3155">
                  <c:v>732.67965423816304</c:v>
                </c:pt>
                <c:pt idx="3156">
                  <c:v>732.91188233776302</c:v>
                </c:pt>
                <c:pt idx="3157">
                  <c:v>733.144110437363</c:v>
                </c:pt>
                <c:pt idx="3158">
                  <c:v>733.37633853696298</c:v>
                </c:pt>
                <c:pt idx="3159">
                  <c:v>733.60856663656295</c:v>
                </c:pt>
                <c:pt idx="3160">
                  <c:v>733.84079473616305</c:v>
                </c:pt>
                <c:pt idx="3161">
                  <c:v>734.07302283576303</c:v>
                </c:pt>
                <c:pt idx="3162">
                  <c:v>734.30525093536301</c:v>
                </c:pt>
                <c:pt idx="3163">
                  <c:v>734.53747903496298</c:v>
                </c:pt>
                <c:pt idx="3164">
                  <c:v>734.76970713456296</c:v>
                </c:pt>
                <c:pt idx="3165">
                  <c:v>735.00193523416306</c:v>
                </c:pt>
                <c:pt idx="3166">
                  <c:v>735.23416333376304</c:v>
                </c:pt>
                <c:pt idx="3167">
                  <c:v>735.46639143336301</c:v>
                </c:pt>
                <c:pt idx="3168">
                  <c:v>735.69861953296402</c:v>
                </c:pt>
                <c:pt idx="3169">
                  <c:v>735.930847632564</c:v>
                </c:pt>
                <c:pt idx="3170">
                  <c:v>736.16307573216397</c:v>
                </c:pt>
                <c:pt idx="3171">
                  <c:v>736.39530383176395</c:v>
                </c:pt>
                <c:pt idx="3172">
                  <c:v>736.62753193136405</c:v>
                </c:pt>
                <c:pt idx="3173">
                  <c:v>736.85976003096403</c:v>
                </c:pt>
                <c:pt idx="3174">
                  <c:v>737.091988130564</c:v>
                </c:pt>
                <c:pt idx="3175">
                  <c:v>737.32421623016398</c:v>
                </c:pt>
                <c:pt idx="3176">
                  <c:v>737.55644432976396</c:v>
                </c:pt>
                <c:pt idx="3177">
                  <c:v>737.78867242936406</c:v>
                </c:pt>
                <c:pt idx="3178">
                  <c:v>738.02090052896403</c:v>
                </c:pt>
                <c:pt idx="3179">
                  <c:v>738.25312862856401</c:v>
                </c:pt>
                <c:pt idx="3180">
                  <c:v>738.48535672816399</c:v>
                </c:pt>
                <c:pt idx="3181">
                  <c:v>738.71758482776397</c:v>
                </c:pt>
                <c:pt idx="3182">
                  <c:v>738.94981292736395</c:v>
                </c:pt>
                <c:pt idx="3183">
                  <c:v>739.18204102696404</c:v>
                </c:pt>
                <c:pt idx="3184">
                  <c:v>739.41426912656402</c:v>
                </c:pt>
                <c:pt idx="3185">
                  <c:v>739.646497226164</c:v>
                </c:pt>
                <c:pt idx="3186">
                  <c:v>739.87872532576398</c:v>
                </c:pt>
                <c:pt idx="3187">
                  <c:v>740.11095342536498</c:v>
                </c:pt>
                <c:pt idx="3188">
                  <c:v>740.34318152496496</c:v>
                </c:pt>
                <c:pt idx="3189">
                  <c:v>740.57540962456505</c:v>
                </c:pt>
                <c:pt idx="3190">
                  <c:v>740.80763772416503</c:v>
                </c:pt>
                <c:pt idx="3191">
                  <c:v>741.03986582376501</c:v>
                </c:pt>
                <c:pt idx="3192">
                  <c:v>741.27209392336499</c:v>
                </c:pt>
                <c:pt idx="3193">
                  <c:v>741.50432202296497</c:v>
                </c:pt>
                <c:pt idx="3194">
                  <c:v>741.73655012256495</c:v>
                </c:pt>
                <c:pt idx="3195">
                  <c:v>741.96877822216504</c:v>
                </c:pt>
                <c:pt idx="3196">
                  <c:v>742.20100632176502</c:v>
                </c:pt>
                <c:pt idx="3197">
                  <c:v>742.433234421365</c:v>
                </c:pt>
                <c:pt idx="3198">
                  <c:v>742.66546252096498</c:v>
                </c:pt>
                <c:pt idx="3199">
                  <c:v>742.89769062056496</c:v>
                </c:pt>
                <c:pt idx="3200">
                  <c:v>743.12991872016505</c:v>
                </c:pt>
                <c:pt idx="3201">
                  <c:v>743.36214681976503</c:v>
                </c:pt>
                <c:pt idx="3202">
                  <c:v>743.59437491936501</c:v>
                </c:pt>
                <c:pt idx="3203">
                  <c:v>743.82660301896499</c:v>
                </c:pt>
                <c:pt idx="3204">
                  <c:v>744.05883111856497</c:v>
                </c:pt>
                <c:pt idx="3205">
                  <c:v>744.29105921816495</c:v>
                </c:pt>
                <c:pt idx="3206">
                  <c:v>744.52328731776504</c:v>
                </c:pt>
                <c:pt idx="3207">
                  <c:v>744.75551541736502</c:v>
                </c:pt>
                <c:pt idx="3208">
                  <c:v>744.98774351696602</c:v>
                </c:pt>
                <c:pt idx="3209">
                  <c:v>745.219971616566</c:v>
                </c:pt>
                <c:pt idx="3210">
                  <c:v>745.45219971616598</c:v>
                </c:pt>
                <c:pt idx="3211">
                  <c:v>745.68442781576596</c:v>
                </c:pt>
                <c:pt idx="3212">
                  <c:v>745.91665591536605</c:v>
                </c:pt>
                <c:pt idx="3213">
                  <c:v>746.14888401496603</c:v>
                </c:pt>
                <c:pt idx="3214">
                  <c:v>746.38111211456601</c:v>
                </c:pt>
                <c:pt idx="3215">
                  <c:v>746.61334021416599</c:v>
                </c:pt>
                <c:pt idx="3216">
                  <c:v>746.84556831376597</c:v>
                </c:pt>
                <c:pt idx="3217">
                  <c:v>747.07779641336595</c:v>
                </c:pt>
                <c:pt idx="3218">
                  <c:v>747.31002451296604</c:v>
                </c:pt>
                <c:pt idx="3219">
                  <c:v>747.54225261256602</c:v>
                </c:pt>
                <c:pt idx="3220">
                  <c:v>747.774480712166</c:v>
                </c:pt>
                <c:pt idx="3221">
                  <c:v>748.00670881176598</c:v>
                </c:pt>
                <c:pt idx="3222">
                  <c:v>748.23893691136595</c:v>
                </c:pt>
                <c:pt idx="3223">
                  <c:v>748.47116501096605</c:v>
                </c:pt>
                <c:pt idx="3224">
                  <c:v>748.70339311056603</c:v>
                </c:pt>
                <c:pt idx="3225">
                  <c:v>748.935621210166</c:v>
                </c:pt>
                <c:pt idx="3226">
                  <c:v>749.16784930976701</c:v>
                </c:pt>
                <c:pt idx="3227">
                  <c:v>749.40007740936699</c:v>
                </c:pt>
                <c:pt idx="3228">
                  <c:v>749.63230550896697</c:v>
                </c:pt>
                <c:pt idx="3229">
                  <c:v>749.86453360856694</c:v>
                </c:pt>
                <c:pt idx="3230">
                  <c:v>750.09676170816704</c:v>
                </c:pt>
                <c:pt idx="3231">
                  <c:v>750.32898980776702</c:v>
                </c:pt>
                <c:pt idx="3232">
                  <c:v>750.56121790736699</c:v>
                </c:pt>
                <c:pt idx="3233">
                  <c:v>750.79344600696697</c:v>
                </c:pt>
                <c:pt idx="3234">
                  <c:v>751.02567410656695</c:v>
                </c:pt>
                <c:pt idx="3235">
                  <c:v>751.25790220616705</c:v>
                </c:pt>
                <c:pt idx="3236">
                  <c:v>751.49013030576702</c:v>
                </c:pt>
                <c:pt idx="3237">
                  <c:v>751.722358405367</c:v>
                </c:pt>
                <c:pt idx="3238">
                  <c:v>751.95458650496698</c:v>
                </c:pt>
                <c:pt idx="3239">
                  <c:v>752.18681460456696</c:v>
                </c:pt>
                <c:pt idx="3240">
                  <c:v>752.41904270416705</c:v>
                </c:pt>
                <c:pt idx="3241">
                  <c:v>752.65127080376703</c:v>
                </c:pt>
                <c:pt idx="3242">
                  <c:v>752.88349890336701</c:v>
                </c:pt>
                <c:pt idx="3243">
                  <c:v>753.11572700296699</c:v>
                </c:pt>
                <c:pt idx="3244">
                  <c:v>753.34795510256697</c:v>
                </c:pt>
                <c:pt idx="3245">
                  <c:v>753.58018320216797</c:v>
                </c:pt>
                <c:pt idx="3246">
                  <c:v>753.81241130176704</c:v>
                </c:pt>
                <c:pt idx="3247">
                  <c:v>754.04463940136804</c:v>
                </c:pt>
                <c:pt idx="3248">
                  <c:v>754.27686750096802</c:v>
                </c:pt>
                <c:pt idx="3249">
                  <c:v>754.509095600568</c:v>
                </c:pt>
                <c:pt idx="3250">
                  <c:v>754.74132370016798</c:v>
                </c:pt>
                <c:pt idx="3251">
                  <c:v>754.97355179976796</c:v>
                </c:pt>
                <c:pt idx="3252">
                  <c:v>755.20577989936805</c:v>
                </c:pt>
                <c:pt idx="3253">
                  <c:v>755.43800799896803</c:v>
                </c:pt>
                <c:pt idx="3254">
                  <c:v>755.67023609856801</c:v>
                </c:pt>
                <c:pt idx="3255">
                  <c:v>755.90246419816799</c:v>
                </c:pt>
                <c:pt idx="3256">
                  <c:v>756.13469229776797</c:v>
                </c:pt>
                <c:pt idx="3257">
                  <c:v>756.36692039736795</c:v>
                </c:pt>
                <c:pt idx="3258">
                  <c:v>756.59914849696804</c:v>
                </c:pt>
                <c:pt idx="3259">
                  <c:v>756.83137659656802</c:v>
                </c:pt>
                <c:pt idx="3260">
                  <c:v>757.063604696168</c:v>
                </c:pt>
                <c:pt idx="3261">
                  <c:v>757.29583279576798</c:v>
                </c:pt>
                <c:pt idx="3262">
                  <c:v>757.52806089536796</c:v>
                </c:pt>
                <c:pt idx="3263">
                  <c:v>757.76028899496805</c:v>
                </c:pt>
                <c:pt idx="3264">
                  <c:v>757.99251709456803</c:v>
                </c:pt>
                <c:pt idx="3265">
                  <c:v>758.22474519416801</c:v>
                </c:pt>
                <c:pt idx="3266">
                  <c:v>758.45697329376901</c:v>
                </c:pt>
                <c:pt idx="3267">
                  <c:v>758.68920139336899</c:v>
                </c:pt>
                <c:pt idx="3268">
                  <c:v>758.92142949296897</c:v>
                </c:pt>
                <c:pt idx="3269">
                  <c:v>759.15365759256895</c:v>
                </c:pt>
                <c:pt idx="3270">
                  <c:v>759.38588569216904</c:v>
                </c:pt>
                <c:pt idx="3271">
                  <c:v>759.61811379176902</c:v>
                </c:pt>
                <c:pt idx="3272">
                  <c:v>759.850341891369</c:v>
                </c:pt>
                <c:pt idx="3273">
                  <c:v>760.08256999096898</c:v>
                </c:pt>
                <c:pt idx="3274">
                  <c:v>760.31479809056896</c:v>
                </c:pt>
                <c:pt idx="3275">
                  <c:v>760.54702619016905</c:v>
                </c:pt>
                <c:pt idx="3276">
                  <c:v>760.77925428976903</c:v>
                </c:pt>
                <c:pt idx="3277">
                  <c:v>761.01148238936901</c:v>
                </c:pt>
                <c:pt idx="3278">
                  <c:v>761.24371048896899</c:v>
                </c:pt>
                <c:pt idx="3279">
                  <c:v>761.47593858856897</c:v>
                </c:pt>
                <c:pt idx="3280">
                  <c:v>761.70816668816894</c:v>
                </c:pt>
                <c:pt idx="3281">
                  <c:v>761.94039478776904</c:v>
                </c:pt>
                <c:pt idx="3282">
                  <c:v>762.17262288736902</c:v>
                </c:pt>
                <c:pt idx="3283">
                  <c:v>762.404850986969</c:v>
                </c:pt>
                <c:pt idx="3284">
                  <c:v>762.63707908657</c:v>
                </c:pt>
                <c:pt idx="3285">
                  <c:v>762.86930718616998</c:v>
                </c:pt>
                <c:pt idx="3286">
                  <c:v>763.10153528576996</c:v>
                </c:pt>
                <c:pt idx="3287">
                  <c:v>763.33376338537005</c:v>
                </c:pt>
                <c:pt idx="3288">
                  <c:v>763.56599148497003</c:v>
                </c:pt>
                <c:pt idx="3289">
                  <c:v>763.79821958457001</c:v>
                </c:pt>
                <c:pt idx="3290">
                  <c:v>764.03044768416999</c:v>
                </c:pt>
                <c:pt idx="3291">
                  <c:v>764.26267578376996</c:v>
                </c:pt>
                <c:pt idx="3292">
                  <c:v>764.49490388336994</c:v>
                </c:pt>
                <c:pt idx="3293">
                  <c:v>764.72713198297004</c:v>
                </c:pt>
                <c:pt idx="3294">
                  <c:v>764.95936008257002</c:v>
                </c:pt>
                <c:pt idx="3295">
                  <c:v>765.19158818216999</c:v>
                </c:pt>
                <c:pt idx="3296">
                  <c:v>765.42381628176997</c:v>
                </c:pt>
                <c:pt idx="3297">
                  <c:v>765.65604438136995</c:v>
                </c:pt>
                <c:pt idx="3298">
                  <c:v>765.88827248097004</c:v>
                </c:pt>
                <c:pt idx="3299">
                  <c:v>766.12050058057002</c:v>
                </c:pt>
                <c:pt idx="3300">
                  <c:v>766.35272868017</c:v>
                </c:pt>
                <c:pt idx="3301">
                  <c:v>766.58495677976998</c:v>
                </c:pt>
                <c:pt idx="3302">
                  <c:v>766.81718487936996</c:v>
                </c:pt>
                <c:pt idx="3303">
                  <c:v>767.04941297897096</c:v>
                </c:pt>
                <c:pt idx="3304">
                  <c:v>767.28164107857003</c:v>
                </c:pt>
                <c:pt idx="3305">
                  <c:v>767.51386917817103</c:v>
                </c:pt>
                <c:pt idx="3306">
                  <c:v>767.74609727777101</c:v>
                </c:pt>
                <c:pt idx="3307">
                  <c:v>767.97832537737099</c:v>
                </c:pt>
                <c:pt idx="3308">
                  <c:v>768.21055347697097</c:v>
                </c:pt>
                <c:pt idx="3309">
                  <c:v>768.44278157657095</c:v>
                </c:pt>
                <c:pt idx="3310">
                  <c:v>768.67500967617104</c:v>
                </c:pt>
                <c:pt idx="3311">
                  <c:v>768.90723777577102</c:v>
                </c:pt>
                <c:pt idx="3312">
                  <c:v>769.139465875371</c:v>
                </c:pt>
                <c:pt idx="3313">
                  <c:v>769.37169397497098</c:v>
                </c:pt>
                <c:pt idx="3314">
                  <c:v>769.60392207457096</c:v>
                </c:pt>
                <c:pt idx="3315">
                  <c:v>769.83615017417105</c:v>
                </c:pt>
                <c:pt idx="3316">
                  <c:v>770.06837827377103</c:v>
                </c:pt>
                <c:pt idx="3317">
                  <c:v>770.30060637337101</c:v>
                </c:pt>
                <c:pt idx="3318">
                  <c:v>770.53283447297099</c:v>
                </c:pt>
                <c:pt idx="3319">
                  <c:v>770.76506257257097</c:v>
                </c:pt>
                <c:pt idx="3320">
                  <c:v>770.99729067217095</c:v>
                </c:pt>
                <c:pt idx="3321">
                  <c:v>771.22951877177104</c:v>
                </c:pt>
                <c:pt idx="3322">
                  <c:v>771.46174687137102</c:v>
                </c:pt>
                <c:pt idx="3323">
                  <c:v>771.693974970971</c:v>
                </c:pt>
                <c:pt idx="3324">
                  <c:v>771.926203070572</c:v>
                </c:pt>
                <c:pt idx="3325">
                  <c:v>772.15843117017198</c:v>
                </c:pt>
                <c:pt idx="3326">
                  <c:v>772.39065926977196</c:v>
                </c:pt>
                <c:pt idx="3327">
                  <c:v>772.62288736937205</c:v>
                </c:pt>
                <c:pt idx="3328">
                  <c:v>772.85511546897203</c:v>
                </c:pt>
                <c:pt idx="3329">
                  <c:v>773.08734356857201</c:v>
                </c:pt>
                <c:pt idx="3330">
                  <c:v>773.31957166817199</c:v>
                </c:pt>
                <c:pt idx="3331">
                  <c:v>773.55179976777197</c:v>
                </c:pt>
                <c:pt idx="3332">
                  <c:v>773.78402786737195</c:v>
                </c:pt>
                <c:pt idx="3333">
                  <c:v>774.01625596697204</c:v>
                </c:pt>
                <c:pt idx="3334">
                  <c:v>774.24848406657202</c:v>
                </c:pt>
                <c:pt idx="3335">
                  <c:v>774.480712166172</c:v>
                </c:pt>
                <c:pt idx="3336">
                  <c:v>774.71294026577198</c:v>
                </c:pt>
                <c:pt idx="3337">
                  <c:v>774.94516836537196</c:v>
                </c:pt>
                <c:pt idx="3338">
                  <c:v>775.17739646497205</c:v>
                </c:pt>
                <c:pt idx="3339">
                  <c:v>775.40962456457203</c:v>
                </c:pt>
                <c:pt idx="3340">
                  <c:v>775.64185266417201</c:v>
                </c:pt>
                <c:pt idx="3341">
                  <c:v>775.87408076377199</c:v>
                </c:pt>
                <c:pt idx="3342">
                  <c:v>776.10630886337299</c:v>
                </c:pt>
                <c:pt idx="3343">
                  <c:v>776.33853696297297</c:v>
                </c:pt>
                <c:pt idx="3344">
                  <c:v>776.57076506257295</c:v>
                </c:pt>
                <c:pt idx="3345">
                  <c:v>776.80299316217304</c:v>
                </c:pt>
                <c:pt idx="3346">
                  <c:v>777.03522126177302</c:v>
                </c:pt>
                <c:pt idx="3347">
                  <c:v>777.267449361373</c:v>
                </c:pt>
                <c:pt idx="3348">
                  <c:v>777.49967746097298</c:v>
                </c:pt>
                <c:pt idx="3349">
                  <c:v>777.73190556057295</c:v>
                </c:pt>
                <c:pt idx="3350">
                  <c:v>777.96413366017305</c:v>
                </c:pt>
                <c:pt idx="3351">
                  <c:v>778.19636175977303</c:v>
                </c:pt>
                <c:pt idx="3352">
                  <c:v>778.42858985937301</c:v>
                </c:pt>
                <c:pt idx="3353">
                  <c:v>778.66081795897298</c:v>
                </c:pt>
                <c:pt idx="3354">
                  <c:v>778.89304605857296</c:v>
                </c:pt>
                <c:pt idx="3355">
                  <c:v>779.12527415817306</c:v>
                </c:pt>
                <c:pt idx="3356">
                  <c:v>779.35750225777304</c:v>
                </c:pt>
                <c:pt idx="3357">
                  <c:v>779.58973035737301</c:v>
                </c:pt>
                <c:pt idx="3358">
                  <c:v>779.82195845697299</c:v>
                </c:pt>
                <c:pt idx="3359">
                  <c:v>780.05418655657297</c:v>
                </c:pt>
                <c:pt idx="3360">
                  <c:v>780.28641465617295</c:v>
                </c:pt>
                <c:pt idx="3361">
                  <c:v>780.51864275577304</c:v>
                </c:pt>
                <c:pt idx="3362">
                  <c:v>780.75087085537302</c:v>
                </c:pt>
                <c:pt idx="3363">
                  <c:v>780.98309895497403</c:v>
                </c:pt>
                <c:pt idx="3364">
                  <c:v>781.215327054574</c:v>
                </c:pt>
                <c:pt idx="3365">
                  <c:v>781.44755515417398</c:v>
                </c:pt>
                <c:pt idx="3366">
                  <c:v>781.67978325377396</c:v>
                </c:pt>
                <c:pt idx="3367">
                  <c:v>781.91201135337406</c:v>
                </c:pt>
                <c:pt idx="3368">
                  <c:v>782.14423945297403</c:v>
                </c:pt>
                <c:pt idx="3369">
                  <c:v>782.37646755257401</c:v>
                </c:pt>
                <c:pt idx="3370">
                  <c:v>782.60869565217399</c:v>
                </c:pt>
                <c:pt idx="3371">
                  <c:v>782.84092375177397</c:v>
                </c:pt>
                <c:pt idx="3372">
                  <c:v>783.07315185137395</c:v>
                </c:pt>
                <c:pt idx="3373">
                  <c:v>783.30537995097404</c:v>
                </c:pt>
                <c:pt idx="3374">
                  <c:v>783.53760805057402</c:v>
                </c:pt>
                <c:pt idx="3375">
                  <c:v>783.769836150174</c:v>
                </c:pt>
                <c:pt idx="3376">
                  <c:v>784.00206424977398</c:v>
                </c:pt>
                <c:pt idx="3377">
                  <c:v>784.23429234937396</c:v>
                </c:pt>
                <c:pt idx="3378">
                  <c:v>784.46652044897405</c:v>
                </c:pt>
                <c:pt idx="3379">
                  <c:v>784.69874854857403</c:v>
                </c:pt>
                <c:pt idx="3380">
                  <c:v>784.93097664817401</c:v>
                </c:pt>
                <c:pt idx="3381">
                  <c:v>785.16320474777501</c:v>
                </c:pt>
                <c:pt idx="3382">
                  <c:v>785.39543284737499</c:v>
                </c:pt>
                <c:pt idx="3383">
                  <c:v>785.62766094697497</c:v>
                </c:pt>
                <c:pt idx="3384">
                  <c:v>785.85988904657495</c:v>
                </c:pt>
                <c:pt idx="3385">
                  <c:v>786.09211714617504</c:v>
                </c:pt>
                <c:pt idx="3386">
                  <c:v>786.32434524577502</c:v>
                </c:pt>
                <c:pt idx="3387">
                  <c:v>786.556573345375</c:v>
                </c:pt>
                <c:pt idx="3388">
                  <c:v>786.78880144497498</c:v>
                </c:pt>
                <c:pt idx="3389">
                  <c:v>787.02102954457496</c:v>
                </c:pt>
                <c:pt idx="3390">
                  <c:v>787.25325764417505</c:v>
                </c:pt>
                <c:pt idx="3391">
                  <c:v>787.48548574377503</c:v>
                </c:pt>
                <c:pt idx="3392">
                  <c:v>787.71771384337501</c:v>
                </c:pt>
                <c:pt idx="3393">
                  <c:v>787.94994194297499</c:v>
                </c:pt>
                <c:pt idx="3394">
                  <c:v>788.18217004257497</c:v>
                </c:pt>
                <c:pt idx="3395">
                  <c:v>788.41439814217495</c:v>
                </c:pt>
                <c:pt idx="3396">
                  <c:v>788.64662624177504</c:v>
                </c:pt>
                <c:pt idx="3397">
                  <c:v>788.87885434137502</c:v>
                </c:pt>
                <c:pt idx="3398">
                  <c:v>789.111082440975</c:v>
                </c:pt>
                <c:pt idx="3399">
                  <c:v>789.34331054057498</c:v>
                </c:pt>
                <c:pt idx="3400">
                  <c:v>789.57553864017598</c:v>
                </c:pt>
                <c:pt idx="3401">
                  <c:v>789.80776673977596</c:v>
                </c:pt>
                <c:pt idx="3402">
                  <c:v>790.03999483937605</c:v>
                </c:pt>
                <c:pt idx="3403">
                  <c:v>790.27222293897603</c:v>
                </c:pt>
                <c:pt idx="3404">
                  <c:v>790.50445103857601</c:v>
                </c:pt>
                <c:pt idx="3405">
                  <c:v>790.73667913817599</c:v>
                </c:pt>
                <c:pt idx="3406">
                  <c:v>790.96890723777597</c:v>
                </c:pt>
                <c:pt idx="3407">
                  <c:v>791.20113533737594</c:v>
                </c:pt>
                <c:pt idx="3408">
                  <c:v>791.43336343697604</c:v>
                </c:pt>
                <c:pt idx="3409">
                  <c:v>791.66559153657602</c:v>
                </c:pt>
                <c:pt idx="3410">
                  <c:v>791.897819636176</c:v>
                </c:pt>
                <c:pt idx="3411">
                  <c:v>792.13004773577597</c:v>
                </c:pt>
                <c:pt idx="3412">
                  <c:v>792.36227583537595</c:v>
                </c:pt>
                <c:pt idx="3413">
                  <c:v>792.59450393497605</c:v>
                </c:pt>
                <c:pt idx="3414">
                  <c:v>792.82673203457603</c:v>
                </c:pt>
                <c:pt idx="3415">
                  <c:v>793.058960134176</c:v>
                </c:pt>
                <c:pt idx="3416">
                  <c:v>793.29118823377598</c:v>
                </c:pt>
                <c:pt idx="3417">
                  <c:v>793.52341633337596</c:v>
                </c:pt>
                <c:pt idx="3418">
                  <c:v>793.75564443297606</c:v>
                </c:pt>
                <c:pt idx="3419">
                  <c:v>793.98787253257603</c:v>
                </c:pt>
                <c:pt idx="3420">
                  <c:v>794.22010063217601</c:v>
                </c:pt>
                <c:pt idx="3421">
                  <c:v>794.45232873177702</c:v>
                </c:pt>
                <c:pt idx="3422">
                  <c:v>794.68455683137699</c:v>
                </c:pt>
                <c:pt idx="3423">
                  <c:v>794.91678493097697</c:v>
                </c:pt>
                <c:pt idx="3424">
                  <c:v>795.14901303057695</c:v>
                </c:pt>
                <c:pt idx="3425">
                  <c:v>795.38124113017705</c:v>
                </c:pt>
                <c:pt idx="3426">
                  <c:v>795.61346922977702</c:v>
                </c:pt>
                <c:pt idx="3427">
                  <c:v>795.845697329377</c:v>
                </c:pt>
                <c:pt idx="3428">
                  <c:v>796.07792542897698</c:v>
                </c:pt>
                <c:pt idx="3429">
                  <c:v>796.31015352857696</c:v>
                </c:pt>
                <c:pt idx="3430">
                  <c:v>796.54238162817705</c:v>
                </c:pt>
                <c:pt idx="3431">
                  <c:v>796.77460972777703</c:v>
                </c:pt>
                <c:pt idx="3432">
                  <c:v>797.00683782737701</c:v>
                </c:pt>
                <c:pt idx="3433">
                  <c:v>797.23906592697699</c:v>
                </c:pt>
                <c:pt idx="3434">
                  <c:v>797.47129402657697</c:v>
                </c:pt>
                <c:pt idx="3435">
                  <c:v>797.70352212617695</c:v>
                </c:pt>
                <c:pt idx="3436">
                  <c:v>797.93575022577704</c:v>
                </c:pt>
                <c:pt idx="3437">
                  <c:v>798.16797832537702</c:v>
                </c:pt>
                <c:pt idx="3438">
                  <c:v>798.400206424977</c:v>
                </c:pt>
                <c:pt idx="3439">
                  <c:v>798.632434524578</c:v>
                </c:pt>
                <c:pt idx="3440">
                  <c:v>798.86466262417798</c:v>
                </c:pt>
                <c:pt idx="3441">
                  <c:v>799.09689072377796</c:v>
                </c:pt>
                <c:pt idx="3442">
                  <c:v>799.32911882337805</c:v>
                </c:pt>
                <c:pt idx="3443">
                  <c:v>799.56134692297803</c:v>
                </c:pt>
                <c:pt idx="3444">
                  <c:v>799.79357502257801</c:v>
                </c:pt>
                <c:pt idx="3445">
                  <c:v>800.02580312217799</c:v>
                </c:pt>
                <c:pt idx="3446">
                  <c:v>800.25803122177797</c:v>
                </c:pt>
                <c:pt idx="3447">
                  <c:v>800.49025932137795</c:v>
                </c:pt>
                <c:pt idx="3448">
                  <c:v>800.72248742097804</c:v>
                </c:pt>
                <c:pt idx="3449">
                  <c:v>800.95471552057802</c:v>
                </c:pt>
                <c:pt idx="3450">
                  <c:v>801.186943620178</c:v>
                </c:pt>
                <c:pt idx="3451">
                  <c:v>801.41917171977798</c:v>
                </c:pt>
                <c:pt idx="3452">
                  <c:v>801.65139981937796</c:v>
                </c:pt>
                <c:pt idx="3453">
                  <c:v>801.88362791897805</c:v>
                </c:pt>
                <c:pt idx="3454">
                  <c:v>802.11585601857803</c:v>
                </c:pt>
                <c:pt idx="3455">
                  <c:v>802.34808411817801</c:v>
                </c:pt>
                <c:pt idx="3456">
                  <c:v>802.58031221777799</c:v>
                </c:pt>
                <c:pt idx="3457">
                  <c:v>802.81254031737797</c:v>
                </c:pt>
                <c:pt idx="3458">
                  <c:v>803.04476841697897</c:v>
                </c:pt>
                <c:pt idx="3459">
                  <c:v>803.27699651657804</c:v>
                </c:pt>
                <c:pt idx="3460">
                  <c:v>803.50922461617904</c:v>
                </c:pt>
                <c:pt idx="3461">
                  <c:v>803.74145271577902</c:v>
                </c:pt>
                <c:pt idx="3462">
                  <c:v>803.973680815379</c:v>
                </c:pt>
                <c:pt idx="3463">
                  <c:v>804.20590891497898</c:v>
                </c:pt>
                <c:pt idx="3464">
                  <c:v>804.43813701457896</c:v>
                </c:pt>
                <c:pt idx="3465">
                  <c:v>804.67036511417905</c:v>
                </c:pt>
                <c:pt idx="3466">
                  <c:v>804.90259321377903</c:v>
                </c:pt>
                <c:pt idx="3467">
                  <c:v>805.13482131337901</c:v>
                </c:pt>
                <c:pt idx="3468">
                  <c:v>805.36704941297899</c:v>
                </c:pt>
                <c:pt idx="3469">
                  <c:v>805.59927751257896</c:v>
                </c:pt>
                <c:pt idx="3470">
                  <c:v>805.83150561217894</c:v>
                </c:pt>
                <c:pt idx="3471">
                  <c:v>806.06373371177904</c:v>
                </c:pt>
                <c:pt idx="3472">
                  <c:v>806.29596181137902</c:v>
                </c:pt>
                <c:pt idx="3473">
                  <c:v>806.52818991097899</c:v>
                </c:pt>
                <c:pt idx="3474">
                  <c:v>806.76041801057897</c:v>
                </c:pt>
                <c:pt idx="3475">
                  <c:v>806.99264611017895</c:v>
                </c:pt>
                <c:pt idx="3476">
                  <c:v>807.22487420977905</c:v>
                </c:pt>
                <c:pt idx="3477">
                  <c:v>807.45710230937902</c:v>
                </c:pt>
                <c:pt idx="3478">
                  <c:v>807.689330408979</c:v>
                </c:pt>
                <c:pt idx="3479">
                  <c:v>807.92155850858001</c:v>
                </c:pt>
                <c:pt idx="3480">
                  <c:v>808.15378660817998</c:v>
                </c:pt>
                <c:pt idx="3481">
                  <c:v>808.38601470777996</c:v>
                </c:pt>
                <c:pt idx="3482">
                  <c:v>808.61824280738006</c:v>
                </c:pt>
                <c:pt idx="3483">
                  <c:v>808.85047090698004</c:v>
                </c:pt>
                <c:pt idx="3484">
                  <c:v>809.08269900658001</c:v>
                </c:pt>
                <c:pt idx="3485">
                  <c:v>809.31492710617999</c:v>
                </c:pt>
                <c:pt idx="3486">
                  <c:v>809.54715520577997</c:v>
                </c:pt>
                <c:pt idx="3487">
                  <c:v>809.77938330537995</c:v>
                </c:pt>
                <c:pt idx="3488">
                  <c:v>810.01161140498004</c:v>
                </c:pt>
                <c:pt idx="3489">
                  <c:v>810.24383950458002</c:v>
                </c:pt>
                <c:pt idx="3490">
                  <c:v>810.47606760418</c:v>
                </c:pt>
                <c:pt idx="3491">
                  <c:v>810.70829570377998</c:v>
                </c:pt>
                <c:pt idx="3492">
                  <c:v>810.94052380337996</c:v>
                </c:pt>
                <c:pt idx="3493">
                  <c:v>811.17275190298005</c:v>
                </c:pt>
                <c:pt idx="3494">
                  <c:v>811.40498000258003</c:v>
                </c:pt>
                <c:pt idx="3495">
                  <c:v>811.63720810218001</c:v>
                </c:pt>
                <c:pt idx="3496">
                  <c:v>811.86943620177999</c:v>
                </c:pt>
                <c:pt idx="3497">
                  <c:v>812.10166430138099</c:v>
                </c:pt>
                <c:pt idx="3498">
                  <c:v>812.33389240098097</c:v>
                </c:pt>
                <c:pt idx="3499">
                  <c:v>812.56612050058095</c:v>
                </c:pt>
                <c:pt idx="3500">
                  <c:v>812.79834860018104</c:v>
                </c:pt>
                <c:pt idx="3501">
                  <c:v>813.03057669978102</c:v>
                </c:pt>
                <c:pt idx="3502">
                  <c:v>813.262804799381</c:v>
                </c:pt>
                <c:pt idx="3503">
                  <c:v>813.49503289898098</c:v>
                </c:pt>
                <c:pt idx="3504">
                  <c:v>813.72726099858096</c:v>
                </c:pt>
                <c:pt idx="3505">
                  <c:v>813.95948909818105</c:v>
                </c:pt>
                <c:pt idx="3506">
                  <c:v>814.19171719778103</c:v>
                </c:pt>
                <c:pt idx="3507">
                  <c:v>814.42394529738101</c:v>
                </c:pt>
                <c:pt idx="3508">
                  <c:v>814.65617339698099</c:v>
                </c:pt>
                <c:pt idx="3509">
                  <c:v>814.88840149658097</c:v>
                </c:pt>
                <c:pt idx="3510">
                  <c:v>815.12062959618095</c:v>
                </c:pt>
                <c:pt idx="3511">
                  <c:v>815.35285769578104</c:v>
                </c:pt>
                <c:pt idx="3512">
                  <c:v>815.58508579538102</c:v>
                </c:pt>
                <c:pt idx="3513">
                  <c:v>815.817313894981</c:v>
                </c:pt>
                <c:pt idx="3514">
                  <c:v>816.04954199458098</c:v>
                </c:pt>
                <c:pt idx="3515">
                  <c:v>816.28177009418096</c:v>
                </c:pt>
                <c:pt idx="3516">
                  <c:v>816.51399819378196</c:v>
                </c:pt>
                <c:pt idx="3517">
                  <c:v>816.74622629338103</c:v>
                </c:pt>
                <c:pt idx="3518">
                  <c:v>816.97845439298203</c:v>
                </c:pt>
                <c:pt idx="3519">
                  <c:v>817.21068249258201</c:v>
                </c:pt>
                <c:pt idx="3520">
                  <c:v>817.44291059218199</c:v>
                </c:pt>
                <c:pt idx="3521">
                  <c:v>817.67513869178197</c:v>
                </c:pt>
                <c:pt idx="3522">
                  <c:v>817.90736679138195</c:v>
                </c:pt>
                <c:pt idx="3523">
                  <c:v>818.13959489098204</c:v>
                </c:pt>
                <c:pt idx="3524">
                  <c:v>818.37182299058202</c:v>
                </c:pt>
                <c:pt idx="3525">
                  <c:v>818.604051090182</c:v>
                </c:pt>
                <c:pt idx="3526">
                  <c:v>818.83627918978198</c:v>
                </c:pt>
                <c:pt idx="3527">
                  <c:v>819.06850728938196</c:v>
                </c:pt>
                <c:pt idx="3528">
                  <c:v>819.30073538898205</c:v>
                </c:pt>
                <c:pt idx="3529">
                  <c:v>819.53296348858203</c:v>
                </c:pt>
                <c:pt idx="3530">
                  <c:v>819.76519158818201</c:v>
                </c:pt>
                <c:pt idx="3531">
                  <c:v>819.99741968778198</c:v>
                </c:pt>
                <c:pt idx="3532">
                  <c:v>820.22964778738196</c:v>
                </c:pt>
                <c:pt idx="3533">
                  <c:v>820.46187588698206</c:v>
                </c:pt>
                <c:pt idx="3534">
                  <c:v>820.69410398658204</c:v>
                </c:pt>
                <c:pt idx="3535">
                  <c:v>820.92633208618201</c:v>
                </c:pt>
                <c:pt idx="3536">
                  <c:v>821.15856018578199</c:v>
                </c:pt>
                <c:pt idx="3537">
                  <c:v>821.390788285383</c:v>
                </c:pt>
                <c:pt idx="3538">
                  <c:v>821.62301638498298</c:v>
                </c:pt>
                <c:pt idx="3539">
                  <c:v>821.85524448458295</c:v>
                </c:pt>
                <c:pt idx="3540">
                  <c:v>822.08747258418305</c:v>
                </c:pt>
                <c:pt idx="3541">
                  <c:v>822.31970068378303</c:v>
                </c:pt>
                <c:pt idx="3542">
                  <c:v>822.551928783383</c:v>
                </c:pt>
                <c:pt idx="3543">
                  <c:v>822.78415688298298</c:v>
                </c:pt>
                <c:pt idx="3544">
                  <c:v>823.01638498258296</c:v>
                </c:pt>
                <c:pt idx="3545">
                  <c:v>823.24861308218306</c:v>
                </c:pt>
                <c:pt idx="3546">
                  <c:v>823.48084118178303</c:v>
                </c:pt>
                <c:pt idx="3547">
                  <c:v>823.71306928138301</c:v>
                </c:pt>
                <c:pt idx="3548">
                  <c:v>823.94529738098299</c:v>
                </c:pt>
                <c:pt idx="3549">
                  <c:v>824.17752548058297</c:v>
                </c:pt>
                <c:pt idx="3550">
                  <c:v>824.40975358018295</c:v>
                </c:pt>
                <c:pt idx="3551">
                  <c:v>824.64198167978304</c:v>
                </c:pt>
                <c:pt idx="3552">
                  <c:v>824.87420977938302</c:v>
                </c:pt>
                <c:pt idx="3553">
                  <c:v>825.106437878983</c:v>
                </c:pt>
                <c:pt idx="3554">
                  <c:v>825.33866597858298</c:v>
                </c:pt>
                <c:pt idx="3555">
                  <c:v>825.57089407818398</c:v>
                </c:pt>
                <c:pt idx="3556">
                  <c:v>825.80312217778396</c:v>
                </c:pt>
                <c:pt idx="3557">
                  <c:v>826.03535027738405</c:v>
                </c:pt>
                <c:pt idx="3558">
                  <c:v>826.26757837698403</c:v>
                </c:pt>
                <c:pt idx="3559">
                  <c:v>826.49980647658401</c:v>
                </c:pt>
                <c:pt idx="3560">
                  <c:v>826.73203457618399</c:v>
                </c:pt>
                <c:pt idx="3561">
                  <c:v>826.96426267578397</c:v>
                </c:pt>
                <c:pt idx="3562">
                  <c:v>827.19649077538395</c:v>
                </c:pt>
                <c:pt idx="3563">
                  <c:v>827.42871887498404</c:v>
                </c:pt>
                <c:pt idx="3564">
                  <c:v>827.66094697458402</c:v>
                </c:pt>
                <c:pt idx="3565">
                  <c:v>827.893175074184</c:v>
                </c:pt>
                <c:pt idx="3566">
                  <c:v>828.12540317378398</c:v>
                </c:pt>
                <c:pt idx="3567">
                  <c:v>828.35763127338396</c:v>
                </c:pt>
                <c:pt idx="3568">
                  <c:v>828.58985937298405</c:v>
                </c:pt>
                <c:pt idx="3569">
                  <c:v>828.82208747258403</c:v>
                </c:pt>
                <c:pt idx="3570">
                  <c:v>829.05431557218401</c:v>
                </c:pt>
                <c:pt idx="3571">
                  <c:v>829.28654367178399</c:v>
                </c:pt>
                <c:pt idx="3572">
                  <c:v>829.51877177138397</c:v>
                </c:pt>
                <c:pt idx="3573">
                  <c:v>829.75099987098395</c:v>
                </c:pt>
                <c:pt idx="3574">
                  <c:v>829.98322797058404</c:v>
                </c:pt>
                <c:pt idx="3575">
                  <c:v>830.21545607018402</c:v>
                </c:pt>
                <c:pt idx="3576">
                  <c:v>830.44768416978502</c:v>
                </c:pt>
                <c:pt idx="3577">
                  <c:v>830.679912269385</c:v>
                </c:pt>
                <c:pt idx="3578">
                  <c:v>830.91214036898498</c:v>
                </c:pt>
                <c:pt idx="3579">
                  <c:v>831.14436846858496</c:v>
                </c:pt>
                <c:pt idx="3580">
                  <c:v>831.37659656818505</c:v>
                </c:pt>
                <c:pt idx="3581">
                  <c:v>831.60882466778503</c:v>
                </c:pt>
                <c:pt idx="3582">
                  <c:v>831.84105276738501</c:v>
                </c:pt>
                <c:pt idx="3583">
                  <c:v>832.07328086698499</c:v>
                </c:pt>
                <c:pt idx="3584">
                  <c:v>832.30550896658497</c:v>
                </c:pt>
                <c:pt idx="3585">
                  <c:v>832.53773706618495</c:v>
                </c:pt>
                <c:pt idx="3586">
                  <c:v>832.76996516578504</c:v>
                </c:pt>
                <c:pt idx="3587">
                  <c:v>833.00219326538502</c:v>
                </c:pt>
                <c:pt idx="3588">
                  <c:v>833.234421364985</c:v>
                </c:pt>
                <c:pt idx="3589">
                  <c:v>833.46664946458498</c:v>
                </c:pt>
                <c:pt idx="3590">
                  <c:v>833.69887756418495</c:v>
                </c:pt>
                <c:pt idx="3591">
                  <c:v>833.93110566378505</c:v>
                </c:pt>
                <c:pt idx="3592">
                  <c:v>834.16333376338503</c:v>
                </c:pt>
                <c:pt idx="3593">
                  <c:v>834.39556186298501</c:v>
                </c:pt>
                <c:pt idx="3594">
                  <c:v>834.62778996258601</c:v>
                </c:pt>
                <c:pt idx="3595">
                  <c:v>834.86001806218599</c:v>
                </c:pt>
                <c:pt idx="3596">
                  <c:v>835.09224616178597</c:v>
                </c:pt>
                <c:pt idx="3597">
                  <c:v>835.32447426138594</c:v>
                </c:pt>
                <c:pt idx="3598">
                  <c:v>835.55670236098604</c:v>
                </c:pt>
                <c:pt idx="3599">
                  <c:v>835.78893046058602</c:v>
                </c:pt>
                <c:pt idx="3600">
                  <c:v>836.021158560186</c:v>
                </c:pt>
                <c:pt idx="3601">
                  <c:v>836.25338665978597</c:v>
                </c:pt>
                <c:pt idx="3602">
                  <c:v>836.48561475938595</c:v>
                </c:pt>
                <c:pt idx="3603">
                  <c:v>836.71784285898605</c:v>
                </c:pt>
                <c:pt idx="3604">
                  <c:v>836.95007095858602</c:v>
                </c:pt>
                <c:pt idx="3605">
                  <c:v>837.182299058186</c:v>
                </c:pt>
                <c:pt idx="3606">
                  <c:v>837.41452715778598</c:v>
                </c:pt>
                <c:pt idx="3607">
                  <c:v>837.64675525738596</c:v>
                </c:pt>
                <c:pt idx="3608">
                  <c:v>837.87898335698605</c:v>
                </c:pt>
                <c:pt idx="3609">
                  <c:v>838.11121145658603</c:v>
                </c:pt>
                <c:pt idx="3610">
                  <c:v>838.34343955618601</c:v>
                </c:pt>
                <c:pt idx="3611">
                  <c:v>838.57566765578599</c:v>
                </c:pt>
                <c:pt idx="3612">
                  <c:v>838.80789575538597</c:v>
                </c:pt>
                <c:pt idx="3613">
                  <c:v>839.04012385498697</c:v>
                </c:pt>
                <c:pt idx="3614">
                  <c:v>839.27235195458604</c:v>
                </c:pt>
                <c:pt idx="3615">
                  <c:v>839.50458005418704</c:v>
                </c:pt>
                <c:pt idx="3616">
                  <c:v>839.73680815378702</c:v>
                </c:pt>
                <c:pt idx="3617">
                  <c:v>839.969036253387</c:v>
                </c:pt>
                <c:pt idx="3618">
                  <c:v>840.20126435298698</c:v>
                </c:pt>
                <c:pt idx="3619">
                  <c:v>840.43349245258696</c:v>
                </c:pt>
                <c:pt idx="3620">
                  <c:v>840.66572055218705</c:v>
                </c:pt>
                <c:pt idx="3621">
                  <c:v>840.89794865178703</c:v>
                </c:pt>
                <c:pt idx="3622">
                  <c:v>841.13017675138701</c:v>
                </c:pt>
                <c:pt idx="3623">
                  <c:v>841.36240485098699</c:v>
                </c:pt>
                <c:pt idx="3624">
                  <c:v>841.59463295058697</c:v>
                </c:pt>
                <c:pt idx="3625">
                  <c:v>841.82686105018695</c:v>
                </c:pt>
                <c:pt idx="3626">
                  <c:v>842.05908914978704</c:v>
                </c:pt>
                <c:pt idx="3627">
                  <c:v>842.29131724938702</c:v>
                </c:pt>
                <c:pt idx="3628">
                  <c:v>842.523545348987</c:v>
                </c:pt>
                <c:pt idx="3629">
                  <c:v>842.75577344858698</c:v>
                </c:pt>
                <c:pt idx="3630">
                  <c:v>842.98800154818696</c:v>
                </c:pt>
                <c:pt idx="3631">
                  <c:v>843.22022964778705</c:v>
                </c:pt>
                <c:pt idx="3632">
                  <c:v>843.45245774738703</c:v>
                </c:pt>
                <c:pt idx="3633">
                  <c:v>843.68468584698701</c:v>
                </c:pt>
                <c:pt idx="3634">
                  <c:v>843.91691394658801</c:v>
                </c:pt>
                <c:pt idx="3635">
                  <c:v>844.14914204618799</c:v>
                </c:pt>
                <c:pt idx="3636">
                  <c:v>844.38137014578797</c:v>
                </c:pt>
                <c:pt idx="3637">
                  <c:v>844.61359824538795</c:v>
                </c:pt>
                <c:pt idx="3638">
                  <c:v>844.84582634498804</c:v>
                </c:pt>
                <c:pt idx="3639">
                  <c:v>845.07805444458802</c:v>
                </c:pt>
                <c:pt idx="3640">
                  <c:v>845.310282544188</c:v>
                </c:pt>
                <c:pt idx="3641">
                  <c:v>845.54251064378798</c:v>
                </c:pt>
                <c:pt idx="3642">
                  <c:v>845.77473874338796</c:v>
                </c:pt>
                <c:pt idx="3643">
                  <c:v>846.00696684298805</c:v>
                </c:pt>
                <c:pt idx="3644">
                  <c:v>846.23919494258803</c:v>
                </c:pt>
                <c:pt idx="3645">
                  <c:v>846.47142304218801</c:v>
                </c:pt>
                <c:pt idx="3646">
                  <c:v>846.70365114178799</c:v>
                </c:pt>
                <c:pt idx="3647">
                  <c:v>846.93587924138797</c:v>
                </c:pt>
                <c:pt idx="3648">
                  <c:v>847.16810734098794</c:v>
                </c:pt>
                <c:pt idx="3649">
                  <c:v>847.40033544058804</c:v>
                </c:pt>
                <c:pt idx="3650">
                  <c:v>847.63256354018802</c:v>
                </c:pt>
                <c:pt idx="3651">
                  <c:v>847.864791639788</c:v>
                </c:pt>
                <c:pt idx="3652">
                  <c:v>848.097019739389</c:v>
                </c:pt>
                <c:pt idx="3653">
                  <c:v>848.32924783898898</c:v>
                </c:pt>
                <c:pt idx="3654">
                  <c:v>848.56147593858896</c:v>
                </c:pt>
                <c:pt idx="3655">
                  <c:v>848.79370403818905</c:v>
                </c:pt>
                <c:pt idx="3656">
                  <c:v>849.02593213778903</c:v>
                </c:pt>
                <c:pt idx="3657">
                  <c:v>849.25816023738901</c:v>
                </c:pt>
                <c:pt idx="3658">
                  <c:v>849.49038833698899</c:v>
                </c:pt>
                <c:pt idx="3659">
                  <c:v>849.72261643658896</c:v>
                </c:pt>
                <c:pt idx="3660">
                  <c:v>849.95484453618894</c:v>
                </c:pt>
                <c:pt idx="3661">
                  <c:v>850.18707263578904</c:v>
                </c:pt>
                <c:pt idx="3662">
                  <c:v>850.41930073538902</c:v>
                </c:pt>
                <c:pt idx="3663">
                  <c:v>850.65152883498899</c:v>
                </c:pt>
                <c:pt idx="3664">
                  <c:v>850.88375693458897</c:v>
                </c:pt>
                <c:pt idx="3665">
                  <c:v>851.11598503418895</c:v>
                </c:pt>
                <c:pt idx="3666">
                  <c:v>851.34821313378905</c:v>
                </c:pt>
                <c:pt idx="3667">
                  <c:v>851.58044123338902</c:v>
                </c:pt>
                <c:pt idx="3668">
                  <c:v>851.812669332989</c:v>
                </c:pt>
                <c:pt idx="3669">
                  <c:v>852.04489743258898</c:v>
                </c:pt>
                <c:pt idx="3670">
                  <c:v>852.27712553218896</c:v>
                </c:pt>
                <c:pt idx="3671">
                  <c:v>852.50935363178996</c:v>
                </c:pt>
                <c:pt idx="3672">
                  <c:v>852.74158173138903</c:v>
                </c:pt>
                <c:pt idx="3673">
                  <c:v>852.97380983099004</c:v>
                </c:pt>
                <c:pt idx="3674">
                  <c:v>853.20603793059001</c:v>
                </c:pt>
                <c:pt idx="3675">
                  <c:v>853.43826603018999</c:v>
                </c:pt>
                <c:pt idx="3676">
                  <c:v>853.67049412978997</c:v>
                </c:pt>
                <c:pt idx="3677">
                  <c:v>853.90272222938995</c:v>
                </c:pt>
                <c:pt idx="3678">
                  <c:v>854.13495032899004</c:v>
                </c:pt>
                <c:pt idx="3679">
                  <c:v>854.36717842859002</c:v>
                </c:pt>
                <c:pt idx="3680">
                  <c:v>854.59940652819</c:v>
                </c:pt>
                <c:pt idx="3681">
                  <c:v>854.83163462778998</c:v>
                </c:pt>
                <c:pt idx="3682">
                  <c:v>855.06386272738996</c:v>
                </c:pt>
                <c:pt idx="3683">
                  <c:v>855.29609082699005</c:v>
                </c:pt>
                <c:pt idx="3684">
                  <c:v>855.52831892659003</c:v>
                </c:pt>
                <c:pt idx="3685">
                  <c:v>855.76054702619001</c:v>
                </c:pt>
                <c:pt idx="3686">
                  <c:v>855.99277512578999</c:v>
                </c:pt>
                <c:pt idx="3687">
                  <c:v>856.22500322538997</c:v>
                </c:pt>
                <c:pt idx="3688">
                  <c:v>856.45723132498995</c:v>
                </c:pt>
                <c:pt idx="3689">
                  <c:v>856.68945942459004</c:v>
                </c:pt>
                <c:pt idx="3690">
                  <c:v>856.92168752419002</c:v>
                </c:pt>
                <c:pt idx="3691">
                  <c:v>857.15391562379</c:v>
                </c:pt>
                <c:pt idx="3692">
                  <c:v>857.386143723391</c:v>
                </c:pt>
                <c:pt idx="3693">
                  <c:v>857.61837182299098</c:v>
                </c:pt>
                <c:pt idx="3694">
                  <c:v>857.85059992259096</c:v>
                </c:pt>
                <c:pt idx="3695">
                  <c:v>858.08282802219105</c:v>
                </c:pt>
                <c:pt idx="3696">
                  <c:v>858.31505612179103</c:v>
                </c:pt>
                <c:pt idx="3697">
                  <c:v>858.54728422139101</c:v>
                </c:pt>
                <c:pt idx="3698">
                  <c:v>858.77951232099099</c:v>
                </c:pt>
                <c:pt idx="3699">
                  <c:v>859.01174042059097</c:v>
                </c:pt>
                <c:pt idx="3700">
                  <c:v>859.24396852019095</c:v>
                </c:pt>
                <c:pt idx="3701">
                  <c:v>859.47619661979104</c:v>
                </c:pt>
                <c:pt idx="3702">
                  <c:v>859.70842471939102</c:v>
                </c:pt>
                <c:pt idx="3703">
                  <c:v>859.940652818991</c:v>
                </c:pt>
                <c:pt idx="3704">
                  <c:v>860.17288091859098</c:v>
                </c:pt>
                <c:pt idx="3705">
                  <c:v>860.40510901819096</c:v>
                </c:pt>
                <c:pt idx="3706">
                  <c:v>860.63733711779105</c:v>
                </c:pt>
                <c:pt idx="3707">
                  <c:v>860.86956521739103</c:v>
                </c:pt>
                <c:pt idx="3708">
                  <c:v>861.10179331699101</c:v>
                </c:pt>
                <c:pt idx="3709">
                  <c:v>861.33402141659099</c:v>
                </c:pt>
                <c:pt idx="3710">
                  <c:v>861.56624951619199</c:v>
                </c:pt>
                <c:pt idx="3711">
                  <c:v>861.79847761579197</c:v>
                </c:pt>
                <c:pt idx="3712">
                  <c:v>862.03070571539195</c:v>
                </c:pt>
                <c:pt idx="3713">
                  <c:v>862.26293381499204</c:v>
                </c:pt>
                <c:pt idx="3714">
                  <c:v>862.49516191459202</c:v>
                </c:pt>
                <c:pt idx="3715">
                  <c:v>862.727390014192</c:v>
                </c:pt>
                <c:pt idx="3716">
                  <c:v>862.95961811379198</c:v>
                </c:pt>
                <c:pt idx="3717">
                  <c:v>863.19184621339195</c:v>
                </c:pt>
                <c:pt idx="3718">
                  <c:v>863.42407431299205</c:v>
                </c:pt>
                <c:pt idx="3719">
                  <c:v>863.65630241259203</c:v>
                </c:pt>
                <c:pt idx="3720">
                  <c:v>863.88853051219201</c:v>
                </c:pt>
                <c:pt idx="3721">
                  <c:v>864.12075861179198</c:v>
                </c:pt>
                <c:pt idx="3722">
                  <c:v>864.35298671139196</c:v>
                </c:pt>
                <c:pt idx="3723">
                  <c:v>864.58521481099206</c:v>
                </c:pt>
                <c:pt idx="3724">
                  <c:v>864.81744291059204</c:v>
                </c:pt>
                <c:pt idx="3725">
                  <c:v>865.04967101019201</c:v>
                </c:pt>
                <c:pt idx="3726">
                  <c:v>865.28189910979199</c:v>
                </c:pt>
                <c:pt idx="3727">
                  <c:v>865.51412720939197</c:v>
                </c:pt>
                <c:pt idx="3728">
                  <c:v>865.74635530899195</c:v>
                </c:pt>
                <c:pt idx="3729">
                  <c:v>865.97858340859204</c:v>
                </c:pt>
                <c:pt idx="3730">
                  <c:v>866.21081150819202</c:v>
                </c:pt>
                <c:pt idx="3731">
                  <c:v>866.44303960779303</c:v>
                </c:pt>
                <c:pt idx="3732">
                  <c:v>866.675267707393</c:v>
                </c:pt>
                <c:pt idx="3733">
                  <c:v>866.90749580699298</c:v>
                </c:pt>
                <c:pt idx="3734">
                  <c:v>867.13972390659296</c:v>
                </c:pt>
                <c:pt idx="3735">
                  <c:v>867.37195200619306</c:v>
                </c:pt>
                <c:pt idx="3736">
                  <c:v>867.60418010579303</c:v>
                </c:pt>
                <c:pt idx="3737">
                  <c:v>867.83640820539301</c:v>
                </c:pt>
                <c:pt idx="3738">
                  <c:v>868.06863630499299</c:v>
                </c:pt>
                <c:pt idx="3739">
                  <c:v>868.30086440459297</c:v>
                </c:pt>
                <c:pt idx="3740">
                  <c:v>868.53309250419295</c:v>
                </c:pt>
                <c:pt idx="3741">
                  <c:v>868.76532060379304</c:v>
                </c:pt>
                <c:pt idx="3742">
                  <c:v>868.99754870339302</c:v>
                </c:pt>
                <c:pt idx="3743">
                  <c:v>869.229776802993</c:v>
                </c:pt>
                <c:pt idx="3744">
                  <c:v>869.46200490259298</c:v>
                </c:pt>
                <c:pt idx="3745">
                  <c:v>869.69423300219296</c:v>
                </c:pt>
                <c:pt idx="3746">
                  <c:v>869.92646110179305</c:v>
                </c:pt>
                <c:pt idx="3747">
                  <c:v>870.15868920139303</c:v>
                </c:pt>
                <c:pt idx="3748">
                  <c:v>870.39091730099301</c:v>
                </c:pt>
                <c:pt idx="3749">
                  <c:v>870.62314540059299</c:v>
                </c:pt>
                <c:pt idx="3750">
                  <c:v>870.85537350019399</c:v>
                </c:pt>
                <c:pt idx="3751">
                  <c:v>871.08760159979397</c:v>
                </c:pt>
                <c:pt idx="3752">
                  <c:v>871.31982969939395</c:v>
                </c:pt>
                <c:pt idx="3753">
                  <c:v>871.55205779899404</c:v>
                </c:pt>
                <c:pt idx="3754">
                  <c:v>871.78428589859402</c:v>
                </c:pt>
                <c:pt idx="3755">
                  <c:v>872.016513998194</c:v>
                </c:pt>
                <c:pt idx="3756">
                  <c:v>872.24874209779398</c:v>
                </c:pt>
                <c:pt idx="3757">
                  <c:v>872.48097019739396</c:v>
                </c:pt>
                <c:pt idx="3758">
                  <c:v>872.71319829699405</c:v>
                </c:pt>
                <c:pt idx="3759">
                  <c:v>872.94542639659403</c:v>
                </c:pt>
                <c:pt idx="3760">
                  <c:v>873.17765449619401</c:v>
                </c:pt>
                <c:pt idx="3761">
                  <c:v>873.40988259579399</c:v>
                </c:pt>
                <c:pt idx="3762">
                  <c:v>873.64211069539397</c:v>
                </c:pt>
                <c:pt idx="3763">
                  <c:v>873.87433879499395</c:v>
                </c:pt>
                <c:pt idx="3764">
                  <c:v>874.10656689459404</c:v>
                </c:pt>
                <c:pt idx="3765">
                  <c:v>874.33879499419402</c:v>
                </c:pt>
                <c:pt idx="3766">
                  <c:v>874.571023093794</c:v>
                </c:pt>
                <c:pt idx="3767">
                  <c:v>874.80325119339398</c:v>
                </c:pt>
                <c:pt idx="3768">
                  <c:v>875.03547929299498</c:v>
                </c:pt>
                <c:pt idx="3769">
                  <c:v>875.26770739259496</c:v>
                </c:pt>
                <c:pt idx="3770">
                  <c:v>875.49993549219505</c:v>
                </c:pt>
                <c:pt idx="3771">
                  <c:v>875.73216359179503</c:v>
                </c:pt>
                <c:pt idx="3772">
                  <c:v>875.96439169139501</c:v>
                </c:pt>
                <c:pt idx="3773">
                  <c:v>876.19661979099499</c:v>
                </c:pt>
                <c:pt idx="3774">
                  <c:v>876.42884789059497</c:v>
                </c:pt>
                <c:pt idx="3775">
                  <c:v>876.66107599019495</c:v>
                </c:pt>
                <c:pt idx="3776">
                  <c:v>876.89330408979504</c:v>
                </c:pt>
                <c:pt idx="3777">
                  <c:v>877.12553218939502</c:v>
                </c:pt>
                <c:pt idx="3778">
                  <c:v>877.357760288995</c:v>
                </c:pt>
                <c:pt idx="3779">
                  <c:v>877.58998838859497</c:v>
                </c:pt>
                <c:pt idx="3780">
                  <c:v>877.82221648819495</c:v>
                </c:pt>
                <c:pt idx="3781">
                  <c:v>878.05444458779505</c:v>
                </c:pt>
                <c:pt idx="3782">
                  <c:v>878.28667268739503</c:v>
                </c:pt>
                <c:pt idx="3783">
                  <c:v>878.518900786995</c:v>
                </c:pt>
                <c:pt idx="3784">
                  <c:v>878.75112888659498</c:v>
                </c:pt>
                <c:pt idx="3785">
                  <c:v>878.98335698619496</c:v>
                </c:pt>
                <c:pt idx="3786">
                  <c:v>879.21558508579506</c:v>
                </c:pt>
                <c:pt idx="3787">
                  <c:v>879.44781318539503</c:v>
                </c:pt>
                <c:pt idx="3788">
                  <c:v>879.68004128499501</c:v>
                </c:pt>
                <c:pt idx="3789">
                  <c:v>879.91226938459602</c:v>
                </c:pt>
                <c:pt idx="3790">
                  <c:v>880.14449748419599</c:v>
                </c:pt>
                <c:pt idx="3791">
                  <c:v>880.37672558379597</c:v>
                </c:pt>
                <c:pt idx="3792">
                  <c:v>880.60895368339595</c:v>
                </c:pt>
                <c:pt idx="3793">
                  <c:v>880.84118178299605</c:v>
                </c:pt>
                <c:pt idx="3794">
                  <c:v>881.07340988259602</c:v>
                </c:pt>
                <c:pt idx="3795">
                  <c:v>881.305637982196</c:v>
                </c:pt>
                <c:pt idx="3796">
                  <c:v>881.53786608179598</c:v>
                </c:pt>
                <c:pt idx="3797">
                  <c:v>881.77009418139596</c:v>
                </c:pt>
                <c:pt idx="3798">
                  <c:v>882.00232228099605</c:v>
                </c:pt>
                <c:pt idx="3799">
                  <c:v>882.23455038059603</c:v>
                </c:pt>
                <c:pt idx="3800">
                  <c:v>882.46677848019601</c:v>
                </c:pt>
                <c:pt idx="3801">
                  <c:v>882.69900657979599</c:v>
                </c:pt>
                <c:pt idx="3802">
                  <c:v>882.93123467939597</c:v>
                </c:pt>
                <c:pt idx="3803">
                  <c:v>883.16346277899595</c:v>
                </c:pt>
                <c:pt idx="3804">
                  <c:v>883.39569087859604</c:v>
                </c:pt>
                <c:pt idx="3805">
                  <c:v>883.62791897819602</c:v>
                </c:pt>
                <c:pt idx="3806">
                  <c:v>883.860147077796</c:v>
                </c:pt>
                <c:pt idx="3807">
                  <c:v>884.09237517739598</c:v>
                </c:pt>
                <c:pt idx="3808">
                  <c:v>884.32460327699698</c:v>
                </c:pt>
                <c:pt idx="3809">
                  <c:v>884.55683137659696</c:v>
                </c:pt>
                <c:pt idx="3810">
                  <c:v>884.78905947619705</c:v>
                </c:pt>
                <c:pt idx="3811">
                  <c:v>885.02128757579703</c:v>
                </c:pt>
                <c:pt idx="3812">
                  <c:v>885.25351567539701</c:v>
                </c:pt>
                <c:pt idx="3813">
                  <c:v>885.48574377499699</c:v>
                </c:pt>
                <c:pt idx="3814">
                  <c:v>885.71797187459697</c:v>
                </c:pt>
                <c:pt idx="3815">
                  <c:v>885.95019997419695</c:v>
                </c:pt>
                <c:pt idx="3816">
                  <c:v>886.18242807379704</c:v>
                </c:pt>
                <c:pt idx="3817">
                  <c:v>886.41465617339702</c:v>
                </c:pt>
                <c:pt idx="3818">
                  <c:v>886.646884272997</c:v>
                </c:pt>
                <c:pt idx="3819">
                  <c:v>886.87911237259698</c:v>
                </c:pt>
                <c:pt idx="3820">
                  <c:v>887.11134047219696</c:v>
                </c:pt>
                <c:pt idx="3821">
                  <c:v>887.34356857179705</c:v>
                </c:pt>
                <c:pt idx="3822">
                  <c:v>887.57579667139703</c:v>
                </c:pt>
                <c:pt idx="3823">
                  <c:v>887.80802477099701</c:v>
                </c:pt>
                <c:pt idx="3824">
                  <c:v>888.04025287059699</c:v>
                </c:pt>
                <c:pt idx="3825">
                  <c:v>888.27248097019697</c:v>
                </c:pt>
                <c:pt idx="3826">
                  <c:v>888.50470906979797</c:v>
                </c:pt>
                <c:pt idx="3827">
                  <c:v>888.73693716939704</c:v>
                </c:pt>
                <c:pt idx="3828">
                  <c:v>888.96916526899804</c:v>
                </c:pt>
                <c:pt idx="3829">
                  <c:v>889.20139336859802</c:v>
                </c:pt>
                <c:pt idx="3830">
                  <c:v>889.433621468198</c:v>
                </c:pt>
                <c:pt idx="3831">
                  <c:v>889.66584956779798</c:v>
                </c:pt>
                <c:pt idx="3832">
                  <c:v>889.89807766739796</c:v>
                </c:pt>
                <c:pt idx="3833">
                  <c:v>890.13030576699805</c:v>
                </c:pt>
                <c:pt idx="3834">
                  <c:v>890.36253386659803</c:v>
                </c:pt>
                <c:pt idx="3835">
                  <c:v>890.59476196619801</c:v>
                </c:pt>
                <c:pt idx="3836">
                  <c:v>890.82699006579799</c:v>
                </c:pt>
                <c:pt idx="3837">
                  <c:v>891.05921816539797</c:v>
                </c:pt>
                <c:pt idx="3838">
                  <c:v>891.29144626499794</c:v>
                </c:pt>
                <c:pt idx="3839">
                  <c:v>891.52367436459804</c:v>
                </c:pt>
                <c:pt idx="3840">
                  <c:v>891.75590246419802</c:v>
                </c:pt>
                <c:pt idx="3841">
                  <c:v>891.98813056379799</c:v>
                </c:pt>
                <c:pt idx="3842">
                  <c:v>892.22035866339797</c:v>
                </c:pt>
                <c:pt idx="3843">
                  <c:v>892.45258676299795</c:v>
                </c:pt>
                <c:pt idx="3844">
                  <c:v>892.68481486259805</c:v>
                </c:pt>
                <c:pt idx="3845">
                  <c:v>892.91704296219802</c:v>
                </c:pt>
                <c:pt idx="3846">
                  <c:v>893.149271061798</c:v>
                </c:pt>
                <c:pt idx="3847">
                  <c:v>893.38149916139901</c:v>
                </c:pt>
                <c:pt idx="3848">
                  <c:v>893.61372726099899</c:v>
                </c:pt>
                <c:pt idx="3849">
                  <c:v>893.84595536059896</c:v>
                </c:pt>
                <c:pt idx="3850">
                  <c:v>894.07818346019906</c:v>
                </c:pt>
                <c:pt idx="3851">
                  <c:v>894.31041155979904</c:v>
                </c:pt>
                <c:pt idx="3852">
                  <c:v>894.54263965939901</c:v>
                </c:pt>
                <c:pt idx="3853">
                  <c:v>894.77486775899899</c:v>
                </c:pt>
                <c:pt idx="3854">
                  <c:v>895.00709585859897</c:v>
                </c:pt>
                <c:pt idx="3855">
                  <c:v>895.23932395819895</c:v>
                </c:pt>
                <c:pt idx="3856">
                  <c:v>895.47155205779904</c:v>
                </c:pt>
                <c:pt idx="3857">
                  <c:v>895.70378015739902</c:v>
                </c:pt>
                <c:pt idx="3858">
                  <c:v>895.936008256999</c:v>
                </c:pt>
                <c:pt idx="3859">
                  <c:v>896.16823635659898</c:v>
                </c:pt>
                <c:pt idx="3860">
                  <c:v>896.40046445619896</c:v>
                </c:pt>
                <c:pt idx="3861">
                  <c:v>896.63269255579905</c:v>
                </c:pt>
                <c:pt idx="3862">
                  <c:v>896.86492065539903</c:v>
                </c:pt>
                <c:pt idx="3863">
                  <c:v>897.09714875499901</c:v>
                </c:pt>
                <c:pt idx="3864">
                  <c:v>897.32937685459899</c:v>
                </c:pt>
                <c:pt idx="3865">
                  <c:v>897.56160495419999</c:v>
                </c:pt>
                <c:pt idx="3866">
                  <c:v>897.79383305379997</c:v>
                </c:pt>
                <c:pt idx="3867">
                  <c:v>898.02606115339995</c:v>
                </c:pt>
                <c:pt idx="3868">
                  <c:v>898.25828925300004</c:v>
                </c:pt>
                <c:pt idx="3869">
                  <c:v>898.49051735260002</c:v>
                </c:pt>
                <c:pt idx="3870">
                  <c:v>898.7227454522</c:v>
                </c:pt>
                <c:pt idx="3871">
                  <c:v>898.95497355179998</c:v>
                </c:pt>
                <c:pt idx="3872">
                  <c:v>899.18720165139996</c:v>
                </c:pt>
                <c:pt idx="3873">
                  <c:v>899.41942975100005</c:v>
                </c:pt>
                <c:pt idx="3874">
                  <c:v>899.65165785060003</c:v>
                </c:pt>
                <c:pt idx="3875">
                  <c:v>899.88388595020001</c:v>
                </c:pt>
                <c:pt idx="3876">
                  <c:v>900.11611404979999</c:v>
                </c:pt>
                <c:pt idx="3877">
                  <c:v>900.34834214939997</c:v>
                </c:pt>
                <c:pt idx="3878">
                  <c:v>900.58057024899995</c:v>
                </c:pt>
                <c:pt idx="3879">
                  <c:v>900.81279834860004</c:v>
                </c:pt>
                <c:pt idx="3880">
                  <c:v>901.04502644820002</c:v>
                </c:pt>
                <c:pt idx="3881">
                  <c:v>901.2772545478</c:v>
                </c:pt>
                <c:pt idx="3882">
                  <c:v>901.50948264739998</c:v>
                </c:pt>
                <c:pt idx="3883">
                  <c:v>901.74171074699996</c:v>
                </c:pt>
                <c:pt idx="3884">
                  <c:v>901.97393884660096</c:v>
                </c:pt>
                <c:pt idx="3885">
                  <c:v>902.20616694620003</c:v>
                </c:pt>
                <c:pt idx="3886">
                  <c:v>902.43839504580103</c:v>
                </c:pt>
                <c:pt idx="3887">
                  <c:v>902.67062314540101</c:v>
                </c:pt>
                <c:pt idx="3888">
                  <c:v>902.90285124500099</c:v>
                </c:pt>
                <c:pt idx="3889">
                  <c:v>903.13507934460097</c:v>
                </c:pt>
                <c:pt idx="3890">
                  <c:v>903.36730744420095</c:v>
                </c:pt>
                <c:pt idx="3891">
                  <c:v>903.59953554380104</c:v>
                </c:pt>
                <c:pt idx="3892">
                  <c:v>903.83176364340102</c:v>
                </c:pt>
                <c:pt idx="3893">
                  <c:v>904.063991743001</c:v>
                </c:pt>
                <c:pt idx="3894">
                  <c:v>904.29621984260098</c:v>
                </c:pt>
                <c:pt idx="3895">
                  <c:v>904.52844794220096</c:v>
                </c:pt>
                <c:pt idx="3896">
                  <c:v>904.76067604180105</c:v>
                </c:pt>
                <c:pt idx="3897">
                  <c:v>904.99290414140103</c:v>
                </c:pt>
                <c:pt idx="3898">
                  <c:v>905.22513224100101</c:v>
                </c:pt>
                <c:pt idx="3899">
                  <c:v>905.45736034060099</c:v>
                </c:pt>
                <c:pt idx="3900">
                  <c:v>905.68958844020096</c:v>
                </c:pt>
                <c:pt idx="3901">
                  <c:v>905.92181653980094</c:v>
                </c:pt>
                <c:pt idx="3902">
                  <c:v>906.15404463940104</c:v>
                </c:pt>
                <c:pt idx="3903">
                  <c:v>906.38627273900101</c:v>
                </c:pt>
                <c:pt idx="3904">
                  <c:v>906.61850083860099</c:v>
                </c:pt>
                <c:pt idx="3905">
                  <c:v>906.850728938202</c:v>
                </c:pt>
                <c:pt idx="3906">
                  <c:v>907.08295703780198</c:v>
                </c:pt>
                <c:pt idx="3907">
                  <c:v>907.31518513740195</c:v>
                </c:pt>
                <c:pt idx="3908">
                  <c:v>907.54741323700205</c:v>
                </c:pt>
                <c:pt idx="3909">
                  <c:v>907.77964133660203</c:v>
                </c:pt>
                <c:pt idx="3910">
                  <c:v>908.01186943620201</c:v>
                </c:pt>
                <c:pt idx="3911">
                  <c:v>908.24409753580198</c:v>
                </c:pt>
                <c:pt idx="3912">
                  <c:v>908.47632563540196</c:v>
                </c:pt>
                <c:pt idx="3913">
                  <c:v>908.70855373500206</c:v>
                </c:pt>
                <c:pt idx="3914">
                  <c:v>908.94078183460203</c:v>
                </c:pt>
                <c:pt idx="3915">
                  <c:v>909.17300993420201</c:v>
                </c:pt>
                <c:pt idx="3916">
                  <c:v>909.40523803380199</c:v>
                </c:pt>
                <c:pt idx="3917">
                  <c:v>909.63746613340197</c:v>
                </c:pt>
                <c:pt idx="3918">
                  <c:v>909.86969423300195</c:v>
                </c:pt>
                <c:pt idx="3919">
                  <c:v>910.10192233260204</c:v>
                </c:pt>
                <c:pt idx="3920">
                  <c:v>910.33415043220202</c:v>
                </c:pt>
                <c:pt idx="3921">
                  <c:v>910.566378531802</c:v>
                </c:pt>
                <c:pt idx="3922">
                  <c:v>910.79860663140198</c:v>
                </c:pt>
                <c:pt idx="3923">
                  <c:v>911.03083473100298</c:v>
                </c:pt>
                <c:pt idx="3924">
                  <c:v>911.26306283060296</c:v>
                </c:pt>
                <c:pt idx="3925">
                  <c:v>911.49529093020305</c:v>
                </c:pt>
                <c:pt idx="3926">
                  <c:v>911.72751902980303</c:v>
                </c:pt>
                <c:pt idx="3927">
                  <c:v>911.95974712940301</c:v>
                </c:pt>
                <c:pt idx="3928">
                  <c:v>912.19197522900299</c:v>
                </c:pt>
                <c:pt idx="3929">
                  <c:v>912.42420332860297</c:v>
                </c:pt>
                <c:pt idx="3930">
                  <c:v>912.65643142820295</c:v>
                </c:pt>
                <c:pt idx="3931">
                  <c:v>912.88865952780304</c:v>
                </c:pt>
                <c:pt idx="3932">
                  <c:v>913.12088762740302</c:v>
                </c:pt>
                <c:pt idx="3933">
                  <c:v>913.353115727003</c:v>
                </c:pt>
                <c:pt idx="3934">
                  <c:v>913.58534382660298</c:v>
                </c:pt>
                <c:pt idx="3935">
                  <c:v>913.81757192620296</c:v>
                </c:pt>
                <c:pt idx="3936">
                  <c:v>914.04980002580305</c:v>
                </c:pt>
                <c:pt idx="3937">
                  <c:v>914.28202812540303</c:v>
                </c:pt>
                <c:pt idx="3938">
                  <c:v>914.51425622500301</c:v>
                </c:pt>
                <c:pt idx="3939">
                  <c:v>914.74648432460299</c:v>
                </c:pt>
                <c:pt idx="3940">
                  <c:v>914.97871242420297</c:v>
                </c:pt>
                <c:pt idx="3941">
                  <c:v>915.21094052380295</c:v>
                </c:pt>
                <c:pt idx="3942">
                  <c:v>915.44316862340304</c:v>
                </c:pt>
                <c:pt idx="3943">
                  <c:v>915.67539672300302</c:v>
                </c:pt>
                <c:pt idx="3944">
                  <c:v>915.90762482260402</c:v>
                </c:pt>
                <c:pt idx="3945">
                  <c:v>916.139852922204</c:v>
                </c:pt>
                <c:pt idx="3946">
                  <c:v>916.37208102180398</c:v>
                </c:pt>
                <c:pt idx="3947">
                  <c:v>916.60430912140396</c:v>
                </c:pt>
                <c:pt idx="3948">
                  <c:v>916.83653722100405</c:v>
                </c:pt>
                <c:pt idx="3949">
                  <c:v>917.06876532060403</c:v>
                </c:pt>
                <c:pt idx="3950">
                  <c:v>917.30099342020401</c:v>
                </c:pt>
                <c:pt idx="3951">
                  <c:v>917.53322151980399</c:v>
                </c:pt>
                <c:pt idx="3952">
                  <c:v>917.76544961940397</c:v>
                </c:pt>
                <c:pt idx="3953">
                  <c:v>917.99767771900395</c:v>
                </c:pt>
                <c:pt idx="3954">
                  <c:v>918.22990581860404</c:v>
                </c:pt>
                <c:pt idx="3955">
                  <c:v>918.46213391820402</c:v>
                </c:pt>
                <c:pt idx="3956">
                  <c:v>918.694362017804</c:v>
                </c:pt>
                <c:pt idx="3957">
                  <c:v>918.92659011740398</c:v>
                </c:pt>
                <c:pt idx="3958">
                  <c:v>919.15881821700395</c:v>
                </c:pt>
                <c:pt idx="3959">
                  <c:v>919.39104631660405</c:v>
                </c:pt>
                <c:pt idx="3960">
                  <c:v>919.62327441620403</c:v>
                </c:pt>
                <c:pt idx="3961">
                  <c:v>919.85550251580401</c:v>
                </c:pt>
                <c:pt idx="3962">
                  <c:v>920.08773061540398</c:v>
                </c:pt>
                <c:pt idx="3963">
                  <c:v>920.31995871500499</c:v>
                </c:pt>
                <c:pt idx="3964">
                  <c:v>920.55218681460497</c:v>
                </c:pt>
                <c:pt idx="3965">
                  <c:v>920.78441491420494</c:v>
                </c:pt>
                <c:pt idx="3966">
                  <c:v>921.01664301380504</c:v>
                </c:pt>
                <c:pt idx="3967">
                  <c:v>921.24887111340502</c:v>
                </c:pt>
                <c:pt idx="3968">
                  <c:v>921.481099213005</c:v>
                </c:pt>
                <c:pt idx="3969">
                  <c:v>921.71332731260497</c:v>
                </c:pt>
                <c:pt idx="3970">
                  <c:v>921.94555541220495</c:v>
                </c:pt>
                <c:pt idx="3971">
                  <c:v>922.17778351180505</c:v>
                </c:pt>
                <c:pt idx="3972">
                  <c:v>922.41001161140503</c:v>
                </c:pt>
                <c:pt idx="3973">
                  <c:v>922.642239711005</c:v>
                </c:pt>
                <c:pt idx="3974">
                  <c:v>922.87446781060498</c:v>
                </c:pt>
                <c:pt idx="3975">
                  <c:v>923.10669591020496</c:v>
                </c:pt>
                <c:pt idx="3976">
                  <c:v>923.33892400980505</c:v>
                </c:pt>
                <c:pt idx="3977">
                  <c:v>923.57115210940503</c:v>
                </c:pt>
                <c:pt idx="3978">
                  <c:v>923.80338020900501</c:v>
                </c:pt>
                <c:pt idx="3979">
                  <c:v>924.03560830860499</c:v>
                </c:pt>
                <c:pt idx="3980">
                  <c:v>924.26783640820497</c:v>
                </c:pt>
                <c:pt idx="3981">
                  <c:v>924.50006450780597</c:v>
                </c:pt>
                <c:pt idx="3982">
                  <c:v>924.73229260740504</c:v>
                </c:pt>
                <c:pt idx="3983">
                  <c:v>924.96452070700605</c:v>
                </c:pt>
                <c:pt idx="3984">
                  <c:v>925.19674880660602</c:v>
                </c:pt>
                <c:pt idx="3985">
                  <c:v>925.428976906206</c:v>
                </c:pt>
                <c:pt idx="3986">
                  <c:v>925.66120500580598</c:v>
                </c:pt>
                <c:pt idx="3987">
                  <c:v>925.89343310540596</c:v>
                </c:pt>
                <c:pt idx="3988">
                  <c:v>926.12566120500605</c:v>
                </c:pt>
                <c:pt idx="3989">
                  <c:v>926.35788930460603</c:v>
                </c:pt>
                <c:pt idx="3990">
                  <c:v>926.59011740420601</c:v>
                </c:pt>
                <c:pt idx="3991">
                  <c:v>926.82234550380599</c:v>
                </c:pt>
                <c:pt idx="3992">
                  <c:v>927.05457360340597</c:v>
                </c:pt>
                <c:pt idx="3993">
                  <c:v>927.28680170300595</c:v>
                </c:pt>
                <c:pt idx="3994">
                  <c:v>927.51902980260604</c:v>
                </c:pt>
                <c:pt idx="3995">
                  <c:v>927.75125790220602</c:v>
                </c:pt>
                <c:pt idx="3996">
                  <c:v>927.983486001806</c:v>
                </c:pt>
                <c:pt idx="3997">
                  <c:v>928.21571410140598</c:v>
                </c:pt>
                <c:pt idx="3998">
                  <c:v>928.44794220100596</c:v>
                </c:pt>
                <c:pt idx="3999">
                  <c:v>928.68017030060605</c:v>
                </c:pt>
                <c:pt idx="4000">
                  <c:v>928.91239840020603</c:v>
                </c:pt>
                <c:pt idx="4001">
                  <c:v>929.14462649980601</c:v>
                </c:pt>
                <c:pt idx="4002">
                  <c:v>929.37685459940701</c:v>
                </c:pt>
                <c:pt idx="4003">
                  <c:v>929.60908269900699</c:v>
                </c:pt>
                <c:pt idx="4004">
                  <c:v>929.84131079860697</c:v>
                </c:pt>
                <c:pt idx="4005">
                  <c:v>930.07353889820695</c:v>
                </c:pt>
                <c:pt idx="4006">
                  <c:v>930.30576699780704</c:v>
                </c:pt>
                <c:pt idx="4007">
                  <c:v>930.53799509740702</c:v>
                </c:pt>
                <c:pt idx="4008">
                  <c:v>930.770223197007</c:v>
                </c:pt>
                <c:pt idx="4009">
                  <c:v>931.00245129660698</c:v>
                </c:pt>
                <c:pt idx="4010">
                  <c:v>931.23467939620696</c:v>
                </c:pt>
                <c:pt idx="4011">
                  <c:v>931.46690749580705</c:v>
                </c:pt>
                <c:pt idx="4012">
                  <c:v>931.69913559540703</c:v>
                </c:pt>
                <c:pt idx="4013">
                  <c:v>931.93136369500701</c:v>
                </c:pt>
                <c:pt idx="4014">
                  <c:v>932.16359179460699</c:v>
                </c:pt>
                <c:pt idx="4015">
                  <c:v>932.39581989420697</c:v>
                </c:pt>
                <c:pt idx="4016">
                  <c:v>932.62804799380694</c:v>
                </c:pt>
                <c:pt idx="4017">
                  <c:v>932.86027609340704</c:v>
                </c:pt>
                <c:pt idx="4018">
                  <c:v>933.09250419300702</c:v>
                </c:pt>
                <c:pt idx="4019">
                  <c:v>933.324732292607</c:v>
                </c:pt>
                <c:pt idx="4020">
                  <c:v>933.55696039220697</c:v>
                </c:pt>
                <c:pt idx="4021">
                  <c:v>933.78918849180798</c:v>
                </c:pt>
                <c:pt idx="4022">
                  <c:v>934.02141659140796</c:v>
                </c:pt>
                <c:pt idx="4023">
                  <c:v>934.25364469100805</c:v>
                </c:pt>
                <c:pt idx="4024">
                  <c:v>934.48587279060803</c:v>
                </c:pt>
                <c:pt idx="4025">
                  <c:v>934.71810089020801</c:v>
                </c:pt>
                <c:pt idx="4026">
                  <c:v>934.95032898980799</c:v>
                </c:pt>
                <c:pt idx="4027">
                  <c:v>935.18255708940796</c:v>
                </c:pt>
                <c:pt idx="4028">
                  <c:v>935.41478518900794</c:v>
                </c:pt>
                <c:pt idx="4029">
                  <c:v>935.64701328860804</c:v>
                </c:pt>
                <c:pt idx="4030">
                  <c:v>935.87924138820802</c:v>
                </c:pt>
                <c:pt idx="4031">
                  <c:v>936.11146948780799</c:v>
                </c:pt>
                <c:pt idx="4032">
                  <c:v>936.34369758740797</c:v>
                </c:pt>
                <c:pt idx="4033">
                  <c:v>936.57592568700795</c:v>
                </c:pt>
                <c:pt idx="4034">
                  <c:v>936.80815378660805</c:v>
                </c:pt>
                <c:pt idx="4035">
                  <c:v>937.04038188620802</c:v>
                </c:pt>
                <c:pt idx="4036">
                  <c:v>937.272609985808</c:v>
                </c:pt>
                <c:pt idx="4037">
                  <c:v>937.50483808540798</c:v>
                </c:pt>
                <c:pt idx="4038">
                  <c:v>937.73706618500796</c:v>
                </c:pt>
                <c:pt idx="4039">
                  <c:v>937.96929428460896</c:v>
                </c:pt>
                <c:pt idx="4040">
                  <c:v>938.20152238420803</c:v>
                </c:pt>
                <c:pt idx="4041">
                  <c:v>938.43375048380904</c:v>
                </c:pt>
                <c:pt idx="4042">
                  <c:v>938.66597858340901</c:v>
                </c:pt>
                <c:pt idx="4043">
                  <c:v>938.89820668300899</c:v>
                </c:pt>
                <c:pt idx="4044">
                  <c:v>939.13043478260897</c:v>
                </c:pt>
                <c:pt idx="4045">
                  <c:v>939.36266288220895</c:v>
                </c:pt>
                <c:pt idx="4046">
                  <c:v>939.59489098180904</c:v>
                </c:pt>
                <c:pt idx="4047">
                  <c:v>939.82711908140902</c:v>
                </c:pt>
                <c:pt idx="4048">
                  <c:v>940.059347181009</c:v>
                </c:pt>
                <c:pt idx="4049">
                  <c:v>940.29157528060898</c:v>
                </c:pt>
                <c:pt idx="4050">
                  <c:v>940.52380338020896</c:v>
                </c:pt>
                <c:pt idx="4051">
                  <c:v>940.75603147980905</c:v>
                </c:pt>
                <c:pt idx="4052">
                  <c:v>940.98825957940903</c:v>
                </c:pt>
                <c:pt idx="4053">
                  <c:v>941.22048767900901</c:v>
                </c:pt>
                <c:pt idx="4054">
                  <c:v>941.45271577860899</c:v>
                </c:pt>
                <c:pt idx="4055">
                  <c:v>941.68494387820897</c:v>
                </c:pt>
                <c:pt idx="4056">
                  <c:v>941.91717197780895</c:v>
                </c:pt>
                <c:pt idx="4057">
                  <c:v>942.14940007740904</c:v>
                </c:pt>
                <c:pt idx="4058">
                  <c:v>942.38162817700902</c:v>
                </c:pt>
                <c:pt idx="4059">
                  <c:v>942.613856276609</c:v>
                </c:pt>
                <c:pt idx="4060">
                  <c:v>942.84608437621</c:v>
                </c:pt>
                <c:pt idx="4061">
                  <c:v>943.07831247580998</c:v>
                </c:pt>
                <c:pt idx="4062">
                  <c:v>943.31054057540996</c:v>
                </c:pt>
                <c:pt idx="4063">
                  <c:v>943.54276867501005</c:v>
                </c:pt>
                <c:pt idx="4064">
                  <c:v>943.77499677461003</c:v>
                </c:pt>
                <c:pt idx="4065">
                  <c:v>944.00722487421001</c:v>
                </c:pt>
                <c:pt idx="4066">
                  <c:v>944.23945297380999</c:v>
                </c:pt>
                <c:pt idx="4067">
                  <c:v>944.47168107340997</c:v>
                </c:pt>
                <c:pt idx="4068">
                  <c:v>944.70390917300995</c:v>
                </c:pt>
                <c:pt idx="4069">
                  <c:v>944.93613727261004</c:v>
                </c:pt>
                <c:pt idx="4070">
                  <c:v>945.16836537221002</c:v>
                </c:pt>
                <c:pt idx="4071">
                  <c:v>945.40059347181</c:v>
                </c:pt>
                <c:pt idx="4072">
                  <c:v>945.63282157140998</c:v>
                </c:pt>
                <c:pt idx="4073">
                  <c:v>945.86504967100996</c:v>
                </c:pt>
                <c:pt idx="4074">
                  <c:v>946.09727777061005</c:v>
                </c:pt>
                <c:pt idx="4075">
                  <c:v>946.32950587021003</c:v>
                </c:pt>
                <c:pt idx="4076">
                  <c:v>946.56173396981001</c:v>
                </c:pt>
                <c:pt idx="4077">
                  <c:v>946.79396206940999</c:v>
                </c:pt>
                <c:pt idx="4078">
                  <c:v>947.02619016901099</c:v>
                </c:pt>
                <c:pt idx="4079">
                  <c:v>947.25841826861097</c:v>
                </c:pt>
                <c:pt idx="4080">
                  <c:v>947.49064636821095</c:v>
                </c:pt>
                <c:pt idx="4081">
                  <c:v>947.72287446781104</c:v>
                </c:pt>
                <c:pt idx="4082">
                  <c:v>947.95510256741102</c:v>
                </c:pt>
                <c:pt idx="4083">
                  <c:v>948.187330667011</c:v>
                </c:pt>
                <c:pt idx="4084">
                  <c:v>948.41955876661098</c:v>
                </c:pt>
                <c:pt idx="4085">
                  <c:v>948.65178686621095</c:v>
                </c:pt>
                <c:pt idx="4086">
                  <c:v>948.88401496581105</c:v>
                </c:pt>
                <c:pt idx="4087">
                  <c:v>949.11624306541103</c:v>
                </c:pt>
                <c:pt idx="4088">
                  <c:v>949.34847116501101</c:v>
                </c:pt>
                <c:pt idx="4089">
                  <c:v>949.58069926461098</c:v>
                </c:pt>
                <c:pt idx="4090">
                  <c:v>949.81292736421096</c:v>
                </c:pt>
                <c:pt idx="4091">
                  <c:v>950.04515546381106</c:v>
                </c:pt>
                <c:pt idx="4092">
                  <c:v>950.27738356341104</c:v>
                </c:pt>
                <c:pt idx="4093">
                  <c:v>950.50961166301101</c:v>
                </c:pt>
                <c:pt idx="4094">
                  <c:v>950.74183976261099</c:v>
                </c:pt>
                <c:pt idx="4095">
                  <c:v>950.97406786221097</c:v>
                </c:pt>
                <c:pt idx="4096">
                  <c:v>951.20629596181095</c:v>
                </c:pt>
                <c:pt idx="4097">
                  <c:v>951.43852406141104</c:v>
                </c:pt>
                <c:pt idx="4098">
                  <c:v>951.67075216101102</c:v>
                </c:pt>
                <c:pt idx="4099">
                  <c:v>951.90298026061203</c:v>
                </c:pt>
                <c:pt idx="4100">
                  <c:v>952.135208360212</c:v>
                </c:pt>
                <c:pt idx="4101">
                  <c:v>952.36743645981198</c:v>
                </c:pt>
                <c:pt idx="4102">
                  <c:v>952.59966455941196</c:v>
                </c:pt>
                <c:pt idx="4103">
                  <c:v>952.83189265901206</c:v>
                </c:pt>
                <c:pt idx="4104">
                  <c:v>953.06412075861203</c:v>
                </c:pt>
                <c:pt idx="4105">
                  <c:v>953.29634885821201</c:v>
                </c:pt>
                <c:pt idx="4106">
                  <c:v>953.52857695781199</c:v>
                </c:pt>
                <c:pt idx="4107">
                  <c:v>953.76080505741197</c:v>
                </c:pt>
                <c:pt idx="4108">
                  <c:v>953.99303315701195</c:v>
                </c:pt>
                <c:pt idx="4109">
                  <c:v>954.22526125661204</c:v>
                </c:pt>
                <c:pt idx="4110">
                  <c:v>954.45748935621202</c:v>
                </c:pt>
                <c:pt idx="4111">
                  <c:v>954.689717455812</c:v>
                </c:pt>
                <c:pt idx="4112">
                  <c:v>954.92194555541198</c:v>
                </c:pt>
                <c:pt idx="4113">
                  <c:v>955.15417365501196</c:v>
                </c:pt>
                <c:pt idx="4114">
                  <c:v>955.38640175461205</c:v>
                </c:pt>
                <c:pt idx="4115">
                  <c:v>955.61862985421203</c:v>
                </c:pt>
                <c:pt idx="4116">
                  <c:v>955.85085795381201</c:v>
                </c:pt>
                <c:pt idx="4117">
                  <c:v>956.08308605341199</c:v>
                </c:pt>
                <c:pt idx="4118">
                  <c:v>956.31531415301299</c:v>
                </c:pt>
                <c:pt idx="4119">
                  <c:v>956.54754225261297</c:v>
                </c:pt>
                <c:pt idx="4120">
                  <c:v>956.77977035221295</c:v>
                </c:pt>
                <c:pt idx="4121">
                  <c:v>957.01199845181304</c:v>
                </c:pt>
                <c:pt idx="4122">
                  <c:v>957.24422655141302</c:v>
                </c:pt>
                <c:pt idx="4123">
                  <c:v>957.476454651013</c:v>
                </c:pt>
                <c:pt idx="4124">
                  <c:v>957.70868275061298</c:v>
                </c:pt>
                <c:pt idx="4125">
                  <c:v>957.94091085021296</c:v>
                </c:pt>
                <c:pt idx="4126">
                  <c:v>958.17313894981305</c:v>
                </c:pt>
                <c:pt idx="4127">
                  <c:v>958.40536704941303</c:v>
                </c:pt>
                <c:pt idx="4128">
                  <c:v>958.63759514901301</c:v>
                </c:pt>
                <c:pt idx="4129">
                  <c:v>958.86982324861299</c:v>
                </c:pt>
                <c:pt idx="4130">
                  <c:v>959.10205134821297</c:v>
                </c:pt>
                <c:pt idx="4131">
                  <c:v>959.33427944781295</c:v>
                </c:pt>
                <c:pt idx="4132">
                  <c:v>959.56650754741304</c:v>
                </c:pt>
                <c:pt idx="4133">
                  <c:v>959.79873564701302</c:v>
                </c:pt>
                <c:pt idx="4134">
                  <c:v>960.030963746613</c:v>
                </c:pt>
                <c:pt idx="4135">
                  <c:v>960.26319184621298</c:v>
                </c:pt>
                <c:pt idx="4136">
                  <c:v>960.49541994581398</c:v>
                </c:pt>
                <c:pt idx="4137">
                  <c:v>960.72764804541396</c:v>
                </c:pt>
                <c:pt idx="4138">
                  <c:v>960.95987614501405</c:v>
                </c:pt>
                <c:pt idx="4139">
                  <c:v>961.19210424461403</c:v>
                </c:pt>
                <c:pt idx="4140">
                  <c:v>961.42433234421401</c:v>
                </c:pt>
                <c:pt idx="4141">
                  <c:v>961.65656044381399</c:v>
                </c:pt>
                <c:pt idx="4142">
                  <c:v>961.88878854341397</c:v>
                </c:pt>
                <c:pt idx="4143">
                  <c:v>962.12101664301395</c:v>
                </c:pt>
                <c:pt idx="4144">
                  <c:v>962.35324474261404</c:v>
                </c:pt>
                <c:pt idx="4145">
                  <c:v>962.58547284221402</c:v>
                </c:pt>
                <c:pt idx="4146">
                  <c:v>962.817700941814</c:v>
                </c:pt>
                <c:pt idx="4147">
                  <c:v>963.04992904141398</c:v>
                </c:pt>
                <c:pt idx="4148">
                  <c:v>963.28215714101395</c:v>
                </c:pt>
                <c:pt idx="4149">
                  <c:v>963.51438524061405</c:v>
                </c:pt>
                <c:pt idx="4150">
                  <c:v>963.74661334021403</c:v>
                </c:pt>
                <c:pt idx="4151">
                  <c:v>963.978841439814</c:v>
                </c:pt>
                <c:pt idx="4152">
                  <c:v>964.21106953941398</c:v>
                </c:pt>
                <c:pt idx="4153">
                  <c:v>964.44329763901396</c:v>
                </c:pt>
                <c:pt idx="4154">
                  <c:v>964.67552573861406</c:v>
                </c:pt>
                <c:pt idx="4155">
                  <c:v>964.90775383821403</c:v>
                </c:pt>
                <c:pt idx="4156">
                  <c:v>965.13998193781401</c:v>
                </c:pt>
                <c:pt idx="4157">
                  <c:v>965.37221003741502</c:v>
                </c:pt>
                <c:pt idx="4158">
                  <c:v>965.60443813701499</c:v>
                </c:pt>
                <c:pt idx="4159">
                  <c:v>965.83666623661497</c:v>
                </c:pt>
                <c:pt idx="4160">
                  <c:v>966.06889433621495</c:v>
                </c:pt>
                <c:pt idx="4161">
                  <c:v>966.30112243581505</c:v>
                </c:pt>
                <c:pt idx="4162">
                  <c:v>966.53335053541502</c:v>
                </c:pt>
                <c:pt idx="4163">
                  <c:v>966.765578635015</c:v>
                </c:pt>
                <c:pt idx="4164">
                  <c:v>966.99780673461498</c:v>
                </c:pt>
                <c:pt idx="4165">
                  <c:v>967.23003483421496</c:v>
                </c:pt>
                <c:pt idx="4166">
                  <c:v>967.46226293381505</c:v>
                </c:pt>
                <c:pt idx="4167">
                  <c:v>967.69449103341503</c:v>
                </c:pt>
                <c:pt idx="4168">
                  <c:v>967.92671913301501</c:v>
                </c:pt>
                <c:pt idx="4169">
                  <c:v>968.15894723261499</c:v>
                </c:pt>
                <c:pt idx="4170">
                  <c:v>968.39117533221497</c:v>
                </c:pt>
                <c:pt idx="4171">
                  <c:v>968.62340343181495</c:v>
                </c:pt>
                <c:pt idx="4172">
                  <c:v>968.85563153141504</c:v>
                </c:pt>
                <c:pt idx="4173">
                  <c:v>969.08785963101502</c:v>
                </c:pt>
                <c:pt idx="4174">
                  <c:v>969.320087730615</c:v>
                </c:pt>
                <c:pt idx="4175">
                  <c:v>969.55231583021498</c:v>
                </c:pt>
                <c:pt idx="4176">
                  <c:v>969.78454392981598</c:v>
                </c:pt>
                <c:pt idx="4177">
                  <c:v>970.01677202941596</c:v>
                </c:pt>
                <c:pt idx="4178">
                  <c:v>970.24900012901605</c:v>
                </c:pt>
                <c:pt idx="4179">
                  <c:v>970.48122822861603</c:v>
                </c:pt>
                <c:pt idx="4180">
                  <c:v>970.71345632821601</c:v>
                </c:pt>
                <c:pt idx="4181">
                  <c:v>970.94568442781599</c:v>
                </c:pt>
                <c:pt idx="4182">
                  <c:v>971.17791252741597</c:v>
                </c:pt>
                <c:pt idx="4183">
                  <c:v>971.41014062701595</c:v>
                </c:pt>
                <c:pt idx="4184">
                  <c:v>971.64236872661604</c:v>
                </c:pt>
                <c:pt idx="4185">
                  <c:v>971.87459682621602</c:v>
                </c:pt>
                <c:pt idx="4186">
                  <c:v>972.106824925816</c:v>
                </c:pt>
                <c:pt idx="4187">
                  <c:v>972.33905302541598</c:v>
                </c:pt>
                <c:pt idx="4188">
                  <c:v>972.57128112501596</c:v>
                </c:pt>
                <c:pt idx="4189">
                  <c:v>972.80350922461605</c:v>
                </c:pt>
                <c:pt idx="4190">
                  <c:v>973.03573732421603</c:v>
                </c:pt>
                <c:pt idx="4191">
                  <c:v>973.26796542381601</c:v>
                </c:pt>
                <c:pt idx="4192">
                  <c:v>973.50019352341599</c:v>
                </c:pt>
                <c:pt idx="4193">
                  <c:v>973.73242162301597</c:v>
                </c:pt>
                <c:pt idx="4194">
                  <c:v>973.96464972261697</c:v>
                </c:pt>
                <c:pt idx="4195">
                  <c:v>974.19687782221604</c:v>
                </c:pt>
                <c:pt idx="4196">
                  <c:v>974.42910592181704</c:v>
                </c:pt>
                <c:pt idx="4197">
                  <c:v>974.66133402141702</c:v>
                </c:pt>
                <c:pt idx="4198">
                  <c:v>974.893562121017</c:v>
                </c:pt>
                <c:pt idx="4199">
                  <c:v>975.12579022061698</c:v>
                </c:pt>
                <c:pt idx="4200">
                  <c:v>975.35801832021696</c:v>
                </c:pt>
                <c:pt idx="4201">
                  <c:v>975.59024641981705</c:v>
                </c:pt>
                <c:pt idx="4202">
                  <c:v>975.82247451941703</c:v>
                </c:pt>
                <c:pt idx="4203">
                  <c:v>976.05470261901701</c:v>
                </c:pt>
                <c:pt idx="4204">
                  <c:v>976.28693071861699</c:v>
                </c:pt>
                <c:pt idx="4205">
                  <c:v>976.51915881821697</c:v>
                </c:pt>
                <c:pt idx="4206">
                  <c:v>976.75138691781694</c:v>
                </c:pt>
                <c:pt idx="4207">
                  <c:v>976.98361501741704</c:v>
                </c:pt>
                <c:pt idx="4208">
                  <c:v>977.21584311701702</c:v>
                </c:pt>
                <c:pt idx="4209">
                  <c:v>977.448071216617</c:v>
                </c:pt>
                <c:pt idx="4210">
                  <c:v>977.68029931621697</c:v>
                </c:pt>
                <c:pt idx="4211">
                  <c:v>977.91252741581695</c:v>
                </c:pt>
                <c:pt idx="4212">
                  <c:v>978.14475551541705</c:v>
                </c:pt>
                <c:pt idx="4213">
                  <c:v>978.37698361501702</c:v>
                </c:pt>
                <c:pt idx="4214">
                  <c:v>978.609211714617</c:v>
                </c:pt>
                <c:pt idx="4215">
                  <c:v>978.84143981421801</c:v>
                </c:pt>
                <c:pt idx="4216">
                  <c:v>979.07366791381799</c:v>
                </c:pt>
                <c:pt idx="4217">
                  <c:v>979.30589601341796</c:v>
                </c:pt>
                <c:pt idx="4218">
                  <c:v>979.53812411301794</c:v>
                </c:pt>
                <c:pt idx="4219">
                  <c:v>979.77035221261804</c:v>
                </c:pt>
                <c:pt idx="4220">
                  <c:v>980.00258031221802</c:v>
                </c:pt>
                <c:pt idx="4221">
                  <c:v>980.23480841181799</c:v>
                </c:pt>
                <c:pt idx="4222">
                  <c:v>980.46703651141797</c:v>
                </c:pt>
                <c:pt idx="4223">
                  <c:v>980.69926461101795</c:v>
                </c:pt>
                <c:pt idx="4224">
                  <c:v>980.93149271061804</c:v>
                </c:pt>
                <c:pt idx="4225">
                  <c:v>981.16372081021802</c:v>
                </c:pt>
                <c:pt idx="4226">
                  <c:v>981.395948909818</c:v>
                </c:pt>
                <c:pt idx="4227">
                  <c:v>981.62817700941798</c:v>
                </c:pt>
                <c:pt idx="4228">
                  <c:v>981.86040510901796</c:v>
                </c:pt>
                <c:pt idx="4229">
                  <c:v>982.09263320861805</c:v>
                </c:pt>
                <c:pt idx="4230">
                  <c:v>982.32486130821803</c:v>
                </c:pt>
                <c:pt idx="4231">
                  <c:v>982.55708940781801</c:v>
                </c:pt>
                <c:pt idx="4232">
                  <c:v>982.78931750741799</c:v>
                </c:pt>
                <c:pt idx="4233">
                  <c:v>983.02154560701797</c:v>
                </c:pt>
                <c:pt idx="4234">
                  <c:v>983.25377370661897</c:v>
                </c:pt>
                <c:pt idx="4235">
                  <c:v>983.48600180621895</c:v>
                </c:pt>
                <c:pt idx="4236">
                  <c:v>983.71822990581904</c:v>
                </c:pt>
                <c:pt idx="4237">
                  <c:v>983.95045800541902</c:v>
                </c:pt>
                <c:pt idx="4238">
                  <c:v>984.182686105019</c:v>
                </c:pt>
                <c:pt idx="4239">
                  <c:v>984.41491420461898</c:v>
                </c:pt>
                <c:pt idx="4240">
                  <c:v>984.64714230421896</c:v>
                </c:pt>
                <c:pt idx="4241">
                  <c:v>984.87937040381905</c:v>
                </c:pt>
                <c:pt idx="4242">
                  <c:v>985.11159850341903</c:v>
                </c:pt>
                <c:pt idx="4243">
                  <c:v>985.34382660301901</c:v>
                </c:pt>
                <c:pt idx="4244">
                  <c:v>985.57605470261899</c:v>
                </c:pt>
                <c:pt idx="4245">
                  <c:v>985.80828280221897</c:v>
                </c:pt>
                <c:pt idx="4246">
                  <c:v>986.04051090181895</c:v>
                </c:pt>
                <c:pt idx="4247">
                  <c:v>986.27273900141904</c:v>
                </c:pt>
                <c:pt idx="4248">
                  <c:v>986.50496710101902</c:v>
                </c:pt>
                <c:pt idx="4249">
                  <c:v>986.737195200619</c:v>
                </c:pt>
                <c:pt idx="4250">
                  <c:v>986.96942330021898</c:v>
                </c:pt>
                <c:pt idx="4251">
                  <c:v>987.20165139981896</c:v>
                </c:pt>
                <c:pt idx="4252">
                  <c:v>987.43387949941996</c:v>
                </c:pt>
                <c:pt idx="4253">
                  <c:v>987.66610759901903</c:v>
                </c:pt>
                <c:pt idx="4254">
                  <c:v>987.89833569862003</c:v>
                </c:pt>
                <c:pt idx="4255">
                  <c:v>988.13056379822001</c:v>
                </c:pt>
                <c:pt idx="4256">
                  <c:v>988.36279189781999</c:v>
                </c:pt>
                <c:pt idx="4257">
                  <c:v>988.59501999741997</c:v>
                </c:pt>
                <c:pt idx="4258">
                  <c:v>988.82724809701995</c:v>
                </c:pt>
                <c:pt idx="4259">
                  <c:v>989.05947619662004</c:v>
                </c:pt>
                <c:pt idx="4260">
                  <c:v>989.29170429622002</c:v>
                </c:pt>
                <c:pt idx="4261">
                  <c:v>989.52393239582</c:v>
                </c:pt>
                <c:pt idx="4262">
                  <c:v>989.75616049541998</c:v>
                </c:pt>
                <c:pt idx="4263">
                  <c:v>989.98838859501996</c:v>
                </c:pt>
                <c:pt idx="4264">
                  <c:v>990.22061669462005</c:v>
                </c:pt>
                <c:pt idx="4265">
                  <c:v>990.45284479422003</c:v>
                </c:pt>
                <c:pt idx="4266">
                  <c:v>990.68507289382001</c:v>
                </c:pt>
                <c:pt idx="4267">
                  <c:v>990.91730099341999</c:v>
                </c:pt>
                <c:pt idx="4268">
                  <c:v>991.14952909301996</c:v>
                </c:pt>
                <c:pt idx="4269">
                  <c:v>991.38175719261994</c:v>
                </c:pt>
                <c:pt idx="4270">
                  <c:v>991.61398529222004</c:v>
                </c:pt>
                <c:pt idx="4271">
                  <c:v>991.84621339182002</c:v>
                </c:pt>
                <c:pt idx="4272">
                  <c:v>992.07844149141999</c:v>
                </c:pt>
                <c:pt idx="4273">
                  <c:v>992.310669591021</c:v>
                </c:pt>
                <c:pt idx="4274">
                  <c:v>992.54289769062098</c:v>
                </c:pt>
                <c:pt idx="4275">
                  <c:v>992.77512579022095</c:v>
                </c:pt>
                <c:pt idx="4276">
                  <c:v>993.00735388982105</c:v>
                </c:pt>
                <c:pt idx="4277">
                  <c:v>993.23958198942103</c:v>
                </c:pt>
                <c:pt idx="4278">
                  <c:v>993.47181008902101</c:v>
                </c:pt>
                <c:pt idx="4279">
                  <c:v>993.70403818862098</c:v>
                </c:pt>
                <c:pt idx="4280">
                  <c:v>993.93626628822096</c:v>
                </c:pt>
                <c:pt idx="4281">
                  <c:v>994.16849438782106</c:v>
                </c:pt>
                <c:pt idx="4282">
                  <c:v>994.40072248742104</c:v>
                </c:pt>
                <c:pt idx="4283">
                  <c:v>994.63295058702101</c:v>
                </c:pt>
                <c:pt idx="4284">
                  <c:v>994.86517868662099</c:v>
                </c:pt>
                <c:pt idx="4285">
                  <c:v>995.09740678622097</c:v>
                </c:pt>
                <c:pt idx="4286">
                  <c:v>995.32963488582095</c:v>
                </c:pt>
                <c:pt idx="4287">
                  <c:v>995.56186298542104</c:v>
                </c:pt>
                <c:pt idx="4288">
                  <c:v>995.79409108502102</c:v>
                </c:pt>
                <c:pt idx="4289">
                  <c:v>996.026319184621</c:v>
                </c:pt>
                <c:pt idx="4290">
                  <c:v>996.25854728422098</c:v>
                </c:pt>
                <c:pt idx="4291">
                  <c:v>996.49077538382096</c:v>
                </c:pt>
                <c:pt idx="4292">
                  <c:v>996.72300348342196</c:v>
                </c:pt>
                <c:pt idx="4293">
                  <c:v>996.95523158302206</c:v>
                </c:pt>
                <c:pt idx="4294">
                  <c:v>997.18745968262203</c:v>
                </c:pt>
                <c:pt idx="4295">
                  <c:v>997.41968778222201</c:v>
                </c:pt>
                <c:pt idx="4296">
                  <c:v>997.65191588182199</c:v>
                </c:pt>
                <c:pt idx="4297">
                  <c:v>997.88414398142197</c:v>
                </c:pt>
                <c:pt idx="4298">
                  <c:v>998.11637208102195</c:v>
                </c:pt>
                <c:pt idx="4299">
                  <c:v>998.34860018062204</c:v>
                </c:pt>
                <c:pt idx="4300">
                  <c:v>998.58082828022202</c:v>
                </c:pt>
                <c:pt idx="4301">
                  <c:v>998.813056379822</c:v>
                </c:pt>
                <c:pt idx="4302">
                  <c:v>999.04528447942198</c:v>
                </c:pt>
                <c:pt idx="4303">
                  <c:v>999.27751257902196</c:v>
                </c:pt>
                <c:pt idx="4304">
                  <c:v>999.50974067862205</c:v>
                </c:pt>
                <c:pt idx="4305">
                  <c:v>999.74196877822203</c:v>
                </c:pt>
                <c:pt idx="4306">
                  <c:v>999.97419687782201</c:v>
                </c:pt>
                <c:pt idx="4307">
                  <c:v>1000.2064249774201</c:v>
                </c:pt>
                <c:pt idx="4308">
                  <c:v>1000.43865307702</c:v>
                </c:pt>
                <c:pt idx="4309">
                  <c:v>1000.67088117662</c:v>
                </c:pt>
                <c:pt idx="4310">
                  <c:v>1000.90310927622</c:v>
                </c:pt>
                <c:pt idx="4311">
                  <c:v>1001.13533737582</c:v>
                </c:pt>
                <c:pt idx="4312">
                  <c:v>1001.36756547542</c:v>
                </c:pt>
                <c:pt idx="4313">
                  <c:v>1001.59979357502</c:v>
                </c:pt>
                <c:pt idx="4314">
                  <c:v>1001.83202167462</c:v>
                </c:pt>
                <c:pt idx="4315">
                  <c:v>1002.06424977422</c:v>
                </c:pt>
                <c:pt idx="4316">
                  <c:v>1002.29647787382</c:v>
                </c:pt>
                <c:pt idx="4317">
                  <c:v>1002.52870597342</c:v>
                </c:pt>
                <c:pt idx="4318">
                  <c:v>1002.7609340730201</c:v>
                </c:pt>
                <c:pt idx="4319">
                  <c:v>1002.99316217262</c:v>
                </c:pt>
                <c:pt idx="4320">
                  <c:v>1003.22539027222</c:v>
                </c:pt>
                <c:pt idx="4321">
                  <c:v>1003.45761837182</c:v>
                </c:pt>
                <c:pt idx="4322">
                  <c:v>1003.68984647142</c:v>
                </c:pt>
                <c:pt idx="4323">
                  <c:v>1003.9220745710199</c:v>
                </c:pt>
                <c:pt idx="4324">
                  <c:v>1004.15430267062</c:v>
                </c:pt>
                <c:pt idx="4325">
                  <c:v>1004.38653077022</c:v>
                </c:pt>
                <c:pt idx="4326">
                  <c:v>1004.61875886982</c:v>
                </c:pt>
                <c:pt idx="4327">
                  <c:v>1004.85098696942</c:v>
                </c:pt>
                <c:pt idx="4328">
                  <c:v>1005.08321506902</c:v>
                </c:pt>
                <c:pt idx="4329">
                  <c:v>1005.31544316862</c:v>
                </c:pt>
                <c:pt idx="4330">
                  <c:v>1005.54767126822</c:v>
                </c:pt>
                <c:pt idx="4331">
                  <c:v>1005.77989936782</c:v>
                </c:pt>
                <c:pt idx="4332">
                  <c:v>1006.01212746742</c:v>
                </c:pt>
                <c:pt idx="4333">
                  <c:v>1006.24435556702</c:v>
                </c:pt>
                <c:pt idx="4334">
                  <c:v>1006.4765836666199</c:v>
                </c:pt>
                <c:pt idx="4335">
                  <c:v>1006.70881176622</c:v>
                </c:pt>
                <c:pt idx="4336">
                  <c:v>1006.94103986582</c:v>
                </c:pt>
                <c:pt idx="4337">
                  <c:v>1007.17326796542</c:v>
                </c:pt>
                <c:pt idx="4338">
                  <c:v>1007.40549606502</c:v>
                </c:pt>
                <c:pt idx="4339">
                  <c:v>1007.63772416462</c:v>
                </c:pt>
                <c:pt idx="4340">
                  <c:v>1007.86995226422</c:v>
                </c:pt>
                <c:pt idx="4341">
                  <c:v>1008.10218036382</c:v>
                </c:pt>
                <c:pt idx="4342">
                  <c:v>1008.33440846342</c:v>
                </c:pt>
                <c:pt idx="4343">
                  <c:v>1008.56663656302</c:v>
                </c:pt>
                <c:pt idx="4344">
                  <c:v>1008.79886466262</c:v>
                </c:pt>
                <c:pt idx="4345">
                  <c:v>1009.0310927622201</c:v>
                </c:pt>
                <c:pt idx="4346">
                  <c:v>1009.26332086182</c:v>
                </c:pt>
                <c:pt idx="4347">
                  <c:v>1009.49554896142</c:v>
                </c:pt>
                <c:pt idx="4348">
                  <c:v>1009.72777706102</c:v>
                </c:pt>
                <c:pt idx="4349">
                  <c:v>1009.96000516062</c:v>
                </c:pt>
                <c:pt idx="4350">
                  <c:v>1010.19223326022</c:v>
                </c:pt>
                <c:pt idx="4351">
                  <c:v>1010.42446135982</c:v>
                </c:pt>
                <c:pt idx="4352">
                  <c:v>1010.65668945942</c:v>
                </c:pt>
                <c:pt idx="4353">
                  <c:v>1010.88891755902</c:v>
                </c:pt>
                <c:pt idx="4354">
                  <c:v>1011.12114565862</c:v>
                </c:pt>
                <c:pt idx="4355">
                  <c:v>1011.35337375822</c:v>
                </c:pt>
                <c:pt idx="4356">
                  <c:v>1011.5856018578201</c:v>
                </c:pt>
                <c:pt idx="4357">
                  <c:v>1011.81782995742</c:v>
                </c:pt>
                <c:pt idx="4358">
                  <c:v>1012.05005805702</c:v>
                </c:pt>
                <c:pt idx="4359">
                  <c:v>1012.28228615662</c:v>
                </c:pt>
                <c:pt idx="4360">
                  <c:v>1012.51451425623</c:v>
                </c:pt>
                <c:pt idx="4361">
                  <c:v>1012.74674235583</c:v>
                </c:pt>
                <c:pt idx="4362">
                  <c:v>1012.97897045543</c:v>
                </c:pt>
                <c:pt idx="4363">
                  <c:v>1013.21119855503</c:v>
                </c:pt>
                <c:pt idx="4364">
                  <c:v>1013.44342665463</c:v>
                </c:pt>
                <c:pt idx="4365">
                  <c:v>1013.67565475423</c:v>
                </c:pt>
                <c:pt idx="4366">
                  <c:v>1013.90788285383</c:v>
                </c:pt>
                <c:pt idx="4367">
                  <c:v>1014.1401109534301</c:v>
                </c:pt>
                <c:pt idx="4368">
                  <c:v>1014.37233905303</c:v>
                </c:pt>
                <c:pt idx="4369">
                  <c:v>1014.60456715263</c:v>
                </c:pt>
                <c:pt idx="4370">
                  <c:v>1014.83679525223</c:v>
                </c:pt>
                <c:pt idx="4371">
                  <c:v>1015.06902335183</c:v>
                </c:pt>
                <c:pt idx="4372">
                  <c:v>1015.3012514514299</c:v>
                </c:pt>
                <c:pt idx="4373">
                  <c:v>1015.53347955103</c:v>
                </c:pt>
                <c:pt idx="4374">
                  <c:v>1015.76570765063</c:v>
                </c:pt>
                <c:pt idx="4375">
                  <c:v>1015.99793575023</c:v>
                </c:pt>
                <c:pt idx="4376">
                  <c:v>1016.23016384983</c:v>
                </c:pt>
                <c:pt idx="4377">
                  <c:v>1016.46239194943</c:v>
                </c:pt>
                <c:pt idx="4378">
                  <c:v>1016.69462004903</c:v>
                </c:pt>
                <c:pt idx="4379">
                  <c:v>1016.92684814863</c:v>
                </c:pt>
                <c:pt idx="4380">
                  <c:v>1017.15907624823</c:v>
                </c:pt>
                <c:pt idx="4381">
                  <c:v>1017.39130434783</c:v>
                </c:pt>
                <c:pt idx="4382">
                  <c:v>1017.62353244743</c:v>
                </c:pt>
                <c:pt idx="4383">
                  <c:v>1017.8557605470299</c:v>
                </c:pt>
                <c:pt idx="4384">
                  <c:v>1018.08798864663</c:v>
                </c:pt>
                <c:pt idx="4385">
                  <c:v>1018.32021674623</c:v>
                </c:pt>
                <c:pt idx="4386">
                  <c:v>1018.55244484583</c:v>
                </c:pt>
                <c:pt idx="4387">
                  <c:v>1018.78467294543</c:v>
                </c:pt>
                <c:pt idx="4388">
                  <c:v>1019.01690104503</c:v>
                </c:pt>
                <c:pt idx="4389">
                  <c:v>1019.24912914463</c:v>
                </c:pt>
                <c:pt idx="4390">
                  <c:v>1019.48135724423</c:v>
                </c:pt>
                <c:pt idx="4391">
                  <c:v>1019.71358534383</c:v>
                </c:pt>
                <c:pt idx="4392">
                  <c:v>1019.94581344343</c:v>
                </c:pt>
                <c:pt idx="4393">
                  <c:v>1020.17804154303</c:v>
                </c:pt>
                <c:pt idx="4394">
                  <c:v>1020.4102696426301</c:v>
                </c:pt>
                <c:pt idx="4395">
                  <c:v>1020.64249774223</c:v>
                </c:pt>
                <c:pt idx="4396">
                  <c:v>1020.87472584183</c:v>
                </c:pt>
                <c:pt idx="4397">
                  <c:v>1021.10695394143</c:v>
                </c:pt>
                <c:pt idx="4398">
                  <c:v>1021.33918204103</c:v>
                </c:pt>
                <c:pt idx="4399">
                  <c:v>1021.57141014063</c:v>
                </c:pt>
                <c:pt idx="4400">
                  <c:v>1021.80363824023</c:v>
                </c:pt>
                <c:pt idx="4401">
                  <c:v>1022.03586633983</c:v>
                </c:pt>
                <c:pt idx="4402">
                  <c:v>1022.26809443943</c:v>
                </c:pt>
                <c:pt idx="4403">
                  <c:v>1022.50032253903</c:v>
                </c:pt>
                <c:pt idx="4404">
                  <c:v>1022.73255063863</c:v>
                </c:pt>
                <c:pt idx="4405">
                  <c:v>1022.9647787382301</c:v>
                </c:pt>
                <c:pt idx="4406">
                  <c:v>1023.19700683783</c:v>
                </c:pt>
                <c:pt idx="4407">
                  <c:v>1023.42923493743</c:v>
                </c:pt>
                <c:pt idx="4408">
                  <c:v>1023.66146303703</c:v>
                </c:pt>
                <c:pt idx="4409">
                  <c:v>1023.89369113663</c:v>
                </c:pt>
                <c:pt idx="4410">
                  <c:v>1024.1259192362299</c:v>
                </c:pt>
                <c:pt idx="4411">
                  <c:v>1024.3581473358299</c:v>
                </c:pt>
                <c:pt idx="4412">
                  <c:v>1024.5903754354299</c:v>
                </c:pt>
                <c:pt idx="4413">
                  <c:v>1024.8226035350301</c:v>
                </c:pt>
                <c:pt idx="4414">
                  <c:v>1025.0548316346301</c:v>
                </c:pt>
                <c:pt idx="4415">
                  <c:v>1025.2870597342301</c:v>
                </c:pt>
                <c:pt idx="4416">
                  <c:v>1025.51928783383</c:v>
                </c:pt>
                <c:pt idx="4417">
                  <c:v>1025.75151593343</c:v>
                </c:pt>
                <c:pt idx="4418">
                  <c:v>1025.98374403303</c:v>
                </c:pt>
                <c:pt idx="4419">
                  <c:v>1026.21597213263</c:v>
                </c:pt>
                <c:pt idx="4420">
                  <c:v>1026.44820023223</c:v>
                </c:pt>
                <c:pt idx="4421">
                  <c:v>1026.6804283318299</c:v>
                </c:pt>
                <c:pt idx="4422">
                  <c:v>1026.9126564314299</c:v>
                </c:pt>
                <c:pt idx="4423">
                  <c:v>1027.1448845310299</c:v>
                </c:pt>
                <c:pt idx="4424">
                  <c:v>1027.3771126306301</c:v>
                </c:pt>
                <c:pt idx="4425">
                  <c:v>1027.6093407302301</c:v>
                </c:pt>
                <c:pt idx="4426">
                  <c:v>1027.8415688298301</c:v>
                </c:pt>
                <c:pt idx="4427">
                  <c:v>1028.07379692943</c:v>
                </c:pt>
                <c:pt idx="4428">
                  <c:v>1028.30602502903</c:v>
                </c:pt>
                <c:pt idx="4429">
                  <c:v>1028.53825312863</c:v>
                </c:pt>
                <c:pt idx="4430">
                  <c:v>1028.77048122823</c:v>
                </c:pt>
                <c:pt idx="4431">
                  <c:v>1029.00270932783</c:v>
                </c:pt>
                <c:pt idx="4432">
                  <c:v>1029.2349374274299</c:v>
                </c:pt>
                <c:pt idx="4433">
                  <c:v>1029.4671655270299</c:v>
                </c:pt>
                <c:pt idx="4434">
                  <c:v>1029.6993936266299</c:v>
                </c:pt>
                <c:pt idx="4435">
                  <c:v>1029.9316217262301</c:v>
                </c:pt>
                <c:pt idx="4436">
                  <c:v>1030.1638498258301</c:v>
                </c:pt>
                <c:pt idx="4437">
                  <c:v>1030.3960779254301</c:v>
                </c:pt>
                <c:pt idx="4438">
                  <c:v>1030.62830602503</c:v>
                </c:pt>
                <c:pt idx="4439">
                  <c:v>1030.86053412463</c:v>
                </c:pt>
                <c:pt idx="4440">
                  <c:v>1031.09276222423</c:v>
                </c:pt>
                <c:pt idx="4441">
                  <c:v>1031.32499032383</c:v>
                </c:pt>
                <c:pt idx="4442">
                  <c:v>1031.55721842343</c:v>
                </c:pt>
                <c:pt idx="4443">
                  <c:v>1031.7894465230299</c:v>
                </c:pt>
                <c:pt idx="4444">
                  <c:v>1032.0216746226299</c:v>
                </c:pt>
                <c:pt idx="4445">
                  <c:v>1032.2539027222299</c:v>
                </c:pt>
                <c:pt idx="4446">
                  <c:v>1032.4861308218301</c:v>
                </c:pt>
                <c:pt idx="4447">
                  <c:v>1032.7183589214301</c:v>
                </c:pt>
                <c:pt idx="4448">
                  <c:v>1032.9505870210301</c:v>
                </c:pt>
                <c:pt idx="4449">
                  <c:v>1033.18281512063</c:v>
                </c:pt>
                <c:pt idx="4450">
                  <c:v>1033.41504322023</c:v>
                </c:pt>
                <c:pt idx="4451">
                  <c:v>1033.64727131983</c:v>
                </c:pt>
                <c:pt idx="4452">
                  <c:v>1033.87949941943</c:v>
                </c:pt>
                <c:pt idx="4453">
                  <c:v>1034.11172751903</c:v>
                </c:pt>
                <c:pt idx="4454">
                  <c:v>1034.3439556186299</c:v>
                </c:pt>
                <c:pt idx="4455">
                  <c:v>1034.5761837182299</c:v>
                </c:pt>
                <c:pt idx="4456">
                  <c:v>1034.8084118178299</c:v>
                </c:pt>
                <c:pt idx="4457">
                  <c:v>1035.0406399174301</c:v>
                </c:pt>
                <c:pt idx="4458">
                  <c:v>1035.2728680170301</c:v>
                </c:pt>
                <c:pt idx="4459">
                  <c:v>1035.5050961166301</c:v>
                </c:pt>
                <c:pt idx="4460">
                  <c:v>1035.73732421623</c:v>
                </c:pt>
                <c:pt idx="4461">
                  <c:v>1035.96955231583</c:v>
                </c:pt>
                <c:pt idx="4462">
                  <c:v>1036.20178041543</c:v>
                </c:pt>
                <c:pt idx="4463">
                  <c:v>1036.43400851503</c:v>
                </c:pt>
                <c:pt idx="4464">
                  <c:v>1036.66623661463</c:v>
                </c:pt>
                <c:pt idx="4465">
                  <c:v>1036.8984647142299</c:v>
                </c:pt>
                <c:pt idx="4466">
                  <c:v>1037.1306928138299</c:v>
                </c:pt>
                <c:pt idx="4467">
                  <c:v>1037.3629209134299</c:v>
                </c:pt>
                <c:pt idx="4468">
                  <c:v>1037.5951490130301</c:v>
                </c:pt>
                <c:pt idx="4469">
                  <c:v>1037.8273771126301</c:v>
                </c:pt>
                <c:pt idx="4470">
                  <c:v>1038.0596052122301</c:v>
                </c:pt>
                <c:pt idx="4471">
                  <c:v>1038.29183331183</c:v>
                </c:pt>
                <c:pt idx="4472">
                  <c:v>1038.52406141143</c:v>
                </c:pt>
                <c:pt idx="4473">
                  <c:v>1038.75628951103</c:v>
                </c:pt>
                <c:pt idx="4474">
                  <c:v>1038.98851761063</c:v>
                </c:pt>
                <c:pt idx="4475">
                  <c:v>1039.2207457102299</c:v>
                </c:pt>
                <c:pt idx="4476">
                  <c:v>1039.4529738098299</c:v>
                </c:pt>
                <c:pt idx="4477">
                  <c:v>1039.6852019094299</c:v>
                </c:pt>
                <c:pt idx="4478">
                  <c:v>1039.9174300090301</c:v>
                </c:pt>
                <c:pt idx="4479">
                  <c:v>1040.1496581086301</c:v>
                </c:pt>
                <c:pt idx="4480">
                  <c:v>1040.3818862082301</c:v>
                </c:pt>
                <c:pt idx="4481">
                  <c:v>1040.6141143078301</c:v>
                </c:pt>
                <c:pt idx="4482">
                  <c:v>1040.84634240743</c:v>
                </c:pt>
                <c:pt idx="4483">
                  <c:v>1041.07857050703</c:v>
                </c:pt>
                <c:pt idx="4484">
                  <c:v>1041.31079860663</c:v>
                </c:pt>
                <c:pt idx="4485">
                  <c:v>1041.54302670623</c:v>
                </c:pt>
                <c:pt idx="4486">
                  <c:v>1041.7752548058299</c:v>
                </c:pt>
                <c:pt idx="4487">
                  <c:v>1042.0074829054299</c:v>
                </c:pt>
                <c:pt idx="4488">
                  <c:v>1042.2397110050299</c:v>
                </c:pt>
                <c:pt idx="4489">
                  <c:v>1042.4719391046301</c:v>
                </c:pt>
                <c:pt idx="4490">
                  <c:v>1042.7041672042301</c:v>
                </c:pt>
                <c:pt idx="4491">
                  <c:v>1042.9363953038301</c:v>
                </c:pt>
                <c:pt idx="4492">
                  <c:v>1043.16862340343</c:v>
                </c:pt>
                <c:pt idx="4493">
                  <c:v>1043.40085150303</c:v>
                </c:pt>
                <c:pt idx="4494">
                  <c:v>1043.63307960263</c:v>
                </c:pt>
                <c:pt idx="4495">
                  <c:v>1043.86530770223</c:v>
                </c:pt>
                <c:pt idx="4496">
                  <c:v>1044.09753580183</c:v>
                </c:pt>
                <c:pt idx="4497">
                  <c:v>1044.3297639014299</c:v>
                </c:pt>
                <c:pt idx="4498">
                  <c:v>1044.5619920010299</c:v>
                </c:pt>
                <c:pt idx="4499">
                  <c:v>1044.7942201006299</c:v>
                </c:pt>
                <c:pt idx="4500">
                  <c:v>1045.0264482002301</c:v>
                </c:pt>
                <c:pt idx="4501">
                  <c:v>1045.2586762998301</c:v>
                </c:pt>
                <c:pt idx="4502">
                  <c:v>1045.4909043994301</c:v>
                </c:pt>
                <c:pt idx="4503">
                  <c:v>1045.72313249903</c:v>
                </c:pt>
                <c:pt idx="4504">
                  <c:v>1045.95536059863</c:v>
                </c:pt>
                <c:pt idx="4505">
                  <c:v>1046.18758869823</c:v>
                </c:pt>
                <c:pt idx="4506">
                  <c:v>1046.41981679783</c:v>
                </c:pt>
                <c:pt idx="4507">
                  <c:v>1046.65204489743</c:v>
                </c:pt>
                <c:pt idx="4508">
                  <c:v>1046.8842729970299</c:v>
                </c:pt>
                <c:pt idx="4509">
                  <c:v>1047.1165010966299</c:v>
                </c:pt>
                <c:pt idx="4510">
                  <c:v>1047.3487291962299</c:v>
                </c:pt>
                <c:pt idx="4511">
                  <c:v>1047.5809572958301</c:v>
                </c:pt>
                <c:pt idx="4512">
                  <c:v>1047.8131853954301</c:v>
                </c:pt>
                <c:pt idx="4513">
                  <c:v>1048.0454134950301</c:v>
                </c:pt>
                <c:pt idx="4514">
                  <c:v>1048.27764159463</c:v>
                </c:pt>
                <c:pt idx="4515">
                  <c:v>1048.50986969423</c:v>
                </c:pt>
                <c:pt idx="4516">
                  <c:v>1048.74209779383</c:v>
                </c:pt>
                <c:pt idx="4517">
                  <c:v>1048.97432589343</c:v>
                </c:pt>
                <c:pt idx="4518">
                  <c:v>1049.20655399303</c:v>
                </c:pt>
                <c:pt idx="4519">
                  <c:v>1049.4387820926299</c:v>
                </c:pt>
                <c:pt idx="4520">
                  <c:v>1049.6710101922299</c:v>
                </c:pt>
                <c:pt idx="4521">
                  <c:v>1049.9032382918299</c:v>
                </c:pt>
                <c:pt idx="4522">
                  <c:v>1050.1354663914301</c:v>
                </c:pt>
                <c:pt idx="4523">
                  <c:v>1050.3676944910301</c:v>
                </c:pt>
                <c:pt idx="4524">
                  <c:v>1050.5999225906301</c:v>
                </c:pt>
                <c:pt idx="4525">
                  <c:v>1050.83215069023</c:v>
                </c:pt>
                <c:pt idx="4526">
                  <c:v>1051.06437878983</c:v>
                </c:pt>
                <c:pt idx="4527">
                  <c:v>1051.29660688943</c:v>
                </c:pt>
                <c:pt idx="4528">
                  <c:v>1051.52883498903</c:v>
                </c:pt>
                <c:pt idx="4529">
                  <c:v>1051.76106308863</c:v>
                </c:pt>
                <c:pt idx="4530">
                  <c:v>1051.9932911882299</c:v>
                </c:pt>
                <c:pt idx="4531">
                  <c:v>1052.2255192878299</c:v>
                </c:pt>
                <c:pt idx="4532">
                  <c:v>1052.4577473874299</c:v>
                </c:pt>
                <c:pt idx="4533">
                  <c:v>1052.6899754870301</c:v>
                </c:pt>
                <c:pt idx="4534">
                  <c:v>1052.9222035866301</c:v>
                </c:pt>
                <c:pt idx="4535">
                  <c:v>1053.1544316862301</c:v>
                </c:pt>
                <c:pt idx="4536">
                  <c:v>1053.38665978583</c:v>
                </c:pt>
                <c:pt idx="4537">
                  <c:v>1053.61888788543</c:v>
                </c:pt>
                <c:pt idx="4538">
                  <c:v>1053.85111598503</c:v>
                </c:pt>
                <c:pt idx="4539">
                  <c:v>1054.08334408463</c:v>
                </c:pt>
                <c:pt idx="4540">
                  <c:v>1054.3155721842299</c:v>
                </c:pt>
                <c:pt idx="4541">
                  <c:v>1054.5478002838299</c:v>
                </c:pt>
                <c:pt idx="4542">
                  <c:v>1054.7800283834299</c:v>
                </c:pt>
                <c:pt idx="4543">
                  <c:v>1055.0122564830299</c:v>
                </c:pt>
                <c:pt idx="4544">
                  <c:v>1055.2444845826301</c:v>
                </c:pt>
                <c:pt idx="4545">
                  <c:v>1055.4767126822301</c:v>
                </c:pt>
                <c:pt idx="4546">
                  <c:v>1055.7089407818301</c:v>
                </c:pt>
                <c:pt idx="4547">
                  <c:v>1055.94116888143</c:v>
                </c:pt>
                <c:pt idx="4548">
                  <c:v>1056.17339698103</c:v>
                </c:pt>
                <c:pt idx="4549">
                  <c:v>1056.40562508063</c:v>
                </c:pt>
                <c:pt idx="4550">
                  <c:v>1056.63785318023</c:v>
                </c:pt>
                <c:pt idx="4551">
                  <c:v>1056.8700812798299</c:v>
                </c:pt>
                <c:pt idx="4552">
                  <c:v>1057.1023093794299</c:v>
                </c:pt>
                <c:pt idx="4553">
                  <c:v>1057.3345374790299</c:v>
                </c:pt>
                <c:pt idx="4554">
                  <c:v>1057.5667655786399</c:v>
                </c:pt>
                <c:pt idx="4555">
                  <c:v>1057.7989936782401</c:v>
                </c:pt>
                <c:pt idx="4556">
                  <c:v>1058.0312217778401</c:v>
                </c:pt>
                <c:pt idx="4557">
                  <c:v>1058.2634498774401</c:v>
                </c:pt>
                <c:pt idx="4558">
                  <c:v>1058.49567797704</c:v>
                </c:pt>
                <c:pt idx="4559">
                  <c:v>1058.72790607664</c:v>
                </c:pt>
                <c:pt idx="4560">
                  <c:v>1058.96013417624</c:v>
                </c:pt>
                <c:pt idx="4561">
                  <c:v>1059.19236227584</c:v>
                </c:pt>
                <c:pt idx="4562">
                  <c:v>1059.4245903754399</c:v>
                </c:pt>
                <c:pt idx="4563">
                  <c:v>1059.6568184750399</c:v>
                </c:pt>
                <c:pt idx="4564">
                  <c:v>1059.8890465746399</c:v>
                </c:pt>
                <c:pt idx="4565">
                  <c:v>1060.1212746742401</c:v>
                </c:pt>
                <c:pt idx="4566">
                  <c:v>1060.3535027738401</c:v>
                </c:pt>
                <c:pt idx="4567">
                  <c:v>1060.5857308734401</c:v>
                </c:pt>
                <c:pt idx="4568">
                  <c:v>1060.81795897304</c:v>
                </c:pt>
                <c:pt idx="4569">
                  <c:v>1061.05018707264</c:v>
                </c:pt>
                <c:pt idx="4570">
                  <c:v>1061.28241517224</c:v>
                </c:pt>
                <c:pt idx="4571">
                  <c:v>1061.51464327184</c:v>
                </c:pt>
                <c:pt idx="4572">
                  <c:v>1061.74687137144</c:v>
                </c:pt>
                <c:pt idx="4573">
                  <c:v>1061.9790994710399</c:v>
                </c:pt>
                <c:pt idx="4574">
                  <c:v>1062.2113275706399</c:v>
                </c:pt>
                <c:pt idx="4575">
                  <c:v>1062.4435556702399</c:v>
                </c:pt>
                <c:pt idx="4576">
                  <c:v>1062.6757837698401</c:v>
                </c:pt>
                <c:pt idx="4577">
                  <c:v>1062.9080118694401</c:v>
                </c:pt>
                <c:pt idx="4578">
                  <c:v>1063.1402399690401</c:v>
                </c:pt>
                <c:pt idx="4579">
                  <c:v>1063.37246806864</c:v>
                </c:pt>
                <c:pt idx="4580">
                  <c:v>1063.60469616824</c:v>
                </c:pt>
                <c:pt idx="4581">
                  <c:v>1063.83692426784</c:v>
                </c:pt>
                <c:pt idx="4582">
                  <c:v>1064.06915236744</c:v>
                </c:pt>
                <c:pt idx="4583">
                  <c:v>1064.30138046704</c:v>
                </c:pt>
                <c:pt idx="4584">
                  <c:v>1064.5336085666399</c:v>
                </c:pt>
                <c:pt idx="4585">
                  <c:v>1064.7658366662399</c:v>
                </c:pt>
                <c:pt idx="4586">
                  <c:v>1064.9980647658399</c:v>
                </c:pt>
                <c:pt idx="4587">
                  <c:v>1065.2302928654401</c:v>
                </c:pt>
                <c:pt idx="4588">
                  <c:v>1065.4625209650401</c:v>
                </c:pt>
                <c:pt idx="4589">
                  <c:v>1065.6947490646401</c:v>
                </c:pt>
                <c:pt idx="4590">
                  <c:v>1065.92697716424</c:v>
                </c:pt>
                <c:pt idx="4591">
                  <c:v>1066.15920526384</c:v>
                </c:pt>
                <c:pt idx="4592">
                  <c:v>1066.39143336344</c:v>
                </c:pt>
                <c:pt idx="4593">
                  <c:v>1066.62366146304</c:v>
                </c:pt>
                <c:pt idx="4594">
                  <c:v>1066.85588956264</c:v>
                </c:pt>
                <c:pt idx="4595">
                  <c:v>1067.0881176622399</c:v>
                </c:pt>
                <c:pt idx="4596">
                  <c:v>1067.3203457618399</c:v>
                </c:pt>
                <c:pt idx="4597">
                  <c:v>1067.5525738614399</c:v>
                </c:pt>
                <c:pt idx="4598">
                  <c:v>1067.7848019610401</c:v>
                </c:pt>
                <c:pt idx="4599">
                  <c:v>1068.0170300606401</c:v>
                </c:pt>
                <c:pt idx="4600">
                  <c:v>1068.2492581602401</c:v>
                </c:pt>
                <c:pt idx="4601">
                  <c:v>1068.48148625984</c:v>
                </c:pt>
                <c:pt idx="4602">
                  <c:v>1068.71371435944</c:v>
                </c:pt>
                <c:pt idx="4603">
                  <c:v>1068.94594245904</c:v>
                </c:pt>
                <c:pt idx="4604">
                  <c:v>1069.17817055864</c:v>
                </c:pt>
                <c:pt idx="4605">
                  <c:v>1069.41039865824</c:v>
                </c:pt>
                <c:pt idx="4606">
                  <c:v>1069.6426267578399</c:v>
                </c:pt>
                <c:pt idx="4607">
                  <c:v>1069.8748548574399</c:v>
                </c:pt>
                <c:pt idx="4608">
                  <c:v>1070.1070829570399</c:v>
                </c:pt>
                <c:pt idx="4609">
                  <c:v>1070.3393110566401</c:v>
                </c:pt>
                <c:pt idx="4610">
                  <c:v>1070.5715391562401</c:v>
                </c:pt>
                <c:pt idx="4611">
                  <c:v>1070.8037672558401</c:v>
                </c:pt>
                <c:pt idx="4612">
                  <c:v>1071.03599535544</c:v>
                </c:pt>
                <c:pt idx="4613">
                  <c:v>1071.26822345504</c:v>
                </c:pt>
                <c:pt idx="4614">
                  <c:v>1071.50045155464</c:v>
                </c:pt>
                <c:pt idx="4615">
                  <c:v>1071.73267965424</c:v>
                </c:pt>
                <c:pt idx="4616">
                  <c:v>1071.96490775384</c:v>
                </c:pt>
                <c:pt idx="4617">
                  <c:v>1072.1971358534399</c:v>
                </c:pt>
                <c:pt idx="4618">
                  <c:v>1072.4293639530399</c:v>
                </c:pt>
                <c:pt idx="4619">
                  <c:v>1072.6615920526399</c:v>
                </c:pt>
                <c:pt idx="4620">
                  <c:v>1072.8938201522401</c:v>
                </c:pt>
                <c:pt idx="4621">
                  <c:v>1073.1260482518401</c:v>
                </c:pt>
                <c:pt idx="4622">
                  <c:v>1073.3582763514401</c:v>
                </c:pt>
                <c:pt idx="4623">
                  <c:v>1073.59050445104</c:v>
                </c:pt>
                <c:pt idx="4624">
                  <c:v>1073.82273255064</c:v>
                </c:pt>
                <c:pt idx="4625">
                  <c:v>1074.05496065024</c:v>
                </c:pt>
                <c:pt idx="4626">
                  <c:v>1074.28718874984</c:v>
                </c:pt>
                <c:pt idx="4627">
                  <c:v>1074.5194168494399</c:v>
                </c:pt>
                <c:pt idx="4628">
                  <c:v>1074.7516449490399</c:v>
                </c:pt>
                <c:pt idx="4629">
                  <c:v>1074.9838730486399</c:v>
                </c:pt>
                <c:pt idx="4630">
                  <c:v>1075.2161011482401</c:v>
                </c:pt>
                <c:pt idx="4631">
                  <c:v>1075.4483292478401</c:v>
                </c:pt>
                <c:pt idx="4632">
                  <c:v>1075.6805573474401</c:v>
                </c:pt>
                <c:pt idx="4633">
                  <c:v>1075.9127854470401</c:v>
                </c:pt>
                <c:pt idx="4634">
                  <c:v>1076.14501354664</c:v>
                </c:pt>
                <c:pt idx="4635">
                  <c:v>1076.37724164624</c:v>
                </c:pt>
                <c:pt idx="4636">
                  <c:v>1076.60946974584</c:v>
                </c:pt>
                <c:pt idx="4637">
                  <c:v>1076.84169784544</c:v>
                </c:pt>
                <c:pt idx="4638">
                  <c:v>1077.0739259450399</c:v>
                </c:pt>
                <c:pt idx="4639">
                  <c:v>1077.3061540446399</c:v>
                </c:pt>
                <c:pt idx="4640">
                  <c:v>1077.5383821442399</c:v>
                </c:pt>
                <c:pt idx="4641">
                  <c:v>1077.7706102438401</c:v>
                </c:pt>
                <c:pt idx="4642">
                  <c:v>1078.0028383434401</c:v>
                </c:pt>
                <c:pt idx="4643">
                  <c:v>1078.2350664430401</c:v>
                </c:pt>
                <c:pt idx="4644">
                  <c:v>1078.46729454264</c:v>
                </c:pt>
                <c:pt idx="4645">
                  <c:v>1078.69952264224</c:v>
                </c:pt>
                <c:pt idx="4646">
                  <c:v>1078.93175074184</c:v>
                </c:pt>
                <c:pt idx="4647">
                  <c:v>1079.16397884144</c:v>
                </c:pt>
                <c:pt idx="4648">
                  <c:v>1079.39620694104</c:v>
                </c:pt>
                <c:pt idx="4649">
                  <c:v>1079.6284350406399</c:v>
                </c:pt>
                <c:pt idx="4650">
                  <c:v>1079.8606631402399</c:v>
                </c:pt>
                <c:pt idx="4651">
                  <c:v>1080.0928912398399</c:v>
                </c:pt>
                <c:pt idx="4652">
                  <c:v>1080.3251193394401</c:v>
                </c:pt>
                <c:pt idx="4653">
                  <c:v>1080.5573474390401</c:v>
                </c:pt>
                <c:pt idx="4654">
                  <c:v>1080.7895755386401</c:v>
                </c:pt>
                <c:pt idx="4655">
                  <c:v>1081.02180363824</c:v>
                </c:pt>
                <c:pt idx="4656">
                  <c:v>1081.25403173784</c:v>
                </c:pt>
                <c:pt idx="4657">
                  <c:v>1081.48625983744</c:v>
                </c:pt>
                <c:pt idx="4658">
                  <c:v>1081.71848793704</c:v>
                </c:pt>
                <c:pt idx="4659">
                  <c:v>1081.95071603664</c:v>
                </c:pt>
                <c:pt idx="4660">
                  <c:v>1082.1829441362399</c:v>
                </c:pt>
                <c:pt idx="4661">
                  <c:v>1082.4151722358399</c:v>
                </c:pt>
                <c:pt idx="4662">
                  <c:v>1082.6474003354399</c:v>
                </c:pt>
                <c:pt idx="4663">
                  <c:v>1082.8796284350401</c:v>
                </c:pt>
                <c:pt idx="4664">
                  <c:v>1083.1118565346401</c:v>
                </c:pt>
                <c:pt idx="4665">
                  <c:v>1083.3440846342401</c:v>
                </c:pt>
                <c:pt idx="4666">
                  <c:v>1083.57631273384</c:v>
                </c:pt>
                <c:pt idx="4667">
                  <c:v>1083.80854083344</c:v>
                </c:pt>
                <c:pt idx="4668">
                  <c:v>1084.04076893304</c:v>
                </c:pt>
                <c:pt idx="4669">
                  <c:v>1084.27299703264</c:v>
                </c:pt>
                <c:pt idx="4670">
                  <c:v>1084.50522513224</c:v>
                </c:pt>
                <c:pt idx="4671">
                  <c:v>1084.7374532318399</c:v>
                </c:pt>
                <c:pt idx="4672">
                  <c:v>1084.9696813314399</c:v>
                </c:pt>
                <c:pt idx="4673">
                  <c:v>1085.2019094310399</c:v>
                </c:pt>
                <c:pt idx="4674">
                  <c:v>1085.4341375306401</c:v>
                </c:pt>
                <c:pt idx="4675">
                  <c:v>1085.6663656302401</c:v>
                </c:pt>
                <c:pt idx="4676">
                  <c:v>1085.8985937298401</c:v>
                </c:pt>
                <c:pt idx="4677">
                  <c:v>1086.13082182944</c:v>
                </c:pt>
                <c:pt idx="4678">
                  <c:v>1086.36304992904</c:v>
                </c:pt>
                <c:pt idx="4679">
                  <c:v>1086.59527802864</c:v>
                </c:pt>
                <c:pt idx="4680">
                  <c:v>1086.82750612824</c:v>
                </c:pt>
                <c:pt idx="4681">
                  <c:v>1087.05973422784</c:v>
                </c:pt>
                <c:pt idx="4682">
                  <c:v>1087.2919623274399</c:v>
                </c:pt>
                <c:pt idx="4683">
                  <c:v>1087.5241904270399</c:v>
                </c:pt>
                <c:pt idx="4684">
                  <c:v>1087.7564185266399</c:v>
                </c:pt>
                <c:pt idx="4685">
                  <c:v>1087.9886466262401</c:v>
                </c:pt>
                <c:pt idx="4686">
                  <c:v>1088.2208747258401</c:v>
                </c:pt>
                <c:pt idx="4687">
                  <c:v>1088.4531028254401</c:v>
                </c:pt>
                <c:pt idx="4688">
                  <c:v>1088.68533092504</c:v>
                </c:pt>
                <c:pt idx="4689">
                  <c:v>1088.91755902464</c:v>
                </c:pt>
                <c:pt idx="4690">
                  <c:v>1089.14978712424</c:v>
                </c:pt>
                <c:pt idx="4691">
                  <c:v>1089.38201522384</c:v>
                </c:pt>
                <c:pt idx="4692">
                  <c:v>1089.61424332344</c:v>
                </c:pt>
                <c:pt idx="4693">
                  <c:v>1089.8464714230399</c:v>
                </c:pt>
                <c:pt idx="4694">
                  <c:v>1090.0786995226399</c:v>
                </c:pt>
                <c:pt idx="4695">
                  <c:v>1090.3109276222399</c:v>
                </c:pt>
                <c:pt idx="4696">
                  <c:v>1090.5431557218401</c:v>
                </c:pt>
                <c:pt idx="4697">
                  <c:v>1090.7753838214401</c:v>
                </c:pt>
                <c:pt idx="4698">
                  <c:v>1091.0076119210401</c:v>
                </c:pt>
                <c:pt idx="4699">
                  <c:v>1091.23984002064</c:v>
                </c:pt>
                <c:pt idx="4700">
                  <c:v>1091.47206812024</c:v>
                </c:pt>
                <c:pt idx="4701">
                  <c:v>1091.70429621984</c:v>
                </c:pt>
                <c:pt idx="4702">
                  <c:v>1091.93652431944</c:v>
                </c:pt>
                <c:pt idx="4703">
                  <c:v>1092.1687524190399</c:v>
                </c:pt>
                <c:pt idx="4704">
                  <c:v>1092.4009805186399</c:v>
                </c:pt>
                <c:pt idx="4705">
                  <c:v>1092.6332086182399</c:v>
                </c:pt>
                <c:pt idx="4706">
                  <c:v>1092.8654367178401</c:v>
                </c:pt>
                <c:pt idx="4707">
                  <c:v>1093.0976648174401</c:v>
                </c:pt>
                <c:pt idx="4708">
                  <c:v>1093.3298929170401</c:v>
                </c:pt>
                <c:pt idx="4709">
                  <c:v>1093.56212101664</c:v>
                </c:pt>
                <c:pt idx="4710">
                  <c:v>1093.79434911624</c:v>
                </c:pt>
                <c:pt idx="4711">
                  <c:v>1094.02657721584</c:v>
                </c:pt>
                <c:pt idx="4712">
                  <c:v>1094.25880531544</c:v>
                </c:pt>
                <c:pt idx="4713">
                  <c:v>1094.49103341504</c:v>
                </c:pt>
                <c:pt idx="4714">
                  <c:v>1094.7232615146399</c:v>
                </c:pt>
                <c:pt idx="4715">
                  <c:v>1094.9554896142399</c:v>
                </c:pt>
                <c:pt idx="4716">
                  <c:v>1095.1877177138399</c:v>
                </c:pt>
                <c:pt idx="4717">
                  <c:v>1095.4199458134401</c:v>
                </c:pt>
                <c:pt idx="4718">
                  <c:v>1095.6521739130401</c:v>
                </c:pt>
                <c:pt idx="4719">
                  <c:v>1095.8844020126401</c:v>
                </c:pt>
                <c:pt idx="4720">
                  <c:v>1096.11663011224</c:v>
                </c:pt>
                <c:pt idx="4721">
                  <c:v>1096.34885821184</c:v>
                </c:pt>
                <c:pt idx="4722">
                  <c:v>1096.58108631144</c:v>
                </c:pt>
                <c:pt idx="4723">
                  <c:v>1096.81331441104</c:v>
                </c:pt>
                <c:pt idx="4724">
                  <c:v>1097.04554251064</c:v>
                </c:pt>
                <c:pt idx="4725">
                  <c:v>1097.2777706102399</c:v>
                </c:pt>
                <c:pt idx="4726">
                  <c:v>1097.5099987098399</c:v>
                </c:pt>
                <c:pt idx="4727">
                  <c:v>1097.7422268094399</c:v>
                </c:pt>
                <c:pt idx="4728">
                  <c:v>1097.9744549090401</c:v>
                </c:pt>
                <c:pt idx="4729">
                  <c:v>1098.2066830086401</c:v>
                </c:pt>
                <c:pt idx="4730">
                  <c:v>1098.4389111082401</c:v>
                </c:pt>
                <c:pt idx="4731">
                  <c:v>1098.67113920784</c:v>
                </c:pt>
                <c:pt idx="4732">
                  <c:v>1098.90336730744</c:v>
                </c:pt>
                <c:pt idx="4733">
                  <c:v>1099.13559540704</c:v>
                </c:pt>
                <c:pt idx="4734">
                  <c:v>1099.36782350664</c:v>
                </c:pt>
                <c:pt idx="4735">
                  <c:v>1099.60005160624</c:v>
                </c:pt>
                <c:pt idx="4736">
                  <c:v>1099.8322797058399</c:v>
                </c:pt>
                <c:pt idx="4737">
                  <c:v>1100.0645078054399</c:v>
                </c:pt>
                <c:pt idx="4738">
                  <c:v>1100.2967359050399</c:v>
                </c:pt>
                <c:pt idx="4739">
                  <c:v>1100.5289640046401</c:v>
                </c:pt>
                <c:pt idx="4740">
                  <c:v>1100.7611921042401</c:v>
                </c:pt>
                <c:pt idx="4741">
                  <c:v>1100.9934202038401</c:v>
                </c:pt>
                <c:pt idx="4742">
                  <c:v>1101.22564830344</c:v>
                </c:pt>
                <c:pt idx="4743">
                  <c:v>1101.45787640304</c:v>
                </c:pt>
                <c:pt idx="4744">
                  <c:v>1101.69010450264</c:v>
                </c:pt>
                <c:pt idx="4745">
                  <c:v>1101.92233260224</c:v>
                </c:pt>
                <c:pt idx="4746">
                  <c:v>1102.15456070184</c:v>
                </c:pt>
                <c:pt idx="4747">
                  <c:v>1102.3867888014399</c:v>
                </c:pt>
                <c:pt idx="4748">
                  <c:v>1102.6190169010499</c:v>
                </c:pt>
                <c:pt idx="4749">
                  <c:v>1102.8512450006499</c:v>
                </c:pt>
                <c:pt idx="4750">
                  <c:v>1103.0834731002501</c:v>
                </c:pt>
                <c:pt idx="4751">
                  <c:v>1103.3157011998501</c:v>
                </c:pt>
                <c:pt idx="4752">
                  <c:v>1103.5479292994501</c:v>
                </c:pt>
                <c:pt idx="4753">
                  <c:v>1103.78015739905</c:v>
                </c:pt>
                <c:pt idx="4754">
                  <c:v>1104.01238549865</c:v>
                </c:pt>
                <c:pt idx="4755">
                  <c:v>1104.24461359825</c:v>
                </c:pt>
                <c:pt idx="4756">
                  <c:v>1104.47684169785</c:v>
                </c:pt>
                <c:pt idx="4757">
                  <c:v>1104.70906979745</c:v>
                </c:pt>
                <c:pt idx="4758">
                  <c:v>1104.9412978970499</c:v>
                </c:pt>
                <c:pt idx="4759">
                  <c:v>1105.1735259966499</c:v>
                </c:pt>
                <c:pt idx="4760">
                  <c:v>1105.4057540962499</c:v>
                </c:pt>
                <c:pt idx="4761">
                  <c:v>1105.6379821958501</c:v>
                </c:pt>
                <c:pt idx="4762">
                  <c:v>1105.8702102954501</c:v>
                </c:pt>
                <c:pt idx="4763">
                  <c:v>1106.1024383950501</c:v>
                </c:pt>
                <c:pt idx="4764">
                  <c:v>1106.33466649465</c:v>
                </c:pt>
                <c:pt idx="4765">
                  <c:v>1106.56689459425</c:v>
                </c:pt>
                <c:pt idx="4766">
                  <c:v>1106.79912269385</c:v>
                </c:pt>
                <c:pt idx="4767">
                  <c:v>1107.03135079345</c:v>
                </c:pt>
                <c:pt idx="4768">
                  <c:v>1107.26357889305</c:v>
                </c:pt>
                <c:pt idx="4769">
                  <c:v>1107.4958069926499</c:v>
                </c:pt>
                <c:pt idx="4770">
                  <c:v>1107.7280350922499</c:v>
                </c:pt>
                <c:pt idx="4771">
                  <c:v>1107.9602631918499</c:v>
                </c:pt>
                <c:pt idx="4772">
                  <c:v>1108.1924912914501</c:v>
                </c:pt>
                <c:pt idx="4773">
                  <c:v>1108.4247193910501</c:v>
                </c:pt>
                <c:pt idx="4774">
                  <c:v>1108.6569474906501</c:v>
                </c:pt>
                <c:pt idx="4775">
                  <c:v>1108.88917559025</c:v>
                </c:pt>
                <c:pt idx="4776">
                  <c:v>1109.12140368985</c:v>
                </c:pt>
                <c:pt idx="4777">
                  <c:v>1109.35363178945</c:v>
                </c:pt>
                <c:pt idx="4778">
                  <c:v>1109.58585988905</c:v>
                </c:pt>
                <c:pt idx="4779">
                  <c:v>1109.8180879886499</c:v>
                </c:pt>
                <c:pt idx="4780">
                  <c:v>1110.0503160882499</c:v>
                </c:pt>
                <c:pt idx="4781">
                  <c:v>1110.2825441878499</c:v>
                </c:pt>
                <c:pt idx="4782">
                  <c:v>1110.5147722874499</c:v>
                </c:pt>
                <c:pt idx="4783">
                  <c:v>1110.7470003870501</c:v>
                </c:pt>
                <c:pt idx="4784">
                  <c:v>1110.9792284866501</c:v>
                </c:pt>
                <c:pt idx="4785">
                  <c:v>1111.2114565862501</c:v>
                </c:pt>
                <c:pt idx="4786">
                  <c:v>1111.44368468585</c:v>
                </c:pt>
                <c:pt idx="4787">
                  <c:v>1111.67591278545</c:v>
                </c:pt>
                <c:pt idx="4788">
                  <c:v>1111.90814088505</c:v>
                </c:pt>
                <c:pt idx="4789">
                  <c:v>1112.14036898465</c:v>
                </c:pt>
                <c:pt idx="4790">
                  <c:v>1112.3725970842499</c:v>
                </c:pt>
                <c:pt idx="4791">
                  <c:v>1112.6048251838499</c:v>
                </c:pt>
                <c:pt idx="4792">
                  <c:v>1112.8370532834499</c:v>
                </c:pt>
                <c:pt idx="4793">
                  <c:v>1113.0692813830501</c:v>
                </c:pt>
                <c:pt idx="4794">
                  <c:v>1113.3015094826501</c:v>
                </c:pt>
                <c:pt idx="4795">
                  <c:v>1113.5337375822501</c:v>
                </c:pt>
                <c:pt idx="4796">
                  <c:v>1113.76596568185</c:v>
                </c:pt>
                <c:pt idx="4797">
                  <c:v>1113.99819378145</c:v>
                </c:pt>
                <c:pt idx="4798">
                  <c:v>1114.23042188105</c:v>
                </c:pt>
                <c:pt idx="4799">
                  <c:v>1114.46264998065</c:v>
                </c:pt>
                <c:pt idx="4800">
                  <c:v>1114.69487808025</c:v>
                </c:pt>
                <c:pt idx="4801">
                  <c:v>1114.9271061798499</c:v>
                </c:pt>
                <c:pt idx="4802">
                  <c:v>1115.1593342794499</c:v>
                </c:pt>
                <c:pt idx="4803">
                  <c:v>1115.3915623790499</c:v>
                </c:pt>
                <c:pt idx="4804">
                  <c:v>1115.6237904786501</c:v>
                </c:pt>
                <c:pt idx="4805">
                  <c:v>1115.8560185782501</c:v>
                </c:pt>
                <c:pt idx="4806">
                  <c:v>1116.0882466778501</c:v>
                </c:pt>
                <c:pt idx="4807">
                  <c:v>1116.32047477745</c:v>
                </c:pt>
                <c:pt idx="4808">
                  <c:v>1116.55270287705</c:v>
                </c:pt>
                <c:pt idx="4809">
                  <c:v>1116.78493097665</c:v>
                </c:pt>
                <c:pt idx="4810">
                  <c:v>1117.01715907625</c:v>
                </c:pt>
                <c:pt idx="4811">
                  <c:v>1117.24938717585</c:v>
                </c:pt>
                <c:pt idx="4812">
                  <c:v>1117.4816152754499</c:v>
                </c:pt>
                <c:pt idx="4813">
                  <c:v>1117.7138433750499</c:v>
                </c:pt>
                <c:pt idx="4814">
                  <c:v>1117.9460714746499</c:v>
                </c:pt>
                <c:pt idx="4815">
                  <c:v>1118.1782995742501</c:v>
                </c:pt>
                <c:pt idx="4816">
                  <c:v>1118.4105276738501</c:v>
                </c:pt>
                <c:pt idx="4817">
                  <c:v>1118.6427557734501</c:v>
                </c:pt>
                <c:pt idx="4818">
                  <c:v>1118.87498387305</c:v>
                </c:pt>
                <c:pt idx="4819">
                  <c:v>1119.10721197265</c:v>
                </c:pt>
                <c:pt idx="4820">
                  <c:v>1119.33944007225</c:v>
                </c:pt>
                <c:pt idx="4821">
                  <c:v>1119.57166817185</c:v>
                </c:pt>
                <c:pt idx="4822">
                  <c:v>1119.80389627145</c:v>
                </c:pt>
                <c:pt idx="4823">
                  <c:v>1120.0361243710499</c:v>
                </c:pt>
                <c:pt idx="4824">
                  <c:v>1120.2683524706499</c:v>
                </c:pt>
                <c:pt idx="4825">
                  <c:v>1120.5005805702499</c:v>
                </c:pt>
                <c:pt idx="4826">
                  <c:v>1120.7328086698501</c:v>
                </c:pt>
                <c:pt idx="4827">
                  <c:v>1120.9650367694501</c:v>
                </c:pt>
                <c:pt idx="4828">
                  <c:v>1121.1972648690501</c:v>
                </c:pt>
                <c:pt idx="4829">
                  <c:v>1121.42949296865</c:v>
                </c:pt>
                <c:pt idx="4830">
                  <c:v>1121.66172106825</c:v>
                </c:pt>
                <c:pt idx="4831">
                  <c:v>1121.89394916785</c:v>
                </c:pt>
                <c:pt idx="4832">
                  <c:v>1122.12617726745</c:v>
                </c:pt>
                <c:pt idx="4833">
                  <c:v>1122.35840536705</c:v>
                </c:pt>
                <c:pt idx="4834">
                  <c:v>1122.5906334666499</c:v>
                </c:pt>
                <c:pt idx="4835">
                  <c:v>1122.8228615662499</c:v>
                </c:pt>
                <c:pt idx="4836">
                  <c:v>1123.0550896658499</c:v>
                </c:pt>
                <c:pt idx="4837">
                  <c:v>1123.2873177654501</c:v>
                </c:pt>
                <c:pt idx="4838">
                  <c:v>1123.5195458650501</c:v>
                </c:pt>
                <c:pt idx="4839">
                  <c:v>1123.7517739646501</c:v>
                </c:pt>
                <c:pt idx="4840">
                  <c:v>1123.98400206425</c:v>
                </c:pt>
                <c:pt idx="4841">
                  <c:v>1124.21623016385</c:v>
                </c:pt>
                <c:pt idx="4842">
                  <c:v>1124.44845826345</c:v>
                </c:pt>
                <c:pt idx="4843">
                  <c:v>1124.68068636305</c:v>
                </c:pt>
                <c:pt idx="4844">
                  <c:v>1124.91291446265</c:v>
                </c:pt>
                <c:pt idx="4845">
                  <c:v>1125.1451425622499</c:v>
                </c:pt>
                <c:pt idx="4846">
                  <c:v>1125.3773706618499</c:v>
                </c:pt>
                <c:pt idx="4847">
                  <c:v>1125.6095987614499</c:v>
                </c:pt>
                <c:pt idx="4848">
                  <c:v>1125.8418268610501</c:v>
                </c:pt>
                <c:pt idx="4849">
                  <c:v>1126.0740549606501</c:v>
                </c:pt>
                <c:pt idx="4850">
                  <c:v>1126.3062830602501</c:v>
                </c:pt>
                <c:pt idx="4851">
                  <c:v>1126.53851115985</c:v>
                </c:pt>
                <c:pt idx="4852">
                  <c:v>1126.77073925945</c:v>
                </c:pt>
                <c:pt idx="4853">
                  <c:v>1127.00296735905</c:v>
                </c:pt>
                <c:pt idx="4854">
                  <c:v>1127.23519545865</c:v>
                </c:pt>
                <c:pt idx="4855">
                  <c:v>1127.4674235582499</c:v>
                </c:pt>
                <c:pt idx="4856">
                  <c:v>1127.6996516578499</c:v>
                </c:pt>
                <c:pt idx="4857">
                  <c:v>1127.9318797574499</c:v>
                </c:pt>
                <c:pt idx="4858">
                  <c:v>1128.1641078570501</c:v>
                </c:pt>
                <c:pt idx="4859">
                  <c:v>1128.3963359566501</c:v>
                </c:pt>
                <c:pt idx="4860">
                  <c:v>1128.6285640562501</c:v>
                </c:pt>
                <c:pt idx="4861">
                  <c:v>1128.86079215585</c:v>
                </c:pt>
                <c:pt idx="4862">
                  <c:v>1129.09302025545</c:v>
                </c:pt>
                <c:pt idx="4863">
                  <c:v>1129.32524835505</c:v>
                </c:pt>
                <c:pt idx="4864">
                  <c:v>1129.55747645465</c:v>
                </c:pt>
                <c:pt idx="4865">
                  <c:v>1129.78970455425</c:v>
                </c:pt>
                <c:pt idx="4866">
                  <c:v>1130.0219326538499</c:v>
                </c:pt>
                <c:pt idx="4867">
                  <c:v>1130.2541607534499</c:v>
                </c:pt>
                <c:pt idx="4868">
                  <c:v>1130.4863888530499</c:v>
                </c:pt>
                <c:pt idx="4869">
                  <c:v>1130.7186169526501</c:v>
                </c:pt>
                <c:pt idx="4870">
                  <c:v>1130.9508450522501</c:v>
                </c:pt>
                <c:pt idx="4871">
                  <c:v>1131.1830731518501</c:v>
                </c:pt>
                <c:pt idx="4872">
                  <c:v>1131.41530125145</c:v>
                </c:pt>
                <c:pt idx="4873">
                  <c:v>1131.64752935105</c:v>
                </c:pt>
                <c:pt idx="4874">
                  <c:v>1131.87975745065</c:v>
                </c:pt>
                <c:pt idx="4875">
                  <c:v>1132.11198555025</c:v>
                </c:pt>
                <c:pt idx="4876">
                  <c:v>1132.34421364985</c:v>
                </c:pt>
                <c:pt idx="4877">
                  <c:v>1132.5764417494499</c:v>
                </c:pt>
                <c:pt idx="4878">
                  <c:v>1132.8086698490499</c:v>
                </c:pt>
                <c:pt idx="4879">
                  <c:v>1133.0408979486499</c:v>
                </c:pt>
                <c:pt idx="4880">
                  <c:v>1133.2731260482501</c:v>
                </c:pt>
                <c:pt idx="4881">
                  <c:v>1133.5053541478501</c:v>
                </c:pt>
                <c:pt idx="4882">
                  <c:v>1133.7375822474501</c:v>
                </c:pt>
                <c:pt idx="4883">
                  <c:v>1133.96981034705</c:v>
                </c:pt>
                <c:pt idx="4884">
                  <c:v>1134.20203844665</c:v>
                </c:pt>
                <c:pt idx="4885">
                  <c:v>1134.43426654625</c:v>
                </c:pt>
                <c:pt idx="4886">
                  <c:v>1134.66649464585</c:v>
                </c:pt>
                <c:pt idx="4887">
                  <c:v>1134.89872274545</c:v>
                </c:pt>
                <c:pt idx="4888">
                  <c:v>1135.1309508450499</c:v>
                </c:pt>
                <c:pt idx="4889">
                  <c:v>1135.3631789446499</c:v>
                </c:pt>
                <c:pt idx="4890">
                  <c:v>1135.5954070442499</c:v>
                </c:pt>
                <c:pt idx="4891">
                  <c:v>1135.8276351438501</c:v>
                </c:pt>
                <c:pt idx="4892">
                  <c:v>1136.0598632434501</c:v>
                </c:pt>
                <c:pt idx="4893">
                  <c:v>1136.2920913430501</c:v>
                </c:pt>
                <c:pt idx="4894">
                  <c:v>1136.52431944265</c:v>
                </c:pt>
                <c:pt idx="4895">
                  <c:v>1136.75654754225</c:v>
                </c:pt>
                <c:pt idx="4896">
                  <c:v>1136.98877564185</c:v>
                </c:pt>
                <c:pt idx="4897">
                  <c:v>1137.22100374145</c:v>
                </c:pt>
                <c:pt idx="4898">
                  <c:v>1137.45323184105</c:v>
                </c:pt>
                <c:pt idx="4899">
                  <c:v>1137.6854599406499</c:v>
                </c:pt>
                <c:pt idx="4900">
                  <c:v>1137.9176880402499</c:v>
                </c:pt>
                <c:pt idx="4901">
                  <c:v>1138.1499161398499</c:v>
                </c:pt>
                <c:pt idx="4902">
                  <c:v>1138.3821442394501</c:v>
                </c:pt>
                <c:pt idx="4903">
                  <c:v>1138.6143723390501</c:v>
                </c:pt>
                <c:pt idx="4904">
                  <c:v>1138.8466004386501</c:v>
                </c:pt>
                <c:pt idx="4905">
                  <c:v>1139.07882853825</c:v>
                </c:pt>
                <c:pt idx="4906">
                  <c:v>1139.31105663785</c:v>
                </c:pt>
                <c:pt idx="4907">
                  <c:v>1139.54328473745</c:v>
                </c:pt>
                <c:pt idx="4908">
                  <c:v>1139.77551283705</c:v>
                </c:pt>
                <c:pt idx="4909">
                  <c:v>1140.00774093665</c:v>
                </c:pt>
                <c:pt idx="4910">
                  <c:v>1140.2399690362499</c:v>
                </c:pt>
                <c:pt idx="4911">
                  <c:v>1140.4721971358499</c:v>
                </c:pt>
                <c:pt idx="4912">
                  <c:v>1140.7044252354499</c:v>
                </c:pt>
                <c:pt idx="4913">
                  <c:v>1140.9366533350501</c:v>
                </c:pt>
                <c:pt idx="4914">
                  <c:v>1141.1688814346501</c:v>
                </c:pt>
                <c:pt idx="4915">
                  <c:v>1141.4011095342501</c:v>
                </c:pt>
                <c:pt idx="4916">
                  <c:v>1141.63333763385</c:v>
                </c:pt>
                <c:pt idx="4917">
                  <c:v>1141.86556573345</c:v>
                </c:pt>
                <c:pt idx="4918">
                  <c:v>1142.09779383305</c:v>
                </c:pt>
                <c:pt idx="4919">
                  <c:v>1142.33002193265</c:v>
                </c:pt>
                <c:pt idx="4920">
                  <c:v>1142.5622500322499</c:v>
                </c:pt>
                <c:pt idx="4921">
                  <c:v>1142.7944781318499</c:v>
                </c:pt>
                <c:pt idx="4922">
                  <c:v>1143.0267062314499</c:v>
                </c:pt>
                <c:pt idx="4923">
                  <c:v>1143.2589343310501</c:v>
                </c:pt>
                <c:pt idx="4924">
                  <c:v>1143.4911624306501</c:v>
                </c:pt>
                <c:pt idx="4925">
                  <c:v>1143.7233905302501</c:v>
                </c:pt>
                <c:pt idx="4926">
                  <c:v>1143.9556186298501</c:v>
                </c:pt>
                <c:pt idx="4927">
                  <c:v>1144.18784672945</c:v>
                </c:pt>
                <c:pt idx="4928">
                  <c:v>1144.42007482905</c:v>
                </c:pt>
                <c:pt idx="4929">
                  <c:v>1144.65230292865</c:v>
                </c:pt>
                <c:pt idx="4930">
                  <c:v>1144.88453102825</c:v>
                </c:pt>
                <c:pt idx="4931">
                  <c:v>1145.1167591278499</c:v>
                </c:pt>
                <c:pt idx="4932">
                  <c:v>1145.3489872274499</c:v>
                </c:pt>
                <c:pt idx="4933">
                  <c:v>1145.5812153270499</c:v>
                </c:pt>
                <c:pt idx="4934">
                  <c:v>1145.8134434266501</c:v>
                </c:pt>
                <c:pt idx="4935">
                  <c:v>1146.0456715262501</c:v>
                </c:pt>
                <c:pt idx="4936">
                  <c:v>1146.2778996258501</c:v>
                </c:pt>
                <c:pt idx="4937">
                  <c:v>1146.51012772545</c:v>
                </c:pt>
                <c:pt idx="4938">
                  <c:v>1146.74235582505</c:v>
                </c:pt>
                <c:pt idx="4939">
                  <c:v>1146.97458392466</c:v>
                </c:pt>
                <c:pt idx="4940">
                  <c:v>1147.20681202425</c:v>
                </c:pt>
                <c:pt idx="4941">
                  <c:v>1147.43904012385</c:v>
                </c:pt>
                <c:pt idx="4942">
                  <c:v>1147.6712682234599</c:v>
                </c:pt>
                <c:pt idx="4943">
                  <c:v>1147.9034963230599</c:v>
                </c:pt>
                <c:pt idx="4944">
                  <c:v>1148.1357244226599</c:v>
                </c:pt>
                <c:pt idx="4945">
                  <c:v>1148.3679525222601</c:v>
                </c:pt>
                <c:pt idx="4946">
                  <c:v>1148.6001806218601</c:v>
                </c:pt>
                <c:pt idx="4947">
                  <c:v>1148.8324087214601</c:v>
                </c:pt>
                <c:pt idx="4948">
                  <c:v>1149.06463682106</c:v>
                </c:pt>
                <c:pt idx="4949">
                  <c:v>1149.29686492066</c:v>
                </c:pt>
                <c:pt idx="4950">
                  <c:v>1149.52909302026</c:v>
                </c:pt>
                <c:pt idx="4951">
                  <c:v>1149.76132111986</c:v>
                </c:pt>
                <c:pt idx="4952">
                  <c:v>1149.99354921946</c:v>
                </c:pt>
                <c:pt idx="4953">
                  <c:v>1150.2257773190599</c:v>
                </c:pt>
                <c:pt idx="4954">
                  <c:v>1150.4580054186599</c:v>
                </c:pt>
                <c:pt idx="4955">
                  <c:v>1150.6902335182599</c:v>
                </c:pt>
                <c:pt idx="4956">
                  <c:v>1150.9224616178601</c:v>
                </c:pt>
                <c:pt idx="4957">
                  <c:v>1151.1546897174601</c:v>
                </c:pt>
                <c:pt idx="4958">
                  <c:v>1151.3869178170601</c:v>
                </c:pt>
                <c:pt idx="4959">
                  <c:v>1151.61914591666</c:v>
                </c:pt>
                <c:pt idx="4960">
                  <c:v>1151.85137401626</c:v>
                </c:pt>
                <c:pt idx="4961">
                  <c:v>1152.08360211586</c:v>
                </c:pt>
                <c:pt idx="4962">
                  <c:v>1152.31583021546</c:v>
                </c:pt>
                <c:pt idx="4963">
                  <c:v>1152.54805831506</c:v>
                </c:pt>
                <c:pt idx="4964">
                  <c:v>1152.7802864146599</c:v>
                </c:pt>
                <c:pt idx="4965">
                  <c:v>1153.0125145142599</c:v>
                </c:pt>
                <c:pt idx="4966">
                  <c:v>1153.2447426138599</c:v>
                </c:pt>
                <c:pt idx="4967">
                  <c:v>1153.4769707134601</c:v>
                </c:pt>
                <c:pt idx="4968">
                  <c:v>1153.7091988130601</c:v>
                </c:pt>
                <c:pt idx="4969">
                  <c:v>1153.9414269126601</c:v>
                </c:pt>
                <c:pt idx="4970">
                  <c:v>1154.17365501226</c:v>
                </c:pt>
                <c:pt idx="4971">
                  <c:v>1154.40588311186</c:v>
                </c:pt>
                <c:pt idx="4972">
                  <c:v>1154.63811121146</c:v>
                </c:pt>
                <c:pt idx="4973">
                  <c:v>1154.87033931106</c:v>
                </c:pt>
                <c:pt idx="4974">
                  <c:v>1155.10256741066</c:v>
                </c:pt>
                <c:pt idx="4975">
                  <c:v>1155.3347955102599</c:v>
                </c:pt>
                <c:pt idx="4976">
                  <c:v>1155.5670236098599</c:v>
                </c:pt>
                <c:pt idx="4977">
                  <c:v>1155.7992517094599</c:v>
                </c:pt>
                <c:pt idx="4978">
                  <c:v>1156.0314798090601</c:v>
                </c:pt>
                <c:pt idx="4979">
                  <c:v>1156.2637079086601</c:v>
                </c:pt>
                <c:pt idx="4980">
                  <c:v>1156.4959360082601</c:v>
                </c:pt>
                <c:pt idx="4981">
                  <c:v>1156.72816410786</c:v>
                </c:pt>
                <c:pt idx="4982">
                  <c:v>1156.96039220746</c:v>
                </c:pt>
                <c:pt idx="4983">
                  <c:v>1157.19262030706</c:v>
                </c:pt>
                <c:pt idx="4984">
                  <c:v>1157.42484840666</c:v>
                </c:pt>
                <c:pt idx="4985">
                  <c:v>1157.65707650626</c:v>
                </c:pt>
                <c:pt idx="4986">
                  <c:v>1157.8893046058599</c:v>
                </c:pt>
                <c:pt idx="4987">
                  <c:v>1158.1215327054599</c:v>
                </c:pt>
                <c:pt idx="4988">
                  <c:v>1158.3537608050599</c:v>
                </c:pt>
                <c:pt idx="4989">
                  <c:v>1158.5859889046601</c:v>
                </c:pt>
                <c:pt idx="4990">
                  <c:v>1158.8182170042601</c:v>
                </c:pt>
                <c:pt idx="4991">
                  <c:v>1159.0504451038601</c:v>
                </c:pt>
                <c:pt idx="4992">
                  <c:v>1159.28267320346</c:v>
                </c:pt>
                <c:pt idx="4993">
                  <c:v>1159.51490130306</c:v>
                </c:pt>
                <c:pt idx="4994">
                  <c:v>1159.74712940266</c:v>
                </c:pt>
                <c:pt idx="4995">
                  <c:v>1159.97935750226</c:v>
                </c:pt>
                <c:pt idx="4996">
                  <c:v>1160.21158560186</c:v>
                </c:pt>
                <c:pt idx="4997">
                  <c:v>1160.4438137014599</c:v>
                </c:pt>
                <c:pt idx="4998">
                  <c:v>1160.6760418010599</c:v>
                </c:pt>
                <c:pt idx="4999">
                  <c:v>1160.9082699006599</c:v>
                </c:pt>
                <c:pt idx="5000">
                  <c:v>1161.1404980002601</c:v>
                </c:pt>
                <c:pt idx="5001">
                  <c:v>1161.3727260998601</c:v>
                </c:pt>
                <c:pt idx="5002">
                  <c:v>1161.6049541994601</c:v>
                </c:pt>
                <c:pt idx="5003">
                  <c:v>1161.83718229906</c:v>
                </c:pt>
                <c:pt idx="5004">
                  <c:v>1162.06941039866</c:v>
                </c:pt>
                <c:pt idx="5005">
                  <c:v>1162.30163849826</c:v>
                </c:pt>
                <c:pt idx="5006">
                  <c:v>1162.53386659786</c:v>
                </c:pt>
                <c:pt idx="5007">
                  <c:v>1162.7660946974599</c:v>
                </c:pt>
                <c:pt idx="5008">
                  <c:v>1162.9983227970599</c:v>
                </c:pt>
                <c:pt idx="5009">
                  <c:v>1163.2305508966599</c:v>
                </c:pt>
                <c:pt idx="5010">
                  <c:v>1163.4627789962601</c:v>
                </c:pt>
                <c:pt idx="5011">
                  <c:v>1163.6950070958601</c:v>
                </c:pt>
                <c:pt idx="5012">
                  <c:v>1163.9272351954601</c:v>
                </c:pt>
                <c:pt idx="5013">
                  <c:v>1164.15946329506</c:v>
                </c:pt>
                <c:pt idx="5014">
                  <c:v>1164.39169139466</c:v>
                </c:pt>
                <c:pt idx="5015">
                  <c:v>1164.62391949426</c:v>
                </c:pt>
                <c:pt idx="5016">
                  <c:v>1164.85614759386</c:v>
                </c:pt>
                <c:pt idx="5017">
                  <c:v>1165.08837569346</c:v>
                </c:pt>
                <c:pt idx="5018">
                  <c:v>1165.3206037930599</c:v>
                </c:pt>
                <c:pt idx="5019">
                  <c:v>1165.5528318926599</c:v>
                </c:pt>
                <c:pt idx="5020">
                  <c:v>1165.7850599922599</c:v>
                </c:pt>
                <c:pt idx="5021">
                  <c:v>1166.0172880918601</c:v>
                </c:pt>
                <c:pt idx="5022">
                  <c:v>1166.2495161914601</c:v>
                </c:pt>
                <c:pt idx="5023">
                  <c:v>1166.4817442910601</c:v>
                </c:pt>
                <c:pt idx="5024">
                  <c:v>1166.71397239066</c:v>
                </c:pt>
                <c:pt idx="5025">
                  <c:v>1166.94620049026</c:v>
                </c:pt>
                <c:pt idx="5026">
                  <c:v>1167.17842858986</c:v>
                </c:pt>
                <c:pt idx="5027">
                  <c:v>1167.41065668946</c:v>
                </c:pt>
                <c:pt idx="5028">
                  <c:v>1167.64288478906</c:v>
                </c:pt>
                <c:pt idx="5029">
                  <c:v>1167.8751128886599</c:v>
                </c:pt>
                <c:pt idx="5030">
                  <c:v>1168.1073409882599</c:v>
                </c:pt>
                <c:pt idx="5031">
                  <c:v>1168.3395690878599</c:v>
                </c:pt>
                <c:pt idx="5032">
                  <c:v>1168.5717971874601</c:v>
                </c:pt>
                <c:pt idx="5033">
                  <c:v>1168.8040252870601</c:v>
                </c:pt>
                <c:pt idx="5034">
                  <c:v>1169.0362533866601</c:v>
                </c:pt>
                <c:pt idx="5035">
                  <c:v>1169.26848148626</c:v>
                </c:pt>
                <c:pt idx="5036">
                  <c:v>1169.50070958586</c:v>
                </c:pt>
                <c:pt idx="5037">
                  <c:v>1169.73293768546</c:v>
                </c:pt>
                <c:pt idx="5038">
                  <c:v>1169.96516578506</c:v>
                </c:pt>
                <c:pt idx="5039">
                  <c:v>1170.19739388466</c:v>
                </c:pt>
                <c:pt idx="5040">
                  <c:v>1170.4296219842599</c:v>
                </c:pt>
                <c:pt idx="5041">
                  <c:v>1170.6618500838599</c:v>
                </c:pt>
                <c:pt idx="5042">
                  <c:v>1170.8940781834599</c:v>
                </c:pt>
                <c:pt idx="5043">
                  <c:v>1171.1263062830601</c:v>
                </c:pt>
                <c:pt idx="5044">
                  <c:v>1171.3585343826601</c:v>
                </c:pt>
                <c:pt idx="5045">
                  <c:v>1171.5907624822601</c:v>
                </c:pt>
                <c:pt idx="5046">
                  <c:v>1171.82299058186</c:v>
                </c:pt>
                <c:pt idx="5047">
                  <c:v>1172.05521868146</c:v>
                </c:pt>
                <c:pt idx="5048">
                  <c:v>1172.28744678106</c:v>
                </c:pt>
                <c:pt idx="5049">
                  <c:v>1172.51967488066</c:v>
                </c:pt>
                <c:pt idx="5050">
                  <c:v>1172.75190298026</c:v>
                </c:pt>
                <c:pt idx="5051">
                  <c:v>1172.9841310798599</c:v>
                </c:pt>
                <c:pt idx="5052">
                  <c:v>1173.2163591794599</c:v>
                </c:pt>
                <c:pt idx="5053">
                  <c:v>1173.4485872790599</c:v>
                </c:pt>
                <c:pt idx="5054">
                  <c:v>1173.6808153786601</c:v>
                </c:pt>
                <c:pt idx="5055">
                  <c:v>1173.9130434782601</c:v>
                </c:pt>
                <c:pt idx="5056">
                  <c:v>1174.1452715778601</c:v>
                </c:pt>
                <c:pt idx="5057">
                  <c:v>1174.37749967746</c:v>
                </c:pt>
                <c:pt idx="5058">
                  <c:v>1174.60972777706</c:v>
                </c:pt>
                <c:pt idx="5059">
                  <c:v>1174.84195587666</c:v>
                </c:pt>
                <c:pt idx="5060">
                  <c:v>1175.07418397626</c:v>
                </c:pt>
                <c:pt idx="5061">
                  <c:v>1175.30641207586</c:v>
                </c:pt>
                <c:pt idx="5062">
                  <c:v>1175.5386401754599</c:v>
                </c:pt>
                <c:pt idx="5063">
                  <c:v>1175.7708682750599</c:v>
                </c:pt>
                <c:pt idx="5064">
                  <c:v>1176.0030963746599</c:v>
                </c:pt>
                <c:pt idx="5065">
                  <c:v>1176.2353244742601</c:v>
                </c:pt>
                <c:pt idx="5066">
                  <c:v>1176.4675525738601</c:v>
                </c:pt>
                <c:pt idx="5067">
                  <c:v>1176.6997806734601</c:v>
                </c:pt>
                <c:pt idx="5068">
                  <c:v>1176.93200877306</c:v>
                </c:pt>
                <c:pt idx="5069">
                  <c:v>1177.16423687266</c:v>
                </c:pt>
                <c:pt idx="5070">
                  <c:v>1177.39646497226</c:v>
                </c:pt>
                <c:pt idx="5071">
                  <c:v>1177.62869307186</c:v>
                </c:pt>
                <c:pt idx="5072">
                  <c:v>1177.8609211714599</c:v>
                </c:pt>
                <c:pt idx="5073">
                  <c:v>1178.0931492710599</c:v>
                </c:pt>
                <c:pt idx="5074">
                  <c:v>1178.3253773706599</c:v>
                </c:pt>
                <c:pt idx="5075">
                  <c:v>1178.5576054702599</c:v>
                </c:pt>
                <c:pt idx="5076">
                  <c:v>1178.7898335698601</c:v>
                </c:pt>
                <c:pt idx="5077">
                  <c:v>1179.0220616694601</c:v>
                </c:pt>
                <c:pt idx="5078">
                  <c:v>1179.2542897690601</c:v>
                </c:pt>
                <c:pt idx="5079">
                  <c:v>1179.48651786866</c:v>
                </c:pt>
                <c:pt idx="5080">
                  <c:v>1179.71874596826</c:v>
                </c:pt>
                <c:pt idx="5081">
                  <c:v>1179.95097406786</c:v>
                </c:pt>
                <c:pt idx="5082">
                  <c:v>1180.18320216746</c:v>
                </c:pt>
                <c:pt idx="5083">
                  <c:v>1180.4154302670599</c:v>
                </c:pt>
                <c:pt idx="5084">
                  <c:v>1180.6476583666599</c:v>
                </c:pt>
                <c:pt idx="5085">
                  <c:v>1180.8798864662599</c:v>
                </c:pt>
                <c:pt idx="5086">
                  <c:v>1181.1121145658601</c:v>
                </c:pt>
                <c:pt idx="5087">
                  <c:v>1181.3443426654601</c:v>
                </c:pt>
                <c:pt idx="5088">
                  <c:v>1181.5765707650601</c:v>
                </c:pt>
                <c:pt idx="5089">
                  <c:v>1181.80879886466</c:v>
                </c:pt>
                <c:pt idx="5090">
                  <c:v>1182.04102696426</c:v>
                </c:pt>
                <c:pt idx="5091">
                  <c:v>1182.27325506386</c:v>
                </c:pt>
                <c:pt idx="5092">
                  <c:v>1182.50548316346</c:v>
                </c:pt>
                <c:pt idx="5093">
                  <c:v>1182.73771126306</c:v>
                </c:pt>
                <c:pt idx="5094">
                  <c:v>1182.9699393626599</c:v>
                </c:pt>
                <c:pt idx="5095">
                  <c:v>1183.2021674622599</c:v>
                </c:pt>
                <c:pt idx="5096">
                  <c:v>1183.4343955618599</c:v>
                </c:pt>
                <c:pt idx="5097">
                  <c:v>1183.6666236614601</c:v>
                </c:pt>
                <c:pt idx="5098">
                  <c:v>1183.8988517610601</c:v>
                </c:pt>
                <c:pt idx="5099">
                  <c:v>1184.1310798606601</c:v>
                </c:pt>
                <c:pt idx="5100">
                  <c:v>1184.36330796026</c:v>
                </c:pt>
                <c:pt idx="5101">
                  <c:v>1184.59553605986</c:v>
                </c:pt>
                <c:pt idx="5102">
                  <c:v>1184.82776415946</c:v>
                </c:pt>
                <c:pt idx="5103">
                  <c:v>1185.05999225906</c:v>
                </c:pt>
                <c:pt idx="5104">
                  <c:v>1185.29222035866</c:v>
                </c:pt>
                <c:pt idx="5105">
                  <c:v>1185.5244484582599</c:v>
                </c:pt>
                <c:pt idx="5106">
                  <c:v>1185.7566765578599</c:v>
                </c:pt>
                <c:pt idx="5107">
                  <c:v>1185.9889046574599</c:v>
                </c:pt>
                <c:pt idx="5108">
                  <c:v>1186.2211327570601</c:v>
                </c:pt>
                <c:pt idx="5109">
                  <c:v>1186.4533608566601</c:v>
                </c:pt>
                <c:pt idx="5110">
                  <c:v>1186.6855889562601</c:v>
                </c:pt>
                <c:pt idx="5111">
                  <c:v>1186.91781705586</c:v>
                </c:pt>
                <c:pt idx="5112">
                  <c:v>1187.15004515546</c:v>
                </c:pt>
                <c:pt idx="5113">
                  <c:v>1187.38227325506</c:v>
                </c:pt>
                <c:pt idx="5114">
                  <c:v>1187.61450135466</c:v>
                </c:pt>
                <c:pt idx="5115">
                  <c:v>1187.84672945426</c:v>
                </c:pt>
                <c:pt idx="5116">
                  <c:v>1188.0789575538599</c:v>
                </c:pt>
                <c:pt idx="5117">
                  <c:v>1188.3111856534599</c:v>
                </c:pt>
                <c:pt idx="5118">
                  <c:v>1188.5434137530599</c:v>
                </c:pt>
                <c:pt idx="5119">
                  <c:v>1188.7756418526601</c:v>
                </c:pt>
                <c:pt idx="5120">
                  <c:v>1189.0078699522601</c:v>
                </c:pt>
                <c:pt idx="5121">
                  <c:v>1189.2400980518601</c:v>
                </c:pt>
                <c:pt idx="5122">
                  <c:v>1189.47232615146</c:v>
                </c:pt>
                <c:pt idx="5123">
                  <c:v>1189.70455425106</c:v>
                </c:pt>
                <c:pt idx="5124">
                  <c:v>1189.93678235066</c:v>
                </c:pt>
                <c:pt idx="5125">
                  <c:v>1190.16901045026</c:v>
                </c:pt>
                <c:pt idx="5126">
                  <c:v>1190.40123854986</c:v>
                </c:pt>
                <c:pt idx="5127">
                  <c:v>1190.6334666494599</c:v>
                </c:pt>
                <c:pt idx="5128">
                  <c:v>1190.8656947490599</c:v>
                </c:pt>
                <c:pt idx="5129">
                  <c:v>1191.0979228486599</c:v>
                </c:pt>
                <c:pt idx="5130">
                  <c:v>1191.3301509482601</c:v>
                </c:pt>
                <c:pt idx="5131">
                  <c:v>1191.5623790478601</c:v>
                </c:pt>
                <c:pt idx="5132">
                  <c:v>1191.7946071474601</c:v>
                </c:pt>
                <c:pt idx="5133">
                  <c:v>1192.02683524707</c:v>
                </c:pt>
                <c:pt idx="5134">
                  <c:v>1192.25906334667</c:v>
                </c:pt>
                <c:pt idx="5135">
                  <c:v>1192.49129144626</c:v>
                </c:pt>
                <c:pt idx="5136">
                  <c:v>1192.72351954586</c:v>
                </c:pt>
                <c:pt idx="5137">
                  <c:v>1192.95574764547</c:v>
                </c:pt>
                <c:pt idx="5138">
                  <c:v>1193.1879757450699</c:v>
                </c:pt>
                <c:pt idx="5139">
                  <c:v>1193.4202038446699</c:v>
                </c:pt>
                <c:pt idx="5140">
                  <c:v>1193.6524319442699</c:v>
                </c:pt>
                <c:pt idx="5141">
                  <c:v>1193.8846600438701</c:v>
                </c:pt>
                <c:pt idx="5142">
                  <c:v>1194.1168881434701</c:v>
                </c:pt>
                <c:pt idx="5143">
                  <c:v>1194.3491162430701</c:v>
                </c:pt>
                <c:pt idx="5144">
                  <c:v>1194.58134434267</c:v>
                </c:pt>
                <c:pt idx="5145">
                  <c:v>1194.81357244227</c:v>
                </c:pt>
                <c:pt idx="5146">
                  <c:v>1195.04580054187</c:v>
                </c:pt>
                <c:pt idx="5147">
                  <c:v>1195.27802864147</c:v>
                </c:pt>
                <c:pt idx="5148">
                  <c:v>1195.51025674107</c:v>
                </c:pt>
                <c:pt idx="5149">
                  <c:v>1195.7424848406699</c:v>
                </c:pt>
                <c:pt idx="5150">
                  <c:v>1195.9747129402699</c:v>
                </c:pt>
                <c:pt idx="5151">
                  <c:v>1196.2069410398699</c:v>
                </c:pt>
                <c:pt idx="5152">
                  <c:v>1196.4391691394701</c:v>
                </c:pt>
                <c:pt idx="5153">
                  <c:v>1196.6713972390701</c:v>
                </c:pt>
                <c:pt idx="5154">
                  <c:v>1196.9036253386701</c:v>
                </c:pt>
                <c:pt idx="5155">
                  <c:v>1197.13585343827</c:v>
                </c:pt>
                <c:pt idx="5156">
                  <c:v>1197.36808153787</c:v>
                </c:pt>
                <c:pt idx="5157">
                  <c:v>1197.60030963747</c:v>
                </c:pt>
                <c:pt idx="5158">
                  <c:v>1197.83253773707</c:v>
                </c:pt>
                <c:pt idx="5159">
                  <c:v>1198.0647658366699</c:v>
                </c:pt>
                <c:pt idx="5160">
                  <c:v>1198.2969939362699</c:v>
                </c:pt>
                <c:pt idx="5161">
                  <c:v>1198.5292220358699</c:v>
                </c:pt>
                <c:pt idx="5162">
                  <c:v>1198.7614501354701</c:v>
                </c:pt>
                <c:pt idx="5163">
                  <c:v>1198.9936782350701</c:v>
                </c:pt>
                <c:pt idx="5164">
                  <c:v>1199.2259063346701</c:v>
                </c:pt>
                <c:pt idx="5165">
                  <c:v>1199.4581344342701</c:v>
                </c:pt>
                <c:pt idx="5166">
                  <c:v>1199.69036253387</c:v>
                </c:pt>
                <c:pt idx="5167">
                  <c:v>1199.92259063347</c:v>
                </c:pt>
                <c:pt idx="5168">
                  <c:v>1200.15481873307</c:v>
                </c:pt>
                <c:pt idx="5169">
                  <c:v>1200.38704683267</c:v>
                </c:pt>
                <c:pt idx="5170">
                  <c:v>1200.6192749322699</c:v>
                </c:pt>
                <c:pt idx="5171">
                  <c:v>1200.8515030318699</c:v>
                </c:pt>
                <c:pt idx="5172">
                  <c:v>1201.0837311314699</c:v>
                </c:pt>
                <c:pt idx="5173">
                  <c:v>1201.3159592310701</c:v>
                </c:pt>
                <c:pt idx="5174">
                  <c:v>1201.5481873306701</c:v>
                </c:pt>
                <c:pt idx="5175">
                  <c:v>1201.7804154302701</c:v>
                </c:pt>
                <c:pt idx="5176">
                  <c:v>1202.01264352987</c:v>
                </c:pt>
                <c:pt idx="5177">
                  <c:v>1202.24487162947</c:v>
                </c:pt>
                <c:pt idx="5178">
                  <c:v>1202.47709972907</c:v>
                </c:pt>
                <c:pt idx="5179">
                  <c:v>1202.70932782867</c:v>
                </c:pt>
                <c:pt idx="5180">
                  <c:v>1202.94155592827</c:v>
                </c:pt>
                <c:pt idx="5181">
                  <c:v>1203.1737840278699</c:v>
                </c:pt>
                <c:pt idx="5182">
                  <c:v>1203.4060121274699</c:v>
                </c:pt>
                <c:pt idx="5183">
                  <c:v>1203.6382402270699</c:v>
                </c:pt>
                <c:pt idx="5184">
                  <c:v>1203.8704683266701</c:v>
                </c:pt>
                <c:pt idx="5185">
                  <c:v>1204.1026964262701</c:v>
                </c:pt>
                <c:pt idx="5186">
                  <c:v>1204.3349245258701</c:v>
                </c:pt>
                <c:pt idx="5187">
                  <c:v>1204.56715262547</c:v>
                </c:pt>
                <c:pt idx="5188">
                  <c:v>1204.79938072507</c:v>
                </c:pt>
                <c:pt idx="5189">
                  <c:v>1205.03160882467</c:v>
                </c:pt>
                <c:pt idx="5190">
                  <c:v>1205.26383692427</c:v>
                </c:pt>
                <c:pt idx="5191">
                  <c:v>1205.49606502387</c:v>
                </c:pt>
                <c:pt idx="5192">
                  <c:v>1205.7282931234699</c:v>
                </c:pt>
                <c:pt idx="5193">
                  <c:v>1205.9605212230699</c:v>
                </c:pt>
                <c:pt idx="5194">
                  <c:v>1206.1927493226699</c:v>
                </c:pt>
                <c:pt idx="5195">
                  <c:v>1206.4249774222701</c:v>
                </c:pt>
                <c:pt idx="5196">
                  <c:v>1206.6572055218701</c:v>
                </c:pt>
                <c:pt idx="5197">
                  <c:v>1206.8894336214701</c:v>
                </c:pt>
                <c:pt idx="5198">
                  <c:v>1207.12166172107</c:v>
                </c:pt>
                <c:pt idx="5199">
                  <c:v>1207.35388982067</c:v>
                </c:pt>
                <c:pt idx="5200">
                  <c:v>1207.58611792027</c:v>
                </c:pt>
                <c:pt idx="5201">
                  <c:v>1207.81834601987</c:v>
                </c:pt>
                <c:pt idx="5202">
                  <c:v>1208.05057411947</c:v>
                </c:pt>
                <c:pt idx="5203">
                  <c:v>1208.2828022190699</c:v>
                </c:pt>
                <c:pt idx="5204">
                  <c:v>1208.5150303186699</c:v>
                </c:pt>
                <c:pt idx="5205">
                  <c:v>1208.7472584182699</c:v>
                </c:pt>
                <c:pt idx="5206">
                  <c:v>1208.9794865178701</c:v>
                </c:pt>
                <c:pt idx="5207">
                  <c:v>1209.2117146174701</c:v>
                </c:pt>
                <c:pt idx="5208">
                  <c:v>1209.4439427170701</c:v>
                </c:pt>
                <c:pt idx="5209">
                  <c:v>1209.67617081667</c:v>
                </c:pt>
                <c:pt idx="5210">
                  <c:v>1209.90839891627</c:v>
                </c:pt>
                <c:pt idx="5211">
                  <c:v>1210.14062701587</c:v>
                </c:pt>
                <c:pt idx="5212">
                  <c:v>1210.37285511547</c:v>
                </c:pt>
                <c:pt idx="5213">
                  <c:v>1210.60508321507</c:v>
                </c:pt>
                <c:pt idx="5214">
                  <c:v>1210.8373113146699</c:v>
                </c:pt>
                <c:pt idx="5215">
                  <c:v>1211.0695394142699</c:v>
                </c:pt>
                <c:pt idx="5216">
                  <c:v>1211.3017675138699</c:v>
                </c:pt>
                <c:pt idx="5217">
                  <c:v>1211.5339956134701</c:v>
                </c:pt>
                <c:pt idx="5218">
                  <c:v>1211.7662237130701</c:v>
                </c:pt>
                <c:pt idx="5219">
                  <c:v>1211.9984518126701</c:v>
                </c:pt>
                <c:pt idx="5220">
                  <c:v>1212.23067991227</c:v>
                </c:pt>
                <c:pt idx="5221">
                  <c:v>1212.46290801187</c:v>
                </c:pt>
                <c:pt idx="5222">
                  <c:v>1212.69513611147</c:v>
                </c:pt>
                <c:pt idx="5223">
                  <c:v>1212.92736421107</c:v>
                </c:pt>
                <c:pt idx="5224">
                  <c:v>1213.15959231067</c:v>
                </c:pt>
                <c:pt idx="5225">
                  <c:v>1213.3918204102699</c:v>
                </c:pt>
                <c:pt idx="5226">
                  <c:v>1213.6240485098699</c:v>
                </c:pt>
                <c:pt idx="5227">
                  <c:v>1213.8562766094699</c:v>
                </c:pt>
                <c:pt idx="5228">
                  <c:v>1214.0885047090701</c:v>
                </c:pt>
                <c:pt idx="5229">
                  <c:v>1214.3207328086701</c:v>
                </c:pt>
                <c:pt idx="5230">
                  <c:v>1214.5529609082701</c:v>
                </c:pt>
                <c:pt idx="5231">
                  <c:v>1214.78518900787</c:v>
                </c:pt>
                <c:pt idx="5232">
                  <c:v>1215.01741710747</c:v>
                </c:pt>
                <c:pt idx="5233">
                  <c:v>1215.24964520707</c:v>
                </c:pt>
                <c:pt idx="5234">
                  <c:v>1215.48187330667</c:v>
                </c:pt>
                <c:pt idx="5235">
                  <c:v>1215.7141014062699</c:v>
                </c:pt>
                <c:pt idx="5236">
                  <c:v>1215.9463295058699</c:v>
                </c:pt>
                <c:pt idx="5237">
                  <c:v>1216.1785576054699</c:v>
                </c:pt>
                <c:pt idx="5238">
                  <c:v>1216.4107857050701</c:v>
                </c:pt>
                <c:pt idx="5239">
                  <c:v>1216.6430138046701</c:v>
                </c:pt>
                <c:pt idx="5240">
                  <c:v>1216.8752419042701</c:v>
                </c:pt>
                <c:pt idx="5241">
                  <c:v>1217.10747000387</c:v>
                </c:pt>
                <c:pt idx="5242">
                  <c:v>1217.33969810347</c:v>
                </c:pt>
                <c:pt idx="5243">
                  <c:v>1217.57192620307</c:v>
                </c:pt>
                <c:pt idx="5244">
                  <c:v>1217.80415430267</c:v>
                </c:pt>
                <c:pt idx="5245">
                  <c:v>1218.03638240227</c:v>
                </c:pt>
                <c:pt idx="5246">
                  <c:v>1218.2686105018699</c:v>
                </c:pt>
                <c:pt idx="5247">
                  <c:v>1218.5008386014699</c:v>
                </c:pt>
                <c:pt idx="5248">
                  <c:v>1218.7330667010699</c:v>
                </c:pt>
                <c:pt idx="5249">
                  <c:v>1218.9652948006701</c:v>
                </c:pt>
                <c:pt idx="5250">
                  <c:v>1219.1975229002701</c:v>
                </c:pt>
                <c:pt idx="5251">
                  <c:v>1219.4297509998701</c:v>
                </c:pt>
                <c:pt idx="5252">
                  <c:v>1219.66197909947</c:v>
                </c:pt>
                <c:pt idx="5253">
                  <c:v>1219.89420719907</c:v>
                </c:pt>
                <c:pt idx="5254">
                  <c:v>1220.12643529867</c:v>
                </c:pt>
                <c:pt idx="5255">
                  <c:v>1220.35866339827</c:v>
                </c:pt>
                <c:pt idx="5256">
                  <c:v>1220.59089149787</c:v>
                </c:pt>
                <c:pt idx="5257">
                  <c:v>1220.8231195974699</c:v>
                </c:pt>
                <c:pt idx="5258">
                  <c:v>1221.0553476970699</c:v>
                </c:pt>
                <c:pt idx="5259">
                  <c:v>1221.2875757966699</c:v>
                </c:pt>
                <c:pt idx="5260">
                  <c:v>1221.5198038962701</c:v>
                </c:pt>
                <c:pt idx="5261">
                  <c:v>1221.7520319958701</c:v>
                </c:pt>
                <c:pt idx="5262">
                  <c:v>1221.9842600954701</c:v>
                </c:pt>
                <c:pt idx="5263">
                  <c:v>1222.21648819507</c:v>
                </c:pt>
                <c:pt idx="5264">
                  <c:v>1222.44871629467</c:v>
                </c:pt>
                <c:pt idx="5265">
                  <c:v>1222.68094439427</c:v>
                </c:pt>
                <c:pt idx="5266">
                  <c:v>1222.91317249387</c:v>
                </c:pt>
                <c:pt idx="5267">
                  <c:v>1223.14540059347</c:v>
                </c:pt>
                <c:pt idx="5268">
                  <c:v>1223.3776286930699</c:v>
                </c:pt>
                <c:pt idx="5269">
                  <c:v>1223.6098567926699</c:v>
                </c:pt>
                <c:pt idx="5270">
                  <c:v>1223.8420848922699</c:v>
                </c:pt>
                <c:pt idx="5271">
                  <c:v>1224.0743129918701</c:v>
                </c:pt>
                <c:pt idx="5272">
                  <c:v>1224.3065410914701</c:v>
                </c:pt>
                <c:pt idx="5273">
                  <c:v>1224.5387691910701</c:v>
                </c:pt>
                <c:pt idx="5274">
                  <c:v>1224.77099729067</c:v>
                </c:pt>
                <c:pt idx="5275">
                  <c:v>1225.00322539027</c:v>
                </c:pt>
                <c:pt idx="5276">
                  <c:v>1225.23545348987</c:v>
                </c:pt>
                <c:pt idx="5277">
                  <c:v>1225.46768158947</c:v>
                </c:pt>
                <c:pt idx="5278">
                  <c:v>1225.69990968907</c:v>
                </c:pt>
                <c:pt idx="5279">
                  <c:v>1225.9321377886699</c:v>
                </c:pt>
                <c:pt idx="5280">
                  <c:v>1226.1643658882699</c:v>
                </c:pt>
                <c:pt idx="5281">
                  <c:v>1226.3965939878699</c:v>
                </c:pt>
                <c:pt idx="5282">
                  <c:v>1226.6288220874701</c:v>
                </c:pt>
                <c:pt idx="5283">
                  <c:v>1226.8610501870701</c:v>
                </c:pt>
                <c:pt idx="5284">
                  <c:v>1227.0932782866701</c:v>
                </c:pt>
                <c:pt idx="5285">
                  <c:v>1227.32550638627</c:v>
                </c:pt>
                <c:pt idx="5286">
                  <c:v>1227.55773448587</c:v>
                </c:pt>
                <c:pt idx="5287">
                  <c:v>1227.78996258547</c:v>
                </c:pt>
                <c:pt idx="5288">
                  <c:v>1228.02219068507</c:v>
                </c:pt>
                <c:pt idx="5289">
                  <c:v>1228.25441878467</c:v>
                </c:pt>
                <c:pt idx="5290">
                  <c:v>1228.4866468842699</c:v>
                </c:pt>
                <c:pt idx="5291">
                  <c:v>1228.7188749838699</c:v>
                </c:pt>
                <c:pt idx="5292">
                  <c:v>1228.9511030834699</c:v>
                </c:pt>
                <c:pt idx="5293">
                  <c:v>1229.1833311830701</c:v>
                </c:pt>
                <c:pt idx="5294">
                  <c:v>1229.4155592826701</c:v>
                </c:pt>
                <c:pt idx="5295">
                  <c:v>1229.6477873822701</c:v>
                </c:pt>
                <c:pt idx="5296">
                  <c:v>1229.88001548187</c:v>
                </c:pt>
                <c:pt idx="5297">
                  <c:v>1230.11224358147</c:v>
                </c:pt>
                <c:pt idx="5298">
                  <c:v>1230.34447168107</c:v>
                </c:pt>
                <c:pt idx="5299">
                  <c:v>1230.57669978067</c:v>
                </c:pt>
                <c:pt idx="5300">
                  <c:v>1230.8089278802699</c:v>
                </c:pt>
                <c:pt idx="5301">
                  <c:v>1231.0411559798699</c:v>
                </c:pt>
                <c:pt idx="5302">
                  <c:v>1231.2733840794699</c:v>
                </c:pt>
                <c:pt idx="5303">
                  <c:v>1231.5056121790701</c:v>
                </c:pt>
                <c:pt idx="5304">
                  <c:v>1231.7378402786701</c:v>
                </c:pt>
                <c:pt idx="5305">
                  <c:v>1231.9700683782701</c:v>
                </c:pt>
                <c:pt idx="5306">
                  <c:v>1232.20229647787</c:v>
                </c:pt>
                <c:pt idx="5307">
                  <c:v>1232.43452457747</c:v>
                </c:pt>
                <c:pt idx="5308">
                  <c:v>1232.66675267707</c:v>
                </c:pt>
                <c:pt idx="5309">
                  <c:v>1232.89898077667</c:v>
                </c:pt>
                <c:pt idx="5310">
                  <c:v>1233.13120887627</c:v>
                </c:pt>
                <c:pt idx="5311">
                  <c:v>1233.3634369758699</c:v>
                </c:pt>
                <c:pt idx="5312">
                  <c:v>1233.5956650754699</c:v>
                </c:pt>
                <c:pt idx="5313">
                  <c:v>1233.8278931750699</c:v>
                </c:pt>
                <c:pt idx="5314">
                  <c:v>1234.0601212746701</c:v>
                </c:pt>
                <c:pt idx="5315">
                  <c:v>1234.2923493742701</c:v>
                </c:pt>
                <c:pt idx="5316">
                  <c:v>1234.5245774738701</c:v>
                </c:pt>
                <c:pt idx="5317">
                  <c:v>1234.75680557347</c:v>
                </c:pt>
                <c:pt idx="5318">
                  <c:v>1234.98903367307</c:v>
                </c:pt>
                <c:pt idx="5319">
                  <c:v>1235.22126177267</c:v>
                </c:pt>
                <c:pt idx="5320">
                  <c:v>1235.45348987227</c:v>
                </c:pt>
                <c:pt idx="5321">
                  <c:v>1235.68571797187</c:v>
                </c:pt>
                <c:pt idx="5322">
                  <c:v>1235.9179460714699</c:v>
                </c:pt>
                <c:pt idx="5323">
                  <c:v>1236.1501741710699</c:v>
                </c:pt>
                <c:pt idx="5324">
                  <c:v>1236.3824022706699</c:v>
                </c:pt>
                <c:pt idx="5325">
                  <c:v>1236.6146303702701</c:v>
                </c:pt>
                <c:pt idx="5326">
                  <c:v>1236.8468584698701</c:v>
                </c:pt>
                <c:pt idx="5327">
                  <c:v>1237.0790865694701</c:v>
                </c:pt>
                <c:pt idx="5328">
                  <c:v>1237.31131466908</c:v>
                </c:pt>
                <c:pt idx="5329">
                  <c:v>1237.54354276868</c:v>
                </c:pt>
                <c:pt idx="5330">
                  <c:v>1237.77577086828</c:v>
                </c:pt>
                <c:pt idx="5331">
                  <c:v>1238.00799896788</c:v>
                </c:pt>
                <c:pt idx="5332">
                  <c:v>1238.24022706748</c:v>
                </c:pt>
                <c:pt idx="5333">
                  <c:v>1238.4724551670799</c:v>
                </c:pt>
                <c:pt idx="5334">
                  <c:v>1238.7046832666799</c:v>
                </c:pt>
                <c:pt idx="5335">
                  <c:v>1238.9369113662799</c:v>
                </c:pt>
                <c:pt idx="5336">
                  <c:v>1239.1691394658801</c:v>
                </c:pt>
                <c:pt idx="5337">
                  <c:v>1239.4013675654801</c:v>
                </c:pt>
                <c:pt idx="5338">
                  <c:v>1239.6335956650801</c:v>
                </c:pt>
                <c:pt idx="5339">
                  <c:v>1239.86582376468</c:v>
                </c:pt>
                <c:pt idx="5340">
                  <c:v>1240.09805186428</c:v>
                </c:pt>
                <c:pt idx="5341">
                  <c:v>1240.33027996388</c:v>
                </c:pt>
                <c:pt idx="5342">
                  <c:v>1240.56250806348</c:v>
                </c:pt>
                <c:pt idx="5343">
                  <c:v>1240.79473616308</c:v>
                </c:pt>
                <c:pt idx="5344">
                  <c:v>1241.0269642626799</c:v>
                </c:pt>
                <c:pt idx="5345">
                  <c:v>1241.2591923622799</c:v>
                </c:pt>
                <c:pt idx="5346">
                  <c:v>1241.4914204618799</c:v>
                </c:pt>
                <c:pt idx="5347">
                  <c:v>1241.7236485614801</c:v>
                </c:pt>
                <c:pt idx="5348">
                  <c:v>1241.9558766610801</c:v>
                </c:pt>
                <c:pt idx="5349">
                  <c:v>1242.1881047606801</c:v>
                </c:pt>
                <c:pt idx="5350">
                  <c:v>1242.42033286028</c:v>
                </c:pt>
                <c:pt idx="5351">
                  <c:v>1242.65256095988</c:v>
                </c:pt>
                <c:pt idx="5352">
                  <c:v>1242.88478905948</c:v>
                </c:pt>
                <c:pt idx="5353">
                  <c:v>1243.11701715908</c:v>
                </c:pt>
                <c:pt idx="5354">
                  <c:v>1243.34924525868</c:v>
                </c:pt>
                <c:pt idx="5355">
                  <c:v>1243.5814733582799</c:v>
                </c:pt>
                <c:pt idx="5356">
                  <c:v>1243.8137014578799</c:v>
                </c:pt>
                <c:pt idx="5357">
                  <c:v>1244.0459295574799</c:v>
                </c:pt>
                <c:pt idx="5358">
                  <c:v>1244.2781576570801</c:v>
                </c:pt>
                <c:pt idx="5359">
                  <c:v>1244.5103857566801</c:v>
                </c:pt>
                <c:pt idx="5360">
                  <c:v>1244.7426138562801</c:v>
                </c:pt>
                <c:pt idx="5361">
                  <c:v>1244.97484195588</c:v>
                </c:pt>
                <c:pt idx="5362">
                  <c:v>1245.20707005548</c:v>
                </c:pt>
                <c:pt idx="5363">
                  <c:v>1245.43929815508</c:v>
                </c:pt>
                <c:pt idx="5364">
                  <c:v>1245.67152625468</c:v>
                </c:pt>
                <c:pt idx="5365">
                  <c:v>1245.90375435428</c:v>
                </c:pt>
                <c:pt idx="5366">
                  <c:v>1246.1359824538799</c:v>
                </c:pt>
                <c:pt idx="5367">
                  <c:v>1246.3682105534799</c:v>
                </c:pt>
                <c:pt idx="5368">
                  <c:v>1246.6004386530799</c:v>
                </c:pt>
                <c:pt idx="5369">
                  <c:v>1246.8326667526801</c:v>
                </c:pt>
                <c:pt idx="5370">
                  <c:v>1247.0648948522801</c:v>
                </c:pt>
                <c:pt idx="5371">
                  <c:v>1247.2971229518801</c:v>
                </c:pt>
                <c:pt idx="5372">
                  <c:v>1247.52935105148</c:v>
                </c:pt>
                <c:pt idx="5373">
                  <c:v>1247.76157915108</c:v>
                </c:pt>
                <c:pt idx="5374">
                  <c:v>1247.99380725068</c:v>
                </c:pt>
                <c:pt idx="5375">
                  <c:v>1248.22603535028</c:v>
                </c:pt>
                <c:pt idx="5376">
                  <c:v>1248.45826344988</c:v>
                </c:pt>
                <c:pt idx="5377">
                  <c:v>1248.6904915494799</c:v>
                </c:pt>
                <c:pt idx="5378">
                  <c:v>1248.9227196490799</c:v>
                </c:pt>
                <c:pt idx="5379">
                  <c:v>1249.1549477486799</c:v>
                </c:pt>
                <c:pt idx="5380">
                  <c:v>1249.3871758482801</c:v>
                </c:pt>
                <c:pt idx="5381">
                  <c:v>1249.6194039478801</c:v>
                </c:pt>
                <c:pt idx="5382">
                  <c:v>1249.8516320474801</c:v>
                </c:pt>
                <c:pt idx="5383">
                  <c:v>1250.08386014708</c:v>
                </c:pt>
                <c:pt idx="5384">
                  <c:v>1250.31608824668</c:v>
                </c:pt>
                <c:pt idx="5385">
                  <c:v>1250.54831634628</c:v>
                </c:pt>
                <c:pt idx="5386">
                  <c:v>1250.78054444588</c:v>
                </c:pt>
                <c:pt idx="5387">
                  <c:v>1251.0127725454799</c:v>
                </c:pt>
                <c:pt idx="5388">
                  <c:v>1251.2450006450799</c:v>
                </c:pt>
                <c:pt idx="5389">
                  <c:v>1251.4772287446799</c:v>
                </c:pt>
                <c:pt idx="5390">
                  <c:v>1251.7094568442801</c:v>
                </c:pt>
                <c:pt idx="5391">
                  <c:v>1251.9416849438801</c:v>
                </c:pt>
                <c:pt idx="5392">
                  <c:v>1252.1739130434801</c:v>
                </c:pt>
                <c:pt idx="5393">
                  <c:v>1252.40614114308</c:v>
                </c:pt>
                <c:pt idx="5394">
                  <c:v>1252.63836924268</c:v>
                </c:pt>
                <c:pt idx="5395">
                  <c:v>1252.87059734228</c:v>
                </c:pt>
                <c:pt idx="5396">
                  <c:v>1253.10282544188</c:v>
                </c:pt>
                <c:pt idx="5397">
                  <c:v>1253.33505354148</c:v>
                </c:pt>
                <c:pt idx="5398">
                  <c:v>1253.5672816410799</c:v>
                </c:pt>
                <c:pt idx="5399">
                  <c:v>1253.7995097406799</c:v>
                </c:pt>
                <c:pt idx="5400">
                  <c:v>1254.0317378402799</c:v>
                </c:pt>
                <c:pt idx="5401">
                  <c:v>1254.2639659398801</c:v>
                </c:pt>
                <c:pt idx="5402">
                  <c:v>1254.4961940394801</c:v>
                </c:pt>
                <c:pt idx="5403">
                  <c:v>1254.7284221390801</c:v>
                </c:pt>
                <c:pt idx="5404">
                  <c:v>1254.96065023868</c:v>
                </c:pt>
                <c:pt idx="5405">
                  <c:v>1255.19287833828</c:v>
                </c:pt>
                <c:pt idx="5406">
                  <c:v>1255.42510643788</c:v>
                </c:pt>
                <c:pt idx="5407">
                  <c:v>1255.65733453748</c:v>
                </c:pt>
                <c:pt idx="5408">
                  <c:v>1255.88956263708</c:v>
                </c:pt>
                <c:pt idx="5409">
                  <c:v>1256.1217907366799</c:v>
                </c:pt>
                <c:pt idx="5410">
                  <c:v>1256.3540188362799</c:v>
                </c:pt>
                <c:pt idx="5411">
                  <c:v>1256.5862469358799</c:v>
                </c:pt>
                <c:pt idx="5412">
                  <c:v>1256.8184750354801</c:v>
                </c:pt>
                <c:pt idx="5413">
                  <c:v>1257.0507031350801</c:v>
                </c:pt>
                <c:pt idx="5414">
                  <c:v>1257.2829312346801</c:v>
                </c:pt>
                <c:pt idx="5415">
                  <c:v>1257.51515933428</c:v>
                </c:pt>
                <c:pt idx="5416">
                  <c:v>1257.74738743388</c:v>
                </c:pt>
                <c:pt idx="5417">
                  <c:v>1257.97961553348</c:v>
                </c:pt>
                <c:pt idx="5418">
                  <c:v>1258.21184363308</c:v>
                </c:pt>
                <c:pt idx="5419">
                  <c:v>1258.44407173268</c:v>
                </c:pt>
                <c:pt idx="5420">
                  <c:v>1258.6762998322799</c:v>
                </c:pt>
                <c:pt idx="5421">
                  <c:v>1258.9085279318799</c:v>
                </c:pt>
                <c:pt idx="5422">
                  <c:v>1259.1407560314799</c:v>
                </c:pt>
                <c:pt idx="5423">
                  <c:v>1259.3729841310801</c:v>
                </c:pt>
                <c:pt idx="5424">
                  <c:v>1259.6052122306801</c:v>
                </c:pt>
                <c:pt idx="5425">
                  <c:v>1259.8374403302801</c:v>
                </c:pt>
                <c:pt idx="5426">
                  <c:v>1260.06966842988</c:v>
                </c:pt>
                <c:pt idx="5427">
                  <c:v>1260.30189652948</c:v>
                </c:pt>
                <c:pt idx="5428">
                  <c:v>1260.53412462908</c:v>
                </c:pt>
                <c:pt idx="5429">
                  <c:v>1260.76635272868</c:v>
                </c:pt>
                <c:pt idx="5430">
                  <c:v>1260.99858082828</c:v>
                </c:pt>
                <c:pt idx="5431">
                  <c:v>1261.2308089278799</c:v>
                </c:pt>
                <c:pt idx="5432">
                  <c:v>1261.4630370274799</c:v>
                </c:pt>
                <c:pt idx="5433">
                  <c:v>1261.6952651270799</c:v>
                </c:pt>
                <c:pt idx="5434">
                  <c:v>1261.9274932266801</c:v>
                </c:pt>
                <c:pt idx="5435">
                  <c:v>1262.1597213262801</c:v>
                </c:pt>
                <c:pt idx="5436">
                  <c:v>1262.3919494258801</c:v>
                </c:pt>
                <c:pt idx="5437">
                  <c:v>1262.62417752548</c:v>
                </c:pt>
                <c:pt idx="5438">
                  <c:v>1262.85640562508</c:v>
                </c:pt>
                <c:pt idx="5439">
                  <c:v>1263.08863372468</c:v>
                </c:pt>
                <c:pt idx="5440">
                  <c:v>1263.32086182428</c:v>
                </c:pt>
                <c:pt idx="5441">
                  <c:v>1263.55308992388</c:v>
                </c:pt>
                <c:pt idx="5442">
                  <c:v>1263.7853180234799</c:v>
                </c:pt>
                <c:pt idx="5443">
                  <c:v>1264.0175461230799</c:v>
                </c:pt>
                <c:pt idx="5444">
                  <c:v>1264.2497742226799</c:v>
                </c:pt>
                <c:pt idx="5445">
                  <c:v>1264.4820023222801</c:v>
                </c:pt>
                <c:pt idx="5446">
                  <c:v>1264.7142304218801</c:v>
                </c:pt>
                <c:pt idx="5447">
                  <c:v>1264.9464585214801</c:v>
                </c:pt>
                <c:pt idx="5448">
                  <c:v>1265.17868662108</c:v>
                </c:pt>
                <c:pt idx="5449">
                  <c:v>1265.41091472068</c:v>
                </c:pt>
                <c:pt idx="5450">
                  <c:v>1265.64314282028</c:v>
                </c:pt>
                <c:pt idx="5451">
                  <c:v>1265.87537091988</c:v>
                </c:pt>
                <c:pt idx="5452">
                  <c:v>1266.1075990194799</c:v>
                </c:pt>
                <c:pt idx="5453">
                  <c:v>1266.3398271190799</c:v>
                </c:pt>
                <c:pt idx="5454">
                  <c:v>1266.5720552186799</c:v>
                </c:pt>
                <c:pt idx="5455">
                  <c:v>1266.8042833182801</c:v>
                </c:pt>
                <c:pt idx="5456">
                  <c:v>1267.0365114178801</c:v>
                </c:pt>
                <c:pt idx="5457">
                  <c:v>1267.2687395174801</c:v>
                </c:pt>
                <c:pt idx="5458">
                  <c:v>1267.5009676170801</c:v>
                </c:pt>
                <c:pt idx="5459">
                  <c:v>1267.73319571668</c:v>
                </c:pt>
                <c:pt idx="5460">
                  <c:v>1267.96542381628</c:v>
                </c:pt>
                <c:pt idx="5461">
                  <c:v>1268.19765191588</c:v>
                </c:pt>
                <c:pt idx="5462">
                  <c:v>1268.42988001548</c:v>
                </c:pt>
                <c:pt idx="5463">
                  <c:v>1268.6621081150799</c:v>
                </c:pt>
                <c:pt idx="5464">
                  <c:v>1268.8943362146799</c:v>
                </c:pt>
                <c:pt idx="5465">
                  <c:v>1269.1265643142799</c:v>
                </c:pt>
                <c:pt idx="5466">
                  <c:v>1269.3587924138801</c:v>
                </c:pt>
                <c:pt idx="5467">
                  <c:v>1269.5910205134801</c:v>
                </c:pt>
                <c:pt idx="5468">
                  <c:v>1269.8232486130801</c:v>
                </c:pt>
                <c:pt idx="5469">
                  <c:v>1270.05547671268</c:v>
                </c:pt>
                <c:pt idx="5470">
                  <c:v>1270.28770481228</c:v>
                </c:pt>
                <c:pt idx="5471">
                  <c:v>1270.51993291188</c:v>
                </c:pt>
                <c:pt idx="5472">
                  <c:v>1270.75216101148</c:v>
                </c:pt>
                <c:pt idx="5473">
                  <c:v>1270.98438911108</c:v>
                </c:pt>
                <c:pt idx="5474">
                  <c:v>1271.2166172106799</c:v>
                </c:pt>
                <c:pt idx="5475">
                  <c:v>1271.4488453102799</c:v>
                </c:pt>
                <c:pt idx="5476">
                  <c:v>1271.6810734098799</c:v>
                </c:pt>
                <c:pt idx="5477">
                  <c:v>1271.9133015094801</c:v>
                </c:pt>
                <c:pt idx="5478">
                  <c:v>1272.1455296090801</c:v>
                </c:pt>
                <c:pt idx="5479">
                  <c:v>1272.3777577086801</c:v>
                </c:pt>
                <c:pt idx="5480">
                  <c:v>1272.60998580828</c:v>
                </c:pt>
                <c:pt idx="5481">
                  <c:v>1272.84221390788</c:v>
                </c:pt>
                <c:pt idx="5482">
                  <c:v>1273.07444200748</c:v>
                </c:pt>
                <c:pt idx="5483">
                  <c:v>1273.30667010708</c:v>
                </c:pt>
                <c:pt idx="5484">
                  <c:v>1273.53889820668</c:v>
                </c:pt>
                <c:pt idx="5485">
                  <c:v>1273.7711263062799</c:v>
                </c:pt>
                <c:pt idx="5486">
                  <c:v>1274.0033544058799</c:v>
                </c:pt>
                <c:pt idx="5487">
                  <c:v>1274.2355825054799</c:v>
                </c:pt>
                <c:pt idx="5488">
                  <c:v>1274.4678106050801</c:v>
                </c:pt>
                <c:pt idx="5489">
                  <c:v>1274.7000387046801</c:v>
                </c:pt>
                <c:pt idx="5490">
                  <c:v>1274.9322668042801</c:v>
                </c:pt>
                <c:pt idx="5491">
                  <c:v>1275.16449490388</c:v>
                </c:pt>
                <c:pt idx="5492">
                  <c:v>1275.39672300348</c:v>
                </c:pt>
                <c:pt idx="5493">
                  <c:v>1275.62895110308</c:v>
                </c:pt>
                <c:pt idx="5494">
                  <c:v>1275.86117920268</c:v>
                </c:pt>
                <c:pt idx="5495">
                  <c:v>1276.09340730228</c:v>
                </c:pt>
                <c:pt idx="5496">
                  <c:v>1276.3256354018799</c:v>
                </c:pt>
                <c:pt idx="5497">
                  <c:v>1276.5578635014799</c:v>
                </c:pt>
                <c:pt idx="5498">
                  <c:v>1276.7900916010799</c:v>
                </c:pt>
                <c:pt idx="5499">
                  <c:v>1277.0223197006801</c:v>
                </c:pt>
                <c:pt idx="5500">
                  <c:v>1277.2545478002801</c:v>
                </c:pt>
                <c:pt idx="5501">
                  <c:v>1277.4867758998801</c:v>
                </c:pt>
                <c:pt idx="5502">
                  <c:v>1277.71900399948</c:v>
                </c:pt>
                <c:pt idx="5503">
                  <c:v>1277.95123209908</c:v>
                </c:pt>
                <c:pt idx="5504">
                  <c:v>1278.18346019868</c:v>
                </c:pt>
                <c:pt idx="5505">
                  <c:v>1278.41568829828</c:v>
                </c:pt>
                <c:pt idx="5506">
                  <c:v>1278.64791639788</c:v>
                </c:pt>
                <c:pt idx="5507">
                  <c:v>1278.8801444974799</c:v>
                </c:pt>
                <c:pt idx="5508">
                  <c:v>1279.1123725970799</c:v>
                </c:pt>
                <c:pt idx="5509">
                  <c:v>1279.3446006966799</c:v>
                </c:pt>
                <c:pt idx="5510">
                  <c:v>1279.5768287962801</c:v>
                </c:pt>
                <c:pt idx="5511">
                  <c:v>1279.8090568958801</c:v>
                </c:pt>
                <c:pt idx="5512">
                  <c:v>1280.0412849954801</c:v>
                </c:pt>
                <c:pt idx="5513">
                  <c:v>1280.27351309508</c:v>
                </c:pt>
                <c:pt idx="5514">
                  <c:v>1280.50574119468</c:v>
                </c:pt>
                <c:pt idx="5515">
                  <c:v>1280.73796929428</c:v>
                </c:pt>
                <c:pt idx="5516">
                  <c:v>1280.97019739388</c:v>
                </c:pt>
                <c:pt idx="5517">
                  <c:v>1281.20242549348</c:v>
                </c:pt>
                <c:pt idx="5518">
                  <c:v>1281.4346535930799</c:v>
                </c:pt>
                <c:pt idx="5519">
                  <c:v>1281.6668816926799</c:v>
                </c:pt>
                <c:pt idx="5520">
                  <c:v>1281.8991097922799</c:v>
                </c:pt>
                <c:pt idx="5521">
                  <c:v>1282.1313378918801</c:v>
                </c:pt>
                <c:pt idx="5522">
                  <c:v>1282.3635659914901</c:v>
                </c:pt>
                <c:pt idx="5523">
                  <c:v>1282.5957940910901</c:v>
                </c:pt>
                <c:pt idx="5524">
                  <c:v>1282.82802219069</c:v>
                </c:pt>
                <c:pt idx="5525">
                  <c:v>1283.06025029029</c:v>
                </c:pt>
                <c:pt idx="5526">
                  <c:v>1283.29247838989</c:v>
                </c:pt>
                <c:pt idx="5527">
                  <c:v>1283.52470648949</c:v>
                </c:pt>
                <c:pt idx="5528">
                  <c:v>1283.75693458909</c:v>
                </c:pt>
                <c:pt idx="5529">
                  <c:v>1283.9891626886899</c:v>
                </c:pt>
                <c:pt idx="5530">
                  <c:v>1284.2213907882899</c:v>
                </c:pt>
                <c:pt idx="5531">
                  <c:v>1284.4536188878899</c:v>
                </c:pt>
                <c:pt idx="5532">
                  <c:v>1284.6858469874901</c:v>
                </c:pt>
                <c:pt idx="5533">
                  <c:v>1284.9180750870901</c:v>
                </c:pt>
                <c:pt idx="5534">
                  <c:v>1285.1503031866901</c:v>
                </c:pt>
                <c:pt idx="5535">
                  <c:v>1285.38253128629</c:v>
                </c:pt>
                <c:pt idx="5536">
                  <c:v>1285.61475938589</c:v>
                </c:pt>
                <c:pt idx="5537">
                  <c:v>1285.84698748549</c:v>
                </c:pt>
                <c:pt idx="5538">
                  <c:v>1286.07921558509</c:v>
                </c:pt>
                <c:pt idx="5539">
                  <c:v>1286.3114436846899</c:v>
                </c:pt>
                <c:pt idx="5540">
                  <c:v>1286.5436717842899</c:v>
                </c:pt>
                <c:pt idx="5541">
                  <c:v>1286.7758998838899</c:v>
                </c:pt>
                <c:pt idx="5542">
                  <c:v>1287.0081279834901</c:v>
                </c:pt>
                <c:pt idx="5543">
                  <c:v>1287.2403560830901</c:v>
                </c:pt>
                <c:pt idx="5544">
                  <c:v>1287.4725841826901</c:v>
                </c:pt>
                <c:pt idx="5545">
                  <c:v>1287.70481228229</c:v>
                </c:pt>
                <c:pt idx="5546">
                  <c:v>1287.93704038189</c:v>
                </c:pt>
                <c:pt idx="5547">
                  <c:v>1288.16926848149</c:v>
                </c:pt>
                <c:pt idx="5548">
                  <c:v>1288.40149658109</c:v>
                </c:pt>
                <c:pt idx="5549">
                  <c:v>1288.63372468069</c:v>
                </c:pt>
                <c:pt idx="5550">
                  <c:v>1288.8659527802899</c:v>
                </c:pt>
                <c:pt idx="5551">
                  <c:v>1289.0981808798899</c:v>
                </c:pt>
                <c:pt idx="5552">
                  <c:v>1289.3304089794899</c:v>
                </c:pt>
                <c:pt idx="5553">
                  <c:v>1289.5626370790901</c:v>
                </c:pt>
                <c:pt idx="5554">
                  <c:v>1289.7948651786901</c:v>
                </c:pt>
                <c:pt idx="5555">
                  <c:v>1290.0270932782901</c:v>
                </c:pt>
                <c:pt idx="5556">
                  <c:v>1290.25932137789</c:v>
                </c:pt>
                <c:pt idx="5557">
                  <c:v>1290.49154947749</c:v>
                </c:pt>
                <c:pt idx="5558">
                  <c:v>1290.72377757709</c:v>
                </c:pt>
                <c:pt idx="5559">
                  <c:v>1290.95600567669</c:v>
                </c:pt>
                <c:pt idx="5560">
                  <c:v>1291.18823377629</c:v>
                </c:pt>
                <c:pt idx="5561">
                  <c:v>1291.4204618758899</c:v>
                </c:pt>
                <c:pt idx="5562">
                  <c:v>1291.6526899754899</c:v>
                </c:pt>
                <c:pt idx="5563">
                  <c:v>1291.8849180750899</c:v>
                </c:pt>
                <c:pt idx="5564">
                  <c:v>1292.1171461746901</c:v>
                </c:pt>
                <c:pt idx="5565">
                  <c:v>1292.3493742742901</c:v>
                </c:pt>
                <c:pt idx="5566">
                  <c:v>1292.5816023738901</c:v>
                </c:pt>
                <c:pt idx="5567">
                  <c:v>1292.81383047349</c:v>
                </c:pt>
                <c:pt idx="5568">
                  <c:v>1293.04605857309</c:v>
                </c:pt>
                <c:pt idx="5569">
                  <c:v>1293.27828667269</c:v>
                </c:pt>
                <c:pt idx="5570">
                  <c:v>1293.51051477229</c:v>
                </c:pt>
                <c:pt idx="5571">
                  <c:v>1293.74274287189</c:v>
                </c:pt>
                <c:pt idx="5572">
                  <c:v>1293.9749709714899</c:v>
                </c:pt>
                <c:pt idx="5573">
                  <c:v>1294.2071990710899</c:v>
                </c:pt>
                <c:pt idx="5574">
                  <c:v>1294.4394271706899</c:v>
                </c:pt>
                <c:pt idx="5575">
                  <c:v>1294.6716552702901</c:v>
                </c:pt>
                <c:pt idx="5576">
                  <c:v>1294.9038833698901</c:v>
                </c:pt>
                <c:pt idx="5577">
                  <c:v>1295.1361114694901</c:v>
                </c:pt>
                <c:pt idx="5578">
                  <c:v>1295.36833956909</c:v>
                </c:pt>
                <c:pt idx="5579">
                  <c:v>1295.60056766869</c:v>
                </c:pt>
                <c:pt idx="5580">
                  <c:v>1295.83279576829</c:v>
                </c:pt>
                <c:pt idx="5581">
                  <c:v>1296.06502386789</c:v>
                </c:pt>
                <c:pt idx="5582">
                  <c:v>1296.29725196749</c:v>
                </c:pt>
                <c:pt idx="5583">
                  <c:v>1296.5294800670899</c:v>
                </c:pt>
                <c:pt idx="5584">
                  <c:v>1296.7617081666899</c:v>
                </c:pt>
                <c:pt idx="5585">
                  <c:v>1296.9939362662899</c:v>
                </c:pt>
                <c:pt idx="5586">
                  <c:v>1297.2261643658901</c:v>
                </c:pt>
                <c:pt idx="5587">
                  <c:v>1297.4583924654901</c:v>
                </c:pt>
                <c:pt idx="5588">
                  <c:v>1297.6906205650901</c:v>
                </c:pt>
                <c:pt idx="5589">
                  <c:v>1297.92284866469</c:v>
                </c:pt>
                <c:pt idx="5590">
                  <c:v>1298.15507676429</c:v>
                </c:pt>
                <c:pt idx="5591">
                  <c:v>1298.38730486389</c:v>
                </c:pt>
                <c:pt idx="5592">
                  <c:v>1298.61953296349</c:v>
                </c:pt>
                <c:pt idx="5593">
                  <c:v>1298.85176106309</c:v>
                </c:pt>
                <c:pt idx="5594">
                  <c:v>1299.0839891626899</c:v>
                </c:pt>
                <c:pt idx="5595">
                  <c:v>1299.3162172622899</c:v>
                </c:pt>
                <c:pt idx="5596">
                  <c:v>1299.5484453618899</c:v>
                </c:pt>
                <c:pt idx="5597">
                  <c:v>1299.7806734614901</c:v>
                </c:pt>
                <c:pt idx="5598">
                  <c:v>1300.0129015610901</c:v>
                </c:pt>
                <c:pt idx="5599">
                  <c:v>1300.2451296606901</c:v>
                </c:pt>
                <c:pt idx="5600">
                  <c:v>1300.47735776029</c:v>
                </c:pt>
                <c:pt idx="5601">
                  <c:v>1300.70958585989</c:v>
                </c:pt>
                <c:pt idx="5602">
                  <c:v>1300.94181395949</c:v>
                </c:pt>
                <c:pt idx="5603">
                  <c:v>1301.17404205909</c:v>
                </c:pt>
                <c:pt idx="5604">
                  <c:v>1301.4062701586899</c:v>
                </c:pt>
                <c:pt idx="5605">
                  <c:v>1301.6384982582899</c:v>
                </c:pt>
                <c:pt idx="5606">
                  <c:v>1301.8707263578899</c:v>
                </c:pt>
                <c:pt idx="5607">
                  <c:v>1302.1029544574899</c:v>
                </c:pt>
                <c:pt idx="5608">
                  <c:v>1302.3351825570901</c:v>
                </c:pt>
                <c:pt idx="5609">
                  <c:v>1302.5674106566901</c:v>
                </c:pt>
                <c:pt idx="5610">
                  <c:v>1302.7996387562901</c:v>
                </c:pt>
                <c:pt idx="5611">
                  <c:v>1303.03186685589</c:v>
                </c:pt>
                <c:pt idx="5612">
                  <c:v>1303.26409495549</c:v>
                </c:pt>
                <c:pt idx="5613">
                  <c:v>1303.49632305509</c:v>
                </c:pt>
                <c:pt idx="5614">
                  <c:v>1303.72855115469</c:v>
                </c:pt>
                <c:pt idx="5615">
                  <c:v>1303.9607792542899</c:v>
                </c:pt>
                <c:pt idx="5616">
                  <c:v>1304.1930073538899</c:v>
                </c:pt>
                <c:pt idx="5617">
                  <c:v>1304.4252354534899</c:v>
                </c:pt>
                <c:pt idx="5618">
                  <c:v>1304.6574635530901</c:v>
                </c:pt>
                <c:pt idx="5619">
                  <c:v>1304.8896916526901</c:v>
                </c:pt>
                <c:pt idx="5620">
                  <c:v>1305.1219197522901</c:v>
                </c:pt>
                <c:pt idx="5621">
                  <c:v>1305.35414785189</c:v>
                </c:pt>
                <c:pt idx="5622">
                  <c:v>1305.58637595149</c:v>
                </c:pt>
                <c:pt idx="5623">
                  <c:v>1305.81860405109</c:v>
                </c:pt>
                <c:pt idx="5624">
                  <c:v>1306.05083215069</c:v>
                </c:pt>
                <c:pt idx="5625">
                  <c:v>1306.28306025029</c:v>
                </c:pt>
                <c:pt idx="5626">
                  <c:v>1306.5152883498899</c:v>
                </c:pt>
                <c:pt idx="5627">
                  <c:v>1306.7475164494899</c:v>
                </c:pt>
                <c:pt idx="5628">
                  <c:v>1306.9797445490899</c:v>
                </c:pt>
                <c:pt idx="5629">
                  <c:v>1307.2119726486901</c:v>
                </c:pt>
                <c:pt idx="5630">
                  <c:v>1307.4442007482901</c:v>
                </c:pt>
                <c:pt idx="5631">
                  <c:v>1307.6764288478901</c:v>
                </c:pt>
                <c:pt idx="5632">
                  <c:v>1307.90865694749</c:v>
                </c:pt>
                <c:pt idx="5633">
                  <c:v>1308.14088504709</c:v>
                </c:pt>
                <c:pt idx="5634">
                  <c:v>1308.37311314669</c:v>
                </c:pt>
                <c:pt idx="5635">
                  <c:v>1308.60534124629</c:v>
                </c:pt>
                <c:pt idx="5636">
                  <c:v>1308.83756934589</c:v>
                </c:pt>
                <c:pt idx="5637">
                  <c:v>1309.0697974454899</c:v>
                </c:pt>
                <c:pt idx="5638">
                  <c:v>1309.3020255450899</c:v>
                </c:pt>
                <c:pt idx="5639">
                  <c:v>1309.5342536446899</c:v>
                </c:pt>
                <c:pt idx="5640">
                  <c:v>1309.7664817442901</c:v>
                </c:pt>
                <c:pt idx="5641">
                  <c:v>1309.9987098438901</c:v>
                </c:pt>
                <c:pt idx="5642">
                  <c:v>1310.2309379434901</c:v>
                </c:pt>
                <c:pt idx="5643">
                  <c:v>1310.46316604309</c:v>
                </c:pt>
                <c:pt idx="5644">
                  <c:v>1310.69539414269</c:v>
                </c:pt>
                <c:pt idx="5645">
                  <c:v>1310.92762224229</c:v>
                </c:pt>
                <c:pt idx="5646">
                  <c:v>1311.15985034189</c:v>
                </c:pt>
                <c:pt idx="5647">
                  <c:v>1311.39207844149</c:v>
                </c:pt>
                <c:pt idx="5648">
                  <c:v>1311.6243065410899</c:v>
                </c:pt>
                <c:pt idx="5649">
                  <c:v>1311.8565346406899</c:v>
                </c:pt>
                <c:pt idx="5650">
                  <c:v>1312.0887627402899</c:v>
                </c:pt>
                <c:pt idx="5651">
                  <c:v>1312.3209908398901</c:v>
                </c:pt>
                <c:pt idx="5652">
                  <c:v>1312.5532189394901</c:v>
                </c:pt>
                <c:pt idx="5653">
                  <c:v>1312.7854470390901</c:v>
                </c:pt>
                <c:pt idx="5654">
                  <c:v>1313.01767513869</c:v>
                </c:pt>
                <c:pt idx="5655">
                  <c:v>1313.24990323829</c:v>
                </c:pt>
                <c:pt idx="5656">
                  <c:v>1313.48213133789</c:v>
                </c:pt>
                <c:pt idx="5657">
                  <c:v>1313.71435943749</c:v>
                </c:pt>
                <c:pt idx="5658">
                  <c:v>1313.94658753709</c:v>
                </c:pt>
                <c:pt idx="5659">
                  <c:v>1314.1788156366899</c:v>
                </c:pt>
                <c:pt idx="5660">
                  <c:v>1314.4110437362899</c:v>
                </c:pt>
                <c:pt idx="5661">
                  <c:v>1314.6432718358899</c:v>
                </c:pt>
                <c:pt idx="5662">
                  <c:v>1314.8754999354901</c:v>
                </c:pt>
                <c:pt idx="5663">
                  <c:v>1315.1077280350901</c:v>
                </c:pt>
                <c:pt idx="5664">
                  <c:v>1315.3399561346901</c:v>
                </c:pt>
                <c:pt idx="5665">
                  <c:v>1315.57218423429</c:v>
                </c:pt>
                <c:pt idx="5666">
                  <c:v>1315.80441233389</c:v>
                </c:pt>
                <c:pt idx="5667">
                  <c:v>1316.03664043349</c:v>
                </c:pt>
                <c:pt idx="5668">
                  <c:v>1316.26886853309</c:v>
                </c:pt>
                <c:pt idx="5669">
                  <c:v>1316.50109663269</c:v>
                </c:pt>
                <c:pt idx="5670">
                  <c:v>1316.7333247322899</c:v>
                </c:pt>
                <c:pt idx="5671">
                  <c:v>1316.9655528318899</c:v>
                </c:pt>
                <c:pt idx="5672">
                  <c:v>1317.1977809314899</c:v>
                </c:pt>
                <c:pt idx="5673">
                  <c:v>1317.4300090310901</c:v>
                </c:pt>
                <c:pt idx="5674">
                  <c:v>1317.6622371306901</c:v>
                </c:pt>
                <c:pt idx="5675">
                  <c:v>1317.8944652302901</c:v>
                </c:pt>
                <c:pt idx="5676">
                  <c:v>1318.12669332989</c:v>
                </c:pt>
                <c:pt idx="5677">
                  <c:v>1318.35892142949</c:v>
                </c:pt>
                <c:pt idx="5678">
                  <c:v>1318.59114952909</c:v>
                </c:pt>
                <c:pt idx="5679">
                  <c:v>1318.82337762869</c:v>
                </c:pt>
                <c:pt idx="5680">
                  <c:v>1319.0556057282899</c:v>
                </c:pt>
                <c:pt idx="5681">
                  <c:v>1319.2878338278899</c:v>
                </c:pt>
                <c:pt idx="5682">
                  <c:v>1319.5200619274899</c:v>
                </c:pt>
                <c:pt idx="5683">
                  <c:v>1319.7522900270901</c:v>
                </c:pt>
                <c:pt idx="5684">
                  <c:v>1319.9845181266901</c:v>
                </c:pt>
                <c:pt idx="5685">
                  <c:v>1320.2167462262901</c:v>
                </c:pt>
                <c:pt idx="5686">
                  <c:v>1320.44897432589</c:v>
                </c:pt>
                <c:pt idx="5687">
                  <c:v>1320.68120242549</c:v>
                </c:pt>
                <c:pt idx="5688">
                  <c:v>1320.91343052509</c:v>
                </c:pt>
                <c:pt idx="5689">
                  <c:v>1321.14565862469</c:v>
                </c:pt>
                <c:pt idx="5690">
                  <c:v>1321.37788672429</c:v>
                </c:pt>
                <c:pt idx="5691">
                  <c:v>1321.6101148238899</c:v>
                </c:pt>
                <c:pt idx="5692">
                  <c:v>1321.8423429234899</c:v>
                </c:pt>
                <c:pt idx="5693">
                  <c:v>1322.0745710230899</c:v>
                </c:pt>
                <c:pt idx="5694">
                  <c:v>1322.3067991226901</c:v>
                </c:pt>
                <c:pt idx="5695">
                  <c:v>1322.5390272222901</c:v>
                </c:pt>
                <c:pt idx="5696">
                  <c:v>1322.7712553218901</c:v>
                </c:pt>
                <c:pt idx="5697">
                  <c:v>1323.00348342149</c:v>
                </c:pt>
                <c:pt idx="5698">
                  <c:v>1323.23571152109</c:v>
                </c:pt>
                <c:pt idx="5699">
                  <c:v>1323.46793962069</c:v>
                </c:pt>
                <c:pt idx="5700">
                  <c:v>1323.70016772029</c:v>
                </c:pt>
                <c:pt idx="5701">
                  <c:v>1323.93239581989</c:v>
                </c:pt>
                <c:pt idx="5702">
                  <c:v>1324.1646239194899</c:v>
                </c:pt>
                <c:pt idx="5703">
                  <c:v>1324.3968520190899</c:v>
                </c:pt>
                <c:pt idx="5704">
                  <c:v>1324.6290801186899</c:v>
                </c:pt>
                <c:pt idx="5705">
                  <c:v>1324.8613082182901</c:v>
                </c:pt>
                <c:pt idx="5706">
                  <c:v>1325.0935363178901</c:v>
                </c:pt>
                <c:pt idx="5707">
                  <c:v>1325.3257644174901</c:v>
                </c:pt>
                <c:pt idx="5708">
                  <c:v>1325.55799251709</c:v>
                </c:pt>
                <c:pt idx="5709">
                  <c:v>1325.79022061669</c:v>
                </c:pt>
                <c:pt idx="5710">
                  <c:v>1326.02244871629</c:v>
                </c:pt>
                <c:pt idx="5711">
                  <c:v>1326.25467681589</c:v>
                </c:pt>
                <c:pt idx="5712">
                  <c:v>1326.48690491549</c:v>
                </c:pt>
                <c:pt idx="5713">
                  <c:v>1326.7191330150899</c:v>
                </c:pt>
                <c:pt idx="5714">
                  <c:v>1326.9513611146899</c:v>
                </c:pt>
                <c:pt idx="5715">
                  <c:v>1327.1835892142899</c:v>
                </c:pt>
                <c:pt idx="5716">
                  <c:v>1327.4158173139001</c:v>
                </c:pt>
                <c:pt idx="5717">
                  <c:v>1327.6480454135001</c:v>
                </c:pt>
                <c:pt idx="5718">
                  <c:v>1327.8802735131001</c:v>
                </c:pt>
                <c:pt idx="5719">
                  <c:v>1328.1125016127</c:v>
                </c:pt>
                <c:pt idx="5720">
                  <c:v>1328.3447297123</c:v>
                </c:pt>
                <c:pt idx="5721">
                  <c:v>1328.5769578119</c:v>
                </c:pt>
                <c:pt idx="5722">
                  <c:v>1328.8091859115</c:v>
                </c:pt>
                <c:pt idx="5723">
                  <c:v>1329.0414140111</c:v>
                </c:pt>
                <c:pt idx="5724">
                  <c:v>1329.2736421106999</c:v>
                </c:pt>
                <c:pt idx="5725">
                  <c:v>1329.5058702102999</c:v>
                </c:pt>
                <c:pt idx="5726">
                  <c:v>1329.7380983098999</c:v>
                </c:pt>
                <c:pt idx="5727">
                  <c:v>1329.9703264095001</c:v>
                </c:pt>
                <c:pt idx="5728">
                  <c:v>1330.2025545091001</c:v>
                </c:pt>
                <c:pt idx="5729">
                  <c:v>1330.4347826087001</c:v>
                </c:pt>
                <c:pt idx="5730">
                  <c:v>1330.6670107083</c:v>
                </c:pt>
                <c:pt idx="5731">
                  <c:v>1330.8992388079</c:v>
                </c:pt>
                <c:pt idx="5732">
                  <c:v>1331.1314669075</c:v>
                </c:pt>
                <c:pt idx="5733">
                  <c:v>1331.3636950071</c:v>
                </c:pt>
                <c:pt idx="5734">
                  <c:v>1331.5959231067</c:v>
                </c:pt>
                <c:pt idx="5735">
                  <c:v>1331.8281512062999</c:v>
                </c:pt>
                <c:pt idx="5736">
                  <c:v>1332.0603793058999</c:v>
                </c:pt>
                <c:pt idx="5737">
                  <c:v>1332.2926074054999</c:v>
                </c:pt>
                <c:pt idx="5738">
                  <c:v>1332.5248355051001</c:v>
                </c:pt>
                <c:pt idx="5739">
                  <c:v>1332.7570636047001</c:v>
                </c:pt>
                <c:pt idx="5740">
                  <c:v>1332.9892917043001</c:v>
                </c:pt>
                <c:pt idx="5741">
                  <c:v>1333.2215198039</c:v>
                </c:pt>
                <c:pt idx="5742">
                  <c:v>1333.4537479035</c:v>
                </c:pt>
                <c:pt idx="5743">
                  <c:v>1333.6859760031</c:v>
                </c:pt>
                <c:pt idx="5744">
                  <c:v>1333.9182041027</c:v>
                </c:pt>
                <c:pt idx="5745">
                  <c:v>1334.1504322023</c:v>
                </c:pt>
                <c:pt idx="5746">
                  <c:v>1334.3826603018999</c:v>
                </c:pt>
                <c:pt idx="5747">
                  <c:v>1334.6148884014999</c:v>
                </c:pt>
                <c:pt idx="5748">
                  <c:v>1334.8471165010999</c:v>
                </c:pt>
                <c:pt idx="5749">
                  <c:v>1335.0793446007001</c:v>
                </c:pt>
                <c:pt idx="5750">
                  <c:v>1335.3115727003001</c:v>
                </c:pt>
                <c:pt idx="5751">
                  <c:v>1335.5438007999001</c:v>
                </c:pt>
                <c:pt idx="5752">
                  <c:v>1335.7760288995</c:v>
                </c:pt>
                <c:pt idx="5753">
                  <c:v>1336.0082569991</c:v>
                </c:pt>
                <c:pt idx="5754">
                  <c:v>1336.2404850987</c:v>
                </c:pt>
                <c:pt idx="5755">
                  <c:v>1336.4727131983</c:v>
                </c:pt>
                <c:pt idx="5756">
                  <c:v>1336.7049412978999</c:v>
                </c:pt>
                <c:pt idx="5757">
                  <c:v>1336.9371693974999</c:v>
                </c:pt>
                <c:pt idx="5758">
                  <c:v>1337.1693974970999</c:v>
                </c:pt>
                <c:pt idx="5759">
                  <c:v>1337.4016255966999</c:v>
                </c:pt>
                <c:pt idx="5760">
                  <c:v>1337.6338536963001</c:v>
                </c:pt>
                <c:pt idx="5761">
                  <c:v>1337.8660817959001</c:v>
                </c:pt>
                <c:pt idx="5762">
                  <c:v>1338.0983098955001</c:v>
                </c:pt>
                <c:pt idx="5763">
                  <c:v>1338.3305379951</c:v>
                </c:pt>
                <c:pt idx="5764">
                  <c:v>1338.5627660947</c:v>
                </c:pt>
                <c:pt idx="5765">
                  <c:v>1338.7949941943</c:v>
                </c:pt>
                <c:pt idx="5766">
                  <c:v>1339.0272222939</c:v>
                </c:pt>
                <c:pt idx="5767">
                  <c:v>1339.2594503934999</c:v>
                </c:pt>
                <c:pt idx="5768">
                  <c:v>1339.4916784930999</c:v>
                </c:pt>
                <c:pt idx="5769">
                  <c:v>1339.7239065926999</c:v>
                </c:pt>
                <c:pt idx="5770">
                  <c:v>1339.9561346923001</c:v>
                </c:pt>
                <c:pt idx="5771">
                  <c:v>1340.1883627919001</c:v>
                </c:pt>
                <c:pt idx="5772">
                  <c:v>1340.4205908915001</c:v>
                </c:pt>
                <c:pt idx="5773">
                  <c:v>1340.6528189911</c:v>
                </c:pt>
                <c:pt idx="5774">
                  <c:v>1340.8850470907</c:v>
                </c:pt>
                <c:pt idx="5775">
                  <c:v>1341.1172751903</c:v>
                </c:pt>
                <c:pt idx="5776">
                  <c:v>1341.3495032899</c:v>
                </c:pt>
                <c:pt idx="5777">
                  <c:v>1341.5817313895</c:v>
                </c:pt>
                <c:pt idx="5778">
                  <c:v>1341.8139594890999</c:v>
                </c:pt>
                <c:pt idx="5779">
                  <c:v>1342.0461875886999</c:v>
                </c:pt>
                <c:pt idx="5780">
                  <c:v>1342.2784156882999</c:v>
                </c:pt>
                <c:pt idx="5781">
                  <c:v>1342.5106437879001</c:v>
                </c:pt>
                <c:pt idx="5782">
                  <c:v>1342.7428718875001</c:v>
                </c:pt>
                <c:pt idx="5783">
                  <c:v>1342.9750999871001</c:v>
                </c:pt>
                <c:pt idx="5784">
                  <c:v>1343.2073280867</c:v>
                </c:pt>
                <c:pt idx="5785">
                  <c:v>1343.4395561863</c:v>
                </c:pt>
                <c:pt idx="5786">
                  <c:v>1343.6717842859</c:v>
                </c:pt>
                <c:pt idx="5787">
                  <c:v>1343.9040123855</c:v>
                </c:pt>
                <c:pt idx="5788">
                  <c:v>1344.1362404851</c:v>
                </c:pt>
                <c:pt idx="5789">
                  <c:v>1344.3684685846999</c:v>
                </c:pt>
                <c:pt idx="5790">
                  <c:v>1344.6006966842999</c:v>
                </c:pt>
                <c:pt idx="5791">
                  <c:v>1344.8329247838999</c:v>
                </c:pt>
                <c:pt idx="5792">
                  <c:v>1345.0651528835001</c:v>
                </c:pt>
                <c:pt idx="5793">
                  <c:v>1345.2973809831001</c:v>
                </c:pt>
                <c:pt idx="5794">
                  <c:v>1345.5296090827001</c:v>
                </c:pt>
                <c:pt idx="5795">
                  <c:v>1345.7618371823</c:v>
                </c:pt>
                <c:pt idx="5796">
                  <c:v>1345.9940652819</c:v>
                </c:pt>
                <c:pt idx="5797">
                  <c:v>1346.2262933815</c:v>
                </c:pt>
                <c:pt idx="5798">
                  <c:v>1346.4585214811</c:v>
                </c:pt>
                <c:pt idx="5799">
                  <c:v>1346.6907495807</c:v>
                </c:pt>
                <c:pt idx="5800">
                  <c:v>1346.9229776802999</c:v>
                </c:pt>
                <c:pt idx="5801">
                  <c:v>1347.1552057798999</c:v>
                </c:pt>
                <c:pt idx="5802">
                  <c:v>1347.3874338794999</c:v>
                </c:pt>
                <c:pt idx="5803">
                  <c:v>1347.6196619791001</c:v>
                </c:pt>
                <c:pt idx="5804">
                  <c:v>1347.8518900787001</c:v>
                </c:pt>
                <c:pt idx="5805">
                  <c:v>1348.0841181783001</c:v>
                </c:pt>
                <c:pt idx="5806">
                  <c:v>1348.3163462779</c:v>
                </c:pt>
                <c:pt idx="5807">
                  <c:v>1348.5485743775</c:v>
                </c:pt>
                <c:pt idx="5808">
                  <c:v>1348.7808024771</c:v>
                </c:pt>
                <c:pt idx="5809">
                  <c:v>1349.0130305767</c:v>
                </c:pt>
                <c:pt idx="5810">
                  <c:v>1349.2452586763</c:v>
                </c:pt>
                <c:pt idx="5811">
                  <c:v>1349.4774867758999</c:v>
                </c:pt>
                <c:pt idx="5812">
                  <c:v>1349.7097148754999</c:v>
                </c:pt>
                <c:pt idx="5813">
                  <c:v>1349.9419429750999</c:v>
                </c:pt>
                <c:pt idx="5814">
                  <c:v>1350.1741710747001</c:v>
                </c:pt>
                <c:pt idx="5815">
                  <c:v>1350.4063991743001</c:v>
                </c:pt>
                <c:pt idx="5816">
                  <c:v>1350.6386272739001</c:v>
                </c:pt>
                <c:pt idx="5817">
                  <c:v>1350.8708553735</c:v>
                </c:pt>
                <c:pt idx="5818">
                  <c:v>1351.1030834731</c:v>
                </c:pt>
                <c:pt idx="5819">
                  <c:v>1351.3353115727</c:v>
                </c:pt>
                <c:pt idx="5820">
                  <c:v>1351.5675396723</c:v>
                </c:pt>
                <c:pt idx="5821">
                  <c:v>1351.7997677719</c:v>
                </c:pt>
                <c:pt idx="5822">
                  <c:v>1352.0319958714999</c:v>
                </c:pt>
                <c:pt idx="5823">
                  <c:v>1352.2642239710999</c:v>
                </c:pt>
                <c:pt idx="5824">
                  <c:v>1352.4964520706999</c:v>
                </c:pt>
                <c:pt idx="5825">
                  <c:v>1352.7286801703001</c:v>
                </c:pt>
                <c:pt idx="5826">
                  <c:v>1352.9609082699001</c:v>
                </c:pt>
                <c:pt idx="5827">
                  <c:v>1353.1931363695001</c:v>
                </c:pt>
                <c:pt idx="5828">
                  <c:v>1353.4253644691</c:v>
                </c:pt>
                <c:pt idx="5829">
                  <c:v>1353.6575925687</c:v>
                </c:pt>
                <c:pt idx="5830">
                  <c:v>1353.8898206683</c:v>
                </c:pt>
                <c:pt idx="5831">
                  <c:v>1354.1220487679</c:v>
                </c:pt>
                <c:pt idx="5832">
                  <c:v>1354.3542768674999</c:v>
                </c:pt>
                <c:pt idx="5833">
                  <c:v>1354.5865049670999</c:v>
                </c:pt>
                <c:pt idx="5834">
                  <c:v>1354.8187330666999</c:v>
                </c:pt>
                <c:pt idx="5835">
                  <c:v>1355.0509611663001</c:v>
                </c:pt>
                <c:pt idx="5836">
                  <c:v>1355.2831892659001</c:v>
                </c:pt>
                <c:pt idx="5837">
                  <c:v>1355.5154173655001</c:v>
                </c:pt>
                <c:pt idx="5838">
                  <c:v>1355.7476454651</c:v>
                </c:pt>
                <c:pt idx="5839">
                  <c:v>1355.9798735647</c:v>
                </c:pt>
                <c:pt idx="5840">
                  <c:v>1356.2121016643</c:v>
                </c:pt>
                <c:pt idx="5841">
                  <c:v>1356.4443297639</c:v>
                </c:pt>
                <c:pt idx="5842">
                  <c:v>1356.6765578635</c:v>
                </c:pt>
                <c:pt idx="5843">
                  <c:v>1356.9087859630999</c:v>
                </c:pt>
                <c:pt idx="5844">
                  <c:v>1357.1410140626999</c:v>
                </c:pt>
                <c:pt idx="5845">
                  <c:v>1357.3732421622999</c:v>
                </c:pt>
                <c:pt idx="5846">
                  <c:v>1357.6054702619001</c:v>
                </c:pt>
                <c:pt idx="5847">
                  <c:v>1357.8376983615001</c:v>
                </c:pt>
                <c:pt idx="5848">
                  <c:v>1358.0699264611001</c:v>
                </c:pt>
                <c:pt idx="5849">
                  <c:v>1358.3021545607</c:v>
                </c:pt>
                <c:pt idx="5850">
                  <c:v>1358.5343826603</c:v>
                </c:pt>
                <c:pt idx="5851">
                  <c:v>1358.7666107599</c:v>
                </c:pt>
                <c:pt idx="5852">
                  <c:v>1358.9988388595</c:v>
                </c:pt>
                <c:pt idx="5853">
                  <c:v>1359.2310669591</c:v>
                </c:pt>
                <c:pt idx="5854">
                  <c:v>1359.4632950586999</c:v>
                </c:pt>
                <c:pt idx="5855">
                  <c:v>1359.6955231582999</c:v>
                </c:pt>
                <c:pt idx="5856">
                  <c:v>1359.9277512578999</c:v>
                </c:pt>
                <c:pt idx="5857">
                  <c:v>1360.1599793575001</c:v>
                </c:pt>
                <c:pt idx="5858">
                  <c:v>1360.3922074571001</c:v>
                </c:pt>
                <c:pt idx="5859">
                  <c:v>1360.6244355567001</c:v>
                </c:pt>
                <c:pt idx="5860">
                  <c:v>1360.8566636563</c:v>
                </c:pt>
                <c:pt idx="5861">
                  <c:v>1361.0888917559</c:v>
                </c:pt>
                <c:pt idx="5862">
                  <c:v>1361.3211198555</c:v>
                </c:pt>
                <c:pt idx="5863">
                  <c:v>1361.5533479551</c:v>
                </c:pt>
                <c:pt idx="5864">
                  <c:v>1361.7855760547</c:v>
                </c:pt>
                <c:pt idx="5865">
                  <c:v>1362.0178041542999</c:v>
                </c:pt>
                <c:pt idx="5866">
                  <c:v>1362.2500322538999</c:v>
                </c:pt>
                <c:pt idx="5867">
                  <c:v>1362.4822603534999</c:v>
                </c:pt>
                <c:pt idx="5868">
                  <c:v>1362.7144884531001</c:v>
                </c:pt>
                <c:pt idx="5869">
                  <c:v>1362.9467165527001</c:v>
                </c:pt>
                <c:pt idx="5870">
                  <c:v>1363.1789446523001</c:v>
                </c:pt>
                <c:pt idx="5871">
                  <c:v>1363.4111727519</c:v>
                </c:pt>
                <c:pt idx="5872">
                  <c:v>1363.6434008515</c:v>
                </c:pt>
                <c:pt idx="5873">
                  <c:v>1363.8756289511</c:v>
                </c:pt>
                <c:pt idx="5874">
                  <c:v>1364.1078570507</c:v>
                </c:pt>
                <c:pt idx="5875">
                  <c:v>1364.3400851503</c:v>
                </c:pt>
                <c:pt idx="5876">
                  <c:v>1364.5723132498999</c:v>
                </c:pt>
                <c:pt idx="5877">
                  <c:v>1364.8045413494999</c:v>
                </c:pt>
                <c:pt idx="5878">
                  <c:v>1365.0367694490999</c:v>
                </c:pt>
                <c:pt idx="5879">
                  <c:v>1365.2689975487001</c:v>
                </c:pt>
                <c:pt idx="5880">
                  <c:v>1365.5012256483001</c:v>
                </c:pt>
                <c:pt idx="5881">
                  <c:v>1365.7334537479001</c:v>
                </c:pt>
                <c:pt idx="5882">
                  <c:v>1365.9656818475</c:v>
                </c:pt>
                <c:pt idx="5883">
                  <c:v>1366.1979099471</c:v>
                </c:pt>
                <c:pt idx="5884">
                  <c:v>1366.4301380467</c:v>
                </c:pt>
                <c:pt idx="5885">
                  <c:v>1366.6623661463</c:v>
                </c:pt>
                <c:pt idx="5886">
                  <c:v>1366.8945942459</c:v>
                </c:pt>
                <c:pt idx="5887">
                  <c:v>1367.1268223454999</c:v>
                </c:pt>
                <c:pt idx="5888">
                  <c:v>1367.3590504450999</c:v>
                </c:pt>
                <c:pt idx="5889">
                  <c:v>1367.5912785446999</c:v>
                </c:pt>
                <c:pt idx="5890">
                  <c:v>1367.8235066443001</c:v>
                </c:pt>
                <c:pt idx="5891">
                  <c:v>1368.0557347439001</c:v>
                </c:pt>
                <c:pt idx="5892">
                  <c:v>1368.2879628435001</c:v>
                </c:pt>
                <c:pt idx="5893">
                  <c:v>1368.5201909431</c:v>
                </c:pt>
                <c:pt idx="5894">
                  <c:v>1368.7524190427</c:v>
                </c:pt>
                <c:pt idx="5895">
                  <c:v>1368.9846471423</c:v>
                </c:pt>
                <c:pt idx="5896">
                  <c:v>1369.2168752419</c:v>
                </c:pt>
                <c:pt idx="5897">
                  <c:v>1369.4491033414999</c:v>
                </c:pt>
                <c:pt idx="5898">
                  <c:v>1369.6813314410999</c:v>
                </c:pt>
                <c:pt idx="5899">
                  <c:v>1369.9135595406999</c:v>
                </c:pt>
                <c:pt idx="5900">
                  <c:v>1370.1457876403001</c:v>
                </c:pt>
                <c:pt idx="5901">
                  <c:v>1370.3780157399001</c:v>
                </c:pt>
                <c:pt idx="5902">
                  <c:v>1370.6102438395001</c:v>
                </c:pt>
                <c:pt idx="5903">
                  <c:v>1370.8424719391001</c:v>
                </c:pt>
                <c:pt idx="5904">
                  <c:v>1371.0747000387</c:v>
                </c:pt>
                <c:pt idx="5905">
                  <c:v>1371.3069281383</c:v>
                </c:pt>
                <c:pt idx="5906">
                  <c:v>1371.5391562379</c:v>
                </c:pt>
                <c:pt idx="5907">
                  <c:v>1371.7713843375</c:v>
                </c:pt>
                <c:pt idx="5908">
                  <c:v>1372.0036124370999</c:v>
                </c:pt>
                <c:pt idx="5909">
                  <c:v>1372.2358405366999</c:v>
                </c:pt>
                <c:pt idx="5910">
                  <c:v>1372.4680686363099</c:v>
                </c:pt>
                <c:pt idx="5911">
                  <c:v>1372.7002967359099</c:v>
                </c:pt>
                <c:pt idx="5912">
                  <c:v>1372.9325248355101</c:v>
                </c:pt>
                <c:pt idx="5913">
                  <c:v>1373.1647529351101</c:v>
                </c:pt>
                <c:pt idx="5914">
                  <c:v>1373.3969810347101</c:v>
                </c:pt>
                <c:pt idx="5915">
                  <c:v>1373.62920913431</c:v>
                </c:pt>
                <c:pt idx="5916">
                  <c:v>1373.86143723391</c:v>
                </c:pt>
                <c:pt idx="5917">
                  <c:v>1374.09366533351</c:v>
                </c:pt>
                <c:pt idx="5918">
                  <c:v>1374.32589343311</c:v>
                </c:pt>
                <c:pt idx="5919">
                  <c:v>1374.5581215327099</c:v>
                </c:pt>
                <c:pt idx="5920">
                  <c:v>1374.7903496323099</c:v>
                </c:pt>
                <c:pt idx="5921">
                  <c:v>1375.0225777319099</c:v>
                </c:pt>
                <c:pt idx="5922">
                  <c:v>1375.2548058315101</c:v>
                </c:pt>
                <c:pt idx="5923">
                  <c:v>1375.4870339311101</c:v>
                </c:pt>
                <c:pt idx="5924">
                  <c:v>1375.7192620307101</c:v>
                </c:pt>
                <c:pt idx="5925">
                  <c:v>1375.95149013031</c:v>
                </c:pt>
                <c:pt idx="5926">
                  <c:v>1376.18371822991</c:v>
                </c:pt>
                <c:pt idx="5927">
                  <c:v>1376.41594632951</c:v>
                </c:pt>
                <c:pt idx="5928">
                  <c:v>1376.64817442911</c:v>
                </c:pt>
                <c:pt idx="5929">
                  <c:v>1376.88040252871</c:v>
                </c:pt>
                <c:pt idx="5930">
                  <c:v>1377.1126306283099</c:v>
                </c:pt>
                <c:pt idx="5931">
                  <c:v>1377.3448587279099</c:v>
                </c:pt>
                <c:pt idx="5932">
                  <c:v>1377.5770868275099</c:v>
                </c:pt>
                <c:pt idx="5933">
                  <c:v>1377.8093149271101</c:v>
                </c:pt>
                <c:pt idx="5934">
                  <c:v>1378.0415430267101</c:v>
                </c:pt>
                <c:pt idx="5935">
                  <c:v>1378.2737711263101</c:v>
                </c:pt>
                <c:pt idx="5936">
                  <c:v>1378.50599922591</c:v>
                </c:pt>
                <c:pt idx="5937">
                  <c:v>1378.73822732551</c:v>
                </c:pt>
                <c:pt idx="5938">
                  <c:v>1378.97045542511</c:v>
                </c:pt>
                <c:pt idx="5939">
                  <c:v>1379.20268352471</c:v>
                </c:pt>
                <c:pt idx="5940">
                  <c:v>1379.43491162431</c:v>
                </c:pt>
                <c:pt idx="5941">
                  <c:v>1379.6671397239099</c:v>
                </c:pt>
                <c:pt idx="5942">
                  <c:v>1379.8993678235099</c:v>
                </c:pt>
                <c:pt idx="5943">
                  <c:v>1380.1315959231099</c:v>
                </c:pt>
                <c:pt idx="5944">
                  <c:v>1380.3638240227101</c:v>
                </c:pt>
                <c:pt idx="5945">
                  <c:v>1380.5960521223101</c:v>
                </c:pt>
                <c:pt idx="5946">
                  <c:v>1380.8282802219101</c:v>
                </c:pt>
                <c:pt idx="5947">
                  <c:v>1381.06050832151</c:v>
                </c:pt>
                <c:pt idx="5948">
                  <c:v>1381.29273642111</c:v>
                </c:pt>
                <c:pt idx="5949">
                  <c:v>1381.52496452071</c:v>
                </c:pt>
                <c:pt idx="5950">
                  <c:v>1381.75719262031</c:v>
                </c:pt>
                <c:pt idx="5951">
                  <c:v>1381.98942071991</c:v>
                </c:pt>
                <c:pt idx="5952">
                  <c:v>1382.2216488195099</c:v>
                </c:pt>
                <c:pt idx="5953">
                  <c:v>1382.4538769191099</c:v>
                </c:pt>
                <c:pt idx="5954">
                  <c:v>1382.6861050187099</c:v>
                </c:pt>
                <c:pt idx="5955">
                  <c:v>1382.9183331183101</c:v>
                </c:pt>
                <c:pt idx="5956">
                  <c:v>1383.1505612179101</c:v>
                </c:pt>
                <c:pt idx="5957">
                  <c:v>1383.3827893175101</c:v>
                </c:pt>
                <c:pt idx="5958">
                  <c:v>1383.61501741711</c:v>
                </c:pt>
                <c:pt idx="5959">
                  <c:v>1383.84724551671</c:v>
                </c:pt>
                <c:pt idx="5960">
                  <c:v>1384.07947361631</c:v>
                </c:pt>
                <c:pt idx="5961">
                  <c:v>1384.31170171591</c:v>
                </c:pt>
                <c:pt idx="5962">
                  <c:v>1384.54392981551</c:v>
                </c:pt>
                <c:pt idx="5963">
                  <c:v>1384.7761579151099</c:v>
                </c:pt>
                <c:pt idx="5964">
                  <c:v>1385.0083860147099</c:v>
                </c:pt>
                <c:pt idx="5965">
                  <c:v>1385.2406141143099</c:v>
                </c:pt>
                <c:pt idx="5966">
                  <c:v>1385.4728422139101</c:v>
                </c:pt>
                <c:pt idx="5967">
                  <c:v>1385.7050703135101</c:v>
                </c:pt>
                <c:pt idx="5968">
                  <c:v>1385.9372984131101</c:v>
                </c:pt>
                <c:pt idx="5969">
                  <c:v>1386.16952651271</c:v>
                </c:pt>
                <c:pt idx="5970">
                  <c:v>1386.40175461231</c:v>
                </c:pt>
                <c:pt idx="5971">
                  <c:v>1386.63398271191</c:v>
                </c:pt>
                <c:pt idx="5972">
                  <c:v>1386.86621081151</c:v>
                </c:pt>
                <c:pt idx="5973">
                  <c:v>1387.09843891111</c:v>
                </c:pt>
                <c:pt idx="5974">
                  <c:v>1387.3306670107099</c:v>
                </c:pt>
                <c:pt idx="5975">
                  <c:v>1387.5628951103099</c:v>
                </c:pt>
                <c:pt idx="5976">
                  <c:v>1387.7951232099099</c:v>
                </c:pt>
                <c:pt idx="5977">
                  <c:v>1388.0273513095101</c:v>
                </c:pt>
                <c:pt idx="5978">
                  <c:v>1388.2595794091101</c:v>
                </c:pt>
                <c:pt idx="5979">
                  <c:v>1388.4918075087101</c:v>
                </c:pt>
                <c:pt idx="5980">
                  <c:v>1388.72403560831</c:v>
                </c:pt>
                <c:pt idx="5981">
                  <c:v>1388.95626370791</c:v>
                </c:pt>
                <c:pt idx="5982">
                  <c:v>1389.18849180751</c:v>
                </c:pt>
                <c:pt idx="5983">
                  <c:v>1389.42071990711</c:v>
                </c:pt>
                <c:pt idx="5984">
                  <c:v>1389.6529480067099</c:v>
                </c:pt>
                <c:pt idx="5985">
                  <c:v>1389.8851761063099</c:v>
                </c:pt>
                <c:pt idx="5986">
                  <c:v>1390.1174042059099</c:v>
                </c:pt>
                <c:pt idx="5987">
                  <c:v>1390.3496323055101</c:v>
                </c:pt>
                <c:pt idx="5988">
                  <c:v>1390.5818604051101</c:v>
                </c:pt>
                <c:pt idx="5989">
                  <c:v>1390.8140885047101</c:v>
                </c:pt>
                <c:pt idx="5990">
                  <c:v>1391.0463166043101</c:v>
                </c:pt>
                <c:pt idx="5991">
                  <c:v>1391.27854470391</c:v>
                </c:pt>
                <c:pt idx="5992">
                  <c:v>1391.51077280351</c:v>
                </c:pt>
                <c:pt idx="5993">
                  <c:v>1391.74300090311</c:v>
                </c:pt>
                <c:pt idx="5994">
                  <c:v>1391.97522900271</c:v>
                </c:pt>
                <c:pt idx="5995">
                  <c:v>1392.2074571023099</c:v>
                </c:pt>
                <c:pt idx="5996">
                  <c:v>1392.4396852019099</c:v>
                </c:pt>
                <c:pt idx="5997">
                  <c:v>1392.6719133015099</c:v>
                </c:pt>
                <c:pt idx="5998">
                  <c:v>1392.9041414011101</c:v>
                </c:pt>
                <c:pt idx="5999">
                  <c:v>1393.1363695007101</c:v>
                </c:pt>
                <c:pt idx="6000">
                  <c:v>1393.3685976003101</c:v>
                </c:pt>
                <c:pt idx="6001">
                  <c:v>1393.60082569991</c:v>
                </c:pt>
                <c:pt idx="6002">
                  <c:v>1393.83305379951</c:v>
                </c:pt>
                <c:pt idx="6003">
                  <c:v>1394.06528189911</c:v>
                </c:pt>
                <c:pt idx="6004">
                  <c:v>1394.29750999871</c:v>
                </c:pt>
                <c:pt idx="6005">
                  <c:v>1394.52973809831</c:v>
                </c:pt>
                <c:pt idx="6006">
                  <c:v>1394.7619661979099</c:v>
                </c:pt>
                <c:pt idx="6007">
                  <c:v>1394.9941942975099</c:v>
                </c:pt>
                <c:pt idx="6008">
                  <c:v>1395.2264223971099</c:v>
                </c:pt>
                <c:pt idx="6009">
                  <c:v>1395.4586504967101</c:v>
                </c:pt>
                <c:pt idx="6010">
                  <c:v>1395.6908785963101</c:v>
                </c:pt>
                <c:pt idx="6011">
                  <c:v>1395.9231066959101</c:v>
                </c:pt>
                <c:pt idx="6012">
                  <c:v>1396.15533479551</c:v>
                </c:pt>
                <c:pt idx="6013">
                  <c:v>1396.38756289511</c:v>
                </c:pt>
                <c:pt idx="6014">
                  <c:v>1396.61979099471</c:v>
                </c:pt>
                <c:pt idx="6015">
                  <c:v>1396.85201909431</c:v>
                </c:pt>
                <c:pt idx="6016">
                  <c:v>1397.08424719391</c:v>
                </c:pt>
                <c:pt idx="6017">
                  <c:v>1397.3164752935099</c:v>
                </c:pt>
                <c:pt idx="6018">
                  <c:v>1397.5487033931099</c:v>
                </c:pt>
                <c:pt idx="6019">
                  <c:v>1397.7809314927099</c:v>
                </c:pt>
                <c:pt idx="6020">
                  <c:v>1398.0131595923101</c:v>
                </c:pt>
                <c:pt idx="6021">
                  <c:v>1398.2453876919101</c:v>
                </c:pt>
                <c:pt idx="6022">
                  <c:v>1398.4776157915101</c:v>
                </c:pt>
                <c:pt idx="6023">
                  <c:v>1398.70984389111</c:v>
                </c:pt>
                <c:pt idx="6024">
                  <c:v>1398.94207199071</c:v>
                </c:pt>
                <c:pt idx="6025">
                  <c:v>1399.17430009031</c:v>
                </c:pt>
                <c:pt idx="6026">
                  <c:v>1399.40652818991</c:v>
                </c:pt>
                <c:pt idx="6027">
                  <c:v>1399.63875628951</c:v>
                </c:pt>
                <c:pt idx="6028">
                  <c:v>1399.8709843891099</c:v>
                </c:pt>
                <c:pt idx="6029">
                  <c:v>1400.1032124887099</c:v>
                </c:pt>
                <c:pt idx="6030">
                  <c:v>1400.3354405883099</c:v>
                </c:pt>
                <c:pt idx="6031">
                  <c:v>1400.5676686879101</c:v>
                </c:pt>
                <c:pt idx="6032">
                  <c:v>1400.7998967875101</c:v>
                </c:pt>
                <c:pt idx="6033">
                  <c:v>1401.0321248871101</c:v>
                </c:pt>
                <c:pt idx="6034">
                  <c:v>1401.26435298671</c:v>
                </c:pt>
                <c:pt idx="6035">
                  <c:v>1401.49658108631</c:v>
                </c:pt>
                <c:pt idx="6036">
                  <c:v>1401.72880918591</c:v>
                </c:pt>
                <c:pt idx="6037">
                  <c:v>1401.96103728551</c:v>
                </c:pt>
                <c:pt idx="6038">
                  <c:v>1402.19326538511</c:v>
                </c:pt>
                <c:pt idx="6039">
                  <c:v>1402.4254934847099</c:v>
                </c:pt>
                <c:pt idx="6040">
                  <c:v>1402.6577215843099</c:v>
                </c:pt>
                <c:pt idx="6041">
                  <c:v>1402.8899496839099</c:v>
                </c:pt>
                <c:pt idx="6042">
                  <c:v>1403.1221777835101</c:v>
                </c:pt>
                <c:pt idx="6043">
                  <c:v>1403.3544058831101</c:v>
                </c:pt>
                <c:pt idx="6044">
                  <c:v>1403.5866339827101</c:v>
                </c:pt>
                <c:pt idx="6045">
                  <c:v>1403.81886208231</c:v>
                </c:pt>
                <c:pt idx="6046">
                  <c:v>1404.05109018191</c:v>
                </c:pt>
                <c:pt idx="6047">
                  <c:v>1404.28331828151</c:v>
                </c:pt>
                <c:pt idx="6048">
                  <c:v>1404.51554638111</c:v>
                </c:pt>
                <c:pt idx="6049">
                  <c:v>1404.7477744807099</c:v>
                </c:pt>
                <c:pt idx="6050">
                  <c:v>1404.9800025803099</c:v>
                </c:pt>
                <c:pt idx="6051">
                  <c:v>1405.2122306799099</c:v>
                </c:pt>
                <c:pt idx="6052">
                  <c:v>1405.4444587795099</c:v>
                </c:pt>
                <c:pt idx="6053">
                  <c:v>1405.6766868791101</c:v>
                </c:pt>
                <c:pt idx="6054">
                  <c:v>1405.9089149787101</c:v>
                </c:pt>
                <c:pt idx="6055">
                  <c:v>1406.1411430783101</c:v>
                </c:pt>
                <c:pt idx="6056">
                  <c:v>1406.37337117791</c:v>
                </c:pt>
                <c:pt idx="6057">
                  <c:v>1406.60559927751</c:v>
                </c:pt>
                <c:pt idx="6058">
                  <c:v>1406.83782737711</c:v>
                </c:pt>
                <c:pt idx="6059">
                  <c:v>1407.07005547671</c:v>
                </c:pt>
                <c:pt idx="6060">
                  <c:v>1407.3022835763099</c:v>
                </c:pt>
                <c:pt idx="6061">
                  <c:v>1407.5345116759099</c:v>
                </c:pt>
                <c:pt idx="6062">
                  <c:v>1407.7667397755099</c:v>
                </c:pt>
                <c:pt idx="6063">
                  <c:v>1407.9989678751101</c:v>
                </c:pt>
                <c:pt idx="6064">
                  <c:v>1408.2311959747101</c:v>
                </c:pt>
                <c:pt idx="6065">
                  <c:v>1408.4634240743101</c:v>
                </c:pt>
                <c:pt idx="6066">
                  <c:v>1408.69565217391</c:v>
                </c:pt>
                <c:pt idx="6067">
                  <c:v>1408.92788027351</c:v>
                </c:pt>
                <c:pt idx="6068">
                  <c:v>1409.16010837311</c:v>
                </c:pt>
                <c:pt idx="6069">
                  <c:v>1409.39233647271</c:v>
                </c:pt>
                <c:pt idx="6070">
                  <c:v>1409.62456457231</c:v>
                </c:pt>
                <c:pt idx="6071">
                  <c:v>1409.8567926719099</c:v>
                </c:pt>
                <c:pt idx="6072">
                  <c:v>1410.0890207715099</c:v>
                </c:pt>
                <c:pt idx="6073">
                  <c:v>1410.3212488711099</c:v>
                </c:pt>
                <c:pt idx="6074">
                  <c:v>1410.5534769707101</c:v>
                </c:pt>
                <c:pt idx="6075">
                  <c:v>1410.7857050703101</c:v>
                </c:pt>
                <c:pt idx="6076">
                  <c:v>1411.0179331699101</c:v>
                </c:pt>
                <c:pt idx="6077">
                  <c:v>1411.25016126951</c:v>
                </c:pt>
                <c:pt idx="6078">
                  <c:v>1411.48238936911</c:v>
                </c:pt>
                <c:pt idx="6079">
                  <c:v>1411.71461746871</c:v>
                </c:pt>
                <c:pt idx="6080">
                  <c:v>1411.94684556831</c:v>
                </c:pt>
                <c:pt idx="6081">
                  <c:v>1412.17907366791</c:v>
                </c:pt>
                <c:pt idx="6082">
                  <c:v>1412.4113017675099</c:v>
                </c:pt>
                <c:pt idx="6083">
                  <c:v>1412.6435298671099</c:v>
                </c:pt>
                <c:pt idx="6084">
                  <c:v>1412.8757579667099</c:v>
                </c:pt>
                <c:pt idx="6085">
                  <c:v>1413.1079860663101</c:v>
                </c:pt>
                <c:pt idx="6086">
                  <c:v>1413.3402141659101</c:v>
                </c:pt>
                <c:pt idx="6087">
                  <c:v>1413.5724422655101</c:v>
                </c:pt>
                <c:pt idx="6088">
                  <c:v>1413.80467036511</c:v>
                </c:pt>
                <c:pt idx="6089">
                  <c:v>1414.03689846471</c:v>
                </c:pt>
                <c:pt idx="6090">
                  <c:v>1414.26912656431</c:v>
                </c:pt>
                <c:pt idx="6091">
                  <c:v>1414.50135466391</c:v>
                </c:pt>
                <c:pt idx="6092">
                  <c:v>1414.73358276351</c:v>
                </c:pt>
                <c:pt idx="6093">
                  <c:v>1414.9658108631099</c:v>
                </c:pt>
                <c:pt idx="6094">
                  <c:v>1415.1980389627099</c:v>
                </c:pt>
                <c:pt idx="6095">
                  <c:v>1415.4302670623099</c:v>
                </c:pt>
                <c:pt idx="6096">
                  <c:v>1415.6624951619101</c:v>
                </c:pt>
                <c:pt idx="6097">
                  <c:v>1415.8947232615101</c:v>
                </c:pt>
                <c:pt idx="6098">
                  <c:v>1416.1269513611101</c:v>
                </c:pt>
                <c:pt idx="6099">
                  <c:v>1416.35917946071</c:v>
                </c:pt>
                <c:pt idx="6100">
                  <c:v>1416.59140756031</c:v>
                </c:pt>
                <c:pt idx="6101">
                  <c:v>1416.82363565991</c:v>
                </c:pt>
                <c:pt idx="6102">
                  <c:v>1417.05586375951</c:v>
                </c:pt>
                <c:pt idx="6103">
                  <c:v>1417.28809185911</c:v>
                </c:pt>
                <c:pt idx="6104">
                  <c:v>1417.5203199587099</c:v>
                </c:pt>
                <c:pt idx="6105">
                  <c:v>1417.7525480583199</c:v>
                </c:pt>
                <c:pt idx="6106">
                  <c:v>1417.9847761579199</c:v>
                </c:pt>
                <c:pt idx="6107">
                  <c:v>1418.2170042575201</c:v>
                </c:pt>
                <c:pt idx="6108">
                  <c:v>1418.4492323571201</c:v>
                </c:pt>
                <c:pt idx="6109">
                  <c:v>1418.6814604567201</c:v>
                </c:pt>
                <c:pt idx="6110">
                  <c:v>1418.91368855632</c:v>
                </c:pt>
                <c:pt idx="6111">
                  <c:v>1419.14591665592</c:v>
                </c:pt>
                <c:pt idx="6112">
                  <c:v>1419.37814475552</c:v>
                </c:pt>
                <c:pt idx="6113">
                  <c:v>1419.61037285512</c:v>
                </c:pt>
                <c:pt idx="6114">
                  <c:v>1419.84260095472</c:v>
                </c:pt>
                <c:pt idx="6115">
                  <c:v>1420.0748290543199</c:v>
                </c:pt>
                <c:pt idx="6116">
                  <c:v>1420.3070571539199</c:v>
                </c:pt>
                <c:pt idx="6117">
                  <c:v>1420.5392852535199</c:v>
                </c:pt>
                <c:pt idx="6118">
                  <c:v>1420.7715133531201</c:v>
                </c:pt>
                <c:pt idx="6119">
                  <c:v>1421.0037414527201</c:v>
                </c:pt>
                <c:pt idx="6120">
                  <c:v>1421.2359695523201</c:v>
                </c:pt>
                <c:pt idx="6121">
                  <c:v>1421.46819765192</c:v>
                </c:pt>
                <c:pt idx="6122">
                  <c:v>1421.70042575152</c:v>
                </c:pt>
                <c:pt idx="6123">
                  <c:v>1421.93265385112</c:v>
                </c:pt>
                <c:pt idx="6124">
                  <c:v>1422.16488195072</c:v>
                </c:pt>
                <c:pt idx="6125">
                  <c:v>1422.39711005032</c:v>
                </c:pt>
                <c:pt idx="6126">
                  <c:v>1422.6293381499199</c:v>
                </c:pt>
                <c:pt idx="6127">
                  <c:v>1422.8615662495199</c:v>
                </c:pt>
                <c:pt idx="6128">
                  <c:v>1423.0937943491199</c:v>
                </c:pt>
                <c:pt idx="6129">
                  <c:v>1423.3260224487201</c:v>
                </c:pt>
                <c:pt idx="6130">
                  <c:v>1423.5582505483201</c:v>
                </c:pt>
                <c:pt idx="6131">
                  <c:v>1423.7904786479201</c:v>
                </c:pt>
                <c:pt idx="6132">
                  <c:v>1424.02270674752</c:v>
                </c:pt>
                <c:pt idx="6133">
                  <c:v>1424.25493484712</c:v>
                </c:pt>
                <c:pt idx="6134">
                  <c:v>1424.48716294672</c:v>
                </c:pt>
                <c:pt idx="6135">
                  <c:v>1424.71939104632</c:v>
                </c:pt>
                <c:pt idx="6136">
                  <c:v>1424.9516191459199</c:v>
                </c:pt>
                <c:pt idx="6137">
                  <c:v>1425.1838472455199</c:v>
                </c:pt>
                <c:pt idx="6138">
                  <c:v>1425.4160753451199</c:v>
                </c:pt>
                <c:pt idx="6139">
                  <c:v>1425.6483034447201</c:v>
                </c:pt>
                <c:pt idx="6140">
                  <c:v>1425.8805315443201</c:v>
                </c:pt>
                <c:pt idx="6141">
                  <c:v>1426.1127596439201</c:v>
                </c:pt>
                <c:pt idx="6142">
                  <c:v>1426.3449877435201</c:v>
                </c:pt>
                <c:pt idx="6143">
                  <c:v>1426.57721584312</c:v>
                </c:pt>
                <c:pt idx="6144">
                  <c:v>1426.80944394272</c:v>
                </c:pt>
                <c:pt idx="6145">
                  <c:v>1427.04167204232</c:v>
                </c:pt>
                <c:pt idx="6146">
                  <c:v>1427.27390014192</c:v>
                </c:pt>
                <c:pt idx="6147">
                  <c:v>1427.5061282415199</c:v>
                </c:pt>
                <c:pt idx="6148">
                  <c:v>1427.7383563411199</c:v>
                </c:pt>
                <c:pt idx="6149">
                  <c:v>1427.9705844407199</c:v>
                </c:pt>
                <c:pt idx="6150">
                  <c:v>1428.2028125403201</c:v>
                </c:pt>
                <c:pt idx="6151">
                  <c:v>1428.4350406399201</c:v>
                </c:pt>
                <c:pt idx="6152">
                  <c:v>1428.6672687395201</c:v>
                </c:pt>
                <c:pt idx="6153">
                  <c:v>1428.89949683912</c:v>
                </c:pt>
                <c:pt idx="6154">
                  <c:v>1429.13172493872</c:v>
                </c:pt>
                <c:pt idx="6155">
                  <c:v>1429.36395303832</c:v>
                </c:pt>
                <c:pt idx="6156">
                  <c:v>1429.59618113792</c:v>
                </c:pt>
                <c:pt idx="6157">
                  <c:v>1429.82840923752</c:v>
                </c:pt>
                <c:pt idx="6158">
                  <c:v>1430.0606373371199</c:v>
                </c:pt>
                <c:pt idx="6159">
                  <c:v>1430.2928654367199</c:v>
                </c:pt>
                <c:pt idx="6160">
                  <c:v>1430.5250935363199</c:v>
                </c:pt>
                <c:pt idx="6161">
                  <c:v>1430.7573216359201</c:v>
                </c:pt>
                <c:pt idx="6162">
                  <c:v>1430.9895497355201</c:v>
                </c:pt>
                <c:pt idx="6163">
                  <c:v>1431.2217778351201</c:v>
                </c:pt>
                <c:pt idx="6164">
                  <c:v>1431.45400593472</c:v>
                </c:pt>
                <c:pt idx="6165">
                  <c:v>1431.68623403432</c:v>
                </c:pt>
                <c:pt idx="6166">
                  <c:v>1431.91846213392</c:v>
                </c:pt>
                <c:pt idx="6167">
                  <c:v>1432.15069023352</c:v>
                </c:pt>
                <c:pt idx="6168">
                  <c:v>1432.38291833312</c:v>
                </c:pt>
                <c:pt idx="6169">
                  <c:v>1432.6151464327199</c:v>
                </c:pt>
                <c:pt idx="6170">
                  <c:v>1432.8473745323199</c:v>
                </c:pt>
                <c:pt idx="6171">
                  <c:v>1433.0796026319199</c:v>
                </c:pt>
                <c:pt idx="6172">
                  <c:v>1433.3118307315201</c:v>
                </c:pt>
                <c:pt idx="6173">
                  <c:v>1433.5440588311201</c:v>
                </c:pt>
                <c:pt idx="6174">
                  <c:v>1433.7762869307201</c:v>
                </c:pt>
                <c:pt idx="6175">
                  <c:v>1434.00851503032</c:v>
                </c:pt>
                <c:pt idx="6176">
                  <c:v>1434.24074312992</c:v>
                </c:pt>
                <c:pt idx="6177">
                  <c:v>1434.47297122952</c:v>
                </c:pt>
                <c:pt idx="6178">
                  <c:v>1434.70519932912</c:v>
                </c:pt>
                <c:pt idx="6179">
                  <c:v>1434.93742742872</c:v>
                </c:pt>
                <c:pt idx="6180">
                  <c:v>1435.1696555283199</c:v>
                </c:pt>
                <c:pt idx="6181">
                  <c:v>1435.4018836279199</c:v>
                </c:pt>
                <c:pt idx="6182">
                  <c:v>1435.6341117275199</c:v>
                </c:pt>
                <c:pt idx="6183">
                  <c:v>1435.8663398271201</c:v>
                </c:pt>
                <c:pt idx="6184">
                  <c:v>1436.0985679267201</c:v>
                </c:pt>
                <c:pt idx="6185">
                  <c:v>1436.3307960263201</c:v>
                </c:pt>
                <c:pt idx="6186">
                  <c:v>1436.56302412592</c:v>
                </c:pt>
                <c:pt idx="6187">
                  <c:v>1436.79525222552</c:v>
                </c:pt>
                <c:pt idx="6188">
                  <c:v>1437.02748032512</c:v>
                </c:pt>
                <c:pt idx="6189">
                  <c:v>1437.25970842472</c:v>
                </c:pt>
                <c:pt idx="6190">
                  <c:v>1437.49193652432</c:v>
                </c:pt>
                <c:pt idx="6191">
                  <c:v>1437.7241646239199</c:v>
                </c:pt>
                <c:pt idx="6192">
                  <c:v>1437.9563927235199</c:v>
                </c:pt>
                <c:pt idx="6193">
                  <c:v>1438.1886208231199</c:v>
                </c:pt>
                <c:pt idx="6194">
                  <c:v>1438.4208489227201</c:v>
                </c:pt>
                <c:pt idx="6195">
                  <c:v>1438.6530770223201</c:v>
                </c:pt>
                <c:pt idx="6196">
                  <c:v>1438.8853051219201</c:v>
                </c:pt>
                <c:pt idx="6197">
                  <c:v>1439.11753322152</c:v>
                </c:pt>
                <c:pt idx="6198">
                  <c:v>1439.34976132112</c:v>
                </c:pt>
                <c:pt idx="6199">
                  <c:v>1439.58198942072</c:v>
                </c:pt>
                <c:pt idx="6200">
                  <c:v>1439.81421752032</c:v>
                </c:pt>
                <c:pt idx="6201">
                  <c:v>1440.04644561992</c:v>
                </c:pt>
                <c:pt idx="6202">
                  <c:v>1440.2786737195199</c:v>
                </c:pt>
                <c:pt idx="6203">
                  <c:v>1440.5109018191199</c:v>
                </c:pt>
                <c:pt idx="6204">
                  <c:v>1440.7431299187199</c:v>
                </c:pt>
                <c:pt idx="6205">
                  <c:v>1440.9753580183201</c:v>
                </c:pt>
                <c:pt idx="6206">
                  <c:v>1441.2075861179201</c:v>
                </c:pt>
                <c:pt idx="6207">
                  <c:v>1441.4398142175201</c:v>
                </c:pt>
                <c:pt idx="6208">
                  <c:v>1441.67204231712</c:v>
                </c:pt>
                <c:pt idx="6209">
                  <c:v>1441.90427041672</c:v>
                </c:pt>
                <c:pt idx="6210">
                  <c:v>1442.13649851632</c:v>
                </c:pt>
                <c:pt idx="6211">
                  <c:v>1442.36872661592</c:v>
                </c:pt>
                <c:pt idx="6212">
                  <c:v>1442.6009547155199</c:v>
                </c:pt>
                <c:pt idx="6213">
                  <c:v>1442.8331828151199</c:v>
                </c:pt>
                <c:pt idx="6214">
                  <c:v>1443.0654109147199</c:v>
                </c:pt>
                <c:pt idx="6215">
                  <c:v>1443.2976390143201</c:v>
                </c:pt>
                <c:pt idx="6216">
                  <c:v>1443.5298671139201</c:v>
                </c:pt>
                <c:pt idx="6217">
                  <c:v>1443.7620952135201</c:v>
                </c:pt>
                <c:pt idx="6218">
                  <c:v>1443.99432331312</c:v>
                </c:pt>
                <c:pt idx="6219">
                  <c:v>1444.22655141272</c:v>
                </c:pt>
                <c:pt idx="6220">
                  <c:v>1444.45877951232</c:v>
                </c:pt>
                <c:pt idx="6221">
                  <c:v>1444.69100761192</c:v>
                </c:pt>
                <c:pt idx="6222">
                  <c:v>1444.92323571152</c:v>
                </c:pt>
                <c:pt idx="6223">
                  <c:v>1445.1554638111199</c:v>
                </c:pt>
                <c:pt idx="6224">
                  <c:v>1445.3876919107199</c:v>
                </c:pt>
                <c:pt idx="6225">
                  <c:v>1445.6199200103199</c:v>
                </c:pt>
                <c:pt idx="6226">
                  <c:v>1445.8521481099201</c:v>
                </c:pt>
                <c:pt idx="6227">
                  <c:v>1446.0843762095201</c:v>
                </c:pt>
                <c:pt idx="6228">
                  <c:v>1446.3166043091201</c:v>
                </c:pt>
                <c:pt idx="6229">
                  <c:v>1446.54883240872</c:v>
                </c:pt>
                <c:pt idx="6230">
                  <c:v>1446.78106050832</c:v>
                </c:pt>
                <c:pt idx="6231">
                  <c:v>1447.01328860792</c:v>
                </c:pt>
                <c:pt idx="6232">
                  <c:v>1447.24551670752</c:v>
                </c:pt>
                <c:pt idx="6233">
                  <c:v>1447.47774480712</c:v>
                </c:pt>
                <c:pt idx="6234">
                  <c:v>1447.7099729067199</c:v>
                </c:pt>
                <c:pt idx="6235">
                  <c:v>1447.9422010063199</c:v>
                </c:pt>
                <c:pt idx="6236">
                  <c:v>1448.1744291059199</c:v>
                </c:pt>
                <c:pt idx="6237">
                  <c:v>1448.4066572055201</c:v>
                </c:pt>
                <c:pt idx="6238">
                  <c:v>1448.6388853051201</c:v>
                </c:pt>
                <c:pt idx="6239">
                  <c:v>1448.8711134047201</c:v>
                </c:pt>
                <c:pt idx="6240">
                  <c:v>1449.10334150432</c:v>
                </c:pt>
                <c:pt idx="6241">
                  <c:v>1449.33556960392</c:v>
                </c:pt>
                <c:pt idx="6242">
                  <c:v>1449.56779770352</c:v>
                </c:pt>
                <c:pt idx="6243">
                  <c:v>1449.80002580312</c:v>
                </c:pt>
                <c:pt idx="6244">
                  <c:v>1450.03225390272</c:v>
                </c:pt>
                <c:pt idx="6245">
                  <c:v>1450.2644820023199</c:v>
                </c:pt>
                <c:pt idx="6246">
                  <c:v>1450.4967101019199</c:v>
                </c:pt>
                <c:pt idx="6247">
                  <c:v>1450.7289382015199</c:v>
                </c:pt>
                <c:pt idx="6248">
                  <c:v>1450.9611663011201</c:v>
                </c:pt>
                <c:pt idx="6249">
                  <c:v>1451.1933944007201</c:v>
                </c:pt>
                <c:pt idx="6250">
                  <c:v>1451.4256225003201</c:v>
                </c:pt>
                <c:pt idx="6251">
                  <c:v>1451.65785059992</c:v>
                </c:pt>
                <c:pt idx="6252">
                  <c:v>1451.89007869952</c:v>
                </c:pt>
                <c:pt idx="6253">
                  <c:v>1452.12230679912</c:v>
                </c:pt>
                <c:pt idx="6254">
                  <c:v>1452.35453489872</c:v>
                </c:pt>
                <c:pt idx="6255">
                  <c:v>1452.58676299832</c:v>
                </c:pt>
                <c:pt idx="6256">
                  <c:v>1452.8189910979199</c:v>
                </c:pt>
                <c:pt idx="6257">
                  <c:v>1453.0512191975199</c:v>
                </c:pt>
                <c:pt idx="6258">
                  <c:v>1453.2834472971199</c:v>
                </c:pt>
                <c:pt idx="6259">
                  <c:v>1453.5156753967201</c:v>
                </c:pt>
                <c:pt idx="6260">
                  <c:v>1453.7479034963201</c:v>
                </c:pt>
                <c:pt idx="6261">
                  <c:v>1453.9801315959201</c:v>
                </c:pt>
                <c:pt idx="6262">
                  <c:v>1454.21235969552</c:v>
                </c:pt>
                <c:pt idx="6263">
                  <c:v>1454.44458779512</c:v>
                </c:pt>
                <c:pt idx="6264">
                  <c:v>1454.67681589472</c:v>
                </c:pt>
                <c:pt idx="6265">
                  <c:v>1454.90904399432</c:v>
                </c:pt>
                <c:pt idx="6266">
                  <c:v>1455.14127209392</c:v>
                </c:pt>
                <c:pt idx="6267">
                  <c:v>1455.3735001935199</c:v>
                </c:pt>
                <c:pt idx="6268">
                  <c:v>1455.6057282931199</c:v>
                </c:pt>
                <c:pt idx="6269">
                  <c:v>1455.8379563927199</c:v>
                </c:pt>
                <c:pt idx="6270">
                  <c:v>1456.0701844923201</c:v>
                </c:pt>
                <c:pt idx="6271">
                  <c:v>1456.3024125919201</c:v>
                </c:pt>
                <c:pt idx="6272">
                  <c:v>1456.5346406915201</c:v>
                </c:pt>
                <c:pt idx="6273">
                  <c:v>1456.76686879112</c:v>
                </c:pt>
                <c:pt idx="6274">
                  <c:v>1456.99909689072</c:v>
                </c:pt>
                <c:pt idx="6275">
                  <c:v>1457.23132499032</c:v>
                </c:pt>
                <c:pt idx="6276">
                  <c:v>1457.46355308992</c:v>
                </c:pt>
                <c:pt idx="6277">
                  <c:v>1457.6957811895199</c:v>
                </c:pt>
                <c:pt idx="6278">
                  <c:v>1457.9280092891199</c:v>
                </c:pt>
                <c:pt idx="6279">
                  <c:v>1458.1602373887199</c:v>
                </c:pt>
                <c:pt idx="6280">
                  <c:v>1458.3924654883201</c:v>
                </c:pt>
                <c:pt idx="6281">
                  <c:v>1458.6246935879201</c:v>
                </c:pt>
                <c:pt idx="6282">
                  <c:v>1458.8569216875201</c:v>
                </c:pt>
                <c:pt idx="6283">
                  <c:v>1459.08914978712</c:v>
                </c:pt>
                <c:pt idx="6284">
                  <c:v>1459.32137788672</c:v>
                </c:pt>
                <c:pt idx="6285">
                  <c:v>1459.55360598632</c:v>
                </c:pt>
                <c:pt idx="6286">
                  <c:v>1459.78583408592</c:v>
                </c:pt>
                <c:pt idx="6287">
                  <c:v>1460.01806218552</c:v>
                </c:pt>
                <c:pt idx="6288">
                  <c:v>1460.2502902851199</c:v>
                </c:pt>
                <c:pt idx="6289">
                  <c:v>1460.4825183847199</c:v>
                </c:pt>
                <c:pt idx="6290">
                  <c:v>1460.7147464843199</c:v>
                </c:pt>
                <c:pt idx="6291">
                  <c:v>1460.9469745839201</c:v>
                </c:pt>
                <c:pt idx="6292">
                  <c:v>1461.1792026835201</c:v>
                </c:pt>
                <c:pt idx="6293">
                  <c:v>1461.4114307831201</c:v>
                </c:pt>
                <c:pt idx="6294">
                  <c:v>1461.64365888272</c:v>
                </c:pt>
                <c:pt idx="6295">
                  <c:v>1461.87588698232</c:v>
                </c:pt>
                <c:pt idx="6296">
                  <c:v>1462.10811508193</c:v>
                </c:pt>
                <c:pt idx="6297">
                  <c:v>1462.34034318152</c:v>
                </c:pt>
                <c:pt idx="6298">
                  <c:v>1462.57257128112</c:v>
                </c:pt>
                <c:pt idx="6299">
                  <c:v>1462.8047993807299</c:v>
                </c:pt>
                <c:pt idx="6300">
                  <c:v>1463.0370274803299</c:v>
                </c:pt>
                <c:pt idx="6301">
                  <c:v>1463.2692555799299</c:v>
                </c:pt>
                <c:pt idx="6302">
                  <c:v>1463.5014836795301</c:v>
                </c:pt>
                <c:pt idx="6303">
                  <c:v>1463.7337117791301</c:v>
                </c:pt>
                <c:pt idx="6304">
                  <c:v>1463.9659398787301</c:v>
                </c:pt>
                <c:pt idx="6305">
                  <c:v>1464.19816797833</c:v>
                </c:pt>
                <c:pt idx="6306">
                  <c:v>1464.43039607793</c:v>
                </c:pt>
                <c:pt idx="6307">
                  <c:v>1464.66262417753</c:v>
                </c:pt>
                <c:pt idx="6308">
                  <c:v>1464.89485227713</c:v>
                </c:pt>
                <c:pt idx="6309">
                  <c:v>1465.12708037673</c:v>
                </c:pt>
                <c:pt idx="6310">
                  <c:v>1465.3593084763299</c:v>
                </c:pt>
                <c:pt idx="6311">
                  <c:v>1465.5915365759299</c:v>
                </c:pt>
                <c:pt idx="6312">
                  <c:v>1465.8237646755299</c:v>
                </c:pt>
                <c:pt idx="6313">
                  <c:v>1466.0559927751301</c:v>
                </c:pt>
                <c:pt idx="6314">
                  <c:v>1466.2882208747301</c:v>
                </c:pt>
                <c:pt idx="6315">
                  <c:v>1466.5204489743301</c:v>
                </c:pt>
                <c:pt idx="6316">
                  <c:v>1466.75267707393</c:v>
                </c:pt>
                <c:pt idx="6317">
                  <c:v>1466.98490517353</c:v>
                </c:pt>
                <c:pt idx="6318">
                  <c:v>1467.21713327313</c:v>
                </c:pt>
                <c:pt idx="6319">
                  <c:v>1467.44936137273</c:v>
                </c:pt>
                <c:pt idx="6320">
                  <c:v>1467.68158947233</c:v>
                </c:pt>
                <c:pt idx="6321">
                  <c:v>1467.9138175719299</c:v>
                </c:pt>
                <c:pt idx="6322">
                  <c:v>1468.1460456715299</c:v>
                </c:pt>
                <c:pt idx="6323">
                  <c:v>1468.3782737711299</c:v>
                </c:pt>
                <c:pt idx="6324">
                  <c:v>1468.6105018707301</c:v>
                </c:pt>
                <c:pt idx="6325">
                  <c:v>1468.8427299703301</c:v>
                </c:pt>
                <c:pt idx="6326">
                  <c:v>1469.0749580699301</c:v>
                </c:pt>
                <c:pt idx="6327">
                  <c:v>1469.30718616953</c:v>
                </c:pt>
                <c:pt idx="6328">
                  <c:v>1469.53941426913</c:v>
                </c:pt>
                <c:pt idx="6329">
                  <c:v>1469.77164236873</c:v>
                </c:pt>
                <c:pt idx="6330">
                  <c:v>1470.00387046833</c:v>
                </c:pt>
                <c:pt idx="6331">
                  <c:v>1470.23609856793</c:v>
                </c:pt>
                <c:pt idx="6332">
                  <c:v>1470.4683266675299</c:v>
                </c:pt>
                <c:pt idx="6333">
                  <c:v>1470.7005547671299</c:v>
                </c:pt>
                <c:pt idx="6334">
                  <c:v>1470.9327828667299</c:v>
                </c:pt>
                <c:pt idx="6335">
                  <c:v>1471.1650109663301</c:v>
                </c:pt>
                <c:pt idx="6336">
                  <c:v>1471.3972390659301</c:v>
                </c:pt>
                <c:pt idx="6337">
                  <c:v>1471.6294671655301</c:v>
                </c:pt>
                <c:pt idx="6338">
                  <c:v>1471.86169526513</c:v>
                </c:pt>
                <c:pt idx="6339">
                  <c:v>1472.09392336473</c:v>
                </c:pt>
                <c:pt idx="6340">
                  <c:v>1472.32615146433</c:v>
                </c:pt>
                <c:pt idx="6341">
                  <c:v>1472.55837956393</c:v>
                </c:pt>
                <c:pt idx="6342">
                  <c:v>1472.79060766353</c:v>
                </c:pt>
                <c:pt idx="6343">
                  <c:v>1473.0228357631299</c:v>
                </c:pt>
                <c:pt idx="6344">
                  <c:v>1473.2550638627299</c:v>
                </c:pt>
                <c:pt idx="6345">
                  <c:v>1473.4872919623299</c:v>
                </c:pt>
                <c:pt idx="6346">
                  <c:v>1473.7195200619301</c:v>
                </c:pt>
                <c:pt idx="6347">
                  <c:v>1473.9517481615301</c:v>
                </c:pt>
                <c:pt idx="6348">
                  <c:v>1474.1839762611301</c:v>
                </c:pt>
                <c:pt idx="6349">
                  <c:v>1474.41620436073</c:v>
                </c:pt>
                <c:pt idx="6350">
                  <c:v>1474.64843246033</c:v>
                </c:pt>
                <c:pt idx="6351">
                  <c:v>1474.88066055993</c:v>
                </c:pt>
                <c:pt idx="6352">
                  <c:v>1475.11288865953</c:v>
                </c:pt>
                <c:pt idx="6353">
                  <c:v>1475.34511675913</c:v>
                </c:pt>
                <c:pt idx="6354">
                  <c:v>1475.5773448587299</c:v>
                </c:pt>
                <c:pt idx="6355">
                  <c:v>1475.8095729583299</c:v>
                </c:pt>
                <c:pt idx="6356">
                  <c:v>1476.0418010579299</c:v>
                </c:pt>
                <c:pt idx="6357">
                  <c:v>1476.2740291575301</c:v>
                </c:pt>
                <c:pt idx="6358">
                  <c:v>1476.5062572571301</c:v>
                </c:pt>
                <c:pt idx="6359">
                  <c:v>1476.7384853567301</c:v>
                </c:pt>
                <c:pt idx="6360">
                  <c:v>1476.97071345633</c:v>
                </c:pt>
                <c:pt idx="6361">
                  <c:v>1477.20294155593</c:v>
                </c:pt>
                <c:pt idx="6362">
                  <c:v>1477.43516965553</c:v>
                </c:pt>
                <c:pt idx="6363">
                  <c:v>1477.66739775513</c:v>
                </c:pt>
                <c:pt idx="6364">
                  <c:v>1477.8996258547299</c:v>
                </c:pt>
                <c:pt idx="6365">
                  <c:v>1478.1318539543299</c:v>
                </c:pt>
                <c:pt idx="6366">
                  <c:v>1478.3640820539299</c:v>
                </c:pt>
                <c:pt idx="6367">
                  <c:v>1478.5963101535301</c:v>
                </c:pt>
                <c:pt idx="6368">
                  <c:v>1478.8285382531301</c:v>
                </c:pt>
                <c:pt idx="6369">
                  <c:v>1479.0607663527301</c:v>
                </c:pt>
                <c:pt idx="6370">
                  <c:v>1479.29299445233</c:v>
                </c:pt>
                <c:pt idx="6371">
                  <c:v>1479.52522255193</c:v>
                </c:pt>
                <c:pt idx="6372">
                  <c:v>1479.75745065153</c:v>
                </c:pt>
                <c:pt idx="6373">
                  <c:v>1479.98967875113</c:v>
                </c:pt>
                <c:pt idx="6374">
                  <c:v>1480.22190685073</c:v>
                </c:pt>
                <c:pt idx="6375">
                  <c:v>1480.4541349503299</c:v>
                </c:pt>
                <c:pt idx="6376">
                  <c:v>1480.6863630499299</c:v>
                </c:pt>
                <c:pt idx="6377">
                  <c:v>1480.9185911495299</c:v>
                </c:pt>
                <c:pt idx="6378">
                  <c:v>1481.1508192491301</c:v>
                </c:pt>
                <c:pt idx="6379">
                  <c:v>1481.3830473487301</c:v>
                </c:pt>
                <c:pt idx="6380">
                  <c:v>1481.6152754483301</c:v>
                </c:pt>
                <c:pt idx="6381">
                  <c:v>1481.84750354793</c:v>
                </c:pt>
                <c:pt idx="6382">
                  <c:v>1482.07973164753</c:v>
                </c:pt>
                <c:pt idx="6383">
                  <c:v>1482.31195974713</c:v>
                </c:pt>
                <c:pt idx="6384">
                  <c:v>1482.54418784673</c:v>
                </c:pt>
                <c:pt idx="6385">
                  <c:v>1482.77641594633</c:v>
                </c:pt>
                <c:pt idx="6386">
                  <c:v>1483.0086440459299</c:v>
                </c:pt>
                <c:pt idx="6387">
                  <c:v>1483.2408721455299</c:v>
                </c:pt>
                <c:pt idx="6388">
                  <c:v>1483.4731002451299</c:v>
                </c:pt>
                <c:pt idx="6389">
                  <c:v>1483.7053283447301</c:v>
                </c:pt>
                <c:pt idx="6390">
                  <c:v>1483.9375564443301</c:v>
                </c:pt>
                <c:pt idx="6391">
                  <c:v>1484.1697845439301</c:v>
                </c:pt>
                <c:pt idx="6392">
                  <c:v>1484.40201264353</c:v>
                </c:pt>
                <c:pt idx="6393">
                  <c:v>1484.63424074313</c:v>
                </c:pt>
                <c:pt idx="6394">
                  <c:v>1484.86646884273</c:v>
                </c:pt>
                <c:pt idx="6395">
                  <c:v>1485.09869694233</c:v>
                </c:pt>
                <c:pt idx="6396">
                  <c:v>1485.33092504193</c:v>
                </c:pt>
                <c:pt idx="6397">
                  <c:v>1485.5631531415299</c:v>
                </c:pt>
                <c:pt idx="6398">
                  <c:v>1485.7953812411299</c:v>
                </c:pt>
                <c:pt idx="6399">
                  <c:v>1486.0276093407299</c:v>
                </c:pt>
                <c:pt idx="6400">
                  <c:v>1486.2598374403301</c:v>
                </c:pt>
                <c:pt idx="6401">
                  <c:v>1486.4920655399301</c:v>
                </c:pt>
                <c:pt idx="6402">
                  <c:v>1486.7242936395301</c:v>
                </c:pt>
                <c:pt idx="6403">
                  <c:v>1486.95652173913</c:v>
                </c:pt>
                <c:pt idx="6404">
                  <c:v>1487.18874983873</c:v>
                </c:pt>
                <c:pt idx="6405">
                  <c:v>1487.42097793833</c:v>
                </c:pt>
                <c:pt idx="6406">
                  <c:v>1487.65320603793</c:v>
                </c:pt>
                <c:pt idx="6407">
                  <c:v>1487.88543413753</c:v>
                </c:pt>
                <c:pt idx="6408">
                  <c:v>1488.1176622371299</c:v>
                </c:pt>
                <c:pt idx="6409">
                  <c:v>1488.3498903367299</c:v>
                </c:pt>
                <c:pt idx="6410">
                  <c:v>1488.5821184363299</c:v>
                </c:pt>
                <c:pt idx="6411">
                  <c:v>1488.8143465359301</c:v>
                </c:pt>
                <c:pt idx="6412">
                  <c:v>1489.0465746355301</c:v>
                </c:pt>
                <c:pt idx="6413">
                  <c:v>1489.2788027351301</c:v>
                </c:pt>
                <c:pt idx="6414">
                  <c:v>1489.51103083473</c:v>
                </c:pt>
                <c:pt idx="6415">
                  <c:v>1489.74325893433</c:v>
                </c:pt>
                <c:pt idx="6416">
                  <c:v>1489.97548703393</c:v>
                </c:pt>
                <c:pt idx="6417">
                  <c:v>1490.20771513353</c:v>
                </c:pt>
                <c:pt idx="6418">
                  <c:v>1490.43994323313</c:v>
                </c:pt>
                <c:pt idx="6419">
                  <c:v>1490.6721713327299</c:v>
                </c:pt>
                <c:pt idx="6420">
                  <c:v>1490.9043994323299</c:v>
                </c:pt>
                <c:pt idx="6421">
                  <c:v>1491.1366275319299</c:v>
                </c:pt>
                <c:pt idx="6422">
                  <c:v>1491.3688556315301</c:v>
                </c:pt>
                <c:pt idx="6423">
                  <c:v>1491.6010837311301</c:v>
                </c:pt>
                <c:pt idx="6424">
                  <c:v>1491.8333118307301</c:v>
                </c:pt>
                <c:pt idx="6425">
                  <c:v>1492.06553993033</c:v>
                </c:pt>
                <c:pt idx="6426">
                  <c:v>1492.29776802993</c:v>
                </c:pt>
                <c:pt idx="6427">
                  <c:v>1492.52999612953</c:v>
                </c:pt>
                <c:pt idx="6428">
                  <c:v>1492.76222422913</c:v>
                </c:pt>
                <c:pt idx="6429">
                  <c:v>1492.9944523287299</c:v>
                </c:pt>
                <c:pt idx="6430">
                  <c:v>1493.2266804283299</c:v>
                </c:pt>
                <c:pt idx="6431">
                  <c:v>1493.4589085279299</c:v>
                </c:pt>
                <c:pt idx="6432">
                  <c:v>1493.6911366275301</c:v>
                </c:pt>
                <c:pt idx="6433">
                  <c:v>1493.9233647271301</c:v>
                </c:pt>
                <c:pt idx="6434">
                  <c:v>1494.1555928267301</c:v>
                </c:pt>
                <c:pt idx="6435">
                  <c:v>1494.3878209263301</c:v>
                </c:pt>
                <c:pt idx="6436">
                  <c:v>1494.62004902593</c:v>
                </c:pt>
                <c:pt idx="6437">
                  <c:v>1494.85227712553</c:v>
                </c:pt>
                <c:pt idx="6438">
                  <c:v>1495.08450522513</c:v>
                </c:pt>
                <c:pt idx="6439">
                  <c:v>1495.31673332473</c:v>
                </c:pt>
                <c:pt idx="6440">
                  <c:v>1495.5489614243299</c:v>
                </c:pt>
                <c:pt idx="6441">
                  <c:v>1495.7811895239299</c:v>
                </c:pt>
                <c:pt idx="6442">
                  <c:v>1496.0134176235299</c:v>
                </c:pt>
                <c:pt idx="6443">
                  <c:v>1496.2456457231301</c:v>
                </c:pt>
                <c:pt idx="6444">
                  <c:v>1496.4778738227301</c:v>
                </c:pt>
                <c:pt idx="6445">
                  <c:v>1496.7101019223301</c:v>
                </c:pt>
                <c:pt idx="6446">
                  <c:v>1496.94233002193</c:v>
                </c:pt>
                <c:pt idx="6447">
                  <c:v>1497.17455812153</c:v>
                </c:pt>
                <c:pt idx="6448">
                  <c:v>1497.40678622113</c:v>
                </c:pt>
                <c:pt idx="6449">
                  <c:v>1497.63901432073</c:v>
                </c:pt>
                <c:pt idx="6450">
                  <c:v>1497.87124242033</c:v>
                </c:pt>
                <c:pt idx="6451">
                  <c:v>1498.1034705199299</c:v>
                </c:pt>
                <c:pt idx="6452">
                  <c:v>1498.3356986195299</c:v>
                </c:pt>
                <c:pt idx="6453">
                  <c:v>1498.5679267191299</c:v>
                </c:pt>
                <c:pt idx="6454">
                  <c:v>1498.8001548187301</c:v>
                </c:pt>
                <c:pt idx="6455">
                  <c:v>1499.0323829183301</c:v>
                </c:pt>
                <c:pt idx="6456">
                  <c:v>1499.2646110179301</c:v>
                </c:pt>
                <c:pt idx="6457">
                  <c:v>1499.49683911753</c:v>
                </c:pt>
                <c:pt idx="6458">
                  <c:v>1499.72906721713</c:v>
                </c:pt>
                <c:pt idx="6459">
                  <c:v>1499.96129531673</c:v>
                </c:pt>
                <c:pt idx="6460">
                  <c:v>1500.19352341633</c:v>
                </c:pt>
                <c:pt idx="6461">
                  <c:v>1500.42575151593</c:v>
                </c:pt>
                <c:pt idx="6462">
                  <c:v>1500.6579796155299</c:v>
                </c:pt>
                <c:pt idx="6463">
                  <c:v>1500.8902077151299</c:v>
                </c:pt>
                <c:pt idx="6464">
                  <c:v>1501.1224358147299</c:v>
                </c:pt>
                <c:pt idx="6465">
                  <c:v>1501.3546639143301</c:v>
                </c:pt>
                <c:pt idx="6466">
                  <c:v>1501.5868920139301</c:v>
                </c:pt>
                <c:pt idx="6467">
                  <c:v>1501.8191201135301</c:v>
                </c:pt>
                <c:pt idx="6468">
                  <c:v>1502.05134821313</c:v>
                </c:pt>
                <c:pt idx="6469">
                  <c:v>1502.28357631273</c:v>
                </c:pt>
                <c:pt idx="6470">
                  <c:v>1502.51580441233</c:v>
                </c:pt>
                <c:pt idx="6471">
                  <c:v>1502.74803251193</c:v>
                </c:pt>
                <c:pt idx="6472">
                  <c:v>1502.98026061153</c:v>
                </c:pt>
                <c:pt idx="6473">
                  <c:v>1503.2124887111299</c:v>
                </c:pt>
                <c:pt idx="6474">
                  <c:v>1503.4447168107299</c:v>
                </c:pt>
                <c:pt idx="6475">
                  <c:v>1503.6769449103299</c:v>
                </c:pt>
                <c:pt idx="6476">
                  <c:v>1503.9091730099301</c:v>
                </c:pt>
                <c:pt idx="6477">
                  <c:v>1504.1414011095301</c:v>
                </c:pt>
                <c:pt idx="6478">
                  <c:v>1504.3736292091301</c:v>
                </c:pt>
                <c:pt idx="6479">
                  <c:v>1504.60585730873</c:v>
                </c:pt>
                <c:pt idx="6480">
                  <c:v>1504.83808540833</c:v>
                </c:pt>
                <c:pt idx="6481">
                  <c:v>1505.07031350793</c:v>
                </c:pt>
                <c:pt idx="6482">
                  <c:v>1505.30254160753</c:v>
                </c:pt>
                <c:pt idx="6483">
                  <c:v>1505.53476970713</c:v>
                </c:pt>
                <c:pt idx="6484">
                  <c:v>1505.7669978067299</c:v>
                </c:pt>
                <c:pt idx="6485">
                  <c:v>1505.9992259063299</c:v>
                </c:pt>
                <c:pt idx="6486">
                  <c:v>1506.2314540059299</c:v>
                </c:pt>
                <c:pt idx="6487">
                  <c:v>1506.4636821055301</c:v>
                </c:pt>
                <c:pt idx="6488">
                  <c:v>1506.6959102051301</c:v>
                </c:pt>
                <c:pt idx="6489">
                  <c:v>1506.9281383047301</c:v>
                </c:pt>
                <c:pt idx="6490">
                  <c:v>1507.16036640434</c:v>
                </c:pt>
                <c:pt idx="6491">
                  <c:v>1507.39259450394</c:v>
                </c:pt>
                <c:pt idx="6492">
                  <c:v>1507.62482260353</c:v>
                </c:pt>
                <c:pt idx="6493">
                  <c:v>1507.85705070314</c:v>
                </c:pt>
                <c:pt idx="6494">
                  <c:v>1508.08927880274</c:v>
                </c:pt>
                <c:pt idx="6495">
                  <c:v>1508.3215069023399</c:v>
                </c:pt>
                <c:pt idx="6496">
                  <c:v>1508.5537350019399</c:v>
                </c:pt>
                <c:pt idx="6497">
                  <c:v>1508.7859631015399</c:v>
                </c:pt>
                <c:pt idx="6498">
                  <c:v>1509.0181912011401</c:v>
                </c:pt>
                <c:pt idx="6499">
                  <c:v>1509.2504193007401</c:v>
                </c:pt>
                <c:pt idx="6500">
                  <c:v>1509.4826474003401</c:v>
                </c:pt>
                <c:pt idx="6501">
                  <c:v>1509.71487549994</c:v>
                </c:pt>
                <c:pt idx="6502">
                  <c:v>1509.94710359954</c:v>
                </c:pt>
                <c:pt idx="6503">
                  <c:v>1510.17933169914</c:v>
                </c:pt>
                <c:pt idx="6504">
                  <c:v>1510.41155979874</c:v>
                </c:pt>
                <c:pt idx="6505">
                  <c:v>1510.64378789834</c:v>
                </c:pt>
                <c:pt idx="6506">
                  <c:v>1510.8760159979399</c:v>
                </c:pt>
                <c:pt idx="6507">
                  <c:v>1511.1082440975399</c:v>
                </c:pt>
                <c:pt idx="6508">
                  <c:v>1511.3404721971399</c:v>
                </c:pt>
                <c:pt idx="6509">
                  <c:v>1511.5727002967401</c:v>
                </c:pt>
                <c:pt idx="6510">
                  <c:v>1511.8049283963401</c:v>
                </c:pt>
                <c:pt idx="6511">
                  <c:v>1512.0371564959401</c:v>
                </c:pt>
                <c:pt idx="6512">
                  <c:v>1512.26938459554</c:v>
                </c:pt>
                <c:pt idx="6513">
                  <c:v>1512.50161269514</c:v>
                </c:pt>
                <c:pt idx="6514">
                  <c:v>1512.73384079474</c:v>
                </c:pt>
                <c:pt idx="6515">
                  <c:v>1512.96606889434</c:v>
                </c:pt>
                <c:pt idx="6516">
                  <c:v>1513.1982969939399</c:v>
                </c:pt>
                <c:pt idx="6517">
                  <c:v>1513.4305250935399</c:v>
                </c:pt>
                <c:pt idx="6518">
                  <c:v>1513.6627531931399</c:v>
                </c:pt>
                <c:pt idx="6519">
                  <c:v>1513.8949812927401</c:v>
                </c:pt>
                <c:pt idx="6520">
                  <c:v>1514.1272093923401</c:v>
                </c:pt>
                <c:pt idx="6521">
                  <c:v>1514.3594374919401</c:v>
                </c:pt>
                <c:pt idx="6522">
                  <c:v>1514.59166559154</c:v>
                </c:pt>
                <c:pt idx="6523">
                  <c:v>1514.82389369114</c:v>
                </c:pt>
                <c:pt idx="6524">
                  <c:v>1515.05612179074</c:v>
                </c:pt>
                <c:pt idx="6525">
                  <c:v>1515.28834989034</c:v>
                </c:pt>
                <c:pt idx="6526">
                  <c:v>1515.52057798994</c:v>
                </c:pt>
                <c:pt idx="6527">
                  <c:v>1515.7528060895399</c:v>
                </c:pt>
                <c:pt idx="6528">
                  <c:v>1515.9850341891399</c:v>
                </c:pt>
                <c:pt idx="6529">
                  <c:v>1516.2172622887399</c:v>
                </c:pt>
                <c:pt idx="6530">
                  <c:v>1516.4494903883401</c:v>
                </c:pt>
                <c:pt idx="6531">
                  <c:v>1516.6817184879401</c:v>
                </c:pt>
                <c:pt idx="6532">
                  <c:v>1516.9139465875401</c:v>
                </c:pt>
                <c:pt idx="6533">
                  <c:v>1517.14617468714</c:v>
                </c:pt>
                <c:pt idx="6534">
                  <c:v>1517.37840278674</c:v>
                </c:pt>
                <c:pt idx="6535">
                  <c:v>1517.61063088634</c:v>
                </c:pt>
                <c:pt idx="6536">
                  <c:v>1517.84285898594</c:v>
                </c:pt>
                <c:pt idx="6537">
                  <c:v>1518.07508708554</c:v>
                </c:pt>
                <c:pt idx="6538">
                  <c:v>1518.3073151851399</c:v>
                </c:pt>
                <c:pt idx="6539">
                  <c:v>1518.5395432847399</c:v>
                </c:pt>
                <c:pt idx="6540">
                  <c:v>1518.7717713843399</c:v>
                </c:pt>
                <c:pt idx="6541">
                  <c:v>1519.0039994839401</c:v>
                </c:pt>
                <c:pt idx="6542">
                  <c:v>1519.2362275835401</c:v>
                </c:pt>
                <c:pt idx="6543">
                  <c:v>1519.4684556831401</c:v>
                </c:pt>
                <c:pt idx="6544">
                  <c:v>1519.70068378274</c:v>
                </c:pt>
                <c:pt idx="6545">
                  <c:v>1519.93291188234</c:v>
                </c:pt>
                <c:pt idx="6546">
                  <c:v>1520.16513998194</c:v>
                </c:pt>
                <c:pt idx="6547">
                  <c:v>1520.39736808154</c:v>
                </c:pt>
                <c:pt idx="6548">
                  <c:v>1520.62959618114</c:v>
                </c:pt>
                <c:pt idx="6549">
                  <c:v>1520.8618242807399</c:v>
                </c:pt>
                <c:pt idx="6550">
                  <c:v>1521.0940523803399</c:v>
                </c:pt>
                <c:pt idx="6551">
                  <c:v>1521.3262804799399</c:v>
                </c:pt>
                <c:pt idx="6552">
                  <c:v>1521.5585085795401</c:v>
                </c:pt>
                <c:pt idx="6553">
                  <c:v>1521.7907366791401</c:v>
                </c:pt>
                <c:pt idx="6554">
                  <c:v>1522.0229647787401</c:v>
                </c:pt>
                <c:pt idx="6555">
                  <c:v>1522.25519287834</c:v>
                </c:pt>
                <c:pt idx="6556">
                  <c:v>1522.48742097794</c:v>
                </c:pt>
                <c:pt idx="6557">
                  <c:v>1522.71964907754</c:v>
                </c:pt>
                <c:pt idx="6558">
                  <c:v>1522.95187717714</c:v>
                </c:pt>
                <c:pt idx="6559">
                  <c:v>1523.18410527674</c:v>
                </c:pt>
                <c:pt idx="6560">
                  <c:v>1523.4163333763399</c:v>
                </c:pt>
                <c:pt idx="6561">
                  <c:v>1523.6485614759399</c:v>
                </c:pt>
                <c:pt idx="6562">
                  <c:v>1523.8807895755399</c:v>
                </c:pt>
                <c:pt idx="6563">
                  <c:v>1524.1130176751401</c:v>
                </c:pt>
                <c:pt idx="6564">
                  <c:v>1524.3452457747401</c:v>
                </c:pt>
                <c:pt idx="6565">
                  <c:v>1524.5774738743401</c:v>
                </c:pt>
                <c:pt idx="6566">
                  <c:v>1524.80970197394</c:v>
                </c:pt>
                <c:pt idx="6567">
                  <c:v>1525.04193007354</c:v>
                </c:pt>
                <c:pt idx="6568">
                  <c:v>1525.27415817314</c:v>
                </c:pt>
                <c:pt idx="6569">
                  <c:v>1525.50638627274</c:v>
                </c:pt>
                <c:pt idx="6570">
                  <c:v>1525.73861437234</c:v>
                </c:pt>
                <c:pt idx="6571">
                  <c:v>1525.9708424719399</c:v>
                </c:pt>
                <c:pt idx="6572">
                  <c:v>1526.2030705715399</c:v>
                </c:pt>
                <c:pt idx="6573">
                  <c:v>1526.4352986711399</c:v>
                </c:pt>
                <c:pt idx="6574">
                  <c:v>1526.6675267707401</c:v>
                </c:pt>
                <c:pt idx="6575">
                  <c:v>1526.8997548703401</c:v>
                </c:pt>
                <c:pt idx="6576">
                  <c:v>1527.1319829699401</c:v>
                </c:pt>
                <c:pt idx="6577">
                  <c:v>1527.36421106954</c:v>
                </c:pt>
                <c:pt idx="6578">
                  <c:v>1527.59643916914</c:v>
                </c:pt>
                <c:pt idx="6579">
                  <c:v>1527.82866726874</c:v>
                </c:pt>
                <c:pt idx="6580">
                  <c:v>1528.06089536834</c:v>
                </c:pt>
                <c:pt idx="6581">
                  <c:v>1528.2931234679399</c:v>
                </c:pt>
                <c:pt idx="6582">
                  <c:v>1528.5253515675399</c:v>
                </c:pt>
                <c:pt idx="6583">
                  <c:v>1528.7575796671399</c:v>
                </c:pt>
                <c:pt idx="6584">
                  <c:v>1528.9898077667399</c:v>
                </c:pt>
                <c:pt idx="6585">
                  <c:v>1529.2220358663401</c:v>
                </c:pt>
                <c:pt idx="6586">
                  <c:v>1529.4542639659401</c:v>
                </c:pt>
                <c:pt idx="6587">
                  <c:v>1529.6864920655401</c:v>
                </c:pt>
                <c:pt idx="6588">
                  <c:v>1529.91872016514</c:v>
                </c:pt>
                <c:pt idx="6589">
                  <c:v>1530.15094826474</c:v>
                </c:pt>
                <c:pt idx="6590">
                  <c:v>1530.38317636434</c:v>
                </c:pt>
                <c:pt idx="6591">
                  <c:v>1530.61540446394</c:v>
                </c:pt>
                <c:pt idx="6592">
                  <c:v>1530.8476325635399</c:v>
                </c:pt>
                <c:pt idx="6593">
                  <c:v>1531.0798606631399</c:v>
                </c:pt>
                <c:pt idx="6594">
                  <c:v>1531.3120887627399</c:v>
                </c:pt>
                <c:pt idx="6595">
                  <c:v>1531.5443168623401</c:v>
                </c:pt>
                <c:pt idx="6596">
                  <c:v>1531.7765449619401</c:v>
                </c:pt>
                <c:pt idx="6597">
                  <c:v>1532.0087730615401</c:v>
                </c:pt>
                <c:pt idx="6598">
                  <c:v>1532.24100116114</c:v>
                </c:pt>
                <c:pt idx="6599">
                  <c:v>1532.47322926074</c:v>
                </c:pt>
                <c:pt idx="6600">
                  <c:v>1532.70545736034</c:v>
                </c:pt>
                <c:pt idx="6601">
                  <c:v>1532.93768545994</c:v>
                </c:pt>
                <c:pt idx="6602">
                  <c:v>1533.16991355954</c:v>
                </c:pt>
                <c:pt idx="6603">
                  <c:v>1533.4021416591399</c:v>
                </c:pt>
                <c:pt idx="6604">
                  <c:v>1533.6343697587399</c:v>
                </c:pt>
                <c:pt idx="6605">
                  <c:v>1533.8665978583399</c:v>
                </c:pt>
                <c:pt idx="6606">
                  <c:v>1534.0988259579401</c:v>
                </c:pt>
                <c:pt idx="6607">
                  <c:v>1534.3310540575401</c:v>
                </c:pt>
                <c:pt idx="6608">
                  <c:v>1534.5632821571401</c:v>
                </c:pt>
                <c:pt idx="6609">
                  <c:v>1534.79551025674</c:v>
                </c:pt>
                <c:pt idx="6610">
                  <c:v>1535.02773835634</c:v>
                </c:pt>
                <c:pt idx="6611">
                  <c:v>1535.25996645594</c:v>
                </c:pt>
                <c:pt idx="6612">
                  <c:v>1535.49219455554</c:v>
                </c:pt>
                <c:pt idx="6613">
                  <c:v>1535.72442265514</c:v>
                </c:pt>
                <c:pt idx="6614">
                  <c:v>1535.9566507547399</c:v>
                </c:pt>
                <c:pt idx="6615">
                  <c:v>1536.1888788543399</c:v>
                </c:pt>
                <c:pt idx="6616">
                  <c:v>1536.4211069539399</c:v>
                </c:pt>
                <c:pt idx="6617">
                  <c:v>1536.6533350535401</c:v>
                </c:pt>
                <c:pt idx="6618">
                  <c:v>1536.8855631531401</c:v>
                </c:pt>
                <c:pt idx="6619">
                  <c:v>1537.1177912527401</c:v>
                </c:pt>
                <c:pt idx="6620">
                  <c:v>1537.35001935234</c:v>
                </c:pt>
                <c:pt idx="6621">
                  <c:v>1537.58224745194</c:v>
                </c:pt>
                <c:pt idx="6622">
                  <c:v>1537.81447555154</c:v>
                </c:pt>
                <c:pt idx="6623">
                  <c:v>1538.04670365114</c:v>
                </c:pt>
                <c:pt idx="6624">
                  <c:v>1538.27893175074</c:v>
                </c:pt>
                <c:pt idx="6625">
                  <c:v>1538.5111598503399</c:v>
                </c:pt>
                <c:pt idx="6626">
                  <c:v>1538.7433879499399</c:v>
                </c:pt>
                <c:pt idx="6627">
                  <c:v>1538.9756160495399</c:v>
                </c:pt>
                <c:pt idx="6628">
                  <c:v>1539.2078441491401</c:v>
                </c:pt>
                <c:pt idx="6629">
                  <c:v>1539.4400722487401</c:v>
                </c:pt>
                <c:pt idx="6630">
                  <c:v>1539.6723003483401</c:v>
                </c:pt>
                <c:pt idx="6631">
                  <c:v>1539.90452844794</c:v>
                </c:pt>
                <c:pt idx="6632">
                  <c:v>1540.13675654754</c:v>
                </c:pt>
                <c:pt idx="6633">
                  <c:v>1540.36898464714</c:v>
                </c:pt>
                <c:pt idx="6634">
                  <c:v>1540.60121274674</c:v>
                </c:pt>
                <c:pt idx="6635">
                  <c:v>1540.83344084634</c:v>
                </c:pt>
                <c:pt idx="6636">
                  <c:v>1541.0656689459399</c:v>
                </c:pt>
                <c:pt idx="6637">
                  <c:v>1541.2978970455399</c:v>
                </c:pt>
                <c:pt idx="6638">
                  <c:v>1541.5301251451399</c:v>
                </c:pt>
                <c:pt idx="6639">
                  <c:v>1541.7623532447401</c:v>
                </c:pt>
                <c:pt idx="6640">
                  <c:v>1541.9945813443401</c:v>
                </c:pt>
                <c:pt idx="6641">
                  <c:v>1542.2268094439401</c:v>
                </c:pt>
                <c:pt idx="6642">
                  <c:v>1542.45903754354</c:v>
                </c:pt>
                <c:pt idx="6643">
                  <c:v>1542.69126564314</c:v>
                </c:pt>
                <c:pt idx="6644">
                  <c:v>1542.92349374274</c:v>
                </c:pt>
                <c:pt idx="6645">
                  <c:v>1543.15572184234</c:v>
                </c:pt>
                <c:pt idx="6646">
                  <c:v>1543.38794994194</c:v>
                </c:pt>
                <c:pt idx="6647">
                  <c:v>1543.6201780415399</c:v>
                </c:pt>
                <c:pt idx="6648">
                  <c:v>1543.8524061411399</c:v>
                </c:pt>
                <c:pt idx="6649">
                  <c:v>1544.0846342407399</c:v>
                </c:pt>
                <c:pt idx="6650">
                  <c:v>1544.3168623403401</c:v>
                </c:pt>
                <c:pt idx="6651">
                  <c:v>1544.5490904399401</c:v>
                </c:pt>
                <c:pt idx="6652">
                  <c:v>1544.7813185395401</c:v>
                </c:pt>
                <c:pt idx="6653">
                  <c:v>1545.01354663914</c:v>
                </c:pt>
                <c:pt idx="6654">
                  <c:v>1545.24577473874</c:v>
                </c:pt>
                <c:pt idx="6655">
                  <c:v>1545.47800283834</c:v>
                </c:pt>
                <c:pt idx="6656">
                  <c:v>1545.71023093794</c:v>
                </c:pt>
                <c:pt idx="6657">
                  <c:v>1545.9424590375399</c:v>
                </c:pt>
                <c:pt idx="6658">
                  <c:v>1546.1746871371399</c:v>
                </c:pt>
                <c:pt idx="6659">
                  <c:v>1546.4069152367399</c:v>
                </c:pt>
                <c:pt idx="6660">
                  <c:v>1546.6391433363401</c:v>
                </c:pt>
                <c:pt idx="6661">
                  <c:v>1546.8713714359401</c:v>
                </c:pt>
                <c:pt idx="6662">
                  <c:v>1547.1035995355401</c:v>
                </c:pt>
                <c:pt idx="6663">
                  <c:v>1547.33582763514</c:v>
                </c:pt>
                <c:pt idx="6664">
                  <c:v>1547.56805573474</c:v>
                </c:pt>
                <c:pt idx="6665">
                  <c:v>1547.80028383434</c:v>
                </c:pt>
                <c:pt idx="6666">
                  <c:v>1548.03251193394</c:v>
                </c:pt>
                <c:pt idx="6667">
                  <c:v>1548.26474003354</c:v>
                </c:pt>
                <c:pt idx="6668">
                  <c:v>1548.4969681331399</c:v>
                </c:pt>
                <c:pt idx="6669">
                  <c:v>1548.7291962327399</c:v>
                </c:pt>
                <c:pt idx="6670">
                  <c:v>1548.9614243323399</c:v>
                </c:pt>
                <c:pt idx="6671">
                  <c:v>1549.1936524319401</c:v>
                </c:pt>
                <c:pt idx="6672">
                  <c:v>1549.4258805315401</c:v>
                </c:pt>
                <c:pt idx="6673">
                  <c:v>1549.6581086311401</c:v>
                </c:pt>
                <c:pt idx="6674">
                  <c:v>1549.89033673074</c:v>
                </c:pt>
                <c:pt idx="6675">
                  <c:v>1550.12256483034</c:v>
                </c:pt>
                <c:pt idx="6676">
                  <c:v>1550.35479292994</c:v>
                </c:pt>
                <c:pt idx="6677">
                  <c:v>1550.58702102954</c:v>
                </c:pt>
                <c:pt idx="6678">
                  <c:v>1550.81924912914</c:v>
                </c:pt>
                <c:pt idx="6679">
                  <c:v>1551.0514772287399</c:v>
                </c:pt>
                <c:pt idx="6680">
                  <c:v>1551.2837053283399</c:v>
                </c:pt>
                <c:pt idx="6681">
                  <c:v>1551.5159334279399</c:v>
                </c:pt>
                <c:pt idx="6682">
                  <c:v>1551.7481615275401</c:v>
                </c:pt>
                <c:pt idx="6683">
                  <c:v>1551.9803896271401</c:v>
                </c:pt>
                <c:pt idx="6684">
                  <c:v>1552.2126177267501</c:v>
                </c:pt>
                <c:pt idx="6685">
                  <c:v>1552.44484582635</c:v>
                </c:pt>
                <c:pt idx="6686">
                  <c:v>1552.67707392595</c:v>
                </c:pt>
                <c:pt idx="6687">
                  <c:v>1552.90930202555</c:v>
                </c:pt>
                <c:pt idx="6688">
                  <c:v>1553.14153012515</c:v>
                </c:pt>
                <c:pt idx="6689">
                  <c:v>1553.37375822475</c:v>
                </c:pt>
                <c:pt idx="6690">
                  <c:v>1553.6059863243499</c:v>
                </c:pt>
                <c:pt idx="6691">
                  <c:v>1553.8382144239499</c:v>
                </c:pt>
                <c:pt idx="6692">
                  <c:v>1554.0704425235499</c:v>
                </c:pt>
                <c:pt idx="6693">
                  <c:v>1554.3026706231501</c:v>
                </c:pt>
                <c:pt idx="6694">
                  <c:v>1554.5348987227501</c:v>
                </c:pt>
                <c:pt idx="6695">
                  <c:v>1554.7671268223501</c:v>
                </c:pt>
                <c:pt idx="6696">
                  <c:v>1554.99935492195</c:v>
                </c:pt>
                <c:pt idx="6697">
                  <c:v>1555.23158302155</c:v>
                </c:pt>
                <c:pt idx="6698">
                  <c:v>1555.46381112115</c:v>
                </c:pt>
                <c:pt idx="6699">
                  <c:v>1555.69603922075</c:v>
                </c:pt>
                <c:pt idx="6700">
                  <c:v>1555.92826732035</c:v>
                </c:pt>
                <c:pt idx="6701">
                  <c:v>1556.1604954199499</c:v>
                </c:pt>
                <c:pt idx="6702">
                  <c:v>1556.3927235195499</c:v>
                </c:pt>
                <c:pt idx="6703">
                  <c:v>1556.6249516191499</c:v>
                </c:pt>
                <c:pt idx="6704">
                  <c:v>1556.8571797187501</c:v>
                </c:pt>
                <c:pt idx="6705">
                  <c:v>1557.0894078183501</c:v>
                </c:pt>
                <c:pt idx="6706">
                  <c:v>1557.3216359179501</c:v>
                </c:pt>
                <c:pt idx="6707">
                  <c:v>1557.55386401755</c:v>
                </c:pt>
                <c:pt idx="6708">
                  <c:v>1557.78609211715</c:v>
                </c:pt>
                <c:pt idx="6709">
                  <c:v>1558.01832021675</c:v>
                </c:pt>
                <c:pt idx="6710">
                  <c:v>1558.25054831635</c:v>
                </c:pt>
                <c:pt idx="6711">
                  <c:v>1558.48277641595</c:v>
                </c:pt>
                <c:pt idx="6712">
                  <c:v>1558.7150045155499</c:v>
                </c:pt>
                <c:pt idx="6713">
                  <c:v>1558.9472326151499</c:v>
                </c:pt>
                <c:pt idx="6714">
                  <c:v>1559.1794607147499</c:v>
                </c:pt>
                <c:pt idx="6715">
                  <c:v>1559.4116888143501</c:v>
                </c:pt>
                <c:pt idx="6716">
                  <c:v>1559.6439169139501</c:v>
                </c:pt>
                <c:pt idx="6717">
                  <c:v>1559.8761450135501</c:v>
                </c:pt>
                <c:pt idx="6718">
                  <c:v>1560.10837311315</c:v>
                </c:pt>
                <c:pt idx="6719">
                  <c:v>1560.34060121275</c:v>
                </c:pt>
                <c:pt idx="6720">
                  <c:v>1560.57282931235</c:v>
                </c:pt>
                <c:pt idx="6721">
                  <c:v>1560.80505741195</c:v>
                </c:pt>
                <c:pt idx="6722">
                  <c:v>1561.03728551155</c:v>
                </c:pt>
                <c:pt idx="6723">
                  <c:v>1561.2695136111499</c:v>
                </c:pt>
                <c:pt idx="6724">
                  <c:v>1561.5017417107499</c:v>
                </c:pt>
                <c:pt idx="6725">
                  <c:v>1561.7339698103499</c:v>
                </c:pt>
                <c:pt idx="6726">
                  <c:v>1561.9661979099501</c:v>
                </c:pt>
                <c:pt idx="6727">
                  <c:v>1562.1984260095501</c:v>
                </c:pt>
                <c:pt idx="6728">
                  <c:v>1562.4306541091501</c:v>
                </c:pt>
                <c:pt idx="6729">
                  <c:v>1562.66288220875</c:v>
                </c:pt>
                <c:pt idx="6730">
                  <c:v>1562.89511030835</c:v>
                </c:pt>
                <c:pt idx="6731">
                  <c:v>1563.12733840795</c:v>
                </c:pt>
                <c:pt idx="6732">
                  <c:v>1563.35956650755</c:v>
                </c:pt>
                <c:pt idx="6733">
                  <c:v>1563.59179460715</c:v>
                </c:pt>
                <c:pt idx="6734">
                  <c:v>1563.8240227067499</c:v>
                </c:pt>
                <c:pt idx="6735">
                  <c:v>1564.0562508063499</c:v>
                </c:pt>
                <c:pt idx="6736">
                  <c:v>1564.2884789059499</c:v>
                </c:pt>
                <c:pt idx="6737">
                  <c:v>1564.5207070055501</c:v>
                </c:pt>
                <c:pt idx="6738">
                  <c:v>1564.7529351051501</c:v>
                </c:pt>
                <c:pt idx="6739">
                  <c:v>1564.9851632047501</c:v>
                </c:pt>
                <c:pt idx="6740">
                  <c:v>1565.21739130435</c:v>
                </c:pt>
                <c:pt idx="6741">
                  <c:v>1565.44961940395</c:v>
                </c:pt>
                <c:pt idx="6742">
                  <c:v>1565.68184750355</c:v>
                </c:pt>
                <c:pt idx="6743">
                  <c:v>1565.91407560315</c:v>
                </c:pt>
                <c:pt idx="6744">
                  <c:v>1566.1463037027499</c:v>
                </c:pt>
                <c:pt idx="6745">
                  <c:v>1566.3785318023499</c:v>
                </c:pt>
                <c:pt idx="6746">
                  <c:v>1566.6107599019499</c:v>
                </c:pt>
                <c:pt idx="6747">
                  <c:v>1566.8429880015501</c:v>
                </c:pt>
                <c:pt idx="6748">
                  <c:v>1567.0752161011501</c:v>
                </c:pt>
                <c:pt idx="6749">
                  <c:v>1567.3074442007501</c:v>
                </c:pt>
                <c:pt idx="6750">
                  <c:v>1567.53967230035</c:v>
                </c:pt>
                <c:pt idx="6751">
                  <c:v>1567.77190039995</c:v>
                </c:pt>
                <c:pt idx="6752">
                  <c:v>1568.00412849955</c:v>
                </c:pt>
                <c:pt idx="6753">
                  <c:v>1568.23635659915</c:v>
                </c:pt>
                <c:pt idx="6754">
                  <c:v>1568.46858469875</c:v>
                </c:pt>
                <c:pt idx="6755">
                  <c:v>1568.7008127983499</c:v>
                </c:pt>
                <c:pt idx="6756">
                  <c:v>1568.9330408979499</c:v>
                </c:pt>
                <c:pt idx="6757">
                  <c:v>1569.1652689975499</c:v>
                </c:pt>
                <c:pt idx="6758">
                  <c:v>1569.3974970971501</c:v>
                </c:pt>
                <c:pt idx="6759">
                  <c:v>1569.6297251967501</c:v>
                </c:pt>
                <c:pt idx="6760">
                  <c:v>1569.8619532963501</c:v>
                </c:pt>
                <c:pt idx="6761">
                  <c:v>1570.09418139595</c:v>
                </c:pt>
                <c:pt idx="6762">
                  <c:v>1570.32640949555</c:v>
                </c:pt>
                <c:pt idx="6763">
                  <c:v>1570.55863759515</c:v>
                </c:pt>
                <c:pt idx="6764">
                  <c:v>1570.79086569475</c:v>
                </c:pt>
                <c:pt idx="6765">
                  <c:v>1571.02309379435</c:v>
                </c:pt>
                <c:pt idx="6766">
                  <c:v>1571.2553218939499</c:v>
                </c:pt>
                <c:pt idx="6767">
                  <c:v>1571.4875499935499</c:v>
                </c:pt>
                <c:pt idx="6768">
                  <c:v>1571.7197780931499</c:v>
                </c:pt>
                <c:pt idx="6769">
                  <c:v>1571.9520061927501</c:v>
                </c:pt>
                <c:pt idx="6770">
                  <c:v>1572.1842342923501</c:v>
                </c:pt>
                <c:pt idx="6771">
                  <c:v>1572.4164623919501</c:v>
                </c:pt>
                <c:pt idx="6772">
                  <c:v>1572.64869049155</c:v>
                </c:pt>
                <c:pt idx="6773">
                  <c:v>1572.88091859115</c:v>
                </c:pt>
                <c:pt idx="6774">
                  <c:v>1573.11314669075</c:v>
                </c:pt>
                <c:pt idx="6775">
                  <c:v>1573.34537479035</c:v>
                </c:pt>
                <c:pt idx="6776">
                  <c:v>1573.57760288995</c:v>
                </c:pt>
                <c:pt idx="6777">
                  <c:v>1573.8098309895499</c:v>
                </c:pt>
                <c:pt idx="6778">
                  <c:v>1574.0420590891499</c:v>
                </c:pt>
                <c:pt idx="6779">
                  <c:v>1574.2742871887499</c:v>
                </c:pt>
                <c:pt idx="6780">
                  <c:v>1574.5065152883501</c:v>
                </c:pt>
                <c:pt idx="6781">
                  <c:v>1574.7387433879501</c:v>
                </c:pt>
                <c:pt idx="6782">
                  <c:v>1574.9709714875501</c:v>
                </c:pt>
                <c:pt idx="6783">
                  <c:v>1575.20319958715</c:v>
                </c:pt>
                <c:pt idx="6784">
                  <c:v>1575.43542768675</c:v>
                </c:pt>
                <c:pt idx="6785">
                  <c:v>1575.66765578635</c:v>
                </c:pt>
                <c:pt idx="6786">
                  <c:v>1575.89988388595</c:v>
                </c:pt>
                <c:pt idx="6787">
                  <c:v>1576.13211198555</c:v>
                </c:pt>
                <c:pt idx="6788">
                  <c:v>1576.3643400851499</c:v>
                </c:pt>
                <c:pt idx="6789">
                  <c:v>1576.5965681847499</c:v>
                </c:pt>
                <c:pt idx="6790">
                  <c:v>1576.8287962843499</c:v>
                </c:pt>
                <c:pt idx="6791">
                  <c:v>1577.0610243839501</c:v>
                </c:pt>
                <c:pt idx="6792">
                  <c:v>1577.2932524835501</c:v>
                </c:pt>
                <c:pt idx="6793">
                  <c:v>1577.5254805831501</c:v>
                </c:pt>
                <c:pt idx="6794">
                  <c:v>1577.75770868275</c:v>
                </c:pt>
                <c:pt idx="6795">
                  <c:v>1577.98993678235</c:v>
                </c:pt>
                <c:pt idx="6796">
                  <c:v>1578.22216488195</c:v>
                </c:pt>
                <c:pt idx="6797">
                  <c:v>1578.45439298155</c:v>
                </c:pt>
                <c:pt idx="6798">
                  <c:v>1578.68662108115</c:v>
                </c:pt>
                <c:pt idx="6799">
                  <c:v>1578.9188491807499</c:v>
                </c:pt>
                <c:pt idx="6800">
                  <c:v>1579.1510772803499</c:v>
                </c:pt>
                <c:pt idx="6801">
                  <c:v>1579.3833053799499</c:v>
                </c:pt>
                <c:pt idx="6802">
                  <c:v>1579.6155334795501</c:v>
                </c:pt>
                <c:pt idx="6803">
                  <c:v>1579.8477615791501</c:v>
                </c:pt>
                <c:pt idx="6804">
                  <c:v>1580.0799896787501</c:v>
                </c:pt>
                <c:pt idx="6805">
                  <c:v>1580.31221777835</c:v>
                </c:pt>
                <c:pt idx="6806">
                  <c:v>1580.54444587795</c:v>
                </c:pt>
                <c:pt idx="6807">
                  <c:v>1580.77667397755</c:v>
                </c:pt>
                <c:pt idx="6808">
                  <c:v>1581.00890207715</c:v>
                </c:pt>
                <c:pt idx="6809">
                  <c:v>1581.2411301767499</c:v>
                </c:pt>
                <c:pt idx="6810">
                  <c:v>1581.4733582763499</c:v>
                </c:pt>
                <c:pt idx="6811">
                  <c:v>1581.7055863759499</c:v>
                </c:pt>
                <c:pt idx="6812">
                  <c:v>1581.9378144755501</c:v>
                </c:pt>
                <c:pt idx="6813">
                  <c:v>1582.1700425751501</c:v>
                </c:pt>
                <c:pt idx="6814">
                  <c:v>1582.4022706747501</c:v>
                </c:pt>
                <c:pt idx="6815">
                  <c:v>1582.63449877435</c:v>
                </c:pt>
                <c:pt idx="6816">
                  <c:v>1582.86672687395</c:v>
                </c:pt>
                <c:pt idx="6817">
                  <c:v>1583.09895497355</c:v>
                </c:pt>
                <c:pt idx="6818">
                  <c:v>1583.33118307315</c:v>
                </c:pt>
                <c:pt idx="6819">
                  <c:v>1583.56341117275</c:v>
                </c:pt>
                <c:pt idx="6820">
                  <c:v>1583.7956392723499</c:v>
                </c:pt>
                <c:pt idx="6821">
                  <c:v>1584.0278673719499</c:v>
                </c:pt>
                <c:pt idx="6822">
                  <c:v>1584.2600954715499</c:v>
                </c:pt>
                <c:pt idx="6823">
                  <c:v>1584.4923235711501</c:v>
                </c:pt>
                <c:pt idx="6824">
                  <c:v>1584.7245516707501</c:v>
                </c:pt>
                <c:pt idx="6825">
                  <c:v>1584.9567797703501</c:v>
                </c:pt>
                <c:pt idx="6826">
                  <c:v>1585.18900786995</c:v>
                </c:pt>
                <c:pt idx="6827">
                  <c:v>1585.42123596955</c:v>
                </c:pt>
                <c:pt idx="6828">
                  <c:v>1585.65346406915</c:v>
                </c:pt>
                <c:pt idx="6829">
                  <c:v>1585.88569216875</c:v>
                </c:pt>
                <c:pt idx="6830">
                  <c:v>1586.11792026835</c:v>
                </c:pt>
                <c:pt idx="6831">
                  <c:v>1586.3501483679499</c:v>
                </c:pt>
                <c:pt idx="6832">
                  <c:v>1586.5823764675499</c:v>
                </c:pt>
                <c:pt idx="6833">
                  <c:v>1586.8146045671499</c:v>
                </c:pt>
                <c:pt idx="6834">
                  <c:v>1587.0468326667501</c:v>
                </c:pt>
                <c:pt idx="6835">
                  <c:v>1587.2790607663501</c:v>
                </c:pt>
                <c:pt idx="6836">
                  <c:v>1587.5112888659501</c:v>
                </c:pt>
                <c:pt idx="6837">
                  <c:v>1587.74351696555</c:v>
                </c:pt>
                <c:pt idx="6838">
                  <c:v>1587.97574506515</c:v>
                </c:pt>
                <c:pt idx="6839">
                  <c:v>1588.20797316475</c:v>
                </c:pt>
                <c:pt idx="6840">
                  <c:v>1588.44020126435</c:v>
                </c:pt>
                <c:pt idx="6841">
                  <c:v>1588.67242936395</c:v>
                </c:pt>
                <c:pt idx="6842">
                  <c:v>1588.9046574635499</c:v>
                </c:pt>
                <c:pt idx="6843">
                  <c:v>1589.1368855631499</c:v>
                </c:pt>
                <c:pt idx="6844">
                  <c:v>1589.3691136627499</c:v>
                </c:pt>
                <c:pt idx="6845">
                  <c:v>1589.6013417623501</c:v>
                </c:pt>
                <c:pt idx="6846">
                  <c:v>1589.8335698619501</c:v>
                </c:pt>
                <c:pt idx="6847">
                  <c:v>1590.0657979615501</c:v>
                </c:pt>
                <c:pt idx="6848">
                  <c:v>1590.29802606115</c:v>
                </c:pt>
                <c:pt idx="6849">
                  <c:v>1590.53025416075</c:v>
                </c:pt>
                <c:pt idx="6850">
                  <c:v>1590.76248226035</c:v>
                </c:pt>
                <c:pt idx="6851">
                  <c:v>1590.99471035995</c:v>
                </c:pt>
                <c:pt idx="6852">
                  <c:v>1591.22693845955</c:v>
                </c:pt>
                <c:pt idx="6853">
                  <c:v>1591.4591665591499</c:v>
                </c:pt>
                <c:pt idx="6854">
                  <c:v>1591.6913946587499</c:v>
                </c:pt>
                <c:pt idx="6855">
                  <c:v>1591.9236227583499</c:v>
                </c:pt>
                <c:pt idx="6856">
                  <c:v>1592.1558508579501</c:v>
                </c:pt>
                <c:pt idx="6857">
                  <c:v>1592.3880789575501</c:v>
                </c:pt>
                <c:pt idx="6858">
                  <c:v>1592.6203070571501</c:v>
                </c:pt>
                <c:pt idx="6859">
                  <c:v>1592.85253515675</c:v>
                </c:pt>
                <c:pt idx="6860">
                  <c:v>1593.08476325635</c:v>
                </c:pt>
                <c:pt idx="6861">
                  <c:v>1593.31699135595</c:v>
                </c:pt>
                <c:pt idx="6862">
                  <c:v>1593.54921945555</c:v>
                </c:pt>
                <c:pt idx="6863">
                  <c:v>1593.78144755515</c:v>
                </c:pt>
                <c:pt idx="6864">
                  <c:v>1594.0136756547499</c:v>
                </c:pt>
                <c:pt idx="6865">
                  <c:v>1594.2459037543499</c:v>
                </c:pt>
                <c:pt idx="6866">
                  <c:v>1594.4781318539499</c:v>
                </c:pt>
                <c:pt idx="6867">
                  <c:v>1594.7103599535501</c:v>
                </c:pt>
                <c:pt idx="6868">
                  <c:v>1594.9425880531501</c:v>
                </c:pt>
                <c:pt idx="6869">
                  <c:v>1595.1748161527501</c:v>
                </c:pt>
                <c:pt idx="6870">
                  <c:v>1595.40704425235</c:v>
                </c:pt>
                <c:pt idx="6871">
                  <c:v>1595.63927235195</c:v>
                </c:pt>
                <c:pt idx="6872">
                  <c:v>1595.87150045155</c:v>
                </c:pt>
                <c:pt idx="6873">
                  <c:v>1596.10372855115</c:v>
                </c:pt>
                <c:pt idx="6874">
                  <c:v>1596.3359566507499</c:v>
                </c:pt>
                <c:pt idx="6875">
                  <c:v>1596.5681847503499</c:v>
                </c:pt>
                <c:pt idx="6876">
                  <c:v>1596.8004128499499</c:v>
                </c:pt>
                <c:pt idx="6877">
                  <c:v>1597.0326409495499</c:v>
                </c:pt>
                <c:pt idx="6878">
                  <c:v>1597.2648690491601</c:v>
                </c:pt>
                <c:pt idx="6879">
                  <c:v>1597.4970971487601</c:v>
                </c:pt>
                <c:pt idx="6880">
                  <c:v>1597.7293252483601</c:v>
                </c:pt>
                <c:pt idx="6881">
                  <c:v>1597.96155334796</c:v>
                </c:pt>
                <c:pt idx="6882">
                  <c:v>1598.19378144756</c:v>
                </c:pt>
                <c:pt idx="6883">
                  <c:v>1598.42600954716</c:v>
                </c:pt>
                <c:pt idx="6884">
                  <c:v>1598.65823764676</c:v>
                </c:pt>
                <c:pt idx="6885">
                  <c:v>1598.89046574636</c:v>
                </c:pt>
                <c:pt idx="6886">
                  <c:v>1599.1226938459599</c:v>
                </c:pt>
                <c:pt idx="6887">
                  <c:v>1599.3549219455599</c:v>
                </c:pt>
                <c:pt idx="6888">
                  <c:v>1599.5871500451599</c:v>
                </c:pt>
                <c:pt idx="6889">
                  <c:v>1599.8193781447601</c:v>
                </c:pt>
                <c:pt idx="6890">
                  <c:v>1600.0516062443601</c:v>
                </c:pt>
                <c:pt idx="6891">
                  <c:v>1600.2838343439601</c:v>
                </c:pt>
                <c:pt idx="6892">
                  <c:v>1600.51606244356</c:v>
                </c:pt>
                <c:pt idx="6893">
                  <c:v>1600.74829054316</c:v>
                </c:pt>
                <c:pt idx="6894">
                  <c:v>1600.98051864276</c:v>
                </c:pt>
                <c:pt idx="6895">
                  <c:v>1601.21274674236</c:v>
                </c:pt>
                <c:pt idx="6896">
                  <c:v>1601.4449748419599</c:v>
                </c:pt>
                <c:pt idx="6897">
                  <c:v>1601.6772029415599</c:v>
                </c:pt>
                <c:pt idx="6898">
                  <c:v>1601.9094310411599</c:v>
                </c:pt>
                <c:pt idx="6899">
                  <c:v>1602.1416591407601</c:v>
                </c:pt>
                <c:pt idx="6900">
                  <c:v>1602.3738872403601</c:v>
                </c:pt>
                <c:pt idx="6901">
                  <c:v>1602.6061153399601</c:v>
                </c:pt>
                <c:pt idx="6902">
                  <c:v>1602.83834343956</c:v>
                </c:pt>
                <c:pt idx="6903">
                  <c:v>1603.07057153916</c:v>
                </c:pt>
                <c:pt idx="6904">
                  <c:v>1603.30279963876</c:v>
                </c:pt>
                <c:pt idx="6905">
                  <c:v>1603.53502773836</c:v>
                </c:pt>
                <c:pt idx="6906">
                  <c:v>1603.76725583796</c:v>
                </c:pt>
                <c:pt idx="6907">
                  <c:v>1603.9994839375599</c:v>
                </c:pt>
                <c:pt idx="6908">
                  <c:v>1604.2317120371599</c:v>
                </c:pt>
                <c:pt idx="6909">
                  <c:v>1604.4639401367599</c:v>
                </c:pt>
                <c:pt idx="6910">
                  <c:v>1604.6961682363601</c:v>
                </c:pt>
                <c:pt idx="6911">
                  <c:v>1604.9283963359601</c:v>
                </c:pt>
                <c:pt idx="6912">
                  <c:v>1605.1606244355601</c:v>
                </c:pt>
                <c:pt idx="6913">
                  <c:v>1605.39285253516</c:v>
                </c:pt>
                <c:pt idx="6914">
                  <c:v>1605.62508063476</c:v>
                </c:pt>
                <c:pt idx="6915">
                  <c:v>1605.85730873436</c:v>
                </c:pt>
                <c:pt idx="6916">
                  <c:v>1606.08953683396</c:v>
                </c:pt>
                <c:pt idx="6917">
                  <c:v>1606.32176493356</c:v>
                </c:pt>
                <c:pt idx="6918">
                  <c:v>1606.5539930331599</c:v>
                </c:pt>
                <c:pt idx="6919">
                  <c:v>1606.7862211327599</c:v>
                </c:pt>
                <c:pt idx="6920">
                  <c:v>1607.0184492323599</c:v>
                </c:pt>
                <c:pt idx="6921">
                  <c:v>1607.2506773319601</c:v>
                </c:pt>
                <c:pt idx="6922">
                  <c:v>1607.4829054315601</c:v>
                </c:pt>
                <c:pt idx="6923">
                  <c:v>1607.7151335311601</c:v>
                </c:pt>
                <c:pt idx="6924">
                  <c:v>1607.94736163076</c:v>
                </c:pt>
                <c:pt idx="6925">
                  <c:v>1608.17958973036</c:v>
                </c:pt>
                <c:pt idx="6926">
                  <c:v>1608.41181782996</c:v>
                </c:pt>
                <c:pt idx="6927">
                  <c:v>1608.64404592956</c:v>
                </c:pt>
                <c:pt idx="6928">
                  <c:v>1608.87627402916</c:v>
                </c:pt>
                <c:pt idx="6929">
                  <c:v>1609.1085021287599</c:v>
                </c:pt>
                <c:pt idx="6930">
                  <c:v>1609.3407302283599</c:v>
                </c:pt>
                <c:pt idx="6931">
                  <c:v>1609.5729583279599</c:v>
                </c:pt>
                <c:pt idx="6932">
                  <c:v>1609.8051864275601</c:v>
                </c:pt>
                <c:pt idx="6933">
                  <c:v>1610.0374145271601</c:v>
                </c:pt>
                <c:pt idx="6934">
                  <c:v>1610.2696426267601</c:v>
                </c:pt>
                <c:pt idx="6935">
                  <c:v>1610.50187072636</c:v>
                </c:pt>
                <c:pt idx="6936">
                  <c:v>1610.73409882596</c:v>
                </c:pt>
                <c:pt idx="6937">
                  <c:v>1610.96632692556</c:v>
                </c:pt>
                <c:pt idx="6938">
                  <c:v>1611.19855502516</c:v>
                </c:pt>
                <c:pt idx="6939">
                  <c:v>1611.43078312476</c:v>
                </c:pt>
                <c:pt idx="6940">
                  <c:v>1611.6630112243599</c:v>
                </c:pt>
                <c:pt idx="6941">
                  <c:v>1611.8952393239599</c:v>
                </c:pt>
                <c:pt idx="6942">
                  <c:v>1612.1274674235599</c:v>
                </c:pt>
                <c:pt idx="6943">
                  <c:v>1612.3596955231601</c:v>
                </c:pt>
                <c:pt idx="6944">
                  <c:v>1612.5919236227601</c:v>
                </c:pt>
                <c:pt idx="6945">
                  <c:v>1612.8241517223601</c:v>
                </c:pt>
                <c:pt idx="6946">
                  <c:v>1613.05637982196</c:v>
                </c:pt>
                <c:pt idx="6947">
                  <c:v>1613.28860792156</c:v>
                </c:pt>
                <c:pt idx="6948">
                  <c:v>1613.52083602116</c:v>
                </c:pt>
                <c:pt idx="6949">
                  <c:v>1613.75306412076</c:v>
                </c:pt>
                <c:pt idx="6950">
                  <c:v>1613.98529222036</c:v>
                </c:pt>
                <c:pt idx="6951">
                  <c:v>1614.2175203199599</c:v>
                </c:pt>
                <c:pt idx="6952">
                  <c:v>1614.4497484195599</c:v>
                </c:pt>
                <c:pt idx="6953">
                  <c:v>1614.6819765191599</c:v>
                </c:pt>
                <c:pt idx="6954">
                  <c:v>1614.9142046187601</c:v>
                </c:pt>
                <c:pt idx="6955">
                  <c:v>1615.1464327183601</c:v>
                </c:pt>
                <c:pt idx="6956">
                  <c:v>1615.3786608179601</c:v>
                </c:pt>
                <c:pt idx="6957">
                  <c:v>1615.61088891756</c:v>
                </c:pt>
                <c:pt idx="6958">
                  <c:v>1615.84311701716</c:v>
                </c:pt>
                <c:pt idx="6959">
                  <c:v>1616.07534511676</c:v>
                </c:pt>
                <c:pt idx="6960">
                  <c:v>1616.30757321636</c:v>
                </c:pt>
                <c:pt idx="6961">
                  <c:v>1616.5398013159599</c:v>
                </c:pt>
                <c:pt idx="6962">
                  <c:v>1616.7720294155599</c:v>
                </c:pt>
                <c:pt idx="6963">
                  <c:v>1617.0042575151599</c:v>
                </c:pt>
                <c:pt idx="6964">
                  <c:v>1617.2364856147601</c:v>
                </c:pt>
                <c:pt idx="6965">
                  <c:v>1617.4687137143601</c:v>
                </c:pt>
                <c:pt idx="6966">
                  <c:v>1617.7009418139601</c:v>
                </c:pt>
                <c:pt idx="6967">
                  <c:v>1617.9331699135601</c:v>
                </c:pt>
                <c:pt idx="6968">
                  <c:v>1618.16539801316</c:v>
                </c:pt>
                <c:pt idx="6969">
                  <c:v>1618.39762611276</c:v>
                </c:pt>
                <c:pt idx="6970">
                  <c:v>1618.62985421236</c:v>
                </c:pt>
                <c:pt idx="6971">
                  <c:v>1618.86208231196</c:v>
                </c:pt>
                <c:pt idx="6972">
                  <c:v>1619.0943104115599</c:v>
                </c:pt>
                <c:pt idx="6973">
                  <c:v>1619.3265385111599</c:v>
                </c:pt>
                <c:pt idx="6974">
                  <c:v>1619.5587666107599</c:v>
                </c:pt>
                <c:pt idx="6975">
                  <c:v>1619.7909947103601</c:v>
                </c:pt>
                <c:pt idx="6976">
                  <c:v>1620.0232228099601</c:v>
                </c:pt>
                <c:pt idx="6977">
                  <c:v>1620.2554509095601</c:v>
                </c:pt>
                <c:pt idx="6978">
                  <c:v>1620.48767900916</c:v>
                </c:pt>
                <c:pt idx="6979">
                  <c:v>1620.71990710876</c:v>
                </c:pt>
                <c:pt idx="6980">
                  <c:v>1620.95213520836</c:v>
                </c:pt>
                <c:pt idx="6981">
                  <c:v>1621.18436330796</c:v>
                </c:pt>
                <c:pt idx="6982">
                  <c:v>1621.41659140756</c:v>
                </c:pt>
                <c:pt idx="6983">
                  <c:v>1621.6488195071599</c:v>
                </c:pt>
                <c:pt idx="6984">
                  <c:v>1621.8810476067599</c:v>
                </c:pt>
                <c:pt idx="6985">
                  <c:v>1622.1132757063599</c:v>
                </c:pt>
                <c:pt idx="6986">
                  <c:v>1622.3455038059601</c:v>
                </c:pt>
                <c:pt idx="6987">
                  <c:v>1622.5777319055601</c:v>
                </c:pt>
                <c:pt idx="6988">
                  <c:v>1622.8099600051601</c:v>
                </c:pt>
                <c:pt idx="6989">
                  <c:v>1623.04218810476</c:v>
                </c:pt>
                <c:pt idx="6990">
                  <c:v>1623.27441620436</c:v>
                </c:pt>
                <c:pt idx="6991">
                  <c:v>1623.50664430396</c:v>
                </c:pt>
                <c:pt idx="6992">
                  <c:v>1623.73887240356</c:v>
                </c:pt>
                <c:pt idx="6993">
                  <c:v>1623.97110050316</c:v>
                </c:pt>
                <c:pt idx="6994">
                  <c:v>1624.2033286027599</c:v>
                </c:pt>
                <c:pt idx="6995">
                  <c:v>1624.4355567023599</c:v>
                </c:pt>
                <c:pt idx="6996">
                  <c:v>1624.6677848019599</c:v>
                </c:pt>
                <c:pt idx="6997">
                  <c:v>1624.9000129015601</c:v>
                </c:pt>
                <c:pt idx="6998">
                  <c:v>1625.1322410011601</c:v>
                </c:pt>
                <c:pt idx="6999">
                  <c:v>1625.3644691007601</c:v>
                </c:pt>
                <c:pt idx="7000">
                  <c:v>1625.59669720036</c:v>
                </c:pt>
                <c:pt idx="7001">
                  <c:v>1625.82892529996</c:v>
                </c:pt>
                <c:pt idx="7002">
                  <c:v>1626.06115339956</c:v>
                </c:pt>
                <c:pt idx="7003">
                  <c:v>1626.29338149916</c:v>
                </c:pt>
                <c:pt idx="7004">
                  <c:v>1626.52560959876</c:v>
                </c:pt>
                <c:pt idx="7005">
                  <c:v>1626.7578376983599</c:v>
                </c:pt>
                <c:pt idx="7006">
                  <c:v>1626.9900657979599</c:v>
                </c:pt>
                <c:pt idx="7007">
                  <c:v>1627.2222938975599</c:v>
                </c:pt>
                <c:pt idx="7008">
                  <c:v>1627.4545219971601</c:v>
                </c:pt>
                <c:pt idx="7009">
                  <c:v>1627.6867500967601</c:v>
                </c:pt>
                <c:pt idx="7010">
                  <c:v>1627.9189781963601</c:v>
                </c:pt>
                <c:pt idx="7011">
                  <c:v>1628.15120629596</c:v>
                </c:pt>
                <c:pt idx="7012">
                  <c:v>1628.38343439556</c:v>
                </c:pt>
                <c:pt idx="7013">
                  <c:v>1628.61566249516</c:v>
                </c:pt>
                <c:pt idx="7014">
                  <c:v>1628.84789059476</c:v>
                </c:pt>
                <c:pt idx="7015">
                  <c:v>1629.08011869436</c:v>
                </c:pt>
                <c:pt idx="7016">
                  <c:v>1629.3123467939599</c:v>
                </c:pt>
                <c:pt idx="7017">
                  <c:v>1629.5445748935599</c:v>
                </c:pt>
                <c:pt idx="7018">
                  <c:v>1629.7768029931599</c:v>
                </c:pt>
                <c:pt idx="7019">
                  <c:v>1630.0090310927601</c:v>
                </c:pt>
                <c:pt idx="7020">
                  <c:v>1630.2412591923601</c:v>
                </c:pt>
                <c:pt idx="7021">
                  <c:v>1630.4734872919601</c:v>
                </c:pt>
                <c:pt idx="7022">
                  <c:v>1630.70571539156</c:v>
                </c:pt>
                <c:pt idx="7023">
                  <c:v>1630.93794349116</c:v>
                </c:pt>
                <c:pt idx="7024">
                  <c:v>1631.17017159076</c:v>
                </c:pt>
                <c:pt idx="7025">
                  <c:v>1631.40239969036</c:v>
                </c:pt>
                <c:pt idx="7026">
                  <c:v>1631.6346277899599</c:v>
                </c:pt>
                <c:pt idx="7027">
                  <c:v>1631.8668558895599</c:v>
                </c:pt>
                <c:pt idx="7028">
                  <c:v>1632.0990839891599</c:v>
                </c:pt>
                <c:pt idx="7029">
                  <c:v>1632.3313120887599</c:v>
                </c:pt>
                <c:pt idx="7030">
                  <c:v>1632.5635401883601</c:v>
                </c:pt>
                <c:pt idx="7031">
                  <c:v>1632.7957682879601</c:v>
                </c:pt>
                <c:pt idx="7032">
                  <c:v>1633.0279963875601</c:v>
                </c:pt>
                <c:pt idx="7033">
                  <c:v>1633.26022448716</c:v>
                </c:pt>
                <c:pt idx="7034">
                  <c:v>1633.49245258676</c:v>
                </c:pt>
                <c:pt idx="7035">
                  <c:v>1633.72468068636</c:v>
                </c:pt>
                <c:pt idx="7036">
                  <c:v>1633.95690878596</c:v>
                </c:pt>
                <c:pt idx="7037">
                  <c:v>1634.1891368855599</c:v>
                </c:pt>
                <c:pt idx="7038">
                  <c:v>1634.4213649851599</c:v>
                </c:pt>
                <c:pt idx="7039">
                  <c:v>1634.6535930847599</c:v>
                </c:pt>
                <c:pt idx="7040">
                  <c:v>1634.8858211843601</c:v>
                </c:pt>
                <c:pt idx="7041">
                  <c:v>1635.1180492839601</c:v>
                </c:pt>
                <c:pt idx="7042">
                  <c:v>1635.3502773835601</c:v>
                </c:pt>
                <c:pt idx="7043">
                  <c:v>1635.58250548316</c:v>
                </c:pt>
                <c:pt idx="7044">
                  <c:v>1635.81473358276</c:v>
                </c:pt>
                <c:pt idx="7045">
                  <c:v>1636.04696168236</c:v>
                </c:pt>
                <c:pt idx="7046">
                  <c:v>1636.27918978196</c:v>
                </c:pt>
                <c:pt idx="7047">
                  <c:v>1636.51141788156</c:v>
                </c:pt>
                <c:pt idx="7048">
                  <c:v>1636.7436459811599</c:v>
                </c:pt>
                <c:pt idx="7049">
                  <c:v>1636.9758740807599</c:v>
                </c:pt>
                <c:pt idx="7050">
                  <c:v>1637.2081021803599</c:v>
                </c:pt>
                <c:pt idx="7051">
                  <c:v>1637.4403302799601</c:v>
                </c:pt>
                <c:pt idx="7052">
                  <c:v>1637.6725583795601</c:v>
                </c:pt>
                <c:pt idx="7053">
                  <c:v>1637.9047864791601</c:v>
                </c:pt>
                <c:pt idx="7054">
                  <c:v>1638.13701457876</c:v>
                </c:pt>
                <c:pt idx="7055">
                  <c:v>1638.36924267836</c:v>
                </c:pt>
                <c:pt idx="7056">
                  <c:v>1638.60147077796</c:v>
                </c:pt>
                <c:pt idx="7057">
                  <c:v>1638.83369887756</c:v>
                </c:pt>
                <c:pt idx="7058">
                  <c:v>1639.06592697716</c:v>
                </c:pt>
                <c:pt idx="7059">
                  <c:v>1639.2981550767599</c:v>
                </c:pt>
                <c:pt idx="7060">
                  <c:v>1639.5303831763599</c:v>
                </c:pt>
                <c:pt idx="7061">
                  <c:v>1639.7626112759599</c:v>
                </c:pt>
                <c:pt idx="7062">
                  <c:v>1639.9948393755601</c:v>
                </c:pt>
                <c:pt idx="7063">
                  <c:v>1640.2270674751601</c:v>
                </c:pt>
                <c:pt idx="7064">
                  <c:v>1640.4592955747601</c:v>
                </c:pt>
                <c:pt idx="7065">
                  <c:v>1640.69152367436</c:v>
                </c:pt>
                <c:pt idx="7066">
                  <c:v>1640.92375177396</c:v>
                </c:pt>
                <c:pt idx="7067">
                  <c:v>1641.15597987356</c:v>
                </c:pt>
                <c:pt idx="7068">
                  <c:v>1641.38820797316</c:v>
                </c:pt>
                <c:pt idx="7069">
                  <c:v>1641.62043607276</c:v>
                </c:pt>
                <c:pt idx="7070">
                  <c:v>1641.8526641723599</c:v>
                </c:pt>
                <c:pt idx="7071">
                  <c:v>1642.0848922719599</c:v>
                </c:pt>
                <c:pt idx="7072">
                  <c:v>1642.3171203715599</c:v>
                </c:pt>
                <c:pt idx="7073">
                  <c:v>1642.5493484711701</c:v>
                </c:pt>
                <c:pt idx="7074">
                  <c:v>1642.7815765707701</c:v>
                </c:pt>
                <c:pt idx="7075">
                  <c:v>1643.0138046703701</c:v>
                </c:pt>
                <c:pt idx="7076">
                  <c:v>1643.24603276997</c:v>
                </c:pt>
                <c:pt idx="7077">
                  <c:v>1643.47826086957</c:v>
                </c:pt>
                <c:pt idx="7078">
                  <c:v>1643.71048896917</c:v>
                </c:pt>
                <c:pt idx="7079">
                  <c:v>1643.94271706877</c:v>
                </c:pt>
                <c:pt idx="7080">
                  <c:v>1644.17494516837</c:v>
                </c:pt>
                <c:pt idx="7081">
                  <c:v>1644.4071732679699</c:v>
                </c:pt>
                <c:pt idx="7082">
                  <c:v>1644.6394013675699</c:v>
                </c:pt>
                <c:pt idx="7083">
                  <c:v>1644.8716294671699</c:v>
                </c:pt>
                <c:pt idx="7084">
                  <c:v>1645.1038575667701</c:v>
                </c:pt>
                <c:pt idx="7085">
                  <c:v>1645.3360856663701</c:v>
                </c:pt>
                <c:pt idx="7086">
                  <c:v>1645.5683137659701</c:v>
                </c:pt>
                <c:pt idx="7087">
                  <c:v>1645.80054186557</c:v>
                </c:pt>
                <c:pt idx="7088">
                  <c:v>1646.03276996517</c:v>
                </c:pt>
                <c:pt idx="7089">
                  <c:v>1646.26499806477</c:v>
                </c:pt>
                <c:pt idx="7090">
                  <c:v>1646.49722616437</c:v>
                </c:pt>
                <c:pt idx="7091">
                  <c:v>1646.72945426397</c:v>
                </c:pt>
                <c:pt idx="7092">
                  <c:v>1646.9616823635699</c:v>
                </c:pt>
                <c:pt idx="7093">
                  <c:v>1647.1939104631699</c:v>
                </c:pt>
                <c:pt idx="7094">
                  <c:v>1647.4261385627699</c:v>
                </c:pt>
                <c:pt idx="7095">
                  <c:v>1647.6583666623701</c:v>
                </c:pt>
                <c:pt idx="7096">
                  <c:v>1647.8905947619701</c:v>
                </c:pt>
                <c:pt idx="7097">
                  <c:v>1648.1228228615701</c:v>
                </c:pt>
                <c:pt idx="7098">
                  <c:v>1648.35505096117</c:v>
                </c:pt>
                <c:pt idx="7099">
                  <c:v>1648.58727906077</c:v>
                </c:pt>
                <c:pt idx="7100">
                  <c:v>1648.81950716037</c:v>
                </c:pt>
                <c:pt idx="7101">
                  <c:v>1649.05173525997</c:v>
                </c:pt>
                <c:pt idx="7102">
                  <c:v>1649.28396335957</c:v>
                </c:pt>
                <c:pt idx="7103">
                  <c:v>1649.5161914591699</c:v>
                </c:pt>
                <c:pt idx="7104">
                  <c:v>1649.7484195587699</c:v>
                </c:pt>
                <c:pt idx="7105">
                  <c:v>1649.9806476583699</c:v>
                </c:pt>
                <c:pt idx="7106">
                  <c:v>1650.2128757579701</c:v>
                </c:pt>
                <c:pt idx="7107">
                  <c:v>1650.4451038575701</c:v>
                </c:pt>
                <c:pt idx="7108">
                  <c:v>1650.6773319571701</c:v>
                </c:pt>
                <c:pt idx="7109">
                  <c:v>1650.90956005677</c:v>
                </c:pt>
                <c:pt idx="7110">
                  <c:v>1651.14178815637</c:v>
                </c:pt>
                <c:pt idx="7111">
                  <c:v>1651.37401625597</c:v>
                </c:pt>
                <c:pt idx="7112">
                  <c:v>1651.60624435557</c:v>
                </c:pt>
                <c:pt idx="7113">
                  <c:v>1651.8384724551699</c:v>
                </c:pt>
                <c:pt idx="7114">
                  <c:v>1652.0707005547699</c:v>
                </c:pt>
                <c:pt idx="7115">
                  <c:v>1652.3029286543699</c:v>
                </c:pt>
                <c:pt idx="7116">
                  <c:v>1652.5351567539701</c:v>
                </c:pt>
                <c:pt idx="7117">
                  <c:v>1652.7673848535701</c:v>
                </c:pt>
                <c:pt idx="7118">
                  <c:v>1652.9996129531701</c:v>
                </c:pt>
                <c:pt idx="7119">
                  <c:v>1653.2318410527701</c:v>
                </c:pt>
                <c:pt idx="7120">
                  <c:v>1653.46406915237</c:v>
                </c:pt>
                <c:pt idx="7121">
                  <c:v>1653.69629725197</c:v>
                </c:pt>
                <c:pt idx="7122">
                  <c:v>1653.92852535157</c:v>
                </c:pt>
                <c:pt idx="7123">
                  <c:v>1654.16075345117</c:v>
                </c:pt>
                <c:pt idx="7124">
                  <c:v>1654.3929815507699</c:v>
                </c:pt>
                <c:pt idx="7125">
                  <c:v>1654.6252096503699</c:v>
                </c:pt>
                <c:pt idx="7126">
                  <c:v>1654.8574377499699</c:v>
                </c:pt>
                <c:pt idx="7127">
                  <c:v>1655.0896658495701</c:v>
                </c:pt>
                <c:pt idx="7128">
                  <c:v>1655.3218939491701</c:v>
                </c:pt>
                <c:pt idx="7129">
                  <c:v>1655.5541220487701</c:v>
                </c:pt>
                <c:pt idx="7130">
                  <c:v>1655.78635014837</c:v>
                </c:pt>
                <c:pt idx="7131">
                  <c:v>1656.01857824797</c:v>
                </c:pt>
                <c:pt idx="7132">
                  <c:v>1656.25080634757</c:v>
                </c:pt>
                <c:pt idx="7133">
                  <c:v>1656.48303444717</c:v>
                </c:pt>
                <c:pt idx="7134">
                  <c:v>1656.71526254677</c:v>
                </c:pt>
                <c:pt idx="7135">
                  <c:v>1656.9474906463699</c:v>
                </c:pt>
                <c:pt idx="7136">
                  <c:v>1657.1797187459699</c:v>
                </c:pt>
                <c:pt idx="7137">
                  <c:v>1657.4119468455699</c:v>
                </c:pt>
                <c:pt idx="7138">
                  <c:v>1657.6441749451701</c:v>
                </c:pt>
                <c:pt idx="7139">
                  <c:v>1657.8764030447701</c:v>
                </c:pt>
                <c:pt idx="7140">
                  <c:v>1658.1086311443701</c:v>
                </c:pt>
                <c:pt idx="7141">
                  <c:v>1658.34085924397</c:v>
                </c:pt>
                <c:pt idx="7142">
                  <c:v>1658.57308734357</c:v>
                </c:pt>
                <c:pt idx="7143">
                  <c:v>1658.80531544317</c:v>
                </c:pt>
                <c:pt idx="7144">
                  <c:v>1659.03754354277</c:v>
                </c:pt>
                <c:pt idx="7145">
                  <c:v>1659.26977164237</c:v>
                </c:pt>
                <c:pt idx="7146">
                  <c:v>1659.5019997419699</c:v>
                </c:pt>
                <c:pt idx="7147">
                  <c:v>1659.7342278415699</c:v>
                </c:pt>
                <c:pt idx="7148">
                  <c:v>1659.9664559411699</c:v>
                </c:pt>
                <c:pt idx="7149">
                  <c:v>1660.1986840407701</c:v>
                </c:pt>
                <c:pt idx="7150">
                  <c:v>1660.4309121403701</c:v>
                </c:pt>
                <c:pt idx="7151">
                  <c:v>1660.6631402399701</c:v>
                </c:pt>
                <c:pt idx="7152">
                  <c:v>1660.89536833957</c:v>
                </c:pt>
                <c:pt idx="7153">
                  <c:v>1661.12759643917</c:v>
                </c:pt>
                <c:pt idx="7154">
                  <c:v>1661.35982453877</c:v>
                </c:pt>
                <c:pt idx="7155">
                  <c:v>1661.59205263837</c:v>
                </c:pt>
                <c:pt idx="7156">
                  <c:v>1661.82428073797</c:v>
                </c:pt>
                <c:pt idx="7157">
                  <c:v>1662.0565088375699</c:v>
                </c:pt>
                <c:pt idx="7158">
                  <c:v>1662.2887369371699</c:v>
                </c:pt>
                <c:pt idx="7159">
                  <c:v>1662.5209650367699</c:v>
                </c:pt>
                <c:pt idx="7160">
                  <c:v>1662.7531931363701</c:v>
                </c:pt>
                <c:pt idx="7161">
                  <c:v>1662.9854212359701</c:v>
                </c:pt>
                <c:pt idx="7162">
                  <c:v>1663.2176493355701</c:v>
                </c:pt>
                <c:pt idx="7163">
                  <c:v>1663.44987743517</c:v>
                </c:pt>
                <c:pt idx="7164">
                  <c:v>1663.68210553477</c:v>
                </c:pt>
                <c:pt idx="7165">
                  <c:v>1663.91433363437</c:v>
                </c:pt>
                <c:pt idx="7166">
                  <c:v>1664.14656173397</c:v>
                </c:pt>
                <c:pt idx="7167">
                  <c:v>1664.37878983357</c:v>
                </c:pt>
                <c:pt idx="7168">
                  <c:v>1664.6110179331699</c:v>
                </c:pt>
                <c:pt idx="7169">
                  <c:v>1664.8432460327699</c:v>
                </c:pt>
                <c:pt idx="7170">
                  <c:v>1665.0754741323699</c:v>
                </c:pt>
                <c:pt idx="7171">
                  <c:v>1665.3077022319701</c:v>
                </c:pt>
                <c:pt idx="7172">
                  <c:v>1665.5399303315701</c:v>
                </c:pt>
                <c:pt idx="7173">
                  <c:v>1665.7721584311701</c:v>
                </c:pt>
                <c:pt idx="7174">
                  <c:v>1666.00438653077</c:v>
                </c:pt>
                <c:pt idx="7175">
                  <c:v>1666.23661463037</c:v>
                </c:pt>
                <c:pt idx="7176">
                  <c:v>1666.46884272997</c:v>
                </c:pt>
                <c:pt idx="7177">
                  <c:v>1666.70107082957</c:v>
                </c:pt>
                <c:pt idx="7178">
                  <c:v>1666.93329892917</c:v>
                </c:pt>
                <c:pt idx="7179">
                  <c:v>1667.1655270287699</c:v>
                </c:pt>
                <c:pt idx="7180">
                  <c:v>1667.3977551283699</c:v>
                </c:pt>
                <c:pt idx="7181">
                  <c:v>1667.6299832279699</c:v>
                </c:pt>
                <c:pt idx="7182">
                  <c:v>1667.8622113275701</c:v>
                </c:pt>
                <c:pt idx="7183">
                  <c:v>1668.0944394271701</c:v>
                </c:pt>
                <c:pt idx="7184">
                  <c:v>1668.3266675267701</c:v>
                </c:pt>
                <c:pt idx="7185">
                  <c:v>1668.55889562637</c:v>
                </c:pt>
                <c:pt idx="7186">
                  <c:v>1668.79112372597</c:v>
                </c:pt>
                <c:pt idx="7187">
                  <c:v>1669.02335182557</c:v>
                </c:pt>
                <c:pt idx="7188">
                  <c:v>1669.25557992517</c:v>
                </c:pt>
                <c:pt idx="7189">
                  <c:v>1669.4878080247699</c:v>
                </c:pt>
                <c:pt idx="7190">
                  <c:v>1669.7200361243699</c:v>
                </c:pt>
                <c:pt idx="7191">
                  <c:v>1669.9522642239699</c:v>
                </c:pt>
                <c:pt idx="7192">
                  <c:v>1670.1844923235701</c:v>
                </c:pt>
                <c:pt idx="7193">
                  <c:v>1670.4167204231701</c:v>
                </c:pt>
                <c:pt idx="7194">
                  <c:v>1670.6489485227701</c:v>
                </c:pt>
                <c:pt idx="7195">
                  <c:v>1670.88117662237</c:v>
                </c:pt>
                <c:pt idx="7196">
                  <c:v>1671.11340472197</c:v>
                </c:pt>
                <c:pt idx="7197">
                  <c:v>1671.34563282157</c:v>
                </c:pt>
                <c:pt idx="7198">
                  <c:v>1671.57786092117</c:v>
                </c:pt>
                <c:pt idx="7199">
                  <c:v>1671.81008902077</c:v>
                </c:pt>
                <c:pt idx="7200">
                  <c:v>1672.0423171203699</c:v>
                </c:pt>
                <c:pt idx="7201">
                  <c:v>1672.2745452199699</c:v>
                </c:pt>
                <c:pt idx="7202">
                  <c:v>1672.5067733195699</c:v>
                </c:pt>
                <c:pt idx="7203">
                  <c:v>1672.7390014191701</c:v>
                </c:pt>
                <c:pt idx="7204">
                  <c:v>1672.9712295187701</c:v>
                </c:pt>
                <c:pt idx="7205">
                  <c:v>1673.2034576183701</c:v>
                </c:pt>
                <c:pt idx="7206">
                  <c:v>1673.43568571797</c:v>
                </c:pt>
                <c:pt idx="7207">
                  <c:v>1673.66791381757</c:v>
                </c:pt>
                <c:pt idx="7208">
                  <c:v>1673.90014191717</c:v>
                </c:pt>
                <c:pt idx="7209">
                  <c:v>1674.13237001677</c:v>
                </c:pt>
                <c:pt idx="7210">
                  <c:v>1674.36459811637</c:v>
                </c:pt>
                <c:pt idx="7211">
                  <c:v>1674.5968262159699</c:v>
                </c:pt>
                <c:pt idx="7212">
                  <c:v>1674.8290543155699</c:v>
                </c:pt>
                <c:pt idx="7213">
                  <c:v>1675.0612824151699</c:v>
                </c:pt>
                <c:pt idx="7214">
                  <c:v>1675.2935105147701</c:v>
                </c:pt>
                <c:pt idx="7215">
                  <c:v>1675.5257386143701</c:v>
                </c:pt>
                <c:pt idx="7216">
                  <c:v>1675.7579667139701</c:v>
                </c:pt>
                <c:pt idx="7217">
                  <c:v>1675.99019481357</c:v>
                </c:pt>
                <c:pt idx="7218">
                  <c:v>1676.22242291317</c:v>
                </c:pt>
                <c:pt idx="7219">
                  <c:v>1676.45465101277</c:v>
                </c:pt>
                <c:pt idx="7220">
                  <c:v>1676.68687911237</c:v>
                </c:pt>
                <c:pt idx="7221">
                  <c:v>1676.91910721197</c:v>
                </c:pt>
                <c:pt idx="7222">
                  <c:v>1677.1513353115699</c:v>
                </c:pt>
                <c:pt idx="7223">
                  <c:v>1677.3835634111699</c:v>
                </c:pt>
                <c:pt idx="7224">
                  <c:v>1677.6157915107699</c:v>
                </c:pt>
                <c:pt idx="7225">
                  <c:v>1677.8480196103701</c:v>
                </c:pt>
                <c:pt idx="7226">
                  <c:v>1678.0802477099701</c:v>
                </c:pt>
                <c:pt idx="7227">
                  <c:v>1678.3124758095701</c:v>
                </c:pt>
                <c:pt idx="7228">
                  <c:v>1678.54470390917</c:v>
                </c:pt>
                <c:pt idx="7229">
                  <c:v>1678.77693200877</c:v>
                </c:pt>
                <c:pt idx="7230">
                  <c:v>1679.00916010837</c:v>
                </c:pt>
                <c:pt idx="7231">
                  <c:v>1679.24138820797</c:v>
                </c:pt>
                <c:pt idx="7232">
                  <c:v>1679.47361630757</c:v>
                </c:pt>
                <c:pt idx="7233">
                  <c:v>1679.7058444071699</c:v>
                </c:pt>
                <c:pt idx="7234">
                  <c:v>1679.9380725067699</c:v>
                </c:pt>
                <c:pt idx="7235">
                  <c:v>1680.1703006063699</c:v>
                </c:pt>
                <c:pt idx="7236">
                  <c:v>1680.4025287059701</c:v>
                </c:pt>
                <c:pt idx="7237">
                  <c:v>1680.6347568055701</c:v>
                </c:pt>
                <c:pt idx="7238">
                  <c:v>1680.8669849051701</c:v>
                </c:pt>
                <c:pt idx="7239">
                  <c:v>1681.09921300477</c:v>
                </c:pt>
                <c:pt idx="7240">
                  <c:v>1681.33144110437</c:v>
                </c:pt>
                <c:pt idx="7241">
                  <c:v>1681.56366920397</c:v>
                </c:pt>
                <c:pt idx="7242">
                  <c:v>1681.79589730357</c:v>
                </c:pt>
                <c:pt idx="7243">
                  <c:v>1682.02812540317</c:v>
                </c:pt>
                <c:pt idx="7244">
                  <c:v>1682.2603535027699</c:v>
                </c:pt>
                <c:pt idx="7245">
                  <c:v>1682.4925816023699</c:v>
                </c:pt>
                <c:pt idx="7246">
                  <c:v>1682.7248097019699</c:v>
                </c:pt>
                <c:pt idx="7247">
                  <c:v>1682.9570378015701</c:v>
                </c:pt>
                <c:pt idx="7248">
                  <c:v>1683.1892659011701</c:v>
                </c:pt>
                <c:pt idx="7249">
                  <c:v>1683.4214940007701</c:v>
                </c:pt>
                <c:pt idx="7250">
                  <c:v>1683.65372210037</c:v>
                </c:pt>
                <c:pt idx="7251">
                  <c:v>1683.88595019997</c:v>
                </c:pt>
                <c:pt idx="7252">
                  <c:v>1684.11817829957</c:v>
                </c:pt>
                <c:pt idx="7253">
                  <c:v>1684.35040639917</c:v>
                </c:pt>
                <c:pt idx="7254">
                  <c:v>1684.5826344987699</c:v>
                </c:pt>
                <c:pt idx="7255">
                  <c:v>1684.8148625983699</c:v>
                </c:pt>
                <c:pt idx="7256">
                  <c:v>1685.0470906979699</c:v>
                </c:pt>
                <c:pt idx="7257">
                  <c:v>1685.2793187975701</c:v>
                </c:pt>
                <c:pt idx="7258">
                  <c:v>1685.5115468971701</c:v>
                </c:pt>
                <c:pt idx="7259">
                  <c:v>1685.7437749967701</c:v>
                </c:pt>
                <c:pt idx="7260">
                  <c:v>1685.9760030963701</c:v>
                </c:pt>
                <c:pt idx="7261">
                  <c:v>1686.20823119597</c:v>
                </c:pt>
                <c:pt idx="7262">
                  <c:v>1686.44045929557</c:v>
                </c:pt>
                <c:pt idx="7263">
                  <c:v>1686.67268739517</c:v>
                </c:pt>
                <c:pt idx="7264">
                  <c:v>1686.90491549477</c:v>
                </c:pt>
                <c:pt idx="7265">
                  <c:v>1687.1371435943699</c:v>
                </c:pt>
                <c:pt idx="7266">
                  <c:v>1687.3693716939699</c:v>
                </c:pt>
                <c:pt idx="7267">
                  <c:v>1687.6015997935799</c:v>
                </c:pt>
                <c:pt idx="7268">
                  <c:v>1687.8338278931799</c:v>
                </c:pt>
                <c:pt idx="7269">
                  <c:v>1688.0660559927801</c:v>
                </c:pt>
                <c:pt idx="7270">
                  <c:v>1688.2982840923801</c:v>
                </c:pt>
                <c:pt idx="7271">
                  <c:v>1688.5305121919801</c:v>
                </c:pt>
                <c:pt idx="7272">
                  <c:v>1688.76274029158</c:v>
                </c:pt>
                <c:pt idx="7273">
                  <c:v>1688.99496839118</c:v>
                </c:pt>
                <c:pt idx="7274">
                  <c:v>1689.22719649078</c:v>
                </c:pt>
                <c:pt idx="7275">
                  <c:v>1689.45942459038</c:v>
                </c:pt>
                <c:pt idx="7276">
                  <c:v>1689.6916526899799</c:v>
                </c:pt>
                <c:pt idx="7277">
                  <c:v>1689.9238807895799</c:v>
                </c:pt>
                <c:pt idx="7278">
                  <c:v>1690.1561088891799</c:v>
                </c:pt>
                <c:pt idx="7279">
                  <c:v>1690.3883369887801</c:v>
                </c:pt>
                <c:pt idx="7280">
                  <c:v>1690.6205650883801</c:v>
                </c:pt>
                <c:pt idx="7281">
                  <c:v>1690.8527931879801</c:v>
                </c:pt>
                <c:pt idx="7282">
                  <c:v>1691.08502128758</c:v>
                </c:pt>
                <c:pt idx="7283">
                  <c:v>1691.31724938718</c:v>
                </c:pt>
                <c:pt idx="7284">
                  <c:v>1691.54947748678</c:v>
                </c:pt>
                <c:pt idx="7285">
                  <c:v>1691.78170558638</c:v>
                </c:pt>
                <c:pt idx="7286">
                  <c:v>1692.01393368598</c:v>
                </c:pt>
                <c:pt idx="7287">
                  <c:v>1692.2461617855799</c:v>
                </c:pt>
                <c:pt idx="7288">
                  <c:v>1692.4783898851799</c:v>
                </c:pt>
                <c:pt idx="7289">
                  <c:v>1692.7106179847799</c:v>
                </c:pt>
                <c:pt idx="7290">
                  <c:v>1692.9428460843801</c:v>
                </c:pt>
                <c:pt idx="7291">
                  <c:v>1693.1750741839801</c:v>
                </c:pt>
                <c:pt idx="7292">
                  <c:v>1693.4073022835801</c:v>
                </c:pt>
                <c:pt idx="7293">
                  <c:v>1693.63953038318</c:v>
                </c:pt>
                <c:pt idx="7294">
                  <c:v>1693.87175848278</c:v>
                </c:pt>
                <c:pt idx="7295">
                  <c:v>1694.10398658238</c:v>
                </c:pt>
                <c:pt idx="7296">
                  <c:v>1694.33621468198</c:v>
                </c:pt>
                <c:pt idx="7297">
                  <c:v>1694.56844278158</c:v>
                </c:pt>
                <c:pt idx="7298">
                  <c:v>1694.8006708811799</c:v>
                </c:pt>
                <c:pt idx="7299">
                  <c:v>1695.0328989807799</c:v>
                </c:pt>
                <c:pt idx="7300">
                  <c:v>1695.2651270803799</c:v>
                </c:pt>
                <c:pt idx="7301">
                  <c:v>1695.4973551799801</c:v>
                </c:pt>
                <c:pt idx="7302">
                  <c:v>1695.7295832795801</c:v>
                </c:pt>
                <c:pt idx="7303">
                  <c:v>1695.9618113791801</c:v>
                </c:pt>
                <c:pt idx="7304">
                  <c:v>1696.19403947878</c:v>
                </c:pt>
                <c:pt idx="7305">
                  <c:v>1696.42626757838</c:v>
                </c:pt>
                <c:pt idx="7306">
                  <c:v>1696.65849567798</c:v>
                </c:pt>
                <c:pt idx="7307">
                  <c:v>1696.89072377758</c:v>
                </c:pt>
                <c:pt idx="7308">
                  <c:v>1697.12295187718</c:v>
                </c:pt>
                <c:pt idx="7309">
                  <c:v>1697.3551799767799</c:v>
                </c:pt>
                <c:pt idx="7310">
                  <c:v>1697.5874080763799</c:v>
                </c:pt>
                <c:pt idx="7311">
                  <c:v>1697.8196361759799</c:v>
                </c:pt>
                <c:pt idx="7312">
                  <c:v>1698.0518642755801</c:v>
                </c:pt>
                <c:pt idx="7313">
                  <c:v>1698.2840923751801</c:v>
                </c:pt>
                <c:pt idx="7314">
                  <c:v>1698.5163204747801</c:v>
                </c:pt>
                <c:pt idx="7315">
                  <c:v>1698.74854857438</c:v>
                </c:pt>
                <c:pt idx="7316">
                  <c:v>1698.98077667398</c:v>
                </c:pt>
                <c:pt idx="7317">
                  <c:v>1699.21300477358</c:v>
                </c:pt>
                <c:pt idx="7318">
                  <c:v>1699.44523287318</c:v>
                </c:pt>
                <c:pt idx="7319">
                  <c:v>1699.67746097278</c:v>
                </c:pt>
                <c:pt idx="7320">
                  <c:v>1699.9096890723799</c:v>
                </c:pt>
                <c:pt idx="7321">
                  <c:v>1700.1419171719799</c:v>
                </c:pt>
                <c:pt idx="7322">
                  <c:v>1700.3741452715799</c:v>
                </c:pt>
                <c:pt idx="7323">
                  <c:v>1700.6063733711801</c:v>
                </c:pt>
                <c:pt idx="7324">
                  <c:v>1700.8386014707801</c:v>
                </c:pt>
                <c:pt idx="7325">
                  <c:v>1701.0708295703801</c:v>
                </c:pt>
                <c:pt idx="7326">
                  <c:v>1701.30305766998</c:v>
                </c:pt>
                <c:pt idx="7327">
                  <c:v>1701.53528576958</c:v>
                </c:pt>
                <c:pt idx="7328">
                  <c:v>1701.76751386918</c:v>
                </c:pt>
                <c:pt idx="7329">
                  <c:v>1701.99974196878</c:v>
                </c:pt>
                <c:pt idx="7330">
                  <c:v>1702.23197006838</c:v>
                </c:pt>
                <c:pt idx="7331">
                  <c:v>1702.4641981679799</c:v>
                </c:pt>
                <c:pt idx="7332">
                  <c:v>1702.6964262675799</c:v>
                </c:pt>
                <c:pt idx="7333">
                  <c:v>1702.9286543671799</c:v>
                </c:pt>
                <c:pt idx="7334">
                  <c:v>1703.1608824667801</c:v>
                </c:pt>
                <c:pt idx="7335">
                  <c:v>1703.3931105663801</c:v>
                </c:pt>
                <c:pt idx="7336">
                  <c:v>1703.6253386659801</c:v>
                </c:pt>
                <c:pt idx="7337">
                  <c:v>1703.85756676558</c:v>
                </c:pt>
                <c:pt idx="7338">
                  <c:v>1704.08979486518</c:v>
                </c:pt>
                <c:pt idx="7339">
                  <c:v>1704.32202296478</c:v>
                </c:pt>
                <c:pt idx="7340">
                  <c:v>1704.55425106438</c:v>
                </c:pt>
                <c:pt idx="7341">
                  <c:v>1704.7864791639799</c:v>
                </c:pt>
                <c:pt idx="7342">
                  <c:v>1705.0187072635799</c:v>
                </c:pt>
                <c:pt idx="7343">
                  <c:v>1705.2509353631799</c:v>
                </c:pt>
                <c:pt idx="7344">
                  <c:v>1705.4831634627801</c:v>
                </c:pt>
                <c:pt idx="7345">
                  <c:v>1705.7153915623801</c:v>
                </c:pt>
                <c:pt idx="7346">
                  <c:v>1705.9476196619801</c:v>
                </c:pt>
                <c:pt idx="7347">
                  <c:v>1706.17984776158</c:v>
                </c:pt>
                <c:pt idx="7348">
                  <c:v>1706.41207586118</c:v>
                </c:pt>
                <c:pt idx="7349">
                  <c:v>1706.64430396078</c:v>
                </c:pt>
                <c:pt idx="7350">
                  <c:v>1706.87653206038</c:v>
                </c:pt>
                <c:pt idx="7351">
                  <c:v>1707.10876015998</c:v>
                </c:pt>
                <c:pt idx="7352">
                  <c:v>1707.3409882595799</c:v>
                </c:pt>
                <c:pt idx="7353">
                  <c:v>1707.5732163591799</c:v>
                </c:pt>
                <c:pt idx="7354">
                  <c:v>1707.8054444587799</c:v>
                </c:pt>
                <c:pt idx="7355">
                  <c:v>1708.0376725583801</c:v>
                </c:pt>
                <c:pt idx="7356">
                  <c:v>1708.2699006579801</c:v>
                </c:pt>
                <c:pt idx="7357">
                  <c:v>1708.5021287575801</c:v>
                </c:pt>
                <c:pt idx="7358">
                  <c:v>1708.73435685718</c:v>
                </c:pt>
                <c:pt idx="7359">
                  <c:v>1708.96658495678</c:v>
                </c:pt>
                <c:pt idx="7360">
                  <c:v>1709.19881305638</c:v>
                </c:pt>
                <c:pt idx="7361">
                  <c:v>1709.43104115598</c:v>
                </c:pt>
                <c:pt idx="7362">
                  <c:v>1709.66326925558</c:v>
                </c:pt>
                <c:pt idx="7363">
                  <c:v>1709.8954973551799</c:v>
                </c:pt>
                <c:pt idx="7364">
                  <c:v>1710.1277254547799</c:v>
                </c:pt>
                <c:pt idx="7365">
                  <c:v>1710.3599535543799</c:v>
                </c:pt>
                <c:pt idx="7366">
                  <c:v>1710.5921816539801</c:v>
                </c:pt>
                <c:pt idx="7367">
                  <c:v>1710.8244097535801</c:v>
                </c:pt>
                <c:pt idx="7368">
                  <c:v>1711.0566378531801</c:v>
                </c:pt>
                <c:pt idx="7369">
                  <c:v>1711.28886595278</c:v>
                </c:pt>
                <c:pt idx="7370">
                  <c:v>1711.52109405238</c:v>
                </c:pt>
                <c:pt idx="7371">
                  <c:v>1711.75332215198</c:v>
                </c:pt>
                <c:pt idx="7372">
                  <c:v>1711.98555025158</c:v>
                </c:pt>
                <c:pt idx="7373">
                  <c:v>1712.21777835118</c:v>
                </c:pt>
                <c:pt idx="7374">
                  <c:v>1712.4500064507799</c:v>
                </c:pt>
                <c:pt idx="7375">
                  <c:v>1712.6822345503799</c:v>
                </c:pt>
                <c:pt idx="7376">
                  <c:v>1712.9144626499799</c:v>
                </c:pt>
                <c:pt idx="7377">
                  <c:v>1713.1466907495801</c:v>
                </c:pt>
                <c:pt idx="7378">
                  <c:v>1713.3789188491801</c:v>
                </c:pt>
                <c:pt idx="7379">
                  <c:v>1713.6111469487801</c:v>
                </c:pt>
                <c:pt idx="7380">
                  <c:v>1713.84337504838</c:v>
                </c:pt>
                <c:pt idx="7381">
                  <c:v>1714.07560314798</c:v>
                </c:pt>
                <c:pt idx="7382">
                  <c:v>1714.30783124758</c:v>
                </c:pt>
                <c:pt idx="7383">
                  <c:v>1714.54005934718</c:v>
                </c:pt>
                <c:pt idx="7384">
                  <c:v>1714.77228744678</c:v>
                </c:pt>
                <c:pt idx="7385">
                  <c:v>1715.0045155463799</c:v>
                </c:pt>
                <c:pt idx="7386">
                  <c:v>1715.2367436459799</c:v>
                </c:pt>
                <c:pt idx="7387">
                  <c:v>1715.4689717455799</c:v>
                </c:pt>
                <c:pt idx="7388">
                  <c:v>1715.7011998451801</c:v>
                </c:pt>
                <c:pt idx="7389">
                  <c:v>1715.9334279447801</c:v>
                </c:pt>
                <c:pt idx="7390">
                  <c:v>1716.1656560443801</c:v>
                </c:pt>
                <c:pt idx="7391">
                  <c:v>1716.39788414398</c:v>
                </c:pt>
                <c:pt idx="7392">
                  <c:v>1716.63011224358</c:v>
                </c:pt>
                <c:pt idx="7393">
                  <c:v>1716.86234034318</c:v>
                </c:pt>
                <c:pt idx="7394">
                  <c:v>1717.09456844278</c:v>
                </c:pt>
                <c:pt idx="7395">
                  <c:v>1717.32679654238</c:v>
                </c:pt>
                <c:pt idx="7396">
                  <c:v>1717.5590246419799</c:v>
                </c:pt>
                <c:pt idx="7397">
                  <c:v>1717.7912527415799</c:v>
                </c:pt>
                <c:pt idx="7398">
                  <c:v>1718.0234808411799</c:v>
                </c:pt>
                <c:pt idx="7399">
                  <c:v>1718.2557089407801</c:v>
                </c:pt>
                <c:pt idx="7400">
                  <c:v>1718.4879370403801</c:v>
                </c:pt>
                <c:pt idx="7401">
                  <c:v>1718.7201651399801</c:v>
                </c:pt>
                <c:pt idx="7402">
                  <c:v>1718.95239323958</c:v>
                </c:pt>
                <c:pt idx="7403">
                  <c:v>1719.18462133918</c:v>
                </c:pt>
                <c:pt idx="7404">
                  <c:v>1719.41684943878</c:v>
                </c:pt>
                <c:pt idx="7405">
                  <c:v>1719.64907753838</c:v>
                </c:pt>
                <c:pt idx="7406">
                  <c:v>1719.8813056379799</c:v>
                </c:pt>
                <c:pt idx="7407">
                  <c:v>1720.1135337375799</c:v>
                </c:pt>
                <c:pt idx="7408">
                  <c:v>1720.3457618371799</c:v>
                </c:pt>
                <c:pt idx="7409">
                  <c:v>1720.5779899367801</c:v>
                </c:pt>
                <c:pt idx="7410">
                  <c:v>1720.8102180363801</c:v>
                </c:pt>
                <c:pt idx="7411">
                  <c:v>1721.0424461359801</c:v>
                </c:pt>
                <c:pt idx="7412">
                  <c:v>1721.2746742355801</c:v>
                </c:pt>
                <c:pt idx="7413">
                  <c:v>1721.50690233518</c:v>
                </c:pt>
                <c:pt idx="7414">
                  <c:v>1721.73913043478</c:v>
                </c:pt>
                <c:pt idx="7415">
                  <c:v>1721.97135853438</c:v>
                </c:pt>
                <c:pt idx="7416">
                  <c:v>1722.20358663398</c:v>
                </c:pt>
                <c:pt idx="7417">
                  <c:v>1722.4358147335799</c:v>
                </c:pt>
                <c:pt idx="7418">
                  <c:v>1722.6680428331799</c:v>
                </c:pt>
                <c:pt idx="7419">
                  <c:v>1722.9002709327799</c:v>
                </c:pt>
                <c:pt idx="7420">
                  <c:v>1723.1324990323801</c:v>
                </c:pt>
                <c:pt idx="7421">
                  <c:v>1723.3647271319801</c:v>
                </c:pt>
                <c:pt idx="7422">
                  <c:v>1723.5969552315801</c:v>
                </c:pt>
                <c:pt idx="7423">
                  <c:v>1723.82918333118</c:v>
                </c:pt>
                <c:pt idx="7424">
                  <c:v>1724.06141143078</c:v>
                </c:pt>
                <c:pt idx="7425">
                  <c:v>1724.29363953038</c:v>
                </c:pt>
                <c:pt idx="7426">
                  <c:v>1724.52586762998</c:v>
                </c:pt>
                <c:pt idx="7427">
                  <c:v>1724.75809572958</c:v>
                </c:pt>
                <c:pt idx="7428">
                  <c:v>1724.9903238291799</c:v>
                </c:pt>
                <c:pt idx="7429">
                  <c:v>1725.2225519287799</c:v>
                </c:pt>
                <c:pt idx="7430">
                  <c:v>1725.4547800283799</c:v>
                </c:pt>
                <c:pt idx="7431">
                  <c:v>1725.6870081279801</c:v>
                </c:pt>
                <c:pt idx="7432">
                  <c:v>1725.9192362275801</c:v>
                </c:pt>
                <c:pt idx="7433">
                  <c:v>1726.1514643271801</c:v>
                </c:pt>
                <c:pt idx="7434">
                  <c:v>1726.38369242678</c:v>
                </c:pt>
                <c:pt idx="7435">
                  <c:v>1726.61592052638</c:v>
                </c:pt>
                <c:pt idx="7436">
                  <c:v>1726.84814862598</c:v>
                </c:pt>
                <c:pt idx="7437">
                  <c:v>1727.08037672558</c:v>
                </c:pt>
                <c:pt idx="7438">
                  <c:v>1727.31260482518</c:v>
                </c:pt>
                <c:pt idx="7439">
                  <c:v>1727.5448329247799</c:v>
                </c:pt>
                <c:pt idx="7440">
                  <c:v>1727.7770610243799</c:v>
                </c:pt>
                <c:pt idx="7441">
                  <c:v>1728.0092891239799</c:v>
                </c:pt>
                <c:pt idx="7442">
                  <c:v>1728.2415172235801</c:v>
                </c:pt>
                <c:pt idx="7443">
                  <c:v>1728.4737453231801</c:v>
                </c:pt>
                <c:pt idx="7444">
                  <c:v>1728.7059734227801</c:v>
                </c:pt>
                <c:pt idx="7445">
                  <c:v>1728.93820152238</c:v>
                </c:pt>
                <c:pt idx="7446">
                  <c:v>1729.17042962198</c:v>
                </c:pt>
                <c:pt idx="7447">
                  <c:v>1729.40265772158</c:v>
                </c:pt>
                <c:pt idx="7448">
                  <c:v>1729.63488582118</c:v>
                </c:pt>
                <c:pt idx="7449">
                  <c:v>1729.86711392078</c:v>
                </c:pt>
                <c:pt idx="7450">
                  <c:v>1730.0993420203799</c:v>
                </c:pt>
                <c:pt idx="7451">
                  <c:v>1730.3315701199799</c:v>
                </c:pt>
                <c:pt idx="7452">
                  <c:v>1730.5637982195799</c:v>
                </c:pt>
                <c:pt idx="7453">
                  <c:v>1730.7960263191801</c:v>
                </c:pt>
                <c:pt idx="7454">
                  <c:v>1731.0282544187801</c:v>
                </c:pt>
                <c:pt idx="7455">
                  <c:v>1731.2604825183801</c:v>
                </c:pt>
                <c:pt idx="7456">
                  <c:v>1731.49271061798</c:v>
                </c:pt>
                <c:pt idx="7457">
                  <c:v>1731.72493871758</c:v>
                </c:pt>
                <c:pt idx="7458">
                  <c:v>1731.95716681718</c:v>
                </c:pt>
                <c:pt idx="7459">
                  <c:v>1732.18939491678</c:v>
                </c:pt>
                <c:pt idx="7460">
                  <c:v>1732.42162301638</c:v>
                </c:pt>
                <c:pt idx="7461">
                  <c:v>1732.6538511159899</c:v>
                </c:pt>
                <c:pt idx="7462">
                  <c:v>1732.8860792155899</c:v>
                </c:pt>
                <c:pt idx="7463">
                  <c:v>1733.1183073151899</c:v>
                </c:pt>
                <c:pt idx="7464">
                  <c:v>1733.3505354147901</c:v>
                </c:pt>
                <c:pt idx="7465">
                  <c:v>1733.5827635143901</c:v>
                </c:pt>
                <c:pt idx="7466">
                  <c:v>1733.8149916139901</c:v>
                </c:pt>
                <c:pt idx="7467">
                  <c:v>1734.04721971359</c:v>
                </c:pt>
                <c:pt idx="7468">
                  <c:v>1734.27944781319</c:v>
                </c:pt>
                <c:pt idx="7469">
                  <c:v>1734.51167591279</c:v>
                </c:pt>
                <c:pt idx="7470">
                  <c:v>1734.74390401239</c:v>
                </c:pt>
                <c:pt idx="7471">
                  <c:v>1734.97613211199</c:v>
                </c:pt>
                <c:pt idx="7472">
                  <c:v>1735.2083602115899</c:v>
                </c:pt>
                <c:pt idx="7473">
                  <c:v>1735.4405883111899</c:v>
                </c:pt>
                <c:pt idx="7474">
                  <c:v>1735.6728164107899</c:v>
                </c:pt>
                <c:pt idx="7475">
                  <c:v>1735.9050445103901</c:v>
                </c:pt>
                <c:pt idx="7476">
                  <c:v>1736.1372726099901</c:v>
                </c:pt>
                <c:pt idx="7477">
                  <c:v>1736.3695007095901</c:v>
                </c:pt>
                <c:pt idx="7478">
                  <c:v>1736.60172880919</c:v>
                </c:pt>
                <c:pt idx="7479">
                  <c:v>1736.83395690879</c:v>
                </c:pt>
                <c:pt idx="7480">
                  <c:v>1737.06618500839</c:v>
                </c:pt>
                <c:pt idx="7481">
                  <c:v>1737.29841310799</c:v>
                </c:pt>
                <c:pt idx="7482">
                  <c:v>1737.53064120759</c:v>
                </c:pt>
                <c:pt idx="7483">
                  <c:v>1737.7628693071899</c:v>
                </c:pt>
                <c:pt idx="7484">
                  <c:v>1737.9950974067899</c:v>
                </c:pt>
                <c:pt idx="7485">
                  <c:v>1738.2273255063899</c:v>
                </c:pt>
                <c:pt idx="7486">
                  <c:v>1738.4595536059901</c:v>
                </c:pt>
                <c:pt idx="7487">
                  <c:v>1738.6917817055901</c:v>
                </c:pt>
                <c:pt idx="7488">
                  <c:v>1738.9240098051901</c:v>
                </c:pt>
                <c:pt idx="7489">
                  <c:v>1739.15623790479</c:v>
                </c:pt>
                <c:pt idx="7490">
                  <c:v>1739.38846600439</c:v>
                </c:pt>
                <c:pt idx="7491">
                  <c:v>1739.62069410399</c:v>
                </c:pt>
                <c:pt idx="7492">
                  <c:v>1739.85292220359</c:v>
                </c:pt>
                <c:pt idx="7493">
                  <c:v>1740.0851503031899</c:v>
                </c:pt>
                <c:pt idx="7494">
                  <c:v>1740.3173784027899</c:v>
                </c:pt>
                <c:pt idx="7495">
                  <c:v>1740.5496065023899</c:v>
                </c:pt>
                <c:pt idx="7496">
                  <c:v>1740.7818346019901</c:v>
                </c:pt>
                <c:pt idx="7497">
                  <c:v>1741.0140627015901</c:v>
                </c:pt>
                <c:pt idx="7498">
                  <c:v>1741.2462908011901</c:v>
                </c:pt>
                <c:pt idx="7499">
                  <c:v>1741.47851890079</c:v>
                </c:pt>
                <c:pt idx="7500">
                  <c:v>1741.71074700039</c:v>
                </c:pt>
                <c:pt idx="7501">
                  <c:v>1741.94297509999</c:v>
                </c:pt>
                <c:pt idx="7502">
                  <c:v>1742.17520319959</c:v>
                </c:pt>
                <c:pt idx="7503">
                  <c:v>1742.40743129919</c:v>
                </c:pt>
                <c:pt idx="7504">
                  <c:v>1742.6396593987899</c:v>
                </c:pt>
                <c:pt idx="7505">
                  <c:v>1742.8718874983899</c:v>
                </c:pt>
                <c:pt idx="7506">
                  <c:v>1743.1041155979899</c:v>
                </c:pt>
                <c:pt idx="7507">
                  <c:v>1743.3363436975901</c:v>
                </c:pt>
                <c:pt idx="7508">
                  <c:v>1743.5685717971901</c:v>
                </c:pt>
                <c:pt idx="7509">
                  <c:v>1743.8007998967901</c:v>
                </c:pt>
                <c:pt idx="7510">
                  <c:v>1744.03302799639</c:v>
                </c:pt>
                <c:pt idx="7511">
                  <c:v>1744.26525609599</c:v>
                </c:pt>
                <c:pt idx="7512">
                  <c:v>1744.49748419559</c:v>
                </c:pt>
                <c:pt idx="7513">
                  <c:v>1744.72971229519</c:v>
                </c:pt>
                <c:pt idx="7514">
                  <c:v>1744.96194039479</c:v>
                </c:pt>
                <c:pt idx="7515">
                  <c:v>1745.1941684943899</c:v>
                </c:pt>
                <c:pt idx="7516">
                  <c:v>1745.4263965939899</c:v>
                </c:pt>
                <c:pt idx="7517">
                  <c:v>1745.6586246935899</c:v>
                </c:pt>
                <c:pt idx="7518">
                  <c:v>1745.8908527931901</c:v>
                </c:pt>
                <c:pt idx="7519">
                  <c:v>1746.1230808927901</c:v>
                </c:pt>
                <c:pt idx="7520">
                  <c:v>1746.3553089923901</c:v>
                </c:pt>
                <c:pt idx="7521">
                  <c:v>1746.58753709199</c:v>
                </c:pt>
                <c:pt idx="7522">
                  <c:v>1746.81976519159</c:v>
                </c:pt>
                <c:pt idx="7523">
                  <c:v>1747.05199329119</c:v>
                </c:pt>
                <c:pt idx="7524">
                  <c:v>1747.28422139079</c:v>
                </c:pt>
                <c:pt idx="7525">
                  <c:v>1747.51644949039</c:v>
                </c:pt>
                <c:pt idx="7526">
                  <c:v>1747.7486775899899</c:v>
                </c:pt>
                <c:pt idx="7527">
                  <c:v>1747.9809056895899</c:v>
                </c:pt>
                <c:pt idx="7528">
                  <c:v>1748.2131337891899</c:v>
                </c:pt>
                <c:pt idx="7529">
                  <c:v>1748.4453618887901</c:v>
                </c:pt>
                <c:pt idx="7530">
                  <c:v>1748.6775899883901</c:v>
                </c:pt>
                <c:pt idx="7531">
                  <c:v>1748.9098180879901</c:v>
                </c:pt>
                <c:pt idx="7532">
                  <c:v>1749.14204618759</c:v>
                </c:pt>
                <c:pt idx="7533">
                  <c:v>1749.37427428719</c:v>
                </c:pt>
                <c:pt idx="7534">
                  <c:v>1749.60650238679</c:v>
                </c:pt>
                <c:pt idx="7535">
                  <c:v>1749.83873048639</c:v>
                </c:pt>
                <c:pt idx="7536">
                  <c:v>1750.07095858599</c:v>
                </c:pt>
                <c:pt idx="7537">
                  <c:v>1750.3031866855899</c:v>
                </c:pt>
                <c:pt idx="7538">
                  <c:v>1750.5354147851899</c:v>
                </c:pt>
                <c:pt idx="7539">
                  <c:v>1750.7676428847899</c:v>
                </c:pt>
                <c:pt idx="7540">
                  <c:v>1750.9998709843901</c:v>
                </c:pt>
                <c:pt idx="7541">
                  <c:v>1751.2320990839901</c:v>
                </c:pt>
                <c:pt idx="7542">
                  <c:v>1751.4643271835901</c:v>
                </c:pt>
                <c:pt idx="7543">
                  <c:v>1751.69655528319</c:v>
                </c:pt>
                <c:pt idx="7544">
                  <c:v>1751.92878338279</c:v>
                </c:pt>
                <c:pt idx="7545">
                  <c:v>1752.16101148239</c:v>
                </c:pt>
                <c:pt idx="7546">
                  <c:v>1752.39323958199</c:v>
                </c:pt>
                <c:pt idx="7547">
                  <c:v>1752.62546768159</c:v>
                </c:pt>
                <c:pt idx="7548">
                  <c:v>1752.8576957811899</c:v>
                </c:pt>
                <c:pt idx="7549">
                  <c:v>1753.0899238807899</c:v>
                </c:pt>
                <c:pt idx="7550">
                  <c:v>1753.3221519803899</c:v>
                </c:pt>
                <c:pt idx="7551">
                  <c:v>1753.5543800799901</c:v>
                </c:pt>
                <c:pt idx="7552">
                  <c:v>1753.7866081795901</c:v>
                </c:pt>
                <c:pt idx="7553">
                  <c:v>1754.0188362791901</c:v>
                </c:pt>
                <c:pt idx="7554">
                  <c:v>1754.25106437879</c:v>
                </c:pt>
                <c:pt idx="7555">
                  <c:v>1754.48329247839</c:v>
                </c:pt>
                <c:pt idx="7556">
                  <c:v>1754.71552057799</c:v>
                </c:pt>
                <c:pt idx="7557">
                  <c:v>1754.94774867759</c:v>
                </c:pt>
                <c:pt idx="7558">
                  <c:v>1755.1799767771899</c:v>
                </c:pt>
                <c:pt idx="7559">
                  <c:v>1755.4122048767899</c:v>
                </c:pt>
                <c:pt idx="7560">
                  <c:v>1755.6444329763899</c:v>
                </c:pt>
                <c:pt idx="7561">
                  <c:v>1755.8766610759899</c:v>
                </c:pt>
                <c:pt idx="7562">
                  <c:v>1756.1088891755901</c:v>
                </c:pt>
                <c:pt idx="7563">
                  <c:v>1756.3411172751901</c:v>
                </c:pt>
                <c:pt idx="7564">
                  <c:v>1756.5733453747901</c:v>
                </c:pt>
                <c:pt idx="7565">
                  <c:v>1756.80557347439</c:v>
                </c:pt>
                <c:pt idx="7566">
                  <c:v>1757.03780157399</c:v>
                </c:pt>
                <c:pt idx="7567">
                  <c:v>1757.27002967359</c:v>
                </c:pt>
                <c:pt idx="7568">
                  <c:v>1757.50225777319</c:v>
                </c:pt>
                <c:pt idx="7569">
                  <c:v>1757.7344858727899</c:v>
                </c:pt>
                <c:pt idx="7570">
                  <c:v>1757.9667139723899</c:v>
                </c:pt>
                <c:pt idx="7571">
                  <c:v>1758.1989420719899</c:v>
                </c:pt>
                <c:pt idx="7572">
                  <c:v>1758.4311701715901</c:v>
                </c:pt>
                <c:pt idx="7573">
                  <c:v>1758.6633982711901</c:v>
                </c:pt>
                <c:pt idx="7574">
                  <c:v>1758.8956263707901</c:v>
                </c:pt>
                <c:pt idx="7575">
                  <c:v>1759.12785447039</c:v>
                </c:pt>
                <c:pt idx="7576">
                  <c:v>1759.36008256999</c:v>
                </c:pt>
                <c:pt idx="7577">
                  <c:v>1759.59231066959</c:v>
                </c:pt>
                <c:pt idx="7578">
                  <c:v>1759.82453876919</c:v>
                </c:pt>
                <c:pt idx="7579">
                  <c:v>1760.05676686879</c:v>
                </c:pt>
                <c:pt idx="7580">
                  <c:v>1760.2889949683899</c:v>
                </c:pt>
                <c:pt idx="7581">
                  <c:v>1760.5212230679899</c:v>
                </c:pt>
                <c:pt idx="7582">
                  <c:v>1760.7534511675899</c:v>
                </c:pt>
                <c:pt idx="7583">
                  <c:v>1760.9856792671901</c:v>
                </c:pt>
                <c:pt idx="7584">
                  <c:v>1761.2179073667901</c:v>
                </c:pt>
                <c:pt idx="7585">
                  <c:v>1761.4501354663901</c:v>
                </c:pt>
                <c:pt idx="7586">
                  <c:v>1761.68236356599</c:v>
                </c:pt>
                <c:pt idx="7587">
                  <c:v>1761.91459166559</c:v>
                </c:pt>
                <c:pt idx="7588">
                  <c:v>1762.14681976519</c:v>
                </c:pt>
                <c:pt idx="7589">
                  <c:v>1762.37904786479</c:v>
                </c:pt>
                <c:pt idx="7590">
                  <c:v>1762.61127596439</c:v>
                </c:pt>
                <c:pt idx="7591">
                  <c:v>1762.8435040639899</c:v>
                </c:pt>
                <c:pt idx="7592">
                  <c:v>1763.0757321635899</c:v>
                </c:pt>
                <c:pt idx="7593">
                  <c:v>1763.3079602631899</c:v>
                </c:pt>
                <c:pt idx="7594">
                  <c:v>1763.5401883627901</c:v>
                </c:pt>
                <c:pt idx="7595">
                  <c:v>1763.7724164623901</c:v>
                </c:pt>
                <c:pt idx="7596">
                  <c:v>1764.0046445619901</c:v>
                </c:pt>
                <c:pt idx="7597">
                  <c:v>1764.23687266159</c:v>
                </c:pt>
                <c:pt idx="7598">
                  <c:v>1764.46910076119</c:v>
                </c:pt>
                <c:pt idx="7599">
                  <c:v>1764.70132886079</c:v>
                </c:pt>
                <c:pt idx="7600">
                  <c:v>1764.93355696039</c:v>
                </c:pt>
                <c:pt idx="7601">
                  <c:v>1765.16578505999</c:v>
                </c:pt>
                <c:pt idx="7602">
                  <c:v>1765.3980131595899</c:v>
                </c:pt>
                <c:pt idx="7603">
                  <c:v>1765.6302412591899</c:v>
                </c:pt>
                <c:pt idx="7604">
                  <c:v>1765.8624693587899</c:v>
                </c:pt>
                <c:pt idx="7605">
                  <c:v>1766.0946974583901</c:v>
                </c:pt>
                <c:pt idx="7606">
                  <c:v>1766.3269255579901</c:v>
                </c:pt>
                <c:pt idx="7607">
                  <c:v>1766.5591536575901</c:v>
                </c:pt>
                <c:pt idx="7608">
                  <c:v>1766.79138175719</c:v>
                </c:pt>
                <c:pt idx="7609">
                  <c:v>1767.02360985679</c:v>
                </c:pt>
                <c:pt idx="7610">
                  <c:v>1767.25583795639</c:v>
                </c:pt>
                <c:pt idx="7611">
                  <c:v>1767.48806605599</c:v>
                </c:pt>
                <c:pt idx="7612">
                  <c:v>1767.72029415559</c:v>
                </c:pt>
                <c:pt idx="7613">
                  <c:v>1767.9525222551899</c:v>
                </c:pt>
                <c:pt idx="7614">
                  <c:v>1768.1847503547899</c:v>
                </c:pt>
                <c:pt idx="7615">
                  <c:v>1768.4169784543899</c:v>
                </c:pt>
                <c:pt idx="7616">
                  <c:v>1768.6492065539901</c:v>
                </c:pt>
                <c:pt idx="7617">
                  <c:v>1768.8814346535901</c:v>
                </c:pt>
                <c:pt idx="7618">
                  <c:v>1769.1136627531901</c:v>
                </c:pt>
                <c:pt idx="7619">
                  <c:v>1769.34589085279</c:v>
                </c:pt>
                <c:pt idx="7620">
                  <c:v>1769.57811895239</c:v>
                </c:pt>
                <c:pt idx="7621">
                  <c:v>1769.81034705199</c:v>
                </c:pt>
                <c:pt idx="7622">
                  <c:v>1770.04257515159</c:v>
                </c:pt>
                <c:pt idx="7623">
                  <c:v>1770.27480325119</c:v>
                </c:pt>
                <c:pt idx="7624">
                  <c:v>1770.5070313507899</c:v>
                </c:pt>
                <c:pt idx="7625">
                  <c:v>1770.7392594503899</c:v>
                </c:pt>
                <c:pt idx="7626">
                  <c:v>1770.9714875499899</c:v>
                </c:pt>
                <c:pt idx="7627">
                  <c:v>1771.2037156495901</c:v>
                </c:pt>
                <c:pt idx="7628">
                  <c:v>1771.4359437491901</c:v>
                </c:pt>
                <c:pt idx="7629">
                  <c:v>1771.6681718487901</c:v>
                </c:pt>
                <c:pt idx="7630">
                  <c:v>1771.90039994839</c:v>
                </c:pt>
                <c:pt idx="7631">
                  <c:v>1772.13262804799</c:v>
                </c:pt>
                <c:pt idx="7632">
                  <c:v>1772.36485614759</c:v>
                </c:pt>
                <c:pt idx="7633">
                  <c:v>1772.59708424719</c:v>
                </c:pt>
                <c:pt idx="7634">
                  <c:v>1772.8293123467899</c:v>
                </c:pt>
                <c:pt idx="7635">
                  <c:v>1773.0615404463899</c:v>
                </c:pt>
                <c:pt idx="7636">
                  <c:v>1773.2937685459899</c:v>
                </c:pt>
                <c:pt idx="7637">
                  <c:v>1773.5259966455901</c:v>
                </c:pt>
                <c:pt idx="7638">
                  <c:v>1773.7582247451901</c:v>
                </c:pt>
                <c:pt idx="7639">
                  <c:v>1773.9904528447901</c:v>
                </c:pt>
                <c:pt idx="7640">
                  <c:v>1774.22268094439</c:v>
                </c:pt>
                <c:pt idx="7641">
                  <c:v>1774.45490904399</c:v>
                </c:pt>
                <c:pt idx="7642">
                  <c:v>1774.68713714359</c:v>
                </c:pt>
                <c:pt idx="7643">
                  <c:v>1774.91936524319</c:v>
                </c:pt>
                <c:pt idx="7644">
                  <c:v>1775.15159334279</c:v>
                </c:pt>
                <c:pt idx="7645">
                  <c:v>1775.3838214423899</c:v>
                </c:pt>
                <c:pt idx="7646">
                  <c:v>1775.6160495419899</c:v>
                </c:pt>
                <c:pt idx="7647">
                  <c:v>1775.8482776415899</c:v>
                </c:pt>
                <c:pt idx="7648">
                  <c:v>1776.0805057411901</c:v>
                </c:pt>
                <c:pt idx="7649">
                  <c:v>1776.3127338407901</c:v>
                </c:pt>
                <c:pt idx="7650">
                  <c:v>1776.5449619403901</c:v>
                </c:pt>
                <c:pt idx="7651">
                  <c:v>1776.77719003999</c:v>
                </c:pt>
                <c:pt idx="7652">
                  <c:v>1777.0094181396</c:v>
                </c:pt>
                <c:pt idx="7653">
                  <c:v>1777.2416462392</c:v>
                </c:pt>
                <c:pt idx="7654">
                  <c:v>1777.47387433879</c:v>
                </c:pt>
                <c:pt idx="7655">
                  <c:v>1777.7061024384</c:v>
                </c:pt>
                <c:pt idx="7656">
                  <c:v>1777.9383305379999</c:v>
                </c:pt>
                <c:pt idx="7657">
                  <c:v>1778.1705586375999</c:v>
                </c:pt>
                <c:pt idx="7658">
                  <c:v>1778.4027867371999</c:v>
                </c:pt>
                <c:pt idx="7659">
                  <c:v>1778.6350148368001</c:v>
                </c:pt>
                <c:pt idx="7660">
                  <c:v>1778.8672429364001</c:v>
                </c:pt>
                <c:pt idx="7661">
                  <c:v>1779.0994710360001</c:v>
                </c:pt>
                <c:pt idx="7662">
                  <c:v>1779.3316991356</c:v>
                </c:pt>
                <c:pt idx="7663">
                  <c:v>1779.5639272352</c:v>
                </c:pt>
                <c:pt idx="7664">
                  <c:v>1779.7961553348</c:v>
                </c:pt>
                <c:pt idx="7665">
                  <c:v>1780.0283834344</c:v>
                </c:pt>
                <c:pt idx="7666">
                  <c:v>1780.260611534</c:v>
                </c:pt>
                <c:pt idx="7667">
                  <c:v>1780.4928396335999</c:v>
                </c:pt>
                <c:pt idx="7668">
                  <c:v>1780.7250677331999</c:v>
                </c:pt>
                <c:pt idx="7669">
                  <c:v>1780.9572958327999</c:v>
                </c:pt>
                <c:pt idx="7670">
                  <c:v>1781.1895239324001</c:v>
                </c:pt>
                <c:pt idx="7671">
                  <c:v>1781.4217520320001</c:v>
                </c:pt>
                <c:pt idx="7672">
                  <c:v>1781.6539801316001</c:v>
                </c:pt>
                <c:pt idx="7673">
                  <c:v>1781.8862082312</c:v>
                </c:pt>
                <c:pt idx="7674">
                  <c:v>1782.1184363308</c:v>
                </c:pt>
                <c:pt idx="7675">
                  <c:v>1782.3506644304</c:v>
                </c:pt>
                <c:pt idx="7676">
                  <c:v>1782.58289253</c:v>
                </c:pt>
                <c:pt idx="7677">
                  <c:v>1782.8151206296</c:v>
                </c:pt>
                <c:pt idx="7678">
                  <c:v>1783.0473487291999</c:v>
                </c:pt>
                <c:pt idx="7679">
                  <c:v>1783.2795768287999</c:v>
                </c:pt>
                <c:pt idx="7680">
                  <c:v>1783.5118049283999</c:v>
                </c:pt>
                <c:pt idx="7681">
                  <c:v>1783.7440330280001</c:v>
                </c:pt>
                <c:pt idx="7682">
                  <c:v>1783.9762611276001</c:v>
                </c:pt>
                <c:pt idx="7683">
                  <c:v>1784.2084892272001</c:v>
                </c:pt>
                <c:pt idx="7684">
                  <c:v>1784.4407173268</c:v>
                </c:pt>
                <c:pt idx="7685">
                  <c:v>1784.6729454264</c:v>
                </c:pt>
                <c:pt idx="7686">
                  <c:v>1784.905173526</c:v>
                </c:pt>
                <c:pt idx="7687">
                  <c:v>1785.1374016256</c:v>
                </c:pt>
                <c:pt idx="7688">
                  <c:v>1785.3696297252</c:v>
                </c:pt>
                <c:pt idx="7689">
                  <c:v>1785.6018578247999</c:v>
                </c:pt>
                <c:pt idx="7690">
                  <c:v>1785.8340859243999</c:v>
                </c:pt>
                <c:pt idx="7691">
                  <c:v>1786.0663140239999</c:v>
                </c:pt>
                <c:pt idx="7692">
                  <c:v>1786.2985421236001</c:v>
                </c:pt>
                <c:pt idx="7693">
                  <c:v>1786.5307702232001</c:v>
                </c:pt>
                <c:pt idx="7694">
                  <c:v>1786.7629983228001</c:v>
                </c:pt>
                <c:pt idx="7695">
                  <c:v>1786.9952264224</c:v>
                </c:pt>
                <c:pt idx="7696">
                  <c:v>1787.227454522</c:v>
                </c:pt>
                <c:pt idx="7697">
                  <c:v>1787.4596826216</c:v>
                </c:pt>
                <c:pt idx="7698">
                  <c:v>1787.6919107212</c:v>
                </c:pt>
                <c:pt idx="7699">
                  <c:v>1787.9241388208</c:v>
                </c:pt>
                <c:pt idx="7700">
                  <c:v>1788.1563669203999</c:v>
                </c:pt>
                <c:pt idx="7701">
                  <c:v>1788.3885950199999</c:v>
                </c:pt>
                <c:pt idx="7702">
                  <c:v>1788.6208231195999</c:v>
                </c:pt>
                <c:pt idx="7703">
                  <c:v>1788.8530512192001</c:v>
                </c:pt>
                <c:pt idx="7704">
                  <c:v>1789.0852793188001</c:v>
                </c:pt>
                <c:pt idx="7705">
                  <c:v>1789.3175074184001</c:v>
                </c:pt>
                <c:pt idx="7706">
                  <c:v>1789.549735518</c:v>
                </c:pt>
                <c:pt idx="7707">
                  <c:v>1789.7819636176</c:v>
                </c:pt>
                <c:pt idx="7708">
                  <c:v>1790.0141917172</c:v>
                </c:pt>
                <c:pt idx="7709">
                  <c:v>1790.2464198168</c:v>
                </c:pt>
                <c:pt idx="7710">
                  <c:v>1790.4786479164</c:v>
                </c:pt>
                <c:pt idx="7711">
                  <c:v>1790.7108760159999</c:v>
                </c:pt>
                <c:pt idx="7712">
                  <c:v>1790.9431041155999</c:v>
                </c:pt>
                <c:pt idx="7713">
                  <c:v>1791.1753322151999</c:v>
                </c:pt>
                <c:pt idx="7714">
                  <c:v>1791.4075603148001</c:v>
                </c:pt>
                <c:pt idx="7715">
                  <c:v>1791.6397884144001</c:v>
                </c:pt>
                <c:pt idx="7716">
                  <c:v>1791.8720165140001</c:v>
                </c:pt>
                <c:pt idx="7717">
                  <c:v>1792.1042446136</c:v>
                </c:pt>
                <c:pt idx="7718">
                  <c:v>1792.3364727132</c:v>
                </c:pt>
                <c:pt idx="7719">
                  <c:v>1792.5687008128</c:v>
                </c:pt>
                <c:pt idx="7720">
                  <c:v>1792.8009289124</c:v>
                </c:pt>
                <c:pt idx="7721">
                  <c:v>1793.0331570119999</c:v>
                </c:pt>
                <c:pt idx="7722">
                  <c:v>1793.2653851115999</c:v>
                </c:pt>
                <c:pt idx="7723">
                  <c:v>1793.4976132111999</c:v>
                </c:pt>
                <c:pt idx="7724">
                  <c:v>1793.7298413108001</c:v>
                </c:pt>
                <c:pt idx="7725">
                  <c:v>1793.9620694104001</c:v>
                </c:pt>
                <c:pt idx="7726">
                  <c:v>1794.1942975100001</c:v>
                </c:pt>
                <c:pt idx="7727">
                  <c:v>1794.4265256096</c:v>
                </c:pt>
                <c:pt idx="7728">
                  <c:v>1794.6587537092</c:v>
                </c:pt>
                <c:pt idx="7729">
                  <c:v>1794.8909818088</c:v>
                </c:pt>
                <c:pt idx="7730">
                  <c:v>1795.1232099084</c:v>
                </c:pt>
                <c:pt idx="7731">
                  <c:v>1795.355438008</c:v>
                </c:pt>
                <c:pt idx="7732">
                  <c:v>1795.5876661075999</c:v>
                </c:pt>
                <c:pt idx="7733">
                  <c:v>1795.8198942071999</c:v>
                </c:pt>
                <c:pt idx="7734">
                  <c:v>1796.0521223067999</c:v>
                </c:pt>
                <c:pt idx="7735">
                  <c:v>1796.2843504064001</c:v>
                </c:pt>
                <c:pt idx="7736">
                  <c:v>1796.5165785060001</c:v>
                </c:pt>
                <c:pt idx="7737">
                  <c:v>1796.7488066056001</c:v>
                </c:pt>
                <c:pt idx="7738">
                  <c:v>1796.9810347052</c:v>
                </c:pt>
                <c:pt idx="7739">
                  <c:v>1797.2132628048</c:v>
                </c:pt>
                <c:pt idx="7740">
                  <c:v>1797.4454909044</c:v>
                </c:pt>
                <c:pt idx="7741">
                  <c:v>1797.677719004</c:v>
                </c:pt>
                <c:pt idx="7742">
                  <c:v>1797.9099471036</c:v>
                </c:pt>
                <c:pt idx="7743">
                  <c:v>1798.1421752031999</c:v>
                </c:pt>
                <c:pt idx="7744">
                  <c:v>1798.3744033027999</c:v>
                </c:pt>
                <c:pt idx="7745">
                  <c:v>1798.6066314023999</c:v>
                </c:pt>
                <c:pt idx="7746">
                  <c:v>1798.8388595020001</c:v>
                </c:pt>
                <c:pt idx="7747">
                  <c:v>1799.0710876016001</c:v>
                </c:pt>
                <c:pt idx="7748">
                  <c:v>1799.3033157012001</c:v>
                </c:pt>
                <c:pt idx="7749">
                  <c:v>1799.5355438008</c:v>
                </c:pt>
                <c:pt idx="7750">
                  <c:v>1799.7677719004</c:v>
                </c:pt>
              </c:numCache>
            </c:numRef>
          </c:xVal>
          <c:yVal>
            <c:numRef>
              <c:f>Sheet1!$B$2:$B$7752</c:f>
              <c:numCache>
                <c:formatCode>General</c:formatCode>
                <c:ptCount val="7751"/>
                <c:pt idx="0">
                  <c:v>2.3275185032319801</c:v>
                </c:pt>
                <c:pt idx="1">
                  <c:v>1.83174608311928</c:v>
                </c:pt>
                <c:pt idx="2">
                  <c:v>1.1644885364606401</c:v>
                </c:pt>
                <c:pt idx="3">
                  <c:v>1.72504469786974</c:v>
                </c:pt>
                <c:pt idx="4">
                  <c:v>0.91426326522749601</c:v>
                </c:pt>
                <c:pt idx="5">
                  <c:v>1.39067769388815</c:v>
                </c:pt>
                <c:pt idx="6">
                  <c:v>1.58145174147858</c:v>
                </c:pt>
                <c:pt idx="7">
                  <c:v>1.2676748591490701</c:v>
                </c:pt>
                <c:pt idx="8">
                  <c:v>1.82728587376775</c:v>
                </c:pt>
                <c:pt idx="9">
                  <c:v>1.8616233523616099</c:v>
                </c:pt>
                <c:pt idx="10">
                  <c:v>2.26737894779273</c:v>
                </c:pt>
                <c:pt idx="11">
                  <c:v>1.7551551070198399</c:v>
                </c:pt>
                <c:pt idx="12">
                  <c:v>2.21939169512261</c:v>
                </c:pt>
                <c:pt idx="13">
                  <c:v>1.73313805611205</c:v>
                </c:pt>
                <c:pt idx="14">
                  <c:v>2.5077548738852999</c:v>
                </c:pt>
                <c:pt idx="15">
                  <c:v>1.6732898400766301</c:v>
                </c:pt>
                <c:pt idx="16">
                  <c:v>1.31651304897066</c:v>
                </c:pt>
                <c:pt idx="17">
                  <c:v>1.82694983107927</c:v>
                </c:pt>
                <c:pt idx="18">
                  <c:v>1.5618678170340501</c:v>
                </c:pt>
                <c:pt idx="19">
                  <c:v>1.9545400547873999</c:v>
                </c:pt>
                <c:pt idx="20">
                  <c:v>2.1984681864732201</c:v>
                </c:pt>
                <c:pt idx="21">
                  <c:v>2.0754087890846602</c:v>
                </c:pt>
                <c:pt idx="22">
                  <c:v>1.76067297432841</c:v>
                </c:pt>
                <c:pt idx="23">
                  <c:v>1.76906380509502</c:v>
                </c:pt>
                <c:pt idx="24">
                  <c:v>2.63964720507323</c:v>
                </c:pt>
                <c:pt idx="25">
                  <c:v>2.6019913336789999</c:v>
                </c:pt>
                <c:pt idx="26">
                  <c:v>2.1105845062323398</c:v>
                </c:pt>
                <c:pt idx="27">
                  <c:v>1.8335465380201901</c:v>
                </c:pt>
                <c:pt idx="28">
                  <c:v>2.0258179964468201</c:v>
                </c:pt>
                <c:pt idx="29">
                  <c:v>1.54458095463699</c:v>
                </c:pt>
                <c:pt idx="30">
                  <c:v>2.0087304005891702</c:v>
                </c:pt>
                <c:pt idx="31">
                  <c:v>1.5620342085904699</c:v>
                </c:pt>
                <c:pt idx="32">
                  <c:v>1.4400014440532201</c:v>
                </c:pt>
                <c:pt idx="33">
                  <c:v>1.68040427040994</c:v>
                </c:pt>
                <c:pt idx="34">
                  <c:v>1.7991974368986501</c:v>
                </c:pt>
                <c:pt idx="35">
                  <c:v>2.1986504418894501</c:v>
                </c:pt>
                <c:pt idx="36">
                  <c:v>2.1046535343012698</c:v>
                </c:pt>
                <c:pt idx="37">
                  <c:v>1.5075050563919701</c:v>
                </c:pt>
                <c:pt idx="38">
                  <c:v>1.8654407725377</c:v>
                </c:pt>
                <c:pt idx="39">
                  <c:v>1.8526906028958601</c:v>
                </c:pt>
                <c:pt idx="40">
                  <c:v>1.4160953852643801</c:v>
                </c:pt>
                <c:pt idx="41">
                  <c:v>0.95991055997539698</c:v>
                </c:pt>
                <c:pt idx="42">
                  <c:v>1.62463646586622</c:v>
                </c:pt>
                <c:pt idx="43">
                  <c:v>2.0258028432908901</c:v>
                </c:pt>
                <c:pt idx="44">
                  <c:v>1.83123196560756</c:v>
                </c:pt>
                <c:pt idx="45">
                  <c:v>1.98610781964543</c:v>
                </c:pt>
                <c:pt idx="46">
                  <c:v>2.4616523176157399</c:v>
                </c:pt>
                <c:pt idx="47">
                  <c:v>2.5730749554019998</c:v>
                </c:pt>
                <c:pt idx="48">
                  <c:v>1.41285921096082</c:v>
                </c:pt>
                <c:pt idx="49">
                  <c:v>2.0309445418449501</c:v>
                </c:pt>
                <c:pt idx="50">
                  <c:v>2.0783813880636801</c:v>
                </c:pt>
                <c:pt idx="51">
                  <c:v>2.0732949903887898</c:v>
                </c:pt>
                <c:pt idx="52">
                  <c:v>2.71782464116803</c:v>
                </c:pt>
                <c:pt idx="53">
                  <c:v>1.3611028892697501</c:v>
                </c:pt>
                <c:pt idx="54">
                  <c:v>1.9860658062730401</c:v>
                </c:pt>
                <c:pt idx="55">
                  <c:v>1.8806568357453599</c:v>
                </c:pt>
                <c:pt idx="56">
                  <c:v>2.1199206052024802</c:v>
                </c:pt>
                <c:pt idx="57">
                  <c:v>1.3044077851928799</c:v>
                </c:pt>
                <c:pt idx="58">
                  <c:v>1.6902930594480201</c:v>
                </c:pt>
                <c:pt idx="59">
                  <c:v>1.7002400235666599</c:v>
                </c:pt>
                <c:pt idx="60">
                  <c:v>2.50070653019637</c:v>
                </c:pt>
                <c:pt idx="61">
                  <c:v>1.3828963482201799</c:v>
                </c:pt>
                <c:pt idx="62">
                  <c:v>1.9387434355234201</c:v>
                </c:pt>
                <c:pt idx="63">
                  <c:v>2.3214587129502702</c:v>
                </c:pt>
                <c:pt idx="64">
                  <c:v>1.67276797757826</c:v>
                </c:pt>
                <c:pt idx="65">
                  <c:v>1.4464226077723401</c:v>
                </c:pt>
                <c:pt idx="66">
                  <c:v>1.65763431940757</c:v>
                </c:pt>
                <c:pt idx="67">
                  <c:v>1.8816270657304399</c:v>
                </c:pt>
                <c:pt idx="68">
                  <c:v>1.4365615570288399</c:v>
                </c:pt>
                <c:pt idx="69">
                  <c:v>2.1201610240456699</c:v>
                </c:pt>
                <c:pt idx="70">
                  <c:v>2.2029273939649099</c:v>
                </c:pt>
                <c:pt idx="71">
                  <c:v>1.6225813450507001</c:v>
                </c:pt>
                <c:pt idx="72">
                  <c:v>1.9375663495578399</c:v>
                </c:pt>
                <c:pt idx="73">
                  <c:v>1.8339355457795601</c:v>
                </c:pt>
                <c:pt idx="74">
                  <c:v>1.9199568834079499</c:v>
                </c:pt>
                <c:pt idx="75">
                  <c:v>2.3106292013172398</c:v>
                </c:pt>
                <c:pt idx="76">
                  <c:v>1.7599525605116999</c:v>
                </c:pt>
                <c:pt idx="77">
                  <c:v>1.54900678978746</c:v>
                </c:pt>
                <c:pt idx="78">
                  <c:v>1.7630050265423101</c:v>
                </c:pt>
                <c:pt idx="79">
                  <c:v>1.78899437810638</c:v>
                </c:pt>
                <c:pt idx="80">
                  <c:v>1.48203741304646</c:v>
                </c:pt>
                <c:pt idx="81">
                  <c:v>1.2673099289510501</c:v>
                </c:pt>
                <c:pt idx="82">
                  <c:v>1.41968125429794</c:v>
                </c:pt>
                <c:pt idx="83">
                  <c:v>1.25447246462564</c:v>
                </c:pt>
                <c:pt idx="84">
                  <c:v>1.2087302394296</c:v>
                </c:pt>
                <c:pt idx="85">
                  <c:v>1.632671238301</c:v>
                </c:pt>
                <c:pt idx="86">
                  <c:v>1.6858404734722401</c:v>
                </c:pt>
                <c:pt idx="87">
                  <c:v>1.31255555394557</c:v>
                </c:pt>
                <c:pt idx="88">
                  <c:v>1.5079586492369901</c:v>
                </c:pt>
                <c:pt idx="89">
                  <c:v>1.9021908220919901</c:v>
                </c:pt>
                <c:pt idx="90">
                  <c:v>2.1154968760842401</c:v>
                </c:pt>
                <c:pt idx="91">
                  <c:v>2.1496144343143802</c:v>
                </c:pt>
                <c:pt idx="92">
                  <c:v>2.2736138467998699</c:v>
                </c:pt>
                <c:pt idx="93">
                  <c:v>1.7570301228555001</c:v>
                </c:pt>
                <c:pt idx="94">
                  <c:v>1.8948325906079699</c:v>
                </c:pt>
                <c:pt idx="95">
                  <c:v>1.48793726768389</c:v>
                </c:pt>
                <c:pt idx="96">
                  <c:v>2.3255192913085998</c:v>
                </c:pt>
                <c:pt idx="97">
                  <c:v>1.98835503112337</c:v>
                </c:pt>
                <c:pt idx="98">
                  <c:v>2.1657590779978402</c:v>
                </c:pt>
                <c:pt idx="99">
                  <c:v>2.2835353546950801</c:v>
                </c:pt>
                <c:pt idx="100">
                  <c:v>2.30879391720035</c:v>
                </c:pt>
                <c:pt idx="101">
                  <c:v>2.3147184780055001</c:v>
                </c:pt>
                <c:pt idx="102">
                  <c:v>2.1720653835119799</c:v>
                </c:pt>
                <c:pt idx="103">
                  <c:v>2.15005640179649</c:v>
                </c:pt>
                <c:pt idx="104">
                  <c:v>2.4410410840715802</c:v>
                </c:pt>
                <c:pt idx="105">
                  <c:v>1.87634273531664</c:v>
                </c:pt>
                <c:pt idx="106">
                  <c:v>3.2973241650812399</c:v>
                </c:pt>
                <c:pt idx="107">
                  <c:v>1.83064827962351</c:v>
                </c:pt>
                <c:pt idx="108">
                  <c:v>2.0443786840228499</c:v>
                </c:pt>
                <c:pt idx="109">
                  <c:v>2.5362455130449302</c:v>
                </c:pt>
                <c:pt idx="110">
                  <c:v>2.7463538574969699</c:v>
                </c:pt>
                <c:pt idx="111">
                  <c:v>2.5835289379584099</c:v>
                </c:pt>
                <c:pt idx="112">
                  <c:v>3.6517966799520001</c:v>
                </c:pt>
                <c:pt idx="113">
                  <c:v>2.2734839521111101</c:v>
                </c:pt>
                <c:pt idx="114">
                  <c:v>2.5702849780307102</c:v>
                </c:pt>
                <c:pt idx="115">
                  <c:v>2.4759410541012401</c:v>
                </c:pt>
                <c:pt idx="116">
                  <c:v>2.2165563056300002</c:v>
                </c:pt>
                <c:pt idx="117">
                  <c:v>3.0795829983981</c:v>
                </c:pt>
                <c:pt idx="118">
                  <c:v>2.61381183794655</c:v>
                </c:pt>
                <c:pt idx="119">
                  <c:v>2.4732152613829301</c:v>
                </c:pt>
                <c:pt idx="120">
                  <c:v>1.95707029351443</c:v>
                </c:pt>
                <c:pt idx="121">
                  <c:v>2.5481440130718398</c:v>
                </c:pt>
                <c:pt idx="122">
                  <c:v>2.4042424701187799</c:v>
                </c:pt>
                <c:pt idx="123">
                  <c:v>2.5587413545405</c:v>
                </c:pt>
                <c:pt idx="124">
                  <c:v>2.3745401296603599</c:v>
                </c:pt>
                <c:pt idx="125">
                  <c:v>3.2045173230711699</c:v>
                </c:pt>
                <c:pt idx="126">
                  <c:v>2.5843103463224599</c:v>
                </c:pt>
                <c:pt idx="127">
                  <c:v>2.6127703302584102</c:v>
                </c:pt>
                <c:pt idx="128">
                  <c:v>1.87450060443792</c:v>
                </c:pt>
                <c:pt idx="129">
                  <c:v>2.5613785272326801</c:v>
                </c:pt>
                <c:pt idx="130">
                  <c:v>2.6806966589629302</c:v>
                </c:pt>
                <c:pt idx="131">
                  <c:v>2.5933127800870999</c:v>
                </c:pt>
                <c:pt idx="132">
                  <c:v>3.2124702789039099</c:v>
                </c:pt>
                <c:pt idx="133">
                  <c:v>2.5196225812581101</c:v>
                </c:pt>
                <c:pt idx="134">
                  <c:v>3.0465588790807199</c:v>
                </c:pt>
                <c:pt idx="135">
                  <c:v>2.8807959871523301</c:v>
                </c:pt>
                <c:pt idx="136">
                  <c:v>3.4680151316744201</c:v>
                </c:pt>
                <c:pt idx="137">
                  <c:v>3.1991245168656</c:v>
                </c:pt>
                <c:pt idx="138">
                  <c:v>2.52177988127589</c:v>
                </c:pt>
                <c:pt idx="139">
                  <c:v>2.1973954056374501</c:v>
                </c:pt>
                <c:pt idx="140">
                  <c:v>2.7402541827016398</c:v>
                </c:pt>
                <c:pt idx="141">
                  <c:v>2.2119217444435901</c:v>
                </c:pt>
                <c:pt idx="142">
                  <c:v>3.0449460775494099</c:v>
                </c:pt>
                <c:pt idx="143">
                  <c:v>2.2535609676280699</c:v>
                </c:pt>
                <c:pt idx="144">
                  <c:v>3.2022456024439099</c:v>
                </c:pt>
                <c:pt idx="145">
                  <c:v>2.9310948876457199</c:v>
                </c:pt>
                <c:pt idx="146">
                  <c:v>2.6477953949666699</c:v>
                </c:pt>
                <c:pt idx="147">
                  <c:v>2.4105421023968598</c:v>
                </c:pt>
                <c:pt idx="148">
                  <c:v>2.43865316616683</c:v>
                </c:pt>
                <c:pt idx="149">
                  <c:v>2.42213669230732</c:v>
                </c:pt>
                <c:pt idx="150">
                  <c:v>2.5748942995811501</c:v>
                </c:pt>
                <c:pt idx="151">
                  <c:v>2.7594222860218101</c:v>
                </c:pt>
                <c:pt idx="152">
                  <c:v>2.0503109646559299</c:v>
                </c:pt>
                <c:pt idx="153">
                  <c:v>1.8315567237505901</c:v>
                </c:pt>
                <c:pt idx="154">
                  <c:v>2.0790941596047801</c:v>
                </c:pt>
                <c:pt idx="155">
                  <c:v>2.3548319400441202</c:v>
                </c:pt>
                <c:pt idx="156">
                  <c:v>2.87459328330117</c:v>
                </c:pt>
                <c:pt idx="157">
                  <c:v>2.56350708916057</c:v>
                </c:pt>
                <c:pt idx="158">
                  <c:v>2.8168116849809199</c:v>
                </c:pt>
                <c:pt idx="159">
                  <c:v>2.7989105567429</c:v>
                </c:pt>
                <c:pt idx="160">
                  <c:v>2.9265125451031202</c:v>
                </c:pt>
                <c:pt idx="161">
                  <c:v>2.6121636196062101</c:v>
                </c:pt>
                <c:pt idx="162">
                  <c:v>2.5544916910715099</c:v>
                </c:pt>
                <c:pt idx="163">
                  <c:v>2.3777427922231098</c:v>
                </c:pt>
                <c:pt idx="164">
                  <c:v>2.4308298593317801</c:v>
                </c:pt>
                <c:pt idx="165">
                  <c:v>2.5563251982274999</c:v>
                </c:pt>
                <c:pt idx="166">
                  <c:v>2.22615903728475</c:v>
                </c:pt>
                <c:pt idx="167">
                  <c:v>2.7472417993318201</c:v>
                </c:pt>
                <c:pt idx="168">
                  <c:v>3.09541654141211</c:v>
                </c:pt>
                <c:pt idx="169">
                  <c:v>2.6027647086179102</c:v>
                </c:pt>
                <c:pt idx="170">
                  <c:v>2.5250293708723301</c:v>
                </c:pt>
                <c:pt idx="171">
                  <c:v>2.25190501014692</c:v>
                </c:pt>
                <c:pt idx="172">
                  <c:v>2.3017400823897201</c:v>
                </c:pt>
                <c:pt idx="173">
                  <c:v>2.8969062202998899</c:v>
                </c:pt>
                <c:pt idx="174">
                  <c:v>2.5111689205782999</c:v>
                </c:pt>
                <c:pt idx="175">
                  <c:v>1.88096512003774</c:v>
                </c:pt>
                <c:pt idx="176">
                  <c:v>1.84439276535981</c:v>
                </c:pt>
                <c:pt idx="177">
                  <c:v>2.7269606843517402</c:v>
                </c:pt>
                <c:pt idx="178">
                  <c:v>2.3539760746993399</c:v>
                </c:pt>
                <c:pt idx="179">
                  <c:v>2.39761222271455</c:v>
                </c:pt>
                <c:pt idx="180">
                  <c:v>2.6736929043949398</c:v>
                </c:pt>
                <c:pt idx="181">
                  <c:v>1.93467838885286</c:v>
                </c:pt>
                <c:pt idx="182">
                  <c:v>2.10559603523917</c:v>
                </c:pt>
                <c:pt idx="183">
                  <c:v>2.9418171143104002</c:v>
                </c:pt>
                <c:pt idx="184">
                  <c:v>2.57284307899406</c:v>
                </c:pt>
                <c:pt idx="185">
                  <c:v>1.7951050268628701</c:v>
                </c:pt>
                <c:pt idx="186">
                  <c:v>2.31104811721513</c:v>
                </c:pt>
                <c:pt idx="187">
                  <c:v>1.9280840595544</c:v>
                </c:pt>
                <c:pt idx="188">
                  <c:v>2.50510956617393</c:v>
                </c:pt>
                <c:pt idx="189">
                  <c:v>1.9128828041601</c:v>
                </c:pt>
                <c:pt idx="190">
                  <c:v>1.5803224875808599</c:v>
                </c:pt>
                <c:pt idx="191">
                  <c:v>2.4974811700742898</c:v>
                </c:pt>
                <c:pt idx="192">
                  <c:v>1.9749871618922901</c:v>
                </c:pt>
                <c:pt idx="193">
                  <c:v>2.2540900310504299</c:v>
                </c:pt>
                <c:pt idx="194">
                  <c:v>2.5143267075039901</c:v>
                </c:pt>
                <c:pt idx="195">
                  <c:v>2.60332207891416</c:v>
                </c:pt>
                <c:pt idx="196">
                  <c:v>2.5058909109171399</c:v>
                </c:pt>
                <c:pt idx="197">
                  <c:v>2.4572327684117998</c:v>
                </c:pt>
                <c:pt idx="198">
                  <c:v>2.2543896961507599</c:v>
                </c:pt>
                <c:pt idx="199">
                  <c:v>2.3333345036778099</c:v>
                </c:pt>
                <c:pt idx="200">
                  <c:v>2.6181433298247301</c:v>
                </c:pt>
                <c:pt idx="201">
                  <c:v>2.4824242194861101</c:v>
                </c:pt>
                <c:pt idx="202">
                  <c:v>2.2994850548255501</c:v>
                </c:pt>
                <c:pt idx="203">
                  <c:v>2.1153456706089999</c:v>
                </c:pt>
                <c:pt idx="204">
                  <c:v>2.61367086425627</c:v>
                </c:pt>
                <c:pt idx="205">
                  <c:v>2.12188527326642</c:v>
                </c:pt>
                <c:pt idx="206">
                  <c:v>2.65228645746777</c:v>
                </c:pt>
                <c:pt idx="207">
                  <c:v>2.68105753233433</c:v>
                </c:pt>
                <c:pt idx="208">
                  <c:v>2.1894982394268898</c:v>
                </c:pt>
                <c:pt idx="209">
                  <c:v>2.0347673204756398</c:v>
                </c:pt>
                <c:pt idx="210">
                  <c:v>1.85572183126073</c:v>
                </c:pt>
                <c:pt idx="211">
                  <c:v>2.5738959047726699</c:v>
                </c:pt>
                <c:pt idx="212">
                  <c:v>2.69468387719491</c:v>
                </c:pt>
                <c:pt idx="213">
                  <c:v>2.2057869225498901</c:v>
                </c:pt>
                <c:pt idx="214">
                  <c:v>2.4473306217119699</c:v>
                </c:pt>
                <c:pt idx="215">
                  <c:v>2.61316602656987</c:v>
                </c:pt>
                <c:pt idx="216">
                  <c:v>3.10280136942735</c:v>
                </c:pt>
                <c:pt idx="217">
                  <c:v>2.45278720063838</c:v>
                </c:pt>
                <c:pt idx="218">
                  <c:v>2.5978996158974801</c:v>
                </c:pt>
                <c:pt idx="219">
                  <c:v>3.17049730775474</c:v>
                </c:pt>
                <c:pt idx="220">
                  <c:v>2.7244098448091201</c:v>
                </c:pt>
                <c:pt idx="221">
                  <c:v>2.3063611988607802</c:v>
                </c:pt>
                <c:pt idx="222">
                  <c:v>2.4278783078330002</c:v>
                </c:pt>
                <c:pt idx="223">
                  <c:v>2.2172699639075999</c:v>
                </c:pt>
                <c:pt idx="224">
                  <c:v>2.5004444478875198</c:v>
                </c:pt>
                <c:pt idx="225">
                  <c:v>2.0854177444316</c:v>
                </c:pt>
                <c:pt idx="226">
                  <c:v>2.4762513948469902</c:v>
                </c:pt>
                <c:pt idx="227">
                  <c:v>3.2030417549757901</c:v>
                </c:pt>
                <c:pt idx="228">
                  <c:v>2.40694153265175</c:v>
                </c:pt>
                <c:pt idx="229">
                  <c:v>2.2269181740308399</c:v>
                </c:pt>
                <c:pt idx="230">
                  <c:v>2.2570151701395602</c:v>
                </c:pt>
                <c:pt idx="231">
                  <c:v>1.7648049448438801</c:v>
                </c:pt>
                <c:pt idx="232">
                  <c:v>2.3057773856010502</c:v>
                </c:pt>
                <c:pt idx="233">
                  <c:v>2.27792544872116</c:v>
                </c:pt>
                <c:pt idx="234">
                  <c:v>2.3049026643701702</c:v>
                </c:pt>
                <c:pt idx="235">
                  <c:v>1.9460444263841401</c:v>
                </c:pt>
                <c:pt idx="236">
                  <c:v>2.6868465857161801</c:v>
                </c:pt>
                <c:pt idx="237">
                  <c:v>2.3550500011838702</c:v>
                </c:pt>
                <c:pt idx="238">
                  <c:v>2.1366439631138601</c:v>
                </c:pt>
                <c:pt idx="239">
                  <c:v>2.5931773559854898</c:v>
                </c:pt>
                <c:pt idx="240">
                  <c:v>2.3203622769113799</c:v>
                </c:pt>
                <c:pt idx="241">
                  <c:v>3.0734903001174998</c:v>
                </c:pt>
                <c:pt idx="242">
                  <c:v>3.3194179614877899</c:v>
                </c:pt>
                <c:pt idx="243">
                  <c:v>2.8029178521442</c:v>
                </c:pt>
                <c:pt idx="244">
                  <c:v>2.5614623689412799</c:v>
                </c:pt>
                <c:pt idx="245">
                  <c:v>3.0427184242880698</c:v>
                </c:pt>
                <c:pt idx="246">
                  <c:v>3.0840689367509202</c:v>
                </c:pt>
                <c:pt idx="247">
                  <c:v>2.9343573670138099</c:v>
                </c:pt>
                <c:pt idx="248">
                  <c:v>2.6164316514068799</c:v>
                </c:pt>
                <c:pt idx="249">
                  <c:v>2.2193610588488601</c:v>
                </c:pt>
                <c:pt idx="250">
                  <c:v>2.0054509491683401</c:v>
                </c:pt>
                <c:pt idx="251">
                  <c:v>2.2188016550465699</c:v>
                </c:pt>
                <c:pt idx="252">
                  <c:v>1.7845365065815899</c:v>
                </c:pt>
                <c:pt idx="253">
                  <c:v>1.9494598409955599</c:v>
                </c:pt>
                <c:pt idx="254">
                  <c:v>2.0282507466571098</c:v>
                </c:pt>
                <c:pt idx="255">
                  <c:v>2.5469010901506701</c:v>
                </c:pt>
                <c:pt idx="256">
                  <c:v>1.96419634517273</c:v>
                </c:pt>
                <c:pt idx="257">
                  <c:v>2.3246518812158898</c:v>
                </c:pt>
                <c:pt idx="258">
                  <c:v>2.4529273838214301</c:v>
                </c:pt>
                <c:pt idx="259">
                  <c:v>1.9332976425353701</c:v>
                </c:pt>
                <c:pt idx="260">
                  <c:v>2.78390145387967</c:v>
                </c:pt>
                <c:pt idx="261">
                  <c:v>2.6158174189841699</c:v>
                </c:pt>
                <c:pt idx="262">
                  <c:v>1.54021547795156</c:v>
                </c:pt>
                <c:pt idx="263">
                  <c:v>2.36963079984793</c:v>
                </c:pt>
                <c:pt idx="264">
                  <c:v>2.0914031812957998</c:v>
                </c:pt>
                <c:pt idx="265">
                  <c:v>1.62580203500355</c:v>
                </c:pt>
                <c:pt idx="266">
                  <c:v>2.0652196106224801</c:v>
                </c:pt>
                <c:pt idx="267">
                  <c:v>2.0181830531729101</c:v>
                </c:pt>
                <c:pt idx="268">
                  <c:v>2.2245139212796698</c:v>
                </c:pt>
                <c:pt idx="269">
                  <c:v>1.67727607879062</c:v>
                </c:pt>
                <c:pt idx="270">
                  <c:v>2.2168862007274299</c:v>
                </c:pt>
                <c:pt idx="271">
                  <c:v>2.00368797619221</c:v>
                </c:pt>
                <c:pt idx="272">
                  <c:v>2.0774332058779201</c:v>
                </c:pt>
                <c:pt idx="273">
                  <c:v>2.1488247116286598</c:v>
                </c:pt>
                <c:pt idx="274">
                  <c:v>2.3485219942184599</c:v>
                </c:pt>
                <c:pt idx="275">
                  <c:v>2.6618007335666198</c:v>
                </c:pt>
                <c:pt idx="276">
                  <c:v>2.0454947227989999</c:v>
                </c:pt>
                <c:pt idx="277">
                  <c:v>2.68650721391456</c:v>
                </c:pt>
                <c:pt idx="278">
                  <c:v>2.6023777871978702</c:v>
                </c:pt>
                <c:pt idx="279">
                  <c:v>2.3743779138371202</c:v>
                </c:pt>
                <c:pt idx="280">
                  <c:v>2.0969570586568098</c:v>
                </c:pt>
                <c:pt idx="281">
                  <c:v>3.19319856391528</c:v>
                </c:pt>
                <c:pt idx="282">
                  <c:v>2.1166492148643301</c:v>
                </c:pt>
                <c:pt idx="283">
                  <c:v>1.9027109865079701</c:v>
                </c:pt>
                <c:pt idx="284">
                  <c:v>2.5238161055996202</c:v>
                </c:pt>
                <c:pt idx="285">
                  <c:v>2.23271934423554</c:v>
                </c:pt>
                <c:pt idx="286">
                  <c:v>2.4449183701272901</c:v>
                </c:pt>
                <c:pt idx="287">
                  <c:v>2.23603284144296</c:v>
                </c:pt>
                <c:pt idx="288">
                  <c:v>2.1162730228122002</c:v>
                </c:pt>
                <c:pt idx="289">
                  <c:v>2.1372623638249002</c:v>
                </c:pt>
                <c:pt idx="290">
                  <c:v>3.3801117693552598</c:v>
                </c:pt>
                <c:pt idx="291">
                  <c:v>2.3408555245536999</c:v>
                </c:pt>
                <c:pt idx="292">
                  <c:v>3.0910689798557498</c:v>
                </c:pt>
                <c:pt idx="293">
                  <c:v>3.11932916372109</c:v>
                </c:pt>
                <c:pt idx="294">
                  <c:v>2.0357099951098698</c:v>
                </c:pt>
                <c:pt idx="295">
                  <c:v>2.9767162920919099</c:v>
                </c:pt>
                <c:pt idx="296">
                  <c:v>2.7437071618165199</c:v>
                </c:pt>
                <c:pt idx="297">
                  <c:v>2.2187502385904301</c:v>
                </c:pt>
                <c:pt idx="298">
                  <c:v>1.9278600473855501</c:v>
                </c:pt>
                <c:pt idx="299">
                  <c:v>2.3774465493181398</c:v>
                </c:pt>
                <c:pt idx="300">
                  <c:v>2.9925194831902</c:v>
                </c:pt>
                <c:pt idx="301">
                  <c:v>2.0666166671517998</c:v>
                </c:pt>
                <c:pt idx="302">
                  <c:v>1.9611654285856901</c:v>
                </c:pt>
                <c:pt idx="303">
                  <c:v>1.7209029651241501</c:v>
                </c:pt>
                <c:pt idx="304">
                  <c:v>2.51337531081509</c:v>
                </c:pt>
                <c:pt idx="305">
                  <c:v>2.0186548481051898</c:v>
                </c:pt>
                <c:pt idx="306">
                  <c:v>3.4431104326418098</c:v>
                </c:pt>
                <c:pt idx="307">
                  <c:v>2.5272891715108798</c:v>
                </c:pt>
                <c:pt idx="308">
                  <c:v>1.7170558616211</c:v>
                </c:pt>
                <c:pt idx="309">
                  <c:v>2.6198032205496999</c:v>
                </c:pt>
                <c:pt idx="310">
                  <c:v>2.7933146950695802</c:v>
                </c:pt>
                <c:pt idx="311">
                  <c:v>2.4162707536221699</c:v>
                </c:pt>
                <c:pt idx="312">
                  <c:v>2.0795745951125402</c:v>
                </c:pt>
                <c:pt idx="313">
                  <c:v>2.9971067794641701</c:v>
                </c:pt>
                <c:pt idx="314">
                  <c:v>3.1510254090444101</c:v>
                </c:pt>
                <c:pt idx="315">
                  <c:v>3.2970911457256702</c:v>
                </c:pt>
                <c:pt idx="316">
                  <c:v>2.7225314442095301</c:v>
                </c:pt>
                <c:pt idx="317">
                  <c:v>3.2417438947122599</c:v>
                </c:pt>
                <c:pt idx="318">
                  <c:v>2.7979294166749802</c:v>
                </c:pt>
                <c:pt idx="319">
                  <c:v>2.3437338672182699</c:v>
                </c:pt>
                <c:pt idx="320">
                  <c:v>3.43331102649864</c:v>
                </c:pt>
                <c:pt idx="321">
                  <c:v>2.6179862058825401</c:v>
                </c:pt>
                <c:pt idx="322">
                  <c:v>2.30329251411671</c:v>
                </c:pt>
                <c:pt idx="323">
                  <c:v>2.1229335783226899</c:v>
                </c:pt>
                <c:pt idx="324">
                  <c:v>2.9666540444849199</c:v>
                </c:pt>
                <c:pt idx="325">
                  <c:v>2.4801122942602598</c:v>
                </c:pt>
                <c:pt idx="326">
                  <c:v>1.91428108197145</c:v>
                </c:pt>
                <c:pt idx="327">
                  <c:v>2.3403956204490202</c:v>
                </c:pt>
                <c:pt idx="328">
                  <c:v>2.4421067514152699</c:v>
                </c:pt>
                <c:pt idx="329">
                  <c:v>1.87611114568521</c:v>
                </c:pt>
                <c:pt idx="330">
                  <c:v>2.3629852857482998</c:v>
                </c:pt>
                <c:pt idx="331">
                  <c:v>2.7504236571509901</c:v>
                </c:pt>
                <c:pt idx="332">
                  <c:v>2.10384024950207</c:v>
                </c:pt>
                <c:pt idx="333">
                  <c:v>1.80112281505701</c:v>
                </c:pt>
                <c:pt idx="334">
                  <c:v>2.0134803604265001</c:v>
                </c:pt>
                <c:pt idx="335">
                  <c:v>1.9467768924525299</c:v>
                </c:pt>
                <c:pt idx="336">
                  <c:v>1.80275231721443</c:v>
                </c:pt>
                <c:pt idx="337">
                  <c:v>1.70193636758123</c:v>
                </c:pt>
                <c:pt idx="338">
                  <c:v>1.95926207143719</c:v>
                </c:pt>
                <c:pt idx="339">
                  <c:v>1.8240849356086799</c:v>
                </c:pt>
                <c:pt idx="340">
                  <c:v>1.9745589898734801</c:v>
                </c:pt>
                <c:pt idx="341">
                  <c:v>2.1193969165471902</c:v>
                </c:pt>
                <c:pt idx="342">
                  <c:v>2.1954741638773401</c:v>
                </c:pt>
                <c:pt idx="343">
                  <c:v>2.33960945425342</c:v>
                </c:pt>
                <c:pt idx="344">
                  <c:v>2.5416828608867599</c:v>
                </c:pt>
                <c:pt idx="345">
                  <c:v>2.6605548835022201</c:v>
                </c:pt>
                <c:pt idx="346">
                  <c:v>1.9032842198754101</c:v>
                </c:pt>
                <c:pt idx="347">
                  <c:v>1.70363444410331</c:v>
                </c:pt>
                <c:pt idx="348">
                  <c:v>2.2042286237014799</c:v>
                </c:pt>
                <c:pt idx="349">
                  <c:v>2.32775530012416</c:v>
                </c:pt>
                <c:pt idx="350">
                  <c:v>1.8372340437917301</c:v>
                </c:pt>
                <c:pt idx="351">
                  <c:v>2.08992074044937</c:v>
                </c:pt>
                <c:pt idx="352">
                  <c:v>2.5282797535964399</c:v>
                </c:pt>
                <c:pt idx="353">
                  <c:v>1.94935175559381</c:v>
                </c:pt>
                <c:pt idx="354">
                  <c:v>1.7350119310755301</c:v>
                </c:pt>
                <c:pt idx="355">
                  <c:v>1.4458952136871299</c:v>
                </c:pt>
                <c:pt idx="356">
                  <c:v>1.6445696028341099</c:v>
                </c:pt>
                <c:pt idx="357">
                  <c:v>1.75334938798639</c:v>
                </c:pt>
                <c:pt idx="358">
                  <c:v>2.2404170356397901</c:v>
                </c:pt>
                <c:pt idx="359">
                  <c:v>2.0755051442236798</c:v>
                </c:pt>
                <c:pt idx="360">
                  <c:v>1.8792303665183601</c:v>
                </c:pt>
                <c:pt idx="361">
                  <c:v>2.8128415341895199</c:v>
                </c:pt>
                <c:pt idx="362">
                  <c:v>2.2896704715801701</c:v>
                </c:pt>
                <c:pt idx="363">
                  <c:v>1.73504518159423</c:v>
                </c:pt>
                <c:pt idx="364">
                  <c:v>2.90071076056222</c:v>
                </c:pt>
                <c:pt idx="365">
                  <c:v>1.47588030120434</c:v>
                </c:pt>
                <c:pt idx="366">
                  <c:v>1.6971448552702</c:v>
                </c:pt>
                <c:pt idx="367">
                  <c:v>1.5009562843217199</c:v>
                </c:pt>
                <c:pt idx="368">
                  <c:v>1.94372099724866</c:v>
                </c:pt>
                <c:pt idx="369">
                  <c:v>1.4978206782968699</c:v>
                </c:pt>
                <c:pt idx="370">
                  <c:v>1.6511235445274299</c:v>
                </c:pt>
                <c:pt idx="371">
                  <c:v>2.33045850896761</c:v>
                </c:pt>
                <c:pt idx="372">
                  <c:v>1.75288135970354</c:v>
                </c:pt>
                <c:pt idx="373">
                  <c:v>1.3491570288675001</c:v>
                </c:pt>
                <c:pt idx="374">
                  <c:v>1.6322475511768</c:v>
                </c:pt>
                <c:pt idx="375">
                  <c:v>1.53274715400159</c:v>
                </c:pt>
                <c:pt idx="376">
                  <c:v>1.7357808271020001</c:v>
                </c:pt>
                <c:pt idx="377">
                  <c:v>2.0179829725826801</c:v>
                </c:pt>
                <c:pt idx="378">
                  <c:v>1.89250978032249</c:v>
                </c:pt>
                <c:pt idx="379">
                  <c:v>1.8351553154485001</c:v>
                </c:pt>
                <c:pt idx="380">
                  <c:v>1.34786557522211</c:v>
                </c:pt>
                <c:pt idx="381">
                  <c:v>1.3185179244795699</c:v>
                </c:pt>
                <c:pt idx="382">
                  <c:v>2.54656610413282</c:v>
                </c:pt>
                <c:pt idx="383">
                  <c:v>2.3065742096233501</c:v>
                </c:pt>
                <c:pt idx="384">
                  <c:v>2.55408848648668</c:v>
                </c:pt>
                <c:pt idx="385">
                  <c:v>2.08560150155032</c:v>
                </c:pt>
                <c:pt idx="386">
                  <c:v>1.62852630574566</c:v>
                </c:pt>
                <c:pt idx="387">
                  <c:v>2.51328297790785</c:v>
                </c:pt>
                <c:pt idx="388">
                  <c:v>2.80337954394244</c:v>
                </c:pt>
                <c:pt idx="389">
                  <c:v>2.6154383392821901</c:v>
                </c:pt>
                <c:pt idx="390">
                  <c:v>2.5373978357619298</c:v>
                </c:pt>
                <c:pt idx="391">
                  <c:v>3.1451770488136099</c:v>
                </c:pt>
                <c:pt idx="392">
                  <c:v>3.0655324214429598</c:v>
                </c:pt>
                <c:pt idx="393">
                  <c:v>2.96323118271002</c:v>
                </c:pt>
                <c:pt idx="394">
                  <c:v>2.92696684312945</c:v>
                </c:pt>
                <c:pt idx="395">
                  <c:v>2.7966903815050101</c:v>
                </c:pt>
                <c:pt idx="396">
                  <c:v>2.5748139486654402</c:v>
                </c:pt>
                <c:pt idx="397">
                  <c:v>3.0048611003206398</c:v>
                </c:pt>
                <c:pt idx="398">
                  <c:v>2.4980859042021701</c:v>
                </c:pt>
                <c:pt idx="399">
                  <c:v>2.78446438943006</c:v>
                </c:pt>
                <c:pt idx="400">
                  <c:v>2.9795935281135701</c:v>
                </c:pt>
                <c:pt idx="401">
                  <c:v>3.2193517885784799</c:v>
                </c:pt>
                <c:pt idx="402">
                  <c:v>3.1363026270766001</c:v>
                </c:pt>
                <c:pt idx="403">
                  <c:v>2.7479404775371998</c:v>
                </c:pt>
                <c:pt idx="404">
                  <c:v>2.7184549467073098</c:v>
                </c:pt>
                <c:pt idx="405">
                  <c:v>2.5583792372613501</c:v>
                </c:pt>
                <c:pt idx="406">
                  <c:v>3.1907927604239199</c:v>
                </c:pt>
                <c:pt idx="407">
                  <c:v>2.9900892300253399</c:v>
                </c:pt>
                <c:pt idx="408">
                  <c:v>3.0568950949937799</c:v>
                </c:pt>
                <c:pt idx="409">
                  <c:v>2.6758821257258001</c:v>
                </c:pt>
                <c:pt idx="410">
                  <c:v>2.7293467190265801</c:v>
                </c:pt>
                <c:pt idx="411">
                  <c:v>2.8681267853532302</c:v>
                </c:pt>
                <c:pt idx="412">
                  <c:v>3.0641741429860798</c:v>
                </c:pt>
                <c:pt idx="413">
                  <c:v>2.86510198802049</c:v>
                </c:pt>
                <c:pt idx="414">
                  <c:v>2.89301132694444</c:v>
                </c:pt>
                <c:pt idx="415">
                  <c:v>3.11249225465393</c:v>
                </c:pt>
                <c:pt idx="416">
                  <c:v>3.0283507361734499</c:v>
                </c:pt>
                <c:pt idx="417">
                  <c:v>3.2114659798739398</c:v>
                </c:pt>
                <c:pt idx="418">
                  <c:v>2.7778440177978498</c:v>
                </c:pt>
                <c:pt idx="419">
                  <c:v>2.8606035726124901</c:v>
                </c:pt>
                <c:pt idx="420">
                  <c:v>3.06736411893419</c:v>
                </c:pt>
                <c:pt idx="421">
                  <c:v>3.01100749326377</c:v>
                </c:pt>
                <c:pt idx="422">
                  <c:v>3.5863493652762002</c:v>
                </c:pt>
                <c:pt idx="423">
                  <c:v>3.1564358866195299</c:v>
                </c:pt>
                <c:pt idx="424">
                  <c:v>3.4679969107614901</c:v>
                </c:pt>
                <c:pt idx="425">
                  <c:v>3.3110342665808701</c:v>
                </c:pt>
                <c:pt idx="426">
                  <c:v>3.2043908924642701</c:v>
                </c:pt>
                <c:pt idx="427">
                  <c:v>2.8607285837269298</c:v>
                </c:pt>
                <c:pt idx="428">
                  <c:v>3.1060576901466201</c:v>
                </c:pt>
                <c:pt idx="429">
                  <c:v>3.2463500509041898</c:v>
                </c:pt>
                <c:pt idx="430">
                  <c:v>3.1826252761979799</c:v>
                </c:pt>
                <c:pt idx="431">
                  <c:v>3.2735180866792701</c:v>
                </c:pt>
                <c:pt idx="432">
                  <c:v>3.0068288124182398</c:v>
                </c:pt>
                <c:pt idx="433">
                  <c:v>2.8336109482669301</c:v>
                </c:pt>
                <c:pt idx="434">
                  <c:v>2.2039481570186101</c:v>
                </c:pt>
                <c:pt idx="435">
                  <c:v>2.7338113488187399</c:v>
                </c:pt>
                <c:pt idx="436">
                  <c:v>2.5520882270952798</c:v>
                </c:pt>
                <c:pt idx="437">
                  <c:v>2.51894618541096</c:v>
                </c:pt>
                <c:pt idx="438">
                  <c:v>2.86358550090912</c:v>
                </c:pt>
                <c:pt idx="439">
                  <c:v>2.7851879169572298</c:v>
                </c:pt>
                <c:pt idx="440">
                  <c:v>2.6323342853757601</c:v>
                </c:pt>
                <c:pt idx="441">
                  <c:v>2.6166416040425999</c:v>
                </c:pt>
                <c:pt idx="442">
                  <c:v>2.2744581634732799</c:v>
                </c:pt>
                <c:pt idx="443">
                  <c:v>2.4017753949890701</c:v>
                </c:pt>
                <c:pt idx="444">
                  <c:v>2.36714287427586</c:v>
                </c:pt>
                <c:pt idx="445">
                  <c:v>2.8768056990127202</c:v>
                </c:pt>
                <c:pt idx="446">
                  <c:v>2.6088058857720902</c:v>
                </c:pt>
                <c:pt idx="447">
                  <c:v>2.1823231778949901</c:v>
                </c:pt>
                <c:pt idx="448">
                  <c:v>2.7833656837383902</c:v>
                </c:pt>
                <c:pt idx="449">
                  <c:v>2.8211754441277601</c:v>
                </c:pt>
                <c:pt idx="450">
                  <c:v>2.5791000285003101</c:v>
                </c:pt>
                <c:pt idx="451">
                  <c:v>2.98622873389282</c:v>
                </c:pt>
                <c:pt idx="452">
                  <c:v>2.2277266445878001</c:v>
                </c:pt>
                <c:pt idx="453">
                  <c:v>2.4353957633046099</c:v>
                </c:pt>
                <c:pt idx="454">
                  <c:v>2.6389023917681098</c:v>
                </c:pt>
                <c:pt idx="455">
                  <c:v>2.5828635054157001</c:v>
                </c:pt>
                <c:pt idx="456">
                  <c:v>3.0163304171084202</c:v>
                </c:pt>
                <c:pt idx="457">
                  <c:v>2.8405316681512098</c:v>
                </c:pt>
                <c:pt idx="458">
                  <c:v>2.64128953409783</c:v>
                </c:pt>
                <c:pt idx="459">
                  <c:v>2.6979758512710701</c:v>
                </c:pt>
                <c:pt idx="460">
                  <c:v>2.88887347142555</c:v>
                </c:pt>
                <c:pt idx="461">
                  <c:v>2.7876362086872701</c:v>
                </c:pt>
                <c:pt idx="462">
                  <c:v>2.6209266893104401</c:v>
                </c:pt>
                <c:pt idx="463">
                  <c:v>2.4539413927380198</c:v>
                </c:pt>
                <c:pt idx="464">
                  <c:v>1.60546163086528</c:v>
                </c:pt>
                <c:pt idx="465">
                  <c:v>1.8183096284263101</c:v>
                </c:pt>
                <c:pt idx="466">
                  <c:v>1.9091445864843499</c:v>
                </c:pt>
                <c:pt idx="467">
                  <c:v>2.06410299961632</c:v>
                </c:pt>
                <c:pt idx="468">
                  <c:v>2.5516696916949102</c:v>
                </c:pt>
                <c:pt idx="469">
                  <c:v>2.2160776212255699</c:v>
                </c:pt>
                <c:pt idx="470">
                  <c:v>2.86142468905958</c:v>
                </c:pt>
                <c:pt idx="471">
                  <c:v>2.08221119446184</c:v>
                </c:pt>
                <c:pt idx="472">
                  <c:v>2.7131366921849698</c:v>
                </c:pt>
                <c:pt idx="473">
                  <c:v>3.3603831829057</c:v>
                </c:pt>
                <c:pt idx="474">
                  <c:v>2.9394329194074098</c:v>
                </c:pt>
                <c:pt idx="475">
                  <c:v>2.82174198032707</c:v>
                </c:pt>
                <c:pt idx="476">
                  <c:v>2.73934740223382</c:v>
                </c:pt>
                <c:pt idx="477">
                  <c:v>2.6071427525098301</c:v>
                </c:pt>
                <c:pt idx="478">
                  <c:v>2.3221759160201301</c:v>
                </c:pt>
                <c:pt idx="479">
                  <c:v>2.6884226263843698</c:v>
                </c:pt>
                <c:pt idx="480">
                  <c:v>3.2254398506408499</c:v>
                </c:pt>
                <c:pt idx="481">
                  <c:v>3.24756378518267</c:v>
                </c:pt>
                <c:pt idx="482">
                  <c:v>3.14119991978585</c:v>
                </c:pt>
                <c:pt idx="483">
                  <c:v>3.1825704276800701</c:v>
                </c:pt>
                <c:pt idx="484">
                  <c:v>3.0461150493910201</c:v>
                </c:pt>
                <c:pt idx="485">
                  <c:v>2.8352272412297101</c:v>
                </c:pt>
                <c:pt idx="486">
                  <c:v>2.5396320376207102</c:v>
                </c:pt>
                <c:pt idx="487">
                  <c:v>2.8986205138515002</c:v>
                </c:pt>
                <c:pt idx="488">
                  <c:v>3.0769915792376099</c:v>
                </c:pt>
                <c:pt idx="489">
                  <c:v>2.8807782324940301</c:v>
                </c:pt>
                <c:pt idx="490">
                  <c:v>3.0368978413277499</c:v>
                </c:pt>
                <c:pt idx="491">
                  <c:v>3.32593447803302</c:v>
                </c:pt>
                <c:pt idx="492">
                  <c:v>3.6512819347391701</c:v>
                </c:pt>
                <c:pt idx="493">
                  <c:v>3.4560797209379199</c:v>
                </c:pt>
                <c:pt idx="494">
                  <c:v>3.3246297258115098</c:v>
                </c:pt>
                <c:pt idx="495">
                  <c:v>2.7697103061228501</c:v>
                </c:pt>
                <c:pt idx="496">
                  <c:v>3.4172349882322202</c:v>
                </c:pt>
                <c:pt idx="497">
                  <c:v>3.0373882320712098</c:v>
                </c:pt>
                <c:pt idx="498">
                  <c:v>2.97627793309693</c:v>
                </c:pt>
                <c:pt idx="499">
                  <c:v>2.87204506068489</c:v>
                </c:pt>
                <c:pt idx="500">
                  <c:v>3.1588623926840298</c:v>
                </c:pt>
                <c:pt idx="501">
                  <c:v>2.9050672483897602</c:v>
                </c:pt>
                <c:pt idx="502">
                  <c:v>2.7227376746598702</c:v>
                </c:pt>
                <c:pt idx="503">
                  <c:v>2.6704451328294301</c:v>
                </c:pt>
                <c:pt idx="504">
                  <c:v>3.2357375543925602</c:v>
                </c:pt>
                <c:pt idx="505">
                  <c:v>3.35445163544951</c:v>
                </c:pt>
                <c:pt idx="506">
                  <c:v>2.7418554430407198</c:v>
                </c:pt>
                <c:pt idx="507">
                  <c:v>2.7501591943808199</c:v>
                </c:pt>
                <c:pt idx="508">
                  <c:v>2.99606742916782</c:v>
                </c:pt>
                <c:pt idx="509">
                  <c:v>3.3673316753735301</c:v>
                </c:pt>
                <c:pt idx="510">
                  <c:v>3.24215631098</c:v>
                </c:pt>
                <c:pt idx="511">
                  <c:v>3.08004214462298</c:v>
                </c:pt>
                <c:pt idx="512">
                  <c:v>3.1310592202818501</c:v>
                </c:pt>
                <c:pt idx="513">
                  <c:v>2.9372527236803898</c:v>
                </c:pt>
                <c:pt idx="514">
                  <c:v>2.5930068305315399</c:v>
                </c:pt>
                <c:pt idx="515">
                  <c:v>2.8232677321366202</c:v>
                </c:pt>
                <c:pt idx="516">
                  <c:v>3.0299831739709102</c:v>
                </c:pt>
                <c:pt idx="517">
                  <c:v>2.9589561014153798</c:v>
                </c:pt>
                <c:pt idx="518">
                  <c:v>2.7179723879275199</c:v>
                </c:pt>
                <c:pt idx="519">
                  <c:v>2.4295395930470698</c:v>
                </c:pt>
                <c:pt idx="520">
                  <c:v>2.8591293419313701</c:v>
                </c:pt>
                <c:pt idx="521">
                  <c:v>2.9411943384886499</c:v>
                </c:pt>
                <c:pt idx="522">
                  <c:v>3.1764286971859601</c:v>
                </c:pt>
                <c:pt idx="523">
                  <c:v>3.6054719669223299</c:v>
                </c:pt>
                <c:pt idx="524">
                  <c:v>2.79167716748529</c:v>
                </c:pt>
                <c:pt idx="525">
                  <c:v>2.9353965414320502</c:v>
                </c:pt>
                <c:pt idx="526">
                  <c:v>2.7355228735504702</c:v>
                </c:pt>
                <c:pt idx="527">
                  <c:v>3.02043216751564</c:v>
                </c:pt>
                <c:pt idx="528">
                  <c:v>3.1356052897383999</c:v>
                </c:pt>
                <c:pt idx="529">
                  <c:v>2.7797327510363101</c:v>
                </c:pt>
                <c:pt idx="530">
                  <c:v>3.0939335932655299</c:v>
                </c:pt>
                <c:pt idx="531">
                  <c:v>2.8870213991813598</c:v>
                </c:pt>
                <c:pt idx="532">
                  <c:v>2.8702559787549702</c:v>
                </c:pt>
                <c:pt idx="533">
                  <c:v>2.63757219029839</c:v>
                </c:pt>
                <c:pt idx="534">
                  <c:v>2.7652977267905801</c:v>
                </c:pt>
                <c:pt idx="535">
                  <c:v>2.5907373577566402</c:v>
                </c:pt>
                <c:pt idx="536">
                  <c:v>3.1305620535324099</c:v>
                </c:pt>
                <c:pt idx="537">
                  <c:v>3.29522731287399</c:v>
                </c:pt>
                <c:pt idx="538">
                  <c:v>2.94181130264265</c:v>
                </c:pt>
                <c:pt idx="539">
                  <c:v>2.7244767779757599</c:v>
                </c:pt>
                <c:pt idx="540">
                  <c:v>2.93551421096433</c:v>
                </c:pt>
                <c:pt idx="541">
                  <c:v>2.8253360246138102</c:v>
                </c:pt>
                <c:pt idx="542">
                  <c:v>2.6828662091023401</c:v>
                </c:pt>
                <c:pt idx="543">
                  <c:v>2.4355361903357999</c:v>
                </c:pt>
                <c:pt idx="544">
                  <c:v>2.8479953810146399</c:v>
                </c:pt>
                <c:pt idx="545">
                  <c:v>3.2677505239807099</c:v>
                </c:pt>
                <c:pt idx="546">
                  <c:v>2.8928162306688301</c:v>
                </c:pt>
                <c:pt idx="547">
                  <c:v>2.5093903272693501</c:v>
                </c:pt>
                <c:pt idx="548">
                  <c:v>3.0665308764778199</c:v>
                </c:pt>
                <c:pt idx="549">
                  <c:v>2.6823810364624801</c:v>
                </c:pt>
                <c:pt idx="550">
                  <c:v>2.6964907014527202</c:v>
                </c:pt>
                <c:pt idx="551">
                  <c:v>2.6132770048657101</c:v>
                </c:pt>
                <c:pt idx="552">
                  <c:v>2.4654107239925001</c:v>
                </c:pt>
                <c:pt idx="553">
                  <c:v>2.8094282156233601</c:v>
                </c:pt>
                <c:pt idx="554">
                  <c:v>2.6863157339655102</c:v>
                </c:pt>
                <c:pt idx="555">
                  <c:v>2.3203250302105798</c:v>
                </c:pt>
                <c:pt idx="556">
                  <c:v>2.5038272817381899</c:v>
                </c:pt>
                <c:pt idx="557">
                  <c:v>2.5391157313219499</c:v>
                </c:pt>
                <c:pt idx="558">
                  <c:v>2.25280536086006</c:v>
                </c:pt>
                <c:pt idx="559">
                  <c:v>2.6145634879337298</c:v>
                </c:pt>
                <c:pt idx="560">
                  <c:v>3.12522196767772</c:v>
                </c:pt>
                <c:pt idx="561">
                  <c:v>2.4929328467038299</c:v>
                </c:pt>
                <c:pt idx="562">
                  <c:v>2.4273398792486098</c:v>
                </c:pt>
                <c:pt idx="563">
                  <c:v>2.9862731317701301</c:v>
                </c:pt>
                <c:pt idx="564">
                  <c:v>2.90525826896801</c:v>
                </c:pt>
                <c:pt idx="565">
                  <c:v>2.72180343888841</c:v>
                </c:pt>
                <c:pt idx="566">
                  <c:v>2.9246401220382898</c:v>
                </c:pt>
                <c:pt idx="567">
                  <c:v>2.8880793422135902</c:v>
                </c:pt>
                <c:pt idx="568">
                  <c:v>2.8773803476425899</c:v>
                </c:pt>
                <c:pt idx="569">
                  <c:v>2.91714087007148</c:v>
                </c:pt>
                <c:pt idx="570">
                  <c:v>3.0944816216061</c:v>
                </c:pt>
                <c:pt idx="571">
                  <c:v>3.6098115287891201</c:v>
                </c:pt>
                <c:pt idx="572">
                  <c:v>3.0623992434442302</c:v>
                </c:pt>
                <c:pt idx="573">
                  <c:v>2.8430718949726699</c:v>
                </c:pt>
                <c:pt idx="574">
                  <c:v>2.7792717767199999</c:v>
                </c:pt>
                <c:pt idx="575">
                  <c:v>3.5212993948996201</c:v>
                </c:pt>
                <c:pt idx="576">
                  <c:v>2.6707786886813398</c:v>
                </c:pt>
                <c:pt idx="577">
                  <c:v>3.0002968708591702</c:v>
                </c:pt>
                <c:pt idx="578">
                  <c:v>2.7446924782135</c:v>
                </c:pt>
                <c:pt idx="579">
                  <c:v>2.8681127120526102</c:v>
                </c:pt>
                <c:pt idx="580">
                  <c:v>2.8662377790914899</c:v>
                </c:pt>
                <c:pt idx="581">
                  <c:v>2.64255081291354</c:v>
                </c:pt>
                <c:pt idx="582">
                  <c:v>2.4603187835140901</c:v>
                </c:pt>
                <c:pt idx="583">
                  <c:v>2.5286072633178098</c:v>
                </c:pt>
                <c:pt idx="584">
                  <c:v>2.7863706582134302</c:v>
                </c:pt>
                <c:pt idx="585">
                  <c:v>3.2648202965083599</c:v>
                </c:pt>
                <c:pt idx="586">
                  <c:v>2.87021427721267</c:v>
                </c:pt>
                <c:pt idx="587">
                  <c:v>3.04501289318616</c:v>
                </c:pt>
                <c:pt idx="588">
                  <c:v>3.1146029375714899</c:v>
                </c:pt>
                <c:pt idx="589">
                  <c:v>3.3395790515164299</c:v>
                </c:pt>
                <c:pt idx="590">
                  <c:v>3.3295430347369401</c:v>
                </c:pt>
                <c:pt idx="591">
                  <c:v>2.7604753601951999</c:v>
                </c:pt>
                <c:pt idx="592">
                  <c:v>2.6445699980244801</c:v>
                </c:pt>
                <c:pt idx="593">
                  <c:v>2.5150829938276198</c:v>
                </c:pt>
                <c:pt idx="594">
                  <c:v>3.0177540478134199</c:v>
                </c:pt>
                <c:pt idx="595">
                  <c:v>3.00491494715118</c:v>
                </c:pt>
                <c:pt idx="596">
                  <c:v>3.3713072475924402</c:v>
                </c:pt>
                <c:pt idx="597">
                  <c:v>3.1196162632911602</c:v>
                </c:pt>
                <c:pt idx="598">
                  <c:v>2.72265100331468</c:v>
                </c:pt>
                <c:pt idx="599">
                  <c:v>2.9996068311938502</c:v>
                </c:pt>
                <c:pt idx="600">
                  <c:v>2.6713072543579801</c:v>
                </c:pt>
                <c:pt idx="601">
                  <c:v>3.21405170880591</c:v>
                </c:pt>
                <c:pt idx="602">
                  <c:v>2.3483314787011502</c:v>
                </c:pt>
                <c:pt idx="603">
                  <c:v>3.12397247275922</c:v>
                </c:pt>
                <c:pt idx="604">
                  <c:v>2.9062341071026201</c:v>
                </c:pt>
                <c:pt idx="605">
                  <c:v>3.0567402001422401</c:v>
                </c:pt>
                <c:pt idx="606">
                  <c:v>3.01421287051302</c:v>
                </c:pt>
                <c:pt idx="607">
                  <c:v>2.6753151121519498</c:v>
                </c:pt>
                <c:pt idx="608">
                  <c:v>2.9570504820607</c:v>
                </c:pt>
                <c:pt idx="609">
                  <c:v>2.4144836404424801</c:v>
                </c:pt>
                <c:pt idx="610">
                  <c:v>3.2721966352885099</c:v>
                </c:pt>
                <c:pt idx="611">
                  <c:v>3.03423912277146</c:v>
                </c:pt>
                <c:pt idx="612">
                  <c:v>3.3334380141767599</c:v>
                </c:pt>
                <c:pt idx="613">
                  <c:v>3.8660134846016598</c:v>
                </c:pt>
                <c:pt idx="614">
                  <c:v>3.4923552087918601</c:v>
                </c:pt>
                <c:pt idx="615">
                  <c:v>3.4598430623028902</c:v>
                </c:pt>
                <c:pt idx="616">
                  <c:v>3.76750044259731</c:v>
                </c:pt>
                <c:pt idx="617">
                  <c:v>4.03984102406167</c:v>
                </c:pt>
                <c:pt idx="618">
                  <c:v>3.1269257713008298</c:v>
                </c:pt>
                <c:pt idx="619">
                  <c:v>2.2030569263834301</c:v>
                </c:pt>
                <c:pt idx="620">
                  <c:v>2.30989481471219</c:v>
                </c:pt>
                <c:pt idx="621">
                  <c:v>2.5147660820132902</c:v>
                </c:pt>
                <c:pt idx="622">
                  <c:v>2.7129758365850001</c:v>
                </c:pt>
                <c:pt idx="623">
                  <c:v>2.1580134772615902</c:v>
                </c:pt>
                <c:pt idx="624">
                  <c:v>3.1362048071349302</c:v>
                </c:pt>
                <c:pt idx="625">
                  <c:v>2.31845736238941</c:v>
                </c:pt>
                <c:pt idx="626">
                  <c:v>2.4631246018344202</c:v>
                </c:pt>
                <c:pt idx="627">
                  <c:v>2.8480601813089201</c:v>
                </c:pt>
                <c:pt idx="628">
                  <c:v>2.3854278486843898</c:v>
                </c:pt>
                <c:pt idx="629">
                  <c:v>2.1643814662338201</c:v>
                </c:pt>
                <c:pt idx="630">
                  <c:v>2.91434637182113</c:v>
                </c:pt>
                <c:pt idx="631">
                  <c:v>2.1694699788095599</c:v>
                </c:pt>
                <c:pt idx="632">
                  <c:v>3.0756419997248399</c:v>
                </c:pt>
                <c:pt idx="633">
                  <c:v>2.5072590552157901</c:v>
                </c:pt>
                <c:pt idx="634">
                  <c:v>2.7609907696567402</c:v>
                </c:pt>
                <c:pt idx="635">
                  <c:v>2.8701565487212499</c:v>
                </c:pt>
                <c:pt idx="636">
                  <c:v>2.1145184896842899</c:v>
                </c:pt>
                <c:pt idx="637">
                  <c:v>3.0270451282617601</c:v>
                </c:pt>
                <c:pt idx="638">
                  <c:v>2.40554670203904</c:v>
                </c:pt>
                <c:pt idx="639">
                  <c:v>3.0166476104537101</c:v>
                </c:pt>
                <c:pt idx="640">
                  <c:v>2.48054515417286</c:v>
                </c:pt>
                <c:pt idx="641">
                  <c:v>2.6347713405846598</c:v>
                </c:pt>
                <c:pt idx="642">
                  <c:v>2.74203942440437</c:v>
                </c:pt>
                <c:pt idx="643">
                  <c:v>2.5065167526348802</c:v>
                </c:pt>
                <c:pt idx="644">
                  <c:v>2.6482664528557698</c:v>
                </c:pt>
                <c:pt idx="645">
                  <c:v>2.1586128826297402</c:v>
                </c:pt>
                <c:pt idx="646">
                  <c:v>2.4280819419417901</c:v>
                </c:pt>
                <c:pt idx="647">
                  <c:v>3.07862568255223</c:v>
                </c:pt>
                <c:pt idx="648">
                  <c:v>2.31961282675115</c:v>
                </c:pt>
                <c:pt idx="649">
                  <c:v>2.0970217415490899</c:v>
                </c:pt>
                <c:pt idx="650">
                  <c:v>2.4824612913854098</c:v>
                </c:pt>
                <c:pt idx="651">
                  <c:v>2.2022585985865399</c:v>
                </c:pt>
                <c:pt idx="652">
                  <c:v>2.4515915357214602</c:v>
                </c:pt>
                <c:pt idx="653">
                  <c:v>2.57540800772626</c:v>
                </c:pt>
                <c:pt idx="654">
                  <c:v>2.9158728259930702</c:v>
                </c:pt>
                <c:pt idx="655">
                  <c:v>2.7643391601658198</c:v>
                </c:pt>
                <c:pt idx="656">
                  <c:v>2.3486033778075002</c:v>
                </c:pt>
                <c:pt idx="657">
                  <c:v>2.09269203174025</c:v>
                </c:pt>
                <c:pt idx="658">
                  <c:v>2.09809067286298</c:v>
                </c:pt>
                <c:pt idx="659">
                  <c:v>2.51845677799392</c:v>
                </c:pt>
                <c:pt idx="660">
                  <c:v>2.73984654510312</c:v>
                </c:pt>
                <c:pt idx="661">
                  <c:v>2.64159590882509</c:v>
                </c:pt>
                <c:pt idx="662">
                  <c:v>2.8041033985109101</c:v>
                </c:pt>
                <c:pt idx="663">
                  <c:v>2.6480528549999698</c:v>
                </c:pt>
                <c:pt idx="664">
                  <c:v>2.9839268541372399</c:v>
                </c:pt>
                <c:pt idx="665">
                  <c:v>3.1926958436041999</c:v>
                </c:pt>
                <c:pt idx="666">
                  <c:v>3.1220103445658398</c:v>
                </c:pt>
                <c:pt idx="667">
                  <c:v>2.5433592787667898</c:v>
                </c:pt>
                <c:pt idx="668">
                  <c:v>3.1104298196639202</c:v>
                </c:pt>
                <c:pt idx="669">
                  <c:v>3.0242104712072901</c:v>
                </c:pt>
                <c:pt idx="670">
                  <c:v>2.4919447482368899</c:v>
                </c:pt>
                <c:pt idx="671">
                  <c:v>3.0059976106210202</c:v>
                </c:pt>
                <c:pt idx="672">
                  <c:v>2.7808392330821499</c:v>
                </c:pt>
                <c:pt idx="673">
                  <c:v>3.4452459486359901</c:v>
                </c:pt>
                <c:pt idx="674">
                  <c:v>3.0383474981020901</c:v>
                </c:pt>
                <c:pt idx="675">
                  <c:v>2.5651605070141201</c:v>
                </c:pt>
                <c:pt idx="676">
                  <c:v>2.4198699178904501</c:v>
                </c:pt>
                <c:pt idx="677">
                  <c:v>2.60851806112617</c:v>
                </c:pt>
                <c:pt idx="678">
                  <c:v>2.4101308259351999</c:v>
                </c:pt>
                <c:pt idx="679">
                  <c:v>2.4371954658466501</c:v>
                </c:pt>
                <c:pt idx="680">
                  <c:v>2.6123740048998298</c:v>
                </c:pt>
                <c:pt idx="681">
                  <c:v>2.7564859332696501</c:v>
                </c:pt>
                <c:pt idx="682">
                  <c:v>2.5848935525062</c:v>
                </c:pt>
                <c:pt idx="683">
                  <c:v>2.6908119426641202</c:v>
                </c:pt>
                <c:pt idx="684">
                  <c:v>3.0760548352563299</c:v>
                </c:pt>
                <c:pt idx="685">
                  <c:v>2.8143805798852299</c:v>
                </c:pt>
                <c:pt idx="686">
                  <c:v>2.3258820531464002</c:v>
                </c:pt>
                <c:pt idx="687">
                  <c:v>2.2089934511684901</c:v>
                </c:pt>
                <c:pt idx="688">
                  <c:v>1.87388163257957</c:v>
                </c:pt>
                <c:pt idx="689">
                  <c:v>2.3397588510439902</c:v>
                </c:pt>
                <c:pt idx="690">
                  <c:v>3.1048509214418898</c:v>
                </c:pt>
                <c:pt idx="691">
                  <c:v>2.6292723545716301</c:v>
                </c:pt>
                <c:pt idx="692">
                  <c:v>3.0514532022081502</c:v>
                </c:pt>
                <c:pt idx="693">
                  <c:v>2.478057740863</c:v>
                </c:pt>
                <c:pt idx="694">
                  <c:v>2.7044062607397099</c:v>
                </c:pt>
                <c:pt idx="695">
                  <c:v>2.3940743187387801</c:v>
                </c:pt>
                <c:pt idx="696">
                  <c:v>2.3954300350161302</c:v>
                </c:pt>
                <c:pt idx="697">
                  <c:v>2.96507978555938</c:v>
                </c:pt>
                <c:pt idx="698">
                  <c:v>3.1041759681878598</c:v>
                </c:pt>
                <c:pt idx="699">
                  <c:v>2.2850430745146002</c:v>
                </c:pt>
                <c:pt idx="700">
                  <c:v>2.56565392142</c:v>
                </c:pt>
                <c:pt idx="701">
                  <c:v>2.53527800884169</c:v>
                </c:pt>
                <c:pt idx="702">
                  <c:v>2.2597682143436302</c:v>
                </c:pt>
                <c:pt idx="703">
                  <c:v>2.24236156188956</c:v>
                </c:pt>
                <c:pt idx="704">
                  <c:v>2.8821720269214102</c:v>
                </c:pt>
                <c:pt idx="705">
                  <c:v>2.6170941123476599</c:v>
                </c:pt>
                <c:pt idx="706">
                  <c:v>2.49867549954591</c:v>
                </c:pt>
                <c:pt idx="707">
                  <c:v>2.7526808985381601</c:v>
                </c:pt>
                <c:pt idx="708">
                  <c:v>1.8882936020308401</c:v>
                </c:pt>
                <c:pt idx="709">
                  <c:v>2.4253901692739701</c:v>
                </c:pt>
                <c:pt idx="710">
                  <c:v>2.3872387861709798</c:v>
                </c:pt>
                <c:pt idx="711">
                  <c:v>3.2655963274898001</c:v>
                </c:pt>
                <c:pt idx="712">
                  <c:v>2.4549000474556202</c:v>
                </c:pt>
                <c:pt idx="713">
                  <c:v>3.10508078033339</c:v>
                </c:pt>
                <c:pt idx="714">
                  <c:v>2.72996587045195</c:v>
                </c:pt>
                <c:pt idx="715">
                  <c:v>1.8557761157164701</c:v>
                </c:pt>
                <c:pt idx="716">
                  <c:v>2.1756240792369499</c:v>
                </c:pt>
                <c:pt idx="717">
                  <c:v>2.5253841861245498</c:v>
                </c:pt>
                <c:pt idx="718">
                  <c:v>2.03452971466286</c:v>
                </c:pt>
                <c:pt idx="719">
                  <c:v>2.8721267825509198</c:v>
                </c:pt>
                <c:pt idx="720">
                  <c:v>2.40409502938595</c:v>
                </c:pt>
                <c:pt idx="721">
                  <c:v>3.0080992870584198</c:v>
                </c:pt>
                <c:pt idx="722">
                  <c:v>2.7358448704291201</c:v>
                </c:pt>
                <c:pt idx="723">
                  <c:v>3.0386848700331401</c:v>
                </c:pt>
                <c:pt idx="724">
                  <c:v>2.4396870778292001</c:v>
                </c:pt>
                <c:pt idx="725">
                  <c:v>3.0539983026944002</c:v>
                </c:pt>
                <c:pt idx="726">
                  <c:v>2.78212257532731</c:v>
                </c:pt>
                <c:pt idx="727">
                  <c:v>2.3916555798611299</c:v>
                </c:pt>
                <c:pt idx="728">
                  <c:v>2.7611292459799701</c:v>
                </c:pt>
                <c:pt idx="729">
                  <c:v>2.4914362715949601</c:v>
                </c:pt>
                <c:pt idx="730">
                  <c:v>2.36535841101901</c:v>
                </c:pt>
                <c:pt idx="731">
                  <c:v>2.4830995010173398</c:v>
                </c:pt>
                <c:pt idx="732">
                  <c:v>2.38786629810624</c:v>
                </c:pt>
                <c:pt idx="733">
                  <c:v>2.51858956649387</c:v>
                </c:pt>
                <c:pt idx="734">
                  <c:v>2.42547172313026</c:v>
                </c:pt>
                <c:pt idx="735">
                  <c:v>2.89413549946602</c:v>
                </c:pt>
                <c:pt idx="736">
                  <c:v>3.0346683108976702</c:v>
                </c:pt>
                <c:pt idx="737">
                  <c:v>3.03549342202811</c:v>
                </c:pt>
                <c:pt idx="738">
                  <c:v>2.61372869501057</c:v>
                </c:pt>
                <c:pt idx="739">
                  <c:v>3.1956573176630299</c:v>
                </c:pt>
                <c:pt idx="740">
                  <c:v>2.9250293044886</c:v>
                </c:pt>
                <c:pt idx="741">
                  <c:v>3.1528495623550601</c:v>
                </c:pt>
                <c:pt idx="742">
                  <c:v>2.8149983166161401</c:v>
                </c:pt>
                <c:pt idx="743">
                  <c:v>2.4432987988064099</c:v>
                </c:pt>
                <c:pt idx="744">
                  <c:v>2.9807770166767802</c:v>
                </c:pt>
                <c:pt idx="745">
                  <c:v>2.66102996370843</c:v>
                </c:pt>
                <c:pt idx="746">
                  <c:v>2.9199809781231498</c:v>
                </c:pt>
                <c:pt idx="747">
                  <c:v>2.78817042941556</c:v>
                </c:pt>
                <c:pt idx="748">
                  <c:v>2.9189389411262101</c:v>
                </c:pt>
                <c:pt idx="749">
                  <c:v>2.2365331287343899</c:v>
                </c:pt>
                <c:pt idx="750">
                  <c:v>2.6268411484331802</c:v>
                </c:pt>
                <c:pt idx="751">
                  <c:v>3.1685123779656501</c:v>
                </c:pt>
                <c:pt idx="752">
                  <c:v>2.5247036812810202</c:v>
                </c:pt>
                <c:pt idx="753">
                  <c:v>3.3487204215767901</c:v>
                </c:pt>
                <c:pt idx="754">
                  <c:v>2.1011470618301198</c:v>
                </c:pt>
                <c:pt idx="755">
                  <c:v>2.1491027457597101</c:v>
                </c:pt>
                <c:pt idx="756">
                  <c:v>2.3425532746530999</c:v>
                </c:pt>
                <c:pt idx="757">
                  <c:v>2.7486259511506401</c:v>
                </c:pt>
                <c:pt idx="758">
                  <c:v>2.1907497575998001</c:v>
                </c:pt>
                <c:pt idx="759">
                  <c:v>2.68395058013262</c:v>
                </c:pt>
                <c:pt idx="760">
                  <c:v>3.5597800192941298</c:v>
                </c:pt>
                <c:pt idx="761">
                  <c:v>2.3691759381736701</c:v>
                </c:pt>
                <c:pt idx="762">
                  <c:v>3.1789049183621101</c:v>
                </c:pt>
                <c:pt idx="763">
                  <c:v>2.9561884533614902</c:v>
                </c:pt>
                <c:pt idx="764">
                  <c:v>3.0183996672049598</c:v>
                </c:pt>
                <c:pt idx="765">
                  <c:v>2.9994579213652202</c:v>
                </c:pt>
                <c:pt idx="766">
                  <c:v>2.8260255236276999</c:v>
                </c:pt>
                <c:pt idx="767">
                  <c:v>3.1622434790585601</c:v>
                </c:pt>
                <c:pt idx="768">
                  <c:v>3.1041365154634599</c:v>
                </c:pt>
                <c:pt idx="769">
                  <c:v>3.7028149672729902</c:v>
                </c:pt>
                <c:pt idx="770">
                  <c:v>3.2174593747742399</c:v>
                </c:pt>
                <c:pt idx="771">
                  <c:v>2.9021670609001999</c:v>
                </c:pt>
                <c:pt idx="772">
                  <c:v>2.7031381377083599</c:v>
                </c:pt>
                <c:pt idx="773">
                  <c:v>3.03736328450948</c:v>
                </c:pt>
                <c:pt idx="774">
                  <c:v>2.4128674638035501</c:v>
                </c:pt>
                <c:pt idx="775">
                  <c:v>3.0640583925534202</c:v>
                </c:pt>
                <c:pt idx="776">
                  <c:v>3.1374299832630501</c:v>
                </c:pt>
                <c:pt idx="777">
                  <c:v>3.23667756623722</c:v>
                </c:pt>
                <c:pt idx="778">
                  <c:v>2.79853839178831</c:v>
                </c:pt>
                <c:pt idx="779">
                  <c:v>2.8634445550300098</c:v>
                </c:pt>
                <c:pt idx="780">
                  <c:v>3.2761017022932402</c:v>
                </c:pt>
                <c:pt idx="781">
                  <c:v>3.3189867906901398</c:v>
                </c:pt>
                <c:pt idx="782">
                  <c:v>3.6706094825101201</c:v>
                </c:pt>
                <c:pt idx="783">
                  <c:v>2.82479293209644</c:v>
                </c:pt>
                <c:pt idx="784">
                  <c:v>3.3128468414110199</c:v>
                </c:pt>
                <c:pt idx="785">
                  <c:v>3.2008359184135098</c:v>
                </c:pt>
                <c:pt idx="786">
                  <c:v>3.35849246676728</c:v>
                </c:pt>
                <c:pt idx="787">
                  <c:v>3.20125231935473</c:v>
                </c:pt>
                <c:pt idx="788">
                  <c:v>3.0098011610467998</c:v>
                </c:pt>
                <c:pt idx="789">
                  <c:v>3.8681870820955799</c:v>
                </c:pt>
                <c:pt idx="790">
                  <c:v>2.7750499417391299</c:v>
                </c:pt>
                <c:pt idx="791">
                  <c:v>3.0447302601133099</c:v>
                </c:pt>
                <c:pt idx="792">
                  <c:v>2.9944312801800601</c:v>
                </c:pt>
                <c:pt idx="793">
                  <c:v>3.1821408369149702</c:v>
                </c:pt>
                <c:pt idx="794">
                  <c:v>3.4120474782827399</c:v>
                </c:pt>
                <c:pt idx="795">
                  <c:v>3.2255524920982701</c:v>
                </c:pt>
                <c:pt idx="796">
                  <c:v>2.7758875032769299</c:v>
                </c:pt>
                <c:pt idx="797">
                  <c:v>3.0720879168158102</c:v>
                </c:pt>
                <c:pt idx="798">
                  <c:v>2.9708064096469999</c:v>
                </c:pt>
                <c:pt idx="799">
                  <c:v>3.0013030272650201</c:v>
                </c:pt>
                <c:pt idx="800">
                  <c:v>2.6105922943361</c:v>
                </c:pt>
                <c:pt idx="801">
                  <c:v>3.1071401035644999</c:v>
                </c:pt>
                <c:pt idx="802">
                  <c:v>2.7659470358855902</c:v>
                </c:pt>
                <c:pt idx="803">
                  <c:v>3.00571563966085</c:v>
                </c:pt>
                <c:pt idx="804">
                  <c:v>3.1092483326870299</c:v>
                </c:pt>
                <c:pt idx="805">
                  <c:v>3.21934745655716</c:v>
                </c:pt>
                <c:pt idx="806">
                  <c:v>3.2390295065357901</c:v>
                </c:pt>
                <c:pt idx="807">
                  <c:v>3.1516523171936899</c:v>
                </c:pt>
                <c:pt idx="808">
                  <c:v>2.9015965824855701</c:v>
                </c:pt>
                <c:pt idx="809">
                  <c:v>3.09611191752778</c:v>
                </c:pt>
                <c:pt idx="810">
                  <c:v>2.87835901755864</c:v>
                </c:pt>
                <c:pt idx="811">
                  <c:v>3.27226789760133</c:v>
                </c:pt>
                <c:pt idx="812">
                  <c:v>2.7133388304103501</c:v>
                </c:pt>
                <c:pt idx="813">
                  <c:v>3.3792856023789302</c:v>
                </c:pt>
                <c:pt idx="814">
                  <c:v>3.2715634178588702</c:v>
                </c:pt>
                <c:pt idx="815">
                  <c:v>3.7602771750411899</c:v>
                </c:pt>
                <c:pt idx="816">
                  <c:v>2.4810788852662302</c:v>
                </c:pt>
                <c:pt idx="817">
                  <c:v>2.7089413895373502</c:v>
                </c:pt>
                <c:pt idx="818">
                  <c:v>2.5058112944441699</c:v>
                </c:pt>
                <c:pt idx="819">
                  <c:v>1.96206670946913</c:v>
                </c:pt>
                <c:pt idx="820">
                  <c:v>3.1017958390894802</c:v>
                </c:pt>
                <c:pt idx="821">
                  <c:v>2.50756093260238</c:v>
                </c:pt>
                <c:pt idx="822">
                  <c:v>2.6247308019058</c:v>
                </c:pt>
                <c:pt idx="823">
                  <c:v>2.4740096362777</c:v>
                </c:pt>
                <c:pt idx="824">
                  <c:v>2.3079530239819102</c:v>
                </c:pt>
                <c:pt idx="825">
                  <c:v>2.01294032306784</c:v>
                </c:pt>
                <c:pt idx="826">
                  <c:v>2.5625848433296099</c:v>
                </c:pt>
                <c:pt idx="827">
                  <c:v>3.1635819884804799</c:v>
                </c:pt>
                <c:pt idx="828">
                  <c:v>2.0377234648051701</c:v>
                </c:pt>
                <c:pt idx="829">
                  <c:v>2.6660187563635298</c:v>
                </c:pt>
                <c:pt idx="830">
                  <c:v>2.3772658762962502</c:v>
                </c:pt>
                <c:pt idx="831">
                  <c:v>2.83587588229289</c:v>
                </c:pt>
                <c:pt idx="832">
                  <c:v>2.26113568050503</c:v>
                </c:pt>
                <c:pt idx="833">
                  <c:v>2.5875928731019702</c:v>
                </c:pt>
                <c:pt idx="834">
                  <c:v>2.9756185984256298</c:v>
                </c:pt>
                <c:pt idx="835">
                  <c:v>2.4001469477569599</c:v>
                </c:pt>
                <c:pt idx="836">
                  <c:v>2.7433381523413498</c:v>
                </c:pt>
                <c:pt idx="837">
                  <c:v>2.3796608740233198</c:v>
                </c:pt>
                <c:pt idx="838">
                  <c:v>2.0356678117772402</c:v>
                </c:pt>
                <c:pt idx="839">
                  <c:v>2.4424051317390298</c:v>
                </c:pt>
                <c:pt idx="840">
                  <c:v>2.3128101878950602</c:v>
                </c:pt>
                <c:pt idx="841">
                  <c:v>2.5415815180411099</c:v>
                </c:pt>
                <c:pt idx="842">
                  <c:v>2.7478566085160998</c:v>
                </c:pt>
                <c:pt idx="843">
                  <c:v>2.9878700334773698</c:v>
                </c:pt>
                <c:pt idx="844">
                  <c:v>2.77651974930777</c:v>
                </c:pt>
                <c:pt idx="845">
                  <c:v>2.85288519858286</c:v>
                </c:pt>
                <c:pt idx="846">
                  <c:v>2.5323588588272701</c:v>
                </c:pt>
                <c:pt idx="847">
                  <c:v>2.90010600616431</c:v>
                </c:pt>
                <c:pt idx="848">
                  <c:v>2.99347588862652</c:v>
                </c:pt>
                <c:pt idx="849">
                  <c:v>2.9687992038848501</c:v>
                </c:pt>
                <c:pt idx="850">
                  <c:v>2.5610545767719599</c:v>
                </c:pt>
                <c:pt idx="851">
                  <c:v>2.4367530521522198</c:v>
                </c:pt>
                <c:pt idx="852">
                  <c:v>2.9261545649712701</c:v>
                </c:pt>
                <c:pt idx="853">
                  <c:v>3.4581330396710102</c:v>
                </c:pt>
                <c:pt idx="854">
                  <c:v>2.9227905647722099</c:v>
                </c:pt>
                <c:pt idx="855">
                  <c:v>2.8050275984555202</c:v>
                </c:pt>
                <c:pt idx="856">
                  <c:v>3.3159828235830902</c:v>
                </c:pt>
                <c:pt idx="857">
                  <c:v>2.8638385184505499</c:v>
                </c:pt>
                <c:pt idx="858">
                  <c:v>3.6636134121824502</c:v>
                </c:pt>
                <c:pt idx="859">
                  <c:v>2.9900408333466801</c:v>
                </c:pt>
                <c:pt idx="860">
                  <c:v>3.0207172116055498</c:v>
                </c:pt>
                <c:pt idx="861">
                  <c:v>3.2794840933181901</c:v>
                </c:pt>
                <c:pt idx="862">
                  <c:v>2.9031639243498</c:v>
                </c:pt>
                <c:pt idx="863">
                  <c:v>3.1070577585253498</c:v>
                </c:pt>
                <c:pt idx="864">
                  <c:v>3.35713344785631</c:v>
                </c:pt>
                <c:pt idx="865">
                  <c:v>3.56171347039278</c:v>
                </c:pt>
                <c:pt idx="866">
                  <c:v>2.9785132307293098</c:v>
                </c:pt>
                <c:pt idx="867">
                  <c:v>3.3664451634715999</c:v>
                </c:pt>
                <c:pt idx="868">
                  <c:v>2.7476619248590999</c:v>
                </c:pt>
                <c:pt idx="869">
                  <c:v>2.8526412813357598</c:v>
                </c:pt>
                <c:pt idx="870">
                  <c:v>3.1154051111321301</c:v>
                </c:pt>
                <c:pt idx="871">
                  <c:v>2.8882498516565001</c:v>
                </c:pt>
                <c:pt idx="872">
                  <c:v>3.4021059245746001</c:v>
                </c:pt>
                <c:pt idx="873">
                  <c:v>3.0857035642683002</c:v>
                </c:pt>
                <c:pt idx="874">
                  <c:v>2.7015007118423502</c:v>
                </c:pt>
                <c:pt idx="875">
                  <c:v>3.1574849139579699</c:v>
                </c:pt>
                <c:pt idx="876">
                  <c:v>3.3771878051810802</c:v>
                </c:pt>
                <c:pt idx="877">
                  <c:v>3.1668131902848802</c:v>
                </c:pt>
                <c:pt idx="878">
                  <c:v>3.1931064345545201</c:v>
                </c:pt>
                <c:pt idx="879">
                  <c:v>2.9543070895678301</c:v>
                </c:pt>
                <c:pt idx="880">
                  <c:v>3.3192913852842598</c:v>
                </c:pt>
                <c:pt idx="881">
                  <c:v>2.8882264703873801</c:v>
                </c:pt>
                <c:pt idx="882">
                  <c:v>3.1742210806482398</c:v>
                </c:pt>
                <c:pt idx="883">
                  <c:v>3.42833664887144</c:v>
                </c:pt>
                <c:pt idx="884">
                  <c:v>2.9835421116667602</c:v>
                </c:pt>
                <c:pt idx="885">
                  <c:v>2.8186200313324501</c:v>
                </c:pt>
                <c:pt idx="886">
                  <c:v>3.1516051025262</c:v>
                </c:pt>
                <c:pt idx="887">
                  <c:v>3.3719885909865499</c:v>
                </c:pt>
                <c:pt idx="888">
                  <c:v>2.9132203399977401</c:v>
                </c:pt>
                <c:pt idx="889">
                  <c:v>2.9931006934688398</c:v>
                </c:pt>
                <c:pt idx="890">
                  <c:v>2.95793259387619</c:v>
                </c:pt>
                <c:pt idx="891">
                  <c:v>3.4153186037532901</c:v>
                </c:pt>
                <c:pt idx="892">
                  <c:v>3.1664479998338599</c:v>
                </c:pt>
                <c:pt idx="893">
                  <c:v>2.7626483082530999</c:v>
                </c:pt>
                <c:pt idx="894">
                  <c:v>2.7331215715480601</c:v>
                </c:pt>
                <c:pt idx="895">
                  <c:v>1.4904109487459101</c:v>
                </c:pt>
                <c:pt idx="896">
                  <c:v>2.7377475502180801</c:v>
                </c:pt>
                <c:pt idx="897">
                  <c:v>2.9578969822041898</c:v>
                </c:pt>
                <c:pt idx="898">
                  <c:v>2.69327168783362</c:v>
                </c:pt>
                <c:pt idx="899">
                  <c:v>2.6323032146205998</c:v>
                </c:pt>
                <c:pt idx="900">
                  <c:v>3.0828897742536601</c:v>
                </c:pt>
                <c:pt idx="901">
                  <c:v>2.4480182691167398</c:v>
                </c:pt>
                <c:pt idx="902">
                  <c:v>3.0791062907729998</c:v>
                </c:pt>
                <c:pt idx="903">
                  <c:v>3.3270284044775602</c:v>
                </c:pt>
                <c:pt idx="904">
                  <c:v>2.6593401769102201</c:v>
                </c:pt>
                <c:pt idx="905">
                  <c:v>2.5672682229191399</c:v>
                </c:pt>
                <c:pt idx="906">
                  <c:v>2.88743108859533</c:v>
                </c:pt>
                <c:pt idx="907">
                  <c:v>2.90106729369188</c:v>
                </c:pt>
                <c:pt idx="908">
                  <c:v>2.9512619979470398</c:v>
                </c:pt>
                <c:pt idx="909">
                  <c:v>2.18230039133452</c:v>
                </c:pt>
                <c:pt idx="910">
                  <c:v>2.5927937098168399</c:v>
                </c:pt>
                <c:pt idx="911">
                  <c:v>2.7544133845302201</c:v>
                </c:pt>
                <c:pt idx="912">
                  <c:v>2.5879090343719899</c:v>
                </c:pt>
                <c:pt idx="913">
                  <c:v>2.5230185801183</c:v>
                </c:pt>
                <c:pt idx="914">
                  <c:v>2.6594179490814298</c:v>
                </c:pt>
                <c:pt idx="915">
                  <c:v>2.7049783551633899</c:v>
                </c:pt>
                <c:pt idx="916">
                  <c:v>2.8029158001599699</c:v>
                </c:pt>
                <c:pt idx="917">
                  <c:v>2.4147097014872401</c:v>
                </c:pt>
                <c:pt idx="918">
                  <c:v>2.8574450335349999</c:v>
                </c:pt>
                <c:pt idx="919">
                  <c:v>2.60843963945941</c:v>
                </c:pt>
                <c:pt idx="920">
                  <c:v>3.3906337192176799</c:v>
                </c:pt>
                <c:pt idx="921">
                  <c:v>2.4069285820550599</c:v>
                </c:pt>
                <c:pt idx="922">
                  <c:v>2.7054015003018201</c:v>
                </c:pt>
                <c:pt idx="923">
                  <c:v>2.0908995381758002</c:v>
                </c:pt>
                <c:pt idx="924">
                  <c:v>2.7919556749685199</c:v>
                </c:pt>
                <c:pt idx="925">
                  <c:v>2.9079885726672199</c:v>
                </c:pt>
                <c:pt idx="926">
                  <c:v>2.9250991304122902</c:v>
                </c:pt>
                <c:pt idx="927">
                  <c:v>3.0033482332999299</c:v>
                </c:pt>
                <c:pt idx="928">
                  <c:v>3.1607160727791199</c:v>
                </c:pt>
                <c:pt idx="929">
                  <c:v>2.3193132014515099</c:v>
                </c:pt>
                <c:pt idx="930">
                  <c:v>3.21127161340487</c:v>
                </c:pt>
                <c:pt idx="931">
                  <c:v>2.9665047277549301</c:v>
                </c:pt>
                <c:pt idx="932">
                  <c:v>2.4245082659664399</c:v>
                </c:pt>
                <c:pt idx="933">
                  <c:v>2.24732196520447</c:v>
                </c:pt>
                <c:pt idx="934">
                  <c:v>2.9167176406092201</c:v>
                </c:pt>
                <c:pt idx="935">
                  <c:v>3.1634484671060701</c:v>
                </c:pt>
                <c:pt idx="936">
                  <c:v>2.6166004361913302</c:v>
                </c:pt>
                <c:pt idx="937">
                  <c:v>2.82038768918326</c:v>
                </c:pt>
                <c:pt idx="938">
                  <c:v>2.4945552225182701</c:v>
                </c:pt>
                <c:pt idx="939">
                  <c:v>2.5189988777555898</c:v>
                </c:pt>
                <c:pt idx="940">
                  <c:v>2.2887520189853001</c:v>
                </c:pt>
                <c:pt idx="941">
                  <c:v>2.06781886320922</c:v>
                </c:pt>
                <c:pt idx="942">
                  <c:v>2.64460874534468</c:v>
                </c:pt>
                <c:pt idx="943">
                  <c:v>1.7420266529600601</c:v>
                </c:pt>
                <c:pt idx="944">
                  <c:v>1.9344531234180899</c:v>
                </c:pt>
                <c:pt idx="945">
                  <c:v>2.3176448099456999</c:v>
                </c:pt>
                <c:pt idx="946">
                  <c:v>2.6954880304756599</c:v>
                </c:pt>
                <c:pt idx="947">
                  <c:v>2.1240623253190001</c:v>
                </c:pt>
                <c:pt idx="948">
                  <c:v>2.5141658083902398</c:v>
                </c:pt>
                <c:pt idx="949">
                  <c:v>2.3346149106082001</c:v>
                </c:pt>
                <c:pt idx="950">
                  <c:v>2.0102472674607399</c:v>
                </c:pt>
                <c:pt idx="951">
                  <c:v>1.81780409297486</c:v>
                </c:pt>
                <c:pt idx="952">
                  <c:v>2.39764716188715</c:v>
                </c:pt>
                <c:pt idx="953">
                  <c:v>2.74584248112635</c:v>
                </c:pt>
                <c:pt idx="954">
                  <c:v>2.8019840332882699</c:v>
                </c:pt>
                <c:pt idx="955">
                  <c:v>2.7566198120242</c:v>
                </c:pt>
                <c:pt idx="956">
                  <c:v>3.0841536376951399</c:v>
                </c:pt>
                <c:pt idx="957">
                  <c:v>2.09675311412167</c:v>
                </c:pt>
                <c:pt idx="958">
                  <c:v>2.42148521988707</c:v>
                </c:pt>
                <c:pt idx="959">
                  <c:v>1.6192590899160599</c:v>
                </c:pt>
                <c:pt idx="960">
                  <c:v>2.6154426379220101</c:v>
                </c:pt>
                <c:pt idx="961">
                  <c:v>2.1612884093994298</c:v>
                </c:pt>
                <c:pt idx="962">
                  <c:v>2.1547661173020898</c:v>
                </c:pt>
                <c:pt idx="963">
                  <c:v>2.0797932916067801</c:v>
                </c:pt>
                <c:pt idx="964">
                  <c:v>1.7296871300799901</c:v>
                </c:pt>
                <c:pt idx="965">
                  <c:v>2.1835271835220902</c:v>
                </c:pt>
                <c:pt idx="966">
                  <c:v>1.76582083452024</c:v>
                </c:pt>
                <c:pt idx="967">
                  <c:v>1.8381089226909999</c:v>
                </c:pt>
                <c:pt idx="968">
                  <c:v>2.17390574673952</c:v>
                </c:pt>
                <c:pt idx="969">
                  <c:v>1.69822958003306</c:v>
                </c:pt>
                <c:pt idx="970">
                  <c:v>1.5045267394441899</c:v>
                </c:pt>
                <c:pt idx="971">
                  <c:v>1.9246035645961299</c:v>
                </c:pt>
                <c:pt idx="972">
                  <c:v>2.0473423430400199</c:v>
                </c:pt>
                <c:pt idx="973">
                  <c:v>1.80149236764848</c:v>
                </c:pt>
                <c:pt idx="974">
                  <c:v>1.8185757863734</c:v>
                </c:pt>
                <c:pt idx="975">
                  <c:v>1.35274319549001</c:v>
                </c:pt>
                <c:pt idx="976">
                  <c:v>1.41652514877541</c:v>
                </c:pt>
                <c:pt idx="977">
                  <c:v>1.89488525015224</c:v>
                </c:pt>
                <c:pt idx="978">
                  <c:v>2.4190169217353201</c:v>
                </c:pt>
                <c:pt idx="979">
                  <c:v>2.2138564753471699</c:v>
                </c:pt>
                <c:pt idx="980">
                  <c:v>2.0483233367087599</c:v>
                </c:pt>
                <c:pt idx="981">
                  <c:v>1.82103217956242</c:v>
                </c:pt>
                <c:pt idx="982">
                  <c:v>1.33681197795562</c:v>
                </c:pt>
                <c:pt idx="983">
                  <c:v>1.4616373023518501</c:v>
                </c:pt>
                <c:pt idx="984">
                  <c:v>1.7685386716556699</c:v>
                </c:pt>
                <c:pt idx="985">
                  <c:v>1.77464995968779</c:v>
                </c:pt>
                <c:pt idx="986">
                  <c:v>1.5566607880066701</c:v>
                </c:pt>
                <c:pt idx="987">
                  <c:v>1.56607561629641</c:v>
                </c:pt>
                <c:pt idx="988">
                  <c:v>1.4386643370611301</c:v>
                </c:pt>
                <c:pt idx="989">
                  <c:v>1.49895471024539</c:v>
                </c:pt>
                <c:pt idx="990">
                  <c:v>1.8427731564927601</c:v>
                </c:pt>
                <c:pt idx="991">
                  <c:v>1.56568737540783</c:v>
                </c:pt>
                <c:pt idx="992">
                  <c:v>1.33357701238321</c:v>
                </c:pt>
                <c:pt idx="993">
                  <c:v>1.72942868466283</c:v>
                </c:pt>
                <c:pt idx="994">
                  <c:v>2.0353993334827001</c:v>
                </c:pt>
                <c:pt idx="995">
                  <c:v>2.0849256084462202</c:v>
                </c:pt>
                <c:pt idx="996">
                  <c:v>2.0751049402091799</c:v>
                </c:pt>
                <c:pt idx="997">
                  <c:v>2.3354576889263501</c:v>
                </c:pt>
                <c:pt idx="998">
                  <c:v>1.9930899887406399</c:v>
                </c:pt>
                <c:pt idx="999">
                  <c:v>2.0133339504687502</c:v>
                </c:pt>
                <c:pt idx="1000">
                  <c:v>1.8237038434042501</c:v>
                </c:pt>
                <c:pt idx="1001">
                  <c:v>1.9594339380613</c:v>
                </c:pt>
                <c:pt idx="1002">
                  <c:v>1.5672198442290199</c:v>
                </c:pt>
                <c:pt idx="1003">
                  <c:v>1.64035190632114</c:v>
                </c:pt>
                <c:pt idx="1004">
                  <c:v>2.04764521615256</c:v>
                </c:pt>
                <c:pt idx="1005">
                  <c:v>2.1606991252640499</c:v>
                </c:pt>
                <c:pt idx="1006">
                  <c:v>2.35569584832907</c:v>
                </c:pt>
                <c:pt idx="1007">
                  <c:v>2.8094580105575799</c:v>
                </c:pt>
                <c:pt idx="1008">
                  <c:v>2.4076012356983001</c:v>
                </c:pt>
                <c:pt idx="1009">
                  <c:v>2.5744674604161002</c:v>
                </c:pt>
                <c:pt idx="1010">
                  <c:v>2.4583836042144802</c:v>
                </c:pt>
                <c:pt idx="1011">
                  <c:v>2.42667790005865</c:v>
                </c:pt>
                <c:pt idx="1012">
                  <c:v>2.1667533493889302</c:v>
                </c:pt>
                <c:pt idx="1013">
                  <c:v>2.0162404387689401</c:v>
                </c:pt>
                <c:pt idx="1014">
                  <c:v>2.5066561102365399</c:v>
                </c:pt>
                <c:pt idx="1015">
                  <c:v>2.4123494892261301</c:v>
                </c:pt>
                <c:pt idx="1016">
                  <c:v>2.4527212428031602</c:v>
                </c:pt>
                <c:pt idx="1017">
                  <c:v>2.9733031591532502</c:v>
                </c:pt>
                <c:pt idx="1018">
                  <c:v>2.74777980311393</c:v>
                </c:pt>
                <c:pt idx="1019">
                  <c:v>2.66225353903581</c:v>
                </c:pt>
                <c:pt idx="1020">
                  <c:v>3.3375523624525298</c:v>
                </c:pt>
                <c:pt idx="1021">
                  <c:v>2.78092067295389</c:v>
                </c:pt>
                <c:pt idx="1022">
                  <c:v>2.1017545318260198</c:v>
                </c:pt>
                <c:pt idx="1023">
                  <c:v>2.17078298035059</c:v>
                </c:pt>
                <c:pt idx="1024">
                  <c:v>3.3024870164498501</c:v>
                </c:pt>
                <c:pt idx="1025">
                  <c:v>2.8357193443244699</c:v>
                </c:pt>
                <c:pt idx="1026">
                  <c:v>2.1699818328688698</c:v>
                </c:pt>
                <c:pt idx="1027">
                  <c:v>3.2650957840881198</c:v>
                </c:pt>
                <c:pt idx="1028">
                  <c:v>1.8979834911545399</c:v>
                </c:pt>
                <c:pt idx="1029">
                  <c:v>2.46073397921527</c:v>
                </c:pt>
                <c:pt idx="1030">
                  <c:v>2.12054546584945</c:v>
                </c:pt>
                <c:pt idx="1031">
                  <c:v>1.4692927413419301</c:v>
                </c:pt>
                <c:pt idx="1032">
                  <c:v>2.2099275505738101</c:v>
                </c:pt>
                <c:pt idx="1033">
                  <c:v>2.40157198904055</c:v>
                </c:pt>
                <c:pt idx="1034">
                  <c:v>2.6502001226485898</c:v>
                </c:pt>
                <c:pt idx="1035">
                  <c:v>1.9661059134655401</c:v>
                </c:pt>
                <c:pt idx="1036">
                  <c:v>2.3771826704676999</c:v>
                </c:pt>
                <c:pt idx="1037">
                  <c:v>1.60837643651081</c:v>
                </c:pt>
                <c:pt idx="1038">
                  <c:v>2.81413065033765</c:v>
                </c:pt>
                <c:pt idx="1039">
                  <c:v>1.78156114353946</c:v>
                </c:pt>
                <c:pt idx="1040">
                  <c:v>2.5381781998368198</c:v>
                </c:pt>
                <c:pt idx="1041">
                  <c:v>2.1005555975303598</c:v>
                </c:pt>
                <c:pt idx="1042">
                  <c:v>2.5566406215692701</c:v>
                </c:pt>
                <c:pt idx="1043">
                  <c:v>2.2034562819599399</c:v>
                </c:pt>
                <c:pt idx="1044">
                  <c:v>2.1548595968414999</c:v>
                </c:pt>
                <c:pt idx="1045">
                  <c:v>2.43119418249228</c:v>
                </c:pt>
                <c:pt idx="1046">
                  <c:v>1.6733692293042699</c:v>
                </c:pt>
                <c:pt idx="1047">
                  <c:v>2.2763658361488499</c:v>
                </c:pt>
                <c:pt idx="1048">
                  <c:v>2.5006886896723999</c:v>
                </c:pt>
                <c:pt idx="1049">
                  <c:v>3.5655307289286</c:v>
                </c:pt>
                <c:pt idx="1050">
                  <c:v>3.2926574582087902</c:v>
                </c:pt>
                <c:pt idx="1051">
                  <c:v>2.7776453438997</c:v>
                </c:pt>
                <c:pt idx="1052">
                  <c:v>3.08919326351629</c:v>
                </c:pt>
                <c:pt idx="1053">
                  <c:v>3.5517753136956398</c:v>
                </c:pt>
                <c:pt idx="1054">
                  <c:v>1.68176559854659</c:v>
                </c:pt>
                <c:pt idx="1055">
                  <c:v>1.89108071703349</c:v>
                </c:pt>
                <c:pt idx="1056">
                  <c:v>2.38899842840374</c:v>
                </c:pt>
                <c:pt idx="1057">
                  <c:v>1.68808226650402</c:v>
                </c:pt>
                <c:pt idx="1058">
                  <c:v>2.51072016388254</c:v>
                </c:pt>
                <c:pt idx="1059">
                  <c:v>2.1030935035373699</c:v>
                </c:pt>
                <c:pt idx="1060">
                  <c:v>2.0844633312479401</c:v>
                </c:pt>
                <c:pt idx="1061">
                  <c:v>1.9830333842527601</c:v>
                </c:pt>
                <c:pt idx="1062">
                  <c:v>1.87542999458429</c:v>
                </c:pt>
                <c:pt idx="1063">
                  <c:v>1.7203929280230901</c:v>
                </c:pt>
                <c:pt idx="1064">
                  <c:v>2.1165713629102099</c:v>
                </c:pt>
                <c:pt idx="1065">
                  <c:v>2.1406350507220702</c:v>
                </c:pt>
                <c:pt idx="1066">
                  <c:v>2.5876339487863098</c:v>
                </c:pt>
                <c:pt idx="1067">
                  <c:v>1.68612882549226</c:v>
                </c:pt>
                <c:pt idx="1068">
                  <c:v>2.0723257775922601</c:v>
                </c:pt>
                <c:pt idx="1069">
                  <c:v>1.8474417480688201</c:v>
                </c:pt>
                <c:pt idx="1070">
                  <c:v>1.19562705565683</c:v>
                </c:pt>
                <c:pt idx="1071">
                  <c:v>2.01381436675215</c:v>
                </c:pt>
                <c:pt idx="1072">
                  <c:v>2.5807549957867</c:v>
                </c:pt>
                <c:pt idx="1073">
                  <c:v>1.92471359646711</c:v>
                </c:pt>
                <c:pt idx="1074">
                  <c:v>1.7719895896348199</c:v>
                </c:pt>
                <c:pt idx="1075">
                  <c:v>2.2900768574881898</c:v>
                </c:pt>
                <c:pt idx="1076">
                  <c:v>2.5890457651096002</c:v>
                </c:pt>
                <c:pt idx="1077">
                  <c:v>2.1194622474845102</c:v>
                </c:pt>
                <c:pt idx="1078">
                  <c:v>2.4848300005588402</c:v>
                </c:pt>
                <c:pt idx="1079">
                  <c:v>2.28061351257332</c:v>
                </c:pt>
                <c:pt idx="1080">
                  <c:v>2.6238650960016598</c:v>
                </c:pt>
                <c:pt idx="1081">
                  <c:v>2.4162917669789001</c:v>
                </c:pt>
                <c:pt idx="1082">
                  <c:v>2.08551246624936</c:v>
                </c:pt>
                <c:pt idx="1083">
                  <c:v>2.1103554798921298</c:v>
                </c:pt>
                <c:pt idx="1084">
                  <c:v>2.4538599691762899</c:v>
                </c:pt>
                <c:pt idx="1085">
                  <c:v>1.9869047668904301</c:v>
                </c:pt>
                <c:pt idx="1086">
                  <c:v>2.5580980380008498</c:v>
                </c:pt>
                <c:pt idx="1087">
                  <c:v>2.4912027405261901</c:v>
                </c:pt>
                <c:pt idx="1088">
                  <c:v>2.3072005841457499</c:v>
                </c:pt>
                <c:pt idx="1089">
                  <c:v>2.51909911278746</c:v>
                </c:pt>
                <c:pt idx="1090">
                  <c:v>2.1585193810224199</c:v>
                </c:pt>
                <c:pt idx="1091">
                  <c:v>1.9312790225013099</c:v>
                </c:pt>
                <c:pt idx="1092">
                  <c:v>1.2600612377315099</c:v>
                </c:pt>
                <c:pt idx="1093">
                  <c:v>1.62705522942533</c:v>
                </c:pt>
                <c:pt idx="1094">
                  <c:v>1.9113431264981</c:v>
                </c:pt>
                <c:pt idx="1095">
                  <c:v>1.9922534960643601</c:v>
                </c:pt>
                <c:pt idx="1096">
                  <c:v>1.3491963006058101</c:v>
                </c:pt>
                <c:pt idx="1097">
                  <c:v>2.11782744301577</c:v>
                </c:pt>
                <c:pt idx="1098">
                  <c:v>1.9840995409309601</c:v>
                </c:pt>
                <c:pt idx="1099">
                  <c:v>1.81677076934207</c:v>
                </c:pt>
                <c:pt idx="1100">
                  <c:v>1.67863348984212</c:v>
                </c:pt>
                <c:pt idx="1101">
                  <c:v>2.1829296343802902</c:v>
                </c:pt>
                <c:pt idx="1102">
                  <c:v>2.0059041693652899</c:v>
                </c:pt>
                <c:pt idx="1103">
                  <c:v>1.7954203850275301</c:v>
                </c:pt>
                <c:pt idx="1104">
                  <c:v>1.7631365431155499</c:v>
                </c:pt>
                <c:pt idx="1105">
                  <c:v>1.9531425382793299</c:v>
                </c:pt>
                <c:pt idx="1106">
                  <c:v>1.69118232858875</c:v>
                </c:pt>
                <c:pt idx="1107">
                  <c:v>1.5889776346987301</c:v>
                </c:pt>
                <c:pt idx="1108">
                  <c:v>1.81874020328416</c:v>
                </c:pt>
                <c:pt idx="1109">
                  <c:v>1.61289898088086</c:v>
                </c:pt>
                <c:pt idx="1110">
                  <c:v>2.3092783731227602</c:v>
                </c:pt>
                <c:pt idx="1111">
                  <c:v>2.36468720182887</c:v>
                </c:pt>
                <c:pt idx="1112">
                  <c:v>2.0176680592828999</c:v>
                </c:pt>
                <c:pt idx="1113">
                  <c:v>1.5954388291252199</c:v>
                </c:pt>
                <c:pt idx="1114">
                  <c:v>1.96968118009288</c:v>
                </c:pt>
                <c:pt idx="1115">
                  <c:v>2.1109208895900502</c:v>
                </c:pt>
                <c:pt idx="1116">
                  <c:v>1.90302184784116</c:v>
                </c:pt>
                <c:pt idx="1117">
                  <c:v>2.45581771016621</c:v>
                </c:pt>
                <c:pt idx="1118">
                  <c:v>2.1341834161698898</c:v>
                </c:pt>
                <c:pt idx="1119">
                  <c:v>2.0934757064667702</c:v>
                </c:pt>
                <c:pt idx="1120">
                  <c:v>1.8497545594618801</c:v>
                </c:pt>
                <c:pt idx="1121">
                  <c:v>1.93179146852941</c:v>
                </c:pt>
                <c:pt idx="1122">
                  <c:v>1.8378441534011201</c:v>
                </c:pt>
                <c:pt idx="1123">
                  <c:v>1.50890968891134</c:v>
                </c:pt>
                <c:pt idx="1124">
                  <c:v>2.2948452791212901</c:v>
                </c:pt>
                <c:pt idx="1125">
                  <c:v>2.1453331526480102</c:v>
                </c:pt>
                <c:pt idx="1126">
                  <c:v>1.7506901618394799</c:v>
                </c:pt>
                <c:pt idx="1127">
                  <c:v>1.2552993021333201</c:v>
                </c:pt>
                <c:pt idx="1128">
                  <c:v>1.9505477918555401</c:v>
                </c:pt>
                <c:pt idx="1129">
                  <c:v>1.7614339685484299</c:v>
                </c:pt>
                <c:pt idx="1130">
                  <c:v>1.3992018695703601</c:v>
                </c:pt>
                <c:pt idx="1131">
                  <c:v>1.56662587998433</c:v>
                </c:pt>
                <c:pt idx="1132">
                  <c:v>2.3068901343341701</c:v>
                </c:pt>
                <c:pt idx="1133">
                  <c:v>2.3607712609063398</c:v>
                </c:pt>
                <c:pt idx="1134">
                  <c:v>2.63061332997987</c:v>
                </c:pt>
                <c:pt idx="1135">
                  <c:v>2.38237138455235</c:v>
                </c:pt>
                <c:pt idx="1136">
                  <c:v>1.9157664263624301</c:v>
                </c:pt>
                <c:pt idx="1137">
                  <c:v>2.1994166657216998</c:v>
                </c:pt>
                <c:pt idx="1138">
                  <c:v>1.8787944272453301</c:v>
                </c:pt>
                <c:pt idx="1139">
                  <c:v>2.3962156823494101</c:v>
                </c:pt>
                <c:pt idx="1140">
                  <c:v>1.8372756133679999</c:v>
                </c:pt>
                <c:pt idx="1141">
                  <c:v>1.94560359841797</c:v>
                </c:pt>
                <c:pt idx="1142">
                  <c:v>2.59747990508238</c:v>
                </c:pt>
                <c:pt idx="1143">
                  <c:v>2.3843824620487002</c:v>
                </c:pt>
                <c:pt idx="1144">
                  <c:v>2.8915841789566201</c:v>
                </c:pt>
                <c:pt idx="1145">
                  <c:v>1.8221483958020299</c:v>
                </c:pt>
                <c:pt idx="1146">
                  <c:v>2.24735743964969</c:v>
                </c:pt>
                <c:pt idx="1147">
                  <c:v>2.2978593366706201</c:v>
                </c:pt>
                <c:pt idx="1148">
                  <c:v>1.9483566806796699</c:v>
                </c:pt>
                <c:pt idx="1149">
                  <c:v>1.9208606715658101</c:v>
                </c:pt>
                <c:pt idx="1150">
                  <c:v>2.4641537590907401</c:v>
                </c:pt>
                <c:pt idx="1151">
                  <c:v>2.0608130876646</c:v>
                </c:pt>
                <c:pt idx="1152">
                  <c:v>2.4659281253987402</c:v>
                </c:pt>
                <c:pt idx="1153">
                  <c:v>1.7322835099882901</c:v>
                </c:pt>
                <c:pt idx="1154">
                  <c:v>1.9792073496128499</c:v>
                </c:pt>
                <c:pt idx="1155">
                  <c:v>1.9926617420880901</c:v>
                </c:pt>
                <c:pt idx="1156">
                  <c:v>1.9990025140496399</c:v>
                </c:pt>
                <c:pt idx="1157">
                  <c:v>2.1335987374500802</c:v>
                </c:pt>
                <c:pt idx="1158">
                  <c:v>1.9760834834633001</c:v>
                </c:pt>
                <c:pt idx="1159">
                  <c:v>1.81125701895351</c:v>
                </c:pt>
                <c:pt idx="1160">
                  <c:v>1.8585152147552699</c:v>
                </c:pt>
                <c:pt idx="1161">
                  <c:v>1.96847862363778</c:v>
                </c:pt>
                <c:pt idx="1162">
                  <c:v>1.61054544198178</c:v>
                </c:pt>
                <c:pt idx="1163">
                  <c:v>1.6023752300074501</c:v>
                </c:pt>
                <c:pt idx="1164">
                  <c:v>1.48019492733466</c:v>
                </c:pt>
                <c:pt idx="1165">
                  <c:v>2.5896609623055</c:v>
                </c:pt>
                <c:pt idx="1166">
                  <c:v>2.3689950811977201</c:v>
                </c:pt>
                <c:pt idx="1167">
                  <c:v>2.0326907246084498</c:v>
                </c:pt>
                <c:pt idx="1168">
                  <c:v>1.9976396252737401</c:v>
                </c:pt>
                <c:pt idx="1169">
                  <c:v>1.9596545724584999</c:v>
                </c:pt>
                <c:pt idx="1170">
                  <c:v>2.3842006178799799</c:v>
                </c:pt>
                <c:pt idx="1171">
                  <c:v>2.1945912924709501</c:v>
                </c:pt>
                <c:pt idx="1172">
                  <c:v>1.80165754201954</c:v>
                </c:pt>
                <c:pt idx="1173">
                  <c:v>1.9109143092457801</c:v>
                </c:pt>
                <c:pt idx="1174">
                  <c:v>3.0576350455846</c:v>
                </c:pt>
                <c:pt idx="1175">
                  <c:v>2.5199326144297598</c:v>
                </c:pt>
                <c:pt idx="1176">
                  <c:v>2.9612103260325502</c:v>
                </c:pt>
                <c:pt idx="1177">
                  <c:v>2.3288541339087998</c:v>
                </c:pt>
                <c:pt idx="1178">
                  <c:v>1.67500295513785</c:v>
                </c:pt>
                <c:pt idx="1179">
                  <c:v>1.81530469360075</c:v>
                </c:pt>
                <c:pt idx="1180">
                  <c:v>1.71253668661004</c:v>
                </c:pt>
                <c:pt idx="1181">
                  <c:v>2.1195759533791101</c:v>
                </c:pt>
                <c:pt idx="1182">
                  <c:v>2.01917107808341</c:v>
                </c:pt>
                <c:pt idx="1183">
                  <c:v>2.00056508595826</c:v>
                </c:pt>
                <c:pt idx="1184">
                  <c:v>2.3875632776810898</c:v>
                </c:pt>
                <c:pt idx="1185">
                  <c:v>2.03500926276506</c:v>
                </c:pt>
                <c:pt idx="1186">
                  <c:v>2.0945544192378902</c:v>
                </c:pt>
                <c:pt idx="1187">
                  <c:v>2.8633715008833698</c:v>
                </c:pt>
                <c:pt idx="1188">
                  <c:v>2.8641327424377399</c:v>
                </c:pt>
                <c:pt idx="1189">
                  <c:v>2.6496126097533299</c:v>
                </c:pt>
                <c:pt idx="1190">
                  <c:v>2.6882292129767902</c:v>
                </c:pt>
                <c:pt idx="1191">
                  <c:v>2.6982545690730002</c:v>
                </c:pt>
                <c:pt idx="1192">
                  <c:v>2.09874847818736</c:v>
                </c:pt>
                <c:pt idx="1193">
                  <c:v>2.7329313333074898</c:v>
                </c:pt>
                <c:pt idx="1194">
                  <c:v>2.89639003702582</c:v>
                </c:pt>
                <c:pt idx="1195">
                  <c:v>2.9729913126366498</c:v>
                </c:pt>
                <c:pt idx="1196">
                  <c:v>2.7768735744753901</c:v>
                </c:pt>
                <c:pt idx="1197">
                  <c:v>2.4843204622927</c:v>
                </c:pt>
                <c:pt idx="1198">
                  <c:v>3.3533483221152398</c:v>
                </c:pt>
                <c:pt idx="1199">
                  <c:v>3.6230104153689502</c:v>
                </c:pt>
                <c:pt idx="1200">
                  <c:v>2.6982708987186599</c:v>
                </c:pt>
                <c:pt idx="1201">
                  <c:v>3.5025388391919798</c:v>
                </c:pt>
                <c:pt idx="1202">
                  <c:v>3.6675116546191502</c:v>
                </c:pt>
                <c:pt idx="1203">
                  <c:v>3.8286291475098699</c:v>
                </c:pt>
                <c:pt idx="1204">
                  <c:v>3.93481536979486</c:v>
                </c:pt>
                <c:pt idx="1205">
                  <c:v>3.40134158294783</c:v>
                </c:pt>
                <c:pt idx="1206">
                  <c:v>3.6491200829368302</c:v>
                </c:pt>
                <c:pt idx="1207">
                  <c:v>3.9995299694246</c:v>
                </c:pt>
                <c:pt idx="1208">
                  <c:v>4.0513335830213197</c:v>
                </c:pt>
                <c:pt idx="1209">
                  <c:v>3.59797309719489</c:v>
                </c:pt>
                <c:pt idx="1210">
                  <c:v>2.82750381951162</c:v>
                </c:pt>
                <c:pt idx="1211">
                  <c:v>3.3054611350303</c:v>
                </c:pt>
                <c:pt idx="1212">
                  <c:v>3.4679885856501098</c:v>
                </c:pt>
                <c:pt idx="1213">
                  <c:v>2.8735632867131402</c:v>
                </c:pt>
                <c:pt idx="1214">
                  <c:v>3.3477608706465398</c:v>
                </c:pt>
                <c:pt idx="1215">
                  <c:v>3.3386488884177501</c:v>
                </c:pt>
                <c:pt idx="1216">
                  <c:v>3.23022953321244</c:v>
                </c:pt>
                <c:pt idx="1217">
                  <c:v>2.47485126616577</c:v>
                </c:pt>
                <c:pt idx="1218">
                  <c:v>2.6473626225071198</c:v>
                </c:pt>
                <c:pt idx="1219">
                  <c:v>3.1333005019900999</c:v>
                </c:pt>
                <c:pt idx="1220">
                  <c:v>3.50551381660192</c:v>
                </c:pt>
                <c:pt idx="1221">
                  <c:v>2.2210743067202801</c:v>
                </c:pt>
                <c:pt idx="1222">
                  <c:v>2.3967672252697398</c:v>
                </c:pt>
                <c:pt idx="1223">
                  <c:v>2.81171375265723</c:v>
                </c:pt>
                <c:pt idx="1224">
                  <c:v>2.6719227990852201</c:v>
                </c:pt>
                <c:pt idx="1225">
                  <c:v>3.1872892320864499</c:v>
                </c:pt>
                <c:pt idx="1226">
                  <c:v>2.42690333653821</c:v>
                </c:pt>
                <c:pt idx="1227">
                  <c:v>2.0761129539819199</c:v>
                </c:pt>
                <c:pt idx="1228">
                  <c:v>2.1475690134730101</c:v>
                </c:pt>
                <c:pt idx="1229">
                  <c:v>2.7713611709936301</c:v>
                </c:pt>
                <c:pt idx="1230">
                  <c:v>2.5409107910722399</c:v>
                </c:pt>
                <c:pt idx="1231">
                  <c:v>1.9999986924085</c:v>
                </c:pt>
                <c:pt idx="1232">
                  <c:v>2.33808601279426</c:v>
                </c:pt>
                <c:pt idx="1233">
                  <c:v>1.98435905015852</c:v>
                </c:pt>
                <c:pt idx="1234">
                  <c:v>2.1639098555962302</c:v>
                </c:pt>
                <c:pt idx="1235">
                  <c:v>2.42478948970466</c:v>
                </c:pt>
                <c:pt idx="1236">
                  <c:v>2.8201645010320102</c:v>
                </c:pt>
                <c:pt idx="1237">
                  <c:v>2.4665362499574002</c:v>
                </c:pt>
                <c:pt idx="1238">
                  <c:v>3.0848389251674799</c:v>
                </c:pt>
                <c:pt idx="1239">
                  <c:v>3.3318911339310202</c:v>
                </c:pt>
                <c:pt idx="1240">
                  <c:v>3.0489847450717402</c:v>
                </c:pt>
                <c:pt idx="1241">
                  <c:v>3.3136655131913901</c:v>
                </c:pt>
                <c:pt idx="1242">
                  <c:v>3.9515833561635501</c:v>
                </c:pt>
                <c:pt idx="1243">
                  <c:v>4.0553711942114203</c:v>
                </c:pt>
                <c:pt idx="1244">
                  <c:v>3.7697559256619102</c:v>
                </c:pt>
                <c:pt idx="1245">
                  <c:v>3.5662316475078701</c:v>
                </c:pt>
                <c:pt idx="1246">
                  <c:v>3.6117391282972</c:v>
                </c:pt>
                <c:pt idx="1247">
                  <c:v>3.7660192944852402</c:v>
                </c:pt>
                <c:pt idx="1248">
                  <c:v>3.2511409000120901</c:v>
                </c:pt>
                <c:pt idx="1249">
                  <c:v>2.7024268550287398</c:v>
                </c:pt>
                <c:pt idx="1250">
                  <c:v>2.94062040204106</c:v>
                </c:pt>
                <c:pt idx="1251">
                  <c:v>3.2287209066657501</c:v>
                </c:pt>
                <c:pt idx="1252">
                  <c:v>3.0530918142526899</c:v>
                </c:pt>
                <c:pt idx="1253">
                  <c:v>3.0027308372733899</c:v>
                </c:pt>
                <c:pt idx="1254">
                  <c:v>3.0975776290850598</c:v>
                </c:pt>
                <c:pt idx="1255">
                  <c:v>2.6697475175671901</c:v>
                </c:pt>
                <c:pt idx="1256">
                  <c:v>3.2203527051598702</c:v>
                </c:pt>
                <c:pt idx="1257">
                  <c:v>2.7209372866566999</c:v>
                </c:pt>
                <c:pt idx="1258">
                  <c:v>2.4876561341961501</c:v>
                </c:pt>
                <c:pt idx="1259">
                  <c:v>2.1394854028943802</c:v>
                </c:pt>
                <c:pt idx="1260">
                  <c:v>1.71589198586374</c:v>
                </c:pt>
                <c:pt idx="1261">
                  <c:v>1.7878652376005</c:v>
                </c:pt>
                <c:pt idx="1262">
                  <c:v>2.4977874804837499</c:v>
                </c:pt>
                <c:pt idx="1263">
                  <c:v>1.84501636145546</c:v>
                </c:pt>
                <c:pt idx="1264">
                  <c:v>2.4442099925093901</c:v>
                </c:pt>
                <c:pt idx="1265">
                  <c:v>2.8507663078491001</c:v>
                </c:pt>
                <c:pt idx="1266">
                  <c:v>2.3514668257386502</c:v>
                </c:pt>
                <c:pt idx="1267">
                  <c:v>2.6750108082015802</c:v>
                </c:pt>
                <c:pt idx="1268">
                  <c:v>2.4322587288998099</c:v>
                </c:pt>
                <c:pt idx="1269">
                  <c:v>2.49198274398768</c:v>
                </c:pt>
                <c:pt idx="1270">
                  <c:v>1.84821467320251</c:v>
                </c:pt>
                <c:pt idx="1271">
                  <c:v>1.94494227028736</c:v>
                </c:pt>
                <c:pt idx="1272">
                  <c:v>2.1619436220525099</c:v>
                </c:pt>
                <c:pt idx="1273">
                  <c:v>2.0086679542573602</c:v>
                </c:pt>
                <c:pt idx="1274">
                  <c:v>2.8374608449930099</c:v>
                </c:pt>
                <c:pt idx="1275">
                  <c:v>2.4528809970773202</c:v>
                </c:pt>
                <c:pt idx="1276">
                  <c:v>2.2348727379282201</c:v>
                </c:pt>
                <c:pt idx="1277">
                  <c:v>2.3417761557710302</c:v>
                </c:pt>
                <c:pt idx="1278">
                  <c:v>3.4545600018103499</c:v>
                </c:pt>
                <c:pt idx="1279">
                  <c:v>2.3002263911740601</c:v>
                </c:pt>
                <c:pt idx="1280">
                  <c:v>2.0624174731419198</c:v>
                </c:pt>
                <c:pt idx="1281">
                  <c:v>2.2804818780750802</c:v>
                </c:pt>
                <c:pt idx="1282">
                  <c:v>2.1112321904476801</c:v>
                </c:pt>
                <c:pt idx="1283">
                  <c:v>2.1738500855312202</c:v>
                </c:pt>
                <c:pt idx="1284">
                  <c:v>1.86242131368733</c:v>
                </c:pt>
                <c:pt idx="1285">
                  <c:v>1.7549027160159401</c:v>
                </c:pt>
                <c:pt idx="1286">
                  <c:v>1.79226788707299</c:v>
                </c:pt>
                <c:pt idx="1287">
                  <c:v>2.57273817585562</c:v>
                </c:pt>
                <c:pt idx="1288">
                  <c:v>2.6274867997348701</c:v>
                </c:pt>
                <c:pt idx="1289">
                  <c:v>2.3261992825246498</c:v>
                </c:pt>
                <c:pt idx="1290">
                  <c:v>2.7470310526723698</c:v>
                </c:pt>
                <c:pt idx="1291">
                  <c:v>2.9029898939636198</c:v>
                </c:pt>
                <c:pt idx="1292">
                  <c:v>2.9440139732307098</c:v>
                </c:pt>
                <c:pt idx="1293">
                  <c:v>3.1411707706079302</c:v>
                </c:pt>
                <c:pt idx="1294">
                  <c:v>2.4824706268619301</c:v>
                </c:pt>
                <c:pt idx="1295">
                  <c:v>2.1583187333232901</c:v>
                </c:pt>
                <c:pt idx="1296">
                  <c:v>2.36586810658953</c:v>
                </c:pt>
                <c:pt idx="1297">
                  <c:v>2.4130510983609801</c:v>
                </c:pt>
                <c:pt idx="1298">
                  <c:v>2.2102577801382202</c:v>
                </c:pt>
                <c:pt idx="1299">
                  <c:v>2.3910174280558998</c:v>
                </c:pt>
                <c:pt idx="1300">
                  <c:v>2.6453349019131802</c:v>
                </c:pt>
                <c:pt idx="1301">
                  <c:v>2.2097729280401399</c:v>
                </c:pt>
                <c:pt idx="1302">
                  <c:v>2.72778432088481</c:v>
                </c:pt>
                <c:pt idx="1303">
                  <c:v>1.8484930688068699</c:v>
                </c:pt>
                <c:pt idx="1304">
                  <c:v>2.45151515947745</c:v>
                </c:pt>
                <c:pt idx="1305">
                  <c:v>2.5518505887329401</c:v>
                </c:pt>
                <c:pt idx="1306">
                  <c:v>2.7275243838193202</c:v>
                </c:pt>
                <c:pt idx="1307">
                  <c:v>2.58470168114656</c:v>
                </c:pt>
                <c:pt idx="1308">
                  <c:v>2.1579584022776901</c:v>
                </c:pt>
                <c:pt idx="1309">
                  <c:v>2.2289429172404298</c:v>
                </c:pt>
                <c:pt idx="1310">
                  <c:v>2.1123827157013699</c:v>
                </c:pt>
                <c:pt idx="1311">
                  <c:v>2.68909985308209</c:v>
                </c:pt>
                <c:pt idx="1312">
                  <c:v>2.3542715183585199</c:v>
                </c:pt>
                <c:pt idx="1313">
                  <c:v>2.27163809467452</c:v>
                </c:pt>
                <c:pt idx="1314">
                  <c:v>2.2937975318663302</c:v>
                </c:pt>
                <c:pt idx="1315">
                  <c:v>2.0314850232551098</c:v>
                </c:pt>
                <c:pt idx="1316">
                  <c:v>2.13993608288501</c:v>
                </c:pt>
                <c:pt idx="1317">
                  <c:v>2.3517998220794998</c:v>
                </c:pt>
                <c:pt idx="1318">
                  <c:v>1.8525137282963799</c:v>
                </c:pt>
                <c:pt idx="1319">
                  <c:v>1.47819307728454</c:v>
                </c:pt>
                <c:pt idx="1320">
                  <c:v>2.2115255193592902</c:v>
                </c:pt>
                <c:pt idx="1321">
                  <c:v>2.3975241141983998</c:v>
                </c:pt>
                <c:pt idx="1322">
                  <c:v>1.9620988333643301</c:v>
                </c:pt>
                <c:pt idx="1323">
                  <c:v>2.5079811183967702</c:v>
                </c:pt>
                <c:pt idx="1324">
                  <c:v>2.0088723975135601</c:v>
                </c:pt>
                <c:pt idx="1325">
                  <c:v>2.7786524874465401</c:v>
                </c:pt>
                <c:pt idx="1326">
                  <c:v>2.5083311975996798</c:v>
                </c:pt>
                <c:pt idx="1327">
                  <c:v>1.7114815930796401</c:v>
                </c:pt>
                <c:pt idx="1328">
                  <c:v>1.9900227908538499</c:v>
                </c:pt>
                <c:pt idx="1329">
                  <c:v>2.9885991440034099</c:v>
                </c:pt>
                <c:pt idx="1330">
                  <c:v>2.28219164678044</c:v>
                </c:pt>
                <c:pt idx="1331">
                  <c:v>1.9180931586113901</c:v>
                </c:pt>
                <c:pt idx="1332">
                  <c:v>2.6954790108862601</c:v>
                </c:pt>
                <c:pt idx="1333">
                  <c:v>2.3863604675040002</c:v>
                </c:pt>
                <c:pt idx="1334">
                  <c:v>2.6279621929820798</c:v>
                </c:pt>
                <c:pt idx="1335">
                  <c:v>2.7182795252615</c:v>
                </c:pt>
                <c:pt idx="1336">
                  <c:v>2.0077185896775598</c:v>
                </c:pt>
                <c:pt idx="1337">
                  <c:v>1.9157440659195299</c:v>
                </c:pt>
                <c:pt idx="1338">
                  <c:v>2.2483583143629202</c:v>
                </c:pt>
                <c:pt idx="1339">
                  <c:v>2.5081558516926199</c:v>
                </c:pt>
                <c:pt idx="1340">
                  <c:v>2.1646084806771402</c:v>
                </c:pt>
                <c:pt idx="1341">
                  <c:v>2.07384593313038</c:v>
                </c:pt>
                <c:pt idx="1342">
                  <c:v>1.65291245633321</c:v>
                </c:pt>
                <c:pt idx="1343">
                  <c:v>2.2391897399404801</c:v>
                </c:pt>
                <c:pt idx="1344">
                  <c:v>2.4928176865631402</c:v>
                </c:pt>
                <c:pt idx="1345">
                  <c:v>2.57001024251002</c:v>
                </c:pt>
                <c:pt idx="1346">
                  <c:v>2.9351113639978599</c:v>
                </c:pt>
                <c:pt idx="1347">
                  <c:v>2.7173294328561099</c:v>
                </c:pt>
                <c:pt idx="1348">
                  <c:v>2.61760525982679</c:v>
                </c:pt>
                <c:pt idx="1349">
                  <c:v>2.6055139765756001</c:v>
                </c:pt>
                <c:pt idx="1350">
                  <c:v>2.4385694078314701</c:v>
                </c:pt>
                <c:pt idx="1351">
                  <c:v>3.1342000344836598</c:v>
                </c:pt>
                <c:pt idx="1352">
                  <c:v>2.1506016094335401</c:v>
                </c:pt>
                <c:pt idx="1353">
                  <c:v>2.0732301237983801</c:v>
                </c:pt>
                <c:pt idx="1354">
                  <c:v>2.4607782391669</c:v>
                </c:pt>
                <c:pt idx="1355">
                  <c:v>2.4107900735013601</c:v>
                </c:pt>
                <c:pt idx="1356">
                  <c:v>2.6630228925732502</c:v>
                </c:pt>
                <c:pt idx="1357">
                  <c:v>3.0206101095091502</c:v>
                </c:pt>
                <c:pt idx="1358">
                  <c:v>2.7090551714033402</c:v>
                </c:pt>
                <c:pt idx="1359">
                  <c:v>2.77002228806536</c:v>
                </c:pt>
                <c:pt idx="1360">
                  <c:v>3.0172972484098901</c:v>
                </c:pt>
                <c:pt idx="1361">
                  <c:v>2.8554499492940399</c:v>
                </c:pt>
                <c:pt idx="1362">
                  <c:v>3.1728945923618199</c:v>
                </c:pt>
                <c:pt idx="1363">
                  <c:v>2.6316181072810401</c:v>
                </c:pt>
                <c:pt idx="1364">
                  <c:v>2.74823634909023</c:v>
                </c:pt>
                <c:pt idx="1365">
                  <c:v>2.73929825388515</c:v>
                </c:pt>
                <c:pt idx="1366">
                  <c:v>2.3113922644294802</c:v>
                </c:pt>
                <c:pt idx="1367">
                  <c:v>2.92286583945911</c:v>
                </c:pt>
                <c:pt idx="1368">
                  <c:v>3.1008400285650102</c:v>
                </c:pt>
                <c:pt idx="1369">
                  <c:v>2.89274566976537</c:v>
                </c:pt>
                <c:pt idx="1370">
                  <c:v>2.6587942366811399</c:v>
                </c:pt>
                <c:pt idx="1371">
                  <c:v>2.4809559700784698</c:v>
                </c:pt>
                <c:pt idx="1372">
                  <c:v>2.7437088392706999</c:v>
                </c:pt>
                <c:pt idx="1373">
                  <c:v>2.7512443248641998</c:v>
                </c:pt>
                <c:pt idx="1374">
                  <c:v>2.6606407247775001</c:v>
                </c:pt>
                <c:pt idx="1375">
                  <c:v>2.2210950293337302</c:v>
                </c:pt>
                <c:pt idx="1376">
                  <c:v>2.5343861516742701</c:v>
                </c:pt>
                <c:pt idx="1377">
                  <c:v>2.96174637757123</c:v>
                </c:pt>
                <c:pt idx="1378">
                  <c:v>2.8977328233559598</c:v>
                </c:pt>
                <c:pt idx="1379">
                  <c:v>3.4488716238242598</c:v>
                </c:pt>
                <c:pt idx="1380">
                  <c:v>2.7963151051158799</c:v>
                </c:pt>
                <c:pt idx="1381">
                  <c:v>2.8562169319187198</c:v>
                </c:pt>
                <c:pt idx="1382">
                  <c:v>2.4912221289935101</c:v>
                </c:pt>
                <c:pt idx="1383">
                  <c:v>2.5988246508283801</c:v>
                </c:pt>
                <c:pt idx="1384">
                  <c:v>2.44402443542924</c:v>
                </c:pt>
                <c:pt idx="1385">
                  <c:v>3.22351861715567</c:v>
                </c:pt>
                <c:pt idx="1386">
                  <c:v>2.5284115371257401</c:v>
                </c:pt>
                <c:pt idx="1387">
                  <c:v>2.62121205109234</c:v>
                </c:pt>
                <c:pt idx="1388">
                  <c:v>2.7400778992521202</c:v>
                </c:pt>
                <c:pt idx="1389">
                  <c:v>2.96270856363265</c:v>
                </c:pt>
                <c:pt idx="1390">
                  <c:v>3.3108467551602101</c:v>
                </c:pt>
                <c:pt idx="1391">
                  <c:v>3.0037497427793198</c:v>
                </c:pt>
                <c:pt idx="1392">
                  <c:v>2.4135942140974702</c:v>
                </c:pt>
                <c:pt idx="1393">
                  <c:v>2.9702966129666302</c:v>
                </c:pt>
                <c:pt idx="1394">
                  <c:v>2.6334226649267198</c:v>
                </c:pt>
                <c:pt idx="1395">
                  <c:v>3.2955111628799001</c:v>
                </c:pt>
                <c:pt idx="1396">
                  <c:v>3.1341978710468101</c:v>
                </c:pt>
                <c:pt idx="1397">
                  <c:v>3.4510895130753898</c:v>
                </c:pt>
                <c:pt idx="1398">
                  <c:v>4.0480983931522196</c:v>
                </c:pt>
                <c:pt idx="1399">
                  <c:v>3.4464333729233401</c:v>
                </c:pt>
                <c:pt idx="1400">
                  <c:v>3.86769070496194</c:v>
                </c:pt>
                <c:pt idx="1401">
                  <c:v>3.6120283801226298</c:v>
                </c:pt>
                <c:pt idx="1402">
                  <c:v>4.3071759757563903</c:v>
                </c:pt>
                <c:pt idx="1403">
                  <c:v>4.4033857729634001</c:v>
                </c:pt>
                <c:pt idx="1404">
                  <c:v>4.1970824261815398</c:v>
                </c:pt>
                <c:pt idx="1405">
                  <c:v>4.27053364682964</c:v>
                </c:pt>
                <c:pt idx="1406">
                  <c:v>3.7368724134033</c:v>
                </c:pt>
                <c:pt idx="1407">
                  <c:v>3.6115180062518699</c:v>
                </c:pt>
                <c:pt idx="1408">
                  <c:v>4.7149809168947003</c:v>
                </c:pt>
                <c:pt idx="1409">
                  <c:v>3.7135550612807502</c:v>
                </c:pt>
                <c:pt idx="1410">
                  <c:v>3.68859504213532</c:v>
                </c:pt>
                <c:pt idx="1411">
                  <c:v>3.78284421644413</c:v>
                </c:pt>
                <c:pt idx="1412">
                  <c:v>4.1377429575109597</c:v>
                </c:pt>
                <c:pt idx="1413">
                  <c:v>3.58739728892514</c:v>
                </c:pt>
                <c:pt idx="1414">
                  <c:v>3.8574298646890601</c:v>
                </c:pt>
                <c:pt idx="1415">
                  <c:v>3.7876756445467401</c:v>
                </c:pt>
                <c:pt idx="1416">
                  <c:v>3.2331797322987801</c:v>
                </c:pt>
                <c:pt idx="1417">
                  <c:v>3.6717926712713802</c:v>
                </c:pt>
                <c:pt idx="1418">
                  <c:v>4.1709722890394696</c:v>
                </c:pt>
                <c:pt idx="1419">
                  <c:v>4.3415501249854502</c:v>
                </c:pt>
                <c:pt idx="1420">
                  <c:v>3.53641594037911</c:v>
                </c:pt>
                <c:pt idx="1421">
                  <c:v>2.9908478298907299</c:v>
                </c:pt>
                <c:pt idx="1422">
                  <c:v>2.80345796281977</c:v>
                </c:pt>
                <c:pt idx="1423">
                  <c:v>2.1897592008268401</c:v>
                </c:pt>
                <c:pt idx="1424">
                  <c:v>3.5880813682939099</c:v>
                </c:pt>
                <c:pt idx="1425">
                  <c:v>2.2825230898277802</c:v>
                </c:pt>
                <c:pt idx="1426">
                  <c:v>2.99240183740037</c:v>
                </c:pt>
                <c:pt idx="1427">
                  <c:v>2.67537141911163</c:v>
                </c:pt>
                <c:pt idx="1428">
                  <c:v>2.1929160479253098</c:v>
                </c:pt>
                <c:pt idx="1429">
                  <c:v>3.1801913501611798</c:v>
                </c:pt>
                <c:pt idx="1430">
                  <c:v>2.6461505002896399</c:v>
                </c:pt>
                <c:pt idx="1431">
                  <c:v>2.9073047766803399</c:v>
                </c:pt>
                <c:pt idx="1432">
                  <c:v>2.82016211729883</c:v>
                </c:pt>
                <c:pt idx="1433">
                  <c:v>2.9361361711694598</c:v>
                </c:pt>
                <c:pt idx="1434">
                  <c:v>2.7622420901256999</c:v>
                </c:pt>
                <c:pt idx="1435">
                  <c:v>2.8958437354918098</c:v>
                </c:pt>
                <c:pt idx="1436">
                  <c:v>2.68624679753774</c:v>
                </c:pt>
                <c:pt idx="1437">
                  <c:v>2.7512156768470502</c:v>
                </c:pt>
                <c:pt idx="1438">
                  <c:v>2.8284470816272602</c:v>
                </c:pt>
                <c:pt idx="1439">
                  <c:v>2.4916364055999001</c:v>
                </c:pt>
                <c:pt idx="1440">
                  <c:v>2.8267138489626999</c:v>
                </c:pt>
                <c:pt idx="1441">
                  <c:v>2.6080196585711199</c:v>
                </c:pt>
                <c:pt idx="1442">
                  <c:v>1.8656953836438801</c:v>
                </c:pt>
                <c:pt idx="1443">
                  <c:v>2.6142003035834498</c:v>
                </c:pt>
                <c:pt idx="1444">
                  <c:v>1.96408296125219</c:v>
                </c:pt>
                <c:pt idx="1445">
                  <c:v>1.54759693235697</c:v>
                </c:pt>
                <c:pt idx="1446">
                  <c:v>1.78326153310596</c:v>
                </c:pt>
                <c:pt idx="1447">
                  <c:v>1.7987057083850899</c:v>
                </c:pt>
                <c:pt idx="1448">
                  <c:v>1.07625186636946</c:v>
                </c:pt>
                <c:pt idx="1449">
                  <c:v>1.79584571044837</c:v>
                </c:pt>
                <c:pt idx="1450">
                  <c:v>2.6343797003564902</c:v>
                </c:pt>
                <c:pt idx="1451">
                  <c:v>2.2811700030983002</c:v>
                </c:pt>
                <c:pt idx="1452">
                  <c:v>2.9008928184125802</c:v>
                </c:pt>
                <c:pt idx="1453">
                  <c:v>2.3884330103504601</c:v>
                </c:pt>
                <c:pt idx="1454">
                  <c:v>2.3969136088196898</c:v>
                </c:pt>
                <c:pt idx="1455">
                  <c:v>1.40734977820298</c:v>
                </c:pt>
                <c:pt idx="1456">
                  <c:v>2.1516658771712098</c:v>
                </c:pt>
                <c:pt idx="1457">
                  <c:v>2.20945825697736</c:v>
                </c:pt>
                <c:pt idx="1458">
                  <c:v>2.3570847282925902</c:v>
                </c:pt>
                <c:pt idx="1459">
                  <c:v>2.5971254018713301</c:v>
                </c:pt>
                <c:pt idx="1460">
                  <c:v>2.6410618691447199</c:v>
                </c:pt>
                <c:pt idx="1461">
                  <c:v>2.5618661957712798</c:v>
                </c:pt>
                <c:pt idx="1462">
                  <c:v>2.9002054400654198</c:v>
                </c:pt>
                <c:pt idx="1463">
                  <c:v>2.0979712110630899</c:v>
                </c:pt>
                <c:pt idx="1464">
                  <c:v>2.3207076933957498</c:v>
                </c:pt>
                <c:pt idx="1465">
                  <c:v>2.1135529599368801</c:v>
                </c:pt>
                <c:pt idx="1466">
                  <c:v>2.01947344810478</c:v>
                </c:pt>
                <c:pt idx="1467">
                  <c:v>1.4836651804613401</c:v>
                </c:pt>
                <c:pt idx="1468">
                  <c:v>2.3626873700033801</c:v>
                </c:pt>
                <c:pt idx="1469">
                  <c:v>2.0758169049184101</c:v>
                </c:pt>
                <c:pt idx="1470">
                  <c:v>2.8531293373934701</c:v>
                </c:pt>
                <c:pt idx="1471">
                  <c:v>1.9855041862473799</c:v>
                </c:pt>
                <c:pt idx="1472">
                  <c:v>1.74351039273222</c:v>
                </c:pt>
                <c:pt idx="1473">
                  <c:v>1.7545407224174301</c:v>
                </c:pt>
                <c:pt idx="1474">
                  <c:v>1.9059421351013299</c:v>
                </c:pt>
                <c:pt idx="1475">
                  <c:v>2.13794595391506</c:v>
                </c:pt>
                <c:pt idx="1476">
                  <c:v>1.65456332154938</c:v>
                </c:pt>
                <c:pt idx="1477">
                  <c:v>2.4225433046454898</c:v>
                </c:pt>
                <c:pt idx="1478">
                  <c:v>2.30539962861697</c:v>
                </c:pt>
                <c:pt idx="1479">
                  <c:v>2.0716595350943101</c:v>
                </c:pt>
                <c:pt idx="1480">
                  <c:v>2.3015035889562601</c:v>
                </c:pt>
                <c:pt idx="1481">
                  <c:v>1.71596856335513</c:v>
                </c:pt>
                <c:pt idx="1482">
                  <c:v>2.2794076609782601</c:v>
                </c:pt>
                <c:pt idx="1483">
                  <c:v>1.5543201158776601</c:v>
                </c:pt>
                <c:pt idx="1484">
                  <c:v>2.2671619771539699</c:v>
                </c:pt>
                <c:pt idx="1485">
                  <c:v>1.8627811650578601</c:v>
                </c:pt>
                <c:pt idx="1486">
                  <c:v>1.7303972946392701</c:v>
                </c:pt>
                <c:pt idx="1487">
                  <c:v>1.72052775825731</c:v>
                </c:pt>
                <c:pt idx="1488">
                  <c:v>1.9753389453747601</c:v>
                </c:pt>
                <c:pt idx="1489">
                  <c:v>2.2787653893384801</c:v>
                </c:pt>
                <c:pt idx="1490">
                  <c:v>2.26734036511575</c:v>
                </c:pt>
                <c:pt idx="1491">
                  <c:v>2.0826406022339401</c:v>
                </c:pt>
                <c:pt idx="1492">
                  <c:v>2.3528108823131699</c:v>
                </c:pt>
                <c:pt idx="1493">
                  <c:v>1.71310611152627</c:v>
                </c:pt>
                <c:pt idx="1494">
                  <c:v>1.9873710251846399</c:v>
                </c:pt>
                <c:pt idx="1495">
                  <c:v>2.2472089350517299</c:v>
                </c:pt>
                <c:pt idx="1496">
                  <c:v>2.3283610086775299</c:v>
                </c:pt>
                <c:pt idx="1497">
                  <c:v>2.32330329522176</c:v>
                </c:pt>
                <c:pt idx="1498">
                  <c:v>1.90053650336653</c:v>
                </c:pt>
                <c:pt idx="1499">
                  <c:v>2.3582782601600898</c:v>
                </c:pt>
                <c:pt idx="1500">
                  <c:v>1.79425633352847</c:v>
                </c:pt>
                <c:pt idx="1501">
                  <c:v>1.5856009920063201</c:v>
                </c:pt>
                <c:pt idx="1502">
                  <c:v>1.9963161540749099</c:v>
                </c:pt>
                <c:pt idx="1503">
                  <c:v>2.09999612141671</c:v>
                </c:pt>
                <c:pt idx="1504">
                  <c:v>2.0817495011729799</c:v>
                </c:pt>
                <c:pt idx="1505">
                  <c:v>2.0704717292154098</c:v>
                </c:pt>
                <c:pt idx="1506">
                  <c:v>1.86961967970996</c:v>
                </c:pt>
                <c:pt idx="1507">
                  <c:v>2.44391051764226</c:v>
                </c:pt>
                <c:pt idx="1508">
                  <c:v>1.7791606795294701</c:v>
                </c:pt>
                <c:pt idx="1509">
                  <c:v>1.71656813343343</c:v>
                </c:pt>
                <c:pt idx="1510">
                  <c:v>2.1157963413637302</c:v>
                </c:pt>
                <c:pt idx="1511">
                  <c:v>2.1516116721476499</c:v>
                </c:pt>
                <c:pt idx="1512">
                  <c:v>2.1040360959591502</c:v>
                </c:pt>
                <c:pt idx="1513">
                  <c:v>1.79781520496926</c:v>
                </c:pt>
                <c:pt idx="1514">
                  <c:v>2.38277639438589</c:v>
                </c:pt>
                <c:pt idx="1515">
                  <c:v>2.0764565211966999</c:v>
                </c:pt>
                <c:pt idx="1516">
                  <c:v>2.1805991844547301</c:v>
                </c:pt>
                <c:pt idx="1517">
                  <c:v>1.9591572614771799</c:v>
                </c:pt>
                <c:pt idx="1518">
                  <c:v>1.84755964113967</c:v>
                </c:pt>
                <c:pt idx="1519">
                  <c:v>1.31676297471287</c:v>
                </c:pt>
                <c:pt idx="1520">
                  <c:v>1.3919872142607499</c:v>
                </c:pt>
                <c:pt idx="1521">
                  <c:v>1.3549715483205</c:v>
                </c:pt>
                <c:pt idx="1522">
                  <c:v>2.2455158609584398</c:v>
                </c:pt>
                <c:pt idx="1523">
                  <c:v>1.9286805978077499</c:v>
                </c:pt>
                <c:pt idx="1524">
                  <c:v>2.0701921715948002</c:v>
                </c:pt>
                <c:pt idx="1525">
                  <c:v>1.94153953501855</c:v>
                </c:pt>
                <c:pt idx="1526">
                  <c:v>2.1150430525002699</c:v>
                </c:pt>
                <c:pt idx="1527">
                  <c:v>2.0951633127921201</c:v>
                </c:pt>
                <c:pt idx="1528">
                  <c:v>2.04134519520177</c:v>
                </c:pt>
                <c:pt idx="1529">
                  <c:v>1.72797302105963</c:v>
                </c:pt>
                <c:pt idx="1530">
                  <c:v>2.0361577432523701</c:v>
                </c:pt>
                <c:pt idx="1531">
                  <c:v>1.4278716670334399</c:v>
                </c:pt>
                <c:pt idx="1532">
                  <c:v>1.76494893238984</c:v>
                </c:pt>
                <c:pt idx="1533">
                  <c:v>1.8840220469768001</c:v>
                </c:pt>
                <c:pt idx="1534">
                  <c:v>2.07997782322659</c:v>
                </c:pt>
                <c:pt idx="1535">
                  <c:v>1.85139614587093</c:v>
                </c:pt>
                <c:pt idx="1536">
                  <c:v>2.4778296862192302</c:v>
                </c:pt>
                <c:pt idx="1537">
                  <c:v>2.6817834660341902</c:v>
                </c:pt>
                <c:pt idx="1538">
                  <c:v>2.0456969648872998</c:v>
                </c:pt>
                <c:pt idx="1539">
                  <c:v>2.1581364846985398</c:v>
                </c:pt>
                <c:pt idx="1540">
                  <c:v>2.40618900571023</c:v>
                </c:pt>
                <c:pt idx="1541">
                  <c:v>1.60295989660861</c:v>
                </c:pt>
                <c:pt idx="1542">
                  <c:v>1.8223677997494001</c:v>
                </c:pt>
                <c:pt idx="1543">
                  <c:v>2.2018746279550001</c:v>
                </c:pt>
                <c:pt idx="1544">
                  <c:v>2.0160468906756099</c:v>
                </c:pt>
                <c:pt idx="1545">
                  <c:v>2.0941364784090402</c:v>
                </c:pt>
                <c:pt idx="1546">
                  <c:v>2.01342643268086</c:v>
                </c:pt>
                <c:pt idx="1547">
                  <c:v>1.80615082764452</c:v>
                </c:pt>
                <c:pt idx="1548">
                  <c:v>2.2158019347330802</c:v>
                </c:pt>
                <c:pt idx="1549">
                  <c:v>2.1376999550414202</c:v>
                </c:pt>
                <c:pt idx="1550">
                  <c:v>2.0763324734286801</c:v>
                </c:pt>
                <c:pt idx="1551">
                  <c:v>2.4047365537449701</c:v>
                </c:pt>
                <c:pt idx="1552">
                  <c:v>0.98367294047731502</c:v>
                </c:pt>
                <c:pt idx="1553">
                  <c:v>2.1969137254375699</c:v>
                </c:pt>
                <c:pt idx="1554">
                  <c:v>2.1720646141902802</c:v>
                </c:pt>
                <c:pt idx="1555">
                  <c:v>2.3501301665053802</c:v>
                </c:pt>
                <c:pt idx="1556">
                  <c:v>2.1757213148984902</c:v>
                </c:pt>
                <c:pt idx="1557">
                  <c:v>2.1160974609718499</c:v>
                </c:pt>
                <c:pt idx="1558">
                  <c:v>2.3004102341774502</c:v>
                </c:pt>
                <c:pt idx="1559">
                  <c:v>1.7060137689232799</c:v>
                </c:pt>
                <c:pt idx="1560">
                  <c:v>1.58984111885098</c:v>
                </c:pt>
                <c:pt idx="1561">
                  <c:v>2.1009208072273902</c:v>
                </c:pt>
                <c:pt idx="1562">
                  <c:v>1.86915575836499</c:v>
                </c:pt>
                <c:pt idx="1563">
                  <c:v>1.7756883344020999</c:v>
                </c:pt>
                <c:pt idx="1564">
                  <c:v>1.5114842061418801</c:v>
                </c:pt>
                <c:pt idx="1565">
                  <c:v>1.88306643095614</c:v>
                </c:pt>
                <c:pt idx="1566">
                  <c:v>1.8760254941605601</c:v>
                </c:pt>
                <c:pt idx="1567">
                  <c:v>1.46046708517457</c:v>
                </c:pt>
                <c:pt idx="1568">
                  <c:v>1.7756415275633299</c:v>
                </c:pt>
                <c:pt idx="1569">
                  <c:v>2.2937843145660799</c:v>
                </c:pt>
                <c:pt idx="1570">
                  <c:v>1.7853264860423499</c:v>
                </c:pt>
                <c:pt idx="1571">
                  <c:v>1.7769758380181899</c:v>
                </c:pt>
                <c:pt idx="1572">
                  <c:v>2.1619609194132399</c:v>
                </c:pt>
                <c:pt idx="1573">
                  <c:v>2.19154804933377</c:v>
                </c:pt>
                <c:pt idx="1574">
                  <c:v>2.2160748126475398</c:v>
                </c:pt>
                <c:pt idx="1575">
                  <c:v>1.98789125080611</c:v>
                </c:pt>
                <c:pt idx="1576">
                  <c:v>2.0722361600351999</c:v>
                </c:pt>
                <c:pt idx="1577">
                  <c:v>2.0352613564996398</c:v>
                </c:pt>
                <c:pt idx="1578">
                  <c:v>2.2449564764494299</c:v>
                </c:pt>
                <c:pt idx="1579">
                  <c:v>2.6391991229456502</c:v>
                </c:pt>
                <c:pt idx="1580">
                  <c:v>1.8822578757284201</c:v>
                </c:pt>
                <c:pt idx="1581">
                  <c:v>2.59915254073118</c:v>
                </c:pt>
                <c:pt idx="1582">
                  <c:v>2.0469404881352098</c:v>
                </c:pt>
                <c:pt idx="1583">
                  <c:v>2.0748219159139598</c:v>
                </c:pt>
                <c:pt idx="1584">
                  <c:v>1.82639776315241</c:v>
                </c:pt>
                <c:pt idx="1585">
                  <c:v>2.0779190614969698</c:v>
                </c:pt>
                <c:pt idx="1586">
                  <c:v>2.7727333904767302</c:v>
                </c:pt>
                <c:pt idx="1587">
                  <c:v>1.9803499339247099</c:v>
                </c:pt>
                <c:pt idx="1588">
                  <c:v>2.21961402690612</c:v>
                </c:pt>
                <c:pt idx="1589">
                  <c:v>1.8157845301057201</c:v>
                </c:pt>
                <c:pt idx="1590">
                  <c:v>2.3690158429693202</c:v>
                </c:pt>
                <c:pt idx="1591">
                  <c:v>2.0747325827260998</c:v>
                </c:pt>
                <c:pt idx="1592">
                  <c:v>2.5604110757092702</c:v>
                </c:pt>
                <c:pt idx="1593">
                  <c:v>2.4875922186944801</c:v>
                </c:pt>
                <c:pt idx="1594">
                  <c:v>2.58482518369728</c:v>
                </c:pt>
                <c:pt idx="1595">
                  <c:v>2.6816722422061101</c:v>
                </c:pt>
                <c:pt idx="1596">
                  <c:v>2.50721545909663</c:v>
                </c:pt>
                <c:pt idx="1597">
                  <c:v>1.92447771419558</c:v>
                </c:pt>
                <c:pt idx="1598">
                  <c:v>2.5113222578262699</c:v>
                </c:pt>
                <c:pt idx="1599">
                  <c:v>2.6015953136681702</c:v>
                </c:pt>
                <c:pt idx="1600">
                  <c:v>2.5457169998853</c:v>
                </c:pt>
                <c:pt idx="1601">
                  <c:v>2.1215018892942701</c:v>
                </c:pt>
                <c:pt idx="1602">
                  <c:v>2.1812032936012198</c:v>
                </c:pt>
                <c:pt idx="1603">
                  <c:v>2.0548782182862801</c:v>
                </c:pt>
                <c:pt idx="1604">
                  <c:v>2.3595215826266598</c:v>
                </c:pt>
                <c:pt idx="1605">
                  <c:v>2.8522116961458899</c:v>
                </c:pt>
                <c:pt idx="1606">
                  <c:v>2.4082934617693299</c:v>
                </c:pt>
                <c:pt idx="1607">
                  <c:v>2.4152439174665399</c:v>
                </c:pt>
                <c:pt idx="1608">
                  <c:v>2.25306834783474</c:v>
                </c:pt>
                <c:pt idx="1609">
                  <c:v>1.9514375786642599</c:v>
                </c:pt>
                <c:pt idx="1610">
                  <c:v>2.7166760312433298</c:v>
                </c:pt>
                <c:pt idx="1611">
                  <c:v>2.52001682826717</c:v>
                </c:pt>
                <c:pt idx="1612">
                  <c:v>2.5491330733617801</c:v>
                </c:pt>
                <c:pt idx="1613">
                  <c:v>2.40526131524526</c:v>
                </c:pt>
                <c:pt idx="1614">
                  <c:v>2.1925780320352599</c:v>
                </c:pt>
                <c:pt idx="1615">
                  <c:v>2.66339971129567</c:v>
                </c:pt>
                <c:pt idx="1616">
                  <c:v>2.5515442701318101</c:v>
                </c:pt>
                <c:pt idx="1617">
                  <c:v>3.0530852224967102</c:v>
                </c:pt>
                <c:pt idx="1618">
                  <c:v>2.9360821476301799</c:v>
                </c:pt>
                <c:pt idx="1619">
                  <c:v>2.3379216890597898</c:v>
                </c:pt>
                <c:pt idx="1620">
                  <c:v>1.89509446793935</c:v>
                </c:pt>
                <c:pt idx="1621">
                  <c:v>2.4349160659040101</c:v>
                </c:pt>
                <c:pt idx="1622">
                  <c:v>2.82617140337676</c:v>
                </c:pt>
                <c:pt idx="1623">
                  <c:v>2.2161568008066999</c:v>
                </c:pt>
                <c:pt idx="1624">
                  <c:v>2.48698648248849</c:v>
                </c:pt>
                <c:pt idx="1625">
                  <c:v>2.22909008151034</c:v>
                </c:pt>
                <c:pt idx="1626">
                  <c:v>2.8148364165065098</c:v>
                </c:pt>
                <c:pt idx="1627">
                  <c:v>2.4023409369027302</c:v>
                </c:pt>
                <c:pt idx="1628">
                  <c:v>1.99998776328199</c:v>
                </c:pt>
                <c:pt idx="1629">
                  <c:v>2.1173175781303502</c:v>
                </c:pt>
                <c:pt idx="1630">
                  <c:v>2.6870964161729098</c:v>
                </c:pt>
                <c:pt idx="1631">
                  <c:v>2.4087765576240101</c:v>
                </c:pt>
                <c:pt idx="1632">
                  <c:v>1.64326396178107</c:v>
                </c:pt>
                <c:pt idx="1633">
                  <c:v>2.5495436916996002</c:v>
                </c:pt>
                <c:pt idx="1634">
                  <c:v>2.1233326495384999</c:v>
                </c:pt>
                <c:pt idx="1635">
                  <c:v>2.3624922186942601</c:v>
                </c:pt>
                <c:pt idx="1636">
                  <c:v>2.06027502967257</c:v>
                </c:pt>
                <c:pt idx="1637">
                  <c:v>2.5602938448661101</c:v>
                </c:pt>
                <c:pt idx="1638">
                  <c:v>2.3838894143513301</c:v>
                </c:pt>
                <c:pt idx="1639">
                  <c:v>2.0911771028819399</c:v>
                </c:pt>
                <c:pt idx="1640">
                  <c:v>2.3481968165643101</c:v>
                </c:pt>
                <c:pt idx="1641">
                  <c:v>3.0284685840961099</c:v>
                </c:pt>
                <c:pt idx="1642">
                  <c:v>2.7110011347774199</c:v>
                </c:pt>
                <c:pt idx="1643">
                  <c:v>2.36271545397799</c:v>
                </c:pt>
                <c:pt idx="1644">
                  <c:v>2.5876240653149498</c:v>
                </c:pt>
                <c:pt idx="1645">
                  <c:v>2.69164026645233</c:v>
                </c:pt>
                <c:pt idx="1646">
                  <c:v>2.73879342145593</c:v>
                </c:pt>
                <c:pt idx="1647">
                  <c:v>2.7621735578206801</c:v>
                </c:pt>
                <c:pt idx="1648">
                  <c:v>2.4839872238562002</c:v>
                </c:pt>
                <c:pt idx="1649">
                  <c:v>2.7129574138892698</c:v>
                </c:pt>
                <c:pt idx="1650">
                  <c:v>2.0712177622813401</c:v>
                </c:pt>
                <c:pt idx="1651">
                  <c:v>2.31458291934833</c:v>
                </c:pt>
                <c:pt idx="1652">
                  <c:v>2.39577832682411</c:v>
                </c:pt>
                <c:pt idx="1653">
                  <c:v>2.7681083334482102</c:v>
                </c:pt>
                <c:pt idx="1654">
                  <c:v>1.9182361673417601</c:v>
                </c:pt>
                <c:pt idx="1655">
                  <c:v>2.30707980184697</c:v>
                </c:pt>
                <c:pt idx="1656">
                  <c:v>2.2357335140340102</c:v>
                </c:pt>
                <c:pt idx="1657">
                  <c:v>3.06705796944193</c:v>
                </c:pt>
                <c:pt idx="1658">
                  <c:v>2.3839407858768902</c:v>
                </c:pt>
                <c:pt idx="1659">
                  <c:v>2.1027583443720399</c:v>
                </c:pt>
                <c:pt idx="1660">
                  <c:v>2.02871709775135</c:v>
                </c:pt>
                <c:pt idx="1661">
                  <c:v>2.2675171019573899</c:v>
                </c:pt>
                <c:pt idx="1662">
                  <c:v>1.8900543195856101</c:v>
                </c:pt>
                <c:pt idx="1663">
                  <c:v>1.8850661612733099</c:v>
                </c:pt>
                <c:pt idx="1664">
                  <c:v>1.81039955048178</c:v>
                </c:pt>
                <c:pt idx="1665">
                  <c:v>1.9436538141802799</c:v>
                </c:pt>
                <c:pt idx="1666">
                  <c:v>1.80974599258738</c:v>
                </c:pt>
                <c:pt idx="1667">
                  <c:v>2.3226501731423301</c:v>
                </c:pt>
                <c:pt idx="1668">
                  <c:v>2.3408436172679301</c:v>
                </c:pt>
                <c:pt idx="1669">
                  <c:v>2.1070992532780601</c:v>
                </c:pt>
                <c:pt idx="1670">
                  <c:v>1.7434932854713401</c:v>
                </c:pt>
                <c:pt idx="1671">
                  <c:v>2.2622337086289401</c:v>
                </c:pt>
                <c:pt idx="1672">
                  <c:v>1.8857899187440901</c:v>
                </c:pt>
                <c:pt idx="1673">
                  <c:v>2.3005932862373601</c:v>
                </c:pt>
                <c:pt idx="1674">
                  <c:v>2.2760888530387402</c:v>
                </c:pt>
                <c:pt idx="1675">
                  <c:v>1.9778851182902399</c:v>
                </c:pt>
                <c:pt idx="1676">
                  <c:v>2.0297953834821398</c:v>
                </c:pt>
                <c:pt idx="1677">
                  <c:v>2.57287903235411</c:v>
                </c:pt>
                <c:pt idx="1678">
                  <c:v>2.3495682381043701</c:v>
                </c:pt>
                <c:pt idx="1679">
                  <c:v>2.0749056201087699</c:v>
                </c:pt>
                <c:pt idx="1680">
                  <c:v>2.2143354583327901</c:v>
                </c:pt>
                <c:pt idx="1681">
                  <c:v>2.0534273156906799</c:v>
                </c:pt>
                <c:pt idx="1682">
                  <c:v>2.0211322320555798</c:v>
                </c:pt>
                <c:pt idx="1683">
                  <c:v>2.1232017642577601</c:v>
                </c:pt>
                <c:pt idx="1684">
                  <c:v>1.8699099177957299</c:v>
                </c:pt>
                <c:pt idx="1685">
                  <c:v>2.3837688568846001</c:v>
                </c:pt>
                <c:pt idx="1686">
                  <c:v>2.5376264472893699</c:v>
                </c:pt>
                <c:pt idx="1687">
                  <c:v>2.3570360839008901</c:v>
                </c:pt>
                <c:pt idx="1688">
                  <c:v>2.1866675892553098</c:v>
                </c:pt>
                <c:pt idx="1689">
                  <c:v>2.0526263930146502</c:v>
                </c:pt>
                <c:pt idx="1690">
                  <c:v>2.0805656627657898</c:v>
                </c:pt>
                <c:pt idx="1691">
                  <c:v>1.9509019330261701</c:v>
                </c:pt>
                <c:pt idx="1692">
                  <c:v>2.6445702002799898</c:v>
                </c:pt>
                <c:pt idx="1693">
                  <c:v>2.2549209318246501</c:v>
                </c:pt>
                <c:pt idx="1694">
                  <c:v>2.1385437329906298</c:v>
                </c:pt>
                <c:pt idx="1695">
                  <c:v>2.2022473945272698</c:v>
                </c:pt>
                <c:pt idx="1696">
                  <c:v>1.3454326150026299</c:v>
                </c:pt>
                <c:pt idx="1697">
                  <c:v>1.9177914308616699</c:v>
                </c:pt>
                <c:pt idx="1698">
                  <c:v>1.68462536652265</c:v>
                </c:pt>
                <c:pt idx="1699">
                  <c:v>1.8195858118775501</c:v>
                </c:pt>
                <c:pt idx="1700">
                  <c:v>1.6966836663599201</c:v>
                </c:pt>
                <c:pt idx="1701">
                  <c:v>1.44349003778746</c:v>
                </c:pt>
                <c:pt idx="1702">
                  <c:v>1.86976380537127</c:v>
                </c:pt>
                <c:pt idx="1703">
                  <c:v>1.3592872793997599</c:v>
                </c:pt>
                <c:pt idx="1704">
                  <c:v>1.79650284634991</c:v>
                </c:pt>
                <c:pt idx="1705">
                  <c:v>2.1380243884933701</c:v>
                </c:pt>
                <c:pt idx="1706">
                  <c:v>2.5140000210814799</c:v>
                </c:pt>
                <c:pt idx="1707">
                  <c:v>3.16888177137773</c:v>
                </c:pt>
                <c:pt idx="1708">
                  <c:v>2.3627237578749201</c:v>
                </c:pt>
                <c:pt idx="1709">
                  <c:v>2.39378189421056</c:v>
                </c:pt>
                <c:pt idx="1710">
                  <c:v>3.1105778774991402</c:v>
                </c:pt>
                <c:pt idx="1711">
                  <c:v>2.91950108416771</c:v>
                </c:pt>
                <c:pt idx="1712">
                  <c:v>2.63534384252694</c:v>
                </c:pt>
                <c:pt idx="1713">
                  <c:v>2.37687710642945</c:v>
                </c:pt>
                <c:pt idx="1714">
                  <c:v>2.3903961538870599</c:v>
                </c:pt>
                <c:pt idx="1715">
                  <c:v>2.6105085545350399</c:v>
                </c:pt>
                <c:pt idx="1716">
                  <c:v>2.3211081508915701</c:v>
                </c:pt>
                <c:pt idx="1717">
                  <c:v>2.8622402277635599</c:v>
                </c:pt>
                <c:pt idx="1718">
                  <c:v>2.7570524048003699</c:v>
                </c:pt>
                <c:pt idx="1719">
                  <c:v>2.8741677924503199</c:v>
                </c:pt>
                <c:pt idx="1720">
                  <c:v>2.51485002718253</c:v>
                </c:pt>
                <c:pt idx="1721">
                  <c:v>3.05945205428822</c:v>
                </c:pt>
                <c:pt idx="1722">
                  <c:v>2.85965135439212</c:v>
                </c:pt>
                <c:pt idx="1723">
                  <c:v>2.53188718103767</c:v>
                </c:pt>
                <c:pt idx="1724">
                  <c:v>2.7637859547914401</c:v>
                </c:pt>
                <c:pt idx="1725">
                  <c:v>2.9449873316883899</c:v>
                </c:pt>
                <c:pt idx="1726">
                  <c:v>3.1672362951404098</c:v>
                </c:pt>
                <c:pt idx="1727">
                  <c:v>2.8909611483693598</c:v>
                </c:pt>
                <c:pt idx="1728">
                  <c:v>3.3591958578764101</c:v>
                </c:pt>
                <c:pt idx="1729">
                  <c:v>2.77279707464877</c:v>
                </c:pt>
                <c:pt idx="1730">
                  <c:v>2.8494857017556598</c:v>
                </c:pt>
                <c:pt idx="1731">
                  <c:v>2.4477336439827302</c:v>
                </c:pt>
                <c:pt idx="1732">
                  <c:v>3.1034579937967899</c:v>
                </c:pt>
                <c:pt idx="1733">
                  <c:v>2.9670244517088902</c:v>
                </c:pt>
                <c:pt idx="1734">
                  <c:v>2.6257846398076299</c:v>
                </c:pt>
                <c:pt idx="1735">
                  <c:v>2.5021527992955401</c:v>
                </c:pt>
                <c:pt idx="1736">
                  <c:v>2.8134236402836899</c:v>
                </c:pt>
                <c:pt idx="1737">
                  <c:v>2.8428707938442801</c:v>
                </c:pt>
                <c:pt idx="1738">
                  <c:v>2.6821704155813402</c:v>
                </c:pt>
                <c:pt idx="1739">
                  <c:v>2.8306141671716301</c:v>
                </c:pt>
                <c:pt idx="1740">
                  <c:v>2.2592576938615099</c:v>
                </c:pt>
                <c:pt idx="1741">
                  <c:v>2.5243099515029601</c:v>
                </c:pt>
                <c:pt idx="1742">
                  <c:v>2.86085992329977</c:v>
                </c:pt>
                <c:pt idx="1743">
                  <c:v>3.2427835137887602</c:v>
                </c:pt>
                <c:pt idx="1744">
                  <c:v>3.4884601435874099</c:v>
                </c:pt>
                <c:pt idx="1745">
                  <c:v>2.8005353553850498</c:v>
                </c:pt>
                <c:pt idx="1746">
                  <c:v>3.0782872133520098</c:v>
                </c:pt>
                <c:pt idx="1747">
                  <c:v>2.68522902606805</c:v>
                </c:pt>
                <c:pt idx="1748">
                  <c:v>2.7142026298520601</c:v>
                </c:pt>
                <c:pt idx="1749">
                  <c:v>2.99057392870299</c:v>
                </c:pt>
                <c:pt idx="1750">
                  <c:v>2.3888555295053999</c:v>
                </c:pt>
                <c:pt idx="1751">
                  <c:v>2.8109559731484399</c:v>
                </c:pt>
                <c:pt idx="1752">
                  <c:v>2.4986994578607402</c:v>
                </c:pt>
                <c:pt idx="1753">
                  <c:v>2.36156271059017</c:v>
                </c:pt>
                <c:pt idx="1754">
                  <c:v>2.53441155297662</c:v>
                </c:pt>
                <c:pt idx="1755">
                  <c:v>2.61054918479135</c:v>
                </c:pt>
                <c:pt idx="1756">
                  <c:v>2.8274216448160301</c:v>
                </c:pt>
                <c:pt idx="1757">
                  <c:v>2.8804866555122102</c:v>
                </c:pt>
                <c:pt idx="1758">
                  <c:v>2.3808889479139901</c:v>
                </c:pt>
                <c:pt idx="1759">
                  <c:v>2.29575344636998</c:v>
                </c:pt>
                <c:pt idx="1760">
                  <c:v>2.7760711830392499</c:v>
                </c:pt>
                <c:pt idx="1761">
                  <c:v>2.9405398832965601</c:v>
                </c:pt>
                <c:pt idx="1762">
                  <c:v>2.5618900634330899</c:v>
                </c:pt>
                <c:pt idx="1763">
                  <c:v>2.5092316897087001</c:v>
                </c:pt>
                <c:pt idx="1764">
                  <c:v>2.6152841340036499</c:v>
                </c:pt>
                <c:pt idx="1765">
                  <c:v>2.0296240875577798</c:v>
                </c:pt>
                <c:pt idx="1766">
                  <c:v>2.7032736843323399</c:v>
                </c:pt>
                <c:pt idx="1767">
                  <c:v>2.4941588463225899</c:v>
                </c:pt>
                <c:pt idx="1768">
                  <c:v>2.5641699524968899</c:v>
                </c:pt>
                <c:pt idx="1769">
                  <c:v>2.37943406331248</c:v>
                </c:pt>
                <c:pt idx="1770">
                  <c:v>3.3860128718457201</c:v>
                </c:pt>
                <c:pt idx="1771">
                  <c:v>2.8411534753146901</c:v>
                </c:pt>
                <c:pt idx="1772">
                  <c:v>2.4562406748789001</c:v>
                </c:pt>
                <c:pt idx="1773">
                  <c:v>2.6835418263394901</c:v>
                </c:pt>
                <c:pt idx="1774">
                  <c:v>2.0538369521061801</c:v>
                </c:pt>
                <c:pt idx="1775">
                  <c:v>2.7485027552585999</c:v>
                </c:pt>
                <c:pt idx="1776">
                  <c:v>3.2429199134500801</c:v>
                </c:pt>
                <c:pt idx="1777">
                  <c:v>3.5399862078767099</c:v>
                </c:pt>
                <c:pt idx="1778">
                  <c:v>2.83365012614165</c:v>
                </c:pt>
                <c:pt idx="1779">
                  <c:v>2.8968960553357901</c:v>
                </c:pt>
                <c:pt idx="1780">
                  <c:v>2.6333816883279599</c:v>
                </c:pt>
                <c:pt idx="1781">
                  <c:v>3.1024138234215899</c:v>
                </c:pt>
                <c:pt idx="1782">
                  <c:v>2.98403459462692</c:v>
                </c:pt>
                <c:pt idx="1783">
                  <c:v>3.1705804063483698</c:v>
                </c:pt>
                <c:pt idx="1784">
                  <c:v>3.1987927337733302</c:v>
                </c:pt>
                <c:pt idx="1785">
                  <c:v>3.3954081106159899</c:v>
                </c:pt>
                <c:pt idx="1786">
                  <c:v>2.8258416963409001</c:v>
                </c:pt>
                <c:pt idx="1787">
                  <c:v>2.7009254111562702</c:v>
                </c:pt>
                <c:pt idx="1788">
                  <c:v>2.57524212380756</c:v>
                </c:pt>
                <c:pt idx="1789">
                  <c:v>3.0480868943718402</c:v>
                </c:pt>
                <c:pt idx="1790">
                  <c:v>2.3770811891869199</c:v>
                </c:pt>
                <c:pt idx="1791">
                  <c:v>2.9643962568136599</c:v>
                </c:pt>
                <c:pt idx="1792">
                  <c:v>3.3377663523289902</c:v>
                </c:pt>
                <c:pt idx="1793">
                  <c:v>2.8470876231115199</c:v>
                </c:pt>
                <c:pt idx="1794">
                  <c:v>2.8344517508315601</c:v>
                </c:pt>
                <c:pt idx="1795">
                  <c:v>2.8731791069431298</c:v>
                </c:pt>
                <c:pt idx="1796">
                  <c:v>2.8718791335209901</c:v>
                </c:pt>
                <c:pt idx="1797">
                  <c:v>2.6141390183078901</c:v>
                </c:pt>
                <c:pt idx="1798">
                  <c:v>2.94319800796413</c:v>
                </c:pt>
                <c:pt idx="1799">
                  <c:v>3.0608470585693901</c:v>
                </c:pt>
                <c:pt idx="1800">
                  <c:v>1.9009139512684501</c:v>
                </c:pt>
                <c:pt idx="1801">
                  <c:v>2.6819282986478199</c:v>
                </c:pt>
                <c:pt idx="1802">
                  <c:v>3.1192691846351601</c:v>
                </c:pt>
                <c:pt idx="1803">
                  <c:v>2.0012912920065702</c:v>
                </c:pt>
                <c:pt idx="1804">
                  <c:v>2.4820620439670198</c:v>
                </c:pt>
                <c:pt idx="1805">
                  <c:v>2.46005745120357</c:v>
                </c:pt>
                <c:pt idx="1806">
                  <c:v>2.5640317920490299</c:v>
                </c:pt>
                <c:pt idx="1807">
                  <c:v>1.70889464089126</c:v>
                </c:pt>
                <c:pt idx="1808">
                  <c:v>1.73650139503844</c:v>
                </c:pt>
                <c:pt idx="1809">
                  <c:v>1.7718902016701801</c:v>
                </c:pt>
                <c:pt idx="1810">
                  <c:v>2.1705472030876498</c:v>
                </c:pt>
                <c:pt idx="1811">
                  <c:v>1.68151011887188</c:v>
                </c:pt>
                <c:pt idx="1812">
                  <c:v>1.6030449215132001</c:v>
                </c:pt>
                <c:pt idx="1813">
                  <c:v>1.9865782961041101</c:v>
                </c:pt>
                <c:pt idx="1814">
                  <c:v>2.1759059324910499</c:v>
                </c:pt>
                <c:pt idx="1815">
                  <c:v>2.59269717471483</c:v>
                </c:pt>
                <c:pt idx="1816">
                  <c:v>2.1238909829522301</c:v>
                </c:pt>
                <c:pt idx="1817">
                  <c:v>2.9045055896104701</c:v>
                </c:pt>
                <c:pt idx="1818">
                  <c:v>2.8744640982759901</c:v>
                </c:pt>
                <c:pt idx="1819">
                  <c:v>2.70497022121575</c:v>
                </c:pt>
                <c:pt idx="1820">
                  <c:v>2.63918358784785</c:v>
                </c:pt>
                <c:pt idx="1821">
                  <c:v>2.4477497740046998</c:v>
                </c:pt>
                <c:pt idx="1822">
                  <c:v>2.3431593337278001</c:v>
                </c:pt>
                <c:pt idx="1823">
                  <c:v>2.4328446448850598</c:v>
                </c:pt>
                <c:pt idx="1824">
                  <c:v>2.8818187140931002</c:v>
                </c:pt>
                <c:pt idx="1825">
                  <c:v>2.46893639957106</c:v>
                </c:pt>
                <c:pt idx="1826">
                  <c:v>1.82046682940491</c:v>
                </c:pt>
                <c:pt idx="1827">
                  <c:v>1.76913117678748</c:v>
                </c:pt>
                <c:pt idx="1828">
                  <c:v>2.5402120475658099</c:v>
                </c:pt>
                <c:pt idx="1829">
                  <c:v>3.0627212127635599</c:v>
                </c:pt>
                <c:pt idx="1830">
                  <c:v>2.4837560179485498</c:v>
                </c:pt>
                <c:pt idx="1831">
                  <c:v>2.9594203442971798</c:v>
                </c:pt>
                <c:pt idx="1832">
                  <c:v>2.8624923902304298</c:v>
                </c:pt>
                <c:pt idx="1833">
                  <c:v>2.3799913758153601</c:v>
                </c:pt>
                <c:pt idx="1834">
                  <c:v>2.7078460751475601</c:v>
                </c:pt>
                <c:pt idx="1835">
                  <c:v>2.2950476608044199</c:v>
                </c:pt>
                <c:pt idx="1836">
                  <c:v>2.8263331803986702</c:v>
                </c:pt>
                <c:pt idx="1837">
                  <c:v>2.0766479306694099</c:v>
                </c:pt>
                <c:pt idx="1838">
                  <c:v>2.3809809881762098</c:v>
                </c:pt>
                <c:pt idx="1839">
                  <c:v>2.41577929743345</c:v>
                </c:pt>
                <c:pt idx="1840">
                  <c:v>1.7212246643071301</c:v>
                </c:pt>
                <c:pt idx="1841">
                  <c:v>1.91431796879669</c:v>
                </c:pt>
                <c:pt idx="1842">
                  <c:v>1.9660166487236601</c:v>
                </c:pt>
                <c:pt idx="1843">
                  <c:v>1.9028854467268601</c:v>
                </c:pt>
                <c:pt idx="1844">
                  <c:v>2.0652503250679501</c:v>
                </c:pt>
                <c:pt idx="1845">
                  <c:v>1.5154073411886599</c:v>
                </c:pt>
                <c:pt idx="1846">
                  <c:v>1.9650401638405099</c:v>
                </c:pt>
                <c:pt idx="1847">
                  <c:v>1.85106441424241</c:v>
                </c:pt>
                <c:pt idx="1848">
                  <c:v>2.2046616556088199</c:v>
                </c:pt>
                <c:pt idx="1849">
                  <c:v>1.69785796748791</c:v>
                </c:pt>
                <c:pt idx="1850">
                  <c:v>1.85039942636379</c:v>
                </c:pt>
                <c:pt idx="1851">
                  <c:v>2.21769772704701</c:v>
                </c:pt>
                <c:pt idx="1852">
                  <c:v>1.72852504857733</c:v>
                </c:pt>
                <c:pt idx="1853">
                  <c:v>1.9062201644082</c:v>
                </c:pt>
                <c:pt idx="1854">
                  <c:v>2.1230868910503999</c:v>
                </c:pt>
                <c:pt idx="1855">
                  <c:v>2.1151892886642498</c:v>
                </c:pt>
                <c:pt idx="1856">
                  <c:v>2.3087659825693598</c:v>
                </c:pt>
                <c:pt idx="1857">
                  <c:v>1.54719735622185</c:v>
                </c:pt>
                <c:pt idx="1858">
                  <c:v>2.07155674347164</c:v>
                </c:pt>
                <c:pt idx="1859">
                  <c:v>2.32341639186073</c:v>
                </c:pt>
                <c:pt idx="1860">
                  <c:v>1.8916899379774601</c:v>
                </c:pt>
                <c:pt idx="1861">
                  <c:v>1.6793393061687401</c:v>
                </c:pt>
                <c:pt idx="1862">
                  <c:v>2.1192648690838598</c:v>
                </c:pt>
                <c:pt idx="1863">
                  <c:v>2.1960364780108002</c:v>
                </c:pt>
                <c:pt idx="1864">
                  <c:v>1.93126747259567</c:v>
                </c:pt>
                <c:pt idx="1865">
                  <c:v>2.5740280634325301</c:v>
                </c:pt>
                <c:pt idx="1866">
                  <c:v>1.93272719629628</c:v>
                </c:pt>
                <c:pt idx="1867">
                  <c:v>2.2634742411088702</c:v>
                </c:pt>
                <c:pt idx="1868">
                  <c:v>3.21656930254608</c:v>
                </c:pt>
                <c:pt idx="1869">
                  <c:v>1.6179310660923001</c:v>
                </c:pt>
                <c:pt idx="1870">
                  <c:v>2.0695037406819501</c:v>
                </c:pt>
                <c:pt idx="1871">
                  <c:v>1.90998602660578</c:v>
                </c:pt>
                <c:pt idx="1872">
                  <c:v>1.93531343485144</c:v>
                </c:pt>
                <c:pt idx="1873">
                  <c:v>2.2023807623636902</c:v>
                </c:pt>
                <c:pt idx="1874">
                  <c:v>2.6382615068059301</c:v>
                </c:pt>
                <c:pt idx="1875">
                  <c:v>2.7316970937395699</c:v>
                </c:pt>
                <c:pt idx="1876">
                  <c:v>2.4334976774559101</c:v>
                </c:pt>
                <c:pt idx="1877">
                  <c:v>2.5004456859730402</c:v>
                </c:pt>
                <c:pt idx="1878">
                  <c:v>2.3470616898942098</c:v>
                </c:pt>
                <c:pt idx="1879">
                  <c:v>2.441311411199</c:v>
                </c:pt>
                <c:pt idx="1880">
                  <c:v>2.3492123568344101</c:v>
                </c:pt>
                <c:pt idx="1881">
                  <c:v>2.5516807696370298</c:v>
                </c:pt>
                <c:pt idx="1882">
                  <c:v>2.88557239703561</c:v>
                </c:pt>
                <c:pt idx="1883">
                  <c:v>2.8931908131072501</c:v>
                </c:pt>
                <c:pt idx="1884">
                  <c:v>1.95950506424668</c:v>
                </c:pt>
                <c:pt idx="1885">
                  <c:v>2.7180065577619499</c:v>
                </c:pt>
                <c:pt idx="1886">
                  <c:v>1.99257449894429</c:v>
                </c:pt>
                <c:pt idx="1887">
                  <c:v>2.89173621756097</c:v>
                </c:pt>
                <c:pt idx="1888">
                  <c:v>2.5374361229173998</c:v>
                </c:pt>
                <c:pt idx="1889">
                  <c:v>2.3463953936988799</c:v>
                </c:pt>
                <c:pt idx="1890">
                  <c:v>2.5400729284153001</c:v>
                </c:pt>
                <c:pt idx="1891">
                  <c:v>2.4291510875544602</c:v>
                </c:pt>
                <c:pt idx="1892">
                  <c:v>1.9281820587682299</c:v>
                </c:pt>
                <c:pt idx="1893">
                  <c:v>1.8779961931978499</c:v>
                </c:pt>
                <c:pt idx="1894">
                  <c:v>2.0351793207922602</c:v>
                </c:pt>
                <c:pt idx="1895">
                  <c:v>2.4904012757968199</c:v>
                </c:pt>
                <c:pt idx="1896">
                  <c:v>2.4529564136637099</c:v>
                </c:pt>
                <c:pt idx="1897">
                  <c:v>2.30607404935223</c:v>
                </c:pt>
                <c:pt idx="1898">
                  <c:v>1.4418464839516001</c:v>
                </c:pt>
                <c:pt idx="1899">
                  <c:v>2.27936690797593</c:v>
                </c:pt>
                <c:pt idx="1900">
                  <c:v>2.8730813923885798</c:v>
                </c:pt>
                <c:pt idx="1901">
                  <c:v>2.2344974617580902</c:v>
                </c:pt>
                <c:pt idx="1902">
                  <c:v>2.6333949460847599</c:v>
                </c:pt>
                <c:pt idx="1903">
                  <c:v>2.6185409692174701</c:v>
                </c:pt>
                <c:pt idx="1904">
                  <c:v>2.6490346804375799</c:v>
                </c:pt>
                <c:pt idx="1905">
                  <c:v>2.3531188979663602</c:v>
                </c:pt>
                <c:pt idx="1906">
                  <c:v>2.4170079034248202</c:v>
                </c:pt>
                <c:pt idx="1907">
                  <c:v>2.3811670099053899</c:v>
                </c:pt>
                <c:pt idx="1908">
                  <c:v>2.2071431179548</c:v>
                </c:pt>
                <c:pt idx="1909">
                  <c:v>2.6538536344114099</c:v>
                </c:pt>
                <c:pt idx="1910">
                  <c:v>2.1621994093986499</c:v>
                </c:pt>
                <c:pt idx="1911">
                  <c:v>2.3640563670513202</c:v>
                </c:pt>
                <c:pt idx="1912">
                  <c:v>2.0384728507945402</c:v>
                </c:pt>
                <c:pt idx="1913">
                  <c:v>1.8161370425499901</c:v>
                </c:pt>
                <c:pt idx="1914">
                  <c:v>2.73206720915551</c:v>
                </c:pt>
                <c:pt idx="1915">
                  <c:v>2.4511401156503698</c:v>
                </c:pt>
                <c:pt idx="1916">
                  <c:v>1.7433126673689301</c:v>
                </c:pt>
                <c:pt idx="1917">
                  <c:v>2.4381530562160898</c:v>
                </c:pt>
                <c:pt idx="1918">
                  <c:v>2.5484148908527802</c:v>
                </c:pt>
                <c:pt idx="1919">
                  <c:v>2.57519216707884</c:v>
                </c:pt>
                <c:pt idx="1920">
                  <c:v>1.99109457741469</c:v>
                </c:pt>
                <c:pt idx="1921">
                  <c:v>2.3287721525844298</c:v>
                </c:pt>
                <c:pt idx="1922">
                  <c:v>2.7100959790892598</c:v>
                </c:pt>
                <c:pt idx="1923">
                  <c:v>2.4751194438185098</c:v>
                </c:pt>
                <c:pt idx="1924">
                  <c:v>2.76749264500046</c:v>
                </c:pt>
                <c:pt idx="1925">
                  <c:v>2.4074206759435</c:v>
                </c:pt>
                <c:pt idx="1926">
                  <c:v>2.68176353934571</c:v>
                </c:pt>
                <c:pt idx="1927">
                  <c:v>3.3851981551475299</c:v>
                </c:pt>
                <c:pt idx="1928">
                  <c:v>2.6019348287140001</c:v>
                </c:pt>
                <c:pt idx="1929">
                  <c:v>2.9465231241967298</c:v>
                </c:pt>
                <c:pt idx="1930">
                  <c:v>3.1254830824722899</c:v>
                </c:pt>
                <c:pt idx="1931">
                  <c:v>3.2622987067032798</c:v>
                </c:pt>
                <c:pt idx="1932">
                  <c:v>3.02251429707706</c:v>
                </c:pt>
                <c:pt idx="1933">
                  <c:v>2.9430166909381898</c:v>
                </c:pt>
                <c:pt idx="1934">
                  <c:v>2.9363885162193699</c:v>
                </c:pt>
                <c:pt idx="1935">
                  <c:v>2.9169052899713099</c:v>
                </c:pt>
                <c:pt idx="1936">
                  <c:v>3.08434584379971</c:v>
                </c:pt>
                <c:pt idx="1937">
                  <c:v>3.04987891537907</c:v>
                </c:pt>
                <c:pt idx="1938">
                  <c:v>2.36623955167593</c:v>
                </c:pt>
                <c:pt idx="1939">
                  <c:v>2.72027486890787</c:v>
                </c:pt>
                <c:pt idx="1940">
                  <c:v>2.3502298028788</c:v>
                </c:pt>
                <c:pt idx="1941">
                  <c:v>2.7920978808893699</c:v>
                </c:pt>
                <c:pt idx="1942">
                  <c:v>2.2111993311224598</c:v>
                </c:pt>
                <c:pt idx="1943">
                  <c:v>2.7560516906376802</c:v>
                </c:pt>
                <c:pt idx="1944">
                  <c:v>2.5161245984838998</c:v>
                </c:pt>
                <c:pt idx="1945">
                  <c:v>2.8750290942010301</c:v>
                </c:pt>
                <c:pt idx="1946">
                  <c:v>2.9659586015192998</c:v>
                </c:pt>
                <c:pt idx="1947">
                  <c:v>2.7126836044692402</c:v>
                </c:pt>
                <c:pt idx="1948">
                  <c:v>3.7486847616677901</c:v>
                </c:pt>
                <c:pt idx="1949">
                  <c:v>3.2187091097940899</c:v>
                </c:pt>
                <c:pt idx="1950">
                  <c:v>2.4622004466799701</c:v>
                </c:pt>
                <c:pt idx="1951">
                  <c:v>3.2702500761172599</c:v>
                </c:pt>
                <c:pt idx="1952">
                  <c:v>3.7062868419189399</c:v>
                </c:pt>
                <c:pt idx="1953">
                  <c:v>3.2664719686464601</c:v>
                </c:pt>
                <c:pt idx="1954">
                  <c:v>3.2203056962675198</c:v>
                </c:pt>
                <c:pt idx="1955">
                  <c:v>2.8904974848281402</c:v>
                </c:pt>
                <c:pt idx="1956">
                  <c:v>2.7803385912888001</c:v>
                </c:pt>
                <c:pt idx="1957">
                  <c:v>3.3809040106360699</c:v>
                </c:pt>
                <c:pt idx="1958">
                  <c:v>3.5942808587286499</c:v>
                </c:pt>
                <c:pt idx="1959">
                  <c:v>2.9774803276675401</c:v>
                </c:pt>
                <c:pt idx="1960">
                  <c:v>2.6810444191011702</c:v>
                </c:pt>
                <c:pt idx="1961">
                  <c:v>2.7901519459004298</c:v>
                </c:pt>
                <c:pt idx="1962">
                  <c:v>2.9019825501961698</c:v>
                </c:pt>
                <c:pt idx="1963">
                  <c:v>3.1336954574766498</c:v>
                </c:pt>
                <c:pt idx="1964">
                  <c:v>3.0715582191537001</c:v>
                </c:pt>
                <c:pt idx="1965">
                  <c:v>3.13824660757414</c:v>
                </c:pt>
                <c:pt idx="1966">
                  <c:v>2.75761375940872</c:v>
                </c:pt>
                <c:pt idx="1967">
                  <c:v>2.7274202869795698</c:v>
                </c:pt>
                <c:pt idx="1968">
                  <c:v>2.6190308688737902</c:v>
                </c:pt>
                <c:pt idx="1969">
                  <c:v>2.0109283266598599</c:v>
                </c:pt>
                <c:pt idx="1970">
                  <c:v>3.3956614978664401</c:v>
                </c:pt>
                <c:pt idx="1971">
                  <c:v>3.25333134363385</c:v>
                </c:pt>
                <c:pt idx="1972">
                  <c:v>3.1873065640443201</c:v>
                </c:pt>
                <c:pt idx="1973">
                  <c:v>3.19208914153988</c:v>
                </c:pt>
                <c:pt idx="1974">
                  <c:v>2.7802874768592298</c:v>
                </c:pt>
                <c:pt idx="1975">
                  <c:v>2.4823197391986001</c:v>
                </c:pt>
                <c:pt idx="1976">
                  <c:v>3.11957418148216</c:v>
                </c:pt>
                <c:pt idx="1977">
                  <c:v>2.79086202165968</c:v>
                </c:pt>
                <c:pt idx="1978">
                  <c:v>3.1895639656260002</c:v>
                </c:pt>
                <c:pt idx="1979">
                  <c:v>2.8315394192551002</c:v>
                </c:pt>
                <c:pt idx="1980">
                  <c:v>2.7824365147011898</c:v>
                </c:pt>
                <c:pt idx="1981">
                  <c:v>3.0304054792769</c:v>
                </c:pt>
                <c:pt idx="1982">
                  <c:v>2.0162484825066902</c:v>
                </c:pt>
                <c:pt idx="1983">
                  <c:v>2.4266929369108099</c:v>
                </c:pt>
                <c:pt idx="1984">
                  <c:v>2.28684405941123</c:v>
                </c:pt>
                <c:pt idx="1985">
                  <c:v>3.15317564532331</c:v>
                </c:pt>
                <c:pt idx="1986">
                  <c:v>2.3131470507643002</c:v>
                </c:pt>
                <c:pt idx="1987">
                  <c:v>2.81237996830792</c:v>
                </c:pt>
                <c:pt idx="1988">
                  <c:v>2.5302537345579599</c:v>
                </c:pt>
                <c:pt idx="1989">
                  <c:v>2.2521477150359202</c:v>
                </c:pt>
                <c:pt idx="1990">
                  <c:v>2.7421098244103299</c:v>
                </c:pt>
                <c:pt idx="1991">
                  <c:v>2.9247991500934001</c:v>
                </c:pt>
                <c:pt idx="1992">
                  <c:v>2.8182797210416499</c:v>
                </c:pt>
                <c:pt idx="1993">
                  <c:v>3.3035562436128099</c:v>
                </c:pt>
                <c:pt idx="1994">
                  <c:v>2.89559727800484</c:v>
                </c:pt>
                <c:pt idx="1995">
                  <c:v>2.90581205941016</c:v>
                </c:pt>
                <c:pt idx="1996">
                  <c:v>2.4935559070770199</c:v>
                </c:pt>
                <c:pt idx="1997">
                  <c:v>3.1061419348442398</c:v>
                </c:pt>
                <c:pt idx="1998">
                  <c:v>3.1926814740406102</c:v>
                </c:pt>
                <c:pt idx="1999">
                  <c:v>3.0201236170444798</c:v>
                </c:pt>
                <c:pt idx="2000">
                  <c:v>2.8804041131672098</c:v>
                </c:pt>
                <c:pt idx="2001">
                  <c:v>2.44349719884167</c:v>
                </c:pt>
                <c:pt idx="2002">
                  <c:v>2.4813602946370801</c:v>
                </c:pt>
                <c:pt idx="2003">
                  <c:v>3.0228094089748199</c:v>
                </c:pt>
                <c:pt idx="2004">
                  <c:v>2.6150095401382099</c:v>
                </c:pt>
                <c:pt idx="2005">
                  <c:v>3.0142527227304798</c:v>
                </c:pt>
                <c:pt idx="2006">
                  <c:v>2.87966512278035</c:v>
                </c:pt>
                <c:pt idx="2007">
                  <c:v>3.0771819627701098</c:v>
                </c:pt>
                <c:pt idx="2008">
                  <c:v>3.7625362844458001</c:v>
                </c:pt>
                <c:pt idx="2009">
                  <c:v>2.7305043742294002</c:v>
                </c:pt>
                <c:pt idx="2010">
                  <c:v>3.3338928892425899</c:v>
                </c:pt>
                <c:pt idx="2011">
                  <c:v>3.7609038600011702</c:v>
                </c:pt>
                <c:pt idx="2012">
                  <c:v>3.4868249863359302</c:v>
                </c:pt>
                <c:pt idx="2013">
                  <c:v>3.14622085179239</c:v>
                </c:pt>
                <c:pt idx="2014">
                  <c:v>2.4059136116668198</c:v>
                </c:pt>
                <c:pt idx="2015">
                  <c:v>2.7574104425780299</c:v>
                </c:pt>
                <c:pt idx="2016">
                  <c:v>3.1290880822187699</c:v>
                </c:pt>
                <c:pt idx="2017">
                  <c:v>2.8575070333678498</c:v>
                </c:pt>
                <c:pt idx="2018">
                  <c:v>3.3523148953033499</c:v>
                </c:pt>
                <c:pt idx="2019">
                  <c:v>3.2958636194238302</c:v>
                </c:pt>
                <c:pt idx="2020">
                  <c:v>3.0001203178079598</c:v>
                </c:pt>
                <c:pt idx="2021">
                  <c:v>2.22548498946017</c:v>
                </c:pt>
                <c:pt idx="2022">
                  <c:v>1.58440316694036</c:v>
                </c:pt>
                <c:pt idx="2023">
                  <c:v>1.9453286284601801</c:v>
                </c:pt>
                <c:pt idx="2024">
                  <c:v>2.1331846413599198</c:v>
                </c:pt>
                <c:pt idx="2025">
                  <c:v>1.76203303864844</c:v>
                </c:pt>
                <c:pt idx="2026">
                  <c:v>2.0246148250838001</c:v>
                </c:pt>
                <c:pt idx="2027">
                  <c:v>1.6037533656590399</c:v>
                </c:pt>
                <c:pt idx="2028">
                  <c:v>1.94153032337517</c:v>
                </c:pt>
                <c:pt idx="2029">
                  <c:v>2.0856729082168499</c:v>
                </c:pt>
                <c:pt idx="2030">
                  <c:v>2.09147050507271</c:v>
                </c:pt>
                <c:pt idx="2031">
                  <c:v>2.0855516135316901</c:v>
                </c:pt>
                <c:pt idx="2032">
                  <c:v>2.0352410860787402</c:v>
                </c:pt>
                <c:pt idx="2033">
                  <c:v>1.8964927381905701</c:v>
                </c:pt>
                <c:pt idx="2034">
                  <c:v>1.7085513399255301</c:v>
                </c:pt>
                <c:pt idx="2035">
                  <c:v>1.9034442601307899</c:v>
                </c:pt>
                <c:pt idx="2036">
                  <c:v>1.70137167976811</c:v>
                </c:pt>
                <c:pt idx="2037">
                  <c:v>2.4759761158575699</c:v>
                </c:pt>
                <c:pt idx="2038">
                  <c:v>2.49698754066464</c:v>
                </c:pt>
                <c:pt idx="2039">
                  <c:v>2.0700959766307601</c:v>
                </c:pt>
                <c:pt idx="2040">
                  <c:v>2.09341275520655</c:v>
                </c:pt>
                <c:pt idx="2041">
                  <c:v>1.71810757636086</c:v>
                </c:pt>
                <c:pt idx="2042">
                  <c:v>1.7001874668883801</c:v>
                </c:pt>
                <c:pt idx="2043">
                  <c:v>1.6393951962440201</c:v>
                </c:pt>
                <c:pt idx="2044">
                  <c:v>1.8886237233027401</c:v>
                </c:pt>
                <c:pt idx="2045">
                  <c:v>2.0557825460777299</c:v>
                </c:pt>
                <c:pt idx="2046">
                  <c:v>1.6884622424106699</c:v>
                </c:pt>
                <c:pt idx="2047">
                  <c:v>2.0122762017521101</c:v>
                </c:pt>
                <c:pt idx="2048">
                  <c:v>2.8342924645285401</c:v>
                </c:pt>
                <c:pt idx="2049">
                  <c:v>1.6318457640337001</c:v>
                </c:pt>
                <c:pt idx="2050">
                  <c:v>1.46624892032272</c:v>
                </c:pt>
                <c:pt idx="2051">
                  <c:v>1.6844272949066099</c:v>
                </c:pt>
                <c:pt idx="2052">
                  <c:v>1.87707725155983</c:v>
                </c:pt>
                <c:pt idx="2053">
                  <c:v>1.7217730918582601</c:v>
                </c:pt>
                <c:pt idx="2054">
                  <c:v>1.70682829795309</c:v>
                </c:pt>
                <c:pt idx="2055">
                  <c:v>2.03933016834028</c:v>
                </c:pt>
                <c:pt idx="2056">
                  <c:v>2.0148229179233499</c:v>
                </c:pt>
                <c:pt idx="2057">
                  <c:v>1.6645395363637501</c:v>
                </c:pt>
                <c:pt idx="2058">
                  <c:v>1.38424163750992</c:v>
                </c:pt>
                <c:pt idx="2059">
                  <c:v>1.8624061802657701</c:v>
                </c:pt>
                <c:pt idx="2060">
                  <c:v>1.1976808537753301</c:v>
                </c:pt>
                <c:pt idx="2061">
                  <c:v>1.37319286456527</c:v>
                </c:pt>
                <c:pt idx="2062">
                  <c:v>1.2423765767128001</c:v>
                </c:pt>
                <c:pt idx="2063">
                  <c:v>1.44410348737307</c:v>
                </c:pt>
                <c:pt idx="2064">
                  <c:v>1.6668046071364999</c:v>
                </c:pt>
                <c:pt idx="2065">
                  <c:v>1.66120332245476</c:v>
                </c:pt>
                <c:pt idx="2066">
                  <c:v>1.95125486939889</c:v>
                </c:pt>
                <c:pt idx="2067">
                  <c:v>1.53027215264566</c:v>
                </c:pt>
                <c:pt idx="2068">
                  <c:v>2.2880621085219901</c:v>
                </c:pt>
                <c:pt idx="2069">
                  <c:v>3.0026513679201101</c:v>
                </c:pt>
                <c:pt idx="2070">
                  <c:v>2.9305375819950101</c:v>
                </c:pt>
                <c:pt idx="2071">
                  <c:v>2.60714469057945</c:v>
                </c:pt>
                <c:pt idx="2072">
                  <c:v>2.5989173793356102</c:v>
                </c:pt>
                <c:pt idx="2073">
                  <c:v>2.7613572119205001</c:v>
                </c:pt>
                <c:pt idx="2074">
                  <c:v>2.8025009003403101</c:v>
                </c:pt>
                <c:pt idx="2075">
                  <c:v>2.2171348065759098</c:v>
                </c:pt>
                <c:pt idx="2076">
                  <c:v>2.1740177242935199</c:v>
                </c:pt>
                <c:pt idx="2077">
                  <c:v>1.9324002491493899</c:v>
                </c:pt>
                <c:pt idx="2078">
                  <c:v>1.6808394615068201</c:v>
                </c:pt>
                <c:pt idx="2079">
                  <c:v>1.6319794085932999</c:v>
                </c:pt>
                <c:pt idx="2080">
                  <c:v>2.6350538641904002</c:v>
                </c:pt>
                <c:pt idx="2081">
                  <c:v>2.3389606627391499</c:v>
                </c:pt>
                <c:pt idx="2082">
                  <c:v>2.81009343661455</c:v>
                </c:pt>
                <c:pt idx="2083">
                  <c:v>2.5635922454594402</c:v>
                </c:pt>
                <c:pt idx="2084">
                  <c:v>2.5261039439521098</c:v>
                </c:pt>
                <c:pt idx="2085">
                  <c:v>2.6213996734787002</c:v>
                </c:pt>
                <c:pt idx="2086">
                  <c:v>2.0826569668952701</c:v>
                </c:pt>
                <c:pt idx="2087">
                  <c:v>2.1412402815044498</c:v>
                </c:pt>
                <c:pt idx="2088">
                  <c:v>2.0034213001412899</c:v>
                </c:pt>
                <c:pt idx="2089">
                  <c:v>2.55649695474363</c:v>
                </c:pt>
                <c:pt idx="2090">
                  <c:v>2.9425581846136502</c:v>
                </c:pt>
                <c:pt idx="2091">
                  <c:v>2.7102019552605401</c:v>
                </c:pt>
                <c:pt idx="2092">
                  <c:v>2.4814322043540198</c:v>
                </c:pt>
                <c:pt idx="2093">
                  <c:v>2.12680830991658</c:v>
                </c:pt>
                <c:pt idx="2094">
                  <c:v>2.34753745970036</c:v>
                </c:pt>
                <c:pt idx="2095">
                  <c:v>2.8282044684279701</c:v>
                </c:pt>
                <c:pt idx="2096">
                  <c:v>2.8045486853530299</c:v>
                </c:pt>
                <c:pt idx="2097">
                  <c:v>2.5697678881151602</c:v>
                </c:pt>
                <c:pt idx="2098">
                  <c:v>2.55758016722947</c:v>
                </c:pt>
                <c:pt idx="2099">
                  <c:v>2.8894810266287001</c:v>
                </c:pt>
                <c:pt idx="2100">
                  <c:v>2.4233275731055399</c:v>
                </c:pt>
                <c:pt idx="2101">
                  <c:v>2.1001347948584499</c:v>
                </c:pt>
                <c:pt idx="2102">
                  <c:v>2.5907622529465799</c:v>
                </c:pt>
                <c:pt idx="2103">
                  <c:v>2.40514967514296</c:v>
                </c:pt>
                <c:pt idx="2104">
                  <c:v>2.3611403977912402</c:v>
                </c:pt>
                <c:pt idx="2105">
                  <c:v>1.5084419621230201</c:v>
                </c:pt>
                <c:pt idx="2106">
                  <c:v>2.4066100181565502</c:v>
                </c:pt>
                <c:pt idx="2107">
                  <c:v>2.4272989833509602</c:v>
                </c:pt>
                <c:pt idx="2108">
                  <c:v>2.39047485023073</c:v>
                </c:pt>
                <c:pt idx="2109">
                  <c:v>2.3423991056187599</c:v>
                </c:pt>
                <c:pt idx="2110">
                  <c:v>2.4787767778284699</c:v>
                </c:pt>
                <c:pt idx="2111">
                  <c:v>2.49239222909921</c:v>
                </c:pt>
                <c:pt idx="2112">
                  <c:v>2.0866207618877501</c:v>
                </c:pt>
                <c:pt idx="2113">
                  <c:v>1.67437557922964</c:v>
                </c:pt>
                <c:pt idx="2114">
                  <c:v>2.5958174783424899</c:v>
                </c:pt>
                <c:pt idx="2115">
                  <c:v>2.4870761546242499</c:v>
                </c:pt>
                <c:pt idx="2116">
                  <c:v>2.3847582049943701</c:v>
                </c:pt>
                <c:pt idx="2117">
                  <c:v>2.71531811415728</c:v>
                </c:pt>
                <c:pt idx="2118">
                  <c:v>3.1488571908214098</c:v>
                </c:pt>
                <c:pt idx="2119">
                  <c:v>3.2112623494425598</c:v>
                </c:pt>
                <c:pt idx="2120">
                  <c:v>2.9934880550074201</c:v>
                </c:pt>
                <c:pt idx="2121">
                  <c:v>3.0673282460853901</c:v>
                </c:pt>
                <c:pt idx="2122">
                  <c:v>2.5059196325606501</c:v>
                </c:pt>
                <c:pt idx="2123">
                  <c:v>2.8873720039037001</c:v>
                </c:pt>
                <c:pt idx="2124">
                  <c:v>3.2827722386945002</c:v>
                </c:pt>
                <c:pt idx="2125">
                  <c:v>2.8692064580513001</c:v>
                </c:pt>
                <c:pt idx="2126">
                  <c:v>2.1482701031215501</c:v>
                </c:pt>
                <c:pt idx="2127">
                  <c:v>2.1986609300172302</c:v>
                </c:pt>
                <c:pt idx="2128">
                  <c:v>2.77728944942749</c:v>
                </c:pt>
                <c:pt idx="2129">
                  <c:v>2.3277776450853902</c:v>
                </c:pt>
                <c:pt idx="2130">
                  <c:v>3.3913628827538802</c:v>
                </c:pt>
                <c:pt idx="2131">
                  <c:v>3.1972438274745398</c:v>
                </c:pt>
                <c:pt idx="2132">
                  <c:v>3.1117328875981198</c:v>
                </c:pt>
                <c:pt idx="2133">
                  <c:v>2.73493018072549</c:v>
                </c:pt>
                <c:pt idx="2134">
                  <c:v>2.5809877359612901</c:v>
                </c:pt>
                <c:pt idx="2135">
                  <c:v>2.9074806170743099</c:v>
                </c:pt>
                <c:pt idx="2136">
                  <c:v>3.1252952982062001</c:v>
                </c:pt>
                <c:pt idx="2137">
                  <c:v>2.7353760702135101</c:v>
                </c:pt>
                <c:pt idx="2138">
                  <c:v>3.4291005202072302</c:v>
                </c:pt>
                <c:pt idx="2139">
                  <c:v>3.03854450366621</c:v>
                </c:pt>
                <c:pt idx="2140">
                  <c:v>3.0315773377670401</c:v>
                </c:pt>
                <c:pt idx="2141">
                  <c:v>3.5703174738739398</c:v>
                </c:pt>
                <c:pt idx="2142">
                  <c:v>2.61562115864495</c:v>
                </c:pt>
                <c:pt idx="2143">
                  <c:v>2.6481369076837602</c:v>
                </c:pt>
                <c:pt idx="2144">
                  <c:v>2.5795934347184502</c:v>
                </c:pt>
                <c:pt idx="2145">
                  <c:v>2.5695595797063899</c:v>
                </c:pt>
                <c:pt idx="2146">
                  <c:v>2.7582349825774402</c:v>
                </c:pt>
                <c:pt idx="2147">
                  <c:v>2.3607142842775599</c:v>
                </c:pt>
                <c:pt idx="2148">
                  <c:v>2.56527583071989</c:v>
                </c:pt>
                <c:pt idx="2149">
                  <c:v>2.74569450033388</c:v>
                </c:pt>
                <c:pt idx="2150">
                  <c:v>2.99905004707704</c:v>
                </c:pt>
                <c:pt idx="2151">
                  <c:v>2.8310552944718701</c:v>
                </c:pt>
                <c:pt idx="2152">
                  <c:v>3.2221747989634202</c:v>
                </c:pt>
                <c:pt idx="2153">
                  <c:v>2.96376465011156</c:v>
                </c:pt>
                <c:pt idx="2154">
                  <c:v>2.8990193996721501</c:v>
                </c:pt>
                <c:pt idx="2155">
                  <c:v>3.0046830612731599</c:v>
                </c:pt>
                <c:pt idx="2156">
                  <c:v>2.77219543060226</c:v>
                </c:pt>
                <c:pt idx="2157">
                  <c:v>2.3823806799237999</c:v>
                </c:pt>
                <c:pt idx="2158">
                  <c:v>3.0983924800765701</c:v>
                </c:pt>
                <c:pt idx="2159">
                  <c:v>3.1029099920052801</c:v>
                </c:pt>
                <c:pt idx="2160">
                  <c:v>3.34002870737852</c:v>
                </c:pt>
                <c:pt idx="2161">
                  <c:v>3.23906034972436</c:v>
                </c:pt>
                <c:pt idx="2162">
                  <c:v>2.5862491567490902</c:v>
                </c:pt>
                <c:pt idx="2163">
                  <c:v>2.81365275282799</c:v>
                </c:pt>
                <c:pt idx="2164">
                  <c:v>2.7306817633845202</c:v>
                </c:pt>
                <c:pt idx="2165">
                  <c:v>2.8961449344720198</c:v>
                </c:pt>
                <c:pt idx="2166">
                  <c:v>2.6667994288260699</c:v>
                </c:pt>
                <c:pt idx="2167">
                  <c:v>2.7145669278307798</c:v>
                </c:pt>
                <c:pt idx="2168">
                  <c:v>3.10869223449789</c:v>
                </c:pt>
                <c:pt idx="2169">
                  <c:v>2.8496547172735598</c:v>
                </c:pt>
                <c:pt idx="2170">
                  <c:v>3.1866694685729202</c:v>
                </c:pt>
                <c:pt idx="2171">
                  <c:v>3.1149420778654502</c:v>
                </c:pt>
                <c:pt idx="2172">
                  <c:v>2.49458381281221</c:v>
                </c:pt>
                <c:pt idx="2173">
                  <c:v>2.2110536451065501</c:v>
                </c:pt>
                <c:pt idx="2174">
                  <c:v>2.5122347993612202</c:v>
                </c:pt>
                <c:pt idx="2175">
                  <c:v>1.8988703637052899</c:v>
                </c:pt>
                <c:pt idx="2176">
                  <c:v>1.8373668923505599</c:v>
                </c:pt>
                <c:pt idx="2177">
                  <c:v>1.7883560490547199</c:v>
                </c:pt>
                <c:pt idx="2178">
                  <c:v>2.18555921358494</c:v>
                </c:pt>
                <c:pt idx="2179">
                  <c:v>1.7251541088670601</c:v>
                </c:pt>
                <c:pt idx="2180">
                  <c:v>1.3682901737767801</c:v>
                </c:pt>
                <c:pt idx="2181">
                  <c:v>1.7583594344768501</c:v>
                </c:pt>
                <c:pt idx="2182">
                  <c:v>2.96467507426896</c:v>
                </c:pt>
                <c:pt idx="2183">
                  <c:v>1.8316674345880699</c:v>
                </c:pt>
                <c:pt idx="2184">
                  <c:v>2.0531579095152499</c:v>
                </c:pt>
                <c:pt idx="2185">
                  <c:v>2.1430116100893102</c:v>
                </c:pt>
                <c:pt idx="2186">
                  <c:v>1.93067485700873</c:v>
                </c:pt>
                <c:pt idx="2187">
                  <c:v>2.5153253691230302</c:v>
                </c:pt>
                <c:pt idx="2188">
                  <c:v>1.5211563429886299</c:v>
                </c:pt>
                <c:pt idx="2189">
                  <c:v>2.1217787961624199</c:v>
                </c:pt>
                <c:pt idx="2190">
                  <c:v>1.31737739182247</c:v>
                </c:pt>
                <c:pt idx="2191">
                  <c:v>2.2554478578914399</c:v>
                </c:pt>
                <c:pt idx="2192">
                  <c:v>1.83274857598803</c:v>
                </c:pt>
                <c:pt idx="2193">
                  <c:v>1.69545931818767</c:v>
                </c:pt>
                <c:pt idx="2194">
                  <c:v>1.1835855676049101</c:v>
                </c:pt>
                <c:pt idx="2195">
                  <c:v>1.0269826886364899</c:v>
                </c:pt>
                <c:pt idx="2196">
                  <c:v>1.7794052800149001</c:v>
                </c:pt>
                <c:pt idx="2197">
                  <c:v>2.3077415036128301</c:v>
                </c:pt>
                <c:pt idx="2198">
                  <c:v>1.90075751038091</c:v>
                </c:pt>
                <c:pt idx="2199">
                  <c:v>2.1463266530104002</c:v>
                </c:pt>
                <c:pt idx="2200">
                  <c:v>2.1390565013888798</c:v>
                </c:pt>
                <c:pt idx="2201">
                  <c:v>1.9815387544174601</c:v>
                </c:pt>
                <c:pt idx="2202">
                  <c:v>2.25971055000372</c:v>
                </c:pt>
                <c:pt idx="2203">
                  <c:v>1.9056880964628899</c:v>
                </c:pt>
                <c:pt idx="2204">
                  <c:v>2.1747713792260002</c:v>
                </c:pt>
                <c:pt idx="2205">
                  <c:v>1.6820886795232199</c:v>
                </c:pt>
                <c:pt idx="2206">
                  <c:v>1.80405153590089</c:v>
                </c:pt>
                <c:pt idx="2207">
                  <c:v>2.1435991947301201</c:v>
                </c:pt>
                <c:pt idx="2208">
                  <c:v>1.7814810343988901</c:v>
                </c:pt>
                <c:pt idx="2209">
                  <c:v>1.6472372463106499</c:v>
                </c:pt>
                <c:pt idx="2210">
                  <c:v>2.2793024942336002</c:v>
                </c:pt>
                <c:pt idx="2211">
                  <c:v>1.9749458460474101</c:v>
                </c:pt>
                <c:pt idx="2212">
                  <c:v>2.05740415542004</c:v>
                </c:pt>
                <c:pt idx="2213">
                  <c:v>2.4835997320265801</c:v>
                </c:pt>
                <c:pt idx="2214">
                  <c:v>1.60046943604892</c:v>
                </c:pt>
                <c:pt idx="2215">
                  <c:v>2.1527255615857999</c:v>
                </c:pt>
                <c:pt idx="2216">
                  <c:v>1.7662951652833301</c:v>
                </c:pt>
                <c:pt idx="2217">
                  <c:v>1.8441540607815801</c:v>
                </c:pt>
                <c:pt idx="2218">
                  <c:v>2.2371778958773501</c:v>
                </c:pt>
                <c:pt idx="2219">
                  <c:v>2.5057286914143502</c:v>
                </c:pt>
                <c:pt idx="2220">
                  <c:v>1.9455480078414999</c:v>
                </c:pt>
                <c:pt idx="2221">
                  <c:v>2.2358124412246898</c:v>
                </c:pt>
                <c:pt idx="2222">
                  <c:v>2.2519549012539302</c:v>
                </c:pt>
                <c:pt idx="2223">
                  <c:v>1.8078403322079499</c:v>
                </c:pt>
                <c:pt idx="2224">
                  <c:v>1.9534979161093899</c:v>
                </c:pt>
                <c:pt idx="2225">
                  <c:v>1.8158568128495201</c:v>
                </c:pt>
                <c:pt idx="2226">
                  <c:v>1.6144353982669599</c:v>
                </c:pt>
                <c:pt idx="2227">
                  <c:v>1.6979257451862699</c:v>
                </c:pt>
                <c:pt idx="2228">
                  <c:v>2.43822145384107</c:v>
                </c:pt>
                <c:pt idx="2229">
                  <c:v>2.0570670404791001</c:v>
                </c:pt>
                <c:pt idx="2230">
                  <c:v>2.25918418697891</c:v>
                </c:pt>
                <c:pt idx="2231">
                  <c:v>2.3972923771000501</c:v>
                </c:pt>
                <c:pt idx="2232">
                  <c:v>2.0438893459034602</c:v>
                </c:pt>
                <c:pt idx="2233">
                  <c:v>1.82073665486522</c:v>
                </c:pt>
                <c:pt idx="2234">
                  <c:v>2.60872103873798</c:v>
                </c:pt>
                <c:pt idx="2235">
                  <c:v>1.7054834560407599</c:v>
                </c:pt>
                <c:pt idx="2236">
                  <c:v>2.1742577067188602</c:v>
                </c:pt>
                <c:pt idx="2237">
                  <c:v>1.81196655004188</c:v>
                </c:pt>
                <c:pt idx="2238">
                  <c:v>2.8235460372866399</c:v>
                </c:pt>
                <c:pt idx="2239">
                  <c:v>1.6078573144378301</c:v>
                </c:pt>
                <c:pt idx="2240">
                  <c:v>1.76349081501187</c:v>
                </c:pt>
                <c:pt idx="2241">
                  <c:v>1.7884481869836899</c:v>
                </c:pt>
                <c:pt idx="2242">
                  <c:v>1.5985768724987399</c:v>
                </c:pt>
                <c:pt idx="2243">
                  <c:v>2.06530648189971</c:v>
                </c:pt>
                <c:pt idx="2244">
                  <c:v>1.99043914130299</c:v>
                </c:pt>
                <c:pt idx="2245">
                  <c:v>1.3937005062323</c:v>
                </c:pt>
                <c:pt idx="2246">
                  <c:v>1.6528262495919599</c:v>
                </c:pt>
                <c:pt idx="2247">
                  <c:v>1.90582516471492</c:v>
                </c:pt>
                <c:pt idx="2248">
                  <c:v>1.83033790283798</c:v>
                </c:pt>
                <c:pt idx="2249">
                  <c:v>2.0583722685377599</c:v>
                </c:pt>
                <c:pt idx="2250">
                  <c:v>1.88916033075222</c:v>
                </c:pt>
                <c:pt idx="2251">
                  <c:v>1.5558841060175801</c:v>
                </c:pt>
                <c:pt idx="2252">
                  <c:v>2.1764084485050001</c:v>
                </c:pt>
                <c:pt idx="2253">
                  <c:v>1.83721567506162</c:v>
                </c:pt>
                <c:pt idx="2254">
                  <c:v>1.6106488637505301</c:v>
                </c:pt>
                <c:pt idx="2255">
                  <c:v>2.0132041768975402</c:v>
                </c:pt>
                <c:pt idx="2256">
                  <c:v>1.80307388446067</c:v>
                </c:pt>
                <c:pt idx="2257">
                  <c:v>2.1185280082247799</c:v>
                </c:pt>
                <c:pt idx="2258">
                  <c:v>2.3469736143221298</c:v>
                </c:pt>
                <c:pt idx="2259">
                  <c:v>2.20878446998758</c:v>
                </c:pt>
                <c:pt idx="2260">
                  <c:v>1.65451205069855</c:v>
                </c:pt>
                <c:pt idx="2261">
                  <c:v>1.5751228625300999</c:v>
                </c:pt>
                <c:pt idx="2262">
                  <c:v>1.98925804520327</c:v>
                </c:pt>
                <c:pt idx="2263">
                  <c:v>1.9305082949050101</c:v>
                </c:pt>
                <c:pt idx="2264">
                  <c:v>2.4321970497404299</c:v>
                </c:pt>
                <c:pt idx="2265">
                  <c:v>2.4605407830558499</c:v>
                </c:pt>
                <c:pt idx="2266">
                  <c:v>1.6437812610089999</c:v>
                </c:pt>
                <c:pt idx="2267">
                  <c:v>1.8053133065174201</c:v>
                </c:pt>
                <c:pt idx="2268">
                  <c:v>2.47470309336697</c:v>
                </c:pt>
                <c:pt idx="2269">
                  <c:v>1.48585545235037</c:v>
                </c:pt>
                <c:pt idx="2270">
                  <c:v>1.5310610331327801</c:v>
                </c:pt>
                <c:pt idx="2271">
                  <c:v>2.5582482755799401</c:v>
                </c:pt>
                <c:pt idx="2272">
                  <c:v>1.79911130312881</c:v>
                </c:pt>
                <c:pt idx="2273">
                  <c:v>1.95994336537116</c:v>
                </c:pt>
                <c:pt idx="2274">
                  <c:v>1.8508519832688901</c:v>
                </c:pt>
                <c:pt idx="2275">
                  <c:v>2.70932267381527</c:v>
                </c:pt>
                <c:pt idx="2276">
                  <c:v>1.79932431792026</c:v>
                </c:pt>
                <c:pt idx="2277">
                  <c:v>2.3239108807782101</c:v>
                </c:pt>
                <c:pt idx="2278">
                  <c:v>1.49272628710719</c:v>
                </c:pt>
                <c:pt idx="2279">
                  <c:v>1.2699360691572901</c:v>
                </c:pt>
                <c:pt idx="2280">
                  <c:v>2.33830289667022</c:v>
                </c:pt>
                <c:pt idx="2281">
                  <c:v>1.7475295529902499</c:v>
                </c:pt>
                <c:pt idx="2282">
                  <c:v>1.73418629396685</c:v>
                </c:pt>
                <c:pt idx="2283">
                  <c:v>1.9272281314287401</c:v>
                </c:pt>
                <c:pt idx="2284">
                  <c:v>1.8361896929371699</c:v>
                </c:pt>
                <c:pt idx="2285">
                  <c:v>2.0835991172158899</c:v>
                </c:pt>
                <c:pt idx="2286">
                  <c:v>1.5923600196760801</c:v>
                </c:pt>
                <c:pt idx="2287">
                  <c:v>1.3856061596079501</c:v>
                </c:pt>
                <c:pt idx="2288">
                  <c:v>1.28119703672068</c:v>
                </c:pt>
                <c:pt idx="2289">
                  <c:v>1.55092967968008</c:v>
                </c:pt>
                <c:pt idx="2290">
                  <c:v>1.62423253362123</c:v>
                </c:pt>
                <c:pt idx="2291">
                  <c:v>1.32228723335579</c:v>
                </c:pt>
                <c:pt idx="2292">
                  <c:v>1.56549375408832</c:v>
                </c:pt>
                <c:pt idx="2293">
                  <c:v>1.7468891341261099</c:v>
                </c:pt>
                <c:pt idx="2294">
                  <c:v>1.76315724662645</c:v>
                </c:pt>
                <c:pt idx="2295">
                  <c:v>2.1765093485770102</c:v>
                </c:pt>
                <c:pt idx="2296">
                  <c:v>1.6353353660639001</c:v>
                </c:pt>
                <c:pt idx="2297">
                  <c:v>1.60520413933309</c:v>
                </c:pt>
                <c:pt idx="2298">
                  <c:v>1.7822932026726199</c:v>
                </c:pt>
                <c:pt idx="2299">
                  <c:v>1.6115312628439</c:v>
                </c:pt>
                <c:pt idx="2300">
                  <c:v>1.9123725921456101</c:v>
                </c:pt>
                <c:pt idx="2301">
                  <c:v>1.40251133703919</c:v>
                </c:pt>
                <c:pt idx="2302">
                  <c:v>2.11743866243983</c:v>
                </c:pt>
                <c:pt idx="2303">
                  <c:v>2.0740683973669798</c:v>
                </c:pt>
                <c:pt idx="2304">
                  <c:v>2.1568012723969998</c:v>
                </c:pt>
                <c:pt idx="2305">
                  <c:v>1.6051089356969299</c:v>
                </c:pt>
                <c:pt idx="2306">
                  <c:v>2.22706640666091</c:v>
                </c:pt>
                <c:pt idx="2307">
                  <c:v>2.2800004385034001</c:v>
                </c:pt>
                <c:pt idx="2308">
                  <c:v>1.91092157547963</c:v>
                </c:pt>
                <c:pt idx="2309">
                  <c:v>2.2561745892675602</c:v>
                </c:pt>
                <c:pt idx="2310">
                  <c:v>1.9715609782630199</c:v>
                </c:pt>
                <c:pt idx="2311">
                  <c:v>1.56442855633306</c:v>
                </c:pt>
                <c:pt idx="2312">
                  <c:v>2.1599136270221702</c:v>
                </c:pt>
                <c:pt idx="2313">
                  <c:v>1.9607907087083001</c:v>
                </c:pt>
                <c:pt idx="2314">
                  <c:v>1.6398138581056101</c:v>
                </c:pt>
                <c:pt idx="2315">
                  <c:v>1.5758347464957101</c:v>
                </c:pt>
                <c:pt idx="2316">
                  <c:v>2.37804464928415</c:v>
                </c:pt>
                <c:pt idx="2317">
                  <c:v>1.86244329458002</c:v>
                </c:pt>
                <c:pt idx="2318">
                  <c:v>1.74712985263479</c:v>
                </c:pt>
                <c:pt idx="2319">
                  <c:v>1.8619637663714499</c:v>
                </c:pt>
                <c:pt idx="2320">
                  <c:v>1.94207673504126</c:v>
                </c:pt>
                <c:pt idx="2321">
                  <c:v>1.6765675565163001</c:v>
                </c:pt>
                <c:pt idx="2322">
                  <c:v>1.5255557975698</c:v>
                </c:pt>
                <c:pt idx="2323">
                  <c:v>1.56032708288697</c:v>
                </c:pt>
                <c:pt idx="2324">
                  <c:v>1.6744096469782801</c:v>
                </c:pt>
                <c:pt idx="2325">
                  <c:v>1.59473707955303</c:v>
                </c:pt>
                <c:pt idx="2326">
                  <c:v>1.8720750925594001</c:v>
                </c:pt>
                <c:pt idx="2327">
                  <c:v>1.5912421202317599</c:v>
                </c:pt>
                <c:pt idx="2328">
                  <c:v>1.9430413202519701</c:v>
                </c:pt>
                <c:pt idx="2329">
                  <c:v>1.76481280798336</c:v>
                </c:pt>
                <c:pt idx="2330">
                  <c:v>1.8757391266675201</c:v>
                </c:pt>
                <c:pt idx="2331">
                  <c:v>1.85109036018805</c:v>
                </c:pt>
                <c:pt idx="2332">
                  <c:v>1.5787558219720299</c:v>
                </c:pt>
                <c:pt idx="2333">
                  <c:v>2.33463749080784</c:v>
                </c:pt>
                <c:pt idx="2334">
                  <c:v>1.9186847088745</c:v>
                </c:pt>
                <c:pt idx="2335">
                  <c:v>2.3628031063350101</c:v>
                </c:pt>
                <c:pt idx="2336">
                  <c:v>2.2193306893000901</c:v>
                </c:pt>
                <c:pt idx="2337">
                  <c:v>1.95690456779434</c:v>
                </c:pt>
                <c:pt idx="2338">
                  <c:v>1.77193556200707</c:v>
                </c:pt>
                <c:pt idx="2339">
                  <c:v>2.1549320998614601</c:v>
                </c:pt>
                <c:pt idx="2340">
                  <c:v>1.88632963926911</c:v>
                </c:pt>
                <c:pt idx="2341">
                  <c:v>2.7070319984473499</c:v>
                </c:pt>
                <c:pt idx="2342">
                  <c:v>2.1763989935155501</c:v>
                </c:pt>
                <c:pt idx="2343">
                  <c:v>1.71871985851564</c:v>
                </c:pt>
                <c:pt idx="2344">
                  <c:v>1.8420333397317901</c:v>
                </c:pt>
                <c:pt idx="2345">
                  <c:v>1.9742240400265101</c:v>
                </c:pt>
                <c:pt idx="2346">
                  <c:v>1.57941910718626</c:v>
                </c:pt>
                <c:pt idx="2347">
                  <c:v>1.4971853599073</c:v>
                </c:pt>
                <c:pt idx="2348">
                  <c:v>1.7975485879619</c:v>
                </c:pt>
                <c:pt idx="2349">
                  <c:v>2.61119173686077</c:v>
                </c:pt>
                <c:pt idx="2350">
                  <c:v>2.2673896151751798</c:v>
                </c:pt>
                <c:pt idx="2351">
                  <c:v>1.5832152682799301</c:v>
                </c:pt>
                <c:pt idx="2352">
                  <c:v>2.02668976732462</c:v>
                </c:pt>
                <c:pt idx="2353">
                  <c:v>1.91926715446215</c:v>
                </c:pt>
                <c:pt idx="2354">
                  <c:v>2.45780436333856</c:v>
                </c:pt>
                <c:pt idx="2355">
                  <c:v>2.7889384391186298</c:v>
                </c:pt>
                <c:pt idx="2356">
                  <c:v>2.8581823437600402</c:v>
                </c:pt>
                <c:pt idx="2357">
                  <c:v>2.26485544271004</c:v>
                </c:pt>
                <c:pt idx="2358">
                  <c:v>1.67638337782708</c:v>
                </c:pt>
                <c:pt idx="2359">
                  <c:v>2.4753351791483502</c:v>
                </c:pt>
                <c:pt idx="2360">
                  <c:v>2.0871999104525099</c:v>
                </c:pt>
                <c:pt idx="2361">
                  <c:v>1.46196249788955</c:v>
                </c:pt>
                <c:pt idx="2362">
                  <c:v>2.0675874127876601</c:v>
                </c:pt>
                <c:pt idx="2363">
                  <c:v>1.86283178106016</c:v>
                </c:pt>
                <c:pt idx="2364">
                  <c:v>1.4923627757620901</c:v>
                </c:pt>
                <c:pt idx="2365">
                  <c:v>2.2803413963556101</c:v>
                </c:pt>
                <c:pt idx="2366">
                  <c:v>1.91739474670877</c:v>
                </c:pt>
                <c:pt idx="2367">
                  <c:v>2.3387678279689301</c:v>
                </c:pt>
                <c:pt idx="2368">
                  <c:v>2.3358695969552499</c:v>
                </c:pt>
                <c:pt idx="2369">
                  <c:v>2.2482975266582002</c:v>
                </c:pt>
                <c:pt idx="2370">
                  <c:v>2.2454171327695902</c:v>
                </c:pt>
                <c:pt idx="2371">
                  <c:v>2.2149619472510902</c:v>
                </c:pt>
                <c:pt idx="2372">
                  <c:v>2.27076975579241</c:v>
                </c:pt>
                <c:pt idx="2373">
                  <c:v>2.3318408733700799</c:v>
                </c:pt>
                <c:pt idx="2374">
                  <c:v>1.81979838304187</c:v>
                </c:pt>
                <c:pt idx="2375">
                  <c:v>2.3049719516867699</c:v>
                </c:pt>
                <c:pt idx="2376">
                  <c:v>2.7244281092845899</c:v>
                </c:pt>
                <c:pt idx="2377">
                  <c:v>2.6169286602627202</c:v>
                </c:pt>
                <c:pt idx="2378">
                  <c:v>2.59982642397611</c:v>
                </c:pt>
                <c:pt idx="2379">
                  <c:v>2.76746752688546</c:v>
                </c:pt>
                <c:pt idx="2380">
                  <c:v>2.7157726605869899</c:v>
                </c:pt>
                <c:pt idx="2381">
                  <c:v>2.1997761643069098</c:v>
                </c:pt>
                <c:pt idx="2382">
                  <c:v>1.95951136751968</c:v>
                </c:pt>
                <c:pt idx="2383">
                  <c:v>1.935873800675</c:v>
                </c:pt>
                <c:pt idx="2384">
                  <c:v>2.3689356495133902</c:v>
                </c:pt>
                <c:pt idx="2385">
                  <c:v>1.94892307205268</c:v>
                </c:pt>
                <c:pt idx="2386">
                  <c:v>1.89522897875708</c:v>
                </c:pt>
                <c:pt idx="2387">
                  <c:v>2.1527857670441102</c:v>
                </c:pt>
                <c:pt idx="2388">
                  <c:v>2.3979418051974002</c:v>
                </c:pt>
                <c:pt idx="2389">
                  <c:v>2.4268681156308198</c:v>
                </c:pt>
                <c:pt idx="2390">
                  <c:v>2.84102467036019</c:v>
                </c:pt>
                <c:pt idx="2391">
                  <c:v>2.24324982323783</c:v>
                </c:pt>
                <c:pt idx="2392">
                  <c:v>2.2539711633449899</c:v>
                </c:pt>
                <c:pt idx="2393">
                  <c:v>2.61659151914419</c:v>
                </c:pt>
                <c:pt idx="2394">
                  <c:v>2.0335571875745599</c:v>
                </c:pt>
                <c:pt idx="2395">
                  <c:v>2.68104893192407</c:v>
                </c:pt>
                <c:pt idx="2396">
                  <c:v>2.3958143057229102</c:v>
                </c:pt>
                <c:pt idx="2397">
                  <c:v>3.1318128301189998</c:v>
                </c:pt>
                <c:pt idx="2398">
                  <c:v>2.7415889666273499</c:v>
                </c:pt>
                <c:pt idx="2399">
                  <c:v>2.6996462687084799</c:v>
                </c:pt>
                <c:pt idx="2400">
                  <c:v>2.3539020963116299</c:v>
                </c:pt>
                <c:pt idx="2401">
                  <c:v>2.0285735749646299</c:v>
                </c:pt>
                <c:pt idx="2402">
                  <c:v>2.34727796908233</c:v>
                </c:pt>
                <c:pt idx="2403">
                  <c:v>2.1811183983755198</c:v>
                </c:pt>
                <c:pt idx="2404">
                  <c:v>2.6144784232081499</c:v>
                </c:pt>
                <c:pt idx="2405">
                  <c:v>2.1826219301005398</c:v>
                </c:pt>
                <c:pt idx="2406">
                  <c:v>2.6876098926088399</c:v>
                </c:pt>
                <c:pt idx="2407">
                  <c:v>2.2546548738447898</c:v>
                </c:pt>
                <c:pt idx="2408">
                  <c:v>2.48316813732432</c:v>
                </c:pt>
                <c:pt idx="2409">
                  <c:v>2.6368833474835198</c:v>
                </c:pt>
                <c:pt idx="2410">
                  <c:v>2.3190461164222702</c:v>
                </c:pt>
                <c:pt idx="2411">
                  <c:v>1.9975870109637801</c:v>
                </c:pt>
                <c:pt idx="2412">
                  <c:v>2.5951554522645202</c:v>
                </c:pt>
                <c:pt idx="2413">
                  <c:v>2.1655708485090699</c:v>
                </c:pt>
                <c:pt idx="2414">
                  <c:v>1.66518695836093</c:v>
                </c:pt>
                <c:pt idx="2415">
                  <c:v>2.1601053669702499</c:v>
                </c:pt>
                <c:pt idx="2416">
                  <c:v>2.8589686532973499</c:v>
                </c:pt>
                <c:pt idx="2417">
                  <c:v>2.1432130281110799</c:v>
                </c:pt>
                <c:pt idx="2418">
                  <c:v>2.2981899616835602</c:v>
                </c:pt>
                <c:pt idx="2419">
                  <c:v>1.8836637128131499</c:v>
                </c:pt>
                <c:pt idx="2420">
                  <c:v>1.33366887305857</c:v>
                </c:pt>
                <c:pt idx="2421">
                  <c:v>2.1205233210486298</c:v>
                </c:pt>
                <c:pt idx="2422">
                  <c:v>2.13751915558572</c:v>
                </c:pt>
                <c:pt idx="2423">
                  <c:v>2.4373982967046501</c:v>
                </c:pt>
                <c:pt idx="2424">
                  <c:v>2.9213213323496099</c:v>
                </c:pt>
                <c:pt idx="2425">
                  <c:v>2.1312430335511499</c:v>
                </c:pt>
                <c:pt idx="2426">
                  <c:v>2.76480609830368</c:v>
                </c:pt>
                <c:pt idx="2427">
                  <c:v>2.4927521286029801</c:v>
                </c:pt>
                <c:pt idx="2428">
                  <c:v>2.2256279406353201</c:v>
                </c:pt>
                <c:pt idx="2429">
                  <c:v>2.6734372314553001</c:v>
                </c:pt>
                <c:pt idx="2430">
                  <c:v>1.97961447000385</c:v>
                </c:pt>
                <c:pt idx="2431">
                  <c:v>2.4351821740914099</c:v>
                </c:pt>
                <c:pt idx="2432">
                  <c:v>1.76042257623039</c:v>
                </c:pt>
                <c:pt idx="2433">
                  <c:v>2.03340332461114</c:v>
                </c:pt>
                <c:pt idx="2434">
                  <c:v>2.1308411073741</c:v>
                </c:pt>
                <c:pt idx="2435">
                  <c:v>1.90088442073162</c:v>
                </c:pt>
                <c:pt idx="2436">
                  <c:v>2.3353083972578501</c:v>
                </c:pt>
                <c:pt idx="2437">
                  <c:v>2.7166985167158502</c:v>
                </c:pt>
                <c:pt idx="2438">
                  <c:v>2.50869111583307</c:v>
                </c:pt>
                <c:pt idx="2439">
                  <c:v>1.9476930500732399</c:v>
                </c:pt>
                <c:pt idx="2440">
                  <c:v>2.0100677218844401</c:v>
                </c:pt>
                <c:pt idx="2441">
                  <c:v>2.3621893538611101</c:v>
                </c:pt>
                <c:pt idx="2442">
                  <c:v>2.08765342992537</c:v>
                </c:pt>
                <c:pt idx="2443">
                  <c:v>2.1549793490884399</c:v>
                </c:pt>
                <c:pt idx="2444">
                  <c:v>2.10092314526237</c:v>
                </c:pt>
                <c:pt idx="2445">
                  <c:v>2.0397083653997599</c:v>
                </c:pt>
                <c:pt idx="2446">
                  <c:v>1.6451728845803699</c:v>
                </c:pt>
                <c:pt idx="2447">
                  <c:v>2.6053650531719099</c:v>
                </c:pt>
                <c:pt idx="2448">
                  <c:v>2.2109125202164801</c:v>
                </c:pt>
                <c:pt idx="2449">
                  <c:v>3.1150689579872402</c:v>
                </c:pt>
                <c:pt idx="2450">
                  <c:v>2.004169018482</c:v>
                </c:pt>
                <c:pt idx="2451">
                  <c:v>2.1721722068332001</c:v>
                </c:pt>
                <c:pt idx="2452">
                  <c:v>1.7845646352373501</c:v>
                </c:pt>
                <c:pt idx="2453">
                  <c:v>2.75203939579337</c:v>
                </c:pt>
                <c:pt idx="2454">
                  <c:v>1.7494626154758199</c:v>
                </c:pt>
                <c:pt idx="2455">
                  <c:v>2.77360529510312</c:v>
                </c:pt>
                <c:pt idx="2456">
                  <c:v>1.4760159425121799</c:v>
                </c:pt>
                <c:pt idx="2457">
                  <c:v>2.4870480254054499</c:v>
                </c:pt>
                <c:pt idx="2458">
                  <c:v>2.12081695701578</c:v>
                </c:pt>
                <c:pt idx="2459">
                  <c:v>2.6022294820742502</c:v>
                </c:pt>
                <c:pt idx="2460">
                  <c:v>2.2757382891955098</c:v>
                </c:pt>
                <c:pt idx="2461">
                  <c:v>2.3434740063645401</c:v>
                </c:pt>
                <c:pt idx="2462">
                  <c:v>2.0754044778596499</c:v>
                </c:pt>
                <c:pt idx="2463">
                  <c:v>2.6937544511034699</c:v>
                </c:pt>
                <c:pt idx="2464">
                  <c:v>2.2057569899858298</c:v>
                </c:pt>
                <c:pt idx="2465">
                  <c:v>2.4006500692736199</c:v>
                </c:pt>
                <c:pt idx="2466">
                  <c:v>1.81992649788869</c:v>
                </c:pt>
                <c:pt idx="2467">
                  <c:v>2.54596630529602</c:v>
                </c:pt>
                <c:pt idx="2468">
                  <c:v>1.8789016487430701</c:v>
                </c:pt>
                <c:pt idx="2469">
                  <c:v>1.9955975293799</c:v>
                </c:pt>
                <c:pt idx="2470">
                  <c:v>1.60558827209737</c:v>
                </c:pt>
                <c:pt idx="2471">
                  <c:v>1.86121251941336</c:v>
                </c:pt>
                <c:pt idx="2472">
                  <c:v>2.1493268578913201</c:v>
                </c:pt>
                <c:pt idx="2473">
                  <c:v>2.19890770991034</c:v>
                </c:pt>
                <c:pt idx="2474">
                  <c:v>2.0020118562993598</c:v>
                </c:pt>
                <c:pt idx="2475">
                  <c:v>2.34387930615036</c:v>
                </c:pt>
                <c:pt idx="2476">
                  <c:v>2.1869216221449799</c:v>
                </c:pt>
                <c:pt idx="2477">
                  <c:v>2.17716546456094</c:v>
                </c:pt>
                <c:pt idx="2478">
                  <c:v>2.0198843937377</c:v>
                </c:pt>
                <c:pt idx="2479">
                  <c:v>1.7607777114705201</c:v>
                </c:pt>
                <c:pt idx="2480">
                  <c:v>2.2359425500057402</c:v>
                </c:pt>
                <c:pt idx="2481">
                  <c:v>1.6423180937008399</c:v>
                </c:pt>
                <c:pt idx="2482">
                  <c:v>1.7513022486677701</c:v>
                </c:pt>
                <c:pt idx="2483">
                  <c:v>1.5731452725805599</c:v>
                </c:pt>
                <c:pt idx="2484">
                  <c:v>1.7602182850899899</c:v>
                </c:pt>
                <c:pt idx="2485">
                  <c:v>1.0306074270388901</c:v>
                </c:pt>
                <c:pt idx="2486">
                  <c:v>2.3185541347027998</c:v>
                </c:pt>
                <c:pt idx="2487">
                  <c:v>1.83853665975626</c:v>
                </c:pt>
                <c:pt idx="2488">
                  <c:v>1.8894864134825999</c:v>
                </c:pt>
                <c:pt idx="2489">
                  <c:v>1.8731535681440299</c:v>
                </c:pt>
                <c:pt idx="2490">
                  <c:v>1.7190079715361</c:v>
                </c:pt>
                <c:pt idx="2491">
                  <c:v>1.5917046988869701</c:v>
                </c:pt>
                <c:pt idx="2492">
                  <c:v>2.0626252099824001</c:v>
                </c:pt>
                <c:pt idx="2493">
                  <c:v>1.42076054533234</c:v>
                </c:pt>
                <c:pt idx="2494">
                  <c:v>1.7710096273599301</c:v>
                </c:pt>
                <c:pt idx="2495">
                  <c:v>0.99261349448223302</c:v>
                </c:pt>
                <c:pt idx="2496">
                  <c:v>1.3735765718284101</c:v>
                </c:pt>
                <c:pt idx="2497">
                  <c:v>1.5714292206126499</c:v>
                </c:pt>
                <c:pt idx="2498">
                  <c:v>1.2817184316121</c:v>
                </c:pt>
                <c:pt idx="2499">
                  <c:v>1.4904224514548301</c:v>
                </c:pt>
                <c:pt idx="2500">
                  <c:v>1.94583555906228</c:v>
                </c:pt>
                <c:pt idx="2501">
                  <c:v>1.8990427386420501</c:v>
                </c:pt>
                <c:pt idx="2502">
                  <c:v>2.1336744916216799</c:v>
                </c:pt>
                <c:pt idx="2503">
                  <c:v>1.6437531399477701</c:v>
                </c:pt>
                <c:pt idx="2504">
                  <c:v>2.7306812237459499</c:v>
                </c:pt>
                <c:pt idx="2505">
                  <c:v>2.0539023485066301</c:v>
                </c:pt>
                <c:pt idx="2506">
                  <c:v>1.99075251416246</c:v>
                </c:pt>
                <c:pt idx="2507">
                  <c:v>1.74960039922809</c:v>
                </c:pt>
                <c:pt idx="2508">
                  <c:v>2.1631610243123802</c:v>
                </c:pt>
                <c:pt idx="2509">
                  <c:v>2.33381731062225</c:v>
                </c:pt>
                <c:pt idx="2510">
                  <c:v>2.53100934235052</c:v>
                </c:pt>
                <c:pt idx="2511">
                  <c:v>2.3936786802297401</c:v>
                </c:pt>
                <c:pt idx="2512">
                  <c:v>1.76888811646043</c:v>
                </c:pt>
                <c:pt idx="2513">
                  <c:v>1.9941832140796101</c:v>
                </c:pt>
                <c:pt idx="2514">
                  <c:v>2.1582390616439402</c:v>
                </c:pt>
                <c:pt idx="2515">
                  <c:v>1.91566086386873</c:v>
                </c:pt>
                <c:pt idx="2516">
                  <c:v>1.92246156595183</c:v>
                </c:pt>
                <c:pt idx="2517">
                  <c:v>2.0648965780525601</c:v>
                </c:pt>
                <c:pt idx="2518">
                  <c:v>1.95293679998175</c:v>
                </c:pt>
                <c:pt idx="2519">
                  <c:v>1.6906096958671299</c:v>
                </c:pt>
                <c:pt idx="2520">
                  <c:v>2.2994256012844998</c:v>
                </c:pt>
                <c:pt idx="2521">
                  <c:v>2.0066785370103801</c:v>
                </c:pt>
                <c:pt idx="2522">
                  <c:v>1.75961535361758</c:v>
                </c:pt>
                <c:pt idx="2523">
                  <c:v>2.7107232651254698</c:v>
                </c:pt>
                <c:pt idx="2524">
                  <c:v>2.5003933371145601</c:v>
                </c:pt>
                <c:pt idx="2525">
                  <c:v>1.97298892579221</c:v>
                </c:pt>
                <c:pt idx="2526">
                  <c:v>1.8178347170603499</c:v>
                </c:pt>
                <c:pt idx="2527">
                  <c:v>1.7766358320671101</c:v>
                </c:pt>
                <c:pt idx="2528">
                  <c:v>1.94774228072977</c:v>
                </c:pt>
                <c:pt idx="2529">
                  <c:v>1.4498355526177999</c:v>
                </c:pt>
                <c:pt idx="2530">
                  <c:v>1.7329084720154899</c:v>
                </c:pt>
                <c:pt idx="2531">
                  <c:v>1.9209499080610299</c:v>
                </c:pt>
                <c:pt idx="2532">
                  <c:v>2.2099431730026402</c:v>
                </c:pt>
                <c:pt idx="2533">
                  <c:v>2.7743762960419098</c:v>
                </c:pt>
                <c:pt idx="2534">
                  <c:v>2.5305239830396302</c:v>
                </c:pt>
                <c:pt idx="2535">
                  <c:v>2.1633061139973799</c:v>
                </c:pt>
                <c:pt idx="2536">
                  <c:v>2.4151427857175398</c:v>
                </c:pt>
                <c:pt idx="2537">
                  <c:v>2.5405986103780398</c:v>
                </c:pt>
                <c:pt idx="2538">
                  <c:v>2.4505134761326901</c:v>
                </c:pt>
                <c:pt idx="2539">
                  <c:v>2.4174167377426201</c:v>
                </c:pt>
                <c:pt idx="2540">
                  <c:v>2.45718800028444</c:v>
                </c:pt>
                <c:pt idx="2541">
                  <c:v>2.0946794561739899</c:v>
                </c:pt>
                <c:pt idx="2542">
                  <c:v>2.6909957383107601</c:v>
                </c:pt>
                <c:pt idx="2543">
                  <c:v>2.55287648672584</c:v>
                </c:pt>
                <c:pt idx="2544">
                  <c:v>1.6945054203311301</c:v>
                </c:pt>
                <c:pt idx="2545">
                  <c:v>1.8651862741359599</c:v>
                </c:pt>
                <c:pt idx="2546">
                  <c:v>2.2588375501816298</c:v>
                </c:pt>
                <c:pt idx="2547">
                  <c:v>1.9451627231623001</c:v>
                </c:pt>
                <c:pt idx="2548">
                  <c:v>0.86062866118760395</c:v>
                </c:pt>
                <c:pt idx="2549">
                  <c:v>1.66854754602927</c:v>
                </c:pt>
                <c:pt idx="2550">
                  <c:v>1.41354398768831</c:v>
                </c:pt>
                <c:pt idx="2551">
                  <c:v>1.6848825448853</c:v>
                </c:pt>
                <c:pt idx="2552">
                  <c:v>2.3160137911441998</c:v>
                </c:pt>
                <c:pt idx="2553">
                  <c:v>1.52799692954557</c:v>
                </c:pt>
                <c:pt idx="2554">
                  <c:v>1.90195912636439</c:v>
                </c:pt>
                <c:pt idx="2555">
                  <c:v>1.5041038758856</c:v>
                </c:pt>
                <c:pt idx="2556">
                  <c:v>1.6617416909187299</c:v>
                </c:pt>
                <c:pt idx="2557">
                  <c:v>1.5792021419894799</c:v>
                </c:pt>
                <c:pt idx="2558">
                  <c:v>1.74490008946416</c:v>
                </c:pt>
                <c:pt idx="2559">
                  <c:v>2.5064909814741498</c:v>
                </c:pt>
                <c:pt idx="2560">
                  <c:v>2.1917046882031701</c:v>
                </c:pt>
                <c:pt idx="2561">
                  <c:v>3.24533207994974</c:v>
                </c:pt>
                <c:pt idx="2562">
                  <c:v>1.83889535435078</c:v>
                </c:pt>
                <c:pt idx="2563">
                  <c:v>2.00117752031968</c:v>
                </c:pt>
                <c:pt idx="2564">
                  <c:v>2.7002212095030802</c:v>
                </c:pt>
                <c:pt idx="2565">
                  <c:v>3.4936864218678698</c:v>
                </c:pt>
                <c:pt idx="2566">
                  <c:v>3.2598474599093001</c:v>
                </c:pt>
                <c:pt idx="2567">
                  <c:v>2.3373031059522398</c:v>
                </c:pt>
                <c:pt idx="2568">
                  <c:v>2.29104832709164</c:v>
                </c:pt>
                <c:pt idx="2569">
                  <c:v>2.99483920654618</c:v>
                </c:pt>
                <c:pt idx="2570">
                  <c:v>2.5572733357333299</c:v>
                </c:pt>
                <c:pt idx="2571">
                  <c:v>2.21799772824623</c:v>
                </c:pt>
                <c:pt idx="2572">
                  <c:v>2.0173500876862902</c:v>
                </c:pt>
                <c:pt idx="2573">
                  <c:v>2.2106337802208502</c:v>
                </c:pt>
                <c:pt idx="2574">
                  <c:v>2.3596135087908099</c:v>
                </c:pt>
                <c:pt idx="2575">
                  <c:v>1.79305921071263</c:v>
                </c:pt>
                <c:pt idx="2576">
                  <c:v>2.89893533462556</c:v>
                </c:pt>
                <c:pt idx="2577">
                  <c:v>3.0341535609884098</c:v>
                </c:pt>
                <c:pt idx="2578">
                  <c:v>2.5505091123269401</c:v>
                </c:pt>
                <c:pt idx="2579">
                  <c:v>2.5537676396508702</c:v>
                </c:pt>
                <c:pt idx="2580">
                  <c:v>2.8731309199628501</c:v>
                </c:pt>
                <c:pt idx="2581">
                  <c:v>2.8476023927982501</c:v>
                </c:pt>
                <c:pt idx="2582">
                  <c:v>2.66363856672164</c:v>
                </c:pt>
                <c:pt idx="2583">
                  <c:v>2.74113005145146</c:v>
                </c:pt>
                <c:pt idx="2584">
                  <c:v>2.5895295456822498</c:v>
                </c:pt>
                <c:pt idx="2585">
                  <c:v>2.3184101734204399</c:v>
                </c:pt>
                <c:pt idx="2586">
                  <c:v>2.2097348424249201</c:v>
                </c:pt>
                <c:pt idx="2587">
                  <c:v>1.8812563306980199</c:v>
                </c:pt>
                <c:pt idx="2588">
                  <c:v>1.92262381180562</c:v>
                </c:pt>
                <c:pt idx="2589">
                  <c:v>2.1484529641510499</c:v>
                </c:pt>
                <c:pt idx="2590">
                  <c:v>2.19509410169448</c:v>
                </c:pt>
                <c:pt idx="2591">
                  <c:v>1.59353640833899</c:v>
                </c:pt>
                <c:pt idx="2592">
                  <c:v>1.4785792113938301</c:v>
                </c:pt>
                <c:pt idx="2593">
                  <c:v>1.8707854048465899</c:v>
                </c:pt>
                <c:pt idx="2594">
                  <c:v>1.71520607817119</c:v>
                </c:pt>
                <c:pt idx="2595">
                  <c:v>1.16551397657327</c:v>
                </c:pt>
                <c:pt idx="2596">
                  <c:v>1.7499289660375701</c:v>
                </c:pt>
                <c:pt idx="2597">
                  <c:v>1.8161900321311299</c:v>
                </c:pt>
                <c:pt idx="2598">
                  <c:v>1.95667548709837</c:v>
                </c:pt>
                <c:pt idx="2599">
                  <c:v>1.8841368529890701</c:v>
                </c:pt>
                <c:pt idx="2600">
                  <c:v>1.6194366458491201</c:v>
                </c:pt>
                <c:pt idx="2601">
                  <c:v>2.3794053930313499</c:v>
                </c:pt>
                <c:pt idx="2602">
                  <c:v>2.0901443757617901</c:v>
                </c:pt>
                <c:pt idx="2603">
                  <c:v>1.7267873396992599</c:v>
                </c:pt>
                <c:pt idx="2604">
                  <c:v>1.5434240848430001</c:v>
                </c:pt>
                <c:pt idx="2605">
                  <c:v>1.9896113569717</c:v>
                </c:pt>
                <c:pt idx="2606">
                  <c:v>2.1705013637203101</c:v>
                </c:pt>
                <c:pt idx="2607">
                  <c:v>1.9014899306247</c:v>
                </c:pt>
                <c:pt idx="2608">
                  <c:v>2.26590630678169</c:v>
                </c:pt>
                <c:pt idx="2609">
                  <c:v>2.2508966169834301</c:v>
                </c:pt>
                <c:pt idx="2610">
                  <c:v>1.7024935130774801</c:v>
                </c:pt>
                <c:pt idx="2611">
                  <c:v>2.3034156253629199</c:v>
                </c:pt>
                <c:pt idx="2612">
                  <c:v>2.0513378582014901</c:v>
                </c:pt>
                <c:pt idx="2613">
                  <c:v>1.8069607163118</c:v>
                </c:pt>
                <c:pt idx="2614">
                  <c:v>2.1142953789255698</c:v>
                </c:pt>
                <c:pt idx="2615">
                  <c:v>2.16414271782378</c:v>
                </c:pt>
                <c:pt idx="2616">
                  <c:v>1.7711402848570299</c:v>
                </c:pt>
                <c:pt idx="2617">
                  <c:v>2.2119136637406598</c:v>
                </c:pt>
                <c:pt idx="2618">
                  <c:v>1.9821420027540799</c:v>
                </c:pt>
                <c:pt idx="2619">
                  <c:v>2.4416465023407699</c:v>
                </c:pt>
                <c:pt idx="2620">
                  <c:v>2.1486672330385002</c:v>
                </c:pt>
                <c:pt idx="2621">
                  <c:v>2.2628306941662801</c:v>
                </c:pt>
                <c:pt idx="2622">
                  <c:v>2.3217998535498299</c:v>
                </c:pt>
                <c:pt idx="2623">
                  <c:v>2.1616328763055601</c:v>
                </c:pt>
                <c:pt idx="2624">
                  <c:v>2.4677910891136401</c:v>
                </c:pt>
                <c:pt idx="2625">
                  <c:v>2.6448285103360001</c:v>
                </c:pt>
                <c:pt idx="2626">
                  <c:v>2.2651663930180099</c:v>
                </c:pt>
                <c:pt idx="2627">
                  <c:v>2.51884289744602</c:v>
                </c:pt>
                <c:pt idx="2628">
                  <c:v>3.0405520253913201</c:v>
                </c:pt>
                <c:pt idx="2629">
                  <c:v>2.9667974585975698</c:v>
                </c:pt>
                <c:pt idx="2630">
                  <c:v>2.1580321783137699</c:v>
                </c:pt>
                <c:pt idx="2631">
                  <c:v>2.3660381885884898</c:v>
                </c:pt>
                <c:pt idx="2632">
                  <c:v>2.4139898606556298</c:v>
                </c:pt>
                <c:pt idx="2633">
                  <c:v>3.2999031055944599</c:v>
                </c:pt>
                <c:pt idx="2634">
                  <c:v>2.3860642129673102</c:v>
                </c:pt>
                <c:pt idx="2635">
                  <c:v>2.6048466550483198</c:v>
                </c:pt>
                <c:pt idx="2636">
                  <c:v>2.2417672874191301</c:v>
                </c:pt>
                <c:pt idx="2637">
                  <c:v>2.3333093825184199</c:v>
                </c:pt>
                <c:pt idx="2638">
                  <c:v>1.66155455141982</c:v>
                </c:pt>
                <c:pt idx="2639">
                  <c:v>2.2931197444352098</c:v>
                </c:pt>
                <c:pt idx="2640">
                  <c:v>2.81193844871573</c:v>
                </c:pt>
                <c:pt idx="2641">
                  <c:v>3.11631890958293</c:v>
                </c:pt>
                <c:pt idx="2642">
                  <c:v>2.4198139486116199</c:v>
                </c:pt>
                <c:pt idx="2643">
                  <c:v>2.1040930527992598</c:v>
                </c:pt>
                <c:pt idx="2644">
                  <c:v>3.10876847063534</c:v>
                </c:pt>
                <c:pt idx="2645">
                  <c:v>1.9095749340181201</c:v>
                </c:pt>
                <c:pt idx="2646">
                  <c:v>1.80874446017082</c:v>
                </c:pt>
                <c:pt idx="2647">
                  <c:v>2.67348923180261</c:v>
                </c:pt>
                <c:pt idx="2648">
                  <c:v>2.0198384729797798</c:v>
                </c:pt>
                <c:pt idx="2649">
                  <c:v>2.5606497024624399</c:v>
                </c:pt>
                <c:pt idx="2650">
                  <c:v>2.3982290316419399</c:v>
                </c:pt>
                <c:pt idx="2651">
                  <c:v>2.2756269927751802</c:v>
                </c:pt>
                <c:pt idx="2652">
                  <c:v>2.8059589489118202</c:v>
                </c:pt>
                <c:pt idx="2653">
                  <c:v>2.9778092630501498</c:v>
                </c:pt>
                <c:pt idx="2654">
                  <c:v>2.4585097339469799</c:v>
                </c:pt>
                <c:pt idx="2655">
                  <c:v>2.3561422609972098</c:v>
                </c:pt>
                <c:pt idx="2656">
                  <c:v>3.0835776580282599</c:v>
                </c:pt>
                <c:pt idx="2657">
                  <c:v>2.5452157251138701</c:v>
                </c:pt>
                <c:pt idx="2658">
                  <c:v>2.72398004934719</c:v>
                </c:pt>
                <c:pt idx="2659">
                  <c:v>3.01585912131622</c:v>
                </c:pt>
                <c:pt idx="2660">
                  <c:v>2.5858845827915902</c:v>
                </c:pt>
                <c:pt idx="2661">
                  <c:v>2.85888082246279</c:v>
                </c:pt>
                <c:pt idx="2662">
                  <c:v>2.5267158289609402</c:v>
                </c:pt>
                <c:pt idx="2663">
                  <c:v>4.0696477097549204</c:v>
                </c:pt>
                <c:pt idx="2664">
                  <c:v>2.5319523399120598</c:v>
                </c:pt>
                <c:pt idx="2665">
                  <c:v>2.8675392446437402</c:v>
                </c:pt>
                <c:pt idx="2666">
                  <c:v>2.0693087386906801</c:v>
                </c:pt>
                <c:pt idx="2667">
                  <c:v>2.27744678313038</c:v>
                </c:pt>
                <c:pt idx="2668">
                  <c:v>3.1728188389443299</c:v>
                </c:pt>
                <c:pt idx="2669">
                  <c:v>2.2043789801303202</c:v>
                </c:pt>
                <c:pt idx="2670">
                  <c:v>2.5940743880563799</c:v>
                </c:pt>
                <c:pt idx="2671">
                  <c:v>2.5987059276246098</c:v>
                </c:pt>
                <c:pt idx="2672">
                  <c:v>2.9337542093312199</c:v>
                </c:pt>
                <c:pt idx="2673">
                  <c:v>2.3174310024926301</c:v>
                </c:pt>
                <c:pt idx="2674">
                  <c:v>1.93771856533609</c:v>
                </c:pt>
                <c:pt idx="2675">
                  <c:v>2.9207772562568</c:v>
                </c:pt>
                <c:pt idx="2676">
                  <c:v>2.7087580460140099</c:v>
                </c:pt>
                <c:pt idx="2677">
                  <c:v>2.7742166735480098</c:v>
                </c:pt>
                <c:pt idx="2678">
                  <c:v>2.6311437619726799</c:v>
                </c:pt>
                <c:pt idx="2679">
                  <c:v>2.0980566191943399</c:v>
                </c:pt>
                <c:pt idx="2680">
                  <c:v>2.2976347642810402</c:v>
                </c:pt>
                <c:pt idx="2681">
                  <c:v>2.8210267543929701</c:v>
                </c:pt>
                <c:pt idx="2682">
                  <c:v>1.4626056892794399</c:v>
                </c:pt>
                <c:pt idx="2683">
                  <c:v>2.5070972256639701</c:v>
                </c:pt>
                <c:pt idx="2684">
                  <c:v>2.6413593198852401</c:v>
                </c:pt>
                <c:pt idx="2685">
                  <c:v>1.86217028631114</c:v>
                </c:pt>
                <c:pt idx="2686">
                  <c:v>2.07044099394182</c:v>
                </c:pt>
                <c:pt idx="2687">
                  <c:v>1.5910299706464499</c:v>
                </c:pt>
                <c:pt idx="2688">
                  <c:v>3.4122686977141901</c:v>
                </c:pt>
                <c:pt idx="2689">
                  <c:v>2.69452684704732</c:v>
                </c:pt>
                <c:pt idx="2690">
                  <c:v>2.60505689899284</c:v>
                </c:pt>
                <c:pt idx="2691">
                  <c:v>1.6487884147215</c:v>
                </c:pt>
                <c:pt idx="2692">
                  <c:v>1.9817129130511799</c:v>
                </c:pt>
                <c:pt idx="2693">
                  <c:v>2.3827161161968702</c:v>
                </c:pt>
                <c:pt idx="2694">
                  <c:v>2.1547962034375798</c:v>
                </c:pt>
                <c:pt idx="2695">
                  <c:v>2.4579157894891601</c:v>
                </c:pt>
                <c:pt idx="2696">
                  <c:v>2.0412177125966098</c:v>
                </c:pt>
                <c:pt idx="2697">
                  <c:v>2.5731809288437599</c:v>
                </c:pt>
                <c:pt idx="2698">
                  <c:v>1.74724468721084</c:v>
                </c:pt>
                <c:pt idx="2699">
                  <c:v>2.3450185098900098</c:v>
                </c:pt>
                <c:pt idx="2700">
                  <c:v>2.3554756796180398</c:v>
                </c:pt>
                <c:pt idx="2701">
                  <c:v>2.4636248026121499</c:v>
                </c:pt>
                <c:pt idx="2702">
                  <c:v>1.7250495620990001</c:v>
                </c:pt>
                <c:pt idx="2703">
                  <c:v>1.8686206078793299</c:v>
                </c:pt>
                <c:pt idx="2704">
                  <c:v>1.80587651276422</c:v>
                </c:pt>
                <c:pt idx="2705">
                  <c:v>2.3199606374467598</c:v>
                </c:pt>
                <c:pt idx="2706">
                  <c:v>1.86219217004597</c:v>
                </c:pt>
                <c:pt idx="2707">
                  <c:v>1.9574426713356501</c:v>
                </c:pt>
                <c:pt idx="2708">
                  <c:v>2.0820817513170802</c:v>
                </c:pt>
                <c:pt idx="2709">
                  <c:v>1.8356246793868001</c:v>
                </c:pt>
                <c:pt idx="2710">
                  <c:v>2.1166026485193901</c:v>
                </c:pt>
                <c:pt idx="2711">
                  <c:v>1.7177081838064201</c:v>
                </c:pt>
                <c:pt idx="2712">
                  <c:v>2.0405528633218402</c:v>
                </c:pt>
                <c:pt idx="2713">
                  <c:v>1.7101546181501299</c:v>
                </c:pt>
                <c:pt idx="2714">
                  <c:v>1.26544401212043</c:v>
                </c:pt>
                <c:pt idx="2715">
                  <c:v>2.8450180382207901</c:v>
                </c:pt>
                <c:pt idx="2716">
                  <c:v>1.47211709971208</c:v>
                </c:pt>
                <c:pt idx="2717">
                  <c:v>2.32216542928981</c:v>
                </c:pt>
                <c:pt idx="2718">
                  <c:v>2.7032818214263798</c:v>
                </c:pt>
                <c:pt idx="2719">
                  <c:v>2.1577429493382598</c:v>
                </c:pt>
                <c:pt idx="2720">
                  <c:v>1.84475181005525</c:v>
                </c:pt>
                <c:pt idx="2721">
                  <c:v>2.3436204932285798</c:v>
                </c:pt>
                <c:pt idx="2722">
                  <c:v>2.46096762522932</c:v>
                </c:pt>
                <c:pt idx="2723">
                  <c:v>2.6608855639700901</c:v>
                </c:pt>
                <c:pt idx="2724">
                  <c:v>1.8604621734684701</c:v>
                </c:pt>
                <c:pt idx="2725">
                  <c:v>2.1238197576584499</c:v>
                </c:pt>
                <c:pt idx="2726">
                  <c:v>1.7626549843278301</c:v>
                </c:pt>
                <c:pt idx="2727">
                  <c:v>1.5990158013145199</c:v>
                </c:pt>
                <c:pt idx="2728">
                  <c:v>2.0990219740602898</c:v>
                </c:pt>
                <c:pt idx="2729">
                  <c:v>1.6908923067089801</c:v>
                </c:pt>
                <c:pt idx="2730">
                  <c:v>1.4488929014877501</c:v>
                </c:pt>
                <c:pt idx="2731">
                  <c:v>2.3198465928562801</c:v>
                </c:pt>
                <c:pt idx="2732">
                  <c:v>1.76380899187083</c:v>
                </c:pt>
                <c:pt idx="2733">
                  <c:v>2.2746320949939101</c:v>
                </c:pt>
                <c:pt idx="2734">
                  <c:v>2.8363518177937799</c:v>
                </c:pt>
                <c:pt idx="2735">
                  <c:v>2.0211231250100199</c:v>
                </c:pt>
                <c:pt idx="2736">
                  <c:v>2.7148163450635798</c:v>
                </c:pt>
                <c:pt idx="2737">
                  <c:v>2.72287327165207</c:v>
                </c:pt>
                <c:pt idx="2738">
                  <c:v>3.0548688755385101</c:v>
                </c:pt>
                <c:pt idx="2739">
                  <c:v>3.2593376248514998</c:v>
                </c:pt>
                <c:pt idx="2740">
                  <c:v>3.1403941826818</c:v>
                </c:pt>
                <c:pt idx="2741">
                  <c:v>2.2232990738480001</c:v>
                </c:pt>
                <c:pt idx="2742">
                  <c:v>1.60554986152292</c:v>
                </c:pt>
                <c:pt idx="2743">
                  <c:v>2.3660602925657499</c:v>
                </c:pt>
                <c:pt idx="2744">
                  <c:v>2.54615398103841</c:v>
                </c:pt>
                <c:pt idx="2745">
                  <c:v>2.34593737404556</c:v>
                </c:pt>
                <c:pt idx="2746">
                  <c:v>1.73941055176584</c:v>
                </c:pt>
                <c:pt idx="2747">
                  <c:v>2.47839476064257</c:v>
                </c:pt>
                <c:pt idx="2748">
                  <c:v>2.9821339717116802</c:v>
                </c:pt>
                <c:pt idx="2749">
                  <c:v>2.6447934395781201</c:v>
                </c:pt>
                <c:pt idx="2750">
                  <c:v>2.3351379225079798</c:v>
                </c:pt>
                <c:pt idx="2751">
                  <c:v>1.9976239285872801</c:v>
                </c:pt>
                <c:pt idx="2752">
                  <c:v>2.1173470454724201</c:v>
                </c:pt>
                <c:pt idx="2753">
                  <c:v>2.5676025374429798</c:v>
                </c:pt>
                <c:pt idx="2754">
                  <c:v>2.5203347244679302</c:v>
                </c:pt>
                <c:pt idx="2755">
                  <c:v>1.8734043396936999</c:v>
                </c:pt>
                <c:pt idx="2756">
                  <c:v>1.95950202855948</c:v>
                </c:pt>
                <c:pt idx="2757">
                  <c:v>1.8363187514169601</c:v>
                </c:pt>
                <c:pt idx="2758">
                  <c:v>2.07326478456817</c:v>
                </c:pt>
                <c:pt idx="2759">
                  <c:v>2.2111867645987999</c:v>
                </c:pt>
                <c:pt idx="2760">
                  <c:v>2.0214530869363099</c:v>
                </c:pt>
                <c:pt idx="2761">
                  <c:v>2.6753396625382302</c:v>
                </c:pt>
                <c:pt idx="2762">
                  <c:v>2.3294793217348402</c:v>
                </c:pt>
                <c:pt idx="2763">
                  <c:v>2.7108268388947399</c:v>
                </c:pt>
                <c:pt idx="2764">
                  <c:v>2.5780088472598002</c:v>
                </c:pt>
                <c:pt idx="2765">
                  <c:v>2.24304343812102</c:v>
                </c:pt>
                <c:pt idx="2766">
                  <c:v>1.90387482047726</c:v>
                </c:pt>
                <c:pt idx="2767">
                  <c:v>2.2247514976398102</c:v>
                </c:pt>
                <c:pt idx="2768">
                  <c:v>2.3431415103967801</c:v>
                </c:pt>
                <c:pt idx="2769">
                  <c:v>2.4509282365126199</c:v>
                </c:pt>
                <c:pt idx="2770">
                  <c:v>1.58774785935984</c:v>
                </c:pt>
                <c:pt idx="2771">
                  <c:v>1.8490069774981399</c:v>
                </c:pt>
                <c:pt idx="2772">
                  <c:v>2.35027912432867</c:v>
                </c:pt>
                <c:pt idx="2773">
                  <c:v>2.1966756677553501</c:v>
                </c:pt>
                <c:pt idx="2774">
                  <c:v>2.2727429841596001</c:v>
                </c:pt>
                <c:pt idx="2775">
                  <c:v>1.7806342599891201</c:v>
                </c:pt>
                <c:pt idx="2776">
                  <c:v>2.6646461886070001</c:v>
                </c:pt>
                <c:pt idx="2777">
                  <c:v>3.01146892999239</c:v>
                </c:pt>
                <c:pt idx="2778">
                  <c:v>2.1255618044142999</c:v>
                </c:pt>
                <c:pt idx="2779">
                  <c:v>2.00108430053265</c:v>
                </c:pt>
                <c:pt idx="2780">
                  <c:v>2.3514450979700698</c:v>
                </c:pt>
                <c:pt idx="2781">
                  <c:v>1.70858347316313</c:v>
                </c:pt>
                <c:pt idx="2782">
                  <c:v>2.21316546788877</c:v>
                </c:pt>
                <c:pt idx="2783">
                  <c:v>2.0406838091524699</c:v>
                </c:pt>
                <c:pt idx="2784">
                  <c:v>3.1558006692998801</c:v>
                </c:pt>
                <c:pt idx="2785">
                  <c:v>1.51778955257167</c:v>
                </c:pt>
                <c:pt idx="2786">
                  <c:v>1.7554527160484601</c:v>
                </c:pt>
                <c:pt idx="2787">
                  <c:v>1.8951903296080199</c:v>
                </c:pt>
                <c:pt idx="2788">
                  <c:v>1.8657823774965201</c:v>
                </c:pt>
                <c:pt idx="2789">
                  <c:v>1.8429709484283301</c:v>
                </c:pt>
                <c:pt idx="2790">
                  <c:v>2.0436871764218898</c:v>
                </c:pt>
                <c:pt idx="2791">
                  <c:v>2.5998182562242702</c:v>
                </c:pt>
                <c:pt idx="2792">
                  <c:v>2.2618339574279198</c:v>
                </c:pt>
                <c:pt idx="2793">
                  <c:v>2.4396744007626299</c:v>
                </c:pt>
                <c:pt idx="2794">
                  <c:v>2.33571808658589</c:v>
                </c:pt>
                <c:pt idx="2795">
                  <c:v>2.0449690489574102</c:v>
                </c:pt>
                <c:pt idx="2796">
                  <c:v>1.6211818981817201</c:v>
                </c:pt>
                <c:pt idx="2797">
                  <c:v>2.1191368595282398</c:v>
                </c:pt>
                <c:pt idx="2798">
                  <c:v>3.2265933842696999</c:v>
                </c:pt>
                <c:pt idx="2799">
                  <c:v>2.5500141171046198</c:v>
                </c:pt>
                <c:pt idx="2800">
                  <c:v>2.2633109762476602</c:v>
                </c:pt>
                <c:pt idx="2801">
                  <c:v>2.3046122053131701</c:v>
                </c:pt>
                <c:pt idx="2802">
                  <c:v>2.1433969202888998</c:v>
                </c:pt>
                <c:pt idx="2803">
                  <c:v>2.3263023989704199</c:v>
                </c:pt>
                <c:pt idx="2804">
                  <c:v>2.4415564800220402</c:v>
                </c:pt>
                <c:pt idx="2805">
                  <c:v>2.90615426683497</c:v>
                </c:pt>
                <c:pt idx="2806">
                  <c:v>2.7586965915024</c:v>
                </c:pt>
                <c:pt idx="2807">
                  <c:v>2.57773247773207</c:v>
                </c:pt>
                <c:pt idx="2808">
                  <c:v>2.36864470248854</c:v>
                </c:pt>
                <c:pt idx="2809">
                  <c:v>2.7081763555489098</c:v>
                </c:pt>
                <c:pt idx="2810">
                  <c:v>2.46387534655651</c:v>
                </c:pt>
                <c:pt idx="2811">
                  <c:v>2.29730421625404</c:v>
                </c:pt>
                <c:pt idx="2812">
                  <c:v>2.3850900528635299</c:v>
                </c:pt>
                <c:pt idx="2813">
                  <c:v>2.3479211628206502</c:v>
                </c:pt>
                <c:pt idx="2814">
                  <c:v>2.9846333852189399</c:v>
                </c:pt>
                <c:pt idx="2815">
                  <c:v>2.7457551256460602</c:v>
                </c:pt>
                <c:pt idx="2816">
                  <c:v>2.6830024638216901</c:v>
                </c:pt>
                <c:pt idx="2817">
                  <c:v>3.4551698707218002</c:v>
                </c:pt>
                <c:pt idx="2818">
                  <c:v>2.3091398723731702</c:v>
                </c:pt>
                <c:pt idx="2819">
                  <c:v>2.3513555444752998</c:v>
                </c:pt>
                <c:pt idx="2820">
                  <c:v>2.3966839932824802</c:v>
                </c:pt>
                <c:pt idx="2821">
                  <c:v>2.39077673324319</c:v>
                </c:pt>
                <c:pt idx="2822">
                  <c:v>1.96957001868533</c:v>
                </c:pt>
                <c:pt idx="2823">
                  <c:v>2.3357756391727502</c:v>
                </c:pt>
                <c:pt idx="2824">
                  <c:v>2.1147024762202902</c:v>
                </c:pt>
                <c:pt idx="2825">
                  <c:v>2.13999044525649</c:v>
                </c:pt>
                <c:pt idx="2826">
                  <c:v>1.6409105486582101</c:v>
                </c:pt>
                <c:pt idx="2827">
                  <c:v>2.5150513860330102</c:v>
                </c:pt>
                <c:pt idx="2828">
                  <c:v>2.1542834169087302</c:v>
                </c:pt>
                <c:pt idx="2829">
                  <c:v>2.7456539325657001</c:v>
                </c:pt>
                <c:pt idx="2830">
                  <c:v>2.6217729712449001</c:v>
                </c:pt>
                <c:pt idx="2831">
                  <c:v>2.3072383011840598</c:v>
                </c:pt>
                <c:pt idx="2832">
                  <c:v>2.3793991677828301</c:v>
                </c:pt>
                <c:pt idx="2833">
                  <c:v>1.9787607232556099</c:v>
                </c:pt>
                <c:pt idx="2834">
                  <c:v>1.88160368445719</c:v>
                </c:pt>
                <c:pt idx="2835">
                  <c:v>2.6547085553781198</c:v>
                </c:pt>
                <c:pt idx="2836">
                  <c:v>1.64732990185511</c:v>
                </c:pt>
                <c:pt idx="2837">
                  <c:v>1.81587574749638</c:v>
                </c:pt>
                <c:pt idx="2838">
                  <c:v>2.1916483909022202</c:v>
                </c:pt>
                <c:pt idx="2839">
                  <c:v>2.18215847351183</c:v>
                </c:pt>
                <c:pt idx="2840">
                  <c:v>1.92542066774564</c:v>
                </c:pt>
                <c:pt idx="2841">
                  <c:v>2.2725504106883299</c:v>
                </c:pt>
                <c:pt idx="2842">
                  <c:v>1.96047342090072</c:v>
                </c:pt>
                <c:pt idx="2843">
                  <c:v>2.3031637726328098</c:v>
                </c:pt>
                <c:pt idx="2844">
                  <c:v>2.0022492011436701</c:v>
                </c:pt>
                <c:pt idx="2845">
                  <c:v>2.4970079686183202</c:v>
                </c:pt>
                <c:pt idx="2846">
                  <c:v>1.78180918010415</c:v>
                </c:pt>
                <c:pt idx="2847">
                  <c:v>1.55260698759989</c:v>
                </c:pt>
                <c:pt idx="2848">
                  <c:v>2.4623548345338602</c:v>
                </c:pt>
                <c:pt idx="2849">
                  <c:v>1.86476941540121</c:v>
                </c:pt>
                <c:pt idx="2850">
                  <c:v>1.9536653177318799</c:v>
                </c:pt>
                <c:pt idx="2851">
                  <c:v>2.2355458026806301</c:v>
                </c:pt>
                <c:pt idx="2852">
                  <c:v>1.3304006222999101</c:v>
                </c:pt>
                <c:pt idx="2853">
                  <c:v>1.80059414212619</c:v>
                </c:pt>
                <c:pt idx="2854">
                  <c:v>2.0043906437538501</c:v>
                </c:pt>
                <c:pt idx="2855">
                  <c:v>1.6023702907918</c:v>
                </c:pt>
                <c:pt idx="2856">
                  <c:v>1.6300120128632001</c:v>
                </c:pt>
                <c:pt idx="2857">
                  <c:v>2.1050345956977599</c:v>
                </c:pt>
                <c:pt idx="2858">
                  <c:v>1.8293430734307801</c:v>
                </c:pt>
                <c:pt idx="2859">
                  <c:v>2.10159948947758</c:v>
                </c:pt>
                <c:pt idx="2860">
                  <c:v>2.00713688416318</c:v>
                </c:pt>
                <c:pt idx="2861">
                  <c:v>2.5227213406538702</c:v>
                </c:pt>
                <c:pt idx="2862">
                  <c:v>1.68638686380125</c:v>
                </c:pt>
                <c:pt idx="2863">
                  <c:v>2.6443591765546302</c:v>
                </c:pt>
                <c:pt idx="2864">
                  <c:v>1.5778977149762901</c:v>
                </c:pt>
                <c:pt idx="2865">
                  <c:v>2.1717868006423</c:v>
                </c:pt>
                <c:pt idx="2866">
                  <c:v>2.03693414862741</c:v>
                </c:pt>
                <c:pt idx="2867">
                  <c:v>2.1046671192557</c:v>
                </c:pt>
                <c:pt idx="2868">
                  <c:v>2.11017123827247</c:v>
                </c:pt>
                <c:pt idx="2869">
                  <c:v>1.46909888566082</c:v>
                </c:pt>
                <c:pt idx="2870">
                  <c:v>2.0047967807812701</c:v>
                </c:pt>
                <c:pt idx="2871">
                  <c:v>1.8925693995655199</c:v>
                </c:pt>
                <c:pt idx="2872">
                  <c:v>2.1380756948132298</c:v>
                </c:pt>
                <c:pt idx="2873">
                  <c:v>2.3711956263682201</c:v>
                </c:pt>
                <c:pt idx="2874">
                  <c:v>2.5843647862674302</c:v>
                </c:pt>
                <c:pt idx="2875">
                  <c:v>1.6402793522928101</c:v>
                </c:pt>
                <c:pt idx="2876">
                  <c:v>1.4188717805878399</c:v>
                </c:pt>
                <c:pt idx="2877">
                  <c:v>2.1477348340994902</c:v>
                </c:pt>
                <c:pt idx="2878">
                  <c:v>1.8333133346834301</c:v>
                </c:pt>
                <c:pt idx="2879">
                  <c:v>1.7920355859194601</c:v>
                </c:pt>
                <c:pt idx="2880">
                  <c:v>1.3211367374024301</c:v>
                </c:pt>
                <c:pt idx="2881">
                  <c:v>2.7827901913109301</c:v>
                </c:pt>
                <c:pt idx="2882">
                  <c:v>2.13069124534527</c:v>
                </c:pt>
                <c:pt idx="2883">
                  <c:v>1.59169068467589</c:v>
                </c:pt>
                <c:pt idx="2884">
                  <c:v>2.43368173239327</c:v>
                </c:pt>
                <c:pt idx="2885">
                  <c:v>2.1663770915746801</c:v>
                </c:pt>
                <c:pt idx="2886">
                  <c:v>2.2245537283237402</c:v>
                </c:pt>
                <c:pt idx="2887">
                  <c:v>1.8523506796786999</c:v>
                </c:pt>
                <c:pt idx="2888">
                  <c:v>2.3341525792736002</c:v>
                </c:pt>
                <c:pt idx="2889">
                  <c:v>2.0845512148970999</c:v>
                </c:pt>
                <c:pt idx="2890">
                  <c:v>1.8468044274198501</c:v>
                </c:pt>
                <c:pt idx="2891">
                  <c:v>2.4915013444189</c:v>
                </c:pt>
                <c:pt idx="2892">
                  <c:v>1.80756474838376</c:v>
                </c:pt>
                <c:pt idx="2893">
                  <c:v>2.62764026809911</c:v>
                </c:pt>
                <c:pt idx="2894">
                  <c:v>1.7835384576856299</c:v>
                </c:pt>
                <c:pt idx="2895">
                  <c:v>1.9029558053976301</c:v>
                </c:pt>
                <c:pt idx="2896">
                  <c:v>2.5671098080580599</c:v>
                </c:pt>
                <c:pt idx="2897">
                  <c:v>2.06141625470047</c:v>
                </c:pt>
                <c:pt idx="2898">
                  <c:v>2.11469585278192</c:v>
                </c:pt>
                <c:pt idx="2899">
                  <c:v>1.7297550274881499</c:v>
                </c:pt>
                <c:pt idx="2900">
                  <c:v>2.2686969040817901</c:v>
                </c:pt>
                <c:pt idx="2901">
                  <c:v>1.7905204709345901</c:v>
                </c:pt>
                <c:pt idx="2902">
                  <c:v>1.9711082109623299</c:v>
                </c:pt>
                <c:pt idx="2903">
                  <c:v>2.2333265051353499</c:v>
                </c:pt>
                <c:pt idx="2904">
                  <c:v>1.51051831743432</c:v>
                </c:pt>
                <c:pt idx="2905">
                  <c:v>2.17992283854031</c:v>
                </c:pt>
                <c:pt idx="2906">
                  <c:v>1.84159000986417</c:v>
                </c:pt>
                <c:pt idx="2907">
                  <c:v>1.7592921219684201</c:v>
                </c:pt>
                <c:pt idx="2908">
                  <c:v>2.0708749939442299</c:v>
                </c:pt>
                <c:pt idx="2909">
                  <c:v>2.2716861659113601</c:v>
                </c:pt>
                <c:pt idx="2910">
                  <c:v>1.99311246178171</c:v>
                </c:pt>
                <c:pt idx="2911">
                  <c:v>1.8512203962221201</c:v>
                </c:pt>
                <c:pt idx="2912">
                  <c:v>2.38266590304291</c:v>
                </c:pt>
                <c:pt idx="2913">
                  <c:v>2.33604701149978</c:v>
                </c:pt>
                <c:pt idx="2914">
                  <c:v>2.15312143640688</c:v>
                </c:pt>
                <c:pt idx="2915">
                  <c:v>2.4373886213183402</c:v>
                </c:pt>
                <c:pt idx="2916">
                  <c:v>2.0189246398418801</c:v>
                </c:pt>
                <c:pt idx="2917">
                  <c:v>2.31275887990429</c:v>
                </c:pt>
                <c:pt idx="2918">
                  <c:v>2.24902371949783</c:v>
                </c:pt>
                <c:pt idx="2919">
                  <c:v>1.99958304236096</c:v>
                </c:pt>
                <c:pt idx="2920">
                  <c:v>1.5728955016812101</c:v>
                </c:pt>
                <c:pt idx="2921">
                  <c:v>1.97338771152759</c:v>
                </c:pt>
                <c:pt idx="2922">
                  <c:v>1.3669245793981299</c:v>
                </c:pt>
                <c:pt idx="2923">
                  <c:v>1.47762993847115</c:v>
                </c:pt>
                <c:pt idx="2924">
                  <c:v>2.24781592847406</c:v>
                </c:pt>
                <c:pt idx="2925">
                  <c:v>2.8258835067355599</c:v>
                </c:pt>
                <c:pt idx="2926">
                  <c:v>2.3380428682920198</c:v>
                </c:pt>
                <c:pt idx="2927">
                  <c:v>1.4865875947520899</c:v>
                </c:pt>
                <c:pt idx="2928">
                  <c:v>2.1696656209140501</c:v>
                </c:pt>
                <c:pt idx="2929">
                  <c:v>2.5241948907245302</c:v>
                </c:pt>
                <c:pt idx="2930">
                  <c:v>1.99141066039242</c:v>
                </c:pt>
                <c:pt idx="2931">
                  <c:v>2.3138790101710902</c:v>
                </c:pt>
                <c:pt idx="2932">
                  <c:v>2.2170290759989699</c:v>
                </c:pt>
                <c:pt idx="2933">
                  <c:v>2.2541828112365598</c:v>
                </c:pt>
                <c:pt idx="2934">
                  <c:v>3.1026673692892599</c:v>
                </c:pt>
                <c:pt idx="2935">
                  <c:v>1.8770165518991899</c:v>
                </c:pt>
                <c:pt idx="2936">
                  <c:v>2.3752043882244598</c:v>
                </c:pt>
                <c:pt idx="2937">
                  <c:v>2.0990985924482701</c:v>
                </c:pt>
                <c:pt idx="2938">
                  <c:v>2.1314380310723502</c:v>
                </c:pt>
                <c:pt idx="2939">
                  <c:v>2.05003676851591</c:v>
                </c:pt>
                <c:pt idx="2940">
                  <c:v>1.4253321464856701</c:v>
                </c:pt>
                <c:pt idx="2941">
                  <c:v>2.5665870654366301</c:v>
                </c:pt>
                <c:pt idx="2942">
                  <c:v>2.0400672066909902</c:v>
                </c:pt>
                <c:pt idx="2943">
                  <c:v>2.1794446879495499</c:v>
                </c:pt>
                <c:pt idx="2944">
                  <c:v>1.5770853431688201</c:v>
                </c:pt>
                <c:pt idx="2945">
                  <c:v>2.23018483541478</c:v>
                </c:pt>
                <c:pt idx="2946">
                  <c:v>2.4867878949931201</c:v>
                </c:pt>
                <c:pt idx="2947">
                  <c:v>1.9515992737800101</c:v>
                </c:pt>
                <c:pt idx="2948">
                  <c:v>1.9812042630492099</c:v>
                </c:pt>
                <c:pt idx="2949">
                  <c:v>2.11023430803123</c:v>
                </c:pt>
                <c:pt idx="2950">
                  <c:v>2.52246437241108</c:v>
                </c:pt>
                <c:pt idx="2951">
                  <c:v>2.1522849474177201</c:v>
                </c:pt>
                <c:pt idx="2952">
                  <c:v>2.31631132523483</c:v>
                </c:pt>
                <c:pt idx="2953">
                  <c:v>2.0619814732068602</c:v>
                </c:pt>
                <c:pt idx="2954">
                  <c:v>2.48007581262998</c:v>
                </c:pt>
                <c:pt idx="2955">
                  <c:v>2.4615336258587002</c:v>
                </c:pt>
                <c:pt idx="2956">
                  <c:v>2.6130035816181398</c:v>
                </c:pt>
                <c:pt idx="2957">
                  <c:v>2.4615643419209099</c:v>
                </c:pt>
                <c:pt idx="2958">
                  <c:v>2.9209003989573699</c:v>
                </c:pt>
                <c:pt idx="2959">
                  <c:v>3.1186126994073602</c:v>
                </c:pt>
                <c:pt idx="2960">
                  <c:v>2.55956173988208</c:v>
                </c:pt>
                <c:pt idx="2961">
                  <c:v>2.0612535934890901</c:v>
                </c:pt>
                <c:pt idx="2962">
                  <c:v>2.55252062081524</c:v>
                </c:pt>
                <c:pt idx="2963">
                  <c:v>1.63421249189901</c:v>
                </c:pt>
                <c:pt idx="2964">
                  <c:v>2.25958385286004</c:v>
                </c:pt>
                <c:pt idx="2965">
                  <c:v>1.6720768334956</c:v>
                </c:pt>
                <c:pt idx="2966">
                  <c:v>1.3633743666623299</c:v>
                </c:pt>
                <c:pt idx="2967">
                  <c:v>1.55971493793272</c:v>
                </c:pt>
                <c:pt idx="2968">
                  <c:v>2.22329059458046</c:v>
                </c:pt>
                <c:pt idx="2969">
                  <c:v>2.0032299902506199</c:v>
                </c:pt>
                <c:pt idx="2970">
                  <c:v>2.2014812080362001</c:v>
                </c:pt>
                <c:pt idx="2971">
                  <c:v>2.3685091177436099</c:v>
                </c:pt>
                <c:pt idx="2972">
                  <c:v>1.8408050771914799</c:v>
                </c:pt>
                <c:pt idx="2973">
                  <c:v>2.3483984624190199</c:v>
                </c:pt>
                <c:pt idx="2974">
                  <c:v>2.00359249777298</c:v>
                </c:pt>
                <c:pt idx="2975">
                  <c:v>2.0060001410886601</c:v>
                </c:pt>
                <c:pt idx="2976">
                  <c:v>2.0733911592424099</c:v>
                </c:pt>
                <c:pt idx="2977">
                  <c:v>2.0887327652713701</c:v>
                </c:pt>
                <c:pt idx="2978">
                  <c:v>2.74874673127617</c:v>
                </c:pt>
                <c:pt idx="2979">
                  <c:v>1.46507616016077</c:v>
                </c:pt>
                <c:pt idx="2980">
                  <c:v>1.8577832456963299</c:v>
                </c:pt>
                <c:pt idx="2981">
                  <c:v>1.5714851445558999</c:v>
                </c:pt>
                <c:pt idx="2982">
                  <c:v>1.70659839927307</c:v>
                </c:pt>
                <c:pt idx="2983">
                  <c:v>1.4900853429363199</c:v>
                </c:pt>
                <c:pt idx="2984">
                  <c:v>1.97332800507518</c:v>
                </c:pt>
                <c:pt idx="2985">
                  <c:v>2.5529654098489698</c:v>
                </c:pt>
                <c:pt idx="2986">
                  <c:v>1.7141454969138601</c:v>
                </c:pt>
                <c:pt idx="2987">
                  <c:v>2.04575778560578</c:v>
                </c:pt>
                <c:pt idx="2988">
                  <c:v>2.1805955758470601</c:v>
                </c:pt>
                <c:pt idx="2989">
                  <c:v>2.7575319740532702</c:v>
                </c:pt>
                <c:pt idx="2990">
                  <c:v>1.7080797174721001</c:v>
                </c:pt>
                <c:pt idx="2991">
                  <c:v>2.1083520069847101</c:v>
                </c:pt>
                <c:pt idx="2992">
                  <c:v>2.2712412133377899</c:v>
                </c:pt>
                <c:pt idx="2993">
                  <c:v>3.0115881471330299</c:v>
                </c:pt>
                <c:pt idx="2994">
                  <c:v>2.4357805346104602</c:v>
                </c:pt>
                <c:pt idx="2995">
                  <c:v>2.6775158023658201</c:v>
                </c:pt>
                <c:pt idx="2996">
                  <c:v>2.38202184105399</c:v>
                </c:pt>
                <c:pt idx="2997">
                  <c:v>2.1851557873552201</c:v>
                </c:pt>
                <c:pt idx="2998">
                  <c:v>2.4025566147852899</c:v>
                </c:pt>
                <c:pt idx="2999">
                  <c:v>2.3597441790477598</c:v>
                </c:pt>
                <c:pt idx="3000">
                  <c:v>2.0688765633200701</c:v>
                </c:pt>
                <c:pt idx="3001">
                  <c:v>1.9523884242187901</c:v>
                </c:pt>
                <c:pt idx="3002">
                  <c:v>1.54978413166086</c:v>
                </c:pt>
                <c:pt idx="3003">
                  <c:v>1.86229790864275</c:v>
                </c:pt>
                <c:pt idx="3004">
                  <c:v>2.0979300264363099</c:v>
                </c:pt>
                <c:pt idx="3005">
                  <c:v>1.94077834063739</c:v>
                </c:pt>
                <c:pt idx="3006">
                  <c:v>2.3802056439091799</c:v>
                </c:pt>
                <c:pt idx="3007">
                  <c:v>2.3027804774190299</c:v>
                </c:pt>
                <c:pt idx="3008">
                  <c:v>2.2516879065832298</c:v>
                </c:pt>
                <c:pt idx="3009">
                  <c:v>1.8489163997589499</c:v>
                </c:pt>
                <c:pt idx="3010">
                  <c:v>1.6625865899944301</c:v>
                </c:pt>
                <c:pt idx="3011">
                  <c:v>2.2606269826675098</c:v>
                </c:pt>
                <c:pt idx="3012">
                  <c:v>1.88797108332125</c:v>
                </c:pt>
                <c:pt idx="3013">
                  <c:v>1.91632724481214</c:v>
                </c:pt>
                <c:pt idx="3014">
                  <c:v>2.04631788079524</c:v>
                </c:pt>
                <c:pt idx="3015">
                  <c:v>1.9597369400317799</c:v>
                </c:pt>
                <c:pt idx="3016">
                  <c:v>2.26058706268884</c:v>
                </c:pt>
                <c:pt idx="3017">
                  <c:v>1.94888940170695</c:v>
                </c:pt>
                <c:pt idx="3018">
                  <c:v>1.83567174330455</c:v>
                </c:pt>
                <c:pt idx="3019">
                  <c:v>2.2682818369364601</c:v>
                </c:pt>
                <c:pt idx="3020">
                  <c:v>1.7792492065111201</c:v>
                </c:pt>
                <c:pt idx="3021">
                  <c:v>2.1615130406119398</c:v>
                </c:pt>
                <c:pt idx="3022">
                  <c:v>1.3428680691657899</c:v>
                </c:pt>
                <c:pt idx="3023">
                  <c:v>1.4366345205507101</c:v>
                </c:pt>
                <c:pt idx="3024">
                  <c:v>1.7343880974796</c:v>
                </c:pt>
                <c:pt idx="3025">
                  <c:v>1.6449082313954499</c:v>
                </c:pt>
                <c:pt idx="3026">
                  <c:v>1.6925912979486599</c:v>
                </c:pt>
                <c:pt idx="3027">
                  <c:v>1.61745915262855</c:v>
                </c:pt>
                <c:pt idx="3028">
                  <c:v>2.16544353262119</c:v>
                </c:pt>
                <c:pt idx="3029">
                  <c:v>1.2008442988219901</c:v>
                </c:pt>
                <c:pt idx="3030">
                  <c:v>1.8681500604016901</c:v>
                </c:pt>
                <c:pt idx="3031">
                  <c:v>1.97710414447487</c:v>
                </c:pt>
                <c:pt idx="3032">
                  <c:v>1.77540220965408</c:v>
                </c:pt>
                <c:pt idx="3033">
                  <c:v>2.0095466222032998</c:v>
                </c:pt>
                <c:pt idx="3034">
                  <c:v>1.7060562381962401</c:v>
                </c:pt>
                <c:pt idx="3035">
                  <c:v>1.8530480950881401</c:v>
                </c:pt>
                <c:pt idx="3036">
                  <c:v>2.065496001094</c:v>
                </c:pt>
                <c:pt idx="3037">
                  <c:v>1.6143862733849801</c:v>
                </c:pt>
                <c:pt idx="3038">
                  <c:v>1.95732766360481</c:v>
                </c:pt>
                <c:pt idx="3039">
                  <c:v>1.83486180556156</c:v>
                </c:pt>
                <c:pt idx="3040">
                  <c:v>1.5843412062034199</c:v>
                </c:pt>
                <c:pt idx="3041">
                  <c:v>1.88020550600921</c:v>
                </c:pt>
                <c:pt idx="3042">
                  <c:v>2.2940951474065701</c:v>
                </c:pt>
                <c:pt idx="3043">
                  <c:v>2.3165879262608202</c:v>
                </c:pt>
                <c:pt idx="3044">
                  <c:v>2.0418236741396401</c:v>
                </c:pt>
                <c:pt idx="3045">
                  <c:v>2.4490900092240699</c:v>
                </c:pt>
                <c:pt idx="3046">
                  <c:v>1.9341864431448701</c:v>
                </c:pt>
                <c:pt idx="3047">
                  <c:v>1.8968390732433</c:v>
                </c:pt>
                <c:pt idx="3048">
                  <c:v>1.5875503511845901</c:v>
                </c:pt>
                <c:pt idx="3049">
                  <c:v>1.98846246391795</c:v>
                </c:pt>
                <c:pt idx="3050">
                  <c:v>2.2742431553980298</c:v>
                </c:pt>
                <c:pt idx="3051">
                  <c:v>2.3423656028146902</c:v>
                </c:pt>
                <c:pt idx="3052">
                  <c:v>2.3827339888989898</c:v>
                </c:pt>
                <c:pt idx="3053">
                  <c:v>2.2184470556307301</c:v>
                </c:pt>
                <c:pt idx="3054">
                  <c:v>2.1373298098175901</c:v>
                </c:pt>
                <c:pt idx="3055">
                  <c:v>2.2073938146734098</c:v>
                </c:pt>
                <c:pt idx="3056">
                  <c:v>2.0741246644681199</c:v>
                </c:pt>
                <c:pt idx="3057">
                  <c:v>1.98199197641868</c:v>
                </c:pt>
                <c:pt idx="3058">
                  <c:v>2.0139176257037499</c:v>
                </c:pt>
                <c:pt idx="3059">
                  <c:v>2.2938599178302499</c:v>
                </c:pt>
                <c:pt idx="3060">
                  <c:v>1.6577010822060501</c:v>
                </c:pt>
                <c:pt idx="3061">
                  <c:v>2.2995699060443999</c:v>
                </c:pt>
                <c:pt idx="3062">
                  <c:v>2.5209146467911401</c:v>
                </c:pt>
                <c:pt idx="3063">
                  <c:v>1.96169190341328</c:v>
                </c:pt>
                <c:pt idx="3064">
                  <c:v>2.1486086404967502</c:v>
                </c:pt>
                <c:pt idx="3065">
                  <c:v>1.94166234390285</c:v>
                </c:pt>
                <c:pt idx="3066">
                  <c:v>2.0119387735441898</c:v>
                </c:pt>
                <c:pt idx="3067">
                  <c:v>1.42476988985176</c:v>
                </c:pt>
                <c:pt idx="3068">
                  <c:v>2.0262183066824102</c:v>
                </c:pt>
                <c:pt idx="3069">
                  <c:v>2.4570832189976302</c:v>
                </c:pt>
                <c:pt idx="3070">
                  <c:v>2.1598551549983398</c:v>
                </c:pt>
                <c:pt idx="3071">
                  <c:v>1.46165511620668</c:v>
                </c:pt>
                <c:pt idx="3072">
                  <c:v>2.84330050587084</c:v>
                </c:pt>
                <c:pt idx="3073">
                  <c:v>2.7963322537584601</c:v>
                </c:pt>
                <c:pt idx="3074">
                  <c:v>2.4700193761024698</c:v>
                </c:pt>
                <c:pt idx="3075">
                  <c:v>1.8421081513658299</c:v>
                </c:pt>
                <c:pt idx="3076">
                  <c:v>2.32505840635904</c:v>
                </c:pt>
                <c:pt idx="3077">
                  <c:v>2.1001204515071601</c:v>
                </c:pt>
                <c:pt idx="3078">
                  <c:v>2.4363634080169398</c:v>
                </c:pt>
                <c:pt idx="3079">
                  <c:v>2.8118942190460898</c:v>
                </c:pt>
                <c:pt idx="3080">
                  <c:v>2.5270944530257</c:v>
                </c:pt>
                <c:pt idx="3081">
                  <c:v>2.1277822832814799</c:v>
                </c:pt>
                <c:pt idx="3082">
                  <c:v>2.2098574477989001</c:v>
                </c:pt>
                <c:pt idx="3083">
                  <c:v>2.1158500403881</c:v>
                </c:pt>
                <c:pt idx="3084">
                  <c:v>2.2151505199907899</c:v>
                </c:pt>
                <c:pt idx="3085">
                  <c:v>2.4142658925544298</c:v>
                </c:pt>
                <c:pt idx="3086">
                  <c:v>3.09606458164766</c:v>
                </c:pt>
                <c:pt idx="3087">
                  <c:v>2.3931025381717501</c:v>
                </c:pt>
                <c:pt idx="3088">
                  <c:v>2.4142982531071899</c:v>
                </c:pt>
                <c:pt idx="3089">
                  <c:v>1.9965798041371201</c:v>
                </c:pt>
                <c:pt idx="3090">
                  <c:v>2.50116619471873</c:v>
                </c:pt>
                <c:pt idx="3091">
                  <c:v>2.5176392502887599</c:v>
                </c:pt>
                <c:pt idx="3092">
                  <c:v>2.1830110571525401</c:v>
                </c:pt>
                <c:pt idx="3093">
                  <c:v>1.88872546351076</c:v>
                </c:pt>
                <c:pt idx="3094">
                  <c:v>2.7159087377067901</c:v>
                </c:pt>
                <c:pt idx="3095">
                  <c:v>2.8806069162844201</c:v>
                </c:pt>
                <c:pt idx="3096">
                  <c:v>2.1926631759506101</c:v>
                </c:pt>
                <c:pt idx="3097">
                  <c:v>2.43304081863795</c:v>
                </c:pt>
                <c:pt idx="3098">
                  <c:v>2.6874834520744999</c:v>
                </c:pt>
                <c:pt idx="3099">
                  <c:v>2.7493631639296701</c:v>
                </c:pt>
                <c:pt idx="3100">
                  <c:v>2.2636168740570701</c:v>
                </c:pt>
                <c:pt idx="3101">
                  <c:v>2.08463744499729</c:v>
                </c:pt>
                <c:pt idx="3102">
                  <c:v>2.1432100242208101</c:v>
                </c:pt>
                <c:pt idx="3103">
                  <c:v>1.9602881811763799</c:v>
                </c:pt>
                <c:pt idx="3104">
                  <c:v>1.7066481765675501</c:v>
                </c:pt>
                <c:pt idx="3105">
                  <c:v>2.0407480165710501</c:v>
                </c:pt>
                <c:pt idx="3106">
                  <c:v>2.2700947704132899</c:v>
                </c:pt>
                <c:pt idx="3107">
                  <c:v>1.8664015470091699</c:v>
                </c:pt>
                <c:pt idx="3108">
                  <c:v>2.0748500593402701</c:v>
                </c:pt>
                <c:pt idx="3109">
                  <c:v>2.46524809133463</c:v>
                </c:pt>
                <c:pt idx="3110">
                  <c:v>1.65789384557762</c:v>
                </c:pt>
                <c:pt idx="3111">
                  <c:v>1.9380530714194499</c:v>
                </c:pt>
                <c:pt idx="3112">
                  <c:v>2.3045953636107499</c:v>
                </c:pt>
                <c:pt idx="3113">
                  <c:v>1.38316809993173</c:v>
                </c:pt>
                <c:pt idx="3114">
                  <c:v>2.1533102481116901</c:v>
                </c:pt>
                <c:pt idx="3115">
                  <c:v>1.6805790234818601</c:v>
                </c:pt>
                <c:pt idx="3116">
                  <c:v>1.88313737097656</c:v>
                </c:pt>
                <c:pt idx="3117">
                  <c:v>2.19899132453209</c:v>
                </c:pt>
                <c:pt idx="3118">
                  <c:v>2.3176610443121</c:v>
                </c:pt>
                <c:pt idx="3119">
                  <c:v>2.1207470196967</c:v>
                </c:pt>
                <c:pt idx="3120">
                  <c:v>2.5717246381632202</c:v>
                </c:pt>
                <c:pt idx="3121">
                  <c:v>1.94565011185725</c:v>
                </c:pt>
                <c:pt idx="3122">
                  <c:v>2.3527051422043699</c:v>
                </c:pt>
                <c:pt idx="3123">
                  <c:v>1.7399825548542101</c:v>
                </c:pt>
                <c:pt idx="3124">
                  <c:v>2.2329494868954298</c:v>
                </c:pt>
                <c:pt idx="3125">
                  <c:v>2.1488168441906002</c:v>
                </c:pt>
                <c:pt idx="3126">
                  <c:v>1.9155917185723399</c:v>
                </c:pt>
                <c:pt idx="3127">
                  <c:v>2.4817169294447901</c:v>
                </c:pt>
                <c:pt idx="3128">
                  <c:v>2.32628957251096</c:v>
                </c:pt>
                <c:pt idx="3129">
                  <c:v>1.81594866342665</c:v>
                </c:pt>
                <c:pt idx="3130">
                  <c:v>2.1568385394784602</c:v>
                </c:pt>
                <c:pt idx="3131">
                  <c:v>2.0631682713669801</c:v>
                </c:pt>
                <c:pt idx="3132">
                  <c:v>2.2118129124227499</c:v>
                </c:pt>
                <c:pt idx="3133">
                  <c:v>1.9415215750552099</c:v>
                </c:pt>
                <c:pt idx="3134">
                  <c:v>1.89556880842078</c:v>
                </c:pt>
                <c:pt idx="3135">
                  <c:v>2.0521877234281298</c:v>
                </c:pt>
                <c:pt idx="3136">
                  <c:v>2.1832780189069401</c:v>
                </c:pt>
                <c:pt idx="3137">
                  <c:v>1.7447113041434701</c:v>
                </c:pt>
                <c:pt idx="3138">
                  <c:v>2.1206533734118702</c:v>
                </c:pt>
                <c:pt idx="3139">
                  <c:v>1.7423859358314899</c:v>
                </c:pt>
                <c:pt idx="3140">
                  <c:v>1.6425925754161199</c:v>
                </c:pt>
                <c:pt idx="3141">
                  <c:v>1.4888192885982801</c:v>
                </c:pt>
                <c:pt idx="3142">
                  <c:v>1.46714041076517</c:v>
                </c:pt>
                <c:pt idx="3143">
                  <c:v>1.6140077079984601</c:v>
                </c:pt>
                <c:pt idx="3144">
                  <c:v>1.38113796996767</c:v>
                </c:pt>
                <c:pt idx="3145">
                  <c:v>1.4471077254326401</c:v>
                </c:pt>
                <c:pt idx="3146">
                  <c:v>1.5156977771564599</c:v>
                </c:pt>
                <c:pt idx="3147">
                  <c:v>1.4015096608681099</c:v>
                </c:pt>
                <c:pt idx="3148">
                  <c:v>1.6004897770177</c:v>
                </c:pt>
                <c:pt idx="3149">
                  <c:v>1.5795947433842199</c:v>
                </c:pt>
                <c:pt idx="3150">
                  <c:v>1.1933549686999601</c:v>
                </c:pt>
                <c:pt idx="3151">
                  <c:v>1.27252496224491</c:v>
                </c:pt>
                <c:pt idx="3152">
                  <c:v>1.0440667923418101</c:v>
                </c:pt>
                <c:pt idx="3153">
                  <c:v>1.8104684241281399</c:v>
                </c:pt>
                <c:pt idx="3154">
                  <c:v>1.96645403856807</c:v>
                </c:pt>
                <c:pt idx="3155">
                  <c:v>2.3319907924254601</c:v>
                </c:pt>
                <c:pt idx="3156">
                  <c:v>3.5194051270929099</c:v>
                </c:pt>
                <c:pt idx="3157">
                  <c:v>2.9535985001743001</c:v>
                </c:pt>
                <c:pt idx="3158">
                  <c:v>2.1924726841218498</c:v>
                </c:pt>
                <c:pt idx="3159">
                  <c:v>1.5502924546246499</c:v>
                </c:pt>
                <c:pt idx="3160">
                  <c:v>2.5917156407371298</c:v>
                </c:pt>
                <c:pt idx="3161">
                  <c:v>2.37615658279779</c:v>
                </c:pt>
                <c:pt idx="3162">
                  <c:v>2.75713710265391</c:v>
                </c:pt>
                <c:pt idx="3163">
                  <c:v>2.4063442335166898</c:v>
                </c:pt>
                <c:pt idx="3164">
                  <c:v>2.8452833134085602</c:v>
                </c:pt>
                <c:pt idx="3165">
                  <c:v>3.2924222852492302</c:v>
                </c:pt>
                <c:pt idx="3166">
                  <c:v>2.1443033687214399</c:v>
                </c:pt>
                <c:pt idx="3167">
                  <c:v>2.7889632039570902</c:v>
                </c:pt>
                <c:pt idx="3168">
                  <c:v>2.1168079812197398</c:v>
                </c:pt>
                <c:pt idx="3169">
                  <c:v>2.2291527589304199</c:v>
                </c:pt>
                <c:pt idx="3170">
                  <c:v>2.7938189252303798</c:v>
                </c:pt>
                <c:pt idx="3171">
                  <c:v>2.5985244591182202</c:v>
                </c:pt>
                <c:pt idx="3172">
                  <c:v>2.5317087721851301</c:v>
                </c:pt>
                <c:pt idx="3173">
                  <c:v>1.7736335168778601</c:v>
                </c:pt>
                <c:pt idx="3174">
                  <c:v>2.0642096411975501</c:v>
                </c:pt>
                <c:pt idx="3175">
                  <c:v>2.98794531394255</c:v>
                </c:pt>
                <c:pt idx="3176">
                  <c:v>2.0049088328846101</c:v>
                </c:pt>
                <c:pt idx="3177">
                  <c:v>2.2542560957989899</c:v>
                </c:pt>
                <c:pt idx="3178">
                  <c:v>2.9094209937237698</c:v>
                </c:pt>
                <c:pt idx="3179">
                  <c:v>2.4920894309088202</c:v>
                </c:pt>
                <c:pt idx="3180">
                  <c:v>2.6627315482869598</c:v>
                </c:pt>
                <c:pt idx="3181">
                  <c:v>2.0574793906727198</c:v>
                </c:pt>
                <c:pt idx="3182">
                  <c:v>3.0140295722172898</c:v>
                </c:pt>
                <c:pt idx="3183">
                  <c:v>2.0580167128047702</c:v>
                </c:pt>
                <c:pt idx="3184">
                  <c:v>2.5335416465201002</c:v>
                </c:pt>
                <c:pt idx="3185">
                  <c:v>2.2556180037045501</c:v>
                </c:pt>
                <c:pt idx="3186">
                  <c:v>2.5664452972690701</c:v>
                </c:pt>
                <c:pt idx="3187">
                  <c:v>2.9505270432136999</c:v>
                </c:pt>
                <c:pt idx="3188">
                  <c:v>2.7886730663858499</c:v>
                </c:pt>
                <c:pt idx="3189">
                  <c:v>2.8000859969534502</c:v>
                </c:pt>
                <c:pt idx="3190">
                  <c:v>1.84612778696463</c:v>
                </c:pt>
                <c:pt idx="3191">
                  <c:v>2.4358628779464602</c:v>
                </c:pt>
                <c:pt idx="3192">
                  <c:v>2.6914466557448602</c:v>
                </c:pt>
                <c:pt idx="3193">
                  <c:v>3.1141212040902602</c:v>
                </c:pt>
                <c:pt idx="3194">
                  <c:v>3.1615955378153102</c:v>
                </c:pt>
                <c:pt idx="3195">
                  <c:v>2.47791187728465</c:v>
                </c:pt>
                <c:pt idx="3196">
                  <c:v>2.5566001333552602</c:v>
                </c:pt>
                <c:pt idx="3197">
                  <c:v>2.24711183568045</c:v>
                </c:pt>
                <c:pt idx="3198">
                  <c:v>2.3449360871570599</c:v>
                </c:pt>
                <c:pt idx="3199">
                  <c:v>2.2734952132618398</c:v>
                </c:pt>
                <c:pt idx="3200">
                  <c:v>2.2575387109933498</c:v>
                </c:pt>
                <c:pt idx="3201">
                  <c:v>2.14571972374931</c:v>
                </c:pt>
                <c:pt idx="3202">
                  <c:v>2.0651292411676798</c:v>
                </c:pt>
                <c:pt idx="3203">
                  <c:v>2.60241960894286</c:v>
                </c:pt>
                <c:pt idx="3204">
                  <c:v>2.2299905730934801</c:v>
                </c:pt>
                <c:pt idx="3205">
                  <c:v>2.44870584864334</c:v>
                </c:pt>
                <c:pt idx="3206">
                  <c:v>2.2604547647353899</c:v>
                </c:pt>
                <c:pt idx="3207">
                  <c:v>2.7009520179333801</c:v>
                </c:pt>
                <c:pt idx="3208">
                  <c:v>2.5878647885135</c:v>
                </c:pt>
                <c:pt idx="3209">
                  <c:v>2.5448370255705202</c:v>
                </c:pt>
                <c:pt idx="3210">
                  <c:v>2.6508998325311999</c:v>
                </c:pt>
                <c:pt idx="3211">
                  <c:v>2.9804097164636398</c:v>
                </c:pt>
                <c:pt idx="3212">
                  <c:v>2.2687560279845602</c:v>
                </c:pt>
                <c:pt idx="3213">
                  <c:v>2.7351366007862401</c:v>
                </c:pt>
                <c:pt idx="3214">
                  <c:v>3.0427556601105601</c:v>
                </c:pt>
                <c:pt idx="3215">
                  <c:v>3.1433790711875602</c:v>
                </c:pt>
                <c:pt idx="3216">
                  <c:v>2.4736568205372902</c:v>
                </c:pt>
                <c:pt idx="3217">
                  <c:v>2.42238565578758</c:v>
                </c:pt>
                <c:pt idx="3218">
                  <c:v>1.95674207995018</c:v>
                </c:pt>
                <c:pt idx="3219">
                  <c:v>2.21565593150157</c:v>
                </c:pt>
                <c:pt idx="3220">
                  <c:v>2.29508269549072</c:v>
                </c:pt>
                <c:pt idx="3221">
                  <c:v>2.39309203322287</c:v>
                </c:pt>
                <c:pt idx="3222">
                  <c:v>1.97320389049446</c:v>
                </c:pt>
                <c:pt idx="3223">
                  <c:v>2.13407160044143</c:v>
                </c:pt>
                <c:pt idx="3224">
                  <c:v>2.75160876606515</c:v>
                </c:pt>
                <c:pt idx="3225">
                  <c:v>1.9461354358513701</c:v>
                </c:pt>
                <c:pt idx="3226">
                  <c:v>2.3590840766722998</c:v>
                </c:pt>
                <c:pt idx="3227">
                  <c:v>2.2894212535227401</c:v>
                </c:pt>
                <c:pt idx="3228">
                  <c:v>2.3289792889955101</c:v>
                </c:pt>
                <c:pt idx="3229">
                  <c:v>2.45824292225991</c:v>
                </c:pt>
                <c:pt idx="3230">
                  <c:v>2.6249939850670798</c:v>
                </c:pt>
                <c:pt idx="3231">
                  <c:v>2.4133333949187601</c:v>
                </c:pt>
                <c:pt idx="3232">
                  <c:v>3.3801230123781099</c:v>
                </c:pt>
                <c:pt idx="3233">
                  <c:v>2.5222054541272101</c:v>
                </c:pt>
                <c:pt idx="3234">
                  <c:v>3.16969887031778</c:v>
                </c:pt>
                <c:pt idx="3235">
                  <c:v>3.0703603360629002</c:v>
                </c:pt>
                <c:pt idx="3236">
                  <c:v>3.1399950623693398</c:v>
                </c:pt>
                <c:pt idx="3237">
                  <c:v>2.5576190607703402</c:v>
                </c:pt>
                <c:pt idx="3238">
                  <c:v>3.0774391026779799</c:v>
                </c:pt>
                <c:pt idx="3239">
                  <c:v>3.0204606713756301</c:v>
                </c:pt>
                <c:pt idx="3240">
                  <c:v>2.9475173718602599</c:v>
                </c:pt>
                <c:pt idx="3241">
                  <c:v>2.3313654044832401</c:v>
                </c:pt>
                <c:pt idx="3242">
                  <c:v>2.8406623804021098</c:v>
                </c:pt>
                <c:pt idx="3243">
                  <c:v>1.7091922332393299</c:v>
                </c:pt>
                <c:pt idx="3244">
                  <c:v>1.8431378302160599</c:v>
                </c:pt>
                <c:pt idx="3245">
                  <c:v>2.5112632724178199</c:v>
                </c:pt>
                <c:pt idx="3246">
                  <c:v>2.1397251202202998</c:v>
                </c:pt>
                <c:pt idx="3247">
                  <c:v>2.0798536544291499</c:v>
                </c:pt>
                <c:pt idx="3248">
                  <c:v>2.1969079417488602</c:v>
                </c:pt>
                <c:pt idx="3249">
                  <c:v>2.1891303561136102</c:v>
                </c:pt>
                <c:pt idx="3250">
                  <c:v>3.0044261891076398</c:v>
                </c:pt>
                <c:pt idx="3251">
                  <c:v>2.8630814528099102</c:v>
                </c:pt>
                <c:pt idx="3252">
                  <c:v>2.8890726788199501</c:v>
                </c:pt>
                <c:pt idx="3253">
                  <c:v>2.4388660390714301</c:v>
                </c:pt>
                <c:pt idx="3254">
                  <c:v>2.374315364923</c:v>
                </c:pt>
                <c:pt idx="3255">
                  <c:v>2.4771980021856801</c:v>
                </c:pt>
                <c:pt idx="3256">
                  <c:v>2.7209316952290501</c:v>
                </c:pt>
                <c:pt idx="3257">
                  <c:v>2.2793935353780901</c:v>
                </c:pt>
                <c:pt idx="3258">
                  <c:v>2.5005538492353998</c:v>
                </c:pt>
                <c:pt idx="3259">
                  <c:v>1.99732981080662</c:v>
                </c:pt>
                <c:pt idx="3260">
                  <c:v>3.0166453912047202</c:v>
                </c:pt>
                <c:pt idx="3261">
                  <c:v>2.0754744737471298</c:v>
                </c:pt>
                <c:pt idx="3262">
                  <c:v>2.4017136518414199</c:v>
                </c:pt>
                <c:pt idx="3263">
                  <c:v>3.19038966602526</c:v>
                </c:pt>
                <c:pt idx="3264">
                  <c:v>2.84837211030636</c:v>
                </c:pt>
                <c:pt idx="3265">
                  <c:v>2.2998667761091198</c:v>
                </c:pt>
                <c:pt idx="3266">
                  <c:v>3.1713939767778601</c:v>
                </c:pt>
                <c:pt idx="3267">
                  <c:v>3.2643877473645602</c:v>
                </c:pt>
                <c:pt idx="3268">
                  <c:v>2.5098628540461498</c:v>
                </c:pt>
                <c:pt idx="3269">
                  <c:v>2.5167534708303898</c:v>
                </c:pt>
                <c:pt idx="3270">
                  <c:v>2.6549879915276602</c:v>
                </c:pt>
                <c:pt idx="3271">
                  <c:v>2.5216111745369898</c:v>
                </c:pt>
                <c:pt idx="3272">
                  <c:v>2.17204086049207</c:v>
                </c:pt>
                <c:pt idx="3273">
                  <c:v>2.3999752199193098</c:v>
                </c:pt>
                <c:pt idx="3274">
                  <c:v>2.5665034730629799</c:v>
                </c:pt>
                <c:pt idx="3275">
                  <c:v>2.57296468587294</c:v>
                </c:pt>
                <c:pt idx="3276">
                  <c:v>2.4718474436345699</c:v>
                </c:pt>
                <c:pt idx="3277">
                  <c:v>2.9106075256529098</c:v>
                </c:pt>
                <c:pt idx="3278">
                  <c:v>2.42996396431242</c:v>
                </c:pt>
                <c:pt idx="3279">
                  <c:v>3.06778955644047</c:v>
                </c:pt>
                <c:pt idx="3280">
                  <c:v>2.94713407219652</c:v>
                </c:pt>
                <c:pt idx="3281">
                  <c:v>2.70814961511168</c:v>
                </c:pt>
                <c:pt idx="3282">
                  <c:v>2.9109499946765802</c:v>
                </c:pt>
                <c:pt idx="3283">
                  <c:v>2.7416212651311</c:v>
                </c:pt>
                <c:pt idx="3284">
                  <c:v>2.72695417547156</c:v>
                </c:pt>
                <c:pt idx="3285">
                  <c:v>3.7603261780825799</c:v>
                </c:pt>
                <c:pt idx="3286">
                  <c:v>3.0921383145837198</c:v>
                </c:pt>
                <c:pt idx="3287">
                  <c:v>2.26908846535623</c:v>
                </c:pt>
                <c:pt idx="3288">
                  <c:v>2.8742514021322099</c:v>
                </c:pt>
                <c:pt idx="3289">
                  <c:v>3.1068436292894202</c:v>
                </c:pt>
                <c:pt idx="3290">
                  <c:v>2.6189298840341899</c:v>
                </c:pt>
                <c:pt idx="3291">
                  <c:v>2.77737695149494</c:v>
                </c:pt>
                <c:pt idx="3292">
                  <c:v>3.0136952769956502</c:v>
                </c:pt>
                <c:pt idx="3293">
                  <c:v>2.5551018252892801</c:v>
                </c:pt>
                <c:pt idx="3294">
                  <c:v>2.1703235478509999</c:v>
                </c:pt>
                <c:pt idx="3295">
                  <c:v>1.78346398539145</c:v>
                </c:pt>
                <c:pt idx="3296">
                  <c:v>2.3979510560519399</c:v>
                </c:pt>
                <c:pt idx="3297">
                  <c:v>2.38544588790664</c:v>
                </c:pt>
                <c:pt idx="3298">
                  <c:v>2.2306555323784498</c:v>
                </c:pt>
                <c:pt idx="3299">
                  <c:v>2.35462669507453</c:v>
                </c:pt>
                <c:pt idx="3300">
                  <c:v>2.04364187354822</c:v>
                </c:pt>
                <c:pt idx="3301">
                  <c:v>2.7547588426791898</c:v>
                </c:pt>
                <c:pt idx="3302">
                  <c:v>2.0842248583975902</c:v>
                </c:pt>
                <c:pt idx="3303">
                  <c:v>2.2347115388042802</c:v>
                </c:pt>
                <c:pt idx="3304">
                  <c:v>2.40472906089613</c:v>
                </c:pt>
                <c:pt idx="3305">
                  <c:v>1.9231112416835701</c:v>
                </c:pt>
                <c:pt idx="3306">
                  <c:v>2.1602322086886798</c:v>
                </c:pt>
                <c:pt idx="3307">
                  <c:v>2.8373540186121899</c:v>
                </c:pt>
                <c:pt idx="3308">
                  <c:v>2.3064398050460402</c:v>
                </c:pt>
                <c:pt idx="3309">
                  <c:v>1.9989869757687699</c:v>
                </c:pt>
                <c:pt idx="3310">
                  <c:v>2.2321755776136101</c:v>
                </c:pt>
                <c:pt idx="3311">
                  <c:v>2.4432201466263499</c:v>
                </c:pt>
                <c:pt idx="3312">
                  <c:v>2.4294386126679202</c:v>
                </c:pt>
                <c:pt idx="3313">
                  <c:v>2.3914802102686501</c:v>
                </c:pt>
                <c:pt idx="3314">
                  <c:v>2.1478796505451498</c:v>
                </c:pt>
                <c:pt idx="3315">
                  <c:v>3.0688592050325298</c:v>
                </c:pt>
                <c:pt idx="3316">
                  <c:v>2.19335084612224</c:v>
                </c:pt>
                <c:pt idx="3317">
                  <c:v>1.79367312486464</c:v>
                </c:pt>
                <c:pt idx="3318">
                  <c:v>2.1284766358009901</c:v>
                </c:pt>
                <c:pt idx="3319">
                  <c:v>2.0802290445196401</c:v>
                </c:pt>
                <c:pt idx="3320">
                  <c:v>2.1429867809510399</c:v>
                </c:pt>
                <c:pt idx="3321">
                  <c:v>2.6205485335979399</c:v>
                </c:pt>
                <c:pt idx="3322">
                  <c:v>2.2182243450905501</c:v>
                </c:pt>
                <c:pt idx="3323">
                  <c:v>2.09026863884502</c:v>
                </c:pt>
                <c:pt idx="3324">
                  <c:v>2.31431206690071</c:v>
                </c:pt>
                <c:pt idx="3325">
                  <c:v>2.3075553651673202</c:v>
                </c:pt>
                <c:pt idx="3326">
                  <c:v>2.2610349935335701</c:v>
                </c:pt>
                <c:pt idx="3327">
                  <c:v>2.47157434435616</c:v>
                </c:pt>
                <c:pt idx="3328">
                  <c:v>1.9645082166631</c:v>
                </c:pt>
                <c:pt idx="3329">
                  <c:v>2.4667802712557898</c:v>
                </c:pt>
                <c:pt idx="3330">
                  <c:v>2.1740175456325401</c:v>
                </c:pt>
                <c:pt idx="3331">
                  <c:v>2.0381808562761798</c:v>
                </c:pt>
                <c:pt idx="3332">
                  <c:v>2.9405503828541999</c:v>
                </c:pt>
                <c:pt idx="3333">
                  <c:v>2.1909911345354498</c:v>
                </c:pt>
                <c:pt idx="3334">
                  <c:v>2.3746006525630401</c:v>
                </c:pt>
                <c:pt idx="3335">
                  <c:v>2.2817619341084501</c:v>
                </c:pt>
                <c:pt idx="3336">
                  <c:v>2.5751882805839901</c:v>
                </c:pt>
                <c:pt idx="3337">
                  <c:v>1.67712376288912</c:v>
                </c:pt>
                <c:pt idx="3338">
                  <c:v>1.9963776019972299</c:v>
                </c:pt>
                <c:pt idx="3339">
                  <c:v>2.44859476734764</c:v>
                </c:pt>
                <c:pt idx="3340">
                  <c:v>2.2082596548</c:v>
                </c:pt>
                <c:pt idx="3341">
                  <c:v>2.1248101421221501</c:v>
                </c:pt>
                <c:pt idx="3342">
                  <c:v>2.1259869717290001</c:v>
                </c:pt>
                <c:pt idx="3343">
                  <c:v>2.3358034612304599</c:v>
                </c:pt>
                <c:pt idx="3344">
                  <c:v>2.7558061911934701</c:v>
                </c:pt>
                <c:pt idx="3345">
                  <c:v>2.5357712991005998</c:v>
                </c:pt>
                <c:pt idx="3346">
                  <c:v>2.9588907321659801</c:v>
                </c:pt>
                <c:pt idx="3347">
                  <c:v>2.37541613416498</c:v>
                </c:pt>
                <c:pt idx="3348">
                  <c:v>2.67356157647064</c:v>
                </c:pt>
                <c:pt idx="3349">
                  <c:v>2.5213471890610299</c:v>
                </c:pt>
                <c:pt idx="3350">
                  <c:v>1.7760282312774101</c:v>
                </c:pt>
                <c:pt idx="3351">
                  <c:v>2.6236943265608299</c:v>
                </c:pt>
                <c:pt idx="3352">
                  <c:v>2.1426201267029099</c:v>
                </c:pt>
                <c:pt idx="3353">
                  <c:v>2.2132924633889202</c:v>
                </c:pt>
                <c:pt idx="3354">
                  <c:v>2.1494786911224999</c:v>
                </c:pt>
                <c:pt idx="3355">
                  <c:v>2.1203831792111298</c:v>
                </c:pt>
                <c:pt idx="3356">
                  <c:v>1.8626114907301901</c:v>
                </c:pt>
                <c:pt idx="3357">
                  <c:v>2.08612166531067</c:v>
                </c:pt>
                <c:pt idx="3358">
                  <c:v>2.9640770859578498</c:v>
                </c:pt>
                <c:pt idx="3359">
                  <c:v>2.44363023799403</c:v>
                </c:pt>
                <c:pt idx="3360">
                  <c:v>2.6538677285110501</c:v>
                </c:pt>
                <c:pt idx="3361">
                  <c:v>2.4391175633500701</c:v>
                </c:pt>
                <c:pt idx="3362">
                  <c:v>1.79292338291108</c:v>
                </c:pt>
                <c:pt idx="3363">
                  <c:v>2.4578821527546899</c:v>
                </c:pt>
                <c:pt idx="3364">
                  <c:v>2.1765404463164</c:v>
                </c:pt>
                <c:pt idx="3365">
                  <c:v>2.1526746728847801</c:v>
                </c:pt>
                <c:pt idx="3366">
                  <c:v>1.9200607269625001</c:v>
                </c:pt>
                <c:pt idx="3367">
                  <c:v>2.4502889771083201</c:v>
                </c:pt>
                <c:pt idx="3368">
                  <c:v>3.1620083130753001</c:v>
                </c:pt>
                <c:pt idx="3369">
                  <c:v>2.3946394593230398</c:v>
                </c:pt>
                <c:pt idx="3370">
                  <c:v>2.0203212397007699</c:v>
                </c:pt>
                <c:pt idx="3371">
                  <c:v>2.1397816653784099</c:v>
                </c:pt>
                <c:pt idx="3372">
                  <c:v>2.5397478994221099</c:v>
                </c:pt>
                <c:pt idx="3373">
                  <c:v>2.78760871008889</c:v>
                </c:pt>
                <c:pt idx="3374">
                  <c:v>1.94444901196938</c:v>
                </c:pt>
                <c:pt idx="3375">
                  <c:v>2.30789580263643</c:v>
                </c:pt>
                <c:pt idx="3376">
                  <c:v>2.6193825504101298</c:v>
                </c:pt>
                <c:pt idx="3377">
                  <c:v>2.21532328410381</c:v>
                </c:pt>
                <c:pt idx="3378">
                  <c:v>2.2102101340123301</c:v>
                </c:pt>
                <c:pt idx="3379">
                  <c:v>2.1272389932385498</c:v>
                </c:pt>
                <c:pt idx="3380">
                  <c:v>2.5214047084815201</c:v>
                </c:pt>
                <c:pt idx="3381">
                  <c:v>2.7781438988687901</c:v>
                </c:pt>
                <c:pt idx="3382">
                  <c:v>2.33729593502389</c:v>
                </c:pt>
                <c:pt idx="3383">
                  <c:v>2.6653587254382201</c:v>
                </c:pt>
                <c:pt idx="3384">
                  <c:v>2.5757939487261701</c:v>
                </c:pt>
                <c:pt idx="3385">
                  <c:v>2.7023317168040699</c:v>
                </c:pt>
                <c:pt idx="3386">
                  <c:v>2.5931561251925102</c:v>
                </c:pt>
                <c:pt idx="3387">
                  <c:v>2.1699456866487901</c:v>
                </c:pt>
                <c:pt idx="3388">
                  <c:v>2.4984375764243301</c:v>
                </c:pt>
                <c:pt idx="3389">
                  <c:v>3.1196469503720299</c:v>
                </c:pt>
                <c:pt idx="3390">
                  <c:v>2.7295885760857099</c:v>
                </c:pt>
                <c:pt idx="3391">
                  <c:v>2.2644073415918902</c:v>
                </c:pt>
                <c:pt idx="3392">
                  <c:v>2.7649329518335501</c:v>
                </c:pt>
                <c:pt idx="3393">
                  <c:v>2.0529885447243998</c:v>
                </c:pt>
                <c:pt idx="3394">
                  <c:v>2.6676774250532498</c:v>
                </c:pt>
                <c:pt idx="3395">
                  <c:v>2.8754293480680202</c:v>
                </c:pt>
                <c:pt idx="3396">
                  <c:v>1.9312765302277699</c:v>
                </c:pt>
                <c:pt idx="3397">
                  <c:v>2.2130070506352899</c:v>
                </c:pt>
                <c:pt idx="3398">
                  <c:v>2.6005362230381102</c:v>
                </c:pt>
                <c:pt idx="3399">
                  <c:v>2.4278530831981402</c:v>
                </c:pt>
                <c:pt idx="3400">
                  <c:v>2.6408087625782</c:v>
                </c:pt>
                <c:pt idx="3401">
                  <c:v>2.3384387867801202</c:v>
                </c:pt>
                <c:pt idx="3402">
                  <c:v>2.2208044534151901</c:v>
                </c:pt>
                <c:pt idx="3403">
                  <c:v>2.2126448280501401</c:v>
                </c:pt>
                <c:pt idx="3404">
                  <c:v>2.0981997325863602</c:v>
                </c:pt>
                <c:pt idx="3405">
                  <c:v>2.1407540101950802</c:v>
                </c:pt>
                <c:pt idx="3406">
                  <c:v>2.7567735650112701</c:v>
                </c:pt>
                <c:pt idx="3407">
                  <c:v>2.1583851677014301</c:v>
                </c:pt>
                <c:pt idx="3408">
                  <c:v>2.39317267120129</c:v>
                </c:pt>
                <c:pt idx="3409">
                  <c:v>2.5102786317206398</c:v>
                </c:pt>
                <c:pt idx="3410">
                  <c:v>2.49927002538587</c:v>
                </c:pt>
                <c:pt idx="3411">
                  <c:v>2.5651461495196299</c:v>
                </c:pt>
                <c:pt idx="3412">
                  <c:v>3.0954015815024301</c:v>
                </c:pt>
                <c:pt idx="3413">
                  <c:v>2.92075189189609</c:v>
                </c:pt>
                <c:pt idx="3414">
                  <c:v>2.7058482369107999</c:v>
                </c:pt>
                <c:pt idx="3415">
                  <c:v>2.8479751194069598</c:v>
                </c:pt>
                <c:pt idx="3416">
                  <c:v>2.8454294077601099</c:v>
                </c:pt>
                <c:pt idx="3417">
                  <c:v>2.7537095434449399</c:v>
                </c:pt>
                <c:pt idx="3418">
                  <c:v>2.39798576414749</c:v>
                </c:pt>
                <c:pt idx="3419">
                  <c:v>2.3748850751248201</c:v>
                </c:pt>
                <c:pt idx="3420">
                  <c:v>2.2042146445340598</c:v>
                </c:pt>
                <c:pt idx="3421">
                  <c:v>2.54112021317819</c:v>
                </c:pt>
                <c:pt idx="3422">
                  <c:v>2.6044343595289199</c:v>
                </c:pt>
                <c:pt idx="3423">
                  <c:v>2.25567042120095</c:v>
                </c:pt>
                <c:pt idx="3424">
                  <c:v>2.5006572666713298</c:v>
                </c:pt>
                <c:pt idx="3425">
                  <c:v>2.16314993052293</c:v>
                </c:pt>
                <c:pt idx="3426">
                  <c:v>3.27908316334074</c:v>
                </c:pt>
                <c:pt idx="3427">
                  <c:v>2.2492260309711698</c:v>
                </c:pt>
                <c:pt idx="3428">
                  <c:v>2.4338323767047099</c:v>
                </c:pt>
                <c:pt idx="3429">
                  <c:v>2.70835823374816</c:v>
                </c:pt>
                <c:pt idx="3430">
                  <c:v>2.6012255483511</c:v>
                </c:pt>
                <c:pt idx="3431">
                  <c:v>3.0015896900650301</c:v>
                </c:pt>
                <c:pt idx="3432">
                  <c:v>2.8124822018717102</c:v>
                </c:pt>
                <c:pt idx="3433">
                  <c:v>2.7192808559016002</c:v>
                </c:pt>
                <c:pt idx="3434">
                  <c:v>3.05243536854428</c:v>
                </c:pt>
                <c:pt idx="3435">
                  <c:v>1.85381214375938</c:v>
                </c:pt>
                <c:pt idx="3436">
                  <c:v>2.7279287709223099</c:v>
                </c:pt>
                <c:pt idx="3437">
                  <c:v>2.3306211432220598</c:v>
                </c:pt>
                <c:pt idx="3438">
                  <c:v>1.9822934740960001</c:v>
                </c:pt>
                <c:pt idx="3439">
                  <c:v>2.1169147860361601</c:v>
                </c:pt>
                <c:pt idx="3440">
                  <c:v>2.5455465366193599</c:v>
                </c:pt>
                <c:pt idx="3441">
                  <c:v>2.4310010639134498</c:v>
                </c:pt>
                <c:pt idx="3442">
                  <c:v>2.1337719695859598</c:v>
                </c:pt>
                <c:pt idx="3443">
                  <c:v>2.1603142358739502</c:v>
                </c:pt>
                <c:pt idx="3444">
                  <c:v>2.4260236527001302</c:v>
                </c:pt>
                <c:pt idx="3445">
                  <c:v>2.4132052713223699</c:v>
                </c:pt>
                <c:pt idx="3446">
                  <c:v>1.8788963549061499</c:v>
                </c:pt>
                <c:pt idx="3447">
                  <c:v>1.93402502076586</c:v>
                </c:pt>
                <c:pt idx="3448">
                  <c:v>2.3985807279903901</c:v>
                </c:pt>
                <c:pt idx="3449">
                  <c:v>2.1652838140487298</c:v>
                </c:pt>
                <c:pt idx="3450">
                  <c:v>2.1195349022219401</c:v>
                </c:pt>
                <c:pt idx="3451">
                  <c:v>1.9568742114601201</c:v>
                </c:pt>
                <c:pt idx="3452">
                  <c:v>1.9038930456469401</c:v>
                </c:pt>
                <c:pt idx="3453">
                  <c:v>2.2497663585393801</c:v>
                </c:pt>
                <c:pt idx="3454">
                  <c:v>2.7272958320215901</c:v>
                </c:pt>
                <c:pt idx="3455">
                  <c:v>2.46935809335428</c:v>
                </c:pt>
                <c:pt idx="3456">
                  <c:v>2.2896328813239299</c:v>
                </c:pt>
                <c:pt idx="3457">
                  <c:v>2.2503734361858099</c:v>
                </c:pt>
                <c:pt idx="3458">
                  <c:v>1.96490371278642</c:v>
                </c:pt>
                <c:pt idx="3459">
                  <c:v>1.9248404211099801</c:v>
                </c:pt>
                <c:pt idx="3460">
                  <c:v>2.7557357733605201</c:v>
                </c:pt>
                <c:pt idx="3461">
                  <c:v>2.46175147821898</c:v>
                </c:pt>
                <c:pt idx="3462">
                  <c:v>2.4608809826384199</c:v>
                </c:pt>
                <c:pt idx="3463">
                  <c:v>1.9838312655619901</c:v>
                </c:pt>
                <c:pt idx="3464">
                  <c:v>1.59252087151296</c:v>
                </c:pt>
                <c:pt idx="3465">
                  <c:v>2.3734100322747098</c:v>
                </c:pt>
                <c:pt idx="3466">
                  <c:v>1.9834442172915101</c:v>
                </c:pt>
                <c:pt idx="3467">
                  <c:v>1.68974500204915</c:v>
                </c:pt>
                <c:pt idx="3468">
                  <c:v>1.9801624522438701</c:v>
                </c:pt>
                <c:pt idx="3469">
                  <c:v>2.5598107100840801</c:v>
                </c:pt>
                <c:pt idx="3470">
                  <c:v>2.2665410209678098</c:v>
                </c:pt>
                <c:pt idx="3471">
                  <c:v>2.1569667676767699</c:v>
                </c:pt>
                <c:pt idx="3472">
                  <c:v>2.2536636399577201</c:v>
                </c:pt>
                <c:pt idx="3473">
                  <c:v>2.0502264004180599</c:v>
                </c:pt>
                <c:pt idx="3474">
                  <c:v>2.2523468086833698</c:v>
                </c:pt>
                <c:pt idx="3475">
                  <c:v>2.5563177683152198</c:v>
                </c:pt>
                <c:pt idx="3476">
                  <c:v>1.81454985762731</c:v>
                </c:pt>
                <c:pt idx="3477">
                  <c:v>2.09690753231187</c:v>
                </c:pt>
                <c:pt idx="3478">
                  <c:v>2.4607436891005898</c:v>
                </c:pt>
                <c:pt idx="3479">
                  <c:v>2.68640260434776</c:v>
                </c:pt>
                <c:pt idx="3480">
                  <c:v>2.53825069550413</c:v>
                </c:pt>
                <c:pt idx="3481">
                  <c:v>2.2282306728433601</c:v>
                </c:pt>
                <c:pt idx="3482">
                  <c:v>2.65030934127646</c:v>
                </c:pt>
                <c:pt idx="3483">
                  <c:v>2.6417220259071299</c:v>
                </c:pt>
                <c:pt idx="3484">
                  <c:v>2.1967496892286098</c:v>
                </c:pt>
                <c:pt idx="3485">
                  <c:v>2.6948482742105</c:v>
                </c:pt>
                <c:pt idx="3486">
                  <c:v>2.8137768589502601</c:v>
                </c:pt>
                <c:pt idx="3487">
                  <c:v>2.4456563917865002</c:v>
                </c:pt>
                <c:pt idx="3488">
                  <c:v>2.8204165162052002</c:v>
                </c:pt>
                <c:pt idx="3489">
                  <c:v>2.6646085889243998</c:v>
                </c:pt>
                <c:pt idx="3490">
                  <c:v>2.6095418366079399</c:v>
                </c:pt>
                <c:pt idx="3491">
                  <c:v>2.5230033471174198</c:v>
                </c:pt>
                <c:pt idx="3492">
                  <c:v>2.8759034377527</c:v>
                </c:pt>
                <c:pt idx="3493">
                  <c:v>2.9921503622544399</c:v>
                </c:pt>
                <c:pt idx="3494">
                  <c:v>2.5179195079945602</c:v>
                </c:pt>
                <c:pt idx="3495">
                  <c:v>2.4511068825997802</c:v>
                </c:pt>
                <c:pt idx="3496">
                  <c:v>2.14711174285239</c:v>
                </c:pt>
                <c:pt idx="3497">
                  <c:v>2.3011761837695501</c:v>
                </c:pt>
                <c:pt idx="3498">
                  <c:v>2.4640587156914799</c:v>
                </c:pt>
                <c:pt idx="3499">
                  <c:v>1.9932959172451801</c:v>
                </c:pt>
                <c:pt idx="3500">
                  <c:v>2.7051410907686502</c:v>
                </c:pt>
                <c:pt idx="3501">
                  <c:v>2.85248335130643</c:v>
                </c:pt>
                <c:pt idx="3502">
                  <c:v>2.3653170747129799</c:v>
                </c:pt>
                <c:pt idx="3503">
                  <c:v>2.3270072957535399</c:v>
                </c:pt>
                <c:pt idx="3504">
                  <c:v>2.6814226689472398</c:v>
                </c:pt>
                <c:pt idx="3505">
                  <c:v>1.9326839717875901</c:v>
                </c:pt>
                <c:pt idx="3506">
                  <c:v>2.4712813946916299</c:v>
                </c:pt>
                <c:pt idx="3507">
                  <c:v>2.76174151079036</c:v>
                </c:pt>
                <c:pt idx="3508">
                  <c:v>2.4864014293660901</c:v>
                </c:pt>
                <c:pt idx="3509">
                  <c:v>2.02323038358392</c:v>
                </c:pt>
                <c:pt idx="3510">
                  <c:v>2.3538673844364602</c:v>
                </c:pt>
                <c:pt idx="3511">
                  <c:v>2.4092025536539201</c:v>
                </c:pt>
                <c:pt idx="3512">
                  <c:v>2.4026869996573699</c:v>
                </c:pt>
                <c:pt idx="3513">
                  <c:v>2.5400645118327798</c:v>
                </c:pt>
                <c:pt idx="3514">
                  <c:v>2.3156154078004798</c:v>
                </c:pt>
                <c:pt idx="3515">
                  <c:v>2.5915165983826198</c:v>
                </c:pt>
                <c:pt idx="3516">
                  <c:v>2.4707515657880301</c:v>
                </c:pt>
                <c:pt idx="3517">
                  <c:v>2.0692944812128902</c:v>
                </c:pt>
                <c:pt idx="3518">
                  <c:v>2.2137023054842802</c:v>
                </c:pt>
                <c:pt idx="3519">
                  <c:v>2.42145463457432</c:v>
                </c:pt>
                <c:pt idx="3520">
                  <c:v>2.7830801358742501</c:v>
                </c:pt>
                <c:pt idx="3521">
                  <c:v>2.4886271625768499</c:v>
                </c:pt>
                <c:pt idx="3522">
                  <c:v>2.3530044025222998</c:v>
                </c:pt>
                <c:pt idx="3523">
                  <c:v>2.6321329783267799</c:v>
                </c:pt>
                <c:pt idx="3524">
                  <c:v>2.7463410782413198</c:v>
                </c:pt>
                <c:pt idx="3525">
                  <c:v>2.5993248550567798</c:v>
                </c:pt>
                <c:pt idx="3526">
                  <c:v>3.1847616355137802</c:v>
                </c:pt>
                <c:pt idx="3527">
                  <c:v>2.8161878810193102</c:v>
                </c:pt>
                <c:pt idx="3528">
                  <c:v>3.1536316500261399</c:v>
                </c:pt>
                <c:pt idx="3529">
                  <c:v>2.8218910405855699</c:v>
                </c:pt>
                <c:pt idx="3530">
                  <c:v>2.5393661763464399</c:v>
                </c:pt>
                <c:pt idx="3531">
                  <c:v>2.6721957239704999</c:v>
                </c:pt>
                <c:pt idx="3532">
                  <c:v>2.7278460889831901</c:v>
                </c:pt>
                <c:pt idx="3533">
                  <c:v>2.4631181016246999</c:v>
                </c:pt>
                <c:pt idx="3534">
                  <c:v>2.2878281947955399</c:v>
                </c:pt>
                <c:pt idx="3535">
                  <c:v>2.3553010680847599</c:v>
                </c:pt>
                <c:pt idx="3536">
                  <c:v>2.8301170688482502</c:v>
                </c:pt>
                <c:pt idx="3537">
                  <c:v>1.6612329565756301</c:v>
                </c:pt>
                <c:pt idx="3538">
                  <c:v>3.0508056753428798</c:v>
                </c:pt>
                <c:pt idx="3539">
                  <c:v>2.6772031521272099</c:v>
                </c:pt>
                <c:pt idx="3540">
                  <c:v>3.0984361038402599</c:v>
                </c:pt>
                <c:pt idx="3541">
                  <c:v>2.4098417734313302</c:v>
                </c:pt>
                <c:pt idx="3542">
                  <c:v>2.7137113606130798</c:v>
                </c:pt>
                <c:pt idx="3543">
                  <c:v>2.0920687365933102</c:v>
                </c:pt>
                <c:pt idx="3544">
                  <c:v>2.97290622367629</c:v>
                </c:pt>
                <c:pt idx="3545">
                  <c:v>1.7823755267302299</c:v>
                </c:pt>
                <c:pt idx="3546">
                  <c:v>2.21721565297084</c:v>
                </c:pt>
                <c:pt idx="3547">
                  <c:v>2.7738404814930702</c:v>
                </c:pt>
                <c:pt idx="3548">
                  <c:v>3.4621853241781002</c:v>
                </c:pt>
                <c:pt idx="3549">
                  <c:v>2.2194639039003201</c:v>
                </c:pt>
                <c:pt idx="3550">
                  <c:v>2.2045827014594899</c:v>
                </c:pt>
                <c:pt idx="3551">
                  <c:v>2.0731356262607399</c:v>
                </c:pt>
                <c:pt idx="3552">
                  <c:v>2.3664691517667098</c:v>
                </c:pt>
                <c:pt idx="3553">
                  <c:v>2.54584153916697</c:v>
                </c:pt>
                <c:pt idx="3554">
                  <c:v>2.8213771968907899</c:v>
                </c:pt>
                <c:pt idx="3555">
                  <c:v>2.17590381456754</c:v>
                </c:pt>
                <c:pt idx="3556">
                  <c:v>2.6827475547878299</c:v>
                </c:pt>
                <c:pt idx="3557">
                  <c:v>2.79452446872736</c:v>
                </c:pt>
                <c:pt idx="3558">
                  <c:v>2.9230083643334801</c:v>
                </c:pt>
                <c:pt idx="3559">
                  <c:v>3.1770157147033098</c:v>
                </c:pt>
                <c:pt idx="3560">
                  <c:v>2.54302057717985</c:v>
                </c:pt>
                <c:pt idx="3561">
                  <c:v>2.6594180053111902</c:v>
                </c:pt>
                <c:pt idx="3562">
                  <c:v>2.5058137856917702</c:v>
                </c:pt>
                <c:pt idx="3563">
                  <c:v>2.6095490660324998</c:v>
                </c:pt>
                <c:pt idx="3564">
                  <c:v>2.8739915881748499</c:v>
                </c:pt>
                <c:pt idx="3565">
                  <c:v>2.2138413712593801</c:v>
                </c:pt>
                <c:pt idx="3566">
                  <c:v>2.6689324491342701</c:v>
                </c:pt>
                <c:pt idx="3567">
                  <c:v>3.0860632713133098</c:v>
                </c:pt>
                <c:pt idx="3568">
                  <c:v>2.41648275092943</c:v>
                </c:pt>
                <c:pt idx="3569">
                  <c:v>2.57388506807925</c:v>
                </c:pt>
                <c:pt idx="3570">
                  <c:v>3.8568379399267498</c:v>
                </c:pt>
                <c:pt idx="3571">
                  <c:v>3.3830099795451001</c:v>
                </c:pt>
                <c:pt idx="3572">
                  <c:v>2.7178296391326602</c:v>
                </c:pt>
                <c:pt idx="3573">
                  <c:v>2.3869799836652201</c:v>
                </c:pt>
                <c:pt idx="3574">
                  <c:v>2.6835297005949998</c:v>
                </c:pt>
                <c:pt idx="3575">
                  <c:v>2.6549960277029498</c:v>
                </c:pt>
                <c:pt idx="3576">
                  <c:v>2.9746395743236298</c:v>
                </c:pt>
                <c:pt idx="3577">
                  <c:v>2.3646990654711999</c:v>
                </c:pt>
                <c:pt idx="3578">
                  <c:v>2.56017687134766</c:v>
                </c:pt>
                <c:pt idx="3579">
                  <c:v>1.76961901181492</c:v>
                </c:pt>
                <c:pt idx="3580">
                  <c:v>2.75768672938944</c:v>
                </c:pt>
                <c:pt idx="3581">
                  <c:v>3.5024182319931798</c:v>
                </c:pt>
                <c:pt idx="3582">
                  <c:v>2.67314139216673</c:v>
                </c:pt>
                <c:pt idx="3583">
                  <c:v>2.1107477774196099</c:v>
                </c:pt>
                <c:pt idx="3584">
                  <c:v>2.4326243967302399</c:v>
                </c:pt>
                <c:pt idx="3585">
                  <c:v>3.38677620469735</c:v>
                </c:pt>
                <c:pt idx="3586">
                  <c:v>2.5476168503916901</c:v>
                </c:pt>
                <c:pt idx="3587">
                  <c:v>2.13765874668844</c:v>
                </c:pt>
                <c:pt idx="3588">
                  <c:v>2.7792960268661502</c:v>
                </c:pt>
                <c:pt idx="3589">
                  <c:v>2.5801978540218</c:v>
                </c:pt>
                <c:pt idx="3590">
                  <c:v>2.7978424290234201</c:v>
                </c:pt>
                <c:pt idx="3591">
                  <c:v>3.1183901591509802</c:v>
                </c:pt>
                <c:pt idx="3592">
                  <c:v>2.3501101089297198</c:v>
                </c:pt>
                <c:pt idx="3593">
                  <c:v>2.9227721696293201</c:v>
                </c:pt>
                <c:pt idx="3594">
                  <c:v>2.9322678290761401</c:v>
                </c:pt>
                <c:pt idx="3595">
                  <c:v>2.6754984844815901</c:v>
                </c:pt>
                <c:pt idx="3596">
                  <c:v>2.3654287838329</c:v>
                </c:pt>
                <c:pt idx="3597">
                  <c:v>2.82016807154376</c:v>
                </c:pt>
                <c:pt idx="3598">
                  <c:v>2.31257076644911</c:v>
                </c:pt>
                <c:pt idx="3599">
                  <c:v>2.25524333361989</c:v>
                </c:pt>
                <c:pt idx="3600">
                  <c:v>3.5450577548481501</c:v>
                </c:pt>
                <c:pt idx="3601">
                  <c:v>3.7883282579986099</c:v>
                </c:pt>
                <c:pt idx="3602">
                  <c:v>3.0657198088150901</c:v>
                </c:pt>
                <c:pt idx="3603">
                  <c:v>2.6982443525316802</c:v>
                </c:pt>
                <c:pt idx="3604">
                  <c:v>2.7841624682118198</c:v>
                </c:pt>
                <c:pt idx="3605">
                  <c:v>2.8071247507164401</c:v>
                </c:pt>
                <c:pt idx="3606">
                  <c:v>3.11458523751556</c:v>
                </c:pt>
                <c:pt idx="3607">
                  <c:v>2.6693530079423402</c:v>
                </c:pt>
                <c:pt idx="3608">
                  <c:v>2.91713511970103</c:v>
                </c:pt>
                <c:pt idx="3609">
                  <c:v>3.2023876493112802</c:v>
                </c:pt>
                <c:pt idx="3610">
                  <c:v>3.2520738220921799</c:v>
                </c:pt>
                <c:pt idx="3611">
                  <c:v>3.12771150513165</c:v>
                </c:pt>
                <c:pt idx="3612">
                  <c:v>2.5958851061766302</c:v>
                </c:pt>
                <c:pt idx="3613">
                  <c:v>2.9398372228968701</c:v>
                </c:pt>
                <c:pt idx="3614">
                  <c:v>2.6216659782495202</c:v>
                </c:pt>
                <c:pt idx="3615">
                  <c:v>3.0190261843200501</c:v>
                </c:pt>
                <c:pt idx="3616">
                  <c:v>3.1842738184798902</c:v>
                </c:pt>
                <c:pt idx="3617">
                  <c:v>3.0166758582948399</c:v>
                </c:pt>
                <c:pt idx="3618">
                  <c:v>3.1310234446640299</c:v>
                </c:pt>
                <c:pt idx="3619">
                  <c:v>2.5245742847797499</c:v>
                </c:pt>
                <c:pt idx="3620">
                  <c:v>2.2876034892694599</c:v>
                </c:pt>
                <c:pt idx="3621">
                  <c:v>3.1220158431181702</c:v>
                </c:pt>
                <c:pt idx="3622">
                  <c:v>2.73658991610696</c:v>
                </c:pt>
                <c:pt idx="3623">
                  <c:v>2.9702259999648701</c:v>
                </c:pt>
                <c:pt idx="3624">
                  <c:v>2.4877893042639001</c:v>
                </c:pt>
                <c:pt idx="3625">
                  <c:v>3.04293977755272</c:v>
                </c:pt>
                <c:pt idx="3626">
                  <c:v>3.0350073934415098</c:v>
                </c:pt>
                <c:pt idx="3627">
                  <c:v>3.0188432957882698</c:v>
                </c:pt>
                <c:pt idx="3628">
                  <c:v>3.3603741696565299</c:v>
                </c:pt>
                <c:pt idx="3629">
                  <c:v>2.59175506273936</c:v>
                </c:pt>
                <c:pt idx="3630">
                  <c:v>2.6081933745621901</c:v>
                </c:pt>
                <c:pt idx="3631">
                  <c:v>3.7340466727922101</c:v>
                </c:pt>
                <c:pt idx="3632">
                  <c:v>2.5626517209104902</c:v>
                </c:pt>
                <c:pt idx="3633">
                  <c:v>2.4731435758820002</c:v>
                </c:pt>
                <c:pt idx="3634">
                  <c:v>2.4642913816993102</c:v>
                </c:pt>
                <c:pt idx="3635">
                  <c:v>2.5177758608258101</c:v>
                </c:pt>
                <c:pt idx="3636">
                  <c:v>2.59494402629071</c:v>
                </c:pt>
                <c:pt idx="3637">
                  <c:v>2.80027170994255</c:v>
                </c:pt>
                <c:pt idx="3638">
                  <c:v>2.59739160655303</c:v>
                </c:pt>
                <c:pt idx="3639">
                  <c:v>2.3213849431944502</c:v>
                </c:pt>
                <c:pt idx="3640">
                  <c:v>2.6810406411160601</c:v>
                </c:pt>
                <c:pt idx="3641">
                  <c:v>1.8636014083386401</c:v>
                </c:pt>
                <c:pt idx="3642">
                  <c:v>2.5516611821474098</c:v>
                </c:pt>
                <c:pt idx="3643">
                  <c:v>2.1350276630212801</c:v>
                </c:pt>
                <c:pt idx="3644">
                  <c:v>2.38597063629273</c:v>
                </c:pt>
                <c:pt idx="3645">
                  <c:v>2.7984429568598199</c:v>
                </c:pt>
                <c:pt idx="3646">
                  <c:v>3.28695545957732</c:v>
                </c:pt>
                <c:pt idx="3647">
                  <c:v>2.0332183765560901</c:v>
                </c:pt>
                <c:pt idx="3648">
                  <c:v>2.55513599968973</c:v>
                </c:pt>
                <c:pt idx="3649">
                  <c:v>2.7812036077325799</c:v>
                </c:pt>
                <c:pt idx="3650">
                  <c:v>2.7172624415863398</c:v>
                </c:pt>
                <c:pt idx="3651">
                  <c:v>2.84465467524624</c:v>
                </c:pt>
                <c:pt idx="3652">
                  <c:v>2.5275427854366201</c:v>
                </c:pt>
                <c:pt idx="3653">
                  <c:v>2.5605868907390801</c:v>
                </c:pt>
                <c:pt idx="3654">
                  <c:v>2.65409300508473</c:v>
                </c:pt>
                <c:pt idx="3655">
                  <c:v>2.6719166420680298</c:v>
                </c:pt>
                <c:pt idx="3656">
                  <c:v>2.8566636595216099</c:v>
                </c:pt>
                <c:pt idx="3657">
                  <c:v>2.9799323887559002</c:v>
                </c:pt>
                <c:pt idx="3658">
                  <c:v>2.5519753575120401</c:v>
                </c:pt>
                <c:pt idx="3659">
                  <c:v>2.2999654342875102</c:v>
                </c:pt>
                <c:pt idx="3660">
                  <c:v>2.7806521996590701</c:v>
                </c:pt>
                <c:pt idx="3661">
                  <c:v>2.5660966954683899</c:v>
                </c:pt>
                <c:pt idx="3662">
                  <c:v>2.76433401068372</c:v>
                </c:pt>
                <c:pt idx="3663">
                  <c:v>2.80575822734485</c:v>
                </c:pt>
                <c:pt idx="3664">
                  <c:v>3.1811443722139301</c:v>
                </c:pt>
                <c:pt idx="3665">
                  <c:v>2.2529438295531699</c:v>
                </c:pt>
                <c:pt idx="3666">
                  <c:v>2.6957685227114401</c:v>
                </c:pt>
                <c:pt idx="3667">
                  <c:v>2.3861985946597599</c:v>
                </c:pt>
                <c:pt idx="3668">
                  <c:v>2.2041011698981001</c:v>
                </c:pt>
                <c:pt idx="3669">
                  <c:v>2.2804274397086401</c:v>
                </c:pt>
                <c:pt idx="3670">
                  <c:v>1.85032241994937</c:v>
                </c:pt>
                <c:pt idx="3671">
                  <c:v>2.34521990763526</c:v>
                </c:pt>
                <c:pt idx="3672">
                  <c:v>2.8236469709738401</c:v>
                </c:pt>
                <c:pt idx="3673">
                  <c:v>2.54430868436943</c:v>
                </c:pt>
                <c:pt idx="3674">
                  <c:v>2.4317118241979099</c:v>
                </c:pt>
                <c:pt idx="3675">
                  <c:v>2.57219198768346</c:v>
                </c:pt>
                <c:pt idx="3676">
                  <c:v>2.20233922018837</c:v>
                </c:pt>
                <c:pt idx="3677">
                  <c:v>2.3565739908186401</c:v>
                </c:pt>
                <c:pt idx="3678">
                  <c:v>2.4771374530795902</c:v>
                </c:pt>
                <c:pt idx="3679">
                  <c:v>2.3973799679621401</c:v>
                </c:pt>
                <c:pt idx="3680">
                  <c:v>2.40925663121621</c:v>
                </c:pt>
                <c:pt idx="3681">
                  <c:v>2.4986849649757499</c:v>
                </c:pt>
                <c:pt idx="3682">
                  <c:v>2.2154077014467601</c:v>
                </c:pt>
                <c:pt idx="3683">
                  <c:v>2.7657621443465401</c:v>
                </c:pt>
                <c:pt idx="3684">
                  <c:v>3.0358680318244202</c:v>
                </c:pt>
                <c:pt idx="3685">
                  <c:v>2.3525268459162798</c:v>
                </c:pt>
                <c:pt idx="3686">
                  <c:v>2.8065910362709099</c:v>
                </c:pt>
                <c:pt idx="3687">
                  <c:v>2.2695789546772902</c:v>
                </c:pt>
                <c:pt idx="3688">
                  <c:v>2.73470532617613</c:v>
                </c:pt>
                <c:pt idx="3689">
                  <c:v>2.1848509696271901</c:v>
                </c:pt>
                <c:pt idx="3690">
                  <c:v>2.1857522659017699</c:v>
                </c:pt>
                <c:pt idx="3691">
                  <c:v>2.4024256227453402</c:v>
                </c:pt>
                <c:pt idx="3692">
                  <c:v>2.0039082610453902</c:v>
                </c:pt>
                <c:pt idx="3693">
                  <c:v>2.6611582608997302</c:v>
                </c:pt>
                <c:pt idx="3694">
                  <c:v>2.3689281076961701</c:v>
                </c:pt>
                <c:pt idx="3695">
                  <c:v>2.8949528966965299</c:v>
                </c:pt>
                <c:pt idx="3696">
                  <c:v>2.0522037041484702</c:v>
                </c:pt>
                <c:pt idx="3697">
                  <c:v>2.6070758884085001</c:v>
                </c:pt>
                <c:pt idx="3698">
                  <c:v>3.1735765163345899</c:v>
                </c:pt>
                <c:pt idx="3699">
                  <c:v>2.7873990937937498</c:v>
                </c:pt>
                <c:pt idx="3700">
                  <c:v>2.2293766678484599</c:v>
                </c:pt>
                <c:pt idx="3701">
                  <c:v>2.1409086299756801</c:v>
                </c:pt>
                <c:pt idx="3702">
                  <c:v>1.9876382123405301</c:v>
                </c:pt>
                <c:pt idx="3703">
                  <c:v>2.0042170155247701</c:v>
                </c:pt>
                <c:pt idx="3704">
                  <c:v>2.3598419825404302</c:v>
                </c:pt>
                <c:pt idx="3705">
                  <c:v>2.3986983582227799</c:v>
                </c:pt>
                <c:pt idx="3706">
                  <c:v>2.3701840017370901</c:v>
                </c:pt>
                <c:pt idx="3707">
                  <c:v>2.8373991235929199</c:v>
                </c:pt>
                <c:pt idx="3708">
                  <c:v>2.4870015119360098</c:v>
                </c:pt>
                <c:pt idx="3709">
                  <c:v>2.82335614081172</c:v>
                </c:pt>
                <c:pt idx="3710">
                  <c:v>2.8292482780191501</c:v>
                </c:pt>
                <c:pt idx="3711">
                  <c:v>2.96465982560093</c:v>
                </c:pt>
                <c:pt idx="3712">
                  <c:v>2.8439920751564598</c:v>
                </c:pt>
                <c:pt idx="3713">
                  <c:v>1.91763855899416</c:v>
                </c:pt>
                <c:pt idx="3714">
                  <c:v>2.39886960820535</c:v>
                </c:pt>
                <c:pt idx="3715">
                  <c:v>2.9062985313655298</c:v>
                </c:pt>
                <c:pt idx="3716">
                  <c:v>2.1539494526017902</c:v>
                </c:pt>
                <c:pt idx="3717">
                  <c:v>2.5600379626307599</c:v>
                </c:pt>
                <c:pt idx="3718">
                  <c:v>3.34639979004558</c:v>
                </c:pt>
                <c:pt idx="3719">
                  <c:v>2.6755085247800698</c:v>
                </c:pt>
                <c:pt idx="3720">
                  <c:v>2.3921279099311299</c:v>
                </c:pt>
                <c:pt idx="3721">
                  <c:v>2.85271714191874</c:v>
                </c:pt>
                <c:pt idx="3722">
                  <c:v>2.6051380369174502</c:v>
                </c:pt>
                <c:pt idx="3723">
                  <c:v>3.1154436458846502</c:v>
                </c:pt>
                <c:pt idx="3724">
                  <c:v>2.9286603450282298</c:v>
                </c:pt>
                <c:pt idx="3725">
                  <c:v>1.9637134746474301</c:v>
                </c:pt>
                <c:pt idx="3726">
                  <c:v>2.7078677125490298</c:v>
                </c:pt>
                <c:pt idx="3727">
                  <c:v>2.4850388037355802</c:v>
                </c:pt>
                <c:pt idx="3728">
                  <c:v>2.8492528498628502</c:v>
                </c:pt>
                <c:pt idx="3729">
                  <c:v>2.5211211348400999</c:v>
                </c:pt>
                <c:pt idx="3730">
                  <c:v>2.9240710646927699</c:v>
                </c:pt>
                <c:pt idx="3731">
                  <c:v>2.7069311814333998</c:v>
                </c:pt>
                <c:pt idx="3732">
                  <c:v>2.31505120517315</c:v>
                </c:pt>
                <c:pt idx="3733">
                  <c:v>2.85008573244972</c:v>
                </c:pt>
                <c:pt idx="3734">
                  <c:v>2.5109063976325801</c:v>
                </c:pt>
                <c:pt idx="3735">
                  <c:v>2.5515202209876202</c:v>
                </c:pt>
                <c:pt idx="3736">
                  <c:v>3.31163285141744</c:v>
                </c:pt>
                <c:pt idx="3737">
                  <c:v>2.8042992845197698</c:v>
                </c:pt>
                <c:pt idx="3738">
                  <c:v>2.8069701813079102</c:v>
                </c:pt>
                <c:pt idx="3739">
                  <c:v>2.97983931676848</c:v>
                </c:pt>
                <c:pt idx="3740">
                  <c:v>3.1066830101729499</c:v>
                </c:pt>
                <c:pt idx="3741">
                  <c:v>3.2759003661271402</c:v>
                </c:pt>
                <c:pt idx="3742">
                  <c:v>2.6250125717645698</c:v>
                </c:pt>
                <c:pt idx="3743">
                  <c:v>2.77064465964561</c:v>
                </c:pt>
                <c:pt idx="3744">
                  <c:v>2.7571883907035399</c:v>
                </c:pt>
                <c:pt idx="3745">
                  <c:v>2.90808536380518</c:v>
                </c:pt>
                <c:pt idx="3746">
                  <c:v>2.97881634988026</c:v>
                </c:pt>
                <c:pt idx="3747">
                  <c:v>2.3405465496689799</c:v>
                </c:pt>
                <c:pt idx="3748">
                  <c:v>2.4749349019236599</c:v>
                </c:pt>
                <c:pt idx="3749">
                  <c:v>2.66030269202352</c:v>
                </c:pt>
                <c:pt idx="3750">
                  <c:v>2.6457622140714299</c:v>
                </c:pt>
                <c:pt idx="3751">
                  <c:v>2.2041121875753098</c:v>
                </c:pt>
                <c:pt idx="3752">
                  <c:v>2.56384836460481</c:v>
                </c:pt>
                <c:pt idx="3753">
                  <c:v>2.36806845823777</c:v>
                </c:pt>
                <c:pt idx="3754">
                  <c:v>2.9400996575295801</c:v>
                </c:pt>
                <c:pt idx="3755">
                  <c:v>2.5824361511103899</c:v>
                </c:pt>
                <c:pt idx="3756">
                  <c:v>2.2623478508158699</c:v>
                </c:pt>
                <c:pt idx="3757">
                  <c:v>2.9570475124073901</c:v>
                </c:pt>
                <c:pt idx="3758">
                  <c:v>2.50667818578248</c:v>
                </c:pt>
                <c:pt idx="3759">
                  <c:v>2.5051075374332799</c:v>
                </c:pt>
                <c:pt idx="3760">
                  <c:v>2.6843606397695798</c:v>
                </c:pt>
                <c:pt idx="3761">
                  <c:v>2.5468767200526701</c:v>
                </c:pt>
                <c:pt idx="3762">
                  <c:v>2.6460451583390698</c:v>
                </c:pt>
                <c:pt idx="3763">
                  <c:v>2.53709107903568</c:v>
                </c:pt>
                <c:pt idx="3764">
                  <c:v>2.31039665360696</c:v>
                </c:pt>
                <c:pt idx="3765">
                  <c:v>2.34252746516401</c:v>
                </c:pt>
                <c:pt idx="3766">
                  <c:v>2.3071442763509098</c:v>
                </c:pt>
                <c:pt idx="3767">
                  <c:v>2.3585669934569502</c:v>
                </c:pt>
                <c:pt idx="3768">
                  <c:v>2.2683691231648901</c:v>
                </c:pt>
                <c:pt idx="3769">
                  <c:v>2.3278471844632</c:v>
                </c:pt>
                <c:pt idx="3770">
                  <c:v>2.8434807355735501</c:v>
                </c:pt>
                <c:pt idx="3771">
                  <c:v>2.7801718388162699</c:v>
                </c:pt>
                <c:pt idx="3772">
                  <c:v>2.7719401628748899</c:v>
                </c:pt>
                <c:pt idx="3773">
                  <c:v>2.3926311019645801</c:v>
                </c:pt>
                <c:pt idx="3774">
                  <c:v>2.3113842974005498</c:v>
                </c:pt>
                <c:pt idx="3775">
                  <c:v>2.4771169468005398</c:v>
                </c:pt>
                <c:pt idx="3776">
                  <c:v>2.4353519382933002</c:v>
                </c:pt>
                <c:pt idx="3777">
                  <c:v>2.99496002667287</c:v>
                </c:pt>
                <c:pt idx="3778">
                  <c:v>2.0551453513891298</c:v>
                </c:pt>
                <c:pt idx="3779">
                  <c:v>2.37559813558109</c:v>
                </c:pt>
                <c:pt idx="3780">
                  <c:v>2.7145343288218902</c:v>
                </c:pt>
                <c:pt idx="3781">
                  <c:v>2.1859127164758498</c:v>
                </c:pt>
                <c:pt idx="3782">
                  <c:v>2.2862616376512901</c:v>
                </c:pt>
                <c:pt idx="3783">
                  <c:v>2.2719389415054199</c:v>
                </c:pt>
                <c:pt idx="3784">
                  <c:v>2.78385069593334</c:v>
                </c:pt>
                <c:pt idx="3785">
                  <c:v>2.4610130437074198</c:v>
                </c:pt>
                <c:pt idx="3786">
                  <c:v>2.8120435923604101</c:v>
                </c:pt>
                <c:pt idx="3787">
                  <c:v>2.5218245187802202</c:v>
                </c:pt>
                <c:pt idx="3788">
                  <c:v>2.08145317343791</c:v>
                </c:pt>
                <c:pt idx="3789">
                  <c:v>2.6923464984317</c:v>
                </c:pt>
                <c:pt idx="3790">
                  <c:v>2.1207664491550999</c:v>
                </c:pt>
                <c:pt idx="3791">
                  <c:v>2.45183073670733</c:v>
                </c:pt>
                <c:pt idx="3792">
                  <c:v>2.5610565136413901</c:v>
                </c:pt>
                <c:pt idx="3793">
                  <c:v>2.74798547939116</c:v>
                </c:pt>
                <c:pt idx="3794">
                  <c:v>2.1594557566624699</c:v>
                </c:pt>
                <c:pt idx="3795">
                  <c:v>2.3741148585188698</c:v>
                </c:pt>
                <c:pt idx="3796">
                  <c:v>1.8241765191605499</c:v>
                </c:pt>
                <c:pt idx="3797">
                  <c:v>1.9820387880282999</c:v>
                </c:pt>
                <c:pt idx="3798">
                  <c:v>2.2303229095758699</c:v>
                </c:pt>
                <c:pt idx="3799">
                  <c:v>2.36150722891789</c:v>
                </c:pt>
                <c:pt idx="3800">
                  <c:v>2.0410190271278199</c:v>
                </c:pt>
                <c:pt idx="3801">
                  <c:v>1.8475186372249199</c:v>
                </c:pt>
                <c:pt idx="3802">
                  <c:v>2.3516162376469301</c:v>
                </c:pt>
                <c:pt idx="3803">
                  <c:v>2.4450882168011301</c:v>
                </c:pt>
                <c:pt idx="3804">
                  <c:v>2.52166084535861</c:v>
                </c:pt>
                <c:pt idx="3805">
                  <c:v>2.3071766902617501</c:v>
                </c:pt>
                <c:pt idx="3806">
                  <c:v>2.6610243606033901</c:v>
                </c:pt>
                <c:pt idx="3807">
                  <c:v>2.7243073470833501</c:v>
                </c:pt>
                <c:pt idx="3808">
                  <c:v>2.4764143368535998</c:v>
                </c:pt>
                <c:pt idx="3809">
                  <c:v>2.1491081322018002</c:v>
                </c:pt>
                <c:pt idx="3810">
                  <c:v>2.4823455032650998</c:v>
                </c:pt>
                <c:pt idx="3811">
                  <c:v>2.0907429434707998</c:v>
                </c:pt>
                <c:pt idx="3812">
                  <c:v>2.28320930074868</c:v>
                </c:pt>
                <c:pt idx="3813">
                  <c:v>2.4892020262910899</c:v>
                </c:pt>
                <c:pt idx="3814">
                  <c:v>2.8736607797577798</c:v>
                </c:pt>
                <c:pt idx="3815">
                  <c:v>2.1930654005220398</c:v>
                </c:pt>
                <c:pt idx="3816">
                  <c:v>2.5611169815352</c:v>
                </c:pt>
                <c:pt idx="3817">
                  <c:v>2.9415732923103599</c:v>
                </c:pt>
                <c:pt idx="3818">
                  <c:v>3.1736854378980799</c:v>
                </c:pt>
                <c:pt idx="3819">
                  <c:v>2.8410766444114102</c:v>
                </c:pt>
                <c:pt idx="3820">
                  <c:v>2.7653829554662201</c:v>
                </c:pt>
                <c:pt idx="3821">
                  <c:v>2.8008231335938998</c:v>
                </c:pt>
                <c:pt idx="3822">
                  <c:v>2.2885811561121301</c:v>
                </c:pt>
                <c:pt idx="3823">
                  <c:v>2.0286766309595401</c:v>
                </c:pt>
                <c:pt idx="3824">
                  <c:v>2.3610422400059798</c:v>
                </c:pt>
                <c:pt idx="3825">
                  <c:v>2.6501194776681598</c:v>
                </c:pt>
                <c:pt idx="3826">
                  <c:v>2.5808270327390201</c:v>
                </c:pt>
                <c:pt idx="3827">
                  <c:v>2.8645529572039399</c:v>
                </c:pt>
                <c:pt idx="3828">
                  <c:v>2.6691426409621002</c:v>
                </c:pt>
                <c:pt idx="3829">
                  <c:v>2.6807950905103501</c:v>
                </c:pt>
                <c:pt idx="3830">
                  <c:v>2.0968250932602999</c:v>
                </c:pt>
                <c:pt idx="3831">
                  <c:v>2.5551258554359499</c:v>
                </c:pt>
                <c:pt idx="3832">
                  <c:v>2.3875677588157602</c:v>
                </c:pt>
                <c:pt idx="3833">
                  <c:v>1.7932664878060001</c:v>
                </c:pt>
                <c:pt idx="3834">
                  <c:v>2.17337206591161</c:v>
                </c:pt>
                <c:pt idx="3835">
                  <c:v>2.8259600966171599</c:v>
                </c:pt>
                <c:pt idx="3836">
                  <c:v>2.8847490190658198</c:v>
                </c:pt>
                <c:pt idx="3837">
                  <c:v>2.5029236663139001</c:v>
                </c:pt>
                <c:pt idx="3838">
                  <c:v>2.3740751555042099</c:v>
                </c:pt>
                <c:pt idx="3839">
                  <c:v>2.5290141338558998</c:v>
                </c:pt>
                <c:pt idx="3840">
                  <c:v>2.0866600249184302</c:v>
                </c:pt>
                <c:pt idx="3841">
                  <c:v>2.4724618477867599</c:v>
                </c:pt>
                <c:pt idx="3842">
                  <c:v>2.14552618061983</c:v>
                </c:pt>
                <c:pt idx="3843">
                  <c:v>2.0199528552369501</c:v>
                </c:pt>
                <c:pt idx="3844">
                  <c:v>2.2652737877992899</c:v>
                </c:pt>
                <c:pt idx="3845">
                  <c:v>1.8045301438572601</c:v>
                </c:pt>
                <c:pt idx="3846">
                  <c:v>1.5600672468627601</c:v>
                </c:pt>
                <c:pt idx="3847">
                  <c:v>2.4211400285696101</c:v>
                </c:pt>
                <c:pt idx="3848">
                  <c:v>1.69040816401019</c:v>
                </c:pt>
                <c:pt idx="3849">
                  <c:v>2.2034023139021102</c:v>
                </c:pt>
                <c:pt idx="3850">
                  <c:v>2.3308301582668398</c:v>
                </c:pt>
                <c:pt idx="3851">
                  <c:v>1.5974586264563599</c:v>
                </c:pt>
                <c:pt idx="3852">
                  <c:v>1.9515414908584401</c:v>
                </c:pt>
                <c:pt idx="3853">
                  <c:v>2.7580336200371098</c:v>
                </c:pt>
                <c:pt idx="3854">
                  <c:v>2.2228138846094101</c:v>
                </c:pt>
                <c:pt idx="3855">
                  <c:v>2.3236319254450799</c:v>
                </c:pt>
                <c:pt idx="3856">
                  <c:v>2.5729108643488301</c:v>
                </c:pt>
                <c:pt idx="3857">
                  <c:v>2.4777444923103502</c:v>
                </c:pt>
                <c:pt idx="3858">
                  <c:v>2.1714668185270098</c:v>
                </c:pt>
                <c:pt idx="3859">
                  <c:v>2.3741779696190699</c:v>
                </c:pt>
                <c:pt idx="3860">
                  <c:v>2.45574812495299</c:v>
                </c:pt>
                <c:pt idx="3861">
                  <c:v>2.952104407217</c:v>
                </c:pt>
                <c:pt idx="3862">
                  <c:v>2.82081112194584</c:v>
                </c:pt>
                <c:pt idx="3863">
                  <c:v>2.7677963558926999</c:v>
                </c:pt>
                <c:pt idx="3864">
                  <c:v>2.0195868936047998</c:v>
                </c:pt>
                <c:pt idx="3865">
                  <c:v>2.45321385007332</c:v>
                </c:pt>
                <c:pt idx="3866">
                  <c:v>2.2289123985397201</c:v>
                </c:pt>
                <c:pt idx="3867">
                  <c:v>2.0054129887058698</c:v>
                </c:pt>
                <c:pt idx="3868">
                  <c:v>3.0099171970360201</c:v>
                </c:pt>
                <c:pt idx="3869">
                  <c:v>2.4810037426696798</c:v>
                </c:pt>
                <c:pt idx="3870">
                  <c:v>3.2493041711953201</c:v>
                </c:pt>
                <c:pt idx="3871">
                  <c:v>2.2861402183482298</c:v>
                </c:pt>
                <c:pt idx="3872">
                  <c:v>2.5302867241781701</c:v>
                </c:pt>
                <c:pt idx="3873">
                  <c:v>2.59494394084542</c:v>
                </c:pt>
                <c:pt idx="3874">
                  <c:v>2.4468259382720698</c:v>
                </c:pt>
                <c:pt idx="3875">
                  <c:v>2.5653027488850801</c:v>
                </c:pt>
                <c:pt idx="3876">
                  <c:v>2.6280790567928101</c:v>
                </c:pt>
                <c:pt idx="3877">
                  <c:v>2.9101511320762601</c:v>
                </c:pt>
                <c:pt idx="3878">
                  <c:v>2.5777105840200001</c:v>
                </c:pt>
                <c:pt idx="3879">
                  <c:v>2.9476088231048601</c:v>
                </c:pt>
                <c:pt idx="3880">
                  <c:v>2.6522961858315099</c:v>
                </c:pt>
                <c:pt idx="3881">
                  <c:v>2.8323927669047002</c:v>
                </c:pt>
                <c:pt idx="3882">
                  <c:v>2.54488401359442</c:v>
                </c:pt>
                <c:pt idx="3883">
                  <c:v>1.87887390177395</c:v>
                </c:pt>
                <c:pt idx="3884">
                  <c:v>2.47635169288781</c:v>
                </c:pt>
                <c:pt idx="3885">
                  <c:v>3.20115175332639</c:v>
                </c:pt>
                <c:pt idx="3886">
                  <c:v>2.74371191522471</c:v>
                </c:pt>
                <c:pt idx="3887">
                  <c:v>2.7811771481393799</c:v>
                </c:pt>
                <c:pt idx="3888">
                  <c:v>2.9534126249412198</c:v>
                </c:pt>
                <c:pt idx="3889">
                  <c:v>2.8416081794071801</c:v>
                </c:pt>
                <c:pt idx="3890">
                  <c:v>3.0539238817875098</c:v>
                </c:pt>
                <c:pt idx="3891">
                  <c:v>3.01792045595298</c:v>
                </c:pt>
                <c:pt idx="3892">
                  <c:v>3.0124154949031201</c:v>
                </c:pt>
                <c:pt idx="3893">
                  <c:v>3.1272787131435802</c:v>
                </c:pt>
                <c:pt idx="3894">
                  <c:v>2.4431314371654</c:v>
                </c:pt>
                <c:pt idx="3895">
                  <c:v>2.9014002051479699</c:v>
                </c:pt>
                <c:pt idx="3896">
                  <c:v>2.48133434570543</c:v>
                </c:pt>
                <c:pt idx="3897">
                  <c:v>2.4198729702369399</c:v>
                </c:pt>
                <c:pt idx="3898">
                  <c:v>2.8074806721463199</c:v>
                </c:pt>
                <c:pt idx="3899">
                  <c:v>2.7875365312918499</c:v>
                </c:pt>
                <c:pt idx="3900">
                  <c:v>3.0152676706460402</c:v>
                </c:pt>
                <c:pt idx="3901">
                  <c:v>2.6393544604239501</c:v>
                </c:pt>
                <c:pt idx="3902">
                  <c:v>2.62674609122061</c:v>
                </c:pt>
                <c:pt idx="3903">
                  <c:v>1.9913887638863199</c:v>
                </c:pt>
                <c:pt idx="3904">
                  <c:v>2.8294081475948101</c:v>
                </c:pt>
                <c:pt idx="3905">
                  <c:v>2.6948489115905301</c:v>
                </c:pt>
                <c:pt idx="3906">
                  <c:v>2.8350384158792501</c:v>
                </c:pt>
                <c:pt idx="3907">
                  <c:v>2.48552500585365</c:v>
                </c:pt>
                <c:pt idx="3908">
                  <c:v>2.7478133258286901</c:v>
                </c:pt>
                <c:pt idx="3909">
                  <c:v>3.1169208270198201</c:v>
                </c:pt>
                <c:pt idx="3910">
                  <c:v>2.2905445330742298</c:v>
                </c:pt>
                <c:pt idx="3911">
                  <c:v>2.8110396002399298</c:v>
                </c:pt>
                <c:pt idx="3912">
                  <c:v>2.7415811855826502</c:v>
                </c:pt>
                <c:pt idx="3913">
                  <c:v>2.2944025935188801</c:v>
                </c:pt>
                <c:pt idx="3914">
                  <c:v>2.89228821288844</c:v>
                </c:pt>
                <c:pt idx="3915">
                  <c:v>3.1098472757434501</c:v>
                </c:pt>
                <c:pt idx="3916">
                  <c:v>2.7580164666601101</c:v>
                </c:pt>
                <c:pt idx="3917">
                  <c:v>2.1819421153717902</c:v>
                </c:pt>
                <c:pt idx="3918">
                  <c:v>2.0928704052062299</c:v>
                </c:pt>
                <c:pt idx="3919">
                  <c:v>2.6511710005587998</c:v>
                </c:pt>
                <c:pt idx="3920">
                  <c:v>3.0333328058998301</c:v>
                </c:pt>
                <c:pt idx="3921">
                  <c:v>2.7352880348959698</c:v>
                </c:pt>
                <c:pt idx="3922">
                  <c:v>3.3023602077758398</c:v>
                </c:pt>
                <c:pt idx="3923">
                  <c:v>2.9801882433129099</c:v>
                </c:pt>
                <c:pt idx="3924">
                  <c:v>2.8182659917347901</c:v>
                </c:pt>
                <c:pt idx="3925">
                  <c:v>2.7212762116353999</c:v>
                </c:pt>
                <c:pt idx="3926">
                  <c:v>2.9073749964297502</c:v>
                </c:pt>
                <c:pt idx="3927">
                  <c:v>2.9265311215494201</c:v>
                </c:pt>
                <c:pt idx="3928">
                  <c:v>3.01280630620069</c:v>
                </c:pt>
                <c:pt idx="3929">
                  <c:v>2.9145578227349298</c:v>
                </c:pt>
                <c:pt idx="3930">
                  <c:v>3.2262178485842798</c:v>
                </c:pt>
                <c:pt idx="3931">
                  <c:v>2.8600291270925999</c:v>
                </c:pt>
                <c:pt idx="3932">
                  <c:v>2.47116054629964</c:v>
                </c:pt>
                <c:pt idx="3933">
                  <c:v>2.7748712873702801</c:v>
                </c:pt>
                <c:pt idx="3934">
                  <c:v>2.2175399327087901</c:v>
                </c:pt>
                <c:pt idx="3935">
                  <c:v>2.1670077336082598</c:v>
                </c:pt>
                <c:pt idx="3936">
                  <c:v>2.4226370329993099</c:v>
                </c:pt>
                <c:pt idx="3937">
                  <c:v>2.4862080432360298</c:v>
                </c:pt>
                <c:pt idx="3938">
                  <c:v>2.7895574952449298</c:v>
                </c:pt>
                <c:pt idx="3939">
                  <c:v>2.40079280539614</c:v>
                </c:pt>
                <c:pt idx="3940">
                  <c:v>3.3903702453681799</c:v>
                </c:pt>
                <c:pt idx="3941">
                  <c:v>3.0428284906141498</c:v>
                </c:pt>
                <c:pt idx="3942">
                  <c:v>3.2549347092977201</c:v>
                </c:pt>
                <c:pt idx="3943">
                  <c:v>3.3185511545684401</c:v>
                </c:pt>
                <c:pt idx="3944">
                  <c:v>2.5635313109769502</c:v>
                </c:pt>
                <c:pt idx="3945">
                  <c:v>3.3028919897967199</c:v>
                </c:pt>
                <c:pt idx="3946">
                  <c:v>3.1874922934680399</c:v>
                </c:pt>
                <c:pt idx="3947">
                  <c:v>4.0295204938149896</c:v>
                </c:pt>
                <c:pt idx="3948">
                  <c:v>3.4789267976418201</c:v>
                </c:pt>
                <c:pt idx="3949">
                  <c:v>3.2625577181679102</c:v>
                </c:pt>
                <c:pt idx="3950">
                  <c:v>3.56086855868082</c:v>
                </c:pt>
                <c:pt idx="3951">
                  <c:v>4.3264283076251502</c:v>
                </c:pt>
                <c:pt idx="3952">
                  <c:v>3.30403639323257</c:v>
                </c:pt>
                <c:pt idx="3953">
                  <c:v>3.07132747885246</c:v>
                </c:pt>
                <c:pt idx="3954">
                  <c:v>3.2435354613282099</c:v>
                </c:pt>
                <c:pt idx="3955">
                  <c:v>3.7813157333899698</c:v>
                </c:pt>
                <c:pt idx="3956">
                  <c:v>3.9606020469609802</c:v>
                </c:pt>
                <c:pt idx="3957">
                  <c:v>4.6446210883748797</c:v>
                </c:pt>
                <c:pt idx="3958">
                  <c:v>4.2196483896080403</c:v>
                </c:pt>
                <c:pt idx="3959">
                  <c:v>3.1932193369516999</c:v>
                </c:pt>
                <c:pt idx="3960">
                  <c:v>3.3729086840034599</c:v>
                </c:pt>
                <c:pt idx="3961">
                  <c:v>3.5167383923879898</c:v>
                </c:pt>
                <c:pt idx="3962">
                  <c:v>3.6173385301098802</c:v>
                </c:pt>
                <c:pt idx="3963">
                  <c:v>3.6271777550089102</c:v>
                </c:pt>
                <c:pt idx="3964">
                  <c:v>3.86502905144728</c:v>
                </c:pt>
                <c:pt idx="3965">
                  <c:v>4.0649620104272799</c:v>
                </c:pt>
                <c:pt idx="3966">
                  <c:v>4.1773441027535698</c:v>
                </c:pt>
                <c:pt idx="3967">
                  <c:v>3.9170837304856501</c:v>
                </c:pt>
                <c:pt idx="3968">
                  <c:v>3.4980571646312502</c:v>
                </c:pt>
                <c:pt idx="3969">
                  <c:v>4.3592852117372098</c:v>
                </c:pt>
                <c:pt idx="3970">
                  <c:v>4.0208505366028104</c:v>
                </c:pt>
                <c:pt idx="3971">
                  <c:v>3.8655875986373598</c:v>
                </c:pt>
                <c:pt idx="3972">
                  <c:v>3.74292372010654</c:v>
                </c:pt>
                <c:pt idx="3973">
                  <c:v>4.1998900882939703</c:v>
                </c:pt>
                <c:pt idx="3974">
                  <c:v>4.2555783845914599</c:v>
                </c:pt>
                <c:pt idx="3975">
                  <c:v>3.4395533743565001</c:v>
                </c:pt>
                <c:pt idx="3976">
                  <c:v>4.1069802513413798</c:v>
                </c:pt>
                <c:pt idx="3977">
                  <c:v>3.41590477870536</c:v>
                </c:pt>
                <c:pt idx="3978">
                  <c:v>4.0141717216726098</c:v>
                </c:pt>
                <c:pt idx="3979">
                  <c:v>3.6915980525476502</c:v>
                </c:pt>
                <c:pt idx="3980">
                  <c:v>3.2101398883071401</c:v>
                </c:pt>
                <c:pt idx="3981">
                  <c:v>3.4261200362822399</c:v>
                </c:pt>
                <c:pt idx="3982">
                  <c:v>3.57206007288401</c:v>
                </c:pt>
                <c:pt idx="3983">
                  <c:v>4.0671186757862996</c:v>
                </c:pt>
                <c:pt idx="3984">
                  <c:v>3.6751712132768302</c:v>
                </c:pt>
                <c:pt idx="3985">
                  <c:v>4.0271068684315496</c:v>
                </c:pt>
                <c:pt idx="3986">
                  <c:v>4.3190039570583396</c:v>
                </c:pt>
                <c:pt idx="3987">
                  <c:v>3.48584683916746</c:v>
                </c:pt>
                <c:pt idx="3988">
                  <c:v>3.79710737840756</c:v>
                </c:pt>
                <c:pt idx="3989">
                  <c:v>3.0934067754421002</c:v>
                </c:pt>
                <c:pt idx="3990">
                  <c:v>3.29772268063804</c:v>
                </c:pt>
                <c:pt idx="3991">
                  <c:v>3.8178283863799498</c:v>
                </c:pt>
                <c:pt idx="3992">
                  <c:v>3.2586490071009</c:v>
                </c:pt>
                <c:pt idx="3993">
                  <c:v>3.29350011717721</c:v>
                </c:pt>
                <c:pt idx="3994">
                  <c:v>3.1787387192952798</c:v>
                </c:pt>
                <c:pt idx="3995">
                  <c:v>3.65084474192932</c:v>
                </c:pt>
                <c:pt idx="3996">
                  <c:v>2.9049380871578401</c:v>
                </c:pt>
                <c:pt idx="3997">
                  <c:v>3.4476266567283398</c:v>
                </c:pt>
                <c:pt idx="3998">
                  <c:v>3.5555111126624901</c:v>
                </c:pt>
                <c:pt idx="3999">
                  <c:v>2.9393558631982701</c:v>
                </c:pt>
                <c:pt idx="4000">
                  <c:v>3.8051260666680098</c:v>
                </c:pt>
                <c:pt idx="4001">
                  <c:v>3.11064554308463</c:v>
                </c:pt>
                <c:pt idx="4002">
                  <c:v>3.3813908745271699</c:v>
                </c:pt>
                <c:pt idx="4003">
                  <c:v>3.4177884948209298</c:v>
                </c:pt>
                <c:pt idx="4004">
                  <c:v>3.1803807970554199</c:v>
                </c:pt>
                <c:pt idx="4005">
                  <c:v>2.38092896840122</c:v>
                </c:pt>
                <c:pt idx="4006">
                  <c:v>3.48471608772646</c:v>
                </c:pt>
                <c:pt idx="4007">
                  <c:v>3.2966473981173201</c:v>
                </c:pt>
                <c:pt idx="4008">
                  <c:v>2.4985185992522498</c:v>
                </c:pt>
                <c:pt idx="4009">
                  <c:v>2.7141354489139098</c:v>
                </c:pt>
                <c:pt idx="4010">
                  <c:v>3.0350799962083101</c:v>
                </c:pt>
                <c:pt idx="4011">
                  <c:v>3.28447024139918</c:v>
                </c:pt>
                <c:pt idx="4012">
                  <c:v>3.8988079088039398</c:v>
                </c:pt>
                <c:pt idx="4013">
                  <c:v>3.3957078618065601</c:v>
                </c:pt>
                <c:pt idx="4014">
                  <c:v>3.2285546662646598</c:v>
                </c:pt>
                <c:pt idx="4015">
                  <c:v>3.3074532230949698</c:v>
                </c:pt>
                <c:pt idx="4016">
                  <c:v>3.2761869800185601</c:v>
                </c:pt>
                <c:pt idx="4017">
                  <c:v>3.5561691307876502</c:v>
                </c:pt>
                <c:pt idx="4018">
                  <c:v>2.9794243713729398</c:v>
                </c:pt>
                <c:pt idx="4019">
                  <c:v>3.6174076133446502</c:v>
                </c:pt>
                <c:pt idx="4020">
                  <c:v>3.11482747349265</c:v>
                </c:pt>
                <c:pt idx="4021">
                  <c:v>3.3132496783599801</c:v>
                </c:pt>
                <c:pt idx="4022">
                  <c:v>2.9163373364377998</c:v>
                </c:pt>
                <c:pt idx="4023">
                  <c:v>3.3137811060860201</c:v>
                </c:pt>
                <c:pt idx="4024">
                  <c:v>3.3840571877756802</c:v>
                </c:pt>
                <c:pt idx="4025">
                  <c:v>3.0999207830042099</c:v>
                </c:pt>
                <c:pt idx="4026">
                  <c:v>3.9466556177133798</c:v>
                </c:pt>
                <c:pt idx="4027">
                  <c:v>3.2341179558244</c:v>
                </c:pt>
                <c:pt idx="4028">
                  <c:v>2.8354178925426301</c:v>
                </c:pt>
                <c:pt idx="4029">
                  <c:v>3.5448596421191501</c:v>
                </c:pt>
                <c:pt idx="4030">
                  <c:v>3.13501829079163</c:v>
                </c:pt>
                <c:pt idx="4031">
                  <c:v>3.6706126408815698</c:v>
                </c:pt>
                <c:pt idx="4032">
                  <c:v>3.3290275793813202</c:v>
                </c:pt>
                <c:pt idx="4033">
                  <c:v>3.5943898642907399</c:v>
                </c:pt>
                <c:pt idx="4034">
                  <c:v>3.48026165662632</c:v>
                </c:pt>
                <c:pt idx="4035">
                  <c:v>3.4292646632478698</c:v>
                </c:pt>
                <c:pt idx="4036">
                  <c:v>3.1056388992824702</c:v>
                </c:pt>
                <c:pt idx="4037">
                  <c:v>3.73631157152772</c:v>
                </c:pt>
                <c:pt idx="4038">
                  <c:v>3.9335461842131201</c:v>
                </c:pt>
                <c:pt idx="4039">
                  <c:v>2.7219808712341398</c:v>
                </c:pt>
                <c:pt idx="4040">
                  <c:v>2.85939500348909</c:v>
                </c:pt>
                <c:pt idx="4041">
                  <c:v>3.01232190673029</c:v>
                </c:pt>
                <c:pt idx="4042">
                  <c:v>3.1829442388478402</c:v>
                </c:pt>
                <c:pt idx="4043">
                  <c:v>3.1550706160133899</c:v>
                </c:pt>
                <c:pt idx="4044">
                  <c:v>3.3354092896182101</c:v>
                </c:pt>
                <c:pt idx="4045">
                  <c:v>2.8646901055866301</c:v>
                </c:pt>
                <c:pt idx="4046">
                  <c:v>3.6787967951142102</c:v>
                </c:pt>
                <c:pt idx="4047">
                  <c:v>3.3109417630357099</c:v>
                </c:pt>
                <c:pt idx="4048">
                  <c:v>3.33215554375343</c:v>
                </c:pt>
                <c:pt idx="4049">
                  <c:v>3.6883798830566299</c:v>
                </c:pt>
                <c:pt idx="4050">
                  <c:v>3.3516617596117002</c:v>
                </c:pt>
                <c:pt idx="4051">
                  <c:v>3.3548900226988798</c:v>
                </c:pt>
                <c:pt idx="4052">
                  <c:v>4.1146715494874098</c:v>
                </c:pt>
                <c:pt idx="4053">
                  <c:v>3.5951637123522602</c:v>
                </c:pt>
                <c:pt idx="4054">
                  <c:v>3.5097384810335499</c:v>
                </c:pt>
                <c:pt idx="4055">
                  <c:v>3.6470859559987998</c:v>
                </c:pt>
                <c:pt idx="4056">
                  <c:v>3.9367924148259998</c:v>
                </c:pt>
                <c:pt idx="4057">
                  <c:v>3.7582528501672301</c:v>
                </c:pt>
                <c:pt idx="4058">
                  <c:v>3.9337537416063402</c:v>
                </c:pt>
                <c:pt idx="4059">
                  <c:v>3.8887810717754201</c:v>
                </c:pt>
                <c:pt idx="4060">
                  <c:v>3.3867229135697299</c:v>
                </c:pt>
                <c:pt idx="4061">
                  <c:v>3.1925034931526701</c:v>
                </c:pt>
                <c:pt idx="4062">
                  <c:v>3.54935119338329</c:v>
                </c:pt>
                <c:pt idx="4063">
                  <c:v>3.3719192334954999</c:v>
                </c:pt>
                <c:pt idx="4064">
                  <c:v>4.0682972210256203</c:v>
                </c:pt>
                <c:pt idx="4065">
                  <c:v>3.4272137675518901</c:v>
                </c:pt>
                <c:pt idx="4066">
                  <c:v>3.0454102201269402</c:v>
                </c:pt>
                <c:pt idx="4067">
                  <c:v>2.96399684182858</c:v>
                </c:pt>
                <c:pt idx="4068">
                  <c:v>3.1278051975300198</c:v>
                </c:pt>
                <c:pt idx="4069">
                  <c:v>3.2210870734074901</c:v>
                </c:pt>
                <c:pt idx="4070">
                  <c:v>2.83452830767451</c:v>
                </c:pt>
                <c:pt idx="4071">
                  <c:v>3.22397228549457</c:v>
                </c:pt>
                <c:pt idx="4072">
                  <c:v>3.1622935659670199</c:v>
                </c:pt>
                <c:pt idx="4073">
                  <c:v>2.87428573983963</c:v>
                </c:pt>
                <c:pt idx="4074">
                  <c:v>2.89905251196548</c:v>
                </c:pt>
                <c:pt idx="4075">
                  <c:v>3.0624486811438301</c:v>
                </c:pt>
                <c:pt idx="4076">
                  <c:v>3.1363209218419299</c:v>
                </c:pt>
                <c:pt idx="4077">
                  <c:v>3.2520881307830498</c:v>
                </c:pt>
                <c:pt idx="4078">
                  <c:v>3.09013531286198</c:v>
                </c:pt>
                <c:pt idx="4079">
                  <c:v>3.2510353443503299</c:v>
                </c:pt>
                <c:pt idx="4080">
                  <c:v>2.9178389275846399</c:v>
                </c:pt>
                <c:pt idx="4081">
                  <c:v>3.7360658090172199</c:v>
                </c:pt>
                <c:pt idx="4082">
                  <c:v>2.8466503522775901</c:v>
                </c:pt>
                <c:pt idx="4083">
                  <c:v>2.7526347381695402</c:v>
                </c:pt>
                <c:pt idx="4084">
                  <c:v>2.5839701760622602</c:v>
                </c:pt>
                <c:pt idx="4085">
                  <c:v>2.9027135906713202</c:v>
                </c:pt>
                <c:pt idx="4086">
                  <c:v>3.1111045871385898</c:v>
                </c:pt>
                <c:pt idx="4087">
                  <c:v>3.25719186257975</c:v>
                </c:pt>
                <c:pt idx="4088">
                  <c:v>3.3760828869510102</c:v>
                </c:pt>
                <c:pt idx="4089">
                  <c:v>3.2004899868507999</c:v>
                </c:pt>
                <c:pt idx="4090">
                  <c:v>3.46254101677405</c:v>
                </c:pt>
                <c:pt idx="4091">
                  <c:v>3.3070721523708602</c:v>
                </c:pt>
                <c:pt idx="4092">
                  <c:v>3.2414702789956298</c:v>
                </c:pt>
                <c:pt idx="4093">
                  <c:v>2.81640298937057</c:v>
                </c:pt>
                <c:pt idx="4094">
                  <c:v>3.2948635604399801</c:v>
                </c:pt>
                <c:pt idx="4095">
                  <c:v>3.117232288686</c:v>
                </c:pt>
                <c:pt idx="4096">
                  <c:v>3.0864623053126898</c:v>
                </c:pt>
                <c:pt idx="4097">
                  <c:v>3.1218919245563499</c:v>
                </c:pt>
                <c:pt idx="4098">
                  <c:v>3.17439957666988</c:v>
                </c:pt>
                <c:pt idx="4099">
                  <c:v>4.0847693852650799</c:v>
                </c:pt>
                <c:pt idx="4100">
                  <c:v>3.3383731695748899</c:v>
                </c:pt>
                <c:pt idx="4101">
                  <c:v>3.4072521526520401</c:v>
                </c:pt>
                <c:pt idx="4102">
                  <c:v>3.16268983970224</c:v>
                </c:pt>
                <c:pt idx="4103">
                  <c:v>3.8179408793794298</c:v>
                </c:pt>
                <c:pt idx="4104">
                  <c:v>3.4247405898577501</c:v>
                </c:pt>
                <c:pt idx="4105">
                  <c:v>3.4652416312521201</c:v>
                </c:pt>
                <c:pt idx="4106">
                  <c:v>3.7432418131882801</c:v>
                </c:pt>
                <c:pt idx="4107">
                  <c:v>3.5418078118683498</c:v>
                </c:pt>
                <c:pt idx="4108">
                  <c:v>4.1645867388921696</c:v>
                </c:pt>
                <c:pt idx="4109">
                  <c:v>3.4438526096414299</c:v>
                </c:pt>
                <c:pt idx="4110">
                  <c:v>3.1947114173808102</c:v>
                </c:pt>
                <c:pt idx="4111">
                  <c:v>2.5902758525685199</c:v>
                </c:pt>
                <c:pt idx="4112">
                  <c:v>2.5499396584473901</c:v>
                </c:pt>
                <c:pt idx="4113">
                  <c:v>2.96461501414346</c:v>
                </c:pt>
                <c:pt idx="4114">
                  <c:v>2.6538418361135299</c:v>
                </c:pt>
                <c:pt idx="4115">
                  <c:v>2.6986997651532501</c:v>
                </c:pt>
                <c:pt idx="4116">
                  <c:v>2.9699366031716998</c:v>
                </c:pt>
                <c:pt idx="4117">
                  <c:v>2.6965956514993401</c:v>
                </c:pt>
                <c:pt idx="4118">
                  <c:v>2.8363746961832801</c:v>
                </c:pt>
                <c:pt idx="4119">
                  <c:v>2.6461900566223902</c:v>
                </c:pt>
                <c:pt idx="4120">
                  <c:v>2.1867976319155602</c:v>
                </c:pt>
                <c:pt idx="4121">
                  <c:v>2.9216814070470098</c:v>
                </c:pt>
                <c:pt idx="4122">
                  <c:v>2.8730843520640201</c:v>
                </c:pt>
                <c:pt idx="4123">
                  <c:v>3.4409817187388101</c:v>
                </c:pt>
                <c:pt idx="4124">
                  <c:v>2.3893945705966999</c:v>
                </c:pt>
                <c:pt idx="4125">
                  <c:v>2.5391840265482499</c:v>
                </c:pt>
                <c:pt idx="4126">
                  <c:v>3.0887939324892901</c:v>
                </c:pt>
                <c:pt idx="4127">
                  <c:v>2.9477192209001299</c:v>
                </c:pt>
                <c:pt idx="4128">
                  <c:v>3.3046768084315001</c:v>
                </c:pt>
                <c:pt idx="4129">
                  <c:v>3.1633187152859299</c:v>
                </c:pt>
                <c:pt idx="4130">
                  <c:v>3.4064337628339199</c:v>
                </c:pt>
                <c:pt idx="4131">
                  <c:v>3.9885736183292302</c:v>
                </c:pt>
                <c:pt idx="4132">
                  <c:v>3.39073262183785</c:v>
                </c:pt>
                <c:pt idx="4133">
                  <c:v>3.51114874528704</c:v>
                </c:pt>
                <c:pt idx="4134">
                  <c:v>2.9051576247696702</c:v>
                </c:pt>
                <c:pt idx="4135">
                  <c:v>3.1029438163852601</c:v>
                </c:pt>
                <c:pt idx="4136">
                  <c:v>2.4045106726314498</c:v>
                </c:pt>
                <c:pt idx="4137">
                  <c:v>2.9406169697759101</c:v>
                </c:pt>
                <c:pt idx="4138">
                  <c:v>2.5728950122414398</c:v>
                </c:pt>
                <c:pt idx="4139">
                  <c:v>3.01546999980985</c:v>
                </c:pt>
                <c:pt idx="4140">
                  <c:v>2.8014729296236802</c:v>
                </c:pt>
                <c:pt idx="4141">
                  <c:v>2.7162211240715401</c:v>
                </c:pt>
                <c:pt idx="4142">
                  <c:v>3.4459198180544499</c:v>
                </c:pt>
                <c:pt idx="4143">
                  <c:v>3.0619778687228298</c:v>
                </c:pt>
                <c:pt idx="4144">
                  <c:v>2.8522605868775699</c:v>
                </c:pt>
                <c:pt idx="4145">
                  <c:v>3.5082883414382802</c:v>
                </c:pt>
                <c:pt idx="4146">
                  <c:v>3.9079117328265398</c:v>
                </c:pt>
                <c:pt idx="4147">
                  <c:v>3.1121844003937298</c:v>
                </c:pt>
                <c:pt idx="4148">
                  <c:v>3.4441761627030498</c:v>
                </c:pt>
                <c:pt idx="4149">
                  <c:v>2.89042149442438</c:v>
                </c:pt>
                <c:pt idx="4150">
                  <c:v>3.10775695493574</c:v>
                </c:pt>
                <c:pt idx="4151">
                  <c:v>3.3619385401513799</c:v>
                </c:pt>
                <c:pt idx="4152">
                  <c:v>3.3736405059168701</c:v>
                </c:pt>
                <c:pt idx="4153">
                  <c:v>3.46587864045217</c:v>
                </c:pt>
                <c:pt idx="4154">
                  <c:v>3.3519951134550099</c:v>
                </c:pt>
                <c:pt idx="4155">
                  <c:v>3.3868102044494202</c:v>
                </c:pt>
                <c:pt idx="4156">
                  <c:v>3.0044127638371201</c:v>
                </c:pt>
                <c:pt idx="4157">
                  <c:v>2.69052745607762</c:v>
                </c:pt>
                <c:pt idx="4158">
                  <c:v>2.9058857692701898</c:v>
                </c:pt>
                <c:pt idx="4159">
                  <c:v>2.9907710025522798</c:v>
                </c:pt>
                <c:pt idx="4160">
                  <c:v>2.72335466383851</c:v>
                </c:pt>
                <c:pt idx="4161">
                  <c:v>3.0474946595638901</c:v>
                </c:pt>
                <c:pt idx="4162">
                  <c:v>3.3065924541568301</c:v>
                </c:pt>
                <c:pt idx="4163">
                  <c:v>4.0744357854608602</c:v>
                </c:pt>
                <c:pt idx="4164">
                  <c:v>2.8144616644467502</c:v>
                </c:pt>
                <c:pt idx="4165">
                  <c:v>2.75240765381389</c:v>
                </c:pt>
                <c:pt idx="4166">
                  <c:v>2.73252249324092</c:v>
                </c:pt>
                <c:pt idx="4167">
                  <c:v>3.1890965973330698</c:v>
                </c:pt>
                <c:pt idx="4168">
                  <c:v>2.97201809020362</c:v>
                </c:pt>
                <c:pt idx="4169">
                  <c:v>2.9018541409285499</c:v>
                </c:pt>
                <c:pt idx="4170">
                  <c:v>3.4273018566343301</c:v>
                </c:pt>
                <c:pt idx="4171">
                  <c:v>2.5441196344742898</c:v>
                </c:pt>
                <c:pt idx="4172">
                  <c:v>3.0303522763294199</c:v>
                </c:pt>
                <c:pt idx="4173">
                  <c:v>3.3398002493580798</c:v>
                </c:pt>
                <c:pt idx="4174">
                  <c:v>3.5510295331942499</c:v>
                </c:pt>
                <c:pt idx="4175">
                  <c:v>3.8166388898996599</c:v>
                </c:pt>
                <c:pt idx="4176">
                  <c:v>4.0039690366684502</c:v>
                </c:pt>
                <c:pt idx="4177">
                  <c:v>4.1760133831687902</c:v>
                </c:pt>
                <c:pt idx="4178">
                  <c:v>3.5180025127131098</c:v>
                </c:pt>
                <c:pt idx="4179">
                  <c:v>3.8810425849058001</c:v>
                </c:pt>
                <c:pt idx="4180">
                  <c:v>3.9414467665915498</c:v>
                </c:pt>
                <c:pt idx="4181">
                  <c:v>3.7497621713609299</c:v>
                </c:pt>
                <c:pt idx="4182">
                  <c:v>4.5627238507807402</c:v>
                </c:pt>
                <c:pt idx="4183">
                  <c:v>3.4403703714389202</c:v>
                </c:pt>
                <c:pt idx="4184">
                  <c:v>3.3173173512091898</c:v>
                </c:pt>
                <c:pt idx="4185">
                  <c:v>3.3762343430196999</c:v>
                </c:pt>
                <c:pt idx="4186">
                  <c:v>3.63049015625556</c:v>
                </c:pt>
                <c:pt idx="4187">
                  <c:v>4.2567977585707402</c:v>
                </c:pt>
                <c:pt idx="4188">
                  <c:v>3.9145192818138002</c:v>
                </c:pt>
                <c:pt idx="4189">
                  <c:v>4.2936490322697702</c:v>
                </c:pt>
                <c:pt idx="4190">
                  <c:v>3.8560731264460202</c:v>
                </c:pt>
                <c:pt idx="4191">
                  <c:v>4.4515118594739702</c:v>
                </c:pt>
                <c:pt idx="4192">
                  <c:v>4.25741870611518</c:v>
                </c:pt>
                <c:pt idx="4193">
                  <c:v>3.8567201786120799</c:v>
                </c:pt>
                <c:pt idx="4194">
                  <c:v>4.0235016396724399</c:v>
                </c:pt>
                <c:pt idx="4195">
                  <c:v>3.3415721759921602</c:v>
                </c:pt>
                <c:pt idx="4196">
                  <c:v>3.7325618582198401</c:v>
                </c:pt>
                <c:pt idx="4197">
                  <c:v>3.7121780315374799</c:v>
                </c:pt>
                <c:pt idx="4198">
                  <c:v>3.6062192401640898</c:v>
                </c:pt>
                <c:pt idx="4199">
                  <c:v>3.4938332326046</c:v>
                </c:pt>
                <c:pt idx="4200">
                  <c:v>2.9134574451176798</c:v>
                </c:pt>
                <c:pt idx="4201">
                  <c:v>3.3155159756649799</c:v>
                </c:pt>
                <c:pt idx="4202">
                  <c:v>3.40687773903533</c:v>
                </c:pt>
                <c:pt idx="4203">
                  <c:v>3.0612096593013001</c:v>
                </c:pt>
                <c:pt idx="4204">
                  <c:v>3.2025489287456099</c:v>
                </c:pt>
                <c:pt idx="4205">
                  <c:v>3.30330724908523</c:v>
                </c:pt>
                <c:pt idx="4206">
                  <c:v>3.2815208015187598</c:v>
                </c:pt>
                <c:pt idx="4207">
                  <c:v>3.1485084113912198</c:v>
                </c:pt>
                <c:pt idx="4208">
                  <c:v>4.4708398780101097</c:v>
                </c:pt>
                <c:pt idx="4209">
                  <c:v>3.6517801852470999</c:v>
                </c:pt>
                <c:pt idx="4210">
                  <c:v>3.5893164520976502</c:v>
                </c:pt>
                <c:pt idx="4211">
                  <c:v>3.7165743831063698</c:v>
                </c:pt>
                <c:pt idx="4212">
                  <c:v>4.1859644750809704</c:v>
                </c:pt>
                <c:pt idx="4213">
                  <c:v>3.2147129899759301</c:v>
                </c:pt>
                <c:pt idx="4214">
                  <c:v>3.6211690873530098</c:v>
                </c:pt>
                <c:pt idx="4215">
                  <c:v>3.55091714851851</c:v>
                </c:pt>
                <c:pt idx="4216">
                  <c:v>3.3072080842732001</c:v>
                </c:pt>
                <c:pt idx="4217">
                  <c:v>3.2577474077069</c:v>
                </c:pt>
                <c:pt idx="4218">
                  <c:v>3.53076347861525</c:v>
                </c:pt>
                <c:pt idx="4219">
                  <c:v>3.4629144653961399</c:v>
                </c:pt>
                <c:pt idx="4220">
                  <c:v>3.2804729320041899</c:v>
                </c:pt>
                <c:pt idx="4221">
                  <c:v>3.5417134044663001</c:v>
                </c:pt>
                <c:pt idx="4222">
                  <c:v>3.9073894210529301</c:v>
                </c:pt>
                <c:pt idx="4223">
                  <c:v>3.8547145143716199</c:v>
                </c:pt>
                <c:pt idx="4224">
                  <c:v>3.6990101899078698</c:v>
                </c:pt>
                <c:pt idx="4225">
                  <c:v>3.74449467880169</c:v>
                </c:pt>
                <c:pt idx="4226">
                  <c:v>3.73184170839547</c:v>
                </c:pt>
                <c:pt idx="4227">
                  <c:v>3.9297968508055798</c:v>
                </c:pt>
                <c:pt idx="4228">
                  <c:v>3.6355233856250901</c:v>
                </c:pt>
                <c:pt idx="4229">
                  <c:v>3.3509393224920698</c:v>
                </c:pt>
                <c:pt idx="4230">
                  <c:v>4.66032891341818</c:v>
                </c:pt>
                <c:pt idx="4231">
                  <c:v>4.44704005688659</c:v>
                </c:pt>
                <c:pt idx="4232">
                  <c:v>3.69248729352072</c:v>
                </c:pt>
                <c:pt idx="4233">
                  <c:v>3.9151790943854401</c:v>
                </c:pt>
                <c:pt idx="4234">
                  <c:v>3.3673943743988799</c:v>
                </c:pt>
                <c:pt idx="4235">
                  <c:v>4.3837168127775099</c:v>
                </c:pt>
                <c:pt idx="4236">
                  <c:v>4.2716559310965101</c:v>
                </c:pt>
                <c:pt idx="4237">
                  <c:v>3.9022719557794998</c:v>
                </c:pt>
                <c:pt idx="4238">
                  <c:v>3.94369466112046</c:v>
                </c:pt>
                <c:pt idx="4239">
                  <c:v>3.9985853454765699</c:v>
                </c:pt>
                <c:pt idx="4240">
                  <c:v>4.40859789710189</c:v>
                </c:pt>
                <c:pt idx="4241">
                  <c:v>3.6706487445154301</c:v>
                </c:pt>
                <c:pt idx="4242">
                  <c:v>3.3951114350261502</c:v>
                </c:pt>
                <c:pt idx="4243">
                  <c:v>3.8468315315007802</c:v>
                </c:pt>
                <c:pt idx="4244">
                  <c:v>3.8724059599918399</c:v>
                </c:pt>
                <c:pt idx="4245">
                  <c:v>3.0213654273080599</c:v>
                </c:pt>
                <c:pt idx="4246">
                  <c:v>2.3957544659835199</c:v>
                </c:pt>
                <c:pt idx="4247">
                  <c:v>2.94630858695982</c:v>
                </c:pt>
                <c:pt idx="4248">
                  <c:v>3.63969447551117</c:v>
                </c:pt>
                <c:pt idx="4249">
                  <c:v>3.6054882275028399</c:v>
                </c:pt>
                <c:pt idx="4250">
                  <c:v>3.3464245792143599</c:v>
                </c:pt>
                <c:pt idx="4251">
                  <c:v>3.7295717455861102</c:v>
                </c:pt>
                <c:pt idx="4252">
                  <c:v>3.5907572375460601</c:v>
                </c:pt>
                <c:pt idx="4253">
                  <c:v>3.8893650080450102</c:v>
                </c:pt>
                <c:pt idx="4254">
                  <c:v>3.9518876739543001</c:v>
                </c:pt>
                <c:pt idx="4255">
                  <c:v>3.6455362769982802</c:v>
                </c:pt>
                <c:pt idx="4256">
                  <c:v>4.1882576149858499</c:v>
                </c:pt>
                <c:pt idx="4257">
                  <c:v>3.8108050877769899</c:v>
                </c:pt>
                <c:pt idx="4258">
                  <c:v>3.67451740362741</c:v>
                </c:pt>
                <c:pt idx="4259">
                  <c:v>3.8779083448032798</c:v>
                </c:pt>
                <c:pt idx="4260">
                  <c:v>3.1344860158330201</c:v>
                </c:pt>
                <c:pt idx="4261">
                  <c:v>3.3268210735254198</c:v>
                </c:pt>
                <c:pt idx="4262">
                  <c:v>3.2903588774339898</c:v>
                </c:pt>
                <c:pt idx="4263">
                  <c:v>3.4744153839549998</c:v>
                </c:pt>
                <c:pt idx="4264">
                  <c:v>3.27777489306655</c:v>
                </c:pt>
                <c:pt idx="4265">
                  <c:v>2.9075509207042201</c:v>
                </c:pt>
                <c:pt idx="4266">
                  <c:v>3.0121043712882298</c:v>
                </c:pt>
                <c:pt idx="4267">
                  <c:v>3.51360654388413</c:v>
                </c:pt>
                <c:pt idx="4268">
                  <c:v>3.1668022691525102</c:v>
                </c:pt>
                <c:pt idx="4269">
                  <c:v>3.27648455157206</c:v>
                </c:pt>
                <c:pt idx="4270">
                  <c:v>3.1130227241056501</c:v>
                </c:pt>
                <c:pt idx="4271">
                  <c:v>3.5146375632011799</c:v>
                </c:pt>
                <c:pt idx="4272">
                  <c:v>3.6060170599266201</c:v>
                </c:pt>
                <c:pt idx="4273">
                  <c:v>3.2834495707945002</c:v>
                </c:pt>
                <c:pt idx="4274">
                  <c:v>3.2977334036938202</c:v>
                </c:pt>
                <c:pt idx="4275">
                  <c:v>3.4411456439852701</c:v>
                </c:pt>
                <c:pt idx="4276">
                  <c:v>3.11645435986259</c:v>
                </c:pt>
                <c:pt idx="4277">
                  <c:v>2.8074866191744601</c:v>
                </c:pt>
                <c:pt idx="4278">
                  <c:v>3.2042180942448799</c:v>
                </c:pt>
                <c:pt idx="4279">
                  <c:v>3.6101521895703201</c:v>
                </c:pt>
                <c:pt idx="4280">
                  <c:v>3.2513463597900598</c:v>
                </c:pt>
                <c:pt idx="4281">
                  <c:v>3.85764936034739</c:v>
                </c:pt>
                <c:pt idx="4282">
                  <c:v>2.9884919314867102</c:v>
                </c:pt>
                <c:pt idx="4283">
                  <c:v>3.3175840254716</c:v>
                </c:pt>
                <c:pt idx="4284">
                  <c:v>3.1557367170650199</c:v>
                </c:pt>
                <c:pt idx="4285">
                  <c:v>3.8745021029901898</c:v>
                </c:pt>
                <c:pt idx="4286">
                  <c:v>3.5740547550636399</c:v>
                </c:pt>
                <c:pt idx="4287">
                  <c:v>3.3159762091150502</c:v>
                </c:pt>
                <c:pt idx="4288">
                  <c:v>3.8490724772521001</c:v>
                </c:pt>
                <c:pt idx="4289">
                  <c:v>3.6224871318056602</c:v>
                </c:pt>
                <c:pt idx="4290">
                  <c:v>3.94283751931362</c:v>
                </c:pt>
                <c:pt idx="4291">
                  <c:v>3.7339537677903101</c:v>
                </c:pt>
                <c:pt idx="4292">
                  <c:v>4.1089112251045696</c:v>
                </c:pt>
                <c:pt idx="4293">
                  <c:v>4.0890569572252398</c:v>
                </c:pt>
                <c:pt idx="4294">
                  <c:v>3.9389358315047698</c:v>
                </c:pt>
                <c:pt idx="4295">
                  <c:v>3.6994853844572599</c:v>
                </c:pt>
                <c:pt idx="4296">
                  <c:v>3.9757487133171501</c:v>
                </c:pt>
                <c:pt idx="4297">
                  <c:v>4.2042699240545502</c:v>
                </c:pt>
                <c:pt idx="4298">
                  <c:v>4.52378439266879</c:v>
                </c:pt>
                <c:pt idx="4299">
                  <c:v>3.77118155973164</c:v>
                </c:pt>
                <c:pt idx="4300">
                  <c:v>3.47688597105603</c:v>
                </c:pt>
                <c:pt idx="4301">
                  <c:v>3.9874280075269701</c:v>
                </c:pt>
                <c:pt idx="4302">
                  <c:v>3.8509180287198301</c:v>
                </c:pt>
                <c:pt idx="4303">
                  <c:v>3.6975232985891999</c:v>
                </c:pt>
                <c:pt idx="4304">
                  <c:v>3.7335423507107199</c:v>
                </c:pt>
                <c:pt idx="4305">
                  <c:v>3.9006925369037799</c:v>
                </c:pt>
                <c:pt idx="4306">
                  <c:v>3.64868496550781</c:v>
                </c:pt>
                <c:pt idx="4307">
                  <c:v>4.03037786367892</c:v>
                </c:pt>
                <c:pt idx="4308">
                  <c:v>3.7217635635379001</c:v>
                </c:pt>
                <c:pt idx="4309">
                  <c:v>3.9892373860064501</c:v>
                </c:pt>
                <c:pt idx="4310">
                  <c:v>3.6036135956074098</c:v>
                </c:pt>
                <c:pt idx="4311">
                  <c:v>3.1362902283643401</c:v>
                </c:pt>
                <c:pt idx="4312">
                  <c:v>3.8480554819394599</c:v>
                </c:pt>
                <c:pt idx="4313">
                  <c:v>3.4493293075322402</c:v>
                </c:pt>
                <c:pt idx="4314">
                  <c:v>4.0631212601395097</c:v>
                </c:pt>
                <c:pt idx="4315">
                  <c:v>3.3663116710332601</c:v>
                </c:pt>
                <c:pt idx="4316">
                  <c:v>3.1686483821521301</c:v>
                </c:pt>
                <c:pt idx="4317">
                  <c:v>3.1660177341320699</c:v>
                </c:pt>
                <c:pt idx="4318">
                  <c:v>3.0717486800099101</c:v>
                </c:pt>
                <c:pt idx="4319">
                  <c:v>2.6904945860174201</c:v>
                </c:pt>
                <c:pt idx="4320">
                  <c:v>3.29798151030728</c:v>
                </c:pt>
                <c:pt idx="4321">
                  <c:v>3.6446523579207799</c:v>
                </c:pt>
                <c:pt idx="4322">
                  <c:v>3.68653133274305</c:v>
                </c:pt>
                <c:pt idx="4323">
                  <c:v>3.9922145495794199</c:v>
                </c:pt>
                <c:pt idx="4324">
                  <c:v>3.70682115579153</c:v>
                </c:pt>
                <c:pt idx="4325">
                  <c:v>3.6366390573126499</c:v>
                </c:pt>
                <c:pt idx="4326">
                  <c:v>3.7021918225050698</c:v>
                </c:pt>
                <c:pt idx="4327">
                  <c:v>3.2310804941283102</c:v>
                </c:pt>
                <c:pt idx="4328">
                  <c:v>4.2495885068942298</c:v>
                </c:pt>
                <c:pt idx="4329">
                  <c:v>3.01534046352947</c:v>
                </c:pt>
                <c:pt idx="4330">
                  <c:v>3.6376372099574601</c:v>
                </c:pt>
                <c:pt idx="4331">
                  <c:v>3.6468426311868498</c:v>
                </c:pt>
                <c:pt idx="4332">
                  <c:v>3.9156332295903198</c:v>
                </c:pt>
                <c:pt idx="4333">
                  <c:v>3.6479355683386601</c:v>
                </c:pt>
                <c:pt idx="4334">
                  <c:v>3.9176677077300202</c:v>
                </c:pt>
                <c:pt idx="4335">
                  <c:v>3.9903368965307799</c:v>
                </c:pt>
                <c:pt idx="4336">
                  <c:v>3.9699602661747</c:v>
                </c:pt>
                <c:pt idx="4337">
                  <c:v>3.87258941014057</c:v>
                </c:pt>
                <c:pt idx="4338">
                  <c:v>3.4981077449101399</c:v>
                </c:pt>
                <c:pt idx="4339">
                  <c:v>3.0007525516472899</c:v>
                </c:pt>
                <c:pt idx="4340">
                  <c:v>3.5398223851736299</c:v>
                </c:pt>
                <c:pt idx="4341">
                  <c:v>3.3740862729910299</c:v>
                </c:pt>
                <c:pt idx="4342">
                  <c:v>3.44045893088856</c:v>
                </c:pt>
                <c:pt idx="4343">
                  <c:v>3.4016193432226398</c:v>
                </c:pt>
                <c:pt idx="4344">
                  <c:v>3.6306099377048699</c:v>
                </c:pt>
                <c:pt idx="4345">
                  <c:v>3.5939690105723798</c:v>
                </c:pt>
                <c:pt idx="4346">
                  <c:v>3.35519367819139</c:v>
                </c:pt>
                <c:pt idx="4347">
                  <c:v>4.0427604611971999</c:v>
                </c:pt>
                <c:pt idx="4348">
                  <c:v>3.07799471564919</c:v>
                </c:pt>
                <c:pt idx="4349">
                  <c:v>3.5805197378479301</c:v>
                </c:pt>
                <c:pt idx="4350">
                  <c:v>3.6449155516654801</c:v>
                </c:pt>
                <c:pt idx="4351">
                  <c:v>3.2066653812949202</c:v>
                </c:pt>
                <c:pt idx="4352">
                  <c:v>3.4005225670608001</c:v>
                </c:pt>
                <c:pt idx="4353">
                  <c:v>4.0191218877685104</c:v>
                </c:pt>
                <c:pt idx="4354">
                  <c:v>3.9293759835049999</c:v>
                </c:pt>
                <c:pt idx="4355">
                  <c:v>3.3016196510740601</c:v>
                </c:pt>
                <c:pt idx="4356">
                  <c:v>2.7990905489687901</c:v>
                </c:pt>
                <c:pt idx="4357">
                  <c:v>3.5443924225216601</c:v>
                </c:pt>
                <c:pt idx="4358">
                  <c:v>3.3031670083173701</c:v>
                </c:pt>
                <c:pt idx="4359">
                  <c:v>3.4923618234816201</c:v>
                </c:pt>
                <c:pt idx="4360">
                  <c:v>3.2303571985384498</c:v>
                </c:pt>
                <c:pt idx="4361">
                  <c:v>3.52552019490714</c:v>
                </c:pt>
                <c:pt idx="4362">
                  <c:v>3.2129835983422499</c:v>
                </c:pt>
                <c:pt idx="4363">
                  <c:v>3.7140732292565999</c:v>
                </c:pt>
                <c:pt idx="4364">
                  <c:v>3.5538171580146298</c:v>
                </c:pt>
                <c:pt idx="4365">
                  <c:v>3.70252472352669</c:v>
                </c:pt>
                <c:pt idx="4366">
                  <c:v>3.6601291163086098</c:v>
                </c:pt>
                <c:pt idx="4367">
                  <c:v>2.7885584375113801</c:v>
                </c:pt>
                <c:pt idx="4368">
                  <c:v>3.6444872145895602</c:v>
                </c:pt>
                <c:pt idx="4369">
                  <c:v>3.8601934087407899</c:v>
                </c:pt>
                <c:pt idx="4370">
                  <c:v>2.7438597456158802</c:v>
                </c:pt>
                <c:pt idx="4371">
                  <c:v>3.6069213235517101</c:v>
                </c:pt>
                <c:pt idx="4372">
                  <c:v>3.4449732382990601</c:v>
                </c:pt>
                <c:pt idx="4373">
                  <c:v>3.61341022425411</c:v>
                </c:pt>
                <c:pt idx="4374">
                  <c:v>3.1769528824381399</c:v>
                </c:pt>
                <c:pt idx="4375">
                  <c:v>2.9310219635832802</c:v>
                </c:pt>
                <c:pt idx="4376">
                  <c:v>3.5725125052750402</c:v>
                </c:pt>
                <c:pt idx="4377">
                  <c:v>2.91897241658494</c:v>
                </c:pt>
                <c:pt idx="4378">
                  <c:v>3.0262364181210901</c:v>
                </c:pt>
                <c:pt idx="4379">
                  <c:v>2.9022236921763902</c:v>
                </c:pt>
                <c:pt idx="4380">
                  <c:v>3.2236983577106</c:v>
                </c:pt>
                <c:pt idx="4381">
                  <c:v>3.11517989473893</c:v>
                </c:pt>
                <c:pt idx="4382">
                  <c:v>2.7772011698808599</c:v>
                </c:pt>
                <c:pt idx="4383">
                  <c:v>2.8703786040005101</c:v>
                </c:pt>
                <c:pt idx="4384">
                  <c:v>3.1303003383112502</c:v>
                </c:pt>
                <c:pt idx="4385">
                  <c:v>3.1479661410730202</c:v>
                </c:pt>
                <c:pt idx="4386">
                  <c:v>3.1720523429441299</c:v>
                </c:pt>
                <c:pt idx="4387">
                  <c:v>3.3484702557230199</c:v>
                </c:pt>
                <c:pt idx="4388">
                  <c:v>2.82196230758885</c:v>
                </c:pt>
                <c:pt idx="4389">
                  <c:v>2.6876101523457701</c:v>
                </c:pt>
                <c:pt idx="4390">
                  <c:v>2.5717788222442799</c:v>
                </c:pt>
                <c:pt idx="4391">
                  <c:v>2.9146933374545601</c:v>
                </c:pt>
                <c:pt idx="4392">
                  <c:v>2.3901126362626099</c:v>
                </c:pt>
                <c:pt idx="4393">
                  <c:v>3.7734924880499801</c:v>
                </c:pt>
                <c:pt idx="4394">
                  <c:v>2.3759026129690199</c:v>
                </c:pt>
                <c:pt idx="4395">
                  <c:v>2.7838569767579902</c:v>
                </c:pt>
                <c:pt idx="4396">
                  <c:v>2.8075614988978601</c:v>
                </c:pt>
                <c:pt idx="4397">
                  <c:v>2.7814057960133298</c:v>
                </c:pt>
                <c:pt idx="4398">
                  <c:v>3.12509446866251</c:v>
                </c:pt>
                <c:pt idx="4399">
                  <c:v>3.5422966118561701</c:v>
                </c:pt>
                <c:pt idx="4400">
                  <c:v>2.8120079489854701</c:v>
                </c:pt>
                <c:pt idx="4401">
                  <c:v>3.0133232552171099</c:v>
                </c:pt>
                <c:pt idx="4402">
                  <c:v>3.0949785851638398</c:v>
                </c:pt>
                <c:pt idx="4403">
                  <c:v>3.3541977667713101</c:v>
                </c:pt>
                <c:pt idx="4404">
                  <c:v>3.49057408580197</c:v>
                </c:pt>
                <c:pt idx="4405">
                  <c:v>3.6827283633052401</c:v>
                </c:pt>
                <c:pt idx="4406">
                  <c:v>4.1386791361130904</c:v>
                </c:pt>
                <c:pt idx="4407">
                  <c:v>3.23623973893126</c:v>
                </c:pt>
                <c:pt idx="4408">
                  <c:v>3.2339217116910102</c:v>
                </c:pt>
                <c:pt idx="4409">
                  <c:v>3.07647349343521</c:v>
                </c:pt>
                <c:pt idx="4410">
                  <c:v>3.2594727530645802</c:v>
                </c:pt>
                <c:pt idx="4411">
                  <c:v>3.1899228866913698</c:v>
                </c:pt>
                <c:pt idx="4412">
                  <c:v>2.9393499896642901</c:v>
                </c:pt>
                <c:pt idx="4413">
                  <c:v>2.9697796863365098</c:v>
                </c:pt>
                <c:pt idx="4414">
                  <c:v>2.8286329843816702</c:v>
                </c:pt>
                <c:pt idx="4415">
                  <c:v>2.82026042079442</c:v>
                </c:pt>
                <c:pt idx="4416">
                  <c:v>3.37309318983373</c:v>
                </c:pt>
                <c:pt idx="4417">
                  <c:v>3.2690419492451199</c:v>
                </c:pt>
                <c:pt idx="4418">
                  <c:v>3.3970863464955001</c:v>
                </c:pt>
                <c:pt idx="4419">
                  <c:v>3.2067408344512902</c:v>
                </c:pt>
                <c:pt idx="4420">
                  <c:v>3.1612021615961599</c:v>
                </c:pt>
                <c:pt idx="4421">
                  <c:v>3.4694978347334402</c:v>
                </c:pt>
                <c:pt idx="4422">
                  <c:v>2.9081983143794501</c:v>
                </c:pt>
                <c:pt idx="4423">
                  <c:v>3.3684227978052199</c:v>
                </c:pt>
                <c:pt idx="4424">
                  <c:v>2.8401553983912899</c:v>
                </c:pt>
                <c:pt idx="4425">
                  <c:v>3.82882467709649</c:v>
                </c:pt>
                <c:pt idx="4426">
                  <c:v>3.1862308490162201</c:v>
                </c:pt>
                <c:pt idx="4427">
                  <c:v>3.4882187235503399</c:v>
                </c:pt>
                <c:pt idx="4428">
                  <c:v>3.5309246812816899</c:v>
                </c:pt>
                <c:pt idx="4429">
                  <c:v>3.3437972294819098</c:v>
                </c:pt>
                <c:pt idx="4430">
                  <c:v>3.6705422691738501</c:v>
                </c:pt>
                <c:pt idx="4431">
                  <c:v>3.4093551018505699</c:v>
                </c:pt>
                <c:pt idx="4432">
                  <c:v>3.5135449600233999</c:v>
                </c:pt>
                <c:pt idx="4433">
                  <c:v>3.1789179209653402</c:v>
                </c:pt>
                <c:pt idx="4434">
                  <c:v>2.8183972916268401</c:v>
                </c:pt>
                <c:pt idx="4435">
                  <c:v>3.37000692641046</c:v>
                </c:pt>
                <c:pt idx="4436">
                  <c:v>2.9348250868616099</c:v>
                </c:pt>
                <c:pt idx="4437">
                  <c:v>2.8131253348822498</c:v>
                </c:pt>
                <c:pt idx="4438">
                  <c:v>3.6552035646135099</c:v>
                </c:pt>
                <c:pt idx="4439">
                  <c:v>3.5407824547483102</c:v>
                </c:pt>
                <c:pt idx="4440">
                  <c:v>2.89944571697515</c:v>
                </c:pt>
                <c:pt idx="4441">
                  <c:v>2.5837023678355702</c:v>
                </c:pt>
                <c:pt idx="4442">
                  <c:v>2.9111062971615098</c:v>
                </c:pt>
                <c:pt idx="4443">
                  <c:v>3.0688050707425298</c:v>
                </c:pt>
                <c:pt idx="4444">
                  <c:v>3.6689045111044001</c:v>
                </c:pt>
                <c:pt idx="4445">
                  <c:v>3.5468025979086302</c:v>
                </c:pt>
                <c:pt idx="4446">
                  <c:v>3.6912622903222001</c:v>
                </c:pt>
                <c:pt idx="4447">
                  <c:v>3.3495861115792902</c:v>
                </c:pt>
                <c:pt idx="4448">
                  <c:v>3.7184581438104898</c:v>
                </c:pt>
                <c:pt idx="4449">
                  <c:v>3.2012577673000702</c:v>
                </c:pt>
                <c:pt idx="4450">
                  <c:v>3.4899858226237801</c:v>
                </c:pt>
                <c:pt idx="4451">
                  <c:v>3.06017681564416</c:v>
                </c:pt>
                <c:pt idx="4452">
                  <c:v>3.5457595699417799</c:v>
                </c:pt>
                <c:pt idx="4453">
                  <c:v>3.8722032255763899</c:v>
                </c:pt>
                <c:pt idx="4454">
                  <c:v>3.2878363565322299</c:v>
                </c:pt>
                <c:pt idx="4455">
                  <c:v>3.9388222006014</c:v>
                </c:pt>
                <c:pt idx="4456">
                  <c:v>4.3647854625312501</c:v>
                </c:pt>
                <c:pt idx="4457">
                  <c:v>3.4294691997300899</c:v>
                </c:pt>
                <c:pt idx="4458">
                  <c:v>3.7429144409199502</c:v>
                </c:pt>
                <c:pt idx="4459">
                  <c:v>3.4423223780535102</c:v>
                </c:pt>
                <c:pt idx="4460">
                  <c:v>3.7902352926688998</c:v>
                </c:pt>
                <c:pt idx="4461">
                  <c:v>3.5168870303295399</c:v>
                </c:pt>
                <c:pt idx="4462">
                  <c:v>2.7894930080827498</c:v>
                </c:pt>
                <c:pt idx="4463">
                  <c:v>2.8766524185037299</c:v>
                </c:pt>
                <c:pt idx="4464">
                  <c:v>2.5582710917016902</c:v>
                </c:pt>
                <c:pt idx="4465">
                  <c:v>2.7963354519741999</c:v>
                </c:pt>
                <c:pt idx="4466">
                  <c:v>3.7947106949308398</c:v>
                </c:pt>
                <c:pt idx="4467">
                  <c:v>3.0228409017354299</c:v>
                </c:pt>
                <c:pt idx="4468">
                  <c:v>2.74478552643698</c:v>
                </c:pt>
                <c:pt idx="4469">
                  <c:v>3.6487153854752199</c:v>
                </c:pt>
                <c:pt idx="4470">
                  <c:v>3.0576531837905598</c:v>
                </c:pt>
                <c:pt idx="4471">
                  <c:v>2.96899691167151</c:v>
                </c:pt>
                <c:pt idx="4472">
                  <c:v>3.1030188156135301</c:v>
                </c:pt>
                <c:pt idx="4473">
                  <c:v>2.9232461856254002</c:v>
                </c:pt>
                <c:pt idx="4474">
                  <c:v>3.9700528758873701</c:v>
                </c:pt>
                <c:pt idx="4475">
                  <c:v>3.2657455343053399</c:v>
                </c:pt>
                <c:pt idx="4476">
                  <c:v>3.0279531365364698</c:v>
                </c:pt>
                <c:pt idx="4477">
                  <c:v>3.2116062608154801</c:v>
                </c:pt>
                <c:pt idx="4478">
                  <c:v>3.5026595955220099</c:v>
                </c:pt>
                <c:pt idx="4479">
                  <c:v>4.0607904507572403</c:v>
                </c:pt>
                <c:pt idx="4480">
                  <c:v>3.5981524004011201</c:v>
                </c:pt>
                <c:pt idx="4481">
                  <c:v>3.09402069465188</c:v>
                </c:pt>
                <c:pt idx="4482">
                  <c:v>3.3279075938414899</c:v>
                </c:pt>
                <c:pt idx="4483">
                  <c:v>2.9231325209735499</c:v>
                </c:pt>
                <c:pt idx="4484">
                  <c:v>2.8697105438094201</c:v>
                </c:pt>
                <c:pt idx="4485">
                  <c:v>2.7813294498443701</c:v>
                </c:pt>
                <c:pt idx="4486">
                  <c:v>2.41709787270874</c:v>
                </c:pt>
                <c:pt idx="4487">
                  <c:v>2.60897211963999</c:v>
                </c:pt>
                <c:pt idx="4488">
                  <c:v>3.0633015688888401</c:v>
                </c:pt>
                <c:pt idx="4489">
                  <c:v>3.3234802837382902</c:v>
                </c:pt>
                <c:pt idx="4490">
                  <c:v>3.2835056431698999</c:v>
                </c:pt>
                <c:pt idx="4491">
                  <c:v>3.1727096925611802</c:v>
                </c:pt>
                <c:pt idx="4492">
                  <c:v>2.5730064305193601</c:v>
                </c:pt>
                <c:pt idx="4493">
                  <c:v>2.4492970325207599</c:v>
                </c:pt>
                <c:pt idx="4494">
                  <c:v>2.9921201152725199</c:v>
                </c:pt>
                <c:pt idx="4495">
                  <c:v>3.1128468565928502</c:v>
                </c:pt>
                <c:pt idx="4496">
                  <c:v>3.5166062152100399</c:v>
                </c:pt>
                <c:pt idx="4497">
                  <c:v>3.6497325155938398</c:v>
                </c:pt>
                <c:pt idx="4498">
                  <c:v>2.82832645073176</c:v>
                </c:pt>
                <c:pt idx="4499">
                  <c:v>2.6053137110850102</c:v>
                </c:pt>
                <c:pt idx="4500">
                  <c:v>3.0111401582519401</c:v>
                </c:pt>
                <c:pt idx="4501">
                  <c:v>3.0604747715857399</c:v>
                </c:pt>
                <c:pt idx="4502">
                  <c:v>3.3590715759644598</c:v>
                </c:pt>
                <c:pt idx="4503">
                  <c:v>2.9754109550908798</c:v>
                </c:pt>
                <c:pt idx="4504">
                  <c:v>3.06516252654861</c:v>
                </c:pt>
                <c:pt idx="4505">
                  <c:v>2.9222802107936299</c:v>
                </c:pt>
                <c:pt idx="4506">
                  <c:v>2.6841999413917601</c:v>
                </c:pt>
                <c:pt idx="4507">
                  <c:v>2.87966769814301</c:v>
                </c:pt>
                <c:pt idx="4508">
                  <c:v>3.3883811965213999</c:v>
                </c:pt>
                <c:pt idx="4509">
                  <c:v>3.9551656579301699</c:v>
                </c:pt>
                <c:pt idx="4510">
                  <c:v>2.9836162287475299</c:v>
                </c:pt>
                <c:pt idx="4511">
                  <c:v>3.2636153724260399</c:v>
                </c:pt>
                <c:pt idx="4512">
                  <c:v>3.28321061828201</c:v>
                </c:pt>
                <c:pt idx="4513">
                  <c:v>2.3967550684315899</c:v>
                </c:pt>
                <c:pt idx="4514">
                  <c:v>3.3956954055434099</c:v>
                </c:pt>
                <c:pt idx="4515">
                  <c:v>3.1111531315402798</c:v>
                </c:pt>
                <c:pt idx="4516">
                  <c:v>3.3923729803040898</c:v>
                </c:pt>
                <c:pt idx="4517">
                  <c:v>2.7774596911018898</c:v>
                </c:pt>
                <c:pt idx="4518">
                  <c:v>2.9454455175089298</c:v>
                </c:pt>
                <c:pt idx="4519">
                  <c:v>3.2208343287359198</c:v>
                </c:pt>
                <c:pt idx="4520">
                  <c:v>3.4850391279754702</c:v>
                </c:pt>
                <c:pt idx="4521">
                  <c:v>2.9084200566612002</c:v>
                </c:pt>
                <c:pt idx="4522">
                  <c:v>2.7264142093850698</c:v>
                </c:pt>
                <c:pt idx="4523">
                  <c:v>2.7609537696775699</c:v>
                </c:pt>
                <c:pt idx="4524">
                  <c:v>2.9626084211866499</c:v>
                </c:pt>
                <c:pt idx="4525">
                  <c:v>2.8764339271313002</c:v>
                </c:pt>
                <c:pt idx="4526">
                  <c:v>2.8874540568982399</c:v>
                </c:pt>
                <c:pt idx="4527">
                  <c:v>2.8034954561254799</c:v>
                </c:pt>
                <c:pt idx="4528">
                  <c:v>3.5053541399653798</c:v>
                </c:pt>
                <c:pt idx="4529">
                  <c:v>2.94656995360535</c:v>
                </c:pt>
                <c:pt idx="4530">
                  <c:v>2.7530690933197799</c:v>
                </c:pt>
                <c:pt idx="4531">
                  <c:v>3.2737510117728901</c:v>
                </c:pt>
                <c:pt idx="4532">
                  <c:v>3.27627466764236</c:v>
                </c:pt>
                <c:pt idx="4533">
                  <c:v>2.9884894918193199</c:v>
                </c:pt>
                <c:pt idx="4534">
                  <c:v>2.5343196466425799</c:v>
                </c:pt>
                <c:pt idx="4535">
                  <c:v>2.4302370856315298</c:v>
                </c:pt>
                <c:pt idx="4536">
                  <c:v>3.1906159476306502</c:v>
                </c:pt>
                <c:pt idx="4537">
                  <c:v>3.02803421096728</c:v>
                </c:pt>
                <c:pt idx="4538">
                  <c:v>2.99247149050584</c:v>
                </c:pt>
                <c:pt idx="4539">
                  <c:v>2.5063981633777299</c:v>
                </c:pt>
                <c:pt idx="4540">
                  <c:v>2.4498223379898301</c:v>
                </c:pt>
                <c:pt idx="4541">
                  <c:v>2.48217582656758</c:v>
                </c:pt>
                <c:pt idx="4542">
                  <c:v>2.5444352820296099</c:v>
                </c:pt>
                <c:pt idx="4543">
                  <c:v>3.0290430071461398</c:v>
                </c:pt>
                <c:pt idx="4544">
                  <c:v>2.8254498155810102</c:v>
                </c:pt>
                <c:pt idx="4545">
                  <c:v>3.2169444169292301</c:v>
                </c:pt>
                <c:pt idx="4546">
                  <c:v>2.7638338246439398</c:v>
                </c:pt>
                <c:pt idx="4547">
                  <c:v>3.6525684346138698</c:v>
                </c:pt>
                <c:pt idx="4548">
                  <c:v>2.5821692994596601</c:v>
                </c:pt>
                <c:pt idx="4549">
                  <c:v>2.9354157127804799</c:v>
                </c:pt>
                <c:pt idx="4550">
                  <c:v>2.5457384801800198</c:v>
                </c:pt>
                <c:pt idx="4551">
                  <c:v>3.3105650882001498</c:v>
                </c:pt>
                <c:pt idx="4552">
                  <c:v>2.3194415684742999</c:v>
                </c:pt>
                <c:pt idx="4553">
                  <c:v>2.8368362464193599</c:v>
                </c:pt>
                <c:pt idx="4554">
                  <c:v>2.8661827281702301</c:v>
                </c:pt>
                <c:pt idx="4555">
                  <c:v>3.1329280398327599</c:v>
                </c:pt>
                <c:pt idx="4556">
                  <c:v>2.7193519841506499</c:v>
                </c:pt>
                <c:pt idx="4557">
                  <c:v>2.44111584277407</c:v>
                </c:pt>
                <c:pt idx="4558">
                  <c:v>2.68534164807765</c:v>
                </c:pt>
                <c:pt idx="4559">
                  <c:v>2.7353193934730502</c:v>
                </c:pt>
                <c:pt idx="4560">
                  <c:v>2.7317522264431799</c:v>
                </c:pt>
                <c:pt idx="4561">
                  <c:v>2.34669664440491</c:v>
                </c:pt>
                <c:pt idx="4562">
                  <c:v>2.5993039664004098</c:v>
                </c:pt>
                <c:pt idx="4563">
                  <c:v>2.5924256608798402</c:v>
                </c:pt>
                <c:pt idx="4564">
                  <c:v>2.71537768778995</c:v>
                </c:pt>
                <c:pt idx="4565">
                  <c:v>3.4375349036065601</c:v>
                </c:pt>
                <c:pt idx="4566">
                  <c:v>3.0000767616721302</c:v>
                </c:pt>
                <c:pt idx="4567">
                  <c:v>2.4002833145602001</c:v>
                </c:pt>
                <c:pt idx="4568">
                  <c:v>3.2192613884646999</c:v>
                </c:pt>
                <c:pt idx="4569">
                  <c:v>2.9178469233955902</c:v>
                </c:pt>
                <c:pt idx="4570">
                  <c:v>3.0648166540934199</c:v>
                </c:pt>
                <c:pt idx="4571">
                  <c:v>2.9392868577820002</c:v>
                </c:pt>
                <c:pt idx="4572">
                  <c:v>2.6947928308286002</c:v>
                </c:pt>
                <c:pt idx="4573">
                  <c:v>2.84683366678675</c:v>
                </c:pt>
                <c:pt idx="4574">
                  <c:v>3.1301445007193398</c:v>
                </c:pt>
                <c:pt idx="4575">
                  <c:v>1.93287673384493</c:v>
                </c:pt>
                <c:pt idx="4576">
                  <c:v>2.4343481170130401</c:v>
                </c:pt>
                <c:pt idx="4577">
                  <c:v>2.3880896414508301</c:v>
                </c:pt>
                <c:pt idx="4578">
                  <c:v>3.5075358760928901</c:v>
                </c:pt>
                <c:pt idx="4579">
                  <c:v>3.2874274971941402</c:v>
                </c:pt>
                <c:pt idx="4580">
                  <c:v>2.9494926259570802</c:v>
                </c:pt>
                <c:pt idx="4581">
                  <c:v>2.8365087827164599</c:v>
                </c:pt>
                <c:pt idx="4582">
                  <c:v>3.52623907438922</c:v>
                </c:pt>
                <c:pt idx="4583">
                  <c:v>3.5084130263286601</c:v>
                </c:pt>
                <c:pt idx="4584">
                  <c:v>2.8197595805389</c:v>
                </c:pt>
                <c:pt idx="4585">
                  <c:v>2.8928348066703098</c:v>
                </c:pt>
                <c:pt idx="4586">
                  <c:v>3.3565360613550501</c:v>
                </c:pt>
                <c:pt idx="4587">
                  <c:v>2.7802353454298001</c:v>
                </c:pt>
                <c:pt idx="4588">
                  <c:v>3.03055946592186</c:v>
                </c:pt>
                <c:pt idx="4589">
                  <c:v>2.07916184107911</c:v>
                </c:pt>
                <c:pt idx="4590">
                  <c:v>2.9556269704417</c:v>
                </c:pt>
                <c:pt idx="4591">
                  <c:v>4.2853242382802197</c:v>
                </c:pt>
                <c:pt idx="4592">
                  <c:v>3.9426579620770701</c:v>
                </c:pt>
                <c:pt idx="4593">
                  <c:v>4.4581650915872402</c:v>
                </c:pt>
                <c:pt idx="4594">
                  <c:v>4.9113552107482104</c:v>
                </c:pt>
                <c:pt idx="4595">
                  <c:v>4.0597954370183302</c:v>
                </c:pt>
                <c:pt idx="4596">
                  <c:v>3.88878180084772</c:v>
                </c:pt>
                <c:pt idx="4597">
                  <c:v>3.8415631700266899</c:v>
                </c:pt>
                <c:pt idx="4598">
                  <c:v>3.8778443742982001</c:v>
                </c:pt>
                <c:pt idx="4599">
                  <c:v>3.5532709437681498</c:v>
                </c:pt>
                <c:pt idx="4600">
                  <c:v>4.0851385139626801</c:v>
                </c:pt>
                <c:pt idx="4601">
                  <c:v>4.3890144224973398</c:v>
                </c:pt>
                <c:pt idx="4602">
                  <c:v>3.4607345608915998</c:v>
                </c:pt>
                <c:pt idx="4603">
                  <c:v>4.5280471480192999</c:v>
                </c:pt>
                <c:pt idx="4604">
                  <c:v>3.8555386567069201</c:v>
                </c:pt>
                <c:pt idx="4605">
                  <c:v>3.8313906234354298</c:v>
                </c:pt>
                <c:pt idx="4606">
                  <c:v>4.2960105953289203</c:v>
                </c:pt>
                <c:pt idx="4607">
                  <c:v>4.1688610610293297</c:v>
                </c:pt>
                <c:pt idx="4608">
                  <c:v>3.62031082755608</c:v>
                </c:pt>
                <c:pt idx="4609">
                  <c:v>3.7611788267150099</c:v>
                </c:pt>
                <c:pt idx="4610">
                  <c:v>3.4477690590103598</c:v>
                </c:pt>
                <c:pt idx="4611">
                  <c:v>3.97613462173527</c:v>
                </c:pt>
                <c:pt idx="4612">
                  <c:v>3.04110285559962</c:v>
                </c:pt>
                <c:pt idx="4613">
                  <c:v>3.65449018135357</c:v>
                </c:pt>
                <c:pt idx="4614">
                  <c:v>2.9928858564</c:v>
                </c:pt>
                <c:pt idx="4615">
                  <c:v>3.9832697825485401</c:v>
                </c:pt>
                <c:pt idx="4616">
                  <c:v>3.0683910888899799</c:v>
                </c:pt>
                <c:pt idx="4617">
                  <c:v>2.7351546915977498</c:v>
                </c:pt>
                <c:pt idx="4618">
                  <c:v>2.2341156814066299</c:v>
                </c:pt>
                <c:pt idx="4619">
                  <c:v>3.4140680500789702</c:v>
                </c:pt>
                <c:pt idx="4620">
                  <c:v>3.4257252999840202</c:v>
                </c:pt>
                <c:pt idx="4621">
                  <c:v>2.7650014916203398</c:v>
                </c:pt>
                <c:pt idx="4622">
                  <c:v>2.3417188572460499</c:v>
                </c:pt>
                <c:pt idx="4623">
                  <c:v>2.8070095765701502</c:v>
                </c:pt>
                <c:pt idx="4624">
                  <c:v>3.03018953707149</c:v>
                </c:pt>
                <c:pt idx="4625">
                  <c:v>2.7594937827000301</c:v>
                </c:pt>
                <c:pt idx="4626">
                  <c:v>2.4609044587924802</c:v>
                </c:pt>
                <c:pt idx="4627">
                  <c:v>2.0855097568851999</c:v>
                </c:pt>
                <c:pt idx="4628">
                  <c:v>2.9186915048483399</c:v>
                </c:pt>
                <c:pt idx="4629">
                  <c:v>1.90450464130494</c:v>
                </c:pt>
                <c:pt idx="4630">
                  <c:v>2.6509563562615899</c:v>
                </c:pt>
                <c:pt idx="4631">
                  <c:v>2.16497901051252</c:v>
                </c:pt>
                <c:pt idx="4632">
                  <c:v>2.4337175986495501</c:v>
                </c:pt>
                <c:pt idx="4633">
                  <c:v>2.9491465737012001</c:v>
                </c:pt>
                <c:pt idx="4634">
                  <c:v>2.23969063914911</c:v>
                </c:pt>
                <c:pt idx="4635">
                  <c:v>2.8293494196471598</c:v>
                </c:pt>
                <c:pt idx="4636">
                  <c:v>2.5461176133081702</c:v>
                </c:pt>
                <c:pt idx="4637">
                  <c:v>1.6781203283162101</c:v>
                </c:pt>
                <c:pt idx="4638">
                  <c:v>2.68301967141428</c:v>
                </c:pt>
                <c:pt idx="4639">
                  <c:v>1.2912711986476899</c:v>
                </c:pt>
                <c:pt idx="4640">
                  <c:v>2.2435356606099002</c:v>
                </c:pt>
                <c:pt idx="4641">
                  <c:v>3.1540489703977901</c:v>
                </c:pt>
                <c:pt idx="4642">
                  <c:v>3.0569280565792001</c:v>
                </c:pt>
                <c:pt idx="4643">
                  <c:v>2.4250011211462299</c:v>
                </c:pt>
                <c:pt idx="4644">
                  <c:v>2.88205993370455</c:v>
                </c:pt>
                <c:pt idx="4645">
                  <c:v>2.8848448540526799</c:v>
                </c:pt>
                <c:pt idx="4646">
                  <c:v>2.7433989313199501</c:v>
                </c:pt>
                <c:pt idx="4647">
                  <c:v>2.6437841895725902</c:v>
                </c:pt>
                <c:pt idx="4648">
                  <c:v>2.93113091956605</c:v>
                </c:pt>
                <c:pt idx="4649">
                  <c:v>2.1218107698446298</c:v>
                </c:pt>
                <c:pt idx="4650">
                  <c:v>2.3155055717394002</c:v>
                </c:pt>
                <c:pt idx="4651">
                  <c:v>2.5821141919085702</c:v>
                </c:pt>
                <c:pt idx="4652">
                  <c:v>2.2956728024914499</c:v>
                </c:pt>
                <c:pt idx="4653">
                  <c:v>2.3008080438079301</c:v>
                </c:pt>
                <c:pt idx="4654">
                  <c:v>2.3424972672804198</c:v>
                </c:pt>
                <c:pt idx="4655">
                  <c:v>2.6344682144605298</c:v>
                </c:pt>
                <c:pt idx="4656">
                  <c:v>2.45000565587263</c:v>
                </c:pt>
                <c:pt idx="4657">
                  <c:v>2.7305573754595001</c:v>
                </c:pt>
                <c:pt idx="4658">
                  <c:v>2.1816811862617702</c:v>
                </c:pt>
                <c:pt idx="4659">
                  <c:v>2.7155557527599301</c:v>
                </c:pt>
                <c:pt idx="4660">
                  <c:v>2.1007420306224001</c:v>
                </c:pt>
                <c:pt idx="4661">
                  <c:v>2.15309597164087</c:v>
                </c:pt>
                <c:pt idx="4662">
                  <c:v>1.96825163123363</c:v>
                </c:pt>
                <c:pt idx="4663">
                  <c:v>2.4586861944629099</c:v>
                </c:pt>
                <c:pt idx="4664">
                  <c:v>2.4317010427144798</c:v>
                </c:pt>
                <c:pt idx="4665">
                  <c:v>2.29008916392283</c:v>
                </c:pt>
                <c:pt idx="4666">
                  <c:v>2.1106981524979802</c:v>
                </c:pt>
                <c:pt idx="4667">
                  <c:v>1.81841539904226</c:v>
                </c:pt>
                <c:pt idx="4668">
                  <c:v>2.67156321452351</c:v>
                </c:pt>
                <c:pt idx="4669">
                  <c:v>2.52685138924915</c:v>
                </c:pt>
                <c:pt idx="4670">
                  <c:v>2.1993474847268399</c:v>
                </c:pt>
                <c:pt idx="4671">
                  <c:v>2.5941278977692201</c:v>
                </c:pt>
                <c:pt idx="4672">
                  <c:v>2.6275222108013598</c:v>
                </c:pt>
                <c:pt idx="4673">
                  <c:v>2.82175241769075</c:v>
                </c:pt>
                <c:pt idx="4674">
                  <c:v>2.3233674855578399</c:v>
                </c:pt>
                <c:pt idx="4675">
                  <c:v>2.9079846957801099</c:v>
                </c:pt>
                <c:pt idx="4676">
                  <c:v>2.9827647386143101</c:v>
                </c:pt>
                <c:pt idx="4677">
                  <c:v>2.4445486189204799</c:v>
                </c:pt>
                <c:pt idx="4678">
                  <c:v>3.76578890008616</c:v>
                </c:pt>
                <c:pt idx="4679">
                  <c:v>3.0476331993534198</c:v>
                </c:pt>
                <c:pt idx="4680">
                  <c:v>2.69316744553951</c:v>
                </c:pt>
                <c:pt idx="4681">
                  <c:v>3.03753435644574</c:v>
                </c:pt>
                <c:pt idx="4682">
                  <c:v>2.48803731155181</c:v>
                </c:pt>
                <c:pt idx="4683">
                  <c:v>2.88784111385002</c:v>
                </c:pt>
                <c:pt idx="4684">
                  <c:v>2.70765740689404</c:v>
                </c:pt>
                <c:pt idx="4685">
                  <c:v>2.3227395967885101</c:v>
                </c:pt>
                <c:pt idx="4686">
                  <c:v>2.9454723037135802</c:v>
                </c:pt>
                <c:pt idx="4687">
                  <c:v>2.6062651442247402</c:v>
                </c:pt>
                <c:pt idx="4688">
                  <c:v>2.5584136936922999</c:v>
                </c:pt>
                <c:pt idx="4689">
                  <c:v>2.79508320636943</c:v>
                </c:pt>
                <c:pt idx="4690">
                  <c:v>2.1705364077038798</c:v>
                </c:pt>
                <c:pt idx="4691">
                  <c:v>2.4952121387449999</c:v>
                </c:pt>
                <c:pt idx="4692">
                  <c:v>2.7187588992696998</c:v>
                </c:pt>
                <c:pt idx="4693">
                  <c:v>2.8981187983134702</c:v>
                </c:pt>
                <c:pt idx="4694">
                  <c:v>2.35103101020449</c:v>
                </c:pt>
                <c:pt idx="4695">
                  <c:v>2.8937986110635499</c:v>
                </c:pt>
                <c:pt idx="4696">
                  <c:v>3.1482930128123199</c:v>
                </c:pt>
                <c:pt idx="4697">
                  <c:v>3.0264499587524698</c:v>
                </c:pt>
                <c:pt idx="4698">
                  <c:v>2.62106847086317</c:v>
                </c:pt>
                <c:pt idx="4699">
                  <c:v>2.87337654679368</c:v>
                </c:pt>
                <c:pt idx="4700">
                  <c:v>2.6988372019652802</c:v>
                </c:pt>
                <c:pt idx="4701">
                  <c:v>3.3098415061811601</c:v>
                </c:pt>
                <c:pt idx="4702">
                  <c:v>3.2908754673871301</c:v>
                </c:pt>
                <c:pt idx="4703">
                  <c:v>2.8520770586803499</c:v>
                </c:pt>
                <c:pt idx="4704">
                  <c:v>3.0046248758718899</c:v>
                </c:pt>
                <c:pt idx="4705">
                  <c:v>2.7451568340764201</c:v>
                </c:pt>
                <c:pt idx="4706">
                  <c:v>2.8616895300755898</c:v>
                </c:pt>
                <c:pt idx="4707">
                  <c:v>2.7351769355607498</c:v>
                </c:pt>
                <c:pt idx="4708">
                  <c:v>3.43606828295029</c:v>
                </c:pt>
                <c:pt idx="4709">
                  <c:v>3.0807990295694601</c:v>
                </c:pt>
                <c:pt idx="4710">
                  <c:v>3.0113426574100899</c:v>
                </c:pt>
                <c:pt idx="4711">
                  <c:v>3.0258078536710298</c:v>
                </c:pt>
                <c:pt idx="4712">
                  <c:v>2.7446333911594598</c:v>
                </c:pt>
                <c:pt idx="4713">
                  <c:v>3.3861118479789498</c:v>
                </c:pt>
                <c:pt idx="4714">
                  <c:v>3.0723219829108102</c:v>
                </c:pt>
                <c:pt idx="4715">
                  <c:v>3.5799800381564699</c:v>
                </c:pt>
                <c:pt idx="4716">
                  <c:v>3.0386684099544801</c:v>
                </c:pt>
                <c:pt idx="4717">
                  <c:v>3.1933453035840502</c:v>
                </c:pt>
                <c:pt idx="4718">
                  <c:v>3.693170555809</c:v>
                </c:pt>
                <c:pt idx="4719">
                  <c:v>3.6391916190343201</c:v>
                </c:pt>
                <c:pt idx="4720">
                  <c:v>3.2322047522767101</c:v>
                </c:pt>
                <c:pt idx="4721">
                  <c:v>3.1487806849062001</c:v>
                </c:pt>
                <c:pt idx="4722">
                  <c:v>3.5071285721029399</c:v>
                </c:pt>
                <c:pt idx="4723">
                  <c:v>3.54155901452449</c:v>
                </c:pt>
                <c:pt idx="4724">
                  <c:v>3.8403869349722402</c:v>
                </c:pt>
                <c:pt idx="4725">
                  <c:v>4.08107063317017</c:v>
                </c:pt>
                <c:pt idx="4726">
                  <c:v>3.1647811432813899</c:v>
                </c:pt>
                <c:pt idx="4727">
                  <c:v>3.6512624641506299</c:v>
                </c:pt>
                <c:pt idx="4728">
                  <c:v>2.8982158156817599</c:v>
                </c:pt>
                <c:pt idx="4729">
                  <c:v>3.2056759916889201</c:v>
                </c:pt>
                <c:pt idx="4730">
                  <c:v>2.68930734186165</c:v>
                </c:pt>
                <c:pt idx="4731">
                  <c:v>3.7004600652264901</c:v>
                </c:pt>
                <c:pt idx="4732">
                  <c:v>3.1193964215442498</c:v>
                </c:pt>
                <c:pt idx="4733">
                  <c:v>2.9602498776130002</c:v>
                </c:pt>
                <c:pt idx="4734">
                  <c:v>2.87188454983173</c:v>
                </c:pt>
                <c:pt idx="4735">
                  <c:v>2.79155220637525</c:v>
                </c:pt>
                <c:pt idx="4736">
                  <c:v>2.9225459176637001</c:v>
                </c:pt>
                <c:pt idx="4737">
                  <c:v>2.7458880713921601</c:v>
                </c:pt>
                <c:pt idx="4738">
                  <c:v>3.8394039789707799</c:v>
                </c:pt>
                <c:pt idx="4739">
                  <c:v>3.9732373211519398</c:v>
                </c:pt>
                <c:pt idx="4740">
                  <c:v>3.33232379995381</c:v>
                </c:pt>
                <c:pt idx="4741">
                  <c:v>2.9133606701540198</c:v>
                </c:pt>
                <c:pt idx="4742">
                  <c:v>3.2708199842533601</c:v>
                </c:pt>
                <c:pt idx="4743">
                  <c:v>3.4331756440522301</c:v>
                </c:pt>
                <c:pt idx="4744">
                  <c:v>2.51709874759631</c:v>
                </c:pt>
                <c:pt idx="4745">
                  <c:v>3.6622190269461798</c:v>
                </c:pt>
                <c:pt idx="4746">
                  <c:v>2.8873210563661802</c:v>
                </c:pt>
                <c:pt idx="4747">
                  <c:v>2.3088715526953401</c:v>
                </c:pt>
                <c:pt idx="4748">
                  <c:v>2.68186751792914</c:v>
                </c:pt>
                <c:pt idx="4749">
                  <c:v>3.1854603521948901</c:v>
                </c:pt>
                <c:pt idx="4750">
                  <c:v>3.0924050497771902</c:v>
                </c:pt>
                <c:pt idx="4751">
                  <c:v>2.3472202062615102</c:v>
                </c:pt>
                <c:pt idx="4752">
                  <c:v>2.7529662929249898</c:v>
                </c:pt>
                <c:pt idx="4753">
                  <c:v>2.92446179163694</c:v>
                </c:pt>
                <c:pt idx="4754">
                  <c:v>2.6972415412322399</c:v>
                </c:pt>
                <c:pt idx="4755">
                  <c:v>3.0611995747587399</c:v>
                </c:pt>
                <c:pt idx="4756">
                  <c:v>2.9697521426413598</c:v>
                </c:pt>
                <c:pt idx="4757">
                  <c:v>3.48834677569105</c:v>
                </c:pt>
                <c:pt idx="4758">
                  <c:v>2.38410997583629</c:v>
                </c:pt>
                <c:pt idx="4759">
                  <c:v>2.9239402528107501</c:v>
                </c:pt>
                <c:pt idx="4760">
                  <c:v>3.2623763279119</c:v>
                </c:pt>
                <c:pt idx="4761">
                  <c:v>2.65836209739183</c:v>
                </c:pt>
                <c:pt idx="4762">
                  <c:v>2.8514510957104102</c:v>
                </c:pt>
                <c:pt idx="4763">
                  <c:v>2.4951532059663499</c:v>
                </c:pt>
                <c:pt idx="4764">
                  <c:v>2.4164400254610201</c:v>
                </c:pt>
                <c:pt idx="4765">
                  <c:v>3.0127014473746798</c:v>
                </c:pt>
                <c:pt idx="4766">
                  <c:v>2.8039867475498701</c:v>
                </c:pt>
                <c:pt idx="4767">
                  <c:v>2.44708840283193</c:v>
                </c:pt>
                <c:pt idx="4768">
                  <c:v>2.5260699796642401</c:v>
                </c:pt>
                <c:pt idx="4769">
                  <c:v>2.4677482105194</c:v>
                </c:pt>
                <c:pt idx="4770">
                  <c:v>2.5840564575692602</c:v>
                </c:pt>
                <c:pt idx="4771">
                  <c:v>2.9075670162722602</c:v>
                </c:pt>
                <c:pt idx="4772">
                  <c:v>3.1417066575118699</c:v>
                </c:pt>
                <c:pt idx="4773">
                  <c:v>2.6686271975024898</c:v>
                </c:pt>
                <c:pt idx="4774">
                  <c:v>2.5277836140122298</c:v>
                </c:pt>
                <c:pt idx="4775">
                  <c:v>3.1811739242494301</c:v>
                </c:pt>
                <c:pt idx="4776">
                  <c:v>3.0519968745222998</c:v>
                </c:pt>
                <c:pt idx="4777">
                  <c:v>3.1040795012754998</c:v>
                </c:pt>
                <c:pt idx="4778">
                  <c:v>2.4468764793425599</c:v>
                </c:pt>
                <c:pt idx="4779">
                  <c:v>2.5888077451025699</c:v>
                </c:pt>
                <c:pt idx="4780">
                  <c:v>2.7151534463966902</c:v>
                </c:pt>
                <c:pt idx="4781">
                  <c:v>2.9046287696097099</c:v>
                </c:pt>
                <c:pt idx="4782">
                  <c:v>2.6122855428178302</c:v>
                </c:pt>
                <c:pt idx="4783">
                  <c:v>2.7713772324783199</c:v>
                </c:pt>
                <c:pt idx="4784">
                  <c:v>2.5067571497435499</c:v>
                </c:pt>
                <c:pt idx="4785">
                  <c:v>2.9034021156933401</c:v>
                </c:pt>
                <c:pt idx="4786">
                  <c:v>2.7175648511806201</c:v>
                </c:pt>
                <c:pt idx="4787">
                  <c:v>2.4732065248458399</c:v>
                </c:pt>
                <c:pt idx="4788">
                  <c:v>3.15961181142359</c:v>
                </c:pt>
                <c:pt idx="4789">
                  <c:v>2.1395452884827302</c:v>
                </c:pt>
                <c:pt idx="4790">
                  <c:v>3.5226887391365298</c:v>
                </c:pt>
                <c:pt idx="4791">
                  <c:v>3.3762207864709399</c:v>
                </c:pt>
                <c:pt idx="4792">
                  <c:v>3.2424426578771501</c:v>
                </c:pt>
                <c:pt idx="4793">
                  <c:v>3.4051612811079299</c:v>
                </c:pt>
                <c:pt idx="4794">
                  <c:v>3.217459445597</c:v>
                </c:pt>
                <c:pt idx="4795">
                  <c:v>2.9895053581441999</c:v>
                </c:pt>
                <c:pt idx="4796">
                  <c:v>2.6785116899718502</c:v>
                </c:pt>
                <c:pt idx="4797">
                  <c:v>2.76286041878841</c:v>
                </c:pt>
                <c:pt idx="4798">
                  <c:v>2.6363057333220299</c:v>
                </c:pt>
                <c:pt idx="4799">
                  <c:v>2.7000055818725701</c:v>
                </c:pt>
                <c:pt idx="4800">
                  <c:v>2.7646438549001102</c:v>
                </c:pt>
                <c:pt idx="4801">
                  <c:v>2.8948586950838702</c:v>
                </c:pt>
                <c:pt idx="4802">
                  <c:v>2.7018107978578998</c:v>
                </c:pt>
                <c:pt idx="4803">
                  <c:v>2.9045852949048498</c:v>
                </c:pt>
                <c:pt idx="4804">
                  <c:v>2.7815123387646601</c:v>
                </c:pt>
                <c:pt idx="4805">
                  <c:v>3.23848621560398</c:v>
                </c:pt>
                <c:pt idx="4806">
                  <c:v>2.73839760846711</c:v>
                </c:pt>
                <c:pt idx="4807">
                  <c:v>2.5821749118028299</c:v>
                </c:pt>
                <c:pt idx="4808">
                  <c:v>3.1733054986942402</c:v>
                </c:pt>
                <c:pt idx="4809">
                  <c:v>2.68395962865893</c:v>
                </c:pt>
                <c:pt idx="4810">
                  <c:v>2.5533507848496502</c:v>
                </c:pt>
                <c:pt idx="4811">
                  <c:v>3.0993436772049399</c:v>
                </c:pt>
                <c:pt idx="4812">
                  <c:v>3.2918742369535998</c:v>
                </c:pt>
                <c:pt idx="4813">
                  <c:v>3.0159325616723498</c:v>
                </c:pt>
                <c:pt idx="4814">
                  <c:v>3.1744477560915998</c:v>
                </c:pt>
                <c:pt idx="4815">
                  <c:v>2.64379873361499</c:v>
                </c:pt>
                <c:pt idx="4816">
                  <c:v>2.31113369682198</c:v>
                </c:pt>
                <c:pt idx="4817">
                  <c:v>2.8945182523475901</c:v>
                </c:pt>
                <c:pt idx="4818">
                  <c:v>2.79478198624318</c:v>
                </c:pt>
                <c:pt idx="4819">
                  <c:v>2.5743011339720199</c:v>
                </c:pt>
                <c:pt idx="4820">
                  <c:v>2.9700929410681098</c:v>
                </c:pt>
                <c:pt idx="4821">
                  <c:v>3.2331494713746198</c:v>
                </c:pt>
                <c:pt idx="4822">
                  <c:v>2.9103403705487798</c:v>
                </c:pt>
                <c:pt idx="4823">
                  <c:v>3.6533393178460298</c:v>
                </c:pt>
                <c:pt idx="4824">
                  <c:v>2.8545693898644702</c:v>
                </c:pt>
                <c:pt idx="4825">
                  <c:v>2.5601354321882202</c:v>
                </c:pt>
                <c:pt idx="4826">
                  <c:v>2.8984449565233499</c:v>
                </c:pt>
                <c:pt idx="4827">
                  <c:v>2.29067233386901</c:v>
                </c:pt>
                <c:pt idx="4828">
                  <c:v>2.4643397450651201</c:v>
                </c:pt>
                <c:pt idx="4829">
                  <c:v>2.3714518116413799</c:v>
                </c:pt>
                <c:pt idx="4830">
                  <c:v>2.3113326978399198</c:v>
                </c:pt>
                <c:pt idx="4831">
                  <c:v>2.42870870043456</c:v>
                </c:pt>
                <c:pt idx="4832">
                  <c:v>2.9681238823560601</c:v>
                </c:pt>
                <c:pt idx="4833">
                  <c:v>3.0653360300722601</c:v>
                </c:pt>
                <c:pt idx="4834">
                  <c:v>2.56728811567503</c:v>
                </c:pt>
                <c:pt idx="4835">
                  <c:v>2.2984213941631002</c:v>
                </c:pt>
                <c:pt idx="4836">
                  <c:v>2.77899489757483</c:v>
                </c:pt>
                <c:pt idx="4837">
                  <c:v>2.4191992705196199</c:v>
                </c:pt>
                <c:pt idx="4838">
                  <c:v>2.3327643531009601</c:v>
                </c:pt>
                <c:pt idx="4839">
                  <c:v>3.3451101723577001</c:v>
                </c:pt>
                <c:pt idx="4840">
                  <c:v>3.1358478303505999</c:v>
                </c:pt>
                <c:pt idx="4841">
                  <c:v>3.1783416897241401</c:v>
                </c:pt>
                <c:pt idx="4842">
                  <c:v>3.1924410797166001</c:v>
                </c:pt>
                <c:pt idx="4843">
                  <c:v>2.9233478809996698</c:v>
                </c:pt>
                <c:pt idx="4844">
                  <c:v>2.7703759896564599</c:v>
                </c:pt>
                <c:pt idx="4845">
                  <c:v>3.0371687406058299</c:v>
                </c:pt>
                <c:pt idx="4846">
                  <c:v>2.4940078987225198</c:v>
                </c:pt>
                <c:pt idx="4847">
                  <c:v>3.1530313154462699</c:v>
                </c:pt>
                <c:pt idx="4848">
                  <c:v>2.7628009557234701</c:v>
                </c:pt>
                <c:pt idx="4849">
                  <c:v>3.1214584937051599</c:v>
                </c:pt>
                <c:pt idx="4850">
                  <c:v>2.6631996997786098</c:v>
                </c:pt>
                <c:pt idx="4851">
                  <c:v>2.8740575219032301</c:v>
                </c:pt>
                <c:pt idx="4852">
                  <c:v>2.6103188873669199</c:v>
                </c:pt>
                <c:pt idx="4853">
                  <c:v>2.4305684573684898</c:v>
                </c:pt>
                <c:pt idx="4854">
                  <c:v>2.7652064624074502</c:v>
                </c:pt>
                <c:pt idx="4855">
                  <c:v>3.06318338251128</c:v>
                </c:pt>
                <c:pt idx="4856">
                  <c:v>3.1235102481562902</c:v>
                </c:pt>
                <c:pt idx="4857">
                  <c:v>2.6632885396312802</c:v>
                </c:pt>
                <c:pt idx="4858">
                  <c:v>2.9592743903597101</c:v>
                </c:pt>
                <c:pt idx="4859">
                  <c:v>2.79467643403013</c:v>
                </c:pt>
                <c:pt idx="4860">
                  <c:v>3.59081695725488</c:v>
                </c:pt>
                <c:pt idx="4861">
                  <c:v>3.3683114847662101</c:v>
                </c:pt>
                <c:pt idx="4862">
                  <c:v>3.96265835443949</c:v>
                </c:pt>
                <c:pt idx="4863">
                  <c:v>2.2887929973412899</c:v>
                </c:pt>
                <c:pt idx="4864">
                  <c:v>3.2018530776052598</c:v>
                </c:pt>
                <c:pt idx="4865">
                  <c:v>3.0196706892047001</c:v>
                </c:pt>
                <c:pt idx="4866">
                  <c:v>3.2851136301425798</c:v>
                </c:pt>
                <c:pt idx="4867">
                  <c:v>3.7620772491082701</c:v>
                </c:pt>
                <c:pt idx="4868">
                  <c:v>2.7868493108757901</c:v>
                </c:pt>
                <c:pt idx="4869">
                  <c:v>3.07246682170743</c:v>
                </c:pt>
                <c:pt idx="4870">
                  <c:v>3.1270664421366399</c:v>
                </c:pt>
                <c:pt idx="4871">
                  <c:v>2.8844838788920701</c:v>
                </c:pt>
                <c:pt idx="4872">
                  <c:v>2.8677210669225301</c:v>
                </c:pt>
                <c:pt idx="4873">
                  <c:v>3.42492242782955</c:v>
                </c:pt>
                <c:pt idx="4874">
                  <c:v>2.7410791165235802</c:v>
                </c:pt>
                <c:pt idx="4875">
                  <c:v>3.4330450209291299</c:v>
                </c:pt>
                <c:pt idx="4876">
                  <c:v>2.7090889525244499</c:v>
                </c:pt>
                <c:pt idx="4877">
                  <c:v>3.6718855114452902</c:v>
                </c:pt>
                <c:pt idx="4878">
                  <c:v>2.88204312681692</c:v>
                </c:pt>
                <c:pt idx="4879">
                  <c:v>3.1801946705537198</c:v>
                </c:pt>
                <c:pt idx="4880">
                  <c:v>3.36945388184404</c:v>
                </c:pt>
                <c:pt idx="4881">
                  <c:v>3.39293838528994</c:v>
                </c:pt>
                <c:pt idx="4882">
                  <c:v>2.6349423952515498</c:v>
                </c:pt>
                <c:pt idx="4883">
                  <c:v>2.8440196404009002</c:v>
                </c:pt>
                <c:pt idx="4884">
                  <c:v>3.26920924412314</c:v>
                </c:pt>
                <c:pt idx="4885">
                  <c:v>2.61562524135622</c:v>
                </c:pt>
                <c:pt idx="4886">
                  <c:v>2.7893878784705901</c:v>
                </c:pt>
                <c:pt idx="4887">
                  <c:v>3.3421900234437301</c:v>
                </c:pt>
                <c:pt idx="4888">
                  <c:v>2.99822977277476</c:v>
                </c:pt>
                <c:pt idx="4889">
                  <c:v>3.0859979137295799</c:v>
                </c:pt>
                <c:pt idx="4890">
                  <c:v>2.70658415049735</c:v>
                </c:pt>
                <c:pt idx="4891">
                  <c:v>3.3172696385185998</c:v>
                </c:pt>
                <c:pt idx="4892">
                  <c:v>2.9509190762759401</c:v>
                </c:pt>
                <c:pt idx="4893">
                  <c:v>2.8502920732447001</c:v>
                </c:pt>
                <c:pt idx="4894">
                  <c:v>2.98633723089586</c:v>
                </c:pt>
                <c:pt idx="4895">
                  <c:v>2.52931442471434</c:v>
                </c:pt>
                <c:pt idx="4896">
                  <c:v>2.64379298910817</c:v>
                </c:pt>
                <c:pt idx="4897">
                  <c:v>2.6878795115154901</c:v>
                </c:pt>
                <c:pt idx="4898">
                  <c:v>2.7597931532542401</c:v>
                </c:pt>
                <c:pt idx="4899">
                  <c:v>2.1917504896696101</c:v>
                </c:pt>
                <c:pt idx="4900">
                  <c:v>3.23687178807501</c:v>
                </c:pt>
                <c:pt idx="4901">
                  <c:v>2.6341269050899401</c:v>
                </c:pt>
                <c:pt idx="4902">
                  <c:v>2.7446462704664301</c:v>
                </c:pt>
                <c:pt idx="4903">
                  <c:v>2.4194539403575801</c:v>
                </c:pt>
                <c:pt idx="4904">
                  <c:v>2.4815559900659498</c:v>
                </c:pt>
                <c:pt idx="4905">
                  <c:v>2.7057661195659999</c:v>
                </c:pt>
                <c:pt idx="4906">
                  <c:v>2.81675603499423</c:v>
                </c:pt>
                <c:pt idx="4907">
                  <c:v>3.2595775011513002</c:v>
                </c:pt>
                <c:pt idx="4908">
                  <c:v>2.9351355176551599</c:v>
                </c:pt>
                <c:pt idx="4909">
                  <c:v>2.92719310563887</c:v>
                </c:pt>
                <c:pt idx="4910">
                  <c:v>2.9802390153250098</c:v>
                </c:pt>
                <c:pt idx="4911">
                  <c:v>3.1833115502606901</c:v>
                </c:pt>
                <c:pt idx="4912">
                  <c:v>3.01885990175411</c:v>
                </c:pt>
                <c:pt idx="4913">
                  <c:v>3.2835088364398302</c:v>
                </c:pt>
                <c:pt idx="4914">
                  <c:v>3.0043050247033598</c:v>
                </c:pt>
                <c:pt idx="4915">
                  <c:v>3.6708689975415698</c:v>
                </c:pt>
                <c:pt idx="4916">
                  <c:v>3.1131470850364198</c:v>
                </c:pt>
                <c:pt idx="4917">
                  <c:v>2.8137058785001998</c:v>
                </c:pt>
                <c:pt idx="4918">
                  <c:v>3.1112171491407299</c:v>
                </c:pt>
                <c:pt idx="4919">
                  <c:v>2.8394014560950098</c:v>
                </c:pt>
                <c:pt idx="4920">
                  <c:v>2.9530231933022999</c:v>
                </c:pt>
                <c:pt idx="4921">
                  <c:v>2.9067882400895999</c:v>
                </c:pt>
                <c:pt idx="4922">
                  <c:v>2.9204915505513198</c:v>
                </c:pt>
                <c:pt idx="4923">
                  <c:v>3.19477154251206</c:v>
                </c:pt>
                <c:pt idx="4924">
                  <c:v>2.8465611331435698</c:v>
                </c:pt>
                <c:pt idx="4925">
                  <c:v>2.8656388877161798</c:v>
                </c:pt>
                <c:pt idx="4926">
                  <c:v>3.57547652814482</c:v>
                </c:pt>
                <c:pt idx="4927">
                  <c:v>3.0632336732681198</c:v>
                </c:pt>
                <c:pt idx="4928">
                  <c:v>2.7330741911894401</c:v>
                </c:pt>
                <c:pt idx="4929">
                  <c:v>2.6587370748665098</c:v>
                </c:pt>
                <c:pt idx="4930">
                  <c:v>3.0429400045927801</c:v>
                </c:pt>
                <c:pt idx="4931">
                  <c:v>3.0361133727199001</c:v>
                </c:pt>
                <c:pt idx="4932">
                  <c:v>2.9569102567883099</c:v>
                </c:pt>
                <c:pt idx="4933">
                  <c:v>3.0562179950299702</c:v>
                </c:pt>
                <c:pt idx="4934">
                  <c:v>3.1298374129560602</c:v>
                </c:pt>
                <c:pt idx="4935">
                  <c:v>3.35828470978517</c:v>
                </c:pt>
                <c:pt idx="4936">
                  <c:v>3.0932444497059901</c:v>
                </c:pt>
                <c:pt idx="4937">
                  <c:v>3.1568387173631098</c:v>
                </c:pt>
                <c:pt idx="4938">
                  <c:v>3.2930035457474398</c:v>
                </c:pt>
                <c:pt idx="4939">
                  <c:v>3.09335753528496</c:v>
                </c:pt>
                <c:pt idx="4940">
                  <c:v>2.4253108777177701</c:v>
                </c:pt>
                <c:pt idx="4941">
                  <c:v>2.4907457649070399</c:v>
                </c:pt>
                <c:pt idx="4942">
                  <c:v>3.2177144074978399</c:v>
                </c:pt>
                <c:pt idx="4943">
                  <c:v>2.8330099751522901</c:v>
                </c:pt>
                <c:pt idx="4944">
                  <c:v>2.5561862609446702</c:v>
                </c:pt>
                <c:pt idx="4945">
                  <c:v>3.1962019356213598</c:v>
                </c:pt>
                <c:pt idx="4946">
                  <c:v>2.4740383646825901</c:v>
                </c:pt>
                <c:pt idx="4947">
                  <c:v>2.4890486677394401</c:v>
                </c:pt>
                <c:pt idx="4948">
                  <c:v>3.44648058789006</c:v>
                </c:pt>
                <c:pt idx="4949">
                  <c:v>3.1041099980007898</c:v>
                </c:pt>
                <c:pt idx="4950">
                  <c:v>3.1624871536716999</c:v>
                </c:pt>
                <c:pt idx="4951">
                  <c:v>3.1351171833288598</c:v>
                </c:pt>
                <c:pt idx="4952">
                  <c:v>2.8349449514688199</c:v>
                </c:pt>
                <c:pt idx="4953">
                  <c:v>2.7228471329694202</c:v>
                </c:pt>
                <c:pt idx="4954">
                  <c:v>3.2356828081990101</c:v>
                </c:pt>
                <c:pt idx="4955">
                  <c:v>2.82529912145531</c:v>
                </c:pt>
                <c:pt idx="4956">
                  <c:v>2.6234319448064101</c:v>
                </c:pt>
                <c:pt idx="4957">
                  <c:v>2.6509496497903</c:v>
                </c:pt>
                <c:pt idx="4958">
                  <c:v>2.51425357282629</c:v>
                </c:pt>
                <c:pt idx="4959">
                  <c:v>2.5685199197078599</c:v>
                </c:pt>
                <c:pt idx="4960">
                  <c:v>2.8567494839917802</c:v>
                </c:pt>
                <c:pt idx="4961">
                  <c:v>2.8509282347617502</c:v>
                </c:pt>
                <c:pt idx="4962">
                  <c:v>2.5263138460489301</c:v>
                </c:pt>
                <c:pt idx="4963">
                  <c:v>2.7639907041216798</c:v>
                </c:pt>
                <c:pt idx="4964">
                  <c:v>1.97736490363677</c:v>
                </c:pt>
                <c:pt idx="4965">
                  <c:v>2.3986641564638198</c:v>
                </c:pt>
                <c:pt idx="4966">
                  <c:v>3.1633194346004401</c:v>
                </c:pt>
                <c:pt idx="4967">
                  <c:v>2.61645389064623</c:v>
                </c:pt>
                <c:pt idx="4968">
                  <c:v>3.7228144772174199</c:v>
                </c:pt>
                <c:pt idx="4969">
                  <c:v>3.1968533594053898</c:v>
                </c:pt>
                <c:pt idx="4970">
                  <c:v>3.0590262860728501</c:v>
                </c:pt>
                <c:pt idx="4971">
                  <c:v>2.86781907628523</c:v>
                </c:pt>
                <c:pt idx="4972">
                  <c:v>2.6339803275482501</c:v>
                </c:pt>
                <c:pt idx="4973">
                  <c:v>3.2781894649724301</c:v>
                </c:pt>
                <c:pt idx="4974">
                  <c:v>2.7232736670403801</c:v>
                </c:pt>
                <c:pt idx="4975">
                  <c:v>2.51286467487793</c:v>
                </c:pt>
                <c:pt idx="4976">
                  <c:v>2.7254287624305298</c:v>
                </c:pt>
                <c:pt idx="4977">
                  <c:v>2.8145255435338199</c:v>
                </c:pt>
                <c:pt idx="4978">
                  <c:v>2.4876521262410201</c:v>
                </c:pt>
                <c:pt idx="4979">
                  <c:v>2.7726960210185099</c:v>
                </c:pt>
                <c:pt idx="4980">
                  <c:v>2.5773168760526399</c:v>
                </c:pt>
                <c:pt idx="4981">
                  <c:v>3.1943203602457699</c:v>
                </c:pt>
                <c:pt idx="4982">
                  <c:v>2.6318183876688801</c:v>
                </c:pt>
                <c:pt idx="4983">
                  <c:v>2.72066520411627</c:v>
                </c:pt>
                <c:pt idx="4984">
                  <c:v>2.8090966545655101</c:v>
                </c:pt>
                <c:pt idx="4985">
                  <c:v>2.92060701845236</c:v>
                </c:pt>
                <c:pt idx="4986">
                  <c:v>2.8650128411019198</c:v>
                </c:pt>
                <c:pt idx="4987">
                  <c:v>3.2083440955144198</c:v>
                </c:pt>
                <c:pt idx="4988">
                  <c:v>3.3246942464132201</c:v>
                </c:pt>
                <c:pt idx="4989">
                  <c:v>3.8290197469006801</c:v>
                </c:pt>
                <c:pt idx="4990">
                  <c:v>3.0214800845578802</c:v>
                </c:pt>
                <c:pt idx="4991">
                  <c:v>3.54580620296319</c:v>
                </c:pt>
                <c:pt idx="4992">
                  <c:v>2.92451332223439</c:v>
                </c:pt>
                <c:pt idx="4993">
                  <c:v>3.6823535783014201</c:v>
                </c:pt>
                <c:pt idx="4994">
                  <c:v>4.0916857432420697</c:v>
                </c:pt>
                <c:pt idx="4995">
                  <c:v>3.2193553516250102</c:v>
                </c:pt>
                <c:pt idx="4996">
                  <c:v>3.18694189086284</c:v>
                </c:pt>
                <c:pt idx="4997">
                  <c:v>3.0797538642698701</c:v>
                </c:pt>
                <c:pt idx="4998">
                  <c:v>2.55624263876574</c:v>
                </c:pt>
                <c:pt idx="4999">
                  <c:v>2.7649046997865199</c:v>
                </c:pt>
                <c:pt idx="5000">
                  <c:v>2.73129054907294</c:v>
                </c:pt>
                <c:pt idx="5001">
                  <c:v>3.1037250070237601</c:v>
                </c:pt>
                <c:pt idx="5002">
                  <c:v>3.0071783399755101</c:v>
                </c:pt>
                <c:pt idx="5003">
                  <c:v>3.3566216486599401</c:v>
                </c:pt>
                <c:pt idx="5004">
                  <c:v>2.8305067754328799</c:v>
                </c:pt>
                <c:pt idx="5005">
                  <c:v>3.1086626788105698</c:v>
                </c:pt>
                <c:pt idx="5006">
                  <c:v>2.5362229621209802</c:v>
                </c:pt>
                <c:pt idx="5007">
                  <c:v>2.6458932282206602</c:v>
                </c:pt>
                <c:pt idx="5008">
                  <c:v>2.8963653302967498</c:v>
                </c:pt>
                <c:pt idx="5009">
                  <c:v>2.86688366228534</c:v>
                </c:pt>
                <c:pt idx="5010">
                  <c:v>3.10040547261399</c:v>
                </c:pt>
                <c:pt idx="5011">
                  <c:v>2.9232792922896098</c:v>
                </c:pt>
                <c:pt idx="5012">
                  <c:v>2.8439044655719501</c:v>
                </c:pt>
                <c:pt idx="5013">
                  <c:v>3.04678954559256</c:v>
                </c:pt>
                <c:pt idx="5014">
                  <c:v>2.38343750904827</c:v>
                </c:pt>
                <c:pt idx="5015">
                  <c:v>3.2121105220794299</c:v>
                </c:pt>
                <c:pt idx="5016">
                  <c:v>2.8856264979920798</c:v>
                </c:pt>
                <c:pt idx="5017">
                  <c:v>2.45521911109818</c:v>
                </c:pt>
                <c:pt idx="5018">
                  <c:v>2.5438042453018599</c:v>
                </c:pt>
                <c:pt idx="5019">
                  <c:v>2.83395094404242</c:v>
                </c:pt>
                <c:pt idx="5020">
                  <c:v>3.2795967755814099</c:v>
                </c:pt>
                <c:pt idx="5021">
                  <c:v>3.1186471813851799</c:v>
                </c:pt>
                <c:pt idx="5022">
                  <c:v>2.75942806622484</c:v>
                </c:pt>
                <c:pt idx="5023">
                  <c:v>3.7116448538229401</c:v>
                </c:pt>
                <c:pt idx="5024">
                  <c:v>2.9017246706661202</c:v>
                </c:pt>
                <c:pt idx="5025">
                  <c:v>2.3025460635936299</c:v>
                </c:pt>
                <c:pt idx="5026">
                  <c:v>2.5315917960577199</c:v>
                </c:pt>
                <c:pt idx="5027">
                  <c:v>2.7260874495698899</c:v>
                </c:pt>
                <c:pt idx="5028">
                  <c:v>2.56977334881643</c:v>
                </c:pt>
                <c:pt idx="5029">
                  <c:v>1.9081099413178799</c:v>
                </c:pt>
                <c:pt idx="5030">
                  <c:v>2.2026050169048501</c:v>
                </c:pt>
                <c:pt idx="5031">
                  <c:v>1.9522018180804499</c:v>
                </c:pt>
                <c:pt idx="5032">
                  <c:v>2.2435459731788101</c:v>
                </c:pt>
                <c:pt idx="5033">
                  <c:v>2.0766992409693699</c:v>
                </c:pt>
                <c:pt idx="5034">
                  <c:v>2.66995699673291</c:v>
                </c:pt>
                <c:pt idx="5035">
                  <c:v>2.5611944957104802</c:v>
                </c:pt>
                <c:pt idx="5036">
                  <c:v>2.4142992722450201</c:v>
                </c:pt>
                <c:pt idx="5037">
                  <c:v>2.1025918500065299</c:v>
                </c:pt>
                <c:pt idx="5038">
                  <c:v>2.7326357066974301</c:v>
                </c:pt>
                <c:pt idx="5039">
                  <c:v>2.7037973589375901</c:v>
                </c:pt>
                <c:pt idx="5040">
                  <c:v>2.7634247950054101</c:v>
                </c:pt>
                <c:pt idx="5041">
                  <c:v>3.0966737114281102</c:v>
                </c:pt>
                <c:pt idx="5042">
                  <c:v>2.5764341388618899</c:v>
                </c:pt>
                <c:pt idx="5043">
                  <c:v>3.05945833123852</c:v>
                </c:pt>
                <c:pt idx="5044">
                  <c:v>2.8023489868525799</c:v>
                </c:pt>
                <c:pt idx="5045">
                  <c:v>2.4776012234062099</c:v>
                </c:pt>
                <c:pt idx="5046">
                  <c:v>2.5060068407680398</c:v>
                </c:pt>
                <c:pt idx="5047">
                  <c:v>2.2676607042766599</c:v>
                </c:pt>
                <c:pt idx="5048">
                  <c:v>2.4670217411149999</c:v>
                </c:pt>
                <c:pt idx="5049">
                  <c:v>2.46982348662377</c:v>
                </c:pt>
                <c:pt idx="5050">
                  <c:v>2.70299740520927</c:v>
                </c:pt>
                <c:pt idx="5051">
                  <c:v>2.27585057596374</c:v>
                </c:pt>
                <c:pt idx="5052">
                  <c:v>2.70946908912294</c:v>
                </c:pt>
                <c:pt idx="5053">
                  <c:v>2.2480356111055699</c:v>
                </c:pt>
                <c:pt idx="5054">
                  <c:v>1.9961438512207901</c:v>
                </c:pt>
                <c:pt idx="5055">
                  <c:v>2.5492378602958699</c:v>
                </c:pt>
                <c:pt idx="5056">
                  <c:v>2.1786380787609598</c:v>
                </c:pt>
                <c:pt idx="5057">
                  <c:v>2.03920247087009</c:v>
                </c:pt>
                <c:pt idx="5058">
                  <c:v>1.78428720981478</c:v>
                </c:pt>
                <c:pt idx="5059">
                  <c:v>2.1725650113764301</c:v>
                </c:pt>
                <c:pt idx="5060">
                  <c:v>2.0128200768452298</c:v>
                </c:pt>
                <c:pt idx="5061">
                  <c:v>1.5322994536747201</c:v>
                </c:pt>
                <c:pt idx="5062">
                  <c:v>1.0887741978594501</c:v>
                </c:pt>
                <c:pt idx="5063">
                  <c:v>1.9515351332289099</c:v>
                </c:pt>
                <c:pt idx="5064">
                  <c:v>2.0371703938746299</c:v>
                </c:pt>
                <c:pt idx="5065">
                  <c:v>1.23332084560635</c:v>
                </c:pt>
                <c:pt idx="5066">
                  <c:v>1.30406768432239</c:v>
                </c:pt>
                <c:pt idx="5067">
                  <c:v>1.4634324696929599</c:v>
                </c:pt>
                <c:pt idx="5068">
                  <c:v>1.2917922710246501</c:v>
                </c:pt>
                <c:pt idx="5069">
                  <c:v>2.1695204319275501</c:v>
                </c:pt>
                <c:pt idx="5070">
                  <c:v>1.8917651433804299</c:v>
                </c:pt>
                <c:pt idx="5071">
                  <c:v>1.4748560204154499</c:v>
                </c:pt>
                <c:pt idx="5072">
                  <c:v>2.4693429371779101</c:v>
                </c:pt>
                <c:pt idx="5073">
                  <c:v>2.4752308996030901</c:v>
                </c:pt>
                <c:pt idx="5074">
                  <c:v>1.8969879022744001</c:v>
                </c:pt>
                <c:pt idx="5075">
                  <c:v>1.5444011214994</c:v>
                </c:pt>
                <c:pt idx="5076">
                  <c:v>2.0762236989649598</c:v>
                </c:pt>
                <c:pt idx="5077">
                  <c:v>1.5768118102953801</c:v>
                </c:pt>
                <c:pt idx="5078">
                  <c:v>1.23249219779894</c:v>
                </c:pt>
                <c:pt idx="5079">
                  <c:v>1.20017138081264</c:v>
                </c:pt>
                <c:pt idx="5080">
                  <c:v>1.2097063715072001</c:v>
                </c:pt>
                <c:pt idx="5081">
                  <c:v>1.64395233210397</c:v>
                </c:pt>
                <c:pt idx="5082">
                  <c:v>1.5356115515104101</c:v>
                </c:pt>
                <c:pt idx="5083">
                  <c:v>2.2879257540323801</c:v>
                </c:pt>
                <c:pt idx="5084">
                  <c:v>1.97969020611103</c:v>
                </c:pt>
                <c:pt idx="5085">
                  <c:v>2.2245480069283801</c:v>
                </c:pt>
                <c:pt idx="5086">
                  <c:v>1.5073414696178999</c:v>
                </c:pt>
                <c:pt idx="5087">
                  <c:v>1.89088657415866</c:v>
                </c:pt>
                <c:pt idx="5088">
                  <c:v>1.9766645583375799</c:v>
                </c:pt>
                <c:pt idx="5089">
                  <c:v>1.73931257940964</c:v>
                </c:pt>
                <c:pt idx="5090">
                  <c:v>1.64523038697445</c:v>
                </c:pt>
                <c:pt idx="5091">
                  <c:v>2.0037829435433498</c:v>
                </c:pt>
                <c:pt idx="5092">
                  <c:v>2.0199499795595601</c:v>
                </c:pt>
                <c:pt idx="5093">
                  <c:v>1.77608221354985</c:v>
                </c:pt>
                <c:pt idx="5094">
                  <c:v>2.1203091419846398</c:v>
                </c:pt>
                <c:pt idx="5095">
                  <c:v>2.5815277589590702</c:v>
                </c:pt>
                <c:pt idx="5096">
                  <c:v>1.94988035179206</c:v>
                </c:pt>
                <c:pt idx="5097">
                  <c:v>2.38573604851591</c:v>
                </c:pt>
                <c:pt idx="5098">
                  <c:v>1.9940874110734601</c:v>
                </c:pt>
                <c:pt idx="5099">
                  <c:v>2.3529609644555798</c:v>
                </c:pt>
                <c:pt idx="5100">
                  <c:v>1.6377016297369</c:v>
                </c:pt>
                <c:pt idx="5101">
                  <c:v>2.0508776843006098</c:v>
                </c:pt>
                <c:pt idx="5102">
                  <c:v>2.3891863273233001</c:v>
                </c:pt>
                <c:pt idx="5103">
                  <c:v>2.7472469066397198</c:v>
                </c:pt>
                <c:pt idx="5104">
                  <c:v>2.3290910608569502</c:v>
                </c:pt>
                <c:pt idx="5105">
                  <c:v>2.27661415630436</c:v>
                </c:pt>
                <c:pt idx="5106">
                  <c:v>2.0711729917952302</c:v>
                </c:pt>
                <c:pt idx="5107">
                  <c:v>2.272535787737</c:v>
                </c:pt>
                <c:pt idx="5108">
                  <c:v>1.9764024315637501</c:v>
                </c:pt>
                <c:pt idx="5109">
                  <c:v>1.5345972851555501</c:v>
                </c:pt>
                <c:pt idx="5110">
                  <c:v>2.26628253126739</c:v>
                </c:pt>
                <c:pt idx="5111">
                  <c:v>1.8417955938383099</c:v>
                </c:pt>
                <c:pt idx="5112">
                  <c:v>2.48345116475216</c:v>
                </c:pt>
                <c:pt idx="5113">
                  <c:v>2.1549378251429498</c:v>
                </c:pt>
                <c:pt idx="5114">
                  <c:v>2.0855400889369902</c:v>
                </c:pt>
                <c:pt idx="5115">
                  <c:v>1.9129748708107299</c:v>
                </c:pt>
                <c:pt idx="5116">
                  <c:v>2.19993197709459</c:v>
                </c:pt>
                <c:pt idx="5117">
                  <c:v>2.2261670500576698</c:v>
                </c:pt>
                <c:pt idx="5118">
                  <c:v>1.7151696806068699</c:v>
                </c:pt>
                <c:pt idx="5119">
                  <c:v>1.96860265834591</c:v>
                </c:pt>
                <c:pt idx="5120">
                  <c:v>2.36135509847841</c:v>
                </c:pt>
                <c:pt idx="5121">
                  <c:v>1.85186681283667</c:v>
                </c:pt>
                <c:pt idx="5122">
                  <c:v>2.1608371673745199</c:v>
                </c:pt>
                <c:pt idx="5123">
                  <c:v>1.6355710096084299</c:v>
                </c:pt>
                <c:pt idx="5124">
                  <c:v>2.3588332429426599</c:v>
                </c:pt>
                <c:pt idx="5125">
                  <c:v>2.1138136137167698</c:v>
                </c:pt>
                <c:pt idx="5126">
                  <c:v>2.4823118856098798</c:v>
                </c:pt>
                <c:pt idx="5127">
                  <c:v>2.0411570615987702</c:v>
                </c:pt>
                <c:pt idx="5128">
                  <c:v>2.0536482432265899</c:v>
                </c:pt>
                <c:pt idx="5129">
                  <c:v>1.9288752340342601</c:v>
                </c:pt>
                <c:pt idx="5130">
                  <c:v>1.9617347269487599</c:v>
                </c:pt>
                <c:pt idx="5131">
                  <c:v>2.5069122059820801</c:v>
                </c:pt>
                <c:pt idx="5132">
                  <c:v>1.87037117489814</c:v>
                </c:pt>
                <c:pt idx="5133">
                  <c:v>2.3014258619021999</c:v>
                </c:pt>
                <c:pt idx="5134">
                  <c:v>2.1119002890966199</c:v>
                </c:pt>
                <c:pt idx="5135">
                  <c:v>1.97357947602892</c:v>
                </c:pt>
                <c:pt idx="5136">
                  <c:v>1.55643351622816</c:v>
                </c:pt>
                <c:pt idx="5137">
                  <c:v>2.50669836400913</c:v>
                </c:pt>
                <c:pt idx="5138">
                  <c:v>2.2674356059879499</c:v>
                </c:pt>
                <c:pt idx="5139">
                  <c:v>2.1613560937568499</c:v>
                </c:pt>
                <c:pt idx="5140">
                  <c:v>3.1690005357629998</c:v>
                </c:pt>
                <c:pt idx="5141">
                  <c:v>2.3613221185331299</c:v>
                </c:pt>
                <c:pt idx="5142">
                  <c:v>2.9940996120741001</c:v>
                </c:pt>
                <c:pt idx="5143">
                  <c:v>2.8020965965812099</c:v>
                </c:pt>
                <c:pt idx="5144">
                  <c:v>2.91511509002647</c:v>
                </c:pt>
                <c:pt idx="5145">
                  <c:v>3.1065161969502899</c:v>
                </c:pt>
                <c:pt idx="5146">
                  <c:v>3.1197423394726398</c:v>
                </c:pt>
                <c:pt idx="5147">
                  <c:v>3.2545082946724602</c:v>
                </c:pt>
                <c:pt idx="5148">
                  <c:v>3.5596695733796202</c:v>
                </c:pt>
                <c:pt idx="5149">
                  <c:v>3.0623132448522301</c:v>
                </c:pt>
                <c:pt idx="5150">
                  <c:v>3.11129681590903</c:v>
                </c:pt>
                <c:pt idx="5151">
                  <c:v>3.2449259815923002</c:v>
                </c:pt>
                <c:pt idx="5152">
                  <c:v>3.3823359700560802</c:v>
                </c:pt>
                <c:pt idx="5153">
                  <c:v>3.2273006818465801</c:v>
                </c:pt>
                <c:pt idx="5154">
                  <c:v>3.1138459621764301</c:v>
                </c:pt>
                <c:pt idx="5155">
                  <c:v>3.0989694210908301</c:v>
                </c:pt>
                <c:pt idx="5156">
                  <c:v>2.7876775223211099</c:v>
                </c:pt>
                <c:pt idx="5157">
                  <c:v>2.8740182610693799</c:v>
                </c:pt>
                <c:pt idx="5158">
                  <c:v>2.9566085194210499</c:v>
                </c:pt>
                <c:pt idx="5159">
                  <c:v>3.0168844761190798</c:v>
                </c:pt>
                <c:pt idx="5160">
                  <c:v>3.2248297470547902</c:v>
                </c:pt>
                <c:pt idx="5161">
                  <c:v>3.4728813574574402</c:v>
                </c:pt>
                <c:pt idx="5162">
                  <c:v>2.8297185318465501</c:v>
                </c:pt>
                <c:pt idx="5163">
                  <c:v>2.8250187341728199</c:v>
                </c:pt>
                <c:pt idx="5164">
                  <c:v>2.7792536365826899</c:v>
                </c:pt>
                <c:pt idx="5165">
                  <c:v>3.6400348727254799</c:v>
                </c:pt>
                <c:pt idx="5166">
                  <c:v>3.2179515781948602</c:v>
                </c:pt>
                <c:pt idx="5167">
                  <c:v>3.1884780986368</c:v>
                </c:pt>
                <c:pt idx="5168">
                  <c:v>3.2125193528335201</c:v>
                </c:pt>
                <c:pt idx="5169">
                  <c:v>3.21651651204205</c:v>
                </c:pt>
                <c:pt idx="5170">
                  <c:v>2.8135579178946899</c:v>
                </c:pt>
                <c:pt idx="5171">
                  <c:v>1.43794710509737</c:v>
                </c:pt>
                <c:pt idx="5172">
                  <c:v>2.63277355572064</c:v>
                </c:pt>
                <c:pt idx="5173">
                  <c:v>2.1361351134292699</c:v>
                </c:pt>
                <c:pt idx="5174">
                  <c:v>2.3701134605356802</c:v>
                </c:pt>
                <c:pt idx="5175">
                  <c:v>2.53045075030446</c:v>
                </c:pt>
                <c:pt idx="5176">
                  <c:v>1.40791951065586</c:v>
                </c:pt>
                <c:pt idx="5177">
                  <c:v>1.96299630108306</c:v>
                </c:pt>
                <c:pt idx="5178">
                  <c:v>1.7618323893468599</c:v>
                </c:pt>
                <c:pt idx="5179">
                  <c:v>2.1553387566332498</c:v>
                </c:pt>
                <c:pt idx="5180">
                  <c:v>1.92911382008557</c:v>
                </c:pt>
                <c:pt idx="5181">
                  <c:v>2.4534397137290198</c:v>
                </c:pt>
                <c:pt idx="5182">
                  <c:v>2.06129524642727</c:v>
                </c:pt>
                <c:pt idx="5183">
                  <c:v>2.53367113002545</c:v>
                </c:pt>
                <c:pt idx="5184">
                  <c:v>2.4191732976309099</c:v>
                </c:pt>
                <c:pt idx="5185">
                  <c:v>2.41261186253822</c:v>
                </c:pt>
                <c:pt idx="5186">
                  <c:v>2.3681536950319599</c:v>
                </c:pt>
                <c:pt idx="5187">
                  <c:v>2.40499188792537</c:v>
                </c:pt>
                <c:pt idx="5188">
                  <c:v>2.58379262711725</c:v>
                </c:pt>
                <c:pt idx="5189">
                  <c:v>2.1787084102133201</c:v>
                </c:pt>
                <c:pt idx="5190">
                  <c:v>2.1264273753557399</c:v>
                </c:pt>
                <c:pt idx="5191">
                  <c:v>2.2152981908165899</c:v>
                </c:pt>
                <c:pt idx="5192">
                  <c:v>2.5429812956897302</c:v>
                </c:pt>
                <c:pt idx="5193">
                  <c:v>1.9803153472644801</c:v>
                </c:pt>
                <c:pt idx="5194">
                  <c:v>1.82282944077958</c:v>
                </c:pt>
                <c:pt idx="5195">
                  <c:v>2.6262497145279999</c:v>
                </c:pt>
                <c:pt idx="5196">
                  <c:v>2.3967782364547801</c:v>
                </c:pt>
                <c:pt idx="5197">
                  <c:v>2.2076564862024002</c:v>
                </c:pt>
                <c:pt idx="5198">
                  <c:v>1.8944997407754101</c:v>
                </c:pt>
                <c:pt idx="5199">
                  <c:v>2.7498189303443801</c:v>
                </c:pt>
                <c:pt idx="5200">
                  <c:v>2.1140195778372401</c:v>
                </c:pt>
                <c:pt idx="5201">
                  <c:v>1.8483091954777</c:v>
                </c:pt>
                <c:pt idx="5202">
                  <c:v>2.27851886340774</c:v>
                </c:pt>
                <c:pt idx="5203">
                  <c:v>1.6446107343763301</c:v>
                </c:pt>
                <c:pt idx="5204">
                  <c:v>1.8090349756433699</c:v>
                </c:pt>
                <c:pt idx="5205">
                  <c:v>1.58708358633793</c:v>
                </c:pt>
                <c:pt idx="5206">
                  <c:v>2.0072448441445001</c:v>
                </c:pt>
                <c:pt idx="5207">
                  <c:v>1.9170785017231999</c:v>
                </c:pt>
                <c:pt idx="5208">
                  <c:v>2.1137494566278798</c:v>
                </c:pt>
                <c:pt idx="5209">
                  <c:v>2.0202363579817999</c:v>
                </c:pt>
                <c:pt idx="5210">
                  <c:v>1.2914389545028899</c:v>
                </c:pt>
                <c:pt idx="5211">
                  <c:v>2.0153350233449201</c:v>
                </c:pt>
                <c:pt idx="5212">
                  <c:v>1.8065415007162799</c:v>
                </c:pt>
                <c:pt idx="5213">
                  <c:v>1.7120275016448501</c:v>
                </c:pt>
                <c:pt idx="5214">
                  <c:v>1.5740046714939699</c:v>
                </c:pt>
                <c:pt idx="5215">
                  <c:v>1.9658119616774301</c:v>
                </c:pt>
                <c:pt idx="5216">
                  <c:v>1.3489909981888499</c:v>
                </c:pt>
                <c:pt idx="5217">
                  <c:v>1.64478414998272</c:v>
                </c:pt>
                <c:pt idx="5218">
                  <c:v>1.58324258893068</c:v>
                </c:pt>
                <c:pt idx="5219">
                  <c:v>1.44494402984616</c:v>
                </c:pt>
                <c:pt idx="5220">
                  <c:v>1.47802554132736</c:v>
                </c:pt>
                <c:pt idx="5221">
                  <c:v>1.17717653870685</c:v>
                </c:pt>
                <c:pt idx="5222">
                  <c:v>1.6275977328614299</c:v>
                </c:pt>
                <c:pt idx="5223">
                  <c:v>1.2299513480995099</c:v>
                </c:pt>
                <c:pt idx="5224">
                  <c:v>1.7172429692632101</c:v>
                </c:pt>
                <c:pt idx="5225">
                  <c:v>1.7213908935533599</c:v>
                </c:pt>
                <c:pt idx="5226">
                  <c:v>1.4800189573959399</c:v>
                </c:pt>
                <c:pt idx="5227">
                  <c:v>1.2637063297523801</c:v>
                </c:pt>
                <c:pt idx="5228">
                  <c:v>1.4493467728560501</c:v>
                </c:pt>
                <c:pt idx="5229">
                  <c:v>1.5420911640694901</c:v>
                </c:pt>
                <c:pt idx="5230">
                  <c:v>1.58637952031604</c:v>
                </c:pt>
                <c:pt idx="5231">
                  <c:v>1.85686641054651</c:v>
                </c:pt>
                <c:pt idx="5232">
                  <c:v>1.9601231779844199</c:v>
                </c:pt>
                <c:pt idx="5233">
                  <c:v>2.2371157164183502</c:v>
                </c:pt>
                <c:pt idx="5234">
                  <c:v>1.82911418603947</c:v>
                </c:pt>
                <c:pt idx="5235">
                  <c:v>1.7700228924762</c:v>
                </c:pt>
                <c:pt idx="5236">
                  <c:v>1.19479262877292</c:v>
                </c:pt>
                <c:pt idx="5237">
                  <c:v>1.47701265188186</c:v>
                </c:pt>
                <c:pt idx="5238">
                  <c:v>1.54711252093648</c:v>
                </c:pt>
                <c:pt idx="5239">
                  <c:v>1.1912842040168099</c:v>
                </c:pt>
                <c:pt idx="5240">
                  <c:v>1.53275814496372</c:v>
                </c:pt>
                <c:pt idx="5241">
                  <c:v>1.8273164981277901</c:v>
                </c:pt>
                <c:pt idx="5242">
                  <c:v>2.1185003303350101</c:v>
                </c:pt>
                <c:pt idx="5243">
                  <c:v>2.3296351972161702</c:v>
                </c:pt>
                <c:pt idx="5244">
                  <c:v>2.5607677198913601</c:v>
                </c:pt>
                <c:pt idx="5245">
                  <c:v>2.3336326831572198</c:v>
                </c:pt>
                <c:pt idx="5246">
                  <c:v>2.0959471748163199</c:v>
                </c:pt>
                <c:pt idx="5247">
                  <c:v>2.0001496510764101</c:v>
                </c:pt>
                <c:pt idx="5248">
                  <c:v>1.6126508900083101</c:v>
                </c:pt>
                <c:pt idx="5249">
                  <c:v>1.50089803779931</c:v>
                </c:pt>
                <c:pt idx="5250">
                  <c:v>1.77683482602801</c:v>
                </c:pt>
                <c:pt idx="5251">
                  <c:v>1.4901543502618</c:v>
                </c:pt>
                <c:pt idx="5252">
                  <c:v>1.8281480147108999</c:v>
                </c:pt>
                <c:pt idx="5253">
                  <c:v>1.61765447496072</c:v>
                </c:pt>
                <c:pt idx="5254">
                  <c:v>2.5442418647986802</c:v>
                </c:pt>
                <c:pt idx="5255">
                  <c:v>1.89722718647344</c:v>
                </c:pt>
                <c:pt idx="5256">
                  <c:v>1.95550360683555</c:v>
                </c:pt>
                <c:pt idx="5257">
                  <c:v>2.03567136833672</c:v>
                </c:pt>
                <c:pt idx="5258">
                  <c:v>1.96139721307795</c:v>
                </c:pt>
                <c:pt idx="5259">
                  <c:v>1.1767229831454</c:v>
                </c:pt>
                <c:pt idx="5260">
                  <c:v>1.9680613534017</c:v>
                </c:pt>
                <c:pt idx="5261">
                  <c:v>2.3963108865027398</c:v>
                </c:pt>
                <c:pt idx="5262">
                  <c:v>1.8893498173096599</c:v>
                </c:pt>
                <c:pt idx="5263">
                  <c:v>2.0575237947734699</c:v>
                </c:pt>
                <c:pt idx="5264">
                  <c:v>1.8252342909779999</c:v>
                </c:pt>
                <c:pt idx="5265">
                  <c:v>2.4437027122510799</c:v>
                </c:pt>
                <c:pt idx="5266">
                  <c:v>2.3669228974325098</c:v>
                </c:pt>
                <c:pt idx="5267">
                  <c:v>2.4619360438756299</c:v>
                </c:pt>
                <c:pt idx="5268">
                  <c:v>2.3073862492136099</c:v>
                </c:pt>
                <c:pt idx="5269">
                  <c:v>1.8849082800702099</c:v>
                </c:pt>
                <c:pt idx="5270">
                  <c:v>2.4439772461657201</c:v>
                </c:pt>
                <c:pt idx="5271">
                  <c:v>1.86580966876426</c:v>
                </c:pt>
                <c:pt idx="5272">
                  <c:v>1.28920553177079</c:v>
                </c:pt>
                <c:pt idx="5273">
                  <c:v>2.04294628274695</c:v>
                </c:pt>
                <c:pt idx="5274">
                  <c:v>1.2180917518975201</c:v>
                </c:pt>
                <c:pt idx="5275">
                  <c:v>1.41531184999634</c:v>
                </c:pt>
                <c:pt idx="5276">
                  <c:v>1.8176637686978101</c:v>
                </c:pt>
                <c:pt idx="5277">
                  <c:v>2.4389304708520601</c:v>
                </c:pt>
                <c:pt idx="5278">
                  <c:v>1.16684025805821</c:v>
                </c:pt>
                <c:pt idx="5279">
                  <c:v>2.4295482965288002</c:v>
                </c:pt>
                <c:pt idx="5280">
                  <c:v>2.62825484151581</c:v>
                </c:pt>
                <c:pt idx="5281">
                  <c:v>2.4898128484175901</c:v>
                </c:pt>
                <c:pt idx="5282">
                  <c:v>1.8769814216105001</c:v>
                </c:pt>
                <c:pt idx="5283">
                  <c:v>1.96757414803001</c:v>
                </c:pt>
                <c:pt idx="5284">
                  <c:v>1.6079350381701401</c:v>
                </c:pt>
                <c:pt idx="5285">
                  <c:v>2.2767619276157198</c:v>
                </c:pt>
                <c:pt idx="5286">
                  <c:v>1.5397582792837701</c:v>
                </c:pt>
                <c:pt idx="5287">
                  <c:v>1.65705935410616</c:v>
                </c:pt>
                <c:pt idx="5288">
                  <c:v>1.80480917194235</c:v>
                </c:pt>
                <c:pt idx="5289">
                  <c:v>1.9699020981643101</c:v>
                </c:pt>
                <c:pt idx="5290">
                  <c:v>1.8375570536383801</c:v>
                </c:pt>
                <c:pt idx="5291">
                  <c:v>1.8433186927307199</c:v>
                </c:pt>
                <c:pt idx="5292">
                  <c:v>1.9112326773522701</c:v>
                </c:pt>
                <c:pt idx="5293">
                  <c:v>1.74904738346027</c:v>
                </c:pt>
                <c:pt idx="5294">
                  <c:v>2.05602367046599</c:v>
                </c:pt>
                <c:pt idx="5295">
                  <c:v>1.82359521367559</c:v>
                </c:pt>
                <c:pt idx="5296">
                  <c:v>1.74099686206538</c:v>
                </c:pt>
                <c:pt idx="5297">
                  <c:v>2.2903466975225899</c:v>
                </c:pt>
                <c:pt idx="5298">
                  <c:v>2.2497004898564001</c:v>
                </c:pt>
                <c:pt idx="5299">
                  <c:v>3.24784218597076</c:v>
                </c:pt>
                <c:pt idx="5300">
                  <c:v>3.8760380492142898</c:v>
                </c:pt>
                <c:pt idx="5301">
                  <c:v>2.5257120775447701</c:v>
                </c:pt>
                <c:pt idx="5302">
                  <c:v>2.2509281312658702</c:v>
                </c:pt>
                <c:pt idx="5303">
                  <c:v>2.5889025476156</c:v>
                </c:pt>
                <c:pt idx="5304">
                  <c:v>2.3866586976007298</c:v>
                </c:pt>
                <c:pt idx="5305">
                  <c:v>2.14342009722191</c:v>
                </c:pt>
                <c:pt idx="5306">
                  <c:v>2.1166755091014799</c:v>
                </c:pt>
                <c:pt idx="5307">
                  <c:v>2.2504879090552299</c:v>
                </c:pt>
                <c:pt idx="5308">
                  <c:v>2.3842163783144201</c:v>
                </c:pt>
                <c:pt idx="5309">
                  <c:v>2.7790910408637299</c:v>
                </c:pt>
                <c:pt idx="5310">
                  <c:v>2.7324911073836802</c:v>
                </c:pt>
                <c:pt idx="5311">
                  <c:v>2.1378884280290902</c:v>
                </c:pt>
                <c:pt idx="5312">
                  <c:v>1.9391259600216</c:v>
                </c:pt>
                <c:pt idx="5313">
                  <c:v>2.8454947134223998</c:v>
                </c:pt>
                <c:pt idx="5314">
                  <c:v>2.0651955284637999</c:v>
                </c:pt>
                <c:pt idx="5315">
                  <c:v>2.6724397102241002</c:v>
                </c:pt>
                <c:pt idx="5316">
                  <c:v>2.5475704395139802</c:v>
                </c:pt>
                <c:pt idx="5317">
                  <c:v>2.71255671738639</c:v>
                </c:pt>
                <c:pt idx="5318">
                  <c:v>2.6775315776708499</c:v>
                </c:pt>
                <c:pt idx="5319">
                  <c:v>2.9233359769715901</c:v>
                </c:pt>
                <c:pt idx="5320">
                  <c:v>2.1270789383526698</c:v>
                </c:pt>
                <c:pt idx="5321">
                  <c:v>2.2725119894208499</c:v>
                </c:pt>
                <c:pt idx="5322">
                  <c:v>3.0963030193415499</c:v>
                </c:pt>
                <c:pt idx="5323">
                  <c:v>2.7151615861310399</c:v>
                </c:pt>
                <c:pt idx="5324">
                  <c:v>2.99535321905114</c:v>
                </c:pt>
                <c:pt idx="5325">
                  <c:v>2.3354482139971702</c:v>
                </c:pt>
                <c:pt idx="5326">
                  <c:v>2.7269258147296398</c:v>
                </c:pt>
                <c:pt idx="5327">
                  <c:v>3.4757452254878798</c:v>
                </c:pt>
                <c:pt idx="5328">
                  <c:v>2.3516498022008001</c:v>
                </c:pt>
                <c:pt idx="5329">
                  <c:v>3.4394322711917402</c:v>
                </c:pt>
                <c:pt idx="5330">
                  <c:v>2.8972198418691999</c:v>
                </c:pt>
                <c:pt idx="5331">
                  <c:v>2.9504540437898998</c:v>
                </c:pt>
                <c:pt idx="5332">
                  <c:v>2.3147351588732601</c:v>
                </c:pt>
                <c:pt idx="5333">
                  <c:v>2.1831119637640999</c:v>
                </c:pt>
                <c:pt idx="5334">
                  <c:v>1.81913861608504</c:v>
                </c:pt>
                <c:pt idx="5335">
                  <c:v>1.64034295656954</c:v>
                </c:pt>
                <c:pt idx="5336">
                  <c:v>2.1247411564165399</c:v>
                </c:pt>
                <c:pt idx="5337">
                  <c:v>1.38119068180269</c:v>
                </c:pt>
                <c:pt idx="5338">
                  <c:v>2.2308782376829099</c:v>
                </c:pt>
                <c:pt idx="5339">
                  <c:v>2.32650503186672</c:v>
                </c:pt>
                <c:pt idx="5340">
                  <c:v>2.1623738503152699</c:v>
                </c:pt>
                <c:pt idx="5341">
                  <c:v>2.2137960315250802</c:v>
                </c:pt>
                <c:pt idx="5342">
                  <c:v>2.2908077333416101</c:v>
                </c:pt>
                <c:pt idx="5343">
                  <c:v>2.3121627552383202</c:v>
                </c:pt>
                <c:pt idx="5344">
                  <c:v>2.1020908423106701</c:v>
                </c:pt>
                <c:pt idx="5345">
                  <c:v>1.8050167077874599</c:v>
                </c:pt>
                <c:pt idx="5346">
                  <c:v>1.9842836149240599</c:v>
                </c:pt>
                <c:pt idx="5347">
                  <c:v>1.7602294844557</c:v>
                </c:pt>
                <c:pt idx="5348">
                  <c:v>2.52304496454218</c:v>
                </c:pt>
                <c:pt idx="5349">
                  <c:v>2.6000595633727102</c:v>
                </c:pt>
                <c:pt idx="5350">
                  <c:v>2.3640966656807398</c:v>
                </c:pt>
                <c:pt idx="5351">
                  <c:v>2.1820218276929899</c:v>
                </c:pt>
                <c:pt idx="5352">
                  <c:v>1.8419169187045501</c:v>
                </c:pt>
                <c:pt idx="5353">
                  <c:v>2.2505093668218898</c:v>
                </c:pt>
                <c:pt idx="5354">
                  <c:v>2.1224983940773998</c:v>
                </c:pt>
                <c:pt idx="5355">
                  <c:v>2.6209575745228899</c:v>
                </c:pt>
                <c:pt idx="5356">
                  <c:v>2.2524377795707999</c:v>
                </c:pt>
                <c:pt idx="5357">
                  <c:v>1.85990305433881</c:v>
                </c:pt>
                <c:pt idx="5358">
                  <c:v>1.8656125874565801</c:v>
                </c:pt>
                <c:pt idx="5359">
                  <c:v>1.7793912854420999</c:v>
                </c:pt>
                <c:pt idx="5360">
                  <c:v>1.9168573002114899</c:v>
                </c:pt>
                <c:pt idx="5361">
                  <c:v>2.1529944263085201</c:v>
                </c:pt>
                <c:pt idx="5362">
                  <c:v>2.4720317272475598</c:v>
                </c:pt>
                <c:pt idx="5363">
                  <c:v>2.9353916281255601</c:v>
                </c:pt>
                <c:pt idx="5364">
                  <c:v>2.3793512070866201</c:v>
                </c:pt>
                <c:pt idx="5365">
                  <c:v>2.4794559118695401</c:v>
                </c:pt>
                <c:pt idx="5366">
                  <c:v>3.3277455215291001</c:v>
                </c:pt>
                <c:pt idx="5367">
                  <c:v>2.7629744837796002</c:v>
                </c:pt>
                <c:pt idx="5368">
                  <c:v>2.9809985922697799</c:v>
                </c:pt>
                <c:pt idx="5369">
                  <c:v>2.23520202330403</c:v>
                </c:pt>
                <c:pt idx="5370">
                  <c:v>2.4998923549848202</c:v>
                </c:pt>
                <c:pt idx="5371">
                  <c:v>2.5750353108250201</c:v>
                </c:pt>
                <c:pt idx="5372">
                  <c:v>2.8534338138351401</c:v>
                </c:pt>
                <c:pt idx="5373">
                  <c:v>2.7801061479470901</c:v>
                </c:pt>
                <c:pt idx="5374">
                  <c:v>3.4333144673536902</c:v>
                </c:pt>
                <c:pt idx="5375">
                  <c:v>2.8927775845485302</c:v>
                </c:pt>
                <c:pt idx="5376">
                  <c:v>1.95699386076377</c:v>
                </c:pt>
                <c:pt idx="5377">
                  <c:v>2.3286720915922201</c:v>
                </c:pt>
                <c:pt idx="5378">
                  <c:v>2.5645758572015298</c:v>
                </c:pt>
                <c:pt idx="5379">
                  <c:v>3.1598181608338298</c:v>
                </c:pt>
                <c:pt idx="5380">
                  <c:v>2.5331009183637101</c:v>
                </c:pt>
                <c:pt idx="5381">
                  <c:v>2.4469081578322101</c:v>
                </c:pt>
                <c:pt idx="5382">
                  <c:v>2.7499980639390502</c:v>
                </c:pt>
                <c:pt idx="5383">
                  <c:v>2.4887744678722301</c:v>
                </c:pt>
                <c:pt idx="5384">
                  <c:v>3.10955594545735</c:v>
                </c:pt>
                <c:pt idx="5385">
                  <c:v>2.5238318350872002</c:v>
                </c:pt>
                <c:pt idx="5386">
                  <c:v>3.1777771954558802</c:v>
                </c:pt>
                <c:pt idx="5387">
                  <c:v>2.8467420175931699</c:v>
                </c:pt>
                <c:pt idx="5388">
                  <c:v>2.5334160440278199</c:v>
                </c:pt>
                <c:pt idx="5389">
                  <c:v>2.4637369383952801</c:v>
                </c:pt>
                <c:pt idx="5390">
                  <c:v>2.5358575526197602</c:v>
                </c:pt>
                <c:pt idx="5391">
                  <c:v>2.9269172917300001</c:v>
                </c:pt>
                <c:pt idx="5392">
                  <c:v>2.5712663175875501</c:v>
                </c:pt>
                <c:pt idx="5393">
                  <c:v>2.6753322388151299</c:v>
                </c:pt>
                <c:pt idx="5394">
                  <c:v>2.3963910117184901</c:v>
                </c:pt>
                <c:pt idx="5395">
                  <c:v>2.6182354286799101</c:v>
                </c:pt>
                <c:pt idx="5396">
                  <c:v>2.8978105654502602</c:v>
                </c:pt>
                <c:pt idx="5397">
                  <c:v>3.1392530627788102</c:v>
                </c:pt>
                <c:pt idx="5398">
                  <c:v>3.0612185051098399</c:v>
                </c:pt>
                <c:pt idx="5399">
                  <c:v>3.0539226055706101</c:v>
                </c:pt>
                <c:pt idx="5400">
                  <c:v>3.7990936730278402</c:v>
                </c:pt>
                <c:pt idx="5401">
                  <c:v>2.8858370228312</c:v>
                </c:pt>
                <c:pt idx="5402">
                  <c:v>3.2663017182651601</c:v>
                </c:pt>
                <c:pt idx="5403">
                  <c:v>2.6124976112118099</c:v>
                </c:pt>
                <c:pt idx="5404">
                  <c:v>2.6721115012488901</c:v>
                </c:pt>
                <c:pt idx="5405">
                  <c:v>3.2143254484201398</c:v>
                </c:pt>
                <c:pt idx="5406">
                  <c:v>2.818490133409</c:v>
                </c:pt>
                <c:pt idx="5407">
                  <c:v>3.38080497282425</c:v>
                </c:pt>
                <c:pt idx="5408">
                  <c:v>2.77518544045446</c:v>
                </c:pt>
                <c:pt idx="5409">
                  <c:v>3.0189968042413202</c:v>
                </c:pt>
                <c:pt idx="5410">
                  <c:v>2.6822046837990201</c:v>
                </c:pt>
                <c:pt idx="5411">
                  <c:v>3.1355204302662001</c:v>
                </c:pt>
                <c:pt idx="5412">
                  <c:v>3.3477598583970201</c:v>
                </c:pt>
                <c:pt idx="5413">
                  <c:v>3.10352748957391</c:v>
                </c:pt>
                <c:pt idx="5414">
                  <c:v>2.72019039111226</c:v>
                </c:pt>
                <c:pt idx="5415">
                  <c:v>3.0209858005172698</c:v>
                </c:pt>
                <c:pt idx="5416">
                  <c:v>3.5593628427754598</c:v>
                </c:pt>
                <c:pt idx="5417">
                  <c:v>3.09397174631397</c:v>
                </c:pt>
                <c:pt idx="5418">
                  <c:v>2.9805997733285499</c:v>
                </c:pt>
                <c:pt idx="5419">
                  <c:v>2.9613221629645698</c:v>
                </c:pt>
                <c:pt idx="5420">
                  <c:v>2.7058831590019699</c:v>
                </c:pt>
                <c:pt idx="5421">
                  <c:v>2.6632309487484198</c:v>
                </c:pt>
                <c:pt idx="5422">
                  <c:v>3.5987750370621501</c:v>
                </c:pt>
                <c:pt idx="5423">
                  <c:v>3.08333413042689</c:v>
                </c:pt>
                <c:pt idx="5424">
                  <c:v>2.69477530994084</c:v>
                </c:pt>
                <c:pt idx="5425">
                  <c:v>2.3727874588692202</c:v>
                </c:pt>
                <c:pt idx="5426">
                  <c:v>2.3725803723790402</c:v>
                </c:pt>
                <c:pt idx="5427">
                  <c:v>3.4870230663397299</c:v>
                </c:pt>
                <c:pt idx="5428">
                  <c:v>2.9932699258478999</c:v>
                </c:pt>
                <c:pt idx="5429">
                  <c:v>3.3949181422547401</c:v>
                </c:pt>
                <c:pt idx="5430">
                  <c:v>3.2938972873601098</c:v>
                </c:pt>
                <c:pt idx="5431">
                  <c:v>3.4707775080171701</c:v>
                </c:pt>
                <c:pt idx="5432">
                  <c:v>3.6413325754903698</c:v>
                </c:pt>
                <c:pt idx="5433">
                  <c:v>2.7198466973812101</c:v>
                </c:pt>
                <c:pt idx="5434">
                  <c:v>3.34705019267924</c:v>
                </c:pt>
                <c:pt idx="5435">
                  <c:v>3.6253801129044998</c:v>
                </c:pt>
                <c:pt idx="5436">
                  <c:v>3.50743414319831</c:v>
                </c:pt>
                <c:pt idx="5437">
                  <c:v>3.4322522677593801</c:v>
                </c:pt>
                <c:pt idx="5438">
                  <c:v>3.6771590838176702</c:v>
                </c:pt>
                <c:pt idx="5439">
                  <c:v>3.8052807814876699</c:v>
                </c:pt>
                <c:pt idx="5440">
                  <c:v>3.2217529324883598</c:v>
                </c:pt>
                <c:pt idx="5441">
                  <c:v>2.9227849567973201</c:v>
                </c:pt>
                <c:pt idx="5442">
                  <c:v>2.5676983286372201</c:v>
                </c:pt>
                <c:pt idx="5443">
                  <c:v>3.3020215534402602</c:v>
                </c:pt>
                <c:pt idx="5444">
                  <c:v>3.4851860132577599</c:v>
                </c:pt>
                <c:pt idx="5445">
                  <c:v>2.9119992468253399</c:v>
                </c:pt>
                <c:pt idx="5446">
                  <c:v>3.2827859567480999</c:v>
                </c:pt>
                <c:pt idx="5447">
                  <c:v>3.2411422320466299</c:v>
                </c:pt>
                <c:pt idx="5448">
                  <c:v>3.4053910971388199</c:v>
                </c:pt>
                <c:pt idx="5449">
                  <c:v>2.9743929808526302</c:v>
                </c:pt>
                <c:pt idx="5450">
                  <c:v>3.67474315443698</c:v>
                </c:pt>
                <c:pt idx="5451">
                  <c:v>3.9546860970051898</c:v>
                </c:pt>
                <c:pt idx="5452">
                  <c:v>3.1126227926817198</c:v>
                </c:pt>
                <c:pt idx="5453">
                  <c:v>3.3914130430104499</c:v>
                </c:pt>
                <c:pt idx="5454">
                  <c:v>3.6215900930848002</c:v>
                </c:pt>
                <c:pt idx="5455">
                  <c:v>2.8480475245840098</c:v>
                </c:pt>
                <c:pt idx="5456">
                  <c:v>3.3948304689893098</c:v>
                </c:pt>
                <c:pt idx="5457">
                  <c:v>2.9535520845273102</c:v>
                </c:pt>
                <c:pt idx="5458">
                  <c:v>2.5293547824758198</c:v>
                </c:pt>
                <c:pt idx="5459">
                  <c:v>3.0627227899748402</c:v>
                </c:pt>
                <c:pt idx="5460">
                  <c:v>3.2477335563978298</c:v>
                </c:pt>
                <c:pt idx="5461">
                  <c:v>3.71318515941008</c:v>
                </c:pt>
                <c:pt idx="5462">
                  <c:v>3.6626081018402399</c:v>
                </c:pt>
                <c:pt idx="5463">
                  <c:v>2.94282670083915</c:v>
                </c:pt>
                <c:pt idx="5464">
                  <c:v>3.15044678488269</c:v>
                </c:pt>
                <c:pt idx="5465">
                  <c:v>2.8040629568304198</c:v>
                </c:pt>
                <c:pt idx="5466">
                  <c:v>2.9251180623771802</c:v>
                </c:pt>
                <c:pt idx="5467">
                  <c:v>3.2515037343888702</c:v>
                </c:pt>
                <c:pt idx="5468">
                  <c:v>3.0478558394128399</c:v>
                </c:pt>
                <c:pt idx="5469">
                  <c:v>2.9234833352146801</c:v>
                </c:pt>
                <c:pt idx="5470">
                  <c:v>3.5609431638533899</c:v>
                </c:pt>
                <c:pt idx="5471">
                  <c:v>3.4060759037111499</c:v>
                </c:pt>
                <c:pt idx="5472">
                  <c:v>3.25451418628053</c:v>
                </c:pt>
                <c:pt idx="5473">
                  <c:v>3.1061911116658201</c:v>
                </c:pt>
                <c:pt idx="5474">
                  <c:v>3.42918247144156</c:v>
                </c:pt>
                <c:pt idx="5475">
                  <c:v>3.1152580723505299</c:v>
                </c:pt>
                <c:pt idx="5476">
                  <c:v>3.2487968344585498</c:v>
                </c:pt>
                <c:pt idx="5477">
                  <c:v>3.02051917861202</c:v>
                </c:pt>
                <c:pt idx="5478">
                  <c:v>2.7059856053168199</c:v>
                </c:pt>
                <c:pt idx="5479">
                  <c:v>2.9565429248895301</c:v>
                </c:pt>
                <c:pt idx="5480">
                  <c:v>2.6789560560732602</c:v>
                </c:pt>
                <c:pt idx="5481">
                  <c:v>3.1109307876160202</c:v>
                </c:pt>
                <c:pt idx="5482">
                  <c:v>3.8651385431979999</c:v>
                </c:pt>
                <c:pt idx="5483">
                  <c:v>3.1311007743558399</c:v>
                </c:pt>
                <c:pt idx="5484">
                  <c:v>3.0873883493234402</c:v>
                </c:pt>
                <c:pt idx="5485">
                  <c:v>3.19025816631058</c:v>
                </c:pt>
                <c:pt idx="5486">
                  <c:v>4.0143427977003601</c:v>
                </c:pt>
                <c:pt idx="5487">
                  <c:v>3.6171754299929599</c:v>
                </c:pt>
                <c:pt idx="5488">
                  <c:v>3.1788619607284301</c:v>
                </c:pt>
                <c:pt idx="5489">
                  <c:v>2.9897578906525899</c:v>
                </c:pt>
                <c:pt idx="5490">
                  <c:v>2.92903763105822</c:v>
                </c:pt>
                <c:pt idx="5491">
                  <c:v>3.34677139842002</c:v>
                </c:pt>
                <c:pt idx="5492">
                  <c:v>2.8580388993213899</c:v>
                </c:pt>
                <c:pt idx="5493">
                  <c:v>3.7672445475530099</c:v>
                </c:pt>
                <c:pt idx="5494">
                  <c:v>2.8671482516184601</c:v>
                </c:pt>
                <c:pt idx="5495">
                  <c:v>3.4514660495383902</c:v>
                </c:pt>
                <c:pt idx="5496">
                  <c:v>3.9883220383669999</c:v>
                </c:pt>
                <c:pt idx="5497">
                  <c:v>3.9200551448832099</c:v>
                </c:pt>
                <c:pt idx="5498">
                  <c:v>3.7713577862479499</c:v>
                </c:pt>
                <c:pt idx="5499">
                  <c:v>4.0554093021851996</c:v>
                </c:pt>
                <c:pt idx="5500">
                  <c:v>4.1617392355229503</c:v>
                </c:pt>
                <c:pt idx="5501">
                  <c:v>3.5860970140036801</c:v>
                </c:pt>
                <c:pt idx="5502">
                  <c:v>3.5321929728530099</c:v>
                </c:pt>
                <c:pt idx="5503">
                  <c:v>3.81867802357585</c:v>
                </c:pt>
                <c:pt idx="5504">
                  <c:v>3.5586511782909001</c:v>
                </c:pt>
                <c:pt idx="5505">
                  <c:v>3.8987519403622102</c:v>
                </c:pt>
                <c:pt idx="5506">
                  <c:v>3.4146084639165499</c:v>
                </c:pt>
                <c:pt idx="5507">
                  <c:v>3.6023319280317501</c:v>
                </c:pt>
                <c:pt idx="5508">
                  <c:v>3.8503989823795202</c:v>
                </c:pt>
                <c:pt idx="5509">
                  <c:v>3.54782212630565</c:v>
                </c:pt>
                <c:pt idx="5510">
                  <c:v>3.14900889265689</c:v>
                </c:pt>
                <c:pt idx="5511">
                  <c:v>4.1568879680342699</c:v>
                </c:pt>
                <c:pt idx="5512">
                  <c:v>3.87625663824817</c:v>
                </c:pt>
                <c:pt idx="5513">
                  <c:v>3.6807409254570298</c:v>
                </c:pt>
                <c:pt idx="5514">
                  <c:v>3.77148357819331</c:v>
                </c:pt>
                <c:pt idx="5515">
                  <c:v>3.6360568066965402</c:v>
                </c:pt>
                <c:pt idx="5516">
                  <c:v>3.7267618124905502</c:v>
                </c:pt>
                <c:pt idx="5517">
                  <c:v>3.84928930254262</c:v>
                </c:pt>
                <c:pt idx="5518">
                  <c:v>3.6546058191953499</c:v>
                </c:pt>
                <c:pt idx="5519">
                  <c:v>3.7514814952333699</c:v>
                </c:pt>
                <c:pt idx="5520">
                  <c:v>4.4057938439789899</c:v>
                </c:pt>
                <c:pt idx="5521">
                  <c:v>3.7586434609310699</c:v>
                </c:pt>
                <c:pt idx="5522">
                  <c:v>3.7604577840906801</c:v>
                </c:pt>
                <c:pt idx="5523">
                  <c:v>4.0708735380004004</c:v>
                </c:pt>
                <c:pt idx="5524">
                  <c:v>3.9137222565545802</c:v>
                </c:pt>
                <c:pt idx="5525">
                  <c:v>4.7490799947811704</c:v>
                </c:pt>
                <c:pt idx="5526">
                  <c:v>4.0851770857151601</c:v>
                </c:pt>
                <c:pt idx="5527">
                  <c:v>3.5704402495023699</c:v>
                </c:pt>
                <c:pt idx="5528">
                  <c:v>3.6816921288126898</c:v>
                </c:pt>
                <c:pt idx="5529">
                  <c:v>4.3515401529899203</c:v>
                </c:pt>
                <c:pt idx="5530">
                  <c:v>4.2149164268641401</c:v>
                </c:pt>
                <c:pt idx="5531">
                  <c:v>3.5472054391405599</c:v>
                </c:pt>
                <c:pt idx="5532">
                  <c:v>4.1863848954168397</c:v>
                </c:pt>
                <c:pt idx="5533">
                  <c:v>4.22513974689336</c:v>
                </c:pt>
                <c:pt idx="5534">
                  <c:v>3.4504508259321098</c:v>
                </c:pt>
                <c:pt idx="5535">
                  <c:v>4.7047412273751803</c:v>
                </c:pt>
                <c:pt idx="5536">
                  <c:v>3.6075491933316299</c:v>
                </c:pt>
                <c:pt idx="5537">
                  <c:v>3.4943690133628298</c:v>
                </c:pt>
                <c:pt idx="5538">
                  <c:v>3.7092472919708599</c:v>
                </c:pt>
                <c:pt idx="5539">
                  <c:v>3.8205099549160302</c:v>
                </c:pt>
                <c:pt idx="5540">
                  <c:v>4.2794739708249896</c:v>
                </c:pt>
                <c:pt idx="5541">
                  <c:v>3.5661055108226498</c:v>
                </c:pt>
                <c:pt idx="5542">
                  <c:v>3.9761488544275099</c:v>
                </c:pt>
                <c:pt idx="5543">
                  <c:v>3.8187330832789002</c:v>
                </c:pt>
                <c:pt idx="5544">
                  <c:v>4.2358211868995497</c:v>
                </c:pt>
                <c:pt idx="5545">
                  <c:v>4.0446286198747803</c:v>
                </c:pt>
                <c:pt idx="5546">
                  <c:v>3.9655623491459502</c:v>
                </c:pt>
                <c:pt idx="5547">
                  <c:v>3.6475247191261402</c:v>
                </c:pt>
                <c:pt idx="5548">
                  <c:v>3.4968389849419901</c:v>
                </c:pt>
                <c:pt idx="5549">
                  <c:v>3.4038960745579101</c:v>
                </c:pt>
                <c:pt idx="5550">
                  <c:v>3.7394074780059299</c:v>
                </c:pt>
                <c:pt idx="5551">
                  <c:v>3.2812852134750701</c:v>
                </c:pt>
                <c:pt idx="5552">
                  <c:v>3.5169811297912998</c:v>
                </c:pt>
                <c:pt idx="5553">
                  <c:v>3.6627259478699199</c:v>
                </c:pt>
                <c:pt idx="5554">
                  <c:v>3.75482312231013</c:v>
                </c:pt>
                <c:pt idx="5555">
                  <c:v>3.6856434433634</c:v>
                </c:pt>
                <c:pt idx="5556">
                  <c:v>3.3304563289946998</c:v>
                </c:pt>
                <c:pt idx="5557">
                  <c:v>4.0201540083604099</c:v>
                </c:pt>
                <c:pt idx="5558">
                  <c:v>3.32179740261651</c:v>
                </c:pt>
                <c:pt idx="5559">
                  <c:v>3.5890261892058399</c:v>
                </c:pt>
                <c:pt idx="5560">
                  <c:v>2.9445982805188602</c:v>
                </c:pt>
                <c:pt idx="5561">
                  <c:v>3.9970232621832098</c:v>
                </c:pt>
                <c:pt idx="5562">
                  <c:v>3.6339612479186698</c:v>
                </c:pt>
                <c:pt idx="5563">
                  <c:v>3.5494376323649202</c:v>
                </c:pt>
                <c:pt idx="5564">
                  <c:v>3.60430786721045</c:v>
                </c:pt>
                <c:pt idx="5565">
                  <c:v>3.62000273260609</c:v>
                </c:pt>
                <c:pt idx="5566">
                  <c:v>3.5358937751965298</c:v>
                </c:pt>
                <c:pt idx="5567">
                  <c:v>3.7520733404685198</c:v>
                </c:pt>
                <c:pt idx="5568">
                  <c:v>3.8325655464416601</c:v>
                </c:pt>
                <c:pt idx="5569">
                  <c:v>3.3157558268705798</c:v>
                </c:pt>
                <c:pt idx="5570">
                  <c:v>2.9457973779882201</c:v>
                </c:pt>
                <c:pt idx="5571">
                  <c:v>2.8469061763860699</c:v>
                </c:pt>
                <c:pt idx="5572">
                  <c:v>3.8037779658455602</c:v>
                </c:pt>
                <c:pt idx="5573">
                  <c:v>3.3774057676620601</c:v>
                </c:pt>
                <c:pt idx="5574">
                  <c:v>2.7959891045762499</c:v>
                </c:pt>
                <c:pt idx="5575">
                  <c:v>2.5009594123392498</c:v>
                </c:pt>
                <c:pt idx="5576">
                  <c:v>2.9781225385952301</c:v>
                </c:pt>
                <c:pt idx="5577">
                  <c:v>3.21094559508398</c:v>
                </c:pt>
                <c:pt idx="5578">
                  <c:v>2.8169256036807502</c:v>
                </c:pt>
                <c:pt idx="5579">
                  <c:v>3.1130753823286299</c:v>
                </c:pt>
                <c:pt idx="5580">
                  <c:v>3.0762555868150598</c:v>
                </c:pt>
                <c:pt idx="5581">
                  <c:v>3.4660672141556002</c:v>
                </c:pt>
                <c:pt idx="5582">
                  <c:v>3.3061646389451602</c:v>
                </c:pt>
                <c:pt idx="5583">
                  <c:v>3.3226011083968401</c:v>
                </c:pt>
                <c:pt idx="5584">
                  <c:v>3.16573527493646</c:v>
                </c:pt>
                <c:pt idx="5585">
                  <c:v>3.1288320605599198</c:v>
                </c:pt>
                <c:pt idx="5586">
                  <c:v>3.15489558675884</c:v>
                </c:pt>
                <c:pt idx="5587">
                  <c:v>3.5716328249790998</c:v>
                </c:pt>
                <c:pt idx="5588">
                  <c:v>3.3083372292648101</c:v>
                </c:pt>
                <c:pt idx="5589">
                  <c:v>3.45867877475253</c:v>
                </c:pt>
                <c:pt idx="5590">
                  <c:v>4.0075945385400704</c:v>
                </c:pt>
                <c:pt idx="5591">
                  <c:v>2.9461845290630402</c:v>
                </c:pt>
                <c:pt idx="5592">
                  <c:v>3.2810199777545299</c:v>
                </c:pt>
                <c:pt idx="5593">
                  <c:v>3.3922231730263199</c:v>
                </c:pt>
                <c:pt idx="5594">
                  <c:v>3.9989634639426099</c:v>
                </c:pt>
                <c:pt idx="5595">
                  <c:v>3.71994496712222</c:v>
                </c:pt>
                <c:pt idx="5596">
                  <c:v>2.8983814717617702</c:v>
                </c:pt>
                <c:pt idx="5597">
                  <c:v>3.5736648893772101</c:v>
                </c:pt>
                <c:pt idx="5598">
                  <c:v>3.9248867455528602</c:v>
                </c:pt>
                <c:pt idx="5599">
                  <c:v>3.6545786215787799</c:v>
                </c:pt>
                <c:pt idx="5600">
                  <c:v>3.0581272074074199</c:v>
                </c:pt>
                <c:pt idx="5601">
                  <c:v>3.1456833293567401</c:v>
                </c:pt>
                <c:pt idx="5602">
                  <c:v>3.8140861839463298</c:v>
                </c:pt>
                <c:pt idx="5603">
                  <c:v>3.5958083093245001</c:v>
                </c:pt>
                <c:pt idx="5604">
                  <c:v>3.8894541263126801</c:v>
                </c:pt>
                <c:pt idx="5605">
                  <c:v>3.3678747505705702</c:v>
                </c:pt>
                <c:pt idx="5606">
                  <c:v>3.2050366794115699</c:v>
                </c:pt>
                <c:pt idx="5607">
                  <c:v>3.06287625403067</c:v>
                </c:pt>
                <c:pt idx="5608">
                  <c:v>3.5084386250504398</c:v>
                </c:pt>
                <c:pt idx="5609">
                  <c:v>4.0516191841092404</c:v>
                </c:pt>
                <c:pt idx="5610">
                  <c:v>3.5022135326579802</c:v>
                </c:pt>
                <c:pt idx="5611">
                  <c:v>3.5424638708377301</c:v>
                </c:pt>
                <c:pt idx="5612">
                  <c:v>3.2818670608394802</c:v>
                </c:pt>
                <c:pt idx="5613">
                  <c:v>4.0386529481451401</c:v>
                </c:pt>
                <c:pt idx="5614">
                  <c:v>3.79671440383868</c:v>
                </c:pt>
                <c:pt idx="5615">
                  <c:v>3.9331202284331099</c:v>
                </c:pt>
                <c:pt idx="5616">
                  <c:v>4.1243027811271897</c:v>
                </c:pt>
                <c:pt idx="5617">
                  <c:v>3.83143933598627</c:v>
                </c:pt>
                <c:pt idx="5618">
                  <c:v>4.6496836958169299</c:v>
                </c:pt>
                <c:pt idx="5619">
                  <c:v>4.4772963150279201</c:v>
                </c:pt>
                <c:pt idx="5620">
                  <c:v>4.4461258950371603</c:v>
                </c:pt>
                <c:pt idx="5621">
                  <c:v>3.4301434485558402</c:v>
                </c:pt>
                <c:pt idx="5622">
                  <c:v>3.8159135534251298</c:v>
                </c:pt>
                <c:pt idx="5623">
                  <c:v>3.48792979247545</c:v>
                </c:pt>
                <c:pt idx="5624">
                  <c:v>3.7038263235783102</c:v>
                </c:pt>
                <c:pt idx="5625">
                  <c:v>4.1649771115014698</c:v>
                </c:pt>
                <c:pt idx="5626">
                  <c:v>3.89257619669843</c:v>
                </c:pt>
                <c:pt idx="5627">
                  <c:v>3.3214526704078899</c:v>
                </c:pt>
                <c:pt idx="5628">
                  <c:v>4.0580610443330603</c:v>
                </c:pt>
                <c:pt idx="5629">
                  <c:v>4.1085960521894798</c:v>
                </c:pt>
                <c:pt idx="5630">
                  <c:v>4.24207146800084</c:v>
                </c:pt>
                <c:pt idx="5631">
                  <c:v>4.25079346504622</c:v>
                </c:pt>
                <c:pt idx="5632">
                  <c:v>3.8278962333960398</c:v>
                </c:pt>
                <c:pt idx="5633">
                  <c:v>4.12328796224784</c:v>
                </c:pt>
                <c:pt idx="5634">
                  <c:v>4.01417940187092</c:v>
                </c:pt>
                <c:pt idx="5635">
                  <c:v>4.1515946649900402</c:v>
                </c:pt>
                <c:pt idx="5636">
                  <c:v>4.1573502969701597</c:v>
                </c:pt>
                <c:pt idx="5637">
                  <c:v>4.5322336378253603</c:v>
                </c:pt>
                <c:pt idx="5638">
                  <c:v>3.7113957550759902</c:v>
                </c:pt>
                <c:pt idx="5639">
                  <c:v>3.3099983648792701</c:v>
                </c:pt>
                <c:pt idx="5640">
                  <c:v>3.6857786535095798</c:v>
                </c:pt>
                <c:pt idx="5641">
                  <c:v>4.2262293101708099</c:v>
                </c:pt>
                <c:pt idx="5642">
                  <c:v>3.80875994525874</c:v>
                </c:pt>
                <c:pt idx="5643">
                  <c:v>3.6219498654583901</c:v>
                </c:pt>
                <c:pt idx="5644">
                  <c:v>3.56084568214311</c:v>
                </c:pt>
                <c:pt idx="5645">
                  <c:v>3.5492594664463701</c:v>
                </c:pt>
                <c:pt idx="5646">
                  <c:v>3.8657635027952302</c:v>
                </c:pt>
                <c:pt idx="5647">
                  <c:v>3.31880071184893</c:v>
                </c:pt>
                <c:pt idx="5648">
                  <c:v>3.3174382559086601</c:v>
                </c:pt>
                <c:pt idx="5649">
                  <c:v>3.5795128066732</c:v>
                </c:pt>
                <c:pt idx="5650">
                  <c:v>3.5074458138594098</c:v>
                </c:pt>
                <c:pt idx="5651">
                  <c:v>3.0002566213024302</c:v>
                </c:pt>
                <c:pt idx="5652">
                  <c:v>4.0694827556954296</c:v>
                </c:pt>
                <c:pt idx="5653">
                  <c:v>2.9911921885227302</c:v>
                </c:pt>
                <c:pt idx="5654">
                  <c:v>3.7080863271390401</c:v>
                </c:pt>
                <c:pt idx="5655">
                  <c:v>3.4533613212447101</c:v>
                </c:pt>
                <c:pt idx="5656">
                  <c:v>3.6857049870720799</c:v>
                </c:pt>
                <c:pt idx="5657">
                  <c:v>3.0440708484862302</c:v>
                </c:pt>
                <c:pt idx="5658">
                  <c:v>3.5199636453413401</c:v>
                </c:pt>
                <c:pt idx="5659">
                  <c:v>3.5938842399420201</c:v>
                </c:pt>
                <c:pt idx="5660">
                  <c:v>2.90106808686531</c:v>
                </c:pt>
                <c:pt idx="5661">
                  <c:v>3.5562023940964198</c:v>
                </c:pt>
                <c:pt idx="5662">
                  <c:v>3.6264719040517202</c:v>
                </c:pt>
                <c:pt idx="5663">
                  <c:v>3.5580710378986198</c:v>
                </c:pt>
                <c:pt idx="5664">
                  <c:v>3.5637614454356101</c:v>
                </c:pt>
                <c:pt idx="5665">
                  <c:v>3.4109247621319598</c:v>
                </c:pt>
                <c:pt idx="5666">
                  <c:v>3.6544176222046501</c:v>
                </c:pt>
                <c:pt idx="5667">
                  <c:v>3.38679263265547</c:v>
                </c:pt>
                <c:pt idx="5668">
                  <c:v>3.7087430850786398</c:v>
                </c:pt>
                <c:pt idx="5669">
                  <c:v>3.1173427286872801</c:v>
                </c:pt>
                <c:pt idx="5670">
                  <c:v>3.6343435482650901</c:v>
                </c:pt>
                <c:pt idx="5671">
                  <c:v>3.7623495392774902</c:v>
                </c:pt>
                <c:pt idx="5672">
                  <c:v>3.9187498986662601</c:v>
                </c:pt>
                <c:pt idx="5673">
                  <c:v>2.9904526441599799</c:v>
                </c:pt>
                <c:pt idx="5674">
                  <c:v>3.8040056456352498</c:v>
                </c:pt>
                <c:pt idx="5675">
                  <c:v>3.44687202977433</c:v>
                </c:pt>
                <c:pt idx="5676">
                  <c:v>4.0134142530088504</c:v>
                </c:pt>
                <c:pt idx="5677">
                  <c:v>3.6556205534006501</c:v>
                </c:pt>
                <c:pt idx="5678">
                  <c:v>3.6134147016650902</c:v>
                </c:pt>
                <c:pt idx="5679">
                  <c:v>3.33468314265706</c:v>
                </c:pt>
                <c:pt idx="5680">
                  <c:v>3.53919227201586</c:v>
                </c:pt>
                <c:pt idx="5681">
                  <c:v>3.8277717758034999</c:v>
                </c:pt>
                <c:pt idx="5682">
                  <c:v>3.5542544322488099</c:v>
                </c:pt>
                <c:pt idx="5683">
                  <c:v>3.3165795539091998</c:v>
                </c:pt>
                <c:pt idx="5684">
                  <c:v>3.07786787430009</c:v>
                </c:pt>
                <c:pt idx="5685">
                  <c:v>2.8798480940158502</c:v>
                </c:pt>
                <c:pt idx="5686">
                  <c:v>3.2844771652629601</c:v>
                </c:pt>
                <c:pt idx="5687">
                  <c:v>3.44560559929565</c:v>
                </c:pt>
                <c:pt idx="5688">
                  <c:v>3.4799674134740899</c:v>
                </c:pt>
                <c:pt idx="5689">
                  <c:v>3.1543278688651402</c:v>
                </c:pt>
                <c:pt idx="5690">
                  <c:v>3.2176743024360501</c:v>
                </c:pt>
                <c:pt idx="5691">
                  <c:v>3.69353439750049</c:v>
                </c:pt>
                <c:pt idx="5692">
                  <c:v>3.2661741389306802</c:v>
                </c:pt>
                <c:pt idx="5693">
                  <c:v>3.4053548958862701</c:v>
                </c:pt>
                <c:pt idx="5694">
                  <c:v>3.74258353644806</c:v>
                </c:pt>
                <c:pt idx="5695">
                  <c:v>3.5906372339260999</c:v>
                </c:pt>
                <c:pt idx="5696">
                  <c:v>3.72199057135352</c:v>
                </c:pt>
                <c:pt idx="5697">
                  <c:v>3.69515032906645</c:v>
                </c:pt>
                <c:pt idx="5698">
                  <c:v>3.4794082484401301</c:v>
                </c:pt>
                <c:pt idx="5699">
                  <c:v>3.1728311800239402</c:v>
                </c:pt>
                <c:pt idx="5700">
                  <c:v>3.3817243684208198</c:v>
                </c:pt>
                <c:pt idx="5701">
                  <c:v>3.6458629201896802</c:v>
                </c:pt>
                <c:pt idx="5702">
                  <c:v>3.23011391559334</c:v>
                </c:pt>
                <c:pt idx="5703">
                  <c:v>3.30658236592941</c:v>
                </c:pt>
                <c:pt idx="5704">
                  <c:v>3.33373702823262</c:v>
                </c:pt>
                <c:pt idx="5705">
                  <c:v>3.8360737916671002</c:v>
                </c:pt>
                <c:pt idx="5706">
                  <c:v>3.46357209212277</c:v>
                </c:pt>
                <c:pt idx="5707">
                  <c:v>3.8284199673447001</c:v>
                </c:pt>
                <c:pt idx="5708">
                  <c:v>3.6402721124181201</c:v>
                </c:pt>
                <c:pt idx="5709">
                  <c:v>3.7459260512755499</c:v>
                </c:pt>
                <c:pt idx="5710">
                  <c:v>3.7789884300847301</c:v>
                </c:pt>
                <c:pt idx="5711">
                  <c:v>3.4554200148359202</c:v>
                </c:pt>
                <c:pt idx="5712">
                  <c:v>4.2249754485518096</c:v>
                </c:pt>
                <c:pt idx="5713">
                  <c:v>3.60527756730691</c:v>
                </c:pt>
                <c:pt idx="5714">
                  <c:v>2.92279902374898</c:v>
                </c:pt>
                <c:pt idx="5715">
                  <c:v>3.5251564346626298</c:v>
                </c:pt>
                <c:pt idx="5716">
                  <c:v>2.8536271509411999</c:v>
                </c:pt>
                <c:pt idx="5717">
                  <c:v>3.3599647515581599</c:v>
                </c:pt>
                <c:pt idx="5718">
                  <c:v>3.6360898999672902</c:v>
                </c:pt>
                <c:pt idx="5719">
                  <c:v>3.5662257307491201</c:v>
                </c:pt>
                <c:pt idx="5720">
                  <c:v>3.3341438174650802</c:v>
                </c:pt>
                <c:pt idx="5721">
                  <c:v>3.5169907466091299</c:v>
                </c:pt>
                <c:pt idx="5722">
                  <c:v>3.3219621616605099</c:v>
                </c:pt>
                <c:pt idx="5723">
                  <c:v>2.64229678330104</c:v>
                </c:pt>
                <c:pt idx="5724">
                  <c:v>2.4930211679333598</c:v>
                </c:pt>
                <c:pt idx="5725">
                  <c:v>3.0994915595855002</c:v>
                </c:pt>
                <c:pt idx="5726">
                  <c:v>2.8626199408363902</c:v>
                </c:pt>
                <c:pt idx="5727">
                  <c:v>3.5925296341164699</c:v>
                </c:pt>
                <c:pt idx="5728">
                  <c:v>2.7151316532613201</c:v>
                </c:pt>
                <c:pt idx="5729">
                  <c:v>2.4625485330263999</c:v>
                </c:pt>
                <c:pt idx="5730">
                  <c:v>3.7041995414067301</c:v>
                </c:pt>
                <c:pt idx="5731">
                  <c:v>3.4350889160031701</c:v>
                </c:pt>
                <c:pt idx="5732">
                  <c:v>3.7813082331764201</c:v>
                </c:pt>
                <c:pt idx="5733">
                  <c:v>2.7219681301394401</c:v>
                </c:pt>
                <c:pt idx="5734">
                  <c:v>3.0652855235105299</c:v>
                </c:pt>
                <c:pt idx="5735">
                  <c:v>2.7196451519445599</c:v>
                </c:pt>
                <c:pt idx="5736">
                  <c:v>3.07023885342781</c:v>
                </c:pt>
                <c:pt idx="5737">
                  <c:v>3.0395062815314602</c:v>
                </c:pt>
                <c:pt idx="5738">
                  <c:v>3.5972471511714401</c:v>
                </c:pt>
                <c:pt idx="5739">
                  <c:v>3.59682934143683</c:v>
                </c:pt>
                <c:pt idx="5740">
                  <c:v>3.1511052760003002</c:v>
                </c:pt>
                <c:pt idx="5741">
                  <c:v>3.15510745423598</c:v>
                </c:pt>
                <c:pt idx="5742">
                  <c:v>3.5069535846575799</c:v>
                </c:pt>
                <c:pt idx="5743">
                  <c:v>3.7718348989944599</c:v>
                </c:pt>
                <c:pt idx="5744">
                  <c:v>4.3635235274358699</c:v>
                </c:pt>
                <c:pt idx="5745">
                  <c:v>3.9720704909927398</c:v>
                </c:pt>
                <c:pt idx="5746">
                  <c:v>3.32067400387997</c:v>
                </c:pt>
                <c:pt idx="5747">
                  <c:v>4.0475472321623904</c:v>
                </c:pt>
                <c:pt idx="5748">
                  <c:v>3.4188912230895401</c:v>
                </c:pt>
                <c:pt idx="5749">
                  <c:v>4.5515478617564504</c:v>
                </c:pt>
                <c:pt idx="5750">
                  <c:v>3.1802793351516998</c:v>
                </c:pt>
                <c:pt idx="5751">
                  <c:v>3.5794080450161099</c:v>
                </c:pt>
                <c:pt idx="5752">
                  <c:v>3.4307198982334501</c:v>
                </c:pt>
                <c:pt idx="5753">
                  <c:v>2.9527592652503398</c:v>
                </c:pt>
                <c:pt idx="5754">
                  <c:v>3.5291854132507501</c:v>
                </c:pt>
                <c:pt idx="5755">
                  <c:v>3.3777699148387001</c:v>
                </c:pt>
                <c:pt idx="5756">
                  <c:v>3.2776448208922799</c:v>
                </c:pt>
                <c:pt idx="5757">
                  <c:v>3.54579141555371</c:v>
                </c:pt>
                <c:pt idx="5758">
                  <c:v>3.3227867104570499</c:v>
                </c:pt>
                <c:pt idx="5759">
                  <c:v>3.2804565482819998</c:v>
                </c:pt>
                <c:pt idx="5760">
                  <c:v>3.8458215896804</c:v>
                </c:pt>
                <c:pt idx="5761">
                  <c:v>3.7478040074435102</c:v>
                </c:pt>
                <c:pt idx="5762">
                  <c:v>3.8939833171751999</c:v>
                </c:pt>
                <c:pt idx="5763">
                  <c:v>3.8029275691028102</c:v>
                </c:pt>
                <c:pt idx="5764">
                  <c:v>3.7687463860786199</c:v>
                </c:pt>
                <c:pt idx="5765">
                  <c:v>3.5067500796117699</c:v>
                </c:pt>
                <c:pt idx="5766">
                  <c:v>3.9131492266103098</c:v>
                </c:pt>
                <c:pt idx="5767">
                  <c:v>3.0195318705659102</c:v>
                </c:pt>
                <c:pt idx="5768">
                  <c:v>3.2290815366505998</c:v>
                </c:pt>
                <c:pt idx="5769">
                  <c:v>2.6818937217480898</c:v>
                </c:pt>
                <c:pt idx="5770">
                  <c:v>3.62962365313075</c:v>
                </c:pt>
                <c:pt idx="5771">
                  <c:v>3.2288645628104198</c:v>
                </c:pt>
                <c:pt idx="5772">
                  <c:v>3.0466289457189601</c:v>
                </c:pt>
                <c:pt idx="5773">
                  <c:v>3.10233386623633</c:v>
                </c:pt>
                <c:pt idx="5774">
                  <c:v>2.8769135276314901</c:v>
                </c:pt>
                <c:pt idx="5775">
                  <c:v>3.78851701250511</c:v>
                </c:pt>
                <c:pt idx="5776">
                  <c:v>3.1130258743764601</c:v>
                </c:pt>
                <c:pt idx="5777">
                  <c:v>3.28358318480042</c:v>
                </c:pt>
                <c:pt idx="5778">
                  <c:v>3.1138524360915301</c:v>
                </c:pt>
                <c:pt idx="5779">
                  <c:v>3.5070179998581099</c:v>
                </c:pt>
                <c:pt idx="5780">
                  <c:v>3.1940157400248599</c:v>
                </c:pt>
                <c:pt idx="5781">
                  <c:v>3.1652411796688802</c:v>
                </c:pt>
                <c:pt idx="5782">
                  <c:v>3.4647344481958098</c:v>
                </c:pt>
                <c:pt idx="5783">
                  <c:v>3.55709895590544</c:v>
                </c:pt>
                <c:pt idx="5784">
                  <c:v>3.3160978490937101</c:v>
                </c:pt>
                <c:pt idx="5785">
                  <c:v>3.6633612202599699</c:v>
                </c:pt>
                <c:pt idx="5786">
                  <c:v>3.25985952088589</c:v>
                </c:pt>
                <c:pt idx="5787">
                  <c:v>3.5519906881666499</c:v>
                </c:pt>
                <c:pt idx="5788">
                  <c:v>3.0549789102664802</c:v>
                </c:pt>
                <c:pt idx="5789">
                  <c:v>2.9229934476381798</c:v>
                </c:pt>
                <c:pt idx="5790">
                  <c:v>3.0890738392950898</c:v>
                </c:pt>
                <c:pt idx="5791">
                  <c:v>3.4962880211048502</c:v>
                </c:pt>
                <c:pt idx="5792">
                  <c:v>2.8109607457685599</c:v>
                </c:pt>
                <c:pt idx="5793">
                  <c:v>3.17095469917103</c:v>
                </c:pt>
                <c:pt idx="5794">
                  <c:v>2.7365844846518201</c:v>
                </c:pt>
                <c:pt idx="5795">
                  <c:v>3.1116932647673599</c:v>
                </c:pt>
                <c:pt idx="5796">
                  <c:v>2.78214571854721</c:v>
                </c:pt>
                <c:pt idx="5797">
                  <c:v>3.4056121249520701</c:v>
                </c:pt>
                <c:pt idx="5798">
                  <c:v>2.4648637113371898</c:v>
                </c:pt>
                <c:pt idx="5799">
                  <c:v>2.37482140950801</c:v>
                </c:pt>
                <c:pt idx="5800">
                  <c:v>2.8776094203525302</c:v>
                </c:pt>
                <c:pt idx="5801">
                  <c:v>3.2170443909342201</c:v>
                </c:pt>
                <c:pt idx="5802">
                  <c:v>2.9430218292858599</c:v>
                </c:pt>
                <c:pt idx="5803">
                  <c:v>3.11257141691723</c:v>
                </c:pt>
                <c:pt idx="5804">
                  <c:v>3.16510602069022</c:v>
                </c:pt>
                <c:pt idx="5805">
                  <c:v>3.0868930928398099</c:v>
                </c:pt>
                <c:pt idx="5806">
                  <c:v>3.2628872232221999</c:v>
                </c:pt>
                <c:pt idx="5807">
                  <c:v>3.0380132549465602</c:v>
                </c:pt>
                <c:pt idx="5808">
                  <c:v>2.3534700057132398</c:v>
                </c:pt>
                <c:pt idx="5809">
                  <c:v>2.7361382162587802</c:v>
                </c:pt>
                <c:pt idx="5810">
                  <c:v>2.4728241765230301</c:v>
                </c:pt>
                <c:pt idx="5811">
                  <c:v>2.8265565063001001</c:v>
                </c:pt>
                <c:pt idx="5812">
                  <c:v>2.81156665715829</c:v>
                </c:pt>
                <c:pt idx="5813">
                  <c:v>3.23648611806771</c:v>
                </c:pt>
                <c:pt idx="5814">
                  <c:v>3.1569070198987998</c:v>
                </c:pt>
                <c:pt idx="5815">
                  <c:v>2.98963997517507</c:v>
                </c:pt>
                <c:pt idx="5816">
                  <c:v>2.8641454388171699</c:v>
                </c:pt>
                <c:pt idx="5817">
                  <c:v>3.2090193047848898</c:v>
                </c:pt>
                <c:pt idx="5818">
                  <c:v>2.4838646977324799</c:v>
                </c:pt>
                <c:pt idx="5819">
                  <c:v>2.35968323152475</c:v>
                </c:pt>
                <c:pt idx="5820">
                  <c:v>2.2209778925105499</c:v>
                </c:pt>
                <c:pt idx="5821">
                  <c:v>2.73529817578315</c:v>
                </c:pt>
                <c:pt idx="5822">
                  <c:v>2.42974428216244</c:v>
                </c:pt>
                <c:pt idx="5823">
                  <c:v>2.76523831344308</c:v>
                </c:pt>
                <c:pt idx="5824">
                  <c:v>2.7066053019304301</c:v>
                </c:pt>
                <c:pt idx="5825">
                  <c:v>2.2616416709014899</c:v>
                </c:pt>
                <c:pt idx="5826">
                  <c:v>2.8433472259374901</c:v>
                </c:pt>
                <c:pt idx="5827">
                  <c:v>2.6928051340608401</c:v>
                </c:pt>
                <c:pt idx="5828">
                  <c:v>2.8452368743187799</c:v>
                </c:pt>
                <c:pt idx="5829">
                  <c:v>3.5837999589463201</c:v>
                </c:pt>
                <c:pt idx="5830">
                  <c:v>3.36839584250278</c:v>
                </c:pt>
                <c:pt idx="5831">
                  <c:v>3.14033608932511</c:v>
                </c:pt>
                <c:pt idx="5832">
                  <c:v>3.4063559941659198</c:v>
                </c:pt>
                <c:pt idx="5833">
                  <c:v>3.7685420312551998</c:v>
                </c:pt>
                <c:pt idx="5834">
                  <c:v>3.7247535151555899</c:v>
                </c:pt>
                <c:pt idx="5835">
                  <c:v>3.23230315467339</c:v>
                </c:pt>
                <c:pt idx="5836">
                  <c:v>3.7287139584220599</c:v>
                </c:pt>
                <c:pt idx="5837">
                  <c:v>4.1846861669587998</c:v>
                </c:pt>
                <c:pt idx="5838">
                  <c:v>2.9290192877352799</c:v>
                </c:pt>
                <c:pt idx="5839">
                  <c:v>2.6109709944311299</c:v>
                </c:pt>
                <c:pt idx="5840">
                  <c:v>3.3417702764664901</c:v>
                </c:pt>
                <c:pt idx="5841">
                  <c:v>3.1163284446348798</c:v>
                </c:pt>
                <c:pt idx="5842">
                  <c:v>3.3615587260716899</c:v>
                </c:pt>
                <c:pt idx="5843">
                  <c:v>3.1170335622062999</c:v>
                </c:pt>
                <c:pt idx="5844">
                  <c:v>3.331086408669</c:v>
                </c:pt>
                <c:pt idx="5845">
                  <c:v>3.0801620311640998</c:v>
                </c:pt>
                <c:pt idx="5846">
                  <c:v>3.5069495919689402</c:v>
                </c:pt>
                <c:pt idx="5847">
                  <c:v>3.26802239860814</c:v>
                </c:pt>
                <c:pt idx="5848">
                  <c:v>3.1220306076997502</c:v>
                </c:pt>
                <c:pt idx="5849">
                  <c:v>3.7179364405656901</c:v>
                </c:pt>
                <c:pt idx="5850">
                  <c:v>2.82923971086232</c:v>
                </c:pt>
                <c:pt idx="5851">
                  <c:v>2.4808652888446598</c:v>
                </c:pt>
                <c:pt idx="5852">
                  <c:v>3.4457513803779301</c:v>
                </c:pt>
                <c:pt idx="5853">
                  <c:v>2.6860626939105101</c:v>
                </c:pt>
                <c:pt idx="5854">
                  <c:v>2.7865601235678601</c:v>
                </c:pt>
                <c:pt idx="5855">
                  <c:v>2.5670848951735801</c:v>
                </c:pt>
                <c:pt idx="5856">
                  <c:v>2.7527253844882802</c:v>
                </c:pt>
                <c:pt idx="5857">
                  <c:v>3.5070994748342001</c:v>
                </c:pt>
                <c:pt idx="5858">
                  <c:v>2.6854835693788899</c:v>
                </c:pt>
                <c:pt idx="5859">
                  <c:v>2.6560241557842601</c:v>
                </c:pt>
                <c:pt idx="5860">
                  <c:v>3.19844029286693</c:v>
                </c:pt>
                <c:pt idx="5861">
                  <c:v>3.38197257875956</c:v>
                </c:pt>
                <c:pt idx="5862">
                  <c:v>3.5051712352433899</c:v>
                </c:pt>
                <c:pt idx="5863">
                  <c:v>2.89910154446049</c:v>
                </c:pt>
                <c:pt idx="5864">
                  <c:v>3.5161057796485302</c:v>
                </c:pt>
                <c:pt idx="5865">
                  <c:v>3.4760697868161601</c:v>
                </c:pt>
                <c:pt idx="5866">
                  <c:v>2.5261207353394899</c:v>
                </c:pt>
                <c:pt idx="5867">
                  <c:v>2.4257043856222502</c:v>
                </c:pt>
                <c:pt idx="5868">
                  <c:v>2.5500714611256798</c:v>
                </c:pt>
                <c:pt idx="5869">
                  <c:v>2.80707682732502</c:v>
                </c:pt>
                <c:pt idx="5870">
                  <c:v>3.1032003834173101</c:v>
                </c:pt>
                <c:pt idx="5871">
                  <c:v>3.4523526912408902</c:v>
                </c:pt>
                <c:pt idx="5872">
                  <c:v>2.48973396551541</c:v>
                </c:pt>
                <c:pt idx="5873">
                  <c:v>2.6336173150228102</c:v>
                </c:pt>
                <c:pt idx="5874">
                  <c:v>2.70401618922878</c:v>
                </c:pt>
                <c:pt idx="5875">
                  <c:v>2.4869332730996399</c:v>
                </c:pt>
                <c:pt idx="5876">
                  <c:v>2.3803359897813499</c:v>
                </c:pt>
                <c:pt idx="5877">
                  <c:v>2.6295163732062599</c:v>
                </c:pt>
                <c:pt idx="5878">
                  <c:v>2.9397606031374099</c:v>
                </c:pt>
                <c:pt idx="5879">
                  <c:v>2.6868931901075199</c:v>
                </c:pt>
                <c:pt idx="5880">
                  <c:v>3.0107270638771202</c:v>
                </c:pt>
                <c:pt idx="5881">
                  <c:v>2.6049932140614001</c:v>
                </c:pt>
                <c:pt idx="5882">
                  <c:v>2.3959510319650299</c:v>
                </c:pt>
                <c:pt idx="5883">
                  <c:v>2.6329156978539299</c:v>
                </c:pt>
                <c:pt idx="5884">
                  <c:v>2.6390051880204499</c:v>
                </c:pt>
                <c:pt idx="5885">
                  <c:v>2.8806599281165401</c:v>
                </c:pt>
                <c:pt idx="5886">
                  <c:v>2.99226698999093</c:v>
                </c:pt>
                <c:pt idx="5887">
                  <c:v>2.8949646145996302</c:v>
                </c:pt>
                <c:pt idx="5888">
                  <c:v>2.7262725965145802</c:v>
                </c:pt>
                <c:pt idx="5889">
                  <c:v>2.6338662872904899</c:v>
                </c:pt>
                <c:pt idx="5890">
                  <c:v>2.93265446079053</c:v>
                </c:pt>
                <c:pt idx="5891">
                  <c:v>2.2511333692203799</c:v>
                </c:pt>
                <c:pt idx="5892">
                  <c:v>2.5528887625635299</c:v>
                </c:pt>
                <c:pt idx="5893">
                  <c:v>2.7883693633454301</c:v>
                </c:pt>
                <c:pt idx="5894">
                  <c:v>2.1255914563235399</c:v>
                </c:pt>
                <c:pt idx="5895">
                  <c:v>2.4855017821965801</c:v>
                </c:pt>
                <c:pt idx="5896">
                  <c:v>2.5241919522424201</c:v>
                </c:pt>
                <c:pt idx="5897">
                  <c:v>2.56737307326165</c:v>
                </c:pt>
                <c:pt idx="5898">
                  <c:v>1.89968364686174</c:v>
                </c:pt>
                <c:pt idx="5899">
                  <c:v>2.6937984326195901</c:v>
                </c:pt>
                <c:pt idx="5900">
                  <c:v>2.6616306544027601</c:v>
                </c:pt>
                <c:pt idx="5901">
                  <c:v>3.0199699049988502</c:v>
                </c:pt>
                <c:pt idx="5902">
                  <c:v>2.4127257914562601</c:v>
                </c:pt>
                <c:pt idx="5903">
                  <c:v>2.43321088078629</c:v>
                </c:pt>
                <c:pt idx="5904">
                  <c:v>2.5813432548385902</c:v>
                </c:pt>
                <c:pt idx="5905">
                  <c:v>2.3641700396531302</c:v>
                </c:pt>
                <c:pt idx="5906">
                  <c:v>2.05593996780348</c:v>
                </c:pt>
                <c:pt idx="5907">
                  <c:v>2.40814109384505</c:v>
                </c:pt>
                <c:pt idx="5908">
                  <c:v>2.27325320119827</c:v>
                </c:pt>
                <c:pt idx="5909">
                  <c:v>2.4792522370870902</c:v>
                </c:pt>
                <c:pt idx="5910">
                  <c:v>2.7836515506950499</c:v>
                </c:pt>
                <c:pt idx="5911">
                  <c:v>2.8862507802350099</c:v>
                </c:pt>
                <c:pt idx="5912">
                  <c:v>3.0505881260756502</c:v>
                </c:pt>
                <c:pt idx="5913">
                  <c:v>2.7730855850385101</c:v>
                </c:pt>
                <c:pt idx="5914">
                  <c:v>3.0071696274522699</c:v>
                </c:pt>
                <c:pt idx="5915">
                  <c:v>2.5357188895935998</c:v>
                </c:pt>
                <c:pt idx="5916">
                  <c:v>3.1582756079547001</c:v>
                </c:pt>
                <c:pt idx="5917">
                  <c:v>3.0380879333732498</c:v>
                </c:pt>
                <c:pt idx="5918">
                  <c:v>2.66185179929774</c:v>
                </c:pt>
                <c:pt idx="5919">
                  <c:v>2.44656645384228</c:v>
                </c:pt>
                <c:pt idx="5920">
                  <c:v>2.4984700071282102</c:v>
                </c:pt>
                <c:pt idx="5921">
                  <c:v>2.4075133337693702</c:v>
                </c:pt>
                <c:pt idx="5922">
                  <c:v>2.5880872767098002</c:v>
                </c:pt>
                <c:pt idx="5923">
                  <c:v>3.10809884370346</c:v>
                </c:pt>
                <c:pt idx="5924">
                  <c:v>2.9285699399502101</c:v>
                </c:pt>
                <c:pt idx="5925">
                  <c:v>3.4731947623831201</c:v>
                </c:pt>
                <c:pt idx="5926">
                  <c:v>2.9881972504313099</c:v>
                </c:pt>
                <c:pt idx="5927">
                  <c:v>2.5538674317286998</c:v>
                </c:pt>
                <c:pt idx="5928">
                  <c:v>2.8649191359565598</c:v>
                </c:pt>
                <c:pt idx="5929">
                  <c:v>2.4811453318021099</c:v>
                </c:pt>
                <c:pt idx="5930">
                  <c:v>2.4083219953717299</c:v>
                </c:pt>
                <c:pt idx="5931">
                  <c:v>3.1582454268064599</c:v>
                </c:pt>
                <c:pt idx="5932">
                  <c:v>2.98682375906832</c:v>
                </c:pt>
                <c:pt idx="5933">
                  <c:v>2.8015747403306799</c:v>
                </c:pt>
                <c:pt idx="5934">
                  <c:v>1.84754928744271</c:v>
                </c:pt>
                <c:pt idx="5935">
                  <c:v>2.8725130651235702</c:v>
                </c:pt>
                <c:pt idx="5936">
                  <c:v>2.6167028052585102</c:v>
                </c:pt>
                <c:pt idx="5937">
                  <c:v>2.0667980773631101</c:v>
                </c:pt>
                <c:pt idx="5938">
                  <c:v>2.8265465449677398</c:v>
                </c:pt>
                <c:pt idx="5939">
                  <c:v>2.31277626501564</c:v>
                </c:pt>
                <c:pt idx="5940">
                  <c:v>2.6270565160538002</c:v>
                </c:pt>
                <c:pt idx="5941">
                  <c:v>2.0634886747851202</c:v>
                </c:pt>
                <c:pt idx="5942">
                  <c:v>2.51400877683565</c:v>
                </c:pt>
                <c:pt idx="5943">
                  <c:v>2.3949671108775799</c:v>
                </c:pt>
                <c:pt idx="5944">
                  <c:v>3.1227158782613502</c:v>
                </c:pt>
                <c:pt idx="5945">
                  <c:v>3.1999721865391799</c:v>
                </c:pt>
                <c:pt idx="5946">
                  <c:v>3.3683753618779999</c:v>
                </c:pt>
                <c:pt idx="5947">
                  <c:v>2.8439061074221299</c:v>
                </c:pt>
                <c:pt idx="5948">
                  <c:v>3.0927042838199599</c:v>
                </c:pt>
                <c:pt idx="5949">
                  <c:v>3.4653367037451401</c:v>
                </c:pt>
                <c:pt idx="5950">
                  <c:v>2.3794005482002398</c:v>
                </c:pt>
                <c:pt idx="5951">
                  <c:v>3.2925207527382399</c:v>
                </c:pt>
                <c:pt idx="5952">
                  <c:v>3.1799797864542598</c:v>
                </c:pt>
                <c:pt idx="5953">
                  <c:v>2.9590513105291101</c:v>
                </c:pt>
                <c:pt idx="5954">
                  <c:v>3.1994605497592801</c:v>
                </c:pt>
                <c:pt idx="5955">
                  <c:v>3.3147388822204298</c:v>
                </c:pt>
                <c:pt idx="5956">
                  <c:v>2.6509002210113102</c:v>
                </c:pt>
                <c:pt idx="5957">
                  <c:v>3.1373443878969498</c:v>
                </c:pt>
                <c:pt idx="5958">
                  <c:v>3.6358751829585501</c:v>
                </c:pt>
                <c:pt idx="5959">
                  <c:v>3.2359508419440099</c:v>
                </c:pt>
                <c:pt idx="5960">
                  <c:v>3.5368693091648402</c:v>
                </c:pt>
                <c:pt idx="5961">
                  <c:v>3.2310754043150101</c:v>
                </c:pt>
                <c:pt idx="5962">
                  <c:v>3.5434899716708199</c:v>
                </c:pt>
                <c:pt idx="5963">
                  <c:v>3.1530548338174702</c:v>
                </c:pt>
                <c:pt idx="5964">
                  <c:v>3.0537765536227099</c:v>
                </c:pt>
                <c:pt idx="5965">
                  <c:v>3.0746373789925698</c:v>
                </c:pt>
                <c:pt idx="5966">
                  <c:v>3.2271617078445098</c:v>
                </c:pt>
                <c:pt idx="5967">
                  <c:v>2.9786619888161301</c:v>
                </c:pt>
                <c:pt idx="5968">
                  <c:v>3.1541992624205801</c:v>
                </c:pt>
                <c:pt idx="5969">
                  <c:v>2.33519964720954</c:v>
                </c:pt>
                <c:pt idx="5970">
                  <c:v>2.46548699130323</c:v>
                </c:pt>
                <c:pt idx="5971">
                  <c:v>2.9386399486011601</c:v>
                </c:pt>
                <c:pt idx="5972">
                  <c:v>3.3508247740720498</c:v>
                </c:pt>
                <c:pt idx="5973">
                  <c:v>2.6268893551535299</c:v>
                </c:pt>
                <c:pt idx="5974">
                  <c:v>2.2753772535762402</c:v>
                </c:pt>
                <c:pt idx="5975">
                  <c:v>2.6256232951061702</c:v>
                </c:pt>
                <c:pt idx="5976">
                  <c:v>2.3404200029099198</c:v>
                </c:pt>
                <c:pt idx="5977">
                  <c:v>2.6712252900796898</c:v>
                </c:pt>
                <c:pt idx="5978">
                  <c:v>2.6317440654841699</c:v>
                </c:pt>
                <c:pt idx="5979">
                  <c:v>2.5934522194559602</c:v>
                </c:pt>
                <c:pt idx="5980">
                  <c:v>2.4304724735296901</c:v>
                </c:pt>
                <c:pt idx="5981">
                  <c:v>2.4751530323464199</c:v>
                </c:pt>
                <c:pt idx="5982">
                  <c:v>2.5079194247438301</c:v>
                </c:pt>
                <c:pt idx="5983">
                  <c:v>2.6681288281232498</c:v>
                </c:pt>
                <c:pt idx="5984">
                  <c:v>2.74423930157017</c:v>
                </c:pt>
                <c:pt idx="5985">
                  <c:v>2.6181608028247698</c:v>
                </c:pt>
                <c:pt idx="5986">
                  <c:v>2.8258492269568398</c:v>
                </c:pt>
                <c:pt idx="5987">
                  <c:v>2.4764414055263599</c:v>
                </c:pt>
                <c:pt idx="5988">
                  <c:v>3.5717102231121101</c:v>
                </c:pt>
                <c:pt idx="5989">
                  <c:v>2.9368847081024101</c:v>
                </c:pt>
                <c:pt idx="5990">
                  <c:v>2.7695099769404599</c:v>
                </c:pt>
                <c:pt idx="5991">
                  <c:v>2.7699047185471399</c:v>
                </c:pt>
                <c:pt idx="5992">
                  <c:v>2.7019772922046799</c:v>
                </c:pt>
                <c:pt idx="5993">
                  <c:v>2.7174976818634802</c:v>
                </c:pt>
                <c:pt idx="5994">
                  <c:v>2.6049393651655901</c:v>
                </c:pt>
                <c:pt idx="5995">
                  <c:v>2.80216122432704</c:v>
                </c:pt>
                <c:pt idx="5996">
                  <c:v>2.91361339937241</c:v>
                </c:pt>
                <c:pt idx="5997">
                  <c:v>2.3550071802899302</c:v>
                </c:pt>
                <c:pt idx="5998">
                  <c:v>2.5023290793085802</c:v>
                </c:pt>
                <c:pt idx="5999">
                  <c:v>2.7382756255339999</c:v>
                </c:pt>
                <c:pt idx="6000">
                  <c:v>2.7753636564035</c:v>
                </c:pt>
                <c:pt idx="6001">
                  <c:v>2.94030733601506</c:v>
                </c:pt>
                <c:pt idx="6002">
                  <c:v>2.6136979267744098</c:v>
                </c:pt>
                <c:pt idx="6003">
                  <c:v>2.3694867293052999</c:v>
                </c:pt>
                <c:pt idx="6004">
                  <c:v>2.9825291315031102</c:v>
                </c:pt>
                <c:pt idx="6005">
                  <c:v>2.9819116935657202</c:v>
                </c:pt>
                <c:pt idx="6006">
                  <c:v>3.42605064985709</c:v>
                </c:pt>
                <c:pt idx="6007">
                  <c:v>3.1026484171695801</c:v>
                </c:pt>
                <c:pt idx="6008">
                  <c:v>2.2881539103647399</c:v>
                </c:pt>
                <c:pt idx="6009">
                  <c:v>3.0569061095576799</c:v>
                </c:pt>
                <c:pt idx="6010">
                  <c:v>2.1855290457221699</c:v>
                </c:pt>
                <c:pt idx="6011">
                  <c:v>2.7262084589055</c:v>
                </c:pt>
                <c:pt idx="6012">
                  <c:v>2.76172180682136</c:v>
                </c:pt>
                <c:pt idx="6013">
                  <c:v>2.2512985201747799</c:v>
                </c:pt>
                <c:pt idx="6014">
                  <c:v>2.3595723265391402</c:v>
                </c:pt>
                <c:pt idx="6015">
                  <c:v>2.3631112466061701</c:v>
                </c:pt>
                <c:pt idx="6016">
                  <c:v>2.7633241072547099</c:v>
                </c:pt>
                <c:pt idx="6017">
                  <c:v>2.8991596725014599</c:v>
                </c:pt>
                <c:pt idx="6018">
                  <c:v>2.94568548788558</c:v>
                </c:pt>
                <c:pt idx="6019">
                  <c:v>2.7850899237016402</c:v>
                </c:pt>
                <c:pt idx="6020">
                  <c:v>3.2910833907702899</c:v>
                </c:pt>
                <c:pt idx="6021">
                  <c:v>2.68939155206222</c:v>
                </c:pt>
                <c:pt idx="6022">
                  <c:v>2.4780258821565302</c:v>
                </c:pt>
                <c:pt idx="6023">
                  <c:v>3.67601240040202</c:v>
                </c:pt>
                <c:pt idx="6024">
                  <c:v>2.7882648701606199</c:v>
                </c:pt>
                <c:pt idx="6025">
                  <c:v>3.1379762268062601</c:v>
                </c:pt>
                <c:pt idx="6026">
                  <c:v>2.8849366127893399</c:v>
                </c:pt>
                <c:pt idx="6027">
                  <c:v>3.5194930085474798</c:v>
                </c:pt>
                <c:pt idx="6028">
                  <c:v>3.1664655274993101</c:v>
                </c:pt>
                <c:pt idx="6029">
                  <c:v>3.9071073817151798</c:v>
                </c:pt>
                <c:pt idx="6030">
                  <c:v>3.09891206087815</c:v>
                </c:pt>
                <c:pt idx="6031">
                  <c:v>2.8279408108717901</c:v>
                </c:pt>
                <c:pt idx="6032">
                  <c:v>3.15856342704063</c:v>
                </c:pt>
                <c:pt idx="6033">
                  <c:v>2.5281241851696201</c:v>
                </c:pt>
                <c:pt idx="6034">
                  <c:v>3.0029646856847698</c:v>
                </c:pt>
                <c:pt idx="6035">
                  <c:v>2.6372110111049798</c:v>
                </c:pt>
                <c:pt idx="6036">
                  <c:v>3.34742673733497</c:v>
                </c:pt>
                <c:pt idx="6037">
                  <c:v>3.5217948221838302</c:v>
                </c:pt>
                <c:pt idx="6038">
                  <c:v>3.4956530883362502</c:v>
                </c:pt>
                <c:pt idx="6039">
                  <c:v>2.8808823899666298</c:v>
                </c:pt>
                <c:pt idx="6040">
                  <c:v>3.4439485496436602</c:v>
                </c:pt>
                <c:pt idx="6041">
                  <c:v>3.33706337890154</c:v>
                </c:pt>
                <c:pt idx="6042">
                  <c:v>2.8735434089700198</c:v>
                </c:pt>
                <c:pt idx="6043">
                  <c:v>2.34375696477341</c:v>
                </c:pt>
                <c:pt idx="6044">
                  <c:v>2.7084277947319699</c:v>
                </c:pt>
                <c:pt idx="6045">
                  <c:v>3.1739919750071302</c:v>
                </c:pt>
                <c:pt idx="6046">
                  <c:v>3.4060477249341798</c:v>
                </c:pt>
                <c:pt idx="6047">
                  <c:v>2.68800992416684</c:v>
                </c:pt>
                <c:pt idx="6048">
                  <c:v>3.7096377822562201</c:v>
                </c:pt>
                <c:pt idx="6049">
                  <c:v>3.7985866506481099</c:v>
                </c:pt>
                <c:pt idx="6050">
                  <c:v>3.6211867572340801</c:v>
                </c:pt>
                <c:pt idx="6051">
                  <c:v>4.1799673176835901</c:v>
                </c:pt>
                <c:pt idx="6052">
                  <c:v>3.8774415239560498</c:v>
                </c:pt>
                <c:pt idx="6053">
                  <c:v>3.8596175581173702</c:v>
                </c:pt>
                <c:pt idx="6054">
                  <c:v>3.8483328670081098</c:v>
                </c:pt>
                <c:pt idx="6055">
                  <c:v>4.2586629071788398</c:v>
                </c:pt>
                <c:pt idx="6056">
                  <c:v>4.0652269346805801</c:v>
                </c:pt>
                <c:pt idx="6057">
                  <c:v>3.7212833870603599</c:v>
                </c:pt>
                <c:pt idx="6058">
                  <c:v>3.3304578593817902</c:v>
                </c:pt>
                <c:pt idx="6059">
                  <c:v>3.3938829878433698</c:v>
                </c:pt>
                <c:pt idx="6060">
                  <c:v>3.76896700548278</c:v>
                </c:pt>
                <c:pt idx="6061">
                  <c:v>3.4571096676913999</c:v>
                </c:pt>
                <c:pt idx="6062">
                  <c:v>3.0493749110818702</c:v>
                </c:pt>
                <c:pt idx="6063">
                  <c:v>3.46719343136937</c:v>
                </c:pt>
                <c:pt idx="6064">
                  <c:v>3.5995548757765801</c:v>
                </c:pt>
                <c:pt idx="6065">
                  <c:v>3.6583761461630702</c:v>
                </c:pt>
                <c:pt idx="6066">
                  <c:v>3.7096262888128302</c:v>
                </c:pt>
                <c:pt idx="6067">
                  <c:v>3.1824119558881998</c:v>
                </c:pt>
                <c:pt idx="6068">
                  <c:v>3.21002804789478</c:v>
                </c:pt>
                <c:pt idx="6069">
                  <c:v>3.4455244502325102</c:v>
                </c:pt>
                <c:pt idx="6070">
                  <c:v>3.38576843725459</c:v>
                </c:pt>
                <c:pt idx="6071">
                  <c:v>3.0038159511724798</c:v>
                </c:pt>
                <c:pt idx="6072">
                  <c:v>3.40506996044622</c:v>
                </c:pt>
                <c:pt idx="6073">
                  <c:v>3.6628390672212299</c:v>
                </c:pt>
                <c:pt idx="6074">
                  <c:v>3.5720511533346002</c:v>
                </c:pt>
                <c:pt idx="6075">
                  <c:v>3.3653249826034801</c:v>
                </c:pt>
                <c:pt idx="6076">
                  <c:v>3.3540551470617399</c:v>
                </c:pt>
                <c:pt idx="6077">
                  <c:v>3.4372173181702199</c:v>
                </c:pt>
                <c:pt idx="6078">
                  <c:v>2.9919291343003098</c:v>
                </c:pt>
                <c:pt idx="6079">
                  <c:v>3.1131856834501401</c:v>
                </c:pt>
                <c:pt idx="6080">
                  <c:v>2.6484555591914201</c:v>
                </c:pt>
                <c:pt idx="6081">
                  <c:v>3.0921694520280298</c:v>
                </c:pt>
                <c:pt idx="6082">
                  <c:v>3.5005940627477501</c:v>
                </c:pt>
                <c:pt idx="6083">
                  <c:v>3.4210249243303599</c:v>
                </c:pt>
                <c:pt idx="6084">
                  <c:v>3.4524591007493401</c:v>
                </c:pt>
                <c:pt idx="6085">
                  <c:v>2.99852063596781</c:v>
                </c:pt>
                <c:pt idx="6086">
                  <c:v>3.1770637943768598</c:v>
                </c:pt>
                <c:pt idx="6087">
                  <c:v>3.3429754761792401</c:v>
                </c:pt>
                <c:pt idx="6088">
                  <c:v>3.1240798540096</c:v>
                </c:pt>
                <c:pt idx="6089">
                  <c:v>3.68445472915678</c:v>
                </c:pt>
                <c:pt idx="6090">
                  <c:v>3.0102237026753502</c:v>
                </c:pt>
                <c:pt idx="6091">
                  <c:v>2.5903441981709898</c:v>
                </c:pt>
                <c:pt idx="6092">
                  <c:v>3.2110048563732301</c:v>
                </c:pt>
                <c:pt idx="6093">
                  <c:v>2.7565168207212398</c:v>
                </c:pt>
                <c:pt idx="6094">
                  <c:v>3.2030724177901502</c:v>
                </c:pt>
                <c:pt idx="6095">
                  <c:v>2.4817389173719802</c:v>
                </c:pt>
                <c:pt idx="6096">
                  <c:v>2.76751717322289</c:v>
                </c:pt>
                <c:pt idx="6097">
                  <c:v>2.5325159137122699</c:v>
                </c:pt>
                <c:pt idx="6098">
                  <c:v>2.3448031163428</c:v>
                </c:pt>
                <c:pt idx="6099">
                  <c:v>2.4776218259329101</c:v>
                </c:pt>
                <c:pt idx="6100">
                  <c:v>2.7479641283017999</c:v>
                </c:pt>
                <c:pt idx="6101">
                  <c:v>2.6137691495272302</c:v>
                </c:pt>
                <c:pt idx="6102">
                  <c:v>2.4724008518938501</c:v>
                </c:pt>
                <c:pt idx="6103">
                  <c:v>2.6771227276449099</c:v>
                </c:pt>
                <c:pt idx="6104">
                  <c:v>3.0372020350805502</c:v>
                </c:pt>
                <c:pt idx="6105">
                  <c:v>3.1994100547223501</c:v>
                </c:pt>
                <c:pt idx="6106">
                  <c:v>2.8277435649785501</c:v>
                </c:pt>
                <c:pt idx="6107">
                  <c:v>2.5549321981963802</c:v>
                </c:pt>
                <c:pt idx="6108">
                  <c:v>2.14290610242</c:v>
                </c:pt>
                <c:pt idx="6109">
                  <c:v>2.9962267299495</c:v>
                </c:pt>
                <c:pt idx="6110">
                  <c:v>3.1310845839798702</c:v>
                </c:pt>
                <c:pt idx="6111">
                  <c:v>2.99334006275864</c:v>
                </c:pt>
                <c:pt idx="6112">
                  <c:v>2.30628349887284</c:v>
                </c:pt>
                <c:pt idx="6113">
                  <c:v>3.21852356114807</c:v>
                </c:pt>
                <c:pt idx="6114">
                  <c:v>3.2229773246338702</c:v>
                </c:pt>
                <c:pt idx="6115">
                  <c:v>2.94777366727482</c:v>
                </c:pt>
                <c:pt idx="6116">
                  <c:v>2.7557608796644302</c:v>
                </c:pt>
                <c:pt idx="6117">
                  <c:v>2.7941483693621398</c:v>
                </c:pt>
                <c:pt idx="6118">
                  <c:v>3.1542659183214501</c:v>
                </c:pt>
                <c:pt idx="6119">
                  <c:v>3.0780733848417401</c:v>
                </c:pt>
                <c:pt idx="6120">
                  <c:v>2.6323488186085502</c:v>
                </c:pt>
                <c:pt idx="6121">
                  <c:v>2.67324446658938</c:v>
                </c:pt>
                <c:pt idx="6122">
                  <c:v>2.6685513802191698</c:v>
                </c:pt>
                <c:pt idx="6123">
                  <c:v>3.63778824873881</c:v>
                </c:pt>
                <c:pt idx="6124">
                  <c:v>3.1715723553624202</c:v>
                </c:pt>
                <c:pt idx="6125">
                  <c:v>2.8345056119223</c:v>
                </c:pt>
                <c:pt idx="6126">
                  <c:v>3.0364883254464599</c:v>
                </c:pt>
                <c:pt idx="6127">
                  <c:v>3.4091099532487199</c:v>
                </c:pt>
                <c:pt idx="6128">
                  <c:v>3.2187360174440101</c:v>
                </c:pt>
                <c:pt idx="6129">
                  <c:v>3.29176941316766</c:v>
                </c:pt>
                <c:pt idx="6130">
                  <c:v>3.2857420876451102</c:v>
                </c:pt>
                <c:pt idx="6131">
                  <c:v>2.6602180014495</c:v>
                </c:pt>
                <c:pt idx="6132">
                  <c:v>2.7976246236454601</c:v>
                </c:pt>
                <c:pt idx="6133">
                  <c:v>3.1317623513941801</c:v>
                </c:pt>
                <c:pt idx="6134">
                  <c:v>2.8641970726839499</c:v>
                </c:pt>
                <c:pt idx="6135">
                  <c:v>3.2138211944461701</c:v>
                </c:pt>
                <c:pt idx="6136">
                  <c:v>2.73230252144287</c:v>
                </c:pt>
                <c:pt idx="6137">
                  <c:v>2.6192797088623401</c:v>
                </c:pt>
                <c:pt idx="6138">
                  <c:v>2.8123050271430099</c:v>
                </c:pt>
                <c:pt idx="6139">
                  <c:v>2.93118225996631</c:v>
                </c:pt>
                <c:pt idx="6140">
                  <c:v>2.60201695419667</c:v>
                </c:pt>
                <c:pt idx="6141">
                  <c:v>2.6138829666491601</c:v>
                </c:pt>
                <c:pt idx="6142">
                  <c:v>2.3899753445644198</c:v>
                </c:pt>
                <c:pt idx="6143">
                  <c:v>2.6746133493355901</c:v>
                </c:pt>
                <c:pt idx="6144">
                  <c:v>3.2055080800310698</c:v>
                </c:pt>
                <c:pt idx="6145">
                  <c:v>2.7790455922274502</c:v>
                </c:pt>
                <c:pt idx="6146">
                  <c:v>2.64059957377841</c:v>
                </c:pt>
                <c:pt idx="6147">
                  <c:v>3.4081766260018398</c:v>
                </c:pt>
                <c:pt idx="6148">
                  <c:v>3.6796351110810299</c:v>
                </c:pt>
                <c:pt idx="6149">
                  <c:v>2.9117721498328399</c:v>
                </c:pt>
                <c:pt idx="6150">
                  <c:v>3.1140453672494499</c:v>
                </c:pt>
                <c:pt idx="6151">
                  <c:v>2.7022668707192601</c:v>
                </c:pt>
                <c:pt idx="6152">
                  <c:v>3.2938480511104</c:v>
                </c:pt>
                <c:pt idx="6153">
                  <c:v>3.3407167348176401</c:v>
                </c:pt>
                <c:pt idx="6154">
                  <c:v>2.8554953902556499</c:v>
                </c:pt>
                <c:pt idx="6155">
                  <c:v>3.0335171993895198</c:v>
                </c:pt>
                <c:pt idx="6156">
                  <c:v>3.2009452503184299</c:v>
                </c:pt>
                <c:pt idx="6157">
                  <c:v>3.28783138346411</c:v>
                </c:pt>
                <c:pt idx="6158">
                  <c:v>3.6255914215245002</c:v>
                </c:pt>
                <c:pt idx="6159">
                  <c:v>3.3204800359845699</c:v>
                </c:pt>
                <c:pt idx="6160">
                  <c:v>2.8611101115322501</c:v>
                </c:pt>
                <c:pt idx="6161">
                  <c:v>2.8823586186648802</c:v>
                </c:pt>
                <c:pt idx="6162">
                  <c:v>2.85248493711677</c:v>
                </c:pt>
                <c:pt idx="6163">
                  <c:v>2.77727747322003</c:v>
                </c:pt>
                <c:pt idx="6164">
                  <c:v>3.0369456665224499</c:v>
                </c:pt>
                <c:pt idx="6165">
                  <c:v>3.09069158055796</c:v>
                </c:pt>
                <c:pt idx="6166">
                  <c:v>2.74780884264367</c:v>
                </c:pt>
                <c:pt idx="6167">
                  <c:v>3.2991251785386901</c:v>
                </c:pt>
                <c:pt idx="6168">
                  <c:v>3.3584824958006201</c:v>
                </c:pt>
                <c:pt idx="6169">
                  <c:v>2.9099409012047701</c:v>
                </c:pt>
                <c:pt idx="6170">
                  <c:v>3.1912045402268299</c:v>
                </c:pt>
                <c:pt idx="6171">
                  <c:v>3.0816001869619201</c:v>
                </c:pt>
                <c:pt idx="6172">
                  <c:v>3.4901691033</c:v>
                </c:pt>
                <c:pt idx="6173">
                  <c:v>3.2682812657729898</c:v>
                </c:pt>
                <c:pt idx="6174">
                  <c:v>3.8491338992038799</c:v>
                </c:pt>
                <c:pt idx="6175">
                  <c:v>3.0856187563617699</c:v>
                </c:pt>
                <c:pt idx="6176">
                  <c:v>3.2152796034773599</c:v>
                </c:pt>
                <c:pt idx="6177">
                  <c:v>2.8149933337323101</c:v>
                </c:pt>
                <c:pt idx="6178">
                  <c:v>3.4384984462969501</c:v>
                </c:pt>
                <c:pt idx="6179">
                  <c:v>3.2332118973112798</c:v>
                </c:pt>
                <c:pt idx="6180">
                  <c:v>3.7549605285298702</c:v>
                </c:pt>
                <c:pt idx="6181">
                  <c:v>3.3423998817915899</c:v>
                </c:pt>
                <c:pt idx="6182">
                  <c:v>3.26658946608288</c:v>
                </c:pt>
                <c:pt idx="6183">
                  <c:v>3.1601250879516201</c:v>
                </c:pt>
                <c:pt idx="6184">
                  <c:v>3.5054564928112799</c:v>
                </c:pt>
                <c:pt idx="6185">
                  <c:v>3.5408963269668798</c:v>
                </c:pt>
                <c:pt idx="6186">
                  <c:v>3.2115189932899302</c:v>
                </c:pt>
                <c:pt idx="6187">
                  <c:v>3.2094844098594599</c:v>
                </c:pt>
                <c:pt idx="6188">
                  <c:v>3.3473970352329201</c:v>
                </c:pt>
                <c:pt idx="6189">
                  <c:v>2.7501592054249402</c:v>
                </c:pt>
                <c:pt idx="6190">
                  <c:v>3.5195283480273298</c:v>
                </c:pt>
                <c:pt idx="6191">
                  <c:v>3.01218615738044</c:v>
                </c:pt>
                <c:pt idx="6192">
                  <c:v>2.99514673543126</c:v>
                </c:pt>
                <c:pt idx="6193">
                  <c:v>3.25283902485369</c:v>
                </c:pt>
                <c:pt idx="6194">
                  <c:v>3.8753570891025602</c:v>
                </c:pt>
                <c:pt idx="6195">
                  <c:v>3.3402320002802601</c:v>
                </c:pt>
                <c:pt idx="6196">
                  <c:v>3.2040349186984498</c:v>
                </c:pt>
                <c:pt idx="6197">
                  <c:v>3.5070712554497798</c:v>
                </c:pt>
                <c:pt idx="6198">
                  <c:v>3.45356423513355</c:v>
                </c:pt>
                <c:pt idx="6199">
                  <c:v>3.2561648917022499</c:v>
                </c:pt>
                <c:pt idx="6200">
                  <c:v>3.5554352379172598</c:v>
                </c:pt>
                <c:pt idx="6201">
                  <c:v>3.4173494346250699</c:v>
                </c:pt>
                <c:pt idx="6202">
                  <c:v>3.4238852438319398</c:v>
                </c:pt>
                <c:pt idx="6203">
                  <c:v>3.12970221317123</c:v>
                </c:pt>
                <c:pt idx="6204">
                  <c:v>2.9128798185346501</c:v>
                </c:pt>
                <c:pt idx="6205">
                  <c:v>2.8882359368928898</c:v>
                </c:pt>
                <c:pt idx="6206">
                  <c:v>2.7353075252987198</c:v>
                </c:pt>
                <c:pt idx="6207">
                  <c:v>2.5962586930225999</c:v>
                </c:pt>
                <c:pt idx="6208">
                  <c:v>3.2935288088317001</c:v>
                </c:pt>
                <c:pt idx="6209">
                  <c:v>3.0296205461125099</c:v>
                </c:pt>
                <c:pt idx="6210">
                  <c:v>2.7116258838837499</c:v>
                </c:pt>
                <c:pt idx="6211">
                  <c:v>2.7343759890322099</c:v>
                </c:pt>
                <c:pt idx="6212">
                  <c:v>3.0460875756820101</c:v>
                </c:pt>
                <c:pt idx="6213">
                  <c:v>2.5819912482492899</c:v>
                </c:pt>
                <c:pt idx="6214">
                  <c:v>2.9956497920903602</c:v>
                </c:pt>
                <c:pt idx="6215">
                  <c:v>3.15721827903098</c:v>
                </c:pt>
                <c:pt idx="6216">
                  <c:v>2.8277219647387102</c:v>
                </c:pt>
                <c:pt idx="6217">
                  <c:v>2.5430599282551198</c:v>
                </c:pt>
                <c:pt idx="6218">
                  <c:v>2.9424409414902102</c:v>
                </c:pt>
                <c:pt idx="6219">
                  <c:v>3.38601518026561</c:v>
                </c:pt>
                <c:pt idx="6220">
                  <c:v>3.5117990505701702</c:v>
                </c:pt>
                <c:pt idx="6221">
                  <c:v>3.5461966506039801</c:v>
                </c:pt>
                <c:pt idx="6222">
                  <c:v>3.2478666957094799</c:v>
                </c:pt>
                <c:pt idx="6223">
                  <c:v>2.6912310860493398</c:v>
                </c:pt>
                <c:pt idx="6224">
                  <c:v>3.0993080462532001</c:v>
                </c:pt>
                <c:pt idx="6225">
                  <c:v>3.2224114400451702</c:v>
                </c:pt>
                <c:pt idx="6226">
                  <c:v>2.7413844019985101</c:v>
                </c:pt>
                <c:pt idx="6227">
                  <c:v>2.93073659879563</c:v>
                </c:pt>
                <c:pt idx="6228">
                  <c:v>3.52909371115474</c:v>
                </c:pt>
                <c:pt idx="6229">
                  <c:v>2.9218394924748701</c:v>
                </c:pt>
                <c:pt idx="6230">
                  <c:v>3.6127535632782202</c:v>
                </c:pt>
                <c:pt idx="6231">
                  <c:v>3.0373209585238499</c:v>
                </c:pt>
                <c:pt idx="6232">
                  <c:v>2.3698494328481798</c:v>
                </c:pt>
                <c:pt idx="6233">
                  <c:v>2.9368575495628901</c:v>
                </c:pt>
                <c:pt idx="6234">
                  <c:v>2.38167657329504</c:v>
                </c:pt>
                <c:pt idx="6235">
                  <c:v>3.0010837187702002</c:v>
                </c:pt>
                <c:pt idx="6236">
                  <c:v>2.9110584094054102</c:v>
                </c:pt>
                <c:pt idx="6237">
                  <c:v>2.5864050916349699</c:v>
                </c:pt>
                <c:pt idx="6238">
                  <c:v>2.6734860426959699</c:v>
                </c:pt>
                <c:pt idx="6239">
                  <c:v>2.8153056434472501</c:v>
                </c:pt>
                <c:pt idx="6240">
                  <c:v>3.0336722838581398</c:v>
                </c:pt>
                <c:pt idx="6241">
                  <c:v>2.4201920255880101</c:v>
                </c:pt>
                <c:pt idx="6242">
                  <c:v>2.5371989898847702</c:v>
                </c:pt>
                <c:pt idx="6243">
                  <c:v>3.0794135846953901</c:v>
                </c:pt>
                <c:pt idx="6244">
                  <c:v>2.6926006231322699</c:v>
                </c:pt>
                <c:pt idx="6245">
                  <c:v>2.3619011840992901</c:v>
                </c:pt>
                <c:pt idx="6246">
                  <c:v>3.3063329130020098</c:v>
                </c:pt>
                <c:pt idx="6247">
                  <c:v>2.6395440785335298</c:v>
                </c:pt>
                <c:pt idx="6248">
                  <c:v>2.3620181432419902</c:v>
                </c:pt>
                <c:pt idx="6249">
                  <c:v>3.09236358896097</c:v>
                </c:pt>
                <c:pt idx="6250">
                  <c:v>2.7146416994623102</c:v>
                </c:pt>
                <c:pt idx="6251">
                  <c:v>3.0726572134774801</c:v>
                </c:pt>
                <c:pt idx="6252">
                  <c:v>2.23607226902103</c:v>
                </c:pt>
                <c:pt idx="6253">
                  <c:v>3.77487845785565</c:v>
                </c:pt>
                <c:pt idx="6254">
                  <c:v>2.99990957281197</c:v>
                </c:pt>
                <c:pt idx="6255">
                  <c:v>2.7728365667119701</c:v>
                </c:pt>
                <c:pt idx="6256">
                  <c:v>3.3131582567001598</c:v>
                </c:pt>
                <c:pt idx="6257">
                  <c:v>2.7137360162765201</c:v>
                </c:pt>
                <c:pt idx="6258">
                  <c:v>2.6969093723619602</c:v>
                </c:pt>
                <c:pt idx="6259">
                  <c:v>3.1711667705503799</c:v>
                </c:pt>
                <c:pt idx="6260">
                  <c:v>2.7855646956892599</c:v>
                </c:pt>
                <c:pt idx="6261">
                  <c:v>3.6325795792514501</c:v>
                </c:pt>
                <c:pt idx="6262">
                  <c:v>4.1634676636584702</c:v>
                </c:pt>
                <c:pt idx="6263">
                  <c:v>3.5252535975616102</c:v>
                </c:pt>
                <c:pt idx="6264">
                  <c:v>3.3908277811426801</c:v>
                </c:pt>
                <c:pt idx="6265">
                  <c:v>3.38961149203217</c:v>
                </c:pt>
                <c:pt idx="6266">
                  <c:v>4.0563480661036504</c:v>
                </c:pt>
                <c:pt idx="6267">
                  <c:v>3.8955446612848701</c:v>
                </c:pt>
                <c:pt idx="6268">
                  <c:v>3.4805216559393202</c:v>
                </c:pt>
                <c:pt idx="6269">
                  <c:v>3.2746540946909701</c:v>
                </c:pt>
                <c:pt idx="6270">
                  <c:v>3.46773520127336</c:v>
                </c:pt>
                <c:pt idx="6271">
                  <c:v>3.8771896113688902</c:v>
                </c:pt>
                <c:pt idx="6272">
                  <c:v>3.22242333652428</c:v>
                </c:pt>
                <c:pt idx="6273">
                  <c:v>3.66354021420742</c:v>
                </c:pt>
                <c:pt idx="6274">
                  <c:v>3.7650833978210101</c:v>
                </c:pt>
                <c:pt idx="6275">
                  <c:v>3.82760651349655</c:v>
                </c:pt>
                <c:pt idx="6276">
                  <c:v>4.0353124795132702</c:v>
                </c:pt>
                <c:pt idx="6277">
                  <c:v>3.8274499196429699</c:v>
                </c:pt>
                <c:pt idx="6278">
                  <c:v>3.2812266003056698</c:v>
                </c:pt>
                <c:pt idx="6279">
                  <c:v>3.1327323327926302</c:v>
                </c:pt>
                <c:pt idx="6280">
                  <c:v>3.5527163534869102</c:v>
                </c:pt>
                <c:pt idx="6281">
                  <c:v>3.4693323243521199</c:v>
                </c:pt>
                <c:pt idx="6282">
                  <c:v>3.1926657842155701</c:v>
                </c:pt>
                <c:pt idx="6283">
                  <c:v>2.50155173480834</c:v>
                </c:pt>
                <c:pt idx="6284">
                  <c:v>2.9154468043954398</c:v>
                </c:pt>
                <c:pt idx="6285">
                  <c:v>3.0692991260793399</c:v>
                </c:pt>
                <c:pt idx="6286">
                  <c:v>3.5041312176983501</c:v>
                </c:pt>
                <c:pt idx="6287">
                  <c:v>3.19412054551292</c:v>
                </c:pt>
                <c:pt idx="6288">
                  <c:v>3.2909996710353</c:v>
                </c:pt>
                <c:pt idx="6289">
                  <c:v>2.9443530242288301</c:v>
                </c:pt>
                <c:pt idx="6290">
                  <c:v>2.95599464464425</c:v>
                </c:pt>
                <c:pt idx="6291">
                  <c:v>2.6455457691012501</c:v>
                </c:pt>
                <c:pt idx="6292">
                  <c:v>2.8454378441860899</c:v>
                </c:pt>
                <c:pt idx="6293">
                  <c:v>2.8476180516267302</c:v>
                </c:pt>
                <c:pt idx="6294">
                  <c:v>1.8742448501145399</c:v>
                </c:pt>
                <c:pt idx="6295">
                  <c:v>1.92685486467181</c:v>
                </c:pt>
                <c:pt idx="6296">
                  <c:v>3.3517614470001398</c:v>
                </c:pt>
                <c:pt idx="6297">
                  <c:v>2.7540373905958599</c:v>
                </c:pt>
                <c:pt idx="6298">
                  <c:v>2.5696696720780401</c:v>
                </c:pt>
                <c:pt idx="6299">
                  <c:v>2.5101359725269701</c:v>
                </c:pt>
                <c:pt idx="6300">
                  <c:v>2.9924181031933599</c:v>
                </c:pt>
                <c:pt idx="6301">
                  <c:v>3.2055264476956098</c:v>
                </c:pt>
                <c:pt idx="6302">
                  <c:v>3.14962822990229</c:v>
                </c:pt>
                <c:pt idx="6303">
                  <c:v>3.09187938207711</c:v>
                </c:pt>
                <c:pt idx="6304">
                  <c:v>2.2721936866436199</c:v>
                </c:pt>
                <c:pt idx="6305">
                  <c:v>2.6082555628995201</c:v>
                </c:pt>
                <c:pt idx="6306">
                  <c:v>2.9557274287420898</c:v>
                </c:pt>
                <c:pt idx="6307">
                  <c:v>2.3879869115867902</c:v>
                </c:pt>
                <c:pt idx="6308">
                  <c:v>3.3307584730148601</c:v>
                </c:pt>
                <c:pt idx="6309">
                  <c:v>2.7429916100540801</c:v>
                </c:pt>
                <c:pt idx="6310">
                  <c:v>3.7402634372472399</c:v>
                </c:pt>
                <c:pt idx="6311">
                  <c:v>3.29494676961263</c:v>
                </c:pt>
                <c:pt idx="6312">
                  <c:v>2.9464263443800598</c:v>
                </c:pt>
                <c:pt idx="6313">
                  <c:v>2.5632260351083498</c:v>
                </c:pt>
                <c:pt idx="6314">
                  <c:v>3.3381134575267999</c:v>
                </c:pt>
                <c:pt idx="6315">
                  <c:v>2.9804623889723101</c:v>
                </c:pt>
                <c:pt idx="6316">
                  <c:v>3.3974281757055098</c:v>
                </c:pt>
                <c:pt idx="6317">
                  <c:v>3.7268540152994798</c:v>
                </c:pt>
                <c:pt idx="6318">
                  <c:v>3.3469143257824698</c:v>
                </c:pt>
                <c:pt idx="6319">
                  <c:v>3.2412739913714099</c:v>
                </c:pt>
                <c:pt idx="6320">
                  <c:v>2.8299036177874499</c:v>
                </c:pt>
                <c:pt idx="6321">
                  <c:v>3.7454027806775199</c:v>
                </c:pt>
                <c:pt idx="6322">
                  <c:v>3.7171286469467799</c:v>
                </c:pt>
                <c:pt idx="6323">
                  <c:v>3.1568276217997702</c:v>
                </c:pt>
                <c:pt idx="6324">
                  <c:v>3.7651478543983901</c:v>
                </c:pt>
                <c:pt idx="6325">
                  <c:v>2.8415680469914402</c:v>
                </c:pt>
                <c:pt idx="6326">
                  <c:v>2.7801150796314502</c:v>
                </c:pt>
                <c:pt idx="6327">
                  <c:v>2.7827269910785799</c:v>
                </c:pt>
                <c:pt idx="6328">
                  <c:v>2.98370078532998</c:v>
                </c:pt>
                <c:pt idx="6329">
                  <c:v>2.9447681838028599</c:v>
                </c:pt>
                <c:pt idx="6330">
                  <c:v>2.9881867936421398</c:v>
                </c:pt>
                <c:pt idx="6331">
                  <c:v>2.7999527442957102</c:v>
                </c:pt>
                <c:pt idx="6332">
                  <c:v>2.2039741228013501</c:v>
                </c:pt>
                <c:pt idx="6333">
                  <c:v>3.1076906684029102</c:v>
                </c:pt>
                <c:pt idx="6334">
                  <c:v>3.0621843835137401</c:v>
                </c:pt>
                <c:pt idx="6335">
                  <c:v>2.71774674425478</c:v>
                </c:pt>
                <c:pt idx="6336">
                  <c:v>2.9507864554192502</c:v>
                </c:pt>
                <c:pt idx="6337">
                  <c:v>2.5071203968133098</c:v>
                </c:pt>
                <c:pt idx="6338">
                  <c:v>3.4884147460535</c:v>
                </c:pt>
                <c:pt idx="6339">
                  <c:v>3.3331774570584001</c:v>
                </c:pt>
                <c:pt idx="6340">
                  <c:v>3.27128099528242</c:v>
                </c:pt>
                <c:pt idx="6341">
                  <c:v>2.6369444826496</c:v>
                </c:pt>
                <c:pt idx="6342">
                  <c:v>3.1317189476545102</c:v>
                </c:pt>
                <c:pt idx="6343">
                  <c:v>3.3395737078224799</c:v>
                </c:pt>
                <c:pt idx="6344">
                  <c:v>2.7380944058988299</c:v>
                </c:pt>
                <c:pt idx="6345">
                  <c:v>2.7617053761814399</c:v>
                </c:pt>
                <c:pt idx="6346">
                  <c:v>3.30143160245508</c:v>
                </c:pt>
                <c:pt idx="6347">
                  <c:v>3.08247194199576</c:v>
                </c:pt>
                <c:pt idx="6348">
                  <c:v>2.7760254091063099</c:v>
                </c:pt>
                <c:pt idx="6349">
                  <c:v>3.02449538541642</c:v>
                </c:pt>
                <c:pt idx="6350">
                  <c:v>2.4806343048538202</c:v>
                </c:pt>
                <c:pt idx="6351">
                  <c:v>2.8492649375358399</c:v>
                </c:pt>
                <c:pt idx="6352">
                  <c:v>1.9813114070014</c:v>
                </c:pt>
                <c:pt idx="6353">
                  <c:v>2.5084993773259701</c:v>
                </c:pt>
                <c:pt idx="6354">
                  <c:v>3.21746270980793</c:v>
                </c:pt>
                <c:pt idx="6355">
                  <c:v>3.18570300448128</c:v>
                </c:pt>
                <c:pt idx="6356">
                  <c:v>2.6665149814163698</c:v>
                </c:pt>
                <c:pt idx="6357">
                  <c:v>2.6674492584609499</c:v>
                </c:pt>
                <c:pt idx="6358">
                  <c:v>2.80579839042881</c:v>
                </c:pt>
                <c:pt idx="6359">
                  <c:v>2.8616817896092299</c:v>
                </c:pt>
                <c:pt idx="6360">
                  <c:v>2.5367853885113498</c:v>
                </c:pt>
                <c:pt idx="6361">
                  <c:v>2.1813104411918101</c:v>
                </c:pt>
                <c:pt idx="6362">
                  <c:v>2.4649080829179</c:v>
                </c:pt>
                <c:pt idx="6363">
                  <c:v>2.8431128126119201</c:v>
                </c:pt>
                <c:pt idx="6364">
                  <c:v>2.3027271644358298</c:v>
                </c:pt>
                <c:pt idx="6365">
                  <c:v>2.5114128659279999</c:v>
                </c:pt>
                <c:pt idx="6366">
                  <c:v>2.6924690385407599</c:v>
                </c:pt>
                <c:pt idx="6367">
                  <c:v>2.6298738131787802</c:v>
                </c:pt>
                <c:pt idx="6368">
                  <c:v>2.5137229447884799</c:v>
                </c:pt>
                <c:pt idx="6369">
                  <c:v>2.5191844816659201</c:v>
                </c:pt>
                <c:pt idx="6370">
                  <c:v>2.64996447447214</c:v>
                </c:pt>
                <c:pt idx="6371">
                  <c:v>2.72477443150329</c:v>
                </c:pt>
                <c:pt idx="6372">
                  <c:v>2.95592202831899</c:v>
                </c:pt>
                <c:pt idx="6373">
                  <c:v>2.7985210410396801</c:v>
                </c:pt>
                <c:pt idx="6374">
                  <c:v>2.1348465100917302</c:v>
                </c:pt>
                <c:pt idx="6375">
                  <c:v>2.76593101176837</c:v>
                </c:pt>
                <c:pt idx="6376">
                  <c:v>2.4080689384086198</c:v>
                </c:pt>
                <c:pt idx="6377">
                  <c:v>2.3010407334825702</c:v>
                </c:pt>
                <c:pt idx="6378">
                  <c:v>1.9633873689538199</c:v>
                </c:pt>
                <c:pt idx="6379">
                  <c:v>2.1775062319838501</c:v>
                </c:pt>
                <c:pt idx="6380">
                  <c:v>2.91731600098462</c:v>
                </c:pt>
                <c:pt idx="6381">
                  <c:v>2.1417396241439701</c:v>
                </c:pt>
                <c:pt idx="6382">
                  <c:v>2.2503569680246498</c:v>
                </c:pt>
                <c:pt idx="6383">
                  <c:v>2.6340112453804401</c:v>
                </c:pt>
                <c:pt idx="6384">
                  <c:v>2.6177912722337702</c:v>
                </c:pt>
                <c:pt idx="6385">
                  <c:v>2.7184388248703799</c:v>
                </c:pt>
                <c:pt idx="6386">
                  <c:v>2.5656889539560601</c:v>
                </c:pt>
                <c:pt idx="6387">
                  <c:v>2.0619325329429401</c:v>
                </c:pt>
                <c:pt idx="6388">
                  <c:v>2.5015749030446801</c:v>
                </c:pt>
                <c:pt idx="6389">
                  <c:v>3.0929266845713301</c:v>
                </c:pt>
                <c:pt idx="6390">
                  <c:v>3.0918708294617301</c:v>
                </c:pt>
                <c:pt idx="6391">
                  <c:v>2.8287748322641799</c:v>
                </c:pt>
                <c:pt idx="6392">
                  <c:v>2.7726326828924899</c:v>
                </c:pt>
                <c:pt idx="6393">
                  <c:v>2.6179728450692901</c:v>
                </c:pt>
                <c:pt idx="6394">
                  <c:v>2.3856135159654999</c:v>
                </c:pt>
                <c:pt idx="6395">
                  <c:v>2.6892012642222798</c:v>
                </c:pt>
                <c:pt idx="6396">
                  <c:v>2.4104891580082102</c:v>
                </c:pt>
                <c:pt idx="6397">
                  <c:v>2.8291286847739001</c:v>
                </c:pt>
                <c:pt idx="6398">
                  <c:v>3.1321707310271898</c:v>
                </c:pt>
                <c:pt idx="6399">
                  <c:v>2.5812753728819202</c:v>
                </c:pt>
                <c:pt idx="6400">
                  <c:v>2.7983593846910599</c:v>
                </c:pt>
                <c:pt idx="6401">
                  <c:v>2.5754663993568299</c:v>
                </c:pt>
                <c:pt idx="6402">
                  <c:v>2.87297967477424</c:v>
                </c:pt>
                <c:pt idx="6403">
                  <c:v>2.7873059554103099</c:v>
                </c:pt>
                <c:pt idx="6404">
                  <c:v>2.4251807457735</c:v>
                </c:pt>
                <c:pt idx="6405">
                  <c:v>2.9755577708739298</c:v>
                </c:pt>
                <c:pt idx="6406">
                  <c:v>3.0259756470812</c:v>
                </c:pt>
                <c:pt idx="6407">
                  <c:v>2.5305885983990701</c:v>
                </c:pt>
                <c:pt idx="6408">
                  <c:v>2.8785569478619202</c:v>
                </c:pt>
                <c:pt idx="6409">
                  <c:v>3.4548281415584698</c:v>
                </c:pt>
                <c:pt idx="6410">
                  <c:v>3.59342763887636</c:v>
                </c:pt>
                <c:pt idx="6411">
                  <c:v>2.5732908836090398</c:v>
                </c:pt>
                <c:pt idx="6412">
                  <c:v>3.08308082013914</c:v>
                </c:pt>
                <c:pt idx="6413">
                  <c:v>3.0599307396835802</c:v>
                </c:pt>
                <c:pt idx="6414">
                  <c:v>2.9364868744147001</c:v>
                </c:pt>
                <c:pt idx="6415">
                  <c:v>3.0618523321963398</c:v>
                </c:pt>
                <c:pt idx="6416">
                  <c:v>2.8273793485739702</c:v>
                </c:pt>
                <c:pt idx="6417">
                  <c:v>2.82275394180789</c:v>
                </c:pt>
                <c:pt idx="6418">
                  <c:v>3.2462309523111599</c:v>
                </c:pt>
                <c:pt idx="6419">
                  <c:v>2.4621118542821199</c:v>
                </c:pt>
                <c:pt idx="6420">
                  <c:v>3.00341416839388</c:v>
                </c:pt>
                <c:pt idx="6421">
                  <c:v>2.8040918798280998</c:v>
                </c:pt>
                <c:pt idx="6422">
                  <c:v>1.98159705591696</c:v>
                </c:pt>
                <c:pt idx="6423">
                  <c:v>2.5877919441686101</c:v>
                </c:pt>
                <c:pt idx="6424">
                  <c:v>3.3724661353796299</c:v>
                </c:pt>
                <c:pt idx="6425">
                  <c:v>2.9249641265025601</c:v>
                </c:pt>
                <c:pt idx="6426">
                  <c:v>2.92643878809114</c:v>
                </c:pt>
                <c:pt idx="6427">
                  <c:v>2.39457791568082</c:v>
                </c:pt>
                <c:pt idx="6428">
                  <c:v>2.5968080578786101</c:v>
                </c:pt>
                <c:pt idx="6429">
                  <c:v>2.7756031730012198</c:v>
                </c:pt>
                <c:pt idx="6430">
                  <c:v>3.5264624467840502</c:v>
                </c:pt>
                <c:pt idx="6431">
                  <c:v>2.8364635607586499</c:v>
                </c:pt>
                <c:pt idx="6432">
                  <c:v>2.5952079376594099</c:v>
                </c:pt>
                <c:pt idx="6433">
                  <c:v>2.7190692505325802</c:v>
                </c:pt>
                <c:pt idx="6434">
                  <c:v>2.8991137462743701</c:v>
                </c:pt>
                <c:pt idx="6435">
                  <c:v>2.8579790886963798</c:v>
                </c:pt>
                <c:pt idx="6436">
                  <c:v>3.0805934790635101</c:v>
                </c:pt>
                <c:pt idx="6437">
                  <c:v>2.9307062834838402</c:v>
                </c:pt>
                <c:pt idx="6438">
                  <c:v>3.4024191603178502</c:v>
                </c:pt>
                <c:pt idx="6439">
                  <c:v>3.3075687900644799</c:v>
                </c:pt>
                <c:pt idx="6440">
                  <c:v>3.4377350902836001</c:v>
                </c:pt>
                <c:pt idx="6441">
                  <c:v>3.0771513602062202</c:v>
                </c:pt>
                <c:pt idx="6442">
                  <c:v>2.9197999528852301</c:v>
                </c:pt>
                <c:pt idx="6443">
                  <c:v>2.9872858244609399</c:v>
                </c:pt>
                <c:pt idx="6444">
                  <c:v>3.12154865015289</c:v>
                </c:pt>
                <c:pt idx="6445">
                  <c:v>3.1823592140627102</c:v>
                </c:pt>
                <c:pt idx="6446">
                  <c:v>3.2541575031640599</c:v>
                </c:pt>
                <c:pt idx="6447">
                  <c:v>2.9132863206529902</c:v>
                </c:pt>
                <c:pt idx="6448">
                  <c:v>2.7705309376056801</c:v>
                </c:pt>
                <c:pt idx="6449">
                  <c:v>2.1881340175839799</c:v>
                </c:pt>
                <c:pt idx="6450">
                  <c:v>2.9117228699484601</c:v>
                </c:pt>
                <c:pt idx="6451">
                  <c:v>3.10195847217945</c:v>
                </c:pt>
                <c:pt idx="6452">
                  <c:v>2.4104090187982101</c:v>
                </c:pt>
                <c:pt idx="6453">
                  <c:v>2.3873844362922498</c:v>
                </c:pt>
                <c:pt idx="6454">
                  <c:v>2.18593070364046</c:v>
                </c:pt>
                <c:pt idx="6455">
                  <c:v>2.5851842234329099</c:v>
                </c:pt>
                <c:pt idx="6456">
                  <c:v>2.39278664657679</c:v>
                </c:pt>
                <c:pt idx="6457">
                  <c:v>2.5202898255334798</c:v>
                </c:pt>
                <c:pt idx="6458">
                  <c:v>2.4182891536661</c:v>
                </c:pt>
                <c:pt idx="6459">
                  <c:v>2.1194246461307902</c:v>
                </c:pt>
                <c:pt idx="6460">
                  <c:v>2.7017751105979499</c:v>
                </c:pt>
                <c:pt idx="6461">
                  <c:v>2.84740504538581</c:v>
                </c:pt>
                <c:pt idx="6462">
                  <c:v>2.10068243677257</c:v>
                </c:pt>
                <c:pt idx="6463">
                  <c:v>2.16285945359071</c:v>
                </c:pt>
                <c:pt idx="6464">
                  <c:v>2.5272917472905498</c:v>
                </c:pt>
                <c:pt idx="6465">
                  <c:v>2.3830744746233301</c:v>
                </c:pt>
                <c:pt idx="6466">
                  <c:v>1.9280942857616701</c:v>
                </c:pt>
                <c:pt idx="6467">
                  <c:v>1.5286370166090699</c:v>
                </c:pt>
                <c:pt idx="6468">
                  <c:v>1.69889049654536</c:v>
                </c:pt>
                <c:pt idx="6469">
                  <c:v>2.0144311018962799</c:v>
                </c:pt>
                <c:pt idx="6470">
                  <c:v>2.3066530933964402</c:v>
                </c:pt>
                <c:pt idx="6471">
                  <c:v>1.89184375321813</c:v>
                </c:pt>
                <c:pt idx="6472">
                  <c:v>1.75148393761414</c:v>
                </c:pt>
                <c:pt idx="6473">
                  <c:v>1.4805469901267301</c:v>
                </c:pt>
                <c:pt idx="6474">
                  <c:v>2.0284789322872299</c:v>
                </c:pt>
                <c:pt idx="6475">
                  <c:v>1.7175183083824099</c:v>
                </c:pt>
                <c:pt idx="6476">
                  <c:v>2.19700090118419</c:v>
                </c:pt>
                <c:pt idx="6477">
                  <c:v>2.2446198413216401</c:v>
                </c:pt>
                <c:pt idx="6478">
                  <c:v>2.1599956123064898</c:v>
                </c:pt>
                <c:pt idx="6479">
                  <c:v>1.66705700982857</c:v>
                </c:pt>
                <c:pt idx="6480">
                  <c:v>1.7019207023899201</c:v>
                </c:pt>
                <c:pt idx="6481">
                  <c:v>1.79865244063135</c:v>
                </c:pt>
                <c:pt idx="6482">
                  <c:v>1.69350848903068</c:v>
                </c:pt>
                <c:pt idx="6483">
                  <c:v>2.1441347882020301</c:v>
                </c:pt>
                <c:pt idx="6484">
                  <c:v>2.0229528464194999</c:v>
                </c:pt>
                <c:pt idx="6485">
                  <c:v>1.72449167179429</c:v>
                </c:pt>
                <c:pt idx="6486">
                  <c:v>1.5385714512229101</c:v>
                </c:pt>
                <c:pt idx="6487">
                  <c:v>1.6014000977107901</c:v>
                </c:pt>
                <c:pt idx="6488">
                  <c:v>1.9888468868764699</c:v>
                </c:pt>
                <c:pt idx="6489">
                  <c:v>2.35198145105127</c:v>
                </c:pt>
                <c:pt idx="6490">
                  <c:v>1.80112265521263</c:v>
                </c:pt>
                <c:pt idx="6491">
                  <c:v>2.9713517814727899</c:v>
                </c:pt>
                <c:pt idx="6492">
                  <c:v>1.1585328721334101</c:v>
                </c:pt>
                <c:pt idx="6493">
                  <c:v>2.12746395333969</c:v>
                </c:pt>
                <c:pt idx="6494">
                  <c:v>2.4907703517650601</c:v>
                </c:pt>
                <c:pt idx="6495">
                  <c:v>2.95819082975154</c:v>
                </c:pt>
                <c:pt idx="6496">
                  <c:v>1.98091292060199</c:v>
                </c:pt>
                <c:pt idx="6497">
                  <c:v>3.0905872326666599</c:v>
                </c:pt>
                <c:pt idx="6498">
                  <c:v>2.55571831456888</c:v>
                </c:pt>
                <c:pt idx="6499">
                  <c:v>1.1725471064778501</c:v>
                </c:pt>
                <c:pt idx="6500">
                  <c:v>1.8977548909769499</c:v>
                </c:pt>
                <c:pt idx="6501">
                  <c:v>1.9640733058128399</c:v>
                </c:pt>
                <c:pt idx="6502">
                  <c:v>2.4008269419329902</c:v>
                </c:pt>
                <c:pt idx="6503">
                  <c:v>2.2053493435393299</c:v>
                </c:pt>
                <c:pt idx="6504">
                  <c:v>2.06052760281153</c:v>
                </c:pt>
                <c:pt idx="6505">
                  <c:v>2.7652007187063798</c:v>
                </c:pt>
                <c:pt idx="6506">
                  <c:v>2.8972560005029599</c:v>
                </c:pt>
                <c:pt idx="6507">
                  <c:v>2.82521837259358</c:v>
                </c:pt>
                <c:pt idx="6508">
                  <c:v>3.0676328096053802</c:v>
                </c:pt>
                <c:pt idx="6509">
                  <c:v>3.3037340159803001</c:v>
                </c:pt>
                <c:pt idx="6510">
                  <c:v>2.3959835527249198</c:v>
                </c:pt>
                <c:pt idx="6511">
                  <c:v>2.4215508381609001</c:v>
                </c:pt>
                <c:pt idx="6512">
                  <c:v>2.6263761919388502</c:v>
                </c:pt>
                <c:pt idx="6513">
                  <c:v>2.6058557936484501</c:v>
                </c:pt>
                <c:pt idx="6514">
                  <c:v>2.4192961429200599</c:v>
                </c:pt>
                <c:pt idx="6515">
                  <c:v>2.5396389688148799</c:v>
                </c:pt>
                <c:pt idx="6516">
                  <c:v>2.3492965280142499</c:v>
                </c:pt>
                <c:pt idx="6517">
                  <c:v>2.8097912893806098</c:v>
                </c:pt>
                <c:pt idx="6518">
                  <c:v>2.9593761765700299</c:v>
                </c:pt>
                <c:pt idx="6519">
                  <c:v>2.7899451132498401</c:v>
                </c:pt>
                <c:pt idx="6520">
                  <c:v>2.2891747951703598</c:v>
                </c:pt>
                <c:pt idx="6521">
                  <c:v>2.5651863279009901</c:v>
                </c:pt>
                <c:pt idx="6522">
                  <c:v>2.7510698085477001</c:v>
                </c:pt>
                <c:pt idx="6523">
                  <c:v>2.7247624983111698</c:v>
                </c:pt>
                <c:pt idx="6524">
                  <c:v>3.0644518174092301</c:v>
                </c:pt>
                <c:pt idx="6525">
                  <c:v>2.2258517918542</c:v>
                </c:pt>
                <c:pt idx="6526">
                  <c:v>2.56234039160694</c:v>
                </c:pt>
                <c:pt idx="6527">
                  <c:v>2.5552577488631298</c:v>
                </c:pt>
                <c:pt idx="6528">
                  <c:v>1.92057923938867</c:v>
                </c:pt>
                <c:pt idx="6529">
                  <c:v>2.2960836827243001</c:v>
                </c:pt>
                <c:pt idx="6530">
                  <c:v>2.9189965282460002</c:v>
                </c:pt>
                <c:pt idx="6531">
                  <c:v>2.3642468506398999</c:v>
                </c:pt>
                <c:pt idx="6532">
                  <c:v>2.7091433513529601</c:v>
                </c:pt>
                <c:pt idx="6533">
                  <c:v>2.4682776136194602</c:v>
                </c:pt>
                <c:pt idx="6534">
                  <c:v>2.7977850672515499</c:v>
                </c:pt>
                <c:pt idx="6535">
                  <c:v>2.53258854405781</c:v>
                </c:pt>
                <c:pt idx="6536">
                  <c:v>2.3917716323556899</c:v>
                </c:pt>
                <c:pt idx="6537">
                  <c:v>2.8039428685995502</c:v>
                </c:pt>
                <c:pt idx="6538">
                  <c:v>1.4918182431851399</c:v>
                </c:pt>
                <c:pt idx="6539">
                  <c:v>2.5786827673575998</c:v>
                </c:pt>
                <c:pt idx="6540">
                  <c:v>2.6896883544421799</c:v>
                </c:pt>
                <c:pt idx="6541">
                  <c:v>2.13182512835344</c:v>
                </c:pt>
                <c:pt idx="6542">
                  <c:v>2.8638485927513799</c:v>
                </c:pt>
                <c:pt idx="6543">
                  <c:v>3.2658198381939298</c:v>
                </c:pt>
                <c:pt idx="6544">
                  <c:v>2.62409738228135</c:v>
                </c:pt>
                <c:pt idx="6545">
                  <c:v>3.5854555009212299</c:v>
                </c:pt>
                <c:pt idx="6546">
                  <c:v>2.7645984205731202</c:v>
                </c:pt>
                <c:pt idx="6547">
                  <c:v>3.1763336776345898</c:v>
                </c:pt>
                <c:pt idx="6548">
                  <c:v>2.8130470791243098</c:v>
                </c:pt>
                <c:pt idx="6549">
                  <c:v>3.0068081943978999</c:v>
                </c:pt>
                <c:pt idx="6550">
                  <c:v>3.20301890826221</c:v>
                </c:pt>
                <c:pt idx="6551">
                  <c:v>2.59755440184564</c:v>
                </c:pt>
                <c:pt idx="6552">
                  <c:v>2.9225562561301901</c:v>
                </c:pt>
                <c:pt idx="6553">
                  <c:v>2.9590727155961201</c:v>
                </c:pt>
                <c:pt idx="6554">
                  <c:v>2.9486990224815499</c:v>
                </c:pt>
                <c:pt idx="6555">
                  <c:v>2.1335384524132999</c:v>
                </c:pt>
                <c:pt idx="6556">
                  <c:v>2.1146700477743998</c:v>
                </c:pt>
                <c:pt idx="6557">
                  <c:v>2.1154747361970698</c:v>
                </c:pt>
                <c:pt idx="6558">
                  <c:v>3.23124897972518</c:v>
                </c:pt>
                <c:pt idx="6559">
                  <c:v>2.8749270640405</c:v>
                </c:pt>
                <c:pt idx="6560">
                  <c:v>3.1858934347061401</c:v>
                </c:pt>
                <c:pt idx="6561">
                  <c:v>3.1303692815614599</c:v>
                </c:pt>
                <c:pt idx="6562">
                  <c:v>3.264578457442</c:v>
                </c:pt>
                <c:pt idx="6563">
                  <c:v>3.6265198179015798</c:v>
                </c:pt>
                <c:pt idx="6564">
                  <c:v>2.4270965559089501</c:v>
                </c:pt>
                <c:pt idx="6565">
                  <c:v>1.6418769385040199</c:v>
                </c:pt>
                <c:pt idx="6566">
                  <c:v>2.1574833223833698</c:v>
                </c:pt>
                <c:pt idx="6567">
                  <c:v>2.4270017334435598</c:v>
                </c:pt>
                <c:pt idx="6568">
                  <c:v>2.9783597111329798</c:v>
                </c:pt>
                <c:pt idx="6569">
                  <c:v>1.9151084098862901</c:v>
                </c:pt>
                <c:pt idx="6570">
                  <c:v>2.8677655877304602</c:v>
                </c:pt>
                <c:pt idx="6571">
                  <c:v>2.63332096817058</c:v>
                </c:pt>
                <c:pt idx="6572">
                  <c:v>2.2834446404733799</c:v>
                </c:pt>
                <c:pt idx="6573">
                  <c:v>3.02449889905354</c:v>
                </c:pt>
                <c:pt idx="6574">
                  <c:v>2.9727485510516298</c:v>
                </c:pt>
                <c:pt idx="6575">
                  <c:v>3.0912056152638399</c:v>
                </c:pt>
                <c:pt idx="6576">
                  <c:v>3.0551970410086899</c:v>
                </c:pt>
                <c:pt idx="6577">
                  <c:v>3.0499582558416498</c:v>
                </c:pt>
                <c:pt idx="6578">
                  <c:v>3.3379186833837</c:v>
                </c:pt>
                <c:pt idx="6579">
                  <c:v>3.64146649855731</c:v>
                </c:pt>
                <c:pt idx="6580">
                  <c:v>2.7020592772355401</c:v>
                </c:pt>
                <c:pt idx="6581">
                  <c:v>3.11838744902375</c:v>
                </c:pt>
                <c:pt idx="6582">
                  <c:v>2.9333787533818398</c:v>
                </c:pt>
                <c:pt idx="6583">
                  <c:v>2.9601226255679798</c:v>
                </c:pt>
                <c:pt idx="6584">
                  <c:v>2.62208073672821</c:v>
                </c:pt>
                <c:pt idx="6585">
                  <c:v>2.8001942676749501</c:v>
                </c:pt>
                <c:pt idx="6586">
                  <c:v>2.5423800968753798</c:v>
                </c:pt>
                <c:pt idx="6587">
                  <c:v>1.99691937577509</c:v>
                </c:pt>
                <c:pt idx="6588">
                  <c:v>2.0218586084752999</c:v>
                </c:pt>
                <c:pt idx="6589">
                  <c:v>3.3171272237026401</c:v>
                </c:pt>
                <c:pt idx="6590">
                  <c:v>2.56818967077673</c:v>
                </c:pt>
                <c:pt idx="6591">
                  <c:v>2.5732318874938498</c:v>
                </c:pt>
                <c:pt idx="6592">
                  <c:v>2.8462592215854499</c:v>
                </c:pt>
                <c:pt idx="6593">
                  <c:v>2.6452709164698498</c:v>
                </c:pt>
                <c:pt idx="6594">
                  <c:v>2.4799021446602301</c:v>
                </c:pt>
                <c:pt idx="6595">
                  <c:v>2.5160900011443101</c:v>
                </c:pt>
                <c:pt idx="6596">
                  <c:v>2.84382539767067</c:v>
                </c:pt>
                <c:pt idx="6597">
                  <c:v>2.0153274793542</c:v>
                </c:pt>
                <c:pt idx="6598">
                  <c:v>2.3872612991481801</c:v>
                </c:pt>
                <c:pt idx="6599">
                  <c:v>2.4429645704323999</c:v>
                </c:pt>
                <c:pt idx="6600">
                  <c:v>3.6160334163717298</c:v>
                </c:pt>
                <c:pt idx="6601">
                  <c:v>2.8693581135035102</c:v>
                </c:pt>
                <c:pt idx="6602">
                  <c:v>3.60877452131197</c:v>
                </c:pt>
                <c:pt idx="6603">
                  <c:v>2.9946371788472002</c:v>
                </c:pt>
                <c:pt idx="6604">
                  <c:v>2.7502777206859101</c:v>
                </c:pt>
                <c:pt idx="6605">
                  <c:v>2.6500496818630199</c:v>
                </c:pt>
                <c:pt idx="6606">
                  <c:v>2.4725745521476901</c:v>
                </c:pt>
                <c:pt idx="6607">
                  <c:v>3.28022832148761</c:v>
                </c:pt>
                <c:pt idx="6608">
                  <c:v>3.08179232784319</c:v>
                </c:pt>
                <c:pt idx="6609">
                  <c:v>3.1640652609412001</c:v>
                </c:pt>
                <c:pt idx="6610">
                  <c:v>2.6045545192545201</c:v>
                </c:pt>
                <c:pt idx="6611">
                  <c:v>3.5577634189991501</c:v>
                </c:pt>
                <c:pt idx="6612">
                  <c:v>3.0488588448257001</c:v>
                </c:pt>
                <c:pt idx="6613">
                  <c:v>3.3510241454197902</c:v>
                </c:pt>
                <c:pt idx="6614">
                  <c:v>3.1745490226875299</c:v>
                </c:pt>
                <c:pt idx="6615">
                  <c:v>2.0716421254378599</c:v>
                </c:pt>
                <c:pt idx="6616">
                  <c:v>2.5681624338755902</c:v>
                </c:pt>
                <c:pt idx="6617">
                  <c:v>2.6882026964372101</c:v>
                </c:pt>
                <c:pt idx="6618">
                  <c:v>1.96860749528538</c:v>
                </c:pt>
                <c:pt idx="6619">
                  <c:v>1.7915044240198199</c:v>
                </c:pt>
                <c:pt idx="6620">
                  <c:v>2.1810692166095702</c:v>
                </c:pt>
                <c:pt idx="6621">
                  <c:v>1.7797674117673401</c:v>
                </c:pt>
                <c:pt idx="6622">
                  <c:v>1.8187647176615001</c:v>
                </c:pt>
                <c:pt idx="6623">
                  <c:v>1.7290376191046799</c:v>
                </c:pt>
                <c:pt idx="6624">
                  <c:v>1.3637485309158299</c:v>
                </c:pt>
                <c:pt idx="6625">
                  <c:v>2.111643601161</c:v>
                </c:pt>
                <c:pt idx="6626">
                  <c:v>2.36510324922014</c:v>
                </c:pt>
                <c:pt idx="6627">
                  <c:v>1.1994482893738001</c:v>
                </c:pt>
                <c:pt idx="6628">
                  <c:v>2.4017636623196501</c:v>
                </c:pt>
                <c:pt idx="6629">
                  <c:v>1.43914658851536</c:v>
                </c:pt>
                <c:pt idx="6630">
                  <c:v>1.938449748494</c:v>
                </c:pt>
                <c:pt idx="6631">
                  <c:v>1.58132286798104</c:v>
                </c:pt>
                <c:pt idx="6632">
                  <c:v>1.8006127831960099</c:v>
                </c:pt>
                <c:pt idx="6633">
                  <c:v>2.5300343330344499</c:v>
                </c:pt>
                <c:pt idx="6634">
                  <c:v>3.0272713904017299</c:v>
                </c:pt>
                <c:pt idx="6635">
                  <c:v>1.88865849742502</c:v>
                </c:pt>
                <c:pt idx="6636">
                  <c:v>1.9055701024709599</c:v>
                </c:pt>
                <c:pt idx="6637">
                  <c:v>1.7988010822335501</c:v>
                </c:pt>
                <c:pt idx="6638">
                  <c:v>1.5809968653526101</c:v>
                </c:pt>
                <c:pt idx="6639">
                  <c:v>1.1688384198864401</c:v>
                </c:pt>
                <c:pt idx="6640">
                  <c:v>2.1532517922427701</c:v>
                </c:pt>
                <c:pt idx="6641">
                  <c:v>2.05594334447047</c:v>
                </c:pt>
                <c:pt idx="6642">
                  <c:v>1.94640669123974</c:v>
                </c:pt>
                <c:pt idx="6643">
                  <c:v>1.1077906746428401</c:v>
                </c:pt>
                <c:pt idx="6644">
                  <c:v>1.5021033655662701</c:v>
                </c:pt>
                <c:pt idx="6645">
                  <c:v>1.7172473471169201</c:v>
                </c:pt>
                <c:pt idx="6646">
                  <c:v>2.3035529159247798</c:v>
                </c:pt>
                <c:pt idx="6647">
                  <c:v>1.64806249369015</c:v>
                </c:pt>
                <c:pt idx="6648">
                  <c:v>1.9007193370667399</c:v>
                </c:pt>
                <c:pt idx="6649">
                  <c:v>2.12914017505565</c:v>
                </c:pt>
                <c:pt idx="6650">
                  <c:v>2.0952604245267201</c:v>
                </c:pt>
                <c:pt idx="6651">
                  <c:v>2.1980870890083599</c:v>
                </c:pt>
                <c:pt idx="6652">
                  <c:v>2.6179489169444499</c:v>
                </c:pt>
                <c:pt idx="6653">
                  <c:v>1.89192289036477</c:v>
                </c:pt>
                <c:pt idx="6654">
                  <c:v>2.4859498724896798</c:v>
                </c:pt>
                <c:pt idx="6655">
                  <c:v>2.3055922048536002</c:v>
                </c:pt>
                <c:pt idx="6656">
                  <c:v>2.7351102226809001</c:v>
                </c:pt>
                <c:pt idx="6657">
                  <c:v>1.9264122238644701</c:v>
                </c:pt>
                <c:pt idx="6658">
                  <c:v>1.64852244882239</c:v>
                </c:pt>
                <c:pt idx="6659">
                  <c:v>1.5238380048083</c:v>
                </c:pt>
                <c:pt idx="6660">
                  <c:v>2.3022544627174302</c:v>
                </c:pt>
                <c:pt idx="6661">
                  <c:v>2.13169807380492</c:v>
                </c:pt>
                <c:pt idx="6662">
                  <c:v>2.0693909532691599</c:v>
                </c:pt>
                <c:pt idx="6663">
                  <c:v>2.3758050173711198</c:v>
                </c:pt>
                <c:pt idx="6664">
                  <c:v>2.5995470714990501</c:v>
                </c:pt>
                <c:pt idx="6665">
                  <c:v>2.97680972100274</c:v>
                </c:pt>
                <c:pt idx="6666">
                  <c:v>2.9174801175898102</c:v>
                </c:pt>
                <c:pt idx="6667">
                  <c:v>2.80377322080207</c:v>
                </c:pt>
                <c:pt idx="6668">
                  <c:v>2.1009457191254799</c:v>
                </c:pt>
                <c:pt idx="6669">
                  <c:v>2.38302112115489</c:v>
                </c:pt>
                <c:pt idx="6670">
                  <c:v>2.5326516256924401</c:v>
                </c:pt>
                <c:pt idx="6671">
                  <c:v>2.3594830603282602</c:v>
                </c:pt>
                <c:pt idx="6672">
                  <c:v>2.40232345819933</c:v>
                </c:pt>
                <c:pt idx="6673">
                  <c:v>2.31089128785709</c:v>
                </c:pt>
                <c:pt idx="6674">
                  <c:v>2.2451904266875</c:v>
                </c:pt>
                <c:pt idx="6675">
                  <c:v>2.2489688698801</c:v>
                </c:pt>
                <c:pt idx="6676">
                  <c:v>2.17491030314683</c:v>
                </c:pt>
                <c:pt idx="6677">
                  <c:v>2.3447044726909199</c:v>
                </c:pt>
                <c:pt idx="6678">
                  <c:v>2.6660065601270899</c:v>
                </c:pt>
                <c:pt idx="6679">
                  <c:v>2.5458806203680902</c:v>
                </c:pt>
                <c:pt idx="6680">
                  <c:v>1.9773555056183401</c:v>
                </c:pt>
                <c:pt idx="6681">
                  <c:v>1.7024541533653199</c:v>
                </c:pt>
                <c:pt idx="6682">
                  <c:v>2.15895325509966</c:v>
                </c:pt>
                <c:pt idx="6683">
                  <c:v>2.4856318262175399</c:v>
                </c:pt>
                <c:pt idx="6684">
                  <c:v>2.0636832998383698</c:v>
                </c:pt>
                <c:pt idx="6685">
                  <c:v>1.4550996792208399</c:v>
                </c:pt>
                <c:pt idx="6686">
                  <c:v>1.90857499781331</c:v>
                </c:pt>
                <c:pt idx="6687">
                  <c:v>2.3135079077779599</c:v>
                </c:pt>
                <c:pt idx="6688">
                  <c:v>2.0565787605807002</c:v>
                </c:pt>
                <c:pt idx="6689">
                  <c:v>1.5252760562609999</c:v>
                </c:pt>
                <c:pt idx="6690">
                  <c:v>2.63405058403937</c:v>
                </c:pt>
                <c:pt idx="6691">
                  <c:v>1.0822624376074499</c:v>
                </c:pt>
                <c:pt idx="6692">
                  <c:v>2.6125781916972701</c:v>
                </c:pt>
                <c:pt idx="6693">
                  <c:v>2.70059804591643</c:v>
                </c:pt>
                <c:pt idx="6694">
                  <c:v>2.2513404478200898</c:v>
                </c:pt>
                <c:pt idx="6695">
                  <c:v>2.4632930424051498</c:v>
                </c:pt>
                <c:pt idx="6696">
                  <c:v>1.97705565543978</c:v>
                </c:pt>
                <c:pt idx="6697">
                  <c:v>1.9860761718436799</c:v>
                </c:pt>
                <c:pt idx="6698">
                  <c:v>3.0523781692383301</c:v>
                </c:pt>
                <c:pt idx="6699">
                  <c:v>3.00228227572895</c:v>
                </c:pt>
                <c:pt idx="6700">
                  <c:v>3.3886296753812601</c:v>
                </c:pt>
                <c:pt idx="6701">
                  <c:v>2.5016423281719802</c:v>
                </c:pt>
                <c:pt idx="6702">
                  <c:v>2.85183600539116</c:v>
                </c:pt>
                <c:pt idx="6703">
                  <c:v>2.6976764406050502</c:v>
                </c:pt>
                <c:pt idx="6704">
                  <c:v>2.7600388190437601</c:v>
                </c:pt>
                <c:pt idx="6705">
                  <c:v>2.8866841646841999</c:v>
                </c:pt>
                <c:pt idx="6706">
                  <c:v>1.8434318194932899</c:v>
                </c:pt>
                <c:pt idx="6707">
                  <c:v>2.30619378747974</c:v>
                </c:pt>
                <c:pt idx="6708">
                  <c:v>2.1692713726419899</c:v>
                </c:pt>
                <c:pt idx="6709">
                  <c:v>2.7542199846957098</c:v>
                </c:pt>
                <c:pt idx="6710">
                  <c:v>2.24268910230911</c:v>
                </c:pt>
                <c:pt idx="6711">
                  <c:v>2.6129273082360198</c:v>
                </c:pt>
                <c:pt idx="6712">
                  <c:v>2.1152694141236101</c:v>
                </c:pt>
                <c:pt idx="6713">
                  <c:v>2.07890306146043</c:v>
                </c:pt>
                <c:pt idx="6714">
                  <c:v>1.61057554535511</c:v>
                </c:pt>
                <c:pt idx="6715">
                  <c:v>1.6971729284369399</c:v>
                </c:pt>
                <c:pt idx="6716">
                  <c:v>2.4466672098883699</c:v>
                </c:pt>
                <c:pt idx="6717">
                  <c:v>2.3425289128956002</c:v>
                </c:pt>
                <c:pt idx="6718">
                  <c:v>2.5193731131808499</c:v>
                </c:pt>
                <c:pt idx="6719">
                  <c:v>1.9802241946849399</c:v>
                </c:pt>
                <c:pt idx="6720">
                  <c:v>1.7949209348742501</c:v>
                </c:pt>
                <c:pt idx="6721">
                  <c:v>1.9779914834307399</c:v>
                </c:pt>
                <c:pt idx="6722">
                  <c:v>2.12203615092089</c:v>
                </c:pt>
                <c:pt idx="6723">
                  <c:v>2.27839562000579</c:v>
                </c:pt>
                <c:pt idx="6724">
                  <c:v>3.28726190257763</c:v>
                </c:pt>
                <c:pt idx="6725">
                  <c:v>2.5612831311932598</c:v>
                </c:pt>
                <c:pt idx="6726">
                  <c:v>2.9880086964603301</c:v>
                </c:pt>
                <c:pt idx="6727">
                  <c:v>3.01495837661321</c:v>
                </c:pt>
                <c:pt idx="6728">
                  <c:v>2.5438593236771898</c:v>
                </c:pt>
                <c:pt idx="6729">
                  <c:v>2.2124607468617801</c:v>
                </c:pt>
                <c:pt idx="6730">
                  <c:v>2.31761941409441</c:v>
                </c:pt>
                <c:pt idx="6731">
                  <c:v>2.4049522556212501</c:v>
                </c:pt>
                <c:pt idx="6732">
                  <c:v>2.2584807351000902</c:v>
                </c:pt>
                <c:pt idx="6733">
                  <c:v>2.1071839427580801</c:v>
                </c:pt>
                <c:pt idx="6734">
                  <c:v>2.7178709103902201</c:v>
                </c:pt>
                <c:pt idx="6735">
                  <c:v>2.322317187805</c:v>
                </c:pt>
                <c:pt idx="6736">
                  <c:v>2.0997110276652098</c:v>
                </c:pt>
                <c:pt idx="6737">
                  <c:v>2.8410789055696499</c:v>
                </c:pt>
                <c:pt idx="6738">
                  <c:v>2.14370282407</c:v>
                </c:pt>
                <c:pt idx="6739">
                  <c:v>2.0806471173758401</c:v>
                </c:pt>
                <c:pt idx="6740">
                  <c:v>2.6161895526019299</c:v>
                </c:pt>
                <c:pt idx="6741">
                  <c:v>2.5004124254909801</c:v>
                </c:pt>
                <c:pt idx="6742">
                  <c:v>2.7637485663477301</c:v>
                </c:pt>
                <c:pt idx="6743">
                  <c:v>3.0411373362201299</c:v>
                </c:pt>
                <c:pt idx="6744">
                  <c:v>2.4547944312781098</c:v>
                </c:pt>
                <c:pt idx="6745">
                  <c:v>1.8974864106404601</c:v>
                </c:pt>
                <c:pt idx="6746">
                  <c:v>2.3670518490305499</c:v>
                </c:pt>
                <c:pt idx="6747">
                  <c:v>2.4550844838793902</c:v>
                </c:pt>
                <c:pt idx="6748">
                  <c:v>2.6223780908567398</c:v>
                </c:pt>
                <c:pt idx="6749">
                  <c:v>2.5316581974644299</c:v>
                </c:pt>
                <c:pt idx="6750">
                  <c:v>2.2131893263395601</c:v>
                </c:pt>
                <c:pt idx="6751">
                  <c:v>3.0313031061595801</c:v>
                </c:pt>
                <c:pt idx="6752">
                  <c:v>2.8709745983725701</c:v>
                </c:pt>
                <c:pt idx="6753">
                  <c:v>3.0317766735956799</c:v>
                </c:pt>
                <c:pt idx="6754">
                  <c:v>2.7085403388773899</c:v>
                </c:pt>
                <c:pt idx="6755">
                  <c:v>2.5385556946618402</c:v>
                </c:pt>
                <c:pt idx="6756">
                  <c:v>2.42434060689942</c:v>
                </c:pt>
                <c:pt idx="6757">
                  <c:v>2.8724441541874701</c:v>
                </c:pt>
                <c:pt idx="6758">
                  <c:v>2.4400909119656502</c:v>
                </c:pt>
                <c:pt idx="6759">
                  <c:v>2.8652702865842699</c:v>
                </c:pt>
                <c:pt idx="6760">
                  <c:v>2.13349745597603</c:v>
                </c:pt>
                <c:pt idx="6761">
                  <c:v>2.5398091590040499</c:v>
                </c:pt>
                <c:pt idx="6762">
                  <c:v>2.7566293919974898</c:v>
                </c:pt>
                <c:pt idx="6763">
                  <c:v>2.7375285873687698</c:v>
                </c:pt>
                <c:pt idx="6764">
                  <c:v>2.61226775663371</c:v>
                </c:pt>
                <c:pt idx="6765">
                  <c:v>3.2316718030101699</c:v>
                </c:pt>
                <c:pt idx="6766">
                  <c:v>2.2760413321508599</c:v>
                </c:pt>
                <c:pt idx="6767">
                  <c:v>2.4465380956063099</c:v>
                </c:pt>
                <c:pt idx="6768">
                  <c:v>2.6779902914795599</c:v>
                </c:pt>
                <c:pt idx="6769">
                  <c:v>2.8911248169736501</c:v>
                </c:pt>
                <c:pt idx="6770">
                  <c:v>2.6236547920167101</c:v>
                </c:pt>
                <c:pt idx="6771">
                  <c:v>2.7771691648979902</c:v>
                </c:pt>
                <c:pt idx="6772">
                  <c:v>3.06724629738404</c:v>
                </c:pt>
                <c:pt idx="6773">
                  <c:v>2.8517155962301501</c:v>
                </c:pt>
                <c:pt idx="6774">
                  <c:v>2.9410449955134901</c:v>
                </c:pt>
                <c:pt idx="6775">
                  <c:v>2.5375123536544599</c:v>
                </c:pt>
                <c:pt idx="6776">
                  <c:v>2.8966816352340099</c:v>
                </c:pt>
                <c:pt idx="6777">
                  <c:v>2.18724201461418</c:v>
                </c:pt>
                <c:pt idx="6778">
                  <c:v>2.8053145090904699</c:v>
                </c:pt>
                <c:pt idx="6779">
                  <c:v>2.5788629752687702</c:v>
                </c:pt>
                <c:pt idx="6780">
                  <c:v>2.8508644544483301</c:v>
                </c:pt>
                <c:pt idx="6781">
                  <c:v>2.6876134875314501</c:v>
                </c:pt>
                <c:pt idx="6782">
                  <c:v>2.3648171772795599</c:v>
                </c:pt>
                <c:pt idx="6783">
                  <c:v>2.22177337466265</c:v>
                </c:pt>
                <c:pt idx="6784">
                  <c:v>3.0557290175015699</c:v>
                </c:pt>
                <c:pt idx="6785">
                  <c:v>2.5268487771252</c:v>
                </c:pt>
                <c:pt idx="6786">
                  <c:v>3.0517912941995098</c:v>
                </c:pt>
                <c:pt idx="6787">
                  <c:v>2.98682770982757</c:v>
                </c:pt>
                <c:pt idx="6788">
                  <c:v>2.5478260370117098</c:v>
                </c:pt>
                <c:pt idx="6789">
                  <c:v>2.2790350582415901</c:v>
                </c:pt>
                <c:pt idx="6790">
                  <c:v>1.8995793569901001</c:v>
                </c:pt>
                <c:pt idx="6791">
                  <c:v>2.1312614448974898</c:v>
                </c:pt>
                <c:pt idx="6792">
                  <c:v>2.5798491339063099</c:v>
                </c:pt>
                <c:pt idx="6793">
                  <c:v>2.2942726252105099</c:v>
                </c:pt>
                <c:pt idx="6794">
                  <c:v>2.8854822313715101</c:v>
                </c:pt>
                <c:pt idx="6795">
                  <c:v>2.1825402464307699</c:v>
                </c:pt>
                <c:pt idx="6796">
                  <c:v>2.4536542666021099</c:v>
                </c:pt>
                <c:pt idx="6797">
                  <c:v>2.14124310240511</c:v>
                </c:pt>
                <c:pt idx="6798">
                  <c:v>2.52511041418866</c:v>
                </c:pt>
                <c:pt idx="6799">
                  <c:v>3.1256242421715599</c:v>
                </c:pt>
                <c:pt idx="6800">
                  <c:v>2.09558837244801</c:v>
                </c:pt>
                <c:pt idx="6801">
                  <c:v>1.81022267837301</c:v>
                </c:pt>
                <c:pt idx="6802">
                  <c:v>2.4177301932555202</c:v>
                </c:pt>
                <c:pt idx="6803">
                  <c:v>2.41126260624663</c:v>
                </c:pt>
                <c:pt idx="6804">
                  <c:v>2.69762798162972</c:v>
                </c:pt>
                <c:pt idx="6805">
                  <c:v>2.3411301504637598</c:v>
                </c:pt>
                <c:pt idx="6806">
                  <c:v>2.2559235658976502</c:v>
                </c:pt>
                <c:pt idx="6807">
                  <c:v>2.5491441025516499</c:v>
                </c:pt>
                <c:pt idx="6808">
                  <c:v>2.04596896290494</c:v>
                </c:pt>
                <c:pt idx="6809">
                  <c:v>2.3168323355654499</c:v>
                </c:pt>
                <c:pt idx="6810">
                  <c:v>2.4143024228784702</c:v>
                </c:pt>
                <c:pt idx="6811">
                  <c:v>1.8846413193382401</c:v>
                </c:pt>
                <c:pt idx="6812">
                  <c:v>2.1358229352664799</c:v>
                </c:pt>
                <c:pt idx="6813">
                  <c:v>2.1615446237613098</c:v>
                </c:pt>
                <c:pt idx="6814">
                  <c:v>2.5727152249554801</c:v>
                </c:pt>
                <c:pt idx="6815">
                  <c:v>2.3895827808374102</c:v>
                </c:pt>
                <c:pt idx="6816">
                  <c:v>2.0252879490506999</c:v>
                </c:pt>
                <c:pt idx="6817">
                  <c:v>2.6606319184007701</c:v>
                </c:pt>
                <c:pt idx="6818">
                  <c:v>2.3291636371273401</c:v>
                </c:pt>
                <c:pt idx="6819">
                  <c:v>2.0793107340688599</c:v>
                </c:pt>
                <c:pt idx="6820">
                  <c:v>2.4731530388731202</c:v>
                </c:pt>
                <c:pt idx="6821">
                  <c:v>2.3507811909153098</c:v>
                </c:pt>
                <c:pt idx="6822">
                  <c:v>2.7103925456437201</c:v>
                </c:pt>
                <c:pt idx="6823">
                  <c:v>2.1243612415206701</c:v>
                </c:pt>
                <c:pt idx="6824">
                  <c:v>2.5303516742498799</c:v>
                </c:pt>
                <c:pt idx="6825">
                  <c:v>2.9475405586813799</c:v>
                </c:pt>
                <c:pt idx="6826">
                  <c:v>3.46173461080389</c:v>
                </c:pt>
                <c:pt idx="6827">
                  <c:v>2.6519848321599602</c:v>
                </c:pt>
                <c:pt idx="6828">
                  <c:v>3.2309126306782598</c:v>
                </c:pt>
                <c:pt idx="6829">
                  <c:v>2.70556641431642</c:v>
                </c:pt>
                <c:pt idx="6830">
                  <c:v>2.5286304751743698</c:v>
                </c:pt>
                <c:pt idx="6831">
                  <c:v>2.8612143460711401</c:v>
                </c:pt>
                <c:pt idx="6832">
                  <c:v>2.4557425432531002</c:v>
                </c:pt>
                <c:pt idx="6833">
                  <c:v>1.8586681747869001</c:v>
                </c:pt>
                <c:pt idx="6834">
                  <c:v>2.3151917867166598</c:v>
                </c:pt>
                <c:pt idx="6835">
                  <c:v>2.9634609374192098</c:v>
                </c:pt>
                <c:pt idx="6836">
                  <c:v>2.8295743871152701</c:v>
                </c:pt>
                <c:pt idx="6837">
                  <c:v>1.64091533663416</c:v>
                </c:pt>
                <c:pt idx="6838">
                  <c:v>2.02715823655149</c:v>
                </c:pt>
                <c:pt idx="6839">
                  <c:v>2.5832883656601</c:v>
                </c:pt>
                <c:pt idx="6840">
                  <c:v>2.1565920755768802</c:v>
                </c:pt>
                <c:pt idx="6841">
                  <c:v>2.4469198217842698</c:v>
                </c:pt>
                <c:pt idx="6842">
                  <c:v>2.5634309394031201</c:v>
                </c:pt>
                <c:pt idx="6843">
                  <c:v>2.7215606382673898</c:v>
                </c:pt>
                <c:pt idx="6844">
                  <c:v>3.0872448323645099</c:v>
                </c:pt>
                <c:pt idx="6845">
                  <c:v>2.5459860514954298</c:v>
                </c:pt>
                <c:pt idx="6846">
                  <c:v>3.2795385476150698</c:v>
                </c:pt>
                <c:pt idx="6847">
                  <c:v>2.3456176918200802</c:v>
                </c:pt>
                <c:pt idx="6848">
                  <c:v>2.4571943299824799</c:v>
                </c:pt>
                <c:pt idx="6849">
                  <c:v>2.74253904466444</c:v>
                </c:pt>
                <c:pt idx="6850">
                  <c:v>2.6489272083296398</c:v>
                </c:pt>
                <c:pt idx="6851">
                  <c:v>2.2795360341119002</c:v>
                </c:pt>
                <c:pt idx="6852">
                  <c:v>2.85142730373104</c:v>
                </c:pt>
                <c:pt idx="6853">
                  <c:v>2.2093374953275902</c:v>
                </c:pt>
                <c:pt idx="6854">
                  <c:v>2.9775159113932701</c:v>
                </c:pt>
                <c:pt idx="6855">
                  <c:v>3.5140485513492199</c:v>
                </c:pt>
                <c:pt idx="6856">
                  <c:v>3.3117475346493102</c:v>
                </c:pt>
                <c:pt idx="6857">
                  <c:v>3.0943680891933099</c:v>
                </c:pt>
                <c:pt idx="6858">
                  <c:v>2.7349964796983599</c:v>
                </c:pt>
                <c:pt idx="6859">
                  <c:v>2.2247591076375302</c:v>
                </c:pt>
                <c:pt idx="6860">
                  <c:v>2.1036410377600498</c:v>
                </c:pt>
                <c:pt idx="6861">
                  <c:v>2.78858189709418</c:v>
                </c:pt>
                <c:pt idx="6862">
                  <c:v>3.1256214618543399</c:v>
                </c:pt>
                <c:pt idx="6863">
                  <c:v>2.2704061667607802</c:v>
                </c:pt>
                <c:pt idx="6864">
                  <c:v>2.0582495561870502</c:v>
                </c:pt>
                <c:pt idx="6865">
                  <c:v>1.8474949507628899</c:v>
                </c:pt>
                <c:pt idx="6866">
                  <c:v>3.1431516197368699</c:v>
                </c:pt>
                <c:pt idx="6867">
                  <c:v>3.5376256234235002</c:v>
                </c:pt>
                <c:pt idx="6868">
                  <c:v>2.7971777580557902</c:v>
                </c:pt>
                <c:pt idx="6869">
                  <c:v>2.49187821636716</c:v>
                </c:pt>
                <c:pt idx="6870">
                  <c:v>2.6959569933743799</c:v>
                </c:pt>
                <c:pt idx="6871">
                  <c:v>3.02047086769285</c:v>
                </c:pt>
                <c:pt idx="6872">
                  <c:v>2.3121959133180798</c:v>
                </c:pt>
                <c:pt idx="6873">
                  <c:v>2.26933484707404</c:v>
                </c:pt>
                <c:pt idx="6874">
                  <c:v>2.5480466997949098</c:v>
                </c:pt>
                <c:pt idx="6875">
                  <c:v>1.6937466836741299</c:v>
                </c:pt>
                <c:pt idx="6876">
                  <c:v>2.4518586834970999</c:v>
                </c:pt>
                <c:pt idx="6877">
                  <c:v>2.41961350974633</c:v>
                </c:pt>
                <c:pt idx="6878">
                  <c:v>2.6481656297910399</c:v>
                </c:pt>
                <c:pt idx="6879">
                  <c:v>2.7417713042673402</c:v>
                </c:pt>
                <c:pt idx="6880">
                  <c:v>2.5034960741116699</c:v>
                </c:pt>
                <c:pt idx="6881">
                  <c:v>2.4273164581088902</c:v>
                </c:pt>
                <c:pt idx="6882">
                  <c:v>2.3218478028268801</c:v>
                </c:pt>
                <c:pt idx="6883">
                  <c:v>2.2547821941664101</c:v>
                </c:pt>
                <c:pt idx="6884">
                  <c:v>3.19991136870203</c:v>
                </c:pt>
                <c:pt idx="6885">
                  <c:v>2.0721808221919802</c:v>
                </c:pt>
                <c:pt idx="6886">
                  <c:v>1.78047689420387</c:v>
                </c:pt>
                <c:pt idx="6887">
                  <c:v>1.9010146890861399</c:v>
                </c:pt>
                <c:pt idx="6888">
                  <c:v>1.7109500419050701</c:v>
                </c:pt>
                <c:pt idx="6889">
                  <c:v>2.16592782930524</c:v>
                </c:pt>
                <c:pt idx="6890">
                  <c:v>2.2907230337765401</c:v>
                </c:pt>
                <c:pt idx="6891">
                  <c:v>2.54181392438135</c:v>
                </c:pt>
                <c:pt idx="6892">
                  <c:v>1.74009589070792</c:v>
                </c:pt>
                <c:pt idx="6893">
                  <c:v>2.1584678820821601</c:v>
                </c:pt>
                <c:pt idx="6894">
                  <c:v>2.2802366508972098</c:v>
                </c:pt>
                <c:pt idx="6895">
                  <c:v>2.6004769711524802</c:v>
                </c:pt>
                <c:pt idx="6896">
                  <c:v>2.5246869919084198</c:v>
                </c:pt>
                <c:pt idx="6897">
                  <c:v>2.5386888376774199</c:v>
                </c:pt>
                <c:pt idx="6898">
                  <c:v>2.6444301524678502</c:v>
                </c:pt>
                <c:pt idx="6899">
                  <c:v>3.1472789430824899</c:v>
                </c:pt>
                <c:pt idx="6900">
                  <c:v>2.1844927722866698</c:v>
                </c:pt>
                <c:pt idx="6901">
                  <c:v>2.5699117980700299</c:v>
                </c:pt>
                <c:pt idx="6902">
                  <c:v>2.4090678907940699</c:v>
                </c:pt>
                <c:pt idx="6903">
                  <c:v>2.4487134993494299</c:v>
                </c:pt>
                <c:pt idx="6904">
                  <c:v>2.8242663199495399</c:v>
                </c:pt>
                <c:pt idx="6905">
                  <c:v>3.0760778543608098</c:v>
                </c:pt>
                <c:pt idx="6906">
                  <c:v>2.4354213948547301</c:v>
                </c:pt>
                <c:pt idx="6907">
                  <c:v>3.2205513093965701</c:v>
                </c:pt>
                <c:pt idx="6908">
                  <c:v>3.6169947894771002</c:v>
                </c:pt>
                <c:pt idx="6909">
                  <c:v>3.0808793438278799</c:v>
                </c:pt>
                <c:pt idx="6910">
                  <c:v>2.98439727757428</c:v>
                </c:pt>
                <c:pt idx="6911">
                  <c:v>3.4395190712541699</c:v>
                </c:pt>
                <c:pt idx="6912">
                  <c:v>2.7935872484758102</c:v>
                </c:pt>
                <c:pt idx="6913">
                  <c:v>3.38842298987479</c:v>
                </c:pt>
                <c:pt idx="6914">
                  <c:v>2.72745357140345</c:v>
                </c:pt>
                <c:pt idx="6915">
                  <c:v>2.4513989604175701</c:v>
                </c:pt>
                <c:pt idx="6916">
                  <c:v>2.7189221092381501</c:v>
                </c:pt>
                <c:pt idx="6917">
                  <c:v>2.7865400856815001</c:v>
                </c:pt>
                <c:pt idx="6918">
                  <c:v>2.3616419007328702</c:v>
                </c:pt>
                <c:pt idx="6919">
                  <c:v>2.8623674529574599</c:v>
                </c:pt>
                <c:pt idx="6920">
                  <c:v>2.7691149794542298</c:v>
                </c:pt>
                <c:pt idx="6921">
                  <c:v>2.66682445557305</c:v>
                </c:pt>
                <c:pt idx="6922">
                  <c:v>2.2705963599105901</c:v>
                </c:pt>
                <c:pt idx="6923">
                  <c:v>2.84256035536704</c:v>
                </c:pt>
                <c:pt idx="6924">
                  <c:v>3.2977282798868099</c:v>
                </c:pt>
                <c:pt idx="6925">
                  <c:v>2.54717338114934</c:v>
                </c:pt>
                <c:pt idx="6926">
                  <c:v>2.69912215961909</c:v>
                </c:pt>
                <c:pt idx="6927">
                  <c:v>2.40455941918154</c:v>
                </c:pt>
                <c:pt idx="6928">
                  <c:v>2.6275931676532398</c:v>
                </c:pt>
                <c:pt idx="6929">
                  <c:v>3.4389354875356801</c:v>
                </c:pt>
                <c:pt idx="6930">
                  <c:v>2.3849968158241799</c:v>
                </c:pt>
                <c:pt idx="6931">
                  <c:v>3.0884100268056298</c:v>
                </c:pt>
                <c:pt idx="6932">
                  <c:v>2.40289348995588</c:v>
                </c:pt>
                <c:pt idx="6933">
                  <c:v>2.7717648088576698</c:v>
                </c:pt>
                <c:pt idx="6934">
                  <c:v>2.51993679763061</c:v>
                </c:pt>
                <c:pt idx="6935">
                  <c:v>2.3545714257556098</c:v>
                </c:pt>
                <c:pt idx="6936">
                  <c:v>2.9790940961197401</c:v>
                </c:pt>
                <c:pt idx="6937">
                  <c:v>3.2021781790574999</c:v>
                </c:pt>
                <c:pt idx="6938">
                  <c:v>3.0055694753791902</c:v>
                </c:pt>
                <c:pt idx="6939">
                  <c:v>2.5613275029614702</c:v>
                </c:pt>
                <c:pt idx="6940">
                  <c:v>3.68260675545136</c:v>
                </c:pt>
                <c:pt idx="6941">
                  <c:v>3.1887182237136602</c:v>
                </c:pt>
                <c:pt idx="6942">
                  <c:v>2.9155120491694499</c:v>
                </c:pt>
                <c:pt idx="6943">
                  <c:v>2.7331917322538701</c:v>
                </c:pt>
                <c:pt idx="6944">
                  <c:v>3.4536838666095999</c:v>
                </c:pt>
                <c:pt idx="6945">
                  <c:v>2.98132913438068</c:v>
                </c:pt>
                <c:pt idx="6946">
                  <c:v>3.0350892755752601</c:v>
                </c:pt>
                <c:pt idx="6947">
                  <c:v>3.2008759645573499</c:v>
                </c:pt>
                <c:pt idx="6948">
                  <c:v>3.6890847941868499</c:v>
                </c:pt>
                <c:pt idx="6949">
                  <c:v>3.64051594986875</c:v>
                </c:pt>
                <c:pt idx="6950">
                  <c:v>2.93059359942679</c:v>
                </c:pt>
                <c:pt idx="6951">
                  <c:v>2.9168561634971901</c:v>
                </c:pt>
                <c:pt idx="6952">
                  <c:v>2.2374143847133601</c:v>
                </c:pt>
                <c:pt idx="6953">
                  <c:v>3.07852923040788</c:v>
                </c:pt>
                <c:pt idx="6954">
                  <c:v>2.6123231185258402</c:v>
                </c:pt>
                <c:pt idx="6955">
                  <c:v>3.21617575323438</c:v>
                </c:pt>
                <c:pt idx="6956">
                  <c:v>3.2118540056824498</c:v>
                </c:pt>
                <c:pt idx="6957">
                  <c:v>3.05035628571193</c:v>
                </c:pt>
                <c:pt idx="6958">
                  <c:v>2.9286948483029498</c:v>
                </c:pt>
                <c:pt idx="6959">
                  <c:v>2.9369413488622902</c:v>
                </c:pt>
                <c:pt idx="6960">
                  <c:v>3.43483618643481</c:v>
                </c:pt>
                <c:pt idx="6961">
                  <c:v>3.2909545390039501</c:v>
                </c:pt>
                <c:pt idx="6962">
                  <c:v>3.4596988151966399</c:v>
                </c:pt>
                <c:pt idx="6963">
                  <c:v>2.9809098579609299</c:v>
                </c:pt>
                <c:pt idx="6964">
                  <c:v>2.7794745098743201</c:v>
                </c:pt>
                <c:pt idx="6965">
                  <c:v>2.97564040130833</c:v>
                </c:pt>
                <c:pt idx="6966">
                  <c:v>2.7787941515136398</c:v>
                </c:pt>
                <c:pt idx="6967">
                  <c:v>2.2415744744246999</c:v>
                </c:pt>
                <c:pt idx="6968">
                  <c:v>2.6991443174157799</c:v>
                </c:pt>
                <c:pt idx="6969">
                  <c:v>2.3069112637236699</c:v>
                </c:pt>
                <c:pt idx="6970">
                  <c:v>2.2381497004695801</c:v>
                </c:pt>
                <c:pt idx="6971">
                  <c:v>1.96871989704907</c:v>
                </c:pt>
                <c:pt idx="6972">
                  <c:v>2.5312706765906898</c:v>
                </c:pt>
                <c:pt idx="6973">
                  <c:v>2.63195509439928</c:v>
                </c:pt>
                <c:pt idx="6974">
                  <c:v>2.0750287936290599</c:v>
                </c:pt>
                <c:pt idx="6975">
                  <c:v>1.8726483578920301</c:v>
                </c:pt>
                <c:pt idx="6976">
                  <c:v>2.24983978072156</c:v>
                </c:pt>
                <c:pt idx="6977">
                  <c:v>2.8614847387365501</c:v>
                </c:pt>
                <c:pt idx="6978">
                  <c:v>2.5844454777611401</c:v>
                </c:pt>
                <c:pt idx="6979">
                  <c:v>2.59451129811475</c:v>
                </c:pt>
                <c:pt idx="6980">
                  <c:v>2.1407275264688699</c:v>
                </c:pt>
                <c:pt idx="6981">
                  <c:v>2.7684697735617898</c:v>
                </c:pt>
                <c:pt idx="6982">
                  <c:v>2.2470694799672399</c:v>
                </c:pt>
                <c:pt idx="6983">
                  <c:v>2.1923485121991999</c:v>
                </c:pt>
                <c:pt idx="6984">
                  <c:v>1.82517143940336</c:v>
                </c:pt>
                <c:pt idx="6985">
                  <c:v>2.0546542145178299</c:v>
                </c:pt>
                <c:pt idx="6986">
                  <c:v>1.96628402029033</c:v>
                </c:pt>
                <c:pt idx="6987">
                  <c:v>3.0111640325340101</c:v>
                </c:pt>
                <c:pt idx="6988">
                  <c:v>2.4924528167185098</c:v>
                </c:pt>
                <c:pt idx="6989">
                  <c:v>2.29688098188912</c:v>
                </c:pt>
                <c:pt idx="6990">
                  <c:v>2.7966354963812301</c:v>
                </c:pt>
                <c:pt idx="6991">
                  <c:v>2.3434301395094299</c:v>
                </c:pt>
                <c:pt idx="6992">
                  <c:v>2.1194261018790801</c:v>
                </c:pt>
                <c:pt idx="6993">
                  <c:v>3.31043443476594</c:v>
                </c:pt>
                <c:pt idx="6994">
                  <c:v>3.0846819768688101</c:v>
                </c:pt>
                <c:pt idx="6995">
                  <c:v>2.9463628166456899</c:v>
                </c:pt>
                <c:pt idx="6996">
                  <c:v>3.0646877368132599</c:v>
                </c:pt>
                <c:pt idx="6997">
                  <c:v>2.7801904453430599</c:v>
                </c:pt>
                <c:pt idx="6998">
                  <c:v>2.7856287551361198</c:v>
                </c:pt>
                <c:pt idx="6999">
                  <c:v>2.6243882739253102</c:v>
                </c:pt>
                <c:pt idx="7000">
                  <c:v>3.0955095694043102</c:v>
                </c:pt>
                <c:pt idx="7001">
                  <c:v>2.8313573632654201</c:v>
                </c:pt>
                <c:pt idx="7002">
                  <c:v>2.80110491190726</c:v>
                </c:pt>
                <c:pt idx="7003">
                  <c:v>3.0501092259333702</c:v>
                </c:pt>
                <c:pt idx="7004">
                  <c:v>2.5147441029614499</c:v>
                </c:pt>
                <c:pt idx="7005">
                  <c:v>2.2452612124249001</c:v>
                </c:pt>
                <c:pt idx="7006">
                  <c:v>2.31176955327338</c:v>
                </c:pt>
                <c:pt idx="7007">
                  <c:v>3.25195036089309</c:v>
                </c:pt>
                <c:pt idx="7008">
                  <c:v>2.9835767228286798</c:v>
                </c:pt>
                <c:pt idx="7009">
                  <c:v>2.0373557722934401</c:v>
                </c:pt>
                <c:pt idx="7010">
                  <c:v>2.6139008208677001</c:v>
                </c:pt>
                <c:pt idx="7011">
                  <c:v>2.08080621989515</c:v>
                </c:pt>
                <c:pt idx="7012">
                  <c:v>2.7957594851580199</c:v>
                </c:pt>
                <c:pt idx="7013">
                  <c:v>3.18740145034206</c:v>
                </c:pt>
                <c:pt idx="7014">
                  <c:v>2.0651804616179699</c:v>
                </c:pt>
                <c:pt idx="7015">
                  <c:v>3.52942304651063</c:v>
                </c:pt>
                <c:pt idx="7016">
                  <c:v>2.9496061892234899</c:v>
                </c:pt>
                <c:pt idx="7017">
                  <c:v>2.9033398303115301</c:v>
                </c:pt>
                <c:pt idx="7018">
                  <c:v>2.8109755633420299</c:v>
                </c:pt>
                <c:pt idx="7019">
                  <c:v>2.7764643725608198</c:v>
                </c:pt>
                <c:pt idx="7020">
                  <c:v>2.4254988077248099</c:v>
                </c:pt>
                <c:pt idx="7021">
                  <c:v>2.3712432481395198</c:v>
                </c:pt>
                <c:pt idx="7022">
                  <c:v>2.2426216244955999</c:v>
                </c:pt>
                <c:pt idx="7023">
                  <c:v>2.5222964574254298</c:v>
                </c:pt>
                <c:pt idx="7024">
                  <c:v>2.8786902896911402</c:v>
                </c:pt>
                <c:pt idx="7025">
                  <c:v>2.4413659047993499</c:v>
                </c:pt>
                <c:pt idx="7026">
                  <c:v>3.02114047164258</c:v>
                </c:pt>
                <c:pt idx="7027">
                  <c:v>2.5576518673294801</c:v>
                </c:pt>
                <c:pt idx="7028">
                  <c:v>3.5479094576102201</c:v>
                </c:pt>
                <c:pt idx="7029">
                  <c:v>2.8741611534484099</c:v>
                </c:pt>
                <c:pt idx="7030">
                  <c:v>2.9859553615607299</c:v>
                </c:pt>
                <c:pt idx="7031">
                  <c:v>3.0743656169251001</c:v>
                </c:pt>
                <c:pt idx="7032">
                  <c:v>2.8572144321933499</c:v>
                </c:pt>
                <c:pt idx="7033">
                  <c:v>2.32112878386876</c:v>
                </c:pt>
                <c:pt idx="7034">
                  <c:v>3.0670596084740298</c:v>
                </c:pt>
                <c:pt idx="7035">
                  <c:v>2.2732226329610401</c:v>
                </c:pt>
                <c:pt idx="7036">
                  <c:v>3.52817939437162</c:v>
                </c:pt>
                <c:pt idx="7037">
                  <c:v>2.7883836199604102</c:v>
                </c:pt>
                <c:pt idx="7038">
                  <c:v>3.0185645753314798</c:v>
                </c:pt>
                <c:pt idx="7039">
                  <c:v>2.6817257946474902</c:v>
                </c:pt>
                <c:pt idx="7040">
                  <c:v>2.9775930175225702</c:v>
                </c:pt>
                <c:pt idx="7041">
                  <c:v>3.3316802499988598</c:v>
                </c:pt>
                <c:pt idx="7042">
                  <c:v>2.75551905861925</c:v>
                </c:pt>
                <c:pt idx="7043">
                  <c:v>3.1446421355890402</c:v>
                </c:pt>
                <c:pt idx="7044">
                  <c:v>2.4217015700542799</c:v>
                </c:pt>
                <c:pt idx="7045">
                  <c:v>2.79332340346207</c:v>
                </c:pt>
                <c:pt idx="7046">
                  <c:v>2.62968183951762</c:v>
                </c:pt>
                <c:pt idx="7047">
                  <c:v>2.5777425875505502</c:v>
                </c:pt>
                <c:pt idx="7048">
                  <c:v>3.1292771324118198</c:v>
                </c:pt>
                <c:pt idx="7049">
                  <c:v>2.88195645788092</c:v>
                </c:pt>
                <c:pt idx="7050">
                  <c:v>3.3781374887903302</c:v>
                </c:pt>
                <c:pt idx="7051">
                  <c:v>2.0405372987837298</c:v>
                </c:pt>
                <c:pt idx="7052">
                  <c:v>2.6110085205752398</c:v>
                </c:pt>
                <c:pt idx="7053">
                  <c:v>3.2564336408117498</c:v>
                </c:pt>
                <c:pt idx="7054">
                  <c:v>2.9063865795281298</c:v>
                </c:pt>
                <c:pt idx="7055">
                  <c:v>2.9685401898886701</c:v>
                </c:pt>
                <c:pt idx="7056">
                  <c:v>2.5877045266505601</c:v>
                </c:pt>
                <c:pt idx="7057">
                  <c:v>2.5446911429807599</c:v>
                </c:pt>
                <c:pt idx="7058">
                  <c:v>2.9437892442257598</c:v>
                </c:pt>
                <c:pt idx="7059">
                  <c:v>2.9740730634224701</c:v>
                </c:pt>
                <c:pt idx="7060">
                  <c:v>3.2189377213907502</c:v>
                </c:pt>
                <c:pt idx="7061">
                  <c:v>2.3128201239838102</c:v>
                </c:pt>
                <c:pt idx="7062">
                  <c:v>2.7720354640871099</c:v>
                </c:pt>
                <c:pt idx="7063">
                  <c:v>3.2784490810645801</c:v>
                </c:pt>
                <c:pt idx="7064">
                  <c:v>2.4727330151656899</c:v>
                </c:pt>
                <c:pt idx="7065">
                  <c:v>2.9305123129631601</c:v>
                </c:pt>
                <c:pt idx="7066">
                  <c:v>3.2543806041432801</c:v>
                </c:pt>
                <c:pt idx="7067">
                  <c:v>3.1104985119942201</c:v>
                </c:pt>
                <c:pt idx="7068">
                  <c:v>2.4989099852712702</c:v>
                </c:pt>
                <c:pt idx="7069">
                  <c:v>2.7585878457696098</c:v>
                </c:pt>
                <c:pt idx="7070">
                  <c:v>2.5300132186061202</c:v>
                </c:pt>
                <c:pt idx="7071">
                  <c:v>3.49943082948205</c:v>
                </c:pt>
                <c:pt idx="7072">
                  <c:v>2.48244466556591</c:v>
                </c:pt>
                <c:pt idx="7073">
                  <c:v>2.6617032556866298</c:v>
                </c:pt>
                <c:pt idx="7074">
                  <c:v>3.0511386361250699</c:v>
                </c:pt>
                <c:pt idx="7075">
                  <c:v>2.8698110868703699</c:v>
                </c:pt>
                <c:pt idx="7076">
                  <c:v>2.9128746976782498</c:v>
                </c:pt>
                <c:pt idx="7077">
                  <c:v>2.4777759552770302</c:v>
                </c:pt>
                <c:pt idx="7078">
                  <c:v>3.29050008819411</c:v>
                </c:pt>
                <c:pt idx="7079">
                  <c:v>3.2370845185705699</c:v>
                </c:pt>
                <c:pt idx="7080">
                  <c:v>3.0577637557064001</c:v>
                </c:pt>
                <c:pt idx="7081">
                  <c:v>2.80950667837639</c:v>
                </c:pt>
                <c:pt idx="7082">
                  <c:v>2.9225412018131198</c:v>
                </c:pt>
                <c:pt idx="7083">
                  <c:v>3.3922164053389898</c:v>
                </c:pt>
                <c:pt idx="7084">
                  <c:v>2.3942759434281999</c:v>
                </c:pt>
                <c:pt idx="7085">
                  <c:v>3.2430358252015501</c:v>
                </c:pt>
                <c:pt idx="7086">
                  <c:v>2.73216600511843</c:v>
                </c:pt>
                <c:pt idx="7087">
                  <c:v>2.5990424806463999</c:v>
                </c:pt>
                <c:pt idx="7088">
                  <c:v>3.2614070491721101</c:v>
                </c:pt>
                <c:pt idx="7089">
                  <c:v>2.9967571770558399</c:v>
                </c:pt>
                <c:pt idx="7090">
                  <c:v>3.28898794675424</c:v>
                </c:pt>
                <c:pt idx="7091">
                  <c:v>3.1638732012892699</c:v>
                </c:pt>
                <c:pt idx="7092">
                  <c:v>2.5119625037668798</c:v>
                </c:pt>
                <c:pt idx="7093">
                  <c:v>2.8578097641490801</c:v>
                </c:pt>
                <c:pt idx="7094">
                  <c:v>2.5083271438264099</c:v>
                </c:pt>
                <c:pt idx="7095">
                  <c:v>3.1927320896453799</c:v>
                </c:pt>
                <c:pt idx="7096">
                  <c:v>2.7589424616162699</c:v>
                </c:pt>
                <c:pt idx="7097">
                  <c:v>2.7569587539287501</c:v>
                </c:pt>
                <c:pt idx="7098">
                  <c:v>3.3175028827639599</c:v>
                </c:pt>
                <c:pt idx="7099">
                  <c:v>3.0020540416538299</c:v>
                </c:pt>
                <c:pt idx="7100">
                  <c:v>2.3225607479372301</c:v>
                </c:pt>
                <c:pt idx="7101">
                  <c:v>2.7954057758266999</c:v>
                </c:pt>
                <c:pt idx="7102">
                  <c:v>2.13543383742183</c:v>
                </c:pt>
                <c:pt idx="7103">
                  <c:v>2.7668733809020001</c:v>
                </c:pt>
                <c:pt idx="7104">
                  <c:v>3.38131927204808</c:v>
                </c:pt>
                <c:pt idx="7105">
                  <c:v>2.7804864258922599</c:v>
                </c:pt>
                <c:pt idx="7106">
                  <c:v>2.5514790123755899</c:v>
                </c:pt>
                <c:pt idx="7107">
                  <c:v>2.80496110540258</c:v>
                </c:pt>
                <c:pt idx="7108">
                  <c:v>2.6673430888469398</c:v>
                </c:pt>
                <c:pt idx="7109">
                  <c:v>2.3979964250893699</c:v>
                </c:pt>
                <c:pt idx="7110">
                  <c:v>3.3703417498345001</c:v>
                </c:pt>
                <c:pt idx="7111">
                  <c:v>3.0387455193194999</c:v>
                </c:pt>
                <c:pt idx="7112">
                  <c:v>2.7310546047632802</c:v>
                </c:pt>
                <c:pt idx="7113">
                  <c:v>2.9262082340082101</c:v>
                </c:pt>
                <c:pt idx="7114">
                  <c:v>2.9633184901471101</c:v>
                </c:pt>
                <c:pt idx="7115">
                  <c:v>2.7270661124554798</c:v>
                </c:pt>
                <c:pt idx="7116">
                  <c:v>3.0955577299402499</c:v>
                </c:pt>
                <c:pt idx="7117">
                  <c:v>2.7914560016471599</c:v>
                </c:pt>
                <c:pt idx="7118">
                  <c:v>2.82922041812619</c:v>
                </c:pt>
                <c:pt idx="7119">
                  <c:v>2.83799022631759</c:v>
                </c:pt>
                <c:pt idx="7120">
                  <c:v>3.0685820122209999</c:v>
                </c:pt>
                <c:pt idx="7121">
                  <c:v>3.1509704345181899</c:v>
                </c:pt>
                <c:pt idx="7122">
                  <c:v>2.5125249655235402</c:v>
                </c:pt>
                <c:pt idx="7123">
                  <c:v>2.6162978767917702</c:v>
                </c:pt>
                <c:pt idx="7124">
                  <c:v>2.8851685145027299</c:v>
                </c:pt>
                <c:pt idx="7125">
                  <c:v>3.56943381429166</c:v>
                </c:pt>
                <c:pt idx="7126">
                  <c:v>2.8878300000760202</c:v>
                </c:pt>
                <c:pt idx="7127">
                  <c:v>2.7174884227906699</c:v>
                </c:pt>
                <c:pt idx="7128">
                  <c:v>2.9139679489841899</c:v>
                </c:pt>
                <c:pt idx="7129">
                  <c:v>2.3201656281116301</c:v>
                </c:pt>
                <c:pt idx="7130">
                  <c:v>3.1536558803619199</c:v>
                </c:pt>
                <c:pt idx="7131">
                  <c:v>3.0660709196965801</c:v>
                </c:pt>
                <c:pt idx="7132">
                  <c:v>3.5459419189588299</c:v>
                </c:pt>
                <c:pt idx="7133">
                  <c:v>3.05947662789456</c:v>
                </c:pt>
                <c:pt idx="7134">
                  <c:v>2.8897657989838299</c:v>
                </c:pt>
                <c:pt idx="7135">
                  <c:v>3.5380198573855002</c:v>
                </c:pt>
                <c:pt idx="7136">
                  <c:v>2.51072923896391</c:v>
                </c:pt>
                <c:pt idx="7137">
                  <c:v>3.2800360873740302</c:v>
                </c:pt>
                <c:pt idx="7138">
                  <c:v>3.12792665781835</c:v>
                </c:pt>
                <c:pt idx="7139">
                  <c:v>2.5891731793916102</c:v>
                </c:pt>
                <c:pt idx="7140">
                  <c:v>3.2255650336002502</c:v>
                </c:pt>
                <c:pt idx="7141">
                  <c:v>2.87644378636702</c:v>
                </c:pt>
                <c:pt idx="7142">
                  <c:v>2.9483725951191202</c:v>
                </c:pt>
                <c:pt idx="7143">
                  <c:v>3.27917759686314</c:v>
                </c:pt>
                <c:pt idx="7144">
                  <c:v>3.42767132486903</c:v>
                </c:pt>
                <c:pt idx="7145">
                  <c:v>3.3092436257312401</c:v>
                </c:pt>
                <c:pt idx="7146">
                  <c:v>3.1956652859883699</c:v>
                </c:pt>
                <c:pt idx="7147">
                  <c:v>3.4010108997854198</c:v>
                </c:pt>
                <c:pt idx="7148">
                  <c:v>2.3428540998770102</c:v>
                </c:pt>
                <c:pt idx="7149">
                  <c:v>3.1818855728024</c:v>
                </c:pt>
                <c:pt idx="7150">
                  <c:v>2.4277046766483599</c:v>
                </c:pt>
                <c:pt idx="7151">
                  <c:v>3.2017172288525999</c:v>
                </c:pt>
                <c:pt idx="7152">
                  <c:v>2.6946117734442301</c:v>
                </c:pt>
                <c:pt idx="7153">
                  <c:v>3.0289934200369402</c:v>
                </c:pt>
                <c:pt idx="7154">
                  <c:v>3.0446457165726901</c:v>
                </c:pt>
                <c:pt idx="7155">
                  <c:v>3.1137390378718202</c:v>
                </c:pt>
                <c:pt idx="7156">
                  <c:v>3.4661692583833901</c:v>
                </c:pt>
                <c:pt idx="7157">
                  <c:v>3.0792251740728398</c:v>
                </c:pt>
                <c:pt idx="7158">
                  <c:v>2.7842002971048299</c:v>
                </c:pt>
                <c:pt idx="7159">
                  <c:v>2.7839551913437601</c:v>
                </c:pt>
                <c:pt idx="7160">
                  <c:v>2.6857117234021501</c:v>
                </c:pt>
                <c:pt idx="7161">
                  <c:v>3.34993795927394</c:v>
                </c:pt>
                <c:pt idx="7162">
                  <c:v>3.1999635083365998</c:v>
                </c:pt>
                <c:pt idx="7163">
                  <c:v>3.1935151529425099</c:v>
                </c:pt>
                <c:pt idx="7164">
                  <c:v>3.43891039287616</c:v>
                </c:pt>
                <c:pt idx="7165">
                  <c:v>2.76817508211832</c:v>
                </c:pt>
                <c:pt idx="7166">
                  <c:v>2.9301245749443798</c:v>
                </c:pt>
                <c:pt idx="7167">
                  <c:v>3.2421014773824899</c:v>
                </c:pt>
                <c:pt idx="7168">
                  <c:v>3.22761558748797</c:v>
                </c:pt>
                <c:pt idx="7169">
                  <c:v>3.0581569191654498</c:v>
                </c:pt>
                <c:pt idx="7170">
                  <c:v>3.0903188037413201</c:v>
                </c:pt>
                <c:pt idx="7171">
                  <c:v>3.3481368731766001</c:v>
                </c:pt>
                <c:pt idx="7172">
                  <c:v>2.8963066483714499</c:v>
                </c:pt>
                <c:pt idx="7173">
                  <c:v>2.8048671099605502</c:v>
                </c:pt>
                <c:pt idx="7174">
                  <c:v>3.06738408483836</c:v>
                </c:pt>
                <c:pt idx="7175">
                  <c:v>3.20692054022091</c:v>
                </c:pt>
                <c:pt idx="7176">
                  <c:v>3.4974531838532501</c:v>
                </c:pt>
                <c:pt idx="7177">
                  <c:v>3.65704699566618</c:v>
                </c:pt>
                <c:pt idx="7178">
                  <c:v>3.0850731551942299</c:v>
                </c:pt>
                <c:pt idx="7179">
                  <c:v>3.12905265415765</c:v>
                </c:pt>
                <c:pt idx="7180">
                  <c:v>3.1543699895025101</c:v>
                </c:pt>
                <c:pt idx="7181">
                  <c:v>3.1739073655193102</c:v>
                </c:pt>
                <c:pt idx="7182">
                  <c:v>3.3268714209206798</c:v>
                </c:pt>
                <c:pt idx="7183">
                  <c:v>3.0433784350757702</c:v>
                </c:pt>
                <c:pt idx="7184">
                  <c:v>3.5357195254375</c:v>
                </c:pt>
                <c:pt idx="7185">
                  <c:v>2.9001749000724999</c:v>
                </c:pt>
                <c:pt idx="7186">
                  <c:v>3.0867291312541698</c:v>
                </c:pt>
                <c:pt idx="7187">
                  <c:v>3.2998884997037701</c:v>
                </c:pt>
                <c:pt idx="7188">
                  <c:v>3.3853610737775801</c:v>
                </c:pt>
                <c:pt idx="7189">
                  <c:v>3.62382331842743</c:v>
                </c:pt>
                <c:pt idx="7190">
                  <c:v>3.7320612894684002</c:v>
                </c:pt>
                <c:pt idx="7191">
                  <c:v>2.9150767751269</c:v>
                </c:pt>
                <c:pt idx="7192">
                  <c:v>3.6402266735998099</c:v>
                </c:pt>
                <c:pt idx="7193">
                  <c:v>3.07094902002365</c:v>
                </c:pt>
                <c:pt idx="7194">
                  <c:v>3.3921291610478899</c:v>
                </c:pt>
                <c:pt idx="7195">
                  <c:v>3.8748665862171001</c:v>
                </c:pt>
                <c:pt idx="7196">
                  <c:v>3.79127580992939</c:v>
                </c:pt>
                <c:pt idx="7197">
                  <c:v>2.7499218490075599</c:v>
                </c:pt>
                <c:pt idx="7198">
                  <c:v>3.34246404240865</c:v>
                </c:pt>
                <c:pt idx="7199">
                  <c:v>2.6511195467627</c:v>
                </c:pt>
                <c:pt idx="7200">
                  <c:v>2.6603836695338399</c:v>
                </c:pt>
                <c:pt idx="7201">
                  <c:v>2.5134505450595399</c:v>
                </c:pt>
                <c:pt idx="7202">
                  <c:v>3.0808289125424402</c:v>
                </c:pt>
                <c:pt idx="7203">
                  <c:v>2.41656347867344</c:v>
                </c:pt>
                <c:pt idx="7204">
                  <c:v>1.71093212839398</c:v>
                </c:pt>
                <c:pt idx="7205">
                  <c:v>1.93347518869103</c:v>
                </c:pt>
                <c:pt idx="7206">
                  <c:v>2.6602508569551899</c:v>
                </c:pt>
                <c:pt idx="7207">
                  <c:v>2.39377950004355</c:v>
                </c:pt>
                <c:pt idx="7208">
                  <c:v>2.52256974833166</c:v>
                </c:pt>
                <c:pt idx="7209">
                  <c:v>2.4581848618103601</c:v>
                </c:pt>
                <c:pt idx="7210">
                  <c:v>2.6091147281046001</c:v>
                </c:pt>
                <c:pt idx="7211">
                  <c:v>2.9622732402509899</c:v>
                </c:pt>
                <c:pt idx="7212">
                  <c:v>3.0244216243159898</c:v>
                </c:pt>
                <c:pt idx="7213">
                  <c:v>2.3651232023072999</c:v>
                </c:pt>
                <c:pt idx="7214">
                  <c:v>2.6794605017915498</c:v>
                </c:pt>
                <c:pt idx="7215">
                  <c:v>2.3362820792666401</c:v>
                </c:pt>
                <c:pt idx="7216">
                  <c:v>2.57908973164702</c:v>
                </c:pt>
                <c:pt idx="7217">
                  <c:v>2.9495997740178002</c:v>
                </c:pt>
                <c:pt idx="7218">
                  <c:v>3.5457602331460798</c:v>
                </c:pt>
                <c:pt idx="7219">
                  <c:v>2.3096333565018701</c:v>
                </c:pt>
                <c:pt idx="7220">
                  <c:v>2.4073697937007301</c:v>
                </c:pt>
                <c:pt idx="7221">
                  <c:v>2.51943363060197</c:v>
                </c:pt>
                <c:pt idx="7222">
                  <c:v>2.1852720825824301</c:v>
                </c:pt>
                <c:pt idx="7223">
                  <c:v>2.4042321346755702</c:v>
                </c:pt>
                <c:pt idx="7224">
                  <c:v>1.8163417459928199</c:v>
                </c:pt>
                <c:pt idx="7225">
                  <c:v>2.2745943415782399</c:v>
                </c:pt>
                <c:pt idx="7226">
                  <c:v>3.0244997818302699</c:v>
                </c:pt>
                <c:pt idx="7227">
                  <c:v>2.5077367943062399</c:v>
                </c:pt>
                <c:pt idx="7228">
                  <c:v>2.68614462634023</c:v>
                </c:pt>
                <c:pt idx="7229">
                  <c:v>1.9025951960142</c:v>
                </c:pt>
                <c:pt idx="7230">
                  <c:v>2.7188647515666</c:v>
                </c:pt>
                <c:pt idx="7231">
                  <c:v>2.55336618222668</c:v>
                </c:pt>
                <c:pt idx="7232">
                  <c:v>2.2302802346883599</c:v>
                </c:pt>
                <c:pt idx="7233">
                  <c:v>1.83135518029485</c:v>
                </c:pt>
                <c:pt idx="7234">
                  <c:v>2.9857796666782002</c:v>
                </c:pt>
                <c:pt idx="7235">
                  <c:v>2.6181067887166298</c:v>
                </c:pt>
                <c:pt idx="7236">
                  <c:v>2.3587423266140499</c:v>
                </c:pt>
                <c:pt idx="7237">
                  <c:v>2.8600595008867602</c:v>
                </c:pt>
                <c:pt idx="7238">
                  <c:v>2.8046621496110702</c:v>
                </c:pt>
                <c:pt idx="7239">
                  <c:v>2.69622750708217</c:v>
                </c:pt>
                <c:pt idx="7240">
                  <c:v>3.2381798505673798</c:v>
                </c:pt>
                <c:pt idx="7241">
                  <c:v>3.1703737525451898</c:v>
                </c:pt>
                <c:pt idx="7242">
                  <c:v>2.2060948252097998</c:v>
                </c:pt>
                <c:pt idx="7243">
                  <c:v>1.83790603312566</c:v>
                </c:pt>
                <c:pt idx="7244">
                  <c:v>1.9314793144376901</c:v>
                </c:pt>
                <c:pt idx="7245">
                  <c:v>2.3821911503761899</c:v>
                </c:pt>
                <c:pt idx="7246">
                  <c:v>2.3629289868097998</c:v>
                </c:pt>
                <c:pt idx="7247">
                  <c:v>2.9747477533650102</c:v>
                </c:pt>
                <c:pt idx="7248">
                  <c:v>3.32386499914226</c:v>
                </c:pt>
                <c:pt idx="7249">
                  <c:v>2.1208031957758098</c:v>
                </c:pt>
                <c:pt idx="7250">
                  <c:v>1.7313893079622</c:v>
                </c:pt>
                <c:pt idx="7251">
                  <c:v>2.3453661048745902</c:v>
                </c:pt>
                <c:pt idx="7252">
                  <c:v>2.5505294859829002</c:v>
                </c:pt>
                <c:pt idx="7253">
                  <c:v>1.94985904422845</c:v>
                </c:pt>
                <c:pt idx="7254">
                  <c:v>1.50919475910124</c:v>
                </c:pt>
                <c:pt idx="7255">
                  <c:v>2.4053032644699499</c:v>
                </c:pt>
                <c:pt idx="7256">
                  <c:v>2.0324258499365802</c:v>
                </c:pt>
                <c:pt idx="7257">
                  <c:v>2.3900701779724902</c:v>
                </c:pt>
                <c:pt idx="7258">
                  <c:v>2.6617998571398598</c:v>
                </c:pt>
                <c:pt idx="7259">
                  <c:v>2.8229236763243399</c:v>
                </c:pt>
                <c:pt idx="7260">
                  <c:v>2.6148966119582</c:v>
                </c:pt>
                <c:pt idx="7261">
                  <c:v>3.08410019501776</c:v>
                </c:pt>
                <c:pt idx="7262">
                  <c:v>2.6031428317790102</c:v>
                </c:pt>
                <c:pt idx="7263">
                  <c:v>1.9941996132267299</c:v>
                </c:pt>
                <c:pt idx="7264">
                  <c:v>2.8259582906994298</c:v>
                </c:pt>
                <c:pt idx="7265">
                  <c:v>1.2104324359985601</c:v>
                </c:pt>
                <c:pt idx="7266">
                  <c:v>3.03843100309882</c:v>
                </c:pt>
                <c:pt idx="7267">
                  <c:v>1.98645013591075</c:v>
                </c:pt>
                <c:pt idx="7268">
                  <c:v>3.3338895325928202</c:v>
                </c:pt>
                <c:pt idx="7269">
                  <c:v>2.4292827218600501</c:v>
                </c:pt>
                <c:pt idx="7270">
                  <c:v>2.5469457241273701</c:v>
                </c:pt>
                <c:pt idx="7271">
                  <c:v>2.1953055952326799</c:v>
                </c:pt>
                <c:pt idx="7272">
                  <c:v>2.34876634840758</c:v>
                </c:pt>
                <c:pt idx="7273">
                  <c:v>2.6246948984923999</c:v>
                </c:pt>
                <c:pt idx="7274">
                  <c:v>2.7862107403253602</c:v>
                </c:pt>
                <c:pt idx="7275">
                  <c:v>2.1131352902586999</c:v>
                </c:pt>
                <c:pt idx="7276">
                  <c:v>2.3081563815702402</c:v>
                </c:pt>
                <c:pt idx="7277">
                  <c:v>2.2642108944969599</c:v>
                </c:pt>
                <c:pt idx="7278">
                  <c:v>1.8694167423363399</c:v>
                </c:pt>
                <c:pt idx="7279">
                  <c:v>2.0560575708382101</c:v>
                </c:pt>
                <c:pt idx="7280">
                  <c:v>2.6756632494541801</c:v>
                </c:pt>
                <c:pt idx="7281">
                  <c:v>2.2757697464419899</c:v>
                </c:pt>
                <c:pt idx="7282">
                  <c:v>3.42236802265877</c:v>
                </c:pt>
                <c:pt idx="7283">
                  <c:v>2.95679090871434</c:v>
                </c:pt>
                <c:pt idx="7284">
                  <c:v>2.8968278735066399</c:v>
                </c:pt>
                <c:pt idx="7285">
                  <c:v>2.6164824015536201</c:v>
                </c:pt>
                <c:pt idx="7286">
                  <c:v>3.74472255882347</c:v>
                </c:pt>
                <c:pt idx="7287">
                  <c:v>3.5360528839293801</c:v>
                </c:pt>
                <c:pt idx="7288">
                  <c:v>2.5961193870360999</c:v>
                </c:pt>
                <c:pt idx="7289">
                  <c:v>3.2789375953894901</c:v>
                </c:pt>
                <c:pt idx="7290">
                  <c:v>2.86271745528181</c:v>
                </c:pt>
                <c:pt idx="7291">
                  <c:v>3.3684822354121802</c:v>
                </c:pt>
                <c:pt idx="7292">
                  <c:v>3.34045176462002</c:v>
                </c:pt>
                <c:pt idx="7293">
                  <c:v>3.80813991427428</c:v>
                </c:pt>
                <c:pt idx="7294">
                  <c:v>2.1484072832362</c:v>
                </c:pt>
                <c:pt idx="7295">
                  <c:v>1.9983925143703201</c:v>
                </c:pt>
                <c:pt idx="7296">
                  <c:v>2.3826601610297198</c:v>
                </c:pt>
                <c:pt idx="7297">
                  <c:v>2.4158307499479901</c:v>
                </c:pt>
                <c:pt idx="7298">
                  <c:v>2.8792569454116599</c:v>
                </c:pt>
                <c:pt idx="7299">
                  <c:v>2.1045434901234401</c:v>
                </c:pt>
                <c:pt idx="7300">
                  <c:v>2.40678753611851</c:v>
                </c:pt>
                <c:pt idx="7301">
                  <c:v>2.5172209284432498</c:v>
                </c:pt>
                <c:pt idx="7302">
                  <c:v>2.15118119461955</c:v>
                </c:pt>
                <c:pt idx="7303">
                  <c:v>1.63415328431855</c:v>
                </c:pt>
                <c:pt idx="7304">
                  <c:v>2.85636873554671</c:v>
                </c:pt>
                <c:pt idx="7305">
                  <c:v>2.2761581669890498</c:v>
                </c:pt>
                <c:pt idx="7306">
                  <c:v>2.95166294763616</c:v>
                </c:pt>
                <c:pt idx="7307">
                  <c:v>2.4601091056548299</c:v>
                </c:pt>
                <c:pt idx="7308">
                  <c:v>2.3287975033325798</c:v>
                </c:pt>
                <c:pt idx="7309">
                  <c:v>2.9072012517819901</c:v>
                </c:pt>
                <c:pt idx="7310">
                  <c:v>2.09377779368991</c:v>
                </c:pt>
                <c:pt idx="7311">
                  <c:v>2.0467996715306298</c:v>
                </c:pt>
                <c:pt idx="7312">
                  <c:v>2.1249971335881099</c:v>
                </c:pt>
                <c:pt idx="7313">
                  <c:v>2.1137031497983299</c:v>
                </c:pt>
                <c:pt idx="7314">
                  <c:v>2.2511835791238801</c:v>
                </c:pt>
                <c:pt idx="7315">
                  <c:v>2.8783226571379799</c:v>
                </c:pt>
                <c:pt idx="7316">
                  <c:v>2.3487901322957301</c:v>
                </c:pt>
                <c:pt idx="7317">
                  <c:v>1.96614055846886</c:v>
                </c:pt>
                <c:pt idx="7318">
                  <c:v>1.5843378160720001</c:v>
                </c:pt>
                <c:pt idx="7319">
                  <c:v>1.6895006457064301</c:v>
                </c:pt>
                <c:pt idx="7320">
                  <c:v>1.75876389597112</c:v>
                </c:pt>
                <c:pt idx="7321">
                  <c:v>2.3700448646230798</c:v>
                </c:pt>
                <c:pt idx="7322">
                  <c:v>2.81967984930108</c:v>
                </c:pt>
                <c:pt idx="7323">
                  <c:v>3.1214725767907798</c:v>
                </c:pt>
                <c:pt idx="7324">
                  <c:v>2.09441956941173</c:v>
                </c:pt>
                <c:pt idx="7325">
                  <c:v>2.3646809194852501</c:v>
                </c:pt>
                <c:pt idx="7326">
                  <c:v>2.2643566159768</c:v>
                </c:pt>
                <c:pt idx="7327">
                  <c:v>2.1628894655624</c:v>
                </c:pt>
                <c:pt idx="7328">
                  <c:v>2.30273019034014</c:v>
                </c:pt>
                <c:pt idx="7329">
                  <c:v>2.7364943544930398</c:v>
                </c:pt>
                <c:pt idx="7330">
                  <c:v>2.0768078247343</c:v>
                </c:pt>
                <c:pt idx="7331">
                  <c:v>1.9723489304744899</c:v>
                </c:pt>
                <c:pt idx="7332">
                  <c:v>2.4083956559135502</c:v>
                </c:pt>
                <c:pt idx="7333">
                  <c:v>2.0575493629195498</c:v>
                </c:pt>
                <c:pt idx="7334">
                  <c:v>1.8769361361669501</c:v>
                </c:pt>
                <c:pt idx="7335">
                  <c:v>1.99715013788846</c:v>
                </c:pt>
                <c:pt idx="7336">
                  <c:v>1.65309085128948</c:v>
                </c:pt>
                <c:pt idx="7337">
                  <c:v>1.8038075192723799</c:v>
                </c:pt>
                <c:pt idx="7338">
                  <c:v>1.9955670851329499</c:v>
                </c:pt>
                <c:pt idx="7339">
                  <c:v>1.99601175898358</c:v>
                </c:pt>
                <c:pt idx="7340">
                  <c:v>2.2192108188248998</c:v>
                </c:pt>
                <c:pt idx="7341">
                  <c:v>1.47091852603499</c:v>
                </c:pt>
                <c:pt idx="7342">
                  <c:v>1.78593934708006</c:v>
                </c:pt>
                <c:pt idx="7343">
                  <c:v>1.3887096023055301</c:v>
                </c:pt>
                <c:pt idx="7344">
                  <c:v>1.6328808603609599</c:v>
                </c:pt>
                <c:pt idx="7345">
                  <c:v>1.7048989861005801</c:v>
                </c:pt>
                <c:pt idx="7346">
                  <c:v>1.9246475355885</c:v>
                </c:pt>
                <c:pt idx="7347">
                  <c:v>1.5659107198887501</c:v>
                </c:pt>
                <c:pt idx="7348">
                  <c:v>1.83141011401871</c:v>
                </c:pt>
                <c:pt idx="7349">
                  <c:v>2.5905696844481301</c:v>
                </c:pt>
                <c:pt idx="7350">
                  <c:v>2.1321246998913899</c:v>
                </c:pt>
                <c:pt idx="7351">
                  <c:v>2.0488416583958999</c:v>
                </c:pt>
                <c:pt idx="7352">
                  <c:v>2.76628502842803</c:v>
                </c:pt>
                <c:pt idx="7353">
                  <c:v>2.0957719715487002</c:v>
                </c:pt>
                <c:pt idx="7354">
                  <c:v>2.741021942438</c:v>
                </c:pt>
                <c:pt idx="7355">
                  <c:v>1.64505064632144</c:v>
                </c:pt>
                <c:pt idx="7356">
                  <c:v>2.1527111827794099</c:v>
                </c:pt>
                <c:pt idx="7357">
                  <c:v>2.5851347092211401</c:v>
                </c:pt>
                <c:pt idx="7358">
                  <c:v>3.1299757173871301</c:v>
                </c:pt>
                <c:pt idx="7359">
                  <c:v>2.1181523971107601</c:v>
                </c:pt>
                <c:pt idx="7360">
                  <c:v>2.3822246459764398</c:v>
                </c:pt>
                <c:pt idx="7361">
                  <c:v>2.1297041587511401</c:v>
                </c:pt>
                <c:pt idx="7362">
                  <c:v>2.6109837880192601</c:v>
                </c:pt>
                <c:pt idx="7363">
                  <c:v>1.9786339227015799</c:v>
                </c:pt>
                <c:pt idx="7364">
                  <c:v>2.51555210945771</c:v>
                </c:pt>
                <c:pt idx="7365">
                  <c:v>2.2238172505568601</c:v>
                </c:pt>
                <c:pt idx="7366">
                  <c:v>2.3634402963799599</c:v>
                </c:pt>
                <c:pt idx="7367">
                  <c:v>2.1271195541177699</c:v>
                </c:pt>
                <c:pt idx="7368">
                  <c:v>2.49921862233654</c:v>
                </c:pt>
                <c:pt idx="7369">
                  <c:v>2.4406216551342901</c:v>
                </c:pt>
                <c:pt idx="7370">
                  <c:v>2.7882478427067299</c:v>
                </c:pt>
                <c:pt idx="7371">
                  <c:v>2.3392888260915501</c:v>
                </c:pt>
                <c:pt idx="7372">
                  <c:v>2.2861406385302598</c:v>
                </c:pt>
                <c:pt idx="7373">
                  <c:v>2.25815204540487</c:v>
                </c:pt>
                <c:pt idx="7374">
                  <c:v>2.6910390173498802</c:v>
                </c:pt>
                <c:pt idx="7375">
                  <c:v>2.9420617997640401</c:v>
                </c:pt>
                <c:pt idx="7376">
                  <c:v>1.8877146417056001</c:v>
                </c:pt>
                <c:pt idx="7377">
                  <c:v>2.3874731735188099</c:v>
                </c:pt>
                <c:pt idx="7378">
                  <c:v>1.4941039710672701</c:v>
                </c:pt>
                <c:pt idx="7379">
                  <c:v>2.5189024215756701</c:v>
                </c:pt>
                <c:pt idx="7380">
                  <c:v>1.72208812171486</c:v>
                </c:pt>
                <c:pt idx="7381">
                  <c:v>2.0766425678977698</c:v>
                </c:pt>
                <c:pt idx="7382">
                  <c:v>2.1253606878553302</c:v>
                </c:pt>
                <c:pt idx="7383">
                  <c:v>2.5722233857701098</c:v>
                </c:pt>
                <c:pt idx="7384">
                  <c:v>2.5723293653136898</c:v>
                </c:pt>
                <c:pt idx="7385">
                  <c:v>3.0579620289924598</c:v>
                </c:pt>
                <c:pt idx="7386">
                  <c:v>2.5595648020562001</c:v>
                </c:pt>
                <c:pt idx="7387">
                  <c:v>2.7114420440187401</c:v>
                </c:pt>
                <c:pt idx="7388">
                  <c:v>2.4783493272300001</c:v>
                </c:pt>
                <c:pt idx="7389">
                  <c:v>2.5072646868196502</c:v>
                </c:pt>
                <c:pt idx="7390">
                  <c:v>2.8778023238852501</c:v>
                </c:pt>
                <c:pt idx="7391">
                  <c:v>3.0246693007497099</c:v>
                </c:pt>
                <c:pt idx="7392">
                  <c:v>2.3444399980216302</c:v>
                </c:pt>
                <c:pt idx="7393">
                  <c:v>2.7585133809394402</c:v>
                </c:pt>
                <c:pt idx="7394">
                  <c:v>2.8514619934834</c:v>
                </c:pt>
                <c:pt idx="7395">
                  <c:v>2.8187098864517699</c:v>
                </c:pt>
                <c:pt idx="7396">
                  <c:v>2.3233303066304698</c:v>
                </c:pt>
                <c:pt idx="7397">
                  <c:v>2.40004987381697</c:v>
                </c:pt>
                <c:pt idx="7398">
                  <c:v>2.9984957645635899</c:v>
                </c:pt>
                <c:pt idx="7399">
                  <c:v>2.70874319304655</c:v>
                </c:pt>
                <c:pt idx="7400">
                  <c:v>3.1120839716487199</c:v>
                </c:pt>
                <c:pt idx="7401">
                  <c:v>2.6272537960084699</c:v>
                </c:pt>
                <c:pt idx="7402">
                  <c:v>2.7571677798492802</c:v>
                </c:pt>
                <c:pt idx="7403">
                  <c:v>2.5062011065494199</c:v>
                </c:pt>
                <c:pt idx="7404">
                  <c:v>2.3622645554306301</c:v>
                </c:pt>
                <c:pt idx="7405">
                  <c:v>2.1575552850530602</c:v>
                </c:pt>
                <c:pt idx="7406">
                  <c:v>2.39288919925343</c:v>
                </c:pt>
                <c:pt idx="7407">
                  <c:v>3.2106438184504902</c:v>
                </c:pt>
                <c:pt idx="7408">
                  <c:v>2.4975405059270699</c:v>
                </c:pt>
                <c:pt idx="7409">
                  <c:v>2.4435353869346899</c:v>
                </c:pt>
                <c:pt idx="7410">
                  <c:v>2.4052035508385998</c:v>
                </c:pt>
                <c:pt idx="7411">
                  <c:v>2.6704749011820699</c:v>
                </c:pt>
                <c:pt idx="7412">
                  <c:v>2.6056030855071</c:v>
                </c:pt>
                <c:pt idx="7413">
                  <c:v>1.98202869809184</c:v>
                </c:pt>
                <c:pt idx="7414">
                  <c:v>2.5884608437258501</c:v>
                </c:pt>
                <c:pt idx="7415">
                  <c:v>1.89892484475914</c:v>
                </c:pt>
                <c:pt idx="7416">
                  <c:v>2.8218515908467401</c:v>
                </c:pt>
                <c:pt idx="7417">
                  <c:v>2.0798640850801</c:v>
                </c:pt>
                <c:pt idx="7418">
                  <c:v>2.7007558788514401</c:v>
                </c:pt>
                <c:pt idx="7419">
                  <c:v>2.3321051498680299</c:v>
                </c:pt>
                <c:pt idx="7420">
                  <c:v>2.6341072857073802</c:v>
                </c:pt>
                <c:pt idx="7421">
                  <c:v>3.3036113594786398</c:v>
                </c:pt>
                <c:pt idx="7422">
                  <c:v>2.6503847241780498</c:v>
                </c:pt>
                <c:pt idx="7423">
                  <c:v>2.1059778756609102</c:v>
                </c:pt>
                <c:pt idx="7424">
                  <c:v>2.4335453507616598</c:v>
                </c:pt>
                <c:pt idx="7425">
                  <c:v>1.9890184469721499</c:v>
                </c:pt>
                <c:pt idx="7426">
                  <c:v>1.8970956796095899</c:v>
                </c:pt>
                <c:pt idx="7427">
                  <c:v>2.1380223310929498</c:v>
                </c:pt>
                <c:pt idx="7428">
                  <c:v>2.2855789250232399</c:v>
                </c:pt>
                <c:pt idx="7429">
                  <c:v>2.0327655577274499</c:v>
                </c:pt>
                <c:pt idx="7430">
                  <c:v>2.0154726997185701</c:v>
                </c:pt>
                <c:pt idx="7431">
                  <c:v>2.0495789038618399</c:v>
                </c:pt>
                <c:pt idx="7432">
                  <c:v>2.6475391865549902</c:v>
                </c:pt>
                <c:pt idx="7433">
                  <c:v>1.89559575155496</c:v>
                </c:pt>
                <c:pt idx="7434">
                  <c:v>2.3458659408723301</c:v>
                </c:pt>
                <c:pt idx="7435">
                  <c:v>1.9566670868534399</c:v>
                </c:pt>
                <c:pt idx="7436">
                  <c:v>2.40234850281644</c:v>
                </c:pt>
                <c:pt idx="7437">
                  <c:v>1.9157106115454801</c:v>
                </c:pt>
                <c:pt idx="7438">
                  <c:v>1.8057065462278601</c:v>
                </c:pt>
                <c:pt idx="7439">
                  <c:v>1.67024523800817</c:v>
                </c:pt>
                <c:pt idx="7440">
                  <c:v>2.5253691277154799</c:v>
                </c:pt>
                <c:pt idx="7441">
                  <c:v>2.3564261900619501</c:v>
                </c:pt>
                <c:pt idx="7442">
                  <c:v>2.6303280030495499</c:v>
                </c:pt>
                <c:pt idx="7443">
                  <c:v>2.5733810088467202</c:v>
                </c:pt>
                <c:pt idx="7444">
                  <c:v>2.50265943651263</c:v>
                </c:pt>
                <c:pt idx="7445">
                  <c:v>2.62737309055826</c:v>
                </c:pt>
                <c:pt idx="7446">
                  <c:v>2.3441643120825999</c:v>
                </c:pt>
                <c:pt idx="7447">
                  <c:v>1.9580666787829899</c:v>
                </c:pt>
                <c:pt idx="7448">
                  <c:v>2.1077583164917399</c:v>
                </c:pt>
                <c:pt idx="7449">
                  <c:v>2.19576787727999</c:v>
                </c:pt>
                <c:pt idx="7450">
                  <c:v>2.1259729870812398</c:v>
                </c:pt>
                <c:pt idx="7451">
                  <c:v>1.7514641674731499</c:v>
                </c:pt>
                <c:pt idx="7452">
                  <c:v>2.2835320666046202</c:v>
                </c:pt>
                <c:pt idx="7453">
                  <c:v>2.54443619509926</c:v>
                </c:pt>
                <c:pt idx="7454">
                  <c:v>2.5541044269611399</c:v>
                </c:pt>
                <c:pt idx="7455">
                  <c:v>2.7301659661978701</c:v>
                </c:pt>
                <c:pt idx="7456">
                  <c:v>2.1909585879445101</c:v>
                </c:pt>
                <c:pt idx="7457">
                  <c:v>2.5054703585901699</c:v>
                </c:pt>
                <c:pt idx="7458">
                  <c:v>1.48664296787855</c:v>
                </c:pt>
                <c:pt idx="7459">
                  <c:v>2.10997117697449</c:v>
                </c:pt>
                <c:pt idx="7460">
                  <c:v>2.3595078603930202</c:v>
                </c:pt>
                <c:pt idx="7461">
                  <c:v>2.4910903499922301</c:v>
                </c:pt>
                <c:pt idx="7462">
                  <c:v>2.3975498177323198</c:v>
                </c:pt>
                <c:pt idx="7463">
                  <c:v>2.3032274273420499</c:v>
                </c:pt>
                <c:pt idx="7464">
                  <c:v>2.27871081053082</c:v>
                </c:pt>
                <c:pt idx="7465">
                  <c:v>2.0505138295963499</c:v>
                </c:pt>
                <c:pt idx="7466">
                  <c:v>2.5859116608972301</c:v>
                </c:pt>
                <c:pt idx="7467">
                  <c:v>2.2569328317635602</c:v>
                </c:pt>
                <c:pt idx="7468">
                  <c:v>3.6312984447519998</c:v>
                </c:pt>
                <c:pt idx="7469">
                  <c:v>2.6326457415409501</c:v>
                </c:pt>
                <c:pt idx="7470">
                  <c:v>2.69245082549571</c:v>
                </c:pt>
                <c:pt idx="7471">
                  <c:v>2.9258370504048501</c:v>
                </c:pt>
                <c:pt idx="7472">
                  <c:v>3.4236496532639902</c:v>
                </c:pt>
                <c:pt idx="7473">
                  <c:v>3.3859442220285501</c:v>
                </c:pt>
                <c:pt idx="7474">
                  <c:v>2.9203670324121802</c:v>
                </c:pt>
                <c:pt idx="7475">
                  <c:v>3.2705244083715601</c:v>
                </c:pt>
                <c:pt idx="7476">
                  <c:v>3.1786330775373401</c:v>
                </c:pt>
                <c:pt idx="7477">
                  <c:v>3.0895018012904498</c:v>
                </c:pt>
                <c:pt idx="7478">
                  <c:v>3.3412667312470901</c:v>
                </c:pt>
                <c:pt idx="7479">
                  <c:v>2.2256179385867099</c:v>
                </c:pt>
                <c:pt idx="7480">
                  <c:v>2.5589117235288201</c:v>
                </c:pt>
                <c:pt idx="7481">
                  <c:v>1.8014561993870699</c:v>
                </c:pt>
                <c:pt idx="7482">
                  <c:v>2.07318606116096</c:v>
                </c:pt>
                <c:pt idx="7483">
                  <c:v>3.0222670964367802</c:v>
                </c:pt>
                <c:pt idx="7484">
                  <c:v>2.8276152282395701</c:v>
                </c:pt>
                <c:pt idx="7485">
                  <c:v>2.6181216960481599</c:v>
                </c:pt>
                <c:pt idx="7486">
                  <c:v>2.4510868356688098</c:v>
                </c:pt>
                <c:pt idx="7487">
                  <c:v>3.0213550440188999</c:v>
                </c:pt>
                <c:pt idx="7488">
                  <c:v>2.7454877039857299</c:v>
                </c:pt>
                <c:pt idx="7489">
                  <c:v>2.7357895676418398</c:v>
                </c:pt>
                <c:pt idx="7490">
                  <c:v>3.1206795999214498</c:v>
                </c:pt>
                <c:pt idx="7491">
                  <c:v>2.4838143721793702</c:v>
                </c:pt>
                <c:pt idx="7492">
                  <c:v>2.33812500333616</c:v>
                </c:pt>
                <c:pt idx="7493">
                  <c:v>2.3800412397544499</c:v>
                </c:pt>
                <c:pt idx="7494">
                  <c:v>3.1221801398011801</c:v>
                </c:pt>
                <c:pt idx="7495">
                  <c:v>2.6027708133127101</c:v>
                </c:pt>
                <c:pt idx="7496">
                  <c:v>2.9980487927413999</c:v>
                </c:pt>
                <c:pt idx="7497">
                  <c:v>2.9398046360058401</c:v>
                </c:pt>
                <c:pt idx="7498">
                  <c:v>2.6587778867557099</c:v>
                </c:pt>
                <c:pt idx="7499">
                  <c:v>2.4791456399603899</c:v>
                </c:pt>
                <c:pt idx="7500">
                  <c:v>2.42986466125787</c:v>
                </c:pt>
                <c:pt idx="7501">
                  <c:v>2.3516854162434901</c:v>
                </c:pt>
                <c:pt idx="7502">
                  <c:v>2.43161660724263</c:v>
                </c:pt>
                <c:pt idx="7503">
                  <c:v>2.1878314452080301</c:v>
                </c:pt>
                <c:pt idx="7504">
                  <c:v>2.55935661039292</c:v>
                </c:pt>
                <c:pt idx="7505">
                  <c:v>2.22440476473226</c:v>
                </c:pt>
                <c:pt idx="7506">
                  <c:v>2.6866199811983802</c:v>
                </c:pt>
                <c:pt idx="7507">
                  <c:v>2.3682212001933598</c:v>
                </c:pt>
                <c:pt idx="7508">
                  <c:v>2.50259597324396</c:v>
                </c:pt>
                <c:pt idx="7509">
                  <c:v>2.2353107469492501</c:v>
                </c:pt>
                <c:pt idx="7510">
                  <c:v>2.3212894232664598</c:v>
                </c:pt>
                <c:pt idx="7511">
                  <c:v>2.3248054088191998</c:v>
                </c:pt>
                <c:pt idx="7512">
                  <c:v>3.0325533338475998</c:v>
                </c:pt>
                <c:pt idx="7513">
                  <c:v>2.7709755588239999</c:v>
                </c:pt>
                <c:pt idx="7514">
                  <c:v>2.5430387028387802</c:v>
                </c:pt>
                <c:pt idx="7515">
                  <c:v>2.1775146433208601</c:v>
                </c:pt>
                <c:pt idx="7516">
                  <c:v>1.9785666975818901</c:v>
                </c:pt>
                <c:pt idx="7517">
                  <c:v>3.6888261573855798</c:v>
                </c:pt>
                <c:pt idx="7518">
                  <c:v>2.9134328277561901</c:v>
                </c:pt>
                <c:pt idx="7519">
                  <c:v>2.9828682261070099</c:v>
                </c:pt>
                <c:pt idx="7520">
                  <c:v>2.0358243178210902</c:v>
                </c:pt>
                <c:pt idx="7521">
                  <c:v>2.4931398493359298</c:v>
                </c:pt>
                <c:pt idx="7522">
                  <c:v>2.5624189224722</c:v>
                </c:pt>
                <c:pt idx="7523">
                  <c:v>3.1636919396711298</c:v>
                </c:pt>
                <c:pt idx="7524">
                  <c:v>2.8971218014153601</c:v>
                </c:pt>
                <c:pt idx="7525">
                  <c:v>2.64457597705821</c:v>
                </c:pt>
                <c:pt idx="7526">
                  <c:v>3.0444290723964702</c:v>
                </c:pt>
                <c:pt idx="7527">
                  <c:v>2.4416042864840799</c:v>
                </c:pt>
                <c:pt idx="7528">
                  <c:v>2.57465139514709</c:v>
                </c:pt>
                <c:pt idx="7529">
                  <c:v>2.2584061880705799</c:v>
                </c:pt>
                <c:pt idx="7530">
                  <c:v>3.0461511265830299</c:v>
                </c:pt>
                <c:pt idx="7531">
                  <c:v>2.1707002559376498</c:v>
                </c:pt>
                <c:pt idx="7532">
                  <c:v>2.7101864109151399</c:v>
                </c:pt>
                <c:pt idx="7533">
                  <c:v>2.43277226881741</c:v>
                </c:pt>
                <c:pt idx="7534">
                  <c:v>2.02840086682667</c:v>
                </c:pt>
                <c:pt idx="7535">
                  <c:v>2.6462641754851499</c:v>
                </c:pt>
                <c:pt idx="7536">
                  <c:v>3.0443034676925298</c:v>
                </c:pt>
                <c:pt idx="7537">
                  <c:v>2.9114513374063602</c:v>
                </c:pt>
                <c:pt idx="7538">
                  <c:v>2.8807286071850902</c:v>
                </c:pt>
                <c:pt idx="7539">
                  <c:v>2.8856778274428998</c:v>
                </c:pt>
                <c:pt idx="7540">
                  <c:v>2.6293089494789301</c:v>
                </c:pt>
                <c:pt idx="7541">
                  <c:v>2.8729284383534299</c:v>
                </c:pt>
                <c:pt idx="7542">
                  <c:v>2.6626907903868098</c:v>
                </c:pt>
                <c:pt idx="7543">
                  <c:v>2.4338964416182098</c:v>
                </c:pt>
                <c:pt idx="7544">
                  <c:v>2.6098926683358199</c:v>
                </c:pt>
                <c:pt idx="7545">
                  <c:v>2.4773896482515698</c:v>
                </c:pt>
                <c:pt idx="7546">
                  <c:v>3.0539299708569798</c:v>
                </c:pt>
                <c:pt idx="7547">
                  <c:v>2.2711206871676302</c:v>
                </c:pt>
                <c:pt idx="7548">
                  <c:v>2.4081320104864798</c:v>
                </c:pt>
                <c:pt idx="7549">
                  <c:v>2.79919399199601</c:v>
                </c:pt>
                <c:pt idx="7550">
                  <c:v>3.35845424664479</c:v>
                </c:pt>
                <c:pt idx="7551">
                  <c:v>3.0456968526142001</c:v>
                </c:pt>
                <c:pt idx="7552">
                  <c:v>2.6561474158938401</c:v>
                </c:pt>
                <c:pt idx="7553">
                  <c:v>1.9605200214330101</c:v>
                </c:pt>
                <c:pt idx="7554">
                  <c:v>2.4498181215049102</c:v>
                </c:pt>
                <c:pt idx="7555">
                  <c:v>2.2018450693107101</c:v>
                </c:pt>
                <c:pt idx="7556">
                  <c:v>2.12430242090903</c:v>
                </c:pt>
                <c:pt idx="7557">
                  <c:v>3.2169367385259302</c:v>
                </c:pt>
                <c:pt idx="7558">
                  <c:v>2.4985946760132398</c:v>
                </c:pt>
                <c:pt idx="7559">
                  <c:v>2.3588786305168998</c:v>
                </c:pt>
                <c:pt idx="7560">
                  <c:v>2.5444927464196798</c:v>
                </c:pt>
                <c:pt idx="7561">
                  <c:v>3.13308909624975</c:v>
                </c:pt>
                <c:pt idx="7562">
                  <c:v>3.0610599390134299</c:v>
                </c:pt>
                <c:pt idx="7563">
                  <c:v>2.6028440456487498</c:v>
                </c:pt>
                <c:pt idx="7564">
                  <c:v>2.8981259590605402</c:v>
                </c:pt>
                <c:pt idx="7565">
                  <c:v>2.82378087021785</c:v>
                </c:pt>
                <c:pt idx="7566">
                  <c:v>2.3803812755365201</c:v>
                </c:pt>
                <c:pt idx="7567">
                  <c:v>2.7126934420469802</c:v>
                </c:pt>
                <c:pt idx="7568">
                  <c:v>2.9771785287170802</c:v>
                </c:pt>
                <c:pt idx="7569">
                  <c:v>2.6200527742068802</c:v>
                </c:pt>
                <c:pt idx="7570">
                  <c:v>2.6627046621758401</c:v>
                </c:pt>
                <c:pt idx="7571">
                  <c:v>2.2363435680158701</c:v>
                </c:pt>
                <c:pt idx="7572">
                  <c:v>3.2757716461107398</c:v>
                </c:pt>
                <c:pt idx="7573">
                  <c:v>3.5579133831157801</c:v>
                </c:pt>
                <c:pt idx="7574">
                  <c:v>2.2277339882018699</c:v>
                </c:pt>
                <c:pt idx="7575">
                  <c:v>2.8904141905499601</c:v>
                </c:pt>
                <c:pt idx="7576">
                  <c:v>3.1945851678999202</c:v>
                </c:pt>
                <c:pt idx="7577">
                  <c:v>2.7750104212578401</c:v>
                </c:pt>
                <c:pt idx="7578">
                  <c:v>2.5324284963887802</c:v>
                </c:pt>
                <c:pt idx="7579">
                  <c:v>3.01087603128332</c:v>
                </c:pt>
                <c:pt idx="7580">
                  <c:v>2.2631013047026598</c:v>
                </c:pt>
                <c:pt idx="7581">
                  <c:v>2.4757028185646699</c:v>
                </c:pt>
                <c:pt idx="7582">
                  <c:v>3.39210149255858</c:v>
                </c:pt>
                <c:pt idx="7583">
                  <c:v>3.09033806808575</c:v>
                </c:pt>
                <c:pt idx="7584">
                  <c:v>3.31848408313216</c:v>
                </c:pt>
                <c:pt idx="7585">
                  <c:v>2.7111317151286598</c:v>
                </c:pt>
                <c:pt idx="7586">
                  <c:v>2.9493711498188602</c:v>
                </c:pt>
                <c:pt idx="7587">
                  <c:v>1.9192368754417</c:v>
                </c:pt>
                <c:pt idx="7588">
                  <c:v>2.6660833753948601</c:v>
                </c:pt>
                <c:pt idx="7589">
                  <c:v>3.1302314872352301</c:v>
                </c:pt>
                <c:pt idx="7590">
                  <c:v>3.2234818319085301</c:v>
                </c:pt>
                <c:pt idx="7591">
                  <c:v>3.2786612663565098</c:v>
                </c:pt>
                <c:pt idx="7592">
                  <c:v>2.9178948616514799</c:v>
                </c:pt>
                <c:pt idx="7593">
                  <c:v>2.65309293981701</c:v>
                </c:pt>
                <c:pt idx="7594">
                  <c:v>2.7591441895159901</c:v>
                </c:pt>
                <c:pt idx="7595">
                  <c:v>2.4558302137462098</c:v>
                </c:pt>
                <c:pt idx="7596">
                  <c:v>2.5043830996566099</c:v>
                </c:pt>
                <c:pt idx="7597">
                  <c:v>2.45827926908796</c:v>
                </c:pt>
                <c:pt idx="7598">
                  <c:v>2.1157896778156098</c:v>
                </c:pt>
                <c:pt idx="7599">
                  <c:v>2.8898107820946799</c:v>
                </c:pt>
                <c:pt idx="7600">
                  <c:v>2.8391021934246701</c:v>
                </c:pt>
                <c:pt idx="7601">
                  <c:v>2.09057906401017</c:v>
                </c:pt>
                <c:pt idx="7602">
                  <c:v>2.9382419799756501</c:v>
                </c:pt>
                <c:pt idx="7603">
                  <c:v>1.91740533999028</c:v>
                </c:pt>
                <c:pt idx="7604">
                  <c:v>2.96724827737185</c:v>
                </c:pt>
                <c:pt idx="7605">
                  <c:v>3.1248770371338499</c:v>
                </c:pt>
                <c:pt idx="7606">
                  <c:v>2.6290091637370998</c:v>
                </c:pt>
                <c:pt idx="7607">
                  <c:v>2.1916617811054002</c:v>
                </c:pt>
                <c:pt idx="7608">
                  <c:v>2.68946929096863</c:v>
                </c:pt>
                <c:pt idx="7609">
                  <c:v>2.4084448643590299</c:v>
                </c:pt>
                <c:pt idx="7610">
                  <c:v>3.0162871260653601</c:v>
                </c:pt>
                <c:pt idx="7611">
                  <c:v>1.6521442248188201</c:v>
                </c:pt>
                <c:pt idx="7612">
                  <c:v>2.22298212148117</c:v>
                </c:pt>
                <c:pt idx="7613">
                  <c:v>2.4419419352509899</c:v>
                </c:pt>
                <c:pt idx="7614">
                  <c:v>2.4886614675322201</c:v>
                </c:pt>
                <c:pt idx="7615">
                  <c:v>2.37760111021423</c:v>
                </c:pt>
                <c:pt idx="7616">
                  <c:v>2.0705480154739999</c:v>
                </c:pt>
                <c:pt idx="7617">
                  <c:v>2.6634787685000099</c:v>
                </c:pt>
                <c:pt idx="7618">
                  <c:v>2.6638074045135101</c:v>
                </c:pt>
                <c:pt idx="7619">
                  <c:v>2.28130730951198</c:v>
                </c:pt>
                <c:pt idx="7620">
                  <c:v>2.7997269748067399</c:v>
                </c:pt>
                <c:pt idx="7621">
                  <c:v>2.78939162740215</c:v>
                </c:pt>
                <c:pt idx="7622">
                  <c:v>2.1194703532425301</c:v>
                </c:pt>
                <c:pt idx="7623">
                  <c:v>2.5075969252388002</c:v>
                </c:pt>
                <c:pt idx="7624">
                  <c:v>3.1590156267201701</c:v>
                </c:pt>
                <c:pt idx="7625">
                  <c:v>2.3911470315514598</c:v>
                </c:pt>
                <c:pt idx="7626">
                  <c:v>2.3096809381305401</c:v>
                </c:pt>
                <c:pt idx="7627">
                  <c:v>2.6664333658814199</c:v>
                </c:pt>
                <c:pt idx="7628">
                  <c:v>2.6283122523475</c:v>
                </c:pt>
                <c:pt idx="7629">
                  <c:v>3.1246374696330999</c:v>
                </c:pt>
                <c:pt idx="7630">
                  <c:v>2.4488913000162502</c:v>
                </c:pt>
                <c:pt idx="7631">
                  <c:v>2.6435346581627401</c:v>
                </c:pt>
                <c:pt idx="7632">
                  <c:v>3.1242573432059002</c:v>
                </c:pt>
                <c:pt idx="7633">
                  <c:v>2.0152053649282702</c:v>
                </c:pt>
                <c:pt idx="7634">
                  <c:v>3.6058258308028899</c:v>
                </c:pt>
                <c:pt idx="7635">
                  <c:v>3.1912671539143602</c:v>
                </c:pt>
                <c:pt idx="7636">
                  <c:v>1.8608366950398401</c:v>
                </c:pt>
                <c:pt idx="7637">
                  <c:v>3.11105775713918</c:v>
                </c:pt>
                <c:pt idx="7638">
                  <c:v>2.4374194233863702</c:v>
                </c:pt>
                <c:pt idx="7639">
                  <c:v>1.6552229662790701</c:v>
                </c:pt>
                <c:pt idx="7640">
                  <c:v>2.8616533041397298</c:v>
                </c:pt>
                <c:pt idx="7641">
                  <c:v>2.9110156956789801</c:v>
                </c:pt>
                <c:pt idx="7642">
                  <c:v>2.7454199621387199</c:v>
                </c:pt>
                <c:pt idx="7643">
                  <c:v>2.2983500254445501</c:v>
                </c:pt>
                <c:pt idx="7644">
                  <c:v>2.5752090828029499</c:v>
                </c:pt>
                <c:pt idx="7645">
                  <c:v>2.8077370069232201</c:v>
                </c:pt>
                <c:pt idx="7646">
                  <c:v>2.9446525128365999</c:v>
                </c:pt>
                <c:pt idx="7647">
                  <c:v>3.0565451821559102</c:v>
                </c:pt>
                <c:pt idx="7648">
                  <c:v>2.5174031526194902</c:v>
                </c:pt>
                <c:pt idx="7649">
                  <c:v>2.2856590674756601</c:v>
                </c:pt>
                <c:pt idx="7650">
                  <c:v>2.7815682844055898</c:v>
                </c:pt>
                <c:pt idx="7651">
                  <c:v>2.7771230210483799</c:v>
                </c:pt>
                <c:pt idx="7652">
                  <c:v>2.9029442754781201</c:v>
                </c:pt>
                <c:pt idx="7653">
                  <c:v>3.5019396675215901</c:v>
                </c:pt>
                <c:pt idx="7654">
                  <c:v>2.94468696219647</c:v>
                </c:pt>
                <c:pt idx="7655">
                  <c:v>3.0823678043912301</c:v>
                </c:pt>
                <c:pt idx="7656">
                  <c:v>2.8988660274639</c:v>
                </c:pt>
                <c:pt idx="7657">
                  <c:v>2.6875419977299901</c:v>
                </c:pt>
                <c:pt idx="7658">
                  <c:v>2.7976386008368501</c:v>
                </c:pt>
                <c:pt idx="7659">
                  <c:v>2.9763572526585702</c:v>
                </c:pt>
                <c:pt idx="7660">
                  <c:v>2.8627897297435498</c:v>
                </c:pt>
                <c:pt idx="7661">
                  <c:v>2.6640485230307598</c:v>
                </c:pt>
                <c:pt idx="7662">
                  <c:v>2.33242554775356</c:v>
                </c:pt>
                <c:pt idx="7663">
                  <c:v>2.9032867175491801</c:v>
                </c:pt>
                <c:pt idx="7664">
                  <c:v>2.57064879247068</c:v>
                </c:pt>
                <c:pt idx="7665">
                  <c:v>2.27654073970103</c:v>
                </c:pt>
                <c:pt idx="7666">
                  <c:v>1.6668675051409101</c:v>
                </c:pt>
                <c:pt idx="7667">
                  <c:v>2.2850603138087102</c:v>
                </c:pt>
                <c:pt idx="7668">
                  <c:v>2.2238979907789602</c:v>
                </c:pt>
                <c:pt idx="7669">
                  <c:v>2.0954228766270702</c:v>
                </c:pt>
                <c:pt idx="7670">
                  <c:v>2.3272932481518001</c:v>
                </c:pt>
                <c:pt idx="7671">
                  <c:v>2.4300947599296601</c:v>
                </c:pt>
                <c:pt idx="7672">
                  <c:v>3.1632179921959298</c:v>
                </c:pt>
                <c:pt idx="7673">
                  <c:v>3.3801391938342</c:v>
                </c:pt>
                <c:pt idx="7674">
                  <c:v>2.85460838322662</c:v>
                </c:pt>
                <c:pt idx="7675">
                  <c:v>2.4572892746065498</c:v>
                </c:pt>
                <c:pt idx="7676">
                  <c:v>2.0155763786276202</c:v>
                </c:pt>
                <c:pt idx="7677">
                  <c:v>3.1678205293025399</c:v>
                </c:pt>
                <c:pt idx="7678">
                  <c:v>2.0710441892534899</c:v>
                </c:pt>
                <c:pt idx="7679">
                  <c:v>2.4065971553128098</c:v>
                </c:pt>
                <c:pt idx="7680">
                  <c:v>2.3810564344983498</c:v>
                </c:pt>
                <c:pt idx="7681">
                  <c:v>2.61656258758196</c:v>
                </c:pt>
                <c:pt idx="7682">
                  <c:v>2.95423732804842</c:v>
                </c:pt>
                <c:pt idx="7683">
                  <c:v>3.0311880560084301</c:v>
                </c:pt>
                <c:pt idx="7684">
                  <c:v>1.94611942353402</c:v>
                </c:pt>
                <c:pt idx="7685">
                  <c:v>2.1381952068580401</c:v>
                </c:pt>
                <c:pt idx="7686">
                  <c:v>3.3529014233524399</c:v>
                </c:pt>
                <c:pt idx="7687">
                  <c:v>2.82537414204198</c:v>
                </c:pt>
                <c:pt idx="7688">
                  <c:v>2.0953899620669798</c:v>
                </c:pt>
                <c:pt idx="7689">
                  <c:v>2.21022047741844</c:v>
                </c:pt>
                <c:pt idx="7690">
                  <c:v>2.38225459808287</c:v>
                </c:pt>
                <c:pt idx="7691">
                  <c:v>2.8554303698755801</c:v>
                </c:pt>
                <c:pt idx="7692">
                  <c:v>2.4815959625091901</c:v>
                </c:pt>
                <c:pt idx="7693">
                  <c:v>3.1516289560573099</c:v>
                </c:pt>
                <c:pt idx="7694">
                  <c:v>2.4309215898911098</c:v>
                </c:pt>
                <c:pt idx="7695">
                  <c:v>1.81516902246092</c:v>
                </c:pt>
                <c:pt idx="7696">
                  <c:v>1.9656293944002801</c:v>
                </c:pt>
                <c:pt idx="7697">
                  <c:v>2.9350814791725699</c:v>
                </c:pt>
                <c:pt idx="7698">
                  <c:v>1.76108916582064</c:v>
                </c:pt>
                <c:pt idx="7699">
                  <c:v>1.9425787078177501</c:v>
                </c:pt>
                <c:pt idx="7700">
                  <c:v>2.4974880625779599</c:v>
                </c:pt>
                <c:pt idx="7701">
                  <c:v>2.46882111818655</c:v>
                </c:pt>
                <c:pt idx="7702">
                  <c:v>2.41239425386541</c:v>
                </c:pt>
                <c:pt idx="7703">
                  <c:v>2.6492761323709901</c:v>
                </c:pt>
                <c:pt idx="7704">
                  <c:v>2.79172841883274</c:v>
                </c:pt>
                <c:pt idx="7705">
                  <c:v>2.4752015351141199</c:v>
                </c:pt>
                <c:pt idx="7706">
                  <c:v>1.7737448062393499</c:v>
                </c:pt>
                <c:pt idx="7707">
                  <c:v>2.55150925210941</c:v>
                </c:pt>
                <c:pt idx="7708">
                  <c:v>2.47563519106598</c:v>
                </c:pt>
                <c:pt idx="7709">
                  <c:v>2.2736523743787602</c:v>
                </c:pt>
                <c:pt idx="7710">
                  <c:v>2.7560069626979198</c:v>
                </c:pt>
                <c:pt idx="7711">
                  <c:v>2.7362235886798598</c:v>
                </c:pt>
                <c:pt idx="7712">
                  <c:v>2.9606780903273302</c:v>
                </c:pt>
                <c:pt idx="7713">
                  <c:v>2.2116492432688202</c:v>
                </c:pt>
                <c:pt idx="7714">
                  <c:v>2.6370967973058201</c:v>
                </c:pt>
                <c:pt idx="7715">
                  <c:v>1.9679918607739499</c:v>
                </c:pt>
                <c:pt idx="7716">
                  <c:v>2.4235385495151198</c:v>
                </c:pt>
                <c:pt idx="7717">
                  <c:v>2.3635088650821299</c:v>
                </c:pt>
                <c:pt idx="7718">
                  <c:v>3.01580824869112</c:v>
                </c:pt>
                <c:pt idx="7719">
                  <c:v>2.7696324285750999</c:v>
                </c:pt>
                <c:pt idx="7720">
                  <c:v>2.68496298367252</c:v>
                </c:pt>
                <c:pt idx="7721">
                  <c:v>3.0978616543592898</c:v>
                </c:pt>
                <c:pt idx="7722">
                  <c:v>2.1215567908689001</c:v>
                </c:pt>
                <c:pt idx="7723">
                  <c:v>1.6999705965241201</c:v>
                </c:pt>
                <c:pt idx="7724">
                  <c:v>2.76368649950735</c:v>
                </c:pt>
                <c:pt idx="7725">
                  <c:v>2.5420321403867199</c:v>
                </c:pt>
                <c:pt idx="7726">
                  <c:v>2.2064790549070099</c:v>
                </c:pt>
                <c:pt idx="7727">
                  <c:v>2.4288238194627301</c:v>
                </c:pt>
                <c:pt idx="7728">
                  <c:v>1.98421351090267</c:v>
                </c:pt>
                <c:pt idx="7729">
                  <c:v>2.81700437554449</c:v>
                </c:pt>
                <c:pt idx="7730">
                  <c:v>3.0946190510489102</c:v>
                </c:pt>
                <c:pt idx="7731">
                  <c:v>2.5735213811469602</c:v>
                </c:pt>
                <c:pt idx="7732">
                  <c:v>2.6968972194961598</c:v>
                </c:pt>
                <c:pt idx="7733">
                  <c:v>3.3847245528931502</c:v>
                </c:pt>
                <c:pt idx="7734">
                  <c:v>2.5470645455046501</c:v>
                </c:pt>
                <c:pt idx="7735">
                  <c:v>2.3983829903523599</c:v>
                </c:pt>
                <c:pt idx="7736">
                  <c:v>2.7193608122147701</c:v>
                </c:pt>
                <c:pt idx="7737">
                  <c:v>2.7551593840914301</c:v>
                </c:pt>
                <c:pt idx="7738">
                  <c:v>2.8307902635817799</c:v>
                </c:pt>
                <c:pt idx="7739">
                  <c:v>2.3952529380152101</c:v>
                </c:pt>
                <c:pt idx="7740">
                  <c:v>2.5062453735024399</c:v>
                </c:pt>
                <c:pt idx="7741">
                  <c:v>2.8491322791940399</c:v>
                </c:pt>
                <c:pt idx="7742">
                  <c:v>2.2194452751409299</c:v>
                </c:pt>
                <c:pt idx="7743">
                  <c:v>2.2965577162829698</c:v>
                </c:pt>
                <c:pt idx="7744">
                  <c:v>2.12608997104762</c:v>
                </c:pt>
                <c:pt idx="7745">
                  <c:v>2.6533415865338199</c:v>
                </c:pt>
                <c:pt idx="7746">
                  <c:v>2.4223967763820902</c:v>
                </c:pt>
                <c:pt idx="7747">
                  <c:v>2.7750433272536599</c:v>
                </c:pt>
                <c:pt idx="7748">
                  <c:v>2.7511658393801102</c:v>
                </c:pt>
                <c:pt idx="7749">
                  <c:v>2.8095899527860002</c:v>
                </c:pt>
                <c:pt idx="7750">
                  <c:v>2.72137423679121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EB6-4E5B-A29A-C1E38892F60F}"/>
            </c:ext>
          </c:extLst>
        </c:ser>
        <c:ser>
          <c:idx val="1"/>
          <c:order val="1"/>
          <c:tx>
            <c:v>GtfA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heet1!$D$2:$D$4801</c:f>
              <c:numCache>
                <c:formatCode>General</c:formatCode>
                <c:ptCount val="4800"/>
                <c:pt idx="0">
                  <c:v>0</c:v>
                </c:pt>
                <c:pt idx="1">
                  <c:v>0.23958333333333301</c:v>
                </c:pt>
                <c:pt idx="2">
                  <c:v>0.47916666666666702</c:v>
                </c:pt>
                <c:pt idx="3">
                  <c:v>0.71875</c:v>
                </c:pt>
                <c:pt idx="4">
                  <c:v>0.95833333333333304</c:v>
                </c:pt>
                <c:pt idx="5">
                  <c:v>1.1979166666666701</c:v>
                </c:pt>
                <c:pt idx="6">
                  <c:v>1.4375</c:v>
                </c:pt>
                <c:pt idx="7">
                  <c:v>1.6770833333333299</c:v>
                </c:pt>
                <c:pt idx="8">
                  <c:v>1.9166666666666701</c:v>
                </c:pt>
                <c:pt idx="9">
                  <c:v>2.15625</c:v>
                </c:pt>
                <c:pt idx="10">
                  <c:v>2.3958333333333299</c:v>
                </c:pt>
                <c:pt idx="11">
                  <c:v>2.6354166666666701</c:v>
                </c:pt>
                <c:pt idx="12">
                  <c:v>2.875</c:v>
                </c:pt>
                <c:pt idx="13">
                  <c:v>3.1145833333333299</c:v>
                </c:pt>
                <c:pt idx="14">
                  <c:v>3.3541666666666701</c:v>
                </c:pt>
                <c:pt idx="15">
                  <c:v>3.59375</c:v>
                </c:pt>
                <c:pt idx="16">
                  <c:v>3.8333333333333299</c:v>
                </c:pt>
                <c:pt idx="17">
                  <c:v>4.0729166666666696</c:v>
                </c:pt>
                <c:pt idx="18">
                  <c:v>4.3125</c:v>
                </c:pt>
                <c:pt idx="19">
                  <c:v>4.5520833333333304</c:v>
                </c:pt>
                <c:pt idx="20">
                  <c:v>4.7916666666666696</c:v>
                </c:pt>
                <c:pt idx="21">
                  <c:v>5.03125</c:v>
                </c:pt>
                <c:pt idx="22">
                  <c:v>5.2708333333333304</c:v>
                </c:pt>
                <c:pt idx="23">
                  <c:v>5.5104166666666696</c:v>
                </c:pt>
                <c:pt idx="24">
                  <c:v>5.75</c:v>
                </c:pt>
                <c:pt idx="25">
                  <c:v>5.9895833333333304</c:v>
                </c:pt>
                <c:pt idx="26">
                  <c:v>6.2291666666666696</c:v>
                </c:pt>
                <c:pt idx="27">
                  <c:v>6.46875</c:v>
                </c:pt>
                <c:pt idx="28">
                  <c:v>6.7083333333333304</c:v>
                </c:pt>
                <c:pt idx="29">
                  <c:v>6.9479166666666696</c:v>
                </c:pt>
                <c:pt idx="30">
                  <c:v>7.1875</c:v>
                </c:pt>
                <c:pt idx="31">
                  <c:v>7.4270833333333304</c:v>
                </c:pt>
                <c:pt idx="32">
                  <c:v>7.6666666666666696</c:v>
                </c:pt>
                <c:pt idx="33">
                  <c:v>7.90625</c:v>
                </c:pt>
                <c:pt idx="34">
                  <c:v>8.1458333333333304</c:v>
                </c:pt>
                <c:pt idx="35">
                  <c:v>8.3854166666666696</c:v>
                </c:pt>
                <c:pt idx="36">
                  <c:v>8.625</c:v>
                </c:pt>
                <c:pt idx="37">
                  <c:v>8.8645833333333304</c:v>
                </c:pt>
                <c:pt idx="38">
                  <c:v>9.1041666666666696</c:v>
                </c:pt>
                <c:pt idx="39">
                  <c:v>9.34375</c:v>
                </c:pt>
                <c:pt idx="40">
                  <c:v>9.5833333333333304</c:v>
                </c:pt>
                <c:pt idx="41">
                  <c:v>9.8229166666666696</c:v>
                </c:pt>
                <c:pt idx="42">
                  <c:v>10.0625</c:v>
                </c:pt>
                <c:pt idx="43">
                  <c:v>10.3020833333333</c:v>
                </c:pt>
                <c:pt idx="44">
                  <c:v>10.5416666666667</c:v>
                </c:pt>
                <c:pt idx="45">
                  <c:v>10.78125</c:v>
                </c:pt>
                <c:pt idx="46">
                  <c:v>11.0208333333333</c:v>
                </c:pt>
                <c:pt idx="47">
                  <c:v>11.2604166666667</c:v>
                </c:pt>
                <c:pt idx="48">
                  <c:v>11.5</c:v>
                </c:pt>
                <c:pt idx="49">
                  <c:v>11.7395833333333</c:v>
                </c:pt>
                <c:pt idx="50">
                  <c:v>11.9791666666667</c:v>
                </c:pt>
                <c:pt idx="51">
                  <c:v>12.21875</c:v>
                </c:pt>
                <c:pt idx="52">
                  <c:v>12.4583333333333</c:v>
                </c:pt>
                <c:pt idx="53">
                  <c:v>12.6979166666667</c:v>
                </c:pt>
                <c:pt idx="54">
                  <c:v>12.9375</c:v>
                </c:pt>
                <c:pt idx="55">
                  <c:v>13.1770833333333</c:v>
                </c:pt>
                <c:pt idx="56">
                  <c:v>13.4166666666667</c:v>
                </c:pt>
                <c:pt idx="57">
                  <c:v>13.65625</c:v>
                </c:pt>
                <c:pt idx="58">
                  <c:v>13.8958333333333</c:v>
                </c:pt>
                <c:pt idx="59">
                  <c:v>14.1354166666667</c:v>
                </c:pt>
                <c:pt idx="60">
                  <c:v>14.375</c:v>
                </c:pt>
                <c:pt idx="61">
                  <c:v>14.6145833333333</c:v>
                </c:pt>
                <c:pt idx="62">
                  <c:v>14.8541666666667</c:v>
                </c:pt>
                <c:pt idx="63">
                  <c:v>15.09375</c:v>
                </c:pt>
                <c:pt idx="64">
                  <c:v>15.3333333333333</c:v>
                </c:pt>
                <c:pt idx="65">
                  <c:v>15.5729166666667</c:v>
                </c:pt>
                <c:pt idx="66">
                  <c:v>15.8125</c:v>
                </c:pt>
                <c:pt idx="67">
                  <c:v>16.0520833333333</c:v>
                </c:pt>
                <c:pt idx="68">
                  <c:v>16.2916666666667</c:v>
                </c:pt>
                <c:pt idx="69">
                  <c:v>16.53125</c:v>
                </c:pt>
                <c:pt idx="70">
                  <c:v>16.7708333333333</c:v>
                </c:pt>
                <c:pt idx="71">
                  <c:v>17.0104166666667</c:v>
                </c:pt>
                <c:pt idx="72">
                  <c:v>17.25</c:v>
                </c:pt>
                <c:pt idx="73">
                  <c:v>17.4895833333333</c:v>
                </c:pt>
                <c:pt idx="74">
                  <c:v>17.7291666666667</c:v>
                </c:pt>
                <c:pt idx="75">
                  <c:v>17.96875</c:v>
                </c:pt>
                <c:pt idx="76">
                  <c:v>18.2083333333333</c:v>
                </c:pt>
                <c:pt idx="77">
                  <c:v>18.4479166666667</c:v>
                </c:pt>
                <c:pt idx="78">
                  <c:v>18.6875</c:v>
                </c:pt>
                <c:pt idx="79">
                  <c:v>18.9270833333333</c:v>
                </c:pt>
                <c:pt idx="80">
                  <c:v>19.1666666666667</c:v>
                </c:pt>
                <c:pt idx="81">
                  <c:v>19.40625</c:v>
                </c:pt>
                <c:pt idx="82">
                  <c:v>19.6458333333333</c:v>
                </c:pt>
                <c:pt idx="83">
                  <c:v>19.8854166666667</c:v>
                </c:pt>
                <c:pt idx="84">
                  <c:v>20.125</c:v>
                </c:pt>
                <c:pt idx="85">
                  <c:v>20.3645833333333</c:v>
                </c:pt>
                <c:pt idx="86">
                  <c:v>20.6041666666667</c:v>
                </c:pt>
                <c:pt idx="87">
                  <c:v>20.84375</c:v>
                </c:pt>
                <c:pt idx="88">
                  <c:v>21.0833333333333</c:v>
                </c:pt>
                <c:pt idx="89">
                  <c:v>21.3229166666667</c:v>
                </c:pt>
                <c:pt idx="90">
                  <c:v>21.5625</c:v>
                </c:pt>
                <c:pt idx="91">
                  <c:v>21.8020833333333</c:v>
                </c:pt>
                <c:pt idx="92">
                  <c:v>22.0416666666667</c:v>
                </c:pt>
                <c:pt idx="93">
                  <c:v>22.28125</c:v>
                </c:pt>
                <c:pt idx="94">
                  <c:v>22.5208333333333</c:v>
                </c:pt>
                <c:pt idx="95">
                  <c:v>22.7604166666667</c:v>
                </c:pt>
                <c:pt idx="96">
                  <c:v>23</c:v>
                </c:pt>
                <c:pt idx="97">
                  <c:v>23.2395833333333</c:v>
                </c:pt>
                <c:pt idx="98">
                  <c:v>23.4791666666667</c:v>
                </c:pt>
                <c:pt idx="99">
                  <c:v>23.71875</c:v>
                </c:pt>
                <c:pt idx="100">
                  <c:v>23.9583333333333</c:v>
                </c:pt>
                <c:pt idx="101">
                  <c:v>24.1979166666667</c:v>
                </c:pt>
                <c:pt idx="102">
                  <c:v>24.4375</c:v>
                </c:pt>
                <c:pt idx="103">
                  <c:v>24.6770833333333</c:v>
                </c:pt>
                <c:pt idx="104">
                  <c:v>24.9166666666667</c:v>
                </c:pt>
                <c:pt idx="105">
                  <c:v>25.15625</c:v>
                </c:pt>
                <c:pt idx="106">
                  <c:v>25.3958333333333</c:v>
                </c:pt>
                <c:pt idx="107">
                  <c:v>25.6354166666667</c:v>
                </c:pt>
                <c:pt idx="108">
                  <c:v>25.875</c:v>
                </c:pt>
                <c:pt idx="109">
                  <c:v>26.1145833333333</c:v>
                </c:pt>
                <c:pt idx="110">
                  <c:v>26.3541666666667</c:v>
                </c:pt>
                <c:pt idx="111">
                  <c:v>26.59375</c:v>
                </c:pt>
                <c:pt idx="112">
                  <c:v>26.8333333333333</c:v>
                </c:pt>
                <c:pt idx="113">
                  <c:v>27.0729166666667</c:v>
                </c:pt>
                <c:pt idx="114">
                  <c:v>27.3125</c:v>
                </c:pt>
                <c:pt idx="115">
                  <c:v>27.5520833333333</c:v>
                </c:pt>
                <c:pt idx="116">
                  <c:v>27.7916666666667</c:v>
                </c:pt>
                <c:pt idx="117">
                  <c:v>28.03125</c:v>
                </c:pt>
                <c:pt idx="118">
                  <c:v>28.2708333333333</c:v>
                </c:pt>
                <c:pt idx="119">
                  <c:v>28.5104166666667</c:v>
                </c:pt>
                <c:pt idx="120">
                  <c:v>28.75</c:v>
                </c:pt>
                <c:pt idx="121">
                  <c:v>28.9895833333333</c:v>
                </c:pt>
                <c:pt idx="122">
                  <c:v>29.2291666666667</c:v>
                </c:pt>
                <c:pt idx="123">
                  <c:v>29.46875</c:v>
                </c:pt>
                <c:pt idx="124">
                  <c:v>29.7083333333333</c:v>
                </c:pt>
                <c:pt idx="125">
                  <c:v>29.9479166666667</c:v>
                </c:pt>
                <c:pt idx="126">
                  <c:v>30.1875</c:v>
                </c:pt>
                <c:pt idx="127">
                  <c:v>30.4270833333333</c:v>
                </c:pt>
                <c:pt idx="128">
                  <c:v>30.6666666666667</c:v>
                </c:pt>
                <c:pt idx="129">
                  <c:v>30.90625</c:v>
                </c:pt>
                <c:pt idx="130">
                  <c:v>31.1458333333333</c:v>
                </c:pt>
                <c:pt idx="131">
                  <c:v>31.3854166666667</c:v>
                </c:pt>
                <c:pt idx="132">
                  <c:v>31.625</c:v>
                </c:pt>
                <c:pt idx="133">
                  <c:v>31.8645833333333</c:v>
                </c:pt>
                <c:pt idx="134">
                  <c:v>32.1041666666667</c:v>
                </c:pt>
                <c:pt idx="135">
                  <c:v>32.34375</c:v>
                </c:pt>
                <c:pt idx="136">
                  <c:v>32.5833333333333</c:v>
                </c:pt>
                <c:pt idx="137">
                  <c:v>32.8229166666667</c:v>
                </c:pt>
                <c:pt idx="138">
                  <c:v>33.0625</c:v>
                </c:pt>
                <c:pt idx="139">
                  <c:v>33.3020833333333</c:v>
                </c:pt>
                <c:pt idx="140">
                  <c:v>33.5416666666667</c:v>
                </c:pt>
                <c:pt idx="141">
                  <c:v>33.78125</c:v>
                </c:pt>
                <c:pt idx="142">
                  <c:v>34.0208333333333</c:v>
                </c:pt>
                <c:pt idx="143">
                  <c:v>34.2604166666667</c:v>
                </c:pt>
                <c:pt idx="144">
                  <c:v>34.5</c:v>
                </c:pt>
                <c:pt idx="145">
                  <c:v>34.7395833333333</c:v>
                </c:pt>
                <c:pt idx="146">
                  <c:v>34.9791666666667</c:v>
                </c:pt>
                <c:pt idx="147">
                  <c:v>35.21875</c:v>
                </c:pt>
                <c:pt idx="148">
                  <c:v>35.4583333333333</c:v>
                </c:pt>
                <c:pt idx="149">
                  <c:v>35.6979166666667</c:v>
                </c:pt>
                <c:pt idx="150">
                  <c:v>35.9375</c:v>
                </c:pt>
                <c:pt idx="151">
                  <c:v>36.1770833333333</c:v>
                </c:pt>
                <c:pt idx="152">
                  <c:v>36.4166666666667</c:v>
                </c:pt>
                <c:pt idx="153">
                  <c:v>36.65625</c:v>
                </c:pt>
                <c:pt idx="154">
                  <c:v>36.8958333333333</c:v>
                </c:pt>
                <c:pt idx="155">
                  <c:v>37.1354166666667</c:v>
                </c:pt>
                <c:pt idx="156">
                  <c:v>37.375</c:v>
                </c:pt>
                <c:pt idx="157">
                  <c:v>37.6145833333333</c:v>
                </c:pt>
                <c:pt idx="158">
                  <c:v>37.8541666666667</c:v>
                </c:pt>
                <c:pt idx="159">
                  <c:v>38.09375</c:v>
                </c:pt>
                <c:pt idx="160">
                  <c:v>38.3333333333333</c:v>
                </c:pt>
                <c:pt idx="161">
                  <c:v>38.5729166666667</c:v>
                </c:pt>
                <c:pt idx="162">
                  <c:v>38.8125</c:v>
                </c:pt>
                <c:pt idx="163">
                  <c:v>39.0520833333333</c:v>
                </c:pt>
                <c:pt idx="164">
                  <c:v>39.2916666666667</c:v>
                </c:pt>
                <c:pt idx="165">
                  <c:v>39.53125</c:v>
                </c:pt>
                <c:pt idx="166">
                  <c:v>39.7708333333333</c:v>
                </c:pt>
                <c:pt idx="167">
                  <c:v>40.0104166666667</c:v>
                </c:pt>
                <c:pt idx="168">
                  <c:v>40.25</c:v>
                </c:pt>
                <c:pt idx="169">
                  <c:v>40.4895833333333</c:v>
                </c:pt>
                <c:pt idx="170">
                  <c:v>40.7291666666667</c:v>
                </c:pt>
                <c:pt idx="171">
                  <c:v>40.96875</c:v>
                </c:pt>
                <c:pt idx="172">
                  <c:v>41.2083333333333</c:v>
                </c:pt>
                <c:pt idx="173">
                  <c:v>41.4479166666667</c:v>
                </c:pt>
                <c:pt idx="174">
                  <c:v>41.6875</c:v>
                </c:pt>
                <c:pt idx="175">
                  <c:v>41.9270833333333</c:v>
                </c:pt>
                <c:pt idx="176">
                  <c:v>42.1666666666667</c:v>
                </c:pt>
                <c:pt idx="177">
                  <c:v>42.40625</c:v>
                </c:pt>
                <c:pt idx="178">
                  <c:v>42.6458333333333</c:v>
                </c:pt>
                <c:pt idx="179">
                  <c:v>42.8854166666667</c:v>
                </c:pt>
                <c:pt idx="180">
                  <c:v>43.125</c:v>
                </c:pt>
                <c:pt idx="181">
                  <c:v>43.3645833333333</c:v>
                </c:pt>
                <c:pt idx="182">
                  <c:v>43.6041666666667</c:v>
                </c:pt>
                <c:pt idx="183">
                  <c:v>43.84375</c:v>
                </c:pt>
                <c:pt idx="184">
                  <c:v>44.0833333333333</c:v>
                </c:pt>
                <c:pt idx="185">
                  <c:v>44.3229166666667</c:v>
                </c:pt>
                <c:pt idx="186">
                  <c:v>44.5625</c:v>
                </c:pt>
                <c:pt idx="187">
                  <c:v>44.8020833333333</c:v>
                </c:pt>
                <c:pt idx="188">
                  <c:v>45.0416666666667</c:v>
                </c:pt>
                <c:pt idx="189">
                  <c:v>45.28125</c:v>
                </c:pt>
                <c:pt idx="190">
                  <c:v>45.5208333333333</c:v>
                </c:pt>
                <c:pt idx="191">
                  <c:v>45.7604166666667</c:v>
                </c:pt>
                <c:pt idx="192">
                  <c:v>46</c:v>
                </c:pt>
                <c:pt idx="193">
                  <c:v>46.2395833333333</c:v>
                </c:pt>
                <c:pt idx="194">
                  <c:v>46.4791666666667</c:v>
                </c:pt>
                <c:pt idx="195">
                  <c:v>46.71875</c:v>
                </c:pt>
                <c:pt idx="196">
                  <c:v>46.9583333333333</c:v>
                </c:pt>
                <c:pt idx="197">
                  <c:v>47.1979166666667</c:v>
                </c:pt>
                <c:pt idx="198">
                  <c:v>47.4375</c:v>
                </c:pt>
                <c:pt idx="199">
                  <c:v>47.6770833333333</c:v>
                </c:pt>
                <c:pt idx="200">
                  <c:v>47.9166666666667</c:v>
                </c:pt>
                <c:pt idx="201">
                  <c:v>48.15625</c:v>
                </c:pt>
                <c:pt idx="202">
                  <c:v>48.3958333333333</c:v>
                </c:pt>
                <c:pt idx="203">
                  <c:v>48.6354166666667</c:v>
                </c:pt>
                <c:pt idx="204">
                  <c:v>48.875</c:v>
                </c:pt>
                <c:pt idx="205">
                  <c:v>49.1145833333333</c:v>
                </c:pt>
                <c:pt idx="206">
                  <c:v>49.3541666666667</c:v>
                </c:pt>
                <c:pt idx="207">
                  <c:v>49.59375</c:v>
                </c:pt>
                <c:pt idx="208">
                  <c:v>49.8333333333333</c:v>
                </c:pt>
                <c:pt idx="209">
                  <c:v>50.0729166666667</c:v>
                </c:pt>
                <c:pt idx="210">
                  <c:v>50.3125</c:v>
                </c:pt>
                <c:pt idx="211">
                  <c:v>50.5520833333333</c:v>
                </c:pt>
                <c:pt idx="212">
                  <c:v>50.7916666666667</c:v>
                </c:pt>
                <c:pt idx="213">
                  <c:v>51.03125</c:v>
                </c:pt>
                <c:pt idx="214">
                  <c:v>51.2708333333333</c:v>
                </c:pt>
                <c:pt idx="215">
                  <c:v>51.5104166666667</c:v>
                </c:pt>
                <c:pt idx="216">
                  <c:v>51.75</c:v>
                </c:pt>
                <c:pt idx="217">
                  <c:v>51.9895833333333</c:v>
                </c:pt>
                <c:pt idx="218">
                  <c:v>52.2291666666667</c:v>
                </c:pt>
                <c:pt idx="219">
                  <c:v>52.46875</c:v>
                </c:pt>
                <c:pt idx="220">
                  <c:v>52.7083333333333</c:v>
                </c:pt>
                <c:pt idx="221">
                  <c:v>52.9479166666667</c:v>
                </c:pt>
                <c:pt idx="222">
                  <c:v>53.1875</c:v>
                </c:pt>
                <c:pt idx="223">
                  <c:v>53.4270833333333</c:v>
                </c:pt>
                <c:pt idx="224">
                  <c:v>53.6666666666667</c:v>
                </c:pt>
                <c:pt idx="225">
                  <c:v>53.90625</c:v>
                </c:pt>
                <c:pt idx="226">
                  <c:v>54.1458333333333</c:v>
                </c:pt>
                <c:pt idx="227">
                  <c:v>54.3854166666667</c:v>
                </c:pt>
                <c:pt idx="228">
                  <c:v>54.625</c:v>
                </c:pt>
                <c:pt idx="229">
                  <c:v>54.8645833333333</c:v>
                </c:pt>
                <c:pt idx="230">
                  <c:v>55.1041666666667</c:v>
                </c:pt>
                <c:pt idx="231">
                  <c:v>55.34375</c:v>
                </c:pt>
                <c:pt idx="232">
                  <c:v>55.5833333333333</c:v>
                </c:pt>
                <c:pt idx="233">
                  <c:v>55.8229166666667</c:v>
                </c:pt>
                <c:pt idx="234">
                  <c:v>56.0625</c:v>
                </c:pt>
                <c:pt idx="235">
                  <c:v>56.3020833333333</c:v>
                </c:pt>
                <c:pt idx="236">
                  <c:v>56.5416666666667</c:v>
                </c:pt>
                <c:pt idx="237">
                  <c:v>56.78125</c:v>
                </c:pt>
                <c:pt idx="238">
                  <c:v>57.0208333333333</c:v>
                </c:pt>
                <c:pt idx="239">
                  <c:v>57.2604166666667</c:v>
                </c:pt>
                <c:pt idx="240">
                  <c:v>57.5</c:v>
                </c:pt>
                <c:pt idx="241">
                  <c:v>57.7395833333333</c:v>
                </c:pt>
                <c:pt idx="242">
                  <c:v>57.9791666666667</c:v>
                </c:pt>
                <c:pt idx="243">
                  <c:v>58.21875</c:v>
                </c:pt>
                <c:pt idx="244">
                  <c:v>58.4583333333333</c:v>
                </c:pt>
                <c:pt idx="245">
                  <c:v>58.6979166666667</c:v>
                </c:pt>
                <c:pt idx="246">
                  <c:v>58.9375</c:v>
                </c:pt>
                <c:pt idx="247">
                  <c:v>59.1770833333333</c:v>
                </c:pt>
                <c:pt idx="248">
                  <c:v>59.4166666666667</c:v>
                </c:pt>
                <c:pt idx="249">
                  <c:v>59.65625</c:v>
                </c:pt>
                <c:pt idx="250">
                  <c:v>59.8958333333333</c:v>
                </c:pt>
                <c:pt idx="251">
                  <c:v>60.1354166666667</c:v>
                </c:pt>
                <c:pt idx="252">
                  <c:v>60.375</c:v>
                </c:pt>
                <c:pt idx="253">
                  <c:v>60.6145833333333</c:v>
                </c:pt>
                <c:pt idx="254">
                  <c:v>60.8541666666667</c:v>
                </c:pt>
                <c:pt idx="255">
                  <c:v>61.09375</c:v>
                </c:pt>
                <c:pt idx="256">
                  <c:v>61.3333333333333</c:v>
                </c:pt>
                <c:pt idx="257">
                  <c:v>61.5729166666667</c:v>
                </c:pt>
                <c:pt idx="258">
                  <c:v>61.8125</c:v>
                </c:pt>
                <c:pt idx="259">
                  <c:v>62.0520833333333</c:v>
                </c:pt>
                <c:pt idx="260">
                  <c:v>62.2916666666667</c:v>
                </c:pt>
                <c:pt idx="261">
                  <c:v>62.53125</c:v>
                </c:pt>
                <c:pt idx="262">
                  <c:v>62.7708333333333</c:v>
                </c:pt>
                <c:pt idx="263">
                  <c:v>63.0104166666667</c:v>
                </c:pt>
                <c:pt idx="264">
                  <c:v>63.25</c:v>
                </c:pt>
                <c:pt idx="265">
                  <c:v>63.4895833333333</c:v>
                </c:pt>
                <c:pt idx="266">
                  <c:v>63.7291666666667</c:v>
                </c:pt>
                <c:pt idx="267">
                  <c:v>63.96875</c:v>
                </c:pt>
                <c:pt idx="268">
                  <c:v>64.2083333333333</c:v>
                </c:pt>
                <c:pt idx="269">
                  <c:v>64.4479166666667</c:v>
                </c:pt>
                <c:pt idx="270">
                  <c:v>64.6875</c:v>
                </c:pt>
                <c:pt idx="271">
                  <c:v>64.9270833333333</c:v>
                </c:pt>
                <c:pt idx="272">
                  <c:v>65.1666666666667</c:v>
                </c:pt>
                <c:pt idx="273">
                  <c:v>65.40625</c:v>
                </c:pt>
                <c:pt idx="274">
                  <c:v>65.6458333333333</c:v>
                </c:pt>
                <c:pt idx="275">
                  <c:v>65.8854166666667</c:v>
                </c:pt>
                <c:pt idx="276">
                  <c:v>66.125</c:v>
                </c:pt>
                <c:pt idx="277">
                  <c:v>66.3645833333333</c:v>
                </c:pt>
                <c:pt idx="278">
                  <c:v>66.6041666666667</c:v>
                </c:pt>
                <c:pt idx="279">
                  <c:v>66.84375</c:v>
                </c:pt>
                <c:pt idx="280">
                  <c:v>67.0833333333333</c:v>
                </c:pt>
                <c:pt idx="281">
                  <c:v>67.3229166666667</c:v>
                </c:pt>
                <c:pt idx="282">
                  <c:v>67.5625</c:v>
                </c:pt>
                <c:pt idx="283">
                  <c:v>67.8020833333333</c:v>
                </c:pt>
                <c:pt idx="284">
                  <c:v>68.0416666666667</c:v>
                </c:pt>
                <c:pt idx="285">
                  <c:v>68.28125</c:v>
                </c:pt>
                <c:pt idx="286">
                  <c:v>68.5208333333333</c:v>
                </c:pt>
                <c:pt idx="287">
                  <c:v>68.7604166666667</c:v>
                </c:pt>
                <c:pt idx="288">
                  <c:v>69</c:v>
                </c:pt>
                <c:pt idx="289">
                  <c:v>69.2395833333333</c:v>
                </c:pt>
                <c:pt idx="290">
                  <c:v>69.4791666666667</c:v>
                </c:pt>
                <c:pt idx="291">
                  <c:v>69.71875</c:v>
                </c:pt>
                <c:pt idx="292">
                  <c:v>69.9583333333333</c:v>
                </c:pt>
                <c:pt idx="293">
                  <c:v>70.1979166666667</c:v>
                </c:pt>
                <c:pt idx="294">
                  <c:v>70.4375</c:v>
                </c:pt>
                <c:pt idx="295">
                  <c:v>70.6770833333333</c:v>
                </c:pt>
                <c:pt idx="296">
                  <c:v>70.9166666666667</c:v>
                </c:pt>
                <c:pt idx="297">
                  <c:v>71.15625</c:v>
                </c:pt>
                <c:pt idx="298">
                  <c:v>71.3958333333333</c:v>
                </c:pt>
                <c:pt idx="299">
                  <c:v>71.6354166666667</c:v>
                </c:pt>
                <c:pt idx="300">
                  <c:v>71.875</c:v>
                </c:pt>
                <c:pt idx="301">
                  <c:v>72.1145833333333</c:v>
                </c:pt>
                <c:pt idx="302">
                  <c:v>72.3541666666667</c:v>
                </c:pt>
                <c:pt idx="303">
                  <c:v>72.59375</c:v>
                </c:pt>
                <c:pt idx="304">
                  <c:v>72.8333333333333</c:v>
                </c:pt>
                <c:pt idx="305">
                  <c:v>73.0729166666667</c:v>
                </c:pt>
                <c:pt idx="306">
                  <c:v>73.3125</c:v>
                </c:pt>
                <c:pt idx="307">
                  <c:v>73.5520833333333</c:v>
                </c:pt>
                <c:pt idx="308">
                  <c:v>73.7916666666667</c:v>
                </c:pt>
                <c:pt idx="309">
                  <c:v>74.03125</c:v>
                </c:pt>
                <c:pt idx="310">
                  <c:v>74.2708333333333</c:v>
                </c:pt>
                <c:pt idx="311">
                  <c:v>74.5104166666667</c:v>
                </c:pt>
                <c:pt idx="312">
                  <c:v>74.75</c:v>
                </c:pt>
                <c:pt idx="313">
                  <c:v>74.9895833333333</c:v>
                </c:pt>
                <c:pt idx="314">
                  <c:v>75.2291666666667</c:v>
                </c:pt>
                <c:pt idx="315">
                  <c:v>75.46875</c:v>
                </c:pt>
                <c:pt idx="316">
                  <c:v>75.7083333333333</c:v>
                </c:pt>
                <c:pt idx="317">
                  <c:v>75.9479166666667</c:v>
                </c:pt>
                <c:pt idx="318">
                  <c:v>76.1875</c:v>
                </c:pt>
                <c:pt idx="319">
                  <c:v>76.4270833333333</c:v>
                </c:pt>
                <c:pt idx="320">
                  <c:v>76.6666666666667</c:v>
                </c:pt>
                <c:pt idx="321">
                  <c:v>76.90625</c:v>
                </c:pt>
                <c:pt idx="322">
                  <c:v>77.1458333333333</c:v>
                </c:pt>
                <c:pt idx="323">
                  <c:v>77.3854166666667</c:v>
                </c:pt>
                <c:pt idx="324">
                  <c:v>77.625</c:v>
                </c:pt>
                <c:pt idx="325">
                  <c:v>77.8645833333333</c:v>
                </c:pt>
                <c:pt idx="326">
                  <c:v>78.1041666666667</c:v>
                </c:pt>
                <c:pt idx="327">
                  <c:v>78.34375</c:v>
                </c:pt>
                <c:pt idx="328">
                  <c:v>78.5833333333333</c:v>
                </c:pt>
                <c:pt idx="329">
                  <c:v>78.8229166666667</c:v>
                </c:pt>
                <c:pt idx="330">
                  <c:v>79.0625</c:v>
                </c:pt>
                <c:pt idx="331">
                  <c:v>79.3020833333333</c:v>
                </c:pt>
                <c:pt idx="332">
                  <c:v>79.5416666666667</c:v>
                </c:pt>
                <c:pt idx="333">
                  <c:v>79.78125</c:v>
                </c:pt>
                <c:pt idx="334">
                  <c:v>80.0208333333333</c:v>
                </c:pt>
                <c:pt idx="335">
                  <c:v>80.2604166666667</c:v>
                </c:pt>
                <c:pt idx="336">
                  <c:v>80.5</c:v>
                </c:pt>
                <c:pt idx="337">
                  <c:v>80.7395833333333</c:v>
                </c:pt>
                <c:pt idx="338">
                  <c:v>80.9791666666667</c:v>
                </c:pt>
                <c:pt idx="339">
                  <c:v>81.21875</c:v>
                </c:pt>
                <c:pt idx="340">
                  <c:v>81.4583333333333</c:v>
                </c:pt>
                <c:pt idx="341">
                  <c:v>81.6979166666667</c:v>
                </c:pt>
                <c:pt idx="342">
                  <c:v>81.9375</c:v>
                </c:pt>
                <c:pt idx="343">
                  <c:v>82.1770833333333</c:v>
                </c:pt>
                <c:pt idx="344">
                  <c:v>82.4166666666667</c:v>
                </c:pt>
                <c:pt idx="345">
                  <c:v>82.65625</c:v>
                </c:pt>
                <c:pt idx="346">
                  <c:v>82.8958333333333</c:v>
                </c:pt>
                <c:pt idx="347">
                  <c:v>83.1354166666667</c:v>
                </c:pt>
                <c:pt idx="348">
                  <c:v>83.375</c:v>
                </c:pt>
                <c:pt idx="349">
                  <c:v>83.6145833333333</c:v>
                </c:pt>
                <c:pt idx="350">
                  <c:v>83.8541666666667</c:v>
                </c:pt>
                <c:pt idx="351">
                  <c:v>84.09375</c:v>
                </c:pt>
                <c:pt idx="352">
                  <c:v>84.3333333333333</c:v>
                </c:pt>
                <c:pt idx="353">
                  <c:v>84.5729166666667</c:v>
                </c:pt>
                <c:pt idx="354">
                  <c:v>84.8125</c:v>
                </c:pt>
                <c:pt idx="355">
                  <c:v>85.0520833333333</c:v>
                </c:pt>
                <c:pt idx="356">
                  <c:v>85.2916666666667</c:v>
                </c:pt>
                <c:pt idx="357">
                  <c:v>85.53125</c:v>
                </c:pt>
                <c:pt idx="358">
                  <c:v>85.7708333333333</c:v>
                </c:pt>
                <c:pt idx="359">
                  <c:v>86.0104166666667</c:v>
                </c:pt>
                <c:pt idx="360">
                  <c:v>86.25</c:v>
                </c:pt>
                <c:pt idx="361">
                  <c:v>86.4895833333333</c:v>
                </c:pt>
                <c:pt idx="362">
                  <c:v>86.7291666666667</c:v>
                </c:pt>
                <c:pt idx="363">
                  <c:v>86.96875</c:v>
                </c:pt>
                <c:pt idx="364">
                  <c:v>87.2083333333333</c:v>
                </c:pt>
                <c:pt idx="365">
                  <c:v>87.4479166666667</c:v>
                </c:pt>
                <c:pt idx="366">
                  <c:v>87.6875</c:v>
                </c:pt>
                <c:pt idx="367">
                  <c:v>87.9270833333333</c:v>
                </c:pt>
                <c:pt idx="368">
                  <c:v>88.1666666666667</c:v>
                </c:pt>
                <c:pt idx="369">
                  <c:v>88.40625</c:v>
                </c:pt>
                <c:pt idx="370">
                  <c:v>88.6458333333333</c:v>
                </c:pt>
                <c:pt idx="371">
                  <c:v>88.8854166666667</c:v>
                </c:pt>
                <c:pt idx="372">
                  <c:v>89.125</c:v>
                </c:pt>
                <c:pt idx="373">
                  <c:v>89.3645833333333</c:v>
                </c:pt>
                <c:pt idx="374">
                  <c:v>89.6041666666667</c:v>
                </c:pt>
                <c:pt idx="375">
                  <c:v>89.84375</c:v>
                </c:pt>
                <c:pt idx="376">
                  <c:v>90.0833333333333</c:v>
                </c:pt>
                <c:pt idx="377">
                  <c:v>90.3229166666667</c:v>
                </c:pt>
                <c:pt idx="378">
                  <c:v>90.5625</c:v>
                </c:pt>
                <c:pt idx="379">
                  <c:v>90.8020833333333</c:v>
                </c:pt>
                <c:pt idx="380">
                  <c:v>91.0416666666667</c:v>
                </c:pt>
                <c:pt idx="381">
                  <c:v>91.28125</c:v>
                </c:pt>
                <c:pt idx="382">
                  <c:v>91.5208333333333</c:v>
                </c:pt>
                <c:pt idx="383">
                  <c:v>91.7604166666667</c:v>
                </c:pt>
                <c:pt idx="384">
                  <c:v>92</c:v>
                </c:pt>
                <c:pt idx="385">
                  <c:v>92.2395833333333</c:v>
                </c:pt>
                <c:pt idx="386">
                  <c:v>92.4791666666667</c:v>
                </c:pt>
                <c:pt idx="387">
                  <c:v>92.71875</c:v>
                </c:pt>
                <c:pt idx="388">
                  <c:v>92.9583333333333</c:v>
                </c:pt>
                <c:pt idx="389">
                  <c:v>93.1979166666667</c:v>
                </c:pt>
                <c:pt idx="390">
                  <c:v>93.4375</c:v>
                </c:pt>
                <c:pt idx="391">
                  <c:v>93.6770833333333</c:v>
                </c:pt>
                <c:pt idx="392">
                  <c:v>93.9166666666667</c:v>
                </c:pt>
                <c:pt idx="393">
                  <c:v>94.15625</c:v>
                </c:pt>
                <c:pt idx="394">
                  <c:v>94.3958333333333</c:v>
                </c:pt>
                <c:pt idx="395">
                  <c:v>94.6354166666667</c:v>
                </c:pt>
                <c:pt idx="396">
                  <c:v>94.875</c:v>
                </c:pt>
                <c:pt idx="397">
                  <c:v>95.1145833333333</c:v>
                </c:pt>
                <c:pt idx="398">
                  <c:v>95.3541666666667</c:v>
                </c:pt>
                <c:pt idx="399">
                  <c:v>95.59375</c:v>
                </c:pt>
                <c:pt idx="400">
                  <c:v>95.8333333333333</c:v>
                </c:pt>
                <c:pt idx="401">
                  <c:v>96.0729166666667</c:v>
                </c:pt>
                <c:pt idx="402">
                  <c:v>96.3125</c:v>
                </c:pt>
                <c:pt idx="403">
                  <c:v>96.5520833333333</c:v>
                </c:pt>
                <c:pt idx="404">
                  <c:v>96.7916666666667</c:v>
                </c:pt>
                <c:pt idx="405">
                  <c:v>97.03125</c:v>
                </c:pt>
                <c:pt idx="406">
                  <c:v>97.2708333333333</c:v>
                </c:pt>
                <c:pt idx="407">
                  <c:v>97.5104166666667</c:v>
                </c:pt>
                <c:pt idx="408">
                  <c:v>97.75</c:v>
                </c:pt>
                <c:pt idx="409">
                  <c:v>97.9895833333333</c:v>
                </c:pt>
                <c:pt idx="410">
                  <c:v>98.2291666666667</c:v>
                </c:pt>
                <c:pt idx="411">
                  <c:v>98.46875</c:v>
                </c:pt>
                <c:pt idx="412">
                  <c:v>98.7083333333333</c:v>
                </c:pt>
                <c:pt idx="413">
                  <c:v>98.9479166666667</c:v>
                </c:pt>
                <c:pt idx="414">
                  <c:v>99.1875</c:v>
                </c:pt>
                <c:pt idx="415">
                  <c:v>99.4270833333333</c:v>
                </c:pt>
                <c:pt idx="416">
                  <c:v>99.6666666666667</c:v>
                </c:pt>
                <c:pt idx="417">
                  <c:v>99.90625</c:v>
                </c:pt>
                <c:pt idx="418">
                  <c:v>100.145833333333</c:v>
                </c:pt>
                <c:pt idx="419">
                  <c:v>100.385416666667</c:v>
                </c:pt>
                <c:pt idx="420">
                  <c:v>100.625</c:v>
                </c:pt>
                <c:pt idx="421">
                  <c:v>100.864583333333</c:v>
                </c:pt>
                <c:pt idx="422">
                  <c:v>101.104166666667</c:v>
                </c:pt>
                <c:pt idx="423">
                  <c:v>101.34375</c:v>
                </c:pt>
                <c:pt idx="424">
                  <c:v>101.583333333333</c:v>
                </c:pt>
                <c:pt idx="425">
                  <c:v>101.822916666667</c:v>
                </c:pt>
                <c:pt idx="426">
                  <c:v>102.0625</c:v>
                </c:pt>
                <c:pt idx="427">
                  <c:v>102.302083333333</c:v>
                </c:pt>
                <c:pt idx="428">
                  <c:v>102.541666666667</c:v>
                </c:pt>
                <c:pt idx="429">
                  <c:v>102.78125</c:v>
                </c:pt>
                <c:pt idx="430">
                  <c:v>103.020833333333</c:v>
                </c:pt>
                <c:pt idx="431">
                  <c:v>103.260416666667</c:v>
                </c:pt>
                <c:pt idx="432">
                  <c:v>103.5</c:v>
                </c:pt>
                <c:pt idx="433">
                  <c:v>103.739583333333</c:v>
                </c:pt>
                <c:pt idx="434">
                  <c:v>103.979166666667</c:v>
                </c:pt>
                <c:pt idx="435">
                  <c:v>104.21875</c:v>
                </c:pt>
                <c:pt idx="436">
                  <c:v>104.458333333333</c:v>
                </c:pt>
                <c:pt idx="437">
                  <c:v>104.697916666667</c:v>
                </c:pt>
                <c:pt idx="438">
                  <c:v>104.9375</c:v>
                </c:pt>
                <c:pt idx="439">
                  <c:v>105.177083333333</c:v>
                </c:pt>
                <c:pt idx="440">
                  <c:v>105.416666666667</c:v>
                </c:pt>
                <c:pt idx="441">
                  <c:v>105.65625</c:v>
                </c:pt>
                <c:pt idx="442">
                  <c:v>105.895833333333</c:v>
                </c:pt>
                <c:pt idx="443">
                  <c:v>106.135416666667</c:v>
                </c:pt>
                <c:pt idx="444">
                  <c:v>106.375</c:v>
                </c:pt>
                <c:pt idx="445">
                  <c:v>106.614583333333</c:v>
                </c:pt>
                <c:pt idx="446">
                  <c:v>106.854166666667</c:v>
                </c:pt>
                <c:pt idx="447">
                  <c:v>107.09375</c:v>
                </c:pt>
                <c:pt idx="448">
                  <c:v>107.333333333333</c:v>
                </c:pt>
                <c:pt idx="449">
                  <c:v>107.572916666667</c:v>
                </c:pt>
                <c:pt idx="450">
                  <c:v>107.8125</c:v>
                </c:pt>
                <c:pt idx="451">
                  <c:v>108.052083333333</c:v>
                </c:pt>
                <c:pt idx="452">
                  <c:v>108.291666666667</c:v>
                </c:pt>
                <c:pt idx="453">
                  <c:v>108.53125</c:v>
                </c:pt>
                <c:pt idx="454">
                  <c:v>108.770833333333</c:v>
                </c:pt>
                <c:pt idx="455">
                  <c:v>109.010416666667</c:v>
                </c:pt>
                <c:pt idx="456">
                  <c:v>109.25</c:v>
                </c:pt>
                <c:pt idx="457">
                  <c:v>109.489583333333</c:v>
                </c:pt>
                <c:pt idx="458">
                  <c:v>109.729166666667</c:v>
                </c:pt>
                <c:pt idx="459">
                  <c:v>109.96875</c:v>
                </c:pt>
                <c:pt idx="460">
                  <c:v>110.208333333333</c:v>
                </c:pt>
                <c:pt idx="461">
                  <c:v>110.447916666667</c:v>
                </c:pt>
                <c:pt idx="462">
                  <c:v>110.6875</c:v>
                </c:pt>
                <c:pt idx="463">
                  <c:v>110.927083333333</c:v>
                </c:pt>
                <c:pt idx="464">
                  <c:v>111.166666666667</c:v>
                </c:pt>
                <c:pt idx="465">
                  <c:v>111.40625</c:v>
                </c:pt>
                <c:pt idx="466">
                  <c:v>111.645833333333</c:v>
                </c:pt>
                <c:pt idx="467">
                  <c:v>111.885416666667</c:v>
                </c:pt>
                <c:pt idx="468">
                  <c:v>112.125</c:v>
                </c:pt>
                <c:pt idx="469">
                  <c:v>112.364583333333</c:v>
                </c:pt>
                <c:pt idx="470">
                  <c:v>112.604166666667</c:v>
                </c:pt>
                <c:pt idx="471">
                  <c:v>112.84375</c:v>
                </c:pt>
                <c:pt idx="472">
                  <c:v>113.083333333333</c:v>
                </c:pt>
                <c:pt idx="473">
                  <c:v>113.322916666667</c:v>
                </c:pt>
                <c:pt idx="474">
                  <c:v>113.5625</c:v>
                </c:pt>
                <c:pt idx="475">
                  <c:v>113.802083333333</c:v>
                </c:pt>
                <c:pt idx="476">
                  <c:v>114.041666666667</c:v>
                </c:pt>
                <c:pt idx="477">
                  <c:v>114.28125</c:v>
                </c:pt>
                <c:pt idx="478">
                  <c:v>114.520833333333</c:v>
                </c:pt>
                <c:pt idx="479">
                  <c:v>114.760416666667</c:v>
                </c:pt>
                <c:pt idx="480">
                  <c:v>115</c:v>
                </c:pt>
                <c:pt idx="481">
                  <c:v>115.239583333333</c:v>
                </c:pt>
                <c:pt idx="482">
                  <c:v>115.479166666667</c:v>
                </c:pt>
                <c:pt idx="483">
                  <c:v>115.71875</c:v>
                </c:pt>
                <c:pt idx="484">
                  <c:v>115.958333333333</c:v>
                </c:pt>
                <c:pt idx="485">
                  <c:v>116.197916666667</c:v>
                </c:pt>
                <c:pt idx="486">
                  <c:v>116.4375</c:v>
                </c:pt>
                <c:pt idx="487">
                  <c:v>116.677083333333</c:v>
                </c:pt>
                <c:pt idx="488">
                  <c:v>116.916666666667</c:v>
                </c:pt>
                <c:pt idx="489">
                  <c:v>117.15625</c:v>
                </c:pt>
                <c:pt idx="490">
                  <c:v>117.395833333333</c:v>
                </c:pt>
                <c:pt idx="491">
                  <c:v>117.635416666667</c:v>
                </c:pt>
                <c:pt idx="492">
                  <c:v>117.875</c:v>
                </c:pt>
                <c:pt idx="493">
                  <c:v>118.114583333333</c:v>
                </c:pt>
                <c:pt idx="494">
                  <c:v>118.354166666667</c:v>
                </c:pt>
                <c:pt idx="495">
                  <c:v>118.59375</c:v>
                </c:pt>
                <c:pt idx="496">
                  <c:v>118.833333333333</c:v>
                </c:pt>
                <c:pt idx="497">
                  <c:v>119.072916666667</c:v>
                </c:pt>
                <c:pt idx="498">
                  <c:v>119.3125</c:v>
                </c:pt>
                <c:pt idx="499">
                  <c:v>119.552083333333</c:v>
                </c:pt>
                <c:pt idx="500">
                  <c:v>119.791666666667</c:v>
                </c:pt>
                <c:pt idx="501">
                  <c:v>120.03125</c:v>
                </c:pt>
                <c:pt idx="502">
                  <c:v>120.270833333333</c:v>
                </c:pt>
                <c:pt idx="503">
                  <c:v>120.510416666667</c:v>
                </c:pt>
                <c:pt idx="504">
                  <c:v>120.75</c:v>
                </c:pt>
                <c:pt idx="505">
                  <c:v>120.989583333333</c:v>
                </c:pt>
                <c:pt idx="506">
                  <c:v>121.229166666667</c:v>
                </c:pt>
                <c:pt idx="507">
                  <c:v>121.46875</c:v>
                </c:pt>
                <c:pt idx="508">
                  <c:v>121.708333333333</c:v>
                </c:pt>
                <c:pt idx="509">
                  <c:v>121.947916666667</c:v>
                </c:pt>
                <c:pt idx="510">
                  <c:v>122.1875</c:v>
                </c:pt>
                <c:pt idx="511">
                  <c:v>122.427083333333</c:v>
                </c:pt>
                <c:pt idx="512">
                  <c:v>122.666666666667</c:v>
                </c:pt>
                <c:pt idx="513">
                  <c:v>122.90625</c:v>
                </c:pt>
                <c:pt idx="514">
                  <c:v>123.145833333333</c:v>
                </c:pt>
                <c:pt idx="515">
                  <c:v>123.385416666667</c:v>
                </c:pt>
                <c:pt idx="516">
                  <c:v>123.625</c:v>
                </c:pt>
                <c:pt idx="517">
                  <c:v>123.864583333333</c:v>
                </c:pt>
                <c:pt idx="518">
                  <c:v>124.104166666667</c:v>
                </c:pt>
                <c:pt idx="519">
                  <c:v>124.34375</c:v>
                </c:pt>
                <c:pt idx="520">
                  <c:v>124.583333333333</c:v>
                </c:pt>
                <c:pt idx="521">
                  <c:v>124.822916666667</c:v>
                </c:pt>
                <c:pt idx="522">
                  <c:v>125.0625</c:v>
                </c:pt>
                <c:pt idx="523">
                  <c:v>125.302083333333</c:v>
                </c:pt>
                <c:pt idx="524">
                  <c:v>125.541666666667</c:v>
                </c:pt>
                <c:pt idx="525">
                  <c:v>125.78125</c:v>
                </c:pt>
                <c:pt idx="526">
                  <c:v>126.020833333333</c:v>
                </c:pt>
                <c:pt idx="527">
                  <c:v>126.260416666667</c:v>
                </c:pt>
                <c:pt idx="528">
                  <c:v>126.5</c:v>
                </c:pt>
                <c:pt idx="529">
                  <c:v>126.739583333333</c:v>
                </c:pt>
                <c:pt idx="530">
                  <c:v>126.979166666667</c:v>
                </c:pt>
                <c:pt idx="531">
                  <c:v>127.21875</c:v>
                </c:pt>
                <c:pt idx="532">
                  <c:v>127.458333333333</c:v>
                </c:pt>
                <c:pt idx="533">
                  <c:v>127.697916666667</c:v>
                </c:pt>
                <c:pt idx="534">
                  <c:v>127.9375</c:v>
                </c:pt>
                <c:pt idx="535">
                  <c:v>128.177083333333</c:v>
                </c:pt>
                <c:pt idx="536">
                  <c:v>128.416666666667</c:v>
                </c:pt>
                <c:pt idx="537">
                  <c:v>128.65625</c:v>
                </c:pt>
                <c:pt idx="538">
                  <c:v>128.895833333333</c:v>
                </c:pt>
                <c:pt idx="539">
                  <c:v>129.135416666667</c:v>
                </c:pt>
                <c:pt idx="540">
                  <c:v>129.375</c:v>
                </c:pt>
                <c:pt idx="541">
                  <c:v>129.614583333333</c:v>
                </c:pt>
                <c:pt idx="542">
                  <c:v>129.854166666667</c:v>
                </c:pt>
                <c:pt idx="543">
                  <c:v>130.09375</c:v>
                </c:pt>
                <c:pt idx="544">
                  <c:v>130.333333333333</c:v>
                </c:pt>
                <c:pt idx="545">
                  <c:v>130.572916666667</c:v>
                </c:pt>
                <c:pt idx="546">
                  <c:v>130.8125</c:v>
                </c:pt>
                <c:pt idx="547">
                  <c:v>131.052083333333</c:v>
                </c:pt>
                <c:pt idx="548">
                  <c:v>131.291666666667</c:v>
                </c:pt>
                <c:pt idx="549">
                  <c:v>131.53125</c:v>
                </c:pt>
                <c:pt idx="550">
                  <c:v>131.770833333333</c:v>
                </c:pt>
                <c:pt idx="551">
                  <c:v>132.010416666667</c:v>
                </c:pt>
                <c:pt idx="552">
                  <c:v>132.25</c:v>
                </c:pt>
                <c:pt idx="553">
                  <c:v>132.489583333333</c:v>
                </c:pt>
                <c:pt idx="554">
                  <c:v>132.729166666667</c:v>
                </c:pt>
                <c:pt idx="555">
                  <c:v>132.96875</c:v>
                </c:pt>
                <c:pt idx="556">
                  <c:v>133.208333333333</c:v>
                </c:pt>
                <c:pt idx="557">
                  <c:v>133.447916666667</c:v>
                </c:pt>
                <c:pt idx="558">
                  <c:v>133.6875</c:v>
                </c:pt>
                <c:pt idx="559">
                  <c:v>133.927083333333</c:v>
                </c:pt>
                <c:pt idx="560">
                  <c:v>134.166666666667</c:v>
                </c:pt>
                <c:pt idx="561">
                  <c:v>134.40625</c:v>
                </c:pt>
                <c:pt idx="562">
                  <c:v>134.645833333333</c:v>
                </c:pt>
                <c:pt idx="563">
                  <c:v>134.885416666667</c:v>
                </c:pt>
                <c:pt idx="564">
                  <c:v>135.125</c:v>
                </c:pt>
                <c:pt idx="565">
                  <c:v>135.364583333333</c:v>
                </c:pt>
                <c:pt idx="566">
                  <c:v>135.604166666667</c:v>
                </c:pt>
                <c:pt idx="567">
                  <c:v>135.84375</c:v>
                </c:pt>
                <c:pt idx="568">
                  <c:v>136.083333333333</c:v>
                </c:pt>
                <c:pt idx="569">
                  <c:v>136.322916666667</c:v>
                </c:pt>
                <c:pt idx="570">
                  <c:v>136.5625</c:v>
                </c:pt>
                <c:pt idx="571">
                  <c:v>136.802083333333</c:v>
                </c:pt>
                <c:pt idx="572">
                  <c:v>137.041666666667</c:v>
                </c:pt>
                <c:pt idx="573">
                  <c:v>137.28125</c:v>
                </c:pt>
                <c:pt idx="574">
                  <c:v>137.520833333333</c:v>
                </c:pt>
                <c:pt idx="575">
                  <c:v>137.760416666667</c:v>
                </c:pt>
                <c:pt idx="576">
                  <c:v>138</c:v>
                </c:pt>
                <c:pt idx="577">
                  <c:v>138.239583333333</c:v>
                </c:pt>
                <c:pt idx="578">
                  <c:v>138.479166666667</c:v>
                </c:pt>
                <c:pt idx="579">
                  <c:v>138.71875</c:v>
                </c:pt>
                <c:pt idx="580">
                  <c:v>138.958333333333</c:v>
                </c:pt>
                <c:pt idx="581">
                  <c:v>139.197916666667</c:v>
                </c:pt>
                <c:pt idx="582">
                  <c:v>139.4375</c:v>
                </c:pt>
                <c:pt idx="583">
                  <c:v>139.677083333333</c:v>
                </c:pt>
                <c:pt idx="584">
                  <c:v>139.916666666667</c:v>
                </c:pt>
                <c:pt idx="585">
                  <c:v>140.15625</c:v>
                </c:pt>
                <c:pt idx="586">
                  <c:v>140.395833333333</c:v>
                </c:pt>
                <c:pt idx="587">
                  <c:v>140.635416666667</c:v>
                </c:pt>
                <c:pt idx="588">
                  <c:v>140.875</c:v>
                </c:pt>
                <c:pt idx="589">
                  <c:v>141.114583333333</c:v>
                </c:pt>
                <c:pt idx="590">
                  <c:v>141.354166666667</c:v>
                </c:pt>
                <c:pt idx="591">
                  <c:v>141.59375</c:v>
                </c:pt>
                <c:pt idx="592">
                  <c:v>141.833333333333</c:v>
                </c:pt>
                <c:pt idx="593">
                  <c:v>142.072916666667</c:v>
                </c:pt>
                <c:pt idx="594">
                  <c:v>142.3125</c:v>
                </c:pt>
                <c:pt idx="595">
                  <c:v>142.552083333333</c:v>
                </c:pt>
                <c:pt idx="596">
                  <c:v>142.791666666667</c:v>
                </c:pt>
                <c:pt idx="597">
                  <c:v>143.03125</c:v>
                </c:pt>
                <c:pt idx="598">
                  <c:v>143.270833333333</c:v>
                </c:pt>
                <c:pt idx="599">
                  <c:v>143.510416666667</c:v>
                </c:pt>
                <c:pt idx="600">
                  <c:v>143.75</c:v>
                </c:pt>
                <c:pt idx="601">
                  <c:v>143.989583333333</c:v>
                </c:pt>
                <c:pt idx="602">
                  <c:v>144.229166666667</c:v>
                </c:pt>
                <c:pt idx="603">
                  <c:v>144.46875</c:v>
                </c:pt>
                <c:pt idx="604">
                  <c:v>144.708333333333</c:v>
                </c:pt>
                <c:pt idx="605">
                  <c:v>144.947916666667</c:v>
                </c:pt>
                <c:pt idx="606">
                  <c:v>145.1875</c:v>
                </c:pt>
                <c:pt idx="607">
                  <c:v>145.427083333333</c:v>
                </c:pt>
                <c:pt idx="608">
                  <c:v>145.666666666667</c:v>
                </c:pt>
                <c:pt idx="609">
                  <c:v>145.90625</c:v>
                </c:pt>
                <c:pt idx="610">
                  <c:v>146.145833333333</c:v>
                </c:pt>
                <c:pt idx="611">
                  <c:v>146.385416666667</c:v>
                </c:pt>
                <c:pt idx="612">
                  <c:v>146.625</c:v>
                </c:pt>
                <c:pt idx="613">
                  <c:v>146.864583333333</c:v>
                </c:pt>
                <c:pt idx="614">
                  <c:v>147.104166666667</c:v>
                </c:pt>
                <c:pt idx="615">
                  <c:v>147.34375</c:v>
                </c:pt>
                <c:pt idx="616">
                  <c:v>147.583333333333</c:v>
                </c:pt>
                <c:pt idx="617">
                  <c:v>147.822916666667</c:v>
                </c:pt>
                <c:pt idx="618">
                  <c:v>148.0625</c:v>
                </c:pt>
                <c:pt idx="619">
                  <c:v>148.302083333333</c:v>
                </c:pt>
                <c:pt idx="620">
                  <c:v>148.541666666667</c:v>
                </c:pt>
                <c:pt idx="621">
                  <c:v>148.78125</c:v>
                </c:pt>
                <c:pt idx="622">
                  <c:v>149.020833333333</c:v>
                </c:pt>
                <c:pt idx="623">
                  <c:v>149.260416666667</c:v>
                </c:pt>
                <c:pt idx="624">
                  <c:v>149.5</c:v>
                </c:pt>
                <c:pt idx="625">
                  <c:v>149.739583333333</c:v>
                </c:pt>
                <c:pt idx="626">
                  <c:v>149.979166666667</c:v>
                </c:pt>
                <c:pt idx="627">
                  <c:v>150.21875</c:v>
                </c:pt>
                <c:pt idx="628">
                  <c:v>150.458333333333</c:v>
                </c:pt>
                <c:pt idx="629">
                  <c:v>150.697916666667</c:v>
                </c:pt>
                <c:pt idx="630">
                  <c:v>150.9375</c:v>
                </c:pt>
                <c:pt idx="631">
                  <c:v>151.177083333333</c:v>
                </c:pt>
                <c:pt idx="632">
                  <c:v>151.416666666667</c:v>
                </c:pt>
                <c:pt idx="633">
                  <c:v>151.65625</c:v>
                </c:pt>
                <c:pt idx="634">
                  <c:v>151.895833333333</c:v>
                </c:pt>
                <c:pt idx="635">
                  <c:v>152.135416666667</c:v>
                </c:pt>
                <c:pt idx="636">
                  <c:v>152.375</c:v>
                </c:pt>
                <c:pt idx="637">
                  <c:v>152.614583333333</c:v>
                </c:pt>
                <c:pt idx="638">
                  <c:v>152.854166666667</c:v>
                </c:pt>
                <c:pt idx="639">
                  <c:v>153.09375</c:v>
                </c:pt>
                <c:pt idx="640">
                  <c:v>153.333333333333</c:v>
                </c:pt>
                <c:pt idx="641">
                  <c:v>153.572916666667</c:v>
                </c:pt>
                <c:pt idx="642">
                  <c:v>153.8125</c:v>
                </c:pt>
                <c:pt idx="643">
                  <c:v>154.052083333333</c:v>
                </c:pt>
                <c:pt idx="644">
                  <c:v>154.291666666667</c:v>
                </c:pt>
                <c:pt idx="645">
                  <c:v>154.53125</c:v>
                </c:pt>
                <c:pt idx="646">
                  <c:v>154.770833333333</c:v>
                </c:pt>
                <c:pt idx="647">
                  <c:v>155.010416666667</c:v>
                </c:pt>
                <c:pt idx="648">
                  <c:v>155.25</c:v>
                </c:pt>
                <c:pt idx="649">
                  <c:v>155.489583333333</c:v>
                </c:pt>
                <c:pt idx="650">
                  <c:v>155.729166666667</c:v>
                </c:pt>
                <c:pt idx="651">
                  <c:v>155.96875</c:v>
                </c:pt>
                <c:pt idx="652">
                  <c:v>156.208333333333</c:v>
                </c:pt>
                <c:pt idx="653">
                  <c:v>156.447916666667</c:v>
                </c:pt>
                <c:pt idx="654">
                  <c:v>156.6875</c:v>
                </c:pt>
                <c:pt idx="655">
                  <c:v>156.927083333333</c:v>
                </c:pt>
                <c:pt idx="656">
                  <c:v>157.166666666667</c:v>
                </c:pt>
                <c:pt idx="657">
                  <c:v>157.40625</c:v>
                </c:pt>
                <c:pt idx="658">
                  <c:v>157.645833333333</c:v>
                </c:pt>
                <c:pt idx="659">
                  <c:v>157.885416666667</c:v>
                </c:pt>
                <c:pt idx="660">
                  <c:v>158.125</c:v>
                </c:pt>
                <c:pt idx="661">
                  <c:v>158.364583333333</c:v>
                </c:pt>
                <c:pt idx="662">
                  <c:v>158.604166666667</c:v>
                </c:pt>
                <c:pt idx="663">
                  <c:v>158.84375</c:v>
                </c:pt>
                <c:pt idx="664">
                  <c:v>159.083333333333</c:v>
                </c:pt>
                <c:pt idx="665">
                  <c:v>159.322916666667</c:v>
                </c:pt>
                <c:pt idx="666">
                  <c:v>159.5625</c:v>
                </c:pt>
                <c:pt idx="667">
                  <c:v>159.802083333333</c:v>
                </c:pt>
                <c:pt idx="668">
                  <c:v>160.041666666667</c:v>
                </c:pt>
                <c:pt idx="669">
                  <c:v>160.28125</c:v>
                </c:pt>
                <c:pt idx="670">
                  <c:v>160.520833333333</c:v>
                </c:pt>
                <c:pt idx="671">
                  <c:v>160.760416666667</c:v>
                </c:pt>
                <c:pt idx="672">
                  <c:v>161</c:v>
                </c:pt>
                <c:pt idx="673">
                  <c:v>161.239583333333</c:v>
                </c:pt>
                <c:pt idx="674">
                  <c:v>161.479166666667</c:v>
                </c:pt>
                <c:pt idx="675">
                  <c:v>161.71875</c:v>
                </c:pt>
                <c:pt idx="676">
                  <c:v>161.958333333333</c:v>
                </c:pt>
                <c:pt idx="677">
                  <c:v>162.197916666667</c:v>
                </c:pt>
                <c:pt idx="678">
                  <c:v>162.4375</c:v>
                </c:pt>
                <c:pt idx="679">
                  <c:v>162.677083333333</c:v>
                </c:pt>
                <c:pt idx="680">
                  <c:v>162.916666666667</c:v>
                </c:pt>
                <c:pt idx="681">
                  <c:v>163.15625</c:v>
                </c:pt>
                <c:pt idx="682">
                  <c:v>163.395833333333</c:v>
                </c:pt>
                <c:pt idx="683">
                  <c:v>163.635416666667</c:v>
                </c:pt>
                <c:pt idx="684">
                  <c:v>163.875</c:v>
                </c:pt>
                <c:pt idx="685">
                  <c:v>164.114583333333</c:v>
                </c:pt>
                <c:pt idx="686">
                  <c:v>164.354166666667</c:v>
                </c:pt>
                <c:pt idx="687">
                  <c:v>164.59375</c:v>
                </c:pt>
                <c:pt idx="688">
                  <c:v>164.833333333333</c:v>
                </c:pt>
                <c:pt idx="689">
                  <c:v>165.072916666667</c:v>
                </c:pt>
                <c:pt idx="690">
                  <c:v>165.3125</c:v>
                </c:pt>
                <c:pt idx="691">
                  <c:v>165.552083333333</c:v>
                </c:pt>
                <c:pt idx="692">
                  <c:v>165.791666666667</c:v>
                </c:pt>
                <c:pt idx="693">
                  <c:v>166.03125</c:v>
                </c:pt>
                <c:pt idx="694">
                  <c:v>166.270833333333</c:v>
                </c:pt>
                <c:pt idx="695">
                  <c:v>166.510416666667</c:v>
                </c:pt>
                <c:pt idx="696">
                  <c:v>166.75</c:v>
                </c:pt>
                <c:pt idx="697">
                  <c:v>166.989583333333</c:v>
                </c:pt>
                <c:pt idx="698">
                  <c:v>167.229166666667</c:v>
                </c:pt>
                <c:pt idx="699">
                  <c:v>167.46875</c:v>
                </c:pt>
                <c:pt idx="700">
                  <c:v>167.708333333333</c:v>
                </c:pt>
                <c:pt idx="701">
                  <c:v>167.947916666667</c:v>
                </c:pt>
                <c:pt idx="702">
                  <c:v>168.1875</c:v>
                </c:pt>
                <c:pt idx="703">
                  <c:v>168.427083333333</c:v>
                </c:pt>
                <c:pt idx="704">
                  <c:v>168.666666666667</c:v>
                </c:pt>
                <c:pt idx="705">
                  <c:v>168.90625</c:v>
                </c:pt>
                <c:pt idx="706">
                  <c:v>169.145833333333</c:v>
                </c:pt>
                <c:pt idx="707">
                  <c:v>169.385416666667</c:v>
                </c:pt>
                <c:pt idx="708">
                  <c:v>169.625</c:v>
                </c:pt>
                <c:pt idx="709">
                  <c:v>169.864583333333</c:v>
                </c:pt>
                <c:pt idx="710">
                  <c:v>170.104166666667</c:v>
                </c:pt>
                <c:pt idx="711">
                  <c:v>170.34375</c:v>
                </c:pt>
                <c:pt idx="712">
                  <c:v>170.583333333333</c:v>
                </c:pt>
                <c:pt idx="713">
                  <c:v>170.822916666667</c:v>
                </c:pt>
                <c:pt idx="714">
                  <c:v>171.0625</c:v>
                </c:pt>
                <c:pt idx="715">
                  <c:v>171.302083333333</c:v>
                </c:pt>
                <c:pt idx="716">
                  <c:v>171.541666666667</c:v>
                </c:pt>
                <c:pt idx="717">
                  <c:v>171.78125</c:v>
                </c:pt>
                <c:pt idx="718">
                  <c:v>172.020833333333</c:v>
                </c:pt>
                <c:pt idx="719">
                  <c:v>172.260416666667</c:v>
                </c:pt>
                <c:pt idx="720">
                  <c:v>172.5</c:v>
                </c:pt>
                <c:pt idx="721">
                  <c:v>172.739583333333</c:v>
                </c:pt>
                <c:pt idx="722">
                  <c:v>172.979166666667</c:v>
                </c:pt>
                <c:pt idx="723">
                  <c:v>173.21875</c:v>
                </c:pt>
                <c:pt idx="724">
                  <c:v>173.458333333333</c:v>
                </c:pt>
                <c:pt idx="725">
                  <c:v>173.697916666667</c:v>
                </c:pt>
                <c:pt idx="726">
                  <c:v>173.9375</c:v>
                </c:pt>
                <c:pt idx="727">
                  <c:v>174.177083333333</c:v>
                </c:pt>
                <c:pt idx="728">
                  <c:v>174.416666666667</c:v>
                </c:pt>
                <c:pt idx="729">
                  <c:v>174.65625</c:v>
                </c:pt>
                <c:pt idx="730">
                  <c:v>174.895833333333</c:v>
                </c:pt>
                <c:pt idx="731">
                  <c:v>175.135416666667</c:v>
                </c:pt>
                <c:pt idx="732">
                  <c:v>175.375</c:v>
                </c:pt>
                <c:pt idx="733">
                  <c:v>175.614583333333</c:v>
                </c:pt>
                <c:pt idx="734">
                  <c:v>175.854166666667</c:v>
                </c:pt>
                <c:pt idx="735">
                  <c:v>176.09375</c:v>
                </c:pt>
                <c:pt idx="736">
                  <c:v>176.333333333333</c:v>
                </c:pt>
                <c:pt idx="737">
                  <c:v>176.572916666667</c:v>
                </c:pt>
                <c:pt idx="738">
                  <c:v>176.8125</c:v>
                </c:pt>
                <c:pt idx="739">
                  <c:v>177.052083333333</c:v>
                </c:pt>
                <c:pt idx="740">
                  <c:v>177.291666666667</c:v>
                </c:pt>
                <c:pt idx="741">
                  <c:v>177.53125</c:v>
                </c:pt>
                <c:pt idx="742">
                  <c:v>177.770833333333</c:v>
                </c:pt>
                <c:pt idx="743">
                  <c:v>178.010416666667</c:v>
                </c:pt>
                <c:pt idx="744">
                  <c:v>178.25</c:v>
                </c:pt>
                <c:pt idx="745">
                  <c:v>178.489583333333</c:v>
                </c:pt>
                <c:pt idx="746">
                  <c:v>178.729166666667</c:v>
                </c:pt>
                <c:pt idx="747">
                  <c:v>178.96875</c:v>
                </c:pt>
                <c:pt idx="748">
                  <c:v>179.208333333333</c:v>
                </c:pt>
                <c:pt idx="749">
                  <c:v>179.447916666667</c:v>
                </c:pt>
                <c:pt idx="750">
                  <c:v>179.6875</c:v>
                </c:pt>
                <c:pt idx="751">
                  <c:v>179.927083333333</c:v>
                </c:pt>
                <c:pt idx="752">
                  <c:v>180.166666666667</c:v>
                </c:pt>
                <c:pt idx="753">
                  <c:v>180.40625</c:v>
                </c:pt>
                <c:pt idx="754">
                  <c:v>180.645833333333</c:v>
                </c:pt>
                <c:pt idx="755">
                  <c:v>180.885416666667</c:v>
                </c:pt>
                <c:pt idx="756">
                  <c:v>181.125</c:v>
                </c:pt>
                <c:pt idx="757">
                  <c:v>181.364583333333</c:v>
                </c:pt>
                <c:pt idx="758">
                  <c:v>181.604166666667</c:v>
                </c:pt>
                <c:pt idx="759">
                  <c:v>181.84375</c:v>
                </c:pt>
                <c:pt idx="760">
                  <c:v>182.083333333333</c:v>
                </c:pt>
                <c:pt idx="761">
                  <c:v>182.322916666667</c:v>
                </c:pt>
                <c:pt idx="762">
                  <c:v>182.5625</c:v>
                </c:pt>
                <c:pt idx="763">
                  <c:v>182.802083333333</c:v>
                </c:pt>
                <c:pt idx="764">
                  <c:v>183.041666666667</c:v>
                </c:pt>
                <c:pt idx="765">
                  <c:v>183.28125</c:v>
                </c:pt>
                <c:pt idx="766">
                  <c:v>183.520833333333</c:v>
                </c:pt>
                <c:pt idx="767">
                  <c:v>183.760416666667</c:v>
                </c:pt>
                <c:pt idx="768">
                  <c:v>184</c:v>
                </c:pt>
                <c:pt idx="769">
                  <c:v>184.239583333333</c:v>
                </c:pt>
                <c:pt idx="770">
                  <c:v>184.479166666667</c:v>
                </c:pt>
                <c:pt idx="771">
                  <c:v>184.71875</c:v>
                </c:pt>
                <c:pt idx="772">
                  <c:v>184.958333333333</c:v>
                </c:pt>
                <c:pt idx="773">
                  <c:v>185.197916666667</c:v>
                </c:pt>
                <c:pt idx="774">
                  <c:v>185.4375</c:v>
                </c:pt>
                <c:pt idx="775">
                  <c:v>185.677083333333</c:v>
                </c:pt>
                <c:pt idx="776">
                  <c:v>185.916666666667</c:v>
                </c:pt>
                <c:pt idx="777">
                  <c:v>186.15625</c:v>
                </c:pt>
                <c:pt idx="778">
                  <c:v>186.395833333333</c:v>
                </c:pt>
                <c:pt idx="779">
                  <c:v>186.635416666667</c:v>
                </c:pt>
                <c:pt idx="780">
                  <c:v>186.875</c:v>
                </c:pt>
                <c:pt idx="781">
                  <c:v>187.114583333333</c:v>
                </c:pt>
                <c:pt idx="782">
                  <c:v>187.354166666667</c:v>
                </c:pt>
                <c:pt idx="783">
                  <c:v>187.59375</c:v>
                </c:pt>
                <c:pt idx="784">
                  <c:v>187.833333333333</c:v>
                </c:pt>
                <c:pt idx="785">
                  <c:v>188.072916666667</c:v>
                </c:pt>
                <c:pt idx="786">
                  <c:v>188.3125</c:v>
                </c:pt>
                <c:pt idx="787">
                  <c:v>188.552083333333</c:v>
                </c:pt>
                <c:pt idx="788">
                  <c:v>188.791666666667</c:v>
                </c:pt>
                <c:pt idx="789">
                  <c:v>189.03125</c:v>
                </c:pt>
                <c:pt idx="790">
                  <c:v>189.270833333333</c:v>
                </c:pt>
                <c:pt idx="791">
                  <c:v>189.510416666667</c:v>
                </c:pt>
                <c:pt idx="792">
                  <c:v>189.75</c:v>
                </c:pt>
                <c:pt idx="793">
                  <c:v>189.989583333333</c:v>
                </c:pt>
                <c:pt idx="794">
                  <c:v>190.229166666667</c:v>
                </c:pt>
                <c:pt idx="795">
                  <c:v>190.46875</c:v>
                </c:pt>
                <c:pt idx="796">
                  <c:v>190.708333333333</c:v>
                </c:pt>
                <c:pt idx="797">
                  <c:v>190.947916666667</c:v>
                </c:pt>
                <c:pt idx="798">
                  <c:v>191.1875</c:v>
                </c:pt>
                <c:pt idx="799">
                  <c:v>191.427083333333</c:v>
                </c:pt>
                <c:pt idx="800">
                  <c:v>191.666666666667</c:v>
                </c:pt>
                <c:pt idx="801">
                  <c:v>191.90625</c:v>
                </c:pt>
                <c:pt idx="802">
                  <c:v>192.145833333333</c:v>
                </c:pt>
                <c:pt idx="803">
                  <c:v>192.385416666667</c:v>
                </c:pt>
                <c:pt idx="804">
                  <c:v>192.625</c:v>
                </c:pt>
                <c:pt idx="805">
                  <c:v>192.864583333333</c:v>
                </c:pt>
                <c:pt idx="806">
                  <c:v>193.104166666667</c:v>
                </c:pt>
                <c:pt idx="807">
                  <c:v>193.34375</c:v>
                </c:pt>
                <c:pt idx="808">
                  <c:v>193.583333333333</c:v>
                </c:pt>
                <c:pt idx="809">
                  <c:v>193.822916666667</c:v>
                </c:pt>
                <c:pt idx="810">
                  <c:v>194.0625</c:v>
                </c:pt>
                <c:pt idx="811">
                  <c:v>194.302083333333</c:v>
                </c:pt>
                <c:pt idx="812">
                  <c:v>194.541666666667</c:v>
                </c:pt>
                <c:pt idx="813">
                  <c:v>194.78125</c:v>
                </c:pt>
                <c:pt idx="814">
                  <c:v>195.020833333333</c:v>
                </c:pt>
                <c:pt idx="815">
                  <c:v>195.260416666667</c:v>
                </c:pt>
                <c:pt idx="816">
                  <c:v>195.5</c:v>
                </c:pt>
                <c:pt idx="817">
                  <c:v>195.739583333333</c:v>
                </c:pt>
                <c:pt idx="818">
                  <c:v>195.979166666667</c:v>
                </c:pt>
                <c:pt idx="819">
                  <c:v>196.21875</c:v>
                </c:pt>
                <c:pt idx="820">
                  <c:v>196.458333333333</c:v>
                </c:pt>
                <c:pt idx="821">
                  <c:v>196.697916666667</c:v>
                </c:pt>
                <c:pt idx="822">
                  <c:v>196.9375</c:v>
                </c:pt>
                <c:pt idx="823">
                  <c:v>197.177083333333</c:v>
                </c:pt>
                <c:pt idx="824">
                  <c:v>197.416666666667</c:v>
                </c:pt>
                <c:pt idx="825">
                  <c:v>197.65625</c:v>
                </c:pt>
                <c:pt idx="826">
                  <c:v>197.895833333333</c:v>
                </c:pt>
                <c:pt idx="827">
                  <c:v>198.135416666667</c:v>
                </c:pt>
                <c:pt idx="828">
                  <c:v>198.375</c:v>
                </c:pt>
                <c:pt idx="829">
                  <c:v>198.614583333333</c:v>
                </c:pt>
                <c:pt idx="830">
                  <c:v>198.854166666667</c:v>
                </c:pt>
                <c:pt idx="831">
                  <c:v>199.09375</c:v>
                </c:pt>
                <c:pt idx="832">
                  <c:v>199.333333333333</c:v>
                </c:pt>
                <c:pt idx="833">
                  <c:v>199.572916666667</c:v>
                </c:pt>
                <c:pt idx="834">
                  <c:v>199.8125</c:v>
                </c:pt>
                <c:pt idx="835">
                  <c:v>200.052083333333</c:v>
                </c:pt>
                <c:pt idx="836">
                  <c:v>200.291666666667</c:v>
                </c:pt>
                <c:pt idx="837">
                  <c:v>200.53125</c:v>
                </c:pt>
                <c:pt idx="838">
                  <c:v>200.770833333333</c:v>
                </c:pt>
                <c:pt idx="839">
                  <c:v>201.010416666667</c:v>
                </c:pt>
                <c:pt idx="840">
                  <c:v>201.25</c:v>
                </c:pt>
                <c:pt idx="841">
                  <c:v>201.489583333333</c:v>
                </c:pt>
                <c:pt idx="842">
                  <c:v>201.729166666667</c:v>
                </c:pt>
                <c:pt idx="843">
                  <c:v>201.96875</c:v>
                </c:pt>
                <c:pt idx="844">
                  <c:v>202.208333333333</c:v>
                </c:pt>
                <c:pt idx="845">
                  <c:v>202.447916666667</c:v>
                </c:pt>
                <c:pt idx="846">
                  <c:v>202.6875</c:v>
                </c:pt>
                <c:pt idx="847">
                  <c:v>202.927083333333</c:v>
                </c:pt>
                <c:pt idx="848">
                  <c:v>203.166666666667</c:v>
                </c:pt>
                <c:pt idx="849">
                  <c:v>203.40625</c:v>
                </c:pt>
                <c:pt idx="850">
                  <c:v>203.645833333333</c:v>
                </c:pt>
                <c:pt idx="851">
                  <c:v>203.885416666667</c:v>
                </c:pt>
                <c:pt idx="852">
                  <c:v>204.125</c:v>
                </c:pt>
                <c:pt idx="853">
                  <c:v>204.364583333333</c:v>
                </c:pt>
                <c:pt idx="854">
                  <c:v>204.604166666667</c:v>
                </c:pt>
                <c:pt idx="855">
                  <c:v>204.84375</c:v>
                </c:pt>
                <c:pt idx="856">
                  <c:v>205.083333333333</c:v>
                </c:pt>
                <c:pt idx="857">
                  <c:v>205.322916666667</c:v>
                </c:pt>
                <c:pt idx="858">
                  <c:v>205.5625</c:v>
                </c:pt>
                <c:pt idx="859">
                  <c:v>205.802083333333</c:v>
                </c:pt>
                <c:pt idx="860">
                  <c:v>206.041666666667</c:v>
                </c:pt>
                <c:pt idx="861">
                  <c:v>206.28125</c:v>
                </c:pt>
                <c:pt idx="862">
                  <c:v>206.520833333333</c:v>
                </c:pt>
                <c:pt idx="863">
                  <c:v>206.760416666667</c:v>
                </c:pt>
                <c:pt idx="864">
                  <c:v>207</c:v>
                </c:pt>
                <c:pt idx="865">
                  <c:v>207.239583333333</c:v>
                </c:pt>
                <c:pt idx="866">
                  <c:v>207.479166666667</c:v>
                </c:pt>
                <c:pt idx="867">
                  <c:v>207.71875</c:v>
                </c:pt>
                <c:pt idx="868">
                  <c:v>207.958333333333</c:v>
                </c:pt>
                <c:pt idx="869">
                  <c:v>208.197916666667</c:v>
                </c:pt>
                <c:pt idx="870">
                  <c:v>208.4375</c:v>
                </c:pt>
                <c:pt idx="871">
                  <c:v>208.677083333333</c:v>
                </c:pt>
                <c:pt idx="872">
                  <c:v>208.916666666667</c:v>
                </c:pt>
                <c:pt idx="873">
                  <c:v>209.15625</c:v>
                </c:pt>
                <c:pt idx="874">
                  <c:v>209.395833333333</c:v>
                </c:pt>
                <c:pt idx="875">
                  <c:v>209.635416666667</c:v>
                </c:pt>
                <c:pt idx="876">
                  <c:v>209.875</c:v>
                </c:pt>
                <c:pt idx="877">
                  <c:v>210.114583333333</c:v>
                </c:pt>
                <c:pt idx="878">
                  <c:v>210.354166666667</c:v>
                </c:pt>
                <c:pt idx="879">
                  <c:v>210.59375</c:v>
                </c:pt>
                <c:pt idx="880">
                  <c:v>210.833333333333</c:v>
                </c:pt>
                <c:pt idx="881">
                  <c:v>211.072916666667</c:v>
                </c:pt>
                <c:pt idx="882">
                  <c:v>211.3125</c:v>
                </c:pt>
                <c:pt idx="883">
                  <c:v>211.552083333333</c:v>
                </c:pt>
                <c:pt idx="884">
                  <c:v>211.791666666667</c:v>
                </c:pt>
                <c:pt idx="885">
                  <c:v>212.03125</c:v>
                </c:pt>
                <c:pt idx="886">
                  <c:v>212.270833333333</c:v>
                </c:pt>
                <c:pt idx="887">
                  <c:v>212.510416666667</c:v>
                </c:pt>
                <c:pt idx="888">
                  <c:v>212.75</c:v>
                </c:pt>
                <c:pt idx="889">
                  <c:v>212.989583333333</c:v>
                </c:pt>
                <c:pt idx="890">
                  <c:v>213.229166666667</c:v>
                </c:pt>
                <c:pt idx="891">
                  <c:v>213.46875</c:v>
                </c:pt>
                <c:pt idx="892">
                  <c:v>213.708333333333</c:v>
                </c:pt>
                <c:pt idx="893">
                  <c:v>213.947916666667</c:v>
                </c:pt>
                <c:pt idx="894">
                  <c:v>214.1875</c:v>
                </c:pt>
                <c:pt idx="895">
                  <c:v>214.427083333333</c:v>
                </c:pt>
                <c:pt idx="896">
                  <c:v>214.666666666667</c:v>
                </c:pt>
                <c:pt idx="897">
                  <c:v>214.90625</c:v>
                </c:pt>
                <c:pt idx="898">
                  <c:v>215.145833333333</c:v>
                </c:pt>
                <c:pt idx="899">
                  <c:v>215.385416666667</c:v>
                </c:pt>
                <c:pt idx="900">
                  <c:v>215.625</c:v>
                </c:pt>
                <c:pt idx="901">
                  <c:v>215.864583333333</c:v>
                </c:pt>
                <c:pt idx="902">
                  <c:v>216.104166666667</c:v>
                </c:pt>
                <c:pt idx="903">
                  <c:v>216.34375</c:v>
                </c:pt>
                <c:pt idx="904">
                  <c:v>216.583333333333</c:v>
                </c:pt>
                <c:pt idx="905">
                  <c:v>216.822916666667</c:v>
                </c:pt>
                <c:pt idx="906">
                  <c:v>217.0625</c:v>
                </c:pt>
                <c:pt idx="907">
                  <c:v>217.302083333333</c:v>
                </c:pt>
                <c:pt idx="908">
                  <c:v>217.541666666667</c:v>
                </c:pt>
                <c:pt idx="909">
                  <c:v>217.78125</c:v>
                </c:pt>
                <c:pt idx="910">
                  <c:v>218.020833333333</c:v>
                </c:pt>
                <c:pt idx="911">
                  <c:v>218.260416666667</c:v>
                </c:pt>
                <c:pt idx="912">
                  <c:v>218.5</c:v>
                </c:pt>
                <c:pt idx="913">
                  <c:v>218.739583333333</c:v>
                </c:pt>
                <c:pt idx="914">
                  <c:v>218.979166666667</c:v>
                </c:pt>
                <c:pt idx="915">
                  <c:v>219.21875</c:v>
                </c:pt>
                <c:pt idx="916">
                  <c:v>219.458333333333</c:v>
                </c:pt>
                <c:pt idx="917">
                  <c:v>219.697916666667</c:v>
                </c:pt>
                <c:pt idx="918">
                  <c:v>219.9375</c:v>
                </c:pt>
                <c:pt idx="919">
                  <c:v>220.177083333333</c:v>
                </c:pt>
                <c:pt idx="920">
                  <c:v>220.416666666667</c:v>
                </c:pt>
                <c:pt idx="921">
                  <c:v>220.65625</c:v>
                </c:pt>
                <c:pt idx="922">
                  <c:v>220.895833333333</c:v>
                </c:pt>
                <c:pt idx="923">
                  <c:v>221.135416666667</c:v>
                </c:pt>
                <c:pt idx="924">
                  <c:v>221.375</c:v>
                </c:pt>
                <c:pt idx="925">
                  <c:v>221.614583333333</c:v>
                </c:pt>
                <c:pt idx="926">
                  <c:v>221.854166666667</c:v>
                </c:pt>
                <c:pt idx="927">
                  <c:v>222.09375</c:v>
                </c:pt>
                <c:pt idx="928">
                  <c:v>222.333333333333</c:v>
                </c:pt>
                <c:pt idx="929">
                  <c:v>222.572916666667</c:v>
                </c:pt>
                <c:pt idx="930">
                  <c:v>222.8125</c:v>
                </c:pt>
                <c:pt idx="931">
                  <c:v>223.052083333333</c:v>
                </c:pt>
                <c:pt idx="932">
                  <c:v>223.291666666667</c:v>
                </c:pt>
                <c:pt idx="933">
                  <c:v>223.53125</c:v>
                </c:pt>
                <c:pt idx="934">
                  <c:v>223.770833333333</c:v>
                </c:pt>
                <c:pt idx="935">
                  <c:v>224.010416666667</c:v>
                </c:pt>
                <c:pt idx="936">
                  <c:v>224.25</c:v>
                </c:pt>
                <c:pt idx="937">
                  <c:v>224.489583333333</c:v>
                </c:pt>
                <c:pt idx="938">
                  <c:v>224.729166666667</c:v>
                </c:pt>
                <c:pt idx="939">
                  <c:v>224.96875</c:v>
                </c:pt>
                <c:pt idx="940">
                  <c:v>225.208333333333</c:v>
                </c:pt>
                <c:pt idx="941">
                  <c:v>225.447916666667</c:v>
                </c:pt>
                <c:pt idx="942">
                  <c:v>225.6875</c:v>
                </c:pt>
                <c:pt idx="943">
                  <c:v>225.927083333333</c:v>
                </c:pt>
                <c:pt idx="944">
                  <c:v>226.166666666667</c:v>
                </c:pt>
                <c:pt idx="945">
                  <c:v>226.40625</c:v>
                </c:pt>
                <c:pt idx="946">
                  <c:v>226.645833333333</c:v>
                </c:pt>
                <c:pt idx="947">
                  <c:v>226.885416666667</c:v>
                </c:pt>
                <c:pt idx="948">
                  <c:v>227.125</c:v>
                </c:pt>
                <c:pt idx="949">
                  <c:v>227.364583333333</c:v>
                </c:pt>
                <c:pt idx="950">
                  <c:v>227.604166666667</c:v>
                </c:pt>
                <c:pt idx="951">
                  <c:v>227.84375</c:v>
                </c:pt>
                <c:pt idx="952">
                  <c:v>228.083333333333</c:v>
                </c:pt>
                <c:pt idx="953">
                  <c:v>228.322916666667</c:v>
                </c:pt>
                <c:pt idx="954">
                  <c:v>228.5625</c:v>
                </c:pt>
                <c:pt idx="955">
                  <c:v>228.802083333333</c:v>
                </c:pt>
                <c:pt idx="956">
                  <c:v>229.041666666667</c:v>
                </c:pt>
                <c:pt idx="957">
                  <c:v>229.28125</c:v>
                </c:pt>
                <c:pt idx="958">
                  <c:v>229.520833333333</c:v>
                </c:pt>
                <c:pt idx="959">
                  <c:v>229.760416666667</c:v>
                </c:pt>
                <c:pt idx="960">
                  <c:v>230</c:v>
                </c:pt>
                <c:pt idx="961">
                  <c:v>230.239583333333</c:v>
                </c:pt>
                <c:pt idx="962">
                  <c:v>230.479166666667</c:v>
                </c:pt>
                <c:pt idx="963">
                  <c:v>230.71875</c:v>
                </c:pt>
                <c:pt idx="964">
                  <c:v>230.958333333333</c:v>
                </c:pt>
                <c:pt idx="965">
                  <c:v>231.197916666667</c:v>
                </c:pt>
                <c:pt idx="966">
                  <c:v>231.4375</c:v>
                </c:pt>
                <c:pt idx="967">
                  <c:v>231.677083333333</c:v>
                </c:pt>
                <c:pt idx="968">
                  <c:v>231.916666666667</c:v>
                </c:pt>
                <c:pt idx="969">
                  <c:v>232.15625</c:v>
                </c:pt>
                <c:pt idx="970">
                  <c:v>232.395833333333</c:v>
                </c:pt>
                <c:pt idx="971">
                  <c:v>232.635416666667</c:v>
                </c:pt>
                <c:pt idx="972">
                  <c:v>232.875</c:v>
                </c:pt>
                <c:pt idx="973">
                  <c:v>233.114583333333</c:v>
                </c:pt>
                <c:pt idx="974">
                  <c:v>233.354166666667</c:v>
                </c:pt>
                <c:pt idx="975">
                  <c:v>233.59375</c:v>
                </c:pt>
                <c:pt idx="976">
                  <c:v>233.833333333333</c:v>
                </c:pt>
                <c:pt idx="977">
                  <c:v>234.072916666667</c:v>
                </c:pt>
                <c:pt idx="978">
                  <c:v>234.3125</c:v>
                </c:pt>
                <c:pt idx="979">
                  <c:v>234.552083333333</c:v>
                </c:pt>
                <c:pt idx="980">
                  <c:v>234.791666666667</c:v>
                </c:pt>
                <c:pt idx="981">
                  <c:v>235.03125</c:v>
                </c:pt>
                <c:pt idx="982">
                  <c:v>235.270833333333</c:v>
                </c:pt>
                <c:pt idx="983">
                  <c:v>235.510416666667</c:v>
                </c:pt>
                <c:pt idx="984">
                  <c:v>235.75</c:v>
                </c:pt>
                <c:pt idx="985">
                  <c:v>235.989583333333</c:v>
                </c:pt>
                <c:pt idx="986">
                  <c:v>236.229166666667</c:v>
                </c:pt>
                <c:pt idx="987">
                  <c:v>236.46875</c:v>
                </c:pt>
                <c:pt idx="988">
                  <c:v>236.708333333333</c:v>
                </c:pt>
                <c:pt idx="989">
                  <c:v>236.947916666667</c:v>
                </c:pt>
                <c:pt idx="990">
                  <c:v>237.1875</c:v>
                </c:pt>
                <c:pt idx="991">
                  <c:v>237.427083333333</c:v>
                </c:pt>
                <c:pt idx="992">
                  <c:v>237.666666666667</c:v>
                </c:pt>
                <c:pt idx="993">
                  <c:v>237.90625</c:v>
                </c:pt>
                <c:pt idx="994">
                  <c:v>238.145833333333</c:v>
                </c:pt>
                <c:pt idx="995">
                  <c:v>238.385416666667</c:v>
                </c:pt>
                <c:pt idx="996">
                  <c:v>238.625</c:v>
                </c:pt>
                <c:pt idx="997">
                  <c:v>238.864583333333</c:v>
                </c:pt>
                <c:pt idx="998">
                  <c:v>239.104166666667</c:v>
                </c:pt>
                <c:pt idx="999">
                  <c:v>239.34375</c:v>
                </c:pt>
                <c:pt idx="1000">
                  <c:v>239.583333333333</c:v>
                </c:pt>
                <c:pt idx="1001">
                  <c:v>239.822916666667</c:v>
                </c:pt>
                <c:pt idx="1002">
                  <c:v>240.0625</c:v>
                </c:pt>
                <c:pt idx="1003">
                  <c:v>240.302083333333</c:v>
                </c:pt>
                <c:pt idx="1004">
                  <c:v>240.541666666667</c:v>
                </c:pt>
                <c:pt idx="1005">
                  <c:v>240.78125</c:v>
                </c:pt>
                <c:pt idx="1006">
                  <c:v>241.020833333333</c:v>
                </c:pt>
                <c:pt idx="1007">
                  <c:v>241.260416666667</c:v>
                </c:pt>
                <c:pt idx="1008">
                  <c:v>241.5</c:v>
                </c:pt>
                <c:pt idx="1009">
                  <c:v>241.739583333333</c:v>
                </c:pt>
                <c:pt idx="1010">
                  <c:v>241.979166666667</c:v>
                </c:pt>
                <c:pt idx="1011">
                  <c:v>242.21875</c:v>
                </c:pt>
                <c:pt idx="1012">
                  <c:v>242.458333333333</c:v>
                </c:pt>
                <c:pt idx="1013">
                  <c:v>242.697916666667</c:v>
                </c:pt>
                <c:pt idx="1014">
                  <c:v>242.9375</c:v>
                </c:pt>
                <c:pt idx="1015">
                  <c:v>243.177083333333</c:v>
                </c:pt>
                <c:pt idx="1016">
                  <c:v>243.416666666667</c:v>
                </c:pt>
                <c:pt idx="1017">
                  <c:v>243.65625</c:v>
                </c:pt>
                <c:pt idx="1018">
                  <c:v>243.895833333333</c:v>
                </c:pt>
                <c:pt idx="1019">
                  <c:v>244.135416666667</c:v>
                </c:pt>
                <c:pt idx="1020">
                  <c:v>244.375</c:v>
                </c:pt>
                <c:pt idx="1021">
                  <c:v>244.614583333333</c:v>
                </c:pt>
                <c:pt idx="1022">
                  <c:v>244.854166666667</c:v>
                </c:pt>
                <c:pt idx="1023">
                  <c:v>245.09375</c:v>
                </c:pt>
                <c:pt idx="1024">
                  <c:v>245.333333333333</c:v>
                </c:pt>
                <c:pt idx="1025">
                  <c:v>245.572916666667</c:v>
                </c:pt>
                <c:pt idx="1026">
                  <c:v>245.8125</c:v>
                </c:pt>
                <c:pt idx="1027">
                  <c:v>246.052083333333</c:v>
                </c:pt>
                <c:pt idx="1028">
                  <c:v>246.291666666667</c:v>
                </c:pt>
                <c:pt idx="1029">
                  <c:v>246.53125</c:v>
                </c:pt>
                <c:pt idx="1030">
                  <c:v>246.770833333333</c:v>
                </c:pt>
                <c:pt idx="1031">
                  <c:v>247.010416666667</c:v>
                </c:pt>
                <c:pt idx="1032">
                  <c:v>247.25</c:v>
                </c:pt>
                <c:pt idx="1033">
                  <c:v>247.489583333333</c:v>
                </c:pt>
                <c:pt idx="1034">
                  <c:v>247.729166666667</c:v>
                </c:pt>
                <c:pt idx="1035">
                  <c:v>247.96875</c:v>
                </c:pt>
                <c:pt idx="1036">
                  <c:v>248.208333333333</c:v>
                </c:pt>
                <c:pt idx="1037">
                  <c:v>248.447916666667</c:v>
                </c:pt>
                <c:pt idx="1038">
                  <c:v>248.6875</c:v>
                </c:pt>
                <c:pt idx="1039">
                  <c:v>248.927083333333</c:v>
                </c:pt>
                <c:pt idx="1040">
                  <c:v>249.166666666667</c:v>
                </c:pt>
                <c:pt idx="1041">
                  <c:v>249.40625</c:v>
                </c:pt>
                <c:pt idx="1042">
                  <c:v>249.645833333333</c:v>
                </c:pt>
                <c:pt idx="1043">
                  <c:v>249.885416666667</c:v>
                </c:pt>
                <c:pt idx="1044">
                  <c:v>250.125</c:v>
                </c:pt>
                <c:pt idx="1045">
                  <c:v>250.364583333333</c:v>
                </c:pt>
                <c:pt idx="1046">
                  <c:v>250.604166666667</c:v>
                </c:pt>
                <c:pt idx="1047">
                  <c:v>250.84375</c:v>
                </c:pt>
                <c:pt idx="1048">
                  <c:v>251.083333333333</c:v>
                </c:pt>
                <c:pt idx="1049">
                  <c:v>251.322916666667</c:v>
                </c:pt>
                <c:pt idx="1050">
                  <c:v>251.5625</c:v>
                </c:pt>
                <c:pt idx="1051">
                  <c:v>251.802083333333</c:v>
                </c:pt>
                <c:pt idx="1052">
                  <c:v>252.041666666667</c:v>
                </c:pt>
                <c:pt idx="1053">
                  <c:v>252.28125</c:v>
                </c:pt>
                <c:pt idx="1054">
                  <c:v>252.520833333333</c:v>
                </c:pt>
                <c:pt idx="1055">
                  <c:v>252.760416666667</c:v>
                </c:pt>
                <c:pt idx="1056">
                  <c:v>253</c:v>
                </c:pt>
                <c:pt idx="1057">
                  <c:v>253.239583333333</c:v>
                </c:pt>
                <c:pt idx="1058">
                  <c:v>253.479166666667</c:v>
                </c:pt>
                <c:pt idx="1059">
                  <c:v>253.71875</c:v>
                </c:pt>
                <c:pt idx="1060">
                  <c:v>253.958333333333</c:v>
                </c:pt>
                <c:pt idx="1061">
                  <c:v>254.197916666667</c:v>
                </c:pt>
                <c:pt idx="1062">
                  <c:v>254.4375</c:v>
                </c:pt>
                <c:pt idx="1063">
                  <c:v>254.677083333333</c:v>
                </c:pt>
                <c:pt idx="1064">
                  <c:v>254.916666666667</c:v>
                </c:pt>
                <c:pt idx="1065">
                  <c:v>255.15625</c:v>
                </c:pt>
                <c:pt idx="1066">
                  <c:v>255.395833333333</c:v>
                </c:pt>
                <c:pt idx="1067">
                  <c:v>255.635416666667</c:v>
                </c:pt>
                <c:pt idx="1068">
                  <c:v>255.875</c:v>
                </c:pt>
                <c:pt idx="1069">
                  <c:v>256.11458333333297</c:v>
                </c:pt>
                <c:pt idx="1070">
                  <c:v>256.35416666666703</c:v>
                </c:pt>
                <c:pt idx="1071">
                  <c:v>256.59375</c:v>
                </c:pt>
                <c:pt idx="1072">
                  <c:v>256.83333333333297</c:v>
                </c:pt>
                <c:pt idx="1073">
                  <c:v>257.07291666666703</c:v>
                </c:pt>
                <c:pt idx="1074">
                  <c:v>257.3125</c:v>
                </c:pt>
                <c:pt idx="1075">
                  <c:v>257.55208333333297</c:v>
                </c:pt>
                <c:pt idx="1076">
                  <c:v>257.79166666666703</c:v>
                </c:pt>
                <c:pt idx="1077">
                  <c:v>258.03125</c:v>
                </c:pt>
                <c:pt idx="1078">
                  <c:v>258.27083333333297</c:v>
                </c:pt>
                <c:pt idx="1079">
                  <c:v>258.51041666666703</c:v>
                </c:pt>
                <c:pt idx="1080">
                  <c:v>258.75</c:v>
                </c:pt>
                <c:pt idx="1081">
                  <c:v>258.98958333333297</c:v>
                </c:pt>
                <c:pt idx="1082">
                  <c:v>259.22916666666703</c:v>
                </c:pt>
                <c:pt idx="1083">
                  <c:v>259.46875</c:v>
                </c:pt>
                <c:pt idx="1084">
                  <c:v>259.70833333333297</c:v>
                </c:pt>
                <c:pt idx="1085">
                  <c:v>259.94791666666703</c:v>
                </c:pt>
                <c:pt idx="1086">
                  <c:v>260.1875</c:v>
                </c:pt>
                <c:pt idx="1087">
                  <c:v>260.42708333333297</c:v>
                </c:pt>
                <c:pt idx="1088">
                  <c:v>260.66666666666703</c:v>
                </c:pt>
                <c:pt idx="1089">
                  <c:v>260.90625</c:v>
                </c:pt>
                <c:pt idx="1090">
                  <c:v>261.14583333333297</c:v>
                </c:pt>
                <c:pt idx="1091">
                  <c:v>261.38541666666703</c:v>
                </c:pt>
                <c:pt idx="1092">
                  <c:v>261.625</c:v>
                </c:pt>
                <c:pt idx="1093">
                  <c:v>261.86458333333297</c:v>
                </c:pt>
                <c:pt idx="1094">
                  <c:v>262.10416666666703</c:v>
                </c:pt>
                <c:pt idx="1095">
                  <c:v>262.34375</c:v>
                </c:pt>
                <c:pt idx="1096">
                  <c:v>262.58333333333297</c:v>
                </c:pt>
                <c:pt idx="1097">
                  <c:v>262.82291666666703</c:v>
                </c:pt>
                <c:pt idx="1098">
                  <c:v>263.0625</c:v>
                </c:pt>
                <c:pt idx="1099">
                  <c:v>263.30208333333297</c:v>
                </c:pt>
                <c:pt idx="1100">
                  <c:v>263.54166666666703</c:v>
                </c:pt>
                <c:pt idx="1101">
                  <c:v>263.78125</c:v>
                </c:pt>
                <c:pt idx="1102">
                  <c:v>264.02083333333297</c:v>
                </c:pt>
                <c:pt idx="1103">
                  <c:v>264.26041666666703</c:v>
                </c:pt>
                <c:pt idx="1104">
                  <c:v>264.5</c:v>
                </c:pt>
                <c:pt idx="1105">
                  <c:v>264.73958333333297</c:v>
                </c:pt>
                <c:pt idx="1106">
                  <c:v>264.97916666666703</c:v>
                </c:pt>
                <c:pt idx="1107">
                  <c:v>265.21875</c:v>
                </c:pt>
                <c:pt idx="1108">
                  <c:v>265.45833333333297</c:v>
                </c:pt>
                <c:pt idx="1109">
                  <c:v>265.69791666666703</c:v>
                </c:pt>
                <c:pt idx="1110">
                  <c:v>265.9375</c:v>
                </c:pt>
                <c:pt idx="1111">
                  <c:v>266.17708333333297</c:v>
                </c:pt>
                <c:pt idx="1112">
                  <c:v>266.41666666666703</c:v>
                </c:pt>
                <c:pt idx="1113">
                  <c:v>266.65625</c:v>
                </c:pt>
                <c:pt idx="1114">
                  <c:v>266.89583333333297</c:v>
                </c:pt>
                <c:pt idx="1115">
                  <c:v>267.13541666666703</c:v>
                </c:pt>
                <c:pt idx="1116">
                  <c:v>267.375</c:v>
                </c:pt>
                <c:pt idx="1117">
                  <c:v>267.61458333333297</c:v>
                </c:pt>
                <c:pt idx="1118">
                  <c:v>267.85416666666703</c:v>
                </c:pt>
                <c:pt idx="1119">
                  <c:v>268.09375</c:v>
                </c:pt>
                <c:pt idx="1120">
                  <c:v>268.33333333333297</c:v>
                </c:pt>
                <c:pt idx="1121">
                  <c:v>268.57291666666703</c:v>
                </c:pt>
                <c:pt idx="1122">
                  <c:v>268.8125</c:v>
                </c:pt>
                <c:pt idx="1123">
                  <c:v>269.05208333333297</c:v>
                </c:pt>
                <c:pt idx="1124">
                  <c:v>269.29166666666703</c:v>
                </c:pt>
                <c:pt idx="1125">
                  <c:v>269.53125</c:v>
                </c:pt>
                <c:pt idx="1126">
                  <c:v>269.77083333333297</c:v>
                </c:pt>
                <c:pt idx="1127">
                  <c:v>270.01041666666703</c:v>
                </c:pt>
                <c:pt idx="1128">
                  <c:v>270.25</c:v>
                </c:pt>
                <c:pt idx="1129">
                  <c:v>270.48958333333297</c:v>
                </c:pt>
                <c:pt idx="1130">
                  <c:v>270.72916666666703</c:v>
                </c:pt>
                <c:pt idx="1131">
                  <c:v>270.96875</c:v>
                </c:pt>
                <c:pt idx="1132">
                  <c:v>271.20833333333297</c:v>
                </c:pt>
                <c:pt idx="1133">
                  <c:v>271.44791666666703</c:v>
                </c:pt>
                <c:pt idx="1134">
                  <c:v>271.6875</c:v>
                </c:pt>
                <c:pt idx="1135">
                  <c:v>271.92708333333297</c:v>
                </c:pt>
                <c:pt idx="1136">
                  <c:v>272.16666666666703</c:v>
                </c:pt>
                <c:pt idx="1137">
                  <c:v>272.40625</c:v>
                </c:pt>
                <c:pt idx="1138">
                  <c:v>272.64583333333297</c:v>
                </c:pt>
                <c:pt idx="1139">
                  <c:v>272.88541666666703</c:v>
                </c:pt>
                <c:pt idx="1140">
                  <c:v>273.125</c:v>
                </c:pt>
                <c:pt idx="1141">
                  <c:v>273.36458333333297</c:v>
                </c:pt>
                <c:pt idx="1142">
                  <c:v>273.60416666666703</c:v>
                </c:pt>
                <c:pt idx="1143">
                  <c:v>273.84375</c:v>
                </c:pt>
                <c:pt idx="1144">
                  <c:v>274.08333333333297</c:v>
                </c:pt>
                <c:pt idx="1145">
                  <c:v>274.32291666666703</c:v>
                </c:pt>
                <c:pt idx="1146">
                  <c:v>274.5625</c:v>
                </c:pt>
                <c:pt idx="1147">
                  <c:v>274.80208333333297</c:v>
                </c:pt>
                <c:pt idx="1148">
                  <c:v>275.04166666666703</c:v>
                </c:pt>
                <c:pt idx="1149">
                  <c:v>275.28125</c:v>
                </c:pt>
                <c:pt idx="1150">
                  <c:v>275.52083333333297</c:v>
                </c:pt>
                <c:pt idx="1151">
                  <c:v>275.76041666666703</c:v>
                </c:pt>
                <c:pt idx="1152">
                  <c:v>276</c:v>
                </c:pt>
                <c:pt idx="1153">
                  <c:v>276.23958333333297</c:v>
                </c:pt>
                <c:pt idx="1154">
                  <c:v>276.47916666666703</c:v>
                </c:pt>
                <c:pt idx="1155">
                  <c:v>276.71875</c:v>
                </c:pt>
                <c:pt idx="1156">
                  <c:v>276.95833333333297</c:v>
                </c:pt>
                <c:pt idx="1157">
                  <c:v>277.19791666666703</c:v>
                </c:pt>
                <c:pt idx="1158">
                  <c:v>277.4375</c:v>
                </c:pt>
                <c:pt idx="1159">
                  <c:v>277.67708333333297</c:v>
                </c:pt>
                <c:pt idx="1160">
                  <c:v>277.91666666666703</c:v>
                </c:pt>
                <c:pt idx="1161">
                  <c:v>278.15625</c:v>
                </c:pt>
                <c:pt idx="1162">
                  <c:v>278.39583333333297</c:v>
                </c:pt>
                <c:pt idx="1163">
                  <c:v>278.63541666666703</c:v>
                </c:pt>
                <c:pt idx="1164">
                  <c:v>278.875</c:v>
                </c:pt>
                <c:pt idx="1165">
                  <c:v>279.11458333333297</c:v>
                </c:pt>
                <c:pt idx="1166">
                  <c:v>279.35416666666703</c:v>
                </c:pt>
                <c:pt idx="1167">
                  <c:v>279.59375</c:v>
                </c:pt>
                <c:pt idx="1168">
                  <c:v>279.83333333333297</c:v>
                </c:pt>
                <c:pt idx="1169">
                  <c:v>280.07291666666703</c:v>
                </c:pt>
                <c:pt idx="1170">
                  <c:v>280.3125</c:v>
                </c:pt>
                <c:pt idx="1171">
                  <c:v>280.55208333333297</c:v>
                </c:pt>
                <c:pt idx="1172">
                  <c:v>280.79166666666703</c:v>
                </c:pt>
                <c:pt idx="1173">
                  <c:v>281.03125</c:v>
                </c:pt>
                <c:pt idx="1174">
                  <c:v>281.27083333333297</c:v>
                </c:pt>
                <c:pt idx="1175">
                  <c:v>281.51041666666703</c:v>
                </c:pt>
                <c:pt idx="1176">
                  <c:v>281.75</c:v>
                </c:pt>
                <c:pt idx="1177">
                  <c:v>281.98958333333297</c:v>
                </c:pt>
                <c:pt idx="1178">
                  <c:v>282.22916666666703</c:v>
                </c:pt>
                <c:pt idx="1179">
                  <c:v>282.46875</c:v>
                </c:pt>
                <c:pt idx="1180">
                  <c:v>282.70833333333297</c:v>
                </c:pt>
                <c:pt idx="1181">
                  <c:v>282.94791666666703</c:v>
                </c:pt>
                <c:pt idx="1182">
                  <c:v>283.1875</c:v>
                </c:pt>
                <c:pt idx="1183">
                  <c:v>283.42708333333297</c:v>
                </c:pt>
                <c:pt idx="1184">
                  <c:v>283.66666666666703</c:v>
                </c:pt>
                <c:pt idx="1185">
                  <c:v>283.90625</c:v>
                </c:pt>
                <c:pt idx="1186">
                  <c:v>284.14583333333297</c:v>
                </c:pt>
                <c:pt idx="1187">
                  <c:v>284.38541666666703</c:v>
                </c:pt>
                <c:pt idx="1188">
                  <c:v>284.625</c:v>
                </c:pt>
                <c:pt idx="1189">
                  <c:v>284.86458333333297</c:v>
                </c:pt>
                <c:pt idx="1190">
                  <c:v>285.10416666666703</c:v>
                </c:pt>
                <c:pt idx="1191">
                  <c:v>285.34375</c:v>
                </c:pt>
                <c:pt idx="1192">
                  <c:v>285.58333333333297</c:v>
                </c:pt>
                <c:pt idx="1193">
                  <c:v>285.82291666666703</c:v>
                </c:pt>
                <c:pt idx="1194">
                  <c:v>286.0625</c:v>
                </c:pt>
                <c:pt idx="1195">
                  <c:v>286.30208333333297</c:v>
                </c:pt>
                <c:pt idx="1196">
                  <c:v>286.54166666666703</c:v>
                </c:pt>
                <c:pt idx="1197">
                  <c:v>286.78125</c:v>
                </c:pt>
                <c:pt idx="1198">
                  <c:v>287.02083333333297</c:v>
                </c:pt>
                <c:pt idx="1199">
                  <c:v>287.26041666666703</c:v>
                </c:pt>
                <c:pt idx="1200">
                  <c:v>287.5</c:v>
                </c:pt>
                <c:pt idx="1201">
                  <c:v>287.73958333333297</c:v>
                </c:pt>
                <c:pt idx="1202">
                  <c:v>287.97916666666703</c:v>
                </c:pt>
                <c:pt idx="1203">
                  <c:v>288.21875</c:v>
                </c:pt>
                <c:pt idx="1204">
                  <c:v>288.45833333333297</c:v>
                </c:pt>
                <c:pt idx="1205">
                  <c:v>288.69791666666703</c:v>
                </c:pt>
                <c:pt idx="1206">
                  <c:v>288.9375</c:v>
                </c:pt>
                <c:pt idx="1207">
                  <c:v>289.17708333333297</c:v>
                </c:pt>
                <c:pt idx="1208">
                  <c:v>289.41666666666703</c:v>
                </c:pt>
                <c:pt idx="1209">
                  <c:v>289.65625</c:v>
                </c:pt>
                <c:pt idx="1210">
                  <c:v>289.89583333333297</c:v>
                </c:pt>
                <c:pt idx="1211">
                  <c:v>290.13541666666703</c:v>
                </c:pt>
                <c:pt idx="1212">
                  <c:v>290.375</c:v>
                </c:pt>
                <c:pt idx="1213">
                  <c:v>290.61458333333297</c:v>
                </c:pt>
                <c:pt idx="1214">
                  <c:v>290.85416666666703</c:v>
                </c:pt>
                <c:pt idx="1215">
                  <c:v>291.09375</c:v>
                </c:pt>
                <c:pt idx="1216">
                  <c:v>291.33333333333297</c:v>
                </c:pt>
                <c:pt idx="1217">
                  <c:v>291.57291666666703</c:v>
                </c:pt>
                <c:pt idx="1218">
                  <c:v>291.8125</c:v>
                </c:pt>
                <c:pt idx="1219">
                  <c:v>292.05208333333297</c:v>
                </c:pt>
                <c:pt idx="1220">
                  <c:v>292.29166666666703</c:v>
                </c:pt>
                <c:pt idx="1221">
                  <c:v>292.53125</c:v>
                </c:pt>
                <c:pt idx="1222">
                  <c:v>292.77083333333297</c:v>
                </c:pt>
                <c:pt idx="1223">
                  <c:v>293.01041666666703</c:v>
                </c:pt>
                <c:pt idx="1224">
                  <c:v>293.25</c:v>
                </c:pt>
                <c:pt idx="1225">
                  <c:v>293.48958333333297</c:v>
                </c:pt>
                <c:pt idx="1226">
                  <c:v>293.72916666666703</c:v>
                </c:pt>
                <c:pt idx="1227">
                  <c:v>293.96875</c:v>
                </c:pt>
                <c:pt idx="1228">
                  <c:v>294.20833333333297</c:v>
                </c:pt>
                <c:pt idx="1229">
                  <c:v>294.44791666666703</c:v>
                </c:pt>
                <c:pt idx="1230">
                  <c:v>294.6875</c:v>
                </c:pt>
                <c:pt idx="1231">
                  <c:v>294.92708333333297</c:v>
                </c:pt>
                <c:pt idx="1232">
                  <c:v>295.16666666666703</c:v>
                </c:pt>
                <c:pt idx="1233">
                  <c:v>295.40625</c:v>
                </c:pt>
                <c:pt idx="1234">
                  <c:v>295.64583333333297</c:v>
                </c:pt>
                <c:pt idx="1235">
                  <c:v>295.88541666666703</c:v>
                </c:pt>
                <c:pt idx="1236">
                  <c:v>296.125</c:v>
                </c:pt>
                <c:pt idx="1237">
                  <c:v>296.36458333333297</c:v>
                </c:pt>
                <c:pt idx="1238">
                  <c:v>296.60416666666703</c:v>
                </c:pt>
                <c:pt idx="1239">
                  <c:v>296.84375</c:v>
                </c:pt>
                <c:pt idx="1240">
                  <c:v>297.08333333333297</c:v>
                </c:pt>
                <c:pt idx="1241">
                  <c:v>297.32291666666703</c:v>
                </c:pt>
                <c:pt idx="1242">
                  <c:v>297.5625</c:v>
                </c:pt>
                <c:pt idx="1243">
                  <c:v>297.80208333333297</c:v>
                </c:pt>
                <c:pt idx="1244">
                  <c:v>298.04166666666703</c:v>
                </c:pt>
                <c:pt idx="1245">
                  <c:v>298.28125</c:v>
                </c:pt>
                <c:pt idx="1246">
                  <c:v>298.52083333333297</c:v>
                </c:pt>
                <c:pt idx="1247">
                  <c:v>298.76041666666703</c:v>
                </c:pt>
                <c:pt idx="1248">
                  <c:v>299</c:v>
                </c:pt>
                <c:pt idx="1249">
                  <c:v>299.23958333333297</c:v>
                </c:pt>
                <c:pt idx="1250">
                  <c:v>299.47916666666703</c:v>
                </c:pt>
                <c:pt idx="1251">
                  <c:v>299.71875</c:v>
                </c:pt>
                <c:pt idx="1252">
                  <c:v>299.95833333333297</c:v>
                </c:pt>
                <c:pt idx="1253">
                  <c:v>300.19791666666703</c:v>
                </c:pt>
                <c:pt idx="1254">
                  <c:v>300.4375</c:v>
                </c:pt>
                <c:pt idx="1255">
                  <c:v>300.67708333333297</c:v>
                </c:pt>
                <c:pt idx="1256">
                  <c:v>300.91666666666703</c:v>
                </c:pt>
                <c:pt idx="1257">
                  <c:v>301.15625</c:v>
                </c:pt>
                <c:pt idx="1258">
                  <c:v>301.39583333333297</c:v>
                </c:pt>
                <c:pt idx="1259">
                  <c:v>301.63541666666703</c:v>
                </c:pt>
                <c:pt idx="1260">
                  <c:v>301.875</c:v>
                </c:pt>
                <c:pt idx="1261">
                  <c:v>302.11458333333297</c:v>
                </c:pt>
                <c:pt idx="1262">
                  <c:v>302.35416666666703</c:v>
                </c:pt>
                <c:pt idx="1263">
                  <c:v>302.59375</c:v>
                </c:pt>
                <c:pt idx="1264">
                  <c:v>302.83333333333297</c:v>
                </c:pt>
                <c:pt idx="1265">
                  <c:v>303.07291666666703</c:v>
                </c:pt>
                <c:pt idx="1266">
                  <c:v>303.3125</c:v>
                </c:pt>
                <c:pt idx="1267">
                  <c:v>303.55208333333297</c:v>
                </c:pt>
                <c:pt idx="1268">
                  <c:v>303.79166666666703</c:v>
                </c:pt>
                <c:pt idx="1269">
                  <c:v>304.03125</c:v>
                </c:pt>
                <c:pt idx="1270">
                  <c:v>304.27083333333297</c:v>
                </c:pt>
                <c:pt idx="1271">
                  <c:v>304.51041666666703</c:v>
                </c:pt>
                <c:pt idx="1272">
                  <c:v>304.75</c:v>
                </c:pt>
                <c:pt idx="1273">
                  <c:v>304.98958333333297</c:v>
                </c:pt>
                <c:pt idx="1274">
                  <c:v>305.22916666666703</c:v>
                </c:pt>
                <c:pt idx="1275">
                  <c:v>305.46875</c:v>
                </c:pt>
                <c:pt idx="1276">
                  <c:v>305.70833333333297</c:v>
                </c:pt>
                <c:pt idx="1277">
                  <c:v>305.94791666666703</c:v>
                </c:pt>
                <c:pt idx="1278">
                  <c:v>306.1875</c:v>
                </c:pt>
                <c:pt idx="1279">
                  <c:v>306.42708333333297</c:v>
                </c:pt>
                <c:pt idx="1280">
                  <c:v>306.66666666666703</c:v>
                </c:pt>
                <c:pt idx="1281">
                  <c:v>306.90625</c:v>
                </c:pt>
                <c:pt idx="1282">
                  <c:v>307.14583333333297</c:v>
                </c:pt>
                <c:pt idx="1283">
                  <c:v>307.38541666666703</c:v>
                </c:pt>
                <c:pt idx="1284">
                  <c:v>307.625</c:v>
                </c:pt>
                <c:pt idx="1285">
                  <c:v>307.86458333333297</c:v>
                </c:pt>
                <c:pt idx="1286">
                  <c:v>308.10416666666703</c:v>
                </c:pt>
                <c:pt idx="1287">
                  <c:v>308.34375</c:v>
                </c:pt>
                <c:pt idx="1288">
                  <c:v>308.58333333333297</c:v>
                </c:pt>
                <c:pt idx="1289">
                  <c:v>308.82291666666703</c:v>
                </c:pt>
                <c:pt idx="1290">
                  <c:v>309.0625</c:v>
                </c:pt>
                <c:pt idx="1291">
                  <c:v>309.30208333333297</c:v>
                </c:pt>
                <c:pt idx="1292">
                  <c:v>309.54166666666703</c:v>
                </c:pt>
                <c:pt idx="1293">
                  <c:v>309.78125</c:v>
                </c:pt>
                <c:pt idx="1294">
                  <c:v>310.02083333333297</c:v>
                </c:pt>
                <c:pt idx="1295">
                  <c:v>310.26041666666703</c:v>
                </c:pt>
                <c:pt idx="1296">
                  <c:v>310.5</c:v>
                </c:pt>
                <c:pt idx="1297">
                  <c:v>310.73958333333297</c:v>
                </c:pt>
                <c:pt idx="1298">
                  <c:v>310.97916666666703</c:v>
                </c:pt>
                <c:pt idx="1299">
                  <c:v>311.21875</c:v>
                </c:pt>
                <c:pt idx="1300">
                  <c:v>311.45833333333297</c:v>
                </c:pt>
                <c:pt idx="1301">
                  <c:v>311.69791666666703</c:v>
                </c:pt>
                <c:pt idx="1302">
                  <c:v>311.9375</c:v>
                </c:pt>
                <c:pt idx="1303">
                  <c:v>312.17708333333297</c:v>
                </c:pt>
                <c:pt idx="1304">
                  <c:v>312.41666666666703</c:v>
                </c:pt>
                <c:pt idx="1305">
                  <c:v>312.65625</c:v>
                </c:pt>
                <c:pt idx="1306">
                  <c:v>312.89583333333297</c:v>
                </c:pt>
                <c:pt idx="1307">
                  <c:v>313.13541666666703</c:v>
                </c:pt>
                <c:pt idx="1308">
                  <c:v>313.375</c:v>
                </c:pt>
                <c:pt idx="1309">
                  <c:v>313.61458333333297</c:v>
                </c:pt>
                <c:pt idx="1310">
                  <c:v>313.85416666666703</c:v>
                </c:pt>
                <c:pt idx="1311">
                  <c:v>314.09375</c:v>
                </c:pt>
                <c:pt idx="1312">
                  <c:v>314.33333333333297</c:v>
                </c:pt>
                <c:pt idx="1313">
                  <c:v>314.57291666666703</c:v>
                </c:pt>
                <c:pt idx="1314">
                  <c:v>314.8125</c:v>
                </c:pt>
                <c:pt idx="1315">
                  <c:v>315.05208333333297</c:v>
                </c:pt>
                <c:pt idx="1316">
                  <c:v>315.29166666666703</c:v>
                </c:pt>
                <c:pt idx="1317">
                  <c:v>315.53125</c:v>
                </c:pt>
                <c:pt idx="1318">
                  <c:v>315.77083333333297</c:v>
                </c:pt>
                <c:pt idx="1319">
                  <c:v>316.01041666666703</c:v>
                </c:pt>
                <c:pt idx="1320">
                  <c:v>316.25</c:v>
                </c:pt>
                <c:pt idx="1321">
                  <c:v>316.48958333333297</c:v>
                </c:pt>
                <c:pt idx="1322">
                  <c:v>316.72916666666703</c:v>
                </c:pt>
                <c:pt idx="1323">
                  <c:v>316.96875</c:v>
                </c:pt>
                <c:pt idx="1324">
                  <c:v>317.20833333333297</c:v>
                </c:pt>
                <c:pt idx="1325">
                  <c:v>317.44791666666703</c:v>
                </c:pt>
                <c:pt idx="1326">
                  <c:v>317.6875</c:v>
                </c:pt>
                <c:pt idx="1327">
                  <c:v>317.92708333333297</c:v>
                </c:pt>
                <c:pt idx="1328">
                  <c:v>318.16666666666703</c:v>
                </c:pt>
                <c:pt idx="1329">
                  <c:v>318.40625</c:v>
                </c:pt>
                <c:pt idx="1330">
                  <c:v>318.64583333333297</c:v>
                </c:pt>
                <c:pt idx="1331">
                  <c:v>318.88541666666703</c:v>
                </c:pt>
                <c:pt idx="1332">
                  <c:v>319.125</c:v>
                </c:pt>
                <c:pt idx="1333">
                  <c:v>319.36458333333297</c:v>
                </c:pt>
                <c:pt idx="1334">
                  <c:v>319.60416666666703</c:v>
                </c:pt>
                <c:pt idx="1335">
                  <c:v>319.84375</c:v>
                </c:pt>
                <c:pt idx="1336">
                  <c:v>320.08333333333297</c:v>
                </c:pt>
                <c:pt idx="1337">
                  <c:v>320.32291666666703</c:v>
                </c:pt>
                <c:pt idx="1338">
                  <c:v>320.5625</c:v>
                </c:pt>
                <c:pt idx="1339">
                  <c:v>320.80208333333297</c:v>
                </c:pt>
                <c:pt idx="1340">
                  <c:v>321.04166666666703</c:v>
                </c:pt>
                <c:pt idx="1341">
                  <c:v>321.28125</c:v>
                </c:pt>
                <c:pt idx="1342">
                  <c:v>321.52083333333297</c:v>
                </c:pt>
                <c:pt idx="1343">
                  <c:v>321.76041666666703</c:v>
                </c:pt>
                <c:pt idx="1344">
                  <c:v>322</c:v>
                </c:pt>
                <c:pt idx="1345">
                  <c:v>322.23958333333297</c:v>
                </c:pt>
                <c:pt idx="1346">
                  <c:v>322.47916666666703</c:v>
                </c:pt>
                <c:pt idx="1347">
                  <c:v>322.71875</c:v>
                </c:pt>
                <c:pt idx="1348">
                  <c:v>322.95833333333297</c:v>
                </c:pt>
                <c:pt idx="1349">
                  <c:v>323.19791666666703</c:v>
                </c:pt>
                <c:pt idx="1350">
                  <c:v>323.4375</c:v>
                </c:pt>
                <c:pt idx="1351">
                  <c:v>323.67708333333297</c:v>
                </c:pt>
                <c:pt idx="1352">
                  <c:v>323.91666666666703</c:v>
                </c:pt>
                <c:pt idx="1353">
                  <c:v>324.15625</c:v>
                </c:pt>
                <c:pt idx="1354">
                  <c:v>324.39583333333297</c:v>
                </c:pt>
                <c:pt idx="1355">
                  <c:v>324.63541666666703</c:v>
                </c:pt>
                <c:pt idx="1356">
                  <c:v>324.875</c:v>
                </c:pt>
                <c:pt idx="1357">
                  <c:v>325.11458333333297</c:v>
                </c:pt>
                <c:pt idx="1358">
                  <c:v>325.35416666666703</c:v>
                </c:pt>
                <c:pt idx="1359">
                  <c:v>325.59375</c:v>
                </c:pt>
                <c:pt idx="1360">
                  <c:v>325.83333333333297</c:v>
                </c:pt>
                <c:pt idx="1361">
                  <c:v>326.07291666666703</c:v>
                </c:pt>
                <c:pt idx="1362">
                  <c:v>326.3125</c:v>
                </c:pt>
                <c:pt idx="1363">
                  <c:v>326.55208333333297</c:v>
                </c:pt>
                <c:pt idx="1364">
                  <c:v>326.79166666666703</c:v>
                </c:pt>
                <c:pt idx="1365">
                  <c:v>327.03125</c:v>
                </c:pt>
                <c:pt idx="1366">
                  <c:v>327.27083333333297</c:v>
                </c:pt>
                <c:pt idx="1367">
                  <c:v>327.51041666666703</c:v>
                </c:pt>
                <c:pt idx="1368">
                  <c:v>327.75</c:v>
                </c:pt>
                <c:pt idx="1369">
                  <c:v>327.98958333333297</c:v>
                </c:pt>
                <c:pt idx="1370">
                  <c:v>328.22916666666703</c:v>
                </c:pt>
                <c:pt idx="1371">
                  <c:v>328.46875</c:v>
                </c:pt>
                <c:pt idx="1372">
                  <c:v>328.70833333333297</c:v>
                </c:pt>
                <c:pt idx="1373">
                  <c:v>328.94791666666703</c:v>
                </c:pt>
                <c:pt idx="1374">
                  <c:v>329.1875</c:v>
                </c:pt>
                <c:pt idx="1375">
                  <c:v>329.42708333333297</c:v>
                </c:pt>
                <c:pt idx="1376">
                  <c:v>329.66666666666703</c:v>
                </c:pt>
                <c:pt idx="1377">
                  <c:v>329.90625</c:v>
                </c:pt>
                <c:pt idx="1378">
                  <c:v>330.14583333333297</c:v>
                </c:pt>
                <c:pt idx="1379">
                  <c:v>330.38541666666703</c:v>
                </c:pt>
                <c:pt idx="1380">
                  <c:v>330.625</c:v>
                </c:pt>
                <c:pt idx="1381">
                  <c:v>330.86458333333297</c:v>
                </c:pt>
                <c:pt idx="1382">
                  <c:v>331.10416666666703</c:v>
                </c:pt>
                <c:pt idx="1383">
                  <c:v>331.34375</c:v>
                </c:pt>
                <c:pt idx="1384">
                  <c:v>331.58333333333297</c:v>
                </c:pt>
                <c:pt idx="1385">
                  <c:v>331.82291666666703</c:v>
                </c:pt>
                <c:pt idx="1386">
                  <c:v>332.0625</c:v>
                </c:pt>
                <c:pt idx="1387">
                  <c:v>332.30208333333297</c:v>
                </c:pt>
                <c:pt idx="1388">
                  <c:v>332.54166666666703</c:v>
                </c:pt>
                <c:pt idx="1389">
                  <c:v>332.78125</c:v>
                </c:pt>
                <c:pt idx="1390">
                  <c:v>333.02083333333297</c:v>
                </c:pt>
                <c:pt idx="1391">
                  <c:v>333.26041666666703</c:v>
                </c:pt>
                <c:pt idx="1392">
                  <c:v>333.5</c:v>
                </c:pt>
                <c:pt idx="1393">
                  <c:v>333.73958333333297</c:v>
                </c:pt>
                <c:pt idx="1394">
                  <c:v>333.97916666666703</c:v>
                </c:pt>
                <c:pt idx="1395">
                  <c:v>334.21875</c:v>
                </c:pt>
                <c:pt idx="1396">
                  <c:v>334.45833333333297</c:v>
                </c:pt>
                <c:pt idx="1397">
                  <c:v>334.69791666666703</c:v>
                </c:pt>
                <c:pt idx="1398">
                  <c:v>334.9375</c:v>
                </c:pt>
                <c:pt idx="1399">
                  <c:v>335.17708333333297</c:v>
                </c:pt>
                <c:pt idx="1400">
                  <c:v>335.41666666666703</c:v>
                </c:pt>
                <c:pt idx="1401">
                  <c:v>335.65625</c:v>
                </c:pt>
                <c:pt idx="1402">
                  <c:v>335.89583333333297</c:v>
                </c:pt>
                <c:pt idx="1403">
                  <c:v>336.13541666666703</c:v>
                </c:pt>
                <c:pt idx="1404">
                  <c:v>336.375</c:v>
                </c:pt>
                <c:pt idx="1405">
                  <c:v>336.61458333333297</c:v>
                </c:pt>
                <c:pt idx="1406">
                  <c:v>336.85416666666703</c:v>
                </c:pt>
                <c:pt idx="1407">
                  <c:v>337.09375</c:v>
                </c:pt>
                <c:pt idx="1408">
                  <c:v>337.33333333333297</c:v>
                </c:pt>
                <c:pt idx="1409">
                  <c:v>337.57291666666703</c:v>
                </c:pt>
                <c:pt idx="1410">
                  <c:v>337.8125</c:v>
                </c:pt>
                <c:pt idx="1411">
                  <c:v>338.05208333333297</c:v>
                </c:pt>
                <c:pt idx="1412">
                  <c:v>338.29166666666703</c:v>
                </c:pt>
                <c:pt idx="1413">
                  <c:v>338.53125</c:v>
                </c:pt>
                <c:pt idx="1414">
                  <c:v>338.77083333333297</c:v>
                </c:pt>
                <c:pt idx="1415">
                  <c:v>339.01041666666703</c:v>
                </c:pt>
                <c:pt idx="1416">
                  <c:v>339.25</c:v>
                </c:pt>
                <c:pt idx="1417">
                  <c:v>339.48958333333297</c:v>
                </c:pt>
                <c:pt idx="1418">
                  <c:v>339.72916666666703</c:v>
                </c:pt>
                <c:pt idx="1419">
                  <c:v>339.96875</c:v>
                </c:pt>
                <c:pt idx="1420">
                  <c:v>340.20833333333297</c:v>
                </c:pt>
                <c:pt idx="1421">
                  <c:v>340.44791666666703</c:v>
                </c:pt>
                <c:pt idx="1422">
                  <c:v>340.6875</c:v>
                </c:pt>
                <c:pt idx="1423">
                  <c:v>340.92708333333297</c:v>
                </c:pt>
                <c:pt idx="1424">
                  <c:v>341.16666666666703</c:v>
                </c:pt>
                <c:pt idx="1425">
                  <c:v>341.40625</c:v>
                </c:pt>
                <c:pt idx="1426">
                  <c:v>341.64583333333297</c:v>
                </c:pt>
                <c:pt idx="1427">
                  <c:v>341.88541666666703</c:v>
                </c:pt>
                <c:pt idx="1428">
                  <c:v>342.125</c:v>
                </c:pt>
                <c:pt idx="1429">
                  <c:v>342.36458333333297</c:v>
                </c:pt>
                <c:pt idx="1430">
                  <c:v>342.60416666666703</c:v>
                </c:pt>
                <c:pt idx="1431">
                  <c:v>342.84375</c:v>
                </c:pt>
                <c:pt idx="1432">
                  <c:v>343.08333333333297</c:v>
                </c:pt>
                <c:pt idx="1433">
                  <c:v>343.32291666666703</c:v>
                </c:pt>
                <c:pt idx="1434">
                  <c:v>343.5625</c:v>
                </c:pt>
                <c:pt idx="1435">
                  <c:v>343.80208333333297</c:v>
                </c:pt>
                <c:pt idx="1436">
                  <c:v>344.04166666666703</c:v>
                </c:pt>
                <c:pt idx="1437">
                  <c:v>344.28125</c:v>
                </c:pt>
                <c:pt idx="1438">
                  <c:v>344.52083333333297</c:v>
                </c:pt>
                <c:pt idx="1439">
                  <c:v>344.76041666666703</c:v>
                </c:pt>
                <c:pt idx="1440">
                  <c:v>345</c:v>
                </c:pt>
                <c:pt idx="1441">
                  <c:v>345.23958333333297</c:v>
                </c:pt>
                <c:pt idx="1442">
                  <c:v>345.47916666666703</c:v>
                </c:pt>
                <c:pt idx="1443">
                  <c:v>345.71875</c:v>
                </c:pt>
                <c:pt idx="1444">
                  <c:v>345.95833333333297</c:v>
                </c:pt>
                <c:pt idx="1445">
                  <c:v>346.19791666666703</c:v>
                </c:pt>
                <c:pt idx="1446">
                  <c:v>346.4375</c:v>
                </c:pt>
                <c:pt idx="1447">
                  <c:v>346.67708333333297</c:v>
                </c:pt>
                <c:pt idx="1448">
                  <c:v>346.91666666666703</c:v>
                </c:pt>
                <c:pt idx="1449">
                  <c:v>347.15625</c:v>
                </c:pt>
                <c:pt idx="1450">
                  <c:v>347.39583333333297</c:v>
                </c:pt>
                <c:pt idx="1451">
                  <c:v>347.63541666666703</c:v>
                </c:pt>
                <c:pt idx="1452">
                  <c:v>347.875</c:v>
                </c:pt>
                <c:pt idx="1453">
                  <c:v>348.11458333333297</c:v>
                </c:pt>
                <c:pt idx="1454">
                  <c:v>348.35416666666703</c:v>
                </c:pt>
                <c:pt idx="1455">
                  <c:v>348.59375</c:v>
                </c:pt>
                <c:pt idx="1456">
                  <c:v>348.83333333333297</c:v>
                </c:pt>
                <c:pt idx="1457">
                  <c:v>349.07291666666703</c:v>
                </c:pt>
                <c:pt idx="1458">
                  <c:v>349.3125</c:v>
                </c:pt>
                <c:pt idx="1459">
                  <c:v>349.55208333333297</c:v>
                </c:pt>
                <c:pt idx="1460">
                  <c:v>349.79166666666703</c:v>
                </c:pt>
                <c:pt idx="1461">
                  <c:v>350.03125</c:v>
                </c:pt>
                <c:pt idx="1462">
                  <c:v>350.27083333333297</c:v>
                </c:pt>
                <c:pt idx="1463">
                  <c:v>350.51041666666703</c:v>
                </c:pt>
                <c:pt idx="1464">
                  <c:v>350.75</c:v>
                </c:pt>
                <c:pt idx="1465">
                  <c:v>350.98958333333297</c:v>
                </c:pt>
                <c:pt idx="1466">
                  <c:v>351.22916666666703</c:v>
                </c:pt>
                <c:pt idx="1467">
                  <c:v>351.46875</c:v>
                </c:pt>
                <c:pt idx="1468">
                  <c:v>351.70833333333297</c:v>
                </c:pt>
                <c:pt idx="1469">
                  <c:v>351.94791666666703</c:v>
                </c:pt>
                <c:pt idx="1470">
                  <c:v>352.1875</c:v>
                </c:pt>
                <c:pt idx="1471">
                  <c:v>352.42708333333297</c:v>
                </c:pt>
                <c:pt idx="1472">
                  <c:v>352.66666666666703</c:v>
                </c:pt>
                <c:pt idx="1473">
                  <c:v>352.90625</c:v>
                </c:pt>
                <c:pt idx="1474">
                  <c:v>353.14583333333297</c:v>
                </c:pt>
                <c:pt idx="1475">
                  <c:v>353.38541666666703</c:v>
                </c:pt>
                <c:pt idx="1476">
                  <c:v>353.625</c:v>
                </c:pt>
                <c:pt idx="1477">
                  <c:v>353.86458333333297</c:v>
                </c:pt>
                <c:pt idx="1478">
                  <c:v>354.10416666666703</c:v>
                </c:pt>
                <c:pt idx="1479">
                  <c:v>354.34375</c:v>
                </c:pt>
                <c:pt idx="1480">
                  <c:v>354.58333333333297</c:v>
                </c:pt>
                <c:pt idx="1481">
                  <c:v>354.82291666666703</c:v>
                </c:pt>
                <c:pt idx="1482">
                  <c:v>355.0625</c:v>
                </c:pt>
                <c:pt idx="1483">
                  <c:v>355.30208333333297</c:v>
                </c:pt>
                <c:pt idx="1484">
                  <c:v>355.54166666666703</c:v>
                </c:pt>
                <c:pt idx="1485">
                  <c:v>355.78125</c:v>
                </c:pt>
                <c:pt idx="1486">
                  <c:v>356.02083333333297</c:v>
                </c:pt>
                <c:pt idx="1487">
                  <c:v>356.26041666666703</c:v>
                </c:pt>
                <c:pt idx="1488">
                  <c:v>356.5</c:v>
                </c:pt>
                <c:pt idx="1489">
                  <c:v>356.73958333333297</c:v>
                </c:pt>
                <c:pt idx="1490">
                  <c:v>356.97916666666703</c:v>
                </c:pt>
                <c:pt idx="1491">
                  <c:v>357.21875</c:v>
                </c:pt>
                <c:pt idx="1492">
                  <c:v>357.45833333333297</c:v>
                </c:pt>
                <c:pt idx="1493">
                  <c:v>357.69791666666703</c:v>
                </c:pt>
                <c:pt idx="1494">
                  <c:v>357.9375</c:v>
                </c:pt>
                <c:pt idx="1495">
                  <c:v>358.17708333333297</c:v>
                </c:pt>
                <c:pt idx="1496">
                  <c:v>358.41666666666703</c:v>
                </c:pt>
                <c:pt idx="1497">
                  <c:v>358.65625</c:v>
                </c:pt>
                <c:pt idx="1498">
                  <c:v>358.89583333333297</c:v>
                </c:pt>
                <c:pt idx="1499">
                  <c:v>359.13541666666703</c:v>
                </c:pt>
                <c:pt idx="1500">
                  <c:v>359.375</c:v>
                </c:pt>
                <c:pt idx="1501">
                  <c:v>359.61458333333297</c:v>
                </c:pt>
                <c:pt idx="1502">
                  <c:v>359.85416666666703</c:v>
                </c:pt>
                <c:pt idx="1503">
                  <c:v>360.09375</c:v>
                </c:pt>
                <c:pt idx="1504">
                  <c:v>360.33333333333297</c:v>
                </c:pt>
                <c:pt idx="1505">
                  <c:v>360.57291666666703</c:v>
                </c:pt>
                <c:pt idx="1506">
                  <c:v>360.8125</c:v>
                </c:pt>
                <c:pt idx="1507">
                  <c:v>361.05208333333297</c:v>
                </c:pt>
                <c:pt idx="1508">
                  <c:v>361.29166666666703</c:v>
                </c:pt>
                <c:pt idx="1509">
                  <c:v>361.53125</c:v>
                </c:pt>
                <c:pt idx="1510">
                  <c:v>361.77083333333297</c:v>
                </c:pt>
                <c:pt idx="1511">
                  <c:v>362.01041666666703</c:v>
                </c:pt>
                <c:pt idx="1512">
                  <c:v>362.25</c:v>
                </c:pt>
                <c:pt idx="1513">
                  <c:v>362.48958333333297</c:v>
                </c:pt>
                <c:pt idx="1514">
                  <c:v>362.72916666666703</c:v>
                </c:pt>
                <c:pt idx="1515">
                  <c:v>362.96875</c:v>
                </c:pt>
                <c:pt idx="1516">
                  <c:v>363.20833333333297</c:v>
                </c:pt>
                <c:pt idx="1517">
                  <c:v>363.44791666666703</c:v>
                </c:pt>
                <c:pt idx="1518">
                  <c:v>363.6875</c:v>
                </c:pt>
                <c:pt idx="1519">
                  <c:v>363.92708333333297</c:v>
                </c:pt>
                <c:pt idx="1520">
                  <c:v>364.16666666666703</c:v>
                </c:pt>
                <c:pt idx="1521">
                  <c:v>364.40625</c:v>
                </c:pt>
                <c:pt idx="1522">
                  <c:v>364.64583333333297</c:v>
                </c:pt>
                <c:pt idx="1523">
                  <c:v>364.88541666666703</c:v>
                </c:pt>
                <c:pt idx="1524">
                  <c:v>365.125</c:v>
                </c:pt>
                <c:pt idx="1525">
                  <c:v>365.36458333333297</c:v>
                </c:pt>
                <c:pt idx="1526">
                  <c:v>365.60416666666703</c:v>
                </c:pt>
                <c:pt idx="1527">
                  <c:v>365.84375</c:v>
                </c:pt>
                <c:pt idx="1528">
                  <c:v>366.08333333333297</c:v>
                </c:pt>
                <c:pt idx="1529">
                  <c:v>366.32291666666703</c:v>
                </c:pt>
                <c:pt idx="1530">
                  <c:v>366.5625</c:v>
                </c:pt>
                <c:pt idx="1531">
                  <c:v>366.80208333333297</c:v>
                </c:pt>
                <c:pt idx="1532">
                  <c:v>367.04166666666703</c:v>
                </c:pt>
                <c:pt idx="1533">
                  <c:v>367.28125</c:v>
                </c:pt>
                <c:pt idx="1534">
                  <c:v>367.52083333333297</c:v>
                </c:pt>
                <c:pt idx="1535">
                  <c:v>367.76041666666703</c:v>
                </c:pt>
                <c:pt idx="1536">
                  <c:v>368</c:v>
                </c:pt>
                <c:pt idx="1537">
                  <c:v>368.23958333333297</c:v>
                </c:pt>
                <c:pt idx="1538">
                  <c:v>368.47916666666703</c:v>
                </c:pt>
                <c:pt idx="1539">
                  <c:v>368.71875</c:v>
                </c:pt>
                <c:pt idx="1540">
                  <c:v>368.95833333333297</c:v>
                </c:pt>
                <c:pt idx="1541">
                  <c:v>369.19791666666703</c:v>
                </c:pt>
                <c:pt idx="1542">
                  <c:v>369.4375</c:v>
                </c:pt>
                <c:pt idx="1543">
                  <c:v>369.67708333333297</c:v>
                </c:pt>
                <c:pt idx="1544">
                  <c:v>369.91666666666703</c:v>
                </c:pt>
                <c:pt idx="1545">
                  <c:v>370.15625</c:v>
                </c:pt>
                <c:pt idx="1546">
                  <c:v>370.39583333333297</c:v>
                </c:pt>
                <c:pt idx="1547">
                  <c:v>370.63541666666703</c:v>
                </c:pt>
                <c:pt idx="1548">
                  <c:v>370.875</c:v>
                </c:pt>
                <c:pt idx="1549">
                  <c:v>371.11458333333297</c:v>
                </c:pt>
                <c:pt idx="1550">
                  <c:v>371.35416666666703</c:v>
                </c:pt>
                <c:pt idx="1551">
                  <c:v>371.59375</c:v>
                </c:pt>
                <c:pt idx="1552">
                  <c:v>371.83333333333297</c:v>
                </c:pt>
                <c:pt idx="1553">
                  <c:v>372.07291666666703</c:v>
                </c:pt>
                <c:pt idx="1554">
                  <c:v>372.3125</c:v>
                </c:pt>
                <c:pt idx="1555">
                  <c:v>372.55208333333297</c:v>
                </c:pt>
                <c:pt idx="1556">
                  <c:v>372.79166666666703</c:v>
                </c:pt>
                <c:pt idx="1557">
                  <c:v>373.03125</c:v>
                </c:pt>
                <c:pt idx="1558">
                  <c:v>373.27083333333297</c:v>
                </c:pt>
                <c:pt idx="1559">
                  <c:v>373.51041666666703</c:v>
                </c:pt>
                <c:pt idx="1560">
                  <c:v>373.75</c:v>
                </c:pt>
                <c:pt idx="1561">
                  <c:v>373.98958333333297</c:v>
                </c:pt>
                <c:pt idx="1562">
                  <c:v>374.22916666666703</c:v>
                </c:pt>
                <c:pt idx="1563">
                  <c:v>374.46875</c:v>
                </c:pt>
                <c:pt idx="1564">
                  <c:v>374.70833333333297</c:v>
                </c:pt>
                <c:pt idx="1565">
                  <c:v>374.94791666666703</c:v>
                </c:pt>
                <c:pt idx="1566">
                  <c:v>375.1875</c:v>
                </c:pt>
                <c:pt idx="1567">
                  <c:v>375.42708333333297</c:v>
                </c:pt>
                <c:pt idx="1568">
                  <c:v>375.66666666666703</c:v>
                </c:pt>
                <c:pt idx="1569">
                  <c:v>375.90625</c:v>
                </c:pt>
                <c:pt idx="1570">
                  <c:v>376.14583333333297</c:v>
                </c:pt>
                <c:pt idx="1571">
                  <c:v>376.38541666666703</c:v>
                </c:pt>
                <c:pt idx="1572">
                  <c:v>376.625</c:v>
                </c:pt>
                <c:pt idx="1573">
                  <c:v>376.86458333333297</c:v>
                </c:pt>
                <c:pt idx="1574">
                  <c:v>377.10416666666703</c:v>
                </c:pt>
                <c:pt idx="1575">
                  <c:v>377.34375</c:v>
                </c:pt>
                <c:pt idx="1576">
                  <c:v>377.58333333333297</c:v>
                </c:pt>
                <c:pt idx="1577">
                  <c:v>377.82291666666703</c:v>
                </c:pt>
                <c:pt idx="1578">
                  <c:v>378.0625</c:v>
                </c:pt>
                <c:pt idx="1579">
                  <c:v>378.30208333333297</c:v>
                </c:pt>
                <c:pt idx="1580">
                  <c:v>378.54166666666703</c:v>
                </c:pt>
                <c:pt idx="1581">
                  <c:v>378.78125</c:v>
                </c:pt>
                <c:pt idx="1582">
                  <c:v>379.02083333333297</c:v>
                </c:pt>
                <c:pt idx="1583">
                  <c:v>379.26041666666703</c:v>
                </c:pt>
                <c:pt idx="1584">
                  <c:v>379.5</c:v>
                </c:pt>
                <c:pt idx="1585">
                  <c:v>379.73958333333297</c:v>
                </c:pt>
                <c:pt idx="1586">
                  <c:v>379.97916666666703</c:v>
                </c:pt>
                <c:pt idx="1587">
                  <c:v>380.21875</c:v>
                </c:pt>
                <c:pt idx="1588">
                  <c:v>380.45833333333297</c:v>
                </c:pt>
                <c:pt idx="1589">
                  <c:v>380.69791666666703</c:v>
                </c:pt>
                <c:pt idx="1590">
                  <c:v>380.9375</c:v>
                </c:pt>
                <c:pt idx="1591">
                  <c:v>381.17708333333297</c:v>
                </c:pt>
                <c:pt idx="1592">
                  <c:v>381.41666666666703</c:v>
                </c:pt>
                <c:pt idx="1593">
                  <c:v>381.65625</c:v>
                </c:pt>
                <c:pt idx="1594">
                  <c:v>381.89583333333297</c:v>
                </c:pt>
                <c:pt idx="1595">
                  <c:v>382.13541666666703</c:v>
                </c:pt>
                <c:pt idx="1596">
                  <c:v>382.375</c:v>
                </c:pt>
                <c:pt idx="1597">
                  <c:v>382.61458333333297</c:v>
                </c:pt>
                <c:pt idx="1598">
                  <c:v>382.85416666666703</c:v>
                </c:pt>
                <c:pt idx="1599">
                  <c:v>383.09375</c:v>
                </c:pt>
                <c:pt idx="1600">
                  <c:v>383.33333333333297</c:v>
                </c:pt>
                <c:pt idx="1601">
                  <c:v>383.57291666666703</c:v>
                </c:pt>
                <c:pt idx="1602">
                  <c:v>383.8125</c:v>
                </c:pt>
                <c:pt idx="1603">
                  <c:v>384.05208333333297</c:v>
                </c:pt>
                <c:pt idx="1604">
                  <c:v>384.29166666666703</c:v>
                </c:pt>
                <c:pt idx="1605">
                  <c:v>384.53125</c:v>
                </c:pt>
                <c:pt idx="1606">
                  <c:v>384.77083333333297</c:v>
                </c:pt>
                <c:pt idx="1607">
                  <c:v>385.01041666666703</c:v>
                </c:pt>
                <c:pt idx="1608">
                  <c:v>385.25</c:v>
                </c:pt>
                <c:pt idx="1609">
                  <c:v>385.48958333333297</c:v>
                </c:pt>
                <c:pt idx="1610">
                  <c:v>385.72916666666703</c:v>
                </c:pt>
                <c:pt idx="1611">
                  <c:v>385.96875</c:v>
                </c:pt>
                <c:pt idx="1612">
                  <c:v>386.20833333333297</c:v>
                </c:pt>
                <c:pt idx="1613">
                  <c:v>386.44791666666703</c:v>
                </c:pt>
                <c:pt idx="1614">
                  <c:v>386.6875</c:v>
                </c:pt>
                <c:pt idx="1615">
                  <c:v>386.92708333333297</c:v>
                </c:pt>
                <c:pt idx="1616">
                  <c:v>387.16666666666703</c:v>
                </c:pt>
                <c:pt idx="1617">
                  <c:v>387.40625</c:v>
                </c:pt>
                <c:pt idx="1618">
                  <c:v>387.64583333333297</c:v>
                </c:pt>
                <c:pt idx="1619">
                  <c:v>387.88541666666703</c:v>
                </c:pt>
                <c:pt idx="1620">
                  <c:v>388.125</c:v>
                </c:pt>
                <c:pt idx="1621">
                  <c:v>388.36458333333297</c:v>
                </c:pt>
                <c:pt idx="1622">
                  <c:v>388.60416666666703</c:v>
                </c:pt>
                <c:pt idx="1623">
                  <c:v>388.84375</c:v>
                </c:pt>
                <c:pt idx="1624">
                  <c:v>389.08333333333297</c:v>
                </c:pt>
                <c:pt idx="1625">
                  <c:v>389.32291666666703</c:v>
                </c:pt>
                <c:pt idx="1626">
                  <c:v>389.5625</c:v>
                </c:pt>
                <c:pt idx="1627">
                  <c:v>389.80208333333297</c:v>
                </c:pt>
                <c:pt idx="1628">
                  <c:v>390.04166666666703</c:v>
                </c:pt>
                <c:pt idx="1629">
                  <c:v>390.28125</c:v>
                </c:pt>
                <c:pt idx="1630">
                  <c:v>390.52083333333297</c:v>
                </c:pt>
                <c:pt idx="1631">
                  <c:v>390.76041666666703</c:v>
                </c:pt>
                <c:pt idx="1632">
                  <c:v>391</c:v>
                </c:pt>
                <c:pt idx="1633">
                  <c:v>391.23958333333297</c:v>
                </c:pt>
                <c:pt idx="1634">
                  <c:v>391.47916666666703</c:v>
                </c:pt>
                <c:pt idx="1635">
                  <c:v>391.71875</c:v>
                </c:pt>
                <c:pt idx="1636">
                  <c:v>391.95833333333297</c:v>
                </c:pt>
                <c:pt idx="1637">
                  <c:v>392.19791666666703</c:v>
                </c:pt>
                <c:pt idx="1638">
                  <c:v>392.4375</c:v>
                </c:pt>
                <c:pt idx="1639">
                  <c:v>392.67708333333297</c:v>
                </c:pt>
                <c:pt idx="1640">
                  <c:v>392.91666666666703</c:v>
                </c:pt>
                <c:pt idx="1641">
                  <c:v>393.15625</c:v>
                </c:pt>
                <c:pt idx="1642">
                  <c:v>393.39583333333297</c:v>
                </c:pt>
                <c:pt idx="1643">
                  <c:v>393.63541666666703</c:v>
                </c:pt>
                <c:pt idx="1644">
                  <c:v>393.875</c:v>
                </c:pt>
                <c:pt idx="1645">
                  <c:v>394.11458333333297</c:v>
                </c:pt>
                <c:pt idx="1646">
                  <c:v>394.35416666666703</c:v>
                </c:pt>
                <c:pt idx="1647">
                  <c:v>394.59375</c:v>
                </c:pt>
                <c:pt idx="1648">
                  <c:v>394.83333333333297</c:v>
                </c:pt>
                <c:pt idx="1649">
                  <c:v>395.07291666666703</c:v>
                </c:pt>
                <c:pt idx="1650">
                  <c:v>395.3125</c:v>
                </c:pt>
                <c:pt idx="1651">
                  <c:v>395.55208333333297</c:v>
                </c:pt>
                <c:pt idx="1652">
                  <c:v>395.79166666666703</c:v>
                </c:pt>
                <c:pt idx="1653">
                  <c:v>396.03125</c:v>
                </c:pt>
                <c:pt idx="1654">
                  <c:v>396.27083333333297</c:v>
                </c:pt>
                <c:pt idx="1655">
                  <c:v>396.51041666666703</c:v>
                </c:pt>
                <c:pt idx="1656">
                  <c:v>396.75</c:v>
                </c:pt>
                <c:pt idx="1657">
                  <c:v>396.98958333333297</c:v>
                </c:pt>
                <c:pt idx="1658">
                  <c:v>397.22916666666703</c:v>
                </c:pt>
                <c:pt idx="1659">
                  <c:v>397.46875</c:v>
                </c:pt>
                <c:pt idx="1660">
                  <c:v>397.70833333333297</c:v>
                </c:pt>
                <c:pt idx="1661">
                  <c:v>397.94791666666703</c:v>
                </c:pt>
                <c:pt idx="1662">
                  <c:v>398.1875</c:v>
                </c:pt>
                <c:pt idx="1663">
                  <c:v>398.42708333333297</c:v>
                </c:pt>
                <c:pt idx="1664">
                  <c:v>398.66666666666703</c:v>
                </c:pt>
                <c:pt idx="1665">
                  <c:v>398.90625</c:v>
                </c:pt>
                <c:pt idx="1666">
                  <c:v>399.14583333333297</c:v>
                </c:pt>
                <c:pt idx="1667">
                  <c:v>399.38541666666703</c:v>
                </c:pt>
                <c:pt idx="1668">
                  <c:v>399.625</c:v>
                </c:pt>
                <c:pt idx="1669">
                  <c:v>399.86458333333297</c:v>
                </c:pt>
                <c:pt idx="1670">
                  <c:v>400.10416666666703</c:v>
                </c:pt>
                <c:pt idx="1671">
                  <c:v>400.34375</c:v>
                </c:pt>
                <c:pt idx="1672">
                  <c:v>400.58333333333297</c:v>
                </c:pt>
                <c:pt idx="1673">
                  <c:v>400.82291666666703</c:v>
                </c:pt>
                <c:pt idx="1674">
                  <c:v>401.0625</c:v>
                </c:pt>
                <c:pt idx="1675">
                  <c:v>401.30208333333297</c:v>
                </c:pt>
                <c:pt idx="1676">
                  <c:v>401.54166666666703</c:v>
                </c:pt>
                <c:pt idx="1677">
                  <c:v>401.78125</c:v>
                </c:pt>
                <c:pt idx="1678">
                  <c:v>402.02083333333297</c:v>
                </c:pt>
                <c:pt idx="1679">
                  <c:v>402.26041666666703</c:v>
                </c:pt>
                <c:pt idx="1680">
                  <c:v>402.5</c:v>
                </c:pt>
                <c:pt idx="1681">
                  <c:v>402.73958333333297</c:v>
                </c:pt>
                <c:pt idx="1682">
                  <c:v>402.97916666666703</c:v>
                </c:pt>
                <c:pt idx="1683">
                  <c:v>403.21875</c:v>
                </c:pt>
                <c:pt idx="1684">
                  <c:v>403.45833333333297</c:v>
                </c:pt>
                <c:pt idx="1685">
                  <c:v>403.69791666666703</c:v>
                </c:pt>
                <c:pt idx="1686">
                  <c:v>403.9375</c:v>
                </c:pt>
                <c:pt idx="1687">
                  <c:v>404.17708333333297</c:v>
                </c:pt>
                <c:pt idx="1688">
                  <c:v>404.41666666666703</c:v>
                </c:pt>
                <c:pt idx="1689">
                  <c:v>404.65625</c:v>
                </c:pt>
                <c:pt idx="1690">
                  <c:v>404.89583333333297</c:v>
                </c:pt>
                <c:pt idx="1691">
                  <c:v>405.13541666666703</c:v>
                </c:pt>
                <c:pt idx="1692">
                  <c:v>405.375</c:v>
                </c:pt>
                <c:pt idx="1693">
                  <c:v>405.61458333333297</c:v>
                </c:pt>
                <c:pt idx="1694">
                  <c:v>405.85416666666703</c:v>
                </c:pt>
                <c:pt idx="1695">
                  <c:v>406.09375</c:v>
                </c:pt>
                <c:pt idx="1696">
                  <c:v>406.33333333333297</c:v>
                </c:pt>
                <c:pt idx="1697">
                  <c:v>406.57291666666703</c:v>
                </c:pt>
                <c:pt idx="1698">
                  <c:v>406.8125</c:v>
                </c:pt>
                <c:pt idx="1699">
                  <c:v>407.05208333333297</c:v>
                </c:pt>
                <c:pt idx="1700">
                  <c:v>407.29166666666703</c:v>
                </c:pt>
                <c:pt idx="1701">
                  <c:v>407.53125</c:v>
                </c:pt>
                <c:pt idx="1702">
                  <c:v>407.77083333333297</c:v>
                </c:pt>
                <c:pt idx="1703">
                  <c:v>408.01041666666703</c:v>
                </c:pt>
                <c:pt idx="1704">
                  <c:v>408.25</c:v>
                </c:pt>
                <c:pt idx="1705">
                  <c:v>408.48958333333297</c:v>
                </c:pt>
                <c:pt idx="1706">
                  <c:v>408.72916666666703</c:v>
                </c:pt>
                <c:pt idx="1707">
                  <c:v>408.96875</c:v>
                </c:pt>
                <c:pt idx="1708">
                  <c:v>409.20833333333297</c:v>
                </c:pt>
                <c:pt idx="1709">
                  <c:v>409.44791666666703</c:v>
                </c:pt>
                <c:pt idx="1710">
                  <c:v>409.6875</c:v>
                </c:pt>
                <c:pt idx="1711">
                  <c:v>409.92708333333297</c:v>
                </c:pt>
                <c:pt idx="1712">
                  <c:v>410.16666666666703</c:v>
                </c:pt>
                <c:pt idx="1713">
                  <c:v>410.40625</c:v>
                </c:pt>
                <c:pt idx="1714">
                  <c:v>410.64583333333297</c:v>
                </c:pt>
                <c:pt idx="1715">
                  <c:v>410.88541666666703</c:v>
                </c:pt>
                <c:pt idx="1716">
                  <c:v>411.125</c:v>
                </c:pt>
                <c:pt idx="1717">
                  <c:v>411.36458333333297</c:v>
                </c:pt>
                <c:pt idx="1718">
                  <c:v>411.60416666666703</c:v>
                </c:pt>
                <c:pt idx="1719">
                  <c:v>411.84375</c:v>
                </c:pt>
                <c:pt idx="1720">
                  <c:v>412.08333333333297</c:v>
                </c:pt>
                <c:pt idx="1721">
                  <c:v>412.32291666666703</c:v>
                </c:pt>
                <c:pt idx="1722">
                  <c:v>412.5625</c:v>
                </c:pt>
                <c:pt idx="1723">
                  <c:v>412.80208333333297</c:v>
                </c:pt>
                <c:pt idx="1724">
                  <c:v>413.04166666666703</c:v>
                </c:pt>
                <c:pt idx="1725">
                  <c:v>413.28125</c:v>
                </c:pt>
                <c:pt idx="1726">
                  <c:v>413.52083333333297</c:v>
                </c:pt>
                <c:pt idx="1727">
                  <c:v>413.76041666666703</c:v>
                </c:pt>
                <c:pt idx="1728">
                  <c:v>414</c:v>
                </c:pt>
                <c:pt idx="1729">
                  <c:v>414.23958333333297</c:v>
                </c:pt>
                <c:pt idx="1730">
                  <c:v>414.47916666666703</c:v>
                </c:pt>
                <c:pt idx="1731">
                  <c:v>414.71875</c:v>
                </c:pt>
                <c:pt idx="1732">
                  <c:v>414.95833333333297</c:v>
                </c:pt>
                <c:pt idx="1733">
                  <c:v>415.19791666666703</c:v>
                </c:pt>
                <c:pt idx="1734">
                  <c:v>415.4375</c:v>
                </c:pt>
                <c:pt idx="1735">
                  <c:v>415.67708333333297</c:v>
                </c:pt>
                <c:pt idx="1736">
                  <c:v>415.91666666666703</c:v>
                </c:pt>
                <c:pt idx="1737">
                  <c:v>416.15625</c:v>
                </c:pt>
                <c:pt idx="1738">
                  <c:v>416.39583333333297</c:v>
                </c:pt>
                <c:pt idx="1739">
                  <c:v>416.63541666666703</c:v>
                </c:pt>
                <c:pt idx="1740">
                  <c:v>416.875</c:v>
                </c:pt>
                <c:pt idx="1741">
                  <c:v>417.11458333333297</c:v>
                </c:pt>
                <c:pt idx="1742">
                  <c:v>417.35416666666703</c:v>
                </c:pt>
                <c:pt idx="1743">
                  <c:v>417.59375</c:v>
                </c:pt>
                <c:pt idx="1744">
                  <c:v>417.83333333333297</c:v>
                </c:pt>
                <c:pt idx="1745">
                  <c:v>418.07291666666703</c:v>
                </c:pt>
                <c:pt idx="1746">
                  <c:v>418.3125</c:v>
                </c:pt>
                <c:pt idx="1747">
                  <c:v>418.55208333333297</c:v>
                </c:pt>
                <c:pt idx="1748">
                  <c:v>418.79166666666703</c:v>
                </c:pt>
                <c:pt idx="1749">
                  <c:v>419.03125</c:v>
                </c:pt>
                <c:pt idx="1750">
                  <c:v>419.27083333333297</c:v>
                </c:pt>
                <c:pt idx="1751">
                  <c:v>419.51041666666703</c:v>
                </c:pt>
                <c:pt idx="1752">
                  <c:v>419.75</c:v>
                </c:pt>
                <c:pt idx="1753">
                  <c:v>419.98958333333297</c:v>
                </c:pt>
                <c:pt idx="1754">
                  <c:v>420.22916666666703</c:v>
                </c:pt>
                <c:pt idx="1755">
                  <c:v>420.46875</c:v>
                </c:pt>
                <c:pt idx="1756">
                  <c:v>420.70833333333297</c:v>
                </c:pt>
                <c:pt idx="1757">
                  <c:v>420.94791666666703</c:v>
                </c:pt>
                <c:pt idx="1758">
                  <c:v>421.1875</c:v>
                </c:pt>
                <c:pt idx="1759">
                  <c:v>421.42708333333297</c:v>
                </c:pt>
                <c:pt idx="1760">
                  <c:v>421.66666666666703</c:v>
                </c:pt>
                <c:pt idx="1761">
                  <c:v>421.90625</c:v>
                </c:pt>
                <c:pt idx="1762">
                  <c:v>422.14583333333297</c:v>
                </c:pt>
                <c:pt idx="1763">
                  <c:v>422.38541666666703</c:v>
                </c:pt>
                <c:pt idx="1764">
                  <c:v>422.625</c:v>
                </c:pt>
                <c:pt idx="1765">
                  <c:v>422.86458333333297</c:v>
                </c:pt>
                <c:pt idx="1766">
                  <c:v>423.10416666666703</c:v>
                </c:pt>
                <c:pt idx="1767">
                  <c:v>423.34375</c:v>
                </c:pt>
                <c:pt idx="1768">
                  <c:v>423.58333333333297</c:v>
                </c:pt>
                <c:pt idx="1769">
                  <c:v>423.82291666666703</c:v>
                </c:pt>
                <c:pt idx="1770">
                  <c:v>424.0625</c:v>
                </c:pt>
                <c:pt idx="1771">
                  <c:v>424.30208333333297</c:v>
                </c:pt>
                <c:pt idx="1772">
                  <c:v>424.54166666666703</c:v>
                </c:pt>
                <c:pt idx="1773">
                  <c:v>424.78125</c:v>
                </c:pt>
                <c:pt idx="1774">
                  <c:v>425.02083333333297</c:v>
                </c:pt>
                <c:pt idx="1775">
                  <c:v>425.26041666666703</c:v>
                </c:pt>
                <c:pt idx="1776">
                  <c:v>425.5</c:v>
                </c:pt>
                <c:pt idx="1777">
                  <c:v>425.73958333333297</c:v>
                </c:pt>
                <c:pt idx="1778">
                  <c:v>425.97916666666703</c:v>
                </c:pt>
                <c:pt idx="1779">
                  <c:v>426.21875</c:v>
                </c:pt>
                <c:pt idx="1780">
                  <c:v>426.45833333333297</c:v>
                </c:pt>
                <c:pt idx="1781">
                  <c:v>426.69791666666703</c:v>
                </c:pt>
                <c:pt idx="1782">
                  <c:v>426.9375</c:v>
                </c:pt>
                <c:pt idx="1783">
                  <c:v>427.17708333333297</c:v>
                </c:pt>
                <c:pt idx="1784">
                  <c:v>427.41666666666703</c:v>
                </c:pt>
                <c:pt idx="1785">
                  <c:v>427.65625</c:v>
                </c:pt>
                <c:pt idx="1786">
                  <c:v>427.89583333333297</c:v>
                </c:pt>
                <c:pt idx="1787">
                  <c:v>428.13541666666703</c:v>
                </c:pt>
                <c:pt idx="1788">
                  <c:v>428.375</c:v>
                </c:pt>
                <c:pt idx="1789">
                  <c:v>428.61458333333297</c:v>
                </c:pt>
                <c:pt idx="1790">
                  <c:v>428.85416666666703</c:v>
                </c:pt>
                <c:pt idx="1791">
                  <c:v>429.09375</c:v>
                </c:pt>
                <c:pt idx="1792">
                  <c:v>429.33333333333297</c:v>
                </c:pt>
                <c:pt idx="1793">
                  <c:v>429.57291666666703</c:v>
                </c:pt>
                <c:pt idx="1794">
                  <c:v>429.8125</c:v>
                </c:pt>
                <c:pt idx="1795">
                  <c:v>430.05208333333297</c:v>
                </c:pt>
                <c:pt idx="1796">
                  <c:v>430.29166666666703</c:v>
                </c:pt>
                <c:pt idx="1797">
                  <c:v>430.53125</c:v>
                </c:pt>
                <c:pt idx="1798">
                  <c:v>430.77083333333297</c:v>
                </c:pt>
                <c:pt idx="1799">
                  <c:v>431.01041666666703</c:v>
                </c:pt>
                <c:pt idx="1800">
                  <c:v>431.25</c:v>
                </c:pt>
                <c:pt idx="1801">
                  <c:v>431.48958333333297</c:v>
                </c:pt>
                <c:pt idx="1802">
                  <c:v>431.72916666666703</c:v>
                </c:pt>
                <c:pt idx="1803">
                  <c:v>431.96875</c:v>
                </c:pt>
                <c:pt idx="1804">
                  <c:v>432.20833333333297</c:v>
                </c:pt>
                <c:pt idx="1805">
                  <c:v>432.44791666666703</c:v>
                </c:pt>
                <c:pt idx="1806">
                  <c:v>432.6875</c:v>
                </c:pt>
                <c:pt idx="1807">
                  <c:v>432.92708333333297</c:v>
                </c:pt>
                <c:pt idx="1808">
                  <c:v>433.16666666666703</c:v>
                </c:pt>
                <c:pt idx="1809">
                  <c:v>433.40625</c:v>
                </c:pt>
                <c:pt idx="1810">
                  <c:v>433.64583333333297</c:v>
                </c:pt>
                <c:pt idx="1811">
                  <c:v>433.88541666666703</c:v>
                </c:pt>
                <c:pt idx="1812">
                  <c:v>434.125</c:v>
                </c:pt>
                <c:pt idx="1813">
                  <c:v>434.36458333333297</c:v>
                </c:pt>
                <c:pt idx="1814">
                  <c:v>434.60416666666703</c:v>
                </c:pt>
                <c:pt idx="1815">
                  <c:v>434.84375</c:v>
                </c:pt>
                <c:pt idx="1816">
                  <c:v>435.08333333333297</c:v>
                </c:pt>
                <c:pt idx="1817">
                  <c:v>435.32291666666703</c:v>
                </c:pt>
                <c:pt idx="1818">
                  <c:v>435.5625</c:v>
                </c:pt>
                <c:pt idx="1819">
                  <c:v>435.80208333333297</c:v>
                </c:pt>
                <c:pt idx="1820">
                  <c:v>436.04166666666703</c:v>
                </c:pt>
                <c:pt idx="1821">
                  <c:v>436.28125</c:v>
                </c:pt>
                <c:pt idx="1822">
                  <c:v>436.52083333333297</c:v>
                </c:pt>
                <c:pt idx="1823">
                  <c:v>436.76041666666703</c:v>
                </c:pt>
                <c:pt idx="1824">
                  <c:v>437</c:v>
                </c:pt>
                <c:pt idx="1825">
                  <c:v>437.23958333333297</c:v>
                </c:pt>
                <c:pt idx="1826">
                  <c:v>437.47916666666703</c:v>
                </c:pt>
                <c:pt idx="1827">
                  <c:v>437.71875</c:v>
                </c:pt>
                <c:pt idx="1828">
                  <c:v>437.95833333333297</c:v>
                </c:pt>
                <c:pt idx="1829">
                  <c:v>438.19791666666703</c:v>
                </c:pt>
                <c:pt idx="1830">
                  <c:v>438.4375</c:v>
                </c:pt>
                <c:pt idx="1831">
                  <c:v>438.67708333333297</c:v>
                </c:pt>
                <c:pt idx="1832">
                  <c:v>438.91666666666703</c:v>
                </c:pt>
                <c:pt idx="1833">
                  <c:v>439.15625</c:v>
                </c:pt>
                <c:pt idx="1834">
                  <c:v>439.39583333333297</c:v>
                </c:pt>
                <c:pt idx="1835">
                  <c:v>439.63541666666703</c:v>
                </c:pt>
                <c:pt idx="1836">
                  <c:v>439.875</c:v>
                </c:pt>
                <c:pt idx="1837">
                  <c:v>440.11458333333297</c:v>
                </c:pt>
                <c:pt idx="1838">
                  <c:v>440.35416666666703</c:v>
                </c:pt>
                <c:pt idx="1839">
                  <c:v>440.59375</c:v>
                </c:pt>
                <c:pt idx="1840">
                  <c:v>440.83333333333297</c:v>
                </c:pt>
                <c:pt idx="1841">
                  <c:v>441.07291666666703</c:v>
                </c:pt>
                <c:pt idx="1842">
                  <c:v>441.3125</c:v>
                </c:pt>
                <c:pt idx="1843">
                  <c:v>441.55208333333297</c:v>
                </c:pt>
                <c:pt idx="1844">
                  <c:v>441.79166666666703</c:v>
                </c:pt>
                <c:pt idx="1845">
                  <c:v>442.03125</c:v>
                </c:pt>
                <c:pt idx="1846">
                  <c:v>442.27083333333297</c:v>
                </c:pt>
                <c:pt idx="1847">
                  <c:v>442.51041666666703</c:v>
                </c:pt>
                <c:pt idx="1848">
                  <c:v>442.75</c:v>
                </c:pt>
                <c:pt idx="1849">
                  <c:v>442.98958333333297</c:v>
                </c:pt>
                <c:pt idx="1850">
                  <c:v>443.22916666666703</c:v>
                </c:pt>
                <c:pt idx="1851">
                  <c:v>443.46875</c:v>
                </c:pt>
                <c:pt idx="1852">
                  <c:v>443.70833333333297</c:v>
                </c:pt>
                <c:pt idx="1853">
                  <c:v>443.94791666666703</c:v>
                </c:pt>
                <c:pt idx="1854">
                  <c:v>444.1875</c:v>
                </c:pt>
                <c:pt idx="1855">
                  <c:v>444.42708333333297</c:v>
                </c:pt>
                <c:pt idx="1856">
                  <c:v>444.66666666666703</c:v>
                </c:pt>
                <c:pt idx="1857">
                  <c:v>444.90625</c:v>
                </c:pt>
                <c:pt idx="1858">
                  <c:v>445.14583333333297</c:v>
                </c:pt>
                <c:pt idx="1859">
                  <c:v>445.38541666666703</c:v>
                </c:pt>
                <c:pt idx="1860">
                  <c:v>445.625</c:v>
                </c:pt>
                <c:pt idx="1861">
                  <c:v>445.86458333333297</c:v>
                </c:pt>
                <c:pt idx="1862">
                  <c:v>446.10416666666703</c:v>
                </c:pt>
                <c:pt idx="1863">
                  <c:v>446.34375</c:v>
                </c:pt>
                <c:pt idx="1864">
                  <c:v>446.58333333333297</c:v>
                </c:pt>
                <c:pt idx="1865">
                  <c:v>446.82291666666703</c:v>
                </c:pt>
                <c:pt idx="1866">
                  <c:v>447.0625</c:v>
                </c:pt>
                <c:pt idx="1867">
                  <c:v>447.30208333333297</c:v>
                </c:pt>
                <c:pt idx="1868">
                  <c:v>447.54166666666703</c:v>
                </c:pt>
                <c:pt idx="1869">
                  <c:v>447.78125</c:v>
                </c:pt>
                <c:pt idx="1870">
                  <c:v>448.02083333333297</c:v>
                </c:pt>
                <c:pt idx="1871">
                  <c:v>448.26041666666703</c:v>
                </c:pt>
                <c:pt idx="1872">
                  <c:v>448.5</c:v>
                </c:pt>
                <c:pt idx="1873">
                  <c:v>448.73958333333297</c:v>
                </c:pt>
                <c:pt idx="1874">
                  <c:v>448.97916666666703</c:v>
                </c:pt>
                <c:pt idx="1875">
                  <c:v>449.21875</c:v>
                </c:pt>
                <c:pt idx="1876">
                  <c:v>449.45833333333297</c:v>
                </c:pt>
                <c:pt idx="1877">
                  <c:v>449.69791666666703</c:v>
                </c:pt>
                <c:pt idx="1878">
                  <c:v>449.9375</c:v>
                </c:pt>
                <c:pt idx="1879">
                  <c:v>450.17708333333297</c:v>
                </c:pt>
                <c:pt idx="1880">
                  <c:v>450.41666666666703</c:v>
                </c:pt>
                <c:pt idx="1881">
                  <c:v>450.65625</c:v>
                </c:pt>
                <c:pt idx="1882">
                  <c:v>450.89583333333297</c:v>
                </c:pt>
                <c:pt idx="1883">
                  <c:v>451.13541666666703</c:v>
                </c:pt>
                <c:pt idx="1884">
                  <c:v>451.375</c:v>
                </c:pt>
                <c:pt idx="1885">
                  <c:v>451.61458333333297</c:v>
                </c:pt>
                <c:pt idx="1886">
                  <c:v>451.85416666666703</c:v>
                </c:pt>
                <c:pt idx="1887">
                  <c:v>452.09375</c:v>
                </c:pt>
                <c:pt idx="1888">
                  <c:v>452.33333333333297</c:v>
                </c:pt>
                <c:pt idx="1889">
                  <c:v>452.57291666666703</c:v>
                </c:pt>
                <c:pt idx="1890">
                  <c:v>452.8125</c:v>
                </c:pt>
                <c:pt idx="1891">
                  <c:v>453.05208333333297</c:v>
                </c:pt>
                <c:pt idx="1892">
                  <c:v>453.29166666666703</c:v>
                </c:pt>
                <c:pt idx="1893">
                  <c:v>453.53125</c:v>
                </c:pt>
                <c:pt idx="1894">
                  <c:v>453.77083333333297</c:v>
                </c:pt>
                <c:pt idx="1895">
                  <c:v>454.01041666666703</c:v>
                </c:pt>
                <c:pt idx="1896">
                  <c:v>454.25</c:v>
                </c:pt>
                <c:pt idx="1897">
                  <c:v>454.48958333333297</c:v>
                </c:pt>
                <c:pt idx="1898">
                  <c:v>454.72916666666703</c:v>
                </c:pt>
                <c:pt idx="1899">
                  <c:v>454.96875</c:v>
                </c:pt>
                <c:pt idx="1900">
                  <c:v>455.20833333333297</c:v>
                </c:pt>
                <c:pt idx="1901">
                  <c:v>455.44791666666703</c:v>
                </c:pt>
                <c:pt idx="1902">
                  <c:v>455.6875</c:v>
                </c:pt>
                <c:pt idx="1903">
                  <c:v>455.92708333333297</c:v>
                </c:pt>
                <c:pt idx="1904">
                  <c:v>456.16666666666703</c:v>
                </c:pt>
                <c:pt idx="1905">
                  <c:v>456.40625</c:v>
                </c:pt>
                <c:pt idx="1906">
                  <c:v>456.64583333333297</c:v>
                </c:pt>
                <c:pt idx="1907">
                  <c:v>456.88541666666703</c:v>
                </c:pt>
                <c:pt idx="1908">
                  <c:v>457.125</c:v>
                </c:pt>
                <c:pt idx="1909">
                  <c:v>457.36458333333297</c:v>
                </c:pt>
                <c:pt idx="1910">
                  <c:v>457.60416666666703</c:v>
                </c:pt>
                <c:pt idx="1911">
                  <c:v>457.84375</c:v>
                </c:pt>
                <c:pt idx="1912">
                  <c:v>458.08333333333297</c:v>
                </c:pt>
                <c:pt idx="1913">
                  <c:v>458.32291666666703</c:v>
                </c:pt>
                <c:pt idx="1914">
                  <c:v>458.5625</c:v>
                </c:pt>
                <c:pt idx="1915">
                  <c:v>458.80208333333297</c:v>
                </c:pt>
                <c:pt idx="1916">
                  <c:v>459.04166666666703</c:v>
                </c:pt>
                <c:pt idx="1917">
                  <c:v>459.28125</c:v>
                </c:pt>
                <c:pt idx="1918">
                  <c:v>459.52083333333297</c:v>
                </c:pt>
                <c:pt idx="1919">
                  <c:v>459.76041666666703</c:v>
                </c:pt>
                <c:pt idx="1920">
                  <c:v>460</c:v>
                </c:pt>
                <c:pt idx="1921">
                  <c:v>460.23958333333297</c:v>
                </c:pt>
                <c:pt idx="1922">
                  <c:v>460.47916666666703</c:v>
                </c:pt>
                <c:pt idx="1923">
                  <c:v>460.71875</c:v>
                </c:pt>
                <c:pt idx="1924">
                  <c:v>460.95833333333297</c:v>
                </c:pt>
                <c:pt idx="1925">
                  <c:v>461.19791666666703</c:v>
                </c:pt>
                <c:pt idx="1926">
                  <c:v>461.4375</c:v>
                </c:pt>
                <c:pt idx="1927">
                  <c:v>461.67708333333297</c:v>
                </c:pt>
                <c:pt idx="1928">
                  <c:v>461.91666666666703</c:v>
                </c:pt>
                <c:pt idx="1929">
                  <c:v>462.15625</c:v>
                </c:pt>
                <c:pt idx="1930">
                  <c:v>462.39583333333297</c:v>
                </c:pt>
                <c:pt idx="1931">
                  <c:v>462.63541666666703</c:v>
                </c:pt>
                <c:pt idx="1932">
                  <c:v>462.875</c:v>
                </c:pt>
                <c:pt idx="1933">
                  <c:v>463.11458333333297</c:v>
                </c:pt>
                <c:pt idx="1934">
                  <c:v>463.35416666666703</c:v>
                </c:pt>
                <c:pt idx="1935">
                  <c:v>463.59375</c:v>
                </c:pt>
                <c:pt idx="1936">
                  <c:v>463.83333333333297</c:v>
                </c:pt>
                <c:pt idx="1937">
                  <c:v>464.07291666666703</c:v>
                </c:pt>
                <c:pt idx="1938">
                  <c:v>464.3125</c:v>
                </c:pt>
                <c:pt idx="1939">
                  <c:v>464.55208333333297</c:v>
                </c:pt>
                <c:pt idx="1940">
                  <c:v>464.79166666666703</c:v>
                </c:pt>
                <c:pt idx="1941">
                  <c:v>465.03125</c:v>
                </c:pt>
                <c:pt idx="1942">
                  <c:v>465.27083333333297</c:v>
                </c:pt>
                <c:pt idx="1943">
                  <c:v>465.51041666666703</c:v>
                </c:pt>
                <c:pt idx="1944">
                  <c:v>465.75</c:v>
                </c:pt>
                <c:pt idx="1945">
                  <c:v>465.98958333333297</c:v>
                </c:pt>
                <c:pt idx="1946">
                  <c:v>466.22916666666703</c:v>
                </c:pt>
                <c:pt idx="1947">
                  <c:v>466.46875</c:v>
                </c:pt>
                <c:pt idx="1948">
                  <c:v>466.70833333333297</c:v>
                </c:pt>
                <c:pt idx="1949">
                  <c:v>466.94791666666703</c:v>
                </c:pt>
                <c:pt idx="1950">
                  <c:v>467.1875</c:v>
                </c:pt>
                <c:pt idx="1951">
                  <c:v>467.42708333333297</c:v>
                </c:pt>
                <c:pt idx="1952">
                  <c:v>467.66666666666703</c:v>
                </c:pt>
                <c:pt idx="1953">
                  <c:v>467.90625</c:v>
                </c:pt>
                <c:pt idx="1954">
                  <c:v>468.14583333333297</c:v>
                </c:pt>
                <c:pt idx="1955">
                  <c:v>468.38541666666703</c:v>
                </c:pt>
                <c:pt idx="1956">
                  <c:v>468.625</c:v>
                </c:pt>
                <c:pt idx="1957">
                  <c:v>468.86458333333297</c:v>
                </c:pt>
                <c:pt idx="1958">
                  <c:v>469.10416666666703</c:v>
                </c:pt>
                <c:pt idx="1959">
                  <c:v>469.34375</c:v>
                </c:pt>
                <c:pt idx="1960">
                  <c:v>469.58333333333297</c:v>
                </c:pt>
                <c:pt idx="1961">
                  <c:v>469.82291666666703</c:v>
                </c:pt>
                <c:pt idx="1962">
                  <c:v>470.0625</c:v>
                </c:pt>
                <c:pt idx="1963">
                  <c:v>470.30208333333297</c:v>
                </c:pt>
                <c:pt idx="1964">
                  <c:v>470.54166666666703</c:v>
                </c:pt>
                <c:pt idx="1965">
                  <c:v>470.78125</c:v>
                </c:pt>
                <c:pt idx="1966">
                  <c:v>471.02083333333297</c:v>
                </c:pt>
                <c:pt idx="1967">
                  <c:v>471.26041666666703</c:v>
                </c:pt>
                <c:pt idx="1968">
                  <c:v>471.5</c:v>
                </c:pt>
                <c:pt idx="1969">
                  <c:v>471.73958333333297</c:v>
                </c:pt>
                <c:pt idx="1970">
                  <c:v>471.97916666666703</c:v>
                </c:pt>
                <c:pt idx="1971">
                  <c:v>472.21875</c:v>
                </c:pt>
                <c:pt idx="1972">
                  <c:v>472.45833333333297</c:v>
                </c:pt>
                <c:pt idx="1973">
                  <c:v>472.69791666666703</c:v>
                </c:pt>
                <c:pt idx="1974">
                  <c:v>472.9375</c:v>
                </c:pt>
                <c:pt idx="1975">
                  <c:v>473.17708333333297</c:v>
                </c:pt>
                <c:pt idx="1976">
                  <c:v>473.41666666666703</c:v>
                </c:pt>
                <c:pt idx="1977">
                  <c:v>473.65625</c:v>
                </c:pt>
                <c:pt idx="1978">
                  <c:v>473.89583333333297</c:v>
                </c:pt>
                <c:pt idx="1979">
                  <c:v>474.13541666666703</c:v>
                </c:pt>
                <c:pt idx="1980">
                  <c:v>474.375</c:v>
                </c:pt>
                <c:pt idx="1981">
                  <c:v>474.61458333333297</c:v>
                </c:pt>
                <c:pt idx="1982">
                  <c:v>474.85416666666703</c:v>
                </c:pt>
                <c:pt idx="1983">
                  <c:v>475.09375</c:v>
                </c:pt>
                <c:pt idx="1984">
                  <c:v>475.33333333333297</c:v>
                </c:pt>
                <c:pt idx="1985">
                  <c:v>475.57291666666703</c:v>
                </c:pt>
                <c:pt idx="1986">
                  <c:v>475.8125</c:v>
                </c:pt>
                <c:pt idx="1987">
                  <c:v>476.05208333333297</c:v>
                </c:pt>
                <c:pt idx="1988">
                  <c:v>476.29166666666703</c:v>
                </c:pt>
                <c:pt idx="1989">
                  <c:v>476.53125</c:v>
                </c:pt>
                <c:pt idx="1990">
                  <c:v>476.77083333333297</c:v>
                </c:pt>
                <c:pt idx="1991">
                  <c:v>477.01041666666703</c:v>
                </c:pt>
                <c:pt idx="1992">
                  <c:v>477.25</c:v>
                </c:pt>
                <c:pt idx="1993">
                  <c:v>477.48958333333297</c:v>
                </c:pt>
                <c:pt idx="1994">
                  <c:v>477.72916666666703</c:v>
                </c:pt>
                <c:pt idx="1995">
                  <c:v>477.96875</c:v>
                </c:pt>
                <c:pt idx="1996">
                  <c:v>478.20833333333297</c:v>
                </c:pt>
                <c:pt idx="1997">
                  <c:v>478.44791666666703</c:v>
                </c:pt>
                <c:pt idx="1998">
                  <c:v>478.6875</c:v>
                </c:pt>
                <c:pt idx="1999">
                  <c:v>478.92708333333297</c:v>
                </c:pt>
                <c:pt idx="2000">
                  <c:v>479.16666666666703</c:v>
                </c:pt>
                <c:pt idx="2001">
                  <c:v>479.40625</c:v>
                </c:pt>
                <c:pt idx="2002">
                  <c:v>479.64583333333297</c:v>
                </c:pt>
                <c:pt idx="2003">
                  <c:v>479.88541666666703</c:v>
                </c:pt>
                <c:pt idx="2004">
                  <c:v>480.125</c:v>
                </c:pt>
                <c:pt idx="2005">
                  <c:v>480.36458333333297</c:v>
                </c:pt>
                <c:pt idx="2006">
                  <c:v>480.60416666666703</c:v>
                </c:pt>
                <c:pt idx="2007">
                  <c:v>480.84375</c:v>
                </c:pt>
                <c:pt idx="2008">
                  <c:v>481.08333333333297</c:v>
                </c:pt>
                <c:pt idx="2009">
                  <c:v>481.32291666666703</c:v>
                </c:pt>
                <c:pt idx="2010">
                  <c:v>481.5625</c:v>
                </c:pt>
                <c:pt idx="2011">
                  <c:v>481.80208333333297</c:v>
                </c:pt>
                <c:pt idx="2012">
                  <c:v>482.04166666666703</c:v>
                </c:pt>
                <c:pt idx="2013">
                  <c:v>482.28125</c:v>
                </c:pt>
                <c:pt idx="2014">
                  <c:v>482.52083333333297</c:v>
                </c:pt>
                <c:pt idx="2015">
                  <c:v>482.76041666666703</c:v>
                </c:pt>
                <c:pt idx="2016">
                  <c:v>483</c:v>
                </c:pt>
                <c:pt idx="2017">
                  <c:v>483.23958333333297</c:v>
                </c:pt>
                <c:pt idx="2018">
                  <c:v>483.47916666666703</c:v>
                </c:pt>
                <c:pt idx="2019">
                  <c:v>483.71875</c:v>
                </c:pt>
                <c:pt idx="2020">
                  <c:v>483.95833333333297</c:v>
                </c:pt>
                <c:pt idx="2021">
                  <c:v>484.19791666666703</c:v>
                </c:pt>
                <c:pt idx="2022">
                  <c:v>484.4375</c:v>
                </c:pt>
                <c:pt idx="2023">
                  <c:v>484.67708333333297</c:v>
                </c:pt>
                <c:pt idx="2024">
                  <c:v>484.91666666666703</c:v>
                </c:pt>
                <c:pt idx="2025">
                  <c:v>485.15625</c:v>
                </c:pt>
                <c:pt idx="2026">
                  <c:v>485.39583333333297</c:v>
                </c:pt>
                <c:pt idx="2027">
                  <c:v>485.63541666666703</c:v>
                </c:pt>
                <c:pt idx="2028">
                  <c:v>485.875</c:v>
                </c:pt>
                <c:pt idx="2029">
                  <c:v>486.11458333333297</c:v>
                </c:pt>
                <c:pt idx="2030">
                  <c:v>486.35416666666703</c:v>
                </c:pt>
                <c:pt idx="2031">
                  <c:v>486.59375</c:v>
                </c:pt>
                <c:pt idx="2032">
                  <c:v>486.83333333333297</c:v>
                </c:pt>
                <c:pt idx="2033">
                  <c:v>487.07291666666703</c:v>
                </c:pt>
                <c:pt idx="2034">
                  <c:v>487.3125</c:v>
                </c:pt>
                <c:pt idx="2035">
                  <c:v>487.55208333333297</c:v>
                </c:pt>
                <c:pt idx="2036">
                  <c:v>487.79166666666703</c:v>
                </c:pt>
                <c:pt idx="2037">
                  <c:v>488.03125</c:v>
                </c:pt>
                <c:pt idx="2038">
                  <c:v>488.27083333333297</c:v>
                </c:pt>
                <c:pt idx="2039">
                  <c:v>488.51041666666703</c:v>
                </c:pt>
                <c:pt idx="2040">
                  <c:v>488.75</c:v>
                </c:pt>
                <c:pt idx="2041">
                  <c:v>488.98958333333297</c:v>
                </c:pt>
                <c:pt idx="2042">
                  <c:v>489.22916666666703</c:v>
                </c:pt>
                <c:pt idx="2043">
                  <c:v>489.46875</c:v>
                </c:pt>
                <c:pt idx="2044">
                  <c:v>489.70833333333297</c:v>
                </c:pt>
                <c:pt idx="2045">
                  <c:v>489.94791666666703</c:v>
                </c:pt>
                <c:pt idx="2046">
                  <c:v>490.1875</c:v>
                </c:pt>
                <c:pt idx="2047">
                  <c:v>490.42708333333297</c:v>
                </c:pt>
                <c:pt idx="2048">
                  <c:v>490.66666666666703</c:v>
                </c:pt>
                <c:pt idx="2049">
                  <c:v>490.90625</c:v>
                </c:pt>
                <c:pt idx="2050">
                  <c:v>491.14583333333297</c:v>
                </c:pt>
                <c:pt idx="2051">
                  <c:v>491.38541666666703</c:v>
                </c:pt>
                <c:pt idx="2052">
                  <c:v>491.625</c:v>
                </c:pt>
                <c:pt idx="2053">
                  <c:v>491.86458333333297</c:v>
                </c:pt>
                <c:pt idx="2054">
                  <c:v>492.10416666666703</c:v>
                </c:pt>
                <c:pt idx="2055">
                  <c:v>492.34375</c:v>
                </c:pt>
                <c:pt idx="2056">
                  <c:v>492.58333333333297</c:v>
                </c:pt>
                <c:pt idx="2057">
                  <c:v>492.82291666666703</c:v>
                </c:pt>
                <c:pt idx="2058">
                  <c:v>493.0625</c:v>
                </c:pt>
                <c:pt idx="2059">
                  <c:v>493.30208333333297</c:v>
                </c:pt>
                <c:pt idx="2060">
                  <c:v>493.54166666666703</c:v>
                </c:pt>
                <c:pt idx="2061">
                  <c:v>493.78125</c:v>
                </c:pt>
                <c:pt idx="2062">
                  <c:v>494.02083333333297</c:v>
                </c:pt>
                <c:pt idx="2063">
                  <c:v>494.26041666666703</c:v>
                </c:pt>
                <c:pt idx="2064">
                  <c:v>494.5</c:v>
                </c:pt>
                <c:pt idx="2065">
                  <c:v>494.73958333333297</c:v>
                </c:pt>
                <c:pt idx="2066">
                  <c:v>494.97916666666703</c:v>
                </c:pt>
                <c:pt idx="2067">
                  <c:v>495.21875</c:v>
                </c:pt>
                <c:pt idx="2068">
                  <c:v>495.45833333333297</c:v>
                </c:pt>
                <c:pt idx="2069">
                  <c:v>495.69791666666703</c:v>
                </c:pt>
                <c:pt idx="2070">
                  <c:v>495.9375</c:v>
                </c:pt>
                <c:pt idx="2071">
                  <c:v>496.17708333333297</c:v>
                </c:pt>
                <c:pt idx="2072">
                  <c:v>496.41666666666703</c:v>
                </c:pt>
                <c:pt idx="2073">
                  <c:v>496.65625</c:v>
                </c:pt>
                <c:pt idx="2074">
                  <c:v>496.89583333333297</c:v>
                </c:pt>
                <c:pt idx="2075">
                  <c:v>497.13541666666703</c:v>
                </c:pt>
                <c:pt idx="2076">
                  <c:v>497.375</c:v>
                </c:pt>
                <c:pt idx="2077">
                  <c:v>497.61458333333297</c:v>
                </c:pt>
                <c:pt idx="2078">
                  <c:v>497.85416666666703</c:v>
                </c:pt>
                <c:pt idx="2079">
                  <c:v>498.09375</c:v>
                </c:pt>
                <c:pt idx="2080">
                  <c:v>498.33333333333297</c:v>
                </c:pt>
                <c:pt idx="2081">
                  <c:v>498.57291666666703</c:v>
                </c:pt>
                <c:pt idx="2082">
                  <c:v>498.8125</c:v>
                </c:pt>
                <c:pt idx="2083">
                  <c:v>499.05208333333297</c:v>
                </c:pt>
                <c:pt idx="2084">
                  <c:v>499.29166666666703</c:v>
                </c:pt>
                <c:pt idx="2085">
                  <c:v>499.53125</c:v>
                </c:pt>
                <c:pt idx="2086">
                  <c:v>499.77083333333297</c:v>
                </c:pt>
                <c:pt idx="2087">
                  <c:v>500.01041666666703</c:v>
                </c:pt>
                <c:pt idx="2088">
                  <c:v>500.25</c:v>
                </c:pt>
                <c:pt idx="2089">
                  <c:v>500.48958333333297</c:v>
                </c:pt>
                <c:pt idx="2090">
                  <c:v>500.72916666666703</c:v>
                </c:pt>
                <c:pt idx="2091">
                  <c:v>500.96875</c:v>
                </c:pt>
                <c:pt idx="2092">
                  <c:v>501.20833333333297</c:v>
                </c:pt>
                <c:pt idx="2093">
                  <c:v>501.44791666666703</c:v>
                </c:pt>
                <c:pt idx="2094">
                  <c:v>501.6875</c:v>
                </c:pt>
                <c:pt idx="2095">
                  <c:v>501.92708333333297</c:v>
                </c:pt>
                <c:pt idx="2096">
                  <c:v>502.16666666666703</c:v>
                </c:pt>
                <c:pt idx="2097">
                  <c:v>502.40625</c:v>
                </c:pt>
                <c:pt idx="2098">
                  <c:v>502.64583333333297</c:v>
                </c:pt>
                <c:pt idx="2099">
                  <c:v>502.88541666666703</c:v>
                </c:pt>
                <c:pt idx="2100">
                  <c:v>503.125</c:v>
                </c:pt>
                <c:pt idx="2101">
                  <c:v>503.36458333333297</c:v>
                </c:pt>
                <c:pt idx="2102">
                  <c:v>503.60416666666703</c:v>
                </c:pt>
                <c:pt idx="2103">
                  <c:v>503.84375</c:v>
                </c:pt>
                <c:pt idx="2104">
                  <c:v>504.08333333333297</c:v>
                </c:pt>
                <c:pt idx="2105">
                  <c:v>504.32291666666703</c:v>
                </c:pt>
                <c:pt idx="2106">
                  <c:v>504.5625</c:v>
                </c:pt>
                <c:pt idx="2107">
                  <c:v>504.80208333333297</c:v>
                </c:pt>
                <c:pt idx="2108">
                  <c:v>505.04166666666703</c:v>
                </c:pt>
                <c:pt idx="2109">
                  <c:v>505.28125</c:v>
                </c:pt>
                <c:pt idx="2110">
                  <c:v>505.52083333333297</c:v>
                </c:pt>
                <c:pt idx="2111">
                  <c:v>505.76041666666703</c:v>
                </c:pt>
                <c:pt idx="2112">
                  <c:v>506</c:v>
                </c:pt>
                <c:pt idx="2113">
                  <c:v>506.23958333333297</c:v>
                </c:pt>
                <c:pt idx="2114">
                  <c:v>506.47916666666703</c:v>
                </c:pt>
                <c:pt idx="2115">
                  <c:v>506.71875</c:v>
                </c:pt>
                <c:pt idx="2116">
                  <c:v>506.95833333333297</c:v>
                </c:pt>
                <c:pt idx="2117">
                  <c:v>507.19791666666703</c:v>
                </c:pt>
                <c:pt idx="2118">
                  <c:v>507.4375</c:v>
                </c:pt>
                <c:pt idx="2119">
                  <c:v>507.67708333333297</c:v>
                </c:pt>
                <c:pt idx="2120">
                  <c:v>507.91666666666703</c:v>
                </c:pt>
                <c:pt idx="2121">
                  <c:v>508.15625</c:v>
                </c:pt>
                <c:pt idx="2122">
                  <c:v>508.39583333333297</c:v>
                </c:pt>
                <c:pt idx="2123">
                  <c:v>508.63541666666703</c:v>
                </c:pt>
                <c:pt idx="2124">
                  <c:v>508.875</c:v>
                </c:pt>
                <c:pt idx="2125">
                  <c:v>509.11458333333297</c:v>
                </c:pt>
                <c:pt idx="2126">
                  <c:v>509.35416666666703</c:v>
                </c:pt>
                <c:pt idx="2127">
                  <c:v>509.59375</c:v>
                </c:pt>
                <c:pt idx="2128">
                  <c:v>509.83333333333297</c:v>
                </c:pt>
                <c:pt idx="2129">
                  <c:v>510.07291666666703</c:v>
                </c:pt>
                <c:pt idx="2130">
                  <c:v>510.3125</c:v>
                </c:pt>
                <c:pt idx="2131">
                  <c:v>510.55208333333297</c:v>
                </c:pt>
                <c:pt idx="2132">
                  <c:v>510.79166666666703</c:v>
                </c:pt>
                <c:pt idx="2133">
                  <c:v>511.03125</c:v>
                </c:pt>
                <c:pt idx="2134">
                  <c:v>511.27083333333297</c:v>
                </c:pt>
                <c:pt idx="2135">
                  <c:v>511.51041666666703</c:v>
                </c:pt>
                <c:pt idx="2136">
                  <c:v>511.75</c:v>
                </c:pt>
                <c:pt idx="2137">
                  <c:v>511.98958333333297</c:v>
                </c:pt>
                <c:pt idx="2138">
                  <c:v>512.22916666666697</c:v>
                </c:pt>
                <c:pt idx="2139">
                  <c:v>512.46875</c:v>
                </c:pt>
                <c:pt idx="2140">
                  <c:v>512.70833333333303</c:v>
                </c:pt>
                <c:pt idx="2141">
                  <c:v>512.94791666666697</c:v>
                </c:pt>
                <c:pt idx="2142">
                  <c:v>513.1875</c:v>
                </c:pt>
                <c:pt idx="2143">
                  <c:v>513.42708333333303</c:v>
                </c:pt>
                <c:pt idx="2144">
                  <c:v>513.66666666666697</c:v>
                </c:pt>
                <c:pt idx="2145">
                  <c:v>513.90625</c:v>
                </c:pt>
                <c:pt idx="2146">
                  <c:v>514.14583333333303</c:v>
                </c:pt>
                <c:pt idx="2147">
                  <c:v>514.38541666666697</c:v>
                </c:pt>
                <c:pt idx="2148">
                  <c:v>514.625</c:v>
                </c:pt>
                <c:pt idx="2149">
                  <c:v>514.86458333333303</c:v>
                </c:pt>
                <c:pt idx="2150">
                  <c:v>515.10416666666697</c:v>
                </c:pt>
                <c:pt idx="2151">
                  <c:v>515.34375</c:v>
                </c:pt>
                <c:pt idx="2152">
                  <c:v>515.58333333333303</c:v>
                </c:pt>
                <c:pt idx="2153">
                  <c:v>515.82291666666697</c:v>
                </c:pt>
                <c:pt idx="2154">
                  <c:v>516.0625</c:v>
                </c:pt>
                <c:pt idx="2155">
                  <c:v>516.30208333333303</c:v>
                </c:pt>
                <c:pt idx="2156">
                  <c:v>516.54166666666697</c:v>
                </c:pt>
                <c:pt idx="2157">
                  <c:v>516.78125</c:v>
                </c:pt>
                <c:pt idx="2158">
                  <c:v>517.02083333333303</c:v>
                </c:pt>
                <c:pt idx="2159">
                  <c:v>517.26041666666697</c:v>
                </c:pt>
                <c:pt idx="2160">
                  <c:v>517.5</c:v>
                </c:pt>
                <c:pt idx="2161">
                  <c:v>517.73958333333303</c:v>
                </c:pt>
                <c:pt idx="2162">
                  <c:v>517.97916666666697</c:v>
                </c:pt>
                <c:pt idx="2163">
                  <c:v>518.21875</c:v>
                </c:pt>
                <c:pt idx="2164">
                  <c:v>518.45833333333303</c:v>
                </c:pt>
                <c:pt idx="2165">
                  <c:v>518.69791666666697</c:v>
                </c:pt>
                <c:pt idx="2166">
                  <c:v>518.9375</c:v>
                </c:pt>
                <c:pt idx="2167">
                  <c:v>519.17708333333303</c:v>
                </c:pt>
                <c:pt idx="2168">
                  <c:v>519.41666666666697</c:v>
                </c:pt>
                <c:pt idx="2169">
                  <c:v>519.65625</c:v>
                </c:pt>
                <c:pt idx="2170">
                  <c:v>519.89583333333303</c:v>
                </c:pt>
                <c:pt idx="2171">
                  <c:v>520.13541666666697</c:v>
                </c:pt>
                <c:pt idx="2172">
                  <c:v>520.375</c:v>
                </c:pt>
                <c:pt idx="2173">
                  <c:v>520.61458333333303</c:v>
                </c:pt>
                <c:pt idx="2174">
                  <c:v>520.85416666666697</c:v>
                </c:pt>
                <c:pt idx="2175">
                  <c:v>521.09375</c:v>
                </c:pt>
                <c:pt idx="2176">
                  <c:v>521.33333333333303</c:v>
                </c:pt>
                <c:pt idx="2177">
                  <c:v>521.57291666666697</c:v>
                </c:pt>
                <c:pt idx="2178">
                  <c:v>521.8125</c:v>
                </c:pt>
                <c:pt idx="2179">
                  <c:v>522.05208333333303</c:v>
                </c:pt>
                <c:pt idx="2180">
                  <c:v>522.29166666666697</c:v>
                </c:pt>
                <c:pt idx="2181">
                  <c:v>522.53125</c:v>
                </c:pt>
                <c:pt idx="2182">
                  <c:v>522.77083333333303</c:v>
                </c:pt>
                <c:pt idx="2183">
                  <c:v>523.01041666666697</c:v>
                </c:pt>
                <c:pt idx="2184">
                  <c:v>523.25</c:v>
                </c:pt>
                <c:pt idx="2185">
                  <c:v>523.48958333333303</c:v>
                </c:pt>
                <c:pt idx="2186">
                  <c:v>523.72916666666697</c:v>
                </c:pt>
                <c:pt idx="2187">
                  <c:v>523.96875</c:v>
                </c:pt>
                <c:pt idx="2188">
                  <c:v>524.20833333333303</c:v>
                </c:pt>
                <c:pt idx="2189">
                  <c:v>524.44791666666697</c:v>
                </c:pt>
                <c:pt idx="2190">
                  <c:v>524.6875</c:v>
                </c:pt>
                <c:pt idx="2191">
                  <c:v>524.92708333333303</c:v>
                </c:pt>
                <c:pt idx="2192">
                  <c:v>525.16666666666697</c:v>
                </c:pt>
                <c:pt idx="2193">
                  <c:v>525.40625</c:v>
                </c:pt>
                <c:pt idx="2194">
                  <c:v>525.64583333333303</c:v>
                </c:pt>
                <c:pt idx="2195">
                  <c:v>525.88541666666697</c:v>
                </c:pt>
                <c:pt idx="2196">
                  <c:v>526.125</c:v>
                </c:pt>
                <c:pt idx="2197">
                  <c:v>526.36458333333303</c:v>
                </c:pt>
                <c:pt idx="2198">
                  <c:v>526.60416666666697</c:v>
                </c:pt>
                <c:pt idx="2199">
                  <c:v>526.84375</c:v>
                </c:pt>
                <c:pt idx="2200">
                  <c:v>527.08333333333303</c:v>
                </c:pt>
                <c:pt idx="2201">
                  <c:v>527.32291666666697</c:v>
                </c:pt>
                <c:pt idx="2202">
                  <c:v>527.5625</c:v>
                </c:pt>
                <c:pt idx="2203">
                  <c:v>527.80208333333303</c:v>
                </c:pt>
                <c:pt idx="2204">
                  <c:v>528.04166666666697</c:v>
                </c:pt>
                <c:pt idx="2205">
                  <c:v>528.28125</c:v>
                </c:pt>
                <c:pt idx="2206">
                  <c:v>528.52083333333303</c:v>
                </c:pt>
                <c:pt idx="2207">
                  <c:v>528.76041666666697</c:v>
                </c:pt>
                <c:pt idx="2208">
                  <c:v>529</c:v>
                </c:pt>
                <c:pt idx="2209">
                  <c:v>529.23958333333303</c:v>
                </c:pt>
                <c:pt idx="2210">
                  <c:v>529.47916666666697</c:v>
                </c:pt>
                <c:pt idx="2211">
                  <c:v>529.71875</c:v>
                </c:pt>
                <c:pt idx="2212">
                  <c:v>529.95833333333303</c:v>
                </c:pt>
                <c:pt idx="2213">
                  <c:v>530.19791666666697</c:v>
                </c:pt>
                <c:pt idx="2214">
                  <c:v>530.4375</c:v>
                </c:pt>
                <c:pt idx="2215">
                  <c:v>530.67708333333303</c:v>
                </c:pt>
                <c:pt idx="2216">
                  <c:v>530.91666666666697</c:v>
                </c:pt>
                <c:pt idx="2217">
                  <c:v>531.15625</c:v>
                </c:pt>
                <c:pt idx="2218">
                  <c:v>531.39583333333303</c:v>
                </c:pt>
                <c:pt idx="2219">
                  <c:v>531.63541666666697</c:v>
                </c:pt>
                <c:pt idx="2220">
                  <c:v>531.875</c:v>
                </c:pt>
                <c:pt idx="2221">
                  <c:v>532.11458333333303</c:v>
                </c:pt>
                <c:pt idx="2222">
                  <c:v>532.35416666666697</c:v>
                </c:pt>
                <c:pt idx="2223">
                  <c:v>532.59375</c:v>
                </c:pt>
                <c:pt idx="2224">
                  <c:v>532.83333333333303</c:v>
                </c:pt>
                <c:pt idx="2225">
                  <c:v>533.07291666666697</c:v>
                </c:pt>
                <c:pt idx="2226">
                  <c:v>533.3125</c:v>
                </c:pt>
                <c:pt idx="2227">
                  <c:v>533.55208333333303</c:v>
                </c:pt>
                <c:pt idx="2228">
                  <c:v>533.79166666666697</c:v>
                </c:pt>
                <c:pt idx="2229">
                  <c:v>534.03125</c:v>
                </c:pt>
                <c:pt idx="2230">
                  <c:v>534.27083333333303</c:v>
                </c:pt>
                <c:pt idx="2231">
                  <c:v>534.51041666666697</c:v>
                </c:pt>
                <c:pt idx="2232">
                  <c:v>534.75</c:v>
                </c:pt>
                <c:pt idx="2233">
                  <c:v>534.98958333333303</c:v>
                </c:pt>
                <c:pt idx="2234">
                  <c:v>535.22916666666697</c:v>
                </c:pt>
                <c:pt idx="2235">
                  <c:v>535.46875</c:v>
                </c:pt>
                <c:pt idx="2236">
                  <c:v>535.70833333333303</c:v>
                </c:pt>
                <c:pt idx="2237">
                  <c:v>535.94791666666697</c:v>
                </c:pt>
                <c:pt idx="2238">
                  <c:v>536.1875</c:v>
                </c:pt>
                <c:pt idx="2239">
                  <c:v>536.42708333333303</c:v>
                </c:pt>
                <c:pt idx="2240">
                  <c:v>536.66666666666697</c:v>
                </c:pt>
                <c:pt idx="2241">
                  <c:v>536.90625</c:v>
                </c:pt>
                <c:pt idx="2242">
                  <c:v>537.14583333333303</c:v>
                </c:pt>
                <c:pt idx="2243">
                  <c:v>537.38541666666697</c:v>
                </c:pt>
                <c:pt idx="2244">
                  <c:v>537.625</c:v>
                </c:pt>
                <c:pt idx="2245">
                  <c:v>537.86458333333303</c:v>
                </c:pt>
                <c:pt idx="2246">
                  <c:v>538.10416666666697</c:v>
                </c:pt>
                <c:pt idx="2247">
                  <c:v>538.34375</c:v>
                </c:pt>
                <c:pt idx="2248">
                  <c:v>538.58333333333303</c:v>
                </c:pt>
                <c:pt idx="2249">
                  <c:v>538.82291666666697</c:v>
                </c:pt>
                <c:pt idx="2250">
                  <c:v>539.0625</c:v>
                </c:pt>
                <c:pt idx="2251">
                  <c:v>539.30208333333303</c:v>
                </c:pt>
                <c:pt idx="2252">
                  <c:v>539.54166666666697</c:v>
                </c:pt>
                <c:pt idx="2253">
                  <c:v>539.78125</c:v>
                </c:pt>
                <c:pt idx="2254">
                  <c:v>540.02083333333303</c:v>
                </c:pt>
                <c:pt idx="2255">
                  <c:v>540.26041666666697</c:v>
                </c:pt>
                <c:pt idx="2256">
                  <c:v>540.5</c:v>
                </c:pt>
                <c:pt idx="2257">
                  <c:v>540.73958333333303</c:v>
                </c:pt>
                <c:pt idx="2258">
                  <c:v>540.97916666666697</c:v>
                </c:pt>
                <c:pt idx="2259">
                  <c:v>541.21875</c:v>
                </c:pt>
                <c:pt idx="2260">
                  <c:v>541.45833333333303</c:v>
                </c:pt>
                <c:pt idx="2261">
                  <c:v>541.69791666666697</c:v>
                </c:pt>
                <c:pt idx="2262">
                  <c:v>541.9375</c:v>
                </c:pt>
                <c:pt idx="2263">
                  <c:v>542.17708333333303</c:v>
                </c:pt>
                <c:pt idx="2264">
                  <c:v>542.41666666666697</c:v>
                </c:pt>
                <c:pt idx="2265">
                  <c:v>542.65625</c:v>
                </c:pt>
                <c:pt idx="2266">
                  <c:v>542.89583333333303</c:v>
                </c:pt>
                <c:pt idx="2267">
                  <c:v>543.13541666666697</c:v>
                </c:pt>
                <c:pt idx="2268">
                  <c:v>543.375</c:v>
                </c:pt>
                <c:pt idx="2269">
                  <c:v>543.61458333333303</c:v>
                </c:pt>
                <c:pt idx="2270">
                  <c:v>543.85416666666697</c:v>
                </c:pt>
                <c:pt idx="2271">
                  <c:v>544.09375</c:v>
                </c:pt>
                <c:pt idx="2272">
                  <c:v>544.33333333333303</c:v>
                </c:pt>
                <c:pt idx="2273">
                  <c:v>544.57291666666697</c:v>
                </c:pt>
                <c:pt idx="2274">
                  <c:v>544.8125</c:v>
                </c:pt>
                <c:pt idx="2275">
                  <c:v>545.05208333333303</c:v>
                </c:pt>
                <c:pt idx="2276">
                  <c:v>545.29166666666697</c:v>
                </c:pt>
                <c:pt idx="2277">
                  <c:v>545.53125</c:v>
                </c:pt>
                <c:pt idx="2278">
                  <c:v>545.77083333333303</c:v>
                </c:pt>
                <c:pt idx="2279">
                  <c:v>546.01041666666697</c:v>
                </c:pt>
                <c:pt idx="2280">
                  <c:v>546.25</c:v>
                </c:pt>
                <c:pt idx="2281">
                  <c:v>546.48958333333303</c:v>
                </c:pt>
                <c:pt idx="2282">
                  <c:v>546.72916666666697</c:v>
                </c:pt>
                <c:pt idx="2283">
                  <c:v>546.96875</c:v>
                </c:pt>
                <c:pt idx="2284">
                  <c:v>547.20833333333303</c:v>
                </c:pt>
                <c:pt idx="2285">
                  <c:v>547.44791666666697</c:v>
                </c:pt>
                <c:pt idx="2286">
                  <c:v>547.6875</c:v>
                </c:pt>
                <c:pt idx="2287">
                  <c:v>547.92708333333303</c:v>
                </c:pt>
                <c:pt idx="2288">
                  <c:v>548.16666666666697</c:v>
                </c:pt>
                <c:pt idx="2289">
                  <c:v>548.40625</c:v>
                </c:pt>
                <c:pt idx="2290">
                  <c:v>548.64583333333303</c:v>
                </c:pt>
                <c:pt idx="2291">
                  <c:v>548.88541666666697</c:v>
                </c:pt>
                <c:pt idx="2292">
                  <c:v>549.125</c:v>
                </c:pt>
                <c:pt idx="2293">
                  <c:v>549.36458333333303</c:v>
                </c:pt>
                <c:pt idx="2294">
                  <c:v>549.60416666666697</c:v>
                </c:pt>
                <c:pt idx="2295">
                  <c:v>549.84375</c:v>
                </c:pt>
                <c:pt idx="2296">
                  <c:v>550.08333333333303</c:v>
                </c:pt>
                <c:pt idx="2297">
                  <c:v>550.32291666666697</c:v>
                </c:pt>
                <c:pt idx="2298">
                  <c:v>550.5625</c:v>
                </c:pt>
                <c:pt idx="2299">
                  <c:v>550.80208333333303</c:v>
                </c:pt>
                <c:pt idx="2300">
                  <c:v>551.04166666666697</c:v>
                </c:pt>
                <c:pt idx="2301">
                  <c:v>551.28125</c:v>
                </c:pt>
                <c:pt idx="2302">
                  <c:v>551.52083333333303</c:v>
                </c:pt>
                <c:pt idx="2303">
                  <c:v>551.76041666666697</c:v>
                </c:pt>
                <c:pt idx="2304">
                  <c:v>552</c:v>
                </c:pt>
                <c:pt idx="2305">
                  <c:v>552.23958333333303</c:v>
                </c:pt>
                <c:pt idx="2306">
                  <c:v>552.47916666666697</c:v>
                </c:pt>
                <c:pt idx="2307">
                  <c:v>552.71875</c:v>
                </c:pt>
                <c:pt idx="2308">
                  <c:v>552.95833333333303</c:v>
                </c:pt>
                <c:pt idx="2309">
                  <c:v>553.19791666666697</c:v>
                </c:pt>
                <c:pt idx="2310">
                  <c:v>553.4375</c:v>
                </c:pt>
                <c:pt idx="2311">
                  <c:v>553.67708333333303</c:v>
                </c:pt>
                <c:pt idx="2312">
                  <c:v>553.91666666666697</c:v>
                </c:pt>
                <c:pt idx="2313">
                  <c:v>554.15625</c:v>
                </c:pt>
                <c:pt idx="2314">
                  <c:v>554.39583333333303</c:v>
                </c:pt>
                <c:pt idx="2315">
                  <c:v>554.63541666666697</c:v>
                </c:pt>
                <c:pt idx="2316">
                  <c:v>554.875</c:v>
                </c:pt>
                <c:pt idx="2317">
                  <c:v>555.11458333333303</c:v>
                </c:pt>
                <c:pt idx="2318">
                  <c:v>555.35416666666697</c:v>
                </c:pt>
                <c:pt idx="2319">
                  <c:v>555.59375</c:v>
                </c:pt>
                <c:pt idx="2320">
                  <c:v>555.83333333333303</c:v>
                </c:pt>
                <c:pt idx="2321">
                  <c:v>556.07291666666697</c:v>
                </c:pt>
                <c:pt idx="2322">
                  <c:v>556.3125</c:v>
                </c:pt>
                <c:pt idx="2323">
                  <c:v>556.55208333333303</c:v>
                </c:pt>
                <c:pt idx="2324">
                  <c:v>556.79166666666697</c:v>
                </c:pt>
                <c:pt idx="2325">
                  <c:v>557.03125</c:v>
                </c:pt>
                <c:pt idx="2326">
                  <c:v>557.27083333333303</c:v>
                </c:pt>
                <c:pt idx="2327">
                  <c:v>557.51041666666697</c:v>
                </c:pt>
                <c:pt idx="2328">
                  <c:v>557.75</c:v>
                </c:pt>
                <c:pt idx="2329">
                  <c:v>557.98958333333303</c:v>
                </c:pt>
                <c:pt idx="2330">
                  <c:v>558.22916666666697</c:v>
                </c:pt>
                <c:pt idx="2331">
                  <c:v>558.46875</c:v>
                </c:pt>
                <c:pt idx="2332">
                  <c:v>558.70833333333303</c:v>
                </c:pt>
                <c:pt idx="2333">
                  <c:v>558.94791666666697</c:v>
                </c:pt>
                <c:pt idx="2334">
                  <c:v>559.1875</c:v>
                </c:pt>
                <c:pt idx="2335">
                  <c:v>559.42708333333303</c:v>
                </c:pt>
                <c:pt idx="2336">
                  <c:v>559.66666666666697</c:v>
                </c:pt>
                <c:pt idx="2337">
                  <c:v>559.90625</c:v>
                </c:pt>
                <c:pt idx="2338">
                  <c:v>560.14583333333303</c:v>
                </c:pt>
                <c:pt idx="2339">
                  <c:v>560.38541666666697</c:v>
                </c:pt>
                <c:pt idx="2340">
                  <c:v>560.625</c:v>
                </c:pt>
                <c:pt idx="2341">
                  <c:v>560.86458333333303</c:v>
                </c:pt>
                <c:pt idx="2342">
                  <c:v>561.10416666666697</c:v>
                </c:pt>
                <c:pt idx="2343">
                  <c:v>561.34375</c:v>
                </c:pt>
                <c:pt idx="2344">
                  <c:v>561.58333333333303</c:v>
                </c:pt>
                <c:pt idx="2345">
                  <c:v>561.82291666666697</c:v>
                </c:pt>
                <c:pt idx="2346">
                  <c:v>562.0625</c:v>
                </c:pt>
                <c:pt idx="2347">
                  <c:v>562.30208333333303</c:v>
                </c:pt>
                <c:pt idx="2348">
                  <c:v>562.54166666666697</c:v>
                </c:pt>
                <c:pt idx="2349">
                  <c:v>562.78125</c:v>
                </c:pt>
                <c:pt idx="2350">
                  <c:v>563.02083333333303</c:v>
                </c:pt>
                <c:pt idx="2351">
                  <c:v>563.26041666666697</c:v>
                </c:pt>
                <c:pt idx="2352">
                  <c:v>563.5</c:v>
                </c:pt>
                <c:pt idx="2353">
                  <c:v>563.73958333333303</c:v>
                </c:pt>
                <c:pt idx="2354">
                  <c:v>563.97916666666697</c:v>
                </c:pt>
                <c:pt idx="2355">
                  <c:v>564.21875</c:v>
                </c:pt>
                <c:pt idx="2356">
                  <c:v>564.45833333333303</c:v>
                </c:pt>
                <c:pt idx="2357">
                  <c:v>564.69791666666697</c:v>
                </c:pt>
                <c:pt idx="2358">
                  <c:v>564.9375</c:v>
                </c:pt>
                <c:pt idx="2359">
                  <c:v>565.17708333333303</c:v>
                </c:pt>
                <c:pt idx="2360">
                  <c:v>565.41666666666697</c:v>
                </c:pt>
                <c:pt idx="2361">
                  <c:v>565.65625</c:v>
                </c:pt>
                <c:pt idx="2362">
                  <c:v>565.89583333333303</c:v>
                </c:pt>
                <c:pt idx="2363">
                  <c:v>566.13541666666697</c:v>
                </c:pt>
                <c:pt idx="2364">
                  <c:v>566.375</c:v>
                </c:pt>
                <c:pt idx="2365">
                  <c:v>566.61458333333303</c:v>
                </c:pt>
                <c:pt idx="2366">
                  <c:v>566.85416666666697</c:v>
                </c:pt>
                <c:pt idx="2367">
                  <c:v>567.09375</c:v>
                </c:pt>
                <c:pt idx="2368">
                  <c:v>567.33333333333303</c:v>
                </c:pt>
                <c:pt idx="2369">
                  <c:v>567.57291666666697</c:v>
                </c:pt>
                <c:pt idx="2370">
                  <c:v>567.8125</c:v>
                </c:pt>
                <c:pt idx="2371">
                  <c:v>568.05208333333303</c:v>
                </c:pt>
                <c:pt idx="2372">
                  <c:v>568.29166666666697</c:v>
                </c:pt>
                <c:pt idx="2373">
                  <c:v>568.53125</c:v>
                </c:pt>
                <c:pt idx="2374">
                  <c:v>568.77083333333303</c:v>
                </c:pt>
                <c:pt idx="2375">
                  <c:v>569.01041666666697</c:v>
                </c:pt>
                <c:pt idx="2376">
                  <c:v>569.25</c:v>
                </c:pt>
                <c:pt idx="2377">
                  <c:v>569.48958333333303</c:v>
                </c:pt>
                <c:pt idx="2378">
                  <c:v>569.72916666666697</c:v>
                </c:pt>
                <c:pt idx="2379">
                  <c:v>569.96875</c:v>
                </c:pt>
                <c:pt idx="2380">
                  <c:v>570.20833333333303</c:v>
                </c:pt>
                <c:pt idx="2381">
                  <c:v>570.44791666666697</c:v>
                </c:pt>
                <c:pt idx="2382">
                  <c:v>570.6875</c:v>
                </c:pt>
                <c:pt idx="2383">
                  <c:v>570.92708333333303</c:v>
                </c:pt>
                <c:pt idx="2384">
                  <c:v>571.16666666666697</c:v>
                </c:pt>
                <c:pt idx="2385">
                  <c:v>571.40625</c:v>
                </c:pt>
                <c:pt idx="2386">
                  <c:v>571.64583333333303</c:v>
                </c:pt>
                <c:pt idx="2387">
                  <c:v>571.88541666666697</c:v>
                </c:pt>
                <c:pt idx="2388">
                  <c:v>572.125</c:v>
                </c:pt>
                <c:pt idx="2389">
                  <c:v>572.36458333333303</c:v>
                </c:pt>
                <c:pt idx="2390">
                  <c:v>572.60416666666697</c:v>
                </c:pt>
                <c:pt idx="2391">
                  <c:v>572.84375</c:v>
                </c:pt>
                <c:pt idx="2392">
                  <c:v>573.08333333333303</c:v>
                </c:pt>
                <c:pt idx="2393">
                  <c:v>573.32291666666697</c:v>
                </c:pt>
                <c:pt idx="2394">
                  <c:v>573.5625</c:v>
                </c:pt>
                <c:pt idx="2395">
                  <c:v>573.80208333333303</c:v>
                </c:pt>
                <c:pt idx="2396">
                  <c:v>574.04166666666697</c:v>
                </c:pt>
                <c:pt idx="2397">
                  <c:v>574.28125</c:v>
                </c:pt>
                <c:pt idx="2398">
                  <c:v>574.52083333333303</c:v>
                </c:pt>
                <c:pt idx="2399">
                  <c:v>574.76041666666697</c:v>
                </c:pt>
                <c:pt idx="2400">
                  <c:v>575</c:v>
                </c:pt>
                <c:pt idx="2401">
                  <c:v>575.23958333333303</c:v>
                </c:pt>
                <c:pt idx="2402">
                  <c:v>575.47916666666697</c:v>
                </c:pt>
                <c:pt idx="2403">
                  <c:v>575.71875</c:v>
                </c:pt>
                <c:pt idx="2404">
                  <c:v>575.95833333333303</c:v>
                </c:pt>
                <c:pt idx="2405">
                  <c:v>576.19791666666697</c:v>
                </c:pt>
                <c:pt idx="2406">
                  <c:v>576.4375</c:v>
                </c:pt>
                <c:pt idx="2407">
                  <c:v>576.67708333333303</c:v>
                </c:pt>
                <c:pt idx="2408">
                  <c:v>576.91666666666697</c:v>
                </c:pt>
                <c:pt idx="2409">
                  <c:v>577.15625</c:v>
                </c:pt>
                <c:pt idx="2410">
                  <c:v>577.39583333333303</c:v>
                </c:pt>
                <c:pt idx="2411">
                  <c:v>577.63541666666697</c:v>
                </c:pt>
                <c:pt idx="2412">
                  <c:v>577.875</c:v>
                </c:pt>
                <c:pt idx="2413">
                  <c:v>578.11458333333303</c:v>
                </c:pt>
                <c:pt idx="2414">
                  <c:v>578.35416666666697</c:v>
                </c:pt>
                <c:pt idx="2415">
                  <c:v>578.59375</c:v>
                </c:pt>
                <c:pt idx="2416">
                  <c:v>578.83333333333303</c:v>
                </c:pt>
                <c:pt idx="2417">
                  <c:v>579.07291666666697</c:v>
                </c:pt>
                <c:pt idx="2418">
                  <c:v>579.3125</c:v>
                </c:pt>
                <c:pt idx="2419">
                  <c:v>579.55208333333303</c:v>
                </c:pt>
                <c:pt idx="2420">
                  <c:v>579.79166666666697</c:v>
                </c:pt>
                <c:pt idx="2421">
                  <c:v>580.03125</c:v>
                </c:pt>
                <c:pt idx="2422">
                  <c:v>580.27083333333303</c:v>
                </c:pt>
                <c:pt idx="2423">
                  <c:v>580.51041666666697</c:v>
                </c:pt>
                <c:pt idx="2424">
                  <c:v>580.75</c:v>
                </c:pt>
                <c:pt idx="2425">
                  <c:v>580.98958333333303</c:v>
                </c:pt>
                <c:pt idx="2426">
                  <c:v>581.22916666666697</c:v>
                </c:pt>
                <c:pt idx="2427">
                  <c:v>581.46875</c:v>
                </c:pt>
                <c:pt idx="2428">
                  <c:v>581.70833333333303</c:v>
                </c:pt>
                <c:pt idx="2429">
                  <c:v>581.94791666666697</c:v>
                </c:pt>
                <c:pt idx="2430">
                  <c:v>582.1875</c:v>
                </c:pt>
                <c:pt idx="2431">
                  <c:v>582.42708333333303</c:v>
                </c:pt>
                <c:pt idx="2432">
                  <c:v>582.66666666666697</c:v>
                </c:pt>
                <c:pt idx="2433">
                  <c:v>582.90625</c:v>
                </c:pt>
                <c:pt idx="2434">
                  <c:v>583.14583333333303</c:v>
                </c:pt>
                <c:pt idx="2435">
                  <c:v>583.38541666666697</c:v>
                </c:pt>
                <c:pt idx="2436">
                  <c:v>583.625</c:v>
                </c:pt>
                <c:pt idx="2437">
                  <c:v>583.86458333333303</c:v>
                </c:pt>
                <c:pt idx="2438">
                  <c:v>584.10416666666697</c:v>
                </c:pt>
                <c:pt idx="2439">
                  <c:v>584.34375</c:v>
                </c:pt>
                <c:pt idx="2440">
                  <c:v>584.58333333333303</c:v>
                </c:pt>
                <c:pt idx="2441">
                  <c:v>584.82291666666697</c:v>
                </c:pt>
                <c:pt idx="2442">
                  <c:v>585.0625</c:v>
                </c:pt>
                <c:pt idx="2443">
                  <c:v>585.30208333333303</c:v>
                </c:pt>
                <c:pt idx="2444">
                  <c:v>585.54166666666697</c:v>
                </c:pt>
                <c:pt idx="2445">
                  <c:v>585.78125</c:v>
                </c:pt>
                <c:pt idx="2446">
                  <c:v>586.02083333333303</c:v>
                </c:pt>
                <c:pt idx="2447">
                  <c:v>586.26041666666697</c:v>
                </c:pt>
                <c:pt idx="2448">
                  <c:v>586.5</c:v>
                </c:pt>
                <c:pt idx="2449">
                  <c:v>586.73958333333303</c:v>
                </c:pt>
                <c:pt idx="2450">
                  <c:v>586.97916666666697</c:v>
                </c:pt>
                <c:pt idx="2451">
                  <c:v>587.21875</c:v>
                </c:pt>
                <c:pt idx="2452">
                  <c:v>587.45833333333303</c:v>
                </c:pt>
                <c:pt idx="2453">
                  <c:v>587.69791666666697</c:v>
                </c:pt>
                <c:pt idx="2454">
                  <c:v>587.9375</c:v>
                </c:pt>
                <c:pt idx="2455">
                  <c:v>588.17708333333303</c:v>
                </c:pt>
                <c:pt idx="2456">
                  <c:v>588.41666666666697</c:v>
                </c:pt>
                <c:pt idx="2457">
                  <c:v>588.65625</c:v>
                </c:pt>
                <c:pt idx="2458">
                  <c:v>588.89583333333303</c:v>
                </c:pt>
                <c:pt idx="2459">
                  <c:v>589.13541666666697</c:v>
                </c:pt>
                <c:pt idx="2460">
                  <c:v>589.375</c:v>
                </c:pt>
                <c:pt idx="2461">
                  <c:v>589.61458333333303</c:v>
                </c:pt>
                <c:pt idx="2462">
                  <c:v>589.85416666666697</c:v>
                </c:pt>
                <c:pt idx="2463">
                  <c:v>590.09375</c:v>
                </c:pt>
                <c:pt idx="2464">
                  <c:v>590.33333333333303</c:v>
                </c:pt>
                <c:pt idx="2465">
                  <c:v>590.57291666666697</c:v>
                </c:pt>
                <c:pt idx="2466">
                  <c:v>590.8125</c:v>
                </c:pt>
                <c:pt idx="2467">
                  <c:v>591.05208333333303</c:v>
                </c:pt>
                <c:pt idx="2468">
                  <c:v>591.29166666666697</c:v>
                </c:pt>
                <c:pt idx="2469">
                  <c:v>591.53125</c:v>
                </c:pt>
                <c:pt idx="2470">
                  <c:v>591.77083333333303</c:v>
                </c:pt>
                <c:pt idx="2471">
                  <c:v>592.01041666666697</c:v>
                </c:pt>
                <c:pt idx="2472">
                  <c:v>592.25</c:v>
                </c:pt>
                <c:pt idx="2473">
                  <c:v>592.48958333333303</c:v>
                </c:pt>
                <c:pt idx="2474">
                  <c:v>592.72916666666697</c:v>
                </c:pt>
                <c:pt idx="2475">
                  <c:v>592.96875</c:v>
                </c:pt>
                <c:pt idx="2476">
                  <c:v>593.20833333333303</c:v>
                </c:pt>
                <c:pt idx="2477">
                  <c:v>593.44791666666697</c:v>
                </c:pt>
                <c:pt idx="2478">
                  <c:v>593.6875</c:v>
                </c:pt>
                <c:pt idx="2479">
                  <c:v>593.92708333333303</c:v>
                </c:pt>
                <c:pt idx="2480">
                  <c:v>594.16666666666697</c:v>
                </c:pt>
                <c:pt idx="2481">
                  <c:v>594.40625</c:v>
                </c:pt>
                <c:pt idx="2482">
                  <c:v>594.64583333333303</c:v>
                </c:pt>
                <c:pt idx="2483">
                  <c:v>594.88541666666697</c:v>
                </c:pt>
                <c:pt idx="2484">
                  <c:v>595.125</c:v>
                </c:pt>
                <c:pt idx="2485">
                  <c:v>595.36458333333303</c:v>
                </c:pt>
                <c:pt idx="2486">
                  <c:v>595.60416666666697</c:v>
                </c:pt>
                <c:pt idx="2487">
                  <c:v>595.84375</c:v>
                </c:pt>
                <c:pt idx="2488">
                  <c:v>596.08333333333303</c:v>
                </c:pt>
                <c:pt idx="2489">
                  <c:v>596.32291666666697</c:v>
                </c:pt>
                <c:pt idx="2490">
                  <c:v>596.5625</c:v>
                </c:pt>
                <c:pt idx="2491">
                  <c:v>596.80208333333303</c:v>
                </c:pt>
                <c:pt idx="2492">
                  <c:v>597.04166666666697</c:v>
                </c:pt>
                <c:pt idx="2493">
                  <c:v>597.28125</c:v>
                </c:pt>
                <c:pt idx="2494">
                  <c:v>597.52083333333303</c:v>
                </c:pt>
                <c:pt idx="2495">
                  <c:v>597.76041666666697</c:v>
                </c:pt>
                <c:pt idx="2496">
                  <c:v>598</c:v>
                </c:pt>
                <c:pt idx="2497">
                  <c:v>598.23958333333303</c:v>
                </c:pt>
                <c:pt idx="2498">
                  <c:v>598.47916666666697</c:v>
                </c:pt>
                <c:pt idx="2499">
                  <c:v>598.71875</c:v>
                </c:pt>
                <c:pt idx="2500">
                  <c:v>598.95833333333303</c:v>
                </c:pt>
                <c:pt idx="2501">
                  <c:v>599.19791666666697</c:v>
                </c:pt>
                <c:pt idx="2502">
                  <c:v>599.4375</c:v>
                </c:pt>
                <c:pt idx="2503">
                  <c:v>599.67708333333303</c:v>
                </c:pt>
                <c:pt idx="2504">
                  <c:v>599.91666666666697</c:v>
                </c:pt>
                <c:pt idx="2505">
                  <c:v>600.15625</c:v>
                </c:pt>
                <c:pt idx="2506">
                  <c:v>600.39583333333303</c:v>
                </c:pt>
                <c:pt idx="2507">
                  <c:v>600.63541666666697</c:v>
                </c:pt>
                <c:pt idx="2508">
                  <c:v>600.875</c:v>
                </c:pt>
                <c:pt idx="2509">
                  <c:v>601.11458333333303</c:v>
                </c:pt>
                <c:pt idx="2510">
                  <c:v>601.35416666666697</c:v>
                </c:pt>
                <c:pt idx="2511">
                  <c:v>601.59375</c:v>
                </c:pt>
                <c:pt idx="2512">
                  <c:v>601.83333333333303</c:v>
                </c:pt>
                <c:pt idx="2513">
                  <c:v>602.07291666666697</c:v>
                </c:pt>
                <c:pt idx="2514">
                  <c:v>602.3125</c:v>
                </c:pt>
                <c:pt idx="2515">
                  <c:v>602.55208333333303</c:v>
                </c:pt>
                <c:pt idx="2516">
                  <c:v>602.79166666666697</c:v>
                </c:pt>
                <c:pt idx="2517">
                  <c:v>603.03125</c:v>
                </c:pt>
                <c:pt idx="2518">
                  <c:v>603.27083333333303</c:v>
                </c:pt>
                <c:pt idx="2519">
                  <c:v>603.51041666666697</c:v>
                </c:pt>
                <c:pt idx="2520">
                  <c:v>603.75</c:v>
                </c:pt>
                <c:pt idx="2521">
                  <c:v>603.98958333333303</c:v>
                </c:pt>
                <c:pt idx="2522">
                  <c:v>604.22916666666697</c:v>
                </c:pt>
                <c:pt idx="2523">
                  <c:v>604.46875</c:v>
                </c:pt>
                <c:pt idx="2524">
                  <c:v>604.70833333333303</c:v>
                </c:pt>
                <c:pt idx="2525">
                  <c:v>604.94791666666697</c:v>
                </c:pt>
                <c:pt idx="2526">
                  <c:v>605.1875</c:v>
                </c:pt>
                <c:pt idx="2527">
                  <c:v>605.42708333333303</c:v>
                </c:pt>
                <c:pt idx="2528">
                  <c:v>605.66666666666697</c:v>
                </c:pt>
                <c:pt idx="2529">
                  <c:v>605.90625</c:v>
                </c:pt>
                <c:pt idx="2530">
                  <c:v>606.14583333333303</c:v>
                </c:pt>
                <c:pt idx="2531">
                  <c:v>606.38541666666697</c:v>
                </c:pt>
                <c:pt idx="2532">
                  <c:v>606.625</c:v>
                </c:pt>
                <c:pt idx="2533">
                  <c:v>606.86458333333303</c:v>
                </c:pt>
                <c:pt idx="2534">
                  <c:v>607.10416666666697</c:v>
                </c:pt>
                <c:pt idx="2535">
                  <c:v>607.34375</c:v>
                </c:pt>
                <c:pt idx="2536">
                  <c:v>607.58333333333303</c:v>
                </c:pt>
                <c:pt idx="2537">
                  <c:v>607.82291666666697</c:v>
                </c:pt>
                <c:pt idx="2538">
                  <c:v>608.0625</c:v>
                </c:pt>
                <c:pt idx="2539">
                  <c:v>608.30208333333303</c:v>
                </c:pt>
                <c:pt idx="2540">
                  <c:v>608.54166666666697</c:v>
                </c:pt>
                <c:pt idx="2541">
                  <c:v>608.78125</c:v>
                </c:pt>
                <c:pt idx="2542">
                  <c:v>609.02083333333303</c:v>
                </c:pt>
                <c:pt idx="2543">
                  <c:v>609.26041666666697</c:v>
                </c:pt>
                <c:pt idx="2544">
                  <c:v>609.5</c:v>
                </c:pt>
                <c:pt idx="2545">
                  <c:v>609.73958333333303</c:v>
                </c:pt>
                <c:pt idx="2546">
                  <c:v>609.97916666666697</c:v>
                </c:pt>
                <c:pt idx="2547">
                  <c:v>610.21875</c:v>
                </c:pt>
                <c:pt idx="2548">
                  <c:v>610.45833333333303</c:v>
                </c:pt>
                <c:pt idx="2549">
                  <c:v>610.69791666666697</c:v>
                </c:pt>
                <c:pt idx="2550">
                  <c:v>610.9375</c:v>
                </c:pt>
                <c:pt idx="2551">
                  <c:v>611.17708333333303</c:v>
                </c:pt>
                <c:pt idx="2552">
                  <c:v>611.41666666666697</c:v>
                </c:pt>
                <c:pt idx="2553">
                  <c:v>611.65625</c:v>
                </c:pt>
                <c:pt idx="2554">
                  <c:v>611.89583333333303</c:v>
                </c:pt>
                <c:pt idx="2555">
                  <c:v>612.13541666666697</c:v>
                </c:pt>
                <c:pt idx="2556">
                  <c:v>612.375</c:v>
                </c:pt>
                <c:pt idx="2557">
                  <c:v>612.61458333333303</c:v>
                </c:pt>
                <c:pt idx="2558">
                  <c:v>612.85416666666697</c:v>
                </c:pt>
                <c:pt idx="2559">
                  <c:v>613.09375</c:v>
                </c:pt>
                <c:pt idx="2560">
                  <c:v>613.33333333333303</c:v>
                </c:pt>
                <c:pt idx="2561">
                  <c:v>613.57291666666697</c:v>
                </c:pt>
                <c:pt idx="2562">
                  <c:v>613.8125</c:v>
                </c:pt>
                <c:pt idx="2563">
                  <c:v>614.05208333333303</c:v>
                </c:pt>
                <c:pt idx="2564">
                  <c:v>614.29166666666697</c:v>
                </c:pt>
                <c:pt idx="2565">
                  <c:v>614.53125</c:v>
                </c:pt>
                <c:pt idx="2566">
                  <c:v>614.77083333333303</c:v>
                </c:pt>
                <c:pt idx="2567">
                  <c:v>615.01041666666697</c:v>
                </c:pt>
                <c:pt idx="2568">
                  <c:v>615.25</c:v>
                </c:pt>
                <c:pt idx="2569">
                  <c:v>615.48958333333303</c:v>
                </c:pt>
                <c:pt idx="2570">
                  <c:v>615.72916666666697</c:v>
                </c:pt>
                <c:pt idx="2571">
                  <c:v>615.96875</c:v>
                </c:pt>
                <c:pt idx="2572">
                  <c:v>616.20833333333303</c:v>
                </c:pt>
                <c:pt idx="2573">
                  <c:v>616.44791666666697</c:v>
                </c:pt>
                <c:pt idx="2574">
                  <c:v>616.6875</c:v>
                </c:pt>
                <c:pt idx="2575">
                  <c:v>616.92708333333303</c:v>
                </c:pt>
                <c:pt idx="2576">
                  <c:v>617.16666666666697</c:v>
                </c:pt>
                <c:pt idx="2577">
                  <c:v>617.40625</c:v>
                </c:pt>
                <c:pt idx="2578">
                  <c:v>617.64583333333303</c:v>
                </c:pt>
                <c:pt idx="2579">
                  <c:v>617.88541666666697</c:v>
                </c:pt>
                <c:pt idx="2580">
                  <c:v>618.125</c:v>
                </c:pt>
                <c:pt idx="2581">
                  <c:v>618.36458333333303</c:v>
                </c:pt>
                <c:pt idx="2582">
                  <c:v>618.60416666666697</c:v>
                </c:pt>
                <c:pt idx="2583">
                  <c:v>618.84375</c:v>
                </c:pt>
                <c:pt idx="2584">
                  <c:v>619.08333333333303</c:v>
                </c:pt>
                <c:pt idx="2585">
                  <c:v>619.32291666666697</c:v>
                </c:pt>
                <c:pt idx="2586">
                  <c:v>619.5625</c:v>
                </c:pt>
                <c:pt idx="2587">
                  <c:v>619.80208333333303</c:v>
                </c:pt>
                <c:pt idx="2588">
                  <c:v>620.04166666666697</c:v>
                </c:pt>
                <c:pt idx="2589">
                  <c:v>620.28125</c:v>
                </c:pt>
                <c:pt idx="2590">
                  <c:v>620.52083333333303</c:v>
                </c:pt>
                <c:pt idx="2591">
                  <c:v>620.76041666666697</c:v>
                </c:pt>
                <c:pt idx="2592">
                  <c:v>621</c:v>
                </c:pt>
                <c:pt idx="2593">
                  <c:v>621.23958333333303</c:v>
                </c:pt>
                <c:pt idx="2594">
                  <c:v>621.47916666666697</c:v>
                </c:pt>
                <c:pt idx="2595">
                  <c:v>621.71875</c:v>
                </c:pt>
                <c:pt idx="2596">
                  <c:v>621.95833333333303</c:v>
                </c:pt>
                <c:pt idx="2597">
                  <c:v>622.19791666666697</c:v>
                </c:pt>
                <c:pt idx="2598">
                  <c:v>622.4375</c:v>
                </c:pt>
                <c:pt idx="2599">
                  <c:v>622.67708333333303</c:v>
                </c:pt>
                <c:pt idx="2600">
                  <c:v>622.91666666666697</c:v>
                </c:pt>
                <c:pt idx="2601">
                  <c:v>623.15625</c:v>
                </c:pt>
                <c:pt idx="2602">
                  <c:v>623.39583333333303</c:v>
                </c:pt>
                <c:pt idx="2603">
                  <c:v>623.63541666666697</c:v>
                </c:pt>
                <c:pt idx="2604">
                  <c:v>623.875</c:v>
                </c:pt>
                <c:pt idx="2605">
                  <c:v>624.11458333333303</c:v>
                </c:pt>
                <c:pt idx="2606">
                  <c:v>624.35416666666697</c:v>
                </c:pt>
                <c:pt idx="2607">
                  <c:v>624.59375</c:v>
                </c:pt>
                <c:pt idx="2608">
                  <c:v>624.83333333333303</c:v>
                </c:pt>
                <c:pt idx="2609">
                  <c:v>625.07291666666697</c:v>
                </c:pt>
                <c:pt idx="2610">
                  <c:v>625.3125</c:v>
                </c:pt>
                <c:pt idx="2611">
                  <c:v>625.55208333333303</c:v>
                </c:pt>
                <c:pt idx="2612">
                  <c:v>625.79166666666697</c:v>
                </c:pt>
                <c:pt idx="2613">
                  <c:v>626.03125</c:v>
                </c:pt>
                <c:pt idx="2614">
                  <c:v>626.27083333333303</c:v>
                </c:pt>
                <c:pt idx="2615">
                  <c:v>626.51041666666697</c:v>
                </c:pt>
                <c:pt idx="2616">
                  <c:v>626.75</c:v>
                </c:pt>
                <c:pt idx="2617">
                  <c:v>626.98958333333303</c:v>
                </c:pt>
                <c:pt idx="2618">
                  <c:v>627.22916666666697</c:v>
                </c:pt>
                <c:pt idx="2619">
                  <c:v>627.46875</c:v>
                </c:pt>
                <c:pt idx="2620">
                  <c:v>627.70833333333303</c:v>
                </c:pt>
                <c:pt idx="2621">
                  <c:v>627.94791666666697</c:v>
                </c:pt>
                <c:pt idx="2622">
                  <c:v>628.1875</c:v>
                </c:pt>
                <c:pt idx="2623">
                  <c:v>628.42708333333303</c:v>
                </c:pt>
                <c:pt idx="2624">
                  <c:v>628.66666666666697</c:v>
                </c:pt>
                <c:pt idx="2625">
                  <c:v>628.90625</c:v>
                </c:pt>
                <c:pt idx="2626">
                  <c:v>629.14583333333303</c:v>
                </c:pt>
                <c:pt idx="2627">
                  <c:v>629.38541666666697</c:v>
                </c:pt>
                <c:pt idx="2628">
                  <c:v>629.625</c:v>
                </c:pt>
                <c:pt idx="2629">
                  <c:v>629.86458333333303</c:v>
                </c:pt>
                <c:pt idx="2630">
                  <c:v>630.10416666666697</c:v>
                </c:pt>
                <c:pt idx="2631">
                  <c:v>630.34375</c:v>
                </c:pt>
                <c:pt idx="2632">
                  <c:v>630.58333333333303</c:v>
                </c:pt>
                <c:pt idx="2633">
                  <c:v>630.82291666666697</c:v>
                </c:pt>
                <c:pt idx="2634">
                  <c:v>631.0625</c:v>
                </c:pt>
                <c:pt idx="2635">
                  <c:v>631.30208333333303</c:v>
                </c:pt>
                <c:pt idx="2636">
                  <c:v>631.54166666666697</c:v>
                </c:pt>
                <c:pt idx="2637">
                  <c:v>631.78125</c:v>
                </c:pt>
                <c:pt idx="2638">
                  <c:v>632.02083333333303</c:v>
                </c:pt>
                <c:pt idx="2639">
                  <c:v>632.26041666666697</c:v>
                </c:pt>
                <c:pt idx="2640">
                  <c:v>632.5</c:v>
                </c:pt>
                <c:pt idx="2641">
                  <c:v>632.73958333333303</c:v>
                </c:pt>
                <c:pt idx="2642">
                  <c:v>632.97916666666697</c:v>
                </c:pt>
                <c:pt idx="2643">
                  <c:v>633.21875</c:v>
                </c:pt>
                <c:pt idx="2644">
                  <c:v>633.45833333333303</c:v>
                </c:pt>
                <c:pt idx="2645">
                  <c:v>633.69791666666697</c:v>
                </c:pt>
                <c:pt idx="2646">
                  <c:v>633.9375</c:v>
                </c:pt>
                <c:pt idx="2647">
                  <c:v>634.17708333333303</c:v>
                </c:pt>
                <c:pt idx="2648">
                  <c:v>634.41666666666697</c:v>
                </c:pt>
                <c:pt idx="2649">
                  <c:v>634.65625</c:v>
                </c:pt>
                <c:pt idx="2650">
                  <c:v>634.89583333333303</c:v>
                </c:pt>
                <c:pt idx="2651">
                  <c:v>635.13541666666697</c:v>
                </c:pt>
                <c:pt idx="2652">
                  <c:v>635.375</c:v>
                </c:pt>
                <c:pt idx="2653">
                  <c:v>635.61458333333303</c:v>
                </c:pt>
                <c:pt idx="2654">
                  <c:v>635.85416666666697</c:v>
                </c:pt>
                <c:pt idx="2655">
                  <c:v>636.09375</c:v>
                </c:pt>
                <c:pt idx="2656">
                  <c:v>636.33333333333303</c:v>
                </c:pt>
                <c:pt idx="2657">
                  <c:v>636.57291666666697</c:v>
                </c:pt>
                <c:pt idx="2658">
                  <c:v>636.8125</c:v>
                </c:pt>
                <c:pt idx="2659">
                  <c:v>637.05208333333303</c:v>
                </c:pt>
                <c:pt idx="2660">
                  <c:v>637.29166666666697</c:v>
                </c:pt>
                <c:pt idx="2661">
                  <c:v>637.53125</c:v>
                </c:pt>
                <c:pt idx="2662">
                  <c:v>637.77083333333303</c:v>
                </c:pt>
                <c:pt idx="2663">
                  <c:v>638.01041666666697</c:v>
                </c:pt>
                <c:pt idx="2664">
                  <c:v>638.25</c:v>
                </c:pt>
                <c:pt idx="2665">
                  <c:v>638.48958333333303</c:v>
                </c:pt>
                <c:pt idx="2666">
                  <c:v>638.72916666666697</c:v>
                </c:pt>
                <c:pt idx="2667">
                  <c:v>638.96875</c:v>
                </c:pt>
                <c:pt idx="2668">
                  <c:v>639.20833333333303</c:v>
                </c:pt>
                <c:pt idx="2669">
                  <c:v>639.44791666666697</c:v>
                </c:pt>
                <c:pt idx="2670">
                  <c:v>639.6875</c:v>
                </c:pt>
                <c:pt idx="2671">
                  <c:v>639.92708333333303</c:v>
                </c:pt>
                <c:pt idx="2672">
                  <c:v>640.16666666666697</c:v>
                </c:pt>
                <c:pt idx="2673">
                  <c:v>640.40625</c:v>
                </c:pt>
                <c:pt idx="2674">
                  <c:v>640.64583333333303</c:v>
                </c:pt>
                <c:pt idx="2675">
                  <c:v>640.88541666666697</c:v>
                </c:pt>
                <c:pt idx="2676">
                  <c:v>641.125</c:v>
                </c:pt>
                <c:pt idx="2677">
                  <c:v>641.36458333333303</c:v>
                </c:pt>
                <c:pt idx="2678">
                  <c:v>641.60416666666697</c:v>
                </c:pt>
                <c:pt idx="2679">
                  <c:v>641.84375</c:v>
                </c:pt>
                <c:pt idx="2680">
                  <c:v>642.08333333333303</c:v>
                </c:pt>
                <c:pt idx="2681">
                  <c:v>642.32291666666697</c:v>
                </c:pt>
                <c:pt idx="2682">
                  <c:v>642.5625</c:v>
                </c:pt>
                <c:pt idx="2683">
                  <c:v>642.80208333333303</c:v>
                </c:pt>
                <c:pt idx="2684">
                  <c:v>643.04166666666697</c:v>
                </c:pt>
                <c:pt idx="2685">
                  <c:v>643.28125</c:v>
                </c:pt>
                <c:pt idx="2686">
                  <c:v>643.52083333333303</c:v>
                </c:pt>
                <c:pt idx="2687">
                  <c:v>643.76041666666697</c:v>
                </c:pt>
                <c:pt idx="2688">
                  <c:v>644</c:v>
                </c:pt>
                <c:pt idx="2689">
                  <c:v>644.23958333333303</c:v>
                </c:pt>
                <c:pt idx="2690">
                  <c:v>644.47916666666697</c:v>
                </c:pt>
                <c:pt idx="2691">
                  <c:v>644.71875</c:v>
                </c:pt>
                <c:pt idx="2692">
                  <c:v>644.95833333333303</c:v>
                </c:pt>
                <c:pt idx="2693">
                  <c:v>645.19791666666697</c:v>
                </c:pt>
                <c:pt idx="2694">
                  <c:v>645.4375</c:v>
                </c:pt>
                <c:pt idx="2695">
                  <c:v>645.67708333333303</c:v>
                </c:pt>
                <c:pt idx="2696">
                  <c:v>645.91666666666697</c:v>
                </c:pt>
                <c:pt idx="2697">
                  <c:v>646.15625</c:v>
                </c:pt>
                <c:pt idx="2698">
                  <c:v>646.39583333333303</c:v>
                </c:pt>
                <c:pt idx="2699">
                  <c:v>646.63541666666697</c:v>
                </c:pt>
                <c:pt idx="2700">
                  <c:v>646.875</c:v>
                </c:pt>
                <c:pt idx="2701">
                  <c:v>647.11458333333303</c:v>
                </c:pt>
                <c:pt idx="2702">
                  <c:v>647.35416666666697</c:v>
                </c:pt>
                <c:pt idx="2703">
                  <c:v>647.59375</c:v>
                </c:pt>
                <c:pt idx="2704">
                  <c:v>647.83333333333303</c:v>
                </c:pt>
                <c:pt idx="2705">
                  <c:v>648.07291666666697</c:v>
                </c:pt>
                <c:pt idx="2706">
                  <c:v>648.3125</c:v>
                </c:pt>
                <c:pt idx="2707">
                  <c:v>648.55208333333303</c:v>
                </c:pt>
                <c:pt idx="2708">
                  <c:v>648.79166666666697</c:v>
                </c:pt>
                <c:pt idx="2709">
                  <c:v>649.03125</c:v>
                </c:pt>
                <c:pt idx="2710">
                  <c:v>649.27083333333303</c:v>
                </c:pt>
                <c:pt idx="2711">
                  <c:v>649.51041666666697</c:v>
                </c:pt>
                <c:pt idx="2712">
                  <c:v>649.75</c:v>
                </c:pt>
                <c:pt idx="2713">
                  <c:v>649.98958333333303</c:v>
                </c:pt>
                <c:pt idx="2714">
                  <c:v>650.22916666666697</c:v>
                </c:pt>
                <c:pt idx="2715">
                  <c:v>650.46875</c:v>
                </c:pt>
                <c:pt idx="2716">
                  <c:v>650.70833333333303</c:v>
                </c:pt>
                <c:pt idx="2717">
                  <c:v>650.94791666666697</c:v>
                </c:pt>
                <c:pt idx="2718">
                  <c:v>651.1875</c:v>
                </c:pt>
                <c:pt idx="2719">
                  <c:v>651.42708333333303</c:v>
                </c:pt>
                <c:pt idx="2720">
                  <c:v>651.66666666666697</c:v>
                </c:pt>
                <c:pt idx="2721">
                  <c:v>651.90625</c:v>
                </c:pt>
                <c:pt idx="2722">
                  <c:v>652.14583333333303</c:v>
                </c:pt>
                <c:pt idx="2723">
                  <c:v>652.38541666666697</c:v>
                </c:pt>
                <c:pt idx="2724">
                  <c:v>652.625</c:v>
                </c:pt>
                <c:pt idx="2725">
                  <c:v>652.86458333333303</c:v>
                </c:pt>
                <c:pt idx="2726">
                  <c:v>653.10416666666697</c:v>
                </c:pt>
                <c:pt idx="2727">
                  <c:v>653.34375</c:v>
                </c:pt>
                <c:pt idx="2728">
                  <c:v>653.58333333333303</c:v>
                </c:pt>
                <c:pt idx="2729">
                  <c:v>653.82291666666697</c:v>
                </c:pt>
                <c:pt idx="2730">
                  <c:v>654.0625</c:v>
                </c:pt>
                <c:pt idx="2731">
                  <c:v>654.30208333333303</c:v>
                </c:pt>
                <c:pt idx="2732">
                  <c:v>654.54166666666697</c:v>
                </c:pt>
                <c:pt idx="2733">
                  <c:v>654.78125</c:v>
                </c:pt>
                <c:pt idx="2734">
                  <c:v>655.02083333333303</c:v>
                </c:pt>
                <c:pt idx="2735">
                  <c:v>655.26041666666697</c:v>
                </c:pt>
                <c:pt idx="2736">
                  <c:v>655.5</c:v>
                </c:pt>
                <c:pt idx="2737">
                  <c:v>655.73958333333303</c:v>
                </c:pt>
                <c:pt idx="2738">
                  <c:v>655.97916666666697</c:v>
                </c:pt>
                <c:pt idx="2739">
                  <c:v>656.21875</c:v>
                </c:pt>
                <c:pt idx="2740">
                  <c:v>656.45833333333303</c:v>
                </c:pt>
                <c:pt idx="2741">
                  <c:v>656.69791666666697</c:v>
                </c:pt>
                <c:pt idx="2742">
                  <c:v>656.9375</c:v>
                </c:pt>
                <c:pt idx="2743">
                  <c:v>657.17708333333303</c:v>
                </c:pt>
                <c:pt idx="2744">
                  <c:v>657.41666666666697</c:v>
                </c:pt>
                <c:pt idx="2745">
                  <c:v>657.65625</c:v>
                </c:pt>
                <c:pt idx="2746">
                  <c:v>657.89583333333303</c:v>
                </c:pt>
                <c:pt idx="2747">
                  <c:v>658.13541666666697</c:v>
                </c:pt>
                <c:pt idx="2748">
                  <c:v>658.375</c:v>
                </c:pt>
                <c:pt idx="2749">
                  <c:v>658.61458333333303</c:v>
                </c:pt>
                <c:pt idx="2750">
                  <c:v>658.85416666666697</c:v>
                </c:pt>
                <c:pt idx="2751">
                  <c:v>659.09375</c:v>
                </c:pt>
                <c:pt idx="2752">
                  <c:v>659.33333333333303</c:v>
                </c:pt>
                <c:pt idx="2753">
                  <c:v>659.57291666666697</c:v>
                </c:pt>
                <c:pt idx="2754">
                  <c:v>659.8125</c:v>
                </c:pt>
                <c:pt idx="2755">
                  <c:v>660.05208333333303</c:v>
                </c:pt>
                <c:pt idx="2756">
                  <c:v>660.29166666666697</c:v>
                </c:pt>
                <c:pt idx="2757">
                  <c:v>660.53125</c:v>
                </c:pt>
                <c:pt idx="2758">
                  <c:v>660.77083333333303</c:v>
                </c:pt>
                <c:pt idx="2759">
                  <c:v>661.01041666666697</c:v>
                </c:pt>
                <c:pt idx="2760">
                  <c:v>661.25</c:v>
                </c:pt>
                <c:pt idx="2761">
                  <c:v>661.48958333333303</c:v>
                </c:pt>
                <c:pt idx="2762">
                  <c:v>661.72916666666697</c:v>
                </c:pt>
                <c:pt idx="2763">
                  <c:v>661.96875</c:v>
                </c:pt>
                <c:pt idx="2764">
                  <c:v>662.20833333333303</c:v>
                </c:pt>
                <c:pt idx="2765">
                  <c:v>662.44791666666697</c:v>
                </c:pt>
                <c:pt idx="2766">
                  <c:v>662.6875</c:v>
                </c:pt>
                <c:pt idx="2767">
                  <c:v>662.92708333333303</c:v>
                </c:pt>
                <c:pt idx="2768">
                  <c:v>663.16666666666697</c:v>
                </c:pt>
                <c:pt idx="2769">
                  <c:v>663.40625</c:v>
                </c:pt>
                <c:pt idx="2770">
                  <c:v>663.64583333333303</c:v>
                </c:pt>
                <c:pt idx="2771">
                  <c:v>663.88541666666697</c:v>
                </c:pt>
                <c:pt idx="2772">
                  <c:v>664.125</c:v>
                </c:pt>
                <c:pt idx="2773">
                  <c:v>664.36458333333303</c:v>
                </c:pt>
                <c:pt idx="2774">
                  <c:v>664.60416666666697</c:v>
                </c:pt>
                <c:pt idx="2775">
                  <c:v>664.84375</c:v>
                </c:pt>
                <c:pt idx="2776">
                  <c:v>665.08333333333303</c:v>
                </c:pt>
                <c:pt idx="2777">
                  <c:v>665.32291666666697</c:v>
                </c:pt>
                <c:pt idx="2778">
                  <c:v>665.5625</c:v>
                </c:pt>
                <c:pt idx="2779">
                  <c:v>665.80208333333303</c:v>
                </c:pt>
                <c:pt idx="2780">
                  <c:v>666.04166666666697</c:v>
                </c:pt>
                <c:pt idx="2781">
                  <c:v>666.28125</c:v>
                </c:pt>
                <c:pt idx="2782">
                  <c:v>666.52083333333303</c:v>
                </c:pt>
                <c:pt idx="2783">
                  <c:v>666.76041666666697</c:v>
                </c:pt>
                <c:pt idx="2784">
                  <c:v>667</c:v>
                </c:pt>
                <c:pt idx="2785">
                  <c:v>667.23958333333303</c:v>
                </c:pt>
                <c:pt idx="2786">
                  <c:v>667.47916666666697</c:v>
                </c:pt>
                <c:pt idx="2787">
                  <c:v>667.71875</c:v>
                </c:pt>
                <c:pt idx="2788">
                  <c:v>667.95833333333303</c:v>
                </c:pt>
                <c:pt idx="2789">
                  <c:v>668.19791666666697</c:v>
                </c:pt>
                <c:pt idx="2790">
                  <c:v>668.4375</c:v>
                </c:pt>
                <c:pt idx="2791">
                  <c:v>668.67708333333303</c:v>
                </c:pt>
                <c:pt idx="2792">
                  <c:v>668.91666666666697</c:v>
                </c:pt>
                <c:pt idx="2793">
                  <c:v>669.15625</c:v>
                </c:pt>
                <c:pt idx="2794">
                  <c:v>669.39583333333303</c:v>
                </c:pt>
                <c:pt idx="2795">
                  <c:v>669.63541666666697</c:v>
                </c:pt>
                <c:pt idx="2796">
                  <c:v>669.875</c:v>
                </c:pt>
                <c:pt idx="2797">
                  <c:v>670.11458333333303</c:v>
                </c:pt>
                <c:pt idx="2798">
                  <c:v>670.35416666666697</c:v>
                </c:pt>
                <c:pt idx="2799">
                  <c:v>670.59375</c:v>
                </c:pt>
                <c:pt idx="2800">
                  <c:v>670.83333333333303</c:v>
                </c:pt>
                <c:pt idx="2801">
                  <c:v>671.07291666666697</c:v>
                </c:pt>
                <c:pt idx="2802">
                  <c:v>671.3125</c:v>
                </c:pt>
                <c:pt idx="2803">
                  <c:v>671.55208333333303</c:v>
                </c:pt>
                <c:pt idx="2804">
                  <c:v>671.79166666666697</c:v>
                </c:pt>
                <c:pt idx="2805">
                  <c:v>672.03125</c:v>
                </c:pt>
                <c:pt idx="2806">
                  <c:v>672.27083333333303</c:v>
                </c:pt>
                <c:pt idx="2807">
                  <c:v>672.51041666666697</c:v>
                </c:pt>
                <c:pt idx="2808">
                  <c:v>672.75</c:v>
                </c:pt>
                <c:pt idx="2809">
                  <c:v>672.98958333333303</c:v>
                </c:pt>
                <c:pt idx="2810">
                  <c:v>673.22916666666697</c:v>
                </c:pt>
                <c:pt idx="2811">
                  <c:v>673.46875</c:v>
                </c:pt>
                <c:pt idx="2812">
                  <c:v>673.70833333333303</c:v>
                </c:pt>
                <c:pt idx="2813">
                  <c:v>673.94791666666697</c:v>
                </c:pt>
                <c:pt idx="2814">
                  <c:v>674.1875</c:v>
                </c:pt>
                <c:pt idx="2815">
                  <c:v>674.42708333333303</c:v>
                </c:pt>
                <c:pt idx="2816">
                  <c:v>674.66666666666697</c:v>
                </c:pt>
                <c:pt idx="2817">
                  <c:v>674.90625</c:v>
                </c:pt>
                <c:pt idx="2818">
                  <c:v>675.14583333333303</c:v>
                </c:pt>
                <c:pt idx="2819">
                  <c:v>675.38541666666697</c:v>
                </c:pt>
                <c:pt idx="2820">
                  <c:v>675.625</c:v>
                </c:pt>
                <c:pt idx="2821">
                  <c:v>675.86458333333303</c:v>
                </c:pt>
                <c:pt idx="2822">
                  <c:v>676.10416666666697</c:v>
                </c:pt>
                <c:pt idx="2823">
                  <c:v>676.34375</c:v>
                </c:pt>
                <c:pt idx="2824">
                  <c:v>676.58333333333303</c:v>
                </c:pt>
                <c:pt idx="2825">
                  <c:v>676.82291666666697</c:v>
                </c:pt>
                <c:pt idx="2826">
                  <c:v>677.0625</c:v>
                </c:pt>
                <c:pt idx="2827">
                  <c:v>677.30208333333303</c:v>
                </c:pt>
                <c:pt idx="2828">
                  <c:v>677.54166666666697</c:v>
                </c:pt>
                <c:pt idx="2829">
                  <c:v>677.78125</c:v>
                </c:pt>
                <c:pt idx="2830">
                  <c:v>678.02083333333303</c:v>
                </c:pt>
                <c:pt idx="2831">
                  <c:v>678.26041666666697</c:v>
                </c:pt>
                <c:pt idx="2832">
                  <c:v>678.5</c:v>
                </c:pt>
                <c:pt idx="2833">
                  <c:v>678.73958333333303</c:v>
                </c:pt>
                <c:pt idx="2834">
                  <c:v>678.97916666666697</c:v>
                </c:pt>
                <c:pt idx="2835">
                  <c:v>679.21875</c:v>
                </c:pt>
                <c:pt idx="2836">
                  <c:v>679.45833333333303</c:v>
                </c:pt>
                <c:pt idx="2837">
                  <c:v>679.69791666666697</c:v>
                </c:pt>
                <c:pt idx="2838">
                  <c:v>679.9375</c:v>
                </c:pt>
                <c:pt idx="2839">
                  <c:v>680.17708333333303</c:v>
                </c:pt>
                <c:pt idx="2840">
                  <c:v>680.41666666666697</c:v>
                </c:pt>
                <c:pt idx="2841">
                  <c:v>680.65625</c:v>
                </c:pt>
                <c:pt idx="2842">
                  <c:v>680.89583333333303</c:v>
                </c:pt>
                <c:pt idx="2843">
                  <c:v>681.13541666666697</c:v>
                </c:pt>
                <c:pt idx="2844">
                  <c:v>681.375</c:v>
                </c:pt>
                <c:pt idx="2845">
                  <c:v>681.61458333333303</c:v>
                </c:pt>
                <c:pt idx="2846">
                  <c:v>681.85416666666697</c:v>
                </c:pt>
                <c:pt idx="2847">
                  <c:v>682.09375</c:v>
                </c:pt>
                <c:pt idx="2848">
                  <c:v>682.33333333333303</c:v>
                </c:pt>
                <c:pt idx="2849">
                  <c:v>682.57291666666697</c:v>
                </c:pt>
                <c:pt idx="2850">
                  <c:v>682.8125</c:v>
                </c:pt>
                <c:pt idx="2851">
                  <c:v>683.05208333333303</c:v>
                </c:pt>
                <c:pt idx="2852">
                  <c:v>683.29166666666697</c:v>
                </c:pt>
                <c:pt idx="2853">
                  <c:v>683.53125</c:v>
                </c:pt>
                <c:pt idx="2854">
                  <c:v>683.77083333333303</c:v>
                </c:pt>
                <c:pt idx="2855">
                  <c:v>684.01041666666697</c:v>
                </c:pt>
                <c:pt idx="2856">
                  <c:v>684.25</c:v>
                </c:pt>
                <c:pt idx="2857">
                  <c:v>684.48958333333303</c:v>
                </c:pt>
                <c:pt idx="2858">
                  <c:v>684.72916666666697</c:v>
                </c:pt>
                <c:pt idx="2859">
                  <c:v>684.96875</c:v>
                </c:pt>
                <c:pt idx="2860">
                  <c:v>685.20833333333303</c:v>
                </c:pt>
                <c:pt idx="2861">
                  <c:v>685.44791666666697</c:v>
                </c:pt>
                <c:pt idx="2862">
                  <c:v>685.6875</c:v>
                </c:pt>
                <c:pt idx="2863">
                  <c:v>685.92708333333303</c:v>
                </c:pt>
                <c:pt idx="2864">
                  <c:v>686.16666666666697</c:v>
                </c:pt>
                <c:pt idx="2865">
                  <c:v>686.40625</c:v>
                </c:pt>
                <c:pt idx="2866">
                  <c:v>686.64583333333303</c:v>
                </c:pt>
                <c:pt idx="2867">
                  <c:v>686.88541666666697</c:v>
                </c:pt>
                <c:pt idx="2868">
                  <c:v>687.125</c:v>
                </c:pt>
                <c:pt idx="2869">
                  <c:v>687.36458333333303</c:v>
                </c:pt>
                <c:pt idx="2870">
                  <c:v>687.60416666666697</c:v>
                </c:pt>
                <c:pt idx="2871">
                  <c:v>687.84375</c:v>
                </c:pt>
                <c:pt idx="2872">
                  <c:v>688.08333333333303</c:v>
                </c:pt>
                <c:pt idx="2873">
                  <c:v>688.32291666666697</c:v>
                </c:pt>
                <c:pt idx="2874">
                  <c:v>688.5625</c:v>
                </c:pt>
                <c:pt idx="2875">
                  <c:v>688.80208333333303</c:v>
                </c:pt>
                <c:pt idx="2876">
                  <c:v>689.04166666666697</c:v>
                </c:pt>
                <c:pt idx="2877">
                  <c:v>689.28125</c:v>
                </c:pt>
                <c:pt idx="2878">
                  <c:v>689.52083333333303</c:v>
                </c:pt>
                <c:pt idx="2879">
                  <c:v>689.76041666666697</c:v>
                </c:pt>
                <c:pt idx="2880">
                  <c:v>690</c:v>
                </c:pt>
                <c:pt idx="2881">
                  <c:v>690.23958333333303</c:v>
                </c:pt>
                <c:pt idx="2882">
                  <c:v>690.47916666666697</c:v>
                </c:pt>
                <c:pt idx="2883">
                  <c:v>690.71875</c:v>
                </c:pt>
                <c:pt idx="2884">
                  <c:v>690.95833333333303</c:v>
                </c:pt>
                <c:pt idx="2885">
                  <c:v>691.19791666666697</c:v>
                </c:pt>
                <c:pt idx="2886">
                  <c:v>691.4375</c:v>
                </c:pt>
                <c:pt idx="2887">
                  <c:v>691.67708333333303</c:v>
                </c:pt>
                <c:pt idx="2888">
                  <c:v>691.91666666666697</c:v>
                </c:pt>
                <c:pt idx="2889">
                  <c:v>692.15625</c:v>
                </c:pt>
                <c:pt idx="2890">
                  <c:v>692.39583333333303</c:v>
                </c:pt>
                <c:pt idx="2891">
                  <c:v>692.63541666666697</c:v>
                </c:pt>
                <c:pt idx="2892">
                  <c:v>692.875</c:v>
                </c:pt>
                <c:pt idx="2893">
                  <c:v>693.11458333333303</c:v>
                </c:pt>
                <c:pt idx="2894">
                  <c:v>693.35416666666697</c:v>
                </c:pt>
                <c:pt idx="2895">
                  <c:v>693.59375</c:v>
                </c:pt>
                <c:pt idx="2896">
                  <c:v>693.83333333333303</c:v>
                </c:pt>
                <c:pt idx="2897">
                  <c:v>694.07291666666697</c:v>
                </c:pt>
                <c:pt idx="2898">
                  <c:v>694.3125</c:v>
                </c:pt>
                <c:pt idx="2899">
                  <c:v>694.55208333333303</c:v>
                </c:pt>
                <c:pt idx="2900">
                  <c:v>694.79166666666697</c:v>
                </c:pt>
                <c:pt idx="2901">
                  <c:v>695.03125</c:v>
                </c:pt>
                <c:pt idx="2902">
                  <c:v>695.27083333333303</c:v>
                </c:pt>
                <c:pt idx="2903">
                  <c:v>695.51041666666697</c:v>
                </c:pt>
                <c:pt idx="2904">
                  <c:v>695.75</c:v>
                </c:pt>
                <c:pt idx="2905">
                  <c:v>695.98958333333303</c:v>
                </c:pt>
                <c:pt idx="2906">
                  <c:v>696.22916666666697</c:v>
                </c:pt>
                <c:pt idx="2907">
                  <c:v>696.46875</c:v>
                </c:pt>
                <c:pt idx="2908">
                  <c:v>696.70833333333303</c:v>
                </c:pt>
                <c:pt idx="2909">
                  <c:v>696.94791666666697</c:v>
                </c:pt>
                <c:pt idx="2910">
                  <c:v>697.1875</c:v>
                </c:pt>
                <c:pt idx="2911">
                  <c:v>697.42708333333303</c:v>
                </c:pt>
                <c:pt idx="2912">
                  <c:v>697.66666666666697</c:v>
                </c:pt>
                <c:pt idx="2913">
                  <c:v>697.90625</c:v>
                </c:pt>
                <c:pt idx="2914">
                  <c:v>698.14583333333303</c:v>
                </c:pt>
                <c:pt idx="2915">
                  <c:v>698.38541666666697</c:v>
                </c:pt>
                <c:pt idx="2916">
                  <c:v>698.625</c:v>
                </c:pt>
                <c:pt idx="2917">
                  <c:v>698.86458333333303</c:v>
                </c:pt>
                <c:pt idx="2918">
                  <c:v>699.10416666666697</c:v>
                </c:pt>
                <c:pt idx="2919">
                  <c:v>699.34375</c:v>
                </c:pt>
                <c:pt idx="2920">
                  <c:v>699.58333333333303</c:v>
                </c:pt>
                <c:pt idx="2921">
                  <c:v>699.82291666666697</c:v>
                </c:pt>
                <c:pt idx="2922">
                  <c:v>700.0625</c:v>
                </c:pt>
                <c:pt idx="2923">
                  <c:v>700.30208333333303</c:v>
                </c:pt>
                <c:pt idx="2924">
                  <c:v>700.54166666666697</c:v>
                </c:pt>
                <c:pt idx="2925">
                  <c:v>700.78125</c:v>
                </c:pt>
                <c:pt idx="2926">
                  <c:v>701.02083333333303</c:v>
                </c:pt>
                <c:pt idx="2927">
                  <c:v>701.26041666666697</c:v>
                </c:pt>
                <c:pt idx="2928">
                  <c:v>701.5</c:v>
                </c:pt>
                <c:pt idx="2929">
                  <c:v>701.73958333333303</c:v>
                </c:pt>
                <c:pt idx="2930">
                  <c:v>701.97916666666697</c:v>
                </c:pt>
                <c:pt idx="2931">
                  <c:v>702.21875</c:v>
                </c:pt>
                <c:pt idx="2932">
                  <c:v>702.45833333333303</c:v>
                </c:pt>
                <c:pt idx="2933">
                  <c:v>702.69791666666697</c:v>
                </c:pt>
                <c:pt idx="2934">
                  <c:v>702.9375</c:v>
                </c:pt>
                <c:pt idx="2935">
                  <c:v>703.17708333333303</c:v>
                </c:pt>
                <c:pt idx="2936">
                  <c:v>703.41666666666697</c:v>
                </c:pt>
                <c:pt idx="2937">
                  <c:v>703.65625</c:v>
                </c:pt>
                <c:pt idx="2938">
                  <c:v>703.89583333333303</c:v>
                </c:pt>
                <c:pt idx="2939">
                  <c:v>704.13541666666697</c:v>
                </c:pt>
                <c:pt idx="2940">
                  <c:v>704.375</c:v>
                </c:pt>
                <c:pt idx="2941">
                  <c:v>704.61458333333303</c:v>
                </c:pt>
                <c:pt idx="2942">
                  <c:v>704.85416666666697</c:v>
                </c:pt>
                <c:pt idx="2943">
                  <c:v>705.09375</c:v>
                </c:pt>
                <c:pt idx="2944">
                  <c:v>705.33333333333303</c:v>
                </c:pt>
                <c:pt idx="2945">
                  <c:v>705.57291666666697</c:v>
                </c:pt>
                <c:pt idx="2946">
                  <c:v>705.8125</c:v>
                </c:pt>
                <c:pt idx="2947">
                  <c:v>706.05208333333303</c:v>
                </c:pt>
                <c:pt idx="2948">
                  <c:v>706.29166666666697</c:v>
                </c:pt>
                <c:pt idx="2949">
                  <c:v>706.53125</c:v>
                </c:pt>
                <c:pt idx="2950">
                  <c:v>706.77083333333303</c:v>
                </c:pt>
                <c:pt idx="2951">
                  <c:v>707.01041666666697</c:v>
                </c:pt>
                <c:pt idx="2952">
                  <c:v>707.25</c:v>
                </c:pt>
                <c:pt idx="2953">
                  <c:v>707.48958333333303</c:v>
                </c:pt>
                <c:pt idx="2954">
                  <c:v>707.72916666666697</c:v>
                </c:pt>
                <c:pt idx="2955">
                  <c:v>707.96875</c:v>
                </c:pt>
                <c:pt idx="2956">
                  <c:v>708.20833333333303</c:v>
                </c:pt>
                <c:pt idx="2957">
                  <c:v>708.44791666666697</c:v>
                </c:pt>
                <c:pt idx="2958">
                  <c:v>708.6875</c:v>
                </c:pt>
                <c:pt idx="2959">
                  <c:v>708.92708333333303</c:v>
                </c:pt>
                <c:pt idx="2960">
                  <c:v>709.16666666666697</c:v>
                </c:pt>
                <c:pt idx="2961">
                  <c:v>709.40625</c:v>
                </c:pt>
                <c:pt idx="2962">
                  <c:v>709.64583333333303</c:v>
                </c:pt>
                <c:pt idx="2963">
                  <c:v>709.88541666666697</c:v>
                </c:pt>
                <c:pt idx="2964">
                  <c:v>710.125</c:v>
                </c:pt>
                <c:pt idx="2965">
                  <c:v>710.36458333333303</c:v>
                </c:pt>
                <c:pt idx="2966">
                  <c:v>710.60416666666697</c:v>
                </c:pt>
                <c:pt idx="2967">
                  <c:v>710.84375</c:v>
                </c:pt>
                <c:pt idx="2968">
                  <c:v>711.08333333333303</c:v>
                </c:pt>
                <c:pt idx="2969">
                  <c:v>711.32291666666697</c:v>
                </c:pt>
                <c:pt idx="2970">
                  <c:v>711.5625</c:v>
                </c:pt>
                <c:pt idx="2971">
                  <c:v>711.80208333333303</c:v>
                </c:pt>
                <c:pt idx="2972">
                  <c:v>712.04166666666697</c:v>
                </c:pt>
                <c:pt idx="2973">
                  <c:v>712.28125</c:v>
                </c:pt>
                <c:pt idx="2974">
                  <c:v>712.52083333333303</c:v>
                </c:pt>
                <c:pt idx="2975">
                  <c:v>712.76041666666697</c:v>
                </c:pt>
                <c:pt idx="2976">
                  <c:v>713</c:v>
                </c:pt>
                <c:pt idx="2977">
                  <c:v>713.23958333333303</c:v>
                </c:pt>
                <c:pt idx="2978">
                  <c:v>713.47916666666697</c:v>
                </c:pt>
                <c:pt idx="2979">
                  <c:v>713.71875</c:v>
                </c:pt>
                <c:pt idx="2980">
                  <c:v>713.95833333333303</c:v>
                </c:pt>
                <c:pt idx="2981">
                  <c:v>714.19791666666697</c:v>
                </c:pt>
                <c:pt idx="2982">
                  <c:v>714.4375</c:v>
                </c:pt>
                <c:pt idx="2983">
                  <c:v>714.67708333333303</c:v>
                </c:pt>
                <c:pt idx="2984">
                  <c:v>714.91666666666697</c:v>
                </c:pt>
                <c:pt idx="2985">
                  <c:v>715.15625</c:v>
                </c:pt>
                <c:pt idx="2986">
                  <c:v>715.39583333333303</c:v>
                </c:pt>
                <c:pt idx="2987">
                  <c:v>715.63541666666697</c:v>
                </c:pt>
                <c:pt idx="2988">
                  <c:v>715.875</c:v>
                </c:pt>
                <c:pt idx="2989">
                  <c:v>716.11458333333303</c:v>
                </c:pt>
                <c:pt idx="2990">
                  <c:v>716.35416666666697</c:v>
                </c:pt>
                <c:pt idx="2991">
                  <c:v>716.59375</c:v>
                </c:pt>
                <c:pt idx="2992">
                  <c:v>716.83333333333303</c:v>
                </c:pt>
                <c:pt idx="2993">
                  <c:v>717.07291666666697</c:v>
                </c:pt>
                <c:pt idx="2994">
                  <c:v>717.3125</c:v>
                </c:pt>
                <c:pt idx="2995">
                  <c:v>717.55208333333303</c:v>
                </c:pt>
                <c:pt idx="2996">
                  <c:v>717.79166666666697</c:v>
                </c:pt>
                <c:pt idx="2997">
                  <c:v>718.03125</c:v>
                </c:pt>
                <c:pt idx="2998">
                  <c:v>718.27083333333303</c:v>
                </c:pt>
                <c:pt idx="2999">
                  <c:v>718.51041666666697</c:v>
                </c:pt>
                <c:pt idx="3000">
                  <c:v>718.75</c:v>
                </c:pt>
                <c:pt idx="3001">
                  <c:v>718.98958333333303</c:v>
                </c:pt>
                <c:pt idx="3002">
                  <c:v>719.22916666666697</c:v>
                </c:pt>
                <c:pt idx="3003">
                  <c:v>719.46875</c:v>
                </c:pt>
                <c:pt idx="3004">
                  <c:v>719.70833333333303</c:v>
                </c:pt>
                <c:pt idx="3005">
                  <c:v>719.94791666666697</c:v>
                </c:pt>
                <c:pt idx="3006">
                  <c:v>720.1875</c:v>
                </c:pt>
                <c:pt idx="3007">
                  <c:v>720.42708333333303</c:v>
                </c:pt>
                <c:pt idx="3008">
                  <c:v>720.66666666666697</c:v>
                </c:pt>
                <c:pt idx="3009">
                  <c:v>720.90625</c:v>
                </c:pt>
                <c:pt idx="3010">
                  <c:v>721.14583333333303</c:v>
                </c:pt>
                <c:pt idx="3011">
                  <c:v>721.38541666666697</c:v>
                </c:pt>
                <c:pt idx="3012">
                  <c:v>721.625</c:v>
                </c:pt>
                <c:pt idx="3013">
                  <c:v>721.86458333333303</c:v>
                </c:pt>
                <c:pt idx="3014">
                  <c:v>722.10416666666697</c:v>
                </c:pt>
                <c:pt idx="3015">
                  <c:v>722.34375</c:v>
                </c:pt>
                <c:pt idx="3016">
                  <c:v>722.58333333333303</c:v>
                </c:pt>
                <c:pt idx="3017">
                  <c:v>722.82291666666697</c:v>
                </c:pt>
                <c:pt idx="3018">
                  <c:v>723.0625</c:v>
                </c:pt>
                <c:pt idx="3019">
                  <c:v>723.30208333333303</c:v>
                </c:pt>
                <c:pt idx="3020">
                  <c:v>723.54166666666697</c:v>
                </c:pt>
                <c:pt idx="3021">
                  <c:v>723.78125</c:v>
                </c:pt>
                <c:pt idx="3022">
                  <c:v>724.02083333333303</c:v>
                </c:pt>
                <c:pt idx="3023">
                  <c:v>724.26041666666697</c:v>
                </c:pt>
                <c:pt idx="3024">
                  <c:v>724.5</c:v>
                </c:pt>
                <c:pt idx="3025">
                  <c:v>724.73958333333303</c:v>
                </c:pt>
                <c:pt idx="3026">
                  <c:v>724.97916666666697</c:v>
                </c:pt>
                <c:pt idx="3027">
                  <c:v>725.21875</c:v>
                </c:pt>
                <c:pt idx="3028">
                  <c:v>725.45833333333303</c:v>
                </c:pt>
                <c:pt idx="3029">
                  <c:v>725.69791666666697</c:v>
                </c:pt>
                <c:pt idx="3030">
                  <c:v>725.9375</c:v>
                </c:pt>
                <c:pt idx="3031">
                  <c:v>726.17708333333303</c:v>
                </c:pt>
                <c:pt idx="3032">
                  <c:v>726.41666666666697</c:v>
                </c:pt>
                <c:pt idx="3033">
                  <c:v>726.65625</c:v>
                </c:pt>
                <c:pt idx="3034">
                  <c:v>726.89583333333303</c:v>
                </c:pt>
                <c:pt idx="3035">
                  <c:v>727.13541666666697</c:v>
                </c:pt>
                <c:pt idx="3036">
                  <c:v>727.375</c:v>
                </c:pt>
                <c:pt idx="3037">
                  <c:v>727.61458333333303</c:v>
                </c:pt>
                <c:pt idx="3038">
                  <c:v>727.85416666666697</c:v>
                </c:pt>
                <c:pt idx="3039">
                  <c:v>728.09375</c:v>
                </c:pt>
                <c:pt idx="3040">
                  <c:v>728.33333333333303</c:v>
                </c:pt>
                <c:pt idx="3041">
                  <c:v>728.57291666666697</c:v>
                </c:pt>
                <c:pt idx="3042">
                  <c:v>728.8125</c:v>
                </c:pt>
                <c:pt idx="3043">
                  <c:v>729.05208333333303</c:v>
                </c:pt>
                <c:pt idx="3044">
                  <c:v>729.29166666666697</c:v>
                </c:pt>
                <c:pt idx="3045">
                  <c:v>729.53125</c:v>
                </c:pt>
                <c:pt idx="3046">
                  <c:v>729.77083333333303</c:v>
                </c:pt>
                <c:pt idx="3047">
                  <c:v>730.01041666666697</c:v>
                </c:pt>
                <c:pt idx="3048">
                  <c:v>730.25</c:v>
                </c:pt>
                <c:pt idx="3049">
                  <c:v>730.48958333333303</c:v>
                </c:pt>
                <c:pt idx="3050">
                  <c:v>730.72916666666697</c:v>
                </c:pt>
                <c:pt idx="3051">
                  <c:v>730.96875</c:v>
                </c:pt>
                <c:pt idx="3052">
                  <c:v>731.20833333333303</c:v>
                </c:pt>
                <c:pt idx="3053">
                  <c:v>731.44791666666697</c:v>
                </c:pt>
                <c:pt idx="3054">
                  <c:v>731.6875</c:v>
                </c:pt>
                <c:pt idx="3055">
                  <c:v>731.92708333333303</c:v>
                </c:pt>
                <c:pt idx="3056">
                  <c:v>732.16666666666697</c:v>
                </c:pt>
                <c:pt idx="3057">
                  <c:v>732.40625</c:v>
                </c:pt>
                <c:pt idx="3058">
                  <c:v>732.64583333333303</c:v>
                </c:pt>
                <c:pt idx="3059">
                  <c:v>732.88541666666697</c:v>
                </c:pt>
                <c:pt idx="3060">
                  <c:v>733.125</c:v>
                </c:pt>
                <c:pt idx="3061">
                  <c:v>733.36458333333303</c:v>
                </c:pt>
                <c:pt idx="3062">
                  <c:v>733.60416666666697</c:v>
                </c:pt>
                <c:pt idx="3063">
                  <c:v>733.84375</c:v>
                </c:pt>
                <c:pt idx="3064">
                  <c:v>734.08333333333303</c:v>
                </c:pt>
                <c:pt idx="3065">
                  <c:v>734.32291666666697</c:v>
                </c:pt>
                <c:pt idx="3066">
                  <c:v>734.5625</c:v>
                </c:pt>
                <c:pt idx="3067">
                  <c:v>734.80208333333303</c:v>
                </c:pt>
                <c:pt idx="3068">
                  <c:v>735.04166666666697</c:v>
                </c:pt>
                <c:pt idx="3069">
                  <c:v>735.28125</c:v>
                </c:pt>
                <c:pt idx="3070">
                  <c:v>735.52083333333303</c:v>
                </c:pt>
                <c:pt idx="3071">
                  <c:v>735.76041666666697</c:v>
                </c:pt>
                <c:pt idx="3072">
                  <c:v>736</c:v>
                </c:pt>
                <c:pt idx="3073">
                  <c:v>736.23958333333303</c:v>
                </c:pt>
                <c:pt idx="3074">
                  <c:v>736.47916666666697</c:v>
                </c:pt>
                <c:pt idx="3075">
                  <c:v>736.71875</c:v>
                </c:pt>
                <c:pt idx="3076">
                  <c:v>736.95833333333303</c:v>
                </c:pt>
                <c:pt idx="3077">
                  <c:v>737.19791666666697</c:v>
                </c:pt>
                <c:pt idx="3078">
                  <c:v>737.4375</c:v>
                </c:pt>
                <c:pt idx="3079">
                  <c:v>737.67708333333303</c:v>
                </c:pt>
                <c:pt idx="3080">
                  <c:v>737.91666666666697</c:v>
                </c:pt>
                <c:pt idx="3081">
                  <c:v>738.15625</c:v>
                </c:pt>
                <c:pt idx="3082">
                  <c:v>738.39583333333303</c:v>
                </c:pt>
                <c:pt idx="3083">
                  <c:v>738.63541666666697</c:v>
                </c:pt>
                <c:pt idx="3084">
                  <c:v>738.875</c:v>
                </c:pt>
                <c:pt idx="3085">
                  <c:v>739.11458333333303</c:v>
                </c:pt>
                <c:pt idx="3086">
                  <c:v>739.35416666666697</c:v>
                </c:pt>
                <c:pt idx="3087">
                  <c:v>739.59375</c:v>
                </c:pt>
                <c:pt idx="3088">
                  <c:v>739.83333333333303</c:v>
                </c:pt>
                <c:pt idx="3089">
                  <c:v>740.07291666666697</c:v>
                </c:pt>
                <c:pt idx="3090">
                  <c:v>740.3125</c:v>
                </c:pt>
                <c:pt idx="3091">
                  <c:v>740.55208333333303</c:v>
                </c:pt>
                <c:pt idx="3092">
                  <c:v>740.79166666666697</c:v>
                </c:pt>
                <c:pt idx="3093">
                  <c:v>741.03125</c:v>
                </c:pt>
                <c:pt idx="3094">
                  <c:v>741.27083333333303</c:v>
                </c:pt>
                <c:pt idx="3095">
                  <c:v>741.51041666666697</c:v>
                </c:pt>
                <c:pt idx="3096">
                  <c:v>741.75</c:v>
                </c:pt>
                <c:pt idx="3097">
                  <c:v>741.98958333333303</c:v>
                </c:pt>
                <c:pt idx="3098">
                  <c:v>742.22916666666697</c:v>
                </c:pt>
                <c:pt idx="3099">
                  <c:v>742.46875</c:v>
                </c:pt>
                <c:pt idx="3100">
                  <c:v>742.70833333333303</c:v>
                </c:pt>
                <c:pt idx="3101">
                  <c:v>742.94791666666697</c:v>
                </c:pt>
                <c:pt idx="3102">
                  <c:v>743.1875</c:v>
                </c:pt>
                <c:pt idx="3103">
                  <c:v>743.42708333333303</c:v>
                </c:pt>
                <c:pt idx="3104">
                  <c:v>743.66666666666697</c:v>
                </c:pt>
                <c:pt idx="3105">
                  <c:v>743.90625</c:v>
                </c:pt>
                <c:pt idx="3106">
                  <c:v>744.14583333333303</c:v>
                </c:pt>
                <c:pt idx="3107">
                  <c:v>744.38541666666697</c:v>
                </c:pt>
                <c:pt idx="3108">
                  <c:v>744.625</c:v>
                </c:pt>
                <c:pt idx="3109">
                  <c:v>744.86458333333303</c:v>
                </c:pt>
                <c:pt idx="3110">
                  <c:v>745.10416666666697</c:v>
                </c:pt>
                <c:pt idx="3111">
                  <c:v>745.34375</c:v>
                </c:pt>
                <c:pt idx="3112">
                  <c:v>745.58333333333303</c:v>
                </c:pt>
                <c:pt idx="3113">
                  <c:v>745.82291666666697</c:v>
                </c:pt>
                <c:pt idx="3114">
                  <c:v>746.0625</c:v>
                </c:pt>
                <c:pt idx="3115">
                  <c:v>746.30208333333303</c:v>
                </c:pt>
                <c:pt idx="3116">
                  <c:v>746.54166666666697</c:v>
                </c:pt>
                <c:pt idx="3117">
                  <c:v>746.78125</c:v>
                </c:pt>
                <c:pt idx="3118">
                  <c:v>747.02083333333303</c:v>
                </c:pt>
                <c:pt idx="3119">
                  <c:v>747.26041666666697</c:v>
                </c:pt>
                <c:pt idx="3120">
                  <c:v>747.5</c:v>
                </c:pt>
                <c:pt idx="3121">
                  <c:v>747.73958333333303</c:v>
                </c:pt>
                <c:pt idx="3122">
                  <c:v>747.97916666666697</c:v>
                </c:pt>
                <c:pt idx="3123">
                  <c:v>748.21875</c:v>
                </c:pt>
                <c:pt idx="3124">
                  <c:v>748.45833333333303</c:v>
                </c:pt>
                <c:pt idx="3125">
                  <c:v>748.69791666666697</c:v>
                </c:pt>
                <c:pt idx="3126">
                  <c:v>748.9375</c:v>
                </c:pt>
                <c:pt idx="3127">
                  <c:v>749.17708333333303</c:v>
                </c:pt>
                <c:pt idx="3128">
                  <c:v>749.41666666666697</c:v>
                </c:pt>
                <c:pt idx="3129">
                  <c:v>749.65625</c:v>
                </c:pt>
                <c:pt idx="3130">
                  <c:v>749.89583333333303</c:v>
                </c:pt>
                <c:pt idx="3131">
                  <c:v>750.13541666666697</c:v>
                </c:pt>
                <c:pt idx="3132">
                  <c:v>750.375</c:v>
                </c:pt>
                <c:pt idx="3133">
                  <c:v>750.61458333333303</c:v>
                </c:pt>
                <c:pt idx="3134">
                  <c:v>750.85416666666697</c:v>
                </c:pt>
                <c:pt idx="3135">
                  <c:v>751.09375</c:v>
                </c:pt>
                <c:pt idx="3136">
                  <c:v>751.33333333333303</c:v>
                </c:pt>
                <c:pt idx="3137">
                  <c:v>751.57291666666697</c:v>
                </c:pt>
                <c:pt idx="3138">
                  <c:v>751.8125</c:v>
                </c:pt>
                <c:pt idx="3139">
                  <c:v>752.05208333333303</c:v>
                </c:pt>
                <c:pt idx="3140">
                  <c:v>752.29166666666697</c:v>
                </c:pt>
                <c:pt idx="3141">
                  <c:v>752.53125</c:v>
                </c:pt>
                <c:pt idx="3142">
                  <c:v>752.77083333333303</c:v>
                </c:pt>
                <c:pt idx="3143">
                  <c:v>753.01041666666697</c:v>
                </c:pt>
                <c:pt idx="3144">
                  <c:v>753.25</c:v>
                </c:pt>
                <c:pt idx="3145">
                  <c:v>753.48958333333303</c:v>
                </c:pt>
                <c:pt idx="3146">
                  <c:v>753.72916666666697</c:v>
                </c:pt>
                <c:pt idx="3147">
                  <c:v>753.96875</c:v>
                </c:pt>
                <c:pt idx="3148">
                  <c:v>754.20833333333303</c:v>
                </c:pt>
                <c:pt idx="3149">
                  <c:v>754.44791666666697</c:v>
                </c:pt>
                <c:pt idx="3150">
                  <c:v>754.6875</c:v>
                </c:pt>
                <c:pt idx="3151">
                  <c:v>754.92708333333303</c:v>
                </c:pt>
                <c:pt idx="3152">
                  <c:v>755.16666666666697</c:v>
                </c:pt>
                <c:pt idx="3153">
                  <c:v>755.40625</c:v>
                </c:pt>
                <c:pt idx="3154">
                  <c:v>755.64583333333303</c:v>
                </c:pt>
                <c:pt idx="3155">
                  <c:v>755.88541666666697</c:v>
                </c:pt>
                <c:pt idx="3156">
                  <c:v>756.125</c:v>
                </c:pt>
                <c:pt idx="3157">
                  <c:v>756.36458333333303</c:v>
                </c:pt>
                <c:pt idx="3158">
                  <c:v>756.60416666666697</c:v>
                </c:pt>
                <c:pt idx="3159">
                  <c:v>756.84375</c:v>
                </c:pt>
                <c:pt idx="3160">
                  <c:v>757.08333333333303</c:v>
                </c:pt>
                <c:pt idx="3161">
                  <c:v>757.32291666666697</c:v>
                </c:pt>
                <c:pt idx="3162">
                  <c:v>757.5625</c:v>
                </c:pt>
                <c:pt idx="3163">
                  <c:v>757.80208333333303</c:v>
                </c:pt>
                <c:pt idx="3164">
                  <c:v>758.04166666666697</c:v>
                </c:pt>
                <c:pt idx="3165">
                  <c:v>758.28125</c:v>
                </c:pt>
                <c:pt idx="3166">
                  <c:v>758.52083333333303</c:v>
                </c:pt>
                <c:pt idx="3167">
                  <c:v>758.76041666666697</c:v>
                </c:pt>
                <c:pt idx="3168">
                  <c:v>759</c:v>
                </c:pt>
                <c:pt idx="3169">
                  <c:v>759.23958333333303</c:v>
                </c:pt>
                <c:pt idx="3170">
                  <c:v>759.47916666666697</c:v>
                </c:pt>
                <c:pt idx="3171">
                  <c:v>759.71875</c:v>
                </c:pt>
                <c:pt idx="3172">
                  <c:v>759.95833333333303</c:v>
                </c:pt>
                <c:pt idx="3173">
                  <c:v>760.19791666666697</c:v>
                </c:pt>
                <c:pt idx="3174">
                  <c:v>760.4375</c:v>
                </c:pt>
                <c:pt idx="3175">
                  <c:v>760.67708333333303</c:v>
                </c:pt>
                <c:pt idx="3176">
                  <c:v>760.91666666666697</c:v>
                </c:pt>
                <c:pt idx="3177">
                  <c:v>761.15625</c:v>
                </c:pt>
                <c:pt idx="3178">
                  <c:v>761.39583333333303</c:v>
                </c:pt>
                <c:pt idx="3179">
                  <c:v>761.63541666666697</c:v>
                </c:pt>
                <c:pt idx="3180">
                  <c:v>761.875</c:v>
                </c:pt>
                <c:pt idx="3181">
                  <c:v>762.11458333333303</c:v>
                </c:pt>
                <c:pt idx="3182">
                  <c:v>762.35416666666697</c:v>
                </c:pt>
                <c:pt idx="3183">
                  <c:v>762.59375</c:v>
                </c:pt>
                <c:pt idx="3184">
                  <c:v>762.83333333333303</c:v>
                </c:pt>
                <c:pt idx="3185">
                  <c:v>763.07291666666697</c:v>
                </c:pt>
                <c:pt idx="3186">
                  <c:v>763.3125</c:v>
                </c:pt>
                <c:pt idx="3187">
                  <c:v>763.55208333333303</c:v>
                </c:pt>
                <c:pt idx="3188">
                  <c:v>763.79166666666697</c:v>
                </c:pt>
                <c:pt idx="3189">
                  <c:v>764.03125</c:v>
                </c:pt>
                <c:pt idx="3190">
                  <c:v>764.27083333333303</c:v>
                </c:pt>
                <c:pt idx="3191">
                  <c:v>764.51041666666697</c:v>
                </c:pt>
                <c:pt idx="3192">
                  <c:v>764.75</c:v>
                </c:pt>
                <c:pt idx="3193">
                  <c:v>764.98958333333303</c:v>
                </c:pt>
                <c:pt idx="3194">
                  <c:v>765.22916666666697</c:v>
                </c:pt>
                <c:pt idx="3195">
                  <c:v>765.46875</c:v>
                </c:pt>
                <c:pt idx="3196">
                  <c:v>765.70833333333303</c:v>
                </c:pt>
                <c:pt idx="3197">
                  <c:v>765.94791666666697</c:v>
                </c:pt>
                <c:pt idx="3198">
                  <c:v>766.1875</c:v>
                </c:pt>
                <c:pt idx="3199">
                  <c:v>766.42708333333303</c:v>
                </c:pt>
                <c:pt idx="3200">
                  <c:v>766.66666666666697</c:v>
                </c:pt>
                <c:pt idx="3201">
                  <c:v>766.90625</c:v>
                </c:pt>
                <c:pt idx="3202">
                  <c:v>767.14583333333303</c:v>
                </c:pt>
                <c:pt idx="3203">
                  <c:v>767.38541666666697</c:v>
                </c:pt>
                <c:pt idx="3204">
                  <c:v>767.625</c:v>
                </c:pt>
                <c:pt idx="3205">
                  <c:v>767.86458333333303</c:v>
                </c:pt>
                <c:pt idx="3206">
                  <c:v>768.10416666666697</c:v>
                </c:pt>
                <c:pt idx="3207">
                  <c:v>768.34375</c:v>
                </c:pt>
                <c:pt idx="3208">
                  <c:v>768.58333333333303</c:v>
                </c:pt>
                <c:pt idx="3209">
                  <c:v>768.82291666666697</c:v>
                </c:pt>
                <c:pt idx="3210">
                  <c:v>769.0625</c:v>
                </c:pt>
                <c:pt idx="3211">
                  <c:v>769.30208333333303</c:v>
                </c:pt>
                <c:pt idx="3212">
                  <c:v>769.54166666666697</c:v>
                </c:pt>
                <c:pt idx="3213">
                  <c:v>769.78125</c:v>
                </c:pt>
                <c:pt idx="3214">
                  <c:v>770.02083333333303</c:v>
                </c:pt>
                <c:pt idx="3215">
                  <c:v>770.26041666666697</c:v>
                </c:pt>
                <c:pt idx="3216">
                  <c:v>770.5</c:v>
                </c:pt>
                <c:pt idx="3217">
                  <c:v>770.73958333333303</c:v>
                </c:pt>
                <c:pt idx="3218">
                  <c:v>770.97916666666697</c:v>
                </c:pt>
                <c:pt idx="3219">
                  <c:v>771.21875</c:v>
                </c:pt>
                <c:pt idx="3220">
                  <c:v>771.45833333333303</c:v>
                </c:pt>
                <c:pt idx="3221">
                  <c:v>771.69791666666697</c:v>
                </c:pt>
                <c:pt idx="3222">
                  <c:v>771.9375</c:v>
                </c:pt>
                <c:pt idx="3223">
                  <c:v>772.17708333333303</c:v>
                </c:pt>
                <c:pt idx="3224">
                  <c:v>772.41666666666697</c:v>
                </c:pt>
                <c:pt idx="3225">
                  <c:v>772.65625</c:v>
                </c:pt>
                <c:pt idx="3226">
                  <c:v>772.89583333333303</c:v>
                </c:pt>
                <c:pt idx="3227">
                  <c:v>773.13541666666697</c:v>
                </c:pt>
                <c:pt idx="3228">
                  <c:v>773.375</c:v>
                </c:pt>
                <c:pt idx="3229">
                  <c:v>773.61458333333303</c:v>
                </c:pt>
                <c:pt idx="3230">
                  <c:v>773.85416666666697</c:v>
                </c:pt>
                <c:pt idx="3231">
                  <c:v>774.09375</c:v>
                </c:pt>
                <c:pt idx="3232">
                  <c:v>774.33333333333303</c:v>
                </c:pt>
                <c:pt idx="3233">
                  <c:v>774.57291666666697</c:v>
                </c:pt>
                <c:pt idx="3234">
                  <c:v>774.8125</c:v>
                </c:pt>
                <c:pt idx="3235">
                  <c:v>775.05208333333303</c:v>
                </c:pt>
                <c:pt idx="3236">
                  <c:v>775.29166666666697</c:v>
                </c:pt>
                <c:pt idx="3237">
                  <c:v>775.53125</c:v>
                </c:pt>
                <c:pt idx="3238">
                  <c:v>775.77083333333303</c:v>
                </c:pt>
                <c:pt idx="3239">
                  <c:v>776.01041666666697</c:v>
                </c:pt>
                <c:pt idx="3240">
                  <c:v>776.25</c:v>
                </c:pt>
                <c:pt idx="3241">
                  <c:v>776.48958333333303</c:v>
                </c:pt>
                <c:pt idx="3242">
                  <c:v>776.72916666666697</c:v>
                </c:pt>
                <c:pt idx="3243">
                  <c:v>776.96875</c:v>
                </c:pt>
                <c:pt idx="3244">
                  <c:v>777.20833333333303</c:v>
                </c:pt>
                <c:pt idx="3245">
                  <c:v>777.44791666666697</c:v>
                </c:pt>
                <c:pt idx="3246">
                  <c:v>777.6875</c:v>
                </c:pt>
                <c:pt idx="3247">
                  <c:v>777.92708333333303</c:v>
                </c:pt>
                <c:pt idx="3248">
                  <c:v>778.16666666666697</c:v>
                </c:pt>
                <c:pt idx="3249">
                  <c:v>778.40625</c:v>
                </c:pt>
                <c:pt idx="3250">
                  <c:v>778.64583333333303</c:v>
                </c:pt>
                <c:pt idx="3251">
                  <c:v>778.88541666666697</c:v>
                </c:pt>
                <c:pt idx="3252">
                  <c:v>779.125</c:v>
                </c:pt>
                <c:pt idx="3253">
                  <c:v>779.36458333333303</c:v>
                </c:pt>
                <c:pt idx="3254">
                  <c:v>779.60416666666697</c:v>
                </c:pt>
                <c:pt idx="3255">
                  <c:v>779.84375</c:v>
                </c:pt>
                <c:pt idx="3256">
                  <c:v>780.08333333333303</c:v>
                </c:pt>
                <c:pt idx="3257">
                  <c:v>780.32291666666697</c:v>
                </c:pt>
                <c:pt idx="3258">
                  <c:v>780.5625</c:v>
                </c:pt>
                <c:pt idx="3259">
                  <c:v>780.80208333333303</c:v>
                </c:pt>
                <c:pt idx="3260">
                  <c:v>781.04166666666697</c:v>
                </c:pt>
                <c:pt idx="3261">
                  <c:v>781.28125</c:v>
                </c:pt>
                <c:pt idx="3262">
                  <c:v>781.52083333333303</c:v>
                </c:pt>
                <c:pt idx="3263">
                  <c:v>781.76041666666697</c:v>
                </c:pt>
                <c:pt idx="3264">
                  <c:v>782</c:v>
                </c:pt>
                <c:pt idx="3265">
                  <c:v>782.23958333333303</c:v>
                </c:pt>
                <c:pt idx="3266">
                  <c:v>782.47916666666697</c:v>
                </c:pt>
                <c:pt idx="3267">
                  <c:v>782.71875</c:v>
                </c:pt>
                <c:pt idx="3268">
                  <c:v>782.95833333333303</c:v>
                </c:pt>
                <c:pt idx="3269">
                  <c:v>783.19791666666697</c:v>
                </c:pt>
                <c:pt idx="3270">
                  <c:v>783.4375</c:v>
                </c:pt>
                <c:pt idx="3271">
                  <c:v>783.67708333333303</c:v>
                </c:pt>
                <c:pt idx="3272">
                  <c:v>783.91666666666697</c:v>
                </c:pt>
                <c:pt idx="3273">
                  <c:v>784.15625</c:v>
                </c:pt>
                <c:pt idx="3274">
                  <c:v>784.39583333333303</c:v>
                </c:pt>
                <c:pt idx="3275">
                  <c:v>784.63541666666697</c:v>
                </c:pt>
                <c:pt idx="3276">
                  <c:v>784.875</c:v>
                </c:pt>
                <c:pt idx="3277">
                  <c:v>785.11458333333303</c:v>
                </c:pt>
                <c:pt idx="3278">
                  <c:v>785.35416666666697</c:v>
                </c:pt>
                <c:pt idx="3279">
                  <c:v>785.59375</c:v>
                </c:pt>
                <c:pt idx="3280">
                  <c:v>785.83333333333303</c:v>
                </c:pt>
                <c:pt idx="3281">
                  <c:v>786.07291666666697</c:v>
                </c:pt>
                <c:pt idx="3282">
                  <c:v>786.3125</c:v>
                </c:pt>
                <c:pt idx="3283">
                  <c:v>786.55208333333303</c:v>
                </c:pt>
                <c:pt idx="3284">
                  <c:v>786.79166666666697</c:v>
                </c:pt>
                <c:pt idx="3285">
                  <c:v>787.03125</c:v>
                </c:pt>
                <c:pt idx="3286">
                  <c:v>787.27083333333303</c:v>
                </c:pt>
                <c:pt idx="3287">
                  <c:v>787.51041666666697</c:v>
                </c:pt>
                <c:pt idx="3288">
                  <c:v>787.75</c:v>
                </c:pt>
                <c:pt idx="3289">
                  <c:v>787.98958333333303</c:v>
                </c:pt>
                <c:pt idx="3290">
                  <c:v>788.22916666666697</c:v>
                </c:pt>
                <c:pt idx="3291">
                  <c:v>788.46875</c:v>
                </c:pt>
                <c:pt idx="3292">
                  <c:v>788.70833333333303</c:v>
                </c:pt>
                <c:pt idx="3293">
                  <c:v>788.94791666666697</c:v>
                </c:pt>
                <c:pt idx="3294">
                  <c:v>789.1875</c:v>
                </c:pt>
                <c:pt idx="3295">
                  <c:v>789.42708333333303</c:v>
                </c:pt>
                <c:pt idx="3296">
                  <c:v>789.66666666666697</c:v>
                </c:pt>
                <c:pt idx="3297">
                  <c:v>789.90625</c:v>
                </c:pt>
                <c:pt idx="3298">
                  <c:v>790.14583333333303</c:v>
                </c:pt>
                <c:pt idx="3299">
                  <c:v>790.38541666666697</c:v>
                </c:pt>
                <c:pt idx="3300">
                  <c:v>790.625</c:v>
                </c:pt>
                <c:pt idx="3301">
                  <c:v>790.86458333333303</c:v>
                </c:pt>
                <c:pt idx="3302">
                  <c:v>791.10416666666697</c:v>
                </c:pt>
                <c:pt idx="3303">
                  <c:v>791.34375</c:v>
                </c:pt>
                <c:pt idx="3304">
                  <c:v>791.58333333333303</c:v>
                </c:pt>
                <c:pt idx="3305">
                  <c:v>791.82291666666697</c:v>
                </c:pt>
                <c:pt idx="3306">
                  <c:v>792.0625</c:v>
                </c:pt>
                <c:pt idx="3307">
                  <c:v>792.30208333333303</c:v>
                </c:pt>
                <c:pt idx="3308">
                  <c:v>792.54166666666697</c:v>
                </c:pt>
                <c:pt idx="3309">
                  <c:v>792.78125</c:v>
                </c:pt>
                <c:pt idx="3310">
                  <c:v>793.02083333333303</c:v>
                </c:pt>
                <c:pt idx="3311">
                  <c:v>793.26041666666697</c:v>
                </c:pt>
                <c:pt idx="3312">
                  <c:v>793.5</c:v>
                </c:pt>
                <c:pt idx="3313">
                  <c:v>793.73958333333303</c:v>
                </c:pt>
                <c:pt idx="3314">
                  <c:v>793.97916666666697</c:v>
                </c:pt>
                <c:pt idx="3315">
                  <c:v>794.21875</c:v>
                </c:pt>
                <c:pt idx="3316">
                  <c:v>794.45833333333303</c:v>
                </c:pt>
                <c:pt idx="3317">
                  <c:v>794.69791666666697</c:v>
                </c:pt>
                <c:pt idx="3318">
                  <c:v>794.9375</c:v>
                </c:pt>
                <c:pt idx="3319">
                  <c:v>795.17708333333303</c:v>
                </c:pt>
                <c:pt idx="3320">
                  <c:v>795.41666666666697</c:v>
                </c:pt>
                <c:pt idx="3321">
                  <c:v>795.65625</c:v>
                </c:pt>
                <c:pt idx="3322">
                  <c:v>795.89583333333303</c:v>
                </c:pt>
                <c:pt idx="3323">
                  <c:v>796.13541666666697</c:v>
                </c:pt>
                <c:pt idx="3324">
                  <c:v>796.375</c:v>
                </c:pt>
                <c:pt idx="3325">
                  <c:v>796.61458333333303</c:v>
                </c:pt>
                <c:pt idx="3326">
                  <c:v>796.85416666666697</c:v>
                </c:pt>
                <c:pt idx="3327">
                  <c:v>797.09375</c:v>
                </c:pt>
                <c:pt idx="3328">
                  <c:v>797.33333333333303</c:v>
                </c:pt>
                <c:pt idx="3329">
                  <c:v>797.57291666666697</c:v>
                </c:pt>
                <c:pt idx="3330">
                  <c:v>797.8125</c:v>
                </c:pt>
                <c:pt idx="3331">
                  <c:v>798.05208333333303</c:v>
                </c:pt>
                <c:pt idx="3332">
                  <c:v>798.29166666666697</c:v>
                </c:pt>
                <c:pt idx="3333">
                  <c:v>798.53125</c:v>
                </c:pt>
                <c:pt idx="3334">
                  <c:v>798.77083333333303</c:v>
                </c:pt>
                <c:pt idx="3335">
                  <c:v>799.01041666666697</c:v>
                </c:pt>
                <c:pt idx="3336">
                  <c:v>799.25</c:v>
                </c:pt>
                <c:pt idx="3337">
                  <c:v>799.48958333333303</c:v>
                </c:pt>
                <c:pt idx="3338">
                  <c:v>799.72916666666697</c:v>
                </c:pt>
                <c:pt idx="3339">
                  <c:v>799.96875</c:v>
                </c:pt>
                <c:pt idx="3340">
                  <c:v>800.20833333333303</c:v>
                </c:pt>
                <c:pt idx="3341">
                  <c:v>800.44791666666697</c:v>
                </c:pt>
                <c:pt idx="3342">
                  <c:v>800.6875</c:v>
                </c:pt>
                <c:pt idx="3343">
                  <c:v>800.92708333333303</c:v>
                </c:pt>
                <c:pt idx="3344">
                  <c:v>801.16666666666697</c:v>
                </c:pt>
                <c:pt idx="3345">
                  <c:v>801.40625</c:v>
                </c:pt>
                <c:pt idx="3346">
                  <c:v>801.64583333333303</c:v>
                </c:pt>
                <c:pt idx="3347">
                  <c:v>801.88541666666697</c:v>
                </c:pt>
                <c:pt idx="3348">
                  <c:v>802.125</c:v>
                </c:pt>
                <c:pt idx="3349">
                  <c:v>802.36458333333303</c:v>
                </c:pt>
                <c:pt idx="3350">
                  <c:v>802.60416666666697</c:v>
                </c:pt>
                <c:pt idx="3351">
                  <c:v>802.84375</c:v>
                </c:pt>
                <c:pt idx="3352">
                  <c:v>803.08333333333303</c:v>
                </c:pt>
                <c:pt idx="3353">
                  <c:v>803.32291666666697</c:v>
                </c:pt>
                <c:pt idx="3354">
                  <c:v>803.5625</c:v>
                </c:pt>
                <c:pt idx="3355">
                  <c:v>803.80208333333303</c:v>
                </c:pt>
                <c:pt idx="3356">
                  <c:v>804.04166666666697</c:v>
                </c:pt>
                <c:pt idx="3357">
                  <c:v>804.28125</c:v>
                </c:pt>
                <c:pt idx="3358">
                  <c:v>804.52083333333303</c:v>
                </c:pt>
                <c:pt idx="3359">
                  <c:v>804.76041666666697</c:v>
                </c:pt>
                <c:pt idx="3360">
                  <c:v>805</c:v>
                </c:pt>
                <c:pt idx="3361">
                  <c:v>805.23958333333303</c:v>
                </c:pt>
                <c:pt idx="3362">
                  <c:v>805.47916666666697</c:v>
                </c:pt>
                <c:pt idx="3363">
                  <c:v>805.71875</c:v>
                </c:pt>
                <c:pt idx="3364">
                  <c:v>805.95833333333303</c:v>
                </c:pt>
                <c:pt idx="3365">
                  <c:v>806.19791666666697</c:v>
                </c:pt>
                <c:pt idx="3366">
                  <c:v>806.4375</c:v>
                </c:pt>
                <c:pt idx="3367">
                  <c:v>806.67708333333303</c:v>
                </c:pt>
                <c:pt idx="3368">
                  <c:v>806.91666666666697</c:v>
                </c:pt>
                <c:pt idx="3369">
                  <c:v>807.15625</c:v>
                </c:pt>
                <c:pt idx="3370">
                  <c:v>807.39583333333303</c:v>
                </c:pt>
                <c:pt idx="3371">
                  <c:v>807.63541666666697</c:v>
                </c:pt>
                <c:pt idx="3372">
                  <c:v>807.875</c:v>
                </c:pt>
                <c:pt idx="3373">
                  <c:v>808.11458333333303</c:v>
                </c:pt>
                <c:pt idx="3374">
                  <c:v>808.35416666666697</c:v>
                </c:pt>
                <c:pt idx="3375">
                  <c:v>808.59375</c:v>
                </c:pt>
                <c:pt idx="3376">
                  <c:v>808.83333333333303</c:v>
                </c:pt>
                <c:pt idx="3377">
                  <c:v>809.07291666666697</c:v>
                </c:pt>
                <c:pt idx="3378">
                  <c:v>809.3125</c:v>
                </c:pt>
                <c:pt idx="3379">
                  <c:v>809.55208333333303</c:v>
                </c:pt>
                <c:pt idx="3380">
                  <c:v>809.79166666666697</c:v>
                </c:pt>
                <c:pt idx="3381">
                  <c:v>810.03125</c:v>
                </c:pt>
                <c:pt idx="3382">
                  <c:v>810.27083333333303</c:v>
                </c:pt>
                <c:pt idx="3383">
                  <c:v>810.51041666666697</c:v>
                </c:pt>
                <c:pt idx="3384">
                  <c:v>810.75</c:v>
                </c:pt>
                <c:pt idx="3385">
                  <c:v>810.98958333333303</c:v>
                </c:pt>
                <c:pt idx="3386">
                  <c:v>811.22916666666697</c:v>
                </c:pt>
                <c:pt idx="3387">
                  <c:v>811.46875</c:v>
                </c:pt>
                <c:pt idx="3388">
                  <c:v>811.70833333333303</c:v>
                </c:pt>
                <c:pt idx="3389">
                  <c:v>811.94791666666697</c:v>
                </c:pt>
                <c:pt idx="3390">
                  <c:v>812.1875</c:v>
                </c:pt>
                <c:pt idx="3391">
                  <c:v>812.42708333333303</c:v>
                </c:pt>
                <c:pt idx="3392">
                  <c:v>812.66666666666697</c:v>
                </c:pt>
                <c:pt idx="3393">
                  <c:v>812.90625</c:v>
                </c:pt>
                <c:pt idx="3394">
                  <c:v>813.14583333333303</c:v>
                </c:pt>
                <c:pt idx="3395">
                  <c:v>813.38541666666697</c:v>
                </c:pt>
                <c:pt idx="3396">
                  <c:v>813.625</c:v>
                </c:pt>
                <c:pt idx="3397">
                  <c:v>813.86458333333303</c:v>
                </c:pt>
                <c:pt idx="3398">
                  <c:v>814.10416666666697</c:v>
                </c:pt>
                <c:pt idx="3399">
                  <c:v>814.34375</c:v>
                </c:pt>
                <c:pt idx="3400">
                  <c:v>814.58333333333303</c:v>
                </c:pt>
                <c:pt idx="3401">
                  <c:v>814.82291666666697</c:v>
                </c:pt>
                <c:pt idx="3402">
                  <c:v>815.0625</c:v>
                </c:pt>
                <c:pt idx="3403">
                  <c:v>815.30208333333303</c:v>
                </c:pt>
                <c:pt idx="3404">
                  <c:v>815.54166666666697</c:v>
                </c:pt>
                <c:pt idx="3405">
                  <c:v>815.78125</c:v>
                </c:pt>
                <c:pt idx="3406">
                  <c:v>816.02083333333303</c:v>
                </c:pt>
                <c:pt idx="3407">
                  <c:v>816.26041666666697</c:v>
                </c:pt>
                <c:pt idx="3408">
                  <c:v>816.5</c:v>
                </c:pt>
                <c:pt idx="3409">
                  <c:v>816.73958333333303</c:v>
                </c:pt>
                <c:pt idx="3410">
                  <c:v>816.97916666666697</c:v>
                </c:pt>
                <c:pt idx="3411">
                  <c:v>817.21875</c:v>
                </c:pt>
                <c:pt idx="3412">
                  <c:v>817.45833333333303</c:v>
                </c:pt>
                <c:pt idx="3413">
                  <c:v>817.69791666666697</c:v>
                </c:pt>
                <c:pt idx="3414">
                  <c:v>817.9375</c:v>
                </c:pt>
                <c:pt idx="3415">
                  <c:v>818.17708333333303</c:v>
                </c:pt>
                <c:pt idx="3416">
                  <c:v>818.41666666666697</c:v>
                </c:pt>
                <c:pt idx="3417">
                  <c:v>818.65625</c:v>
                </c:pt>
                <c:pt idx="3418">
                  <c:v>818.89583333333303</c:v>
                </c:pt>
                <c:pt idx="3419">
                  <c:v>819.13541666666697</c:v>
                </c:pt>
                <c:pt idx="3420">
                  <c:v>819.375</c:v>
                </c:pt>
                <c:pt idx="3421">
                  <c:v>819.61458333333303</c:v>
                </c:pt>
                <c:pt idx="3422">
                  <c:v>819.85416666666697</c:v>
                </c:pt>
                <c:pt idx="3423">
                  <c:v>820.09375</c:v>
                </c:pt>
                <c:pt idx="3424">
                  <c:v>820.33333333333303</c:v>
                </c:pt>
                <c:pt idx="3425">
                  <c:v>820.57291666666697</c:v>
                </c:pt>
                <c:pt idx="3426">
                  <c:v>820.8125</c:v>
                </c:pt>
                <c:pt idx="3427">
                  <c:v>821.05208333333303</c:v>
                </c:pt>
                <c:pt idx="3428">
                  <c:v>821.29166666666697</c:v>
                </c:pt>
                <c:pt idx="3429">
                  <c:v>821.53125</c:v>
                </c:pt>
                <c:pt idx="3430">
                  <c:v>821.77083333333303</c:v>
                </c:pt>
                <c:pt idx="3431">
                  <c:v>822.01041666666697</c:v>
                </c:pt>
                <c:pt idx="3432">
                  <c:v>822.25</c:v>
                </c:pt>
                <c:pt idx="3433">
                  <c:v>822.48958333333303</c:v>
                </c:pt>
                <c:pt idx="3434">
                  <c:v>822.72916666666697</c:v>
                </c:pt>
                <c:pt idx="3435">
                  <c:v>822.96875</c:v>
                </c:pt>
                <c:pt idx="3436">
                  <c:v>823.20833333333303</c:v>
                </c:pt>
                <c:pt idx="3437">
                  <c:v>823.44791666666697</c:v>
                </c:pt>
                <c:pt idx="3438">
                  <c:v>823.6875</c:v>
                </c:pt>
                <c:pt idx="3439">
                  <c:v>823.92708333333303</c:v>
                </c:pt>
                <c:pt idx="3440">
                  <c:v>824.16666666666697</c:v>
                </c:pt>
                <c:pt idx="3441">
                  <c:v>824.40625</c:v>
                </c:pt>
                <c:pt idx="3442">
                  <c:v>824.64583333333303</c:v>
                </c:pt>
                <c:pt idx="3443">
                  <c:v>824.88541666666697</c:v>
                </c:pt>
                <c:pt idx="3444">
                  <c:v>825.125</c:v>
                </c:pt>
                <c:pt idx="3445">
                  <c:v>825.36458333333303</c:v>
                </c:pt>
                <c:pt idx="3446">
                  <c:v>825.60416666666697</c:v>
                </c:pt>
                <c:pt idx="3447">
                  <c:v>825.84375</c:v>
                </c:pt>
                <c:pt idx="3448">
                  <c:v>826.08333333333303</c:v>
                </c:pt>
                <c:pt idx="3449">
                  <c:v>826.32291666666697</c:v>
                </c:pt>
                <c:pt idx="3450">
                  <c:v>826.5625</c:v>
                </c:pt>
                <c:pt idx="3451">
                  <c:v>826.80208333333303</c:v>
                </c:pt>
                <c:pt idx="3452">
                  <c:v>827.04166666666697</c:v>
                </c:pt>
                <c:pt idx="3453">
                  <c:v>827.28125</c:v>
                </c:pt>
                <c:pt idx="3454">
                  <c:v>827.52083333333303</c:v>
                </c:pt>
                <c:pt idx="3455">
                  <c:v>827.76041666666697</c:v>
                </c:pt>
                <c:pt idx="3456">
                  <c:v>828</c:v>
                </c:pt>
                <c:pt idx="3457">
                  <c:v>828.23958333333303</c:v>
                </c:pt>
                <c:pt idx="3458">
                  <c:v>828.47916666666697</c:v>
                </c:pt>
                <c:pt idx="3459">
                  <c:v>828.71875</c:v>
                </c:pt>
                <c:pt idx="3460">
                  <c:v>828.95833333333303</c:v>
                </c:pt>
                <c:pt idx="3461">
                  <c:v>829.19791666666697</c:v>
                </c:pt>
                <c:pt idx="3462">
                  <c:v>829.4375</c:v>
                </c:pt>
                <c:pt idx="3463">
                  <c:v>829.67708333333303</c:v>
                </c:pt>
                <c:pt idx="3464">
                  <c:v>829.91666666666697</c:v>
                </c:pt>
                <c:pt idx="3465">
                  <c:v>830.15625</c:v>
                </c:pt>
                <c:pt idx="3466">
                  <c:v>830.39583333333303</c:v>
                </c:pt>
                <c:pt idx="3467">
                  <c:v>830.63541666666697</c:v>
                </c:pt>
                <c:pt idx="3468">
                  <c:v>830.875</c:v>
                </c:pt>
                <c:pt idx="3469">
                  <c:v>831.11458333333303</c:v>
                </c:pt>
                <c:pt idx="3470">
                  <c:v>831.35416666666697</c:v>
                </c:pt>
                <c:pt idx="3471">
                  <c:v>831.59375</c:v>
                </c:pt>
                <c:pt idx="3472">
                  <c:v>831.83333333333303</c:v>
                </c:pt>
                <c:pt idx="3473">
                  <c:v>832.07291666666697</c:v>
                </c:pt>
                <c:pt idx="3474">
                  <c:v>832.3125</c:v>
                </c:pt>
                <c:pt idx="3475">
                  <c:v>832.55208333333303</c:v>
                </c:pt>
                <c:pt idx="3476">
                  <c:v>832.79166666666697</c:v>
                </c:pt>
                <c:pt idx="3477">
                  <c:v>833.03125</c:v>
                </c:pt>
                <c:pt idx="3478">
                  <c:v>833.27083333333303</c:v>
                </c:pt>
                <c:pt idx="3479">
                  <c:v>833.51041666666697</c:v>
                </c:pt>
                <c:pt idx="3480">
                  <c:v>833.75</c:v>
                </c:pt>
                <c:pt idx="3481">
                  <c:v>833.98958333333303</c:v>
                </c:pt>
                <c:pt idx="3482">
                  <c:v>834.22916666666697</c:v>
                </c:pt>
                <c:pt idx="3483">
                  <c:v>834.46875</c:v>
                </c:pt>
                <c:pt idx="3484">
                  <c:v>834.70833333333303</c:v>
                </c:pt>
                <c:pt idx="3485">
                  <c:v>834.94791666666697</c:v>
                </c:pt>
                <c:pt idx="3486">
                  <c:v>835.1875</c:v>
                </c:pt>
                <c:pt idx="3487">
                  <c:v>835.42708333333303</c:v>
                </c:pt>
                <c:pt idx="3488">
                  <c:v>835.66666666666697</c:v>
                </c:pt>
                <c:pt idx="3489">
                  <c:v>835.90625</c:v>
                </c:pt>
                <c:pt idx="3490">
                  <c:v>836.14583333333303</c:v>
                </c:pt>
                <c:pt idx="3491">
                  <c:v>836.38541666666697</c:v>
                </c:pt>
                <c:pt idx="3492">
                  <c:v>836.625</c:v>
                </c:pt>
                <c:pt idx="3493">
                  <c:v>836.86458333333303</c:v>
                </c:pt>
                <c:pt idx="3494">
                  <c:v>837.10416666666697</c:v>
                </c:pt>
                <c:pt idx="3495">
                  <c:v>837.34375</c:v>
                </c:pt>
                <c:pt idx="3496">
                  <c:v>837.58333333333303</c:v>
                </c:pt>
                <c:pt idx="3497">
                  <c:v>837.82291666666697</c:v>
                </c:pt>
                <c:pt idx="3498">
                  <c:v>838.0625</c:v>
                </c:pt>
                <c:pt idx="3499">
                  <c:v>838.30208333333303</c:v>
                </c:pt>
                <c:pt idx="3500">
                  <c:v>838.54166666666697</c:v>
                </c:pt>
                <c:pt idx="3501">
                  <c:v>838.78125</c:v>
                </c:pt>
                <c:pt idx="3502">
                  <c:v>839.02083333333303</c:v>
                </c:pt>
                <c:pt idx="3503">
                  <c:v>839.26041666666697</c:v>
                </c:pt>
                <c:pt idx="3504">
                  <c:v>839.5</c:v>
                </c:pt>
                <c:pt idx="3505">
                  <c:v>839.73958333333303</c:v>
                </c:pt>
                <c:pt idx="3506">
                  <c:v>839.97916666666697</c:v>
                </c:pt>
                <c:pt idx="3507">
                  <c:v>840.21875</c:v>
                </c:pt>
                <c:pt idx="3508">
                  <c:v>840.45833333333303</c:v>
                </c:pt>
                <c:pt idx="3509">
                  <c:v>840.69791666666697</c:v>
                </c:pt>
                <c:pt idx="3510">
                  <c:v>840.9375</c:v>
                </c:pt>
                <c:pt idx="3511">
                  <c:v>841.17708333333303</c:v>
                </c:pt>
                <c:pt idx="3512">
                  <c:v>841.41666666666697</c:v>
                </c:pt>
                <c:pt idx="3513">
                  <c:v>841.65625</c:v>
                </c:pt>
                <c:pt idx="3514">
                  <c:v>841.89583333333303</c:v>
                </c:pt>
                <c:pt idx="3515">
                  <c:v>842.13541666666697</c:v>
                </c:pt>
                <c:pt idx="3516">
                  <c:v>842.375</c:v>
                </c:pt>
                <c:pt idx="3517">
                  <c:v>842.61458333333303</c:v>
                </c:pt>
                <c:pt idx="3518">
                  <c:v>842.85416666666697</c:v>
                </c:pt>
                <c:pt idx="3519">
                  <c:v>843.09375</c:v>
                </c:pt>
                <c:pt idx="3520">
                  <c:v>843.33333333333303</c:v>
                </c:pt>
                <c:pt idx="3521">
                  <c:v>843.57291666666697</c:v>
                </c:pt>
                <c:pt idx="3522">
                  <c:v>843.8125</c:v>
                </c:pt>
                <c:pt idx="3523">
                  <c:v>844.05208333333303</c:v>
                </c:pt>
                <c:pt idx="3524">
                  <c:v>844.29166666666697</c:v>
                </c:pt>
                <c:pt idx="3525">
                  <c:v>844.53125</c:v>
                </c:pt>
                <c:pt idx="3526">
                  <c:v>844.77083333333303</c:v>
                </c:pt>
                <c:pt idx="3527">
                  <c:v>845.01041666666697</c:v>
                </c:pt>
                <c:pt idx="3528">
                  <c:v>845.25</c:v>
                </c:pt>
                <c:pt idx="3529">
                  <c:v>845.48958333333303</c:v>
                </c:pt>
                <c:pt idx="3530">
                  <c:v>845.72916666666697</c:v>
                </c:pt>
                <c:pt idx="3531">
                  <c:v>845.96875</c:v>
                </c:pt>
                <c:pt idx="3532">
                  <c:v>846.20833333333303</c:v>
                </c:pt>
                <c:pt idx="3533">
                  <c:v>846.44791666666697</c:v>
                </c:pt>
                <c:pt idx="3534">
                  <c:v>846.6875</c:v>
                </c:pt>
                <c:pt idx="3535">
                  <c:v>846.92708333333303</c:v>
                </c:pt>
                <c:pt idx="3536">
                  <c:v>847.16666666666697</c:v>
                </c:pt>
                <c:pt idx="3537">
                  <c:v>847.40625</c:v>
                </c:pt>
                <c:pt idx="3538">
                  <c:v>847.64583333333303</c:v>
                </c:pt>
                <c:pt idx="3539">
                  <c:v>847.88541666666697</c:v>
                </c:pt>
                <c:pt idx="3540">
                  <c:v>848.125</c:v>
                </c:pt>
                <c:pt idx="3541">
                  <c:v>848.36458333333303</c:v>
                </c:pt>
                <c:pt idx="3542">
                  <c:v>848.60416666666697</c:v>
                </c:pt>
                <c:pt idx="3543">
                  <c:v>848.84375</c:v>
                </c:pt>
                <c:pt idx="3544">
                  <c:v>849.08333333333303</c:v>
                </c:pt>
                <c:pt idx="3545">
                  <c:v>849.32291666666697</c:v>
                </c:pt>
                <c:pt idx="3546">
                  <c:v>849.5625</c:v>
                </c:pt>
                <c:pt idx="3547">
                  <c:v>849.80208333333303</c:v>
                </c:pt>
                <c:pt idx="3548">
                  <c:v>850.04166666666697</c:v>
                </c:pt>
                <c:pt idx="3549">
                  <c:v>850.28125</c:v>
                </c:pt>
                <c:pt idx="3550">
                  <c:v>850.52083333333303</c:v>
                </c:pt>
                <c:pt idx="3551">
                  <c:v>850.76041666666697</c:v>
                </c:pt>
                <c:pt idx="3552">
                  <c:v>851</c:v>
                </c:pt>
                <c:pt idx="3553">
                  <c:v>851.23958333333303</c:v>
                </c:pt>
                <c:pt idx="3554">
                  <c:v>851.47916666666697</c:v>
                </c:pt>
                <c:pt idx="3555">
                  <c:v>851.71875</c:v>
                </c:pt>
                <c:pt idx="3556">
                  <c:v>851.95833333333303</c:v>
                </c:pt>
                <c:pt idx="3557">
                  <c:v>852.19791666666697</c:v>
                </c:pt>
                <c:pt idx="3558">
                  <c:v>852.4375</c:v>
                </c:pt>
                <c:pt idx="3559">
                  <c:v>852.67708333333303</c:v>
                </c:pt>
                <c:pt idx="3560">
                  <c:v>852.91666666666697</c:v>
                </c:pt>
                <c:pt idx="3561">
                  <c:v>853.15625</c:v>
                </c:pt>
                <c:pt idx="3562">
                  <c:v>853.39583333333303</c:v>
                </c:pt>
                <c:pt idx="3563">
                  <c:v>853.63541666666697</c:v>
                </c:pt>
                <c:pt idx="3564">
                  <c:v>853.875</c:v>
                </c:pt>
                <c:pt idx="3565">
                  <c:v>854.11458333333303</c:v>
                </c:pt>
                <c:pt idx="3566">
                  <c:v>854.35416666666697</c:v>
                </c:pt>
                <c:pt idx="3567">
                  <c:v>854.59375</c:v>
                </c:pt>
                <c:pt idx="3568">
                  <c:v>854.83333333333303</c:v>
                </c:pt>
                <c:pt idx="3569">
                  <c:v>855.07291666666697</c:v>
                </c:pt>
                <c:pt idx="3570">
                  <c:v>855.3125</c:v>
                </c:pt>
                <c:pt idx="3571">
                  <c:v>855.55208333333303</c:v>
                </c:pt>
                <c:pt idx="3572">
                  <c:v>855.79166666666697</c:v>
                </c:pt>
                <c:pt idx="3573">
                  <c:v>856.03125</c:v>
                </c:pt>
                <c:pt idx="3574">
                  <c:v>856.27083333333303</c:v>
                </c:pt>
                <c:pt idx="3575">
                  <c:v>856.51041666666697</c:v>
                </c:pt>
                <c:pt idx="3576">
                  <c:v>856.75</c:v>
                </c:pt>
                <c:pt idx="3577">
                  <c:v>856.98958333333303</c:v>
                </c:pt>
                <c:pt idx="3578">
                  <c:v>857.22916666666697</c:v>
                </c:pt>
                <c:pt idx="3579">
                  <c:v>857.46875</c:v>
                </c:pt>
                <c:pt idx="3580">
                  <c:v>857.70833333333303</c:v>
                </c:pt>
                <c:pt idx="3581">
                  <c:v>857.94791666666697</c:v>
                </c:pt>
                <c:pt idx="3582">
                  <c:v>858.1875</c:v>
                </c:pt>
                <c:pt idx="3583">
                  <c:v>858.42708333333303</c:v>
                </c:pt>
                <c:pt idx="3584">
                  <c:v>858.66666666666697</c:v>
                </c:pt>
                <c:pt idx="3585">
                  <c:v>858.90625</c:v>
                </c:pt>
                <c:pt idx="3586">
                  <c:v>859.14583333333303</c:v>
                </c:pt>
                <c:pt idx="3587">
                  <c:v>859.38541666666697</c:v>
                </c:pt>
                <c:pt idx="3588">
                  <c:v>859.625</c:v>
                </c:pt>
                <c:pt idx="3589">
                  <c:v>859.86458333333303</c:v>
                </c:pt>
                <c:pt idx="3590">
                  <c:v>860.10416666666697</c:v>
                </c:pt>
                <c:pt idx="3591">
                  <c:v>860.34375</c:v>
                </c:pt>
                <c:pt idx="3592">
                  <c:v>860.58333333333303</c:v>
                </c:pt>
                <c:pt idx="3593">
                  <c:v>860.82291666666697</c:v>
                </c:pt>
                <c:pt idx="3594">
                  <c:v>861.0625</c:v>
                </c:pt>
                <c:pt idx="3595">
                  <c:v>861.30208333333303</c:v>
                </c:pt>
                <c:pt idx="3596">
                  <c:v>861.54166666666697</c:v>
                </c:pt>
                <c:pt idx="3597">
                  <c:v>861.78125</c:v>
                </c:pt>
                <c:pt idx="3598">
                  <c:v>862.02083333333303</c:v>
                </c:pt>
                <c:pt idx="3599">
                  <c:v>862.26041666666697</c:v>
                </c:pt>
                <c:pt idx="3600">
                  <c:v>862.5</c:v>
                </c:pt>
                <c:pt idx="3601">
                  <c:v>862.73958333333303</c:v>
                </c:pt>
                <c:pt idx="3602">
                  <c:v>862.97916666666697</c:v>
                </c:pt>
                <c:pt idx="3603">
                  <c:v>863.21875</c:v>
                </c:pt>
                <c:pt idx="3604">
                  <c:v>863.45833333333303</c:v>
                </c:pt>
                <c:pt idx="3605">
                  <c:v>863.69791666666697</c:v>
                </c:pt>
                <c:pt idx="3606">
                  <c:v>863.9375</c:v>
                </c:pt>
                <c:pt idx="3607">
                  <c:v>864.17708333333303</c:v>
                </c:pt>
                <c:pt idx="3608">
                  <c:v>864.41666666666697</c:v>
                </c:pt>
                <c:pt idx="3609">
                  <c:v>864.65625</c:v>
                </c:pt>
                <c:pt idx="3610">
                  <c:v>864.89583333333303</c:v>
                </c:pt>
                <c:pt idx="3611">
                  <c:v>865.13541666666697</c:v>
                </c:pt>
                <c:pt idx="3612">
                  <c:v>865.375</c:v>
                </c:pt>
                <c:pt idx="3613">
                  <c:v>865.61458333333303</c:v>
                </c:pt>
                <c:pt idx="3614">
                  <c:v>865.85416666666697</c:v>
                </c:pt>
                <c:pt idx="3615">
                  <c:v>866.09375</c:v>
                </c:pt>
                <c:pt idx="3616">
                  <c:v>866.33333333333303</c:v>
                </c:pt>
                <c:pt idx="3617">
                  <c:v>866.57291666666697</c:v>
                </c:pt>
                <c:pt idx="3618">
                  <c:v>866.8125</c:v>
                </c:pt>
                <c:pt idx="3619">
                  <c:v>867.05208333333303</c:v>
                </c:pt>
                <c:pt idx="3620">
                  <c:v>867.29166666666697</c:v>
                </c:pt>
                <c:pt idx="3621">
                  <c:v>867.53125</c:v>
                </c:pt>
                <c:pt idx="3622">
                  <c:v>867.77083333333303</c:v>
                </c:pt>
                <c:pt idx="3623">
                  <c:v>868.01041666666697</c:v>
                </c:pt>
                <c:pt idx="3624">
                  <c:v>868.25</c:v>
                </c:pt>
                <c:pt idx="3625">
                  <c:v>868.48958333333303</c:v>
                </c:pt>
                <c:pt idx="3626">
                  <c:v>868.72916666666697</c:v>
                </c:pt>
                <c:pt idx="3627">
                  <c:v>868.96875</c:v>
                </c:pt>
                <c:pt idx="3628">
                  <c:v>869.20833333333303</c:v>
                </c:pt>
                <c:pt idx="3629">
                  <c:v>869.44791666666697</c:v>
                </c:pt>
                <c:pt idx="3630">
                  <c:v>869.6875</c:v>
                </c:pt>
                <c:pt idx="3631">
                  <c:v>869.92708333333303</c:v>
                </c:pt>
                <c:pt idx="3632">
                  <c:v>870.16666666666697</c:v>
                </c:pt>
                <c:pt idx="3633">
                  <c:v>870.40625</c:v>
                </c:pt>
                <c:pt idx="3634">
                  <c:v>870.64583333333303</c:v>
                </c:pt>
                <c:pt idx="3635">
                  <c:v>870.88541666666697</c:v>
                </c:pt>
                <c:pt idx="3636">
                  <c:v>871.125</c:v>
                </c:pt>
                <c:pt idx="3637">
                  <c:v>871.36458333333303</c:v>
                </c:pt>
                <c:pt idx="3638">
                  <c:v>871.60416666666697</c:v>
                </c:pt>
                <c:pt idx="3639">
                  <c:v>871.84375</c:v>
                </c:pt>
                <c:pt idx="3640">
                  <c:v>872.08333333333303</c:v>
                </c:pt>
                <c:pt idx="3641">
                  <c:v>872.32291666666697</c:v>
                </c:pt>
                <c:pt idx="3642">
                  <c:v>872.5625</c:v>
                </c:pt>
                <c:pt idx="3643">
                  <c:v>872.80208333333303</c:v>
                </c:pt>
                <c:pt idx="3644">
                  <c:v>873.04166666666697</c:v>
                </c:pt>
                <c:pt idx="3645">
                  <c:v>873.28125</c:v>
                </c:pt>
                <c:pt idx="3646">
                  <c:v>873.52083333333303</c:v>
                </c:pt>
                <c:pt idx="3647">
                  <c:v>873.76041666666697</c:v>
                </c:pt>
                <c:pt idx="3648">
                  <c:v>874</c:v>
                </c:pt>
                <c:pt idx="3649">
                  <c:v>874.23958333333303</c:v>
                </c:pt>
                <c:pt idx="3650">
                  <c:v>874.47916666666697</c:v>
                </c:pt>
                <c:pt idx="3651">
                  <c:v>874.71875</c:v>
                </c:pt>
                <c:pt idx="3652">
                  <c:v>874.95833333333303</c:v>
                </c:pt>
                <c:pt idx="3653">
                  <c:v>875.19791666666697</c:v>
                </c:pt>
                <c:pt idx="3654">
                  <c:v>875.4375</c:v>
                </c:pt>
                <c:pt idx="3655">
                  <c:v>875.67708333333303</c:v>
                </c:pt>
                <c:pt idx="3656">
                  <c:v>875.91666666666697</c:v>
                </c:pt>
                <c:pt idx="3657">
                  <c:v>876.15625</c:v>
                </c:pt>
                <c:pt idx="3658">
                  <c:v>876.39583333333303</c:v>
                </c:pt>
                <c:pt idx="3659">
                  <c:v>876.63541666666697</c:v>
                </c:pt>
                <c:pt idx="3660">
                  <c:v>876.875</c:v>
                </c:pt>
                <c:pt idx="3661">
                  <c:v>877.11458333333303</c:v>
                </c:pt>
                <c:pt idx="3662">
                  <c:v>877.35416666666697</c:v>
                </c:pt>
                <c:pt idx="3663">
                  <c:v>877.59375</c:v>
                </c:pt>
                <c:pt idx="3664">
                  <c:v>877.83333333333303</c:v>
                </c:pt>
                <c:pt idx="3665">
                  <c:v>878.07291666666697</c:v>
                </c:pt>
                <c:pt idx="3666">
                  <c:v>878.3125</c:v>
                </c:pt>
                <c:pt idx="3667">
                  <c:v>878.55208333333303</c:v>
                </c:pt>
                <c:pt idx="3668">
                  <c:v>878.79166666666697</c:v>
                </c:pt>
                <c:pt idx="3669">
                  <c:v>879.03125</c:v>
                </c:pt>
                <c:pt idx="3670">
                  <c:v>879.27083333333303</c:v>
                </c:pt>
                <c:pt idx="3671">
                  <c:v>879.51041666666697</c:v>
                </c:pt>
                <c:pt idx="3672">
                  <c:v>879.75</c:v>
                </c:pt>
                <c:pt idx="3673">
                  <c:v>879.98958333333303</c:v>
                </c:pt>
                <c:pt idx="3674">
                  <c:v>880.22916666666697</c:v>
                </c:pt>
                <c:pt idx="3675">
                  <c:v>880.46875</c:v>
                </c:pt>
                <c:pt idx="3676">
                  <c:v>880.70833333333303</c:v>
                </c:pt>
                <c:pt idx="3677">
                  <c:v>880.94791666666697</c:v>
                </c:pt>
                <c:pt idx="3678">
                  <c:v>881.1875</c:v>
                </c:pt>
                <c:pt idx="3679">
                  <c:v>881.42708333333303</c:v>
                </c:pt>
                <c:pt idx="3680">
                  <c:v>881.66666666666697</c:v>
                </c:pt>
                <c:pt idx="3681">
                  <c:v>881.90625</c:v>
                </c:pt>
                <c:pt idx="3682">
                  <c:v>882.14583333333303</c:v>
                </c:pt>
                <c:pt idx="3683">
                  <c:v>882.38541666666697</c:v>
                </c:pt>
                <c:pt idx="3684">
                  <c:v>882.625</c:v>
                </c:pt>
                <c:pt idx="3685">
                  <c:v>882.86458333333303</c:v>
                </c:pt>
                <c:pt idx="3686">
                  <c:v>883.10416666666697</c:v>
                </c:pt>
                <c:pt idx="3687">
                  <c:v>883.34375</c:v>
                </c:pt>
                <c:pt idx="3688">
                  <c:v>883.58333333333303</c:v>
                </c:pt>
                <c:pt idx="3689">
                  <c:v>883.82291666666697</c:v>
                </c:pt>
                <c:pt idx="3690">
                  <c:v>884.0625</c:v>
                </c:pt>
                <c:pt idx="3691">
                  <c:v>884.30208333333303</c:v>
                </c:pt>
                <c:pt idx="3692">
                  <c:v>884.54166666666697</c:v>
                </c:pt>
                <c:pt idx="3693">
                  <c:v>884.78125</c:v>
                </c:pt>
                <c:pt idx="3694">
                  <c:v>885.02083333333303</c:v>
                </c:pt>
                <c:pt idx="3695">
                  <c:v>885.26041666666697</c:v>
                </c:pt>
                <c:pt idx="3696">
                  <c:v>885.5</c:v>
                </c:pt>
                <c:pt idx="3697">
                  <c:v>885.73958333333303</c:v>
                </c:pt>
                <c:pt idx="3698">
                  <c:v>885.97916666666697</c:v>
                </c:pt>
                <c:pt idx="3699">
                  <c:v>886.21875</c:v>
                </c:pt>
                <c:pt idx="3700">
                  <c:v>886.45833333333303</c:v>
                </c:pt>
                <c:pt idx="3701">
                  <c:v>886.69791666666697</c:v>
                </c:pt>
                <c:pt idx="3702">
                  <c:v>886.9375</c:v>
                </c:pt>
                <c:pt idx="3703">
                  <c:v>887.17708333333303</c:v>
                </c:pt>
                <c:pt idx="3704">
                  <c:v>887.41666666666697</c:v>
                </c:pt>
                <c:pt idx="3705">
                  <c:v>887.65625</c:v>
                </c:pt>
                <c:pt idx="3706">
                  <c:v>887.89583333333303</c:v>
                </c:pt>
                <c:pt idx="3707">
                  <c:v>888.13541666666697</c:v>
                </c:pt>
                <c:pt idx="3708">
                  <c:v>888.375</c:v>
                </c:pt>
                <c:pt idx="3709">
                  <c:v>888.61458333333303</c:v>
                </c:pt>
                <c:pt idx="3710">
                  <c:v>888.85416666666697</c:v>
                </c:pt>
                <c:pt idx="3711">
                  <c:v>889.09375</c:v>
                </c:pt>
                <c:pt idx="3712">
                  <c:v>889.33333333333303</c:v>
                </c:pt>
                <c:pt idx="3713">
                  <c:v>889.57291666666697</c:v>
                </c:pt>
                <c:pt idx="3714">
                  <c:v>889.8125</c:v>
                </c:pt>
                <c:pt idx="3715">
                  <c:v>890.05208333333303</c:v>
                </c:pt>
                <c:pt idx="3716">
                  <c:v>890.29166666666697</c:v>
                </c:pt>
                <c:pt idx="3717">
                  <c:v>890.53125</c:v>
                </c:pt>
                <c:pt idx="3718">
                  <c:v>890.77083333333303</c:v>
                </c:pt>
                <c:pt idx="3719">
                  <c:v>891.01041666666697</c:v>
                </c:pt>
                <c:pt idx="3720">
                  <c:v>891.25</c:v>
                </c:pt>
                <c:pt idx="3721">
                  <c:v>891.48958333333303</c:v>
                </c:pt>
                <c:pt idx="3722">
                  <c:v>891.72916666666697</c:v>
                </c:pt>
                <c:pt idx="3723">
                  <c:v>891.96875</c:v>
                </c:pt>
                <c:pt idx="3724">
                  <c:v>892.20833333333303</c:v>
                </c:pt>
                <c:pt idx="3725">
                  <c:v>892.44791666666697</c:v>
                </c:pt>
                <c:pt idx="3726">
                  <c:v>892.6875</c:v>
                </c:pt>
                <c:pt idx="3727">
                  <c:v>892.92708333333303</c:v>
                </c:pt>
                <c:pt idx="3728">
                  <c:v>893.16666666666697</c:v>
                </c:pt>
                <c:pt idx="3729">
                  <c:v>893.40625</c:v>
                </c:pt>
                <c:pt idx="3730">
                  <c:v>893.64583333333303</c:v>
                </c:pt>
                <c:pt idx="3731">
                  <c:v>893.88541666666697</c:v>
                </c:pt>
                <c:pt idx="3732">
                  <c:v>894.125</c:v>
                </c:pt>
                <c:pt idx="3733">
                  <c:v>894.36458333333303</c:v>
                </c:pt>
                <c:pt idx="3734">
                  <c:v>894.60416666666697</c:v>
                </c:pt>
                <c:pt idx="3735">
                  <c:v>894.84375</c:v>
                </c:pt>
                <c:pt idx="3736">
                  <c:v>895.08333333333303</c:v>
                </c:pt>
                <c:pt idx="3737">
                  <c:v>895.32291666666697</c:v>
                </c:pt>
                <c:pt idx="3738">
                  <c:v>895.5625</c:v>
                </c:pt>
                <c:pt idx="3739">
                  <c:v>895.80208333333303</c:v>
                </c:pt>
                <c:pt idx="3740">
                  <c:v>896.04166666666697</c:v>
                </c:pt>
                <c:pt idx="3741">
                  <c:v>896.28125</c:v>
                </c:pt>
                <c:pt idx="3742">
                  <c:v>896.52083333333303</c:v>
                </c:pt>
                <c:pt idx="3743">
                  <c:v>896.76041666666697</c:v>
                </c:pt>
                <c:pt idx="3744">
                  <c:v>897</c:v>
                </c:pt>
                <c:pt idx="3745">
                  <c:v>897.23958333333303</c:v>
                </c:pt>
                <c:pt idx="3746">
                  <c:v>897.47916666666697</c:v>
                </c:pt>
                <c:pt idx="3747">
                  <c:v>897.71875</c:v>
                </c:pt>
                <c:pt idx="3748">
                  <c:v>897.95833333333303</c:v>
                </c:pt>
                <c:pt idx="3749">
                  <c:v>898.19791666666697</c:v>
                </c:pt>
                <c:pt idx="3750">
                  <c:v>898.4375</c:v>
                </c:pt>
                <c:pt idx="3751">
                  <c:v>898.67708333333303</c:v>
                </c:pt>
                <c:pt idx="3752">
                  <c:v>898.91666666666697</c:v>
                </c:pt>
                <c:pt idx="3753">
                  <c:v>899.15625</c:v>
                </c:pt>
                <c:pt idx="3754">
                  <c:v>899.39583333333303</c:v>
                </c:pt>
                <c:pt idx="3755">
                  <c:v>899.63541666666697</c:v>
                </c:pt>
                <c:pt idx="3756">
                  <c:v>899.875</c:v>
                </c:pt>
                <c:pt idx="3757">
                  <c:v>900.11458333333303</c:v>
                </c:pt>
                <c:pt idx="3758">
                  <c:v>900.35416666666697</c:v>
                </c:pt>
                <c:pt idx="3759">
                  <c:v>900.59375</c:v>
                </c:pt>
                <c:pt idx="3760">
                  <c:v>900.83333333333303</c:v>
                </c:pt>
                <c:pt idx="3761">
                  <c:v>901.07291666666697</c:v>
                </c:pt>
                <c:pt idx="3762">
                  <c:v>901.3125</c:v>
                </c:pt>
                <c:pt idx="3763">
                  <c:v>901.55208333333303</c:v>
                </c:pt>
                <c:pt idx="3764">
                  <c:v>901.79166666666697</c:v>
                </c:pt>
                <c:pt idx="3765">
                  <c:v>902.03125</c:v>
                </c:pt>
                <c:pt idx="3766">
                  <c:v>902.27083333333303</c:v>
                </c:pt>
                <c:pt idx="3767">
                  <c:v>902.51041666666697</c:v>
                </c:pt>
                <c:pt idx="3768">
                  <c:v>902.75</c:v>
                </c:pt>
                <c:pt idx="3769">
                  <c:v>902.98958333333303</c:v>
                </c:pt>
                <c:pt idx="3770">
                  <c:v>903.22916666666697</c:v>
                </c:pt>
                <c:pt idx="3771">
                  <c:v>903.46875</c:v>
                </c:pt>
                <c:pt idx="3772">
                  <c:v>903.70833333333303</c:v>
                </c:pt>
                <c:pt idx="3773">
                  <c:v>903.94791666666697</c:v>
                </c:pt>
                <c:pt idx="3774">
                  <c:v>904.1875</c:v>
                </c:pt>
                <c:pt idx="3775">
                  <c:v>904.42708333333303</c:v>
                </c:pt>
                <c:pt idx="3776">
                  <c:v>904.66666666666697</c:v>
                </c:pt>
                <c:pt idx="3777">
                  <c:v>904.90625</c:v>
                </c:pt>
                <c:pt idx="3778">
                  <c:v>905.14583333333303</c:v>
                </c:pt>
                <c:pt idx="3779">
                  <c:v>905.38541666666697</c:v>
                </c:pt>
                <c:pt idx="3780">
                  <c:v>905.625</c:v>
                </c:pt>
                <c:pt idx="3781">
                  <c:v>905.86458333333303</c:v>
                </c:pt>
                <c:pt idx="3782">
                  <c:v>906.10416666666697</c:v>
                </c:pt>
                <c:pt idx="3783">
                  <c:v>906.34375</c:v>
                </c:pt>
                <c:pt idx="3784">
                  <c:v>906.58333333333303</c:v>
                </c:pt>
                <c:pt idx="3785">
                  <c:v>906.82291666666697</c:v>
                </c:pt>
                <c:pt idx="3786">
                  <c:v>907.0625</c:v>
                </c:pt>
                <c:pt idx="3787">
                  <c:v>907.30208333333303</c:v>
                </c:pt>
                <c:pt idx="3788">
                  <c:v>907.54166666666697</c:v>
                </c:pt>
                <c:pt idx="3789">
                  <c:v>907.78125</c:v>
                </c:pt>
                <c:pt idx="3790">
                  <c:v>908.02083333333303</c:v>
                </c:pt>
                <c:pt idx="3791">
                  <c:v>908.26041666666697</c:v>
                </c:pt>
                <c:pt idx="3792">
                  <c:v>908.5</c:v>
                </c:pt>
                <c:pt idx="3793">
                  <c:v>908.73958333333303</c:v>
                </c:pt>
                <c:pt idx="3794">
                  <c:v>908.97916666666697</c:v>
                </c:pt>
                <c:pt idx="3795">
                  <c:v>909.21875</c:v>
                </c:pt>
                <c:pt idx="3796">
                  <c:v>909.45833333333303</c:v>
                </c:pt>
                <c:pt idx="3797">
                  <c:v>909.69791666666697</c:v>
                </c:pt>
                <c:pt idx="3798">
                  <c:v>909.9375</c:v>
                </c:pt>
                <c:pt idx="3799">
                  <c:v>910.17708333333303</c:v>
                </c:pt>
                <c:pt idx="3800">
                  <c:v>910.41666666666697</c:v>
                </c:pt>
                <c:pt idx="3801">
                  <c:v>910.65625</c:v>
                </c:pt>
                <c:pt idx="3802">
                  <c:v>910.89583333333303</c:v>
                </c:pt>
                <c:pt idx="3803">
                  <c:v>911.13541666666697</c:v>
                </c:pt>
                <c:pt idx="3804">
                  <c:v>911.375</c:v>
                </c:pt>
                <c:pt idx="3805">
                  <c:v>911.61458333333303</c:v>
                </c:pt>
                <c:pt idx="3806">
                  <c:v>911.85416666666697</c:v>
                </c:pt>
                <c:pt idx="3807">
                  <c:v>912.09375</c:v>
                </c:pt>
                <c:pt idx="3808">
                  <c:v>912.33333333333303</c:v>
                </c:pt>
                <c:pt idx="3809">
                  <c:v>912.57291666666697</c:v>
                </c:pt>
                <c:pt idx="3810">
                  <c:v>912.8125</c:v>
                </c:pt>
                <c:pt idx="3811">
                  <c:v>913.05208333333303</c:v>
                </c:pt>
                <c:pt idx="3812">
                  <c:v>913.29166666666697</c:v>
                </c:pt>
                <c:pt idx="3813">
                  <c:v>913.53125</c:v>
                </c:pt>
                <c:pt idx="3814">
                  <c:v>913.77083333333303</c:v>
                </c:pt>
                <c:pt idx="3815">
                  <c:v>914.01041666666697</c:v>
                </c:pt>
                <c:pt idx="3816">
                  <c:v>914.25</c:v>
                </c:pt>
                <c:pt idx="3817">
                  <c:v>914.48958333333303</c:v>
                </c:pt>
                <c:pt idx="3818">
                  <c:v>914.72916666666697</c:v>
                </c:pt>
                <c:pt idx="3819">
                  <c:v>914.96875</c:v>
                </c:pt>
                <c:pt idx="3820">
                  <c:v>915.20833333333303</c:v>
                </c:pt>
                <c:pt idx="3821">
                  <c:v>915.44791666666697</c:v>
                </c:pt>
                <c:pt idx="3822">
                  <c:v>915.6875</c:v>
                </c:pt>
                <c:pt idx="3823">
                  <c:v>915.92708333333303</c:v>
                </c:pt>
                <c:pt idx="3824">
                  <c:v>916.16666666666697</c:v>
                </c:pt>
                <c:pt idx="3825">
                  <c:v>916.40625</c:v>
                </c:pt>
                <c:pt idx="3826">
                  <c:v>916.64583333333303</c:v>
                </c:pt>
                <c:pt idx="3827">
                  <c:v>916.88541666666697</c:v>
                </c:pt>
                <c:pt idx="3828">
                  <c:v>917.125</c:v>
                </c:pt>
                <c:pt idx="3829">
                  <c:v>917.36458333333303</c:v>
                </c:pt>
                <c:pt idx="3830">
                  <c:v>917.60416666666697</c:v>
                </c:pt>
                <c:pt idx="3831">
                  <c:v>917.84375</c:v>
                </c:pt>
                <c:pt idx="3832">
                  <c:v>918.08333333333303</c:v>
                </c:pt>
                <c:pt idx="3833">
                  <c:v>918.32291666666697</c:v>
                </c:pt>
                <c:pt idx="3834">
                  <c:v>918.5625</c:v>
                </c:pt>
                <c:pt idx="3835">
                  <c:v>918.80208333333303</c:v>
                </c:pt>
                <c:pt idx="3836">
                  <c:v>919.04166666666697</c:v>
                </c:pt>
                <c:pt idx="3837">
                  <c:v>919.28125</c:v>
                </c:pt>
                <c:pt idx="3838">
                  <c:v>919.52083333333303</c:v>
                </c:pt>
                <c:pt idx="3839">
                  <c:v>919.76041666666697</c:v>
                </c:pt>
                <c:pt idx="3840">
                  <c:v>920</c:v>
                </c:pt>
                <c:pt idx="3841">
                  <c:v>920.23958333333303</c:v>
                </c:pt>
                <c:pt idx="3842">
                  <c:v>920.47916666666697</c:v>
                </c:pt>
                <c:pt idx="3843">
                  <c:v>920.71875</c:v>
                </c:pt>
                <c:pt idx="3844">
                  <c:v>920.95833333333303</c:v>
                </c:pt>
                <c:pt idx="3845">
                  <c:v>921.19791666666697</c:v>
                </c:pt>
                <c:pt idx="3846">
                  <c:v>921.4375</c:v>
                </c:pt>
                <c:pt idx="3847">
                  <c:v>921.67708333333303</c:v>
                </c:pt>
                <c:pt idx="3848">
                  <c:v>921.91666666666697</c:v>
                </c:pt>
                <c:pt idx="3849">
                  <c:v>922.15625</c:v>
                </c:pt>
                <c:pt idx="3850">
                  <c:v>922.39583333333303</c:v>
                </c:pt>
                <c:pt idx="3851">
                  <c:v>922.63541666666697</c:v>
                </c:pt>
                <c:pt idx="3852">
                  <c:v>922.875</c:v>
                </c:pt>
                <c:pt idx="3853">
                  <c:v>923.11458333333303</c:v>
                </c:pt>
                <c:pt idx="3854">
                  <c:v>923.35416666666697</c:v>
                </c:pt>
                <c:pt idx="3855">
                  <c:v>923.59375</c:v>
                </c:pt>
                <c:pt idx="3856">
                  <c:v>923.83333333333303</c:v>
                </c:pt>
                <c:pt idx="3857">
                  <c:v>924.07291666666697</c:v>
                </c:pt>
                <c:pt idx="3858">
                  <c:v>924.3125</c:v>
                </c:pt>
                <c:pt idx="3859">
                  <c:v>924.55208333333303</c:v>
                </c:pt>
                <c:pt idx="3860">
                  <c:v>924.79166666666697</c:v>
                </c:pt>
                <c:pt idx="3861">
                  <c:v>925.03125</c:v>
                </c:pt>
                <c:pt idx="3862">
                  <c:v>925.27083333333303</c:v>
                </c:pt>
                <c:pt idx="3863">
                  <c:v>925.51041666666697</c:v>
                </c:pt>
                <c:pt idx="3864">
                  <c:v>925.75</c:v>
                </c:pt>
                <c:pt idx="3865">
                  <c:v>925.98958333333303</c:v>
                </c:pt>
                <c:pt idx="3866">
                  <c:v>926.22916666666697</c:v>
                </c:pt>
                <c:pt idx="3867">
                  <c:v>926.46875</c:v>
                </c:pt>
                <c:pt idx="3868">
                  <c:v>926.70833333333303</c:v>
                </c:pt>
                <c:pt idx="3869">
                  <c:v>926.94791666666697</c:v>
                </c:pt>
                <c:pt idx="3870">
                  <c:v>927.1875</c:v>
                </c:pt>
                <c:pt idx="3871">
                  <c:v>927.42708333333303</c:v>
                </c:pt>
                <c:pt idx="3872">
                  <c:v>927.66666666666697</c:v>
                </c:pt>
                <c:pt idx="3873">
                  <c:v>927.90625</c:v>
                </c:pt>
                <c:pt idx="3874">
                  <c:v>928.14583333333303</c:v>
                </c:pt>
                <c:pt idx="3875">
                  <c:v>928.38541666666697</c:v>
                </c:pt>
                <c:pt idx="3876">
                  <c:v>928.625</c:v>
                </c:pt>
                <c:pt idx="3877">
                  <c:v>928.86458333333303</c:v>
                </c:pt>
                <c:pt idx="3878">
                  <c:v>929.10416666666697</c:v>
                </c:pt>
                <c:pt idx="3879">
                  <c:v>929.34375</c:v>
                </c:pt>
                <c:pt idx="3880">
                  <c:v>929.58333333333303</c:v>
                </c:pt>
                <c:pt idx="3881">
                  <c:v>929.82291666666697</c:v>
                </c:pt>
                <c:pt idx="3882">
                  <c:v>930.0625</c:v>
                </c:pt>
                <c:pt idx="3883">
                  <c:v>930.30208333333303</c:v>
                </c:pt>
                <c:pt idx="3884">
                  <c:v>930.54166666666697</c:v>
                </c:pt>
                <c:pt idx="3885">
                  <c:v>930.78125</c:v>
                </c:pt>
                <c:pt idx="3886">
                  <c:v>931.02083333333303</c:v>
                </c:pt>
                <c:pt idx="3887">
                  <c:v>931.26041666666697</c:v>
                </c:pt>
                <c:pt idx="3888">
                  <c:v>931.5</c:v>
                </c:pt>
                <c:pt idx="3889">
                  <c:v>931.73958333333303</c:v>
                </c:pt>
                <c:pt idx="3890">
                  <c:v>931.97916666666697</c:v>
                </c:pt>
                <c:pt idx="3891">
                  <c:v>932.21875</c:v>
                </c:pt>
                <c:pt idx="3892">
                  <c:v>932.45833333333303</c:v>
                </c:pt>
                <c:pt idx="3893">
                  <c:v>932.69791666666697</c:v>
                </c:pt>
                <c:pt idx="3894">
                  <c:v>932.9375</c:v>
                </c:pt>
                <c:pt idx="3895">
                  <c:v>933.17708333333303</c:v>
                </c:pt>
                <c:pt idx="3896">
                  <c:v>933.41666666666697</c:v>
                </c:pt>
                <c:pt idx="3897">
                  <c:v>933.65625</c:v>
                </c:pt>
                <c:pt idx="3898">
                  <c:v>933.89583333333303</c:v>
                </c:pt>
                <c:pt idx="3899">
                  <c:v>934.13541666666697</c:v>
                </c:pt>
                <c:pt idx="3900">
                  <c:v>934.375</c:v>
                </c:pt>
                <c:pt idx="3901">
                  <c:v>934.61458333333303</c:v>
                </c:pt>
                <c:pt idx="3902">
                  <c:v>934.85416666666697</c:v>
                </c:pt>
                <c:pt idx="3903">
                  <c:v>935.09375</c:v>
                </c:pt>
                <c:pt idx="3904">
                  <c:v>935.33333333333303</c:v>
                </c:pt>
                <c:pt idx="3905">
                  <c:v>935.57291666666697</c:v>
                </c:pt>
                <c:pt idx="3906">
                  <c:v>935.8125</c:v>
                </c:pt>
                <c:pt idx="3907">
                  <c:v>936.05208333333303</c:v>
                </c:pt>
                <c:pt idx="3908">
                  <c:v>936.29166666666697</c:v>
                </c:pt>
                <c:pt idx="3909">
                  <c:v>936.53125</c:v>
                </c:pt>
                <c:pt idx="3910">
                  <c:v>936.77083333333303</c:v>
                </c:pt>
                <c:pt idx="3911">
                  <c:v>937.01041666666697</c:v>
                </c:pt>
                <c:pt idx="3912">
                  <c:v>937.25</c:v>
                </c:pt>
                <c:pt idx="3913">
                  <c:v>937.48958333333303</c:v>
                </c:pt>
                <c:pt idx="3914">
                  <c:v>937.72916666666697</c:v>
                </c:pt>
                <c:pt idx="3915">
                  <c:v>937.96875</c:v>
                </c:pt>
                <c:pt idx="3916">
                  <c:v>938.20833333333303</c:v>
                </c:pt>
                <c:pt idx="3917">
                  <c:v>938.44791666666697</c:v>
                </c:pt>
                <c:pt idx="3918">
                  <c:v>938.6875</c:v>
                </c:pt>
                <c:pt idx="3919">
                  <c:v>938.92708333333303</c:v>
                </c:pt>
                <c:pt idx="3920">
                  <c:v>939.16666666666697</c:v>
                </c:pt>
                <c:pt idx="3921">
                  <c:v>939.40625</c:v>
                </c:pt>
                <c:pt idx="3922">
                  <c:v>939.64583333333303</c:v>
                </c:pt>
                <c:pt idx="3923">
                  <c:v>939.88541666666697</c:v>
                </c:pt>
                <c:pt idx="3924">
                  <c:v>940.125</c:v>
                </c:pt>
                <c:pt idx="3925">
                  <c:v>940.36458333333303</c:v>
                </c:pt>
                <c:pt idx="3926">
                  <c:v>940.60416666666697</c:v>
                </c:pt>
                <c:pt idx="3927">
                  <c:v>940.84375</c:v>
                </c:pt>
                <c:pt idx="3928">
                  <c:v>941.08333333333303</c:v>
                </c:pt>
                <c:pt idx="3929">
                  <c:v>941.32291666666697</c:v>
                </c:pt>
                <c:pt idx="3930">
                  <c:v>941.5625</c:v>
                </c:pt>
                <c:pt idx="3931">
                  <c:v>941.80208333333303</c:v>
                </c:pt>
                <c:pt idx="3932">
                  <c:v>942.04166666666697</c:v>
                </c:pt>
                <c:pt idx="3933">
                  <c:v>942.28125</c:v>
                </c:pt>
                <c:pt idx="3934">
                  <c:v>942.52083333333303</c:v>
                </c:pt>
                <c:pt idx="3935">
                  <c:v>942.76041666666697</c:v>
                </c:pt>
                <c:pt idx="3936">
                  <c:v>943</c:v>
                </c:pt>
                <c:pt idx="3937">
                  <c:v>943.23958333333303</c:v>
                </c:pt>
                <c:pt idx="3938">
                  <c:v>943.47916666666697</c:v>
                </c:pt>
                <c:pt idx="3939">
                  <c:v>943.71875</c:v>
                </c:pt>
                <c:pt idx="3940">
                  <c:v>943.95833333333303</c:v>
                </c:pt>
                <c:pt idx="3941">
                  <c:v>944.19791666666697</c:v>
                </c:pt>
                <c:pt idx="3942">
                  <c:v>944.4375</c:v>
                </c:pt>
                <c:pt idx="3943">
                  <c:v>944.67708333333303</c:v>
                </c:pt>
                <c:pt idx="3944">
                  <c:v>944.91666666666697</c:v>
                </c:pt>
                <c:pt idx="3945">
                  <c:v>945.15625</c:v>
                </c:pt>
                <c:pt idx="3946">
                  <c:v>945.39583333333303</c:v>
                </c:pt>
                <c:pt idx="3947">
                  <c:v>945.63541666666697</c:v>
                </c:pt>
                <c:pt idx="3948">
                  <c:v>945.875</c:v>
                </c:pt>
                <c:pt idx="3949">
                  <c:v>946.11458333333303</c:v>
                </c:pt>
                <c:pt idx="3950">
                  <c:v>946.35416666666697</c:v>
                </c:pt>
                <c:pt idx="3951">
                  <c:v>946.59375</c:v>
                </c:pt>
                <c:pt idx="3952">
                  <c:v>946.83333333333303</c:v>
                </c:pt>
                <c:pt idx="3953">
                  <c:v>947.07291666666697</c:v>
                </c:pt>
                <c:pt idx="3954">
                  <c:v>947.3125</c:v>
                </c:pt>
                <c:pt idx="3955">
                  <c:v>947.55208333333303</c:v>
                </c:pt>
                <c:pt idx="3956">
                  <c:v>947.79166666666697</c:v>
                </c:pt>
                <c:pt idx="3957">
                  <c:v>948.03125</c:v>
                </c:pt>
                <c:pt idx="3958">
                  <c:v>948.27083333333303</c:v>
                </c:pt>
                <c:pt idx="3959">
                  <c:v>948.51041666666697</c:v>
                </c:pt>
                <c:pt idx="3960">
                  <c:v>948.75</c:v>
                </c:pt>
                <c:pt idx="3961">
                  <c:v>948.98958333333303</c:v>
                </c:pt>
                <c:pt idx="3962">
                  <c:v>949.22916666666697</c:v>
                </c:pt>
                <c:pt idx="3963">
                  <c:v>949.46875</c:v>
                </c:pt>
                <c:pt idx="3964">
                  <c:v>949.70833333333303</c:v>
                </c:pt>
                <c:pt idx="3965">
                  <c:v>949.94791666666697</c:v>
                </c:pt>
                <c:pt idx="3966">
                  <c:v>950.1875</c:v>
                </c:pt>
                <c:pt idx="3967">
                  <c:v>950.42708333333303</c:v>
                </c:pt>
                <c:pt idx="3968">
                  <c:v>950.66666666666697</c:v>
                </c:pt>
                <c:pt idx="3969">
                  <c:v>950.90625</c:v>
                </c:pt>
                <c:pt idx="3970">
                  <c:v>951.14583333333303</c:v>
                </c:pt>
                <c:pt idx="3971">
                  <c:v>951.38541666666697</c:v>
                </c:pt>
                <c:pt idx="3972">
                  <c:v>951.625</c:v>
                </c:pt>
                <c:pt idx="3973">
                  <c:v>951.86458333333303</c:v>
                </c:pt>
                <c:pt idx="3974">
                  <c:v>952.10416666666697</c:v>
                </c:pt>
                <c:pt idx="3975">
                  <c:v>952.34375</c:v>
                </c:pt>
                <c:pt idx="3976">
                  <c:v>952.58333333333303</c:v>
                </c:pt>
                <c:pt idx="3977">
                  <c:v>952.82291666666697</c:v>
                </c:pt>
                <c:pt idx="3978">
                  <c:v>953.0625</c:v>
                </c:pt>
                <c:pt idx="3979">
                  <c:v>953.30208333333303</c:v>
                </c:pt>
                <c:pt idx="3980">
                  <c:v>953.54166666666697</c:v>
                </c:pt>
                <c:pt idx="3981">
                  <c:v>953.78125</c:v>
                </c:pt>
                <c:pt idx="3982">
                  <c:v>954.02083333333303</c:v>
                </c:pt>
                <c:pt idx="3983">
                  <c:v>954.26041666666697</c:v>
                </c:pt>
                <c:pt idx="3984">
                  <c:v>954.5</c:v>
                </c:pt>
                <c:pt idx="3985">
                  <c:v>954.73958333333303</c:v>
                </c:pt>
                <c:pt idx="3986">
                  <c:v>954.97916666666697</c:v>
                </c:pt>
                <c:pt idx="3987">
                  <c:v>955.21875</c:v>
                </c:pt>
                <c:pt idx="3988">
                  <c:v>955.45833333333303</c:v>
                </c:pt>
                <c:pt idx="3989">
                  <c:v>955.69791666666697</c:v>
                </c:pt>
                <c:pt idx="3990">
                  <c:v>955.9375</c:v>
                </c:pt>
                <c:pt idx="3991">
                  <c:v>956.17708333333303</c:v>
                </c:pt>
                <c:pt idx="3992">
                  <c:v>956.41666666666697</c:v>
                </c:pt>
                <c:pt idx="3993">
                  <c:v>956.65625</c:v>
                </c:pt>
                <c:pt idx="3994">
                  <c:v>956.89583333333303</c:v>
                </c:pt>
                <c:pt idx="3995">
                  <c:v>957.13541666666697</c:v>
                </c:pt>
                <c:pt idx="3996">
                  <c:v>957.375</c:v>
                </c:pt>
                <c:pt idx="3997">
                  <c:v>957.61458333333303</c:v>
                </c:pt>
                <c:pt idx="3998">
                  <c:v>957.85416666666697</c:v>
                </c:pt>
                <c:pt idx="3999">
                  <c:v>958.09375</c:v>
                </c:pt>
                <c:pt idx="4000">
                  <c:v>958.33333333333303</c:v>
                </c:pt>
                <c:pt idx="4001">
                  <c:v>958.57291666666697</c:v>
                </c:pt>
                <c:pt idx="4002">
                  <c:v>958.8125</c:v>
                </c:pt>
                <c:pt idx="4003">
                  <c:v>959.05208333333303</c:v>
                </c:pt>
                <c:pt idx="4004">
                  <c:v>959.29166666666697</c:v>
                </c:pt>
                <c:pt idx="4005">
                  <c:v>959.53125</c:v>
                </c:pt>
                <c:pt idx="4006">
                  <c:v>959.77083333333303</c:v>
                </c:pt>
                <c:pt idx="4007">
                  <c:v>960.01041666666697</c:v>
                </c:pt>
                <c:pt idx="4008">
                  <c:v>960.25</c:v>
                </c:pt>
                <c:pt idx="4009">
                  <c:v>960.48958333333303</c:v>
                </c:pt>
                <c:pt idx="4010">
                  <c:v>960.72916666666697</c:v>
                </c:pt>
                <c:pt idx="4011">
                  <c:v>960.96875</c:v>
                </c:pt>
                <c:pt idx="4012">
                  <c:v>961.20833333333303</c:v>
                </c:pt>
                <c:pt idx="4013">
                  <c:v>961.44791666666697</c:v>
                </c:pt>
                <c:pt idx="4014">
                  <c:v>961.6875</c:v>
                </c:pt>
                <c:pt idx="4015">
                  <c:v>961.92708333333303</c:v>
                </c:pt>
                <c:pt idx="4016">
                  <c:v>962.16666666666697</c:v>
                </c:pt>
                <c:pt idx="4017">
                  <c:v>962.40625</c:v>
                </c:pt>
                <c:pt idx="4018">
                  <c:v>962.64583333333303</c:v>
                </c:pt>
                <c:pt idx="4019">
                  <c:v>962.88541666666697</c:v>
                </c:pt>
                <c:pt idx="4020">
                  <c:v>963.125</c:v>
                </c:pt>
                <c:pt idx="4021">
                  <c:v>963.36458333333303</c:v>
                </c:pt>
                <c:pt idx="4022">
                  <c:v>963.60416666666697</c:v>
                </c:pt>
                <c:pt idx="4023">
                  <c:v>963.84375</c:v>
                </c:pt>
                <c:pt idx="4024">
                  <c:v>964.08333333333303</c:v>
                </c:pt>
                <c:pt idx="4025">
                  <c:v>964.32291666666697</c:v>
                </c:pt>
                <c:pt idx="4026">
                  <c:v>964.5625</c:v>
                </c:pt>
                <c:pt idx="4027">
                  <c:v>964.80208333333303</c:v>
                </c:pt>
                <c:pt idx="4028">
                  <c:v>965.04166666666697</c:v>
                </c:pt>
                <c:pt idx="4029">
                  <c:v>965.28125</c:v>
                </c:pt>
                <c:pt idx="4030">
                  <c:v>965.52083333333303</c:v>
                </c:pt>
                <c:pt idx="4031">
                  <c:v>965.76041666666697</c:v>
                </c:pt>
                <c:pt idx="4032">
                  <c:v>966</c:v>
                </c:pt>
                <c:pt idx="4033">
                  <c:v>966.23958333333303</c:v>
                </c:pt>
                <c:pt idx="4034">
                  <c:v>966.47916666666697</c:v>
                </c:pt>
                <c:pt idx="4035">
                  <c:v>966.71875</c:v>
                </c:pt>
                <c:pt idx="4036">
                  <c:v>966.95833333333303</c:v>
                </c:pt>
                <c:pt idx="4037">
                  <c:v>967.19791666666697</c:v>
                </c:pt>
                <c:pt idx="4038">
                  <c:v>967.4375</c:v>
                </c:pt>
                <c:pt idx="4039">
                  <c:v>967.67708333333303</c:v>
                </c:pt>
                <c:pt idx="4040">
                  <c:v>967.91666666666697</c:v>
                </c:pt>
                <c:pt idx="4041">
                  <c:v>968.15625</c:v>
                </c:pt>
                <c:pt idx="4042">
                  <c:v>968.39583333333303</c:v>
                </c:pt>
                <c:pt idx="4043">
                  <c:v>968.63541666666697</c:v>
                </c:pt>
                <c:pt idx="4044">
                  <c:v>968.875</c:v>
                </c:pt>
                <c:pt idx="4045">
                  <c:v>969.11458333333303</c:v>
                </c:pt>
                <c:pt idx="4046">
                  <c:v>969.35416666666697</c:v>
                </c:pt>
                <c:pt idx="4047">
                  <c:v>969.59375</c:v>
                </c:pt>
                <c:pt idx="4048">
                  <c:v>969.83333333333303</c:v>
                </c:pt>
                <c:pt idx="4049">
                  <c:v>970.07291666666697</c:v>
                </c:pt>
                <c:pt idx="4050">
                  <c:v>970.3125</c:v>
                </c:pt>
                <c:pt idx="4051">
                  <c:v>970.55208333333303</c:v>
                </c:pt>
                <c:pt idx="4052">
                  <c:v>970.79166666666697</c:v>
                </c:pt>
                <c:pt idx="4053">
                  <c:v>971.03125</c:v>
                </c:pt>
                <c:pt idx="4054">
                  <c:v>971.27083333333303</c:v>
                </c:pt>
                <c:pt idx="4055">
                  <c:v>971.51041666666697</c:v>
                </c:pt>
                <c:pt idx="4056">
                  <c:v>971.75</c:v>
                </c:pt>
                <c:pt idx="4057">
                  <c:v>971.98958333333303</c:v>
                </c:pt>
                <c:pt idx="4058">
                  <c:v>972.22916666666697</c:v>
                </c:pt>
                <c:pt idx="4059">
                  <c:v>972.46875</c:v>
                </c:pt>
                <c:pt idx="4060">
                  <c:v>972.70833333333303</c:v>
                </c:pt>
                <c:pt idx="4061">
                  <c:v>972.94791666666697</c:v>
                </c:pt>
                <c:pt idx="4062">
                  <c:v>973.1875</c:v>
                </c:pt>
                <c:pt idx="4063">
                  <c:v>973.42708333333303</c:v>
                </c:pt>
                <c:pt idx="4064">
                  <c:v>973.66666666666697</c:v>
                </c:pt>
                <c:pt idx="4065">
                  <c:v>973.90625</c:v>
                </c:pt>
                <c:pt idx="4066">
                  <c:v>974.14583333333303</c:v>
                </c:pt>
                <c:pt idx="4067">
                  <c:v>974.38541666666697</c:v>
                </c:pt>
                <c:pt idx="4068">
                  <c:v>974.625</c:v>
                </c:pt>
                <c:pt idx="4069">
                  <c:v>974.86458333333303</c:v>
                </c:pt>
                <c:pt idx="4070">
                  <c:v>975.10416666666697</c:v>
                </c:pt>
                <c:pt idx="4071">
                  <c:v>975.34375</c:v>
                </c:pt>
                <c:pt idx="4072">
                  <c:v>975.58333333333303</c:v>
                </c:pt>
                <c:pt idx="4073">
                  <c:v>975.82291666666697</c:v>
                </c:pt>
                <c:pt idx="4074">
                  <c:v>976.0625</c:v>
                </c:pt>
                <c:pt idx="4075">
                  <c:v>976.30208333333303</c:v>
                </c:pt>
                <c:pt idx="4076">
                  <c:v>976.54166666666697</c:v>
                </c:pt>
                <c:pt idx="4077">
                  <c:v>976.78125</c:v>
                </c:pt>
                <c:pt idx="4078">
                  <c:v>977.02083333333303</c:v>
                </c:pt>
                <c:pt idx="4079">
                  <c:v>977.26041666666697</c:v>
                </c:pt>
                <c:pt idx="4080">
                  <c:v>977.5</c:v>
                </c:pt>
                <c:pt idx="4081">
                  <c:v>977.73958333333303</c:v>
                </c:pt>
                <c:pt idx="4082">
                  <c:v>977.97916666666697</c:v>
                </c:pt>
                <c:pt idx="4083">
                  <c:v>978.21875</c:v>
                </c:pt>
                <c:pt idx="4084">
                  <c:v>978.45833333333303</c:v>
                </c:pt>
                <c:pt idx="4085">
                  <c:v>978.69791666666697</c:v>
                </c:pt>
                <c:pt idx="4086">
                  <c:v>978.9375</c:v>
                </c:pt>
                <c:pt idx="4087">
                  <c:v>979.17708333333303</c:v>
                </c:pt>
                <c:pt idx="4088">
                  <c:v>979.41666666666697</c:v>
                </c:pt>
                <c:pt idx="4089">
                  <c:v>979.65625</c:v>
                </c:pt>
                <c:pt idx="4090">
                  <c:v>979.89583333333303</c:v>
                </c:pt>
                <c:pt idx="4091">
                  <c:v>980.13541666666697</c:v>
                </c:pt>
                <c:pt idx="4092">
                  <c:v>980.375</c:v>
                </c:pt>
                <c:pt idx="4093">
                  <c:v>980.61458333333303</c:v>
                </c:pt>
                <c:pt idx="4094">
                  <c:v>980.85416666666697</c:v>
                </c:pt>
                <c:pt idx="4095">
                  <c:v>981.09375</c:v>
                </c:pt>
                <c:pt idx="4096">
                  <c:v>981.33333333333303</c:v>
                </c:pt>
                <c:pt idx="4097">
                  <c:v>981.57291666666697</c:v>
                </c:pt>
                <c:pt idx="4098">
                  <c:v>981.8125</c:v>
                </c:pt>
                <c:pt idx="4099">
                  <c:v>982.05208333333303</c:v>
                </c:pt>
                <c:pt idx="4100">
                  <c:v>982.29166666666697</c:v>
                </c:pt>
                <c:pt idx="4101">
                  <c:v>982.53125</c:v>
                </c:pt>
                <c:pt idx="4102">
                  <c:v>982.77083333333303</c:v>
                </c:pt>
                <c:pt idx="4103">
                  <c:v>983.01041666666697</c:v>
                </c:pt>
                <c:pt idx="4104">
                  <c:v>983.25</c:v>
                </c:pt>
                <c:pt idx="4105">
                  <c:v>983.48958333333303</c:v>
                </c:pt>
                <c:pt idx="4106">
                  <c:v>983.72916666666697</c:v>
                </c:pt>
                <c:pt idx="4107">
                  <c:v>983.96875</c:v>
                </c:pt>
                <c:pt idx="4108">
                  <c:v>984.20833333333303</c:v>
                </c:pt>
                <c:pt idx="4109">
                  <c:v>984.44791666666697</c:v>
                </c:pt>
                <c:pt idx="4110">
                  <c:v>984.6875</c:v>
                </c:pt>
                <c:pt idx="4111">
                  <c:v>984.92708333333303</c:v>
                </c:pt>
                <c:pt idx="4112">
                  <c:v>985.16666666666697</c:v>
                </c:pt>
                <c:pt idx="4113">
                  <c:v>985.40625</c:v>
                </c:pt>
                <c:pt idx="4114">
                  <c:v>985.64583333333303</c:v>
                </c:pt>
                <c:pt idx="4115">
                  <c:v>985.88541666666697</c:v>
                </c:pt>
                <c:pt idx="4116">
                  <c:v>986.125</c:v>
                </c:pt>
                <c:pt idx="4117">
                  <c:v>986.36458333333303</c:v>
                </c:pt>
                <c:pt idx="4118">
                  <c:v>986.60416666666697</c:v>
                </c:pt>
                <c:pt idx="4119">
                  <c:v>986.84375</c:v>
                </c:pt>
                <c:pt idx="4120">
                  <c:v>987.08333333333303</c:v>
                </c:pt>
                <c:pt idx="4121">
                  <c:v>987.32291666666697</c:v>
                </c:pt>
                <c:pt idx="4122">
                  <c:v>987.5625</c:v>
                </c:pt>
                <c:pt idx="4123">
                  <c:v>987.80208333333303</c:v>
                </c:pt>
                <c:pt idx="4124">
                  <c:v>988.04166666666697</c:v>
                </c:pt>
                <c:pt idx="4125">
                  <c:v>988.28125</c:v>
                </c:pt>
                <c:pt idx="4126">
                  <c:v>988.52083333333303</c:v>
                </c:pt>
                <c:pt idx="4127">
                  <c:v>988.76041666666697</c:v>
                </c:pt>
                <c:pt idx="4128">
                  <c:v>989</c:v>
                </c:pt>
                <c:pt idx="4129">
                  <c:v>989.23958333333303</c:v>
                </c:pt>
                <c:pt idx="4130">
                  <c:v>989.47916666666697</c:v>
                </c:pt>
                <c:pt idx="4131">
                  <c:v>989.71875</c:v>
                </c:pt>
                <c:pt idx="4132">
                  <c:v>989.95833333333303</c:v>
                </c:pt>
                <c:pt idx="4133">
                  <c:v>990.19791666666697</c:v>
                </c:pt>
                <c:pt idx="4134">
                  <c:v>990.4375</c:v>
                </c:pt>
                <c:pt idx="4135">
                  <c:v>990.67708333333303</c:v>
                </c:pt>
                <c:pt idx="4136">
                  <c:v>990.91666666666697</c:v>
                </c:pt>
                <c:pt idx="4137">
                  <c:v>991.15625</c:v>
                </c:pt>
                <c:pt idx="4138">
                  <c:v>991.39583333333303</c:v>
                </c:pt>
                <c:pt idx="4139">
                  <c:v>991.63541666666697</c:v>
                </c:pt>
                <c:pt idx="4140">
                  <c:v>991.875</c:v>
                </c:pt>
                <c:pt idx="4141">
                  <c:v>992.11458333333303</c:v>
                </c:pt>
                <c:pt idx="4142">
                  <c:v>992.35416666666697</c:v>
                </c:pt>
                <c:pt idx="4143">
                  <c:v>992.59375</c:v>
                </c:pt>
                <c:pt idx="4144">
                  <c:v>992.83333333333303</c:v>
                </c:pt>
                <c:pt idx="4145">
                  <c:v>993.07291666666697</c:v>
                </c:pt>
                <c:pt idx="4146">
                  <c:v>993.3125</c:v>
                </c:pt>
                <c:pt idx="4147">
                  <c:v>993.55208333333303</c:v>
                </c:pt>
                <c:pt idx="4148">
                  <c:v>993.79166666666697</c:v>
                </c:pt>
                <c:pt idx="4149">
                  <c:v>994.03125</c:v>
                </c:pt>
                <c:pt idx="4150">
                  <c:v>994.27083333333303</c:v>
                </c:pt>
                <c:pt idx="4151">
                  <c:v>994.51041666666697</c:v>
                </c:pt>
                <c:pt idx="4152">
                  <c:v>994.75</c:v>
                </c:pt>
                <c:pt idx="4153">
                  <c:v>994.98958333333303</c:v>
                </c:pt>
                <c:pt idx="4154">
                  <c:v>995.22916666666697</c:v>
                </c:pt>
                <c:pt idx="4155">
                  <c:v>995.46875</c:v>
                </c:pt>
                <c:pt idx="4156">
                  <c:v>995.70833333333303</c:v>
                </c:pt>
                <c:pt idx="4157">
                  <c:v>995.94791666666697</c:v>
                </c:pt>
                <c:pt idx="4158">
                  <c:v>996.1875</c:v>
                </c:pt>
                <c:pt idx="4159">
                  <c:v>996.42708333333303</c:v>
                </c:pt>
                <c:pt idx="4160">
                  <c:v>996.66666666666697</c:v>
                </c:pt>
                <c:pt idx="4161">
                  <c:v>996.90625</c:v>
                </c:pt>
                <c:pt idx="4162">
                  <c:v>997.14583333333303</c:v>
                </c:pt>
                <c:pt idx="4163">
                  <c:v>997.38541666666697</c:v>
                </c:pt>
                <c:pt idx="4164">
                  <c:v>997.625</c:v>
                </c:pt>
                <c:pt idx="4165">
                  <c:v>997.86458333333303</c:v>
                </c:pt>
                <c:pt idx="4166">
                  <c:v>998.10416666666697</c:v>
                </c:pt>
                <c:pt idx="4167">
                  <c:v>998.34375</c:v>
                </c:pt>
                <c:pt idx="4168">
                  <c:v>998.58333333333303</c:v>
                </c:pt>
                <c:pt idx="4169">
                  <c:v>998.82291666666697</c:v>
                </c:pt>
                <c:pt idx="4170">
                  <c:v>999.0625</c:v>
                </c:pt>
                <c:pt idx="4171">
                  <c:v>999.30208333333303</c:v>
                </c:pt>
                <c:pt idx="4172">
                  <c:v>999.54166666666697</c:v>
                </c:pt>
                <c:pt idx="4173">
                  <c:v>999.78125</c:v>
                </c:pt>
                <c:pt idx="4174">
                  <c:v>1000.02083333333</c:v>
                </c:pt>
                <c:pt idx="4175">
                  <c:v>1000.26041666667</c:v>
                </c:pt>
                <c:pt idx="4176">
                  <c:v>1000.5</c:v>
                </c:pt>
                <c:pt idx="4177">
                  <c:v>1000.73958333333</c:v>
                </c:pt>
                <c:pt idx="4178">
                  <c:v>1000.97916666667</c:v>
                </c:pt>
                <c:pt idx="4179">
                  <c:v>1001.21875</c:v>
                </c:pt>
                <c:pt idx="4180">
                  <c:v>1001.45833333333</c:v>
                </c:pt>
                <c:pt idx="4181">
                  <c:v>1001.69791666667</c:v>
                </c:pt>
                <c:pt idx="4182">
                  <c:v>1001.9375</c:v>
                </c:pt>
                <c:pt idx="4183">
                  <c:v>1002.17708333333</c:v>
                </c:pt>
                <c:pt idx="4184">
                  <c:v>1002.41666666667</c:v>
                </c:pt>
                <c:pt idx="4185">
                  <c:v>1002.65625</c:v>
                </c:pt>
                <c:pt idx="4186">
                  <c:v>1002.89583333333</c:v>
                </c:pt>
                <c:pt idx="4187">
                  <c:v>1003.13541666667</c:v>
                </c:pt>
                <c:pt idx="4188">
                  <c:v>1003.375</c:v>
                </c:pt>
                <c:pt idx="4189">
                  <c:v>1003.61458333333</c:v>
                </c:pt>
                <c:pt idx="4190">
                  <c:v>1003.85416666667</c:v>
                </c:pt>
                <c:pt idx="4191">
                  <c:v>1004.09375</c:v>
                </c:pt>
                <c:pt idx="4192">
                  <c:v>1004.33333333333</c:v>
                </c:pt>
                <c:pt idx="4193">
                  <c:v>1004.57291666667</c:v>
                </c:pt>
                <c:pt idx="4194">
                  <c:v>1004.8125</c:v>
                </c:pt>
                <c:pt idx="4195">
                  <c:v>1005.05208333333</c:v>
                </c:pt>
                <c:pt idx="4196">
                  <c:v>1005.29166666667</c:v>
                </c:pt>
                <c:pt idx="4197">
                  <c:v>1005.53125</c:v>
                </c:pt>
                <c:pt idx="4198">
                  <c:v>1005.77083333333</c:v>
                </c:pt>
                <c:pt idx="4199">
                  <c:v>1006.01041666667</c:v>
                </c:pt>
                <c:pt idx="4200">
                  <c:v>1006.25</c:v>
                </c:pt>
                <c:pt idx="4201">
                  <c:v>1006.48958333333</c:v>
                </c:pt>
                <c:pt idx="4202">
                  <c:v>1006.72916666667</c:v>
                </c:pt>
                <c:pt idx="4203">
                  <c:v>1006.96875</c:v>
                </c:pt>
                <c:pt idx="4204">
                  <c:v>1007.20833333333</c:v>
                </c:pt>
                <c:pt idx="4205">
                  <c:v>1007.44791666667</c:v>
                </c:pt>
                <c:pt idx="4206">
                  <c:v>1007.6875</c:v>
                </c:pt>
                <c:pt idx="4207">
                  <c:v>1007.92708333333</c:v>
                </c:pt>
                <c:pt idx="4208">
                  <c:v>1008.16666666667</c:v>
                </c:pt>
                <c:pt idx="4209">
                  <c:v>1008.40625</c:v>
                </c:pt>
                <c:pt idx="4210">
                  <c:v>1008.64583333333</c:v>
                </c:pt>
                <c:pt idx="4211">
                  <c:v>1008.88541666667</c:v>
                </c:pt>
                <c:pt idx="4212">
                  <c:v>1009.125</c:v>
                </c:pt>
                <c:pt idx="4213">
                  <c:v>1009.36458333333</c:v>
                </c:pt>
                <c:pt idx="4214">
                  <c:v>1009.60416666667</c:v>
                </c:pt>
                <c:pt idx="4215">
                  <c:v>1009.84375</c:v>
                </c:pt>
                <c:pt idx="4216">
                  <c:v>1010.08333333333</c:v>
                </c:pt>
                <c:pt idx="4217">
                  <c:v>1010.32291666667</c:v>
                </c:pt>
                <c:pt idx="4218">
                  <c:v>1010.5625</c:v>
                </c:pt>
                <c:pt idx="4219">
                  <c:v>1010.80208333333</c:v>
                </c:pt>
                <c:pt idx="4220">
                  <c:v>1011.04166666667</c:v>
                </c:pt>
                <c:pt idx="4221">
                  <c:v>1011.28125</c:v>
                </c:pt>
                <c:pt idx="4222">
                  <c:v>1011.52083333333</c:v>
                </c:pt>
                <c:pt idx="4223">
                  <c:v>1011.76041666667</c:v>
                </c:pt>
                <c:pt idx="4224">
                  <c:v>1012</c:v>
                </c:pt>
                <c:pt idx="4225">
                  <c:v>1012.23958333333</c:v>
                </c:pt>
                <c:pt idx="4226">
                  <c:v>1012.47916666667</c:v>
                </c:pt>
                <c:pt idx="4227">
                  <c:v>1012.71875</c:v>
                </c:pt>
                <c:pt idx="4228">
                  <c:v>1012.95833333333</c:v>
                </c:pt>
                <c:pt idx="4229">
                  <c:v>1013.19791666667</c:v>
                </c:pt>
                <c:pt idx="4230">
                  <c:v>1013.4375</c:v>
                </c:pt>
                <c:pt idx="4231">
                  <c:v>1013.67708333333</c:v>
                </c:pt>
                <c:pt idx="4232">
                  <c:v>1013.91666666667</c:v>
                </c:pt>
                <c:pt idx="4233">
                  <c:v>1014.15625</c:v>
                </c:pt>
                <c:pt idx="4234">
                  <c:v>1014.39583333333</c:v>
                </c:pt>
                <c:pt idx="4235">
                  <c:v>1014.63541666667</c:v>
                </c:pt>
                <c:pt idx="4236">
                  <c:v>1014.875</c:v>
                </c:pt>
                <c:pt idx="4237">
                  <c:v>1015.11458333333</c:v>
                </c:pt>
                <c:pt idx="4238">
                  <c:v>1015.35416666667</c:v>
                </c:pt>
                <c:pt idx="4239">
                  <c:v>1015.59375</c:v>
                </c:pt>
                <c:pt idx="4240">
                  <c:v>1015.83333333333</c:v>
                </c:pt>
                <c:pt idx="4241">
                  <c:v>1016.07291666667</c:v>
                </c:pt>
                <c:pt idx="4242">
                  <c:v>1016.3125</c:v>
                </c:pt>
                <c:pt idx="4243">
                  <c:v>1016.55208333333</c:v>
                </c:pt>
                <c:pt idx="4244">
                  <c:v>1016.79166666667</c:v>
                </c:pt>
                <c:pt idx="4245">
                  <c:v>1017.03125</c:v>
                </c:pt>
                <c:pt idx="4246">
                  <c:v>1017.27083333333</c:v>
                </c:pt>
                <c:pt idx="4247">
                  <c:v>1017.51041666667</c:v>
                </c:pt>
                <c:pt idx="4248">
                  <c:v>1017.75</c:v>
                </c:pt>
                <c:pt idx="4249">
                  <c:v>1017.98958333333</c:v>
                </c:pt>
                <c:pt idx="4250">
                  <c:v>1018.22916666667</c:v>
                </c:pt>
                <c:pt idx="4251">
                  <c:v>1018.46875</c:v>
                </c:pt>
                <c:pt idx="4252">
                  <c:v>1018.70833333333</c:v>
                </c:pt>
                <c:pt idx="4253">
                  <c:v>1018.94791666667</c:v>
                </c:pt>
                <c:pt idx="4254">
                  <c:v>1019.1875</c:v>
                </c:pt>
                <c:pt idx="4255">
                  <c:v>1019.42708333333</c:v>
                </c:pt>
                <c:pt idx="4256">
                  <c:v>1019.66666666667</c:v>
                </c:pt>
                <c:pt idx="4257">
                  <c:v>1019.90625</c:v>
                </c:pt>
                <c:pt idx="4258">
                  <c:v>1020.14583333333</c:v>
                </c:pt>
                <c:pt idx="4259">
                  <c:v>1020.38541666667</c:v>
                </c:pt>
                <c:pt idx="4260">
                  <c:v>1020.625</c:v>
                </c:pt>
                <c:pt idx="4261">
                  <c:v>1020.86458333333</c:v>
                </c:pt>
                <c:pt idx="4262">
                  <c:v>1021.10416666667</c:v>
                </c:pt>
                <c:pt idx="4263">
                  <c:v>1021.34375</c:v>
                </c:pt>
                <c:pt idx="4264">
                  <c:v>1021.58333333333</c:v>
                </c:pt>
                <c:pt idx="4265">
                  <c:v>1021.82291666667</c:v>
                </c:pt>
                <c:pt idx="4266">
                  <c:v>1022.0625</c:v>
                </c:pt>
                <c:pt idx="4267">
                  <c:v>1022.30208333333</c:v>
                </c:pt>
                <c:pt idx="4268">
                  <c:v>1022.54166666667</c:v>
                </c:pt>
                <c:pt idx="4269">
                  <c:v>1022.78125</c:v>
                </c:pt>
                <c:pt idx="4270">
                  <c:v>1023.02083333333</c:v>
                </c:pt>
                <c:pt idx="4271">
                  <c:v>1023.26041666667</c:v>
                </c:pt>
                <c:pt idx="4272">
                  <c:v>1023.5</c:v>
                </c:pt>
                <c:pt idx="4273">
                  <c:v>1023.73958333333</c:v>
                </c:pt>
                <c:pt idx="4274">
                  <c:v>1023.97916666667</c:v>
                </c:pt>
                <c:pt idx="4275">
                  <c:v>1024.21875</c:v>
                </c:pt>
                <c:pt idx="4276">
                  <c:v>1024.4583333333301</c:v>
                </c:pt>
                <c:pt idx="4277">
                  <c:v>1024.6979166666699</c:v>
                </c:pt>
                <c:pt idx="4278">
                  <c:v>1024.9375</c:v>
                </c:pt>
                <c:pt idx="4279">
                  <c:v>1025.1770833333301</c:v>
                </c:pt>
                <c:pt idx="4280">
                  <c:v>1025.4166666666699</c:v>
                </c:pt>
                <c:pt idx="4281">
                  <c:v>1025.65625</c:v>
                </c:pt>
                <c:pt idx="4282">
                  <c:v>1025.8958333333301</c:v>
                </c:pt>
                <c:pt idx="4283">
                  <c:v>1026.1354166666699</c:v>
                </c:pt>
                <c:pt idx="4284">
                  <c:v>1026.375</c:v>
                </c:pt>
                <c:pt idx="4285">
                  <c:v>1026.6145833333301</c:v>
                </c:pt>
                <c:pt idx="4286">
                  <c:v>1026.8541666666699</c:v>
                </c:pt>
                <c:pt idx="4287">
                  <c:v>1027.09375</c:v>
                </c:pt>
                <c:pt idx="4288">
                  <c:v>1027.3333333333301</c:v>
                </c:pt>
                <c:pt idx="4289">
                  <c:v>1027.5729166666699</c:v>
                </c:pt>
                <c:pt idx="4290">
                  <c:v>1027.8125</c:v>
                </c:pt>
                <c:pt idx="4291">
                  <c:v>1028.0520833333301</c:v>
                </c:pt>
                <c:pt idx="4292">
                  <c:v>1028.2916666666699</c:v>
                </c:pt>
                <c:pt idx="4293">
                  <c:v>1028.53125</c:v>
                </c:pt>
                <c:pt idx="4294">
                  <c:v>1028.7708333333301</c:v>
                </c:pt>
                <c:pt idx="4295">
                  <c:v>1029.0104166666699</c:v>
                </c:pt>
                <c:pt idx="4296">
                  <c:v>1029.25</c:v>
                </c:pt>
                <c:pt idx="4297">
                  <c:v>1029.4895833333301</c:v>
                </c:pt>
                <c:pt idx="4298">
                  <c:v>1029.7291666666699</c:v>
                </c:pt>
                <c:pt idx="4299">
                  <c:v>1029.96875</c:v>
                </c:pt>
                <c:pt idx="4300">
                  <c:v>1030.2083333333301</c:v>
                </c:pt>
                <c:pt idx="4301">
                  <c:v>1030.4479166666699</c:v>
                </c:pt>
                <c:pt idx="4302">
                  <c:v>1030.6875</c:v>
                </c:pt>
                <c:pt idx="4303">
                  <c:v>1030.9270833333301</c:v>
                </c:pt>
                <c:pt idx="4304">
                  <c:v>1031.1666666666699</c:v>
                </c:pt>
                <c:pt idx="4305">
                  <c:v>1031.40625</c:v>
                </c:pt>
                <c:pt idx="4306">
                  <c:v>1031.6458333333301</c:v>
                </c:pt>
                <c:pt idx="4307">
                  <c:v>1031.8854166666699</c:v>
                </c:pt>
                <c:pt idx="4308">
                  <c:v>1032.125</c:v>
                </c:pt>
                <c:pt idx="4309">
                  <c:v>1032.3645833333301</c:v>
                </c:pt>
                <c:pt idx="4310">
                  <c:v>1032.6041666666699</c:v>
                </c:pt>
                <c:pt idx="4311">
                  <c:v>1032.84375</c:v>
                </c:pt>
                <c:pt idx="4312">
                  <c:v>1033.0833333333301</c:v>
                </c:pt>
                <c:pt idx="4313">
                  <c:v>1033.3229166666699</c:v>
                </c:pt>
                <c:pt idx="4314">
                  <c:v>1033.5625</c:v>
                </c:pt>
                <c:pt idx="4315">
                  <c:v>1033.8020833333301</c:v>
                </c:pt>
                <c:pt idx="4316">
                  <c:v>1034.0416666666699</c:v>
                </c:pt>
                <c:pt idx="4317">
                  <c:v>1034.28125</c:v>
                </c:pt>
                <c:pt idx="4318">
                  <c:v>1034.5208333333301</c:v>
                </c:pt>
                <c:pt idx="4319">
                  <c:v>1034.7604166666699</c:v>
                </c:pt>
                <c:pt idx="4320">
                  <c:v>1035</c:v>
                </c:pt>
                <c:pt idx="4321">
                  <c:v>1035.2395833333301</c:v>
                </c:pt>
                <c:pt idx="4322">
                  <c:v>1035.4791666666699</c:v>
                </c:pt>
                <c:pt idx="4323">
                  <c:v>1035.71875</c:v>
                </c:pt>
                <c:pt idx="4324">
                  <c:v>1035.9583333333301</c:v>
                </c:pt>
                <c:pt idx="4325">
                  <c:v>1036.1979166666699</c:v>
                </c:pt>
                <c:pt idx="4326">
                  <c:v>1036.4375</c:v>
                </c:pt>
                <c:pt idx="4327">
                  <c:v>1036.6770833333301</c:v>
                </c:pt>
                <c:pt idx="4328">
                  <c:v>1036.9166666666699</c:v>
                </c:pt>
                <c:pt idx="4329">
                  <c:v>1037.15625</c:v>
                </c:pt>
                <c:pt idx="4330">
                  <c:v>1037.3958333333301</c:v>
                </c:pt>
                <c:pt idx="4331">
                  <c:v>1037.6354166666699</c:v>
                </c:pt>
                <c:pt idx="4332">
                  <c:v>1037.875</c:v>
                </c:pt>
                <c:pt idx="4333">
                  <c:v>1038.1145833333301</c:v>
                </c:pt>
                <c:pt idx="4334">
                  <c:v>1038.3541666666699</c:v>
                </c:pt>
                <c:pt idx="4335">
                  <c:v>1038.59375</c:v>
                </c:pt>
                <c:pt idx="4336">
                  <c:v>1038.8333333333301</c:v>
                </c:pt>
                <c:pt idx="4337">
                  <c:v>1039.0729166666699</c:v>
                </c:pt>
                <c:pt idx="4338">
                  <c:v>1039.3125</c:v>
                </c:pt>
                <c:pt idx="4339">
                  <c:v>1039.5520833333301</c:v>
                </c:pt>
                <c:pt idx="4340">
                  <c:v>1039.7916666666699</c:v>
                </c:pt>
                <c:pt idx="4341">
                  <c:v>1040.03125</c:v>
                </c:pt>
                <c:pt idx="4342">
                  <c:v>1040.2708333333301</c:v>
                </c:pt>
                <c:pt idx="4343">
                  <c:v>1040.5104166666699</c:v>
                </c:pt>
                <c:pt idx="4344">
                  <c:v>1040.75</c:v>
                </c:pt>
                <c:pt idx="4345">
                  <c:v>1040.9895833333301</c:v>
                </c:pt>
                <c:pt idx="4346">
                  <c:v>1041.2291666666699</c:v>
                </c:pt>
                <c:pt idx="4347">
                  <c:v>1041.46875</c:v>
                </c:pt>
                <c:pt idx="4348">
                  <c:v>1041.7083333333301</c:v>
                </c:pt>
                <c:pt idx="4349">
                  <c:v>1041.9479166666699</c:v>
                </c:pt>
                <c:pt idx="4350">
                  <c:v>1042.1875</c:v>
                </c:pt>
                <c:pt idx="4351">
                  <c:v>1042.4270833333301</c:v>
                </c:pt>
                <c:pt idx="4352">
                  <c:v>1042.6666666666699</c:v>
                </c:pt>
                <c:pt idx="4353">
                  <c:v>1042.90625</c:v>
                </c:pt>
                <c:pt idx="4354">
                  <c:v>1043.1458333333301</c:v>
                </c:pt>
                <c:pt idx="4355">
                  <c:v>1043.3854166666699</c:v>
                </c:pt>
                <c:pt idx="4356">
                  <c:v>1043.625</c:v>
                </c:pt>
                <c:pt idx="4357">
                  <c:v>1043.8645833333301</c:v>
                </c:pt>
                <c:pt idx="4358">
                  <c:v>1044.1041666666699</c:v>
                </c:pt>
                <c:pt idx="4359">
                  <c:v>1044.34375</c:v>
                </c:pt>
                <c:pt idx="4360">
                  <c:v>1044.5833333333301</c:v>
                </c:pt>
                <c:pt idx="4361">
                  <c:v>1044.8229166666699</c:v>
                </c:pt>
                <c:pt idx="4362">
                  <c:v>1045.0625</c:v>
                </c:pt>
                <c:pt idx="4363">
                  <c:v>1045.3020833333301</c:v>
                </c:pt>
                <c:pt idx="4364">
                  <c:v>1045.5416666666699</c:v>
                </c:pt>
                <c:pt idx="4365">
                  <c:v>1045.78125</c:v>
                </c:pt>
                <c:pt idx="4366">
                  <c:v>1046.0208333333301</c:v>
                </c:pt>
                <c:pt idx="4367">
                  <c:v>1046.2604166666699</c:v>
                </c:pt>
                <c:pt idx="4368">
                  <c:v>1046.5</c:v>
                </c:pt>
                <c:pt idx="4369">
                  <c:v>1046.7395833333301</c:v>
                </c:pt>
                <c:pt idx="4370">
                  <c:v>1046.9791666666699</c:v>
                </c:pt>
                <c:pt idx="4371">
                  <c:v>1047.21875</c:v>
                </c:pt>
                <c:pt idx="4372">
                  <c:v>1047.4583333333301</c:v>
                </c:pt>
                <c:pt idx="4373">
                  <c:v>1047.6979166666699</c:v>
                </c:pt>
                <c:pt idx="4374">
                  <c:v>1047.9375</c:v>
                </c:pt>
                <c:pt idx="4375">
                  <c:v>1048.1770833333301</c:v>
                </c:pt>
                <c:pt idx="4376">
                  <c:v>1048.4166666666699</c:v>
                </c:pt>
                <c:pt idx="4377">
                  <c:v>1048.65625</c:v>
                </c:pt>
                <c:pt idx="4378">
                  <c:v>1048.8958333333301</c:v>
                </c:pt>
                <c:pt idx="4379">
                  <c:v>1049.1354166666699</c:v>
                </c:pt>
                <c:pt idx="4380">
                  <c:v>1049.375</c:v>
                </c:pt>
                <c:pt idx="4381">
                  <c:v>1049.6145833333301</c:v>
                </c:pt>
                <c:pt idx="4382">
                  <c:v>1049.8541666666699</c:v>
                </c:pt>
                <c:pt idx="4383">
                  <c:v>1050.09375</c:v>
                </c:pt>
                <c:pt idx="4384">
                  <c:v>1050.3333333333301</c:v>
                </c:pt>
                <c:pt idx="4385">
                  <c:v>1050.5729166666699</c:v>
                </c:pt>
                <c:pt idx="4386">
                  <c:v>1050.8125</c:v>
                </c:pt>
                <c:pt idx="4387">
                  <c:v>1051.0520833333301</c:v>
                </c:pt>
                <c:pt idx="4388">
                  <c:v>1051.2916666666699</c:v>
                </c:pt>
                <c:pt idx="4389">
                  <c:v>1051.53125</c:v>
                </c:pt>
                <c:pt idx="4390">
                  <c:v>1051.7708333333301</c:v>
                </c:pt>
                <c:pt idx="4391">
                  <c:v>1052.0104166666699</c:v>
                </c:pt>
                <c:pt idx="4392">
                  <c:v>1052.25</c:v>
                </c:pt>
                <c:pt idx="4393">
                  <c:v>1052.4895833333301</c:v>
                </c:pt>
                <c:pt idx="4394">
                  <c:v>1052.7291666666699</c:v>
                </c:pt>
                <c:pt idx="4395">
                  <c:v>1052.96875</c:v>
                </c:pt>
                <c:pt idx="4396">
                  <c:v>1053.2083333333301</c:v>
                </c:pt>
                <c:pt idx="4397">
                  <c:v>1053.4479166666699</c:v>
                </c:pt>
                <c:pt idx="4398">
                  <c:v>1053.6875</c:v>
                </c:pt>
                <c:pt idx="4399">
                  <c:v>1053.9270833333301</c:v>
                </c:pt>
                <c:pt idx="4400">
                  <c:v>1054.1666666666699</c:v>
                </c:pt>
                <c:pt idx="4401">
                  <c:v>1054.40625</c:v>
                </c:pt>
                <c:pt idx="4402">
                  <c:v>1054.6458333333301</c:v>
                </c:pt>
                <c:pt idx="4403">
                  <c:v>1054.8854166666699</c:v>
                </c:pt>
                <c:pt idx="4404">
                  <c:v>1055.125</c:v>
                </c:pt>
                <c:pt idx="4405">
                  <c:v>1055.3645833333301</c:v>
                </c:pt>
                <c:pt idx="4406">
                  <c:v>1055.6041666666699</c:v>
                </c:pt>
                <c:pt idx="4407">
                  <c:v>1055.84375</c:v>
                </c:pt>
                <c:pt idx="4408">
                  <c:v>1056.0833333333301</c:v>
                </c:pt>
                <c:pt idx="4409">
                  <c:v>1056.3229166666699</c:v>
                </c:pt>
                <c:pt idx="4410">
                  <c:v>1056.5625</c:v>
                </c:pt>
                <c:pt idx="4411">
                  <c:v>1056.8020833333301</c:v>
                </c:pt>
                <c:pt idx="4412">
                  <c:v>1057.0416666666699</c:v>
                </c:pt>
                <c:pt idx="4413">
                  <c:v>1057.28125</c:v>
                </c:pt>
                <c:pt idx="4414">
                  <c:v>1057.5208333333301</c:v>
                </c:pt>
                <c:pt idx="4415">
                  <c:v>1057.7604166666699</c:v>
                </c:pt>
                <c:pt idx="4416">
                  <c:v>1058</c:v>
                </c:pt>
                <c:pt idx="4417">
                  <c:v>1058.2395833333301</c:v>
                </c:pt>
                <c:pt idx="4418">
                  <c:v>1058.4791666666699</c:v>
                </c:pt>
                <c:pt idx="4419">
                  <c:v>1058.71875</c:v>
                </c:pt>
                <c:pt idx="4420">
                  <c:v>1058.9583333333301</c:v>
                </c:pt>
                <c:pt idx="4421">
                  <c:v>1059.1979166666699</c:v>
                </c:pt>
                <c:pt idx="4422">
                  <c:v>1059.4375</c:v>
                </c:pt>
                <c:pt idx="4423">
                  <c:v>1059.6770833333301</c:v>
                </c:pt>
                <c:pt idx="4424">
                  <c:v>1059.9166666666699</c:v>
                </c:pt>
                <c:pt idx="4425">
                  <c:v>1060.15625</c:v>
                </c:pt>
                <c:pt idx="4426">
                  <c:v>1060.3958333333301</c:v>
                </c:pt>
                <c:pt idx="4427">
                  <c:v>1060.6354166666699</c:v>
                </c:pt>
                <c:pt idx="4428">
                  <c:v>1060.875</c:v>
                </c:pt>
                <c:pt idx="4429">
                  <c:v>1061.1145833333301</c:v>
                </c:pt>
                <c:pt idx="4430">
                  <c:v>1061.3541666666699</c:v>
                </c:pt>
                <c:pt idx="4431">
                  <c:v>1061.59375</c:v>
                </c:pt>
                <c:pt idx="4432">
                  <c:v>1061.8333333333301</c:v>
                </c:pt>
                <c:pt idx="4433">
                  <c:v>1062.0729166666699</c:v>
                </c:pt>
                <c:pt idx="4434">
                  <c:v>1062.3125</c:v>
                </c:pt>
                <c:pt idx="4435">
                  <c:v>1062.5520833333301</c:v>
                </c:pt>
                <c:pt idx="4436">
                  <c:v>1062.7916666666699</c:v>
                </c:pt>
                <c:pt idx="4437">
                  <c:v>1063.03125</c:v>
                </c:pt>
                <c:pt idx="4438">
                  <c:v>1063.2708333333301</c:v>
                </c:pt>
                <c:pt idx="4439">
                  <c:v>1063.5104166666699</c:v>
                </c:pt>
                <c:pt idx="4440">
                  <c:v>1063.75</c:v>
                </c:pt>
                <c:pt idx="4441">
                  <c:v>1063.9895833333301</c:v>
                </c:pt>
                <c:pt idx="4442">
                  <c:v>1064.2291666666699</c:v>
                </c:pt>
                <c:pt idx="4443">
                  <c:v>1064.46875</c:v>
                </c:pt>
                <c:pt idx="4444">
                  <c:v>1064.7083333333301</c:v>
                </c:pt>
                <c:pt idx="4445">
                  <c:v>1064.9479166666699</c:v>
                </c:pt>
                <c:pt idx="4446">
                  <c:v>1065.1875</c:v>
                </c:pt>
                <c:pt idx="4447">
                  <c:v>1065.4270833333301</c:v>
                </c:pt>
                <c:pt idx="4448">
                  <c:v>1065.6666666666699</c:v>
                </c:pt>
                <c:pt idx="4449">
                  <c:v>1065.90625</c:v>
                </c:pt>
                <c:pt idx="4450">
                  <c:v>1066.1458333333301</c:v>
                </c:pt>
                <c:pt idx="4451">
                  <c:v>1066.3854166666699</c:v>
                </c:pt>
                <c:pt idx="4452">
                  <c:v>1066.625</c:v>
                </c:pt>
                <c:pt idx="4453">
                  <c:v>1066.8645833333301</c:v>
                </c:pt>
                <c:pt idx="4454">
                  <c:v>1067.1041666666699</c:v>
                </c:pt>
                <c:pt idx="4455">
                  <c:v>1067.34375</c:v>
                </c:pt>
                <c:pt idx="4456">
                  <c:v>1067.5833333333301</c:v>
                </c:pt>
                <c:pt idx="4457">
                  <c:v>1067.8229166666699</c:v>
                </c:pt>
                <c:pt idx="4458">
                  <c:v>1068.0625</c:v>
                </c:pt>
                <c:pt idx="4459">
                  <c:v>1068.3020833333301</c:v>
                </c:pt>
                <c:pt idx="4460">
                  <c:v>1068.5416666666699</c:v>
                </c:pt>
                <c:pt idx="4461">
                  <c:v>1068.78125</c:v>
                </c:pt>
                <c:pt idx="4462">
                  <c:v>1069.0208333333301</c:v>
                </c:pt>
                <c:pt idx="4463">
                  <c:v>1069.2604166666699</c:v>
                </c:pt>
                <c:pt idx="4464">
                  <c:v>1069.5</c:v>
                </c:pt>
                <c:pt idx="4465">
                  <c:v>1069.7395833333301</c:v>
                </c:pt>
                <c:pt idx="4466">
                  <c:v>1069.9791666666699</c:v>
                </c:pt>
                <c:pt idx="4467">
                  <c:v>1070.21875</c:v>
                </c:pt>
                <c:pt idx="4468">
                  <c:v>1070.4583333333301</c:v>
                </c:pt>
                <c:pt idx="4469">
                  <c:v>1070.6979166666699</c:v>
                </c:pt>
                <c:pt idx="4470">
                  <c:v>1070.9375</c:v>
                </c:pt>
                <c:pt idx="4471">
                  <c:v>1071.1770833333301</c:v>
                </c:pt>
                <c:pt idx="4472">
                  <c:v>1071.4166666666699</c:v>
                </c:pt>
                <c:pt idx="4473">
                  <c:v>1071.65625</c:v>
                </c:pt>
                <c:pt idx="4474">
                  <c:v>1071.8958333333301</c:v>
                </c:pt>
                <c:pt idx="4475">
                  <c:v>1072.1354166666699</c:v>
                </c:pt>
                <c:pt idx="4476">
                  <c:v>1072.375</c:v>
                </c:pt>
                <c:pt idx="4477">
                  <c:v>1072.6145833333301</c:v>
                </c:pt>
                <c:pt idx="4478">
                  <c:v>1072.8541666666699</c:v>
                </c:pt>
                <c:pt idx="4479">
                  <c:v>1073.09375</c:v>
                </c:pt>
                <c:pt idx="4480">
                  <c:v>1073.3333333333301</c:v>
                </c:pt>
                <c:pt idx="4481">
                  <c:v>1073.5729166666699</c:v>
                </c:pt>
                <c:pt idx="4482">
                  <c:v>1073.8125</c:v>
                </c:pt>
                <c:pt idx="4483">
                  <c:v>1074.0520833333301</c:v>
                </c:pt>
                <c:pt idx="4484">
                  <c:v>1074.2916666666699</c:v>
                </c:pt>
                <c:pt idx="4485">
                  <c:v>1074.53125</c:v>
                </c:pt>
                <c:pt idx="4486">
                  <c:v>1074.7708333333301</c:v>
                </c:pt>
                <c:pt idx="4487">
                  <c:v>1075.0104166666699</c:v>
                </c:pt>
                <c:pt idx="4488">
                  <c:v>1075.25</c:v>
                </c:pt>
                <c:pt idx="4489">
                  <c:v>1075.4895833333301</c:v>
                </c:pt>
                <c:pt idx="4490">
                  <c:v>1075.7291666666699</c:v>
                </c:pt>
                <c:pt idx="4491">
                  <c:v>1075.96875</c:v>
                </c:pt>
                <c:pt idx="4492">
                  <c:v>1076.2083333333301</c:v>
                </c:pt>
                <c:pt idx="4493">
                  <c:v>1076.4479166666699</c:v>
                </c:pt>
                <c:pt idx="4494">
                  <c:v>1076.6875</c:v>
                </c:pt>
                <c:pt idx="4495">
                  <c:v>1076.9270833333301</c:v>
                </c:pt>
                <c:pt idx="4496">
                  <c:v>1077.1666666666699</c:v>
                </c:pt>
                <c:pt idx="4497">
                  <c:v>1077.40625</c:v>
                </c:pt>
                <c:pt idx="4498">
                  <c:v>1077.6458333333301</c:v>
                </c:pt>
                <c:pt idx="4499">
                  <c:v>1077.8854166666699</c:v>
                </c:pt>
                <c:pt idx="4500">
                  <c:v>1078.125</c:v>
                </c:pt>
                <c:pt idx="4501">
                  <c:v>1078.3645833333301</c:v>
                </c:pt>
                <c:pt idx="4502">
                  <c:v>1078.6041666666699</c:v>
                </c:pt>
                <c:pt idx="4503">
                  <c:v>1078.84375</c:v>
                </c:pt>
                <c:pt idx="4504">
                  <c:v>1079.0833333333301</c:v>
                </c:pt>
                <c:pt idx="4505">
                  <c:v>1079.3229166666699</c:v>
                </c:pt>
                <c:pt idx="4506">
                  <c:v>1079.5625</c:v>
                </c:pt>
                <c:pt idx="4507">
                  <c:v>1079.8020833333301</c:v>
                </c:pt>
                <c:pt idx="4508">
                  <c:v>1080.0416666666699</c:v>
                </c:pt>
                <c:pt idx="4509">
                  <c:v>1080.28125</c:v>
                </c:pt>
                <c:pt idx="4510">
                  <c:v>1080.5208333333301</c:v>
                </c:pt>
                <c:pt idx="4511">
                  <c:v>1080.7604166666699</c:v>
                </c:pt>
                <c:pt idx="4512">
                  <c:v>1081</c:v>
                </c:pt>
                <c:pt idx="4513">
                  <c:v>1081.2395833333301</c:v>
                </c:pt>
                <c:pt idx="4514">
                  <c:v>1081.4791666666699</c:v>
                </c:pt>
                <c:pt idx="4515">
                  <c:v>1081.71875</c:v>
                </c:pt>
                <c:pt idx="4516">
                  <c:v>1081.9583333333301</c:v>
                </c:pt>
                <c:pt idx="4517">
                  <c:v>1082.1979166666699</c:v>
                </c:pt>
                <c:pt idx="4518">
                  <c:v>1082.4375</c:v>
                </c:pt>
                <c:pt idx="4519">
                  <c:v>1082.6770833333301</c:v>
                </c:pt>
                <c:pt idx="4520">
                  <c:v>1082.9166666666699</c:v>
                </c:pt>
                <c:pt idx="4521">
                  <c:v>1083.15625</c:v>
                </c:pt>
                <c:pt idx="4522">
                  <c:v>1083.3958333333301</c:v>
                </c:pt>
                <c:pt idx="4523">
                  <c:v>1083.6354166666699</c:v>
                </c:pt>
                <c:pt idx="4524">
                  <c:v>1083.875</c:v>
                </c:pt>
                <c:pt idx="4525">
                  <c:v>1084.1145833333301</c:v>
                </c:pt>
                <c:pt idx="4526">
                  <c:v>1084.3541666666699</c:v>
                </c:pt>
                <c:pt idx="4527">
                  <c:v>1084.59375</c:v>
                </c:pt>
                <c:pt idx="4528">
                  <c:v>1084.8333333333301</c:v>
                </c:pt>
                <c:pt idx="4529">
                  <c:v>1085.0729166666699</c:v>
                </c:pt>
                <c:pt idx="4530">
                  <c:v>1085.3125</c:v>
                </c:pt>
                <c:pt idx="4531">
                  <c:v>1085.5520833333301</c:v>
                </c:pt>
                <c:pt idx="4532">
                  <c:v>1085.7916666666699</c:v>
                </c:pt>
                <c:pt idx="4533">
                  <c:v>1086.03125</c:v>
                </c:pt>
                <c:pt idx="4534">
                  <c:v>1086.2708333333301</c:v>
                </c:pt>
                <c:pt idx="4535">
                  <c:v>1086.5104166666699</c:v>
                </c:pt>
                <c:pt idx="4536">
                  <c:v>1086.75</c:v>
                </c:pt>
                <c:pt idx="4537">
                  <c:v>1086.9895833333301</c:v>
                </c:pt>
                <c:pt idx="4538">
                  <c:v>1087.2291666666699</c:v>
                </c:pt>
                <c:pt idx="4539">
                  <c:v>1087.46875</c:v>
                </c:pt>
                <c:pt idx="4540">
                  <c:v>1087.7083333333301</c:v>
                </c:pt>
                <c:pt idx="4541">
                  <c:v>1087.9479166666699</c:v>
                </c:pt>
                <c:pt idx="4542">
                  <c:v>1088.1875</c:v>
                </c:pt>
                <c:pt idx="4543">
                  <c:v>1088.4270833333301</c:v>
                </c:pt>
                <c:pt idx="4544">
                  <c:v>1088.6666666666699</c:v>
                </c:pt>
                <c:pt idx="4545">
                  <c:v>1088.90625</c:v>
                </c:pt>
                <c:pt idx="4546">
                  <c:v>1089.1458333333301</c:v>
                </c:pt>
                <c:pt idx="4547">
                  <c:v>1089.3854166666699</c:v>
                </c:pt>
                <c:pt idx="4548">
                  <c:v>1089.625</c:v>
                </c:pt>
                <c:pt idx="4549">
                  <c:v>1089.8645833333301</c:v>
                </c:pt>
                <c:pt idx="4550">
                  <c:v>1090.1041666666699</c:v>
                </c:pt>
                <c:pt idx="4551">
                  <c:v>1090.34375</c:v>
                </c:pt>
                <c:pt idx="4552">
                  <c:v>1090.5833333333301</c:v>
                </c:pt>
                <c:pt idx="4553">
                  <c:v>1090.8229166666699</c:v>
                </c:pt>
                <c:pt idx="4554">
                  <c:v>1091.0625</c:v>
                </c:pt>
                <c:pt idx="4555">
                  <c:v>1091.3020833333301</c:v>
                </c:pt>
                <c:pt idx="4556">
                  <c:v>1091.5416666666699</c:v>
                </c:pt>
                <c:pt idx="4557">
                  <c:v>1091.78125</c:v>
                </c:pt>
                <c:pt idx="4558">
                  <c:v>1092.0208333333301</c:v>
                </c:pt>
                <c:pt idx="4559">
                  <c:v>1092.2604166666699</c:v>
                </c:pt>
                <c:pt idx="4560">
                  <c:v>1092.5</c:v>
                </c:pt>
                <c:pt idx="4561">
                  <c:v>1092.7395833333301</c:v>
                </c:pt>
                <c:pt idx="4562">
                  <c:v>1092.9791666666699</c:v>
                </c:pt>
                <c:pt idx="4563">
                  <c:v>1093.21875</c:v>
                </c:pt>
                <c:pt idx="4564">
                  <c:v>1093.4583333333301</c:v>
                </c:pt>
                <c:pt idx="4565">
                  <c:v>1093.6979166666699</c:v>
                </c:pt>
                <c:pt idx="4566">
                  <c:v>1093.9375</c:v>
                </c:pt>
                <c:pt idx="4567">
                  <c:v>1094.1770833333301</c:v>
                </c:pt>
                <c:pt idx="4568">
                  <c:v>1094.4166666666699</c:v>
                </c:pt>
                <c:pt idx="4569">
                  <c:v>1094.65625</c:v>
                </c:pt>
                <c:pt idx="4570">
                  <c:v>1094.8958333333301</c:v>
                </c:pt>
                <c:pt idx="4571">
                  <c:v>1095.1354166666699</c:v>
                </c:pt>
                <c:pt idx="4572">
                  <c:v>1095.375</c:v>
                </c:pt>
                <c:pt idx="4573">
                  <c:v>1095.6145833333301</c:v>
                </c:pt>
                <c:pt idx="4574">
                  <c:v>1095.8541666666699</c:v>
                </c:pt>
                <c:pt idx="4575">
                  <c:v>1096.09375</c:v>
                </c:pt>
                <c:pt idx="4576">
                  <c:v>1096.3333333333301</c:v>
                </c:pt>
                <c:pt idx="4577">
                  <c:v>1096.5729166666699</c:v>
                </c:pt>
                <c:pt idx="4578">
                  <c:v>1096.8125</c:v>
                </c:pt>
                <c:pt idx="4579">
                  <c:v>1097.0520833333301</c:v>
                </c:pt>
                <c:pt idx="4580">
                  <c:v>1097.2916666666699</c:v>
                </c:pt>
                <c:pt idx="4581">
                  <c:v>1097.53125</c:v>
                </c:pt>
                <c:pt idx="4582">
                  <c:v>1097.7708333333301</c:v>
                </c:pt>
                <c:pt idx="4583">
                  <c:v>1098.0104166666699</c:v>
                </c:pt>
                <c:pt idx="4584">
                  <c:v>1098.25</c:v>
                </c:pt>
                <c:pt idx="4585">
                  <c:v>1098.4895833333301</c:v>
                </c:pt>
                <c:pt idx="4586">
                  <c:v>1098.7291666666699</c:v>
                </c:pt>
                <c:pt idx="4587">
                  <c:v>1098.96875</c:v>
                </c:pt>
                <c:pt idx="4588">
                  <c:v>1099.2083333333301</c:v>
                </c:pt>
                <c:pt idx="4589">
                  <c:v>1099.4479166666699</c:v>
                </c:pt>
                <c:pt idx="4590">
                  <c:v>1099.6875</c:v>
                </c:pt>
                <c:pt idx="4591">
                  <c:v>1099.9270833333301</c:v>
                </c:pt>
                <c:pt idx="4592">
                  <c:v>1100.1666666666699</c:v>
                </c:pt>
                <c:pt idx="4593">
                  <c:v>1100.40625</c:v>
                </c:pt>
                <c:pt idx="4594">
                  <c:v>1100.6458333333301</c:v>
                </c:pt>
                <c:pt idx="4595">
                  <c:v>1100.8854166666699</c:v>
                </c:pt>
                <c:pt idx="4596">
                  <c:v>1101.125</c:v>
                </c:pt>
                <c:pt idx="4597">
                  <c:v>1101.3645833333301</c:v>
                </c:pt>
                <c:pt idx="4598">
                  <c:v>1101.6041666666699</c:v>
                </c:pt>
                <c:pt idx="4599">
                  <c:v>1101.84375</c:v>
                </c:pt>
                <c:pt idx="4600">
                  <c:v>1102.0833333333301</c:v>
                </c:pt>
                <c:pt idx="4601">
                  <c:v>1102.3229166666699</c:v>
                </c:pt>
                <c:pt idx="4602">
                  <c:v>1102.5625</c:v>
                </c:pt>
                <c:pt idx="4603">
                  <c:v>1102.8020833333301</c:v>
                </c:pt>
                <c:pt idx="4604">
                  <c:v>1103.0416666666699</c:v>
                </c:pt>
                <c:pt idx="4605">
                  <c:v>1103.28125</c:v>
                </c:pt>
                <c:pt idx="4606">
                  <c:v>1103.5208333333301</c:v>
                </c:pt>
                <c:pt idx="4607">
                  <c:v>1103.7604166666699</c:v>
                </c:pt>
                <c:pt idx="4608">
                  <c:v>1104</c:v>
                </c:pt>
                <c:pt idx="4609">
                  <c:v>1104.2395833333301</c:v>
                </c:pt>
                <c:pt idx="4610">
                  <c:v>1104.4791666666699</c:v>
                </c:pt>
                <c:pt idx="4611">
                  <c:v>1104.71875</c:v>
                </c:pt>
                <c:pt idx="4612">
                  <c:v>1104.9583333333301</c:v>
                </c:pt>
                <c:pt idx="4613">
                  <c:v>1105.1979166666699</c:v>
                </c:pt>
                <c:pt idx="4614">
                  <c:v>1105.4375</c:v>
                </c:pt>
                <c:pt idx="4615">
                  <c:v>1105.6770833333301</c:v>
                </c:pt>
                <c:pt idx="4616">
                  <c:v>1105.9166666666699</c:v>
                </c:pt>
                <c:pt idx="4617">
                  <c:v>1106.15625</c:v>
                </c:pt>
                <c:pt idx="4618">
                  <c:v>1106.3958333333301</c:v>
                </c:pt>
                <c:pt idx="4619">
                  <c:v>1106.6354166666699</c:v>
                </c:pt>
                <c:pt idx="4620">
                  <c:v>1106.875</c:v>
                </c:pt>
                <c:pt idx="4621">
                  <c:v>1107.1145833333301</c:v>
                </c:pt>
                <c:pt idx="4622">
                  <c:v>1107.3541666666699</c:v>
                </c:pt>
                <c:pt idx="4623">
                  <c:v>1107.59375</c:v>
                </c:pt>
                <c:pt idx="4624">
                  <c:v>1107.8333333333301</c:v>
                </c:pt>
                <c:pt idx="4625">
                  <c:v>1108.0729166666699</c:v>
                </c:pt>
                <c:pt idx="4626">
                  <c:v>1108.3125</c:v>
                </c:pt>
                <c:pt idx="4627">
                  <c:v>1108.5520833333301</c:v>
                </c:pt>
                <c:pt idx="4628">
                  <c:v>1108.7916666666699</c:v>
                </c:pt>
                <c:pt idx="4629">
                  <c:v>1109.03125</c:v>
                </c:pt>
                <c:pt idx="4630">
                  <c:v>1109.2708333333301</c:v>
                </c:pt>
                <c:pt idx="4631">
                  <c:v>1109.5104166666699</c:v>
                </c:pt>
                <c:pt idx="4632">
                  <c:v>1109.75</c:v>
                </c:pt>
                <c:pt idx="4633">
                  <c:v>1109.9895833333301</c:v>
                </c:pt>
                <c:pt idx="4634">
                  <c:v>1110.2291666666699</c:v>
                </c:pt>
                <c:pt idx="4635">
                  <c:v>1110.46875</c:v>
                </c:pt>
                <c:pt idx="4636">
                  <c:v>1110.7083333333301</c:v>
                </c:pt>
                <c:pt idx="4637">
                  <c:v>1110.9479166666699</c:v>
                </c:pt>
                <c:pt idx="4638">
                  <c:v>1111.1875</c:v>
                </c:pt>
                <c:pt idx="4639">
                  <c:v>1111.4270833333301</c:v>
                </c:pt>
                <c:pt idx="4640">
                  <c:v>1111.6666666666699</c:v>
                </c:pt>
                <c:pt idx="4641">
                  <c:v>1111.90625</c:v>
                </c:pt>
                <c:pt idx="4642">
                  <c:v>1112.1458333333301</c:v>
                </c:pt>
                <c:pt idx="4643">
                  <c:v>1112.3854166666699</c:v>
                </c:pt>
                <c:pt idx="4644">
                  <c:v>1112.625</c:v>
                </c:pt>
                <c:pt idx="4645">
                  <c:v>1112.8645833333301</c:v>
                </c:pt>
                <c:pt idx="4646">
                  <c:v>1113.1041666666699</c:v>
                </c:pt>
                <c:pt idx="4647">
                  <c:v>1113.34375</c:v>
                </c:pt>
                <c:pt idx="4648">
                  <c:v>1113.5833333333301</c:v>
                </c:pt>
                <c:pt idx="4649">
                  <c:v>1113.8229166666699</c:v>
                </c:pt>
                <c:pt idx="4650">
                  <c:v>1114.0625</c:v>
                </c:pt>
                <c:pt idx="4651">
                  <c:v>1114.3020833333301</c:v>
                </c:pt>
                <c:pt idx="4652">
                  <c:v>1114.5416666666699</c:v>
                </c:pt>
                <c:pt idx="4653">
                  <c:v>1114.78125</c:v>
                </c:pt>
                <c:pt idx="4654">
                  <c:v>1115.0208333333301</c:v>
                </c:pt>
                <c:pt idx="4655">
                  <c:v>1115.2604166666699</c:v>
                </c:pt>
                <c:pt idx="4656">
                  <c:v>1115.5</c:v>
                </c:pt>
                <c:pt idx="4657">
                  <c:v>1115.7395833333301</c:v>
                </c:pt>
                <c:pt idx="4658">
                  <c:v>1115.9791666666699</c:v>
                </c:pt>
                <c:pt idx="4659">
                  <c:v>1116.21875</c:v>
                </c:pt>
                <c:pt idx="4660">
                  <c:v>1116.4583333333301</c:v>
                </c:pt>
                <c:pt idx="4661">
                  <c:v>1116.6979166666699</c:v>
                </c:pt>
                <c:pt idx="4662">
                  <c:v>1116.9375</c:v>
                </c:pt>
                <c:pt idx="4663">
                  <c:v>1117.1770833333301</c:v>
                </c:pt>
                <c:pt idx="4664">
                  <c:v>1117.4166666666699</c:v>
                </c:pt>
                <c:pt idx="4665">
                  <c:v>1117.65625</c:v>
                </c:pt>
                <c:pt idx="4666">
                  <c:v>1117.8958333333301</c:v>
                </c:pt>
                <c:pt idx="4667">
                  <c:v>1118.1354166666699</c:v>
                </c:pt>
                <c:pt idx="4668">
                  <c:v>1118.375</c:v>
                </c:pt>
                <c:pt idx="4669">
                  <c:v>1118.6145833333301</c:v>
                </c:pt>
                <c:pt idx="4670">
                  <c:v>1118.8541666666699</c:v>
                </c:pt>
                <c:pt idx="4671">
                  <c:v>1119.09375</c:v>
                </c:pt>
                <c:pt idx="4672">
                  <c:v>1119.3333333333301</c:v>
                </c:pt>
                <c:pt idx="4673">
                  <c:v>1119.5729166666699</c:v>
                </c:pt>
                <c:pt idx="4674">
                  <c:v>1119.8125</c:v>
                </c:pt>
                <c:pt idx="4675">
                  <c:v>1120.0520833333301</c:v>
                </c:pt>
                <c:pt idx="4676">
                  <c:v>1120.2916666666699</c:v>
                </c:pt>
                <c:pt idx="4677">
                  <c:v>1120.53125</c:v>
                </c:pt>
                <c:pt idx="4678">
                  <c:v>1120.7708333333301</c:v>
                </c:pt>
                <c:pt idx="4679">
                  <c:v>1121.0104166666699</c:v>
                </c:pt>
                <c:pt idx="4680">
                  <c:v>1121.25</c:v>
                </c:pt>
                <c:pt idx="4681">
                  <c:v>1121.4895833333301</c:v>
                </c:pt>
                <c:pt idx="4682">
                  <c:v>1121.7291666666699</c:v>
                </c:pt>
                <c:pt idx="4683">
                  <c:v>1121.96875</c:v>
                </c:pt>
                <c:pt idx="4684">
                  <c:v>1122.2083333333301</c:v>
                </c:pt>
                <c:pt idx="4685">
                  <c:v>1122.4479166666699</c:v>
                </c:pt>
                <c:pt idx="4686">
                  <c:v>1122.6875</c:v>
                </c:pt>
                <c:pt idx="4687">
                  <c:v>1122.9270833333301</c:v>
                </c:pt>
                <c:pt idx="4688">
                  <c:v>1123.1666666666699</c:v>
                </c:pt>
                <c:pt idx="4689">
                  <c:v>1123.40625</c:v>
                </c:pt>
                <c:pt idx="4690">
                  <c:v>1123.6458333333301</c:v>
                </c:pt>
                <c:pt idx="4691">
                  <c:v>1123.8854166666699</c:v>
                </c:pt>
                <c:pt idx="4692">
                  <c:v>1124.125</c:v>
                </c:pt>
                <c:pt idx="4693">
                  <c:v>1124.3645833333301</c:v>
                </c:pt>
                <c:pt idx="4694">
                  <c:v>1124.6041666666699</c:v>
                </c:pt>
                <c:pt idx="4695">
                  <c:v>1124.84375</c:v>
                </c:pt>
                <c:pt idx="4696">
                  <c:v>1125.0833333333301</c:v>
                </c:pt>
                <c:pt idx="4697">
                  <c:v>1125.3229166666699</c:v>
                </c:pt>
                <c:pt idx="4698">
                  <c:v>1125.5625</c:v>
                </c:pt>
                <c:pt idx="4699">
                  <c:v>1125.8020833333301</c:v>
                </c:pt>
                <c:pt idx="4700">
                  <c:v>1126.0416666666699</c:v>
                </c:pt>
                <c:pt idx="4701">
                  <c:v>1126.28125</c:v>
                </c:pt>
                <c:pt idx="4702">
                  <c:v>1126.5208333333301</c:v>
                </c:pt>
                <c:pt idx="4703">
                  <c:v>1126.7604166666699</c:v>
                </c:pt>
                <c:pt idx="4704">
                  <c:v>1127</c:v>
                </c:pt>
                <c:pt idx="4705">
                  <c:v>1127.2395833333301</c:v>
                </c:pt>
                <c:pt idx="4706">
                  <c:v>1127.4791666666699</c:v>
                </c:pt>
                <c:pt idx="4707">
                  <c:v>1127.71875</c:v>
                </c:pt>
                <c:pt idx="4708">
                  <c:v>1127.9583333333301</c:v>
                </c:pt>
                <c:pt idx="4709">
                  <c:v>1128.1979166666699</c:v>
                </c:pt>
                <c:pt idx="4710">
                  <c:v>1128.4375</c:v>
                </c:pt>
                <c:pt idx="4711">
                  <c:v>1128.6770833333301</c:v>
                </c:pt>
                <c:pt idx="4712">
                  <c:v>1128.9166666666699</c:v>
                </c:pt>
                <c:pt idx="4713">
                  <c:v>1129.15625</c:v>
                </c:pt>
                <c:pt idx="4714">
                  <c:v>1129.3958333333301</c:v>
                </c:pt>
                <c:pt idx="4715">
                  <c:v>1129.6354166666699</c:v>
                </c:pt>
                <c:pt idx="4716">
                  <c:v>1129.875</c:v>
                </c:pt>
                <c:pt idx="4717">
                  <c:v>1130.1145833333301</c:v>
                </c:pt>
                <c:pt idx="4718">
                  <c:v>1130.3541666666699</c:v>
                </c:pt>
                <c:pt idx="4719">
                  <c:v>1130.59375</c:v>
                </c:pt>
                <c:pt idx="4720">
                  <c:v>1130.8333333333301</c:v>
                </c:pt>
                <c:pt idx="4721">
                  <c:v>1131.0729166666699</c:v>
                </c:pt>
                <c:pt idx="4722">
                  <c:v>1131.3125</c:v>
                </c:pt>
                <c:pt idx="4723">
                  <c:v>1131.5520833333301</c:v>
                </c:pt>
                <c:pt idx="4724">
                  <c:v>1131.7916666666699</c:v>
                </c:pt>
                <c:pt idx="4725">
                  <c:v>1132.03125</c:v>
                </c:pt>
                <c:pt idx="4726">
                  <c:v>1132.2708333333301</c:v>
                </c:pt>
                <c:pt idx="4727">
                  <c:v>1132.5104166666699</c:v>
                </c:pt>
                <c:pt idx="4728">
                  <c:v>1132.75</c:v>
                </c:pt>
                <c:pt idx="4729">
                  <c:v>1132.9895833333301</c:v>
                </c:pt>
                <c:pt idx="4730">
                  <c:v>1133.2291666666699</c:v>
                </c:pt>
                <c:pt idx="4731">
                  <c:v>1133.46875</c:v>
                </c:pt>
                <c:pt idx="4732">
                  <c:v>1133.7083333333301</c:v>
                </c:pt>
                <c:pt idx="4733">
                  <c:v>1133.9479166666699</c:v>
                </c:pt>
                <c:pt idx="4734">
                  <c:v>1134.1875</c:v>
                </c:pt>
                <c:pt idx="4735">
                  <c:v>1134.4270833333301</c:v>
                </c:pt>
                <c:pt idx="4736">
                  <c:v>1134.6666666666699</c:v>
                </c:pt>
                <c:pt idx="4737">
                  <c:v>1134.90625</c:v>
                </c:pt>
                <c:pt idx="4738">
                  <c:v>1135.1458333333301</c:v>
                </c:pt>
                <c:pt idx="4739">
                  <c:v>1135.3854166666699</c:v>
                </c:pt>
                <c:pt idx="4740">
                  <c:v>1135.625</c:v>
                </c:pt>
                <c:pt idx="4741">
                  <c:v>1135.8645833333301</c:v>
                </c:pt>
                <c:pt idx="4742">
                  <c:v>1136.1041666666699</c:v>
                </c:pt>
                <c:pt idx="4743">
                  <c:v>1136.34375</c:v>
                </c:pt>
                <c:pt idx="4744">
                  <c:v>1136.5833333333301</c:v>
                </c:pt>
                <c:pt idx="4745">
                  <c:v>1136.8229166666699</c:v>
                </c:pt>
                <c:pt idx="4746">
                  <c:v>1137.0625</c:v>
                </c:pt>
                <c:pt idx="4747">
                  <c:v>1137.3020833333301</c:v>
                </c:pt>
                <c:pt idx="4748">
                  <c:v>1137.5416666666699</c:v>
                </c:pt>
                <c:pt idx="4749">
                  <c:v>1137.78125</c:v>
                </c:pt>
                <c:pt idx="4750">
                  <c:v>1138.0208333333301</c:v>
                </c:pt>
                <c:pt idx="4751">
                  <c:v>1138.2604166666699</c:v>
                </c:pt>
                <c:pt idx="4752">
                  <c:v>1138.5</c:v>
                </c:pt>
                <c:pt idx="4753">
                  <c:v>1138.7395833333301</c:v>
                </c:pt>
                <c:pt idx="4754">
                  <c:v>1138.9791666666699</c:v>
                </c:pt>
                <c:pt idx="4755">
                  <c:v>1139.21875</c:v>
                </c:pt>
                <c:pt idx="4756">
                  <c:v>1139.4583333333301</c:v>
                </c:pt>
                <c:pt idx="4757">
                  <c:v>1139.6979166666699</c:v>
                </c:pt>
                <c:pt idx="4758">
                  <c:v>1139.9375</c:v>
                </c:pt>
                <c:pt idx="4759">
                  <c:v>1140.1770833333301</c:v>
                </c:pt>
                <c:pt idx="4760">
                  <c:v>1140.4166666666699</c:v>
                </c:pt>
                <c:pt idx="4761">
                  <c:v>1140.65625</c:v>
                </c:pt>
                <c:pt idx="4762">
                  <c:v>1140.8958333333301</c:v>
                </c:pt>
                <c:pt idx="4763">
                  <c:v>1141.1354166666699</c:v>
                </c:pt>
                <c:pt idx="4764">
                  <c:v>1141.375</c:v>
                </c:pt>
                <c:pt idx="4765">
                  <c:v>1141.6145833333301</c:v>
                </c:pt>
                <c:pt idx="4766">
                  <c:v>1141.8541666666699</c:v>
                </c:pt>
                <c:pt idx="4767">
                  <c:v>1142.09375</c:v>
                </c:pt>
                <c:pt idx="4768">
                  <c:v>1142.3333333333301</c:v>
                </c:pt>
                <c:pt idx="4769">
                  <c:v>1142.5729166666699</c:v>
                </c:pt>
                <c:pt idx="4770">
                  <c:v>1142.8125</c:v>
                </c:pt>
                <c:pt idx="4771">
                  <c:v>1143.0520833333301</c:v>
                </c:pt>
                <c:pt idx="4772">
                  <c:v>1143.2916666666699</c:v>
                </c:pt>
                <c:pt idx="4773">
                  <c:v>1143.53125</c:v>
                </c:pt>
                <c:pt idx="4774">
                  <c:v>1143.7708333333301</c:v>
                </c:pt>
                <c:pt idx="4775">
                  <c:v>1144.0104166666699</c:v>
                </c:pt>
                <c:pt idx="4776">
                  <c:v>1144.25</c:v>
                </c:pt>
                <c:pt idx="4777">
                  <c:v>1144.4895833333301</c:v>
                </c:pt>
                <c:pt idx="4778">
                  <c:v>1144.7291666666699</c:v>
                </c:pt>
                <c:pt idx="4779">
                  <c:v>1144.96875</c:v>
                </c:pt>
                <c:pt idx="4780">
                  <c:v>1145.2083333333301</c:v>
                </c:pt>
                <c:pt idx="4781">
                  <c:v>1145.4479166666699</c:v>
                </c:pt>
                <c:pt idx="4782">
                  <c:v>1145.6875</c:v>
                </c:pt>
                <c:pt idx="4783">
                  <c:v>1145.9270833333301</c:v>
                </c:pt>
                <c:pt idx="4784">
                  <c:v>1146.1666666666699</c:v>
                </c:pt>
                <c:pt idx="4785">
                  <c:v>1146.40625</c:v>
                </c:pt>
                <c:pt idx="4786">
                  <c:v>1146.6458333333301</c:v>
                </c:pt>
                <c:pt idx="4787">
                  <c:v>1146.8854166666699</c:v>
                </c:pt>
                <c:pt idx="4788">
                  <c:v>1147.125</c:v>
                </c:pt>
                <c:pt idx="4789">
                  <c:v>1147.3645833333301</c:v>
                </c:pt>
                <c:pt idx="4790">
                  <c:v>1147.6041666666699</c:v>
                </c:pt>
                <c:pt idx="4791">
                  <c:v>1147.84375</c:v>
                </c:pt>
                <c:pt idx="4792">
                  <c:v>1148.0833333333301</c:v>
                </c:pt>
                <c:pt idx="4793">
                  <c:v>1148.3229166666699</c:v>
                </c:pt>
                <c:pt idx="4794">
                  <c:v>1148.5625</c:v>
                </c:pt>
                <c:pt idx="4795">
                  <c:v>1148.8020833333301</c:v>
                </c:pt>
                <c:pt idx="4796">
                  <c:v>1149.0416666666699</c:v>
                </c:pt>
                <c:pt idx="4797">
                  <c:v>1149.28125</c:v>
                </c:pt>
                <c:pt idx="4798">
                  <c:v>1149.5208333333301</c:v>
                </c:pt>
                <c:pt idx="4799">
                  <c:v>1149.7604166666699</c:v>
                </c:pt>
              </c:numCache>
            </c:numRef>
          </c:xVal>
          <c:yVal>
            <c:numRef>
              <c:f>Sheet1!$E$2:$E$4801</c:f>
              <c:numCache>
                <c:formatCode>General</c:formatCode>
                <c:ptCount val="4800"/>
                <c:pt idx="0">
                  <c:v>3.5754769602216201</c:v>
                </c:pt>
                <c:pt idx="1">
                  <c:v>3.4048519552899901</c:v>
                </c:pt>
                <c:pt idx="2">
                  <c:v>2.9766606763322101</c:v>
                </c:pt>
                <c:pt idx="3">
                  <c:v>3.2386109164967101</c:v>
                </c:pt>
                <c:pt idx="4">
                  <c:v>2.9442339191053</c:v>
                </c:pt>
                <c:pt idx="5">
                  <c:v>3.1049384389493402</c:v>
                </c:pt>
                <c:pt idx="6">
                  <c:v>2.7806459224272499</c:v>
                </c:pt>
                <c:pt idx="7">
                  <c:v>2.7908055126451599</c:v>
                </c:pt>
                <c:pt idx="8">
                  <c:v>3.08555587318346</c:v>
                </c:pt>
                <c:pt idx="9">
                  <c:v>2.8745968388546999</c:v>
                </c:pt>
                <c:pt idx="10">
                  <c:v>2.3241313200310798</c:v>
                </c:pt>
                <c:pt idx="11">
                  <c:v>2.3158061762493598</c:v>
                </c:pt>
                <c:pt idx="12">
                  <c:v>2.5368318782309398</c:v>
                </c:pt>
                <c:pt idx="13">
                  <c:v>3.0525839517208002</c:v>
                </c:pt>
                <c:pt idx="14">
                  <c:v>2.5272951334098499</c:v>
                </c:pt>
                <c:pt idx="15">
                  <c:v>3.0475898065323199</c:v>
                </c:pt>
                <c:pt idx="16">
                  <c:v>2.9545707074240299</c:v>
                </c:pt>
                <c:pt idx="17">
                  <c:v>2.8302772118594599</c:v>
                </c:pt>
                <c:pt idx="18">
                  <c:v>2.8930420184737402</c:v>
                </c:pt>
                <c:pt idx="19">
                  <c:v>2.8350572142289501</c:v>
                </c:pt>
                <c:pt idx="20">
                  <c:v>2.8476482273216299</c:v>
                </c:pt>
                <c:pt idx="21">
                  <c:v>3.4731172361542502</c:v>
                </c:pt>
                <c:pt idx="22">
                  <c:v>2.9970224363237099</c:v>
                </c:pt>
                <c:pt idx="23">
                  <c:v>2.9160674523451502</c:v>
                </c:pt>
                <c:pt idx="24">
                  <c:v>2.64037459048253</c:v>
                </c:pt>
                <c:pt idx="25">
                  <c:v>2.9526228855065901</c:v>
                </c:pt>
                <c:pt idx="26">
                  <c:v>2.8762198238921002</c:v>
                </c:pt>
                <c:pt idx="27">
                  <c:v>3.10855823965389</c:v>
                </c:pt>
                <c:pt idx="28">
                  <c:v>2.7106694794021702</c:v>
                </c:pt>
                <c:pt idx="29">
                  <c:v>2.9146386063916299</c:v>
                </c:pt>
                <c:pt idx="30">
                  <c:v>2.3536423715015999</c:v>
                </c:pt>
                <c:pt idx="31">
                  <c:v>3.0915930930217699</c:v>
                </c:pt>
                <c:pt idx="32">
                  <c:v>2.8667009776961301</c:v>
                </c:pt>
                <c:pt idx="33">
                  <c:v>2.58861190695665</c:v>
                </c:pt>
                <c:pt idx="34">
                  <c:v>3.13790573679199</c:v>
                </c:pt>
                <c:pt idx="35">
                  <c:v>2.5957175179587901</c:v>
                </c:pt>
                <c:pt idx="36">
                  <c:v>3.03942506655914</c:v>
                </c:pt>
                <c:pt idx="37">
                  <c:v>2.5886085590741099</c:v>
                </c:pt>
                <c:pt idx="38">
                  <c:v>3.1937705542881298</c:v>
                </c:pt>
                <c:pt idx="39">
                  <c:v>3.1724938308535502</c:v>
                </c:pt>
                <c:pt idx="40">
                  <c:v>2.9765206899093002</c:v>
                </c:pt>
                <c:pt idx="41">
                  <c:v>3.5678663131296702</c:v>
                </c:pt>
                <c:pt idx="42">
                  <c:v>3.4155086518065501</c:v>
                </c:pt>
                <c:pt idx="43">
                  <c:v>3.2230525299118602</c:v>
                </c:pt>
                <c:pt idx="44">
                  <c:v>2.4574043938444201</c:v>
                </c:pt>
                <c:pt idx="45">
                  <c:v>3.6158268192419301</c:v>
                </c:pt>
                <c:pt idx="46">
                  <c:v>3.1459680629203999</c:v>
                </c:pt>
                <c:pt idx="47">
                  <c:v>3.7937650216016201</c:v>
                </c:pt>
                <c:pt idx="48">
                  <c:v>3.41731924570743</c:v>
                </c:pt>
                <c:pt idx="49">
                  <c:v>4.3428176873678197</c:v>
                </c:pt>
                <c:pt idx="50">
                  <c:v>3.63163566235046</c:v>
                </c:pt>
                <c:pt idx="51">
                  <c:v>4.6640422555152004</c:v>
                </c:pt>
                <c:pt idx="52">
                  <c:v>3.3531681814764198</c:v>
                </c:pt>
                <c:pt idx="53">
                  <c:v>3.4559524586023702</c:v>
                </c:pt>
                <c:pt idx="54">
                  <c:v>3.0354196480493698</c:v>
                </c:pt>
                <c:pt idx="55">
                  <c:v>3.1356440971083699</c:v>
                </c:pt>
                <c:pt idx="56">
                  <c:v>3.7500050782354601</c:v>
                </c:pt>
                <c:pt idx="57">
                  <c:v>3.3786935849447599</c:v>
                </c:pt>
                <c:pt idx="58">
                  <c:v>3.5281370410700199</c:v>
                </c:pt>
                <c:pt idx="59">
                  <c:v>3.4887105580426501</c:v>
                </c:pt>
                <c:pt idx="60">
                  <c:v>3.75961407750501</c:v>
                </c:pt>
                <c:pt idx="61">
                  <c:v>3.1147986381907198</c:v>
                </c:pt>
                <c:pt idx="62">
                  <c:v>3.8715425966797299</c:v>
                </c:pt>
                <c:pt idx="63">
                  <c:v>3.23821002672757</c:v>
                </c:pt>
                <c:pt idx="64">
                  <c:v>3.5361932559705598</c:v>
                </c:pt>
                <c:pt idx="65">
                  <c:v>3.7296220420253601</c:v>
                </c:pt>
                <c:pt idx="66">
                  <c:v>3.4382011374987802</c:v>
                </c:pt>
                <c:pt idx="67">
                  <c:v>3.7633190889884198</c:v>
                </c:pt>
                <c:pt idx="68">
                  <c:v>3.4209010800879902</c:v>
                </c:pt>
                <c:pt idx="69">
                  <c:v>3.09081777314185</c:v>
                </c:pt>
                <c:pt idx="70">
                  <c:v>3.9650012239930801</c:v>
                </c:pt>
                <c:pt idx="71">
                  <c:v>4.2053585238125697</c:v>
                </c:pt>
                <c:pt idx="72">
                  <c:v>3.51039541277878</c:v>
                </c:pt>
                <c:pt idx="73">
                  <c:v>3.6854527597842401</c:v>
                </c:pt>
                <c:pt idx="74">
                  <c:v>3.4543924814681901</c:v>
                </c:pt>
                <c:pt idx="75">
                  <c:v>3.6514405911338801</c:v>
                </c:pt>
                <c:pt idx="76">
                  <c:v>3.5281597359854402</c:v>
                </c:pt>
                <c:pt idx="77">
                  <c:v>2.8718386090453798</c:v>
                </c:pt>
                <c:pt idx="78">
                  <c:v>3.5316554885718499</c:v>
                </c:pt>
                <c:pt idx="79">
                  <c:v>3.63566972836963</c:v>
                </c:pt>
                <c:pt idx="80">
                  <c:v>3.8570225141507399</c:v>
                </c:pt>
                <c:pt idx="81">
                  <c:v>2.9705233011014598</c:v>
                </c:pt>
                <c:pt idx="82">
                  <c:v>3.35563122900207</c:v>
                </c:pt>
                <c:pt idx="83">
                  <c:v>3.80919975576293</c:v>
                </c:pt>
                <c:pt idx="84">
                  <c:v>3.4506706455007801</c:v>
                </c:pt>
                <c:pt idx="85">
                  <c:v>3.5685962824748398</c:v>
                </c:pt>
                <c:pt idx="86">
                  <c:v>3.3216393021868602</c:v>
                </c:pt>
                <c:pt idx="87">
                  <c:v>3.1836620233171198</c:v>
                </c:pt>
                <c:pt idx="88">
                  <c:v>3.5545704976614498</c:v>
                </c:pt>
                <c:pt idx="89">
                  <c:v>3.3052069952900598</c:v>
                </c:pt>
                <c:pt idx="90">
                  <c:v>3.1398248390704402</c:v>
                </c:pt>
                <c:pt idx="91">
                  <c:v>3.1571445263762099</c:v>
                </c:pt>
                <c:pt idx="92">
                  <c:v>3.26025983146548</c:v>
                </c:pt>
                <c:pt idx="93">
                  <c:v>2.8954429823393499</c:v>
                </c:pt>
                <c:pt idx="94">
                  <c:v>3.4335856370861499</c:v>
                </c:pt>
                <c:pt idx="95">
                  <c:v>3.22140331754043</c:v>
                </c:pt>
                <c:pt idx="96">
                  <c:v>2.5833109565461898</c:v>
                </c:pt>
                <c:pt idx="97">
                  <c:v>3.3645780281054201</c:v>
                </c:pt>
                <c:pt idx="98">
                  <c:v>3.69911908721821</c:v>
                </c:pt>
                <c:pt idx="99">
                  <c:v>3.5933578860967499</c:v>
                </c:pt>
                <c:pt idx="100">
                  <c:v>3.2628162469359001</c:v>
                </c:pt>
                <c:pt idx="101">
                  <c:v>3.36188229655736</c:v>
                </c:pt>
                <c:pt idx="102">
                  <c:v>3.5411300969647002</c:v>
                </c:pt>
                <c:pt idx="103">
                  <c:v>3.1279386807297498</c:v>
                </c:pt>
                <c:pt idx="104">
                  <c:v>3.6078789241968998</c:v>
                </c:pt>
                <c:pt idx="105">
                  <c:v>3.57053715254309</c:v>
                </c:pt>
                <c:pt idx="106">
                  <c:v>3.47398740443119</c:v>
                </c:pt>
                <c:pt idx="107">
                  <c:v>3.5868913219317702</c:v>
                </c:pt>
                <c:pt idx="108">
                  <c:v>3.0271499501379999</c:v>
                </c:pt>
                <c:pt idx="109">
                  <c:v>3.27632125205254</c:v>
                </c:pt>
                <c:pt idx="110">
                  <c:v>3.27494138555367</c:v>
                </c:pt>
                <c:pt idx="111">
                  <c:v>3.4966950733744002</c:v>
                </c:pt>
                <c:pt idx="112">
                  <c:v>3.5387122432245102</c:v>
                </c:pt>
                <c:pt idx="113">
                  <c:v>3.2233860769443301</c:v>
                </c:pt>
                <c:pt idx="114">
                  <c:v>3.5881620515032102</c:v>
                </c:pt>
                <c:pt idx="115">
                  <c:v>3.6183612995739098</c:v>
                </c:pt>
                <c:pt idx="116">
                  <c:v>3.2672404691493901</c:v>
                </c:pt>
                <c:pt idx="117">
                  <c:v>3.0955085007814702</c:v>
                </c:pt>
                <c:pt idx="118">
                  <c:v>3.3442383223610199</c:v>
                </c:pt>
                <c:pt idx="119">
                  <c:v>3.40760537865747</c:v>
                </c:pt>
                <c:pt idx="120">
                  <c:v>3.8714604351086801</c:v>
                </c:pt>
                <c:pt idx="121">
                  <c:v>3.1452919158741</c:v>
                </c:pt>
                <c:pt idx="122">
                  <c:v>2.9454639097614699</c:v>
                </c:pt>
                <c:pt idx="123">
                  <c:v>3.31814008763111</c:v>
                </c:pt>
                <c:pt idx="124">
                  <c:v>3.4009171754941798</c:v>
                </c:pt>
                <c:pt idx="125">
                  <c:v>3.3301303512168299</c:v>
                </c:pt>
                <c:pt idx="126">
                  <c:v>3.65358245273233</c:v>
                </c:pt>
                <c:pt idx="127">
                  <c:v>3.5422080180161002</c:v>
                </c:pt>
                <c:pt idx="128">
                  <c:v>3.3712548406245202</c:v>
                </c:pt>
                <c:pt idx="129">
                  <c:v>3.5927923926533998</c:v>
                </c:pt>
                <c:pt idx="130">
                  <c:v>3.1506893609436299</c:v>
                </c:pt>
                <c:pt idx="131">
                  <c:v>3.3903311482282699</c:v>
                </c:pt>
                <c:pt idx="132">
                  <c:v>3.4516955503014399</c:v>
                </c:pt>
                <c:pt idx="133">
                  <c:v>3.0698989417821898</c:v>
                </c:pt>
                <c:pt idx="134">
                  <c:v>3.2217427328863901</c:v>
                </c:pt>
                <c:pt idx="135">
                  <c:v>3.3364893194655001</c:v>
                </c:pt>
                <c:pt idx="136">
                  <c:v>2.90031205118582</c:v>
                </c:pt>
                <c:pt idx="137">
                  <c:v>3.7494473800450598</c:v>
                </c:pt>
                <c:pt idx="138">
                  <c:v>3.17869699685146</c:v>
                </c:pt>
                <c:pt idx="139">
                  <c:v>3.4990093975173102</c:v>
                </c:pt>
                <c:pt idx="140">
                  <c:v>3.7388955299239699</c:v>
                </c:pt>
                <c:pt idx="141">
                  <c:v>4.3934779506340504</c:v>
                </c:pt>
                <c:pt idx="142">
                  <c:v>3.0078225342108</c:v>
                </c:pt>
                <c:pt idx="143">
                  <c:v>3.50664304102997</c:v>
                </c:pt>
                <c:pt idx="144">
                  <c:v>3.29891844975521</c:v>
                </c:pt>
                <c:pt idx="145">
                  <c:v>4.0064648863105701</c:v>
                </c:pt>
                <c:pt idx="146">
                  <c:v>3.30086751470717</c:v>
                </c:pt>
                <c:pt idx="147">
                  <c:v>3.6337021556048499</c:v>
                </c:pt>
                <c:pt idx="148">
                  <c:v>3.8144380785166998</c:v>
                </c:pt>
                <c:pt idx="149">
                  <c:v>3.3336911044969799</c:v>
                </c:pt>
                <c:pt idx="150">
                  <c:v>3.0165674926140502</c:v>
                </c:pt>
                <c:pt idx="151">
                  <c:v>3.0872218078319098</c:v>
                </c:pt>
                <c:pt idx="152">
                  <c:v>3.5747486237389601</c:v>
                </c:pt>
                <c:pt idx="153">
                  <c:v>2.9870121079512102</c:v>
                </c:pt>
                <c:pt idx="154">
                  <c:v>3.25031052239214</c:v>
                </c:pt>
                <c:pt idx="155">
                  <c:v>2.8067838273238599</c:v>
                </c:pt>
                <c:pt idx="156">
                  <c:v>3.4489299149025099</c:v>
                </c:pt>
                <c:pt idx="157">
                  <c:v>2.8835744054991901</c:v>
                </c:pt>
                <c:pt idx="158">
                  <c:v>3.0885867156209499</c:v>
                </c:pt>
                <c:pt idx="159">
                  <c:v>3.3062336188524402</c:v>
                </c:pt>
                <c:pt idx="160">
                  <c:v>3.7416017494351799</c:v>
                </c:pt>
                <c:pt idx="161">
                  <c:v>3.47455078698599</c:v>
                </c:pt>
                <c:pt idx="162">
                  <c:v>3.3384193415958499</c:v>
                </c:pt>
                <c:pt idx="163">
                  <c:v>3.2672511172814298</c:v>
                </c:pt>
                <c:pt idx="164">
                  <c:v>3.0830286167640999</c:v>
                </c:pt>
                <c:pt idx="165">
                  <c:v>3.9851160929579299</c:v>
                </c:pt>
                <c:pt idx="166">
                  <c:v>3.0163236570629799</c:v>
                </c:pt>
                <c:pt idx="167">
                  <c:v>3.48004838984312</c:v>
                </c:pt>
                <c:pt idx="168">
                  <c:v>3.3913688359101499</c:v>
                </c:pt>
                <c:pt idx="169">
                  <c:v>3.0683402685438002</c:v>
                </c:pt>
                <c:pt idx="170">
                  <c:v>3.3604732334378999</c:v>
                </c:pt>
                <c:pt idx="171">
                  <c:v>3.5501876531977601</c:v>
                </c:pt>
                <c:pt idx="172">
                  <c:v>3.2589857616140998</c:v>
                </c:pt>
                <c:pt idx="173">
                  <c:v>3.40972388120012</c:v>
                </c:pt>
                <c:pt idx="174">
                  <c:v>2.8325435642819499</c:v>
                </c:pt>
                <c:pt idx="175">
                  <c:v>3.1971317417910901</c:v>
                </c:pt>
                <c:pt idx="176">
                  <c:v>3.25746270874816</c:v>
                </c:pt>
                <c:pt idx="177">
                  <c:v>3.1811575608012101</c:v>
                </c:pt>
                <c:pt idx="178">
                  <c:v>2.9598565062508202</c:v>
                </c:pt>
                <c:pt idx="179">
                  <c:v>2.8473478417764002</c:v>
                </c:pt>
                <c:pt idx="180">
                  <c:v>3.0165932939312201</c:v>
                </c:pt>
                <c:pt idx="181">
                  <c:v>3.4872738684934301</c:v>
                </c:pt>
                <c:pt idx="182">
                  <c:v>3.07179108232733</c:v>
                </c:pt>
                <c:pt idx="183">
                  <c:v>3.077553910292</c:v>
                </c:pt>
                <c:pt idx="184">
                  <c:v>3.6095026207954701</c:v>
                </c:pt>
                <c:pt idx="185">
                  <c:v>3.2993105915249399</c:v>
                </c:pt>
                <c:pt idx="186">
                  <c:v>3.28017395451351</c:v>
                </c:pt>
                <c:pt idx="187">
                  <c:v>3.5290390628443702</c:v>
                </c:pt>
                <c:pt idx="188">
                  <c:v>3.4579266251996601</c:v>
                </c:pt>
                <c:pt idx="189">
                  <c:v>2.9588984050893399</c:v>
                </c:pt>
                <c:pt idx="190">
                  <c:v>3.1437791926014702</c:v>
                </c:pt>
                <c:pt idx="191">
                  <c:v>3.4101413241550098</c:v>
                </c:pt>
                <c:pt idx="192">
                  <c:v>3.4155588203412202</c:v>
                </c:pt>
                <c:pt idx="193">
                  <c:v>3.3430094638304899</c:v>
                </c:pt>
                <c:pt idx="194">
                  <c:v>3.3055638794808599</c:v>
                </c:pt>
                <c:pt idx="195">
                  <c:v>3.07100302415023</c:v>
                </c:pt>
                <c:pt idx="196">
                  <c:v>3.2740975156936201</c:v>
                </c:pt>
                <c:pt idx="197">
                  <c:v>3.1687924926826998</c:v>
                </c:pt>
                <c:pt idx="198">
                  <c:v>2.54580779107178</c:v>
                </c:pt>
                <c:pt idx="199">
                  <c:v>2.97289541089653</c:v>
                </c:pt>
                <c:pt idx="200">
                  <c:v>3.09112964756766</c:v>
                </c:pt>
                <c:pt idx="201">
                  <c:v>3.3650179255530701</c:v>
                </c:pt>
                <c:pt idx="202">
                  <c:v>3.03754730171655</c:v>
                </c:pt>
                <c:pt idx="203">
                  <c:v>2.98541625503427</c:v>
                </c:pt>
                <c:pt idx="204">
                  <c:v>3.1909876717974499</c:v>
                </c:pt>
                <c:pt idx="205">
                  <c:v>3.1992744970903702</c:v>
                </c:pt>
                <c:pt idx="206">
                  <c:v>3.30490804823443</c:v>
                </c:pt>
                <c:pt idx="207">
                  <c:v>2.8943621039218699</c:v>
                </c:pt>
                <c:pt idx="208">
                  <c:v>2.8742028447852399</c:v>
                </c:pt>
                <c:pt idx="209">
                  <c:v>3.0108930524944602</c:v>
                </c:pt>
                <c:pt idx="210">
                  <c:v>3.0299612546299501</c:v>
                </c:pt>
                <c:pt idx="211">
                  <c:v>3.0220151284610499</c:v>
                </c:pt>
                <c:pt idx="212">
                  <c:v>2.7986798462445899</c:v>
                </c:pt>
                <c:pt idx="213">
                  <c:v>2.4191646017227302</c:v>
                </c:pt>
                <c:pt idx="214">
                  <c:v>2.8257392332990698</c:v>
                </c:pt>
                <c:pt idx="215">
                  <c:v>3.3958277986221401</c:v>
                </c:pt>
                <c:pt idx="216">
                  <c:v>3.2968874664833598</c:v>
                </c:pt>
                <c:pt idx="217">
                  <c:v>2.8929717232932899</c:v>
                </c:pt>
                <c:pt idx="218">
                  <c:v>3.1805813105912701</c:v>
                </c:pt>
                <c:pt idx="219">
                  <c:v>3.10214159230852</c:v>
                </c:pt>
                <c:pt idx="220">
                  <c:v>2.7469547915931898</c:v>
                </c:pt>
                <c:pt idx="221">
                  <c:v>2.9183120673708101</c:v>
                </c:pt>
                <c:pt idx="222">
                  <c:v>3.8204912385508401</c:v>
                </c:pt>
                <c:pt idx="223">
                  <c:v>3.4815736529466901</c:v>
                </c:pt>
                <c:pt idx="224">
                  <c:v>2.9358567337844601</c:v>
                </c:pt>
                <c:pt idx="225">
                  <c:v>3.3005382424568102</c:v>
                </c:pt>
                <c:pt idx="226">
                  <c:v>3.1586441022942902</c:v>
                </c:pt>
                <c:pt idx="227">
                  <c:v>3.2021525065241501</c:v>
                </c:pt>
                <c:pt idx="228">
                  <c:v>3.56247904632641</c:v>
                </c:pt>
                <c:pt idx="229">
                  <c:v>3.3954410482353601</c:v>
                </c:pt>
                <c:pt idx="230">
                  <c:v>3.4324267841893099</c:v>
                </c:pt>
                <c:pt idx="231">
                  <c:v>3.2930156366402401</c:v>
                </c:pt>
                <c:pt idx="232">
                  <c:v>3.2735779933342699</c:v>
                </c:pt>
                <c:pt idx="233">
                  <c:v>2.8717039306901202</c:v>
                </c:pt>
                <c:pt idx="234">
                  <c:v>3.0072657448851299</c:v>
                </c:pt>
                <c:pt idx="235">
                  <c:v>2.9872105268487599</c:v>
                </c:pt>
                <c:pt idx="236">
                  <c:v>3.0638165748178601</c:v>
                </c:pt>
                <c:pt idx="237">
                  <c:v>3.0035425302580001</c:v>
                </c:pt>
                <c:pt idx="238">
                  <c:v>3.0871520911120598</c:v>
                </c:pt>
                <c:pt idx="239">
                  <c:v>2.6853667165714299</c:v>
                </c:pt>
                <c:pt idx="240">
                  <c:v>2.7434231921457601</c:v>
                </c:pt>
                <c:pt idx="241">
                  <c:v>3.49989291312145</c:v>
                </c:pt>
                <c:pt idx="242">
                  <c:v>3.08302008879431</c:v>
                </c:pt>
                <c:pt idx="243">
                  <c:v>2.8812104495173498</c:v>
                </c:pt>
                <c:pt idx="244">
                  <c:v>2.7896166576136401</c:v>
                </c:pt>
                <c:pt idx="245">
                  <c:v>3.1596378348908698</c:v>
                </c:pt>
                <c:pt idx="246">
                  <c:v>3.3165398768230201</c:v>
                </c:pt>
                <c:pt idx="247">
                  <c:v>3.0180298067758602</c:v>
                </c:pt>
                <c:pt idx="248">
                  <c:v>3.4282070126069799</c:v>
                </c:pt>
                <c:pt idx="249">
                  <c:v>3.1043471094005</c:v>
                </c:pt>
                <c:pt idx="250">
                  <c:v>3.4002048165560601</c:v>
                </c:pt>
                <c:pt idx="251">
                  <c:v>3.2035183077523</c:v>
                </c:pt>
                <c:pt idx="252">
                  <c:v>2.9002962246044701</c:v>
                </c:pt>
                <c:pt idx="253">
                  <c:v>3.5730706950362001</c:v>
                </c:pt>
                <c:pt idx="254">
                  <c:v>3.58980050347924</c:v>
                </c:pt>
                <c:pt idx="255">
                  <c:v>3.2222212459081301</c:v>
                </c:pt>
                <c:pt idx="256">
                  <c:v>3.0935757453559298</c:v>
                </c:pt>
                <c:pt idx="257">
                  <c:v>3.0525518900097999</c:v>
                </c:pt>
                <c:pt idx="258">
                  <c:v>2.7885567360427199</c:v>
                </c:pt>
                <c:pt idx="259">
                  <c:v>3.2235488704122299</c:v>
                </c:pt>
                <c:pt idx="260">
                  <c:v>3.5653881307494402</c:v>
                </c:pt>
                <c:pt idx="261">
                  <c:v>3.12549515765618</c:v>
                </c:pt>
                <c:pt idx="262">
                  <c:v>2.7483582414975101</c:v>
                </c:pt>
                <c:pt idx="263">
                  <c:v>2.6256378000649798</c:v>
                </c:pt>
                <c:pt idx="264">
                  <c:v>2.67267374184964</c:v>
                </c:pt>
                <c:pt idx="265">
                  <c:v>2.7353507294058801</c:v>
                </c:pt>
                <c:pt idx="266">
                  <c:v>2.77469973649097</c:v>
                </c:pt>
                <c:pt idx="267">
                  <c:v>2.98415147107238</c:v>
                </c:pt>
                <c:pt idx="268">
                  <c:v>2.4944943537470099</c:v>
                </c:pt>
                <c:pt idx="269">
                  <c:v>2.7468151142213402</c:v>
                </c:pt>
                <c:pt idx="270">
                  <c:v>2.5593441147774998</c:v>
                </c:pt>
                <c:pt idx="271">
                  <c:v>2.7206902026636302</c:v>
                </c:pt>
                <c:pt idx="272">
                  <c:v>3.3796731054654301</c:v>
                </c:pt>
                <c:pt idx="273">
                  <c:v>2.4182508948698702</c:v>
                </c:pt>
                <c:pt idx="274">
                  <c:v>2.5395618972139999</c:v>
                </c:pt>
                <c:pt idx="275">
                  <c:v>2.6278927213994399</c:v>
                </c:pt>
                <c:pt idx="276">
                  <c:v>2.5198976739895098</c:v>
                </c:pt>
                <c:pt idx="277">
                  <c:v>2.4425287608364998</c:v>
                </c:pt>
                <c:pt idx="278">
                  <c:v>3.01186568965585</c:v>
                </c:pt>
                <c:pt idx="279">
                  <c:v>2.4486679802762299</c:v>
                </c:pt>
                <c:pt idx="280">
                  <c:v>2.3185013231156799</c:v>
                </c:pt>
                <c:pt idx="281">
                  <c:v>2.8727854053423001</c:v>
                </c:pt>
                <c:pt idx="282">
                  <c:v>2.7658740492696001</c:v>
                </c:pt>
                <c:pt idx="283">
                  <c:v>3.43170333168365</c:v>
                </c:pt>
                <c:pt idx="284">
                  <c:v>2.9260682061671499</c:v>
                </c:pt>
                <c:pt idx="285">
                  <c:v>2.6320381890794802</c:v>
                </c:pt>
                <c:pt idx="286">
                  <c:v>3.1286472294096299</c:v>
                </c:pt>
                <c:pt idx="287">
                  <c:v>3.4465373871876901</c:v>
                </c:pt>
                <c:pt idx="288">
                  <c:v>3.65005057677031</c:v>
                </c:pt>
                <c:pt idx="289">
                  <c:v>2.9807069146049701</c:v>
                </c:pt>
                <c:pt idx="290">
                  <c:v>2.8036124147783901</c:v>
                </c:pt>
                <c:pt idx="291">
                  <c:v>2.77512080248228</c:v>
                </c:pt>
                <c:pt idx="292">
                  <c:v>2.67856989933306</c:v>
                </c:pt>
                <c:pt idx="293">
                  <c:v>2.8002722915663298</c:v>
                </c:pt>
                <c:pt idx="294">
                  <c:v>2.8630877981697598</c:v>
                </c:pt>
                <c:pt idx="295">
                  <c:v>2.8080978692539702</c:v>
                </c:pt>
                <c:pt idx="296">
                  <c:v>2.938746835041</c:v>
                </c:pt>
                <c:pt idx="297">
                  <c:v>3.4626682536360298</c:v>
                </c:pt>
                <c:pt idx="298">
                  <c:v>2.50375512773094</c:v>
                </c:pt>
                <c:pt idx="299">
                  <c:v>2.8285531173196601</c:v>
                </c:pt>
                <c:pt idx="300">
                  <c:v>3.0497205791978002</c:v>
                </c:pt>
                <c:pt idx="301">
                  <c:v>2.3930966876680699</c:v>
                </c:pt>
                <c:pt idx="302">
                  <c:v>3.3192936257010102</c:v>
                </c:pt>
                <c:pt idx="303">
                  <c:v>3.1105207405872002</c:v>
                </c:pt>
                <c:pt idx="304">
                  <c:v>3.7027832156336</c:v>
                </c:pt>
                <c:pt idx="305">
                  <c:v>3.6313194544185201</c:v>
                </c:pt>
                <c:pt idx="306">
                  <c:v>3.00214157483502</c:v>
                </c:pt>
                <c:pt idx="307">
                  <c:v>2.9896241553891501</c:v>
                </c:pt>
                <c:pt idx="308">
                  <c:v>2.8020205999750298</c:v>
                </c:pt>
                <c:pt idx="309">
                  <c:v>2.5270746138417399</c:v>
                </c:pt>
                <c:pt idx="310">
                  <c:v>2.5307908825574699</c:v>
                </c:pt>
                <c:pt idx="311">
                  <c:v>2.3638386040192199</c:v>
                </c:pt>
                <c:pt idx="312">
                  <c:v>2.54327588015581</c:v>
                </c:pt>
                <c:pt idx="313">
                  <c:v>2.1114212655774902</c:v>
                </c:pt>
                <c:pt idx="314">
                  <c:v>2.60075454241891</c:v>
                </c:pt>
                <c:pt idx="315">
                  <c:v>2.8086067555840599</c:v>
                </c:pt>
                <c:pt idx="316">
                  <c:v>2.2963677247030398</c:v>
                </c:pt>
                <c:pt idx="317">
                  <c:v>2.3822708356016999</c:v>
                </c:pt>
                <c:pt idx="318">
                  <c:v>2.1060032253133101</c:v>
                </c:pt>
                <c:pt idx="319">
                  <c:v>2.35868669332182</c:v>
                </c:pt>
                <c:pt idx="320">
                  <c:v>2.63736638769078</c:v>
                </c:pt>
                <c:pt idx="321">
                  <c:v>2.4552068412249501</c:v>
                </c:pt>
                <c:pt idx="322">
                  <c:v>2.3367897118333798</c:v>
                </c:pt>
                <c:pt idx="323">
                  <c:v>2.1679433407212398</c:v>
                </c:pt>
                <c:pt idx="324">
                  <c:v>2.3981334802569099</c:v>
                </c:pt>
                <c:pt idx="325">
                  <c:v>2.2638796689496901</c:v>
                </c:pt>
                <c:pt idx="326">
                  <c:v>2.4608908385526602</c:v>
                </c:pt>
                <c:pt idx="327">
                  <c:v>2.4703331423041099</c:v>
                </c:pt>
                <c:pt idx="328">
                  <c:v>2.6689497878074802</c:v>
                </c:pt>
                <c:pt idx="329">
                  <c:v>2.5727081810547898</c:v>
                </c:pt>
                <c:pt idx="330">
                  <c:v>3.04374701598194</c:v>
                </c:pt>
                <c:pt idx="331">
                  <c:v>2.1964832763948099</c:v>
                </c:pt>
                <c:pt idx="332">
                  <c:v>2.3041398767577399</c:v>
                </c:pt>
                <c:pt idx="333">
                  <c:v>2.2845894263201698</c:v>
                </c:pt>
                <c:pt idx="334">
                  <c:v>2.0856804179140802</c:v>
                </c:pt>
                <c:pt idx="335">
                  <c:v>3.36807060974157</c:v>
                </c:pt>
                <c:pt idx="336">
                  <c:v>3.3997003030467998</c:v>
                </c:pt>
                <c:pt idx="337">
                  <c:v>3.31222842021399</c:v>
                </c:pt>
                <c:pt idx="338">
                  <c:v>4.0294884063074701</c:v>
                </c:pt>
                <c:pt idx="339">
                  <c:v>2.8000432144944201</c:v>
                </c:pt>
                <c:pt idx="340">
                  <c:v>2.7475809817593202</c:v>
                </c:pt>
                <c:pt idx="341">
                  <c:v>2.4727660704137802</c:v>
                </c:pt>
                <c:pt idx="342">
                  <c:v>1.9497217316016</c:v>
                </c:pt>
                <c:pt idx="343">
                  <c:v>3.0795585807227299</c:v>
                </c:pt>
                <c:pt idx="344">
                  <c:v>3.0330611986291198</c:v>
                </c:pt>
                <c:pt idx="345">
                  <c:v>3.67895054905653</c:v>
                </c:pt>
                <c:pt idx="346">
                  <c:v>2.5901864908111398</c:v>
                </c:pt>
                <c:pt idx="347">
                  <c:v>2.62184304328157</c:v>
                </c:pt>
                <c:pt idx="348">
                  <c:v>3.5700427316690702</c:v>
                </c:pt>
                <c:pt idx="349">
                  <c:v>3.0729089604436299</c:v>
                </c:pt>
                <c:pt idx="350">
                  <c:v>3.6222067296980098</c:v>
                </c:pt>
                <c:pt idx="351">
                  <c:v>3.4785310723150702</c:v>
                </c:pt>
                <c:pt idx="352">
                  <c:v>2.66985123778759</c:v>
                </c:pt>
                <c:pt idx="353">
                  <c:v>2.70118876899119</c:v>
                </c:pt>
                <c:pt idx="354">
                  <c:v>3.5689751850911899</c:v>
                </c:pt>
                <c:pt idx="355">
                  <c:v>3.2656869635111399</c:v>
                </c:pt>
                <c:pt idx="356">
                  <c:v>3.2372286749115902</c:v>
                </c:pt>
                <c:pt idx="357">
                  <c:v>3.1207428509661801</c:v>
                </c:pt>
                <c:pt idx="358">
                  <c:v>3.5188021581541098</c:v>
                </c:pt>
                <c:pt idx="359">
                  <c:v>3.6709171919550401</c:v>
                </c:pt>
                <c:pt idx="360">
                  <c:v>3.0356091699757899</c:v>
                </c:pt>
                <c:pt idx="361">
                  <c:v>3.57844602190751</c:v>
                </c:pt>
                <c:pt idx="362">
                  <c:v>3.58565463977693</c:v>
                </c:pt>
                <c:pt idx="363">
                  <c:v>3.54690600449428</c:v>
                </c:pt>
                <c:pt idx="364">
                  <c:v>2.8247058356498398</c:v>
                </c:pt>
                <c:pt idx="365">
                  <c:v>3.40433819030171</c:v>
                </c:pt>
                <c:pt idx="366">
                  <c:v>2.6171430587721201</c:v>
                </c:pt>
                <c:pt idx="367">
                  <c:v>2.4591024523327598</c:v>
                </c:pt>
                <c:pt idx="368">
                  <c:v>2.7349589610736702</c:v>
                </c:pt>
                <c:pt idx="369">
                  <c:v>2.18921515070442</c:v>
                </c:pt>
                <c:pt idx="370">
                  <c:v>2.8552535657219398</c:v>
                </c:pt>
                <c:pt idx="371">
                  <c:v>2.9364218886938902</c:v>
                </c:pt>
                <c:pt idx="372">
                  <c:v>3.3806693706097999</c:v>
                </c:pt>
                <c:pt idx="373">
                  <c:v>3.8081817283789801</c:v>
                </c:pt>
                <c:pt idx="374">
                  <c:v>2.8188977771073298</c:v>
                </c:pt>
                <c:pt idx="375">
                  <c:v>3.2157793405781598</c:v>
                </c:pt>
                <c:pt idx="376">
                  <c:v>2.6003167368050999</c:v>
                </c:pt>
                <c:pt idx="377">
                  <c:v>3.1116767302019501</c:v>
                </c:pt>
                <c:pt idx="378">
                  <c:v>2.8988204838321798</c:v>
                </c:pt>
                <c:pt idx="379">
                  <c:v>2.60260723028034</c:v>
                </c:pt>
                <c:pt idx="380">
                  <c:v>2.5659952372408998</c:v>
                </c:pt>
                <c:pt idx="381">
                  <c:v>2.35198777043344</c:v>
                </c:pt>
                <c:pt idx="382">
                  <c:v>2.6272642889172899</c:v>
                </c:pt>
                <c:pt idx="383">
                  <c:v>2.43282216650316</c:v>
                </c:pt>
                <c:pt idx="384">
                  <c:v>2.6227597712617801</c:v>
                </c:pt>
                <c:pt idx="385">
                  <c:v>2.68309581655258</c:v>
                </c:pt>
                <c:pt idx="386">
                  <c:v>2.4513902619169601</c:v>
                </c:pt>
                <c:pt idx="387">
                  <c:v>2.4375508168048099</c:v>
                </c:pt>
                <c:pt idx="388">
                  <c:v>2.7377030103871398</c:v>
                </c:pt>
                <c:pt idx="389">
                  <c:v>2.44966772959173</c:v>
                </c:pt>
                <c:pt idx="390">
                  <c:v>2.89983263444371</c:v>
                </c:pt>
                <c:pt idx="391">
                  <c:v>2.9717559083417999</c:v>
                </c:pt>
                <c:pt idx="392">
                  <c:v>2.6414422718294901</c:v>
                </c:pt>
                <c:pt idx="393">
                  <c:v>3.5521617330603501</c:v>
                </c:pt>
                <c:pt idx="394">
                  <c:v>2.4854352191448501</c:v>
                </c:pt>
                <c:pt idx="395">
                  <c:v>2.5027708858423101</c:v>
                </c:pt>
                <c:pt idx="396">
                  <c:v>2.5760102133730598</c:v>
                </c:pt>
                <c:pt idx="397">
                  <c:v>2.26931586843035</c:v>
                </c:pt>
                <c:pt idx="398">
                  <c:v>2.35287343418487</c:v>
                </c:pt>
                <c:pt idx="399">
                  <c:v>2.6256670296568401</c:v>
                </c:pt>
                <c:pt idx="400">
                  <c:v>2.8847736012668701</c:v>
                </c:pt>
                <c:pt idx="401">
                  <c:v>3.5919311387975199</c:v>
                </c:pt>
                <c:pt idx="402">
                  <c:v>2.7798790856863</c:v>
                </c:pt>
                <c:pt idx="403">
                  <c:v>3.4325583287405399</c:v>
                </c:pt>
                <c:pt idx="404">
                  <c:v>2.8956302818455701</c:v>
                </c:pt>
                <c:pt idx="405">
                  <c:v>3.3647683433197901</c:v>
                </c:pt>
                <c:pt idx="406">
                  <c:v>2.9942050690366502</c:v>
                </c:pt>
                <c:pt idx="407">
                  <c:v>2.86312975753148</c:v>
                </c:pt>
                <c:pt idx="408">
                  <c:v>2.8312521907648902</c:v>
                </c:pt>
                <c:pt idx="409">
                  <c:v>3.2799121224296002</c:v>
                </c:pt>
                <c:pt idx="410">
                  <c:v>2.9825589478469201</c:v>
                </c:pt>
                <c:pt idx="411">
                  <c:v>3.02025029924667</c:v>
                </c:pt>
                <c:pt idx="412">
                  <c:v>2.7103245166872698</c:v>
                </c:pt>
                <c:pt idx="413">
                  <c:v>3.43466132272362</c:v>
                </c:pt>
                <c:pt idx="414">
                  <c:v>2.9528864914581501</c:v>
                </c:pt>
                <c:pt idx="415">
                  <c:v>3.2359250141028499</c:v>
                </c:pt>
                <c:pt idx="416">
                  <c:v>3.5673348094719302</c:v>
                </c:pt>
                <c:pt idx="417">
                  <c:v>2.9670385113207698</c:v>
                </c:pt>
                <c:pt idx="418">
                  <c:v>3.0542050675508001</c:v>
                </c:pt>
                <c:pt idx="419">
                  <c:v>2.6185478333923702</c:v>
                </c:pt>
                <c:pt idx="420">
                  <c:v>3.0921486877355502</c:v>
                </c:pt>
                <c:pt idx="421">
                  <c:v>3.0183604075870298</c:v>
                </c:pt>
                <c:pt idx="422">
                  <c:v>3.3457410165887702</c:v>
                </c:pt>
                <c:pt idx="423">
                  <c:v>3.0137980482114801</c:v>
                </c:pt>
                <c:pt idx="424">
                  <c:v>2.63846793098765</c:v>
                </c:pt>
                <c:pt idx="425">
                  <c:v>3.7920086003760498</c:v>
                </c:pt>
                <c:pt idx="426">
                  <c:v>2.9738455938586799</c:v>
                </c:pt>
                <c:pt idx="427">
                  <c:v>2.9753229836423598</c:v>
                </c:pt>
                <c:pt idx="428">
                  <c:v>2.9923414332753202</c:v>
                </c:pt>
                <c:pt idx="429">
                  <c:v>2.8624647292107799</c:v>
                </c:pt>
                <c:pt idx="430">
                  <c:v>3.3260463095557302</c:v>
                </c:pt>
                <c:pt idx="431">
                  <c:v>3.3633871568159099</c:v>
                </c:pt>
                <c:pt idx="432">
                  <c:v>2.90089668871587</c:v>
                </c:pt>
                <c:pt idx="433">
                  <c:v>2.8720147749842599</c:v>
                </c:pt>
                <c:pt idx="434">
                  <c:v>3.0051290889642099</c:v>
                </c:pt>
                <c:pt idx="435">
                  <c:v>3.1356363882591198</c:v>
                </c:pt>
                <c:pt idx="436">
                  <c:v>3.3283467284706401</c:v>
                </c:pt>
                <c:pt idx="437">
                  <c:v>2.7469619183516198</c:v>
                </c:pt>
                <c:pt idx="438">
                  <c:v>3.6545592885752298</c:v>
                </c:pt>
                <c:pt idx="439">
                  <c:v>2.85326900795953</c:v>
                </c:pt>
                <c:pt idx="440">
                  <c:v>3.18639240385586</c:v>
                </c:pt>
                <c:pt idx="441">
                  <c:v>2.7896965843130599</c:v>
                </c:pt>
                <c:pt idx="442">
                  <c:v>3.1851139850201502</c:v>
                </c:pt>
                <c:pt idx="443">
                  <c:v>3.7856157288515799</c:v>
                </c:pt>
                <c:pt idx="444">
                  <c:v>3.5849695378029298</c:v>
                </c:pt>
                <c:pt idx="445">
                  <c:v>2.6475487040056001</c:v>
                </c:pt>
                <c:pt idx="446">
                  <c:v>3.2910001794439001</c:v>
                </c:pt>
                <c:pt idx="447">
                  <c:v>3.4422324860368398</c:v>
                </c:pt>
                <c:pt idx="448">
                  <c:v>3.16471781373009</c:v>
                </c:pt>
                <c:pt idx="449">
                  <c:v>3.0067673486410902</c:v>
                </c:pt>
                <c:pt idx="450">
                  <c:v>2.6074797495793001</c:v>
                </c:pt>
                <c:pt idx="451">
                  <c:v>2.2611091306753899</c:v>
                </c:pt>
                <c:pt idx="452">
                  <c:v>2.5610565776642198</c:v>
                </c:pt>
                <c:pt idx="453">
                  <c:v>2.5733211914884002</c:v>
                </c:pt>
                <c:pt idx="454">
                  <c:v>1.9297576213434</c:v>
                </c:pt>
                <c:pt idx="455">
                  <c:v>2.8192971974294001</c:v>
                </c:pt>
                <c:pt idx="456">
                  <c:v>2.0462551190577098</c:v>
                </c:pt>
                <c:pt idx="457">
                  <c:v>2.32535464331036</c:v>
                </c:pt>
                <c:pt idx="458">
                  <c:v>2.76058871361526</c:v>
                </c:pt>
                <c:pt idx="459">
                  <c:v>2.7319694739700302</c:v>
                </c:pt>
                <c:pt idx="460">
                  <c:v>2.8107751021681202</c:v>
                </c:pt>
                <c:pt idx="461">
                  <c:v>2.3338832469743198</c:v>
                </c:pt>
                <c:pt idx="462">
                  <c:v>2.12309264600131</c:v>
                </c:pt>
                <c:pt idx="463">
                  <c:v>2.6279816855601101</c:v>
                </c:pt>
                <c:pt idx="464">
                  <c:v>2.3199862773397899</c:v>
                </c:pt>
                <c:pt idx="465">
                  <c:v>2.4746275568899998</c:v>
                </c:pt>
                <c:pt idx="466">
                  <c:v>2.5024568360563202</c:v>
                </c:pt>
                <c:pt idx="467">
                  <c:v>2.3845906582587699</c:v>
                </c:pt>
                <c:pt idx="468">
                  <c:v>2.8128467946149902</c:v>
                </c:pt>
                <c:pt idx="469">
                  <c:v>2.9428904175371402</c:v>
                </c:pt>
                <c:pt idx="470">
                  <c:v>2.5441510135091598</c:v>
                </c:pt>
                <c:pt idx="471">
                  <c:v>2.88401059025602</c:v>
                </c:pt>
                <c:pt idx="472">
                  <c:v>3.0098191021884899</c:v>
                </c:pt>
                <c:pt idx="473">
                  <c:v>2.5360801184839299</c:v>
                </c:pt>
                <c:pt idx="474">
                  <c:v>2.5978240978371998</c:v>
                </c:pt>
                <c:pt idx="475">
                  <c:v>2.9550118142056001</c:v>
                </c:pt>
                <c:pt idx="476">
                  <c:v>3.0198676929016899</c:v>
                </c:pt>
                <c:pt idx="477">
                  <c:v>2.3310080243654498</c:v>
                </c:pt>
                <c:pt idx="478">
                  <c:v>2.0728663523528001</c:v>
                </c:pt>
                <c:pt idx="479">
                  <c:v>2.6200999737920401</c:v>
                </c:pt>
                <c:pt idx="480">
                  <c:v>1.8274315189908801</c:v>
                </c:pt>
                <c:pt idx="481">
                  <c:v>2.7589834707149499</c:v>
                </c:pt>
                <c:pt idx="482">
                  <c:v>2.1385547912826302</c:v>
                </c:pt>
                <c:pt idx="483">
                  <c:v>2.1261322652812198</c:v>
                </c:pt>
                <c:pt idx="484">
                  <c:v>2.1212912830191102</c:v>
                </c:pt>
                <c:pt idx="485">
                  <c:v>2.2989791418546002</c:v>
                </c:pt>
                <c:pt idx="486">
                  <c:v>2.37881830097461</c:v>
                </c:pt>
                <c:pt idx="487">
                  <c:v>2.5090639134275001</c:v>
                </c:pt>
                <c:pt idx="488">
                  <c:v>1.8120989313628499</c:v>
                </c:pt>
                <c:pt idx="489">
                  <c:v>2.3239932130655401</c:v>
                </c:pt>
                <c:pt idx="490">
                  <c:v>1.8233090366885101</c:v>
                </c:pt>
                <c:pt idx="491">
                  <c:v>1.78666410433141</c:v>
                </c:pt>
                <c:pt idx="492">
                  <c:v>2.27977056352031</c:v>
                </c:pt>
                <c:pt idx="493">
                  <c:v>2.2097419594418501</c:v>
                </c:pt>
                <c:pt idx="494">
                  <c:v>1.92116826282804</c:v>
                </c:pt>
                <c:pt idx="495">
                  <c:v>2.1330374647497798</c:v>
                </c:pt>
                <c:pt idx="496">
                  <c:v>2.23604125138979</c:v>
                </c:pt>
                <c:pt idx="497">
                  <c:v>2.1528878492280499</c:v>
                </c:pt>
                <c:pt idx="498">
                  <c:v>2.2062779674675599</c:v>
                </c:pt>
                <c:pt idx="499">
                  <c:v>2.1610260601954998</c:v>
                </c:pt>
                <c:pt idx="500">
                  <c:v>1.7378132466409399</c:v>
                </c:pt>
                <c:pt idx="501">
                  <c:v>1.8261687940215601</c:v>
                </c:pt>
                <c:pt idx="502">
                  <c:v>2.1844780182907599</c:v>
                </c:pt>
                <c:pt idx="503">
                  <c:v>2.37349501253395</c:v>
                </c:pt>
                <c:pt idx="504">
                  <c:v>2.81102621037099</c:v>
                </c:pt>
                <c:pt idx="505">
                  <c:v>2.48781465777608</c:v>
                </c:pt>
                <c:pt idx="506">
                  <c:v>2.6210597791021</c:v>
                </c:pt>
                <c:pt idx="507">
                  <c:v>2.0278441399546998</c:v>
                </c:pt>
                <c:pt idx="508">
                  <c:v>2.11071955500493</c:v>
                </c:pt>
                <c:pt idx="509">
                  <c:v>2.26714126212805</c:v>
                </c:pt>
                <c:pt idx="510">
                  <c:v>2.08841775373882</c:v>
                </c:pt>
                <c:pt idx="511">
                  <c:v>2.4654631195877701</c:v>
                </c:pt>
                <c:pt idx="512">
                  <c:v>1.91557842362828</c:v>
                </c:pt>
                <c:pt idx="513">
                  <c:v>2.2010259490087098</c:v>
                </c:pt>
                <c:pt idx="514">
                  <c:v>1.7092374180059799</c:v>
                </c:pt>
                <c:pt idx="515">
                  <c:v>2.6058866224841499</c:v>
                </c:pt>
                <c:pt idx="516">
                  <c:v>2.8543200525241499</c:v>
                </c:pt>
                <c:pt idx="517">
                  <c:v>2.64520559219834</c:v>
                </c:pt>
                <c:pt idx="518">
                  <c:v>2.6935246588586099</c:v>
                </c:pt>
                <c:pt idx="519">
                  <c:v>2.3183899511055501</c:v>
                </c:pt>
                <c:pt idx="520">
                  <c:v>2.0264955939927498</c:v>
                </c:pt>
                <c:pt idx="521">
                  <c:v>2.25832425126577</c:v>
                </c:pt>
                <c:pt idx="522">
                  <c:v>1.8709374827191101</c:v>
                </c:pt>
                <c:pt idx="523">
                  <c:v>2.0824598689630598</c:v>
                </c:pt>
                <c:pt idx="524">
                  <c:v>1.4546011008699999</c:v>
                </c:pt>
                <c:pt idx="525">
                  <c:v>2.1827501734111898</c:v>
                </c:pt>
                <c:pt idx="526">
                  <c:v>2.0297680995319398</c:v>
                </c:pt>
                <c:pt idx="527">
                  <c:v>2.6154573813309798</c:v>
                </c:pt>
                <c:pt idx="528">
                  <c:v>1.7495494783795</c:v>
                </c:pt>
                <c:pt idx="529">
                  <c:v>2.1583840410483899</c:v>
                </c:pt>
                <c:pt idx="530">
                  <c:v>1.94257474131316</c:v>
                </c:pt>
                <c:pt idx="531">
                  <c:v>2.1180683852012798</c:v>
                </c:pt>
                <c:pt idx="532">
                  <c:v>1.9634626252705201</c:v>
                </c:pt>
                <c:pt idx="533">
                  <c:v>2.29203141400632</c:v>
                </c:pt>
                <c:pt idx="534">
                  <c:v>2.0635085318346502</c:v>
                </c:pt>
                <c:pt idx="535">
                  <c:v>1.96265721346307</c:v>
                </c:pt>
                <c:pt idx="536">
                  <c:v>2.5085782664744301</c:v>
                </c:pt>
                <c:pt idx="537">
                  <c:v>2.2794336350233499</c:v>
                </c:pt>
                <c:pt idx="538">
                  <c:v>2.8293851167733202</c:v>
                </c:pt>
                <c:pt idx="539">
                  <c:v>2.4024430486689798</c:v>
                </c:pt>
                <c:pt idx="540">
                  <c:v>2.7906555542178699</c:v>
                </c:pt>
                <c:pt idx="541">
                  <c:v>2.6383419647240198</c:v>
                </c:pt>
                <c:pt idx="542">
                  <c:v>2.7396990610203602</c:v>
                </c:pt>
                <c:pt idx="543">
                  <c:v>2.4139324181027599</c:v>
                </c:pt>
                <c:pt idx="544">
                  <c:v>2.2363423857502398</c:v>
                </c:pt>
                <c:pt idx="545">
                  <c:v>1.85479554363404</c:v>
                </c:pt>
                <c:pt idx="546">
                  <c:v>2.3513633194143</c:v>
                </c:pt>
                <c:pt idx="547">
                  <c:v>2.8845163601769199</c:v>
                </c:pt>
                <c:pt idx="548">
                  <c:v>2.7950930721535601</c:v>
                </c:pt>
                <c:pt idx="549">
                  <c:v>2.5865116372251902</c:v>
                </c:pt>
                <c:pt idx="550">
                  <c:v>2.3648933315148599</c:v>
                </c:pt>
                <c:pt idx="551">
                  <c:v>2.56763105601746</c:v>
                </c:pt>
                <c:pt idx="552">
                  <c:v>2.0994005827711799</c:v>
                </c:pt>
                <c:pt idx="553">
                  <c:v>2.65258551302253</c:v>
                </c:pt>
                <c:pt idx="554">
                  <c:v>3.12326809154712</c:v>
                </c:pt>
                <c:pt idx="555">
                  <c:v>2.88123538005576</c:v>
                </c:pt>
                <c:pt idx="556">
                  <c:v>2.88303372332404</c:v>
                </c:pt>
                <c:pt idx="557">
                  <c:v>2.69012521314919</c:v>
                </c:pt>
                <c:pt idx="558">
                  <c:v>2.6805987488629799</c:v>
                </c:pt>
                <c:pt idx="559">
                  <c:v>2.14219390678773</c:v>
                </c:pt>
                <c:pt idx="560">
                  <c:v>2.1205966462421499</c:v>
                </c:pt>
                <c:pt idx="561">
                  <c:v>1.9566419338113601</c:v>
                </c:pt>
                <c:pt idx="562">
                  <c:v>2.27680776140918</c:v>
                </c:pt>
                <c:pt idx="563">
                  <c:v>2.2767058972211398</c:v>
                </c:pt>
                <c:pt idx="564">
                  <c:v>2.5804150710384102</c:v>
                </c:pt>
                <c:pt idx="565">
                  <c:v>2.51044789075678</c:v>
                </c:pt>
                <c:pt idx="566">
                  <c:v>1.8855004267959901</c:v>
                </c:pt>
                <c:pt idx="567">
                  <c:v>2.4742309656533101</c:v>
                </c:pt>
                <c:pt idx="568">
                  <c:v>2.52262594726934</c:v>
                </c:pt>
                <c:pt idx="569">
                  <c:v>2.2707880611869702</c:v>
                </c:pt>
                <c:pt idx="570">
                  <c:v>1.9915557776489501</c:v>
                </c:pt>
                <c:pt idx="571">
                  <c:v>2.1076703422309002</c:v>
                </c:pt>
                <c:pt idx="572">
                  <c:v>1.9862606340709199</c:v>
                </c:pt>
                <c:pt idx="573">
                  <c:v>2.1971429891831198</c:v>
                </c:pt>
                <c:pt idx="574">
                  <c:v>2.1981110148340699</c:v>
                </c:pt>
                <c:pt idx="575">
                  <c:v>1.8248311134458599</c:v>
                </c:pt>
                <c:pt idx="576">
                  <c:v>2.02302885016856</c:v>
                </c:pt>
                <c:pt idx="577">
                  <c:v>2.2106712234799399</c:v>
                </c:pt>
                <c:pt idx="578">
                  <c:v>2.2974112369728599</c:v>
                </c:pt>
                <c:pt idx="579">
                  <c:v>2.2641346137035701</c:v>
                </c:pt>
                <c:pt idx="580">
                  <c:v>1.7154407538123899</c:v>
                </c:pt>
                <c:pt idx="581">
                  <c:v>2.0596609407440498</c:v>
                </c:pt>
                <c:pt idx="582">
                  <c:v>1.99931093235164</c:v>
                </c:pt>
                <c:pt idx="583">
                  <c:v>1.80373864231206</c:v>
                </c:pt>
                <c:pt idx="584">
                  <c:v>2.3180549308033802</c:v>
                </c:pt>
                <c:pt idx="585">
                  <c:v>2.0051653442264499</c:v>
                </c:pt>
                <c:pt idx="586">
                  <c:v>2.2559775807619702</c:v>
                </c:pt>
                <c:pt idx="587">
                  <c:v>2.32058474426228</c:v>
                </c:pt>
                <c:pt idx="588">
                  <c:v>2.2928559576087699</c:v>
                </c:pt>
                <c:pt idx="589">
                  <c:v>1.99674359863358</c:v>
                </c:pt>
                <c:pt idx="590">
                  <c:v>2.1965877167315999</c:v>
                </c:pt>
                <c:pt idx="591">
                  <c:v>2.1849551381889101</c:v>
                </c:pt>
                <c:pt idx="592">
                  <c:v>2.6034062485498199</c:v>
                </c:pt>
                <c:pt idx="593">
                  <c:v>2.1975940864836598</c:v>
                </c:pt>
                <c:pt idx="594">
                  <c:v>2.6754816618194601</c:v>
                </c:pt>
                <c:pt idx="595">
                  <c:v>2.1024300714940298</c:v>
                </c:pt>
                <c:pt idx="596">
                  <c:v>2.7831988263024199</c:v>
                </c:pt>
                <c:pt idx="597">
                  <c:v>2.4866793598384902</c:v>
                </c:pt>
                <c:pt idx="598">
                  <c:v>2.9321417719914802</c:v>
                </c:pt>
                <c:pt idx="599">
                  <c:v>2.3457608656336202</c:v>
                </c:pt>
                <c:pt idx="600">
                  <c:v>2.8320021522789598</c:v>
                </c:pt>
                <c:pt idx="601">
                  <c:v>2.88017752206399</c:v>
                </c:pt>
                <c:pt idx="602">
                  <c:v>2.7151453058120998</c:v>
                </c:pt>
                <c:pt idx="603">
                  <c:v>2.7823962038868402</c:v>
                </c:pt>
                <c:pt idx="604">
                  <c:v>2.5304617970752301</c:v>
                </c:pt>
                <c:pt idx="605">
                  <c:v>2.3186669960836701</c:v>
                </c:pt>
                <c:pt idx="606">
                  <c:v>2.2464423245181</c:v>
                </c:pt>
                <c:pt idx="607">
                  <c:v>2.4346090176191599</c:v>
                </c:pt>
                <c:pt idx="608">
                  <c:v>2.9179691449831702</c:v>
                </c:pt>
                <c:pt idx="609">
                  <c:v>2.97459510323245</c:v>
                </c:pt>
                <c:pt idx="610">
                  <c:v>2.6502653102104898</c:v>
                </c:pt>
                <c:pt idx="611">
                  <c:v>2.3917032096789601</c:v>
                </c:pt>
                <c:pt idx="612">
                  <c:v>2.4475179204541999</c:v>
                </c:pt>
                <c:pt idx="613">
                  <c:v>2.49492900357779</c:v>
                </c:pt>
                <c:pt idx="614">
                  <c:v>2.00797062999859</c:v>
                </c:pt>
                <c:pt idx="615">
                  <c:v>2.5869247637348001</c:v>
                </c:pt>
                <c:pt idx="616">
                  <c:v>2.4756894100465199</c:v>
                </c:pt>
                <c:pt idx="617">
                  <c:v>2.5229688228053799</c:v>
                </c:pt>
                <c:pt idx="618">
                  <c:v>2.3267730122652601</c:v>
                </c:pt>
                <c:pt idx="619">
                  <c:v>2.1188598318410898</c:v>
                </c:pt>
                <c:pt idx="620">
                  <c:v>1.94990455576067</c:v>
                </c:pt>
                <c:pt idx="621">
                  <c:v>2.50545610322918</c:v>
                </c:pt>
                <c:pt idx="622">
                  <c:v>2.4726999202145898</c:v>
                </c:pt>
                <c:pt idx="623">
                  <c:v>2.7838320969108801</c:v>
                </c:pt>
                <c:pt idx="624">
                  <c:v>2.0547372603434599</c:v>
                </c:pt>
                <c:pt idx="625">
                  <c:v>2.0006975614861302</c:v>
                </c:pt>
                <c:pt idx="626">
                  <c:v>2.3003069790944699</c:v>
                </c:pt>
                <c:pt idx="627">
                  <c:v>2.32841070889762</c:v>
                </c:pt>
                <c:pt idx="628">
                  <c:v>2.39224066765822</c:v>
                </c:pt>
                <c:pt idx="629">
                  <c:v>2.4188323686666799</c:v>
                </c:pt>
                <c:pt idx="630">
                  <c:v>2.5504199115720798</c:v>
                </c:pt>
                <c:pt idx="631">
                  <c:v>2.46853465466365</c:v>
                </c:pt>
                <c:pt idx="632">
                  <c:v>2.7145601243627602</c:v>
                </c:pt>
                <c:pt idx="633">
                  <c:v>2.1801503037321202</c:v>
                </c:pt>
                <c:pt idx="634">
                  <c:v>2.3391269570448401</c:v>
                </c:pt>
                <c:pt idx="635">
                  <c:v>2.3808107061008501</c:v>
                </c:pt>
                <c:pt idx="636">
                  <c:v>2.4064738252526601</c:v>
                </c:pt>
                <c:pt idx="637">
                  <c:v>2.63946795976634</c:v>
                </c:pt>
                <c:pt idx="638">
                  <c:v>1.67162836050996</c:v>
                </c:pt>
                <c:pt idx="639">
                  <c:v>1.83002180649922</c:v>
                </c:pt>
                <c:pt idx="640">
                  <c:v>2.54753790835036</c:v>
                </c:pt>
                <c:pt idx="641">
                  <c:v>2.16176394106192</c:v>
                </c:pt>
                <c:pt idx="642">
                  <c:v>1.93700367258247</c:v>
                </c:pt>
                <c:pt idx="643">
                  <c:v>2.3377458426094102</c:v>
                </c:pt>
                <c:pt idx="644">
                  <c:v>2.43225721055672</c:v>
                </c:pt>
                <c:pt idx="645">
                  <c:v>2.7751531027169198</c:v>
                </c:pt>
                <c:pt idx="646">
                  <c:v>2.58534588989236</c:v>
                </c:pt>
                <c:pt idx="647">
                  <c:v>2.71449799787742</c:v>
                </c:pt>
                <c:pt idx="648">
                  <c:v>2.6833205370768698</c:v>
                </c:pt>
                <c:pt idx="649">
                  <c:v>1.94441270021608</c:v>
                </c:pt>
                <c:pt idx="650">
                  <c:v>2.1780242689849501</c:v>
                </c:pt>
                <c:pt idx="651">
                  <c:v>2.04226713911895</c:v>
                </c:pt>
                <c:pt idx="652">
                  <c:v>1.9637967808308201</c:v>
                </c:pt>
                <c:pt idx="653">
                  <c:v>2.1525966653503001</c:v>
                </c:pt>
                <c:pt idx="654">
                  <c:v>2.12652910658087</c:v>
                </c:pt>
                <c:pt idx="655">
                  <c:v>1.8576628667800801</c:v>
                </c:pt>
                <c:pt idx="656">
                  <c:v>2.0101186243126099</c:v>
                </c:pt>
                <c:pt idx="657">
                  <c:v>2.1986288365749398</c:v>
                </c:pt>
                <c:pt idx="658">
                  <c:v>2.3930596621171798</c:v>
                </c:pt>
                <c:pt idx="659">
                  <c:v>2.2768838318125502</c:v>
                </c:pt>
                <c:pt idx="660">
                  <c:v>2.09134389389355</c:v>
                </c:pt>
                <c:pt idx="661">
                  <c:v>2.2914065423897201</c:v>
                </c:pt>
                <c:pt idx="662">
                  <c:v>2.46909624561841</c:v>
                </c:pt>
                <c:pt idx="663">
                  <c:v>1.68401510569401</c:v>
                </c:pt>
                <c:pt idx="664">
                  <c:v>2.0402773294082102</c:v>
                </c:pt>
                <c:pt idx="665">
                  <c:v>1.92513963554571</c:v>
                </c:pt>
                <c:pt idx="666">
                  <c:v>2.18129012046048</c:v>
                </c:pt>
                <c:pt idx="667">
                  <c:v>1.7928621052078999</c:v>
                </c:pt>
                <c:pt idx="668">
                  <c:v>2.0102389075775902</c:v>
                </c:pt>
                <c:pt idx="669">
                  <c:v>2.3831157278950599</c:v>
                </c:pt>
                <c:pt idx="670">
                  <c:v>2.0414510914334998</c:v>
                </c:pt>
                <c:pt idx="671">
                  <c:v>2.9142492558160802</c:v>
                </c:pt>
                <c:pt idx="672">
                  <c:v>2.31325256583421</c:v>
                </c:pt>
                <c:pt idx="673">
                  <c:v>2.8068562251998999</c:v>
                </c:pt>
                <c:pt idx="674">
                  <c:v>2.6353650028037001</c:v>
                </c:pt>
                <c:pt idx="675">
                  <c:v>2.1245334850651698</c:v>
                </c:pt>
                <c:pt idx="676">
                  <c:v>2.6500683573680099</c:v>
                </c:pt>
                <c:pt idx="677">
                  <c:v>2.4007055496579</c:v>
                </c:pt>
                <c:pt idx="678">
                  <c:v>2.4185432895485701</c:v>
                </c:pt>
                <c:pt idx="679">
                  <c:v>2.7367864484162698</c:v>
                </c:pt>
                <c:pt idx="680">
                  <c:v>2.87165510761373</c:v>
                </c:pt>
                <c:pt idx="681">
                  <c:v>2.1876833902806401</c:v>
                </c:pt>
                <c:pt idx="682">
                  <c:v>2.7631897888235999</c:v>
                </c:pt>
                <c:pt idx="683">
                  <c:v>2.58823966106341</c:v>
                </c:pt>
                <c:pt idx="684">
                  <c:v>2.70950770055043</c:v>
                </c:pt>
                <c:pt idx="685">
                  <c:v>2.15190349649037</c:v>
                </c:pt>
                <c:pt idx="686">
                  <c:v>2.4572663296670401</c:v>
                </c:pt>
                <c:pt idx="687">
                  <c:v>2.5239608750575502</c:v>
                </c:pt>
                <c:pt idx="688">
                  <c:v>2.7382190993744202</c:v>
                </c:pt>
                <c:pt idx="689">
                  <c:v>2.5553329720373399</c:v>
                </c:pt>
                <c:pt idx="690">
                  <c:v>2.59875429604958</c:v>
                </c:pt>
                <c:pt idx="691">
                  <c:v>2.81664124350266</c:v>
                </c:pt>
                <c:pt idx="692">
                  <c:v>2.5015383923521401</c:v>
                </c:pt>
                <c:pt idx="693">
                  <c:v>2.5418895313873402</c:v>
                </c:pt>
                <c:pt idx="694">
                  <c:v>2.41418289209743</c:v>
                </c:pt>
                <c:pt idx="695">
                  <c:v>2.9777187538054202</c:v>
                </c:pt>
                <c:pt idx="696">
                  <c:v>2.7292396199384901</c:v>
                </c:pt>
                <c:pt idx="697">
                  <c:v>3.20347350027401</c:v>
                </c:pt>
                <c:pt idx="698">
                  <c:v>2.9019172742634201</c:v>
                </c:pt>
                <c:pt idx="699">
                  <c:v>2.7833417530715101</c:v>
                </c:pt>
                <c:pt idx="700">
                  <c:v>2.9779608471391201</c:v>
                </c:pt>
                <c:pt idx="701">
                  <c:v>2.8539998507964102</c:v>
                </c:pt>
                <c:pt idx="702">
                  <c:v>2.2413543486847201</c:v>
                </c:pt>
                <c:pt idx="703">
                  <c:v>2.7034250058080902</c:v>
                </c:pt>
                <c:pt idx="704">
                  <c:v>2.36479362773653</c:v>
                </c:pt>
                <c:pt idx="705">
                  <c:v>2.2615601304421</c:v>
                </c:pt>
                <c:pt idx="706">
                  <c:v>2.3510731357858399</c:v>
                </c:pt>
                <c:pt idx="707">
                  <c:v>2.6709417529419799</c:v>
                </c:pt>
                <c:pt idx="708">
                  <c:v>2.1963007826157099</c:v>
                </c:pt>
                <c:pt idx="709">
                  <c:v>2.9046625296361599</c:v>
                </c:pt>
                <c:pt idx="710">
                  <c:v>2.89228013842563</c:v>
                </c:pt>
                <c:pt idx="711">
                  <c:v>2.7351817983733699</c:v>
                </c:pt>
                <c:pt idx="712">
                  <c:v>2.1147031104573499</c:v>
                </c:pt>
                <c:pt idx="713">
                  <c:v>2.2730018425019201</c:v>
                </c:pt>
                <c:pt idx="714">
                  <c:v>2.9734882458756902</c:v>
                </c:pt>
                <c:pt idx="715">
                  <c:v>2.8559447805386999</c:v>
                </c:pt>
                <c:pt idx="716">
                  <c:v>2.47338895829441</c:v>
                </c:pt>
                <c:pt idx="717">
                  <c:v>2.82350719463712</c:v>
                </c:pt>
                <c:pt idx="718">
                  <c:v>2.9077759366414</c:v>
                </c:pt>
                <c:pt idx="719">
                  <c:v>2.4390161149695699</c:v>
                </c:pt>
                <c:pt idx="720">
                  <c:v>3.0733534212067801</c:v>
                </c:pt>
                <c:pt idx="721">
                  <c:v>3.2412589845214801</c:v>
                </c:pt>
                <c:pt idx="722">
                  <c:v>2.8996773351602401</c:v>
                </c:pt>
                <c:pt idx="723">
                  <c:v>2.3630233871389099</c:v>
                </c:pt>
                <c:pt idx="724">
                  <c:v>2.76216754022294</c:v>
                </c:pt>
                <c:pt idx="725">
                  <c:v>2.7510325122996599</c:v>
                </c:pt>
                <c:pt idx="726">
                  <c:v>3.0204645290432399</c:v>
                </c:pt>
                <c:pt idx="727">
                  <c:v>2.42294812934326</c:v>
                </c:pt>
                <c:pt idx="728">
                  <c:v>2.8804712786118198</c:v>
                </c:pt>
                <c:pt idx="729">
                  <c:v>2.4811843661873101</c:v>
                </c:pt>
                <c:pt idx="730">
                  <c:v>2.3019283122226399</c:v>
                </c:pt>
                <c:pt idx="731">
                  <c:v>1.7273617104157599</c:v>
                </c:pt>
                <c:pt idx="732">
                  <c:v>2.2348210262227401</c:v>
                </c:pt>
                <c:pt idx="733">
                  <c:v>2.5478111824090202</c:v>
                </c:pt>
                <c:pt idx="734">
                  <c:v>2.3474552259509398</c:v>
                </c:pt>
                <c:pt idx="735">
                  <c:v>2.19673541273735</c:v>
                </c:pt>
                <c:pt idx="736">
                  <c:v>1.5912508207154601</c:v>
                </c:pt>
                <c:pt idx="737">
                  <c:v>1.93098112359924</c:v>
                </c:pt>
                <c:pt idx="738">
                  <c:v>1.58869181285283</c:v>
                </c:pt>
                <c:pt idx="739">
                  <c:v>1.60350442751452</c:v>
                </c:pt>
                <c:pt idx="740">
                  <c:v>1.7160365511737301</c:v>
                </c:pt>
                <c:pt idx="741">
                  <c:v>2.0034258553165598</c:v>
                </c:pt>
                <c:pt idx="742">
                  <c:v>2.0146840284188499</c:v>
                </c:pt>
                <c:pt idx="743">
                  <c:v>2.43659379382495</c:v>
                </c:pt>
                <c:pt idx="744">
                  <c:v>2.02933859689991</c:v>
                </c:pt>
                <c:pt idx="745">
                  <c:v>1.9713134533594501</c:v>
                </c:pt>
                <c:pt idx="746">
                  <c:v>2.26511937580453</c:v>
                </c:pt>
                <c:pt idx="747">
                  <c:v>1.7483660782016499</c:v>
                </c:pt>
                <c:pt idx="748">
                  <c:v>2.0089352540750398</c:v>
                </c:pt>
                <c:pt idx="749">
                  <c:v>2.1982204535962699</c:v>
                </c:pt>
                <c:pt idx="750">
                  <c:v>2.4559921696440998</c:v>
                </c:pt>
                <c:pt idx="751">
                  <c:v>2.1721035075688002</c:v>
                </c:pt>
                <c:pt idx="752">
                  <c:v>1.89079075126082</c:v>
                </c:pt>
                <c:pt idx="753">
                  <c:v>2.2948965383207298</c:v>
                </c:pt>
                <c:pt idx="754">
                  <c:v>2.1412669418570802</c:v>
                </c:pt>
                <c:pt idx="755">
                  <c:v>2.6863478515525498</c:v>
                </c:pt>
                <c:pt idx="756">
                  <c:v>2.5847574980253998</c:v>
                </c:pt>
                <c:pt idx="757">
                  <c:v>2.3507770114122599</c:v>
                </c:pt>
                <c:pt idx="758">
                  <c:v>2.7491591672980902</c:v>
                </c:pt>
                <c:pt idx="759">
                  <c:v>3.0267859745197798</c:v>
                </c:pt>
                <c:pt idx="760">
                  <c:v>2.1826354560504302</c:v>
                </c:pt>
                <c:pt idx="761">
                  <c:v>2.08761251006141</c:v>
                </c:pt>
                <c:pt idx="762">
                  <c:v>2.0905052766108998</c:v>
                </c:pt>
                <c:pt idx="763">
                  <c:v>2.2679819429833099</c:v>
                </c:pt>
                <c:pt idx="764">
                  <c:v>2.11664566088331</c:v>
                </c:pt>
                <c:pt idx="765">
                  <c:v>2.2036914454029599</c:v>
                </c:pt>
                <c:pt idx="766">
                  <c:v>2.0385948010027399</c:v>
                </c:pt>
                <c:pt idx="767">
                  <c:v>2.0084376211413999</c:v>
                </c:pt>
                <c:pt idx="768">
                  <c:v>2.2157418015875399</c:v>
                </c:pt>
                <c:pt idx="769">
                  <c:v>1.96427133986553</c:v>
                </c:pt>
                <c:pt idx="770">
                  <c:v>1.9996722047309099</c:v>
                </c:pt>
                <c:pt idx="771">
                  <c:v>2.3955959925245001</c:v>
                </c:pt>
                <c:pt idx="772">
                  <c:v>2.0373905852045699</c:v>
                </c:pt>
                <c:pt idx="773">
                  <c:v>2.1833330737291599</c:v>
                </c:pt>
                <c:pt idx="774">
                  <c:v>2.04245726944115</c:v>
                </c:pt>
                <c:pt idx="775">
                  <c:v>2.3857913704432399</c:v>
                </c:pt>
                <c:pt idx="776">
                  <c:v>2.4386467195226</c:v>
                </c:pt>
                <c:pt idx="777">
                  <c:v>1.85793403474438</c:v>
                </c:pt>
                <c:pt idx="778">
                  <c:v>2.1306242242006701</c:v>
                </c:pt>
                <c:pt idx="779">
                  <c:v>1.5612700643778501</c:v>
                </c:pt>
                <c:pt idx="780">
                  <c:v>2.1555791562457398</c:v>
                </c:pt>
                <c:pt idx="781">
                  <c:v>1.6791862571835401</c:v>
                </c:pt>
                <c:pt idx="782">
                  <c:v>1.5935525385954601</c:v>
                </c:pt>
                <c:pt idx="783">
                  <c:v>1.8768662904614599</c:v>
                </c:pt>
                <c:pt idx="784">
                  <c:v>1.8907163669910001</c:v>
                </c:pt>
                <c:pt idx="785">
                  <c:v>2.86704325022228</c:v>
                </c:pt>
                <c:pt idx="786">
                  <c:v>2.3564677480136198</c:v>
                </c:pt>
                <c:pt idx="787">
                  <c:v>2.3645806656425101</c:v>
                </c:pt>
                <c:pt idx="788">
                  <c:v>2.2893595093813399</c:v>
                </c:pt>
                <c:pt idx="789">
                  <c:v>1.9342652081020799</c:v>
                </c:pt>
                <c:pt idx="790">
                  <c:v>2.4926351455945599</c:v>
                </c:pt>
                <c:pt idx="791">
                  <c:v>2.52903971891089</c:v>
                </c:pt>
                <c:pt idx="792">
                  <c:v>2.1473198040525299</c:v>
                </c:pt>
                <c:pt idx="793">
                  <c:v>1.9068603243698601</c:v>
                </c:pt>
                <c:pt idx="794">
                  <c:v>2.3789863923893999</c:v>
                </c:pt>
                <c:pt idx="795">
                  <c:v>1.4985914860713201</c:v>
                </c:pt>
                <c:pt idx="796">
                  <c:v>2.0580514162007999</c:v>
                </c:pt>
                <c:pt idx="797">
                  <c:v>1.70778762091338</c:v>
                </c:pt>
                <c:pt idx="798">
                  <c:v>1.93640712867025</c:v>
                </c:pt>
                <c:pt idx="799">
                  <c:v>1.77399335452377</c:v>
                </c:pt>
                <c:pt idx="800">
                  <c:v>1.8822714936228999</c:v>
                </c:pt>
                <c:pt idx="801">
                  <c:v>1.9784624390374601</c:v>
                </c:pt>
                <c:pt idx="802">
                  <c:v>1.9477300262672901</c:v>
                </c:pt>
                <c:pt idx="803">
                  <c:v>2.0585068602502199</c:v>
                </c:pt>
                <c:pt idx="804">
                  <c:v>2.4155695300987499</c:v>
                </c:pt>
                <c:pt idx="805">
                  <c:v>1.96328273009218</c:v>
                </c:pt>
                <c:pt idx="806">
                  <c:v>2.1072722151067498</c:v>
                </c:pt>
                <c:pt idx="807">
                  <c:v>1.7001368462254201</c:v>
                </c:pt>
                <c:pt idx="808">
                  <c:v>2.1793963088442698</c:v>
                </c:pt>
                <c:pt idx="809">
                  <c:v>2.6113982889675902</c:v>
                </c:pt>
                <c:pt idx="810">
                  <c:v>2.2460010480521801</c:v>
                </c:pt>
                <c:pt idx="811">
                  <c:v>2.49633960106121</c:v>
                </c:pt>
                <c:pt idx="812">
                  <c:v>2.1718882147669798</c:v>
                </c:pt>
                <c:pt idx="813">
                  <c:v>2.23441242956507</c:v>
                </c:pt>
                <c:pt idx="814">
                  <c:v>1.75834287926531</c:v>
                </c:pt>
                <c:pt idx="815">
                  <c:v>1.9859488564674901</c:v>
                </c:pt>
                <c:pt idx="816">
                  <c:v>2.4442969259506899</c:v>
                </c:pt>
                <c:pt idx="817">
                  <c:v>2.0297725644139399</c:v>
                </c:pt>
                <c:pt idx="818">
                  <c:v>2.0799872959699002</c:v>
                </c:pt>
                <c:pt idx="819">
                  <c:v>2.51047634336827</c:v>
                </c:pt>
                <c:pt idx="820">
                  <c:v>2.3132260526513702</c:v>
                </c:pt>
                <c:pt idx="821">
                  <c:v>1.7726230159944201</c:v>
                </c:pt>
                <c:pt idx="822">
                  <c:v>1.7983455823630601</c:v>
                </c:pt>
                <c:pt idx="823">
                  <c:v>1.6541972765394399</c:v>
                </c:pt>
                <c:pt idx="824">
                  <c:v>1.70485882452615</c:v>
                </c:pt>
                <c:pt idx="825">
                  <c:v>1.65640956415373</c:v>
                </c:pt>
                <c:pt idx="826">
                  <c:v>2.0892537743020401</c:v>
                </c:pt>
                <c:pt idx="827">
                  <c:v>2.07288551001264</c:v>
                </c:pt>
                <c:pt idx="828">
                  <c:v>1.52080246923494</c:v>
                </c:pt>
                <c:pt idx="829">
                  <c:v>2.5319816928760699</c:v>
                </c:pt>
                <c:pt idx="830">
                  <c:v>2.6513909319578102</c:v>
                </c:pt>
                <c:pt idx="831">
                  <c:v>2.1703758308168699</c:v>
                </c:pt>
                <c:pt idx="832">
                  <c:v>2.2225451699658998</c:v>
                </c:pt>
                <c:pt idx="833">
                  <c:v>2.71027339545447</c:v>
                </c:pt>
                <c:pt idx="834">
                  <c:v>2.75616766661628</c:v>
                </c:pt>
                <c:pt idx="835">
                  <c:v>2.3746049942109</c:v>
                </c:pt>
                <c:pt idx="836">
                  <c:v>2.0791119889162299</c:v>
                </c:pt>
                <c:pt idx="837">
                  <c:v>2.39839962685625</c:v>
                </c:pt>
                <c:pt idx="838">
                  <c:v>1.6458056462803701</c:v>
                </c:pt>
                <c:pt idx="839">
                  <c:v>2.1303301071749501</c:v>
                </c:pt>
                <c:pt idx="840">
                  <c:v>2.0955459123871401</c:v>
                </c:pt>
                <c:pt idx="841">
                  <c:v>2.5084827017649598</c:v>
                </c:pt>
                <c:pt idx="842">
                  <c:v>2.5100855823997401</c:v>
                </c:pt>
                <c:pt idx="843">
                  <c:v>1.86866638972495</c:v>
                </c:pt>
                <c:pt idx="844">
                  <c:v>1.72151673766027</c:v>
                </c:pt>
                <c:pt idx="845">
                  <c:v>1.7950111654293801</c:v>
                </c:pt>
                <c:pt idx="846">
                  <c:v>2.0964434235154199</c:v>
                </c:pt>
                <c:pt idx="847">
                  <c:v>2.0336303136170701</c:v>
                </c:pt>
                <c:pt idx="848">
                  <c:v>1.85820753774142</c:v>
                </c:pt>
                <c:pt idx="849">
                  <c:v>1.8144048295142201</c:v>
                </c:pt>
                <c:pt idx="850">
                  <c:v>2.2142650849976699</c:v>
                </c:pt>
                <c:pt idx="851">
                  <c:v>1.5386371564933301</c:v>
                </c:pt>
                <c:pt idx="852">
                  <c:v>2.62498888496589</c:v>
                </c:pt>
                <c:pt idx="853">
                  <c:v>2.7065840170546198</c:v>
                </c:pt>
                <c:pt idx="854">
                  <c:v>2.7386329714839701</c:v>
                </c:pt>
                <c:pt idx="855">
                  <c:v>2.6060353756487</c:v>
                </c:pt>
                <c:pt idx="856">
                  <c:v>2.1803912695286898</c:v>
                </c:pt>
                <c:pt idx="857">
                  <c:v>2.2788975842762298</c:v>
                </c:pt>
                <c:pt idx="858">
                  <c:v>2.4104625871090999</c:v>
                </c:pt>
                <c:pt idx="859">
                  <c:v>2.0047470668951002</c:v>
                </c:pt>
                <c:pt idx="860">
                  <c:v>1.8075924996036701</c:v>
                </c:pt>
                <c:pt idx="861">
                  <c:v>2.4435231907836599</c:v>
                </c:pt>
                <c:pt idx="862">
                  <c:v>2.1891982083195698</c:v>
                </c:pt>
                <c:pt idx="863">
                  <c:v>2.3792203894265098</c:v>
                </c:pt>
                <c:pt idx="864">
                  <c:v>1.9238024425992299</c:v>
                </c:pt>
                <c:pt idx="865">
                  <c:v>2.2386005069515602</c:v>
                </c:pt>
                <c:pt idx="866">
                  <c:v>1.66044653567698</c:v>
                </c:pt>
                <c:pt idx="867">
                  <c:v>1.83517029052453</c:v>
                </c:pt>
                <c:pt idx="868">
                  <c:v>1.9670055396430599</c:v>
                </c:pt>
                <c:pt idx="869">
                  <c:v>1.7723809616123001</c:v>
                </c:pt>
                <c:pt idx="870">
                  <c:v>1.6576581943089499</c:v>
                </c:pt>
                <c:pt idx="871">
                  <c:v>1.4271955551672699</c:v>
                </c:pt>
                <c:pt idx="872">
                  <c:v>2.0275184390003802</c:v>
                </c:pt>
                <c:pt idx="873">
                  <c:v>1.67721008705604</c:v>
                </c:pt>
                <c:pt idx="874">
                  <c:v>2.3492436392056399</c:v>
                </c:pt>
                <c:pt idx="875">
                  <c:v>2.1559014559781402</c:v>
                </c:pt>
                <c:pt idx="876">
                  <c:v>2.07134924240854</c:v>
                </c:pt>
                <c:pt idx="877">
                  <c:v>1.8378823741052599</c:v>
                </c:pt>
                <c:pt idx="878">
                  <c:v>2.42577231497437</c:v>
                </c:pt>
                <c:pt idx="879">
                  <c:v>1.9953458362633201</c:v>
                </c:pt>
                <c:pt idx="880">
                  <c:v>2.0946798800919701</c:v>
                </c:pt>
                <c:pt idx="881">
                  <c:v>2.28042034914712</c:v>
                </c:pt>
                <c:pt idx="882">
                  <c:v>2.1683211166577099</c:v>
                </c:pt>
                <c:pt idx="883">
                  <c:v>2.1201733957658</c:v>
                </c:pt>
                <c:pt idx="884">
                  <c:v>2.1082881212906601</c:v>
                </c:pt>
                <c:pt idx="885">
                  <c:v>2.4728948712830601</c:v>
                </c:pt>
                <c:pt idx="886">
                  <c:v>2.6286863026033598</c:v>
                </c:pt>
                <c:pt idx="887">
                  <c:v>2.2573593183607601</c:v>
                </c:pt>
                <c:pt idx="888">
                  <c:v>2.03471076914134</c:v>
                </c:pt>
                <c:pt idx="889">
                  <c:v>2.68804623152357</c:v>
                </c:pt>
                <c:pt idx="890">
                  <c:v>2.5689303658156102</c:v>
                </c:pt>
                <c:pt idx="891">
                  <c:v>2.2027129767101998</c:v>
                </c:pt>
                <c:pt idx="892">
                  <c:v>2.0970187142460102</c:v>
                </c:pt>
                <c:pt idx="893">
                  <c:v>2.3816940620177398</c:v>
                </c:pt>
                <c:pt idx="894">
                  <c:v>2.8264167358084702</c:v>
                </c:pt>
                <c:pt idx="895">
                  <c:v>2.7426822749603899</c:v>
                </c:pt>
                <c:pt idx="896">
                  <c:v>2.3631871043499499</c:v>
                </c:pt>
                <c:pt idx="897">
                  <c:v>2.14394649496003</c:v>
                </c:pt>
                <c:pt idx="898">
                  <c:v>2.69790593939386</c:v>
                </c:pt>
                <c:pt idx="899">
                  <c:v>2.8946843394330499</c:v>
                </c:pt>
                <c:pt idx="900">
                  <c:v>3.03079231274002</c:v>
                </c:pt>
                <c:pt idx="901">
                  <c:v>1.8413881264699401</c:v>
                </c:pt>
                <c:pt idx="902">
                  <c:v>2.8064240490868402</c:v>
                </c:pt>
                <c:pt idx="903">
                  <c:v>2.4327978179502101</c:v>
                </c:pt>
                <c:pt idx="904">
                  <c:v>2.7357165726135801</c:v>
                </c:pt>
                <c:pt idx="905">
                  <c:v>2.1524945340293198</c:v>
                </c:pt>
                <c:pt idx="906">
                  <c:v>2.24127653714201</c:v>
                </c:pt>
                <c:pt idx="907">
                  <c:v>2.5756065967038699</c:v>
                </c:pt>
                <c:pt idx="908">
                  <c:v>2.6323081288914398</c:v>
                </c:pt>
                <c:pt idx="909">
                  <c:v>2.6238695543396799</c:v>
                </c:pt>
                <c:pt idx="910">
                  <c:v>2.2633725228983299</c:v>
                </c:pt>
                <c:pt idx="911">
                  <c:v>2.4788906769792298</c:v>
                </c:pt>
                <c:pt idx="912">
                  <c:v>2.86567815631892</c:v>
                </c:pt>
                <c:pt idx="913">
                  <c:v>2.6863565202831001</c:v>
                </c:pt>
                <c:pt idx="914">
                  <c:v>1.7656954099729301</c:v>
                </c:pt>
                <c:pt idx="915">
                  <c:v>1.99216138494932</c:v>
                </c:pt>
                <c:pt idx="916">
                  <c:v>3.0389416063631698</c:v>
                </c:pt>
                <c:pt idx="917">
                  <c:v>2.68076843172951</c:v>
                </c:pt>
                <c:pt idx="918">
                  <c:v>2.6738119107595102</c:v>
                </c:pt>
                <c:pt idx="919">
                  <c:v>2.3768885180950399</c:v>
                </c:pt>
                <c:pt idx="920">
                  <c:v>2.7311028998338398</c:v>
                </c:pt>
                <c:pt idx="921">
                  <c:v>3.1473869115575499</c:v>
                </c:pt>
                <c:pt idx="922">
                  <c:v>2.6350777861385102</c:v>
                </c:pt>
                <c:pt idx="923">
                  <c:v>2.2817305967463599</c:v>
                </c:pt>
                <c:pt idx="924">
                  <c:v>3.1329738614283098</c:v>
                </c:pt>
                <c:pt idx="925">
                  <c:v>2.7751079263923502</c:v>
                </c:pt>
                <c:pt idx="926">
                  <c:v>2.7775774876991401</c:v>
                </c:pt>
                <c:pt idx="927">
                  <c:v>3.3619697732597902</c:v>
                </c:pt>
                <c:pt idx="928">
                  <c:v>2.6121189104929101</c:v>
                </c:pt>
                <c:pt idx="929">
                  <c:v>2.99585867135526</c:v>
                </c:pt>
                <c:pt idx="930">
                  <c:v>3.0241169657259301</c:v>
                </c:pt>
                <c:pt idx="931">
                  <c:v>2.2074435703128699</c:v>
                </c:pt>
                <c:pt idx="932">
                  <c:v>2.48698936366499</c:v>
                </c:pt>
                <c:pt idx="933">
                  <c:v>2.8289014814533799</c:v>
                </c:pt>
                <c:pt idx="934">
                  <c:v>2.5157919819828098</c:v>
                </c:pt>
                <c:pt idx="935">
                  <c:v>2.9694843759003899</c:v>
                </c:pt>
                <c:pt idx="936">
                  <c:v>2.5699623122494</c:v>
                </c:pt>
                <c:pt idx="937">
                  <c:v>2.6336017799356899</c:v>
                </c:pt>
                <c:pt idx="938">
                  <c:v>2.7783552164512</c:v>
                </c:pt>
                <c:pt idx="939">
                  <c:v>2.6747302087620199</c:v>
                </c:pt>
                <c:pt idx="940">
                  <c:v>3.2899553836245699</c:v>
                </c:pt>
                <c:pt idx="941">
                  <c:v>2.8101373870106698</c:v>
                </c:pt>
                <c:pt idx="942">
                  <c:v>2.8991379232902501</c:v>
                </c:pt>
                <c:pt idx="943">
                  <c:v>3.1867815740822198</c:v>
                </c:pt>
                <c:pt idx="944">
                  <c:v>3.00000339137322</c:v>
                </c:pt>
                <c:pt idx="945">
                  <c:v>3.4013533245696599</c:v>
                </c:pt>
                <c:pt idx="946">
                  <c:v>2.83305690827603</c:v>
                </c:pt>
                <c:pt idx="947">
                  <c:v>2.9793857403193398</c:v>
                </c:pt>
                <c:pt idx="948">
                  <c:v>2.8589336057982901</c:v>
                </c:pt>
                <c:pt idx="949">
                  <c:v>3.1708872592612498</c:v>
                </c:pt>
                <c:pt idx="950">
                  <c:v>2.8762407620779902</c:v>
                </c:pt>
                <c:pt idx="951">
                  <c:v>3.4537981572751102</c:v>
                </c:pt>
                <c:pt idx="952">
                  <c:v>3.4056567532303998</c:v>
                </c:pt>
                <c:pt idx="953">
                  <c:v>3.2410939137475698</c:v>
                </c:pt>
                <c:pt idx="954">
                  <c:v>3.3029339931663499</c:v>
                </c:pt>
                <c:pt idx="955">
                  <c:v>3.13143328567811</c:v>
                </c:pt>
                <c:pt idx="956">
                  <c:v>2.8799181998510601</c:v>
                </c:pt>
                <c:pt idx="957">
                  <c:v>3.7901188232352698</c:v>
                </c:pt>
                <c:pt idx="958">
                  <c:v>3.3104568551683098</c:v>
                </c:pt>
                <c:pt idx="959">
                  <c:v>2.8499179328733</c:v>
                </c:pt>
                <c:pt idx="960">
                  <c:v>3.1689769260828</c:v>
                </c:pt>
                <c:pt idx="961">
                  <c:v>2.63808184768182</c:v>
                </c:pt>
                <c:pt idx="962">
                  <c:v>3.1117137152536101</c:v>
                </c:pt>
                <c:pt idx="963">
                  <c:v>3.2734573954621502</c:v>
                </c:pt>
                <c:pt idx="964">
                  <c:v>2.8381987815214602</c:v>
                </c:pt>
                <c:pt idx="965">
                  <c:v>2.84922132539984</c:v>
                </c:pt>
                <c:pt idx="966">
                  <c:v>3.1476948297125</c:v>
                </c:pt>
                <c:pt idx="967">
                  <c:v>2.84451685395257</c:v>
                </c:pt>
                <c:pt idx="968">
                  <c:v>2.67217631666073</c:v>
                </c:pt>
                <c:pt idx="969">
                  <c:v>3.0033019511926602</c:v>
                </c:pt>
                <c:pt idx="970">
                  <c:v>2.36878600664713</c:v>
                </c:pt>
                <c:pt idx="971">
                  <c:v>2.8072254293601002</c:v>
                </c:pt>
                <c:pt idx="972">
                  <c:v>3.1574839769604899</c:v>
                </c:pt>
                <c:pt idx="973">
                  <c:v>2.6207863985758801</c:v>
                </c:pt>
                <c:pt idx="974">
                  <c:v>2.3756746761284901</c:v>
                </c:pt>
                <c:pt idx="975">
                  <c:v>2.4422265495270699</c:v>
                </c:pt>
                <c:pt idx="976">
                  <c:v>2.9507674257601901</c:v>
                </c:pt>
                <c:pt idx="977">
                  <c:v>2.4587740219805698</c:v>
                </c:pt>
                <c:pt idx="978">
                  <c:v>2.4363146444398001</c:v>
                </c:pt>
                <c:pt idx="979">
                  <c:v>2.5126985056992401</c:v>
                </c:pt>
                <c:pt idx="980">
                  <c:v>2.94185210356396</c:v>
                </c:pt>
                <c:pt idx="981">
                  <c:v>2.67762709053186</c:v>
                </c:pt>
                <c:pt idx="982">
                  <c:v>3.0433869868130601</c:v>
                </c:pt>
                <c:pt idx="983">
                  <c:v>2.4726996292058701</c:v>
                </c:pt>
                <c:pt idx="984">
                  <c:v>2.4142671850079598</c:v>
                </c:pt>
                <c:pt idx="985">
                  <c:v>2.3929200269109199</c:v>
                </c:pt>
                <c:pt idx="986">
                  <c:v>1.73419385503199</c:v>
                </c:pt>
                <c:pt idx="987">
                  <c:v>3.3089542169179902</c:v>
                </c:pt>
                <c:pt idx="988">
                  <c:v>2.23265021149134</c:v>
                </c:pt>
                <c:pt idx="989">
                  <c:v>2.1206332998821402</c:v>
                </c:pt>
                <c:pt idx="990">
                  <c:v>2.2758443645469302</c:v>
                </c:pt>
                <c:pt idx="991">
                  <c:v>2.4001675165942</c:v>
                </c:pt>
                <c:pt idx="992">
                  <c:v>2.3872841885894198</c:v>
                </c:pt>
                <c:pt idx="993">
                  <c:v>2.05572685855328</c:v>
                </c:pt>
                <c:pt idx="994">
                  <c:v>2.3192971038125401</c:v>
                </c:pt>
                <c:pt idx="995">
                  <c:v>2.0701027996828301</c:v>
                </c:pt>
                <c:pt idx="996">
                  <c:v>2.2168276460150902</c:v>
                </c:pt>
                <c:pt idx="997">
                  <c:v>1.71988398257615</c:v>
                </c:pt>
                <c:pt idx="998">
                  <c:v>2.2700052063112901</c:v>
                </c:pt>
                <c:pt idx="999">
                  <c:v>1.73591701114223</c:v>
                </c:pt>
                <c:pt idx="1000">
                  <c:v>1.99330580807762</c:v>
                </c:pt>
                <c:pt idx="1001">
                  <c:v>2.7026944518480098</c:v>
                </c:pt>
                <c:pt idx="1002">
                  <c:v>2.1926226312475001</c:v>
                </c:pt>
                <c:pt idx="1003">
                  <c:v>2.3582504550913601</c:v>
                </c:pt>
                <c:pt idx="1004">
                  <c:v>2.68829303053678</c:v>
                </c:pt>
                <c:pt idx="1005">
                  <c:v>2.7521352320925199</c:v>
                </c:pt>
                <c:pt idx="1006">
                  <c:v>2.23773948276928</c:v>
                </c:pt>
                <c:pt idx="1007">
                  <c:v>1.92815036699384</c:v>
                </c:pt>
                <c:pt idx="1008">
                  <c:v>2.4110528274316598</c:v>
                </c:pt>
                <c:pt idx="1009">
                  <c:v>2.22517850199758</c:v>
                </c:pt>
                <c:pt idx="1010">
                  <c:v>2.6193881754127499</c:v>
                </c:pt>
                <c:pt idx="1011">
                  <c:v>2.1140765701870499</c:v>
                </c:pt>
                <c:pt idx="1012">
                  <c:v>2.1060221174337501</c:v>
                </c:pt>
                <c:pt idx="1013">
                  <c:v>2.7373468558515199</c:v>
                </c:pt>
                <c:pt idx="1014">
                  <c:v>2.69427814993572</c:v>
                </c:pt>
                <c:pt idx="1015">
                  <c:v>2.9528407074840199</c:v>
                </c:pt>
                <c:pt idx="1016">
                  <c:v>2.2635784406448298</c:v>
                </c:pt>
                <c:pt idx="1017">
                  <c:v>2.8111909717716301</c:v>
                </c:pt>
                <c:pt idx="1018">
                  <c:v>3.0384651722113198</c:v>
                </c:pt>
                <c:pt idx="1019">
                  <c:v>2.68835858595425</c:v>
                </c:pt>
                <c:pt idx="1020">
                  <c:v>2.8252942562615502</c:v>
                </c:pt>
                <c:pt idx="1021">
                  <c:v>2.2322617722497098</c:v>
                </c:pt>
                <c:pt idx="1022">
                  <c:v>2.5134322714692301</c:v>
                </c:pt>
                <c:pt idx="1023">
                  <c:v>2.1267749454812899</c:v>
                </c:pt>
                <c:pt idx="1024">
                  <c:v>2.33267317834065</c:v>
                </c:pt>
                <c:pt idx="1025">
                  <c:v>2.3721222067348999</c:v>
                </c:pt>
                <c:pt idx="1026">
                  <c:v>2.6050953972047801</c:v>
                </c:pt>
                <c:pt idx="1027">
                  <c:v>2.8264221444623199</c:v>
                </c:pt>
                <c:pt idx="1028">
                  <c:v>2.13161007561974</c:v>
                </c:pt>
                <c:pt idx="1029">
                  <c:v>1.7246771498750999</c:v>
                </c:pt>
                <c:pt idx="1030">
                  <c:v>2.4648877679951502</c:v>
                </c:pt>
                <c:pt idx="1031">
                  <c:v>1.72514260639108</c:v>
                </c:pt>
                <c:pt idx="1032">
                  <c:v>2.1494219339824601</c:v>
                </c:pt>
                <c:pt idx="1033">
                  <c:v>2.7234269392202299</c:v>
                </c:pt>
                <c:pt idx="1034">
                  <c:v>2.91092847710769</c:v>
                </c:pt>
                <c:pt idx="1035">
                  <c:v>2.6578990108934701</c:v>
                </c:pt>
                <c:pt idx="1036">
                  <c:v>2.55330815715705</c:v>
                </c:pt>
                <c:pt idx="1037">
                  <c:v>2.8052621105290498</c:v>
                </c:pt>
                <c:pt idx="1038">
                  <c:v>3.1772666011777102</c:v>
                </c:pt>
                <c:pt idx="1039">
                  <c:v>2.7881796374042902</c:v>
                </c:pt>
                <c:pt idx="1040">
                  <c:v>2.7753438543818798</c:v>
                </c:pt>
                <c:pt idx="1041">
                  <c:v>1.9253759186810899</c:v>
                </c:pt>
                <c:pt idx="1042">
                  <c:v>2.70840240803942</c:v>
                </c:pt>
                <c:pt idx="1043">
                  <c:v>2.15881392705385</c:v>
                </c:pt>
                <c:pt idx="1044">
                  <c:v>2.3001108908672201</c:v>
                </c:pt>
                <c:pt idx="1045">
                  <c:v>1.96628338905975</c:v>
                </c:pt>
                <c:pt idx="1046">
                  <c:v>2.2722140431785798</c:v>
                </c:pt>
                <c:pt idx="1047">
                  <c:v>2.3737150263829001</c:v>
                </c:pt>
                <c:pt idx="1048">
                  <c:v>2.4342227670482002</c:v>
                </c:pt>
                <c:pt idx="1049">
                  <c:v>2.5139554048202499</c:v>
                </c:pt>
                <c:pt idx="1050">
                  <c:v>2.3881132853412801</c:v>
                </c:pt>
                <c:pt idx="1051">
                  <c:v>2.3168956901124198</c:v>
                </c:pt>
                <c:pt idx="1052">
                  <c:v>2.0306697331011798</c:v>
                </c:pt>
                <c:pt idx="1053">
                  <c:v>2.1395329903441498</c:v>
                </c:pt>
                <c:pt idx="1054">
                  <c:v>2.31939467706145</c:v>
                </c:pt>
                <c:pt idx="1055">
                  <c:v>1.9532825565545999</c:v>
                </c:pt>
                <c:pt idx="1056">
                  <c:v>1.7969791343742301</c:v>
                </c:pt>
                <c:pt idx="1057">
                  <c:v>3.0150366484528801</c:v>
                </c:pt>
                <c:pt idx="1058">
                  <c:v>1.8364174470451899</c:v>
                </c:pt>
                <c:pt idx="1059">
                  <c:v>1.9417522507773499</c:v>
                </c:pt>
                <c:pt idx="1060">
                  <c:v>1.8639470014386701</c:v>
                </c:pt>
                <c:pt idx="1061">
                  <c:v>1.8783522636982799</c:v>
                </c:pt>
                <c:pt idx="1062">
                  <c:v>2.0895576794953401</c:v>
                </c:pt>
                <c:pt idx="1063">
                  <c:v>2.2458119720317602</c:v>
                </c:pt>
                <c:pt idx="1064">
                  <c:v>1.8963218863112099</c:v>
                </c:pt>
                <c:pt idx="1065">
                  <c:v>2.41447062336082</c:v>
                </c:pt>
                <c:pt idx="1066">
                  <c:v>1.9059795439642</c:v>
                </c:pt>
                <c:pt idx="1067">
                  <c:v>2.59636777160337</c:v>
                </c:pt>
                <c:pt idx="1068">
                  <c:v>2.34086068778617</c:v>
                </c:pt>
                <c:pt idx="1069">
                  <c:v>1.7390835545146699</c:v>
                </c:pt>
                <c:pt idx="1070">
                  <c:v>1.7761630428748001</c:v>
                </c:pt>
                <c:pt idx="1071">
                  <c:v>1.87574155801844</c:v>
                </c:pt>
                <c:pt idx="1072">
                  <c:v>2.1402320606615799</c:v>
                </c:pt>
                <c:pt idx="1073">
                  <c:v>2.1821938813670601</c:v>
                </c:pt>
                <c:pt idx="1074">
                  <c:v>1.77713503827363</c:v>
                </c:pt>
                <c:pt idx="1075">
                  <c:v>1.69210399163923</c:v>
                </c:pt>
                <c:pt idx="1076">
                  <c:v>1.4218919975461299</c:v>
                </c:pt>
                <c:pt idx="1077">
                  <c:v>1.6448626174171701</c:v>
                </c:pt>
                <c:pt idx="1078">
                  <c:v>2.0174635040554998</c:v>
                </c:pt>
                <c:pt idx="1079">
                  <c:v>1.64154539647913</c:v>
                </c:pt>
                <c:pt idx="1080">
                  <c:v>2.25381865738844</c:v>
                </c:pt>
                <c:pt idx="1081">
                  <c:v>1.1446822529528999</c:v>
                </c:pt>
                <c:pt idx="1082">
                  <c:v>2.0215510137015502</c:v>
                </c:pt>
                <c:pt idx="1083">
                  <c:v>1.8316619112290999</c:v>
                </c:pt>
                <c:pt idx="1084">
                  <c:v>1.86098558462957</c:v>
                </c:pt>
                <c:pt idx="1085">
                  <c:v>1.4934088820181599</c:v>
                </c:pt>
                <c:pt idx="1086">
                  <c:v>1.99556128337644</c:v>
                </c:pt>
                <c:pt idx="1087">
                  <c:v>2.0436053498830899</c:v>
                </c:pt>
                <c:pt idx="1088">
                  <c:v>1.9844352183305101</c:v>
                </c:pt>
                <c:pt idx="1089">
                  <c:v>1.6586333565442799</c:v>
                </c:pt>
                <c:pt idx="1090">
                  <c:v>2.1386887788389601</c:v>
                </c:pt>
                <c:pt idx="1091">
                  <c:v>2.0300912295157998</c:v>
                </c:pt>
                <c:pt idx="1092">
                  <c:v>1.7140754053254501</c:v>
                </c:pt>
                <c:pt idx="1093">
                  <c:v>1.7658636826726499</c:v>
                </c:pt>
                <c:pt idx="1094">
                  <c:v>2.1265892037774798</c:v>
                </c:pt>
                <c:pt idx="1095">
                  <c:v>1.7579500701508499</c:v>
                </c:pt>
                <c:pt idx="1096">
                  <c:v>0.99305440801015199</c:v>
                </c:pt>
                <c:pt idx="1097">
                  <c:v>1.6262888532609301</c:v>
                </c:pt>
                <c:pt idx="1098">
                  <c:v>1.5608072714239101</c:v>
                </c:pt>
                <c:pt idx="1099">
                  <c:v>1.4090801627440801</c:v>
                </c:pt>
                <c:pt idx="1100">
                  <c:v>2.1118312891615001</c:v>
                </c:pt>
                <c:pt idx="1101">
                  <c:v>2.4694149003968402</c:v>
                </c:pt>
                <c:pt idx="1102">
                  <c:v>2.8059344590727502</c:v>
                </c:pt>
                <c:pt idx="1103">
                  <c:v>1.98370438736106</c:v>
                </c:pt>
                <c:pt idx="1104">
                  <c:v>1.81931876528224</c:v>
                </c:pt>
                <c:pt idx="1105">
                  <c:v>1.96258591510225</c:v>
                </c:pt>
                <c:pt idx="1106">
                  <c:v>2.1934839648648499</c:v>
                </c:pt>
                <c:pt idx="1107">
                  <c:v>1.9301931752102399</c:v>
                </c:pt>
                <c:pt idx="1108">
                  <c:v>1.51394557984631</c:v>
                </c:pt>
                <c:pt idx="1109">
                  <c:v>1.9125062193341</c:v>
                </c:pt>
                <c:pt idx="1110">
                  <c:v>1.43053694173941</c:v>
                </c:pt>
                <c:pt idx="1111">
                  <c:v>0.98045822780496505</c:v>
                </c:pt>
                <c:pt idx="1112">
                  <c:v>1.35164048861939</c:v>
                </c:pt>
                <c:pt idx="1113">
                  <c:v>1.4851803704937401</c:v>
                </c:pt>
                <c:pt idx="1114">
                  <c:v>1.8406619659999801</c:v>
                </c:pt>
                <c:pt idx="1115">
                  <c:v>1.2925930680857001</c:v>
                </c:pt>
                <c:pt idx="1116">
                  <c:v>0.79722792479931004</c:v>
                </c:pt>
                <c:pt idx="1117">
                  <c:v>1.6917777342132101</c:v>
                </c:pt>
                <c:pt idx="1118">
                  <c:v>1.7218458849324101</c:v>
                </c:pt>
                <c:pt idx="1119">
                  <c:v>1.8831921750369101</c:v>
                </c:pt>
                <c:pt idx="1120">
                  <c:v>2.12714063306646</c:v>
                </c:pt>
                <c:pt idx="1121">
                  <c:v>1.82358090525224</c:v>
                </c:pt>
                <c:pt idx="1122">
                  <c:v>2.3099217035389499</c:v>
                </c:pt>
                <c:pt idx="1123">
                  <c:v>1.98243583700157</c:v>
                </c:pt>
                <c:pt idx="1124">
                  <c:v>2.16288442763208</c:v>
                </c:pt>
                <c:pt idx="1125">
                  <c:v>2.2923463126413002</c:v>
                </c:pt>
                <c:pt idx="1126">
                  <c:v>2.4007900171735401</c:v>
                </c:pt>
                <c:pt idx="1127">
                  <c:v>2.0850062335072201</c:v>
                </c:pt>
                <c:pt idx="1128">
                  <c:v>1.91998521115612</c:v>
                </c:pt>
                <c:pt idx="1129">
                  <c:v>1.8530638664930299</c:v>
                </c:pt>
                <c:pt idx="1130">
                  <c:v>2.3871027901519599</c:v>
                </c:pt>
                <c:pt idx="1131">
                  <c:v>2.3246583253638402</c:v>
                </c:pt>
                <c:pt idx="1132">
                  <c:v>2.2217293596363499</c:v>
                </c:pt>
                <c:pt idx="1133">
                  <c:v>1.9252747410682101</c:v>
                </c:pt>
                <c:pt idx="1134">
                  <c:v>2.1748963211713601</c:v>
                </c:pt>
                <c:pt idx="1135">
                  <c:v>2.4271309522333402</c:v>
                </c:pt>
                <c:pt idx="1136">
                  <c:v>2.1244584507786399</c:v>
                </c:pt>
                <c:pt idx="1137">
                  <c:v>2.3369473052285099</c:v>
                </c:pt>
                <c:pt idx="1138">
                  <c:v>2.4449819571029998</c:v>
                </c:pt>
                <c:pt idx="1139">
                  <c:v>2.3347598761613502</c:v>
                </c:pt>
                <c:pt idx="1140">
                  <c:v>1.9347368132265601</c:v>
                </c:pt>
                <c:pt idx="1141">
                  <c:v>2.2985725748852501</c:v>
                </c:pt>
                <c:pt idx="1142">
                  <c:v>2.34605308673589</c:v>
                </c:pt>
                <c:pt idx="1143">
                  <c:v>2.4582329236016101</c:v>
                </c:pt>
                <c:pt idx="1144">
                  <c:v>2.0081893685697398</c:v>
                </c:pt>
                <c:pt idx="1145">
                  <c:v>2.4682595072672</c:v>
                </c:pt>
                <c:pt idx="1146">
                  <c:v>2.1111768963399502</c:v>
                </c:pt>
                <c:pt idx="1147">
                  <c:v>2.2427556717711101</c:v>
                </c:pt>
                <c:pt idx="1148">
                  <c:v>2.2525026370215402</c:v>
                </c:pt>
                <c:pt idx="1149">
                  <c:v>2.4573431029046899</c:v>
                </c:pt>
                <c:pt idx="1150">
                  <c:v>2.24923792150895</c:v>
                </c:pt>
                <c:pt idx="1151">
                  <c:v>2.32636528489168</c:v>
                </c:pt>
                <c:pt idx="1152">
                  <c:v>2.3984505270443202</c:v>
                </c:pt>
                <c:pt idx="1153">
                  <c:v>1.9263253193925001</c:v>
                </c:pt>
                <c:pt idx="1154">
                  <c:v>1.53430560440681</c:v>
                </c:pt>
                <c:pt idx="1155">
                  <c:v>2.2200239580471299</c:v>
                </c:pt>
                <c:pt idx="1156">
                  <c:v>1.9604715193293001</c:v>
                </c:pt>
                <c:pt idx="1157">
                  <c:v>1.9894310083687601</c:v>
                </c:pt>
                <c:pt idx="1158">
                  <c:v>1.77565415727219</c:v>
                </c:pt>
                <c:pt idx="1159">
                  <c:v>2.1424816961527502</c:v>
                </c:pt>
                <c:pt idx="1160">
                  <c:v>2.3271277899243699</c:v>
                </c:pt>
                <c:pt idx="1161">
                  <c:v>2.1389510137127998</c:v>
                </c:pt>
                <c:pt idx="1162">
                  <c:v>2.4298911865271902</c:v>
                </c:pt>
                <c:pt idx="1163">
                  <c:v>1.97302285339395</c:v>
                </c:pt>
                <c:pt idx="1164">
                  <c:v>2.02134580752689</c:v>
                </c:pt>
                <c:pt idx="1165">
                  <c:v>2.0606486113638298</c:v>
                </c:pt>
                <c:pt idx="1166">
                  <c:v>1.89706523611941</c:v>
                </c:pt>
                <c:pt idx="1167">
                  <c:v>1.8838202687638199</c:v>
                </c:pt>
                <c:pt idx="1168">
                  <c:v>2.2515494938489899</c:v>
                </c:pt>
                <c:pt idx="1169">
                  <c:v>2.2897911259704098</c:v>
                </c:pt>
                <c:pt idx="1170">
                  <c:v>2.5375286827754202</c:v>
                </c:pt>
                <c:pt idx="1171">
                  <c:v>2.2760325944614102</c:v>
                </c:pt>
                <c:pt idx="1172">
                  <c:v>2.2236500215097701</c:v>
                </c:pt>
                <c:pt idx="1173">
                  <c:v>2.5820747627926601</c:v>
                </c:pt>
                <c:pt idx="1174">
                  <c:v>2.3475105834989498</c:v>
                </c:pt>
                <c:pt idx="1175">
                  <c:v>1.6826914612391399</c:v>
                </c:pt>
                <c:pt idx="1176">
                  <c:v>2.9729318593135998</c:v>
                </c:pt>
                <c:pt idx="1177">
                  <c:v>2.1387520605605501</c:v>
                </c:pt>
                <c:pt idx="1178">
                  <c:v>1.78975996044513</c:v>
                </c:pt>
                <c:pt idx="1179">
                  <c:v>1.93187634663051</c:v>
                </c:pt>
                <c:pt idx="1180">
                  <c:v>1.68067078875899</c:v>
                </c:pt>
                <c:pt idx="1181">
                  <c:v>1.9808794382082</c:v>
                </c:pt>
                <c:pt idx="1182">
                  <c:v>2.5835387813742101</c:v>
                </c:pt>
                <c:pt idx="1183">
                  <c:v>2.1536115934133799</c:v>
                </c:pt>
                <c:pt idx="1184">
                  <c:v>2.1007587016831999</c:v>
                </c:pt>
                <c:pt idx="1185">
                  <c:v>1.74259999979152</c:v>
                </c:pt>
                <c:pt idx="1186">
                  <c:v>2.0585049771550099</c:v>
                </c:pt>
                <c:pt idx="1187">
                  <c:v>1.9369350091890001</c:v>
                </c:pt>
                <c:pt idx="1188">
                  <c:v>2.0956891896733199</c:v>
                </c:pt>
                <c:pt idx="1189">
                  <c:v>2.5406529234692101</c:v>
                </c:pt>
                <c:pt idx="1190">
                  <c:v>1.9133925583767999</c:v>
                </c:pt>
                <c:pt idx="1191">
                  <c:v>2.2300131467597399</c:v>
                </c:pt>
                <c:pt idx="1192">
                  <c:v>2.49122653942932</c:v>
                </c:pt>
                <c:pt idx="1193">
                  <c:v>2.1169220735449898</c:v>
                </c:pt>
                <c:pt idx="1194">
                  <c:v>2.4450403027099799</c:v>
                </c:pt>
                <c:pt idx="1195">
                  <c:v>1.93615928744248</c:v>
                </c:pt>
                <c:pt idx="1196">
                  <c:v>2.5233363797190198</c:v>
                </c:pt>
                <c:pt idx="1197">
                  <c:v>2.2344869630701201</c:v>
                </c:pt>
                <c:pt idx="1198">
                  <c:v>2.43330201259807</c:v>
                </c:pt>
                <c:pt idx="1199">
                  <c:v>2.6341256869581802</c:v>
                </c:pt>
                <c:pt idx="1200">
                  <c:v>2.2996493619396099</c:v>
                </c:pt>
                <c:pt idx="1201">
                  <c:v>2.9001827296895999</c:v>
                </c:pt>
                <c:pt idx="1202">
                  <c:v>2.6607322621741401</c:v>
                </c:pt>
                <c:pt idx="1203">
                  <c:v>2.7762730062321501</c:v>
                </c:pt>
                <c:pt idx="1204">
                  <c:v>2.80085889292197</c:v>
                </c:pt>
                <c:pt idx="1205">
                  <c:v>3.23115896896359</c:v>
                </c:pt>
                <c:pt idx="1206">
                  <c:v>2.6433901962457602</c:v>
                </c:pt>
                <c:pt idx="1207">
                  <c:v>2.5503238554026799</c:v>
                </c:pt>
                <c:pt idx="1208">
                  <c:v>2.4038684209992698</c:v>
                </c:pt>
                <c:pt idx="1209">
                  <c:v>2.19365579826035</c:v>
                </c:pt>
                <c:pt idx="1210">
                  <c:v>2.6728487308210802</c:v>
                </c:pt>
                <c:pt idx="1211">
                  <c:v>2.44837603321773</c:v>
                </c:pt>
                <c:pt idx="1212">
                  <c:v>2.4648155608537001</c:v>
                </c:pt>
                <c:pt idx="1213">
                  <c:v>3.3403404736751501</c:v>
                </c:pt>
                <c:pt idx="1214">
                  <c:v>2.6806729862365701</c:v>
                </c:pt>
                <c:pt idx="1215">
                  <c:v>2.1333849413121602</c:v>
                </c:pt>
                <c:pt idx="1216">
                  <c:v>2.9314481084675101</c:v>
                </c:pt>
                <c:pt idx="1217">
                  <c:v>2.3584600465578598</c:v>
                </c:pt>
                <c:pt idx="1218">
                  <c:v>2.4205363464777001</c:v>
                </c:pt>
                <c:pt idx="1219">
                  <c:v>2.3509118859170899</c:v>
                </c:pt>
                <c:pt idx="1220">
                  <c:v>1.9794921628578499</c:v>
                </c:pt>
                <c:pt idx="1221">
                  <c:v>2.1520999570076702</c:v>
                </c:pt>
                <c:pt idx="1222">
                  <c:v>1.79636387372368</c:v>
                </c:pt>
                <c:pt idx="1223">
                  <c:v>2.15723362741817</c:v>
                </c:pt>
                <c:pt idx="1224">
                  <c:v>2.0660434638823899</c:v>
                </c:pt>
                <c:pt idx="1225">
                  <c:v>2.5458855302678498</c:v>
                </c:pt>
                <c:pt idx="1226">
                  <c:v>2.2424812711398801</c:v>
                </c:pt>
                <c:pt idx="1227">
                  <c:v>1.75257834163756</c:v>
                </c:pt>
                <c:pt idx="1228">
                  <c:v>1.80400411403144</c:v>
                </c:pt>
                <c:pt idx="1229">
                  <c:v>1.99779299686463</c:v>
                </c:pt>
                <c:pt idx="1230">
                  <c:v>2.5136672052930198</c:v>
                </c:pt>
                <c:pt idx="1231">
                  <c:v>1.86794532601009</c:v>
                </c:pt>
                <c:pt idx="1232">
                  <c:v>2.12788242766125</c:v>
                </c:pt>
                <c:pt idx="1233">
                  <c:v>2.4056167737376399</c:v>
                </c:pt>
                <c:pt idx="1234">
                  <c:v>2.8405683397880401</c:v>
                </c:pt>
                <c:pt idx="1235">
                  <c:v>2.51082041742053</c:v>
                </c:pt>
                <c:pt idx="1236">
                  <c:v>1.91281279440938</c:v>
                </c:pt>
                <c:pt idx="1237">
                  <c:v>1.8384522551270599</c:v>
                </c:pt>
                <c:pt idx="1238">
                  <c:v>2.1134410389506999</c:v>
                </c:pt>
                <c:pt idx="1239">
                  <c:v>1.9595518986687499</c:v>
                </c:pt>
                <c:pt idx="1240">
                  <c:v>2.3973071695888102</c:v>
                </c:pt>
                <c:pt idx="1241">
                  <c:v>2.4721777675135499</c:v>
                </c:pt>
                <c:pt idx="1242">
                  <c:v>2.0891253567283501</c:v>
                </c:pt>
                <c:pt idx="1243">
                  <c:v>2.3460415850010898</c:v>
                </c:pt>
                <c:pt idx="1244">
                  <c:v>2.6971000349409402</c:v>
                </c:pt>
                <c:pt idx="1245">
                  <c:v>2.6366319880625499</c:v>
                </c:pt>
                <c:pt idx="1246">
                  <c:v>2.1719040857491301</c:v>
                </c:pt>
                <c:pt idx="1247">
                  <c:v>1.71817345369055</c:v>
                </c:pt>
                <c:pt idx="1248">
                  <c:v>1.9392745007976999</c:v>
                </c:pt>
                <c:pt idx="1249">
                  <c:v>2.39139708574585</c:v>
                </c:pt>
                <c:pt idx="1250">
                  <c:v>3.17656833878008</c:v>
                </c:pt>
                <c:pt idx="1251">
                  <c:v>3.19900095851873</c:v>
                </c:pt>
                <c:pt idx="1252">
                  <c:v>2.3930631640934101</c:v>
                </c:pt>
                <c:pt idx="1253">
                  <c:v>2.5926466733697602</c:v>
                </c:pt>
                <c:pt idx="1254">
                  <c:v>2.73758573219291</c:v>
                </c:pt>
                <c:pt idx="1255">
                  <c:v>2.6699074083972199</c:v>
                </c:pt>
                <c:pt idx="1256">
                  <c:v>2.8119796332182201</c:v>
                </c:pt>
                <c:pt idx="1257">
                  <c:v>2.5681578561697198</c:v>
                </c:pt>
                <c:pt idx="1258">
                  <c:v>1.96533500550147</c:v>
                </c:pt>
                <c:pt idx="1259">
                  <c:v>1.9148623110529099</c:v>
                </c:pt>
                <c:pt idx="1260">
                  <c:v>1.95179374257868</c:v>
                </c:pt>
                <c:pt idx="1261">
                  <c:v>2.1610311892501599</c:v>
                </c:pt>
                <c:pt idx="1262">
                  <c:v>2.3380386087346499</c:v>
                </c:pt>
                <c:pt idx="1263">
                  <c:v>2.45225708513449</c:v>
                </c:pt>
                <c:pt idx="1264">
                  <c:v>1.5761520409076499</c:v>
                </c:pt>
                <c:pt idx="1265">
                  <c:v>2.7787738735180398</c:v>
                </c:pt>
                <c:pt idx="1266">
                  <c:v>2.3490165574877899</c:v>
                </c:pt>
                <c:pt idx="1267">
                  <c:v>2.6213587339601299</c:v>
                </c:pt>
                <c:pt idx="1268">
                  <c:v>2.2950007874362002</c:v>
                </c:pt>
                <c:pt idx="1269">
                  <c:v>2.0769288916694402</c:v>
                </c:pt>
                <c:pt idx="1270">
                  <c:v>2.4668075149940001</c:v>
                </c:pt>
                <c:pt idx="1271">
                  <c:v>2.7998989277466602</c:v>
                </c:pt>
                <c:pt idx="1272">
                  <c:v>2.6466243893448</c:v>
                </c:pt>
                <c:pt idx="1273">
                  <c:v>2.7888540324450202</c:v>
                </c:pt>
                <c:pt idx="1274">
                  <c:v>3.0827957589757999</c:v>
                </c:pt>
                <c:pt idx="1275">
                  <c:v>2.8427841034169998</c:v>
                </c:pt>
                <c:pt idx="1276">
                  <c:v>2.7655385376268602</c:v>
                </c:pt>
                <c:pt idx="1277">
                  <c:v>2.5046461459520901</c:v>
                </c:pt>
                <c:pt idx="1278">
                  <c:v>3.3633653864534399</c:v>
                </c:pt>
                <c:pt idx="1279">
                  <c:v>3.0375869844843</c:v>
                </c:pt>
                <c:pt idx="1280">
                  <c:v>2.74997147336008</c:v>
                </c:pt>
                <c:pt idx="1281">
                  <c:v>2.5828739029774201</c:v>
                </c:pt>
                <c:pt idx="1282">
                  <c:v>2.9215099297792699</c:v>
                </c:pt>
                <c:pt idx="1283">
                  <c:v>2.76221675073749</c:v>
                </c:pt>
                <c:pt idx="1284">
                  <c:v>2.6962414114210702</c:v>
                </c:pt>
                <c:pt idx="1285">
                  <c:v>2.6368371990255399</c:v>
                </c:pt>
                <c:pt idx="1286">
                  <c:v>2.5435810727793999</c:v>
                </c:pt>
                <c:pt idx="1287">
                  <c:v>2.7931144526589602</c:v>
                </c:pt>
                <c:pt idx="1288">
                  <c:v>2.04082526909297</c:v>
                </c:pt>
                <c:pt idx="1289">
                  <c:v>2.7997389973894999</c:v>
                </c:pt>
                <c:pt idx="1290">
                  <c:v>2.1237268723062699</c:v>
                </c:pt>
                <c:pt idx="1291">
                  <c:v>2.7620538510132402</c:v>
                </c:pt>
                <c:pt idx="1292">
                  <c:v>2.4850549156500801</c:v>
                </c:pt>
                <c:pt idx="1293">
                  <c:v>2.83176117328239</c:v>
                </c:pt>
                <c:pt idx="1294">
                  <c:v>2.81368200565952</c:v>
                </c:pt>
                <c:pt idx="1295">
                  <c:v>2.60502137749683</c:v>
                </c:pt>
                <c:pt idx="1296">
                  <c:v>2.4877604067447998</c:v>
                </c:pt>
                <c:pt idx="1297">
                  <c:v>2.96936387715748</c:v>
                </c:pt>
                <c:pt idx="1298">
                  <c:v>2.2428596143105</c:v>
                </c:pt>
                <c:pt idx="1299">
                  <c:v>2.6097528684003</c:v>
                </c:pt>
                <c:pt idx="1300">
                  <c:v>2.3938269445253701</c:v>
                </c:pt>
                <c:pt idx="1301">
                  <c:v>2.4626891089654701</c:v>
                </c:pt>
                <c:pt idx="1302">
                  <c:v>2.4469176095027598</c:v>
                </c:pt>
                <c:pt idx="1303">
                  <c:v>2.94761038315358</c:v>
                </c:pt>
                <c:pt idx="1304">
                  <c:v>2.8131950917915098</c:v>
                </c:pt>
                <c:pt idx="1305">
                  <c:v>2.6779864284835</c:v>
                </c:pt>
                <c:pt idx="1306">
                  <c:v>3.0119100303595898</c:v>
                </c:pt>
                <c:pt idx="1307">
                  <c:v>2.5106168576994401</c:v>
                </c:pt>
                <c:pt idx="1308">
                  <c:v>2.59730435454258</c:v>
                </c:pt>
                <c:pt idx="1309">
                  <c:v>2.8010673957265699</c:v>
                </c:pt>
                <c:pt idx="1310">
                  <c:v>2.81609522665322</c:v>
                </c:pt>
                <c:pt idx="1311">
                  <c:v>2.9728812861358702</c:v>
                </c:pt>
                <c:pt idx="1312">
                  <c:v>2.8664585399517701</c:v>
                </c:pt>
                <c:pt idx="1313">
                  <c:v>2.6652497162730602</c:v>
                </c:pt>
                <c:pt idx="1314">
                  <c:v>2.7416991044538102</c:v>
                </c:pt>
                <c:pt idx="1315">
                  <c:v>2.9140220312394498</c:v>
                </c:pt>
                <c:pt idx="1316">
                  <c:v>2.9971523073747899</c:v>
                </c:pt>
                <c:pt idx="1317">
                  <c:v>3.0243914305413502</c:v>
                </c:pt>
                <c:pt idx="1318">
                  <c:v>3.00690296133115</c:v>
                </c:pt>
                <c:pt idx="1319">
                  <c:v>2.77686404671786</c:v>
                </c:pt>
                <c:pt idx="1320">
                  <c:v>2.8874468452271902</c:v>
                </c:pt>
                <c:pt idx="1321">
                  <c:v>3.0013393439734601</c:v>
                </c:pt>
                <c:pt idx="1322">
                  <c:v>3.1421723248838398</c:v>
                </c:pt>
                <c:pt idx="1323">
                  <c:v>2.6889783984371398</c:v>
                </c:pt>
                <c:pt idx="1324">
                  <c:v>2.7642657894858398</c:v>
                </c:pt>
                <c:pt idx="1325">
                  <c:v>2.4723635412184999</c:v>
                </c:pt>
                <c:pt idx="1326">
                  <c:v>2.6382638268890299</c:v>
                </c:pt>
                <c:pt idx="1327">
                  <c:v>2.6544823581591301</c:v>
                </c:pt>
                <c:pt idx="1328">
                  <c:v>2.5622478650154501</c:v>
                </c:pt>
                <c:pt idx="1329">
                  <c:v>2.7214989836297998</c:v>
                </c:pt>
                <c:pt idx="1330">
                  <c:v>2.65293829127349</c:v>
                </c:pt>
                <c:pt idx="1331">
                  <c:v>2.6859335607944899</c:v>
                </c:pt>
                <c:pt idx="1332">
                  <c:v>3.0450343198040701</c:v>
                </c:pt>
                <c:pt idx="1333">
                  <c:v>2.65391234020588</c:v>
                </c:pt>
                <c:pt idx="1334">
                  <c:v>2.7473598305788398</c:v>
                </c:pt>
                <c:pt idx="1335">
                  <c:v>2.63196415143809</c:v>
                </c:pt>
                <c:pt idx="1336">
                  <c:v>2.4008466424369099</c:v>
                </c:pt>
                <c:pt idx="1337">
                  <c:v>2.72960985992112</c:v>
                </c:pt>
                <c:pt idx="1338">
                  <c:v>2.9188773210812902</c:v>
                </c:pt>
                <c:pt idx="1339">
                  <c:v>2.13731296084736</c:v>
                </c:pt>
                <c:pt idx="1340">
                  <c:v>2.3092838578799002</c:v>
                </c:pt>
                <c:pt idx="1341">
                  <c:v>2.5215267610241501</c:v>
                </c:pt>
                <c:pt idx="1342">
                  <c:v>2.3074935054355499</c:v>
                </c:pt>
                <c:pt idx="1343">
                  <c:v>2.39785517654258</c:v>
                </c:pt>
                <c:pt idx="1344">
                  <c:v>2.9576758035783701</c:v>
                </c:pt>
                <c:pt idx="1345">
                  <c:v>2.49863750150916</c:v>
                </c:pt>
                <c:pt idx="1346">
                  <c:v>2.55614911196886</c:v>
                </c:pt>
                <c:pt idx="1347">
                  <c:v>2.0114018305647798</c:v>
                </c:pt>
                <c:pt idx="1348">
                  <c:v>3.0933255055381701</c:v>
                </c:pt>
                <c:pt idx="1349">
                  <c:v>3.2841864876253299</c:v>
                </c:pt>
                <c:pt idx="1350">
                  <c:v>3.0032225267769199</c:v>
                </c:pt>
                <c:pt idx="1351">
                  <c:v>2.4058584482491101</c:v>
                </c:pt>
                <c:pt idx="1352">
                  <c:v>2.4882336100819402</c:v>
                </c:pt>
                <c:pt idx="1353">
                  <c:v>2.7173437623896399</c:v>
                </c:pt>
                <c:pt idx="1354">
                  <c:v>2.3181006503177</c:v>
                </c:pt>
                <c:pt idx="1355">
                  <c:v>3.1616933859729901</c:v>
                </c:pt>
                <c:pt idx="1356">
                  <c:v>2.5621948034877802</c:v>
                </c:pt>
                <c:pt idx="1357">
                  <c:v>2.1685791906928999</c:v>
                </c:pt>
                <c:pt idx="1358">
                  <c:v>2.4620820611437999</c:v>
                </c:pt>
                <c:pt idx="1359">
                  <c:v>2.6741099507495401</c:v>
                </c:pt>
                <c:pt idx="1360">
                  <c:v>2.9375925366464801</c:v>
                </c:pt>
                <c:pt idx="1361">
                  <c:v>2.8970048153104599</c:v>
                </c:pt>
                <c:pt idx="1362">
                  <c:v>2.9019391317327199</c:v>
                </c:pt>
                <c:pt idx="1363">
                  <c:v>3.0576836839908599</c:v>
                </c:pt>
                <c:pt idx="1364">
                  <c:v>2.73278094471579</c:v>
                </c:pt>
                <c:pt idx="1365">
                  <c:v>3.14351301044305</c:v>
                </c:pt>
                <c:pt idx="1366">
                  <c:v>2.8738407868693501</c:v>
                </c:pt>
                <c:pt idx="1367">
                  <c:v>3.0560207719886301</c:v>
                </c:pt>
                <c:pt idx="1368">
                  <c:v>2.9693578685120601</c:v>
                </c:pt>
                <c:pt idx="1369">
                  <c:v>3.15081604222671</c:v>
                </c:pt>
                <c:pt idx="1370">
                  <c:v>2.9839653128064199</c:v>
                </c:pt>
                <c:pt idx="1371">
                  <c:v>3.4508034223984398</c:v>
                </c:pt>
                <c:pt idx="1372">
                  <c:v>3.25102855914351</c:v>
                </c:pt>
                <c:pt idx="1373">
                  <c:v>3.6098947068581801</c:v>
                </c:pt>
                <c:pt idx="1374">
                  <c:v>3.8132791243252</c:v>
                </c:pt>
                <c:pt idx="1375">
                  <c:v>3.4167004784576198</c:v>
                </c:pt>
                <c:pt idx="1376">
                  <c:v>3.7278919807626698</c:v>
                </c:pt>
                <c:pt idx="1377">
                  <c:v>2.7387357112608801</c:v>
                </c:pt>
                <c:pt idx="1378">
                  <c:v>3.8138061420048999</c:v>
                </c:pt>
                <c:pt idx="1379">
                  <c:v>3.5271174313418401</c:v>
                </c:pt>
                <c:pt idx="1380">
                  <c:v>3.0328922782447698</c:v>
                </c:pt>
                <c:pt idx="1381">
                  <c:v>2.9182429133726302</c:v>
                </c:pt>
                <c:pt idx="1382">
                  <c:v>3.7044029560631699</c:v>
                </c:pt>
                <c:pt idx="1383">
                  <c:v>3.8796640467039101</c:v>
                </c:pt>
                <c:pt idx="1384">
                  <c:v>3.9344927228658899</c:v>
                </c:pt>
                <c:pt idx="1385">
                  <c:v>3.7930111889761302</c:v>
                </c:pt>
                <c:pt idx="1386">
                  <c:v>3.5617567389281</c:v>
                </c:pt>
                <c:pt idx="1387">
                  <c:v>3.5423053761727799</c:v>
                </c:pt>
                <c:pt idx="1388">
                  <c:v>3.48559933673583</c:v>
                </c:pt>
                <c:pt idx="1389">
                  <c:v>3.41710411544544</c:v>
                </c:pt>
                <c:pt idx="1390">
                  <c:v>3.69632771804317</c:v>
                </c:pt>
                <c:pt idx="1391">
                  <c:v>3.42651579980086</c:v>
                </c:pt>
                <c:pt idx="1392">
                  <c:v>3.9215561346835401</c:v>
                </c:pt>
                <c:pt idx="1393">
                  <c:v>3.7328537883331698</c:v>
                </c:pt>
                <c:pt idx="1394">
                  <c:v>3.4223981026671102</c:v>
                </c:pt>
                <c:pt idx="1395">
                  <c:v>4.18362300070718</c:v>
                </c:pt>
                <c:pt idx="1396">
                  <c:v>3.3910255890865701</c:v>
                </c:pt>
                <c:pt idx="1397">
                  <c:v>3.4155640568929302</c:v>
                </c:pt>
                <c:pt idx="1398">
                  <c:v>3.7569933794065</c:v>
                </c:pt>
                <c:pt idx="1399">
                  <c:v>3.6873593281694399</c:v>
                </c:pt>
                <c:pt idx="1400">
                  <c:v>4.16437906384024</c:v>
                </c:pt>
                <c:pt idx="1401">
                  <c:v>3.6187557000108002</c:v>
                </c:pt>
                <c:pt idx="1402">
                  <c:v>3.4444845341074601</c:v>
                </c:pt>
                <c:pt idx="1403">
                  <c:v>2.8225820259687402</c:v>
                </c:pt>
                <c:pt idx="1404">
                  <c:v>2.6486390620337099</c:v>
                </c:pt>
                <c:pt idx="1405">
                  <c:v>2.75008554751787</c:v>
                </c:pt>
                <c:pt idx="1406">
                  <c:v>2.4425587023417901</c:v>
                </c:pt>
                <c:pt idx="1407">
                  <c:v>3.1157708401528899</c:v>
                </c:pt>
                <c:pt idx="1408">
                  <c:v>3.2316607173525198</c:v>
                </c:pt>
                <c:pt idx="1409">
                  <c:v>3.2960191126101601</c:v>
                </c:pt>
                <c:pt idx="1410">
                  <c:v>3.2598034711306898</c:v>
                </c:pt>
                <c:pt idx="1411">
                  <c:v>3.48116619510238</c:v>
                </c:pt>
                <c:pt idx="1412">
                  <c:v>3.31848931738452</c:v>
                </c:pt>
                <c:pt idx="1413">
                  <c:v>3.3391566830986701</c:v>
                </c:pt>
                <c:pt idx="1414">
                  <c:v>3.37380181902064</c:v>
                </c:pt>
                <c:pt idx="1415">
                  <c:v>3.3348559716805499</c:v>
                </c:pt>
                <c:pt idx="1416">
                  <c:v>2.6814003056101599</c:v>
                </c:pt>
                <c:pt idx="1417">
                  <c:v>3.3373882062874798</c:v>
                </c:pt>
                <c:pt idx="1418">
                  <c:v>3.5593348657909298</c:v>
                </c:pt>
                <c:pt idx="1419">
                  <c:v>3.1840734113148099</c:v>
                </c:pt>
                <c:pt idx="1420">
                  <c:v>2.7612500303204199</c:v>
                </c:pt>
                <c:pt idx="1421">
                  <c:v>3.27243568550178</c:v>
                </c:pt>
                <c:pt idx="1422">
                  <c:v>3.39124629939097</c:v>
                </c:pt>
                <c:pt idx="1423">
                  <c:v>3.0870974232922199</c:v>
                </c:pt>
                <c:pt idx="1424">
                  <c:v>3.0477969220574801</c:v>
                </c:pt>
                <c:pt idx="1425">
                  <c:v>3.22675329638263</c:v>
                </c:pt>
                <c:pt idx="1426">
                  <c:v>3.1000710460127299</c:v>
                </c:pt>
                <c:pt idx="1427">
                  <c:v>3.75248540865429</c:v>
                </c:pt>
                <c:pt idx="1428">
                  <c:v>2.9865850442611901</c:v>
                </c:pt>
                <c:pt idx="1429">
                  <c:v>2.9664932106546198</c:v>
                </c:pt>
                <c:pt idx="1430">
                  <c:v>2.7866973351445701</c:v>
                </c:pt>
                <c:pt idx="1431">
                  <c:v>2.5164556384305299</c:v>
                </c:pt>
                <c:pt idx="1432">
                  <c:v>3.8187188031341899</c:v>
                </c:pt>
                <c:pt idx="1433">
                  <c:v>3.8819845075800101</c:v>
                </c:pt>
                <c:pt idx="1434">
                  <c:v>3.4199197358937701</c:v>
                </c:pt>
                <c:pt idx="1435">
                  <c:v>3.6374844285381598</c:v>
                </c:pt>
                <c:pt idx="1436">
                  <c:v>3.9815828108877702</c:v>
                </c:pt>
                <c:pt idx="1437">
                  <c:v>3.52573343080347</c:v>
                </c:pt>
                <c:pt idx="1438">
                  <c:v>3.6647319072851099</c:v>
                </c:pt>
                <c:pt idx="1439">
                  <c:v>3.25804653283571</c:v>
                </c:pt>
                <c:pt idx="1440">
                  <c:v>3.88569549420821</c:v>
                </c:pt>
                <c:pt idx="1441">
                  <c:v>3.8290440540652702</c:v>
                </c:pt>
                <c:pt idx="1442">
                  <c:v>3.6361580022498798</c:v>
                </c:pt>
                <c:pt idx="1443">
                  <c:v>3.7822764706713801</c:v>
                </c:pt>
                <c:pt idx="1444">
                  <c:v>3.7173598347584802</c:v>
                </c:pt>
                <c:pt idx="1445">
                  <c:v>3.49866396606761</c:v>
                </c:pt>
                <c:pt idx="1446">
                  <c:v>3.5985202326730299</c:v>
                </c:pt>
                <c:pt idx="1447">
                  <c:v>3.7351100088114801</c:v>
                </c:pt>
                <c:pt idx="1448">
                  <c:v>3.5712878681328499</c:v>
                </c:pt>
                <c:pt idx="1449">
                  <c:v>3.3863314046672501</c:v>
                </c:pt>
                <c:pt idx="1450">
                  <c:v>2.9759462757881701</c:v>
                </c:pt>
                <c:pt idx="1451">
                  <c:v>2.9280963273282099</c:v>
                </c:pt>
                <c:pt idx="1452">
                  <c:v>3.22804576307515</c:v>
                </c:pt>
                <c:pt idx="1453">
                  <c:v>2.9026814849068501</c:v>
                </c:pt>
                <c:pt idx="1454">
                  <c:v>3.5796830845216498</c:v>
                </c:pt>
                <c:pt idx="1455">
                  <c:v>3.38883615584025</c:v>
                </c:pt>
                <c:pt idx="1456">
                  <c:v>3.5040872068409001</c:v>
                </c:pt>
                <c:pt idx="1457">
                  <c:v>3.27964276268919</c:v>
                </c:pt>
                <c:pt idx="1458">
                  <c:v>2.89329713545068</c:v>
                </c:pt>
                <c:pt idx="1459">
                  <c:v>3.1079490332753199</c:v>
                </c:pt>
                <c:pt idx="1460">
                  <c:v>3.6074911456671002</c:v>
                </c:pt>
                <c:pt idx="1461">
                  <c:v>3.7038637945934401</c:v>
                </c:pt>
                <c:pt idx="1462">
                  <c:v>3.6617629057235099</c:v>
                </c:pt>
                <c:pt idx="1463">
                  <c:v>3.6764552643299502</c:v>
                </c:pt>
                <c:pt idx="1464">
                  <c:v>4.3437317201475798</c:v>
                </c:pt>
                <c:pt idx="1465">
                  <c:v>3.4718320179789699</c:v>
                </c:pt>
                <c:pt idx="1466">
                  <c:v>3.7091022836273502</c:v>
                </c:pt>
                <c:pt idx="1467">
                  <c:v>3.2271274831669698</c:v>
                </c:pt>
                <c:pt idx="1468">
                  <c:v>3.0231259267540498</c:v>
                </c:pt>
                <c:pt idx="1469">
                  <c:v>3.2407103979187202</c:v>
                </c:pt>
                <c:pt idx="1470">
                  <c:v>3.6430841690561002</c:v>
                </c:pt>
                <c:pt idx="1471">
                  <c:v>3.7369159501595099</c:v>
                </c:pt>
                <c:pt idx="1472">
                  <c:v>4.1371407616794302</c:v>
                </c:pt>
                <c:pt idx="1473">
                  <c:v>3.9777242592836499</c:v>
                </c:pt>
                <c:pt idx="1474">
                  <c:v>3.6736193427881201</c:v>
                </c:pt>
                <c:pt idx="1475">
                  <c:v>3.7550046037328602</c:v>
                </c:pt>
                <c:pt idx="1476">
                  <c:v>3.9716515610453</c:v>
                </c:pt>
                <c:pt idx="1477">
                  <c:v>4.5524845099705802</c:v>
                </c:pt>
                <c:pt idx="1478">
                  <c:v>4.2036693975766903</c:v>
                </c:pt>
                <c:pt idx="1479">
                  <c:v>4.0975332706209704</c:v>
                </c:pt>
                <c:pt idx="1480">
                  <c:v>3.87819981304937</c:v>
                </c:pt>
                <c:pt idx="1481">
                  <c:v>3.5107035826441901</c:v>
                </c:pt>
                <c:pt idx="1482">
                  <c:v>4.4372424785303197</c:v>
                </c:pt>
                <c:pt idx="1483">
                  <c:v>4.0992393422037798</c:v>
                </c:pt>
                <c:pt idx="1484">
                  <c:v>3.8010324888946001</c:v>
                </c:pt>
                <c:pt idx="1485">
                  <c:v>3.9158894986796602</c:v>
                </c:pt>
                <c:pt idx="1486">
                  <c:v>4.0375965255504704</c:v>
                </c:pt>
                <c:pt idx="1487">
                  <c:v>2.9870068281781101</c:v>
                </c:pt>
                <c:pt idx="1488">
                  <c:v>2.83898170397788</c:v>
                </c:pt>
                <c:pt idx="1489">
                  <c:v>3.63113894207559</c:v>
                </c:pt>
                <c:pt idx="1490">
                  <c:v>4.0035779233365796</c:v>
                </c:pt>
                <c:pt idx="1491">
                  <c:v>4.4946664396029803</c:v>
                </c:pt>
                <c:pt idx="1492">
                  <c:v>4.0666436640216803</c:v>
                </c:pt>
                <c:pt idx="1493">
                  <c:v>3.8584842968323101</c:v>
                </c:pt>
                <c:pt idx="1494">
                  <c:v>3.9053541684392798</c:v>
                </c:pt>
                <c:pt idx="1495">
                  <c:v>4.5560072248659802</c:v>
                </c:pt>
                <c:pt idx="1496">
                  <c:v>3.550294837574</c:v>
                </c:pt>
                <c:pt idx="1497">
                  <c:v>4.1399426896879001</c:v>
                </c:pt>
                <c:pt idx="1498">
                  <c:v>4.08917367943332</c:v>
                </c:pt>
                <c:pt idx="1499">
                  <c:v>3.5608849638292899</c:v>
                </c:pt>
                <c:pt idx="1500">
                  <c:v>4.2643228094790198</c:v>
                </c:pt>
                <c:pt idx="1501">
                  <c:v>3.8141704282397901</c:v>
                </c:pt>
                <c:pt idx="1502">
                  <c:v>4.2031471377626</c:v>
                </c:pt>
                <c:pt idx="1503">
                  <c:v>3.8777037017139602</c:v>
                </c:pt>
                <c:pt idx="1504">
                  <c:v>3.5585348380183999</c:v>
                </c:pt>
                <c:pt idx="1505">
                  <c:v>4.4263904740827904</c:v>
                </c:pt>
                <c:pt idx="1506">
                  <c:v>4.05877254526572</c:v>
                </c:pt>
                <c:pt idx="1507">
                  <c:v>4.24899621180698</c:v>
                </c:pt>
                <c:pt idx="1508">
                  <c:v>3.9633426702657699</c:v>
                </c:pt>
                <c:pt idx="1509">
                  <c:v>3.8624341312476802</c:v>
                </c:pt>
                <c:pt idx="1510">
                  <c:v>3.80931235489536</c:v>
                </c:pt>
                <c:pt idx="1511">
                  <c:v>3.7723181558644701</c:v>
                </c:pt>
                <c:pt idx="1512">
                  <c:v>4.0109896862687702</c:v>
                </c:pt>
                <c:pt idx="1513">
                  <c:v>3.9712875627911299</c:v>
                </c:pt>
                <c:pt idx="1514">
                  <c:v>4.3440096990947596</c:v>
                </c:pt>
                <c:pt idx="1515">
                  <c:v>4.0025029724610297</c:v>
                </c:pt>
                <c:pt idx="1516">
                  <c:v>2.9389210763491702</c:v>
                </c:pt>
                <c:pt idx="1517">
                  <c:v>3.6637781379843899</c:v>
                </c:pt>
                <c:pt idx="1518">
                  <c:v>4.0682417030132898</c:v>
                </c:pt>
                <c:pt idx="1519">
                  <c:v>4.4229209029176202</c:v>
                </c:pt>
                <c:pt idx="1520">
                  <c:v>3.72664417626966</c:v>
                </c:pt>
                <c:pt idx="1521">
                  <c:v>3.93644159385848</c:v>
                </c:pt>
                <c:pt idx="1522">
                  <c:v>3.56053884348258</c:v>
                </c:pt>
                <c:pt idx="1523">
                  <c:v>4.0109642191615897</c:v>
                </c:pt>
                <c:pt idx="1524">
                  <c:v>3.88751233101994</c:v>
                </c:pt>
                <c:pt idx="1525">
                  <c:v>4.0464674034144599</c:v>
                </c:pt>
                <c:pt idx="1526">
                  <c:v>3.7618554642234101</c:v>
                </c:pt>
                <c:pt idx="1527">
                  <c:v>3.88539513580568</c:v>
                </c:pt>
                <c:pt idx="1528">
                  <c:v>3.9342177740078701</c:v>
                </c:pt>
                <c:pt idx="1529">
                  <c:v>4.34595168555163</c:v>
                </c:pt>
                <c:pt idx="1530">
                  <c:v>3.7467643688490799</c:v>
                </c:pt>
                <c:pt idx="1531">
                  <c:v>4.1221769601330296</c:v>
                </c:pt>
                <c:pt idx="1532">
                  <c:v>3.7400275907423199</c:v>
                </c:pt>
                <c:pt idx="1533">
                  <c:v>3.7900908910548798</c:v>
                </c:pt>
                <c:pt idx="1534">
                  <c:v>4.0225572836864396</c:v>
                </c:pt>
                <c:pt idx="1535">
                  <c:v>3.5721866540263001</c:v>
                </c:pt>
                <c:pt idx="1536">
                  <c:v>3.81493988447804</c:v>
                </c:pt>
                <c:pt idx="1537">
                  <c:v>4.3298656151323502</c:v>
                </c:pt>
                <c:pt idx="1538">
                  <c:v>3.98322872300565</c:v>
                </c:pt>
                <c:pt idx="1539">
                  <c:v>3.75898650408456</c:v>
                </c:pt>
                <c:pt idx="1540">
                  <c:v>3.8956993574154799</c:v>
                </c:pt>
                <c:pt idx="1541">
                  <c:v>4.2924233682275004</c:v>
                </c:pt>
                <c:pt idx="1542">
                  <c:v>3.9863251877433701</c:v>
                </c:pt>
                <c:pt idx="1543">
                  <c:v>4.0315771518429599</c:v>
                </c:pt>
                <c:pt idx="1544">
                  <c:v>4.5757728010390997</c:v>
                </c:pt>
                <c:pt idx="1545">
                  <c:v>4.0590341637121901</c:v>
                </c:pt>
                <c:pt idx="1546">
                  <c:v>4.3638224175918996</c:v>
                </c:pt>
                <c:pt idx="1547">
                  <c:v>4.3656495875881696</c:v>
                </c:pt>
                <c:pt idx="1548">
                  <c:v>4.1946579245409001</c:v>
                </c:pt>
                <c:pt idx="1549">
                  <c:v>3.0848658600028398</c:v>
                </c:pt>
                <c:pt idx="1550">
                  <c:v>3.7377019709069899</c:v>
                </c:pt>
                <c:pt idx="1551">
                  <c:v>4.1459285697972597</c:v>
                </c:pt>
                <c:pt idx="1552">
                  <c:v>3.5943950661386301</c:v>
                </c:pt>
                <c:pt idx="1553">
                  <c:v>3.3614299904432099</c:v>
                </c:pt>
                <c:pt idx="1554">
                  <c:v>3.9208306204659502</c:v>
                </c:pt>
                <c:pt idx="1555">
                  <c:v>3.87589177987264</c:v>
                </c:pt>
                <c:pt idx="1556">
                  <c:v>3.3444245420924399</c:v>
                </c:pt>
                <c:pt idx="1557">
                  <c:v>3.25766732029969</c:v>
                </c:pt>
                <c:pt idx="1558">
                  <c:v>2.9726570774943899</c:v>
                </c:pt>
                <c:pt idx="1559">
                  <c:v>3.0456718469864001</c:v>
                </c:pt>
                <c:pt idx="1560">
                  <c:v>3.38612507939358</c:v>
                </c:pt>
                <c:pt idx="1561">
                  <c:v>3.4806032983509501</c:v>
                </c:pt>
                <c:pt idx="1562">
                  <c:v>2.9227059079027198</c:v>
                </c:pt>
                <c:pt idx="1563">
                  <c:v>3.5630363930857198</c:v>
                </c:pt>
                <c:pt idx="1564">
                  <c:v>3.2576561902156</c:v>
                </c:pt>
                <c:pt idx="1565">
                  <c:v>3.14904059905261</c:v>
                </c:pt>
                <c:pt idx="1566">
                  <c:v>3.02238642754233</c:v>
                </c:pt>
                <c:pt idx="1567">
                  <c:v>4.0068483308596496</c:v>
                </c:pt>
                <c:pt idx="1568">
                  <c:v>3.5287984546895501</c:v>
                </c:pt>
                <c:pt idx="1569">
                  <c:v>2.73248679946186</c:v>
                </c:pt>
                <c:pt idx="1570">
                  <c:v>2.7642302592095702</c:v>
                </c:pt>
                <c:pt idx="1571">
                  <c:v>3.5272541107228399</c:v>
                </c:pt>
                <c:pt idx="1572">
                  <c:v>3.6335105738522402</c:v>
                </c:pt>
                <c:pt idx="1573">
                  <c:v>3.6537107866818599</c:v>
                </c:pt>
                <c:pt idx="1574">
                  <c:v>3.6738975467272201</c:v>
                </c:pt>
                <c:pt idx="1575">
                  <c:v>2.7191392292605601</c:v>
                </c:pt>
                <c:pt idx="1576">
                  <c:v>2.7669042132525501</c:v>
                </c:pt>
                <c:pt idx="1577">
                  <c:v>2.6379602933485402</c:v>
                </c:pt>
                <c:pt idx="1578">
                  <c:v>2.8128326332193598</c:v>
                </c:pt>
                <c:pt idx="1579">
                  <c:v>3.0051661384195398</c:v>
                </c:pt>
                <c:pt idx="1580">
                  <c:v>2.8094199934627402</c:v>
                </c:pt>
                <c:pt idx="1581">
                  <c:v>2.6540735434972098</c:v>
                </c:pt>
                <c:pt idx="1582">
                  <c:v>2.0110347391301802</c:v>
                </c:pt>
                <c:pt idx="1583">
                  <c:v>2.3339955745092</c:v>
                </c:pt>
                <c:pt idx="1584">
                  <c:v>2.1294832465486802</c:v>
                </c:pt>
                <c:pt idx="1585">
                  <c:v>2.6034723468208698</c:v>
                </c:pt>
                <c:pt idx="1586">
                  <c:v>2.7405332824533</c:v>
                </c:pt>
                <c:pt idx="1587">
                  <c:v>2.53553461778835</c:v>
                </c:pt>
                <c:pt idx="1588">
                  <c:v>2.82908225503237</c:v>
                </c:pt>
                <c:pt idx="1589">
                  <c:v>2.5921101809747098</c:v>
                </c:pt>
                <c:pt idx="1590">
                  <c:v>3.06068214543405</c:v>
                </c:pt>
                <c:pt idx="1591">
                  <c:v>2.3005542224757498</c:v>
                </c:pt>
                <c:pt idx="1592">
                  <c:v>2.64244806395374</c:v>
                </c:pt>
                <c:pt idx="1593">
                  <c:v>2.7536032595542799</c:v>
                </c:pt>
                <c:pt idx="1594">
                  <c:v>3.4108189247865601</c:v>
                </c:pt>
                <c:pt idx="1595">
                  <c:v>2.9540616890495199</c:v>
                </c:pt>
                <c:pt idx="1596">
                  <c:v>2.49912118103058</c:v>
                </c:pt>
                <c:pt idx="1597">
                  <c:v>2.5783271813018902</c:v>
                </c:pt>
                <c:pt idx="1598">
                  <c:v>2.6383027707241702</c:v>
                </c:pt>
                <c:pt idx="1599">
                  <c:v>2.75954578060297</c:v>
                </c:pt>
                <c:pt idx="1600">
                  <c:v>2.4118102169773898</c:v>
                </c:pt>
                <c:pt idx="1601">
                  <c:v>2.31562113041895</c:v>
                </c:pt>
                <c:pt idx="1602">
                  <c:v>3.2078900878222698</c:v>
                </c:pt>
                <c:pt idx="1603">
                  <c:v>2.7098978746301099</c:v>
                </c:pt>
                <c:pt idx="1604">
                  <c:v>2.2968082955359601</c:v>
                </c:pt>
                <c:pt idx="1605">
                  <c:v>2.8445122838113002</c:v>
                </c:pt>
                <c:pt idx="1606">
                  <c:v>3.2569162550675999</c:v>
                </c:pt>
                <c:pt idx="1607">
                  <c:v>2.5097866992448901</c:v>
                </c:pt>
                <c:pt idx="1608">
                  <c:v>2.6127419161174301</c:v>
                </c:pt>
                <c:pt idx="1609">
                  <c:v>2.55868932861349</c:v>
                </c:pt>
                <c:pt idx="1610">
                  <c:v>2.94809009314167</c:v>
                </c:pt>
                <c:pt idx="1611">
                  <c:v>2.6833087037880099</c:v>
                </c:pt>
                <c:pt idx="1612">
                  <c:v>2.57921661362843</c:v>
                </c:pt>
                <c:pt idx="1613">
                  <c:v>2.2629245257693298</c:v>
                </c:pt>
                <c:pt idx="1614">
                  <c:v>2.0560361821953399</c:v>
                </c:pt>
                <c:pt idx="1615">
                  <c:v>2.2830446954757599</c:v>
                </c:pt>
                <c:pt idx="1616">
                  <c:v>2.53400935692606</c:v>
                </c:pt>
                <c:pt idx="1617">
                  <c:v>2.5064203696579601</c:v>
                </c:pt>
                <c:pt idx="1618">
                  <c:v>2.5097469046485599</c:v>
                </c:pt>
                <c:pt idx="1619">
                  <c:v>2.31453265307846</c:v>
                </c:pt>
                <c:pt idx="1620">
                  <c:v>2.63178443665984</c:v>
                </c:pt>
                <c:pt idx="1621">
                  <c:v>2.2490666061256901</c:v>
                </c:pt>
                <c:pt idx="1622">
                  <c:v>1.5852105852514</c:v>
                </c:pt>
                <c:pt idx="1623">
                  <c:v>1.6683434601284799</c:v>
                </c:pt>
                <c:pt idx="1624">
                  <c:v>1.8611680242621</c:v>
                </c:pt>
                <c:pt idx="1625">
                  <c:v>2.0023258506265398</c:v>
                </c:pt>
                <c:pt idx="1626">
                  <c:v>2.7696296775737701</c:v>
                </c:pt>
                <c:pt idx="1627">
                  <c:v>2.6236531783434098</c:v>
                </c:pt>
                <c:pt idx="1628">
                  <c:v>2.4338484912996901</c:v>
                </c:pt>
                <c:pt idx="1629">
                  <c:v>2.0374962832091899</c:v>
                </c:pt>
                <c:pt idx="1630">
                  <c:v>2.0752487196226799</c:v>
                </c:pt>
                <c:pt idx="1631">
                  <c:v>1.8953577117610301</c:v>
                </c:pt>
                <c:pt idx="1632">
                  <c:v>1.92872756869363</c:v>
                </c:pt>
                <c:pt idx="1633">
                  <c:v>1.37502116312582</c:v>
                </c:pt>
                <c:pt idx="1634">
                  <c:v>1.5388300178057399</c:v>
                </c:pt>
                <c:pt idx="1635">
                  <c:v>1.6110243195021099</c:v>
                </c:pt>
                <c:pt idx="1636">
                  <c:v>1.6468534511119299</c:v>
                </c:pt>
                <c:pt idx="1637">
                  <c:v>1.28760467349776</c:v>
                </c:pt>
                <c:pt idx="1638">
                  <c:v>1.8677217065693099</c:v>
                </c:pt>
                <c:pt idx="1639">
                  <c:v>2.1738431829728699</c:v>
                </c:pt>
                <c:pt idx="1640">
                  <c:v>1.7946519417337501</c:v>
                </c:pt>
                <c:pt idx="1641">
                  <c:v>1.5982628182281999</c:v>
                </c:pt>
                <c:pt idx="1642">
                  <c:v>2.5383762169295201</c:v>
                </c:pt>
                <c:pt idx="1643">
                  <c:v>2.4351111269670098</c:v>
                </c:pt>
                <c:pt idx="1644">
                  <c:v>1.78799572538093</c:v>
                </c:pt>
                <c:pt idx="1645">
                  <c:v>1.7052199499334699</c:v>
                </c:pt>
                <c:pt idx="1646">
                  <c:v>1.8168775368115999</c:v>
                </c:pt>
                <c:pt idx="1647">
                  <c:v>2.33517883347232</c:v>
                </c:pt>
                <c:pt idx="1648">
                  <c:v>1.9025349166804799</c:v>
                </c:pt>
                <c:pt idx="1649">
                  <c:v>2.1331015654450298</c:v>
                </c:pt>
                <c:pt idx="1650">
                  <c:v>2.2304316389166399</c:v>
                </c:pt>
                <c:pt idx="1651">
                  <c:v>2.2695242601001602</c:v>
                </c:pt>
                <c:pt idx="1652">
                  <c:v>1.96013350283254</c:v>
                </c:pt>
                <c:pt idx="1653">
                  <c:v>2.3515734630642302</c:v>
                </c:pt>
                <c:pt idx="1654">
                  <c:v>2.6714136953896501</c:v>
                </c:pt>
                <c:pt idx="1655">
                  <c:v>2.15169295375647</c:v>
                </c:pt>
                <c:pt idx="1656">
                  <c:v>1.8197310013776</c:v>
                </c:pt>
                <c:pt idx="1657">
                  <c:v>2.2195823765491198</c:v>
                </c:pt>
                <c:pt idx="1658">
                  <c:v>1.91297036980535</c:v>
                </c:pt>
                <c:pt idx="1659">
                  <c:v>1.6554495086334999</c:v>
                </c:pt>
                <c:pt idx="1660">
                  <c:v>2.0428884110541299</c:v>
                </c:pt>
                <c:pt idx="1661">
                  <c:v>2.2431624796423</c:v>
                </c:pt>
                <c:pt idx="1662">
                  <c:v>2.5155686714175398</c:v>
                </c:pt>
                <c:pt idx="1663">
                  <c:v>2.0813242831433398</c:v>
                </c:pt>
                <c:pt idx="1664">
                  <c:v>2.9958971160524399</c:v>
                </c:pt>
                <c:pt idx="1665">
                  <c:v>2.11318375685175</c:v>
                </c:pt>
                <c:pt idx="1666">
                  <c:v>1.9652919523474901</c:v>
                </c:pt>
                <c:pt idx="1667">
                  <c:v>2.3585097005539701</c:v>
                </c:pt>
                <c:pt idx="1668">
                  <c:v>2.3054012134467898</c:v>
                </c:pt>
                <c:pt idx="1669">
                  <c:v>2.5866780322696798</c:v>
                </c:pt>
                <c:pt idx="1670">
                  <c:v>2.3220286958458698</c:v>
                </c:pt>
                <c:pt idx="1671">
                  <c:v>2.2862378861791601</c:v>
                </c:pt>
                <c:pt idx="1672">
                  <c:v>2.4720631435483198</c:v>
                </c:pt>
                <c:pt idx="1673">
                  <c:v>2.4738982917032399</c:v>
                </c:pt>
                <c:pt idx="1674">
                  <c:v>2.0951711045157002</c:v>
                </c:pt>
                <c:pt idx="1675">
                  <c:v>2.1525236955414102</c:v>
                </c:pt>
                <c:pt idx="1676">
                  <c:v>2.4328580598427898</c:v>
                </c:pt>
                <c:pt idx="1677">
                  <c:v>2.1786890443383302</c:v>
                </c:pt>
                <c:pt idx="1678">
                  <c:v>2.0367620245193301</c:v>
                </c:pt>
                <c:pt idx="1679">
                  <c:v>2.2068981399099701</c:v>
                </c:pt>
                <c:pt idx="1680">
                  <c:v>2.73659416865604</c:v>
                </c:pt>
                <c:pt idx="1681">
                  <c:v>3.0426406500124199</c:v>
                </c:pt>
                <c:pt idx="1682">
                  <c:v>2.41153343535473</c:v>
                </c:pt>
                <c:pt idx="1683">
                  <c:v>2.6077126935536099</c:v>
                </c:pt>
                <c:pt idx="1684">
                  <c:v>2.6180120918167402</c:v>
                </c:pt>
                <c:pt idx="1685">
                  <c:v>2.5408786053817001</c:v>
                </c:pt>
                <c:pt idx="1686">
                  <c:v>2.75688877527547</c:v>
                </c:pt>
                <c:pt idx="1687">
                  <c:v>3.1102068638793101</c:v>
                </c:pt>
                <c:pt idx="1688">
                  <c:v>2.8394498342568402</c:v>
                </c:pt>
                <c:pt idx="1689">
                  <c:v>2.8295357772215302</c:v>
                </c:pt>
                <c:pt idx="1690">
                  <c:v>2.8350747221776</c:v>
                </c:pt>
                <c:pt idx="1691">
                  <c:v>2.4588768884489101</c:v>
                </c:pt>
                <c:pt idx="1692">
                  <c:v>2.23631360102031</c:v>
                </c:pt>
                <c:pt idx="1693">
                  <c:v>2.0661469992247201</c:v>
                </c:pt>
                <c:pt idx="1694">
                  <c:v>2.5943814475795399</c:v>
                </c:pt>
                <c:pt idx="1695">
                  <c:v>2.12115535809584</c:v>
                </c:pt>
                <c:pt idx="1696">
                  <c:v>2.1136603721384999</c:v>
                </c:pt>
                <c:pt idx="1697">
                  <c:v>2.2578092847071698</c:v>
                </c:pt>
                <c:pt idx="1698">
                  <c:v>3.30102475951607</c:v>
                </c:pt>
                <c:pt idx="1699">
                  <c:v>2.47150819627009</c:v>
                </c:pt>
                <c:pt idx="1700">
                  <c:v>2.8094925343496899</c:v>
                </c:pt>
                <c:pt idx="1701">
                  <c:v>2.21935727210992</c:v>
                </c:pt>
                <c:pt idx="1702">
                  <c:v>2.53764496467427</c:v>
                </c:pt>
                <c:pt idx="1703">
                  <c:v>2.6044324651267701</c:v>
                </c:pt>
                <c:pt idx="1704">
                  <c:v>2.9834857936133901</c:v>
                </c:pt>
                <c:pt idx="1705">
                  <c:v>3.0457947706267499</c:v>
                </c:pt>
                <c:pt idx="1706">
                  <c:v>2.56808627595339</c:v>
                </c:pt>
                <c:pt idx="1707">
                  <c:v>2.76996357702243</c:v>
                </c:pt>
                <c:pt idx="1708">
                  <c:v>2.22142192925797</c:v>
                </c:pt>
                <c:pt idx="1709">
                  <c:v>2.01698105804735</c:v>
                </c:pt>
                <c:pt idx="1710">
                  <c:v>1.3718764058891699</c:v>
                </c:pt>
                <c:pt idx="1711">
                  <c:v>2.3219410040169701</c:v>
                </c:pt>
                <c:pt idx="1712">
                  <c:v>2.73912274523411</c:v>
                </c:pt>
                <c:pt idx="1713">
                  <c:v>2.72296398721025</c:v>
                </c:pt>
                <c:pt idx="1714">
                  <c:v>2.1838243812134399</c:v>
                </c:pt>
                <c:pt idx="1715">
                  <c:v>2.2050880272509099</c:v>
                </c:pt>
                <c:pt idx="1716">
                  <c:v>2.0299166083465598</c:v>
                </c:pt>
                <c:pt idx="1717">
                  <c:v>2.4390554388914301</c:v>
                </c:pt>
                <c:pt idx="1718">
                  <c:v>2.54218771621494</c:v>
                </c:pt>
                <c:pt idx="1719">
                  <c:v>2.0678184051102999</c:v>
                </c:pt>
                <c:pt idx="1720">
                  <c:v>2.2651478028032601</c:v>
                </c:pt>
                <c:pt idx="1721">
                  <c:v>2.4839212353598201</c:v>
                </c:pt>
                <c:pt idx="1722">
                  <c:v>2.4865312596740701</c:v>
                </c:pt>
                <c:pt idx="1723">
                  <c:v>2.29455969865539</c:v>
                </c:pt>
                <c:pt idx="1724">
                  <c:v>2.09580215439731</c:v>
                </c:pt>
                <c:pt idx="1725">
                  <c:v>2.2731952301751801</c:v>
                </c:pt>
                <c:pt idx="1726">
                  <c:v>1.5903300154084501</c:v>
                </c:pt>
                <c:pt idx="1727">
                  <c:v>1.82024393825769</c:v>
                </c:pt>
                <c:pt idx="1728">
                  <c:v>2.6072267909105702</c:v>
                </c:pt>
                <c:pt idx="1729">
                  <c:v>2.5942456180745501</c:v>
                </c:pt>
                <c:pt idx="1730">
                  <c:v>2.71393978127763</c:v>
                </c:pt>
                <c:pt idx="1731">
                  <c:v>2.5454069422980701</c:v>
                </c:pt>
                <c:pt idx="1732">
                  <c:v>2.51650033634417</c:v>
                </c:pt>
                <c:pt idx="1733">
                  <c:v>1.9621868938148701</c:v>
                </c:pt>
                <c:pt idx="1734">
                  <c:v>2.6965597370405998</c:v>
                </c:pt>
                <c:pt idx="1735">
                  <c:v>2.5051548111542501</c:v>
                </c:pt>
                <c:pt idx="1736">
                  <c:v>2.14721040968054</c:v>
                </c:pt>
                <c:pt idx="1737">
                  <c:v>2.4119799051836299</c:v>
                </c:pt>
                <c:pt idx="1738">
                  <c:v>2.4032024081950598</c:v>
                </c:pt>
                <c:pt idx="1739">
                  <c:v>2.4360667151638999</c:v>
                </c:pt>
                <c:pt idx="1740">
                  <c:v>2.4572007381219199</c:v>
                </c:pt>
                <c:pt idx="1741">
                  <c:v>2.19658024614542</c:v>
                </c:pt>
                <c:pt idx="1742">
                  <c:v>2.4057675954809499</c:v>
                </c:pt>
                <c:pt idx="1743">
                  <c:v>2.1436022114997102</c:v>
                </c:pt>
                <c:pt idx="1744">
                  <c:v>2.3418962514875599</c:v>
                </c:pt>
                <c:pt idx="1745">
                  <c:v>2.3923032069941699</c:v>
                </c:pt>
                <c:pt idx="1746">
                  <c:v>1.7867493395824701</c:v>
                </c:pt>
                <c:pt idx="1747">
                  <c:v>1.81976222835017</c:v>
                </c:pt>
                <c:pt idx="1748">
                  <c:v>2.0546879088154402</c:v>
                </c:pt>
                <c:pt idx="1749">
                  <c:v>1.8561783875842801</c:v>
                </c:pt>
                <c:pt idx="1750">
                  <c:v>1.8001119631359499</c:v>
                </c:pt>
                <c:pt idx="1751">
                  <c:v>1.86905543205097</c:v>
                </c:pt>
                <c:pt idx="1752">
                  <c:v>2.0541295667169099</c:v>
                </c:pt>
                <c:pt idx="1753">
                  <c:v>1.9345676074207101</c:v>
                </c:pt>
                <c:pt idx="1754">
                  <c:v>1.8200533920345801</c:v>
                </c:pt>
                <c:pt idx="1755">
                  <c:v>2.39037160710176</c:v>
                </c:pt>
                <c:pt idx="1756">
                  <c:v>1.8827945167239899</c:v>
                </c:pt>
                <c:pt idx="1757">
                  <c:v>1.95408561360533</c:v>
                </c:pt>
                <c:pt idx="1758">
                  <c:v>2.4889332348527899</c:v>
                </c:pt>
                <c:pt idx="1759">
                  <c:v>1.87928575582249</c:v>
                </c:pt>
                <c:pt idx="1760">
                  <c:v>1.43336973626304</c:v>
                </c:pt>
                <c:pt idx="1761">
                  <c:v>2.2997273694437799</c:v>
                </c:pt>
                <c:pt idx="1762">
                  <c:v>1.7290608081438701</c:v>
                </c:pt>
                <c:pt idx="1763">
                  <c:v>2.4284221952678702</c:v>
                </c:pt>
                <c:pt idx="1764">
                  <c:v>2.6814499508431</c:v>
                </c:pt>
                <c:pt idx="1765">
                  <c:v>1.96544586720766</c:v>
                </c:pt>
                <c:pt idx="1766">
                  <c:v>1.71098416945342</c:v>
                </c:pt>
                <c:pt idx="1767">
                  <c:v>2.6074221140019298</c:v>
                </c:pt>
                <c:pt idx="1768">
                  <c:v>2.0913393014994801</c:v>
                </c:pt>
                <c:pt idx="1769">
                  <c:v>2.1902652974564698</c:v>
                </c:pt>
                <c:pt idx="1770">
                  <c:v>1.94428314167886</c:v>
                </c:pt>
                <c:pt idx="1771">
                  <c:v>2.3096686708313201</c:v>
                </c:pt>
                <c:pt idx="1772">
                  <c:v>2.0934280105363201</c:v>
                </c:pt>
                <c:pt idx="1773">
                  <c:v>2.1400789534852498</c:v>
                </c:pt>
                <c:pt idx="1774">
                  <c:v>1.94931400308442</c:v>
                </c:pt>
                <c:pt idx="1775">
                  <c:v>1.92868371998996</c:v>
                </c:pt>
                <c:pt idx="1776">
                  <c:v>1.8437916066103901</c:v>
                </c:pt>
                <c:pt idx="1777">
                  <c:v>1.6450455630793299</c:v>
                </c:pt>
                <c:pt idx="1778">
                  <c:v>1.8092382056824801</c:v>
                </c:pt>
                <c:pt idx="1779">
                  <c:v>1.9129554304316101</c:v>
                </c:pt>
                <c:pt idx="1780">
                  <c:v>1.4401652188829199</c:v>
                </c:pt>
                <c:pt idx="1781">
                  <c:v>1.87348137206762</c:v>
                </c:pt>
                <c:pt idx="1782">
                  <c:v>1.4454916878834501</c:v>
                </c:pt>
                <c:pt idx="1783">
                  <c:v>1.6629848059022101</c:v>
                </c:pt>
                <c:pt idx="1784">
                  <c:v>2.15083639425605</c:v>
                </c:pt>
                <c:pt idx="1785">
                  <c:v>2.1573239634979799</c:v>
                </c:pt>
                <c:pt idx="1786">
                  <c:v>2.1206408901760798</c:v>
                </c:pt>
                <c:pt idx="1787">
                  <c:v>1.76957987504805</c:v>
                </c:pt>
                <c:pt idx="1788">
                  <c:v>2.3524774176604701</c:v>
                </c:pt>
                <c:pt idx="1789">
                  <c:v>1.70221104502542</c:v>
                </c:pt>
                <c:pt idx="1790">
                  <c:v>2.205048464266</c:v>
                </c:pt>
                <c:pt idx="1791">
                  <c:v>2.3651626146254299</c:v>
                </c:pt>
                <c:pt idx="1792">
                  <c:v>1.75839881827845</c:v>
                </c:pt>
                <c:pt idx="1793">
                  <c:v>1.8337581160757099</c:v>
                </c:pt>
                <c:pt idx="1794">
                  <c:v>1.92739498362913</c:v>
                </c:pt>
                <c:pt idx="1795">
                  <c:v>2.2309498814031201</c:v>
                </c:pt>
                <c:pt idx="1796">
                  <c:v>1.6164072206007001</c:v>
                </c:pt>
                <c:pt idx="1797">
                  <c:v>1.60233179292142</c:v>
                </c:pt>
                <c:pt idx="1798">
                  <c:v>1.9803828756776301</c:v>
                </c:pt>
                <c:pt idx="1799">
                  <c:v>2.2698477551057299</c:v>
                </c:pt>
                <c:pt idx="1800">
                  <c:v>2.11231403312433</c:v>
                </c:pt>
                <c:pt idx="1801">
                  <c:v>1.9257879747278099</c:v>
                </c:pt>
                <c:pt idx="1802">
                  <c:v>2.55292184588561</c:v>
                </c:pt>
                <c:pt idx="1803">
                  <c:v>2.46036536059977</c:v>
                </c:pt>
                <c:pt idx="1804">
                  <c:v>2.724225741118</c:v>
                </c:pt>
                <c:pt idx="1805">
                  <c:v>2.4048833864855799</c:v>
                </c:pt>
                <c:pt idx="1806">
                  <c:v>2.4234873007378899</c:v>
                </c:pt>
                <c:pt idx="1807">
                  <c:v>2.0713159185290002</c:v>
                </c:pt>
                <c:pt idx="1808">
                  <c:v>1.9279546485150101</c:v>
                </c:pt>
                <c:pt idx="1809">
                  <c:v>2.2568563128450601</c:v>
                </c:pt>
                <c:pt idx="1810">
                  <c:v>1.9487727509216299</c:v>
                </c:pt>
                <c:pt idx="1811">
                  <c:v>2.2782640562554302</c:v>
                </c:pt>
                <c:pt idx="1812">
                  <c:v>1.6918955105570701</c:v>
                </c:pt>
                <c:pt idx="1813">
                  <c:v>1.44347993670911</c:v>
                </c:pt>
                <c:pt idx="1814">
                  <c:v>1.79651940228545</c:v>
                </c:pt>
                <c:pt idx="1815">
                  <c:v>2.5764190217462</c:v>
                </c:pt>
                <c:pt idx="1816">
                  <c:v>3.48690889777924</c:v>
                </c:pt>
                <c:pt idx="1817">
                  <c:v>2.0834654452845101</c:v>
                </c:pt>
                <c:pt idx="1818">
                  <c:v>2.3120433264158202</c:v>
                </c:pt>
                <c:pt idx="1819">
                  <c:v>2.59267765138198</c:v>
                </c:pt>
                <c:pt idx="1820">
                  <c:v>2.6821827717540798</c:v>
                </c:pt>
                <c:pt idx="1821">
                  <c:v>2.9276031352875398</c:v>
                </c:pt>
                <c:pt idx="1822">
                  <c:v>2.8693439887241801</c:v>
                </c:pt>
                <c:pt idx="1823">
                  <c:v>2.5020568419132601</c:v>
                </c:pt>
                <c:pt idx="1824">
                  <c:v>2.2976761840397502</c:v>
                </c:pt>
                <c:pt idx="1825">
                  <c:v>2.6027626084255302</c:v>
                </c:pt>
                <c:pt idx="1826">
                  <c:v>2.6541733835622998</c:v>
                </c:pt>
                <c:pt idx="1827">
                  <c:v>2.7640245653078002</c:v>
                </c:pt>
                <c:pt idx="1828">
                  <c:v>2.3839122210844401</c:v>
                </c:pt>
                <c:pt idx="1829">
                  <c:v>2.4202325590016298</c:v>
                </c:pt>
                <c:pt idx="1830">
                  <c:v>2.2192926290498298</c:v>
                </c:pt>
                <c:pt idx="1831">
                  <c:v>2.2050006911502602</c:v>
                </c:pt>
                <c:pt idx="1832">
                  <c:v>2.3723561372283699</c:v>
                </c:pt>
                <c:pt idx="1833">
                  <c:v>2.2681831762704601</c:v>
                </c:pt>
                <c:pt idx="1834">
                  <c:v>2.31601482852277</c:v>
                </c:pt>
                <c:pt idx="1835">
                  <c:v>2.4335964670945001</c:v>
                </c:pt>
                <c:pt idx="1836">
                  <c:v>1.81254346011985</c:v>
                </c:pt>
                <c:pt idx="1837">
                  <c:v>2.7435751637538601</c:v>
                </c:pt>
                <c:pt idx="1838">
                  <c:v>2.4003025442166201</c:v>
                </c:pt>
                <c:pt idx="1839">
                  <c:v>2.0005125862651001</c:v>
                </c:pt>
                <c:pt idx="1840">
                  <c:v>1.79681454117868</c:v>
                </c:pt>
                <c:pt idx="1841">
                  <c:v>1.75076405160721</c:v>
                </c:pt>
                <c:pt idx="1842">
                  <c:v>2.7249037861384</c:v>
                </c:pt>
                <c:pt idx="1843">
                  <c:v>2.73117309336416</c:v>
                </c:pt>
                <c:pt idx="1844">
                  <c:v>2.6363798530876901</c:v>
                </c:pt>
                <c:pt idx="1845">
                  <c:v>2.7658687063365499</c:v>
                </c:pt>
                <c:pt idx="1846">
                  <c:v>1.9807279912226601</c:v>
                </c:pt>
                <c:pt idx="1847">
                  <c:v>2.5019492954744198</c:v>
                </c:pt>
                <c:pt idx="1848">
                  <c:v>2.6889847995609601</c:v>
                </c:pt>
                <c:pt idx="1849">
                  <c:v>2.2022935842489502</c:v>
                </c:pt>
                <c:pt idx="1850">
                  <c:v>2.0921541819346001</c:v>
                </c:pt>
                <c:pt idx="1851">
                  <c:v>2.3565055520726301</c:v>
                </c:pt>
                <c:pt idx="1852">
                  <c:v>2.3262804610088801</c:v>
                </c:pt>
                <c:pt idx="1853">
                  <c:v>2.4685234726634402</c:v>
                </c:pt>
                <c:pt idx="1854">
                  <c:v>2.0429012616450599</c:v>
                </c:pt>
                <c:pt idx="1855">
                  <c:v>2.0900418296122099</c:v>
                </c:pt>
                <c:pt idx="1856">
                  <c:v>2.2596425900542498</c:v>
                </c:pt>
                <c:pt idx="1857">
                  <c:v>2.6733333110256501</c:v>
                </c:pt>
                <c:pt idx="1858">
                  <c:v>2.8215524290997598</c:v>
                </c:pt>
                <c:pt idx="1859">
                  <c:v>2.5666129450598301</c:v>
                </c:pt>
                <c:pt idx="1860">
                  <c:v>1.9091324356969499</c:v>
                </c:pt>
                <c:pt idx="1861">
                  <c:v>2.4871350050352898</c:v>
                </c:pt>
                <c:pt idx="1862">
                  <c:v>2.6522417522170501</c:v>
                </c:pt>
                <c:pt idx="1863">
                  <c:v>2.4114302135346901</c:v>
                </c:pt>
                <c:pt idx="1864">
                  <c:v>2.3489840208099402</c:v>
                </c:pt>
                <c:pt idx="1865">
                  <c:v>2.43061911412219</c:v>
                </c:pt>
                <c:pt idx="1866">
                  <c:v>2.2206005694409998</c:v>
                </c:pt>
                <c:pt idx="1867">
                  <c:v>2.5404004172384602</c:v>
                </c:pt>
                <c:pt idx="1868">
                  <c:v>2.1365841482760901</c:v>
                </c:pt>
                <c:pt idx="1869">
                  <c:v>2.4301660558529501</c:v>
                </c:pt>
                <c:pt idx="1870">
                  <c:v>2.19856810325386</c:v>
                </c:pt>
                <c:pt idx="1871">
                  <c:v>2.49662552607768</c:v>
                </c:pt>
                <c:pt idx="1872">
                  <c:v>2.4229845370965402</c:v>
                </c:pt>
                <c:pt idx="1873">
                  <c:v>2.46786205511631</c:v>
                </c:pt>
                <c:pt idx="1874">
                  <c:v>2.1756177593473298</c:v>
                </c:pt>
                <c:pt idx="1875">
                  <c:v>2.6548579089925699</c:v>
                </c:pt>
                <c:pt idx="1876">
                  <c:v>2.3311982902427801</c:v>
                </c:pt>
                <c:pt idx="1877">
                  <c:v>3.0310955165632598</c:v>
                </c:pt>
                <c:pt idx="1878">
                  <c:v>1.8755527694634999</c:v>
                </c:pt>
                <c:pt idx="1879">
                  <c:v>2.27294552336364</c:v>
                </c:pt>
                <c:pt idx="1880">
                  <c:v>2.0032803952867901</c:v>
                </c:pt>
                <c:pt idx="1881">
                  <c:v>1.7644180827073099</c:v>
                </c:pt>
                <c:pt idx="1882">
                  <c:v>2.6203922016857502</c:v>
                </c:pt>
                <c:pt idx="1883">
                  <c:v>2.3874501972764399</c:v>
                </c:pt>
                <c:pt idx="1884">
                  <c:v>2.4076988331245301</c:v>
                </c:pt>
                <c:pt idx="1885">
                  <c:v>2.7477677703085202</c:v>
                </c:pt>
                <c:pt idx="1886">
                  <c:v>2.5268826677844101</c:v>
                </c:pt>
                <c:pt idx="1887">
                  <c:v>2.1873204304654799</c:v>
                </c:pt>
                <c:pt idx="1888">
                  <c:v>2.0489718882405401</c:v>
                </c:pt>
                <c:pt idx="1889">
                  <c:v>2.8450740755043298</c:v>
                </c:pt>
                <c:pt idx="1890">
                  <c:v>2.47908152180855</c:v>
                </c:pt>
                <c:pt idx="1891">
                  <c:v>2.3301307616368798</c:v>
                </c:pt>
                <c:pt idx="1892">
                  <c:v>2.77431024958031</c:v>
                </c:pt>
                <c:pt idx="1893">
                  <c:v>2.3623921386569902</c:v>
                </c:pt>
                <c:pt idx="1894">
                  <c:v>2.2833415497614999</c:v>
                </c:pt>
                <c:pt idx="1895">
                  <c:v>2.56611912707766</c:v>
                </c:pt>
                <c:pt idx="1896">
                  <c:v>2.5620322774923698</c:v>
                </c:pt>
                <c:pt idx="1897">
                  <c:v>2.4577507250474802</c:v>
                </c:pt>
                <c:pt idx="1898">
                  <c:v>2.5166711558278001</c:v>
                </c:pt>
                <c:pt idx="1899">
                  <c:v>2.09378471730765</c:v>
                </c:pt>
                <c:pt idx="1900">
                  <c:v>2.4668741539079702</c:v>
                </c:pt>
                <c:pt idx="1901">
                  <c:v>2.5487285165919999</c:v>
                </c:pt>
                <c:pt idx="1902">
                  <c:v>2.0093007155737399</c:v>
                </c:pt>
                <c:pt idx="1903">
                  <c:v>2.0639568148318799</c:v>
                </c:pt>
                <c:pt idx="1904">
                  <c:v>2.50929326641258</c:v>
                </c:pt>
                <c:pt idx="1905">
                  <c:v>2.68042826769214</c:v>
                </c:pt>
                <c:pt idx="1906">
                  <c:v>2.1267589809437499</c:v>
                </c:pt>
                <c:pt idx="1907">
                  <c:v>2.2594605479804999</c:v>
                </c:pt>
                <c:pt idx="1908">
                  <c:v>2.6803747206686901</c:v>
                </c:pt>
                <c:pt idx="1909">
                  <c:v>2.7623462558076102</c:v>
                </c:pt>
                <c:pt idx="1910">
                  <c:v>2.4541426761331002</c:v>
                </c:pt>
                <c:pt idx="1911">
                  <c:v>2.4260361458378701</c:v>
                </c:pt>
                <c:pt idx="1912">
                  <c:v>2.7435946194047198</c:v>
                </c:pt>
                <c:pt idx="1913">
                  <c:v>1.9740114417622701</c:v>
                </c:pt>
                <c:pt idx="1914">
                  <c:v>2.3790877639385601</c:v>
                </c:pt>
                <c:pt idx="1915">
                  <c:v>2.17944411642647</c:v>
                </c:pt>
                <c:pt idx="1916">
                  <c:v>2.26533168547871</c:v>
                </c:pt>
                <c:pt idx="1917">
                  <c:v>2.0473903426770899</c:v>
                </c:pt>
                <c:pt idx="1918">
                  <c:v>2.4772231167367398</c:v>
                </c:pt>
                <c:pt idx="1919">
                  <c:v>2.8013330439995499</c:v>
                </c:pt>
                <c:pt idx="1920">
                  <c:v>2.1527113172302301</c:v>
                </c:pt>
                <c:pt idx="1921">
                  <c:v>2.1100420308577701</c:v>
                </c:pt>
                <c:pt idx="1922">
                  <c:v>2.4647206946686002</c:v>
                </c:pt>
                <c:pt idx="1923">
                  <c:v>2.01525303129573</c:v>
                </c:pt>
                <c:pt idx="1924">
                  <c:v>2.1873027747163798</c:v>
                </c:pt>
                <c:pt idx="1925">
                  <c:v>2.2221065287905102</c:v>
                </c:pt>
                <c:pt idx="1926">
                  <c:v>3.0536590315808598</c:v>
                </c:pt>
                <c:pt idx="1927">
                  <c:v>2.5375025947320502</c:v>
                </c:pt>
                <c:pt idx="1928">
                  <c:v>2.58649337069166</c:v>
                </c:pt>
                <c:pt idx="1929">
                  <c:v>2.67264213249033</c:v>
                </c:pt>
                <c:pt idx="1930">
                  <c:v>2.5887784955791502</c:v>
                </c:pt>
                <c:pt idx="1931">
                  <c:v>2.34877026903454</c:v>
                </c:pt>
                <c:pt idx="1932">
                  <c:v>2.7374592639398601</c:v>
                </c:pt>
                <c:pt idx="1933">
                  <c:v>2.3408987391343401</c:v>
                </c:pt>
                <c:pt idx="1934">
                  <c:v>2.9805463806019201</c:v>
                </c:pt>
                <c:pt idx="1935">
                  <c:v>2.1922131722031999</c:v>
                </c:pt>
                <c:pt idx="1936">
                  <c:v>2.5082420952218301</c:v>
                </c:pt>
                <c:pt idx="1937">
                  <c:v>2.2326890678047402</c:v>
                </c:pt>
                <c:pt idx="1938">
                  <c:v>2.3724260591767901</c:v>
                </c:pt>
                <c:pt idx="1939">
                  <c:v>2.9843945493862698</c:v>
                </c:pt>
                <c:pt idx="1940">
                  <c:v>2.2084883221667502</c:v>
                </c:pt>
                <c:pt idx="1941">
                  <c:v>2.6288709669430901</c:v>
                </c:pt>
                <c:pt idx="1942">
                  <c:v>2.3574322703669601</c:v>
                </c:pt>
                <c:pt idx="1943">
                  <c:v>2.3668226588946402</c:v>
                </c:pt>
                <c:pt idx="1944">
                  <c:v>2.69992335133318</c:v>
                </c:pt>
                <c:pt idx="1945">
                  <c:v>2.7972131863146501</c:v>
                </c:pt>
                <c:pt idx="1946">
                  <c:v>2.9350880355440601</c:v>
                </c:pt>
                <c:pt idx="1947">
                  <c:v>2.6815379495704201</c:v>
                </c:pt>
                <c:pt idx="1948">
                  <c:v>3.0675562370109599</c:v>
                </c:pt>
                <c:pt idx="1949">
                  <c:v>2.6503196151009698</c:v>
                </c:pt>
                <c:pt idx="1950">
                  <c:v>2.7576233303937898</c:v>
                </c:pt>
                <c:pt idx="1951">
                  <c:v>2.73623080337895</c:v>
                </c:pt>
                <c:pt idx="1952">
                  <c:v>2.7063092110822198</c:v>
                </c:pt>
                <c:pt idx="1953">
                  <c:v>2.38247177099087</c:v>
                </c:pt>
                <c:pt idx="1954">
                  <c:v>2.5309358711679599</c:v>
                </c:pt>
                <c:pt idx="1955">
                  <c:v>3.1419178568828299</c:v>
                </c:pt>
                <c:pt idx="1956">
                  <c:v>3.1793984554517301</c:v>
                </c:pt>
                <c:pt idx="1957">
                  <c:v>2.8651599159132002</c:v>
                </c:pt>
                <c:pt idx="1958">
                  <c:v>2.9076315652753499</c:v>
                </c:pt>
                <c:pt idx="1959">
                  <c:v>2.9360277337257199</c:v>
                </c:pt>
                <c:pt idx="1960">
                  <c:v>2.7100618435644499</c:v>
                </c:pt>
                <c:pt idx="1961">
                  <c:v>2.5265549856161802</c:v>
                </c:pt>
                <c:pt idx="1962">
                  <c:v>3.0310847269821601</c:v>
                </c:pt>
                <c:pt idx="1963">
                  <c:v>3.0034686792403802</c:v>
                </c:pt>
                <c:pt idx="1964">
                  <c:v>2.4705397568370402</c:v>
                </c:pt>
                <c:pt idx="1965">
                  <c:v>2.5012404958219601</c:v>
                </c:pt>
                <c:pt idx="1966">
                  <c:v>3.09611331737361</c:v>
                </c:pt>
                <c:pt idx="1967">
                  <c:v>2.7368945356013299</c:v>
                </c:pt>
                <c:pt idx="1968">
                  <c:v>2.9510053504881899</c:v>
                </c:pt>
                <c:pt idx="1969">
                  <c:v>2.1978131756626098</c:v>
                </c:pt>
                <c:pt idx="1970">
                  <c:v>2.7237066855632399</c:v>
                </c:pt>
                <c:pt idx="1971">
                  <c:v>2.1647110066465101</c:v>
                </c:pt>
                <c:pt idx="1972">
                  <c:v>1.8363120194709699</c:v>
                </c:pt>
                <c:pt idx="1973">
                  <c:v>2.0365208525136298</c:v>
                </c:pt>
                <c:pt idx="1974">
                  <c:v>2.2697762420277598</c:v>
                </c:pt>
                <c:pt idx="1975">
                  <c:v>2.4168391092872601</c:v>
                </c:pt>
                <c:pt idx="1976">
                  <c:v>2.3207266844915901</c:v>
                </c:pt>
                <c:pt idx="1977">
                  <c:v>1.9823842476150499</c:v>
                </c:pt>
                <c:pt idx="1978">
                  <c:v>2.3712492947947501</c:v>
                </c:pt>
                <c:pt idx="1979">
                  <c:v>1.8560628573865601</c:v>
                </c:pt>
                <c:pt idx="1980">
                  <c:v>2.8455377320840198</c:v>
                </c:pt>
                <c:pt idx="1981">
                  <c:v>3.2296670559726399</c:v>
                </c:pt>
                <c:pt idx="1982">
                  <c:v>2.19977183748495</c:v>
                </c:pt>
                <c:pt idx="1983">
                  <c:v>2.0610998273242598</c:v>
                </c:pt>
                <c:pt idx="1984">
                  <c:v>2.09110531698063</c:v>
                </c:pt>
                <c:pt idx="1985">
                  <c:v>2.0484237012751598</c:v>
                </c:pt>
                <c:pt idx="1986">
                  <c:v>1.58445192710792</c:v>
                </c:pt>
                <c:pt idx="1987">
                  <c:v>2.0162912652164899</c:v>
                </c:pt>
                <c:pt idx="1988">
                  <c:v>2.2591203196909801</c:v>
                </c:pt>
                <c:pt idx="1989">
                  <c:v>2.4690254564165102</c:v>
                </c:pt>
                <c:pt idx="1990">
                  <c:v>1.76494741598222</c:v>
                </c:pt>
                <c:pt idx="1991">
                  <c:v>2.6844346227965099</c:v>
                </c:pt>
                <c:pt idx="1992">
                  <c:v>2.4013202247907302</c:v>
                </c:pt>
                <c:pt idx="1993">
                  <c:v>2.3360889516401899</c:v>
                </c:pt>
                <c:pt idx="1994">
                  <c:v>2.5786420035413702</c:v>
                </c:pt>
                <c:pt idx="1995">
                  <c:v>2.4239201713173699</c:v>
                </c:pt>
                <c:pt idx="1996">
                  <c:v>2.3316923280013002</c:v>
                </c:pt>
                <c:pt idx="1997">
                  <c:v>2.1631281798308999</c:v>
                </c:pt>
                <c:pt idx="1998">
                  <c:v>2.46204154505604</c:v>
                </c:pt>
                <c:pt idx="1999">
                  <c:v>2.0911071567531399</c:v>
                </c:pt>
                <c:pt idx="2000">
                  <c:v>1.7360206530325</c:v>
                </c:pt>
                <c:pt idx="2001">
                  <c:v>2.4714796307628299</c:v>
                </c:pt>
                <c:pt idx="2002">
                  <c:v>2.1032891507601401</c:v>
                </c:pt>
                <c:pt idx="2003">
                  <c:v>2.55760187684962</c:v>
                </c:pt>
                <c:pt idx="2004">
                  <c:v>1.98752661783655</c:v>
                </c:pt>
                <c:pt idx="2005">
                  <c:v>2.3834910865078398</c:v>
                </c:pt>
                <c:pt idx="2006">
                  <c:v>2.0791547989457499</c:v>
                </c:pt>
                <c:pt idx="2007">
                  <c:v>2.4045911263070598</c:v>
                </c:pt>
                <c:pt idx="2008">
                  <c:v>2.2657026815079502</c:v>
                </c:pt>
                <c:pt idx="2009">
                  <c:v>2.7707935859021502</c:v>
                </c:pt>
                <c:pt idx="2010">
                  <c:v>2.7381350812963698</c:v>
                </c:pt>
                <c:pt idx="2011">
                  <c:v>2.6789654861400498</c:v>
                </c:pt>
                <c:pt idx="2012">
                  <c:v>2.7598823888758499</c:v>
                </c:pt>
                <c:pt idx="2013">
                  <c:v>2.90413660414176</c:v>
                </c:pt>
                <c:pt idx="2014">
                  <c:v>2.0369822145947998</c:v>
                </c:pt>
                <c:pt idx="2015">
                  <c:v>1.78924753011708</c:v>
                </c:pt>
                <c:pt idx="2016">
                  <c:v>2.6080365070112599</c:v>
                </c:pt>
                <c:pt idx="2017">
                  <c:v>2.31415792901198</c:v>
                </c:pt>
                <c:pt idx="2018">
                  <c:v>2.1013660271245</c:v>
                </c:pt>
                <c:pt idx="2019">
                  <c:v>2.2689689688131698</c:v>
                </c:pt>
                <c:pt idx="2020">
                  <c:v>2.1981876550912198</c:v>
                </c:pt>
                <c:pt idx="2021">
                  <c:v>2.0495075755910901</c:v>
                </c:pt>
                <c:pt idx="2022">
                  <c:v>1.65728717661792</c:v>
                </c:pt>
                <c:pt idx="2023">
                  <c:v>1.6842187014805801</c:v>
                </c:pt>
                <c:pt idx="2024">
                  <c:v>2.6959164028403202</c:v>
                </c:pt>
                <c:pt idx="2025">
                  <c:v>2.0537925454108898</c:v>
                </c:pt>
                <c:pt idx="2026">
                  <c:v>1.8645179274011201</c:v>
                </c:pt>
                <c:pt idx="2027">
                  <c:v>2.10371327199833</c:v>
                </c:pt>
                <c:pt idx="2028">
                  <c:v>2.3833655739473101</c:v>
                </c:pt>
                <c:pt idx="2029">
                  <c:v>1.5987427904751701</c:v>
                </c:pt>
                <c:pt idx="2030">
                  <c:v>2.2989622498964701</c:v>
                </c:pt>
                <c:pt idx="2031">
                  <c:v>2.0594916875585398</c:v>
                </c:pt>
                <c:pt idx="2032">
                  <c:v>1.96692467126158</c:v>
                </c:pt>
                <c:pt idx="2033">
                  <c:v>2.22061826789137</c:v>
                </c:pt>
                <c:pt idx="2034">
                  <c:v>2.37843495186232</c:v>
                </c:pt>
                <c:pt idx="2035">
                  <c:v>2.0030116985470299</c:v>
                </c:pt>
                <c:pt idx="2036">
                  <c:v>2.0276005723280299</c:v>
                </c:pt>
                <c:pt idx="2037">
                  <c:v>2.1467673808718901</c:v>
                </c:pt>
                <c:pt idx="2038">
                  <c:v>2.47173687105006</c:v>
                </c:pt>
                <c:pt idx="2039">
                  <c:v>2.3742391772358</c:v>
                </c:pt>
                <c:pt idx="2040">
                  <c:v>2.0312301402764801</c:v>
                </c:pt>
                <c:pt idx="2041">
                  <c:v>1.6733443099780401</c:v>
                </c:pt>
                <c:pt idx="2042">
                  <c:v>2.1077851061167099</c:v>
                </c:pt>
                <c:pt idx="2043">
                  <c:v>2.2663359108650099</c:v>
                </c:pt>
                <c:pt idx="2044">
                  <c:v>1.7725790826444801</c:v>
                </c:pt>
                <c:pt idx="2045">
                  <c:v>2.2501788239404701</c:v>
                </c:pt>
                <c:pt idx="2046">
                  <c:v>1.7275226576882701</c:v>
                </c:pt>
                <c:pt idx="2047">
                  <c:v>1.4438106263884301</c:v>
                </c:pt>
                <c:pt idx="2048">
                  <c:v>2.0370237745084001</c:v>
                </c:pt>
                <c:pt idx="2049">
                  <c:v>1.7184276093530599</c:v>
                </c:pt>
                <c:pt idx="2050">
                  <c:v>2.1145910648838799</c:v>
                </c:pt>
                <c:pt idx="2051">
                  <c:v>1.9764292501230101</c:v>
                </c:pt>
                <c:pt idx="2052">
                  <c:v>1.90572451168679</c:v>
                </c:pt>
                <c:pt idx="2053">
                  <c:v>2.3497310692269902</c:v>
                </c:pt>
                <c:pt idx="2054">
                  <c:v>2.1079960102559201</c:v>
                </c:pt>
                <c:pt idx="2055">
                  <c:v>2.06745839604663</c:v>
                </c:pt>
                <c:pt idx="2056">
                  <c:v>2.27516158075729</c:v>
                </c:pt>
                <c:pt idx="2057">
                  <c:v>1.8818970005828</c:v>
                </c:pt>
                <c:pt idx="2058">
                  <c:v>2.5761589584054398</c:v>
                </c:pt>
                <c:pt idx="2059">
                  <c:v>1.74989476444476</c:v>
                </c:pt>
                <c:pt idx="2060">
                  <c:v>2.0839695114757202</c:v>
                </c:pt>
                <c:pt idx="2061">
                  <c:v>2.0363536850973998</c:v>
                </c:pt>
                <c:pt idx="2062">
                  <c:v>1.3613110968920199</c:v>
                </c:pt>
                <c:pt idx="2063">
                  <c:v>2.2138493841761702</c:v>
                </c:pt>
                <c:pt idx="2064">
                  <c:v>2.1638620883667801</c:v>
                </c:pt>
                <c:pt idx="2065">
                  <c:v>2.79341404808308</c:v>
                </c:pt>
                <c:pt idx="2066">
                  <c:v>2.3762745665367899</c:v>
                </c:pt>
                <c:pt idx="2067">
                  <c:v>2.35589125532664</c:v>
                </c:pt>
                <c:pt idx="2068">
                  <c:v>2.1879174386010201</c:v>
                </c:pt>
                <c:pt idx="2069">
                  <c:v>2.3491828727285902</c:v>
                </c:pt>
                <c:pt idx="2070">
                  <c:v>1.6874483204166999</c:v>
                </c:pt>
                <c:pt idx="2071">
                  <c:v>2.68639204934161</c:v>
                </c:pt>
                <c:pt idx="2072">
                  <c:v>2.39529705930974</c:v>
                </c:pt>
                <c:pt idx="2073">
                  <c:v>1.9427955246111701</c:v>
                </c:pt>
                <c:pt idx="2074">
                  <c:v>2.30403838179177</c:v>
                </c:pt>
                <c:pt idx="2075">
                  <c:v>2.1477929807120599</c:v>
                </c:pt>
                <c:pt idx="2076">
                  <c:v>2.2924287960470902</c:v>
                </c:pt>
                <c:pt idx="2077">
                  <c:v>1.6113264979047801</c:v>
                </c:pt>
                <c:pt idx="2078">
                  <c:v>1.6339276770354301</c:v>
                </c:pt>
                <c:pt idx="2079">
                  <c:v>2.2364218979400401</c:v>
                </c:pt>
                <c:pt idx="2080">
                  <c:v>2.2873994078459101</c:v>
                </c:pt>
                <c:pt idx="2081">
                  <c:v>1.7547357934388801</c:v>
                </c:pt>
                <c:pt idx="2082">
                  <c:v>1.60230048406514</c:v>
                </c:pt>
                <c:pt idx="2083">
                  <c:v>1.59447811416545</c:v>
                </c:pt>
                <c:pt idx="2084">
                  <c:v>2.3138355012369498</c:v>
                </c:pt>
                <c:pt idx="2085">
                  <c:v>2.0771540048855002</c:v>
                </c:pt>
                <c:pt idx="2086">
                  <c:v>1.65438322969401</c:v>
                </c:pt>
                <c:pt idx="2087">
                  <c:v>2.0042737472179901</c:v>
                </c:pt>
                <c:pt idx="2088">
                  <c:v>2.10899217703165</c:v>
                </c:pt>
                <c:pt idx="2089">
                  <c:v>2.7836199264935599</c:v>
                </c:pt>
                <c:pt idx="2090">
                  <c:v>1.6128985809074901</c:v>
                </c:pt>
                <c:pt idx="2091">
                  <c:v>1.66763706694028</c:v>
                </c:pt>
                <c:pt idx="2092">
                  <c:v>2.4238625466620101</c:v>
                </c:pt>
                <c:pt idx="2093">
                  <c:v>2.3953209290794399</c:v>
                </c:pt>
                <c:pt idx="2094">
                  <c:v>2.00614542490346</c:v>
                </c:pt>
                <c:pt idx="2095">
                  <c:v>2.4454535447394798</c:v>
                </c:pt>
                <c:pt idx="2096">
                  <c:v>3.1237840583553398</c:v>
                </c:pt>
                <c:pt idx="2097">
                  <c:v>3.0200330788529599</c:v>
                </c:pt>
                <c:pt idx="2098">
                  <c:v>2.14033551220124</c:v>
                </c:pt>
                <c:pt idx="2099">
                  <c:v>2.5466196981185201</c:v>
                </c:pt>
                <c:pt idx="2100">
                  <c:v>2.6083615586485598</c:v>
                </c:pt>
                <c:pt idx="2101">
                  <c:v>2.09658977745881</c:v>
                </c:pt>
                <c:pt idx="2102">
                  <c:v>1.7809103532542401</c:v>
                </c:pt>
                <c:pt idx="2103">
                  <c:v>1.9424271022278701</c:v>
                </c:pt>
                <c:pt idx="2104">
                  <c:v>2.3952321172415898</c:v>
                </c:pt>
                <c:pt idx="2105">
                  <c:v>1.74986823261354</c:v>
                </c:pt>
                <c:pt idx="2106">
                  <c:v>2.5719648475202801</c:v>
                </c:pt>
                <c:pt idx="2107">
                  <c:v>2.7063149217776199</c:v>
                </c:pt>
                <c:pt idx="2108">
                  <c:v>2.3779347735767402</c:v>
                </c:pt>
                <c:pt idx="2109">
                  <c:v>2.27425582922567</c:v>
                </c:pt>
                <c:pt idx="2110">
                  <c:v>2.4599523530340899</c:v>
                </c:pt>
                <c:pt idx="2111">
                  <c:v>2.8316485813593699</c:v>
                </c:pt>
                <c:pt idx="2112">
                  <c:v>3.3062828295693598</c:v>
                </c:pt>
                <c:pt idx="2113">
                  <c:v>2.7330831983074</c:v>
                </c:pt>
                <c:pt idx="2114">
                  <c:v>2.8961861488028302</c:v>
                </c:pt>
                <c:pt idx="2115">
                  <c:v>1.72461964084396</c:v>
                </c:pt>
                <c:pt idx="2116">
                  <c:v>2.2657119480568202</c:v>
                </c:pt>
                <c:pt idx="2117">
                  <c:v>2.8062317224948901</c:v>
                </c:pt>
                <c:pt idx="2118">
                  <c:v>2.5393531796277302</c:v>
                </c:pt>
                <c:pt idx="2119">
                  <c:v>2.7861724835505601</c:v>
                </c:pt>
                <c:pt idx="2120">
                  <c:v>2.7662944438979502</c:v>
                </c:pt>
                <c:pt idx="2121">
                  <c:v>3.0031628656080098</c:v>
                </c:pt>
                <c:pt idx="2122">
                  <c:v>2.6703208669495302</c:v>
                </c:pt>
                <c:pt idx="2123">
                  <c:v>2.1296330278435298</c:v>
                </c:pt>
                <c:pt idx="2124">
                  <c:v>2.1746232704659199</c:v>
                </c:pt>
                <c:pt idx="2125">
                  <c:v>2.6119565020103499</c:v>
                </c:pt>
                <c:pt idx="2126">
                  <c:v>2.2223518739444401</c:v>
                </c:pt>
                <c:pt idx="2127">
                  <c:v>2.5906476545413502</c:v>
                </c:pt>
                <c:pt idx="2128">
                  <c:v>3.2754061354734101</c:v>
                </c:pt>
                <c:pt idx="2129">
                  <c:v>3.0486393389341102</c:v>
                </c:pt>
                <c:pt idx="2130">
                  <c:v>3.05253847643989</c:v>
                </c:pt>
                <c:pt idx="2131">
                  <c:v>2.4650024864293498</c:v>
                </c:pt>
                <c:pt idx="2132">
                  <c:v>2.6403718248104702</c:v>
                </c:pt>
                <c:pt idx="2133">
                  <c:v>2.4985691728949502</c:v>
                </c:pt>
                <c:pt idx="2134">
                  <c:v>2.3804635914925898</c:v>
                </c:pt>
                <c:pt idx="2135">
                  <c:v>2.1158926509490001</c:v>
                </c:pt>
                <c:pt idx="2136">
                  <c:v>2.242483498041</c:v>
                </c:pt>
                <c:pt idx="2137">
                  <c:v>2.6117543025772001</c:v>
                </c:pt>
                <c:pt idx="2138">
                  <c:v>3.0730469744942601</c:v>
                </c:pt>
                <c:pt idx="2139">
                  <c:v>2.5715667530558699</c:v>
                </c:pt>
                <c:pt idx="2140">
                  <c:v>2.3611417312032801</c:v>
                </c:pt>
                <c:pt idx="2141">
                  <c:v>2.9180805855663299</c:v>
                </c:pt>
                <c:pt idx="2142">
                  <c:v>2.9768876269448499</c:v>
                </c:pt>
                <c:pt idx="2143">
                  <c:v>2.5762663754807602</c:v>
                </c:pt>
                <c:pt idx="2144">
                  <c:v>3.2606196856404299</c:v>
                </c:pt>
                <c:pt idx="2145">
                  <c:v>2.6048414602529602</c:v>
                </c:pt>
                <c:pt idx="2146">
                  <c:v>2.69899583235925</c:v>
                </c:pt>
                <c:pt idx="2147">
                  <c:v>3.01785747497672</c:v>
                </c:pt>
                <c:pt idx="2148">
                  <c:v>2.6569815247547699</c:v>
                </c:pt>
                <c:pt idx="2149">
                  <c:v>3.08316567804984</c:v>
                </c:pt>
                <c:pt idx="2150">
                  <c:v>2.8857372069340199</c:v>
                </c:pt>
                <c:pt idx="2151">
                  <c:v>2.8658775535086201</c:v>
                </c:pt>
                <c:pt idx="2152">
                  <c:v>2.3992548803601998</c:v>
                </c:pt>
                <c:pt idx="2153">
                  <c:v>2.6336991360868298</c:v>
                </c:pt>
                <c:pt idx="2154">
                  <c:v>1.87079735157422</c:v>
                </c:pt>
                <c:pt idx="2155">
                  <c:v>2.8230772531281998</c:v>
                </c:pt>
                <c:pt idx="2156">
                  <c:v>2.0687528180374302</c:v>
                </c:pt>
                <c:pt idx="2157">
                  <c:v>2.5483391684148899</c:v>
                </c:pt>
                <c:pt idx="2158">
                  <c:v>2.0877669398253902</c:v>
                </c:pt>
                <c:pt idx="2159">
                  <c:v>1.3533652049412701</c:v>
                </c:pt>
                <c:pt idx="2160">
                  <c:v>2.25066703633567</c:v>
                </c:pt>
                <c:pt idx="2161">
                  <c:v>2.1042937096810101</c:v>
                </c:pt>
                <c:pt idx="2162">
                  <c:v>2.7670266676523099</c:v>
                </c:pt>
                <c:pt idx="2163">
                  <c:v>2.2724717807004899</c:v>
                </c:pt>
                <c:pt idx="2164">
                  <c:v>1.9241810477961601</c:v>
                </c:pt>
                <c:pt idx="2165">
                  <c:v>2.3393521830864099</c:v>
                </c:pt>
                <c:pt idx="2166">
                  <c:v>1.9499802392723899</c:v>
                </c:pt>
                <c:pt idx="2167">
                  <c:v>2.0813925949333698</c:v>
                </c:pt>
                <c:pt idx="2168">
                  <c:v>2.0132011588181999</c:v>
                </c:pt>
                <c:pt idx="2169">
                  <c:v>1.9313044443082299</c:v>
                </c:pt>
                <c:pt idx="2170">
                  <c:v>1.39794347736522</c:v>
                </c:pt>
                <c:pt idx="2171">
                  <c:v>1.78850715654847</c:v>
                </c:pt>
                <c:pt idx="2172">
                  <c:v>2.0221082514507698</c:v>
                </c:pt>
                <c:pt idx="2173">
                  <c:v>2.3990369820924</c:v>
                </c:pt>
                <c:pt idx="2174">
                  <c:v>2.4002637618334601</c:v>
                </c:pt>
                <c:pt idx="2175">
                  <c:v>1.9176622368620699</c:v>
                </c:pt>
                <c:pt idx="2176">
                  <c:v>2.2176365897277299</c:v>
                </c:pt>
                <c:pt idx="2177">
                  <c:v>2.3851864634515101</c:v>
                </c:pt>
                <c:pt idx="2178">
                  <c:v>2.7165485904643099</c:v>
                </c:pt>
                <c:pt idx="2179">
                  <c:v>2.4060582757554401</c:v>
                </c:pt>
                <c:pt idx="2180">
                  <c:v>2.4222461579568502</c:v>
                </c:pt>
                <c:pt idx="2181">
                  <c:v>2.39009435126539</c:v>
                </c:pt>
                <c:pt idx="2182">
                  <c:v>1.90159941500973</c:v>
                </c:pt>
                <c:pt idx="2183">
                  <c:v>1.38159700427784</c:v>
                </c:pt>
                <c:pt idx="2184">
                  <c:v>2.4124583925249201</c:v>
                </c:pt>
                <c:pt idx="2185">
                  <c:v>2.2357192774176702</c:v>
                </c:pt>
                <c:pt idx="2186">
                  <c:v>3.0182925504571498</c:v>
                </c:pt>
                <c:pt idx="2187">
                  <c:v>2.7757285568983598</c:v>
                </c:pt>
                <c:pt idx="2188">
                  <c:v>2.6400108214101499</c:v>
                </c:pt>
                <c:pt idx="2189">
                  <c:v>2.8991812400347499</c:v>
                </c:pt>
                <c:pt idx="2190">
                  <c:v>2.9267394493118402</c:v>
                </c:pt>
                <c:pt idx="2191">
                  <c:v>2.584762836116</c:v>
                </c:pt>
                <c:pt idx="2192">
                  <c:v>2.2476853269411099</c:v>
                </c:pt>
                <c:pt idx="2193">
                  <c:v>2.9326621049847201</c:v>
                </c:pt>
                <c:pt idx="2194">
                  <c:v>3.00774412240373</c:v>
                </c:pt>
                <c:pt idx="2195">
                  <c:v>2.4587670376408801</c:v>
                </c:pt>
                <c:pt idx="2196">
                  <c:v>2.2031884557835801</c:v>
                </c:pt>
                <c:pt idx="2197">
                  <c:v>2.3461518885986501</c:v>
                </c:pt>
                <c:pt idx="2198">
                  <c:v>2.5564844907956701</c:v>
                </c:pt>
                <c:pt idx="2199">
                  <c:v>1.9609060169839301</c:v>
                </c:pt>
                <c:pt idx="2200">
                  <c:v>1.9086125594283501</c:v>
                </c:pt>
                <c:pt idx="2201">
                  <c:v>2.21362396252916</c:v>
                </c:pt>
                <c:pt idx="2202">
                  <c:v>1.30693950141195</c:v>
                </c:pt>
                <c:pt idx="2203">
                  <c:v>2.4281526258988202</c:v>
                </c:pt>
                <c:pt idx="2204">
                  <c:v>2.28798121435422</c:v>
                </c:pt>
                <c:pt idx="2205">
                  <c:v>2.8447266385887402</c:v>
                </c:pt>
                <c:pt idx="2206">
                  <c:v>2.3361556319054699</c:v>
                </c:pt>
                <c:pt idx="2207">
                  <c:v>2.2774818027967698</c:v>
                </c:pt>
                <c:pt idx="2208">
                  <c:v>2.11146496191733</c:v>
                </c:pt>
                <c:pt idx="2209">
                  <c:v>2.0251909850328098</c:v>
                </c:pt>
                <c:pt idx="2210">
                  <c:v>2.32309374400882</c:v>
                </c:pt>
                <c:pt idx="2211">
                  <c:v>1.9114300249624501</c:v>
                </c:pt>
                <c:pt idx="2212">
                  <c:v>2.5867566192740798</c:v>
                </c:pt>
                <c:pt idx="2213">
                  <c:v>2.63585359195985</c:v>
                </c:pt>
                <c:pt idx="2214">
                  <c:v>2.4547363791858601</c:v>
                </c:pt>
                <c:pt idx="2215">
                  <c:v>2.3019122126063598</c:v>
                </c:pt>
                <c:pt idx="2216">
                  <c:v>2.14283694508477</c:v>
                </c:pt>
                <c:pt idx="2217">
                  <c:v>2.4958292993768798</c:v>
                </c:pt>
                <c:pt idx="2218">
                  <c:v>2.0139337267199098</c:v>
                </c:pt>
                <c:pt idx="2219">
                  <c:v>2.41703703471785</c:v>
                </c:pt>
                <c:pt idx="2220">
                  <c:v>1.4965586484148501</c:v>
                </c:pt>
                <c:pt idx="2221">
                  <c:v>1.83223783173263</c:v>
                </c:pt>
                <c:pt idx="2222">
                  <c:v>2.1099077716008101</c:v>
                </c:pt>
                <c:pt idx="2223">
                  <c:v>2.1609510778516201</c:v>
                </c:pt>
                <c:pt idx="2224">
                  <c:v>2.1551395017705599</c:v>
                </c:pt>
                <c:pt idx="2225">
                  <c:v>2.3598230850221098</c:v>
                </c:pt>
                <c:pt idx="2226">
                  <c:v>2.79705111383223</c:v>
                </c:pt>
                <c:pt idx="2227">
                  <c:v>2.4467916002868901</c:v>
                </c:pt>
                <c:pt idx="2228">
                  <c:v>2.4752730149017999</c:v>
                </c:pt>
                <c:pt idx="2229">
                  <c:v>2.9938438294962602</c:v>
                </c:pt>
                <c:pt idx="2230">
                  <c:v>2.55647230141604</c:v>
                </c:pt>
                <c:pt idx="2231">
                  <c:v>2.30144185814475</c:v>
                </c:pt>
                <c:pt idx="2232">
                  <c:v>2.1087354321582299</c:v>
                </c:pt>
                <c:pt idx="2233">
                  <c:v>1.9987987759914101</c:v>
                </c:pt>
                <c:pt idx="2234">
                  <c:v>2.72615591285766</c:v>
                </c:pt>
                <c:pt idx="2235">
                  <c:v>2.9844844354035498</c:v>
                </c:pt>
                <c:pt idx="2236">
                  <c:v>3.19032650244622</c:v>
                </c:pt>
                <c:pt idx="2237">
                  <c:v>2.5805105277975402</c:v>
                </c:pt>
                <c:pt idx="2238">
                  <c:v>2.9194474169531102</c:v>
                </c:pt>
                <c:pt idx="2239">
                  <c:v>2.5499886439343298</c:v>
                </c:pt>
                <c:pt idx="2240">
                  <c:v>2.2020666588738802</c:v>
                </c:pt>
                <c:pt idx="2241">
                  <c:v>2.2882120927607801</c:v>
                </c:pt>
                <c:pt idx="2242">
                  <c:v>2.3946937627304101</c:v>
                </c:pt>
                <c:pt idx="2243">
                  <c:v>2.0471551778402302</c:v>
                </c:pt>
                <c:pt idx="2244">
                  <c:v>2.7700546960741801</c:v>
                </c:pt>
                <c:pt idx="2245">
                  <c:v>2.3074548388777498</c:v>
                </c:pt>
                <c:pt idx="2246">
                  <c:v>2.9936307669294302</c:v>
                </c:pt>
                <c:pt idx="2247">
                  <c:v>3.5328077952980599</c:v>
                </c:pt>
                <c:pt idx="2248">
                  <c:v>2.6853799405280201</c:v>
                </c:pt>
                <c:pt idx="2249">
                  <c:v>2.86931936245437</c:v>
                </c:pt>
                <c:pt idx="2250">
                  <c:v>2.7104232964185901</c:v>
                </c:pt>
                <c:pt idx="2251">
                  <c:v>2.3921578241278501</c:v>
                </c:pt>
                <c:pt idx="2252">
                  <c:v>2.9465263758791398</c:v>
                </c:pt>
                <c:pt idx="2253">
                  <c:v>3.0211015483396899</c:v>
                </c:pt>
                <c:pt idx="2254">
                  <c:v>2.83258026969142</c:v>
                </c:pt>
                <c:pt idx="2255">
                  <c:v>2.7576301219247301</c:v>
                </c:pt>
                <c:pt idx="2256">
                  <c:v>3.0042818542997201</c:v>
                </c:pt>
                <c:pt idx="2257">
                  <c:v>2.8074810860605099</c:v>
                </c:pt>
                <c:pt idx="2258">
                  <c:v>2.4896644699949402</c:v>
                </c:pt>
                <c:pt idx="2259">
                  <c:v>2.3971851274550602</c:v>
                </c:pt>
                <c:pt idx="2260">
                  <c:v>2.3042242958134498</c:v>
                </c:pt>
                <c:pt idx="2261">
                  <c:v>1.9590458055534601</c:v>
                </c:pt>
                <c:pt idx="2262">
                  <c:v>2.0095836762424701</c:v>
                </c:pt>
                <c:pt idx="2263">
                  <c:v>2.2139502722953499</c:v>
                </c:pt>
                <c:pt idx="2264">
                  <c:v>1.9782833258379899</c:v>
                </c:pt>
                <c:pt idx="2265">
                  <c:v>2.3985957214387699</c:v>
                </c:pt>
                <c:pt idx="2266">
                  <c:v>2.3798171694507402</c:v>
                </c:pt>
                <c:pt idx="2267">
                  <c:v>2.3330376627564999</c:v>
                </c:pt>
                <c:pt idx="2268">
                  <c:v>1.8385162736823399</c:v>
                </c:pt>
                <c:pt idx="2269">
                  <c:v>2.1269147330696598</c:v>
                </c:pt>
                <c:pt idx="2270">
                  <c:v>1.9399946297194099</c:v>
                </c:pt>
                <c:pt idx="2271">
                  <c:v>1.6439008341716701</c:v>
                </c:pt>
                <c:pt idx="2272">
                  <c:v>2.0562879865821801</c:v>
                </c:pt>
                <c:pt idx="2273">
                  <c:v>2.0450286880309698</c:v>
                </c:pt>
                <c:pt idx="2274">
                  <c:v>2.0158805009777598</c:v>
                </c:pt>
                <c:pt idx="2275">
                  <c:v>1.7784003830839901</c:v>
                </c:pt>
                <c:pt idx="2276">
                  <c:v>1.5554312713243801</c:v>
                </c:pt>
                <c:pt idx="2277">
                  <c:v>1.5924092885530301</c:v>
                </c:pt>
                <c:pt idx="2278">
                  <c:v>1.9116470769291101</c:v>
                </c:pt>
                <c:pt idx="2279">
                  <c:v>1.95215278278732</c:v>
                </c:pt>
                <c:pt idx="2280">
                  <c:v>2.0499956573692599</c:v>
                </c:pt>
                <c:pt idx="2281">
                  <c:v>1.4744608465760101</c:v>
                </c:pt>
                <c:pt idx="2282">
                  <c:v>1.93593362788159</c:v>
                </c:pt>
                <c:pt idx="2283">
                  <c:v>2.1625091390704898</c:v>
                </c:pt>
                <c:pt idx="2284">
                  <c:v>1.7815422527079401</c:v>
                </c:pt>
                <c:pt idx="2285">
                  <c:v>1.9375470020952399</c:v>
                </c:pt>
                <c:pt idx="2286">
                  <c:v>2.2572332487922799</c:v>
                </c:pt>
                <c:pt idx="2287">
                  <c:v>1.56098401536345</c:v>
                </c:pt>
                <c:pt idx="2288">
                  <c:v>1.7726830679907299</c:v>
                </c:pt>
                <c:pt idx="2289">
                  <c:v>1.9147967547204801</c:v>
                </c:pt>
                <c:pt idx="2290">
                  <c:v>1.7022473270519201</c:v>
                </c:pt>
                <c:pt idx="2291">
                  <c:v>2.0105425931318202</c:v>
                </c:pt>
                <c:pt idx="2292">
                  <c:v>1.38856530259864</c:v>
                </c:pt>
                <c:pt idx="2293">
                  <c:v>1.5386123462161301</c:v>
                </c:pt>
                <c:pt idx="2294">
                  <c:v>1.9430231480267599</c:v>
                </c:pt>
                <c:pt idx="2295">
                  <c:v>1.74000195741149</c:v>
                </c:pt>
                <c:pt idx="2296">
                  <c:v>1.90107530682052</c:v>
                </c:pt>
                <c:pt idx="2297">
                  <c:v>1.70257593119185</c:v>
                </c:pt>
                <c:pt idx="2298">
                  <c:v>1.5987166816695</c:v>
                </c:pt>
                <c:pt idx="2299">
                  <c:v>1.55624525086327</c:v>
                </c:pt>
                <c:pt idx="2300">
                  <c:v>1.2681845646005101</c:v>
                </c:pt>
                <c:pt idx="2301">
                  <c:v>2.5681240214249601</c:v>
                </c:pt>
                <c:pt idx="2302">
                  <c:v>1.4493085484515</c:v>
                </c:pt>
                <c:pt idx="2303">
                  <c:v>1.7845931191906601</c:v>
                </c:pt>
                <c:pt idx="2304">
                  <c:v>2.31211956994518</c:v>
                </c:pt>
                <c:pt idx="2305">
                  <c:v>1.8470472607427399</c:v>
                </c:pt>
                <c:pt idx="2306">
                  <c:v>1.07899313751244</c:v>
                </c:pt>
                <c:pt idx="2307">
                  <c:v>1.6142414261243401</c:v>
                </c:pt>
                <c:pt idx="2308">
                  <c:v>1.2397743757208499</c:v>
                </c:pt>
                <c:pt idx="2309">
                  <c:v>2.0796543085997099</c:v>
                </c:pt>
                <c:pt idx="2310">
                  <c:v>0.87482066911410095</c:v>
                </c:pt>
                <c:pt idx="2311">
                  <c:v>1.0391077348681099</c:v>
                </c:pt>
                <c:pt idx="2312">
                  <c:v>2.3172311268311998</c:v>
                </c:pt>
                <c:pt idx="2313">
                  <c:v>1.9376186561115001</c:v>
                </c:pt>
                <c:pt idx="2314">
                  <c:v>2.2872487881775498</c:v>
                </c:pt>
                <c:pt idx="2315">
                  <c:v>2.7577544224002799</c:v>
                </c:pt>
                <c:pt idx="2316">
                  <c:v>3.2237492856526799</c:v>
                </c:pt>
                <c:pt idx="2317">
                  <c:v>2.3107193361065699</c:v>
                </c:pt>
                <c:pt idx="2318">
                  <c:v>1.8776639865517399</c:v>
                </c:pt>
                <c:pt idx="2319">
                  <c:v>1.57930397011171</c:v>
                </c:pt>
                <c:pt idx="2320">
                  <c:v>2.04650221675975</c:v>
                </c:pt>
                <c:pt idx="2321">
                  <c:v>1.9316313180451199</c:v>
                </c:pt>
                <c:pt idx="2322">
                  <c:v>1.80986182836039</c:v>
                </c:pt>
                <c:pt idx="2323">
                  <c:v>1.5426735215427401</c:v>
                </c:pt>
                <c:pt idx="2324">
                  <c:v>1.6186823528038099</c:v>
                </c:pt>
                <c:pt idx="2325">
                  <c:v>2.2514223428497</c:v>
                </c:pt>
                <c:pt idx="2326">
                  <c:v>1.2799062380525199</c:v>
                </c:pt>
                <c:pt idx="2327">
                  <c:v>1.4191155296698801</c:v>
                </c:pt>
                <c:pt idx="2328">
                  <c:v>1.9710743353175899</c:v>
                </c:pt>
                <c:pt idx="2329">
                  <c:v>1.56987716624271</c:v>
                </c:pt>
                <c:pt idx="2330">
                  <c:v>2.0502376609038402</c:v>
                </c:pt>
                <c:pt idx="2331">
                  <c:v>2.40511769013998</c:v>
                </c:pt>
                <c:pt idx="2332">
                  <c:v>2.1545975438970499</c:v>
                </c:pt>
                <c:pt idx="2333">
                  <c:v>2.7700922459334598</c:v>
                </c:pt>
                <c:pt idx="2334">
                  <c:v>2.5624095881354099</c:v>
                </c:pt>
                <c:pt idx="2335">
                  <c:v>2.2327631041096798</c:v>
                </c:pt>
                <c:pt idx="2336">
                  <c:v>2.593850573084</c:v>
                </c:pt>
                <c:pt idx="2337">
                  <c:v>2.8502282192868602</c:v>
                </c:pt>
                <c:pt idx="2338">
                  <c:v>1.7028877113536001</c:v>
                </c:pt>
                <c:pt idx="2339">
                  <c:v>1.92291314874769</c:v>
                </c:pt>
                <c:pt idx="2340">
                  <c:v>2.1265248329665498</c:v>
                </c:pt>
                <c:pt idx="2341">
                  <c:v>2.6803808540410001</c:v>
                </c:pt>
                <c:pt idx="2342">
                  <c:v>2.22317971002207</c:v>
                </c:pt>
                <c:pt idx="2343">
                  <c:v>2.0816015023008401</c:v>
                </c:pt>
                <c:pt idx="2344">
                  <c:v>1.5927115764778099</c:v>
                </c:pt>
                <c:pt idx="2345">
                  <c:v>2.3235602401766799</c:v>
                </c:pt>
                <c:pt idx="2346">
                  <c:v>1.21787994405876</c:v>
                </c:pt>
                <c:pt idx="2347">
                  <c:v>1.78300745495462</c:v>
                </c:pt>
                <c:pt idx="2348">
                  <c:v>1.94894950150694</c:v>
                </c:pt>
                <c:pt idx="2349">
                  <c:v>2.19306009763006</c:v>
                </c:pt>
                <c:pt idx="2350">
                  <c:v>1.96466576217789</c:v>
                </c:pt>
                <c:pt idx="2351">
                  <c:v>2.0347717404614301</c:v>
                </c:pt>
                <c:pt idx="2352">
                  <c:v>2.3835733587233801</c:v>
                </c:pt>
                <c:pt idx="2353">
                  <c:v>2.2454573856949702</c:v>
                </c:pt>
                <c:pt idx="2354">
                  <c:v>1.82555254533986</c:v>
                </c:pt>
                <c:pt idx="2355">
                  <c:v>2.14048930997579</c:v>
                </c:pt>
                <c:pt idx="2356">
                  <c:v>1.74474028696941</c:v>
                </c:pt>
                <c:pt idx="2357">
                  <c:v>1.4541878698761399</c:v>
                </c:pt>
                <c:pt idx="2358">
                  <c:v>2.1057679323068799</c:v>
                </c:pt>
                <c:pt idx="2359">
                  <c:v>2.3270610868685999</c:v>
                </c:pt>
                <c:pt idx="2360">
                  <c:v>2.2965859806240099</c:v>
                </c:pt>
                <c:pt idx="2361">
                  <c:v>2.3789284789770901</c:v>
                </c:pt>
                <c:pt idx="2362">
                  <c:v>1.89364796160885</c:v>
                </c:pt>
                <c:pt idx="2363">
                  <c:v>2.54645984224031</c:v>
                </c:pt>
                <c:pt idx="2364">
                  <c:v>2.4964726838367501</c:v>
                </c:pt>
                <c:pt idx="2365">
                  <c:v>2.19127287407313</c:v>
                </c:pt>
                <c:pt idx="2366">
                  <c:v>2.4501213576727201</c:v>
                </c:pt>
                <c:pt idx="2367">
                  <c:v>2.49864650027363</c:v>
                </c:pt>
                <c:pt idx="2368">
                  <c:v>1.6003906589339301</c:v>
                </c:pt>
                <c:pt idx="2369">
                  <c:v>1.7101676653609901</c:v>
                </c:pt>
                <c:pt idx="2370">
                  <c:v>1.6894091146138801</c:v>
                </c:pt>
                <c:pt idx="2371">
                  <c:v>1.9766585032261099</c:v>
                </c:pt>
                <c:pt idx="2372">
                  <c:v>2.1288411671020402</c:v>
                </c:pt>
                <c:pt idx="2373">
                  <c:v>2.1638580656538702</c:v>
                </c:pt>
                <c:pt idx="2374">
                  <c:v>2.09221013098206</c:v>
                </c:pt>
                <c:pt idx="2375">
                  <c:v>1.9704991954150599</c:v>
                </c:pt>
                <c:pt idx="2376">
                  <c:v>1.6748423692013801</c:v>
                </c:pt>
                <c:pt idx="2377">
                  <c:v>1.9245613663330301</c:v>
                </c:pt>
                <c:pt idx="2378">
                  <c:v>2.25396746318797</c:v>
                </c:pt>
                <c:pt idx="2379">
                  <c:v>2.8191061723178201</c:v>
                </c:pt>
                <c:pt idx="2380">
                  <c:v>2.36433415380895</c:v>
                </c:pt>
                <c:pt idx="2381">
                  <c:v>2.5223036406783601</c:v>
                </c:pt>
                <c:pt idx="2382">
                  <c:v>1.80265827860846</c:v>
                </c:pt>
                <c:pt idx="2383">
                  <c:v>2.7183151349147701</c:v>
                </c:pt>
                <c:pt idx="2384">
                  <c:v>2.5030653535352201</c:v>
                </c:pt>
                <c:pt idx="2385">
                  <c:v>2.3530038190967599</c:v>
                </c:pt>
                <c:pt idx="2386">
                  <c:v>2.4795949926824701</c:v>
                </c:pt>
                <c:pt idx="2387">
                  <c:v>2.1964747597786101</c:v>
                </c:pt>
                <c:pt idx="2388">
                  <c:v>2.0147492202275998</c:v>
                </c:pt>
                <c:pt idx="2389">
                  <c:v>1.8772161012593001</c:v>
                </c:pt>
                <c:pt idx="2390">
                  <c:v>2.6182193889711698</c:v>
                </c:pt>
                <c:pt idx="2391">
                  <c:v>3.12905639445454</c:v>
                </c:pt>
                <c:pt idx="2392">
                  <c:v>2.8877913720889601</c:v>
                </c:pt>
                <c:pt idx="2393">
                  <c:v>2.9137726223458502</c:v>
                </c:pt>
                <c:pt idx="2394">
                  <c:v>2.6133188129774698</c:v>
                </c:pt>
                <c:pt idx="2395">
                  <c:v>1.9303410150175999</c:v>
                </c:pt>
                <c:pt idx="2396">
                  <c:v>1.9997641457083599</c:v>
                </c:pt>
                <c:pt idx="2397">
                  <c:v>2.6946147898696799</c:v>
                </c:pt>
                <c:pt idx="2398">
                  <c:v>2.5702019436606198</c:v>
                </c:pt>
                <c:pt idx="2399">
                  <c:v>3.2554849051105501</c:v>
                </c:pt>
                <c:pt idx="2400">
                  <c:v>2.5390836886826098</c:v>
                </c:pt>
                <c:pt idx="2401">
                  <c:v>2.51814064481627</c:v>
                </c:pt>
                <c:pt idx="2402">
                  <c:v>2.718665017832</c:v>
                </c:pt>
                <c:pt idx="2403">
                  <c:v>3.2799480511886201</c:v>
                </c:pt>
                <c:pt idx="2404">
                  <c:v>2.4576592464220202</c:v>
                </c:pt>
                <c:pt idx="2405">
                  <c:v>2.5574442967049298</c:v>
                </c:pt>
                <c:pt idx="2406">
                  <c:v>2.7556834227504599</c:v>
                </c:pt>
                <c:pt idx="2407">
                  <c:v>2.2847388814212302</c:v>
                </c:pt>
                <c:pt idx="2408">
                  <c:v>2.0814892148720299</c:v>
                </c:pt>
                <c:pt idx="2409">
                  <c:v>1.96626979507738</c:v>
                </c:pt>
                <c:pt idx="2410">
                  <c:v>2.21295008328915</c:v>
                </c:pt>
                <c:pt idx="2411">
                  <c:v>2.6650159964301898</c:v>
                </c:pt>
                <c:pt idx="2412">
                  <c:v>3.4139246538713999</c:v>
                </c:pt>
                <c:pt idx="2413">
                  <c:v>1.9353007134751801</c:v>
                </c:pt>
                <c:pt idx="2414">
                  <c:v>2.72875256663488</c:v>
                </c:pt>
                <c:pt idx="2415">
                  <c:v>2.50219769140271</c:v>
                </c:pt>
                <c:pt idx="2416">
                  <c:v>1.89305712949612</c:v>
                </c:pt>
                <c:pt idx="2417">
                  <c:v>2.6234426640961499</c:v>
                </c:pt>
                <c:pt idx="2418">
                  <c:v>2.6426485536422</c:v>
                </c:pt>
                <c:pt idx="2419">
                  <c:v>2.97541980140694</c:v>
                </c:pt>
                <c:pt idx="2420">
                  <c:v>2.70713452535069</c:v>
                </c:pt>
                <c:pt idx="2421">
                  <c:v>2.77263221197031</c:v>
                </c:pt>
                <c:pt idx="2422">
                  <c:v>3.1413565141228199</c:v>
                </c:pt>
                <c:pt idx="2423">
                  <c:v>2.5601216403459</c:v>
                </c:pt>
                <c:pt idx="2424">
                  <c:v>2.50751929227782</c:v>
                </c:pt>
                <c:pt idx="2425">
                  <c:v>2.40967099309914</c:v>
                </c:pt>
                <c:pt idx="2426">
                  <c:v>2.2811608568254398</c:v>
                </c:pt>
                <c:pt idx="2427">
                  <c:v>2.9825368180021998</c:v>
                </c:pt>
                <c:pt idx="2428">
                  <c:v>2.5793030914230801</c:v>
                </c:pt>
                <c:pt idx="2429">
                  <c:v>2.61566559366939</c:v>
                </c:pt>
                <c:pt idx="2430">
                  <c:v>2.1078858820087301</c:v>
                </c:pt>
                <c:pt idx="2431">
                  <c:v>2.5072656120269601</c:v>
                </c:pt>
                <c:pt idx="2432">
                  <c:v>2.3170606058468102</c:v>
                </c:pt>
                <c:pt idx="2433">
                  <c:v>2.65701521708543</c:v>
                </c:pt>
                <c:pt idx="2434">
                  <c:v>2.6279706918190202</c:v>
                </c:pt>
                <c:pt idx="2435">
                  <c:v>2.9802383361014</c:v>
                </c:pt>
                <c:pt idx="2436">
                  <c:v>2.5100082570401798</c:v>
                </c:pt>
                <c:pt idx="2437">
                  <c:v>2.6676129674902098</c:v>
                </c:pt>
                <c:pt idx="2438">
                  <c:v>2.72828591081689</c:v>
                </c:pt>
                <c:pt idx="2439">
                  <c:v>2.2568850902943201</c:v>
                </c:pt>
                <c:pt idx="2440">
                  <c:v>2.89653452566129</c:v>
                </c:pt>
                <c:pt idx="2441">
                  <c:v>2.5628260801386902</c:v>
                </c:pt>
                <c:pt idx="2442">
                  <c:v>1.9253987361493401</c:v>
                </c:pt>
                <c:pt idx="2443">
                  <c:v>2.0249360524158702</c:v>
                </c:pt>
                <c:pt idx="2444">
                  <c:v>2.4362539783359201</c:v>
                </c:pt>
                <c:pt idx="2445">
                  <c:v>2.8092888962932201</c:v>
                </c:pt>
                <c:pt idx="2446">
                  <c:v>2.25265149255265</c:v>
                </c:pt>
                <c:pt idx="2447">
                  <c:v>2.2989090445698799</c:v>
                </c:pt>
                <c:pt idx="2448">
                  <c:v>2.8411301996859102</c:v>
                </c:pt>
                <c:pt idx="2449">
                  <c:v>2.3928347072893299</c:v>
                </c:pt>
                <c:pt idx="2450">
                  <c:v>2.4390977197866301</c:v>
                </c:pt>
                <c:pt idx="2451">
                  <c:v>1.7105821131885</c:v>
                </c:pt>
                <c:pt idx="2452">
                  <c:v>1.6979618564502801</c:v>
                </c:pt>
                <c:pt idx="2453">
                  <c:v>2.0099484150198701</c:v>
                </c:pt>
                <c:pt idx="2454">
                  <c:v>2.3592704205990001</c:v>
                </c:pt>
                <c:pt idx="2455">
                  <c:v>2.5496218379815501</c:v>
                </c:pt>
                <c:pt idx="2456">
                  <c:v>2.5088340836780398</c:v>
                </c:pt>
                <c:pt idx="2457">
                  <c:v>2.9129480557669298</c:v>
                </c:pt>
                <c:pt idx="2458">
                  <c:v>2.33349744242736</c:v>
                </c:pt>
                <c:pt idx="2459">
                  <c:v>2.6640698612986</c:v>
                </c:pt>
                <c:pt idx="2460">
                  <c:v>2.7018469524751998</c:v>
                </c:pt>
                <c:pt idx="2461">
                  <c:v>2.3892649040162999</c:v>
                </c:pt>
                <c:pt idx="2462">
                  <c:v>2.30959132611392</c:v>
                </c:pt>
                <c:pt idx="2463">
                  <c:v>2.80448856773697</c:v>
                </c:pt>
                <c:pt idx="2464">
                  <c:v>2.96916424742767</c:v>
                </c:pt>
                <c:pt idx="2465">
                  <c:v>2.05582586605914</c:v>
                </c:pt>
                <c:pt idx="2466">
                  <c:v>2.2002407076303401</c:v>
                </c:pt>
                <c:pt idx="2467">
                  <c:v>2.1190336021752301</c:v>
                </c:pt>
                <c:pt idx="2468">
                  <c:v>2.2433368405841301</c:v>
                </c:pt>
                <c:pt idx="2469">
                  <c:v>2.6120888675987</c:v>
                </c:pt>
                <c:pt idx="2470">
                  <c:v>2.9823521327056901</c:v>
                </c:pt>
                <c:pt idx="2471">
                  <c:v>2.13203101075035</c:v>
                </c:pt>
                <c:pt idx="2472">
                  <c:v>1.9448849794396801</c:v>
                </c:pt>
                <c:pt idx="2473">
                  <c:v>2.6204684515917598</c:v>
                </c:pt>
                <c:pt idx="2474">
                  <c:v>2.4396718967347599</c:v>
                </c:pt>
                <c:pt idx="2475">
                  <c:v>2.4330377579309799</c:v>
                </c:pt>
                <c:pt idx="2476">
                  <c:v>2.6205375721024802</c:v>
                </c:pt>
                <c:pt idx="2477">
                  <c:v>1.6751409066316201</c:v>
                </c:pt>
                <c:pt idx="2478">
                  <c:v>1.32376961028787</c:v>
                </c:pt>
                <c:pt idx="2479">
                  <c:v>1.62981967601871</c:v>
                </c:pt>
                <c:pt idx="2480">
                  <c:v>1.13145132818118</c:v>
                </c:pt>
                <c:pt idx="2481">
                  <c:v>1.5531886537800099</c:v>
                </c:pt>
                <c:pt idx="2482">
                  <c:v>1.33808399081079</c:v>
                </c:pt>
                <c:pt idx="2483">
                  <c:v>1.2710307101657099</c:v>
                </c:pt>
                <c:pt idx="2484">
                  <c:v>1.33984675661535</c:v>
                </c:pt>
                <c:pt idx="2485">
                  <c:v>1.606146444523</c:v>
                </c:pt>
                <c:pt idx="2486">
                  <c:v>1.18288898927839</c:v>
                </c:pt>
                <c:pt idx="2487">
                  <c:v>2.0215132212599398</c:v>
                </c:pt>
                <c:pt idx="2488">
                  <c:v>0.84591657360596195</c:v>
                </c:pt>
                <c:pt idx="2489">
                  <c:v>1.75930806264716</c:v>
                </c:pt>
                <c:pt idx="2490">
                  <c:v>2.19680256917054</c:v>
                </c:pt>
                <c:pt idx="2491">
                  <c:v>1.86581542933973</c:v>
                </c:pt>
                <c:pt idx="2492">
                  <c:v>1.73869421583568</c:v>
                </c:pt>
                <c:pt idx="2493">
                  <c:v>1.87157038394132</c:v>
                </c:pt>
                <c:pt idx="2494">
                  <c:v>1.6477601534005299</c:v>
                </c:pt>
                <c:pt idx="2495">
                  <c:v>1.9865455334114499</c:v>
                </c:pt>
                <c:pt idx="2496">
                  <c:v>2.4045946460069101</c:v>
                </c:pt>
                <c:pt idx="2497">
                  <c:v>1.3367380453547599</c:v>
                </c:pt>
                <c:pt idx="2498">
                  <c:v>1.07482398741958</c:v>
                </c:pt>
                <c:pt idx="2499">
                  <c:v>1.7112521966294501</c:v>
                </c:pt>
                <c:pt idx="2500">
                  <c:v>1.52914767051534</c:v>
                </c:pt>
                <c:pt idx="2501">
                  <c:v>1.21326814574842</c:v>
                </c:pt>
                <c:pt idx="2502">
                  <c:v>1.33320358492567</c:v>
                </c:pt>
                <c:pt idx="2503">
                  <c:v>2.1801714225700901</c:v>
                </c:pt>
                <c:pt idx="2504">
                  <c:v>1.3075865011866299</c:v>
                </c:pt>
                <c:pt idx="2505">
                  <c:v>1.6527858573443199</c:v>
                </c:pt>
                <c:pt idx="2506">
                  <c:v>2.6040580003390801</c:v>
                </c:pt>
                <c:pt idx="2507">
                  <c:v>1.89561435498558</c:v>
                </c:pt>
                <c:pt idx="2508">
                  <c:v>2.24507497970342</c:v>
                </c:pt>
                <c:pt idx="2509">
                  <c:v>1.7469277454460399</c:v>
                </c:pt>
                <c:pt idx="2510">
                  <c:v>1.88375801871816</c:v>
                </c:pt>
                <c:pt idx="2511">
                  <c:v>1.86895573277244</c:v>
                </c:pt>
                <c:pt idx="2512">
                  <c:v>1.9047522820065601</c:v>
                </c:pt>
                <c:pt idx="2513">
                  <c:v>2.1450792805762</c:v>
                </c:pt>
                <c:pt idx="2514">
                  <c:v>2.2356906662305098</c:v>
                </c:pt>
                <c:pt idx="2515">
                  <c:v>2.1144329470393699</c:v>
                </c:pt>
                <c:pt idx="2516">
                  <c:v>2.1223241502749701</c:v>
                </c:pt>
                <c:pt idx="2517">
                  <c:v>1.8954718688453001</c:v>
                </c:pt>
                <c:pt idx="2518">
                  <c:v>1.69165010803847</c:v>
                </c:pt>
                <c:pt idx="2519">
                  <c:v>1.67780784080826</c:v>
                </c:pt>
                <c:pt idx="2520">
                  <c:v>2.3361031405851298</c:v>
                </c:pt>
                <c:pt idx="2521">
                  <c:v>2.2084721743981102</c:v>
                </c:pt>
                <c:pt idx="2522">
                  <c:v>2.1910012244588799</c:v>
                </c:pt>
                <c:pt idx="2523">
                  <c:v>2.1451615781929698</c:v>
                </c:pt>
                <c:pt idx="2524">
                  <c:v>2.2889008114164202</c:v>
                </c:pt>
                <c:pt idx="2525">
                  <c:v>1.9922339839680001</c:v>
                </c:pt>
                <c:pt idx="2526">
                  <c:v>1.724247660793</c:v>
                </c:pt>
                <c:pt idx="2527">
                  <c:v>2.06590837465003</c:v>
                </c:pt>
                <c:pt idx="2528">
                  <c:v>1.9152598978917099</c:v>
                </c:pt>
                <c:pt idx="2529">
                  <c:v>2.2319332808555399</c:v>
                </c:pt>
                <c:pt idx="2530">
                  <c:v>2.07466107981642</c:v>
                </c:pt>
                <c:pt idx="2531">
                  <c:v>1.49237920566454</c:v>
                </c:pt>
                <c:pt idx="2532">
                  <c:v>2.3253225373642699</c:v>
                </c:pt>
                <c:pt idx="2533">
                  <c:v>1.5849920338899099</c:v>
                </c:pt>
                <c:pt idx="2534">
                  <c:v>1.8427379925441201</c:v>
                </c:pt>
                <c:pt idx="2535">
                  <c:v>1.59609467559258</c:v>
                </c:pt>
                <c:pt idx="2536">
                  <c:v>1.50346263990912</c:v>
                </c:pt>
                <c:pt idx="2537">
                  <c:v>2.50784587508404</c:v>
                </c:pt>
                <c:pt idx="2538">
                  <c:v>2.31454718002463</c:v>
                </c:pt>
                <c:pt idx="2539">
                  <c:v>2.1556173207674401</c:v>
                </c:pt>
                <c:pt idx="2540">
                  <c:v>2.4271912561090399</c:v>
                </c:pt>
                <c:pt idx="2541">
                  <c:v>2.1377372863789601</c:v>
                </c:pt>
                <c:pt idx="2542">
                  <c:v>2.33539850080225</c:v>
                </c:pt>
                <c:pt idx="2543">
                  <c:v>2.1078265983589999</c:v>
                </c:pt>
                <c:pt idx="2544">
                  <c:v>2.1784175323505499</c:v>
                </c:pt>
                <c:pt idx="2545">
                  <c:v>1.8396974778308499</c:v>
                </c:pt>
                <c:pt idx="2546">
                  <c:v>1.6797376677532001</c:v>
                </c:pt>
                <c:pt idx="2547">
                  <c:v>2.0980332270785298</c:v>
                </c:pt>
                <c:pt idx="2548">
                  <c:v>2.5676472318771402</c:v>
                </c:pt>
                <c:pt idx="2549">
                  <c:v>1.88056819417961</c:v>
                </c:pt>
                <c:pt idx="2550">
                  <c:v>1.8887544495341699</c:v>
                </c:pt>
                <c:pt idx="2551">
                  <c:v>1.6657193794687899</c:v>
                </c:pt>
                <c:pt idx="2552">
                  <c:v>1.9546614100928801</c:v>
                </c:pt>
                <c:pt idx="2553">
                  <c:v>2.00710277029382</c:v>
                </c:pt>
                <c:pt idx="2554">
                  <c:v>1.10739712239902</c:v>
                </c:pt>
                <c:pt idx="2555">
                  <c:v>1.4770413117187799</c:v>
                </c:pt>
                <c:pt idx="2556">
                  <c:v>1.0679674641755199</c:v>
                </c:pt>
                <c:pt idx="2557">
                  <c:v>1.50596215037862</c:v>
                </c:pt>
                <c:pt idx="2558">
                  <c:v>1.9060502856291199</c:v>
                </c:pt>
                <c:pt idx="2559">
                  <c:v>1.3761623756419199</c:v>
                </c:pt>
                <c:pt idx="2560">
                  <c:v>0.929653371687307</c:v>
                </c:pt>
                <c:pt idx="2561">
                  <c:v>1.17310024105116</c:v>
                </c:pt>
                <c:pt idx="2562">
                  <c:v>2.27768049907491</c:v>
                </c:pt>
                <c:pt idx="2563">
                  <c:v>1.8049524205201499</c:v>
                </c:pt>
                <c:pt idx="2564">
                  <c:v>1.13085008783425</c:v>
                </c:pt>
                <c:pt idx="2565">
                  <c:v>1.9071449829982901</c:v>
                </c:pt>
                <c:pt idx="2566">
                  <c:v>1.37906064355106</c:v>
                </c:pt>
                <c:pt idx="2567">
                  <c:v>1.64303329774582</c:v>
                </c:pt>
                <c:pt idx="2568">
                  <c:v>1.9021231756130399</c:v>
                </c:pt>
                <c:pt idx="2569">
                  <c:v>1.8387737737659999</c:v>
                </c:pt>
                <c:pt idx="2570">
                  <c:v>2.0586878869863301</c:v>
                </c:pt>
                <c:pt idx="2571">
                  <c:v>1.9819004888752201</c:v>
                </c:pt>
                <c:pt idx="2572">
                  <c:v>1.65936657479856</c:v>
                </c:pt>
                <c:pt idx="2573">
                  <c:v>1.9242116244816001</c:v>
                </c:pt>
                <c:pt idx="2574">
                  <c:v>2.1014917229987899</c:v>
                </c:pt>
                <c:pt idx="2575">
                  <c:v>1.8314140133154899</c:v>
                </c:pt>
                <c:pt idx="2576">
                  <c:v>0.89150854436173499</c:v>
                </c:pt>
                <c:pt idx="2577">
                  <c:v>0.94594840719990603</c:v>
                </c:pt>
                <c:pt idx="2578">
                  <c:v>0.60008682875594299</c:v>
                </c:pt>
                <c:pt idx="2579">
                  <c:v>1.1405012721105401</c:v>
                </c:pt>
                <c:pt idx="2580">
                  <c:v>0.85399860835048802</c:v>
                </c:pt>
                <c:pt idx="2581">
                  <c:v>0.77364345889319397</c:v>
                </c:pt>
                <c:pt idx="2582">
                  <c:v>0.78232927947252195</c:v>
                </c:pt>
                <c:pt idx="2583">
                  <c:v>0.72657751284072702</c:v>
                </c:pt>
                <c:pt idx="2584">
                  <c:v>0.86931822959375604</c:v>
                </c:pt>
                <c:pt idx="2585">
                  <c:v>0.64306128720510802</c:v>
                </c:pt>
                <c:pt idx="2586">
                  <c:v>1.22604885252885</c:v>
                </c:pt>
                <c:pt idx="2587">
                  <c:v>0.96780597822200898</c:v>
                </c:pt>
                <c:pt idx="2588">
                  <c:v>0.87837141368152905</c:v>
                </c:pt>
                <c:pt idx="2589">
                  <c:v>0.37579945916318003</c:v>
                </c:pt>
                <c:pt idx="2590">
                  <c:v>1.9117453523766099</c:v>
                </c:pt>
                <c:pt idx="2591">
                  <c:v>0.701211804489698</c:v>
                </c:pt>
                <c:pt idx="2592">
                  <c:v>1.3704494749939899</c:v>
                </c:pt>
                <c:pt idx="2593">
                  <c:v>0.76967837902492697</c:v>
                </c:pt>
                <c:pt idx="2594">
                  <c:v>0.91573689959581706</c:v>
                </c:pt>
                <c:pt idx="2595">
                  <c:v>1.4705993150311301</c:v>
                </c:pt>
                <c:pt idx="2596">
                  <c:v>0.91458014517425301</c:v>
                </c:pt>
                <c:pt idx="2597">
                  <c:v>1.14959884623798</c:v>
                </c:pt>
                <c:pt idx="2598">
                  <c:v>1.1901143422076601</c:v>
                </c:pt>
                <c:pt idx="2599">
                  <c:v>1.5092011619493999</c:v>
                </c:pt>
                <c:pt idx="2600">
                  <c:v>1.38974975030314</c:v>
                </c:pt>
                <c:pt idx="2601">
                  <c:v>1.4763269705239299</c:v>
                </c:pt>
                <c:pt idx="2602">
                  <c:v>1.19522214464216</c:v>
                </c:pt>
                <c:pt idx="2603">
                  <c:v>1.6375511944362799</c:v>
                </c:pt>
                <c:pt idx="2604">
                  <c:v>1.1457337147214799</c:v>
                </c:pt>
                <c:pt idx="2605">
                  <c:v>1.3848611169868099</c:v>
                </c:pt>
                <c:pt idx="2606">
                  <c:v>1.5606951738738399</c:v>
                </c:pt>
                <c:pt idx="2607">
                  <c:v>1.27319531743432</c:v>
                </c:pt>
                <c:pt idx="2608">
                  <c:v>1.6360434714494401</c:v>
                </c:pt>
                <c:pt idx="2609">
                  <c:v>1.6540953213524201</c:v>
                </c:pt>
                <c:pt idx="2610">
                  <c:v>1.5883760827211699</c:v>
                </c:pt>
                <c:pt idx="2611">
                  <c:v>1.9501390728646</c:v>
                </c:pt>
                <c:pt idx="2612">
                  <c:v>1.5938675834468301</c:v>
                </c:pt>
                <c:pt idx="2613">
                  <c:v>1.18486486857755</c:v>
                </c:pt>
                <c:pt idx="2614">
                  <c:v>1.80125369762195</c:v>
                </c:pt>
                <c:pt idx="2615">
                  <c:v>1.7258774037628899</c:v>
                </c:pt>
                <c:pt idx="2616">
                  <c:v>2.00957158285861</c:v>
                </c:pt>
                <c:pt idx="2617">
                  <c:v>2.0009357485044998</c:v>
                </c:pt>
                <c:pt idx="2618">
                  <c:v>1.7373276003095299</c:v>
                </c:pt>
                <c:pt idx="2619">
                  <c:v>1.8280926061941201</c:v>
                </c:pt>
                <c:pt idx="2620">
                  <c:v>2.1369148993225702</c:v>
                </c:pt>
                <c:pt idx="2621">
                  <c:v>1.63995670856747</c:v>
                </c:pt>
                <c:pt idx="2622">
                  <c:v>1.4412012076132299</c:v>
                </c:pt>
                <c:pt idx="2623">
                  <c:v>1.6085302881805801</c:v>
                </c:pt>
                <c:pt idx="2624">
                  <c:v>1.93489125635006</c:v>
                </c:pt>
                <c:pt idx="2625">
                  <c:v>1.9163236673939199</c:v>
                </c:pt>
                <c:pt idx="2626">
                  <c:v>2.00241636329427</c:v>
                </c:pt>
                <c:pt idx="2627">
                  <c:v>1.7722001144492401</c:v>
                </c:pt>
                <c:pt idx="2628">
                  <c:v>1.57605846352905</c:v>
                </c:pt>
                <c:pt idx="2629">
                  <c:v>1.2177329436565201</c:v>
                </c:pt>
                <c:pt idx="2630">
                  <c:v>1.6470096626442601</c:v>
                </c:pt>
                <c:pt idx="2631">
                  <c:v>1.83609868512817</c:v>
                </c:pt>
                <c:pt idx="2632">
                  <c:v>2.3537831862101699</c:v>
                </c:pt>
                <c:pt idx="2633">
                  <c:v>1.98817649005396</c:v>
                </c:pt>
                <c:pt idx="2634">
                  <c:v>1.82715705685862</c:v>
                </c:pt>
                <c:pt idx="2635">
                  <c:v>1.44989659011475</c:v>
                </c:pt>
                <c:pt idx="2636">
                  <c:v>2.18879598957386</c:v>
                </c:pt>
                <c:pt idx="2637">
                  <c:v>1.64955020635648</c:v>
                </c:pt>
                <c:pt idx="2638">
                  <c:v>1.7935285269204699</c:v>
                </c:pt>
                <c:pt idx="2639">
                  <c:v>1.7885735586875</c:v>
                </c:pt>
                <c:pt idx="2640">
                  <c:v>1.8741307714471001</c:v>
                </c:pt>
                <c:pt idx="2641">
                  <c:v>1.5150166817536199</c:v>
                </c:pt>
                <c:pt idx="2642">
                  <c:v>1.12219796401712</c:v>
                </c:pt>
                <c:pt idx="2643">
                  <c:v>1.63653972696604</c:v>
                </c:pt>
                <c:pt idx="2644">
                  <c:v>1.585923597286</c:v>
                </c:pt>
                <c:pt idx="2645">
                  <c:v>1.71565784594529</c:v>
                </c:pt>
                <c:pt idx="2646">
                  <c:v>1.45243054142701</c:v>
                </c:pt>
                <c:pt idx="2647">
                  <c:v>1.3808454245517401</c:v>
                </c:pt>
                <c:pt idx="2648">
                  <c:v>2.0661624548045601</c:v>
                </c:pt>
                <c:pt idx="2649">
                  <c:v>1.16331362156546</c:v>
                </c:pt>
                <c:pt idx="2650">
                  <c:v>1.5310136334145901</c:v>
                </c:pt>
                <c:pt idx="2651">
                  <c:v>2.17860974138837</c:v>
                </c:pt>
                <c:pt idx="2652">
                  <c:v>1.7391286002845601</c:v>
                </c:pt>
                <c:pt idx="2653">
                  <c:v>1.55352837850082</c:v>
                </c:pt>
                <c:pt idx="2654">
                  <c:v>1.10541996426106</c:v>
                </c:pt>
                <c:pt idx="2655">
                  <c:v>1.57777958149668</c:v>
                </c:pt>
                <c:pt idx="2656">
                  <c:v>1.1861385811193501</c:v>
                </c:pt>
                <c:pt idx="2657">
                  <c:v>1.79164746664801</c:v>
                </c:pt>
                <c:pt idx="2658">
                  <c:v>1.83983868424703</c:v>
                </c:pt>
                <c:pt idx="2659">
                  <c:v>1.7408184920123</c:v>
                </c:pt>
                <c:pt idx="2660">
                  <c:v>1.9612841554858</c:v>
                </c:pt>
                <c:pt idx="2661">
                  <c:v>1.35411982638568</c:v>
                </c:pt>
                <c:pt idx="2662">
                  <c:v>1.69978527798118</c:v>
                </c:pt>
                <c:pt idx="2663">
                  <c:v>2.03981151774006</c:v>
                </c:pt>
                <c:pt idx="2664">
                  <c:v>1.6935256398940699</c:v>
                </c:pt>
                <c:pt idx="2665">
                  <c:v>2.0458112185466901</c:v>
                </c:pt>
                <c:pt idx="2666">
                  <c:v>0.68718735910523898</c:v>
                </c:pt>
                <c:pt idx="2667">
                  <c:v>1.26045613012768</c:v>
                </c:pt>
                <c:pt idx="2668">
                  <c:v>2.0642573751291602</c:v>
                </c:pt>
                <c:pt idx="2669">
                  <c:v>1.5842279472912399</c:v>
                </c:pt>
                <c:pt idx="2670">
                  <c:v>1.5380015551042701</c:v>
                </c:pt>
                <c:pt idx="2671">
                  <c:v>1.9026194339973099</c:v>
                </c:pt>
                <c:pt idx="2672">
                  <c:v>1.5244428649309201</c:v>
                </c:pt>
                <c:pt idx="2673">
                  <c:v>1.11393744150707</c:v>
                </c:pt>
                <c:pt idx="2674">
                  <c:v>1.3179037406090399</c:v>
                </c:pt>
                <c:pt idx="2675">
                  <c:v>1.9616474312541901</c:v>
                </c:pt>
                <c:pt idx="2676">
                  <c:v>1.71385514681202</c:v>
                </c:pt>
                <c:pt idx="2677">
                  <c:v>1.95199148371728</c:v>
                </c:pt>
                <c:pt idx="2678">
                  <c:v>1.6640965520706601</c:v>
                </c:pt>
                <c:pt idx="2679">
                  <c:v>1.5002414552438801</c:v>
                </c:pt>
                <c:pt idx="2680">
                  <c:v>1.7321032834693899</c:v>
                </c:pt>
                <c:pt idx="2681">
                  <c:v>1.5436870004958501</c:v>
                </c:pt>
                <c:pt idx="2682">
                  <c:v>1.22152354584664</c:v>
                </c:pt>
                <c:pt idx="2683">
                  <c:v>1.0634896373896701</c:v>
                </c:pt>
                <c:pt idx="2684">
                  <c:v>1.15328849822199</c:v>
                </c:pt>
                <c:pt idx="2685">
                  <c:v>1.4936619515462599</c:v>
                </c:pt>
                <c:pt idx="2686">
                  <c:v>1.75112510147528</c:v>
                </c:pt>
                <c:pt idx="2687">
                  <c:v>2.4151244382197801</c:v>
                </c:pt>
                <c:pt idx="2688">
                  <c:v>1.43368057806322</c:v>
                </c:pt>
                <c:pt idx="2689">
                  <c:v>1.40327397534211</c:v>
                </c:pt>
                <c:pt idx="2690">
                  <c:v>1.00951473931018</c:v>
                </c:pt>
                <c:pt idx="2691">
                  <c:v>1.85073293765015</c:v>
                </c:pt>
                <c:pt idx="2692">
                  <c:v>1.8240787067494599</c:v>
                </c:pt>
                <c:pt idx="2693">
                  <c:v>1.54321568642387</c:v>
                </c:pt>
                <c:pt idx="2694">
                  <c:v>1.9735724518637301</c:v>
                </c:pt>
                <c:pt idx="2695">
                  <c:v>1.6352719508758999</c:v>
                </c:pt>
                <c:pt idx="2696">
                  <c:v>1.43579125360106</c:v>
                </c:pt>
                <c:pt idx="2697">
                  <c:v>1.5416639877321101</c:v>
                </c:pt>
                <c:pt idx="2698">
                  <c:v>2.3023228308897199</c:v>
                </c:pt>
                <c:pt idx="2699">
                  <c:v>2.1523586979360698</c:v>
                </c:pt>
                <c:pt idx="2700">
                  <c:v>1.8157237949040701</c:v>
                </c:pt>
                <c:pt idx="2701">
                  <c:v>1.95319391644206</c:v>
                </c:pt>
                <c:pt idx="2702">
                  <c:v>1.5928207660090099</c:v>
                </c:pt>
                <c:pt idx="2703">
                  <c:v>1.9737616686189301</c:v>
                </c:pt>
                <c:pt idx="2704">
                  <c:v>2.0692299988314802</c:v>
                </c:pt>
                <c:pt idx="2705">
                  <c:v>1.4501388049880399</c:v>
                </c:pt>
                <c:pt idx="2706">
                  <c:v>2.1194294404543901</c:v>
                </c:pt>
                <c:pt idx="2707">
                  <c:v>2.0911521592191802</c:v>
                </c:pt>
                <c:pt idx="2708">
                  <c:v>1.65076564567326</c:v>
                </c:pt>
                <c:pt idx="2709">
                  <c:v>1.6342245195224601</c:v>
                </c:pt>
                <c:pt idx="2710">
                  <c:v>1.3306568110071599</c:v>
                </c:pt>
                <c:pt idx="2711">
                  <c:v>1.5085218720112199</c:v>
                </c:pt>
                <c:pt idx="2712">
                  <c:v>1.2330426137507899</c:v>
                </c:pt>
                <c:pt idx="2713">
                  <c:v>2.15475351394812</c:v>
                </c:pt>
                <c:pt idx="2714">
                  <c:v>1.7665762996185299</c:v>
                </c:pt>
                <c:pt idx="2715">
                  <c:v>1.2806632736202901</c:v>
                </c:pt>
                <c:pt idx="2716">
                  <c:v>1.5253225243924899</c:v>
                </c:pt>
                <c:pt idx="2717">
                  <c:v>2.1951047198334499</c:v>
                </c:pt>
                <c:pt idx="2718">
                  <c:v>1.46799244540632</c:v>
                </c:pt>
                <c:pt idx="2719">
                  <c:v>1.89253501982943</c:v>
                </c:pt>
                <c:pt idx="2720">
                  <c:v>1.6178650694369101</c:v>
                </c:pt>
                <c:pt idx="2721">
                  <c:v>1.7209802148335001</c:v>
                </c:pt>
                <c:pt idx="2722">
                  <c:v>1.4201439930628501</c:v>
                </c:pt>
                <c:pt idx="2723">
                  <c:v>1.6570663390156299</c:v>
                </c:pt>
                <c:pt idx="2724">
                  <c:v>2.11919563583628</c:v>
                </c:pt>
                <c:pt idx="2725">
                  <c:v>1.57754045312932</c:v>
                </c:pt>
                <c:pt idx="2726">
                  <c:v>1.7129974523579601</c:v>
                </c:pt>
                <c:pt idx="2727">
                  <c:v>1.5278557761801199</c:v>
                </c:pt>
                <c:pt idx="2728">
                  <c:v>1.96687141506807</c:v>
                </c:pt>
                <c:pt idx="2729">
                  <c:v>2.35087582967479</c:v>
                </c:pt>
                <c:pt idx="2730">
                  <c:v>2.0083947216284699</c:v>
                </c:pt>
                <c:pt idx="2731">
                  <c:v>1.5144520897739799</c:v>
                </c:pt>
                <c:pt idx="2732">
                  <c:v>1.28236961503819</c:v>
                </c:pt>
                <c:pt idx="2733">
                  <c:v>1.51719959266687</c:v>
                </c:pt>
                <c:pt idx="2734">
                  <c:v>1.60304912161807</c:v>
                </c:pt>
                <c:pt idx="2735">
                  <c:v>1.12205320032018</c:v>
                </c:pt>
                <c:pt idx="2736">
                  <c:v>1.2619500947703099</c:v>
                </c:pt>
                <c:pt idx="2737">
                  <c:v>1.8400650616385199</c:v>
                </c:pt>
                <c:pt idx="2738">
                  <c:v>1.7879421720301001</c:v>
                </c:pt>
                <c:pt idx="2739">
                  <c:v>1.4126371195571501</c:v>
                </c:pt>
                <c:pt idx="2740">
                  <c:v>1.16428697711794</c:v>
                </c:pt>
                <c:pt idx="2741">
                  <c:v>0.99045572023938899</c:v>
                </c:pt>
                <c:pt idx="2742">
                  <c:v>1.4994185246845499</c:v>
                </c:pt>
                <c:pt idx="2743">
                  <c:v>1.2889425424866401</c:v>
                </c:pt>
                <c:pt idx="2744">
                  <c:v>1.1801433463964901</c:v>
                </c:pt>
                <c:pt idx="2745">
                  <c:v>2.2863464431413401</c:v>
                </c:pt>
                <c:pt idx="2746">
                  <c:v>1.45403686195715</c:v>
                </c:pt>
                <c:pt idx="2747">
                  <c:v>1.3343727645154899</c:v>
                </c:pt>
                <c:pt idx="2748">
                  <c:v>0.84189538281352805</c:v>
                </c:pt>
                <c:pt idx="2749">
                  <c:v>1.9283007726522301</c:v>
                </c:pt>
                <c:pt idx="2750">
                  <c:v>1.3674564691345601</c:v>
                </c:pt>
                <c:pt idx="2751">
                  <c:v>1.24895162671613</c:v>
                </c:pt>
                <c:pt idx="2752">
                  <c:v>1.66666714362282</c:v>
                </c:pt>
                <c:pt idx="2753">
                  <c:v>1.74058781321713</c:v>
                </c:pt>
                <c:pt idx="2754">
                  <c:v>1.4321000799304799</c:v>
                </c:pt>
                <c:pt idx="2755">
                  <c:v>1.45439624937697</c:v>
                </c:pt>
                <c:pt idx="2756">
                  <c:v>1.6505655130452701</c:v>
                </c:pt>
                <c:pt idx="2757">
                  <c:v>2.2319271125138398</c:v>
                </c:pt>
                <c:pt idx="2758">
                  <c:v>1.17327075082385</c:v>
                </c:pt>
                <c:pt idx="2759">
                  <c:v>1.0507895929287501</c:v>
                </c:pt>
                <c:pt idx="2760">
                  <c:v>1.30537190864213</c:v>
                </c:pt>
                <c:pt idx="2761">
                  <c:v>1.13740530093732</c:v>
                </c:pt>
                <c:pt idx="2762">
                  <c:v>1.9574421775714199</c:v>
                </c:pt>
                <c:pt idx="2763">
                  <c:v>1.25446730472631</c:v>
                </c:pt>
                <c:pt idx="2764">
                  <c:v>1.3031610038577699</c:v>
                </c:pt>
                <c:pt idx="2765">
                  <c:v>1.50552863434675</c:v>
                </c:pt>
                <c:pt idx="2766">
                  <c:v>2.6173763720057699</c:v>
                </c:pt>
                <c:pt idx="2767">
                  <c:v>2.1152893464986202</c:v>
                </c:pt>
                <c:pt idx="2768">
                  <c:v>1.1579194830739401</c:v>
                </c:pt>
                <c:pt idx="2769">
                  <c:v>1.3528548117145101</c:v>
                </c:pt>
                <c:pt idx="2770">
                  <c:v>1.11044205951501</c:v>
                </c:pt>
                <c:pt idx="2771">
                  <c:v>1.0362430235187501</c:v>
                </c:pt>
                <c:pt idx="2772">
                  <c:v>1.18847282024878</c:v>
                </c:pt>
                <c:pt idx="2773">
                  <c:v>1.3491991693312499</c:v>
                </c:pt>
                <c:pt idx="2774">
                  <c:v>1.1082151541551799</c:v>
                </c:pt>
                <c:pt idx="2775">
                  <c:v>1.2309878089820501</c:v>
                </c:pt>
                <c:pt idx="2776">
                  <c:v>0.90377648422291401</c:v>
                </c:pt>
                <c:pt idx="2777">
                  <c:v>1.3576574801127801</c:v>
                </c:pt>
                <c:pt idx="2778">
                  <c:v>0.65605497701976401</c:v>
                </c:pt>
                <c:pt idx="2779">
                  <c:v>1.3347478131833199</c:v>
                </c:pt>
                <c:pt idx="2780">
                  <c:v>0.87711443540072798</c:v>
                </c:pt>
                <c:pt idx="2781">
                  <c:v>0.85397435128161103</c:v>
                </c:pt>
                <c:pt idx="2782">
                  <c:v>1.53618862535814</c:v>
                </c:pt>
                <c:pt idx="2783">
                  <c:v>0.934443462654027</c:v>
                </c:pt>
                <c:pt idx="2784">
                  <c:v>0.69285355100680901</c:v>
                </c:pt>
                <c:pt idx="2785">
                  <c:v>0.80412373090343303</c:v>
                </c:pt>
                <c:pt idx="2786">
                  <c:v>1.08056643832715</c:v>
                </c:pt>
                <c:pt idx="2787">
                  <c:v>0.87954182795785896</c:v>
                </c:pt>
                <c:pt idx="2788">
                  <c:v>1.28199789233352</c:v>
                </c:pt>
                <c:pt idx="2789">
                  <c:v>0.88872378502596805</c:v>
                </c:pt>
                <c:pt idx="2790">
                  <c:v>1.3419739526914001</c:v>
                </c:pt>
                <c:pt idx="2791">
                  <c:v>1.01407700646442</c:v>
                </c:pt>
                <c:pt idx="2792">
                  <c:v>0.79603339294023001</c:v>
                </c:pt>
                <c:pt idx="2793">
                  <c:v>1.14008788459109</c:v>
                </c:pt>
                <c:pt idx="2794">
                  <c:v>1.1811206317674701</c:v>
                </c:pt>
                <c:pt idx="2795">
                  <c:v>1.59431193469371</c:v>
                </c:pt>
                <c:pt idx="2796">
                  <c:v>1.9574192043598999</c:v>
                </c:pt>
                <c:pt idx="2797">
                  <c:v>1.7615056126359701</c:v>
                </c:pt>
                <c:pt idx="2798">
                  <c:v>1.2223438180899799</c:v>
                </c:pt>
                <c:pt idx="2799">
                  <c:v>0.98579111789686502</c:v>
                </c:pt>
                <c:pt idx="2800">
                  <c:v>1.1200083640890699</c:v>
                </c:pt>
                <c:pt idx="2801">
                  <c:v>1.38277786630658</c:v>
                </c:pt>
                <c:pt idx="2802">
                  <c:v>1.43352804671912</c:v>
                </c:pt>
                <c:pt idx="2803">
                  <c:v>1.4572694754958599</c:v>
                </c:pt>
                <c:pt idx="2804">
                  <c:v>1.2283844804528701</c:v>
                </c:pt>
                <c:pt idx="2805">
                  <c:v>1.0611102605434799</c:v>
                </c:pt>
                <c:pt idx="2806">
                  <c:v>1.4676548752362399</c:v>
                </c:pt>
                <c:pt idx="2807">
                  <c:v>1.29172494138395</c:v>
                </c:pt>
                <c:pt idx="2808">
                  <c:v>1.6104754404815</c:v>
                </c:pt>
                <c:pt idx="2809">
                  <c:v>1.6646171576364399</c:v>
                </c:pt>
                <c:pt idx="2810">
                  <c:v>1.0513424224630801</c:v>
                </c:pt>
                <c:pt idx="2811">
                  <c:v>1.2324500284880999</c:v>
                </c:pt>
                <c:pt idx="2812">
                  <c:v>0.78629800525561699</c:v>
                </c:pt>
                <c:pt idx="2813">
                  <c:v>2.0347743890250398</c:v>
                </c:pt>
                <c:pt idx="2814">
                  <c:v>1.6183104336906999</c:v>
                </c:pt>
                <c:pt idx="2815">
                  <c:v>1.8139876056367501</c:v>
                </c:pt>
                <c:pt idx="2816">
                  <c:v>2.03256095899504</c:v>
                </c:pt>
                <c:pt idx="2817">
                  <c:v>1.5581490792538999</c:v>
                </c:pt>
                <c:pt idx="2818">
                  <c:v>1.9994210911488499</c:v>
                </c:pt>
                <c:pt idx="2819">
                  <c:v>1.61395179899013</c:v>
                </c:pt>
                <c:pt idx="2820">
                  <c:v>1.9522514011547401</c:v>
                </c:pt>
                <c:pt idx="2821">
                  <c:v>1.18554864964177</c:v>
                </c:pt>
                <c:pt idx="2822">
                  <c:v>1.2899885659913799</c:v>
                </c:pt>
                <c:pt idx="2823">
                  <c:v>1.45687202719001</c:v>
                </c:pt>
                <c:pt idx="2824">
                  <c:v>1.04547912969094</c:v>
                </c:pt>
                <c:pt idx="2825">
                  <c:v>1.49999489273493</c:v>
                </c:pt>
                <c:pt idx="2826">
                  <c:v>0.84820221762752401</c:v>
                </c:pt>
                <c:pt idx="2827">
                  <c:v>1.0048252636256001</c:v>
                </c:pt>
                <c:pt idx="2828">
                  <c:v>0.94762156440176404</c:v>
                </c:pt>
                <c:pt idx="2829">
                  <c:v>1.1861824095793501</c:v>
                </c:pt>
                <c:pt idx="2830">
                  <c:v>1.5222674709878301</c:v>
                </c:pt>
                <c:pt idx="2831">
                  <c:v>1.04477962830569</c:v>
                </c:pt>
                <c:pt idx="2832">
                  <c:v>1.3967408084435</c:v>
                </c:pt>
                <c:pt idx="2833">
                  <c:v>0.58626533143378801</c:v>
                </c:pt>
                <c:pt idx="2834">
                  <c:v>1.60898236788626</c:v>
                </c:pt>
                <c:pt idx="2835">
                  <c:v>0.98969225392776305</c:v>
                </c:pt>
                <c:pt idx="2836">
                  <c:v>1.1736644882426399</c:v>
                </c:pt>
                <c:pt idx="2837">
                  <c:v>1.1105597984710001</c:v>
                </c:pt>
                <c:pt idx="2838">
                  <c:v>1.4307303656086701</c:v>
                </c:pt>
                <c:pt idx="2839">
                  <c:v>1.32806114017885</c:v>
                </c:pt>
                <c:pt idx="2840">
                  <c:v>1.10823019976267</c:v>
                </c:pt>
                <c:pt idx="2841">
                  <c:v>1.2267503545960099</c:v>
                </c:pt>
                <c:pt idx="2842">
                  <c:v>1.7970827801023299</c:v>
                </c:pt>
                <c:pt idx="2843">
                  <c:v>1.3521735449663499</c:v>
                </c:pt>
                <c:pt idx="2844">
                  <c:v>1.2678712476498</c:v>
                </c:pt>
                <c:pt idx="2845">
                  <c:v>2.0733245168269399</c:v>
                </c:pt>
                <c:pt idx="2846">
                  <c:v>1.28758404137215</c:v>
                </c:pt>
                <c:pt idx="2847">
                  <c:v>1.2535669949780699</c:v>
                </c:pt>
                <c:pt idx="2848">
                  <c:v>0.96911157694887795</c:v>
                </c:pt>
                <c:pt idx="2849">
                  <c:v>1.34650205005303</c:v>
                </c:pt>
                <c:pt idx="2850">
                  <c:v>1.94067682820606</c:v>
                </c:pt>
                <c:pt idx="2851">
                  <c:v>1.6377431229229999</c:v>
                </c:pt>
                <c:pt idx="2852">
                  <c:v>1.0732659732346099</c:v>
                </c:pt>
                <c:pt idx="2853">
                  <c:v>1.5644915183042201</c:v>
                </c:pt>
                <c:pt idx="2854">
                  <c:v>1.0738546783663001</c:v>
                </c:pt>
                <c:pt idx="2855">
                  <c:v>1.7703114675528899</c:v>
                </c:pt>
                <c:pt idx="2856">
                  <c:v>1.10610021937423</c:v>
                </c:pt>
                <c:pt idx="2857">
                  <c:v>1.0975911186712799</c:v>
                </c:pt>
                <c:pt idx="2858">
                  <c:v>0.72350960780171603</c:v>
                </c:pt>
                <c:pt idx="2859">
                  <c:v>0.91202628296003396</c:v>
                </c:pt>
                <c:pt idx="2860">
                  <c:v>0.77994033290192499</c:v>
                </c:pt>
                <c:pt idx="2861">
                  <c:v>0.77894845251056699</c:v>
                </c:pt>
                <c:pt idx="2862">
                  <c:v>0.97651826715625101</c:v>
                </c:pt>
                <c:pt idx="2863">
                  <c:v>1.1642309661326</c:v>
                </c:pt>
                <c:pt idx="2864">
                  <c:v>0.96956584935466905</c:v>
                </c:pt>
                <c:pt idx="2865">
                  <c:v>0.92302767054988299</c:v>
                </c:pt>
                <c:pt idx="2866">
                  <c:v>1.3160812659321799</c:v>
                </c:pt>
                <c:pt idx="2867">
                  <c:v>1.68812917538921</c:v>
                </c:pt>
                <c:pt idx="2868">
                  <c:v>1.46496129754766</c:v>
                </c:pt>
                <c:pt idx="2869">
                  <c:v>1.1032356076776999</c:v>
                </c:pt>
                <c:pt idx="2870">
                  <c:v>0.88253031759282496</c:v>
                </c:pt>
                <c:pt idx="2871">
                  <c:v>1.4930031369893999</c:v>
                </c:pt>
                <c:pt idx="2872">
                  <c:v>0.84405622013509296</c:v>
                </c:pt>
                <c:pt idx="2873">
                  <c:v>0.86747553831770896</c:v>
                </c:pt>
                <c:pt idx="2874">
                  <c:v>0.84159409161983101</c:v>
                </c:pt>
                <c:pt idx="2875">
                  <c:v>0.736767576326399</c:v>
                </c:pt>
                <c:pt idx="2876">
                  <c:v>0.54561589535251298</c:v>
                </c:pt>
                <c:pt idx="2877">
                  <c:v>0.51699197898692795</c:v>
                </c:pt>
                <c:pt idx="2878">
                  <c:v>0.97235115080897006</c:v>
                </c:pt>
                <c:pt idx="2879">
                  <c:v>1.09255053482824</c:v>
                </c:pt>
                <c:pt idx="2880">
                  <c:v>1.07568208502219</c:v>
                </c:pt>
                <c:pt idx="2881">
                  <c:v>0.44330585854455801</c:v>
                </c:pt>
                <c:pt idx="2882">
                  <c:v>0.97993480227199603</c:v>
                </c:pt>
                <c:pt idx="2883">
                  <c:v>0.79954547405615894</c:v>
                </c:pt>
                <c:pt idx="2884">
                  <c:v>0.55539907065677097</c:v>
                </c:pt>
                <c:pt idx="2885">
                  <c:v>0.53066704384119701</c:v>
                </c:pt>
                <c:pt idx="2886">
                  <c:v>0.42834591233251601</c:v>
                </c:pt>
                <c:pt idx="2887">
                  <c:v>0.56338083205435596</c:v>
                </c:pt>
                <c:pt idx="2888">
                  <c:v>1.0442615542906999</c:v>
                </c:pt>
                <c:pt idx="2889">
                  <c:v>0.52166598820381704</c:v>
                </c:pt>
                <c:pt idx="2890">
                  <c:v>1.15639435258891</c:v>
                </c:pt>
                <c:pt idx="2891">
                  <c:v>0.57203863199844196</c:v>
                </c:pt>
                <c:pt idx="2892">
                  <c:v>1.1449947988607501</c:v>
                </c:pt>
                <c:pt idx="2893">
                  <c:v>1.1744948536866</c:v>
                </c:pt>
                <c:pt idx="2894">
                  <c:v>0.88843280547278403</c:v>
                </c:pt>
                <c:pt idx="2895">
                  <c:v>0.59260315285159704</c:v>
                </c:pt>
                <c:pt idx="2896">
                  <c:v>0.23454009027210099</c:v>
                </c:pt>
                <c:pt idx="2897">
                  <c:v>1.07590133466127</c:v>
                </c:pt>
                <c:pt idx="2898">
                  <c:v>0.19188092163592699</c:v>
                </c:pt>
                <c:pt idx="2899">
                  <c:v>1.26308443812634</c:v>
                </c:pt>
                <c:pt idx="2900">
                  <c:v>0.64416761384125598</c:v>
                </c:pt>
                <c:pt idx="2901">
                  <c:v>0.67343410969110795</c:v>
                </c:pt>
                <c:pt idx="2902">
                  <c:v>0.81093734286221697</c:v>
                </c:pt>
                <c:pt idx="2903">
                  <c:v>0.79359218506768703</c:v>
                </c:pt>
                <c:pt idx="2904">
                  <c:v>1.6119616577154301</c:v>
                </c:pt>
                <c:pt idx="2905">
                  <c:v>0.73404235097968995</c:v>
                </c:pt>
                <c:pt idx="2906">
                  <c:v>1.56273485973458</c:v>
                </c:pt>
                <c:pt idx="2907">
                  <c:v>0.29904787383076098</c:v>
                </c:pt>
                <c:pt idx="2908">
                  <c:v>0.57247262169177904</c:v>
                </c:pt>
                <c:pt idx="2909">
                  <c:v>0.86639659016554704</c:v>
                </c:pt>
                <c:pt idx="2910">
                  <c:v>0.50040124166885902</c:v>
                </c:pt>
                <c:pt idx="2911">
                  <c:v>0.30006389156548702</c:v>
                </c:pt>
                <c:pt idx="2912">
                  <c:v>0.38302145237410601</c:v>
                </c:pt>
                <c:pt idx="2913">
                  <c:v>1.0847195897225299</c:v>
                </c:pt>
                <c:pt idx="2914">
                  <c:v>0.53820801385445605</c:v>
                </c:pt>
                <c:pt idx="2915">
                  <c:v>1.1600384777089601</c:v>
                </c:pt>
                <c:pt idx="2916">
                  <c:v>0.38695394949551598</c:v>
                </c:pt>
                <c:pt idx="2917">
                  <c:v>1.3947697239650301</c:v>
                </c:pt>
                <c:pt idx="2918">
                  <c:v>0.325533309534555</c:v>
                </c:pt>
                <c:pt idx="2919">
                  <c:v>0.53019725631943204</c:v>
                </c:pt>
                <c:pt idx="2920">
                  <c:v>0.528591745810715</c:v>
                </c:pt>
                <c:pt idx="2921">
                  <c:v>0.22814853050977599</c:v>
                </c:pt>
                <c:pt idx="2922">
                  <c:v>0.57620240605653095</c:v>
                </c:pt>
                <c:pt idx="2923">
                  <c:v>0.63410351063083603</c:v>
                </c:pt>
                <c:pt idx="2924">
                  <c:v>0.797790417608784</c:v>
                </c:pt>
                <c:pt idx="2925">
                  <c:v>1.44533835513762</c:v>
                </c:pt>
                <c:pt idx="2926">
                  <c:v>1.5419075480150799</c:v>
                </c:pt>
                <c:pt idx="2927">
                  <c:v>0.59070980691132302</c:v>
                </c:pt>
                <c:pt idx="2928">
                  <c:v>1.1287034236247899</c:v>
                </c:pt>
                <c:pt idx="2929">
                  <c:v>0.91176115828510196</c:v>
                </c:pt>
                <c:pt idx="2930">
                  <c:v>0.95604008593288803</c:v>
                </c:pt>
                <c:pt idx="2931">
                  <c:v>1.20263931614046</c:v>
                </c:pt>
                <c:pt idx="2932">
                  <c:v>1.07664635713641</c:v>
                </c:pt>
                <c:pt idx="2933">
                  <c:v>1.1426652591094</c:v>
                </c:pt>
                <c:pt idx="2934">
                  <c:v>0.858462119767055</c:v>
                </c:pt>
                <c:pt idx="2935">
                  <c:v>0.98089157634613999</c:v>
                </c:pt>
                <c:pt idx="2936">
                  <c:v>0.77508708367380497</c:v>
                </c:pt>
                <c:pt idx="2937">
                  <c:v>1.0968570276811</c:v>
                </c:pt>
                <c:pt idx="2938">
                  <c:v>0.486635607131021</c:v>
                </c:pt>
                <c:pt idx="2939">
                  <c:v>1.1008576346661301</c:v>
                </c:pt>
                <c:pt idx="2940">
                  <c:v>0.40137578534965801</c:v>
                </c:pt>
                <c:pt idx="2941">
                  <c:v>0.37267960169442499</c:v>
                </c:pt>
                <c:pt idx="2942">
                  <c:v>0.63040336513335504</c:v>
                </c:pt>
                <c:pt idx="2943">
                  <c:v>0.47898097791013</c:v>
                </c:pt>
                <c:pt idx="2944">
                  <c:v>1.10608996871396</c:v>
                </c:pt>
                <c:pt idx="2945">
                  <c:v>0.74773443511315396</c:v>
                </c:pt>
                <c:pt idx="2946">
                  <c:v>0.84032408662799096</c:v>
                </c:pt>
                <c:pt idx="2947">
                  <c:v>0.73300582520482804</c:v>
                </c:pt>
                <c:pt idx="2948">
                  <c:v>0.53579647075126802</c:v>
                </c:pt>
                <c:pt idx="2949">
                  <c:v>0.31745977100673001</c:v>
                </c:pt>
                <c:pt idx="2950">
                  <c:v>0.76308443510555002</c:v>
                </c:pt>
                <c:pt idx="2951">
                  <c:v>0.45107288473750701</c:v>
                </c:pt>
                <c:pt idx="2952">
                  <c:v>0.89885790629030904</c:v>
                </c:pt>
                <c:pt idx="2953">
                  <c:v>0.363431352327861</c:v>
                </c:pt>
                <c:pt idx="2954">
                  <c:v>0.87770472217058504</c:v>
                </c:pt>
                <c:pt idx="2955">
                  <c:v>0.81921108348441396</c:v>
                </c:pt>
                <c:pt idx="2956">
                  <c:v>0.71267175707827002</c:v>
                </c:pt>
                <c:pt idx="2957">
                  <c:v>1.0174151857459299</c:v>
                </c:pt>
                <c:pt idx="2958">
                  <c:v>0.95499781963805297</c:v>
                </c:pt>
                <c:pt idx="2959">
                  <c:v>0.59138689115564103</c:v>
                </c:pt>
                <c:pt idx="2960">
                  <c:v>0.42469469108127</c:v>
                </c:pt>
                <c:pt idx="2961">
                  <c:v>0.908766744595634</c:v>
                </c:pt>
                <c:pt idx="2962">
                  <c:v>0.78824802442554098</c:v>
                </c:pt>
                <c:pt idx="2963">
                  <c:v>1.0604767258044701</c:v>
                </c:pt>
                <c:pt idx="2964">
                  <c:v>1.62934537015361</c:v>
                </c:pt>
                <c:pt idx="2965">
                  <c:v>1.1790275495504601</c:v>
                </c:pt>
                <c:pt idx="2966">
                  <c:v>1.02673868547832</c:v>
                </c:pt>
                <c:pt idx="2967">
                  <c:v>0.94468722202676603</c:v>
                </c:pt>
                <c:pt idx="2968">
                  <c:v>1.01728799975747</c:v>
                </c:pt>
                <c:pt idx="2969">
                  <c:v>1.1506378921113201</c:v>
                </c:pt>
                <c:pt idx="2970">
                  <c:v>0.75562848373086999</c:v>
                </c:pt>
                <c:pt idx="2971">
                  <c:v>0.80612655532933397</c:v>
                </c:pt>
                <c:pt idx="2972">
                  <c:v>1.36792753419101</c:v>
                </c:pt>
                <c:pt idx="2973">
                  <c:v>0.82722395156187301</c:v>
                </c:pt>
                <c:pt idx="2974">
                  <c:v>0.72235277702546996</c:v>
                </c:pt>
                <c:pt idx="2975">
                  <c:v>0.59193425847159498</c:v>
                </c:pt>
                <c:pt idx="2976">
                  <c:v>0.97664755828010996</c:v>
                </c:pt>
                <c:pt idx="2977">
                  <c:v>0.93297954974561803</c:v>
                </c:pt>
                <c:pt idx="2978">
                  <c:v>1.2139740741588101</c:v>
                </c:pt>
                <c:pt idx="2979">
                  <c:v>1.1467867331753401</c:v>
                </c:pt>
                <c:pt idx="2980">
                  <c:v>1.0212049375937899</c:v>
                </c:pt>
                <c:pt idx="2981">
                  <c:v>0.72734924389442002</c:v>
                </c:pt>
                <c:pt idx="2982">
                  <c:v>0.89163322440616199</c:v>
                </c:pt>
                <c:pt idx="2983">
                  <c:v>1.2353049489065899</c:v>
                </c:pt>
                <c:pt idx="2984">
                  <c:v>0.84391636319042296</c:v>
                </c:pt>
                <c:pt idx="2985">
                  <c:v>0.74668043301777498</c:v>
                </c:pt>
                <c:pt idx="2986">
                  <c:v>0.98889263432007402</c:v>
                </c:pt>
                <c:pt idx="2987">
                  <c:v>0.70117579300975896</c:v>
                </c:pt>
                <c:pt idx="2988">
                  <c:v>1.2888138878358699</c:v>
                </c:pt>
                <c:pt idx="2989">
                  <c:v>0.73834257508051704</c:v>
                </c:pt>
                <c:pt idx="2990">
                  <c:v>0.95768551252629597</c:v>
                </c:pt>
                <c:pt idx="2991">
                  <c:v>0.97175545920698003</c:v>
                </c:pt>
                <c:pt idx="2992">
                  <c:v>1.2633427759673499</c:v>
                </c:pt>
                <c:pt idx="2993">
                  <c:v>0.64181064275234001</c:v>
                </c:pt>
                <c:pt idx="2994">
                  <c:v>0.76384560098626597</c:v>
                </c:pt>
                <c:pt idx="2995">
                  <c:v>1.3710438563220699</c:v>
                </c:pt>
                <c:pt idx="2996">
                  <c:v>0.97439159022993704</c:v>
                </c:pt>
                <c:pt idx="2997">
                  <c:v>0.93128999800754997</c:v>
                </c:pt>
                <c:pt idx="2998">
                  <c:v>1.22392249280591</c:v>
                </c:pt>
                <c:pt idx="2999">
                  <c:v>0.75800022237458498</c:v>
                </c:pt>
                <c:pt idx="3000">
                  <c:v>0.180954087623518</c:v>
                </c:pt>
                <c:pt idx="3001">
                  <c:v>1.0288317301129599</c:v>
                </c:pt>
                <c:pt idx="3002">
                  <c:v>1.6486012140222299</c:v>
                </c:pt>
                <c:pt idx="3003">
                  <c:v>0.69142766913500597</c:v>
                </c:pt>
                <c:pt idx="3004">
                  <c:v>1.7738716682757401</c:v>
                </c:pt>
                <c:pt idx="3005">
                  <c:v>0.92018649740396596</c:v>
                </c:pt>
                <c:pt idx="3006">
                  <c:v>0.78456693611425499</c:v>
                </c:pt>
                <c:pt idx="3007">
                  <c:v>1.08545354274706</c:v>
                </c:pt>
                <c:pt idx="3008">
                  <c:v>1.00209026886854</c:v>
                </c:pt>
                <c:pt idx="3009">
                  <c:v>0.95011253339303803</c:v>
                </c:pt>
                <c:pt idx="3010">
                  <c:v>0.94282625614909799</c:v>
                </c:pt>
                <c:pt idx="3011">
                  <c:v>1.30360269006934</c:v>
                </c:pt>
                <c:pt idx="3012">
                  <c:v>1.59220742160717</c:v>
                </c:pt>
                <c:pt idx="3013">
                  <c:v>0.99743706313868596</c:v>
                </c:pt>
                <c:pt idx="3014">
                  <c:v>1.0431980223170401</c:v>
                </c:pt>
                <c:pt idx="3015">
                  <c:v>0.18688584137962999</c:v>
                </c:pt>
                <c:pt idx="3016">
                  <c:v>0.73114702007868804</c:v>
                </c:pt>
                <c:pt idx="3017">
                  <c:v>0.59040005355209202</c:v>
                </c:pt>
                <c:pt idx="3018">
                  <c:v>1.1591075845052401</c:v>
                </c:pt>
                <c:pt idx="3019">
                  <c:v>0.170361448046011</c:v>
                </c:pt>
                <c:pt idx="3020">
                  <c:v>1.25985733714958</c:v>
                </c:pt>
                <c:pt idx="3021">
                  <c:v>0.55368502333087899</c:v>
                </c:pt>
                <c:pt idx="3022">
                  <c:v>0.89026180857766402</c:v>
                </c:pt>
                <c:pt idx="3023">
                  <c:v>0.47250459766353797</c:v>
                </c:pt>
                <c:pt idx="3024">
                  <c:v>0.72054483674577097</c:v>
                </c:pt>
                <c:pt idx="3025">
                  <c:v>0.55512816969509504</c:v>
                </c:pt>
                <c:pt idx="3026">
                  <c:v>0.62203570273573106</c:v>
                </c:pt>
                <c:pt idx="3027">
                  <c:v>0.85419489443513297</c:v>
                </c:pt>
                <c:pt idx="3028">
                  <c:v>0.52862442135884002</c:v>
                </c:pt>
                <c:pt idx="3029">
                  <c:v>0.93855126956379598</c:v>
                </c:pt>
                <c:pt idx="3030">
                  <c:v>0.70279148898155597</c:v>
                </c:pt>
                <c:pt idx="3031">
                  <c:v>0.57453828025169296</c:v>
                </c:pt>
                <c:pt idx="3032">
                  <c:v>1.3904784615595001</c:v>
                </c:pt>
                <c:pt idx="3033">
                  <c:v>0.862984564796349</c:v>
                </c:pt>
                <c:pt idx="3034">
                  <c:v>1.1969125011187101</c:v>
                </c:pt>
                <c:pt idx="3035">
                  <c:v>0.27952369388571402</c:v>
                </c:pt>
                <c:pt idx="3036">
                  <c:v>0.82910389833958298</c:v>
                </c:pt>
                <c:pt idx="3037">
                  <c:v>0.67099234878213398</c:v>
                </c:pt>
                <c:pt idx="3038">
                  <c:v>1.4968353595848001</c:v>
                </c:pt>
                <c:pt idx="3039">
                  <c:v>1.1458381137184801</c:v>
                </c:pt>
                <c:pt idx="3040">
                  <c:v>1.6628011866247701</c:v>
                </c:pt>
                <c:pt idx="3041">
                  <c:v>1.6939416201370101</c:v>
                </c:pt>
                <c:pt idx="3042">
                  <c:v>1.44885726147103</c:v>
                </c:pt>
                <c:pt idx="3043">
                  <c:v>1.53727276530338</c:v>
                </c:pt>
                <c:pt idx="3044">
                  <c:v>1.4493680648404399</c:v>
                </c:pt>
                <c:pt idx="3045">
                  <c:v>1.3674278411221801</c:v>
                </c:pt>
                <c:pt idx="3046">
                  <c:v>1.19804147777989</c:v>
                </c:pt>
                <c:pt idx="3047">
                  <c:v>1.1666906239063899</c:v>
                </c:pt>
                <c:pt idx="3048">
                  <c:v>1.51915079623163</c:v>
                </c:pt>
                <c:pt idx="3049">
                  <c:v>1.3060392828040399</c:v>
                </c:pt>
                <c:pt idx="3050">
                  <c:v>1.6839965555809799</c:v>
                </c:pt>
                <c:pt idx="3051">
                  <c:v>1.78415805432914</c:v>
                </c:pt>
                <c:pt idx="3052">
                  <c:v>1.5644773495864399</c:v>
                </c:pt>
                <c:pt idx="3053">
                  <c:v>2.06140452557112</c:v>
                </c:pt>
                <c:pt idx="3054">
                  <c:v>1.07409968418463</c:v>
                </c:pt>
                <c:pt idx="3055">
                  <c:v>1.82757199639207</c:v>
                </c:pt>
                <c:pt idx="3056">
                  <c:v>2.2715381601988698</c:v>
                </c:pt>
                <c:pt idx="3057">
                  <c:v>1.64499506484247</c:v>
                </c:pt>
                <c:pt idx="3058">
                  <c:v>1.79692103844901</c:v>
                </c:pt>
                <c:pt idx="3059">
                  <c:v>1.93619702890402</c:v>
                </c:pt>
                <c:pt idx="3060">
                  <c:v>1.9558220500882699</c:v>
                </c:pt>
                <c:pt idx="3061">
                  <c:v>1.7819573841546601</c:v>
                </c:pt>
                <c:pt idx="3062">
                  <c:v>1.75933094671692</c:v>
                </c:pt>
                <c:pt idx="3063">
                  <c:v>1.97040275112965</c:v>
                </c:pt>
                <c:pt idx="3064">
                  <c:v>2.2720937963471899</c:v>
                </c:pt>
                <c:pt idx="3065">
                  <c:v>1.99763448845157</c:v>
                </c:pt>
                <c:pt idx="3066">
                  <c:v>1.27494372928099</c:v>
                </c:pt>
                <c:pt idx="3067">
                  <c:v>1.30969426355774</c:v>
                </c:pt>
                <c:pt idx="3068">
                  <c:v>1.5333359154306201</c:v>
                </c:pt>
                <c:pt idx="3069">
                  <c:v>1.59130896951305</c:v>
                </c:pt>
                <c:pt idx="3070">
                  <c:v>1.1633750948450801</c:v>
                </c:pt>
                <c:pt idx="3071">
                  <c:v>1.1245592282922701</c:v>
                </c:pt>
                <c:pt idx="3072">
                  <c:v>1.36077786279222</c:v>
                </c:pt>
                <c:pt idx="3073">
                  <c:v>1.10966029468195</c:v>
                </c:pt>
                <c:pt idx="3074">
                  <c:v>1.1120108528713299</c:v>
                </c:pt>
                <c:pt idx="3075">
                  <c:v>1.5600552577728</c:v>
                </c:pt>
                <c:pt idx="3076">
                  <c:v>0.47501942302350098</c:v>
                </c:pt>
                <c:pt idx="3077">
                  <c:v>0.79773320945363302</c:v>
                </c:pt>
                <c:pt idx="3078">
                  <c:v>1.52739747458115</c:v>
                </c:pt>
                <c:pt idx="3079">
                  <c:v>1.5057187158654799</c:v>
                </c:pt>
                <c:pt idx="3080">
                  <c:v>1.3380468039371101</c:v>
                </c:pt>
                <c:pt idx="3081">
                  <c:v>1.1384198405833801</c:v>
                </c:pt>
                <c:pt idx="3082">
                  <c:v>0.91229201470181798</c:v>
                </c:pt>
                <c:pt idx="3083">
                  <c:v>1.0397025940726501</c:v>
                </c:pt>
                <c:pt idx="3084">
                  <c:v>0.68534357551050895</c:v>
                </c:pt>
                <c:pt idx="3085">
                  <c:v>0.53400802000131398</c:v>
                </c:pt>
                <c:pt idx="3086">
                  <c:v>1.9208839954886701</c:v>
                </c:pt>
                <c:pt idx="3087">
                  <c:v>1.0046220236194801</c:v>
                </c:pt>
                <c:pt idx="3088">
                  <c:v>0.68009814933263701</c:v>
                </c:pt>
                <c:pt idx="3089">
                  <c:v>1.3559683356433501</c:v>
                </c:pt>
                <c:pt idx="3090">
                  <c:v>1.27317933233553</c:v>
                </c:pt>
                <c:pt idx="3091">
                  <c:v>0.85578003378881096</c:v>
                </c:pt>
                <c:pt idx="3092">
                  <c:v>1.63371395392505</c:v>
                </c:pt>
                <c:pt idx="3093">
                  <c:v>1.24568661977811</c:v>
                </c:pt>
                <c:pt idx="3094">
                  <c:v>1.0443138186999501</c:v>
                </c:pt>
                <c:pt idx="3095">
                  <c:v>0.79142286005561202</c:v>
                </c:pt>
                <c:pt idx="3096">
                  <c:v>1.0337560432541399</c:v>
                </c:pt>
                <c:pt idx="3097">
                  <c:v>0.791935276810949</c:v>
                </c:pt>
                <c:pt idx="3098">
                  <c:v>0.77247914180770205</c:v>
                </c:pt>
                <c:pt idx="3099">
                  <c:v>0.68177071041311399</c:v>
                </c:pt>
                <c:pt idx="3100">
                  <c:v>1.1866541582247401</c:v>
                </c:pt>
                <c:pt idx="3101">
                  <c:v>0.85317134790071403</c:v>
                </c:pt>
                <c:pt idx="3102">
                  <c:v>1.0409763494675099</c:v>
                </c:pt>
                <c:pt idx="3103">
                  <c:v>1.7947423498939601</c:v>
                </c:pt>
                <c:pt idx="3104">
                  <c:v>1.8323537617494501</c:v>
                </c:pt>
                <c:pt idx="3105">
                  <c:v>0.65600787392446203</c:v>
                </c:pt>
                <c:pt idx="3106">
                  <c:v>0.98784579411946005</c:v>
                </c:pt>
                <c:pt idx="3107">
                  <c:v>1.06627341065314</c:v>
                </c:pt>
                <c:pt idx="3108">
                  <c:v>1.0781010434295599</c:v>
                </c:pt>
                <c:pt idx="3109">
                  <c:v>1.1380112477206099</c:v>
                </c:pt>
                <c:pt idx="3110">
                  <c:v>1.1493138585120899</c:v>
                </c:pt>
                <c:pt idx="3111">
                  <c:v>1.0834078368195501</c:v>
                </c:pt>
                <c:pt idx="3112">
                  <c:v>0.63319107167412403</c:v>
                </c:pt>
                <c:pt idx="3113">
                  <c:v>0.41063448003764402</c:v>
                </c:pt>
                <c:pt idx="3114">
                  <c:v>1.0891224121691401</c:v>
                </c:pt>
                <c:pt idx="3115">
                  <c:v>0.62639237580474505</c:v>
                </c:pt>
                <c:pt idx="3116">
                  <c:v>1.1507744851114801</c:v>
                </c:pt>
                <c:pt idx="3117">
                  <c:v>1.0799851502956099</c:v>
                </c:pt>
                <c:pt idx="3118">
                  <c:v>0.73692637659487503</c:v>
                </c:pt>
                <c:pt idx="3119">
                  <c:v>0.939248653572748</c:v>
                </c:pt>
                <c:pt idx="3120">
                  <c:v>1.26166419694472</c:v>
                </c:pt>
                <c:pt idx="3121">
                  <c:v>0.617086341002552</c:v>
                </c:pt>
                <c:pt idx="3122">
                  <c:v>0.74005889373872602</c:v>
                </c:pt>
                <c:pt idx="3123">
                  <c:v>0.78400206779298298</c:v>
                </c:pt>
                <c:pt idx="3124">
                  <c:v>1.26569131597898</c:v>
                </c:pt>
                <c:pt idx="3125">
                  <c:v>1.2261093772599001</c:v>
                </c:pt>
                <c:pt idx="3126">
                  <c:v>1.4023722891552901</c:v>
                </c:pt>
                <c:pt idx="3127">
                  <c:v>1.17863566270017</c:v>
                </c:pt>
                <c:pt idx="3128">
                  <c:v>1.3174512693061</c:v>
                </c:pt>
                <c:pt idx="3129">
                  <c:v>1.1622490905751</c:v>
                </c:pt>
                <c:pt idx="3130">
                  <c:v>0.71380465982904195</c:v>
                </c:pt>
                <c:pt idx="3131">
                  <c:v>1.07104507259866</c:v>
                </c:pt>
                <c:pt idx="3132">
                  <c:v>1.1964894424621999</c:v>
                </c:pt>
                <c:pt idx="3133">
                  <c:v>0.68409833511829199</c:v>
                </c:pt>
                <c:pt idx="3134">
                  <c:v>1.5503841208194999</c:v>
                </c:pt>
                <c:pt idx="3135">
                  <c:v>1.35019916542394</c:v>
                </c:pt>
                <c:pt idx="3136">
                  <c:v>1.10553479190673</c:v>
                </c:pt>
                <c:pt idx="3137">
                  <c:v>1.2653292953184601</c:v>
                </c:pt>
                <c:pt idx="3138">
                  <c:v>1.28620882615244</c:v>
                </c:pt>
                <c:pt idx="3139">
                  <c:v>0.86265269261164201</c:v>
                </c:pt>
                <c:pt idx="3140">
                  <c:v>1.0381082261777099</c:v>
                </c:pt>
                <c:pt idx="3141">
                  <c:v>1.4819809681940199</c:v>
                </c:pt>
                <c:pt idx="3142">
                  <c:v>1.1606180624934499</c:v>
                </c:pt>
                <c:pt idx="3143">
                  <c:v>1.3520040206444399</c:v>
                </c:pt>
                <c:pt idx="3144">
                  <c:v>1.1223235147789501</c:v>
                </c:pt>
                <c:pt idx="3145">
                  <c:v>0.967089989380854</c:v>
                </c:pt>
                <c:pt idx="3146">
                  <c:v>0.54415397269739696</c:v>
                </c:pt>
                <c:pt idx="3147">
                  <c:v>1.00219582942772</c:v>
                </c:pt>
                <c:pt idx="3148">
                  <c:v>1.1919487966178901</c:v>
                </c:pt>
                <c:pt idx="3149">
                  <c:v>1.3576977123004901</c:v>
                </c:pt>
                <c:pt idx="3150">
                  <c:v>1.3427422345662301</c:v>
                </c:pt>
                <c:pt idx="3151">
                  <c:v>1.2871090214246299</c:v>
                </c:pt>
                <c:pt idx="3152">
                  <c:v>1.3313771007069799</c:v>
                </c:pt>
                <c:pt idx="3153">
                  <c:v>0.88639748098923099</c:v>
                </c:pt>
                <c:pt idx="3154">
                  <c:v>1.27236794984506</c:v>
                </c:pt>
                <c:pt idx="3155">
                  <c:v>0.80982431985175096</c:v>
                </c:pt>
                <c:pt idx="3156">
                  <c:v>1.26368234156585</c:v>
                </c:pt>
                <c:pt idx="3157">
                  <c:v>0.51239965397106901</c:v>
                </c:pt>
                <c:pt idx="3158">
                  <c:v>1.61349026930051</c:v>
                </c:pt>
                <c:pt idx="3159">
                  <c:v>1.2336939365006401</c:v>
                </c:pt>
                <c:pt idx="3160">
                  <c:v>1.8763503135131201</c:v>
                </c:pt>
                <c:pt idx="3161">
                  <c:v>0.92567183126675301</c:v>
                </c:pt>
                <c:pt idx="3162">
                  <c:v>1.0899664062596099</c:v>
                </c:pt>
                <c:pt idx="3163">
                  <c:v>1.4817326514579301</c:v>
                </c:pt>
                <c:pt idx="3164">
                  <c:v>1.2069694595601299</c:v>
                </c:pt>
                <c:pt idx="3165">
                  <c:v>2.0840633523801402</c:v>
                </c:pt>
                <c:pt idx="3166">
                  <c:v>1.5179379958905801</c:v>
                </c:pt>
                <c:pt idx="3167">
                  <c:v>1.5945709821848399</c:v>
                </c:pt>
                <c:pt idx="3168">
                  <c:v>1.35851482607631</c:v>
                </c:pt>
                <c:pt idx="3169">
                  <c:v>1.5346103530000299</c:v>
                </c:pt>
                <c:pt idx="3170">
                  <c:v>1.9241653673243699</c:v>
                </c:pt>
                <c:pt idx="3171">
                  <c:v>1.6747182008433801</c:v>
                </c:pt>
                <c:pt idx="3172">
                  <c:v>1.98876594597337</c:v>
                </c:pt>
                <c:pt idx="3173">
                  <c:v>1.9249796627888101</c:v>
                </c:pt>
                <c:pt idx="3174">
                  <c:v>1.6428966799852101</c:v>
                </c:pt>
                <c:pt idx="3175">
                  <c:v>1.4019607249960899</c:v>
                </c:pt>
                <c:pt idx="3176">
                  <c:v>1.13934653162084</c:v>
                </c:pt>
                <c:pt idx="3177">
                  <c:v>2.1887321832434701</c:v>
                </c:pt>
                <c:pt idx="3178">
                  <c:v>1.25512926208036</c:v>
                </c:pt>
                <c:pt idx="3179">
                  <c:v>1.3745845551074201</c:v>
                </c:pt>
                <c:pt idx="3180">
                  <c:v>1.16563537486853</c:v>
                </c:pt>
                <c:pt idx="3181">
                  <c:v>1.42649195165284</c:v>
                </c:pt>
                <c:pt idx="3182">
                  <c:v>0.85233765954308804</c:v>
                </c:pt>
                <c:pt idx="3183">
                  <c:v>1.38096040775358</c:v>
                </c:pt>
                <c:pt idx="3184">
                  <c:v>1.41533971927627</c:v>
                </c:pt>
                <c:pt idx="3185">
                  <c:v>0.768731137259965</c:v>
                </c:pt>
                <c:pt idx="3186">
                  <c:v>1.0486458579079501</c:v>
                </c:pt>
                <c:pt idx="3187">
                  <c:v>1.27460536010473</c:v>
                </c:pt>
                <c:pt idx="3188">
                  <c:v>1.5568527200793201</c:v>
                </c:pt>
                <c:pt idx="3189">
                  <c:v>1.5914711375800401</c:v>
                </c:pt>
                <c:pt idx="3190">
                  <c:v>1.84184441166181</c:v>
                </c:pt>
                <c:pt idx="3191">
                  <c:v>1.12789310441561</c:v>
                </c:pt>
                <c:pt idx="3192">
                  <c:v>1.4519935972687401</c:v>
                </c:pt>
                <c:pt idx="3193">
                  <c:v>1.73761162367147</c:v>
                </c:pt>
                <c:pt idx="3194">
                  <c:v>1.28996579978839</c:v>
                </c:pt>
                <c:pt idx="3195">
                  <c:v>1.9292691606733701</c:v>
                </c:pt>
                <c:pt idx="3196">
                  <c:v>0.822178848794345</c:v>
                </c:pt>
                <c:pt idx="3197">
                  <c:v>1.78098312556876</c:v>
                </c:pt>
                <c:pt idx="3198">
                  <c:v>1.3935445668166599</c:v>
                </c:pt>
                <c:pt idx="3199">
                  <c:v>1.50177531102485</c:v>
                </c:pt>
                <c:pt idx="3200">
                  <c:v>1.27274737470305</c:v>
                </c:pt>
                <c:pt idx="3201">
                  <c:v>0.68075819010213301</c:v>
                </c:pt>
                <c:pt idx="3202">
                  <c:v>1.2365726401894599</c:v>
                </c:pt>
                <c:pt idx="3203">
                  <c:v>1.2147709845528101</c:v>
                </c:pt>
                <c:pt idx="3204">
                  <c:v>1.32939408755824</c:v>
                </c:pt>
                <c:pt idx="3205">
                  <c:v>1.2137167188073601</c:v>
                </c:pt>
                <c:pt idx="3206">
                  <c:v>1.57293113459294</c:v>
                </c:pt>
                <c:pt idx="3207">
                  <c:v>1.0465969484347799</c:v>
                </c:pt>
                <c:pt idx="3208">
                  <c:v>0.54501550277836397</c:v>
                </c:pt>
                <c:pt idx="3209">
                  <c:v>1.5757543718998399</c:v>
                </c:pt>
                <c:pt idx="3210">
                  <c:v>1.26876222928805</c:v>
                </c:pt>
                <c:pt idx="3211">
                  <c:v>1.3754086670615699</c:v>
                </c:pt>
                <c:pt idx="3212">
                  <c:v>1.27559448640103</c:v>
                </c:pt>
                <c:pt idx="3213">
                  <c:v>1.7211584783656499</c:v>
                </c:pt>
                <c:pt idx="3214">
                  <c:v>1.1287881689161401</c:v>
                </c:pt>
                <c:pt idx="3215">
                  <c:v>1.47213076565061</c:v>
                </c:pt>
                <c:pt idx="3216">
                  <c:v>1.099920400507</c:v>
                </c:pt>
                <c:pt idx="3217">
                  <c:v>1.14095153100814</c:v>
                </c:pt>
                <c:pt idx="3218">
                  <c:v>1.3317680033062</c:v>
                </c:pt>
                <c:pt idx="3219">
                  <c:v>1.4714342200505801</c:v>
                </c:pt>
                <c:pt idx="3220">
                  <c:v>1.5808279224058299</c:v>
                </c:pt>
                <c:pt idx="3221">
                  <c:v>1.2626302484452401</c:v>
                </c:pt>
                <c:pt idx="3222">
                  <c:v>1.5049404614235</c:v>
                </c:pt>
                <c:pt idx="3223">
                  <c:v>1.82849614837324</c:v>
                </c:pt>
                <c:pt idx="3224">
                  <c:v>1.1799370887629499</c:v>
                </c:pt>
                <c:pt idx="3225">
                  <c:v>0.71119889420512705</c:v>
                </c:pt>
                <c:pt idx="3226">
                  <c:v>1.23906665674052</c:v>
                </c:pt>
                <c:pt idx="3227">
                  <c:v>1.3371875528516299</c:v>
                </c:pt>
                <c:pt idx="3228">
                  <c:v>1.57739816285336</c:v>
                </c:pt>
                <c:pt idx="3229">
                  <c:v>1.2604658008101599</c:v>
                </c:pt>
                <c:pt idx="3230">
                  <c:v>1.1685273018143201</c:v>
                </c:pt>
                <c:pt idx="3231">
                  <c:v>1.1633993782030401</c:v>
                </c:pt>
                <c:pt idx="3232">
                  <c:v>0.94545473033190197</c:v>
                </c:pt>
                <c:pt idx="3233">
                  <c:v>1.7132759469904699</c:v>
                </c:pt>
                <c:pt idx="3234">
                  <c:v>0.96847674738950595</c:v>
                </c:pt>
                <c:pt idx="3235">
                  <c:v>1.3407093396985701</c:v>
                </c:pt>
                <c:pt idx="3236">
                  <c:v>1.4250567984399001</c:v>
                </c:pt>
                <c:pt idx="3237">
                  <c:v>1.3309654026570601</c:v>
                </c:pt>
                <c:pt idx="3238">
                  <c:v>0.82401768851388701</c:v>
                </c:pt>
                <c:pt idx="3239">
                  <c:v>1.07739766255046</c:v>
                </c:pt>
                <c:pt idx="3240">
                  <c:v>1.2238158803011101</c:v>
                </c:pt>
                <c:pt idx="3241">
                  <c:v>1.1260168558839201</c:v>
                </c:pt>
                <c:pt idx="3242">
                  <c:v>1.17387971735268</c:v>
                </c:pt>
                <c:pt idx="3243">
                  <c:v>0.87107539962513703</c:v>
                </c:pt>
                <c:pt idx="3244">
                  <c:v>1.1153471274004201</c:v>
                </c:pt>
                <c:pt idx="3245">
                  <c:v>0.79348532219511603</c:v>
                </c:pt>
                <c:pt idx="3246">
                  <c:v>0.92680304179475104</c:v>
                </c:pt>
                <c:pt idx="3247">
                  <c:v>0.75651477560784097</c:v>
                </c:pt>
                <c:pt idx="3248">
                  <c:v>0.983184407204864</c:v>
                </c:pt>
                <c:pt idx="3249">
                  <c:v>0.71492499009113597</c:v>
                </c:pt>
                <c:pt idx="3250">
                  <c:v>0.83638681310511598</c:v>
                </c:pt>
                <c:pt idx="3251">
                  <c:v>1.0996446467996399</c:v>
                </c:pt>
                <c:pt idx="3252">
                  <c:v>0.70395659678612899</c:v>
                </c:pt>
                <c:pt idx="3253">
                  <c:v>0.92492177197473502</c:v>
                </c:pt>
                <c:pt idx="3254">
                  <c:v>0.99644852921709504</c:v>
                </c:pt>
                <c:pt idx="3255">
                  <c:v>0.75896168724698698</c:v>
                </c:pt>
                <c:pt idx="3256">
                  <c:v>0.76258191507468298</c:v>
                </c:pt>
                <c:pt idx="3257">
                  <c:v>1.4626149167428</c:v>
                </c:pt>
                <c:pt idx="3258">
                  <c:v>1.15552569548134</c:v>
                </c:pt>
                <c:pt idx="3259">
                  <c:v>0.84180220542583395</c:v>
                </c:pt>
                <c:pt idx="3260">
                  <c:v>1.02407907897864</c:v>
                </c:pt>
                <c:pt idx="3261">
                  <c:v>1.4363181910651399</c:v>
                </c:pt>
                <c:pt idx="3262">
                  <c:v>0.82366975879445203</c:v>
                </c:pt>
                <c:pt idx="3263">
                  <c:v>1.4199642051678201</c:v>
                </c:pt>
                <c:pt idx="3264">
                  <c:v>1.9703968034755901</c:v>
                </c:pt>
                <c:pt idx="3265">
                  <c:v>1.1723771172931401</c:v>
                </c:pt>
                <c:pt idx="3266">
                  <c:v>1.37857550901871</c:v>
                </c:pt>
                <c:pt idx="3267">
                  <c:v>1.3918430338018599</c:v>
                </c:pt>
                <c:pt idx="3268">
                  <c:v>1.8527477877544101</c:v>
                </c:pt>
                <c:pt idx="3269">
                  <c:v>1.9174038967911</c:v>
                </c:pt>
                <c:pt idx="3270">
                  <c:v>1.49549295245499</c:v>
                </c:pt>
                <c:pt idx="3271">
                  <c:v>1.3777717029025101</c:v>
                </c:pt>
                <c:pt idx="3272">
                  <c:v>0.82273634062012801</c:v>
                </c:pt>
                <c:pt idx="3273">
                  <c:v>1.4012467190503299</c:v>
                </c:pt>
                <c:pt idx="3274">
                  <c:v>0.55186471853544905</c:v>
                </c:pt>
                <c:pt idx="3275">
                  <c:v>1.10904002225208</c:v>
                </c:pt>
                <c:pt idx="3276">
                  <c:v>1.41037513753691</c:v>
                </c:pt>
                <c:pt idx="3277">
                  <c:v>0.78767509758786902</c:v>
                </c:pt>
                <c:pt idx="3278">
                  <c:v>1.70353731344863</c:v>
                </c:pt>
                <c:pt idx="3279">
                  <c:v>0.93293685547002403</c:v>
                </c:pt>
                <c:pt idx="3280">
                  <c:v>1.20184532398699</c:v>
                </c:pt>
                <c:pt idx="3281">
                  <c:v>0.92838553222059195</c:v>
                </c:pt>
                <c:pt idx="3282">
                  <c:v>1.5644770174656699</c:v>
                </c:pt>
                <c:pt idx="3283">
                  <c:v>0.93336313782358704</c:v>
                </c:pt>
                <c:pt idx="3284">
                  <c:v>0.78910547305726597</c:v>
                </c:pt>
                <c:pt idx="3285">
                  <c:v>0.98332767569753099</c:v>
                </c:pt>
                <c:pt idx="3286">
                  <c:v>0.84961495772735995</c:v>
                </c:pt>
                <c:pt idx="3287">
                  <c:v>0.85616264700163103</c:v>
                </c:pt>
                <c:pt idx="3288">
                  <c:v>0.50554271607353196</c:v>
                </c:pt>
                <c:pt idx="3289">
                  <c:v>0.93850237011816395</c:v>
                </c:pt>
                <c:pt idx="3290">
                  <c:v>1.0604005002962</c:v>
                </c:pt>
                <c:pt idx="3291">
                  <c:v>1.0200094261022901</c:v>
                </c:pt>
                <c:pt idx="3292">
                  <c:v>1.0478401281212799</c:v>
                </c:pt>
                <c:pt idx="3293">
                  <c:v>0.93429152643616697</c:v>
                </c:pt>
                <c:pt idx="3294">
                  <c:v>0.90676487795412097</c:v>
                </c:pt>
                <c:pt idx="3295">
                  <c:v>0.96320513491229798</c:v>
                </c:pt>
                <c:pt idx="3296">
                  <c:v>1.1267646910286999</c:v>
                </c:pt>
                <c:pt idx="3297">
                  <c:v>1.04118695537998</c:v>
                </c:pt>
                <c:pt idx="3298">
                  <c:v>1.4104206719941701</c:v>
                </c:pt>
                <c:pt idx="3299">
                  <c:v>1.1334811521922601</c:v>
                </c:pt>
                <c:pt idx="3300">
                  <c:v>1.3594317285215001</c:v>
                </c:pt>
                <c:pt idx="3301">
                  <c:v>0.85161370937119896</c:v>
                </c:pt>
                <c:pt idx="3302">
                  <c:v>1.3437354312230001</c:v>
                </c:pt>
                <c:pt idx="3303">
                  <c:v>1.0008218704240099</c:v>
                </c:pt>
                <c:pt idx="3304">
                  <c:v>0.80668827532663001</c:v>
                </c:pt>
                <c:pt idx="3305">
                  <c:v>0.58980140037756701</c:v>
                </c:pt>
                <c:pt idx="3306">
                  <c:v>1.4623237446499699</c:v>
                </c:pt>
                <c:pt idx="3307">
                  <c:v>0.51368622556936605</c:v>
                </c:pt>
                <c:pt idx="3308">
                  <c:v>0.75181357465929299</c:v>
                </c:pt>
                <c:pt idx="3309">
                  <c:v>1.37266632326038</c:v>
                </c:pt>
                <c:pt idx="3310">
                  <c:v>1.20240599299026</c:v>
                </c:pt>
                <c:pt idx="3311">
                  <c:v>1.52455829584799</c:v>
                </c:pt>
                <c:pt idx="3312">
                  <c:v>1.45368483829843</c:v>
                </c:pt>
                <c:pt idx="3313">
                  <c:v>1.2819319641251199</c:v>
                </c:pt>
                <c:pt idx="3314">
                  <c:v>1.78102345866613</c:v>
                </c:pt>
                <c:pt idx="3315">
                  <c:v>0.78727489858814104</c:v>
                </c:pt>
                <c:pt idx="3316">
                  <c:v>1.40336152553567</c:v>
                </c:pt>
                <c:pt idx="3317">
                  <c:v>1.6682940564167501</c:v>
                </c:pt>
                <c:pt idx="3318">
                  <c:v>0.73950157502539504</c:v>
                </c:pt>
                <c:pt idx="3319">
                  <c:v>1.2945360786898299</c:v>
                </c:pt>
                <c:pt idx="3320">
                  <c:v>0.94418286839276999</c:v>
                </c:pt>
                <c:pt idx="3321">
                  <c:v>0.83659475766678204</c:v>
                </c:pt>
                <c:pt idx="3322">
                  <c:v>1.0128139250040999</c:v>
                </c:pt>
                <c:pt idx="3323">
                  <c:v>1.88725481560052</c:v>
                </c:pt>
                <c:pt idx="3324">
                  <c:v>1.2102186856816299</c:v>
                </c:pt>
                <c:pt idx="3325">
                  <c:v>0.92495413185928199</c:v>
                </c:pt>
                <c:pt idx="3326">
                  <c:v>1.0334453371567101</c:v>
                </c:pt>
                <c:pt idx="3327">
                  <c:v>1.28550745560126</c:v>
                </c:pt>
                <c:pt idx="3328">
                  <c:v>1.1755675163906301</c:v>
                </c:pt>
                <c:pt idx="3329">
                  <c:v>1.67587839515868</c:v>
                </c:pt>
                <c:pt idx="3330">
                  <c:v>1.52794598269912</c:v>
                </c:pt>
                <c:pt idx="3331">
                  <c:v>1.3659925661830701</c:v>
                </c:pt>
                <c:pt idx="3332">
                  <c:v>1.4600662222388201</c:v>
                </c:pt>
                <c:pt idx="3333">
                  <c:v>1.46682474890853</c:v>
                </c:pt>
                <c:pt idx="3334">
                  <c:v>1.2759245501230601</c:v>
                </c:pt>
                <c:pt idx="3335">
                  <c:v>1.18140128921544</c:v>
                </c:pt>
                <c:pt idx="3336">
                  <c:v>0.66028807250629995</c:v>
                </c:pt>
                <c:pt idx="3337">
                  <c:v>1.25959742267324</c:v>
                </c:pt>
                <c:pt idx="3338">
                  <c:v>1.04008952625172</c:v>
                </c:pt>
                <c:pt idx="3339">
                  <c:v>0.47319196551123499</c:v>
                </c:pt>
                <c:pt idx="3340">
                  <c:v>0.50880720095893495</c:v>
                </c:pt>
                <c:pt idx="3341">
                  <c:v>0.94984483050347501</c:v>
                </c:pt>
                <c:pt idx="3342">
                  <c:v>0.90994714830353296</c:v>
                </c:pt>
                <c:pt idx="3343">
                  <c:v>1.0387423408930501</c:v>
                </c:pt>
                <c:pt idx="3344">
                  <c:v>0.93012849316028201</c:v>
                </c:pt>
                <c:pt idx="3345">
                  <c:v>1.5418689598483599</c:v>
                </c:pt>
                <c:pt idx="3346">
                  <c:v>1.34696386203666</c:v>
                </c:pt>
                <c:pt idx="3347">
                  <c:v>1.8172061756251201</c:v>
                </c:pt>
                <c:pt idx="3348">
                  <c:v>0.70682918854785104</c:v>
                </c:pt>
                <c:pt idx="3349">
                  <c:v>0.94250728683229601</c:v>
                </c:pt>
                <c:pt idx="3350">
                  <c:v>1.4261095289211001</c:v>
                </c:pt>
                <c:pt idx="3351">
                  <c:v>1.2884056949309199</c:v>
                </c:pt>
                <c:pt idx="3352">
                  <c:v>0.74302941680797696</c:v>
                </c:pt>
                <c:pt idx="3353">
                  <c:v>1.6738566398929899</c:v>
                </c:pt>
                <c:pt idx="3354">
                  <c:v>1.5060444781022999</c:v>
                </c:pt>
                <c:pt idx="3355">
                  <c:v>1.93627297182703</c:v>
                </c:pt>
                <c:pt idx="3356">
                  <c:v>2.7159602065033202</c:v>
                </c:pt>
                <c:pt idx="3357">
                  <c:v>0.89204203578294805</c:v>
                </c:pt>
                <c:pt idx="3358">
                  <c:v>0.89851296007410897</c:v>
                </c:pt>
                <c:pt idx="3359">
                  <c:v>0.82091056755386604</c:v>
                </c:pt>
                <c:pt idx="3360">
                  <c:v>1.06223872437366</c:v>
                </c:pt>
                <c:pt idx="3361">
                  <c:v>1.20578079965514</c:v>
                </c:pt>
                <c:pt idx="3362">
                  <c:v>1.1053605040769101</c:v>
                </c:pt>
                <c:pt idx="3363">
                  <c:v>1.01677631380429</c:v>
                </c:pt>
                <c:pt idx="3364">
                  <c:v>1.6792558893985301</c:v>
                </c:pt>
                <c:pt idx="3365">
                  <c:v>0.556714721832818</c:v>
                </c:pt>
                <c:pt idx="3366">
                  <c:v>0.66471693590168102</c:v>
                </c:pt>
                <c:pt idx="3367">
                  <c:v>1.10647494696876</c:v>
                </c:pt>
                <c:pt idx="3368">
                  <c:v>0.82921014667235504</c:v>
                </c:pt>
                <c:pt idx="3369">
                  <c:v>0.97645426172144001</c:v>
                </c:pt>
                <c:pt idx="3370">
                  <c:v>1.3418253348976901</c:v>
                </c:pt>
                <c:pt idx="3371">
                  <c:v>1.07878923864023</c:v>
                </c:pt>
                <c:pt idx="3372">
                  <c:v>0.74175580802405405</c:v>
                </c:pt>
                <c:pt idx="3373">
                  <c:v>0.69885888701230503</c:v>
                </c:pt>
                <c:pt idx="3374">
                  <c:v>0.55897409681370303</c:v>
                </c:pt>
                <c:pt idx="3375">
                  <c:v>0.60353028645881601</c:v>
                </c:pt>
                <c:pt idx="3376">
                  <c:v>1.0879451403584799</c:v>
                </c:pt>
                <c:pt idx="3377">
                  <c:v>0.68731903505167402</c:v>
                </c:pt>
                <c:pt idx="3378">
                  <c:v>0.76229590026444205</c:v>
                </c:pt>
                <c:pt idx="3379">
                  <c:v>0.75959904910002896</c:v>
                </c:pt>
                <c:pt idx="3380">
                  <c:v>0.41974966515316198</c:v>
                </c:pt>
                <c:pt idx="3381">
                  <c:v>0.67956272323007305</c:v>
                </c:pt>
                <c:pt idx="3382">
                  <c:v>0.77938093587928103</c:v>
                </c:pt>
                <c:pt idx="3383">
                  <c:v>0.95037157245366399</c:v>
                </c:pt>
                <c:pt idx="3384">
                  <c:v>0.75636228605621403</c:v>
                </c:pt>
                <c:pt idx="3385">
                  <c:v>1.1832717434948901</c:v>
                </c:pt>
                <c:pt idx="3386">
                  <c:v>0.81021580835861795</c:v>
                </c:pt>
                <c:pt idx="3387">
                  <c:v>0.50957917456324797</c:v>
                </c:pt>
                <c:pt idx="3388">
                  <c:v>0.71710677895728603</c:v>
                </c:pt>
                <c:pt idx="3389">
                  <c:v>1.0436445894228199</c:v>
                </c:pt>
                <c:pt idx="3390">
                  <c:v>1.03525992118806</c:v>
                </c:pt>
                <c:pt idx="3391">
                  <c:v>0.82343721241536705</c:v>
                </c:pt>
                <c:pt idx="3392">
                  <c:v>1.14423755294249</c:v>
                </c:pt>
                <c:pt idx="3393">
                  <c:v>1.20007281827311</c:v>
                </c:pt>
                <c:pt idx="3394">
                  <c:v>1.1504849025613899</c:v>
                </c:pt>
                <c:pt idx="3395">
                  <c:v>1.3201225352413</c:v>
                </c:pt>
                <c:pt idx="3396">
                  <c:v>1.32046822011442</c:v>
                </c:pt>
                <c:pt idx="3397">
                  <c:v>0.81029154344885501</c:v>
                </c:pt>
                <c:pt idx="3398">
                  <c:v>0.85842032005493296</c:v>
                </c:pt>
                <c:pt idx="3399">
                  <c:v>0.95335100397614003</c:v>
                </c:pt>
                <c:pt idx="3400">
                  <c:v>0.99712560035172304</c:v>
                </c:pt>
                <c:pt idx="3401">
                  <c:v>0.72634739454611896</c:v>
                </c:pt>
                <c:pt idx="3402">
                  <c:v>1.50146572158418</c:v>
                </c:pt>
                <c:pt idx="3403">
                  <c:v>0.86931486271492298</c:v>
                </c:pt>
                <c:pt idx="3404">
                  <c:v>1.4958262322896001</c:v>
                </c:pt>
                <c:pt idx="3405">
                  <c:v>1.3216193894961901</c:v>
                </c:pt>
                <c:pt idx="3406">
                  <c:v>1.2397833354583601</c:v>
                </c:pt>
                <c:pt idx="3407">
                  <c:v>0.80309615596970096</c:v>
                </c:pt>
                <c:pt idx="3408">
                  <c:v>1.7568826125088199</c:v>
                </c:pt>
                <c:pt idx="3409">
                  <c:v>1.0046306325508001</c:v>
                </c:pt>
                <c:pt idx="3410">
                  <c:v>0.67169221504766097</c:v>
                </c:pt>
                <c:pt idx="3411">
                  <c:v>0.94285550584706401</c:v>
                </c:pt>
                <c:pt idx="3412">
                  <c:v>0.64752257506356403</c:v>
                </c:pt>
                <c:pt idx="3413">
                  <c:v>0.78611344265999505</c:v>
                </c:pt>
                <c:pt idx="3414">
                  <c:v>0.88902946557384199</c:v>
                </c:pt>
                <c:pt idx="3415">
                  <c:v>1.21195268098229</c:v>
                </c:pt>
                <c:pt idx="3416">
                  <c:v>1.1961890731640501</c:v>
                </c:pt>
                <c:pt idx="3417">
                  <c:v>1.1390601095352999</c:v>
                </c:pt>
                <c:pt idx="3418">
                  <c:v>1.14498696739433</c:v>
                </c:pt>
                <c:pt idx="3419">
                  <c:v>0.72270486965596803</c:v>
                </c:pt>
                <c:pt idx="3420">
                  <c:v>1.90880440628509</c:v>
                </c:pt>
                <c:pt idx="3421">
                  <c:v>1.42726341473896</c:v>
                </c:pt>
                <c:pt idx="3422">
                  <c:v>0.95788971036998105</c:v>
                </c:pt>
                <c:pt idx="3423">
                  <c:v>0.94547538010897403</c:v>
                </c:pt>
                <c:pt idx="3424">
                  <c:v>1.88815476036716</c:v>
                </c:pt>
                <c:pt idx="3425">
                  <c:v>1.6551557737820799</c:v>
                </c:pt>
                <c:pt idx="3426">
                  <c:v>0.97659032660849598</c:v>
                </c:pt>
                <c:pt idx="3427">
                  <c:v>1.7011369751050001</c:v>
                </c:pt>
                <c:pt idx="3428">
                  <c:v>1.5032136881696501</c:v>
                </c:pt>
                <c:pt idx="3429">
                  <c:v>1.5270979909498901</c:v>
                </c:pt>
                <c:pt idx="3430">
                  <c:v>1.75806760139598</c:v>
                </c:pt>
                <c:pt idx="3431">
                  <c:v>1.0730838647469201</c:v>
                </c:pt>
                <c:pt idx="3432">
                  <c:v>1.3823249792032299</c:v>
                </c:pt>
                <c:pt idx="3433">
                  <c:v>1.5817475007864501</c:v>
                </c:pt>
                <c:pt idx="3434">
                  <c:v>2.0459957659407499</c:v>
                </c:pt>
                <c:pt idx="3435">
                  <c:v>1.23178566847268</c:v>
                </c:pt>
                <c:pt idx="3436">
                  <c:v>1.1244496958058601</c:v>
                </c:pt>
                <c:pt idx="3437">
                  <c:v>1.45844536056344</c:v>
                </c:pt>
                <c:pt idx="3438">
                  <c:v>1.02959211696407</c:v>
                </c:pt>
                <c:pt idx="3439">
                  <c:v>0.89618243935144304</c:v>
                </c:pt>
                <c:pt idx="3440">
                  <c:v>1.47589006190489</c:v>
                </c:pt>
                <c:pt idx="3441">
                  <c:v>1.1669207350333901</c:v>
                </c:pt>
                <c:pt idx="3442">
                  <c:v>1.3388155625421401</c:v>
                </c:pt>
                <c:pt idx="3443">
                  <c:v>1.7031524455151399</c:v>
                </c:pt>
                <c:pt idx="3444">
                  <c:v>1.28345866618779</c:v>
                </c:pt>
                <c:pt idx="3445">
                  <c:v>1.42296048591532</c:v>
                </c:pt>
                <c:pt idx="3446">
                  <c:v>1.66209287990342</c:v>
                </c:pt>
                <c:pt idx="3447">
                  <c:v>1.41402452522099</c:v>
                </c:pt>
                <c:pt idx="3448">
                  <c:v>1.0050555554204801</c:v>
                </c:pt>
                <c:pt idx="3449">
                  <c:v>0.79519412717251903</c:v>
                </c:pt>
                <c:pt idx="3450">
                  <c:v>1.7285855323711199</c:v>
                </c:pt>
                <c:pt idx="3451">
                  <c:v>2.48022457255423</c:v>
                </c:pt>
                <c:pt idx="3452">
                  <c:v>1.2876518607841401</c:v>
                </c:pt>
                <c:pt idx="3453">
                  <c:v>1.4268025937045801</c:v>
                </c:pt>
                <c:pt idx="3454">
                  <c:v>2.9353189405359501</c:v>
                </c:pt>
                <c:pt idx="3455">
                  <c:v>3.3021396970091001</c:v>
                </c:pt>
                <c:pt idx="3456">
                  <c:v>2.3027819959018498</c:v>
                </c:pt>
                <c:pt idx="3457">
                  <c:v>1.38653905282592</c:v>
                </c:pt>
                <c:pt idx="3458">
                  <c:v>1.62627481447094</c:v>
                </c:pt>
                <c:pt idx="3459">
                  <c:v>2.2303782698985399</c:v>
                </c:pt>
                <c:pt idx="3460">
                  <c:v>2.0489260477159501</c:v>
                </c:pt>
                <c:pt idx="3461">
                  <c:v>2.0278542101885701</c:v>
                </c:pt>
                <c:pt idx="3462">
                  <c:v>2.1986455661713</c:v>
                </c:pt>
                <c:pt idx="3463">
                  <c:v>1.2229505346602301</c:v>
                </c:pt>
                <c:pt idx="3464">
                  <c:v>1.7932357756116399</c:v>
                </c:pt>
                <c:pt idx="3465">
                  <c:v>2.11587134167879</c:v>
                </c:pt>
                <c:pt idx="3466">
                  <c:v>1.9828855556651399</c:v>
                </c:pt>
                <c:pt idx="3467">
                  <c:v>0.62119423125645401</c:v>
                </c:pt>
                <c:pt idx="3468">
                  <c:v>1.55041146542897</c:v>
                </c:pt>
                <c:pt idx="3469">
                  <c:v>0.93034033190550103</c:v>
                </c:pt>
                <c:pt idx="3470">
                  <c:v>1.36264553015666</c:v>
                </c:pt>
                <c:pt idx="3471">
                  <c:v>1.2147397636344699</c:v>
                </c:pt>
                <c:pt idx="3472">
                  <c:v>1.0722383433415601</c:v>
                </c:pt>
                <c:pt idx="3473">
                  <c:v>1.2779558691561801</c:v>
                </c:pt>
                <c:pt idx="3474">
                  <c:v>1.9273102670212301</c:v>
                </c:pt>
                <c:pt idx="3475">
                  <c:v>1.7501156505983799</c:v>
                </c:pt>
                <c:pt idx="3476">
                  <c:v>1.3615711613828201</c:v>
                </c:pt>
                <c:pt idx="3477">
                  <c:v>1.6575327927708301</c:v>
                </c:pt>
                <c:pt idx="3478">
                  <c:v>1.55184680989396</c:v>
                </c:pt>
                <c:pt idx="3479">
                  <c:v>1.5443577903049199</c:v>
                </c:pt>
                <c:pt idx="3480">
                  <c:v>1.2566777788664301</c:v>
                </c:pt>
                <c:pt idx="3481">
                  <c:v>0.87800987312755696</c:v>
                </c:pt>
                <c:pt idx="3482">
                  <c:v>1.4340164720092301</c:v>
                </c:pt>
                <c:pt idx="3483">
                  <c:v>1.25962151144082</c:v>
                </c:pt>
                <c:pt idx="3484">
                  <c:v>1.4996572255365701</c:v>
                </c:pt>
                <c:pt idx="3485">
                  <c:v>1.5434253909953399</c:v>
                </c:pt>
                <c:pt idx="3486">
                  <c:v>1.41481257027339</c:v>
                </c:pt>
                <c:pt idx="3487">
                  <c:v>1.3695669408820901</c:v>
                </c:pt>
                <c:pt idx="3488">
                  <c:v>1.7279266767430701</c:v>
                </c:pt>
                <c:pt idx="3489">
                  <c:v>1.21253527921683</c:v>
                </c:pt>
                <c:pt idx="3490">
                  <c:v>1.4728917347692401</c:v>
                </c:pt>
                <c:pt idx="3491">
                  <c:v>1.0179013435470501</c:v>
                </c:pt>
                <c:pt idx="3492">
                  <c:v>0.89622965868377003</c:v>
                </c:pt>
                <c:pt idx="3493">
                  <c:v>1.37152091337854</c:v>
                </c:pt>
                <c:pt idx="3494">
                  <c:v>0.69459377091018304</c:v>
                </c:pt>
                <c:pt idx="3495">
                  <c:v>1.1124863660162001</c:v>
                </c:pt>
                <c:pt idx="3496">
                  <c:v>1.5849758057329699</c:v>
                </c:pt>
                <c:pt idx="3497">
                  <c:v>1.41271107133354</c:v>
                </c:pt>
                <c:pt idx="3498">
                  <c:v>0.71671755171906704</c:v>
                </c:pt>
                <c:pt idx="3499">
                  <c:v>0.93833824476009098</c:v>
                </c:pt>
                <c:pt idx="3500">
                  <c:v>0.33862422633570999</c:v>
                </c:pt>
                <c:pt idx="3501">
                  <c:v>0.46212785042587001</c:v>
                </c:pt>
                <c:pt idx="3502">
                  <c:v>0.51595805005051798</c:v>
                </c:pt>
                <c:pt idx="3503">
                  <c:v>0.95259296467270205</c:v>
                </c:pt>
                <c:pt idx="3504">
                  <c:v>0.85716972675319203</c:v>
                </c:pt>
                <c:pt idx="3505">
                  <c:v>0.69845029126059299</c:v>
                </c:pt>
                <c:pt idx="3506">
                  <c:v>1.1254511190552401</c:v>
                </c:pt>
                <c:pt idx="3507">
                  <c:v>0.98207158610013701</c:v>
                </c:pt>
                <c:pt idx="3508">
                  <c:v>0.74448436774198701</c:v>
                </c:pt>
                <c:pt idx="3509">
                  <c:v>1.05915529239285</c:v>
                </c:pt>
                <c:pt idx="3510">
                  <c:v>1.01136096602609</c:v>
                </c:pt>
                <c:pt idx="3511">
                  <c:v>0.997141543563279</c:v>
                </c:pt>
                <c:pt idx="3512">
                  <c:v>0.99002768994350698</c:v>
                </c:pt>
                <c:pt idx="3513">
                  <c:v>0.78177661789100905</c:v>
                </c:pt>
                <c:pt idx="3514">
                  <c:v>1.37127997218196</c:v>
                </c:pt>
                <c:pt idx="3515">
                  <c:v>0.98519306503186199</c:v>
                </c:pt>
                <c:pt idx="3516">
                  <c:v>0.789406452762761</c:v>
                </c:pt>
                <c:pt idx="3517">
                  <c:v>1.2157891404736201</c:v>
                </c:pt>
                <c:pt idx="3518">
                  <c:v>0.84591569079734896</c:v>
                </c:pt>
                <c:pt idx="3519">
                  <c:v>1.24331862571634</c:v>
                </c:pt>
                <c:pt idx="3520">
                  <c:v>1.4581548589042601</c:v>
                </c:pt>
                <c:pt idx="3521">
                  <c:v>0.95632178709836302</c:v>
                </c:pt>
                <c:pt idx="3522">
                  <c:v>1.1859502811290501</c:v>
                </c:pt>
                <c:pt idx="3523">
                  <c:v>1.1679746604832399</c:v>
                </c:pt>
                <c:pt idx="3524">
                  <c:v>1.11075254237161</c:v>
                </c:pt>
                <c:pt idx="3525">
                  <c:v>0.99721658402906099</c:v>
                </c:pt>
                <c:pt idx="3526">
                  <c:v>0.82739249613965904</c:v>
                </c:pt>
                <c:pt idx="3527">
                  <c:v>1.6603791671854999</c:v>
                </c:pt>
                <c:pt idx="3528">
                  <c:v>1.12513727203876</c:v>
                </c:pt>
                <c:pt idx="3529">
                  <c:v>0.96941313778368199</c:v>
                </c:pt>
                <c:pt idx="3530">
                  <c:v>1.3409077448428199</c:v>
                </c:pt>
                <c:pt idx="3531">
                  <c:v>1.01527375498821</c:v>
                </c:pt>
                <c:pt idx="3532">
                  <c:v>0.55363223585131605</c:v>
                </c:pt>
                <c:pt idx="3533">
                  <c:v>0.8559898111409</c:v>
                </c:pt>
                <c:pt idx="3534">
                  <c:v>0.66275118669467803</c:v>
                </c:pt>
                <c:pt idx="3535">
                  <c:v>0.60534058448485095</c:v>
                </c:pt>
                <c:pt idx="3536">
                  <c:v>0.76203182751717402</c:v>
                </c:pt>
                <c:pt idx="3537">
                  <c:v>0.93222659822346099</c:v>
                </c:pt>
                <c:pt idx="3538">
                  <c:v>1.2365983191563199</c:v>
                </c:pt>
                <c:pt idx="3539">
                  <c:v>0.94277886430166302</c:v>
                </c:pt>
                <c:pt idx="3540">
                  <c:v>0.98074977271503805</c:v>
                </c:pt>
                <c:pt idx="3541">
                  <c:v>1.04873993945373</c:v>
                </c:pt>
                <c:pt idx="3542">
                  <c:v>0.92022684939920996</c:v>
                </c:pt>
                <c:pt idx="3543">
                  <c:v>0.66045054815085302</c:v>
                </c:pt>
                <c:pt idx="3544">
                  <c:v>1.14380554097485</c:v>
                </c:pt>
                <c:pt idx="3545">
                  <c:v>1.4263375569855501</c:v>
                </c:pt>
                <c:pt idx="3546">
                  <c:v>1.5253991287731901</c:v>
                </c:pt>
                <c:pt idx="3547">
                  <c:v>0.813427467780104</c:v>
                </c:pt>
                <c:pt idx="3548">
                  <c:v>1.4035337737937801</c:v>
                </c:pt>
                <c:pt idx="3549">
                  <c:v>0.98990320258309605</c:v>
                </c:pt>
                <c:pt idx="3550">
                  <c:v>0.92076543973811797</c:v>
                </c:pt>
                <c:pt idx="3551">
                  <c:v>0.63836770986990798</c:v>
                </c:pt>
                <c:pt idx="3552">
                  <c:v>0.88138009391111805</c:v>
                </c:pt>
                <c:pt idx="3553">
                  <c:v>0.88134824974937698</c:v>
                </c:pt>
                <c:pt idx="3554">
                  <c:v>0.829452732600926</c:v>
                </c:pt>
                <c:pt idx="3555">
                  <c:v>1.2785213106578099</c:v>
                </c:pt>
                <c:pt idx="3556">
                  <c:v>1.26663378389407</c:v>
                </c:pt>
                <c:pt idx="3557">
                  <c:v>0.91261077568217097</c:v>
                </c:pt>
                <c:pt idx="3558">
                  <c:v>0.87974539811278696</c:v>
                </c:pt>
                <c:pt idx="3559">
                  <c:v>0.68554666262583097</c:v>
                </c:pt>
                <c:pt idx="3560">
                  <c:v>0.55013188263166601</c:v>
                </c:pt>
                <c:pt idx="3561">
                  <c:v>1.0175686164729101</c:v>
                </c:pt>
                <c:pt idx="3562">
                  <c:v>0.66673813730320497</c:v>
                </c:pt>
                <c:pt idx="3563">
                  <c:v>1.00904516479837</c:v>
                </c:pt>
                <c:pt idx="3564">
                  <c:v>1.16834650845085</c:v>
                </c:pt>
                <c:pt idx="3565">
                  <c:v>0.57088210154696695</c:v>
                </c:pt>
                <c:pt idx="3566">
                  <c:v>0.83782507460017797</c:v>
                </c:pt>
                <c:pt idx="3567">
                  <c:v>1.25654787229986</c:v>
                </c:pt>
                <c:pt idx="3568">
                  <c:v>0.63767405485969297</c:v>
                </c:pt>
                <c:pt idx="3569">
                  <c:v>0.99034694383382305</c:v>
                </c:pt>
                <c:pt idx="3570">
                  <c:v>1.10990147881347</c:v>
                </c:pt>
                <c:pt idx="3571">
                  <c:v>1.03559441925796</c:v>
                </c:pt>
                <c:pt idx="3572">
                  <c:v>0.844253701557651</c:v>
                </c:pt>
                <c:pt idx="3573">
                  <c:v>0.89032622868404798</c:v>
                </c:pt>
                <c:pt idx="3574">
                  <c:v>0.83500275746844699</c:v>
                </c:pt>
                <c:pt idx="3575">
                  <c:v>1.0265004481639799</c:v>
                </c:pt>
                <c:pt idx="3576">
                  <c:v>1.0060089277662101</c:v>
                </c:pt>
                <c:pt idx="3577">
                  <c:v>1.0883909243369001</c:v>
                </c:pt>
                <c:pt idx="3578">
                  <c:v>1.0382929112917201</c:v>
                </c:pt>
                <c:pt idx="3579">
                  <c:v>1.23087696722384</c:v>
                </c:pt>
                <c:pt idx="3580">
                  <c:v>1.3915244215356799</c:v>
                </c:pt>
                <c:pt idx="3581">
                  <c:v>1.0579720297019599</c:v>
                </c:pt>
                <c:pt idx="3582">
                  <c:v>1.7213475812527701</c:v>
                </c:pt>
                <c:pt idx="3583">
                  <c:v>1.1438051320981499</c:v>
                </c:pt>
                <c:pt idx="3584">
                  <c:v>0.70690150861374701</c:v>
                </c:pt>
                <c:pt idx="3585">
                  <c:v>1.0248949944645001</c:v>
                </c:pt>
                <c:pt idx="3586">
                  <c:v>1.3985057744562699</c:v>
                </c:pt>
                <c:pt idx="3587">
                  <c:v>0.91290026333523699</c:v>
                </c:pt>
                <c:pt idx="3588">
                  <c:v>1.03974003970319</c:v>
                </c:pt>
                <c:pt idx="3589">
                  <c:v>0.66214383400545895</c:v>
                </c:pt>
                <c:pt idx="3590">
                  <c:v>0.75365254036672102</c:v>
                </c:pt>
                <c:pt idx="3591">
                  <c:v>0.83944682861542297</c:v>
                </c:pt>
                <c:pt idx="3592">
                  <c:v>1.0179191499978999</c:v>
                </c:pt>
                <c:pt idx="3593">
                  <c:v>0.99435780066617396</c:v>
                </c:pt>
                <c:pt idx="3594">
                  <c:v>0.84621714203387599</c:v>
                </c:pt>
                <c:pt idx="3595">
                  <c:v>1.53024001886179</c:v>
                </c:pt>
                <c:pt idx="3596">
                  <c:v>0.84160846965673097</c:v>
                </c:pt>
                <c:pt idx="3597">
                  <c:v>1.0205326084192401</c:v>
                </c:pt>
                <c:pt idx="3598">
                  <c:v>1.72801935768203</c:v>
                </c:pt>
                <c:pt idx="3599">
                  <c:v>0.81014998296502805</c:v>
                </c:pt>
                <c:pt idx="3600">
                  <c:v>0.63842266176148499</c:v>
                </c:pt>
                <c:pt idx="3601">
                  <c:v>0.95936594678188702</c:v>
                </c:pt>
                <c:pt idx="3602">
                  <c:v>0.90550653020576999</c:v>
                </c:pt>
                <c:pt idx="3603">
                  <c:v>0.88173166381076695</c:v>
                </c:pt>
                <c:pt idx="3604">
                  <c:v>1.1971183202475699</c:v>
                </c:pt>
                <c:pt idx="3605">
                  <c:v>0.61463012904738401</c:v>
                </c:pt>
                <c:pt idx="3606">
                  <c:v>0.854305862943193</c:v>
                </c:pt>
                <c:pt idx="3607">
                  <c:v>1.45163112493282</c:v>
                </c:pt>
                <c:pt idx="3608">
                  <c:v>0.85557287233854695</c:v>
                </c:pt>
                <c:pt idx="3609">
                  <c:v>1.2443152713715</c:v>
                </c:pt>
                <c:pt idx="3610">
                  <c:v>0.91368071551820096</c:v>
                </c:pt>
                <c:pt idx="3611">
                  <c:v>1.2147706808472101</c:v>
                </c:pt>
                <c:pt idx="3612">
                  <c:v>1.79074944852661</c:v>
                </c:pt>
                <c:pt idx="3613">
                  <c:v>0.82549982439827096</c:v>
                </c:pt>
                <c:pt idx="3614">
                  <c:v>1.82047878605308</c:v>
                </c:pt>
                <c:pt idx="3615">
                  <c:v>1.1687499481372301</c:v>
                </c:pt>
                <c:pt idx="3616">
                  <c:v>1.3041042986999201</c:v>
                </c:pt>
                <c:pt idx="3617">
                  <c:v>1.6314827792200299</c:v>
                </c:pt>
                <c:pt idx="3618">
                  <c:v>1.38099300914106</c:v>
                </c:pt>
                <c:pt idx="3619">
                  <c:v>2.0584175134445699</c:v>
                </c:pt>
                <c:pt idx="3620">
                  <c:v>2.1969356922709</c:v>
                </c:pt>
                <c:pt idx="3621">
                  <c:v>1.8168779209040899</c:v>
                </c:pt>
                <c:pt idx="3622">
                  <c:v>1.40269490712265</c:v>
                </c:pt>
                <c:pt idx="3623">
                  <c:v>1.09131326383956</c:v>
                </c:pt>
                <c:pt idx="3624">
                  <c:v>1.1533254648184601</c:v>
                </c:pt>
                <c:pt idx="3625">
                  <c:v>0.46536728272462202</c:v>
                </c:pt>
                <c:pt idx="3626">
                  <c:v>0.773234379541897</c:v>
                </c:pt>
                <c:pt idx="3627">
                  <c:v>1.5509047298174199</c:v>
                </c:pt>
                <c:pt idx="3628">
                  <c:v>0.66098542316609299</c:v>
                </c:pt>
                <c:pt idx="3629">
                  <c:v>1.40933994338612</c:v>
                </c:pt>
                <c:pt idx="3630">
                  <c:v>0.90924817631690202</c:v>
                </c:pt>
                <c:pt idx="3631">
                  <c:v>0.87093124997961702</c:v>
                </c:pt>
                <c:pt idx="3632">
                  <c:v>1.15467137546698</c:v>
                </c:pt>
                <c:pt idx="3633">
                  <c:v>0.86970157150759397</c:v>
                </c:pt>
                <c:pt idx="3634">
                  <c:v>1.35207734301075</c:v>
                </c:pt>
                <c:pt idx="3635">
                  <c:v>1.4449000543293999</c:v>
                </c:pt>
                <c:pt idx="3636">
                  <c:v>0.95210650319280599</c:v>
                </c:pt>
                <c:pt idx="3637">
                  <c:v>0.73104656573682902</c:v>
                </c:pt>
                <c:pt idx="3638">
                  <c:v>0.80530810656346397</c:v>
                </c:pt>
                <c:pt idx="3639">
                  <c:v>0.99477318409120297</c:v>
                </c:pt>
                <c:pt idx="3640">
                  <c:v>0.83802497919518604</c:v>
                </c:pt>
                <c:pt idx="3641">
                  <c:v>0.68528841292823395</c:v>
                </c:pt>
                <c:pt idx="3642">
                  <c:v>0.69759035661191005</c:v>
                </c:pt>
                <c:pt idx="3643">
                  <c:v>0.991995009665396</c:v>
                </c:pt>
                <c:pt idx="3644">
                  <c:v>0.66339513204352896</c:v>
                </c:pt>
                <c:pt idx="3645">
                  <c:v>1.24660277807852</c:v>
                </c:pt>
                <c:pt idx="3646">
                  <c:v>0.85676392722177697</c:v>
                </c:pt>
                <c:pt idx="3647">
                  <c:v>1.0498092068384499</c:v>
                </c:pt>
                <c:pt idx="3648">
                  <c:v>1.10009580555811</c:v>
                </c:pt>
                <c:pt idx="3649">
                  <c:v>0.93031094630591005</c:v>
                </c:pt>
                <c:pt idx="3650">
                  <c:v>0.75910195283279402</c:v>
                </c:pt>
                <c:pt idx="3651">
                  <c:v>0.78215017084151495</c:v>
                </c:pt>
                <c:pt idx="3652">
                  <c:v>1.05199565387295</c:v>
                </c:pt>
                <c:pt idx="3653">
                  <c:v>0.35576981102194299</c:v>
                </c:pt>
                <c:pt idx="3654">
                  <c:v>0.315257623729438</c:v>
                </c:pt>
                <c:pt idx="3655">
                  <c:v>0.77253191542862198</c:v>
                </c:pt>
                <c:pt idx="3656">
                  <c:v>0.44579577230866702</c:v>
                </c:pt>
                <c:pt idx="3657">
                  <c:v>1.31412479626031</c:v>
                </c:pt>
                <c:pt idx="3658">
                  <c:v>0.933287532586212</c:v>
                </c:pt>
                <c:pt idx="3659">
                  <c:v>0.90723914357888802</c:v>
                </c:pt>
                <c:pt idx="3660">
                  <c:v>0.919981431857814</c:v>
                </c:pt>
                <c:pt idx="3661">
                  <c:v>1.28421862435889</c:v>
                </c:pt>
                <c:pt idx="3662">
                  <c:v>0.89845887324120399</c:v>
                </c:pt>
                <c:pt idx="3663">
                  <c:v>1.0721094825389801</c:v>
                </c:pt>
                <c:pt idx="3664">
                  <c:v>0.83873960790048596</c:v>
                </c:pt>
                <c:pt idx="3665">
                  <c:v>0.87348573608573099</c:v>
                </c:pt>
                <c:pt idx="3666">
                  <c:v>0.87689528725823396</c:v>
                </c:pt>
                <c:pt idx="3667">
                  <c:v>0.8980562778251</c:v>
                </c:pt>
                <c:pt idx="3668">
                  <c:v>1.0372887361079499</c:v>
                </c:pt>
                <c:pt idx="3669">
                  <c:v>0.86633389994524901</c:v>
                </c:pt>
                <c:pt idx="3670">
                  <c:v>0.62682452526901</c:v>
                </c:pt>
                <c:pt idx="3671">
                  <c:v>0.59208098798307296</c:v>
                </c:pt>
                <c:pt idx="3672">
                  <c:v>0.82101318197171802</c:v>
                </c:pt>
                <c:pt idx="3673">
                  <c:v>0.47376684084054999</c:v>
                </c:pt>
                <c:pt idx="3674">
                  <c:v>0.89201785111600396</c:v>
                </c:pt>
                <c:pt idx="3675">
                  <c:v>0.78870539133505202</c:v>
                </c:pt>
                <c:pt idx="3676">
                  <c:v>0.75382747294540897</c:v>
                </c:pt>
                <c:pt idx="3677">
                  <c:v>0.604120961568545</c:v>
                </c:pt>
                <c:pt idx="3678">
                  <c:v>0.81623212054568295</c:v>
                </c:pt>
                <c:pt idx="3679">
                  <c:v>0.38305640593853502</c:v>
                </c:pt>
                <c:pt idx="3680">
                  <c:v>1.2744274291228399</c:v>
                </c:pt>
                <c:pt idx="3681">
                  <c:v>0.731955716327922</c:v>
                </c:pt>
                <c:pt idx="3682">
                  <c:v>1.02965982966877</c:v>
                </c:pt>
                <c:pt idx="3683">
                  <c:v>0.95809224165834395</c:v>
                </c:pt>
                <c:pt idx="3684">
                  <c:v>1.3259987194681799</c:v>
                </c:pt>
                <c:pt idx="3685">
                  <c:v>1.1150291369499401</c:v>
                </c:pt>
                <c:pt idx="3686">
                  <c:v>1.3705264556628201</c:v>
                </c:pt>
                <c:pt idx="3687">
                  <c:v>1.2905067885294199</c:v>
                </c:pt>
                <c:pt idx="3688">
                  <c:v>1.1198259060786599</c:v>
                </c:pt>
                <c:pt idx="3689">
                  <c:v>1.78129477116079</c:v>
                </c:pt>
                <c:pt idx="3690">
                  <c:v>1.26567081694161</c:v>
                </c:pt>
                <c:pt idx="3691">
                  <c:v>1.35499583997601</c:v>
                </c:pt>
                <c:pt idx="3692">
                  <c:v>0.98368666901287505</c:v>
                </c:pt>
                <c:pt idx="3693">
                  <c:v>0.97710875945351106</c:v>
                </c:pt>
                <c:pt idx="3694">
                  <c:v>0.92360390916660695</c:v>
                </c:pt>
                <c:pt idx="3695">
                  <c:v>0.96582655193620603</c:v>
                </c:pt>
                <c:pt idx="3696">
                  <c:v>0.65420934244857198</c:v>
                </c:pt>
                <c:pt idx="3697">
                  <c:v>0.90039362791621502</c:v>
                </c:pt>
                <c:pt idx="3698">
                  <c:v>1.51300834453912</c:v>
                </c:pt>
                <c:pt idx="3699">
                  <c:v>1.0344301142677701</c:v>
                </c:pt>
                <c:pt idx="3700">
                  <c:v>1.0557341168804999</c:v>
                </c:pt>
                <c:pt idx="3701">
                  <c:v>1.20409062100244</c:v>
                </c:pt>
                <c:pt idx="3702">
                  <c:v>1.50804529880154</c:v>
                </c:pt>
                <c:pt idx="3703">
                  <c:v>1.4744930611270599</c:v>
                </c:pt>
                <c:pt idx="3704">
                  <c:v>1.4827971535089</c:v>
                </c:pt>
                <c:pt idx="3705">
                  <c:v>0.601722127166186</c:v>
                </c:pt>
                <c:pt idx="3706">
                  <c:v>1.3928624597111401</c:v>
                </c:pt>
                <c:pt idx="3707">
                  <c:v>1.00472541051539</c:v>
                </c:pt>
                <c:pt idx="3708">
                  <c:v>1.2425700662535999</c:v>
                </c:pt>
                <c:pt idx="3709">
                  <c:v>0.86253739055213996</c:v>
                </c:pt>
                <c:pt idx="3710">
                  <c:v>1.5442291835380499</c:v>
                </c:pt>
                <c:pt idx="3711">
                  <c:v>1.06092803444646</c:v>
                </c:pt>
                <c:pt idx="3712">
                  <c:v>0.84147117319484499</c:v>
                </c:pt>
                <c:pt idx="3713">
                  <c:v>1.2050061716034299</c:v>
                </c:pt>
                <c:pt idx="3714">
                  <c:v>1.15042241335088</c:v>
                </c:pt>
                <c:pt idx="3715">
                  <c:v>0.63248742740876995</c:v>
                </c:pt>
                <c:pt idx="3716">
                  <c:v>1.02762800918516</c:v>
                </c:pt>
                <c:pt idx="3717">
                  <c:v>1.0426792251778101</c:v>
                </c:pt>
                <c:pt idx="3718">
                  <c:v>0.76188257711075502</c:v>
                </c:pt>
                <c:pt idx="3719">
                  <c:v>0.73834288860979602</c:v>
                </c:pt>
                <c:pt idx="3720">
                  <c:v>1.26491743005047</c:v>
                </c:pt>
                <c:pt idx="3721">
                  <c:v>1.1493090168331499</c:v>
                </c:pt>
                <c:pt idx="3722">
                  <c:v>0.97164442587826005</c:v>
                </c:pt>
                <c:pt idx="3723">
                  <c:v>0.92657666596064003</c:v>
                </c:pt>
                <c:pt idx="3724">
                  <c:v>0.90889080773896103</c:v>
                </c:pt>
                <c:pt idx="3725">
                  <c:v>0.97739051767894003</c:v>
                </c:pt>
                <c:pt idx="3726">
                  <c:v>1.0857987122338699</c:v>
                </c:pt>
                <c:pt idx="3727">
                  <c:v>1.0955923830984899</c:v>
                </c:pt>
                <c:pt idx="3728">
                  <c:v>1.3206312449520401</c:v>
                </c:pt>
                <c:pt idx="3729">
                  <c:v>0.85028476128143304</c:v>
                </c:pt>
                <c:pt idx="3730">
                  <c:v>0.77398863408464302</c:v>
                </c:pt>
                <c:pt idx="3731">
                  <c:v>0.63802451617141298</c:v>
                </c:pt>
                <c:pt idx="3732">
                  <c:v>0.798271790193682</c:v>
                </c:pt>
                <c:pt idx="3733">
                  <c:v>0.69307324889439503</c:v>
                </c:pt>
                <c:pt idx="3734">
                  <c:v>0.87841896082248205</c:v>
                </c:pt>
                <c:pt idx="3735">
                  <c:v>1.18040528357817</c:v>
                </c:pt>
                <c:pt idx="3736">
                  <c:v>1.1567862870197301</c:v>
                </c:pt>
                <c:pt idx="3737">
                  <c:v>0.71771258815345296</c:v>
                </c:pt>
                <c:pt idx="3738">
                  <c:v>0.95972784660646504</c:v>
                </c:pt>
                <c:pt idx="3739">
                  <c:v>0.80349643482364397</c:v>
                </c:pt>
                <c:pt idx="3740">
                  <c:v>0.95574602652228702</c:v>
                </c:pt>
                <c:pt idx="3741">
                  <c:v>0.817565474448392</c:v>
                </c:pt>
                <c:pt idx="3742">
                  <c:v>1.06907902538355</c:v>
                </c:pt>
                <c:pt idx="3743">
                  <c:v>0.438248235095474</c:v>
                </c:pt>
                <c:pt idx="3744">
                  <c:v>0.65538386406769999</c:v>
                </c:pt>
                <c:pt idx="3745">
                  <c:v>0.79129959191627797</c:v>
                </c:pt>
                <c:pt idx="3746">
                  <c:v>0.67444081198045502</c:v>
                </c:pt>
                <c:pt idx="3747">
                  <c:v>0.81513562413819496</c:v>
                </c:pt>
                <c:pt idx="3748">
                  <c:v>0.99480575267521898</c:v>
                </c:pt>
                <c:pt idx="3749">
                  <c:v>1.2674755024178099</c:v>
                </c:pt>
                <c:pt idx="3750">
                  <c:v>1.2023056310833</c:v>
                </c:pt>
                <c:pt idx="3751">
                  <c:v>0.91117910307231798</c:v>
                </c:pt>
                <c:pt idx="3752">
                  <c:v>0.83488042604202295</c:v>
                </c:pt>
                <c:pt idx="3753">
                  <c:v>1.140799379111</c:v>
                </c:pt>
                <c:pt idx="3754">
                  <c:v>0.72430716177112398</c:v>
                </c:pt>
                <c:pt idx="3755">
                  <c:v>0.63929212307424799</c:v>
                </c:pt>
                <c:pt idx="3756">
                  <c:v>0.98829410018137498</c:v>
                </c:pt>
                <c:pt idx="3757">
                  <c:v>1.0598270169314099</c:v>
                </c:pt>
                <c:pt idx="3758">
                  <c:v>0.77531338700257901</c:v>
                </c:pt>
                <c:pt idx="3759">
                  <c:v>0.59572124566314899</c:v>
                </c:pt>
                <c:pt idx="3760">
                  <c:v>0.85017641889350304</c:v>
                </c:pt>
                <c:pt idx="3761">
                  <c:v>1.0581529103457099</c:v>
                </c:pt>
                <c:pt idx="3762">
                  <c:v>1.0880816915712901</c:v>
                </c:pt>
                <c:pt idx="3763">
                  <c:v>1.24216625073808</c:v>
                </c:pt>
                <c:pt idx="3764">
                  <c:v>1.0182685407774199</c:v>
                </c:pt>
                <c:pt idx="3765">
                  <c:v>0.73882669744987595</c:v>
                </c:pt>
                <c:pt idx="3766">
                  <c:v>0.98560195850127497</c:v>
                </c:pt>
                <c:pt idx="3767">
                  <c:v>1.2086078311072601</c:v>
                </c:pt>
                <c:pt idx="3768">
                  <c:v>0.90891669740302306</c:v>
                </c:pt>
                <c:pt idx="3769">
                  <c:v>0.89450810118643198</c:v>
                </c:pt>
                <c:pt idx="3770">
                  <c:v>0.93209248064287997</c:v>
                </c:pt>
                <c:pt idx="3771">
                  <c:v>0.68517134973303395</c:v>
                </c:pt>
                <c:pt idx="3772">
                  <c:v>1.0217240477723699</c:v>
                </c:pt>
                <c:pt idx="3773">
                  <c:v>0.67650870033785004</c:v>
                </c:pt>
                <c:pt idx="3774">
                  <c:v>0.57868791290403698</c:v>
                </c:pt>
                <c:pt idx="3775">
                  <c:v>0.58047438804519902</c:v>
                </c:pt>
                <c:pt idx="3776">
                  <c:v>0.95602717041916196</c:v>
                </c:pt>
                <c:pt idx="3777">
                  <c:v>1.1179663310427601</c:v>
                </c:pt>
                <c:pt idx="3778">
                  <c:v>1.3580906240627599</c:v>
                </c:pt>
                <c:pt idx="3779">
                  <c:v>0.89154984544973104</c:v>
                </c:pt>
                <c:pt idx="3780">
                  <c:v>1.1567431910419701</c:v>
                </c:pt>
                <c:pt idx="3781">
                  <c:v>1.4976019217457099</c:v>
                </c:pt>
                <c:pt idx="3782">
                  <c:v>1.2907856445508801</c:v>
                </c:pt>
                <c:pt idx="3783">
                  <c:v>0.96657159170090101</c:v>
                </c:pt>
                <c:pt idx="3784">
                  <c:v>1.19704192943729</c:v>
                </c:pt>
                <c:pt idx="3785">
                  <c:v>0.77431545726256301</c:v>
                </c:pt>
                <c:pt idx="3786">
                  <c:v>0.74852357555038995</c:v>
                </c:pt>
                <c:pt idx="3787">
                  <c:v>1.0555816662698301</c:v>
                </c:pt>
                <c:pt idx="3788">
                  <c:v>0.81111880291170302</c:v>
                </c:pt>
                <c:pt idx="3789">
                  <c:v>0.49267413351144002</c:v>
                </c:pt>
                <c:pt idx="3790">
                  <c:v>0.72630328573349601</c:v>
                </c:pt>
                <c:pt idx="3791">
                  <c:v>0.65299106270915597</c:v>
                </c:pt>
                <c:pt idx="3792">
                  <c:v>0.543072145491174</c:v>
                </c:pt>
                <c:pt idx="3793">
                  <c:v>0.93290244715587201</c:v>
                </c:pt>
                <c:pt idx="3794">
                  <c:v>0.59002741479029797</c:v>
                </c:pt>
                <c:pt idx="3795">
                  <c:v>0.66163871445473699</c:v>
                </c:pt>
                <c:pt idx="3796">
                  <c:v>0.64857973974722105</c:v>
                </c:pt>
                <c:pt idx="3797">
                  <c:v>1.1497408993117</c:v>
                </c:pt>
                <c:pt idx="3798">
                  <c:v>0.77171567947623898</c:v>
                </c:pt>
                <c:pt idx="3799">
                  <c:v>0.98346360597566196</c:v>
                </c:pt>
                <c:pt idx="3800">
                  <c:v>0.98312970096320795</c:v>
                </c:pt>
                <c:pt idx="3801">
                  <c:v>0.85208595211393301</c:v>
                </c:pt>
                <c:pt idx="3802">
                  <c:v>0.64793271172891698</c:v>
                </c:pt>
                <c:pt idx="3803">
                  <c:v>1.14191592046672</c:v>
                </c:pt>
                <c:pt idx="3804">
                  <c:v>0.63657372680842506</c:v>
                </c:pt>
                <c:pt idx="3805">
                  <c:v>1.0160325454814001</c:v>
                </c:pt>
                <c:pt idx="3806">
                  <c:v>0.91080357341218299</c:v>
                </c:pt>
                <c:pt idx="3807">
                  <c:v>0.62637429516938403</c:v>
                </c:pt>
                <c:pt idx="3808">
                  <c:v>0.53276947502260197</c:v>
                </c:pt>
                <c:pt idx="3809">
                  <c:v>0.88178617887340305</c:v>
                </c:pt>
                <c:pt idx="3810">
                  <c:v>0.96892617908582201</c:v>
                </c:pt>
                <c:pt idx="3811">
                  <c:v>0.64526657889612204</c:v>
                </c:pt>
                <c:pt idx="3812">
                  <c:v>0.58994822183187601</c:v>
                </c:pt>
                <c:pt idx="3813">
                  <c:v>1.4060884174511501</c:v>
                </c:pt>
                <c:pt idx="3814">
                  <c:v>0.77748214321994202</c:v>
                </c:pt>
                <c:pt idx="3815">
                  <c:v>0.60922156568487695</c:v>
                </c:pt>
                <c:pt idx="3816">
                  <c:v>0.57246254368072602</c:v>
                </c:pt>
                <c:pt idx="3817">
                  <c:v>0.73716649711983495</c:v>
                </c:pt>
                <c:pt idx="3818">
                  <c:v>1.15428807976684</c:v>
                </c:pt>
                <c:pt idx="3819">
                  <c:v>0.656969444047662</c:v>
                </c:pt>
                <c:pt idx="3820">
                  <c:v>1.05536932102041</c:v>
                </c:pt>
                <c:pt idx="3821">
                  <c:v>0.62303471472410599</c:v>
                </c:pt>
                <c:pt idx="3822">
                  <c:v>0.91749478469471801</c:v>
                </c:pt>
                <c:pt idx="3823">
                  <c:v>0.93152280570513801</c:v>
                </c:pt>
                <c:pt idx="3824">
                  <c:v>0.60286465378018395</c:v>
                </c:pt>
                <c:pt idx="3825">
                  <c:v>0.71104136044307198</c:v>
                </c:pt>
                <c:pt idx="3826">
                  <c:v>0.77611502971513802</c:v>
                </c:pt>
                <c:pt idx="3827">
                  <c:v>0.63103582098448296</c:v>
                </c:pt>
                <c:pt idx="3828">
                  <c:v>0.89987309086317302</c:v>
                </c:pt>
                <c:pt idx="3829">
                  <c:v>0.62086739763388898</c:v>
                </c:pt>
                <c:pt idx="3830">
                  <c:v>0.31895153262055198</c:v>
                </c:pt>
                <c:pt idx="3831">
                  <c:v>0.91419856649481801</c:v>
                </c:pt>
                <c:pt idx="3832">
                  <c:v>0.84701140792749596</c:v>
                </c:pt>
                <c:pt idx="3833">
                  <c:v>0.66343970590649404</c:v>
                </c:pt>
                <c:pt idx="3834">
                  <c:v>0.45058473973850299</c:v>
                </c:pt>
                <c:pt idx="3835">
                  <c:v>0.55183451739681499</c:v>
                </c:pt>
                <c:pt idx="3836">
                  <c:v>0.44984702226865902</c:v>
                </c:pt>
                <c:pt idx="3837">
                  <c:v>0.648363597360329</c:v>
                </c:pt>
                <c:pt idx="3838">
                  <c:v>1.12947520634604</c:v>
                </c:pt>
                <c:pt idx="3839">
                  <c:v>0.83324468878231395</c:v>
                </c:pt>
                <c:pt idx="3840">
                  <c:v>0.72565972622777597</c:v>
                </c:pt>
                <c:pt idx="3841">
                  <c:v>0.563791237811895</c:v>
                </c:pt>
                <c:pt idx="3842">
                  <c:v>1.0429361686727201</c:v>
                </c:pt>
                <c:pt idx="3843">
                  <c:v>0.64723453553648502</c:v>
                </c:pt>
                <c:pt idx="3844">
                  <c:v>1.0996306100386899</c:v>
                </c:pt>
                <c:pt idx="3845">
                  <c:v>0.73204514050249303</c:v>
                </c:pt>
                <c:pt idx="3846">
                  <c:v>0.918251247565819</c:v>
                </c:pt>
                <c:pt idx="3847">
                  <c:v>1.12982150291645</c:v>
                </c:pt>
                <c:pt idx="3848">
                  <c:v>1.3399981846012401</c:v>
                </c:pt>
                <c:pt idx="3849">
                  <c:v>0.93323213084472101</c:v>
                </c:pt>
                <c:pt idx="3850">
                  <c:v>1.04792196207085</c:v>
                </c:pt>
                <c:pt idx="3851">
                  <c:v>0.87396522132376298</c:v>
                </c:pt>
                <c:pt idx="3852">
                  <c:v>1.3650434205053099</c:v>
                </c:pt>
                <c:pt idx="3853">
                  <c:v>0.98116485479697602</c:v>
                </c:pt>
                <c:pt idx="3854">
                  <c:v>0.96212270773016995</c:v>
                </c:pt>
                <c:pt idx="3855">
                  <c:v>1.3240017445029799</c:v>
                </c:pt>
                <c:pt idx="3856">
                  <c:v>0.89742185065096602</c:v>
                </c:pt>
                <c:pt idx="3857">
                  <c:v>0.87914211093115102</c:v>
                </c:pt>
                <c:pt idx="3858">
                  <c:v>0.99096255289361401</c:v>
                </c:pt>
                <c:pt idx="3859">
                  <c:v>0.84551639361798803</c:v>
                </c:pt>
                <c:pt idx="3860">
                  <c:v>0.82870248361750198</c:v>
                </c:pt>
                <c:pt idx="3861">
                  <c:v>1.37168942638241</c:v>
                </c:pt>
                <c:pt idx="3862">
                  <c:v>1.52649330526066</c:v>
                </c:pt>
                <c:pt idx="3863">
                  <c:v>1.18109691681034</c:v>
                </c:pt>
                <c:pt idx="3864">
                  <c:v>1.14462925137731</c:v>
                </c:pt>
                <c:pt idx="3865">
                  <c:v>1.1634409175970299</c:v>
                </c:pt>
                <c:pt idx="3866">
                  <c:v>1.00680864742081</c:v>
                </c:pt>
                <c:pt idx="3867">
                  <c:v>1.1387325286669201</c:v>
                </c:pt>
                <c:pt idx="3868">
                  <c:v>1.09692205992805</c:v>
                </c:pt>
                <c:pt idx="3869">
                  <c:v>0.98744305777244601</c:v>
                </c:pt>
                <c:pt idx="3870">
                  <c:v>1.07386510007494</c:v>
                </c:pt>
                <c:pt idx="3871">
                  <c:v>1.3510045821208401</c:v>
                </c:pt>
                <c:pt idx="3872">
                  <c:v>1.5915841195423099</c:v>
                </c:pt>
                <c:pt idx="3873">
                  <c:v>1.80833925994758</c:v>
                </c:pt>
                <c:pt idx="3874">
                  <c:v>1.38213954804034</c:v>
                </c:pt>
                <c:pt idx="3875">
                  <c:v>0.56507114446402396</c:v>
                </c:pt>
                <c:pt idx="3876">
                  <c:v>0.92706503676303897</c:v>
                </c:pt>
                <c:pt idx="3877">
                  <c:v>0.72558573304537499</c:v>
                </c:pt>
                <c:pt idx="3878">
                  <c:v>0.69813253576928902</c:v>
                </c:pt>
                <c:pt idx="3879">
                  <c:v>1.0786866433195601</c:v>
                </c:pt>
                <c:pt idx="3880">
                  <c:v>1.05118834576689</c:v>
                </c:pt>
                <c:pt idx="3881">
                  <c:v>0.52183276117586697</c:v>
                </c:pt>
                <c:pt idx="3882">
                  <c:v>0.70917165791408199</c:v>
                </c:pt>
                <c:pt idx="3883">
                  <c:v>0.52763822313168396</c:v>
                </c:pt>
                <c:pt idx="3884">
                  <c:v>0.60942864735757696</c:v>
                </c:pt>
                <c:pt idx="3885">
                  <c:v>1.20421234391323</c:v>
                </c:pt>
                <c:pt idx="3886">
                  <c:v>0.78133294706876899</c:v>
                </c:pt>
                <c:pt idx="3887">
                  <c:v>0.687397229933986</c:v>
                </c:pt>
                <c:pt idx="3888">
                  <c:v>1.3987565481619499</c:v>
                </c:pt>
                <c:pt idx="3889">
                  <c:v>1.1017369851185499</c:v>
                </c:pt>
                <c:pt idx="3890">
                  <c:v>1.11903431263887</c:v>
                </c:pt>
                <c:pt idx="3891">
                  <c:v>0.795437454616157</c:v>
                </c:pt>
                <c:pt idx="3892">
                  <c:v>0.98231939537706703</c:v>
                </c:pt>
                <c:pt idx="3893">
                  <c:v>1.2523953236396701</c:v>
                </c:pt>
                <c:pt idx="3894">
                  <c:v>1.1107962388706101</c:v>
                </c:pt>
                <c:pt idx="3895">
                  <c:v>0.92371235743078295</c:v>
                </c:pt>
                <c:pt idx="3896">
                  <c:v>0.63485242642415796</c:v>
                </c:pt>
                <c:pt idx="3897">
                  <c:v>1.1445906325174799</c:v>
                </c:pt>
                <c:pt idx="3898">
                  <c:v>1.5382383951673499</c:v>
                </c:pt>
                <c:pt idx="3899">
                  <c:v>0.92253999238525597</c:v>
                </c:pt>
                <c:pt idx="3900">
                  <c:v>0.96948451569399396</c:v>
                </c:pt>
                <c:pt idx="3901">
                  <c:v>0.84803287351930601</c:v>
                </c:pt>
                <c:pt idx="3902">
                  <c:v>0.54714115014880105</c:v>
                </c:pt>
                <c:pt idx="3903">
                  <c:v>0.80203372524779903</c:v>
                </c:pt>
                <c:pt idx="3904">
                  <c:v>1.0602327337309201</c:v>
                </c:pt>
                <c:pt idx="3905">
                  <c:v>0.77263540415607102</c:v>
                </c:pt>
                <c:pt idx="3906">
                  <c:v>1.0379875593987999</c:v>
                </c:pt>
                <c:pt idx="3907">
                  <c:v>0.98021355528832299</c:v>
                </c:pt>
                <c:pt idx="3908">
                  <c:v>0.560770792548962</c:v>
                </c:pt>
                <c:pt idx="3909">
                  <c:v>0.87416729346079403</c:v>
                </c:pt>
                <c:pt idx="3910">
                  <c:v>0.66636437215800304</c:v>
                </c:pt>
                <c:pt idx="3911">
                  <c:v>0.92893537192615905</c:v>
                </c:pt>
                <c:pt idx="3912">
                  <c:v>0.52775950569638697</c:v>
                </c:pt>
                <c:pt idx="3913">
                  <c:v>0.74833074412596701</c:v>
                </c:pt>
                <c:pt idx="3914">
                  <c:v>0.74121419302533997</c:v>
                </c:pt>
                <c:pt idx="3915">
                  <c:v>0.76701044571128796</c:v>
                </c:pt>
                <c:pt idx="3916">
                  <c:v>1.6842220872412501</c:v>
                </c:pt>
                <c:pt idx="3917">
                  <c:v>0.83376332265562902</c:v>
                </c:pt>
                <c:pt idx="3918">
                  <c:v>0.58202031503555396</c:v>
                </c:pt>
                <c:pt idx="3919">
                  <c:v>0.72601177712702303</c:v>
                </c:pt>
                <c:pt idx="3920">
                  <c:v>0.68924211024534798</c:v>
                </c:pt>
                <c:pt idx="3921">
                  <c:v>0.65029287134856095</c:v>
                </c:pt>
                <c:pt idx="3922">
                  <c:v>0.83358672994603999</c:v>
                </c:pt>
                <c:pt idx="3923">
                  <c:v>0.83040619823338802</c:v>
                </c:pt>
                <c:pt idx="3924">
                  <c:v>0.94857672693325401</c:v>
                </c:pt>
                <c:pt idx="3925">
                  <c:v>1.1156747914653899</c:v>
                </c:pt>
                <c:pt idx="3926">
                  <c:v>0.96828134044954095</c:v>
                </c:pt>
                <c:pt idx="3927">
                  <c:v>1.4728906767673999</c:v>
                </c:pt>
                <c:pt idx="3928">
                  <c:v>0.84370174892395999</c:v>
                </c:pt>
                <c:pt idx="3929">
                  <c:v>1.9807938584390801</c:v>
                </c:pt>
                <c:pt idx="3930">
                  <c:v>1.3550278940429801</c:v>
                </c:pt>
                <c:pt idx="3931">
                  <c:v>2.01557840430891</c:v>
                </c:pt>
                <c:pt idx="3932">
                  <c:v>0.54111562044106698</c:v>
                </c:pt>
                <c:pt idx="3933">
                  <c:v>0.67068922007382104</c:v>
                </c:pt>
                <c:pt idx="3934">
                  <c:v>1.2484920769960399</c:v>
                </c:pt>
                <c:pt idx="3935">
                  <c:v>0.81624929086516396</c:v>
                </c:pt>
                <c:pt idx="3936">
                  <c:v>1.1589725258407</c:v>
                </c:pt>
                <c:pt idx="3937">
                  <c:v>1.02205699634487</c:v>
                </c:pt>
                <c:pt idx="3938">
                  <c:v>0.79805798058322497</c:v>
                </c:pt>
                <c:pt idx="3939">
                  <c:v>0.87358831935896997</c:v>
                </c:pt>
                <c:pt idx="3940">
                  <c:v>0.44710243660040899</c:v>
                </c:pt>
                <c:pt idx="3941">
                  <c:v>0.75901966876690796</c:v>
                </c:pt>
                <c:pt idx="3942">
                  <c:v>2.0318480362329301</c:v>
                </c:pt>
                <c:pt idx="3943">
                  <c:v>0.90846339945682497</c:v>
                </c:pt>
                <c:pt idx="3944">
                  <c:v>0.84266485876543196</c:v>
                </c:pt>
                <c:pt idx="3945">
                  <c:v>0.53800369665296699</c:v>
                </c:pt>
                <c:pt idx="3946">
                  <c:v>0.83850498916766603</c:v>
                </c:pt>
                <c:pt idx="3947">
                  <c:v>0.76115872801172102</c:v>
                </c:pt>
                <c:pt idx="3948">
                  <c:v>0.65485626785371598</c:v>
                </c:pt>
                <c:pt idx="3949">
                  <c:v>0.66925385715873398</c:v>
                </c:pt>
                <c:pt idx="3950">
                  <c:v>0.678433491691805</c:v>
                </c:pt>
                <c:pt idx="3951">
                  <c:v>0.62989171790901699</c:v>
                </c:pt>
                <c:pt idx="3952">
                  <c:v>1.25498542565024</c:v>
                </c:pt>
                <c:pt idx="3953">
                  <c:v>1.0080799311482</c:v>
                </c:pt>
                <c:pt idx="3954">
                  <c:v>0.83179911172566401</c:v>
                </c:pt>
                <c:pt idx="3955">
                  <c:v>0.85557995748039295</c:v>
                </c:pt>
                <c:pt idx="3956">
                  <c:v>0.60124683342483598</c:v>
                </c:pt>
                <c:pt idx="3957">
                  <c:v>1.3610832620570601</c:v>
                </c:pt>
                <c:pt idx="3958">
                  <c:v>0.39774559018495598</c:v>
                </c:pt>
                <c:pt idx="3959">
                  <c:v>0.97971252144491305</c:v>
                </c:pt>
                <c:pt idx="3960">
                  <c:v>1.1021127778466899</c:v>
                </c:pt>
                <c:pt idx="3961">
                  <c:v>0.91119317014740997</c:v>
                </c:pt>
                <c:pt idx="3962">
                  <c:v>0.73347898220761998</c:v>
                </c:pt>
                <c:pt idx="3963">
                  <c:v>0.99391949795103596</c:v>
                </c:pt>
                <c:pt idx="3964">
                  <c:v>1.21409184275508</c:v>
                </c:pt>
                <c:pt idx="3965">
                  <c:v>0.64464249215701896</c:v>
                </c:pt>
                <c:pt idx="3966">
                  <c:v>0.72707305155574498</c:v>
                </c:pt>
                <c:pt idx="3967">
                  <c:v>0.56500082017419795</c:v>
                </c:pt>
                <c:pt idx="3968">
                  <c:v>0.938047350535818</c:v>
                </c:pt>
                <c:pt idx="3969">
                  <c:v>0.69902326889093602</c:v>
                </c:pt>
                <c:pt idx="3970">
                  <c:v>0.73299090024536495</c:v>
                </c:pt>
                <c:pt idx="3971">
                  <c:v>1.0118460466958601</c:v>
                </c:pt>
                <c:pt idx="3972">
                  <c:v>0.90819748037765802</c:v>
                </c:pt>
                <c:pt idx="3973">
                  <c:v>1.1772342502509101</c:v>
                </c:pt>
                <c:pt idx="3974">
                  <c:v>0.95156099768223001</c:v>
                </c:pt>
                <c:pt idx="3975">
                  <c:v>1.2811427615502899</c:v>
                </c:pt>
                <c:pt idx="3976">
                  <c:v>2.1592420762142699</c:v>
                </c:pt>
                <c:pt idx="3977">
                  <c:v>1.9934985451463001</c:v>
                </c:pt>
                <c:pt idx="3978">
                  <c:v>0.93926414186980001</c:v>
                </c:pt>
                <c:pt idx="3979">
                  <c:v>1.5281492640352601</c:v>
                </c:pt>
                <c:pt idx="3980">
                  <c:v>1.5031737451103999</c:v>
                </c:pt>
                <c:pt idx="3981">
                  <c:v>1.53304673804735</c:v>
                </c:pt>
                <c:pt idx="3982">
                  <c:v>1.81418884501259</c:v>
                </c:pt>
                <c:pt idx="3983">
                  <c:v>1.2241752794648999</c:v>
                </c:pt>
                <c:pt idx="3984">
                  <c:v>0.93769998743514804</c:v>
                </c:pt>
                <c:pt idx="3985">
                  <c:v>0.59876585936309501</c:v>
                </c:pt>
                <c:pt idx="3986">
                  <c:v>1.11902389386072</c:v>
                </c:pt>
                <c:pt idx="3987">
                  <c:v>1.4657594983367801</c:v>
                </c:pt>
                <c:pt idx="3988">
                  <c:v>1.0091339608297201</c:v>
                </c:pt>
                <c:pt idx="3989">
                  <c:v>0.74983417173499101</c:v>
                </c:pt>
                <c:pt idx="3990">
                  <c:v>0.440173023325312</c:v>
                </c:pt>
                <c:pt idx="3991">
                  <c:v>1.5262216194761999</c:v>
                </c:pt>
                <c:pt idx="3992">
                  <c:v>1.1237315921567099</c:v>
                </c:pt>
                <c:pt idx="3993">
                  <c:v>0.44807127530951402</c:v>
                </c:pt>
                <c:pt idx="3994">
                  <c:v>0.93199094636000201</c:v>
                </c:pt>
                <c:pt idx="3995">
                  <c:v>1.1089063059189499</c:v>
                </c:pt>
                <c:pt idx="3996">
                  <c:v>1.1025795181773801</c:v>
                </c:pt>
                <c:pt idx="3997">
                  <c:v>1.54016671542263</c:v>
                </c:pt>
                <c:pt idx="3998">
                  <c:v>0.85951676521023501</c:v>
                </c:pt>
                <c:pt idx="3999">
                  <c:v>0.54130992648388598</c:v>
                </c:pt>
                <c:pt idx="4000">
                  <c:v>0.983152759351821</c:v>
                </c:pt>
                <c:pt idx="4001">
                  <c:v>0.63251179761575205</c:v>
                </c:pt>
                <c:pt idx="4002">
                  <c:v>0.744953597156081</c:v>
                </c:pt>
                <c:pt idx="4003">
                  <c:v>0.59881163850219099</c:v>
                </c:pt>
                <c:pt idx="4004">
                  <c:v>0.37605430267751799</c:v>
                </c:pt>
                <c:pt idx="4005">
                  <c:v>0.56347766776758601</c:v>
                </c:pt>
                <c:pt idx="4006">
                  <c:v>0.81012211575207005</c:v>
                </c:pt>
                <c:pt idx="4007">
                  <c:v>0.65283457795091804</c:v>
                </c:pt>
                <c:pt idx="4008">
                  <c:v>0.72160630467253795</c:v>
                </c:pt>
                <c:pt idx="4009">
                  <c:v>0.43421129863156999</c:v>
                </c:pt>
                <c:pt idx="4010">
                  <c:v>1.0245465362486501</c:v>
                </c:pt>
                <c:pt idx="4011">
                  <c:v>0.62542284643877499</c:v>
                </c:pt>
                <c:pt idx="4012">
                  <c:v>0.89333680167963203</c:v>
                </c:pt>
                <c:pt idx="4013">
                  <c:v>1.3262425845571999</c:v>
                </c:pt>
                <c:pt idx="4014">
                  <c:v>1.3770352513488999</c:v>
                </c:pt>
                <c:pt idx="4015">
                  <c:v>1.0765416809911299</c:v>
                </c:pt>
                <c:pt idx="4016">
                  <c:v>1.2322762240376901</c:v>
                </c:pt>
                <c:pt idx="4017">
                  <c:v>1.4714385315798</c:v>
                </c:pt>
                <c:pt idx="4018">
                  <c:v>1.3424039961519301</c:v>
                </c:pt>
                <c:pt idx="4019">
                  <c:v>0.89362224911517496</c:v>
                </c:pt>
                <c:pt idx="4020">
                  <c:v>0.89301212456373102</c:v>
                </c:pt>
                <c:pt idx="4021">
                  <c:v>1.0256310385969201</c:v>
                </c:pt>
                <c:pt idx="4022">
                  <c:v>0.73982814382610995</c:v>
                </c:pt>
                <c:pt idx="4023">
                  <c:v>1.48201791014138</c:v>
                </c:pt>
                <c:pt idx="4024">
                  <c:v>0.92447540876171996</c:v>
                </c:pt>
                <c:pt idx="4025">
                  <c:v>1.1981260482720899</c:v>
                </c:pt>
                <c:pt idx="4026">
                  <c:v>1.94847474857925</c:v>
                </c:pt>
                <c:pt idx="4027">
                  <c:v>1.74653887293635</c:v>
                </c:pt>
                <c:pt idx="4028">
                  <c:v>1.3003385215035099</c:v>
                </c:pt>
                <c:pt idx="4029">
                  <c:v>1.66782545089741</c:v>
                </c:pt>
                <c:pt idx="4030">
                  <c:v>2.1030775923939702</c:v>
                </c:pt>
                <c:pt idx="4031">
                  <c:v>1.7176987885786801</c:v>
                </c:pt>
                <c:pt idx="4032">
                  <c:v>1.61283080359459</c:v>
                </c:pt>
                <c:pt idx="4033">
                  <c:v>1.4339137142943199</c:v>
                </c:pt>
                <c:pt idx="4034">
                  <c:v>1.34949145328613</c:v>
                </c:pt>
                <c:pt idx="4035">
                  <c:v>2.0709724334398301</c:v>
                </c:pt>
                <c:pt idx="4036">
                  <c:v>1.7559786759979501</c:v>
                </c:pt>
                <c:pt idx="4037">
                  <c:v>2.1573646737318199</c:v>
                </c:pt>
                <c:pt idx="4038">
                  <c:v>2.2895120849766202</c:v>
                </c:pt>
                <c:pt idx="4039">
                  <c:v>3.3705267667492702</c:v>
                </c:pt>
                <c:pt idx="4040">
                  <c:v>3.0251843270991801</c:v>
                </c:pt>
                <c:pt idx="4041">
                  <c:v>3.0214036062538598</c:v>
                </c:pt>
                <c:pt idx="4042">
                  <c:v>2.2206729877697802</c:v>
                </c:pt>
                <c:pt idx="4043">
                  <c:v>3.19868967555204</c:v>
                </c:pt>
                <c:pt idx="4044">
                  <c:v>3.2645384926858201</c:v>
                </c:pt>
                <c:pt idx="4045">
                  <c:v>3.4386069185864199</c:v>
                </c:pt>
                <c:pt idx="4046">
                  <c:v>2.9070373548832502</c:v>
                </c:pt>
                <c:pt idx="4047">
                  <c:v>2.4825050550938901</c:v>
                </c:pt>
                <c:pt idx="4048">
                  <c:v>3.0035669254369499</c:v>
                </c:pt>
                <c:pt idx="4049">
                  <c:v>3.4589903061567302</c:v>
                </c:pt>
                <c:pt idx="4050">
                  <c:v>3.1122658586065</c:v>
                </c:pt>
                <c:pt idx="4051">
                  <c:v>3.2256651274604602</c:v>
                </c:pt>
                <c:pt idx="4052">
                  <c:v>2.7908210050744402</c:v>
                </c:pt>
                <c:pt idx="4053">
                  <c:v>2.6318457920270699</c:v>
                </c:pt>
                <c:pt idx="4054">
                  <c:v>3.30998407849961</c:v>
                </c:pt>
                <c:pt idx="4055">
                  <c:v>2.8696587617987102</c:v>
                </c:pt>
                <c:pt idx="4056">
                  <c:v>2.77399048252075</c:v>
                </c:pt>
                <c:pt idx="4057">
                  <c:v>3.2493970310238098</c:v>
                </c:pt>
                <c:pt idx="4058">
                  <c:v>2.8274299341152198</c:v>
                </c:pt>
                <c:pt idx="4059">
                  <c:v>3.0780969456357901</c:v>
                </c:pt>
                <c:pt idx="4060">
                  <c:v>2.5332969213591499</c:v>
                </c:pt>
                <c:pt idx="4061">
                  <c:v>2.9907716834274098</c:v>
                </c:pt>
                <c:pt idx="4062">
                  <c:v>3.1183944820044598</c:v>
                </c:pt>
                <c:pt idx="4063">
                  <c:v>2.60314970729147</c:v>
                </c:pt>
                <c:pt idx="4064">
                  <c:v>3.0283152553950599</c:v>
                </c:pt>
                <c:pt idx="4065">
                  <c:v>2.8863889560679601</c:v>
                </c:pt>
                <c:pt idx="4066">
                  <c:v>1.5569862016840399</c:v>
                </c:pt>
                <c:pt idx="4067">
                  <c:v>2.10604471006664</c:v>
                </c:pt>
                <c:pt idx="4068">
                  <c:v>0.97460155894511002</c:v>
                </c:pt>
                <c:pt idx="4069">
                  <c:v>1.24570801782861</c:v>
                </c:pt>
                <c:pt idx="4070">
                  <c:v>1.5235094258309601</c:v>
                </c:pt>
                <c:pt idx="4071">
                  <c:v>1.9008803237796199</c:v>
                </c:pt>
                <c:pt idx="4072">
                  <c:v>1.63617181098727</c:v>
                </c:pt>
                <c:pt idx="4073">
                  <c:v>1.2521437805202</c:v>
                </c:pt>
                <c:pt idx="4074">
                  <c:v>1.68714875287779</c:v>
                </c:pt>
                <c:pt idx="4075">
                  <c:v>1.4581916416452301</c:v>
                </c:pt>
                <c:pt idx="4076">
                  <c:v>1.59624170940433</c:v>
                </c:pt>
                <c:pt idx="4077">
                  <c:v>1.53495036103489</c:v>
                </c:pt>
                <c:pt idx="4078">
                  <c:v>1.599412142744</c:v>
                </c:pt>
                <c:pt idx="4079">
                  <c:v>1.75005237595079</c:v>
                </c:pt>
                <c:pt idx="4080">
                  <c:v>1.7213869158395601</c:v>
                </c:pt>
                <c:pt idx="4081">
                  <c:v>1.8503819750121799</c:v>
                </c:pt>
                <c:pt idx="4082">
                  <c:v>1.9127014163976801</c:v>
                </c:pt>
                <c:pt idx="4083">
                  <c:v>0.89168387440724795</c:v>
                </c:pt>
                <c:pt idx="4084">
                  <c:v>1.3931099585912601</c:v>
                </c:pt>
                <c:pt idx="4085">
                  <c:v>1.3590531164164601</c:v>
                </c:pt>
                <c:pt idx="4086">
                  <c:v>1.5513995534876199</c:v>
                </c:pt>
                <c:pt idx="4087">
                  <c:v>1.49697194749562</c:v>
                </c:pt>
                <c:pt idx="4088">
                  <c:v>2.1455291833872301</c:v>
                </c:pt>
                <c:pt idx="4089">
                  <c:v>1.74137886579812</c:v>
                </c:pt>
                <c:pt idx="4090">
                  <c:v>2.0197670888353501</c:v>
                </c:pt>
                <c:pt idx="4091">
                  <c:v>1.9022075313139</c:v>
                </c:pt>
                <c:pt idx="4092">
                  <c:v>1.3233170626752</c:v>
                </c:pt>
                <c:pt idx="4093">
                  <c:v>1.4509494264246201</c:v>
                </c:pt>
                <c:pt idx="4094">
                  <c:v>1.2904943242221301</c:v>
                </c:pt>
                <c:pt idx="4095">
                  <c:v>1.7160427444350901</c:v>
                </c:pt>
                <c:pt idx="4096">
                  <c:v>1.8178644954062699</c:v>
                </c:pt>
                <c:pt idx="4097">
                  <c:v>1.4851864450026599</c:v>
                </c:pt>
                <c:pt idx="4098">
                  <c:v>1.0696001503068999</c:v>
                </c:pt>
                <c:pt idx="4099">
                  <c:v>1.5799075573697099</c:v>
                </c:pt>
                <c:pt idx="4100">
                  <c:v>1.1335674050942399</c:v>
                </c:pt>
                <c:pt idx="4101">
                  <c:v>1.25109071678143</c:v>
                </c:pt>
                <c:pt idx="4102">
                  <c:v>0.70045618179608604</c:v>
                </c:pt>
                <c:pt idx="4103">
                  <c:v>1.0121050581798501</c:v>
                </c:pt>
                <c:pt idx="4104">
                  <c:v>0.98341840849610795</c:v>
                </c:pt>
                <c:pt idx="4105">
                  <c:v>0.78244310350366597</c:v>
                </c:pt>
                <c:pt idx="4106">
                  <c:v>1.0079504174229801</c:v>
                </c:pt>
                <c:pt idx="4107">
                  <c:v>0.71916566897393897</c:v>
                </c:pt>
                <c:pt idx="4108">
                  <c:v>0.62061029307405002</c:v>
                </c:pt>
                <c:pt idx="4109">
                  <c:v>0.83170773639059203</c:v>
                </c:pt>
                <c:pt idx="4110">
                  <c:v>0.45904343159678801</c:v>
                </c:pt>
                <c:pt idx="4111">
                  <c:v>0.95005305770939896</c:v>
                </c:pt>
                <c:pt idx="4112">
                  <c:v>0.99191175969044199</c:v>
                </c:pt>
                <c:pt idx="4113">
                  <c:v>1.4121373144741001</c:v>
                </c:pt>
                <c:pt idx="4114">
                  <c:v>1.45372403687084</c:v>
                </c:pt>
                <c:pt idx="4115">
                  <c:v>0.71812513349082097</c:v>
                </c:pt>
                <c:pt idx="4116">
                  <c:v>0.86002112026889499</c:v>
                </c:pt>
                <c:pt idx="4117">
                  <c:v>0.65174063393141302</c:v>
                </c:pt>
                <c:pt idx="4118">
                  <c:v>0.63456313901086603</c:v>
                </c:pt>
                <c:pt idx="4119">
                  <c:v>0.948222678415924</c:v>
                </c:pt>
                <c:pt idx="4120">
                  <c:v>1.20660465886043</c:v>
                </c:pt>
                <c:pt idx="4121">
                  <c:v>0.47058397496473697</c:v>
                </c:pt>
                <c:pt idx="4122">
                  <c:v>0.37852832881104398</c:v>
                </c:pt>
                <c:pt idx="4123">
                  <c:v>0.644352449237101</c:v>
                </c:pt>
                <c:pt idx="4124">
                  <c:v>0.70173079549523198</c:v>
                </c:pt>
                <c:pt idx="4125">
                  <c:v>0.66384965695296605</c:v>
                </c:pt>
                <c:pt idx="4126">
                  <c:v>0.44239943008303101</c:v>
                </c:pt>
                <c:pt idx="4127">
                  <c:v>0.63650073485740899</c:v>
                </c:pt>
                <c:pt idx="4128">
                  <c:v>1.14682152176639</c:v>
                </c:pt>
                <c:pt idx="4129">
                  <c:v>0.74627023188930897</c:v>
                </c:pt>
                <c:pt idx="4130">
                  <c:v>0.41571532617431201</c:v>
                </c:pt>
                <c:pt idx="4131">
                  <c:v>0.71806821760518103</c:v>
                </c:pt>
                <c:pt idx="4132">
                  <c:v>0.96552691091216702</c:v>
                </c:pt>
                <c:pt idx="4133">
                  <c:v>0.86547511885301398</c:v>
                </c:pt>
                <c:pt idx="4134">
                  <c:v>0.85938166692295004</c:v>
                </c:pt>
                <c:pt idx="4135">
                  <c:v>0.72726757763320604</c:v>
                </c:pt>
                <c:pt idx="4136">
                  <c:v>1.1137595829918701</c:v>
                </c:pt>
                <c:pt idx="4137">
                  <c:v>1.52734762294311</c:v>
                </c:pt>
                <c:pt idx="4138">
                  <c:v>0.68517325501939097</c:v>
                </c:pt>
                <c:pt idx="4139">
                  <c:v>0.328187344885913</c:v>
                </c:pt>
                <c:pt idx="4140">
                  <c:v>0.89772335835030304</c:v>
                </c:pt>
                <c:pt idx="4141">
                  <c:v>0.77284141271139495</c:v>
                </c:pt>
                <c:pt idx="4142">
                  <c:v>0.56887040728813898</c:v>
                </c:pt>
                <c:pt idx="4143">
                  <c:v>0.43772417176839501</c:v>
                </c:pt>
                <c:pt idx="4144">
                  <c:v>0.85676453843161804</c:v>
                </c:pt>
                <c:pt idx="4145">
                  <c:v>0.68611852416043495</c:v>
                </c:pt>
                <c:pt idx="4146">
                  <c:v>0.74877906709166997</c:v>
                </c:pt>
                <c:pt idx="4147">
                  <c:v>0.57577635586167597</c:v>
                </c:pt>
                <c:pt idx="4148">
                  <c:v>0.82710141637138501</c:v>
                </c:pt>
                <c:pt idx="4149">
                  <c:v>0.384545422203383</c:v>
                </c:pt>
                <c:pt idx="4150">
                  <c:v>0.76048675661826204</c:v>
                </c:pt>
                <c:pt idx="4151">
                  <c:v>0.64501544917696696</c:v>
                </c:pt>
                <c:pt idx="4152">
                  <c:v>0.560410981936315</c:v>
                </c:pt>
                <c:pt idx="4153">
                  <c:v>0.98247874827596604</c:v>
                </c:pt>
                <c:pt idx="4154">
                  <c:v>0.77497931790586505</c:v>
                </c:pt>
                <c:pt idx="4155">
                  <c:v>0.62099753568912397</c:v>
                </c:pt>
                <c:pt idx="4156">
                  <c:v>0.89719818303281296</c:v>
                </c:pt>
                <c:pt idx="4157">
                  <c:v>1.1874633853598799</c:v>
                </c:pt>
                <c:pt idx="4158">
                  <c:v>0.99337146272148102</c:v>
                </c:pt>
                <c:pt idx="4159">
                  <c:v>1.0268704364094801</c:v>
                </c:pt>
                <c:pt idx="4160">
                  <c:v>0.64682544139187603</c:v>
                </c:pt>
                <c:pt idx="4161">
                  <c:v>0.97232165670809401</c:v>
                </c:pt>
                <c:pt idx="4162">
                  <c:v>0.851895067861553</c:v>
                </c:pt>
                <c:pt idx="4163">
                  <c:v>0.77575632875395195</c:v>
                </c:pt>
                <c:pt idx="4164">
                  <c:v>0.67998348930201502</c:v>
                </c:pt>
                <c:pt idx="4165">
                  <c:v>0.76677962949199296</c:v>
                </c:pt>
                <c:pt idx="4166">
                  <c:v>1.1191791725431099</c:v>
                </c:pt>
                <c:pt idx="4167">
                  <c:v>0.72330417645738099</c:v>
                </c:pt>
                <c:pt idx="4168">
                  <c:v>0.42031636607121098</c:v>
                </c:pt>
                <c:pt idx="4169">
                  <c:v>0.43985095577752997</c:v>
                </c:pt>
                <c:pt idx="4170">
                  <c:v>0.52372855888891301</c:v>
                </c:pt>
                <c:pt idx="4171">
                  <c:v>0.82402322260790895</c:v>
                </c:pt>
                <c:pt idx="4172">
                  <c:v>0.34298638905092499</c:v>
                </c:pt>
                <c:pt idx="4173">
                  <c:v>1.08502040966387</c:v>
                </c:pt>
                <c:pt idx="4174">
                  <c:v>0.75987894220594399</c:v>
                </c:pt>
                <c:pt idx="4175">
                  <c:v>1.48002976255782</c:v>
                </c:pt>
                <c:pt idx="4176">
                  <c:v>0.64632784158499701</c:v>
                </c:pt>
                <c:pt idx="4177">
                  <c:v>0.84892629212800896</c:v>
                </c:pt>
                <c:pt idx="4178">
                  <c:v>1.0723155618801401</c:v>
                </c:pt>
                <c:pt idx="4179">
                  <c:v>0.66427937671228898</c:v>
                </c:pt>
                <c:pt idx="4180">
                  <c:v>1.0320031879812299</c:v>
                </c:pt>
                <c:pt idx="4181">
                  <c:v>0.93244230806162198</c:v>
                </c:pt>
                <c:pt idx="4182">
                  <c:v>0.958353179797656</c:v>
                </c:pt>
                <c:pt idx="4183">
                  <c:v>0.85996527448770699</c:v>
                </c:pt>
                <c:pt idx="4184">
                  <c:v>0.78216463459908303</c:v>
                </c:pt>
                <c:pt idx="4185">
                  <c:v>0.93416168269821098</c:v>
                </c:pt>
                <c:pt idx="4186">
                  <c:v>0.97693113951081401</c:v>
                </c:pt>
                <c:pt idx="4187">
                  <c:v>1.3663793435249401</c:v>
                </c:pt>
                <c:pt idx="4188">
                  <c:v>0.94760127284274098</c:v>
                </c:pt>
                <c:pt idx="4189">
                  <c:v>1.5370191397016399</c:v>
                </c:pt>
                <c:pt idx="4190">
                  <c:v>1.2123867988019501</c:v>
                </c:pt>
                <c:pt idx="4191">
                  <c:v>1.28672008990077</c:v>
                </c:pt>
                <c:pt idx="4192">
                  <c:v>0.85822240177516596</c:v>
                </c:pt>
                <c:pt idx="4193">
                  <c:v>0.79615601851295004</c:v>
                </c:pt>
                <c:pt idx="4194">
                  <c:v>0.81477038757967601</c:v>
                </c:pt>
                <c:pt idx="4195">
                  <c:v>0.67973646652726305</c:v>
                </c:pt>
                <c:pt idx="4196">
                  <c:v>0.60849408890007195</c:v>
                </c:pt>
                <c:pt idx="4197">
                  <c:v>0.22607227208627401</c:v>
                </c:pt>
                <c:pt idx="4198">
                  <c:v>0.346054794824662</c:v>
                </c:pt>
                <c:pt idx="4199">
                  <c:v>1.1256404871280401</c:v>
                </c:pt>
                <c:pt idx="4200">
                  <c:v>0.90621998595251096</c:v>
                </c:pt>
                <c:pt idx="4201">
                  <c:v>0.52689446714624</c:v>
                </c:pt>
                <c:pt idx="4202">
                  <c:v>0.81945604179277698</c:v>
                </c:pt>
                <c:pt idx="4203">
                  <c:v>0.59538547871591196</c:v>
                </c:pt>
                <c:pt idx="4204">
                  <c:v>0.49519194095205199</c:v>
                </c:pt>
                <c:pt idx="4205">
                  <c:v>0.78553294353908598</c:v>
                </c:pt>
                <c:pt idx="4206">
                  <c:v>0.82518942793976702</c:v>
                </c:pt>
                <c:pt idx="4207">
                  <c:v>0.36819253409428299</c:v>
                </c:pt>
                <c:pt idx="4208">
                  <c:v>0.68232530880613795</c:v>
                </c:pt>
                <c:pt idx="4209">
                  <c:v>0.96912836218023202</c:v>
                </c:pt>
                <c:pt idx="4210">
                  <c:v>0.67506886079288098</c:v>
                </c:pt>
                <c:pt idx="4211">
                  <c:v>0.67657363338014198</c:v>
                </c:pt>
                <c:pt idx="4212">
                  <c:v>0.90629899963012595</c:v>
                </c:pt>
                <c:pt idx="4213">
                  <c:v>0.70617803421824898</c:v>
                </c:pt>
                <c:pt idx="4214">
                  <c:v>1.19482230764417</c:v>
                </c:pt>
                <c:pt idx="4215">
                  <c:v>0.74648703977358699</c:v>
                </c:pt>
                <c:pt idx="4216">
                  <c:v>0.66090910650023904</c:v>
                </c:pt>
                <c:pt idx="4217">
                  <c:v>0.83447613110320795</c:v>
                </c:pt>
                <c:pt idx="4218">
                  <c:v>0.87254114180213704</c:v>
                </c:pt>
                <c:pt idx="4219">
                  <c:v>0.90201341967746096</c:v>
                </c:pt>
                <c:pt idx="4220">
                  <c:v>0.24795310831549899</c:v>
                </c:pt>
                <c:pt idx="4221">
                  <c:v>0.89114680055579398</c:v>
                </c:pt>
                <c:pt idx="4222">
                  <c:v>0.97486032111271104</c:v>
                </c:pt>
                <c:pt idx="4223">
                  <c:v>0.57119947828249495</c:v>
                </c:pt>
                <c:pt idx="4224">
                  <c:v>0.85272238927810595</c:v>
                </c:pt>
                <c:pt idx="4225">
                  <c:v>0.61405604846692796</c:v>
                </c:pt>
                <c:pt idx="4226">
                  <c:v>0.56397619684486999</c:v>
                </c:pt>
                <c:pt idx="4227">
                  <c:v>0.81130425481838597</c:v>
                </c:pt>
                <c:pt idx="4228">
                  <c:v>0.241806913498187</c:v>
                </c:pt>
                <c:pt idx="4229">
                  <c:v>1.0610484000885001</c:v>
                </c:pt>
                <c:pt idx="4230">
                  <c:v>0.658738959433669</c:v>
                </c:pt>
                <c:pt idx="4231">
                  <c:v>0.85548357300492495</c:v>
                </c:pt>
                <c:pt idx="4232">
                  <c:v>0.96671726531834401</c:v>
                </c:pt>
                <c:pt idx="4233">
                  <c:v>1.0695773396257799</c:v>
                </c:pt>
                <c:pt idx="4234">
                  <c:v>0.80857588327537999</c:v>
                </c:pt>
                <c:pt idx="4235">
                  <c:v>0.96121008707108102</c:v>
                </c:pt>
                <c:pt idx="4236">
                  <c:v>0.90523910342138003</c:v>
                </c:pt>
                <c:pt idx="4237">
                  <c:v>1.09520064548979</c:v>
                </c:pt>
                <c:pt idx="4238">
                  <c:v>0.68000362199473896</c:v>
                </c:pt>
                <c:pt idx="4239">
                  <c:v>0.92458193148525503</c:v>
                </c:pt>
                <c:pt idx="4240">
                  <c:v>0.51283972562028801</c:v>
                </c:pt>
                <c:pt idx="4241">
                  <c:v>0.41937584712635101</c:v>
                </c:pt>
                <c:pt idx="4242">
                  <c:v>0.34403809106328997</c:v>
                </c:pt>
                <c:pt idx="4243">
                  <c:v>0.84457898519725905</c:v>
                </c:pt>
                <c:pt idx="4244">
                  <c:v>0.64487228376623795</c:v>
                </c:pt>
                <c:pt idx="4245">
                  <c:v>0.86373825719555397</c:v>
                </c:pt>
                <c:pt idx="4246">
                  <c:v>1.3234616227321501</c:v>
                </c:pt>
                <c:pt idx="4247">
                  <c:v>0.78275299241118701</c:v>
                </c:pt>
                <c:pt idx="4248">
                  <c:v>0.75987058073981295</c:v>
                </c:pt>
                <c:pt idx="4249">
                  <c:v>0.67799317113109503</c:v>
                </c:pt>
                <c:pt idx="4250">
                  <c:v>0.92328063020738504</c:v>
                </c:pt>
                <c:pt idx="4251">
                  <c:v>0.59551045687174198</c:v>
                </c:pt>
                <c:pt idx="4252">
                  <c:v>0.63030648763709995</c:v>
                </c:pt>
                <c:pt idx="4253">
                  <c:v>0.80715652936857296</c:v>
                </c:pt>
                <c:pt idx="4254">
                  <c:v>0.57940877661036405</c:v>
                </c:pt>
                <c:pt idx="4255">
                  <c:v>1.00176639381574</c:v>
                </c:pt>
                <c:pt idx="4256">
                  <c:v>0.79028474331762599</c:v>
                </c:pt>
                <c:pt idx="4257">
                  <c:v>0.88900392391769001</c:v>
                </c:pt>
                <c:pt idx="4258">
                  <c:v>1.1331253205415399</c:v>
                </c:pt>
                <c:pt idx="4259">
                  <c:v>0.838467572550879</c:v>
                </c:pt>
                <c:pt idx="4260">
                  <c:v>1.0340422576898201</c:v>
                </c:pt>
                <c:pt idx="4261">
                  <c:v>1.12552487368009</c:v>
                </c:pt>
                <c:pt idx="4262">
                  <c:v>0.48108041232857401</c:v>
                </c:pt>
                <c:pt idx="4263">
                  <c:v>0.54335972311190905</c:v>
                </c:pt>
                <c:pt idx="4264">
                  <c:v>0.86610212854853996</c:v>
                </c:pt>
                <c:pt idx="4265">
                  <c:v>1.2305647095485299</c:v>
                </c:pt>
                <c:pt idx="4266">
                  <c:v>0.39478663458409102</c:v>
                </c:pt>
                <c:pt idx="4267">
                  <c:v>0.847862383211055</c:v>
                </c:pt>
                <c:pt idx="4268">
                  <c:v>0.92305081980772696</c:v>
                </c:pt>
                <c:pt idx="4269">
                  <c:v>1.0392564892617899</c:v>
                </c:pt>
                <c:pt idx="4270">
                  <c:v>0.62209041711741297</c:v>
                </c:pt>
                <c:pt idx="4271">
                  <c:v>0.64921683083235404</c:v>
                </c:pt>
                <c:pt idx="4272">
                  <c:v>0.58841441223997704</c:v>
                </c:pt>
                <c:pt idx="4273">
                  <c:v>1.6863546768955699</c:v>
                </c:pt>
                <c:pt idx="4274">
                  <c:v>0.83126634331174798</c:v>
                </c:pt>
                <c:pt idx="4275">
                  <c:v>0.59002819802499296</c:v>
                </c:pt>
                <c:pt idx="4276">
                  <c:v>0.67277407846467396</c:v>
                </c:pt>
                <c:pt idx="4277">
                  <c:v>0.58801536087069495</c:v>
                </c:pt>
                <c:pt idx="4278">
                  <c:v>1.0936453150191801</c:v>
                </c:pt>
                <c:pt idx="4279">
                  <c:v>0.83922657217389895</c:v>
                </c:pt>
                <c:pt idx="4280">
                  <c:v>1.14271762698574</c:v>
                </c:pt>
                <c:pt idx="4281">
                  <c:v>1.5274551717451901</c:v>
                </c:pt>
                <c:pt idx="4282">
                  <c:v>1.6989823218307201</c:v>
                </c:pt>
                <c:pt idx="4283">
                  <c:v>0.96523273390906805</c:v>
                </c:pt>
                <c:pt idx="4284">
                  <c:v>1.0748092332969099</c:v>
                </c:pt>
                <c:pt idx="4285">
                  <c:v>0.42008759277438501</c:v>
                </c:pt>
                <c:pt idx="4286">
                  <c:v>1.02028710164567</c:v>
                </c:pt>
                <c:pt idx="4287">
                  <c:v>0.43671570980591001</c:v>
                </c:pt>
                <c:pt idx="4288">
                  <c:v>1.6941223355497199</c:v>
                </c:pt>
                <c:pt idx="4289">
                  <c:v>0.98240958604681194</c:v>
                </c:pt>
                <c:pt idx="4290">
                  <c:v>1.35672188954293</c:v>
                </c:pt>
                <c:pt idx="4291">
                  <c:v>1.2363099220939699</c:v>
                </c:pt>
                <c:pt idx="4292">
                  <c:v>1.0163603268061401</c:v>
                </c:pt>
                <c:pt idx="4293">
                  <c:v>1.1368497491257199</c:v>
                </c:pt>
                <c:pt idx="4294">
                  <c:v>1.2839316002994201</c:v>
                </c:pt>
                <c:pt idx="4295">
                  <c:v>1.1010574467882699</c:v>
                </c:pt>
                <c:pt idx="4296">
                  <c:v>0.576818307064483</c:v>
                </c:pt>
                <c:pt idx="4297">
                  <c:v>1.1521095341077301</c:v>
                </c:pt>
                <c:pt idx="4298">
                  <c:v>1.3277980686309701</c:v>
                </c:pt>
                <c:pt idx="4299">
                  <c:v>1.1451884153202501</c:v>
                </c:pt>
                <c:pt idx="4300">
                  <c:v>1.0825795983695701</c:v>
                </c:pt>
                <c:pt idx="4301">
                  <c:v>0.87661511109836798</c:v>
                </c:pt>
                <c:pt idx="4302">
                  <c:v>1.1014830640356901</c:v>
                </c:pt>
                <c:pt idx="4303">
                  <c:v>0.796580790253967</c:v>
                </c:pt>
                <c:pt idx="4304">
                  <c:v>1.1168101936108299</c:v>
                </c:pt>
                <c:pt idx="4305">
                  <c:v>1.09967464986809</c:v>
                </c:pt>
                <c:pt idx="4306">
                  <c:v>1.09497068558563</c:v>
                </c:pt>
                <c:pt idx="4307">
                  <c:v>1.0594738312329399</c:v>
                </c:pt>
                <c:pt idx="4308">
                  <c:v>1.16069699413478</c:v>
                </c:pt>
                <c:pt idx="4309">
                  <c:v>0.83232141772171198</c:v>
                </c:pt>
                <c:pt idx="4310">
                  <c:v>0.85450279540941898</c:v>
                </c:pt>
                <c:pt idx="4311">
                  <c:v>0.76191668370445398</c:v>
                </c:pt>
                <c:pt idx="4312">
                  <c:v>1.03420704542757</c:v>
                </c:pt>
                <c:pt idx="4313">
                  <c:v>1.17937521466816</c:v>
                </c:pt>
                <c:pt idx="4314">
                  <c:v>1.3341861883177899</c:v>
                </c:pt>
                <c:pt idx="4315">
                  <c:v>0.94989132450333502</c:v>
                </c:pt>
                <c:pt idx="4316">
                  <c:v>1.50645264321731</c:v>
                </c:pt>
                <c:pt idx="4317">
                  <c:v>1.5655160977811799</c:v>
                </c:pt>
                <c:pt idx="4318">
                  <c:v>0.91657877886873595</c:v>
                </c:pt>
                <c:pt idx="4319">
                  <c:v>1.0663856295157099</c:v>
                </c:pt>
                <c:pt idx="4320">
                  <c:v>0.82348061536064199</c:v>
                </c:pt>
                <c:pt idx="4321">
                  <c:v>1.2745322988885599</c:v>
                </c:pt>
                <c:pt idx="4322">
                  <c:v>1.22775418913958</c:v>
                </c:pt>
                <c:pt idx="4323">
                  <c:v>1.54823488985221</c:v>
                </c:pt>
                <c:pt idx="4324">
                  <c:v>1.08612396974395</c:v>
                </c:pt>
                <c:pt idx="4325">
                  <c:v>1.26931059548408</c:v>
                </c:pt>
                <c:pt idx="4326">
                  <c:v>0.60545986398177298</c:v>
                </c:pt>
                <c:pt idx="4327">
                  <c:v>1.06591972600329</c:v>
                </c:pt>
                <c:pt idx="4328">
                  <c:v>0.88886997130929801</c:v>
                </c:pt>
                <c:pt idx="4329">
                  <c:v>0.53964850848980594</c:v>
                </c:pt>
                <c:pt idx="4330">
                  <c:v>1.5762183666895699</c:v>
                </c:pt>
                <c:pt idx="4331">
                  <c:v>1.2838597212948299</c:v>
                </c:pt>
                <c:pt idx="4332">
                  <c:v>1.4863149530108399</c:v>
                </c:pt>
                <c:pt idx="4333">
                  <c:v>1.38949189831385</c:v>
                </c:pt>
                <c:pt idx="4334">
                  <c:v>1.2330535546350201</c:v>
                </c:pt>
                <c:pt idx="4335">
                  <c:v>1.2663842522236699</c:v>
                </c:pt>
                <c:pt idx="4336">
                  <c:v>1.33120682266028</c:v>
                </c:pt>
                <c:pt idx="4337">
                  <c:v>1.2828176867868299</c:v>
                </c:pt>
                <c:pt idx="4338">
                  <c:v>1.21482671805457</c:v>
                </c:pt>
                <c:pt idx="4339">
                  <c:v>1.59722293125132</c:v>
                </c:pt>
                <c:pt idx="4340">
                  <c:v>1.8759933578878201</c:v>
                </c:pt>
                <c:pt idx="4341">
                  <c:v>1.86397618328822</c:v>
                </c:pt>
                <c:pt idx="4342">
                  <c:v>1.6709655893299</c:v>
                </c:pt>
                <c:pt idx="4343">
                  <c:v>1.53593327154668</c:v>
                </c:pt>
                <c:pt idx="4344">
                  <c:v>1.0816152383330899</c:v>
                </c:pt>
                <c:pt idx="4345">
                  <c:v>1.3390966653531799</c:v>
                </c:pt>
                <c:pt idx="4346">
                  <c:v>1.71871816432472</c:v>
                </c:pt>
                <c:pt idx="4347">
                  <c:v>1.46122426735003</c:v>
                </c:pt>
                <c:pt idx="4348">
                  <c:v>1.14193544209293</c:v>
                </c:pt>
                <c:pt idx="4349">
                  <c:v>0.94061616517389202</c:v>
                </c:pt>
                <c:pt idx="4350">
                  <c:v>1.20214239526406</c:v>
                </c:pt>
                <c:pt idx="4351">
                  <c:v>1.1230348006520099</c:v>
                </c:pt>
                <c:pt idx="4352">
                  <c:v>1.46764599017312</c:v>
                </c:pt>
                <c:pt idx="4353">
                  <c:v>1.32466800439152</c:v>
                </c:pt>
                <c:pt idx="4354">
                  <c:v>0.82813489163778198</c:v>
                </c:pt>
                <c:pt idx="4355">
                  <c:v>1.1584205166660499</c:v>
                </c:pt>
                <c:pt idx="4356">
                  <c:v>1.35645097842954</c:v>
                </c:pt>
                <c:pt idx="4357">
                  <c:v>1.39917136799382</c:v>
                </c:pt>
                <c:pt idx="4358">
                  <c:v>1.4607406029702701</c:v>
                </c:pt>
                <c:pt idx="4359">
                  <c:v>0.934155166489396</c:v>
                </c:pt>
                <c:pt idx="4360">
                  <c:v>1.0433457336793901</c:v>
                </c:pt>
                <c:pt idx="4361">
                  <c:v>0.91521068643855297</c:v>
                </c:pt>
                <c:pt idx="4362">
                  <c:v>0.94011675343964896</c:v>
                </c:pt>
                <c:pt idx="4363">
                  <c:v>0.56637884980438202</c:v>
                </c:pt>
                <c:pt idx="4364">
                  <c:v>1.15877021019129</c:v>
                </c:pt>
                <c:pt idx="4365">
                  <c:v>0.370246109916752</c:v>
                </c:pt>
                <c:pt idx="4366">
                  <c:v>0.71902349841251101</c:v>
                </c:pt>
                <c:pt idx="4367">
                  <c:v>0.58089577308829199</c:v>
                </c:pt>
                <c:pt idx="4368">
                  <c:v>0.69867933974974095</c:v>
                </c:pt>
                <c:pt idx="4369">
                  <c:v>1.2320874450986301</c:v>
                </c:pt>
                <c:pt idx="4370">
                  <c:v>0.60078045230851895</c:v>
                </c:pt>
                <c:pt idx="4371">
                  <c:v>1.32579471861318</c:v>
                </c:pt>
                <c:pt idx="4372">
                  <c:v>1.06978299343228</c:v>
                </c:pt>
                <c:pt idx="4373">
                  <c:v>1.46831653204274</c:v>
                </c:pt>
                <c:pt idx="4374">
                  <c:v>1.00787294569713</c:v>
                </c:pt>
                <c:pt idx="4375">
                  <c:v>1.14656120769454</c:v>
                </c:pt>
                <c:pt idx="4376">
                  <c:v>0.85739156014608697</c:v>
                </c:pt>
                <c:pt idx="4377">
                  <c:v>0.93419574593749599</c:v>
                </c:pt>
                <c:pt idx="4378">
                  <c:v>0.750583797950239</c:v>
                </c:pt>
                <c:pt idx="4379">
                  <c:v>0.779313844117551</c:v>
                </c:pt>
                <c:pt idx="4380">
                  <c:v>1.0007633722335401</c:v>
                </c:pt>
                <c:pt idx="4381">
                  <c:v>1.12811947430786</c:v>
                </c:pt>
                <c:pt idx="4382">
                  <c:v>0.75141938225546001</c:v>
                </c:pt>
                <c:pt idx="4383">
                  <c:v>0.74655133490242898</c:v>
                </c:pt>
                <c:pt idx="4384">
                  <c:v>1.0218156616407601</c:v>
                </c:pt>
                <c:pt idx="4385">
                  <c:v>0.976960765003555</c:v>
                </c:pt>
                <c:pt idx="4386">
                  <c:v>0.65179867513087097</c:v>
                </c:pt>
                <c:pt idx="4387">
                  <c:v>0.893308330791723</c:v>
                </c:pt>
                <c:pt idx="4388">
                  <c:v>0.565019348964097</c:v>
                </c:pt>
                <c:pt idx="4389">
                  <c:v>0.21385313034383099</c:v>
                </c:pt>
                <c:pt idx="4390">
                  <c:v>0.75215508762306504</c:v>
                </c:pt>
                <c:pt idx="4391">
                  <c:v>1.2358787951285699</c:v>
                </c:pt>
                <c:pt idx="4392">
                  <c:v>1.0914881269630701</c:v>
                </c:pt>
                <c:pt idx="4393">
                  <c:v>0.67204564482401596</c:v>
                </c:pt>
                <c:pt idx="4394">
                  <c:v>0.778992414480562</c:v>
                </c:pt>
                <c:pt idx="4395">
                  <c:v>0.32031825420736598</c:v>
                </c:pt>
                <c:pt idx="4396">
                  <c:v>1.37075512532512</c:v>
                </c:pt>
                <c:pt idx="4397">
                  <c:v>0.641766383812025</c:v>
                </c:pt>
                <c:pt idx="4398">
                  <c:v>0.84478911348029095</c:v>
                </c:pt>
                <c:pt idx="4399">
                  <c:v>1.40072918915864</c:v>
                </c:pt>
                <c:pt idx="4400">
                  <c:v>0.91740573961139105</c:v>
                </c:pt>
                <c:pt idx="4401">
                  <c:v>0.82339844085856495</c:v>
                </c:pt>
                <c:pt idx="4402">
                  <c:v>0.68970786906084103</c:v>
                </c:pt>
                <c:pt idx="4403">
                  <c:v>1.01931819758321</c:v>
                </c:pt>
                <c:pt idx="4404">
                  <c:v>0.794078607291963</c:v>
                </c:pt>
                <c:pt idx="4405">
                  <c:v>0.73382995529413297</c:v>
                </c:pt>
                <c:pt idx="4406">
                  <c:v>0.941824546667274</c:v>
                </c:pt>
                <c:pt idx="4407">
                  <c:v>1.24085045230325</c:v>
                </c:pt>
                <c:pt idx="4408">
                  <c:v>1.0005013866774399</c:v>
                </c:pt>
                <c:pt idx="4409">
                  <c:v>1.3340174037388399</c:v>
                </c:pt>
                <c:pt idx="4410">
                  <c:v>1.51013713631027</c:v>
                </c:pt>
                <c:pt idx="4411">
                  <c:v>0.79631533313411795</c:v>
                </c:pt>
                <c:pt idx="4412">
                  <c:v>1.26719814735866</c:v>
                </c:pt>
                <c:pt idx="4413">
                  <c:v>1.0781318730694101</c:v>
                </c:pt>
                <c:pt idx="4414">
                  <c:v>0.609626710706759</c:v>
                </c:pt>
                <c:pt idx="4415">
                  <c:v>0.31579578750649401</c:v>
                </c:pt>
                <c:pt idx="4416">
                  <c:v>0.69370643625130601</c:v>
                </c:pt>
                <c:pt idx="4417">
                  <c:v>0.60177816977048004</c:v>
                </c:pt>
                <c:pt idx="4418">
                  <c:v>1.2148428188039799</c:v>
                </c:pt>
                <c:pt idx="4419">
                  <c:v>1.01135413876615</c:v>
                </c:pt>
                <c:pt idx="4420">
                  <c:v>1.07000352513913</c:v>
                </c:pt>
                <c:pt idx="4421">
                  <c:v>1.0253877840326899</c:v>
                </c:pt>
                <c:pt idx="4422">
                  <c:v>1.17192721978683</c:v>
                </c:pt>
                <c:pt idx="4423">
                  <c:v>1.1338021595593999</c:v>
                </c:pt>
                <c:pt idx="4424">
                  <c:v>0.594568388309478</c:v>
                </c:pt>
                <c:pt idx="4425">
                  <c:v>1.23803102226071</c:v>
                </c:pt>
                <c:pt idx="4426">
                  <c:v>1.0603998095818199</c:v>
                </c:pt>
                <c:pt idx="4427">
                  <c:v>0.79548447394708199</c:v>
                </c:pt>
                <c:pt idx="4428">
                  <c:v>1.21034567842518</c:v>
                </c:pt>
                <c:pt idx="4429">
                  <c:v>0.964938587558405</c:v>
                </c:pt>
                <c:pt idx="4430">
                  <c:v>1.2258899752541701</c:v>
                </c:pt>
                <c:pt idx="4431">
                  <c:v>1.6612473701749699</c:v>
                </c:pt>
                <c:pt idx="4432">
                  <c:v>2.2218051615553098</c:v>
                </c:pt>
                <c:pt idx="4433">
                  <c:v>2.3394236551464598</c:v>
                </c:pt>
                <c:pt idx="4434">
                  <c:v>1.5921011019495299</c:v>
                </c:pt>
                <c:pt idx="4435">
                  <c:v>2.4673381240296299</c:v>
                </c:pt>
                <c:pt idx="4436">
                  <c:v>2.22792653986984</c:v>
                </c:pt>
                <c:pt idx="4437">
                  <c:v>1.9595115286784699</c:v>
                </c:pt>
                <c:pt idx="4438">
                  <c:v>2.0192865026640998</c:v>
                </c:pt>
                <c:pt idx="4439">
                  <c:v>2.29010445190058</c:v>
                </c:pt>
                <c:pt idx="4440">
                  <c:v>1.6595481009609001</c:v>
                </c:pt>
                <c:pt idx="4441">
                  <c:v>2.0213946407098602</c:v>
                </c:pt>
                <c:pt idx="4442">
                  <c:v>1.8167425365421199</c:v>
                </c:pt>
                <c:pt idx="4443">
                  <c:v>1.41273736562805</c:v>
                </c:pt>
                <c:pt idx="4444">
                  <c:v>1.02927473395518</c:v>
                </c:pt>
                <c:pt idx="4445">
                  <c:v>0.87793404502693295</c:v>
                </c:pt>
                <c:pt idx="4446">
                  <c:v>0.98112563091308702</c:v>
                </c:pt>
                <c:pt idx="4447">
                  <c:v>0.84298711551943095</c:v>
                </c:pt>
                <c:pt idx="4448">
                  <c:v>0.81667374207853904</c:v>
                </c:pt>
                <c:pt idx="4449">
                  <c:v>0.99732761439748696</c:v>
                </c:pt>
                <c:pt idx="4450">
                  <c:v>1.24346493794079</c:v>
                </c:pt>
                <c:pt idx="4451">
                  <c:v>0.66621509614492103</c:v>
                </c:pt>
                <c:pt idx="4452">
                  <c:v>0.96642532300798301</c:v>
                </c:pt>
                <c:pt idx="4453">
                  <c:v>2.3171831009880099</c:v>
                </c:pt>
                <c:pt idx="4454">
                  <c:v>1.8021413305854199</c:v>
                </c:pt>
                <c:pt idx="4455">
                  <c:v>2.02947191279116</c:v>
                </c:pt>
                <c:pt idx="4456">
                  <c:v>1.4606444629577899</c:v>
                </c:pt>
                <c:pt idx="4457">
                  <c:v>1.9452706713652099</c:v>
                </c:pt>
                <c:pt idx="4458">
                  <c:v>1.30290872119207</c:v>
                </c:pt>
                <c:pt idx="4459">
                  <c:v>1.16436113221587</c:v>
                </c:pt>
                <c:pt idx="4460">
                  <c:v>1.4051001990029199</c:v>
                </c:pt>
                <c:pt idx="4461">
                  <c:v>1.4471238126263599</c:v>
                </c:pt>
                <c:pt idx="4462">
                  <c:v>1.18043139570563</c:v>
                </c:pt>
                <c:pt idx="4463">
                  <c:v>1.31926019939549</c:v>
                </c:pt>
                <c:pt idx="4464">
                  <c:v>1.5419624853847</c:v>
                </c:pt>
                <c:pt idx="4465">
                  <c:v>0.99195983895626805</c:v>
                </c:pt>
                <c:pt idx="4466">
                  <c:v>1.5885640640485701</c:v>
                </c:pt>
                <c:pt idx="4467">
                  <c:v>1.28999877109563</c:v>
                </c:pt>
                <c:pt idx="4468">
                  <c:v>1.87826446787081</c:v>
                </c:pt>
                <c:pt idx="4469">
                  <c:v>2.0648744055420898</c:v>
                </c:pt>
                <c:pt idx="4470">
                  <c:v>1.6228184457984101</c:v>
                </c:pt>
                <c:pt idx="4471">
                  <c:v>1.7248376221941899</c:v>
                </c:pt>
                <c:pt idx="4472">
                  <c:v>1.1795621993104299</c:v>
                </c:pt>
                <c:pt idx="4473">
                  <c:v>1.20380350433353</c:v>
                </c:pt>
                <c:pt idx="4474">
                  <c:v>1.64690537039206</c:v>
                </c:pt>
                <c:pt idx="4475">
                  <c:v>1.4798751151243299</c:v>
                </c:pt>
                <c:pt idx="4476">
                  <c:v>2.1318780580543599</c:v>
                </c:pt>
                <c:pt idx="4477">
                  <c:v>1.2862111964193701</c:v>
                </c:pt>
                <c:pt idx="4478">
                  <c:v>1.5705418986934501</c:v>
                </c:pt>
                <c:pt idx="4479">
                  <c:v>1.2686908739781699</c:v>
                </c:pt>
                <c:pt idx="4480">
                  <c:v>1.04593686410914</c:v>
                </c:pt>
                <c:pt idx="4481">
                  <c:v>1.20826305203859</c:v>
                </c:pt>
                <c:pt idx="4482">
                  <c:v>1.7462782625951501</c:v>
                </c:pt>
                <c:pt idx="4483">
                  <c:v>1.50474387813171</c:v>
                </c:pt>
                <c:pt idx="4484">
                  <c:v>1.0006046553727701</c:v>
                </c:pt>
                <c:pt idx="4485">
                  <c:v>1.5705404748488201</c:v>
                </c:pt>
                <c:pt idx="4486">
                  <c:v>1.20100381941879</c:v>
                </c:pt>
                <c:pt idx="4487">
                  <c:v>1.7562032140889501</c:v>
                </c:pt>
                <c:pt idx="4488">
                  <c:v>1.54672926204685</c:v>
                </c:pt>
                <c:pt idx="4489">
                  <c:v>2.03079578797428</c:v>
                </c:pt>
                <c:pt idx="4490">
                  <c:v>1.8180211753800799</c:v>
                </c:pt>
                <c:pt idx="4491">
                  <c:v>1.80733869868137</c:v>
                </c:pt>
                <c:pt idx="4492">
                  <c:v>2.1212946391616598</c:v>
                </c:pt>
                <c:pt idx="4493">
                  <c:v>1.28771738591823</c:v>
                </c:pt>
                <c:pt idx="4494">
                  <c:v>1.93413724685578</c:v>
                </c:pt>
                <c:pt idx="4495">
                  <c:v>1.8251742022266599</c:v>
                </c:pt>
                <c:pt idx="4496">
                  <c:v>2.3569136101555799</c:v>
                </c:pt>
                <c:pt idx="4497">
                  <c:v>1.20348265468348</c:v>
                </c:pt>
                <c:pt idx="4498">
                  <c:v>1.8475621196532901</c:v>
                </c:pt>
                <c:pt idx="4499">
                  <c:v>0.98082006847493697</c:v>
                </c:pt>
                <c:pt idx="4500">
                  <c:v>1.8252813184210801</c:v>
                </c:pt>
                <c:pt idx="4501">
                  <c:v>1.2642920835479099</c:v>
                </c:pt>
                <c:pt idx="4502">
                  <c:v>1.4608321474301</c:v>
                </c:pt>
                <c:pt idx="4503">
                  <c:v>1.6842708290241599</c:v>
                </c:pt>
                <c:pt idx="4504">
                  <c:v>1.4304885345430001</c:v>
                </c:pt>
                <c:pt idx="4505">
                  <c:v>1.71376458043488</c:v>
                </c:pt>
                <c:pt idx="4506">
                  <c:v>2.4109100549356799</c:v>
                </c:pt>
                <c:pt idx="4507">
                  <c:v>1.9955065825796501</c:v>
                </c:pt>
                <c:pt idx="4508">
                  <c:v>1.9379642797766301</c:v>
                </c:pt>
                <c:pt idx="4509">
                  <c:v>1.6565842625170399</c:v>
                </c:pt>
                <c:pt idx="4510">
                  <c:v>1.8897218001835701</c:v>
                </c:pt>
                <c:pt idx="4511">
                  <c:v>1.8776896429184899</c:v>
                </c:pt>
                <c:pt idx="4512">
                  <c:v>1.9087967617730699</c:v>
                </c:pt>
                <c:pt idx="4513">
                  <c:v>1.94275979959435</c:v>
                </c:pt>
                <c:pt idx="4514">
                  <c:v>1.7886576654175099</c:v>
                </c:pt>
                <c:pt idx="4515">
                  <c:v>1.90239056685587</c:v>
                </c:pt>
                <c:pt idx="4516">
                  <c:v>1.7168143647504399</c:v>
                </c:pt>
                <c:pt idx="4517">
                  <c:v>1.3442376912056899</c:v>
                </c:pt>
                <c:pt idx="4518">
                  <c:v>1.6686090112560401</c:v>
                </c:pt>
                <c:pt idx="4519">
                  <c:v>2.3175855075444902</c:v>
                </c:pt>
                <c:pt idx="4520">
                  <c:v>1.33813896919792</c:v>
                </c:pt>
                <c:pt idx="4521">
                  <c:v>1.5314897759463999</c:v>
                </c:pt>
                <c:pt idx="4522">
                  <c:v>1.6112455386914899</c:v>
                </c:pt>
                <c:pt idx="4523">
                  <c:v>1.73321301907266</c:v>
                </c:pt>
                <c:pt idx="4524">
                  <c:v>1.8411735775831699</c:v>
                </c:pt>
                <c:pt idx="4525">
                  <c:v>1.28127201291631</c:v>
                </c:pt>
                <c:pt idx="4526">
                  <c:v>1.59600335978033</c:v>
                </c:pt>
                <c:pt idx="4527">
                  <c:v>1.5883286910087999</c:v>
                </c:pt>
                <c:pt idx="4528">
                  <c:v>1.3177347327303299</c:v>
                </c:pt>
                <c:pt idx="4529">
                  <c:v>1.7565817952387499</c:v>
                </c:pt>
                <c:pt idx="4530">
                  <c:v>1.5818019336025499</c:v>
                </c:pt>
                <c:pt idx="4531">
                  <c:v>1.19858259757437</c:v>
                </c:pt>
                <c:pt idx="4532">
                  <c:v>1.5128900324875101</c:v>
                </c:pt>
                <c:pt idx="4533">
                  <c:v>1.8641389395348</c:v>
                </c:pt>
                <c:pt idx="4534">
                  <c:v>1.35726346622373</c:v>
                </c:pt>
                <c:pt idx="4535">
                  <c:v>1.36319597646458</c:v>
                </c:pt>
                <c:pt idx="4536">
                  <c:v>1.3840384963077801</c:v>
                </c:pt>
                <c:pt idx="4537">
                  <c:v>1.6933169942203601</c:v>
                </c:pt>
                <c:pt idx="4538">
                  <c:v>1.7803200259338401</c:v>
                </c:pt>
                <c:pt idx="4539">
                  <c:v>1.5179320465516299</c:v>
                </c:pt>
                <c:pt idx="4540">
                  <c:v>1.43494406099329</c:v>
                </c:pt>
                <c:pt idx="4541">
                  <c:v>1.7747682061118299</c:v>
                </c:pt>
                <c:pt idx="4542">
                  <c:v>1.5933244286127499</c:v>
                </c:pt>
                <c:pt idx="4543">
                  <c:v>1.9469066120434499</c:v>
                </c:pt>
                <c:pt idx="4544">
                  <c:v>1.6589870621578799</c:v>
                </c:pt>
                <c:pt idx="4545">
                  <c:v>1.31594251158783</c:v>
                </c:pt>
                <c:pt idx="4546">
                  <c:v>1.3806467746142901</c:v>
                </c:pt>
                <c:pt idx="4547">
                  <c:v>1.7489183946619</c:v>
                </c:pt>
                <c:pt idx="4548">
                  <c:v>1.82482890293782</c:v>
                </c:pt>
                <c:pt idx="4549">
                  <c:v>1.71021372974549</c:v>
                </c:pt>
                <c:pt idx="4550">
                  <c:v>1.7673994487293101</c:v>
                </c:pt>
                <c:pt idx="4551">
                  <c:v>1.95677590066644</c:v>
                </c:pt>
                <c:pt idx="4552">
                  <c:v>1.69708616420547</c:v>
                </c:pt>
                <c:pt idx="4553">
                  <c:v>1.6048837835460801</c:v>
                </c:pt>
                <c:pt idx="4554">
                  <c:v>1.90430578863593</c:v>
                </c:pt>
                <c:pt idx="4555">
                  <c:v>1.9519725580538501</c:v>
                </c:pt>
                <c:pt idx="4556">
                  <c:v>2.1781866726638399</c:v>
                </c:pt>
                <c:pt idx="4557">
                  <c:v>1.73913768142655</c:v>
                </c:pt>
                <c:pt idx="4558">
                  <c:v>2.23546601328552</c:v>
                </c:pt>
                <c:pt idx="4559">
                  <c:v>2.1174902612178501</c:v>
                </c:pt>
                <c:pt idx="4560">
                  <c:v>1.7388136523423501</c:v>
                </c:pt>
                <c:pt idx="4561">
                  <c:v>1.6695123100834099</c:v>
                </c:pt>
                <c:pt idx="4562">
                  <c:v>1.5513998460078799</c:v>
                </c:pt>
                <c:pt idx="4563">
                  <c:v>1.8982189175558</c:v>
                </c:pt>
                <c:pt idx="4564">
                  <c:v>1.4615708115594099</c:v>
                </c:pt>
                <c:pt idx="4565">
                  <c:v>1.31235843420315</c:v>
                </c:pt>
                <c:pt idx="4566">
                  <c:v>1.9887827451706599</c:v>
                </c:pt>
                <c:pt idx="4567">
                  <c:v>1.6518244405153799</c:v>
                </c:pt>
                <c:pt idx="4568">
                  <c:v>1.8616303548927899</c:v>
                </c:pt>
                <c:pt idx="4569">
                  <c:v>1.8862297126557701</c:v>
                </c:pt>
                <c:pt idx="4570">
                  <c:v>1.95540691011451</c:v>
                </c:pt>
                <c:pt idx="4571">
                  <c:v>1.9413213464999799</c:v>
                </c:pt>
                <c:pt idx="4572">
                  <c:v>1.3406121959194199</c:v>
                </c:pt>
                <c:pt idx="4573">
                  <c:v>2.0805910439696498</c:v>
                </c:pt>
                <c:pt idx="4574">
                  <c:v>2.7507376535921702</c:v>
                </c:pt>
                <c:pt idx="4575">
                  <c:v>2.8698104147689301</c:v>
                </c:pt>
                <c:pt idx="4576">
                  <c:v>3.2098423660590201</c:v>
                </c:pt>
                <c:pt idx="4577">
                  <c:v>3.34679934348868</c:v>
                </c:pt>
                <c:pt idx="4578">
                  <c:v>3.3742393377355802</c:v>
                </c:pt>
                <c:pt idx="4579">
                  <c:v>2.9728174056974099</c:v>
                </c:pt>
                <c:pt idx="4580">
                  <c:v>2.4479646534586199</c:v>
                </c:pt>
                <c:pt idx="4581">
                  <c:v>2.7448532368202598</c:v>
                </c:pt>
                <c:pt idx="4582">
                  <c:v>2.8055336051828399</c:v>
                </c:pt>
                <c:pt idx="4583">
                  <c:v>2.9471126646697199</c:v>
                </c:pt>
                <c:pt idx="4584">
                  <c:v>2.5352129889084498</c:v>
                </c:pt>
                <c:pt idx="4585">
                  <c:v>3.5200013168399198</c:v>
                </c:pt>
                <c:pt idx="4586">
                  <c:v>3.3097957128165798</c:v>
                </c:pt>
                <c:pt idx="4587">
                  <c:v>3.2481175182084598</c:v>
                </c:pt>
                <c:pt idx="4588">
                  <c:v>3.2890436936224599</c:v>
                </c:pt>
                <c:pt idx="4589">
                  <c:v>3.0158411125857998</c:v>
                </c:pt>
                <c:pt idx="4590">
                  <c:v>3.6962844480802799</c:v>
                </c:pt>
                <c:pt idx="4591">
                  <c:v>2.8717854026179901</c:v>
                </c:pt>
                <c:pt idx="4592">
                  <c:v>2.2543824512402102</c:v>
                </c:pt>
                <c:pt idx="4593">
                  <c:v>3.0887092850890698</c:v>
                </c:pt>
                <c:pt idx="4594">
                  <c:v>3.3163897756610599</c:v>
                </c:pt>
                <c:pt idx="4595">
                  <c:v>3.4112744694969299</c:v>
                </c:pt>
                <c:pt idx="4596">
                  <c:v>2.9672955312098299</c:v>
                </c:pt>
                <c:pt idx="4597">
                  <c:v>3.2035642387284402</c:v>
                </c:pt>
                <c:pt idx="4598">
                  <c:v>2.75822468781372</c:v>
                </c:pt>
                <c:pt idx="4599">
                  <c:v>3.0274074395302399</c:v>
                </c:pt>
                <c:pt idx="4600">
                  <c:v>2.6146342624019101</c:v>
                </c:pt>
                <c:pt idx="4601">
                  <c:v>3.2162595398606202</c:v>
                </c:pt>
                <c:pt idx="4602">
                  <c:v>2.85217988705356</c:v>
                </c:pt>
                <c:pt idx="4603">
                  <c:v>3.6301124278991401</c:v>
                </c:pt>
                <c:pt idx="4604">
                  <c:v>2.8400201985654698</c:v>
                </c:pt>
                <c:pt idx="4605">
                  <c:v>2.8026815329728301</c:v>
                </c:pt>
                <c:pt idx="4606">
                  <c:v>2.70194052262354</c:v>
                </c:pt>
                <c:pt idx="4607">
                  <c:v>1.4055375933574701</c:v>
                </c:pt>
                <c:pt idx="4608">
                  <c:v>1.0392759810550301</c:v>
                </c:pt>
                <c:pt idx="4609">
                  <c:v>1.7194871562521099</c:v>
                </c:pt>
                <c:pt idx="4610">
                  <c:v>1.66890013194568</c:v>
                </c:pt>
                <c:pt idx="4611">
                  <c:v>1.84265356065874</c:v>
                </c:pt>
                <c:pt idx="4612">
                  <c:v>2.5818763292976601</c:v>
                </c:pt>
                <c:pt idx="4613">
                  <c:v>1.4022926830043301</c:v>
                </c:pt>
                <c:pt idx="4614">
                  <c:v>1.5332296259960201</c:v>
                </c:pt>
                <c:pt idx="4615">
                  <c:v>2.1171873286971299</c:v>
                </c:pt>
                <c:pt idx="4616">
                  <c:v>1.8313812431890999</c:v>
                </c:pt>
                <c:pt idx="4617">
                  <c:v>1.7191609980265401</c:v>
                </c:pt>
                <c:pt idx="4618">
                  <c:v>1.7239421875190399</c:v>
                </c:pt>
                <c:pt idx="4619">
                  <c:v>2.0396787490878201</c:v>
                </c:pt>
                <c:pt idx="4620">
                  <c:v>1.7085058593281801</c:v>
                </c:pt>
                <c:pt idx="4621">
                  <c:v>2.98818657380053</c:v>
                </c:pt>
                <c:pt idx="4622">
                  <c:v>1.6958658069319601</c:v>
                </c:pt>
                <c:pt idx="4623">
                  <c:v>1.9903022504436001</c:v>
                </c:pt>
                <c:pt idx="4624">
                  <c:v>1.7701589033148</c:v>
                </c:pt>
                <c:pt idx="4625">
                  <c:v>2.1735950686357302</c:v>
                </c:pt>
                <c:pt idx="4626">
                  <c:v>2.21595427526425</c:v>
                </c:pt>
                <c:pt idx="4627">
                  <c:v>1.7264102634693099</c:v>
                </c:pt>
                <c:pt idx="4628">
                  <c:v>1.7697203408264099</c:v>
                </c:pt>
                <c:pt idx="4629">
                  <c:v>1.5238891109281401</c:v>
                </c:pt>
                <c:pt idx="4630">
                  <c:v>2.0286495962071198</c:v>
                </c:pt>
                <c:pt idx="4631">
                  <c:v>1.61299932892723</c:v>
                </c:pt>
                <c:pt idx="4632">
                  <c:v>2.24338223324908</c:v>
                </c:pt>
                <c:pt idx="4633">
                  <c:v>2.8042607602620699</c:v>
                </c:pt>
                <c:pt idx="4634">
                  <c:v>2.3172394377866699</c:v>
                </c:pt>
                <c:pt idx="4635">
                  <c:v>3.1026391457513798</c:v>
                </c:pt>
                <c:pt idx="4636">
                  <c:v>2.5567125710489602</c:v>
                </c:pt>
                <c:pt idx="4637">
                  <c:v>2.8560236180656902</c:v>
                </c:pt>
                <c:pt idx="4638">
                  <c:v>3.1706909076213101</c:v>
                </c:pt>
                <c:pt idx="4639">
                  <c:v>2.5364495404961098</c:v>
                </c:pt>
                <c:pt idx="4640">
                  <c:v>2.3194184053729701</c:v>
                </c:pt>
                <c:pt idx="4641">
                  <c:v>2.5567468432131899</c:v>
                </c:pt>
                <c:pt idx="4642">
                  <c:v>2.08921960756668</c:v>
                </c:pt>
                <c:pt idx="4643">
                  <c:v>1.7724910943230501</c:v>
                </c:pt>
                <c:pt idx="4644">
                  <c:v>2.8471722938383</c:v>
                </c:pt>
                <c:pt idx="4645">
                  <c:v>2.4381400428946201</c:v>
                </c:pt>
                <c:pt idx="4646">
                  <c:v>1.49463451574393</c:v>
                </c:pt>
                <c:pt idx="4647">
                  <c:v>0.74651779882809299</c:v>
                </c:pt>
                <c:pt idx="4648">
                  <c:v>0.96401827392786998</c:v>
                </c:pt>
                <c:pt idx="4649">
                  <c:v>1.0220361809616301</c:v>
                </c:pt>
                <c:pt idx="4650">
                  <c:v>1.6558444436083899</c:v>
                </c:pt>
                <c:pt idx="4651">
                  <c:v>2.2613664972385599</c:v>
                </c:pt>
                <c:pt idx="4652">
                  <c:v>1.6995710307043199</c:v>
                </c:pt>
                <c:pt idx="4653">
                  <c:v>1.53188790971271</c:v>
                </c:pt>
                <c:pt idx="4654">
                  <c:v>2.4898076814154</c:v>
                </c:pt>
                <c:pt idx="4655">
                  <c:v>1.8844917622061499</c:v>
                </c:pt>
                <c:pt idx="4656">
                  <c:v>1.61028975065533</c:v>
                </c:pt>
                <c:pt idx="4657">
                  <c:v>1.22532823081613</c:v>
                </c:pt>
                <c:pt idx="4658">
                  <c:v>1.81733135213229</c:v>
                </c:pt>
                <c:pt idx="4659">
                  <c:v>1.6823709017980799</c:v>
                </c:pt>
                <c:pt idx="4660">
                  <c:v>1.61965912984701</c:v>
                </c:pt>
                <c:pt idx="4661">
                  <c:v>1.1070423565235601</c:v>
                </c:pt>
                <c:pt idx="4662">
                  <c:v>1.9603012850497099</c:v>
                </c:pt>
                <c:pt idx="4663">
                  <c:v>1.2868727856998801</c:v>
                </c:pt>
                <c:pt idx="4664">
                  <c:v>1.1402644285196899</c:v>
                </c:pt>
                <c:pt idx="4665">
                  <c:v>1.7263030254260601</c:v>
                </c:pt>
                <c:pt idx="4666">
                  <c:v>1.53947141408261</c:v>
                </c:pt>
                <c:pt idx="4667">
                  <c:v>1.3428464961920401</c:v>
                </c:pt>
                <c:pt idx="4668">
                  <c:v>0.78859839440514101</c:v>
                </c:pt>
                <c:pt idx="4669">
                  <c:v>1.0851365895046401</c:v>
                </c:pt>
                <c:pt idx="4670">
                  <c:v>1.2435167006302099</c:v>
                </c:pt>
                <c:pt idx="4671">
                  <c:v>2.1088904667247399</c:v>
                </c:pt>
                <c:pt idx="4672">
                  <c:v>1.8528578444867101</c:v>
                </c:pt>
                <c:pt idx="4673">
                  <c:v>1.52766452867567</c:v>
                </c:pt>
                <c:pt idx="4674">
                  <c:v>2.2450102002827501</c:v>
                </c:pt>
                <c:pt idx="4675">
                  <c:v>2.10151024852733</c:v>
                </c:pt>
                <c:pt idx="4676">
                  <c:v>1.42283055613791</c:v>
                </c:pt>
                <c:pt idx="4677">
                  <c:v>1.6724594285281</c:v>
                </c:pt>
                <c:pt idx="4678">
                  <c:v>1.2033504855558801</c:v>
                </c:pt>
                <c:pt idx="4679">
                  <c:v>1.7328319991008001</c:v>
                </c:pt>
                <c:pt idx="4680">
                  <c:v>1.64780020020847</c:v>
                </c:pt>
                <c:pt idx="4681">
                  <c:v>2.41842908796683</c:v>
                </c:pt>
                <c:pt idx="4682">
                  <c:v>2.2071712329187201</c:v>
                </c:pt>
                <c:pt idx="4683">
                  <c:v>2.0721164962611001</c:v>
                </c:pt>
                <c:pt idx="4684">
                  <c:v>2.0231909874960898</c:v>
                </c:pt>
                <c:pt idx="4685">
                  <c:v>2.0101995368533898</c:v>
                </c:pt>
                <c:pt idx="4686">
                  <c:v>1.79031003200562</c:v>
                </c:pt>
                <c:pt idx="4687">
                  <c:v>1.8738664784316601</c:v>
                </c:pt>
                <c:pt idx="4688">
                  <c:v>1.3730056832236399</c:v>
                </c:pt>
                <c:pt idx="4689">
                  <c:v>1.10315419402281</c:v>
                </c:pt>
                <c:pt idx="4690">
                  <c:v>1.5159612445797901</c:v>
                </c:pt>
                <c:pt idx="4691">
                  <c:v>2.5048199199932801</c:v>
                </c:pt>
                <c:pt idx="4692">
                  <c:v>2.2360438261570201</c:v>
                </c:pt>
                <c:pt idx="4693">
                  <c:v>2.5292122683964</c:v>
                </c:pt>
                <c:pt idx="4694">
                  <c:v>1.78409974961528</c:v>
                </c:pt>
                <c:pt idx="4695">
                  <c:v>1.8438724506576301</c:v>
                </c:pt>
                <c:pt idx="4696">
                  <c:v>1.26996459797674</c:v>
                </c:pt>
                <c:pt idx="4697">
                  <c:v>1.2760495368777101</c:v>
                </c:pt>
                <c:pt idx="4698">
                  <c:v>1.8791555398779201</c:v>
                </c:pt>
                <c:pt idx="4699">
                  <c:v>1.4341921258072401</c:v>
                </c:pt>
                <c:pt idx="4700">
                  <c:v>0.91280535427088405</c:v>
                </c:pt>
                <c:pt idx="4701">
                  <c:v>1.2893338416258</c:v>
                </c:pt>
                <c:pt idx="4702">
                  <c:v>1.46824076407402</c:v>
                </c:pt>
                <c:pt idx="4703">
                  <c:v>1.6236625848798101</c:v>
                </c:pt>
                <c:pt idx="4704">
                  <c:v>1.7172695707714301</c:v>
                </c:pt>
                <c:pt idx="4705">
                  <c:v>0.78010861133672005</c:v>
                </c:pt>
                <c:pt idx="4706">
                  <c:v>2.1012667411133799</c:v>
                </c:pt>
                <c:pt idx="4707">
                  <c:v>0.73427683727831505</c:v>
                </c:pt>
                <c:pt idx="4708">
                  <c:v>1.1995720400457199</c:v>
                </c:pt>
                <c:pt idx="4709">
                  <c:v>0.55051993985509395</c:v>
                </c:pt>
                <c:pt idx="4710">
                  <c:v>0.715431864987078</c:v>
                </c:pt>
                <c:pt idx="4711">
                  <c:v>1.2473571704906199</c:v>
                </c:pt>
                <c:pt idx="4712">
                  <c:v>1.5844582642106699</c:v>
                </c:pt>
                <c:pt idx="4713">
                  <c:v>1.2406603726543599</c:v>
                </c:pt>
                <c:pt idx="4714">
                  <c:v>0.83366190768067905</c:v>
                </c:pt>
                <c:pt idx="4715">
                  <c:v>0.82197559889219496</c:v>
                </c:pt>
                <c:pt idx="4716">
                  <c:v>0.74937828297249298</c:v>
                </c:pt>
                <c:pt idx="4717">
                  <c:v>1.1478246461585799</c:v>
                </c:pt>
                <c:pt idx="4718">
                  <c:v>0.77700887077189096</c:v>
                </c:pt>
                <c:pt idx="4719">
                  <c:v>0.50937922487839604</c:v>
                </c:pt>
                <c:pt idx="4720">
                  <c:v>1.5594188466246699</c:v>
                </c:pt>
                <c:pt idx="4721">
                  <c:v>0.80700238483243503</c:v>
                </c:pt>
                <c:pt idx="4722">
                  <c:v>0.81579329206963602</c:v>
                </c:pt>
                <c:pt idx="4723">
                  <c:v>0.79741937137555097</c:v>
                </c:pt>
                <c:pt idx="4724">
                  <c:v>1.33600393559993</c:v>
                </c:pt>
                <c:pt idx="4725">
                  <c:v>1.2794764680778701</c:v>
                </c:pt>
                <c:pt idx="4726">
                  <c:v>0.69151859306853802</c:v>
                </c:pt>
                <c:pt idx="4727">
                  <c:v>0.74750039705224203</c:v>
                </c:pt>
                <c:pt idx="4728">
                  <c:v>1.2260975985401601</c:v>
                </c:pt>
                <c:pt idx="4729">
                  <c:v>1.81108295492027</c:v>
                </c:pt>
                <c:pt idx="4730">
                  <c:v>1.6122237902332099</c:v>
                </c:pt>
                <c:pt idx="4731">
                  <c:v>2.4006311450103599</c:v>
                </c:pt>
                <c:pt idx="4732">
                  <c:v>1.2958955900900799</c:v>
                </c:pt>
                <c:pt idx="4733">
                  <c:v>1.0877131715078401</c:v>
                </c:pt>
                <c:pt idx="4734">
                  <c:v>0.72639625913843398</c:v>
                </c:pt>
                <c:pt idx="4735">
                  <c:v>1.12304086089532</c:v>
                </c:pt>
                <c:pt idx="4736">
                  <c:v>0.64011048583597097</c:v>
                </c:pt>
                <c:pt idx="4737">
                  <c:v>1.39205173203069</c:v>
                </c:pt>
                <c:pt idx="4738">
                  <c:v>1.4077403368935999</c:v>
                </c:pt>
                <c:pt idx="4739">
                  <c:v>0.65239454551590503</c:v>
                </c:pt>
                <c:pt idx="4740">
                  <c:v>0.86929086699824798</c:v>
                </c:pt>
                <c:pt idx="4741">
                  <c:v>0.86722047453077999</c:v>
                </c:pt>
                <c:pt idx="4742">
                  <c:v>0.97562030411210299</c:v>
                </c:pt>
                <c:pt idx="4743">
                  <c:v>1.2916451989776101</c:v>
                </c:pt>
                <c:pt idx="4744">
                  <c:v>0.77894292719089397</c:v>
                </c:pt>
                <c:pt idx="4745">
                  <c:v>2.0681174926437298</c:v>
                </c:pt>
                <c:pt idx="4746">
                  <c:v>1.6921347574966099</c:v>
                </c:pt>
                <c:pt idx="4747">
                  <c:v>0.89939919277706304</c:v>
                </c:pt>
                <c:pt idx="4748">
                  <c:v>0.99196969979648997</c:v>
                </c:pt>
                <c:pt idx="4749">
                  <c:v>1.1019420776465101</c:v>
                </c:pt>
                <c:pt idx="4750">
                  <c:v>0.96206889543481799</c:v>
                </c:pt>
                <c:pt idx="4751">
                  <c:v>0.95754050643932398</c:v>
                </c:pt>
                <c:pt idx="4752">
                  <c:v>1.2008434350041901</c:v>
                </c:pt>
                <c:pt idx="4753">
                  <c:v>1.38680811950523</c:v>
                </c:pt>
                <c:pt idx="4754">
                  <c:v>1.0390157575225101</c:v>
                </c:pt>
                <c:pt idx="4755">
                  <c:v>0.64058560128909403</c:v>
                </c:pt>
                <c:pt idx="4756">
                  <c:v>1.0999752611042</c:v>
                </c:pt>
                <c:pt idx="4757">
                  <c:v>1.4252197696389799</c:v>
                </c:pt>
                <c:pt idx="4758">
                  <c:v>1.4060421283917699</c:v>
                </c:pt>
                <c:pt idx="4759">
                  <c:v>0.73644506867457904</c:v>
                </c:pt>
                <c:pt idx="4760">
                  <c:v>0.63601651717479701</c:v>
                </c:pt>
                <c:pt idx="4761">
                  <c:v>1.18225650147996</c:v>
                </c:pt>
                <c:pt idx="4762">
                  <c:v>1.66150371142529</c:v>
                </c:pt>
                <c:pt idx="4763">
                  <c:v>0.62803812880278798</c:v>
                </c:pt>
                <c:pt idx="4764">
                  <c:v>1.02680906787355</c:v>
                </c:pt>
                <c:pt idx="4765">
                  <c:v>0.74551256956313305</c:v>
                </c:pt>
                <c:pt idx="4766">
                  <c:v>0.84256381383037504</c:v>
                </c:pt>
                <c:pt idx="4767">
                  <c:v>0.85533198063149996</c:v>
                </c:pt>
                <c:pt idx="4768">
                  <c:v>0.728082579749329</c:v>
                </c:pt>
                <c:pt idx="4769">
                  <c:v>1.2209762052997799</c:v>
                </c:pt>
                <c:pt idx="4770">
                  <c:v>0.59950327714976104</c:v>
                </c:pt>
                <c:pt idx="4771">
                  <c:v>1.6723822936974799</c:v>
                </c:pt>
                <c:pt idx="4772">
                  <c:v>1.39702017501473</c:v>
                </c:pt>
                <c:pt idx="4773">
                  <c:v>1.3210029254854301</c:v>
                </c:pt>
                <c:pt idx="4774">
                  <c:v>1.16753647946896</c:v>
                </c:pt>
                <c:pt idx="4775">
                  <c:v>1.5444690043997</c:v>
                </c:pt>
                <c:pt idx="4776">
                  <c:v>1.4011535054400901</c:v>
                </c:pt>
                <c:pt idx="4777">
                  <c:v>1.4961362551433799</c:v>
                </c:pt>
                <c:pt idx="4778">
                  <c:v>1.10187299521211</c:v>
                </c:pt>
                <c:pt idx="4779">
                  <c:v>1.0034310597032201</c:v>
                </c:pt>
                <c:pt idx="4780">
                  <c:v>1.28056718870922</c:v>
                </c:pt>
                <c:pt idx="4781">
                  <c:v>1.3234205920545401</c:v>
                </c:pt>
                <c:pt idx="4782">
                  <c:v>1.48388797526334</c:v>
                </c:pt>
                <c:pt idx="4783">
                  <c:v>1.6533942313898999</c:v>
                </c:pt>
                <c:pt idx="4784">
                  <c:v>0.87863244012319697</c:v>
                </c:pt>
                <c:pt idx="4785">
                  <c:v>1.25163475402399</c:v>
                </c:pt>
                <c:pt idx="4786">
                  <c:v>0.88593351493845196</c:v>
                </c:pt>
                <c:pt idx="4787">
                  <c:v>0.83880944212075703</c:v>
                </c:pt>
                <c:pt idx="4788">
                  <c:v>1.01710139061106</c:v>
                </c:pt>
                <c:pt idx="4789">
                  <c:v>0.97265015901791896</c:v>
                </c:pt>
                <c:pt idx="4790">
                  <c:v>0.37258904423358902</c:v>
                </c:pt>
                <c:pt idx="4791">
                  <c:v>0.95754535782820005</c:v>
                </c:pt>
                <c:pt idx="4792">
                  <c:v>1.30545640988037</c:v>
                </c:pt>
                <c:pt idx="4793">
                  <c:v>0.67768873116282402</c:v>
                </c:pt>
                <c:pt idx="4794">
                  <c:v>0.99132167363003698</c:v>
                </c:pt>
                <c:pt idx="4795">
                  <c:v>0.52873569477146098</c:v>
                </c:pt>
                <c:pt idx="4796">
                  <c:v>0.74131644955119802</c:v>
                </c:pt>
                <c:pt idx="4797">
                  <c:v>0.40122061121757702</c:v>
                </c:pt>
                <c:pt idx="4798">
                  <c:v>0.29986108727404198</c:v>
                </c:pt>
                <c:pt idx="4799" formatCode="0.00E+00">
                  <c:v>6.7989240012200604E-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EB6-4E5B-A29A-C1E38892F6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3948831"/>
        <c:axId val="153932319"/>
      </c:scatterChart>
      <c:valAx>
        <c:axId val="153948831"/>
        <c:scaling>
          <c:orientation val="minMax"/>
          <c:max val="11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Time (</a:t>
                </a:r>
                <a:r>
                  <a:rPr lang="en-US" sz="1600" b="1" i="0" u="none" strike="noStrike" baseline="0" dirty="0">
                    <a:effectLst/>
                  </a:rPr>
                  <a:t>ns</a:t>
                </a:r>
                <a:r>
                  <a:rPr lang="en-US" b="1" dirty="0"/>
                  <a:t>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932319"/>
        <c:crosses val="autoZero"/>
        <c:crossBetween val="midCat"/>
      </c:valAx>
      <c:valAx>
        <c:axId val="15393231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Euclidean </a:t>
                </a:r>
                <a:r>
                  <a:rPr lang="en-US" b="1" dirty="0" smtClean="0"/>
                  <a:t>Distance (nm)</a:t>
                </a:r>
                <a:endParaRPr lang="en-US" b="1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948831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2703677810366411"/>
          <c:y val="5.9754435567940856E-2"/>
          <c:w val="0.44094457970177175"/>
          <c:h val="6.48635385890596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53B5B-37DB-40D6-B713-C01EABA17C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66E15A-EA49-4B28-A7EC-C039408871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AD384C-2471-4721-B18E-20BA6F818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C9CCC-3728-40B3-AC64-73E8131F6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C32E94-A6D1-4C60-B471-E93A9EC9D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703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BCF37D-C675-426F-BFB9-4D7E07760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20FFAA-4292-44AE-9D46-FC70E98094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3E11BB-1AD1-45E5-98DC-B1EF32FCA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32E9CC-AA3B-498F-8231-E121B96A1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0C5712-CF81-49BB-9894-A38C95D9A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257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240A22-D3D5-4EED-89C6-D38AEBEE37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461DA3-0FDC-4B2F-9D08-8BBEFB4D98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05FD2B-EE58-48E5-BDA3-DEBDD6146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B07EC-F2E5-4B74-A0DD-E3F09734A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ABA50B-34F6-44BF-A6DD-655CC8481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588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F6864-1502-4144-B26B-5ABE0FCA9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F77AF-B243-41EC-B21D-C1E0B17D32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ED7E2-BC5D-46A0-B57D-07A2979F3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1B3A35-28AD-4231-9CBB-2D08982A3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E1FBA8-4E64-412D-B9D4-E5FEBC9ACC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39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EEDBBC-3570-4A07-9F09-4A45C0601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89477B-F37B-48F9-95D2-D7D280DE2F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F3AE7-31F9-4882-B2AF-3BC4AD8D8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8F66D-3F53-4F8F-A862-47AFA1718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DED24-EB1F-4068-BE71-2654A6A6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573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08BE9-D1F4-40EB-AE0F-CF6DBC13C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93051D-B8C4-4D48-B41F-85D9A6D29E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0FA07A-6392-4865-9599-3970D6BBB6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BBF5BF-821B-42D2-AAF8-BE61C00CB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11E858-6E8B-4540-8F06-BE5F35348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6FE016-9135-4DCD-9095-5B0B407FA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634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1B0FD0-3BF8-4D03-8E15-DDC4B82C0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4BE530-6A3C-4F88-89B3-A737252CA4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8F2EE2-84CF-42EC-A0FC-2BC485251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14AD10-80BD-47E6-B1A1-EC63270C43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6A027F-EBBC-4500-8A4E-EDF9A72F36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8AA5B1-9973-4878-A51E-A48D6353D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2D5C42-E4F9-42AF-9721-970A2933B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261635-C6F8-4FDD-9E9A-6DB0CDA09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011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D80ED-2B2E-4974-AC6B-7A88D9A74B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0F3EBE-BC39-4C74-854D-98583B80D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C6AF39-7616-4D17-AA29-DE011EDAD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2819FC-A166-4269-9650-10A1EF8E1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68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81570A-C947-491F-9C6F-ABF16B4A5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4DC898-6757-4724-9B2E-0679F1435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F42D47-3A17-431A-ABC7-2D95B2537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746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ED122-CF45-4F0D-AAEC-024A40645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FF1C00-65DA-4076-ADBE-FEFAE64FCC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57695D-1F2B-4E82-A040-156B6B984D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AAD8C3-06B2-49FD-839D-292475918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428EB2-78FC-47EF-AD43-CC395A267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6368D6-EC79-4ACD-B8DD-02C6CC00B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743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2B9D1D-B59F-490A-805E-D9EEC10EAE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AD35D9-FCF4-49C3-9824-B92B97B2A0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40F76F-6CC6-4A0E-A65B-F60095963C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903259-D5B1-492D-ADDD-9DC82961B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597C25-345C-4BC8-9B34-D32FFE98A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B6961C-F362-4B8E-AAD2-AB465821A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548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9897D6-49F6-4F4D-92B7-8429831E20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82FEB9-7FA0-4B23-902A-13CE6363FA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274C39-EC11-4FBF-9623-37C35AFDA5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5A70A-C523-47AE-992E-011AAD39B01F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CB2E06-5115-4DCC-834A-822A2C4703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B7E142-26DF-4E83-9083-53098A7849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C8446-D9F6-4318-B20B-D2D976ECA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64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slideLayout" Target="../slideLayouts/slideLayout7.xml"/><Relationship Id="rId18" Type="http://schemas.openxmlformats.org/officeDocument/2006/relationships/image" Target="../media/image26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video" Target="../media/media6.mp4"/><Relationship Id="rId17" Type="http://schemas.openxmlformats.org/officeDocument/2006/relationships/image" Target="../media/image25.png"/><Relationship Id="rId2" Type="http://schemas.openxmlformats.org/officeDocument/2006/relationships/video" Target="../media/media1.mp4"/><Relationship Id="rId16" Type="http://schemas.openxmlformats.org/officeDocument/2006/relationships/image" Target="../media/image24.pn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microsoft.com/office/2007/relationships/media" Target="../media/media6.mp4"/><Relationship Id="rId5" Type="http://schemas.microsoft.com/office/2007/relationships/media" Target="../media/media3.mp4"/><Relationship Id="rId15" Type="http://schemas.openxmlformats.org/officeDocument/2006/relationships/image" Target="../media/image23.png"/><Relationship Id="rId10" Type="http://schemas.openxmlformats.org/officeDocument/2006/relationships/video" Target="../media/media5.mp4"/><Relationship Id="rId19" Type="http://schemas.openxmlformats.org/officeDocument/2006/relationships/image" Target="../media/image27.png"/><Relationship Id="rId4" Type="http://schemas.openxmlformats.org/officeDocument/2006/relationships/video" Target="../media/media2.mp4"/><Relationship Id="rId9" Type="http://schemas.microsoft.com/office/2007/relationships/media" Target="../media/media5.mp4"/><Relationship Id="rId1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E616D34-71BB-4C2F-BBF8-6AE808E2BEA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6143959" y="1583206"/>
            <a:ext cx="3821741" cy="347454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56C2194-E7AA-4534-AD60-E4AC7A9982C9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2226300" y="1583206"/>
            <a:ext cx="3822122" cy="347454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07996ED-B4F8-4427-BA26-C4AF6AA50436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5671390" y="2994876"/>
            <a:ext cx="70103" cy="6400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995368B-111C-415D-81A6-0AF38B24ED92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2958720" y="1470951"/>
            <a:ext cx="73151" cy="64005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871F780-E630-4B04-BD4B-0CB4EC88FE29}"/>
              </a:ext>
            </a:extLst>
          </p:cNvPr>
          <p:cNvSpPr/>
          <p:nvPr/>
        </p:nvSpPr>
        <p:spPr>
          <a:xfrm>
            <a:off x="3746870" y="992679"/>
            <a:ext cx="78098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epI</a:t>
            </a:r>
            <a:endParaRPr lang="en-US" sz="2400" b="1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685978A-845D-468B-BAC6-9B288CBF7F32}"/>
              </a:ext>
            </a:extLst>
          </p:cNvPr>
          <p:cNvSpPr/>
          <p:nvPr/>
        </p:nvSpPr>
        <p:spPr>
          <a:xfrm>
            <a:off x="7320493" y="992679"/>
            <a:ext cx="1468672" cy="4782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293370" marR="335280" indent="-6350">
              <a:lnSpc>
                <a:spcPct val="110000"/>
              </a:lnSpc>
              <a:spcBef>
                <a:spcPts val="0"/>
              </a:spcBef>
              <a:spcAft>
                <a:spcPts val="15"/>
              </a:spcAft>
            </a:pPr>
            <a:r>
              <a:rPr lang="en-US" sz="2400" b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GtfA</a:t>
            </a:r>
            <a:r>
              <a:rPr lang="en-US" sz="2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endParaRPr lang="en-US" sz="1400" b="1" dirty="0">
              <a:solidFill>
                <a:srgbClr val="0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C50A4A-A1F0-4E27-A0BA-3627A3056D8E}"/>
              </a:ext>
            </a:extLst>
          </p:cNvPr>
          <p:cNvSpPr txBox="1"/>
          <p:nvPr/>
        </p:nvSpPr>
        <p:spPr>
          <a:xfrm>
            <a:off x="2441080" y="5186616"/>
            <a:ext cx="6600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obal C</a:t>
            </a:r>
            <a:r>
              <a:rPr lang="el-GR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MSD of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pI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f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endParaRPr lang="en-US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6975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6F92F97A-5D7A-488D-BB23-A50731EB792A}"/>
              </a:ext>
            </a:extLst>
          </p:cNvPr>
          <p:cNvSpPr txBox="1"/>
          <p:nvPr/>
        </p:nvSpPr>
        <p:spPr>
          <a:xfrm>
            <a:off x="20869" y="5884706"/>
            <a:ext cx="121900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l-GR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MSD of Rossman fold motif secondary structure elements in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pI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f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MD simulation.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Group 51"/>
          <p:cNvGrpSpPr/>
          <p:nvPr/>
        </p:nvGrpSpPr>
        <p:grpSpPr>
          <a:xfrm>
            <a:off x="74565" y="181119"/>
            <a:ext cx="12044793" cy="5588796"/>
            <a:chOff x="147207" y="76344"/>
            <a:chExt cx="12044793" cy="5588796"/>
          </a:xfrm>
        </p:grpSpPr>
        <p:grpSp>
          <p:nvGrpSpPr>
            <p:cNvPr id="50" name="Group 49"/>
            <p:cNvGrpSpPr/>
            <p:nvPr/>
          </p:nvGrpSpPr>
          <p:grpSpPr>
            <a:xfrm>
              <a:off x="147207" y="76344"/>
              <a:ext cx="6041342" cy="5588796"/>
              <a:chOff x="147207" y="76344"/>
              <a:chExt cx="6041342" cy="558879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C6211C4-E90C-491F-A32B-FFB89B177614}"/>
                  </a:ext>
                </a:extLst>
              </p:cNvPr>
              <p:cNvPicPr/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42915" y="76344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75BA6418-9965-4CB2-81C0-2551B58C7F5C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307083" y="76344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28963F09-3FB7-4021-92AE-B459955CBE95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42849" y="3020634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BB056F1B-54A4-406C-9DE2-BE6C307B3B4D}"/>
                  </a:ext>
                </a:extLst>
              </p:cNvPr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307083" y="3045580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5BECE6EC-7054-4816-88CC-AC001956400D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672756" y="2162708"/>
                <a:ext cx="108403" cy="96352"/>
              </a:xfrm>
              <a:prstGeom prst="rect">
                <a:avLst/>
              </a:prstGeom>
            </p:spPr>
          </p:pic>
          <p:sp>
            <p:nvSpPr>
              <p:cNvPr id="14" name="Shape 201">
                <a:extLst>
                  <a:ext uri="{FF2B5EF4-FFF2-40B4-BE49-F238E27FC236}">
                    <a16:creationId xmlns:a16="http://schemas.microsoft.com/office/drawing/2014/main" id="{5775CD44-9DBB-4E49-B2E2-45BC96EE3160}"/>
                  </a:ext>
                </a:extLst>
              </p:cNvPr>
              <p:cNvSpPr/>
              <p:nvPr/>
            </p:nvSpPr>
            <p:spPr>
              <a:xfrm>
                <a:off x="147207" y="3201750"/>
                <a:ext cx="67375" cy="97436"/>
              </a:xfrm>
              <a:custGeom>
                <a:avLst/>
                <a:gdLst/>
                <a:ahLst/>
                <a:cxnLst/>
                <a:rect l="0" t="0" r="0" b="0"/>
                <a:pathLst>
                  <a:path w="68198" h="98634">
                    <a:moveTo>
                      <a:pt x="33819" y="381"/>
                    </a:moveTo>
                    <a:cubicBezTo>
                      <a:pt x="35952" y="0"/>
                      <a:pt x="38137" y="254"/>
                      <a:pt x="40359" y="1016"/>
                    </a:cubicBezTo>
                    <a:cubicBezTo>
                      <a:pt x="42582" y="1905"/>
                      <a:pt x="45020" y="3429"/>
                      <a:pt x="47687" y="5588"/>
                    </a:cubicBezTo>
                    <a:cubicBezTo>
                      <a:pt x="50342" y="7620"/>
                      <a:pt x="53212" y="10541"/>
                      <a:pt x="56298" y="14097"/>
                    </a:cubicBezTo>
                    <a:cubicBezTo>
                      <a:pt x="62470" y="21209"/>
                      <a:pt x="66077" y="27178"/>
                      <a:pt x="67131" y="32004"/>
                    </a:cubicBezTo>
                    <a:cubicBezTo>
                      <a:pt x="68198" y="36830"/>
                      <a:pt x="66940" y="40767"/>
                      <a:pt x="63372" y="43815"/>
                    </a:cubicBezTo>
                    <a:lnTo>
                      <a:pt x="0" y="98634"/>
                    </a:lnTo>
                    <a:lnTo>
                      <a:pt x="0" y="27337"/>
                    </a:lnTo>
                    <a:lnTo>
                      <a:pt x="28078" y="3048"/>
                    </a:lnTo>
                    <a:cubicBezTo>
                      <a:pt x="29768" y="1651"/>
                      <a:pt x="31685" y="635"/>
                      <a:pt x="33819" y="381"/>
                    </a:cubicBezTo>
                    <a:close/>
                  </a:path>
                </a:pathLst>
              </a:custGeom>
              <a:ln w="0" cap="flat">
                <a:miter lim="127000"/>
              </a:ln>
            </p:spPr>
            <p:style>
              <a:lnRef idx="0">
                <a:srgbClr val="000000">
                  <a:alpha val="0"/>
                </a:srgbClr>
              </a:lnRef>
              <a:fillRef idx="1">
                <a:srgbClr val="7F7F7F">
                  <a:alpha val="18039"/>
                </a:srgbClr>
              </a:fillRef>
              <a:effectRef idx="0">
                <a:scrgbClr r="0" g="0" b="0"/>
              </a:effectRef>
              <a:fontRef idx="none"/>
            </p:style>
            <p:txBody>
              <a:bodyPr/>
              <a:lstStyle/>
              <a:p>
                <a:endParaRPr lang="en-US"/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30FC710E-DD51-4896-96E2-52C4EA4342DC}"/>
                  </a:ext>
                </a:extLst>
              </p:cNvPr>
              <p:cNvSpPr/>
              <p:nvPr/>
            </p:nvSpPr>
            <p:spPr>
              <a:xfrm>
                <a:off x="3022250" y="2513714"/>
                <a:ext cx="849913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2400" b="1" dirty="0" err="1">
                    <a:solidFill>
                      <a:srgbClr val="000000"/>
                    </a:solidFill>
                    <a:latin typeface="Calibri" panose="020F0502020204030204" pitchFamily="34" charset="0"/>
                    <a:ea typeface="Calibri" panose="020F0502020204030204" pitchFamily="34" charset="0"/>
                  </a:rPr>
                  <a:t>HepI</a:t>
                </a:r>
                <a:r>
                  <a:rPr lang="en-US" sz="2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Calibri" panose="020F0502020204030204" pitchFamily="34" charset="0"/>
                  </a:rPr>
                  <a:t> </a:t>
                </a:r>
                <a:endParaRPr lang="en-US" sz="2400" b="1" dirty="0"/>
              </a:p>
            </p:txBody>
          </p:sp>
          <p:sp>
            <p:nvSpPr>
              <p:cNvPr id="2" name="Rectangle 1"/>
              <p:cNvSpPr/>
              <p:nvPr/>
            </p:nvSpPr>
            <p:spPr>
              <a:xfrm>
                <a:off x="819150" y="3527554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3872163" y="3040941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724112" y="76344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3770681" y="135464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A18A185E-2912-4CB6-8F8E-BFE8BCC2AB6C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992789" y="342465"/>
                <a:ext cx="108403" cy="96352"/>
              </a:xfrm>
              <a:prstGeom prst="rect">
                <a:avLst/>
              </a:prstGeom>
            </p:spPr>
          </p:pic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AFE0841D-7B8F-4458-84B1-D7C52E39E631}"/>
                  </a:ext>
                </a:extLst>
              </p:cNvPr>
              <p:cNvSpPr/>
              <p:nvPr/>
            </p:nvSpPr>
            <p:spPr>
              <a:xfrm>
                <a:off x="3780040" y="342465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a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A2060831-BD15-47DF-AD4E-312DB34A2810}"/>
                  </a:ext>
                </a:extLst>
              </p:cNvPr>
              <p:cNvSpPr/>
              <p:nvPr/>
            </p:nvSpPr>
            <p:spPr>
              <a:xfrm>
                <a:off x="734056" y="342465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b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A18A185E-2912-4CB6-8F8E-BFE8BCC2AB6C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983430" y="3276540"/>
                <a:ext cx="108403" cy="96352"/>
              </a:xfrm>
              <a:prstGeom prst="rect">
                <a:avLst/>
              </a:prstGeom>
            </p:spPr>
          </p:pic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AFE0841D-7B8F-4458-84B1-D7C52E39E631}"/>
                  </a:ext>
                </a:extLst>
              </p:cNvPr>
              <p:cNvSpPr/>
              <p:nvPr/>
            </p:nvSpPr>
            <p:spPr>
              <a:xfrm>
                <a:off x="3770681" y="3276540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a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A2060831-BD15-47DF-AD4E-312DB34A2810}"/>
                  </a:ext>
                </a:extLst>
              </p:cNvPr>
              <p:cNvSpPr/>
              <p:nvPr/>
            </p:nvSpPr>
            <p:spPr>
              <a:xfrm>
                <a:off x="724697" y="3276540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b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6429068" y="76344"/>
              <a:ext cx="5762932" cy="5588796"/>
              <a:chOff x="6429068" y="76344"/>
              <a:chExt cx="5762932" cy="5588796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03011B0-1BA4-4BF7-BDC3-9F8BDC9CDA7F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9310534" y="76344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29463D1B-6A96-4958-A4BA-35FB266F02AA}"/>
                  </a:ext>
                </a:extLst>
              </p:cNvPr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429068" y="76344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F55A4759-5EF9-4253-A225-8251542115B3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9310534" y="3045580"/>
                <a:ext cx="2881466" cy="261956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DA83A5EA-F682-4CE2-9447-5C6B05ED7930}"/>
                  </a:ext>
                </a:extLst>
              </p:cNvPr>
              <p:cNvPicPr/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429068" y="3045580"/>
                <a:ext cx="2881466" cy="2619560"/>
              </a:xfrm>
              <a:prstGeom prst="rect">
                <a:avLst/>
              </a:prstGeom>
            </p:spPr>
          </p:pic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B1176336-9118-4980-8BC0-07FE79A14443}"/>
                  </a:ext>
                </a:extLst>
              </p:cNvPr>
              <p:cNvSpPr/>
              <p:nvPr/>
            </p:nvSpPr>
            <p:spPr>
              <a:xfrm>
                <a:off x="9074800" y="2501188"/>
                <a:ext cx="840295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2400" b="1" dirty="0" err="1">
                    <a:solidFill>
                      <a:srgbClr val="000000"/>
                    </a:solidFill>
                    <a:latin typeface="Calibri" panose="020F0502020204030204" pitchFamily="34" charset="0"/>
                    <a:ea typeface="Calibri" panose="020F0502020204030204" pitchFamily="34" charset="0"/>
                  </a:rPr>
                  <a:t>GtfA</a:t>
                </a:r>
                <a:r>
                  <a:rPr lang="en-US" sz="2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Calibri" panose="020F0502020204030204" pitchFamily="34" charset="0"/>
                  </a:rPr>
                  <a:t> </a:t>
                </a:r>
                <a:endParaRPr lang="en-US" sz="2400" b="1" dirty="0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6936397" y="3040941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9741868" y="3048601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6847387" y="157954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9741868" y="127699"/>
                <a:ext cx="2085975" cy="3643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AFE0841D-7B8F-4458-84B1-D7C52E39E631}"/>
                  </a:ext>
                </a:extLst>
              </p:cNvPr>
              <p:cNvSpPr/>
              <p:nvPr/>
            </p:nvSpPr>
            <p:spPr>
              <a:xfrm>
                <a:off x="9741868" y="342465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a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A2060831-BD15-47DF-AD4E-312DB34A2810}"/>
                  </a:ext>
                </a:extLst>
              </p:cNvPr>
              <p:cNvSpPr/>
              <p:nvPr/>
            </p:nvSpPr>
            <p:spPr>
              <a:xfrm>
                <a:off x="6857809" y="342465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b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AFE0841D-7B8F-4458-84B1-D7C52E39E631}"/>
                  </a:ext>
                </a:extLst>
              </p:cNvPr>
              <p:cNvSpPr/>
              <p:nvPr/>
            </p:nvSpPr>
            <p:spPr>
              <a:xfrm>
                <a:off x="9732509" y="3276540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a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A2060831-BD15-47DF-AD4E-312DB34A2810}"/>
                  </a:ext>
                </a:extLst>
              </p:cNvPr>
              <p:cNvSpPr/>
              <p:nvPr/>
            </p:nvSpPr>
            <p:spPr>
              <a:xfrm>
                <a:off x="6848450" y="3276540"/>
                <a:ext cx="1375381" cy="332483"/>
              </a:xfrm>
              <a:prstGeom prst="rect">
                <a:avLst/>
              </a:prstGeom>
              <a:ln>
                <a:noFill/>
              </a:ln>
            </p:spPr>
            <p:txBody>
              <a:bodyPr vert="horz" lIns="0" tIns="0" rIns="0" bIns="0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8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-domain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: 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ea typeface="Times New Roman" panose="02020603050405020304" pitchFamily="18" charset="0"/>
                  </a:rPr>
                  <a:t>b</a:t>
                </a:r>
                <a:r>
                  <a:rPr lang="en-US" sz="18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 </a:t>
                </a:r>
                <a:endParaRPr lang="en-US" sz="11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81870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7004991-AB3C-4787-BEFD-E9D9A1F6B881}"/>
              </a:ext>
            </a:extLst>
          </p:cNvPr>
          <p:cNvSpPr txBox="1"/>
          <p:nvPr/>
        </p:nvSpPr>
        <p:spPr>
          <a:xfrm>
            <a:off x="1925" y="5978434"/>
            <a:ext cx="121900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 scatter plot of first three PCs plotted against each other and percentage proportion of variance of each PC for (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-D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HepI and (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-F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GtfA.</a:t>
            </a:r>
            <a:endParaRPr lang="en-US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427295" y="48341"/>
            <a:ext cx="5433393" cy="5782783"/>
            <a:chOff x="427295" y="48341"/>
            <a:chExt cx="5433393" cy="5782783"/>
          </a:xfrm>
        </p:grpSpPr>
        <p:pic>
          <p:nvPicPr>
            <p:cNvPr id="9" name="Picture 8" descr="A close up of text on a white background&#10;&#10;Description automatically generated">
              <a:extLst>
                <a:ext uri="{FF2B5EF4-FFF2-40B4-BE49-F238E27FC236}">
                  <a16:creationId xmlns:a16="http://schemas.microsoft.com/office/drawing/2014/main" id="{57957E16-8545-4B67-A66F-301F1AC7CE8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7295" y="397731"/>
              <a:ext cx="5433393" cy="5433393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0FC710E-DD51-4896-96E2-52C4EA4342DC}"/>
                </a:ext>
              </a:extLst>
            </p:cNvPr>
            <p:cNvSpPr/>
            <p:nvPr/>
          </p:nvSpPr>
          <p:spPr>
            <a:xfrm>
              <a:off x="3086796" y="48341"/>
              <a:ext cx="84991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 err="1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HepI</a:t>
              </a:r>
              <a:r>
                <a:rPr lang="en-US" sz="2400" b="1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 </a:t>
              </a:r>
              <a:endParaRPr lang="en-US" sz="2400" b="1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623100" y="5450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A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328200" y="5450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B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623100" y="32755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C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328200" y="32755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D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6155737" y="35815"/>
            <a:ext cx="5414764" cy="5795309"/>
            <a:chOff x="6155737" y="35815"/>
            <a:chExt cx="5414764" cy="5795309"/>
          </a:xfrm>
        </p:grpSpPr>
        <p:pic>
          <p:nvPicPr>
            <p:cNvPr id="4" name="Picture 3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FE248345-D8D3-46A9-A1C1-199143D975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55737" y="416360"/>
              <a:ext cx="5414764" cy="5414764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1176336-9118-4980-8BC0-07FE79A14443}"/>
                </a:ext>
              </a:extLst>
            </p:cNvPr>
            <p:cNvSpPr/>
            <p:nvPr/>
          </p:nvSpPr>
          <p:spPr>
            <a:xfrm>
              <a:off x="8827372" y="35815"/>
              <a:ext cx="84029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 err="1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GtfA</a:t>
              </a:r>
              <a:r>
                <a:rPr lang="en-US" sz="2400" b="1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 </a:t>
              </a:r>
              <a:endParaRPr lang="en-US" sz="24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338100" y="5704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E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043200" y="5704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F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338100" y="33009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G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1043200" y="3300941"/>
              <a:ext cx="3177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825172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7004991-AB3C-4787-BEFD-E9D9A1F6B881}"/>
              </a:ext>
            </a:extLst>
          </p:cNvPr>
          <p:cNvSpPr txBox="1"/>
          <p:nvPr/>
        </p:nvSpPr>
        <p:spPr>
          <a:xfrm>
            <a:off x="506750" y="6065875"/>
            <a:ext cx="112566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ncipal components 1-3 over time for (A-C) HepI and GtfA (D-F) from MD simulation.</a:t>
            </a:r>
            <a:endParaRPr lang="en-US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625938" y="1"/>
            <a:ext cx="10733895" cy="6065875"/>
            <a:chOff x="625938" y="1"/>
            <a:chExt cx="10733895" cy="6065875"/>
          </a:xfrm>
        </p:grpSpPr>
        <p:pic>
          <p:nvPicPr>
            <p:cNvPr id="25" name="Picture 24" descr="Chart, histogram&#10;&#10;Description automatically generated">
              <a:extLst>
                <a:ext uri="{FF2B5EF4-FFF2-40B4-BE49-F238E27FC236}">
                  <a16:creationId xmlns:a16="http://schemas.microsoft.com/office/drawing/2014/main" id="{B27583FB-39F9-4921-9589-8B94D9CB6F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5939" y="1"/>
              <a:ext cx="3227294" cy="3227294"/>
            </a:xfrm>
            <a:prstGeom prst="rect">
              <a:avLst/>
            </a:prstGeom>
          </p:spPr>
        </p:pic>
        <p:pic>
          <p:nvPicPr>
            <p:cNvPr id="27" name="Picture 26" descr="Chart, histogram&#10;&#10;Description automatically generated">
              <a:extLst>
                <a:ext uri="{FF2B5EF4-FFF2-40B4-BE49-F238E27FC236}">
                  <a16:creationId xmlns:a16="http://schemas.microsoft.com/office/drawing/2014/main" id="{CADA6956-E19E-41E9-A789-B6661C533A9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79239" y="1"/>
              <a:ext cx="3227294" cy="3227294"/>
            </a:xfrm>
            <a:prstGeom prst="rect">
              <a:avLst/>
            </a:prstGeom>
          </p:spPr>
        </p:pic>
        <p:pic>
          <p:nvPicPr>
            <p:cNvPr id="29" name="Picture 28" descr="Chart, histogram&#10;&#10;Description automatically generated">
              <a:extLst>
                <a:ext uri="{FF2B5EF4-FFF2-40B4-BE49-F238E27FC236}">
                  <a16:creationId xmlns:a16="http://schemas.microsoft.com/office/drawing/2014/main" id="{07817008-F25D-4AE3-A5EC-A925051C8E2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32539" y="1"/>
              <a:ext cx="3227294" cy="3227294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EB258AB-A853-4B7B-BE4E-18361C99E9FD}"/>
                </a:ext>
              </a:extLst>
            </p:cNvPr>
            <p:cNvSpPr txBox="1"/>
            <p:nvPr/>
          </p:nvSpPr>
          <p:spPr>
            <a:xfrm>
              <a:off x="685735" y="139377"/>
              <a:ext cx="33791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E0D9B96-CD7B-4D72-97A1-849941EB4EA4}"/>
                </a:ext>
              </a:extLst>
            </p:cNvPr>
            <p:cNvSpPr txBox="1"/>
            <p:nvPr/>
          </p:nvSpPr>
          <p:spPr>
            <a:xfrm>
              <a:off x="4669143" y="214108"/>
              <a:ext cx="3244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829A139-5CDB-427B-9C7B-DAAF57604F2D}"/>
                </a:ext>
              </a:extLst>
            </p:cNvPr>
            <p:cNvSpPr txBox="1"/>
            <p:nvPr/>
          </p:nvSpPr>
          <p:spPr>
            <a:xfrm>
              <a:off x="8783480" y="139377"/>
              <a:ext cx="31504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C</a:t>
              </a:r>
            </a:p>
          </p:txBody>
        </p:sp>
        <p:pic>
          <p:nvPicPr>
            <p:cNvPr id="9" name="Picture 8" descr="A close up of a tree&#10;&#10;Description automatically generated">
              <a:extLst>
                <a:ext uri="{FF2B5EF4-FFF2-40B4-BE49-F238E27FC236}">
                  <a16:creationId xmlns:a16="http://schemas.microsoft.com/office/drawing/2014/main" id="{75B9095F-DA41-44E1-973A-1DA1EBC7158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32538" y="2893807"/>
              <a:ext cx="3172069" cy="3172069"/>
            </a:xfrm>
            <a:prstGeom prst="rect">
              <a:avLst/>
            </a:prstGeom>
          </p:spPr>
        </p:pic>
        <p:pic>
          <p:nvPicPr>
            <p:cNvPr id="10" name="Picture 9" descr="A close up of a tree&#10;&#10;Description automatically generated">
              <a:extLst>
                <a:ext uri="{FF2B5EF4-FFF2-40B4-BE49-F238E27FC236}">
                  <a16:creationId xmlns:a16="http://schemas.microsoft.com/office/drawing/2014/main" id="{85C97AB8-8463-41BF-AB9A-EC10B124BF1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5938" y="2893806"/>
              <a:ext cx="3172069" cy="3172069"/>
            </a:xfrm>
            <a:prstGeom prst="rect">
              <a:avLst/>
            </a:prstGeom>
          </p:spPr>
        </p:pic>
        <p:pic>
          <p:nvPicPr>
            <p:cNvPr id="11" name="Picture 10" descr="A close up of a tree&#10;&#10;Description automatically generated">
              <a:extLst>
                <a:ext uri="{FF2B5EF4-FFF2-40B4-BE49-F238E27FC236}">
                  <a16:creationId xmlns:a16="http://schemas.microsoft.com/office/drawing/2014/main" id="{491B9412-6D05-40F3-A2F0-F371D65A4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79238" y="2893807"/>
              <a:ext cx="3172069" cy="317206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34CFD78-F031-4175-9FF7-49194D99A2A8}"/>
                </a:ext>
              </a:extLst>
            </p:cNvPr>
            <p:cNvSpPr txBox="1"/>
            <p:nvPr/>
          </p:nvSpPr>
          <p:spPr>
            <a:xfrm>
              <a:off x="707012" y="2970632"/>
              <a:ext cx="33282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D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3F2B032-3252-42B2-A29F-72684CE66D44}"/>
                </a:ext>
              </a:extLst>
            </p:cNvPr>
            <p:cNvSpPr txBox="1"/>
            <p:nvPr/>
          </p:nvSpPr>
          <p:spPr>
            <a:xfrm>
              <a:off x="4690420" y="3045363"/>
              <a:ext cx="3195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5365229-160E-446E-B09A-FF2D746711A0}"/>
                </a:ext>
              </a:extLst>
            </p:cNvPr>
            <p:cNvSpPr txBox="1"/>
            <p:nvPr/>
          </p:nvSpPr>
          <p:spPr>
            <a:xfrm>
              <a:off x="8804757" y="2970632"/>
              <a:ext cx="31030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86095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CDA921B-00C5-4665-ADF4-05C5A0053CC4}"/>
              </a:ext>
            </a:extLst>
          </p:cNvPr>
          <p:cNvSpPr txBox="1"/>
          <p:nvPr/>
        </p:nvSpPr>
        <p:spPr>
          <a:xfrm>
            <a:off x="999277" y="6211669"/>
            <a:ext cx="103676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jectories of top 3 principal components of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pI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-C)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f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-F). Fluctuation is represented by tube colored red (low), white (moderate), to blue (large). 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93303" y="131808"/>
            <a:ext cx="10956355" cy="6116630"/>
            <a:chOff x="93303" y="131808"/>
            <a:chExt cx="10956355" cy="6116630"/>
          </a:xfrm>
        </p:grpSpPr>
        <p:pic>
          <p:nvPicPr>
            <p:cNvPr id="4" name="HepI_PC1_bg-black">
              <a:hlinkClick r:id="" action="ppaction://media"/>
              <a:extLst>
                <a:ext uri="{FF2B5EF4-FFF2-40B4-BE49-F238E27FC236}">
                  <a16:creationId xmlns:a16="http://schemas.microsoft.com/office/drawing/2014/main" id="{AE248DF2-7E03-4F38-8121-028EE4F0E916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14"/>
            <a:stretch>
              <a:fillRect/>
            </a:stretch>
          </p:blipFill>
          <p:spPr>
            <a:xfrm>
              <a:off x="1043784" y="131809"/>
              <a:ext cx="3081649" cy="2993601"/>
            </a:xfrm>
            <a:prstGeom prst="rect">
              <a:avLst/>
            </a:prstGeom>
          </p:spPr>
        </p:pic>
        <p:pic>
          <p:nvPicPr>
            <p:cNvPr id="5" name="HepI_PC2_bg-black">
              <a:hlinkClick r:id="" action="ppaction://media"/>
              <a:extLst>
                <a:ext uri="{FF2B5EF4-FFF2-40B4-BE49-F238E27FC236}">
                  <a16:creationId xmlns:a16="http://schemas.microsoft.com/office/drawing/2014/main" id="{F0EBBDB7-E506-464B-8CAD-D8271ECFF3D5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15"/>
            <a:stretch>
              <a:fillRect/>
            </a:stretch>
          </p:blipFill>
          <p:spPr>
            <a:xfrm>
              <a:off x="4505897" y="131809"/>
              <a:ext cx="3081649" cy="2993602"/>
            </a:xfrm>
            <a:prstGeom prst="rect">
              <a:avLst/>
            </a:prstGeom>
          </p:spPr>
        </p:pic>
        <p:pic>
          <p:nvPicPr>
            <p:cNvPr id="6" name="HepI_PC3_bg-black">
              <a:hlinkClick r:id="" action="ppaction://media"/>
              <a:extLst>
                <a:ext uri="{FF2B5EF4-FFF2-40B4-BE49-F238E27FC236}">
                  <a16:creationId xmlns:a16="http://schemas.microsoft.com/office/drawing/2014/main" id="{59BCB83E-AD56-464E-A0BA-298A99D86C0E}"/>
                </a:ext>
              </a:extLst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16"/>
            <a:stretch>
              <a:fillRect/>
            </a:stretch>
          </p:blipFill>
          <p:spPr>
            <a:xfrm>
              <a:off x="7968009" y="131808"/>
              <a:ext cx="3081649" cy="2993602"/>
            </a:xfrm>
            <a:prstGeom prst="rect">
              <a:avLst/>
            </a:prstGeom>
          </p:spPr>
        </p:pic>
        <p:pic>
          <p:nvPicPr>
            <p:cNvPr id="8" name="GtfA_PC1_bg-black">
              <a:hlinkClick r:id="" action="ppaction://media"/>
              <a:extLst>
                <a:ext uri="{FF2B5EF4-FFF2-40B4-BE49-F238E27FC236}">
                  <a16:creationId xmlns:a16="http://schemas.microsoft.com/office/drawing/2014/main" id="{FFBD9FE1-8D6D-4BB7-AD07-92CA8F21EA4E}"/>
                </a:ext>
              </a:extLst>
            </p:cNvPr>
            <p:cNvPicPr>
              <a:picLocks noChangeAspect="1"/>
            </p:cNvPicPr>
            <p:nvPr>
              <a:videoFile r:link="rId8"/>
              <p:extLst>
                <p:ext uri="{DAA4B4D4-6D71-4841-9C94-3DE7FCFB9230}">
                  <p14:media xmlns:p14="http://schemas.microsoft.com/office/powerpoint/2010/main" r:embed="rId7"/>
                </p:ext>
              </p:extLst>
            </p:nvPr>
          </p:nvPicPr>
          <p:blipFill>
            <a:blip r:embed="rId17"/>
            <a:stretch>
              <a:fillRect/>
            </a:stretch>
          </p:blipFill>
          <p:spPr>
            <a:xfrm>
              <a:off x="1043784" y="3254836"/>
              <a:ext cx="3081649" cy="2993602"/>
            </a:xfrm>
            <a:prstGeom prst="rect">
              <a:avLst/>
            </a:prstGeom>
          </p:spPr>
        </p:pic>
        <p:pic>
          <p:nvPicPr>
            <p:cNvPr id="9" name="GtfA_PC2_bg-black">
              <a:hlinkClick r:id="" action="ppaction://media"/>
              <a:extLst>
                <a:ext uri="{FF2B5EF4-FFF2-40B4-BE49-F238E27FC236}">
                  <a16:creationId xmlns:a16="http://schemas.microsoft.com/office/drawing/2014/main" id="{A6A5E600-AA9D-41FE-B3B3-1B9CFD5CB387}"/>
                </a:ext>
              </a:extLst>
            </p:cNvPr>
            <p:cNvPicPr>
              <a:picLocks noChangeAspect="1"/>
            </p:cNvPicPr>
            <p:nvPr>
              <a:videoFile r:link="rId10"/>
              <p:extLst>
                <p:ext uri="{DAA4B4D4-6D71-4841-9C94-3DE7FCFB9230}">
                  <p14:media xmlns:p14="http://schemas.microsoft.com/office/powerpoint/2010/main" r:embed="rId9"/>
                </p:ext>
              </p:extLst>
            </p:nvPr>
          </p:nvPicPr>
          <p:blipFill>
            <a:blip r:embed="rId18"/>
            <a:stretch>
              <a:fillRect/>
            </a:stretch>
          </p:blipFill>
          <p:spPr>
            <a:xfrm>
              <a:off x="4505897" y="3254836"/>
              <a:ext cx="3081649" cy="2993602"/>
            </a:xfrm>
            <a:prstGeom prst="rect">
              <a:avLst/>
            </a:prstGeom>
          </p:spPr>
        </p:pic>
        <p:pic>
          <p:nvPicPr>
            <p:cNvPr id="10" name="GtfA_PC3_bg-black">
              <a:hlinkClick r:id="" action="ppaction://media"/>
              <a:extLst>
                <a:ext uri="{FF2B5EF4-FFF2-40B4-BE49-F238E27FC236}">
                  <a16:creationId xmlns:a16="http://schemas.microsoft.com/office/drawing/2014/main" id="{5159DD3A-CECC-4D87-B81F-33D6C91DB553}"/>
                </a:ext>
              </a:extLst>
            </p:cNvPr>
            <p:cNvPicPr>
              <a:picLocks noChangeAspect="1"/>
            </p:cNvPicPr>
            <p:nvPr>
              <a:videoFile r:link="rId12"/>
              <p:extLst>
                <p:ext uri="{DAA4B4D4-6D71-4841-9C94-3DE7FCFB9230}">
                  <p14:media xmlns:p14="http://schemas.microsoft.com/office/powerpoint/2010/main" r:embed="rId11"/>
                </p:ext>
              </p:extLst>
            </p:nvPr>
          </p:nvPicPr>
          <p:blipFill>
            <a:blip r:embed="rId19"/>
            <a:stretch>
              <a:fillRect/>
            </a:stretch>
          </p:blipFill>
          <p:spPr>
            <a:xfrm>
              <a:off x="7968009" y="3254836"/>
              <a:ext cx="3081649" cy="2993602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D3FA918B-FDD4-477F-93E3-A6903281747E}"/>
                </a:ext>
              </a:extLst>
            </p:cNvPr>
            <p:cNvSpPr/>
            <p:nvPr/>
          </p:nvSpPr>
          <p:spPr>
            <a:xfrm rot="16200000">
              <a:off x="-112363" y="1454844"/>
              <a:ext cx="81144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epI</a:t>
              </a:r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endParaRPr 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828C74D2-518C-4ED7-BF61-96655ED98D65}"/>
                </a:ext>
              </a:extLst>
            </p:cNvPr>
            <p:cNvSpPr/>
            <p:nvPr/>
          </p:nvSpPr>
          <p:spPr>
            <a:xfrm rot="16200000">
              <a:off x="-77657" y="4551582"/>
              <a:ext cx="809837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tfA</a:t>
              </a:r>
              <a:r>
                <a:rPr lang="en-US" sz="2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endParaRPr 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E07FF66-9321-4613-A7D5-FAE6FA1C466F}"/>
                </a:ext>
              </a:extLst>
            </p:cNvPr>
            <p:cNvSpPr txBox="1"/>
            <p:nvPr/>
          </p:nvSpPr>
          <p:spPr>
            <a:xfrm>
              <a:off x="1018749" y="3233122"/>
              <a:ext cx="40588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359CE6E-A283-4AD4-B675-A3FDE8E93E14}"/>
                </a:ext>
              </a:extLst>
            </p:cNvPr>
            <p:cNvSpPr txBox="1"/>
            <p:nvPr/>
          </p:nvSpPr>
          <p:spPr>
            <a:xfrm>
              <a:off x="4513866" y="3247907"/>
              <a:ext cx="3593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339D09E-717F-46E4-A01F-85F470206A6D}"/>
                </a:ext>
              </a:extLst>
            </p:cNvPr>
            <p:cNvSpPr txBox="1"/>
            <p:nvPr/>
          </p:nvSpPr>
          <p:spPr>
            <a:xfrm>
              <a:off x="8037391" y="3276976"/>
              <a:ext cx="34977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F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E21A8FD-3D17-456B-90ED-01622B0B2055}"/>
                </a:ext>
              </a:extLst>
            </p:cNvPr>
            <p:cNvSpPr txBox="1"/>
            <p:nvPr/>
          </p:nvSpPr>
          <p:spPr>
            <a:xfrm>
              <a:off x="999277" y="164331"/>
              <a:ext cx="39305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9F4671C-AECF-4702-8C5F-9FAC5D8B428B}"/>
                </a:ext>
              </a:extLst>
            </p:cNvPr>
            <p:cNvSpPr txBox="1"/>
            <p:nvPr/>
          </p:nvSpPr>
          <p:spPr>
            <a:xfrm>
              <a:off x="4555661" y="161385"/>
              <a:ext cx="38023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48CB077-D44D-4281-A735-9518262CC3BC}"/>
                </a:ext>
              </a:extLst>
            </p:cNvPr>
            <p:cNvSpPr txBox="1"/>
            <p:nvPr/>
          </p:nvSpPr>
          <p:spPr>
            <a:xfrm>
              <a:off x="8040374" y="170208"/>
              <a:ext cx="37542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bg1"/>
                  </a:solidFill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22879238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3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4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5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video>
              <p:cMediaNode vol="80000">
                <p:cTn id="6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D0EF4E5-118A-4D4D-8340-3675C3FAF098}"/>
              </a:ext>
            </a:extLst>
          </p:cNvPr>
          <p:cNvSpPr txBox="1"/>
          <p:nvPr/>
        </p:nvSpPr>
        <p:spPr>
          <a:xfrm>
            <a:off x="1074581" y="5443234"/>
            <a:ext cx="897306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6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irwise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uclidean distances between N and C domain center of masses for HepI and GtfA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er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urse of 1.15 </a:t>
            </a:r>
            <a:r>
              <a:rPr lang="el-GR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 MD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mulation (A) and its </a:t>
            </a:r>
          </a:p>
          <a:p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bability density distribution (B).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87081137-DD9F-474E-B142-850D935565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2803594"/>
              </p:ext>
            </p:extLst>
          </p:nvPr>
        </p:nvGraphicFramePr>
        <p:xfrm>
          <a:off x="999277" y="1442323"/>
          <a:ext cx="5289506" cy="3932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3090" y="1374392"/>
            <a:ext cx="4789710" cy="359228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89647" y="162440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698154" y="162440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t="17786" b="19740"/>
          <a:stretch/>
        </p:blipFill>
        <p:spPr>
          <a:xfrm>
            <a:off x="7283493" y="1702837"/>
            <a:ext cx="1914611" cy="2286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9820275" y="2628900"/>
            <a:ext cx="971550" cy="9429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7738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13">
            <a:extLst>
              <a:ext uri="{FF2B5EF4-FFF2-40B4-BE49-F238E27FC236}">
                <a16:creationId xmlns:a16="http://schemas.microsoft.com/office/drawing/2014/main" id="{585A9D07-7820-4F44-A31D-BBC840C135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5802692"/>
              </p:ext>
            </p:extLst>
          </p:nvPr>
        </p:nvGraphicFramePr>
        <p:xfrm>
          <a:off x="4298746" y="1473200"/>
          <a:ext cx="3441660" cy="36982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147220">
                  <a:extLst>
                    <a:ext uri="{9D8B030D-6E8A-4147-A177-3AD203B41FA5}">
                      <a16:colId xmlns:a16="http://schemas.microsoft.com/office/drawing/2014/main" val="2538754653"/>
                    </a:ext>
                  </a:extLst>
                </a:gridCol>
                <a:gridCol w="1147220">
                  <a:extLst>
                    <a:ext uri="{9D8B030D-6E8A-4147-A177-3AD203B41FA5}">
                      <a16:colId xmlns:a16="http://schemas.microsoft.com/office/drawing/2014/main" val="253111765"/>
                    </a:ext>
                  </a:extLst>
                </a:gridCol>
                <a:gridCol w="1147220">
                  <a:extLst>
                    <a:ext uri="{9D8B030D-6E8A-4147-A177-3AD203B41FA5}">
                      <a16:colId xmlns:a16="http://schemas.microsoft.com/office/drawing/2014/main" val="907814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Octa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/>
                      <a:r>
                        <a:rPr lang="en-US" sz="1400" dirty="0"/>
                        <a:t>HepI Occupancy</a:t>
                      </a:r>
                    </a:p>
                    <a:p>
                      <a:r>
                        <a:rPr lang="en-US" sz="1400" dirty="0"/>
                        <a:t>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GtfA Occupancy</a:t>
                      </a:r>
                    </a:p>
                    <a:p>
                      <a:r>
                        <a:rPr lang="en-US" sz="1400" dirty="0"/>
                        <a:t>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95668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8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7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56634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4.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5.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79473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I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1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20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35257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I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3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9.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45690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1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7.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1897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V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2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6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3267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V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3.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7.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58323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VI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6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5.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078553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75B0EDE-D7C4-42E3-8651-65133E01369D}"/>
              </a:ext>
            </a:extLst>
          </p:cNvPr>
          <p:cNvSpPr txBox="1"/>
          <p:nvPr/>
        </p:nvSpPr>
        <p:spPr>
          <a:xfrm>
            <a:off x="1728177" y="5731011"/>
            <a:ext cx="83558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1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cent occupancy of HepI and GtfA conformations within each octant in 3D PCA space.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425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98</TotalTime>
  <Words>282</Words>
  <Application>Microsoft Office PowerPoint</Application>
  <PresentationFormat>Widescreen</PresentationFormat>
  <Paragraphs>77</Paragraphs>
  <Slides>7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gin Nguyen</dc:creator>
  <cp:lastModifiedBy>Yuk Y Sham</cp:lastModifiedBy>
  <cp:revision>81</cp:revision>
  <dcterms:created xsi:type="dcterms:W3CDTF">2020-06-11T17:22:46Z</dcterms:created>
  <dcterms:modified xsi:type="dcterms:W3CDTF">2021-04-06T14:03:31Z</dcterms:modified>
</cp:coreProperties>
</file>